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4"/>
  </p:notesMasterIdLst>
  <p:sldIdLst>
    <p:sldId id="312" r:id="rId2"/>
    <p:sldId id="284" r:id="rId3"/>
  </p:sldIdLst>
  <p:sldSz cx="9144000" cy="10972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7D3E9"/>
    <a:srgbClr val="0099FF"/>
    <a:srgbClr val="3399FF"/>
    <a:srgbClr val="66CCFF"/>
    <a:srgbClr val="00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558" autoAdjust="0"/>
    <p:restoredTop sz="94660"/>
  </p:normalViewPr>
  <p:slideViewPr>
    <p:cSldViewPr snapToGrid="0">
      <p:cViewPr varScale="1">
        <p:scale>
          <a:sx n="72" d="100"/>
          <a:sy n="72" d="100"/>
        </p:scale>
        <p:origin x="2496"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hengliang wu" userId="be747eab44d2118b" providerId="LiveId" clId="{62ECCD5C-BBFA-4446-9F79-E8121A4B0B3A}"/>
    <pc:docChg chg="delSld">
      <pc:chgData name="zhengliang wu" userId="be747eab44d2118b" providerId="LiveId" clId="{62ECCD5C-BBFA-4446-9F79-E8121A4B0B3A}" dt="2020-01-28T04:08:13.476" v="1" actId="47"/>
      <pc:docMkLst>
        <pc:docMk/>
      </pc:docMkLst>
      <pc:sldChg chg="del">
        <pc:chgData name="zhengliang wu" userId="be747eab44d2118b" providerId="LiveId" clId="{62ECCD5C-BBFA-4446-9F79-E8121A4B0B3A}" dt="2020-01-28T04:08:13.476" v="1" actId="47"/>
        <pc:sldMkLst>
          <pc:docMk/>
          <pc:sldMk cId="3154670962" sldId="275"/>
        </pc:sldMkLst>
      </pc:sldChg>
      <pc:sldChg chg="del">
        <pc:chgData name="zhengliang wu" userId="be747eab44d2118b" providerId="LiveId" clId="{62ECCD5C-BBFA-4446-9F79-E8121A4B0B3A}" dt="2020-01-28T04:08:11.319" v="0" actId="47"/>
        <pc:sldMkLst>
          <pc:docMk/>
          <pc:sldMk cId="1635304775" sldId="300"/>
        </pc:sldMkLst>
      </pc:sldChg>
      <pc:sldChg chg="del">
        <pc:chgData name="zhengliang wu" userId="be747eab44d2118b" providerId="LiveId" clId="{62ECCD5C-BBFA-4446-9F79-E8121A4B0B3A}" dt="2020-01-28T04:08:11.319" v="0" actId="47"/>
        <pc:sldMkLst>
          <pc:docMk/>
          <pc:sldMk cId="2615028356" sldId="310"/>
        </pc:sldMkLst>
      </pc:sldChg>
      <pc:sldChg chg="del">
        <pc:chgData name="zhengliang wu" userId="be747eab44d2118b" providerId="LiveId" clId="{62ECCD5C-BBFA-4446-9F79-E8121A4B0B3A}" dt="2020-01-28T04:08:11.319" v="0" actId="47"/>
        <pc:sldMkLst>
          <pc:docMk/>
          <pc:sldMk cId="1065713140" sldId="322"/>
        </pc:sldMkLst>
      </pc:sldChg>
      <pc:sldChg chg="del">
        <pc:chgData name="zhengliang wu" userId="be747eab44d2118b" providerId="LiveId" clId="{62ECCD5C-BBFA-4446-9F79-E8121A4B0B3A}" dt="2020-01-28T04:08:11.319" v="0" actId="47"/>
        <pc:sldMkLst>
          <pc:docMk/>
          <pc:sldMk cId="1774586423" sldId="324"/>
        </pc:sldMkLst>
      </pc:sldChg>
    </pc:docChg>
  </pc:docChgLst>
</pc:chgInfo>
</file>

<file path=ppt/charts/_rels/chart1.xml.rels><?xml version="1.0" encoding="UTF-8" standalone="yes"?>
<Relationships xmlns="http://schemas.openxmlformats.org/package/2006/relationships"><Relationship Id="rId1"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v>LW RB</c:v>
          </c:tx>
          <c:spPr>
            <a:ln w="19050">
              <a:solidFill>
                <a:srgbClr val="404040"/>
              </a:solidFill>
              <a:prstDash val="solid"/>
              <a:round/>
            </a:ln>
            <a:effectLst/>
          </c:spPr>
          <c:marker>
            <c:symbol val="none"/>
          </c:marker>
          <c:xVal>
            <c:numRef>
              <c:f>'[RB revised.xlsx]Graph Calculations'!$I$5:$DKR$5</c:f>
              <c:numCache>
                <c:formatCode>General</c:formatCode>
                <c:ptCount val="3000"/>
                <c:pt idx="0">
                  <c:v>-4.4839420318603516</c:v>
                </c:pt>
                <c:pt idx="1">
                  <c:v>-4.4823541641235352</c:v>
                </c:pt>
                <c:pt idx="2">
                  <c:v>-4.4804472923278809</c:v>
                </c:pt>
                <c:pt idx="3">
                  <c:v>-4.4782752990722656</c:v>
                </c:pt>
                <c:pt idx="4">
                  <c:v>-4.4758825302124023</c:v>
                </c:pt>
                <c:pt idx="5">
                  <c:v>-4.4732933044433594</c:v>
                </c:pt>
                <c:pt idx="6">
                  <c:v>-4.4705348014831543</c:v>
                </c:pt>
                <c:pt idx="7">
                  <c:v>-4.4676203727722168</c:v>
                </c:pt>
                <c:pt idx="8">
                  <c:v>-4.4645686149597168</c:v>
                </c:pt>
                <c:pt idx="9">
                  <c:v>-4.4613857269287109</c:v>
                </c:pt>
                <c:pt idx="10">
                  <c:v>-4.4580903053283691</c:v>
                </c:pt>
                <c:pt idx="11">
                  <c:v>-4.4546909332275391</c:v>
                </c:pt>
                <c:pt idx="12">
                  <c:v>-4.4511928558349609</c:v>
                </c:pt>
                <c:pt idx="13">
                  <c:v>-4.4476103782653809</c:v>
                </c:pt>
                <c:pt idx="14">
                  <c:v>-4.4439449310302734</c:v>
                </c:pt>
                <c:pt idx="15">
                  <c:v>-4.4402093887329102</c:v>
                </c:pt>
                <c:pt idx="16">
                  <c:v>-4.4364070892333984</c:v>
                </c:pt>
                <c:pt idx="17">
                  <c:v>-4.4325389862060547</c:v>
                </c:pt>
                <c:pt idx="18">
                  <c:v>-4.4286084175109863</c:v>
                </c:pt>
                <c:pt idx="19">
                  <c:v>-4.4246253967285156</c:v>
                </c:pt>
                <c:pt idx="20">
                  <c:v>-4.420588493347168</c:v>
                </c:pt>
                <c:pt idx="21">
                  <c:v>-4.4165134429931641</c:v>
                </c:pt>
                <c:pt idx="22">
                  <c:v>-4.4123897552490234</c:v>
                </c:pt>
                <c:pt idx="23">
                  <c:v>-4.408226490020752</c:v>
                </c:pt>
                <c:pt idx="24">
                  <c:v>-4.4040179252624512</c:v>
                </c:pt>
                <c:pt idx="25">
                  <c:v>-4.399773120880127</c:v>
                </c:pt>
                <c:pt idx="26">
                  <c:v>-4.3954935073852539</c:v>
                </c:pt>
                <c:pt idx="27">
                  <c:v>-4.3911786079406738</c:v>
                </c:pt>
                <c:pt idx="28">
                  <c:v>-4.3868298530578613</c:v>
                </c:pt>
                <c:pt idx="29">
                  <c:v>-4.3824605941772461</c:v>
                </c:pt>
                <c:pt idx="30">
                  <c:v>-4.3780574798583984</c:v>
                </c:pt>
                <c:pt idx="31">
                  <c:v>-4.3736310005187988</c:v>
                </c:pt>
                <c:pt idx="32">
                  <c:v>-4.3691740036010742</c:v>
                </c:pt>
                <c:pt idx="33">
                  <c:v>-4.3646950721740723</c:v>
                </c:pt>
                <c:pt idx="34">
                  <c:v>-4.3601951599121094</c:v>
                </c:pt>
                <c:pt idx="35">
                  <c:v>-4.3556652069091797</c:v>
                </c:pt>
                <c:pt idx="36">
                  <c:v>-4.3511166572570801</c:v>
                </c:pt>
                <c:pt idx="37">
                  <c:v>-4.3465485572814941</c:v>
                </c:pt>
                <c:pt idx="38">
                  <c:v>-4.341956615447998</c:v>
                </c:pt>
                <c:pt idx="39">
                  <c:v>-4.33734130859375</c:v>
                </c:pt>
                <c:pt idx="40">
                  <c:v>-4.3327031135559082</c:v>
                </c:pt>
                <c:pt idx="41">
                  <c:v>-4.3280529975891113</c:v>
                </c:pt>
                <c:pt idx="42">
                  <c:v>-4.3233814239501953</c:v>
                </c:pt>
                <c:pt idx="43">
                  <c:v>-4.3186912536621094</c:v>
                </c:pt>
                <c:pt idx="44">
                  <c:v>-4.3139839172363281</c:v>
                </c:pt>
                <c:pt idx="45">
                  <c:v>-4.3092594146728516</c:v>
                </c:pt>
                <c:pt idx="46">
                  <c:v>-4.3045177459716797</c:v>
                </c:pt>
                <c:pt idx="47">
                  <c:v>-4.2997584342956543</c:v>
                </c:pt>
                <c:pt idx="48">
                  <c:v>-4.2949814796447754</c:v>
                </c:pt>
                <c:pt idx="49">
                  <c:v>-4.2901873588562012</c:v>
                </c:pt>
                <c:pt idx="50">
                  <c:v>-4.2853736877441406</c:v>
                </c:pt>
                <c:pt idx="51">
                  <c:v>-4.2805438041687012</c:v>
                </c:pt>
                <c:pt idx="52">
                  <c:v>-4.2757034301757813</c:v>
                </c:pt>
                <c:pt idx="53">
                  <c:v>-4.2708477973937988</c:v>
                </c:pt>
                <c:pt idx="54">
                  <c:v>-4.2659740447998047</c:v>
                </c:pt>
                <c:pt idx="55">
                  <c:v>-4.2610816955566406</c:v>
                </c:pt>
                <c:pt idx="56">
                  <c:v>-4.2561774253845215</c:v>
                </c:pt>
                <c:pt idx="57">
                  <c:v>-4.2512607574462891</c:v>
                </c:pt>
                <c:pt idx="58">
                  <c:v>-4.2463274002075195</c:v>
                </c:pt>
                <c:pt idx="59">
                  <c:v>-4.2413749694824219</c:v>
                </c:pt>
                <c:pt idx="60">
                  <c:v>-4.2364187240600586</c:v>
                </c:pt>
                <c:pt idx="61">
                  <c:v>-4.2314443588256836</c:v>
                </c:pt>
                <c:pt idx="62">
                  <c:v>-4.2264590263366699</c:v>
                </c:pt>
                <c:pt idx="63">
                  <c:v>-4.2214617729187012</c:v>
                </c:pt>
                <c:pt idx="64">
                  <c:v>-4.2164463996887207</c:v>
                </c:pt>
                <c:pt idx="65">
                  <c:v>-4.2114229202270508</c:v>
                </c:pt>
                <c:pt idx="66">
                  <c:v>-4.2063851356506348</c:v>
                </c:pt>
                <c:pt idx="67">
                  <c:v>-4.2013297080993652</c:v>
                </c:pt>
                <c:pt idx="68">
                  <c:v>-4.1962676048278809</c:v>
                </c:pt>
                <c:pt idx="69">
                  <c:v>-4.1911883354187012</c:v>
                </c:pt>
                <c:pt idx="70">
                  <c:v>-4.1861000061035156</c:v>
                </c:pt>
                <c:pt idx="71">
                  <c:v>-4.1809988021850586</c:v>
                </c:pt>
                <c:pt idx="72">
                  <c:v>-4.1758823394775391</c:v>
                </c:pt>
                <c:pt idx="73">
                  <c:v>-4.1707587242126465</c:v>
                </c:pt>
                <c:pt idx="74">
                  <c:v>-4.165626049041748</c:v>
                </c:pt>
                <c:pt idx="75">
                  <c:v>-4.1604800224304199</c:v>
                </c:pt>
                <c:pt idx="76">
                  <c:v>-4.1553211212158203</c:v>
                </c:pt>
                <c:pt idx="77">
                  <c:v>-4.1501526832580566</c:v>
                </c:pt>
                <c:pt idx="78">
                  <c:v>-4.1449699401855469</c:v>
                </c:pt>
                <c:pt idx="79">
                  <c:v>-4.1397790908813477</c:v>
                </c:pt>
                <c:pt idx="80">
                  <c:v>-4.1345720291137695</c:v>
                </c:pt>
                <c:pt idx="81">
                  <c:v>-4.129359245300293</c:v>
                </c:pt>
                <c:pt idx="82">
                  <c:v>-4.1241307258605957</c:v>
                </c:pt>
                <c:pt idx="83">
                  <c:v>-4.1188955307006836</c:v>
                </c:pt>
                <c:pt idx="84">
                  <c:v>-4.113645076751709</c:v>
                </c:pt>
                <c:pt idx="85">
                  <c:v>-4.1083869934082031</c:v>
                </c:pt>
                <c:pt idx="86">
                  <c:v>-4.103118896484375</c:v>
                </c:pt>
                <c:pt idx="87">
                  <c:v>-4.0978388786315918</c:v>
                </c:pt>
                <c:pt idx="88">
                  <c:v>-4.0925517082214355</c:v>
                </c:pt>
                <c:pt idx="89">
                  <c:v>-4.0872488021850586</c:v>
                </c:pt>
                <c:pt idx="90">
                  <c:v>-4.0819435119628906</c:v>
                </c:pt>
                <c:pt idx="91">
                  <c:v>-4.0766277313232422</c:v>
                </c:pt>
                <c:pt idx="92">
                  <c:v>-4.0712995529174805</c:v>
                </c:pt>
                <c:pt idx="93">
                  <c:v>-4.0659651756286621</c:v>
                </c:pt>
                <c:pt idx="94">
                  <c:v>-4.0606155395507813</c:v>
                </c:pt>
                <c:pt idx="95">
                  <c:v>-4.0552611351013184</c:v>
                </c:pt>
                <c:pt idx="96">
                  <c:v>-4.0498933792114258</c:v>
                </c:pt>
                <c:pt idx="97">
                  <c:v>-4.0445170402526855</c:v>
                </c:pt>
                <c:pt idx="98">
                  <c:v>-4.0391345024108887</c:v>
                </c:pt>
                <c:pt idx="99">
                  <c:v>-4.0337352752685547</c:v>
                </c:pt>
                <c:pt idx="100">
                  <c:v>-4.0283331871032715</c:v>
                </c:pt>
                <c:pt idx="101">
                  <c:v>-4.0229196548461914</c:v>
                </c:pt>
                <c:pt idx="102">
                  <c:v>-4.0174946784973145</c:v>
                </c:pt>
                <c:pt idx="103">
                  <c:v>-4.0120654106140137</c:v>
                </c:pt>
                <c:pt idx="104">
                  <c:v>-4.0066213607788086</c:v>
                </c:pt>
                <c:pt idx="105">
                  <c:v>-4.0011706352233887</c:v>
                </c:pt>
                <c:pt idx="106">
                  <c:v>-3.9957141876220703</c:v>
                </c:pt>
                <c:pt idx="107">
                  <c:v>-3.9902422428131104</c:v>
                </c:pt>
                <c:pt idx="108">
                  <c:v>-3.9847652912139893</c:v>
                </c:pt>
                <c:pt idx="109">
                  <c:v>-3.9792816638946533</c:v>
                </c:pt>
                <c:pt idx="110">
                  <c:v>-3.9737837314605713</c:v>
                </c:pt>
                <c:pt idx="111">
                  <c:v>-3.9682810306549072</c:v>
                </c:pt>
                <c:pt idx="112">
                  <c:v>-3.9627730846405029</c:v>
                </c:pt>
                <c:pt idx="113">
                  <c:v>-3.9572510719299316</c:v>
                </c:pt>
                <c:pt idx="114">
                  <c:v>-3.9517223834991455</c:v>
                </c:pt>
                <c:pt idx="115">
                  <c:v>-3.9461884498596191</c:v>
                </c:pt>
                <c:pt idx="116">
                  <c:v>-3.9406404495239258</c:v>
                </c:pt>
                <c:pt idx="117">
                  <c:v>-3.9350855350494385</c:v>
                </c:pt>
                <c:pt idx="118">
                  <c:v>-3.9295258522033691</c:v>
                </c:pt>
                <c:pt idx="119">
                  <c:v>-3.923957347869873</c:v>
                </c:pt>
                <c:pt idx="120">
                  <c:v>-3.9183762073516846</c:v>
                </c:pt>
                <c:pt idx="121">
                  <c:v>-3.9127919673919678</c:v>
                </c:pt>
                <c:pt idx="122">
                  <c:v>-3.9072010517120361</c:v>
                </c:pt>
                <c:pt idx="123">
                  <c:v>-3.9015941619873047</c:v>
                </c:pt>
                <c:pt idx="124">
                  <c:v>-3.8959836959838867</c:v>
                </c:pt>
                <c:pt idx="125">
                  <c:v>-3.8903684616088867</c:v>
                </c:pt>
                <c:pt idx="126">
                  <c:v>-3.8847403526306152</c:v>
                </c:pt>
                <c:pt idx="127">
                  <c:v>-3.879103422164917</c:v>
                </c:pt>
                <c:pt idx="128">
                  <c:v>-3.8734629154205322</c:v>
                </c:pt>
                <c:pt idx="129">
                  <c:v>-3.8678152561187744</c:v>
                </c:pt>
                <c:pt idx="130">
                  <c:v>-3.8621542453765869</c:v>
                </c:pt>
                <c:pt idx="131">
                  <c:v>-3.8564879894256592</c:v>
                </c:pt>
                <c:pt idx="132">
                  <c:v>-3.8508172035217285</c:v>
                </c:pt>
                <c:pt idx="133">
                  <c:v>-3.8451390266418457</c:v>
                </c:pt>
                <c:pt idx="134">
                  <c:v>-3.8394467830657959</c:v>
                </c:pt>
                <c:pt idx="135">
                  <c:v>-3.8337507247924805</c:v>
                </c:pt>
                <c:pt idx="136">
                  <c:v>-3.8280501365661621</c:v>
                </c:pt>
                <c:pt idx="137">
                  <c:v>-3.8223404884338379</c:v>
                </c:pt>
                <c:pt idx="138">
                  <c:v>-3.8166182041168213</c:v>
                </c:pt>
                <c:pt idx="139">
                  <c:v>-3.8108925819396973</c:v>
                </c:pt>
                <c:pt idx="140">
                  <c:v>-3.8051638603210449</c:v>
                </c:pt>
                <c:pt idx="141">
                  <c:v>-3.7994306087493896</c:v>
                </c:pt>
                <c:pt idx="142">
                  <c:v>-3.7936885356903076</c:v>
                </c:pt>
                <c:pt idx="143">
                  <c:v>-3.7879359722137451</c:v>
                </c:pt>
                <c:pt idx="144">
                  <c:v>-3.782177209854126</c:v>
                </c:pt>
                <c:pt idx="145">
                  <c:v>-3.7764151096343994</c:v>
                </c:pt>
                <c:pt idx="146">
                  <c:v>-3.770646333694458</c:v>
                </c:pt>
                <c:pt idx="147">
                  <c:v>-3.7648646831512451</c:v>
                </c:pt>
                <c:pt idx="148">
                  <c:v>-3.7590761184692383</c:v>
                </c:pt>
                <c:pt idx="149">
                  <c:v>-3.7532844543457031</c:v>
                </c:pt>
                <c:pt idx="150">
                  <c:v>-3.7474877834320068</c:v>
                </c:pt>
                <c:pt idx="151">
                  <c:v>-3.7416832447052002</c:v>
                </c:pt>
                <c:pt idx="152">
                  <c:v>-3.7358665466308594</c:v>
                </c:pt>
                <c:pt idx="153">
                  <c:v>-3.7300448417663574</c:v>
                </c:pt>
                <c:pt idx="154">
                  <c:v>-3.724219799041748</c:v>
                </c:pt>
                <c:pt idx="155">
                  <c:v>-3.7183890342712402</c:v>
                </c:pt>
                <c:pt idx="156">
                  <c:v>-3.712547779083252</c:v>
                </c:pt>
                <c:pt idx="157">
                  <c:v>-3.7066972255706787</c:v>
                </c:pt>
                <c:pt idx="158">
                  <c:v>-3.7008421421051025</c:v>
                </c:pt>
                <c:pt idx="159">
                  <c:v>-3.6949837207794189</c:v>
                </c:pt>
                <c:pt idx="160">
                  <c:v>-3.6891200542449951</c:v>
                </c:pt>
                <c:pt idx="161">
                  <c:v>-3.6832468509674072</c:v>
                </c:pt>
                <c:pt idx="162">
                  <c:v>-3.6773624420166016</c:v>
                </c:pt>
                <c:pt idx="163">
                  <c:v>-3.6714739799499512</c:v>
                </c:pt>
                <c:pt idx="164">
                  <c:v>-3.6655817031860352</c:v>
                </c:pt>
                <c:pt idx="165">
                  <c:v>-3.6596848964691162</c:v>
                </c:pt>
                <c:pt idx="166">
                  <c:v>-3.6537821292877197</c:v>
                </c:pt>
                <c:pt idx="167">
                  <c:v>-3.64786696434021</c:v>
                </c:pt>
                <c:pt idx="168">
                  <c:v>-3.6419451236724854</c:v>
                </c:pt>
                <c:pt idx="169">
                  <c:v>-3.6360199451446533</c:v>
                </c:pt>
                <c:pt idx="170">
                  <c:v>-3.6300899982452393</c:v>
                </c:pt>
                <c:pt idx="171">
                  <c:v>-3.6241543292999268</c:v>
                </c:pt>
                <c:pt idx="172">
                  <c:v>-3.6182117462158203</c:v>
                </c:pt>
                <c:pt idx="173">
                  <c:v>-3.6122586727142334</c:v>
                </c:pt>
                <c:pt idx="174">
                  <c:v>-3.6063001155853271</c:v>
                </c:pt>
                <c:pt idx="175">
                  <c:v>-3.6003379821777344</c:v>
                </c:pt>
                <c:pt idx="176">
                  <c:v>-3.5943715572357178</c:v>
                </c:pt>
                <c:pt idx="177">
                  <c:v>-3.5883996486663818</c:v>
                </c:pt>
                <c:pt idx="178">
                  <c:v>-3.5824184417724609</c:v>
                </c:pt>
                <c:pt idx="179">
                  <c:v>-3.5764279365539551</c:v>
                </c:pt>
                <c:pt idx="180">
                  <c:v>-3.5704317092895508</c:v>
                </c:pt>
                <c:pt idx="181">
                  <c:v>-3.5644323825836182</c:v>
                </c:pt>
                <c:pt idx="182">
                  <c:v>-3.5584299564361572</c:v>
                </c:pt>
                <c:pt idx="183">
                  <c:v>-3.5524234771728516</c:v>
                </c:pt>
                <c:pt idx="184">
                  <c:v>-3.546412467956543</c:v>
                </c:pt>
                <c:pt idx="185">
                  <c:v>-3.5403962135314941</c:v>
                </c:pt>
                <c:pt idx="186">
                  <c:v>-3.5343718528747559</c:v>
                </c:pt>
                <c:pt idx="187">
                  <c:v>-3.5283384323120117</c:v>
                </c:pt>
                <c:pt idx="188">
                  <c:v>-3.5222985744476318</c:v>
                </c:pt>
                <c:pt idx="189">
                  <c:v>-3.5162553787231445</c:v>
                </c:pt>
                <c:pt idx="190">
                  <c:v>-3.5102083683013916</c:v>
                </c:pt>
                <c:pt idx="191">
                  <c:v>-3.5041563510894775</c:v>
                </c:pt>
                <c:pt idx="192">
                  <c:v>-3.4980978965759277</c:v>
                </c:pt>
                <c:pt idx="193">
                  <c:v>-3.4920310974121094</c:v>
                </c:pt>
                <c:pt idx="194">
                  <c:v>-3.4859557151794434</c:v>
                </c:pt>
                <c:pt idx="195">
                  <c:v>-3.4798750877380371</c:v>
                </c:pt>
                <c:pt idx="196">
                  <c:v>-3.4737911224365234</c:v>
                </c:pt>
                <c:pt idx="197">
                  <c:v>-3.467703104019165</c:v>
                </c:pt>
                <c:pt idx="198">
                  <c:v>-3.4616103172302246</c:v>
                </c:pt>
                <c:pt idx="199">
                  <c:v>-3.4555120468139648</c:v>
                </c:pt>
                <c:pt idx="200">
                  <c:v>-3.4494044780731201</c:v>
                </c:pt>
                <c:pt idx="201">
                  <c:v>-3.4432888031005859</c:v>
                </c:pt>
                <c:pt idx="202">
                  <c:v>-3.4371674060821533</c:v>
                </c:pt>
                <c:pt idx="203">
                  <c:v>-3.4310426712036133</c:v>
                </c:pt>
                <c:pt idx="204">
                  <c:v>-3.4249148368835449</c:v>
                </c:pt>
                <c:pt idx="205">
                  <c:v>-3.4187827110290527</c:v>
                </c:pt>
                <c:pt idx="206">
                  <c:v>-3.4126453399658203</c:v>
                </c:pt>
                <c:pt idx="207">
                  <c:v>-3.4065020084381104</c:v>
                </c:pt>
                <c:pt idx="208">
                  <c:v>-3.4003500938415527</c:v>
                </c:pt>
                <c:pt idx="209">
                  <c:v>-3.3941888809204102</c:v>
                </c:pt>
                <c:pt idx="210">
                  <c:v>-3.3880233764648438</c:v>
                </c:pt>
                <c:pt idx="211">
                  <c:v>-3.3818542957305908</c:v>
                </c:pt>
                <c:pt idx="212">
                  <c:v>-3.3756821155548096</c:v>
                </c:pt>
                <c:pt idx="213">
                  <c:v>-3.3695058822631836</c:v>
                </c:pt>
                <c:pt idx="214">
                  <c:v>-3.3633246421813965</c:v>
                </c:pt>
                <c:pt idx="215">
                  <c:v>-3.3571388721466064</c:v>
                </c:pt>
                <c:pt idx="216">
                  <c:v>-3.3509457111358643</c:v>
                </c:pt>
                <c:pt idx="217">
                  <c:v>-3.3447437286376953</c:v>
                </c:pt>
                <c:pt idx="218">
                  <c:v>-3.3385350704193115</c:v>
                </c:pt>
                <c:pt idx="219">
                  <c:v>-3.3323214054107666</c:v>
                </c:pt>
                <c:pt idx="220">
                  <c:v>-3.3261044025421143</c:v>
                </c:pt>
                <c:pt idx="221">
                  <c:v>-3.3198840618133545</c:v>
                </c:pt>
                <c:pt idx="222">
                  <c:v>-3.3136594295501709</c:v>
                </c:pt>
                <c:pt idx="223">
                  <c:v>-3.3074302673339844</c:v>
                </c:pt>
                <c:pt idx="224">
                  <c:v>-3.3011972904205322</c:v>
                </c:pt>
                <c:pt idx="225">
                  <c:v>-3.2949573993682861</c:v>
                </c:pt>
                <c:pt idx="226">
                  <c:v>-3.2887105941772461</c:v>
                </c:pt>
                <c:pt idx="227">
                  <c:v>-3.2824544906616211</c:v>
                </c:pt>
                <c:pt idx="228">
                  <c:v>-3.2761938571929932</c:v>
                </c:pt>
                <c:pt idx="229">
                  <c:v>-3.2699286937713623</c:v>
                </c:pt>
                <c:pt idx="230">
                  <c:v>-3.263660192489624</c:v>
                </c:pt>
                <c:pt idx="231">
                  <c:v>-3.2573883533477783</c:v>
                </c:pt>
                <c:pt idx="232">
                  <c:v>-3.2511117458343506</c:v>
                </c:pt>
                <c:pt idx="233">
                  <c:v>-3.2448313236236572</c:v>
                </c:pt>
                <c:pt idx="234">
                  <c:v>-3.2385458946228027</c:v>
                </c:pt>
                <c:pt idx="235">
                  <c:v>-3.2322549819946289</c:v>
                </c:pt>
                <c:pt idx="236">
                  <c:v>-3.2259597778320313</c:v>
                </c:pt>
                <c:pt idx="237">
                  <c:v>-3.2196564674377441</c:v>
                </c:pt>
                <c:pt idx="238">
                  <c:v>-3.2133457660675049</c:v>
                </c:pt>
                <c:pt idx="239">
                  <c:v>-3.207028865814209</c:v>
                </c:pt>
                <c:pt idx="240">
                  <c:v>-3.2007083892822266</c:v>
                </c:pt>
                <c:pt idx="241">
                  <c:v>-3.1943848133087158</c:v>
                </c:pt>
                <c:pt idx="242">
                  <c:v>-3.1880578994750977</c:v>
                </c:pt>
                <c:pt idx="243">
                  <c:v>-3.1817269325256348</c:v>
                </c:pt>
                <c:pt idx="244">
                  <c:v>-3.175391674041748</c:v>
                </c:pt>
                <c:pt idx="245">
                  <c:v>-3.1690514087677002</c:v>
                </c:pt>
                <c:pt idx="246">
                  <c:v>-3.1627073287963867</c:v>
                </c:pt>
                <c:pt idx="247">
                  <c:v>-3.1563558578491211</c:v>
                </c:pt>
                <c:pt idx="248">
                  <c:v>-3.149996280670166</c:v>
                </c:pt>
                <c:pt idx="249">
                  <c:v>-3.1436305046081543</c:v>
                </c:pt>
                <c:pt idx="250">
                  <c:v>-3.137258768081665</c:v>
                </c:pt>
                <c:pt idx="251">
                  <c:v>-3.1308832168579102</c:v>
                </c:pt>
                <c:pt idx="252">
                  <c:v>-3.1245040893554688</c:v>
                </c:pt>
                <c:pt idx="253">
                  <c:v>-3.1181216239929199</c:v>
                </c:pt>
                <c:pt idx="254">
                  <c:v>-3.1117358207702637</c:v>
                </c:pt>
                <c:pt idx="255">
                  <c:v>-3.1053466796875</c:v>
                </c:pt>
                <c:pt idx="256">
                  <c:v>-3.0989542007446289</c:v>
                </c:pt>
                <c:pt idx="257">
                  <c:v>-3.0925579071044922</c:v>
                </c:pt>
                <c:pt idx="258">
                  <c:v>-3.0861568450927734</c:v>
                </c:pt>
                <c:pt idx="259">
                  <c:v>-3.0797524452209473</c:v>
                </c:pt>
                <c:pt idx="260">
                  <c:v>-3.0733439922332764</c:v>
                </c:pt>
                <c:pt idx="261">
                  <c:v>-3.066929817199707</c:v>
                </c:pt>
                <c:pt idx="262">
                  <c:v>-3.060509204864502</c:v>
                </c:pt>
                <c:pt idx="263">
                  <c:v>-3.0540807247161865</c:v>
                </c:pt>
                <c:pt idx="264">
                  <c:v>-3.0476460456848145</c:v>
                </c:pt>
                <c:pt idx="265">
                  <c:v>-3.0412061214447021</c:v>
                </c:pt>
                <c:pt idx="266">
                  <c:v>-3.034761905670166</c:v>
                </c:pt>
                <c:pt idx="267">
                  <c:v>-3.0283136367797852</c:v>
                </c:pt>
                <c:pt idx="268">
                  <c:v>-3.0218620300292969</c:v>
                </c:pt>
                <c:pt idx="269">
                  <c:v>-3.0154068470001221</c:v>
                </c:pt>
                <c:pt idx="270">
                  <c:v>-3.0089483261108398</c:v>
                </c:pt>
                <c:pt idx="271">
                  <c:v>-3.0024852752685547</c:v>
                </c:pt>
                <c:pt idx="272">
                  <c:v>-2.9960176944732666</c:v>
                </c:pt>
                <c:pt idx="273">
                  <c:v>-2.9895460605621338</c:v>
                </c:pt>
                <c:pt idx="274">
                  <c:v>-2.9830696582794189</c:v>
                </c:pt>
                <c:pt idx="275">
                  <c:v>-2.9765872955322266</c:v>
                </c:pt>
                <c:pt idx="276">
                  <c:v>-2.9700965881347656</c:v>
                </c:pt>
                <c:pt idx="277">
                  <c:v>-2.9636008739471436</c:v>
                </c:pt>
                <c:pt idx="278">
                  <c:v>-2.9570987224578857</c:v>
                </c:pt>
                <c:pt idx="279">
                  <c:v>-2.9505913257598877</c:v>
                </c:pt>
                <c:pt idx="280">
                  <c:v>-2.9440803527832031</c:v>
                </c:pt>
                <c:pt idx="281">
                  <c:v>-2.937565803527832</c:v>
                </c:pt>
                <c:pt idx="282">
                  <c:v>-2.9310479164123535</c:v>
                </c:pt>
                <c:pt idx="283">
                  <c:v>-2.9245266914367676</c:v>
                </c:pt>
                <c:pt idx="284">
                  <c:v>-2.9180014133453369</c:v>
                </c:pt>
                <c:pt idx="285">
                  <c:v>-2.9114730358123779</c:v>
                </c:pt>
                <c:pt idx="286">
                  <c:v>-2.9049394130706787</c:v>
                </c:pt>
                <c:pt idx="287">
                  <c:v>-2.8984005451202393</c:v>
                </c:pt>
                <c:pt idx="288">
                  <c:v>-2.8918581008911133</c:v>
                </c:pt>
                <c:pt idx="289">
                  <c:v>-2.885310173034668</c:v>
                </c:pt>
                <c:pt idx="290">
                  <c:v>-2.8787574768066406</c:v>
                </c:pt>
                <c:pt idx="291">
                  <c:v>-2.8721978664398193</c:v>
                </c:pt>
                <c:pt idx="292">
                  <c:v>-2.8656322956085205</c:v>
                </c:pt>
                <c:pt idx="293">
                  <c:v>-2.8590610027313232</c:v>
                </c:pt>
                <c:pt idx="294">
                  <c:v>-2.8524854183197021</c:v>
                </c:pt>
                <c:pt idx="295">
                  <c:v>-2.8459045886993408</c:v>
                </c:pt>
                <c:pt idx="296">
                  <c:v>-2.8393199443817139</c:v>
                </c:pt>
                <c:pt idx="297">
                  <c:v>-2.8327319622039795</c:v>
                </c:pt>
                <c:pt idx="298">
                  <c:v>-2.8261406421661377</c:v>
                </c:pt>
                <c:pt idx="299">
                  <c:v>-2.8195457458496094</c:v>
                </c:pt>
                <c:pt idx="300">
                  <c:v>-2.8129470348358154</c:v>
                </c:pt>
                <c:pt idx="301">
                  <c:v>-2.8063437938690186</c:v>
                </c:pt>
                <c:pt idx="302">
                  <c:v>-2.7997372150421143</c:v>
                </c:pt>
                <c:pt idx="303">
                  <c:v>-2.7931258678436279</c:v>
                </c:pt>
                <c:pt idx="304">
                  <c:v>-2.7865090370178223</c:v>
                </c:pt>
                <c:pt idx="305">
                  <c:v>-2.7798881530761719</c:v>
                </c:pt>
                <c:pt idx="306">
                  <c:v>-2.7732613086700439</c:v>
                </c:pt>
                <c:pt idx="307">
                  <c:v>-2.7666292190551758</c:v>
                </c:pt>
                <c:pt idx="308">
                  <c:v>-2.7599890232086182</c:v>
                </c:pt>
                <c:pt idx="309">
                  <c:v>-2.7533431053161621</c:v>
                </c:pt>
                <c:pt idx="310">
                  <c:v>-2.7466926574707031</c:v>
                </c:pt>
                <c:pt idx="311">
                  <c:v>-2.7400376796722412</c:v>
                </c:pt>
                <c:pt idx="312">
                  <c:v>-2.7333791255950928</c:v>
                </c:pt>
                <c:pt idx="313">
                  <c:v>-2.7267172336578369</c:v>
                </c:pt>
                <c:pt idx="314">
                  <c:v>-2.7200517654418945</c:v>
                </c:pt>
                <c:pt idx="315">
                  <c:v>-2.7133831977844238</c:v>
                </c:pt>
                <c:pt idx="316">
                  <c:v>-2.7067108154296875</c:v>
                </c:pt>
                <c:pt idx="317">
                  <c:v>-2.7000341415405273</c:v>
                </c:pt>
                <c:pt idx="318">
                  <c:v>-2.6933529376983643</c:v>
                </c:pt>
                <c:pt idx="319">
                  <c:v>-2.6866686344146729</c:v>
                </c:pt>
                <c:pt idx="320">
                  <c:v>-2.6799800395965576</c:v>
                </c:pt>
                <c:pt idx="321">
                  <c:v>-2.6732869148254395</c:v>
                </c:pt>
                <c:pt idx="322">
                  <c:v>-2.6665885448455811</c:v>
                </c:pt>
                <c:pt idx="323">
                  <c:v>-2.659881591796875</c:v>
                </c:pt>
                <c:pt idx="324">
                  <c:v>-2.6531696319580078</c:v>
                </c:pt>
                <c:pt idx="325">
                  <c:v>-2.6464509963989258</c:v>
                </c:pt>
                <c:pt idx="326">
                  <c:v>-2.6397261619567871</c:v>
                </c:pt>
                <c:pt idx="327">
                  <c:v>-2.6329970359802246</c:v>
                </c:pt>
                <c:pt idx="328">
                  <c:v>-2.6262643337249756</c:v>
                </c:pt>
                <c:pt idx="329">
                  <c:v>-2.61952805519104</c:v>
                </c:pt>
                <c:pt idx="330">
                  <c:v>-2.612788200378418</c:v>
                </c:pt>
                <c:pt idx="331">
                  <c:v>-2.6060452461242676</c:v>
                </c:pt>
                <c:pt idx="332">
                  <c:v>-2.5992982387542725</c:v>
                </c:pt>
                <c:pt idx="333">
                  <c:v>-2.592548131942749</c:v>
                </c:pt>
                <c:pt idx="334">
                  <c:v>-2.5857944488525391</c:v>
                </c:pt>
                <c:pt idx="335">
                  <c:v>-2.5790362358093262</c:v>
                </c:pt>
                <c:pt idx="336">
                  <c:v>-2.5722739696502686</c:v>
                </c:pt>
                <c:pt idx="337">
                  <c:v>-2.5655066967010498</c:v>
                </c:pt>
                <c:pt idx="338">
                  <c:v>-2.5587368011474609</c:v>
                </c:pt>
                <c:pt idx="339">
                  <c:v>-2.5519616603851318</c:v>
                </c:pt>
                <c:pt idx="340">
                  <c:v>-2.5451817512512207</c:v>
                </c:pt>
                <c:pt idx="341">
                  <c:v>-2.5383970737457275</c:v>
                </c:pt>
                <c:pt idx="342">
                  <c:v>-2.5316042900085449</c:v>
                </c:pt>
                <c:pt idx="343">
                  <c:v>-2.5248074531555176</c:v>
                </c:pt>
                <c:pt idx="344">
                  <c:v>-2.5180041790008545</c:v>
                </c:pt>
                <c:pt idx="345">
                  <c:v>-2.5111956596374512</c:v>
                </c:pt>
                <c:pt idx="346">
                  <c:v>-2.5043821334838867</c:v>
                </c:pt>
                <c:pt idx="347">
                  <c:v>-2.4975645542144775</c:v>
                </c:pt>
                <c:pt idx="348">
                  <c:v>-2.4907429218292236</c:v>
                </c:pt>
                <c:pt idx="349">
                  <c:v>-2.4839181900024414</c:v>
                </c:pt>
                <c:pt idx="350">
                  <c:v>-2.4770896434783936</c:v>
                </c:pt>
                <c:pt idx="351">
                  <c:v>-2.4702579975128174</c:v>
                </c:pt>
                <c:pt idx="352">
                  <c:v>-2.4634222984313965</c:v>
                </c:pt>
                <c:pt idx="353">
                  <c:v>-2.4565834999084473</c:v>
                </c:pt>
                <c:pt idx="354">
                  <c:v>-2.4497408866882324</c:v>
                </c:pt>
                <c:pt idx="355">
                  <c:v>-2.4428951740264893</c:v>
                </c:pt>
                <c:pt idx="356">
                  <c:v>-2.4360454082489014</c:v>
                </c:pt>
                <c:pt idx="357">
                  <c:v>-2.4291925430297852</c:v>
                </c:pt>
                <c:pt idx="358">
                  <c:v>-2.4223353862762451</c:v>
                </c:pt>
                <c:pt idx="359">
                  <c:v>-2.4154739379882813</c:v>
                </c:pt>
                <c:pt idx="360">
                  <c:v>-2.4086084365844727</c:v>
                </c:pt>
                <c:pt idx="361">
                  <c:v>-2.4017388820648193</c:v>
                </c:pt>
                <c:pt idx="362">
                  <c:v>-2.3948662281036377</c:v>
                </c:pt>
                <c:pt idx="363">
                  <c:v>-2.3879885673522949</c:v>
                </c:pt>
                <c:pt idx="364">
                  <c:v>-2.3811078071594238</c:v>
                </c:pt>
                <c:pt idx="365">
                  <c:v>-2.3742218017578125</c:v>
                </c:pt>
                <c:pt idx="366">
                  <c:v>-2.3673319816589355</c:v>
                </c:pt>
                <c:pt idx="367">
                  <c:v>-2.3604357242584229</c:v>
                </c:pt>
                <c:pt idx="368">
                  <c:v>-2.3535366058349609</c:v>
                </c:pt>
                <c:pt idx="369">
                  <c:v>-2.3466315269470215</c:v>
                </c:pt>
                <c:pt idx="370">
                  <c:v>-2.3397216796875</c:v>
                </c:pt>
                <c:pt idx="371">
                  <c:v>-2.3328068256378174</c:v>
                </c:pt>
                <c:pt idx="372">
                  <c:v>-2.3258872032165527</c:v>
                </c:pt>
                <c:pt idx="373">
                  <c:v>-2.3189618587493896</c:v>
                </c:pt>
                <c:pt idx="374">
                  <c:v>-2.3120324611663818</c:v>
                </c:pt>
                <c:pt idx="375">
                  <c:v>-2.3050987720489502</c:v>
                </c:pt>
                <c:pt idx="376">
                  <c:v>-2.2981603145599365</c:v>
                </c:pt>
                <c:pt idx="377">
                  <c:v>-2.2912185192108154</c:v>
                </c:pt>
                <c:pt idx="378">
                  <c:v>-2.2842733860015869</c:v>
                </c:pt>
                <c:pt idx="379">
                  <c:v>-2.2773244380950928</c:v>
                </c:pt>
                <c:pt idx="380">
                  <c:v>-2.2703721523284912</c:v>
                </c:pt>
                <c:pt idx="381">
                  <c:v>-2.263416051864624</c:v>
                </c:pt>
                <c:pt idx="382">
                  <c:v>-2.2564568519592285</c:v>
                </c:pt>
                <c:pt idx="383">
                  <c:v>-2.2494940757751465</c:v>
                </c:pt>
                <c:pt idx="384">
                  <c:v>-2.2425277233123779</c:v>
                </c:pt>
                <c:pt idx="385">
                  <c:v>-2.2355573177337646</c:v>
                </c:pt>
                <c:pt idx="386">
                  <c:v>-2.2285830974578857</c:v>
                </c:pt>
                <c:pt idx="387">
                  <c:v>-2.2216055393218994</c:v>
                </c:pt>
                <c:pt idx="388">
                  <c:v>-2.2146236896514893</c:v>
                </c:pt>
                <c:pt idx="389">
                  <c:v>-2.2076375484466553</c:v>
                </c:pt>
                <c:pt idx="390">
                  <c:v>-2.2006478309631348</c:v>
                </c:pt>
                <c:pt idx="391">
                  <c:v>-2.1936545372009277</c:v>
                </c:pt>
                <c:pt idx="392">
                  <c:v>-2.1866579055786133</c:v>
                </c:pt>
                <c:pt idx="393">
                  <c:v>-2.1796555519104004</c:v>
                </c:pt>
                <c:pt idx="394">
                  <c:v>-2.1726493835449219</c:v>
                </c:pt>
                <c:pt idx="395">
                  <c:v>-2.1656394004821777</c:v>
                </c:pt>
                <c:pt idx="396">
                  <c:v>-2.1586241722106934</c:v>
                </c:pt>
                <c:pt idx="397">
                  <c:v>-2.1516051292419434</c:v>
                </c:pt>
                <c:pt idx="398">
                  <c:v>-2.1445808410644531</c:v>
                </c:pt>
                <c:pt idx="399">
                  <c:v>-2.1375515460968018</c:v>
                </c:pt>
                <c:pt idx="400">
                  <c:v>-2.1305167675018311</c:v>
                </c:pt>
                <c:pt idx="401">
                  <c:v>-2.1234769821166992</c:v>
                </c:pt>
                <c:pt idx="402">
                  <c:v>-2.1164314746856689</c:v>
                </c:pt>
                <c:pt idx="403">
                  <c:v>-2.1093814373016357</c:v>
                </c:pt>
                <c:pt idx="404">
                  <c:v>-2.1023268699645996</c:v>
                </c:pt>
                <c:pt idx="405">
                  <c:v>-2.0952677726745605</c:v>
                </c:pt>
                <c:pt idx="406">
                  <c:v>-2.0882055759429932</c:v>
                </c:pt>
                <c:pt idx="407">
                  <c:v>-2.0811388492584229</c:v>
                </c:pt>
                <c:pt idx="408">
                  <c:v>-2.074068546295166</c:v>
                </c:pt>
                <c:pt idx="409">
                  <c:v>-2.0669949054718018</c:v>
                </c:pt>
                <c:pt idx="410">
                  <c:v>-2.059917688369751</c:v>
                </c:pt>
                <c:pt idx="411">
                  <c:v>-2.0528371334075928</c:v>
                </c:pt>
                <c:pt idx="412">
                  <c:v>-2.0457527637481689</c:v>
                </c:pt>
                <c:pt idx="413">
                  <c:v>-2.0386650562286377</c:v>
                </c:pt>
                <c:pt idx="414">
                  <c:v>-2.031574010848999</c:v>
                </c:pt>
                <c:pt idx="415">
                  <c:v>-2.0244793891906738</c:v>
                </c:pt>
                <c:pt idx="416">
                  <c:v>-2.0173811912536621</c:v>
                </c:pt>
                <c:pt idx="417">
                  <c:v>-2.0102789402008057</c:v>
                </c:pt>
                <c:pt idx="418">
                  <c:v>-2.003173828125</c:v>
                </c:pt>
                <c:pt idx="419">
                  <c:v>-1.9960651397705078</c:v>
                </c:pt>
                <c:pt idx="420">
                  <c:v>-1.9889529943466187</c:v>
                </c:pt>
                <c:pt idx="421">
                  <c:v>-1.9818363189697266</c:v>
                </c:pt>
                <c:pt idx="422">
                  <c:v>-1.9747145175933838</c:v>
                </c:pt>
                <c:pt idx="423">
                  <c:v>-1.9675896167755127</c:v>
                </c:pt>
                <c:pt idx="424">
                  <c:v>-1.9604603052139282</c:v>
                </c:pt>
                <c:pt idx="425">
                  <c:v>-1.9533274173736572</c:v>
                </c:pt>
                <c:pt idx="426">
                  <c:v>-1.9461899995803833</c:v>
                </c:pt>
                <c:pt idx="427">
                  <c:v>-1.9390488862991333</c:v>
                </c:pt>
                <c:pt idx="428">
                  <c:v>-1.9319032430648804</c:v>
                </c:pt>
                <c:pt idx="429">
                  <c:v>-1.9247531890869141</c:v>
                </c:pt>
                <c:pt idx="430">
                  <c:v>-1.9175957441329956</c:v>
                </c:pt>
                <c:pt idx="431">
                  <c:v>-1.910433292388916</c:v>
                </c:pt>
                <c:pt idx="432">
                  <c:v>-1.9032663106918335</c:v>
                </c:pt>
                <c:pt idx="433">
                  <c:v>-1.8960928916931152</c:v>
                </c:pt>
                <c:pt idx="434">
                  <c:v>-1.8889148235321045</c:v>
                </c:pt>
                <c:pt idx="435">
                  <c:v>-1.8817315101623535</c:v>
                </c:pt>
                <c:pt idx="436">
                  <c:v>-1.8745450973510742</c:v>
                </c:pt>
                <c:pt idx="437">
                  <c:v>-1.8673537969589233</c:v>
                </c:pt>
                <c:pt idx="438">
                  <c:v>-1.8601580858230591</c:v>
                </c:pt>
                <c:pt idx="439">
                  <c:v>-1.8529589176177979</c:v>
                </c:pt>
                <c:pt idx="440">
                  <c:v>-1.8457561731338501</c:v>
                </c:pt>
                <c:pt idx="441">
                  <c:v>-1.8385498523712158</c:v>
                </c:pt>
                <c:pt idx="442">
                  <c:v>-1.8313400745391846</c:v>
                </c:pt>
                <c:pt idx="443">
                  <c:v>-1.8241267204284668</c:v>
                </c:pt>
                <c:pt idx="444">
                  <c:v>-1.8169099092483521</c:v>
                </c:pt>
                <c:pt idx="445">
                  <c:v>-1.8096895217895508</c:v>
                </c:pt>
                <c:pt idx="446">
                  <c:v>-1.8024656772613525</c:v>
                </c:pt>
                <c:pt idx="447">
                  <c:v>-1.7952383756637573</c:v>
                </c:pt>
                <c:pt idx="448">
                  <c:v>-1.7880071401596069</c:v>
                </c:pt>
                <c:pt idx="449">
                  <c:v>-1.7807726860046387</c:v>
                </c:pt>
                <c:pt idx="450">
                  <c:v>-1.7735347747802734</c:v>
                </c:pt>
                <c:pt idx="451">
                  <c:v>-1.7662932872772217</c:v>
                </c:pt>
                <c:pt idx="452">
                  <c:v>-1.7590479850769043</c:v>
                </c:pt>
                <c:pt idx="453">
                  <c:v>-1.7517992258071899</c:v>
                </c:pt>
                <c:pt idx="454">
                  <c:v>-1.7445465326309204</c:v>
                </c:pt>
                <c:pt idx="455">
                  <c:v>-1.7372907400131226</c:v>
                </c:pt>
                <c:pt idx="456">
                  <c:v>-1.7300306558609009</c:v>
                </c:pt>
                <c:pt idx="457">
                  <c:v>-1.7227662801742554</c:v>
                </c:pt>
                <c:pt idx="458">
                  <c:v>-1.7154989242553711</c:v>
                </c:pt>
                <c:pt idx="459">
                  <c:v>-1.7082260847091675</c:v>
                </c:pt>
                <c:pt idx="460">
                  <c:v>-1.7009503841400146</c:v>
                </c:pt>
                <c:pt idx="461">
                  <c:v>-1.6936708688735962</c:v>
                </c:pt>
                <c:pt idx="462">
                  <c:v>-1.6863868236541748</c:v>
                </c:pt>
                <c:pt idx="463">
                  <c:v>-1.6790986061096191</c:v>
                </c:pt>
                <c:pt idx="464">
                  <c:v>-1.6718072891235352</c:v>
                </c:pt>
                <c:pt idx="465">
                  <c:v>-1.6645110845565796</c:v>
                </c:pt>
                <c:pt idx="466">
                  <c:v>-1.6572084426879883</c:v>
                </c:pt>
                <c:pt idx="467">
                  <c:v>-1.64990234375</c:v>
                </c:pt>
                <c:pt idx="468">
                  <c:v>-1.6425909996032715</c:v>
                </c:pt>
                <c:pt idx="469">
                  <c:v>-1.6352758407592773</c:v>
                </c:pt>
                <c:pt idx="470">
                  <c:v>-1.6279532909393311</c:v>
                </c:pt>
                <c:pt idx="471">
                  <c:v>-1.6206271648406982</c:v>
                </c:pt>
                <c:pt idx="472">
                  <c:v>-1.6132943630218506</c:v>
                </c:pt>
                <c:pt idx="473">
                  <c:v>-1.6059572696685791</c:v>
                </c:pt>
                <c:pt idx="474">
                  <c:v>-1.5986160039901733</c:v>
                </c:pt>
                <c:pt idx="475">
                  <c:v>-1.5912696123123169</c:v>
                </c:pt>
                <c:pt idx="476">
                  <c:v>-1.5839194059371948</c:v>
                </c:pt>
                <c:pt idx="477">
                  <c:v>-1.5765656232833862</c:v>
                </c:pt>
                <c:pt idx="478">
                  <c:v>-1.5692083835601807</c:v>
                </c:pt>
                <c:pt idx="479">
                  <c:v>-1.561847448348999</c:v>
                </c:pt>
                <c:pt idx="480">
                  <c:v>-1.5544830560684204</c:v>
                </c:pt>
                <c:pt idx="481">
                  <c:v>-1.5471152067184448</c:v>
                </c:pt>
                <c:pt idx="482">
                  <c:v>-1.5397437810897827</c:v>
                </c:pt>
                <c:pt idx="483">
                  <c:v>-1.5323687791824341</c:v>
                </c:pt>
                <c:pt idx="484">
                  <c:v>-1.5249899625778198</c:v>
                </c:pt>
                <c:pt idx="485">
                  <c:v>-1.5176079273223877</c:v>
                </c:pt>
                <c:pt idx="486">
                  <c:v>-1.510222315788269</c:v>
                </c:pt>
                <c:pt idx="487">
                  <c:v>-1.5028331279754639</c:v>
                </c:pt>
                <c:pt idx="488">
                  <c:v>-1.4954395294189453</c:v>
                </c:pt>
                <c:pt idx="489">
                  <c:v>-1.4880423545837402</c:v>
                </c:pt>
                <c:pt idx="490">
                  <c:v>-1.4806413650512695</c:v>
                </c:pt>
                <c:pt idx="491">
                  <c:v>-1.4732375144958496</c:v>
                </c:pt>
                <c:pt idx="492">
                  <c:v>-1.4658293724060059</c:v>
                </c:pt>
                <c:pt idx="493">
                  <c:v>-1.4584164619445801</c:v>
                </c:pt>
                <c:pt idx="494">
                  <c:v>-1.4509999752044678</c:v>
                </c:pt>
                <c:pt idx="495">
                  <c:v>-1.4435793161392212</c:v>
                </c:pt>
                <c:pt idx="496">
                  <c:v>-1.4361554384231567</c:v>
                </c:pt>
                <c:pt idx="497">
                  <c:v>-1.4287267923355103</c:v>
                </c:pt>
                <c:pt idx="498">
                  <c:v>-1.421295166015625</c:v>
                </c:pt>
                <c:pt idx="499">
                  <c:v>-1.4138576984405518</c:v>
                </c:pt>
                <c:pt idx="500">
                  <c:v>-1.4064171314239502</c:v>
                </c:pt>
                <c:pt idx="501">
                  <c:v>-1.3989719152450562</c:v>
                </c:pt>
                <c:pt idx="502">
                  <c:v>-1.3915209770202637</c:v>
                </c:pt>
                <c:pt idx="503">
                  <c:v>-1.3840664625167847</c:v>
                </c:pt>
                <c:pt idx="504">
                  <c:v>-1.3766037225723267</c:v>
                </c:pt>
                <c:pt idx="505">
                  <c:v>-1.3691390752792358</c:v>
                </c:pt>
                <c:pt idx="506">
                  <c:v>-1.3616670370101929</c:v>
                </c:pt>
                <c:pt idx="507">
                  <c:v>-1.3541910648345947</c:v>
                </c:pt>
                <c:pt idx="508">
                  <c:v>-1.3467092514038086</c:v>
                </c:pt>
                <c:pt idx="509">
                  <c:v>-1.3392235040664673</c:v>
                </c:pt>
                <c:pt idx="510">
                  <c:v>-1.3317333459854126</c:v>
                </c:pt>
                <c:pt idx="511">
                  <c:v>-1.3242385387420654</c:v>
                </c:pt>
                <c:pt idx="512">
                  <c:v>-1.3167401552200317</c:v>
                </c:pt>
                <c:pt idx="513">
                  <c:v>-1.3092379570007324</c:v>
                </c:pt>
                <c:pt idx="514">
                  <c:v>-1.3017321825027466</c:v>
                </c:pt>
                <c:pt idx="515">
                  <c:v>-1.2942228317260742</c:v>
                </c:pt>
                <c:pt idx="516">
                  <c:v>-1.2867100238800049</c:v>
                </c:pt>
                <c:pt idx="517">
                  <c:v>-1.279193639755249</c:v>
                </c:pt>
                <c:pt idx="518">
                  <c:v>-1.2716736793518066</c:v>
                </c:pt>
                <c:pt idx="519">
                  <c:v>-1.2641501426696777</c:v>
                </c:pt>
                <c:pt idx="520">
                  <c:v>-1.2566231489181519</c:v>
                </c:pt>
                <c:pt idx="521">
                  <c:v>-1.2490924596786499</c:v>
                </c:pt>
                <c:pt idx="522">
                  <c:v>-1.2415573596954346</c:v>
                </c:pt>
                <c:pt idx="523">
                  <c:v>-1.2340189218521118</c:v>
                </c:pt>
                <c:pt idx="524">
                  <c:v>-1.2264760732650757</c:v>
                </c:pt>
                <c:pt idx="525">
                  <c:v>-1.2189289331436157</c:v>
                </c:pt>
                <c:pt idx="526">
                  <c:v>-1.2113785743713379</c:v>
                </c:pt>
                <c:pt idx="527">
                  <c:v>-1.2038236856460571</c:v>
                </c:pt>
                <c:pt idx="528">
                  <c:v>-1.1962655782699585</c:v>
                </c:pt>
                <c:pt idx="529">
                  <c:v>-1.1887025833129883</c:v>
                </c:pt>
                <c:pt idx="530">
                  <c:v>-1.1811350584030151</c:v>
                </c:pt>
                <c:pt idx="531">
                  <c:v>-1.1735632419586182</c:v>
                </c:pt>
                <c:pt idx="532">
                  <c:v>-1.1659883260726929</c:v>
                </c:pt>
                <c:pt idx="533">
                  <c:v>-1.1584080457687378</c:v>
                </c:pt>
                <c:pt idx="534">
                  <c:v>-1.150821328163147</c:v>
                </c:pt>
                <c:pt idx="535">
                  <c:v>-1.1432305574417114</c:v>
                </c:pt>
                <c:pt idx="536">
                  <c:v>-1.1356327533721924</c:v>
                </c:pt>
                <c:pt idx="537">
                  <c:v>-1.12803053855896</c:v>
                </c:pt>
                <c:pt idx="538">
                  <c:v>-1.1204215288162231</c:v>
                </c:pt>
                <c:pt idx="539">
                  <c:v>-1.1128089427947998</c:v>
                </c:pt>
                <c:pt idx="540">
                  <c:v>-1.105191707611084</c:v>
                </c:pt>
                <c:pt idx="541">
                  <c:v>-1.0975689888000488</c:v>
                </c:pt>
                <c:pt idx="542">
                  <c:v>-1.0899426937103271</c:v>
                </c:pt>
                <c:pt idx="543">
                  <c:v>-1.0823124647140503</c:v>
                </c:pt>
                <c:pt idx="544">
                  <c:v>-1.0746786594390869</c:v>
                </c:pt>
                <c:pt idx="545">
                  <c:v>-1.067041277885437</c:v>
                </c:pt>
                <c:pt idx="546">
                  <c:v>-1.0594004392623901</c:v>
                </c:pt>
                <c:pt idx="547">
                  <c:v>-1.0517559051513672</c:v>
                </c:pt>
                <c:pt idx="548">
                  <c:v>-1.0441079139709473</c:v>
                </c:pt>
                <c:pt idx="549">
                  <c:v>-1.0364562273025513</c:v>
                </c:pt>
                <c:pt idx="550">
                  <c:v>-1.0288010835647583</c:v>
                </c:pt>
                <c:pt idx="551">
                  <c:v>-1.0211423635482788</c:v>
                </c:pt>
                <c:pt idx="552">
                  <c:v>-1.0134800672531128</c:v>
                </c:pt>
                <c:pt idx="553">
                  <c:v>-1.0058141946792603</c:v>
                </c:pt>
                <c:pt idx="554">
                  <c:v>-0.99814474582672119</c:v>
                </c:pt>
                <c:pt idx="555">
                  <c:v>-0.99047172069549561</c:v>
                </c:pt>
                <c:pt idx="556">
                  <c:v>-0.98279482126235962</c:v>
                </c:pt>
                <c:pt idx="557">
                  <c:v>-0.97511470317840576</c:v>
                </c:pt>
                <c:pt idx="558">
                  <c:v>-0.96743100881576538</c:v>
                </c:pt>
                <c:pt idx="559">
                  <c:v>-0.95974373817443848</c:v>
                </c:pt>
                <c:pt idx="560">
                  <c:v>-0.95205193758010864</c:v>
                </c:pt>
                <c:pt idx="561">
                  <c:v>-0.94435751438140869</c:v>
                </c:pt>
                <c:pt idx="562">
                  <c:v>-0.93665927648544312</c:v>
                </c:pt>
                <c:pt idx="563">
                  <c:v>-0.92895776033401489</c:v>
                </c:pt>
                <c:pt idx="564">
                  <c:v>-0.92125099897384644</c:v>
                </c:pt>
                <c:pt idx="565">
                  <c:v>-0.91354131698608398</c:v>
                </c:pt>
                <c:pt idx="566">
                  <c:v>-0.9058271050453186</c:v>
                </c:pt>
                <c:pt idx="567">
                  <c:v>-0.89811033010482788</c:v>
                </c:pt>
                <c:pt idx="568">
                  <c:v>-0.89038825035095215</c:v>
                </c:pt>
                <c:pt idx="569">
                  <c:v>-0.88266366720199585</c:v>
                </c:pt>
                <c:pt idx="570">
                  <c:v>-0.87493449449539185</c:v>
                </c:pt>
                <c:pt idx="571">
                  <c:v>-0.86720174551010132</c:v>
                </c:pt>
                <c:pt idx="572">
                  <c:v>-0.85946547985076904</c:v>
                </c:pt>
                <c:pt idx="573">
                  <c:v>-0.85172528028488159</c:v>
                </c:pt>
                <c:pt idx="574">
                  <c:v>-0.84398186206817627</c:v>
                </c:pt>
                <c:pt idx="575">
                  <c:v>-0.83623450994491577</c:v>
                </c:pt>
                <c:pt idx="576">
                  <c:v>-0.82848328351974487</c:v>
                </c:pt>
                <c:pt idx="577">
                  <c:v>-0.82072710990905762</c:v>
                </c:pt>
                <c:pt idx="578">
                  <c:v>-0.81296873092651367</c:v>
                </c:pt>
                <c:pt idx="579">
                  <c:v>-0.80520439147949219</c:v>
                </c:pt>
                <c:pt idx="580">
                  <c:v>-0.79743784666061401</c:v>
                </c:pt>
                <c:pt idx="581">
                  <c:v>-0.78966712951660156</c:v>
                </c:pt>
                <c:pt idx="582">
                  <c:v>-0.78189414739608765</c:v>
                </c:pt>
                <c:pt idx="583">
                  <c:v>-0.77411586046218872</c:v>
                </c:pt>
                <c:pt idx="584">
                  <c:v>-0.76633477210998535</c:v>
                </c:pt>
                <c:pt idx="585">
                  <c:v>-0.75854974985122681</c:v>
                </c:pt>
                <c:pt idx="586">
                  <c:v>-0.75076353549957275</c:v>
                </c:pt>
                <c:pt idx="587">
                  <c:v>-0.742972731590271</c:v>
                </c:pt>
                <c:pt idx="588">
                  <c:v>-0.73517870903015137</c:v>
                </c:pt>
                <c:pt idx="589">
                  <c:v>-0.72738081216812134</c:v>
                </c:pt>
                <c:pt idx="590">
                  <c:v>-0.71958035230636597</c:v>
                </c:pt>
                <c:pt idx="591">
                  <c:v>-0.71177667379379272</c:v>
                </c:pt>
                <c:pt idx="592">
                  <c:v>-0.70396912097930908</c:v>
                </c:pt>
                <c:pt idx="593">
                  <c:v>-0.69615799188613892</c:v>
                </c:pt>
                <c:pt idx="594">
                  <c:v>-0.68834328651428223</c:v>
                </c:pt>
                <c:pt idx="595">
                  <c:v>-0.6805267333984375</c:v>
                </c:pt>
                <c:pt idx="596">
                  <c:v>-0.67270666360855103</c:v>
                </c:pt>
                <c:pt idx="597">
                  <c:v>-0.66488265991210938</c:v>
                </c:pt>
                <c:pt idx="598">
                  <c:v>-0.6570550799369812</c:v>
                </c:pt>
                <c:pt idx="599">
                  <c:v>-0.64922535419464111</c:v>
                </c:pt>
                <c:pt idx="600">
                  <c:v>-0.64139169454574585</c:v>
                </c:pt>
                <c:pt idx="601">
                  <c:v>-0.63355487585067749</c:v>
                </c:pt>
                <c:pt idx="602">
                  <c:v>-0.62571442127227783</c:v>
                </c:pt>
                <c:pt idx="603">
                  <c:v>-0.61787045001983643</c:v>
                </c:pt>
                <c:pt idx="604">
                  <c:v>-0.6100229024887085</c:v>
                </c:pt>
                <c:pt idx="605">
                  <c:v>-0.60217183828353882</c:v>
                </c:pt>
                <c:pt idx="606">
                  <c:v>-0.59431719779968262</c:v>
                </c:pt>
                <c:pt idx="607">
                  <c:v>-0.58645898103713989</c:v>
                </c:pt>
                <c:pt idx="608">
                  <c:v>-0.57859718799591064</c:v>
                </c:pt>
                <c:pt idx="609">
                  <c:v>-0.57073187828063965</c:v>
                </c:pt>
                <c:pt idx="610">
                  <c:v>-0.56286334991455078</c:v>
                </c:pt>
                <c:pt idx="611">
                  <c:v>-0.55499124526977539</c:v>
                </c:pt>
                <c:pt idx="612">
                  <c:v>-0.54711633920669556</c:v>
                </c:pt>
                <c:pt idx="613">
                  <c:v>-0.53924059867858887</c:v>
                </c:pt>
                <c:pt idx="614">
                  <c:v>-0.53136199712753296</c:v>
                </c:pt>
                <c:pt idx="615">
                  <c:v>-0.523479163646698</c:v>
                </c:pt>
                <c:pt idx="616">
                  <c:v>-0.51559209823608398</c:v>
                </c:pt>
                <c:pt idx="617">
                  <c:v>-0.50770175457000732</c:v>
                </c:pt>
                <c:pt idx="618">
                  <c:v>-0.49980828166007996</c:v>
                </c:pt>
                <c:pt idx="619">
                  <c:v>-0.49190846085548401</c:v>
                </c:pt>
                <c:pt idx="620">
                  <c:v>-0.48400679230690002</c:v>
                </c:pt>
                <c:pt idx="621">
                  <c:v>-0.47610020637512207</c:v>
                </c:pt>
                <c:pt idx="622">
                  <c:v>-0.4681907594203949</c:v>
                </c:pt>
                <c:pt idx="623">
                  <c:v>-0.46027705073356628</c:v>
                </c:pt>
                <c:pt idx="624">
                  <c:v>-0.45235911011695862</c:v>
                </c:pt>
                <c:pt idx="625">
                  <c:v>-0.44443690776824951</c:v>
                </c:pt>
                <c:pt idx="626">
                  <c:v>-0.43651184439659119</c:v>
                </c:pt>
                <c:pt idx="627">
                  <c:v>-0.42858251929283142</c:v>
                </c:pt>
                <c:pt idx="628">
                  <c:v>-0.42065000534057617</c:v>
                </c:pt>
                <c:pt idx="629">
                  <c:v>-0.4127139151096344</c:v>
                </c:pt>
                <c:pt idx="630">
                  <c:v>-0.40477430820465088</c:v>
                </c:pt>
                <c:pt idx="631">
                  <c:v>-0.39683076739311218</c:v>
                </c:pt>
                <c:pt idx="632">
                  <c:v>-0.388884037733078</c:v>
                </c:pt>
                <c:pt idx="633">
                  <c:v>-0.38093337416648865</c:v>
                </c:pt>
                <c:pt idx="634">
                  <c:v>-0.37297919392585754</c:v>
                </c:pt>
                <c:pt idx="635">
                  <c:v>-0.36502143740653992</c:v>
                </c:pt>
                <c:pt idx="636">
                  <c:v>-0.35706013441085815</c:v>
                </c:pt>
                <c:pt idx="637">
                  <c:v>-0.34909528493881226</c:v>
                </c:pt>
                <c:pt idx="638">
                  <c:v>-0.34112685918807983</c:v>
                </c:pt>
                <c:pt idx="639">
                  <c:v>-0.33315491676330566</c:v>
                </c:pt>
                <c:pt idx="640">
                  <c:v>-0.32517939805984497</c:v>
                </c:pt>
                <c:pt idx="641">
                  <c:v>-0.31720033288002014</c:v>
                </c:pt>
                <c:pt idx="642">
                  <c:v>-0.30921769142150879</c:v>
                </c:pt>
                <c:pt idx="643">
                  <c:v>-0.30123153328895569</c:v>
                </c:pt>
                <c:pt idx="644">
                  <c:v>-0.29324179887771606</c:v>
                </c:pt>
                <c:pt idx="645">
                  <c:v>-0.2852485179901123</c:v>
                </c:pt>
                <c:pt idx="646">
                  <c:v>-0.27725133299827576</c:v>
                </c:pt>
                <c:pt idx="647">
                  <c:v>-0.26925092935562134</c:v>
                </c:pt>
                <c:pt idx="648">
                  <c:v>-0.26124700903892517</c:v>
                </c:pt>
                <c:pt idx="649">
                  <c:v>-0.25323951244354248</c:v>
                </c:pt>
                <c:pt idx="650">
                  <c:v>-0.245228111743927</c:v>
                </c:pt>
                <c:pt idx="651">
                  <c:v>-0.23721350729465485</c:v>
                </c:pt>
                <c:pt idx="652">
                  <c:v>-0.22919465601444244</c:v>
                </c:pt>
                <c:pt idx="653">
                  <c:v>-0.22117225825786591</c:v>
                </c:pt>
                <c:pt idx="654">
                  <c:v>-0.21314558386802673</c:v>
                </c:pt>
                <c:pt idx="655">
                  <c:v>-0.20511607825756073</c:v>
                </c:pt>
                <c:pt idx="656">
                  <c:v>-0.19708231091499329</c:v>
                </c:pt>
                <c:pt idx="657">
                  <c:v>-0.18904604017734528</c:v>
                </c:pt>
                <c:pt idx="658">
                  <c:v>-0.18100516498088837</c:v>
                </c:pt>
                <c:pt idx="659">
                  <c:v>-0.17296038568019867</c:v>
                </c:pt>
                <c:pt idx="660">
                  <c:v>-0.16491098701953888</c:v>
                </c:pt>
                <c:pt idx="661">
                  <c:v>-0.15685911476612091</c:v>
                </c:pt>
                <c:pt idx="662">
                  <c:v>-0.14880366623401642</c:v>
                </c:pt>
                <c:pt idx="663">
                  <c:v>-0.14074502885341644</c:v>
                </c:pt>
                <c:pt idx="664">
                  <c:v>-0.13268178701400757</c:v>
                </c:pt>
                <c:pt idx="665">
                  <c:v>-0.12461569160223007</c:v>
                </c:pt>
                <c:pt idx="666">
                  <c:v>-0.1165463998913765</c:v>
                </c:pt>
                <c:pt idx="667">
                  <c:v>-0.10847356170415878</c:v>
                </c:pt>
                <c:pt idx="668">
                  <c:v>-0.10039681196212769</c:v>
                </c:pt>
                <c:pt idx="669">
                  <c:v>-9.231828898191452E-2</c:v>
                </c:pt>
                <c:pt idx="670">
                  <c:v>-8.4235154092311859E-2</c:v>
                </c:pt>
                <c:pt idx="671">
                  <c:v>-7.6148465275764465E-2</c:v>
                </c:pt>
                <c:pt idx="672">
                  <c:v>-6.8058229982852936E-2</c:v>
                </c:pt>
                <c:pt idx="673">
                  <c:v>-5.9964437037706375E-2</c:v>
                </c:pt>
                <c:pt idx="674">
                  <c:v>-5.1866386085748672E-2</c:v>
                </c:pt>
                <c:pt idx="675">
                  <c:v>-4.3764784932136536E-2</c:v>
                </c:pt>
                <c:pt idx="676">
                  <c:v>-3.565891832113266E-2</c:v>
                </c:pt>
                <c:pt idx="677">
                  <c:v>-2.7550216764211655E-2</c:v>
                </c:pt>
                <c:pt idx="678">
                  <c:v>-1.9437607377767563E-2</c:v>
                </c:pt>
                <c:pt idx="679">
                  <c:v>-1.1322162114083767E-2</c:v>
                </c:pt>
                <c:pt idx="680">
                  <c:v>-3.2024523243308067E-3</c:v>
                </c:pt>
                <c:pt idx="681">
                  <c:v>4.9204500392079353E-3</c:v>
                </c:pt>
                <c:pt idx="682">
                  <c:v>1.3047617860138416E-2</c:v>
                </c:pt>
                <c:pt idx="683">
                  <c:v>2.1178334951400757E-2</c:v>
                </c:pt>
                <c:pt idx="684">
                  <c:v>2.9313318431377411E-2</c:v>
                </c:pt>
                <c:pt idx="685">
                  <c:v>3.7451494485139847E-2</c:v>
                </c:pt>
                <c:pt idx="686">
                  <c:v>4.5593935996294022E-2</c:v>
                </c:pt>
                <c:pt idx="687">
                  <c:v>5.3741004317998886E-2</c:v>
                </c:pt>
                <c:pt idx="688">
                  <c:v>6.1891984194517136E-2</c:v>
                </c:pt>
                <c:pt idx="689">
                  <c:v>7.0048302412033081E-2</c:v>
                </c:pt>
                <c:pt idx="690">
                  <c:v>7.8208185732364655E-2</c:v>
                </c:pt>
                <c:pt idx="691">
                  <c:v>8.6373768746852875E-2</c:v>
                </c:pt>
                <c:pt idx="692">
                  <c:v>9.4543620944023132E-2</c:v>
                </c:pt>
                <c:pt idx="693">
                  <c:v>0.10271883010864258</c:v>
                </c:pt>
                <c:pt idx="694">
                  <c:v>0.11089867353439331</c:v>
                </c:pt>
                <c:pt idx="695">
                  <c:v>0.11908279359340668</c:v>
                </c:pt>
                <c:pt idx="696">
                  <c:v>0.12727083265781403</c:v>
                </c:pt>
                <c:pt idx="697">
                  <c:v>0.13546495139598846</c:v>
                </c:pt>
                <c:pt idx="698">
                  <c:v>0.14366370439529419</c:v>
                </c:pt>
                <c:pt idx="699">
                  <c:v>0.15186423063278198</c:v>
                </c:pt>
                <c:pt idx="700">
                  <c:v>0.16007046401500702</c:v>
                </c:pt>
                <c:pt idx="701">
                  <c:v>0.16828061640262604</c:v>
                </c:pt>
                <c:pt idx="702">
                  <c:v>0.17649650573730469</c:v>
                </c:pt>
                <c:pt idx="703">
                  <c:v>0.18471668660640717</c:v>
                </c:pt>
                <c:pt idx="704">
                  <c:v>0.19293861091136932</c:v>
                </c:pt>
                <c:pt idx="705">
                  <c:v>0.20116445422172546</c:v>
                </c:pt>
                <c:pt idx="706">
                  <c:v>0.20939423143863678</c:v>
                </c:pt>
                <c:pt idx="707">
                  <c:v>0.21762830018997192</c:v>
                </c:pt>
                <c:pt idx="708">
                  <c:v>0.2258666455745697</c:v>
                </c:pt>
                <c:pt idx="709">
                  <c:v>0.23410673439502716</c:v>
                </c:pt>
                <c:pt idx="710">
                  <c:v>0.24235184490680695</c:v>
                </c:pt>
                <c:pt idx="711">
                  <c:v>0.25059980154037476</c:v>
                </c:pt>
                <c:pt idx="712">
                  <c:v>0.2588527500629425</c:v>
                </c:pt>
                <c:pt idx="713">
                  <c:v>0.26710820198059082</c:v>
                </c:pt>
                <c:pt idx="714">
                  <c:v>0.27536863088607788</c:v>
                </c:pt>
                <c:pt idx="715">
                  <c:v>0.28363120555877686</c:v>
                </c:pt>
                <c:pt idx="716">
                  <c:v>0.29189911484718323</c:v>
                </c:pt>
                <c:pt idx="717">
                  <c:v>0.30016916990280151</c:v>
                </c:pt>
                <c:pt idx="718">
                  <c:v>0.30844134092330933</c:v>
                </c:pt>
                <c:pt idx="719">
                  <c:v>0.31671848893165588</c:v>
                </c:pt>
                <c:pt idx="720">
                  <c:v>0.32499957084655762</c:v>
                </c:pt>
                <c:pt idx="721">
                  <c:v>0.33328387141227722</c:v>
                </c:pt>
                <c:pt idx="722">
                  <c:v>0.34157207608222961</c:v>
                </c:pt>
                <c:pt idx="723">
                  <c:v>0.34986424446105957</c:v>
                </c:pt>
                <c:pt idx="724">
                  <c:v>0.35816028714179993</c:v>
                </c:pt>
                <c:pt idx="725">
                  <c:v>0.36646029353141785</c:v>
                </c:pt>
                <c:pt idx="726">
                  <c:v>0.3747638463973999</c:v>
                </c:pt>
                <c:pt idx="727">
                  <c:v>0.38307133316993713</c:v>
                </c:pt>
                <c:pt idx="728">
                  <c:v>0.3913823664188385</c:v>
                </c:pt>
                <c:pt idx="729">
                  <c:v>0.39969551563262939</c:v>
                </c:pt>
                <c:pt idx="730">
                  <c:v>0.40801367163658142</c:v>
                </c:pt>
                <c:pt idx="731">
                  <c:v>0.41633465886116028</c:v>
                </c:pt>
                <c:pt idx="732">
                  <c:v>0.42465850710868835</c:v>
                </c:pt>
                <c:pt idx="733">
                  <c:v>0.43298587203025818</c:v>
                </c:pt>
                <c:pt idx="734">
                  <c:v>0.44131720066070557</c:v>
                </c:pt>
                <c:pt idx="735">
                  <c:v>0.44965168833732605</c:v>
                </c:pt>
                <c:pt idx="736">
                  <c:v>0.45798975229263306</c:v>
                </c:pt>
                <c:pt idx="737">
                  <c:v>0.46633028984069824</c:v>
                </c:pt>
                <c:pt idx="738">
                  <c:v>0.47467547655105591</c:v>
                </c:pt>
                <c:pt idx="739">
                  <c:v>0.48302274942398071</c:v>
                </c:pt>
                <c:pt idx="740">
                  <c:v>0.49137285351753235</c:v>
                </c:pt>
                <c:pt idx="741">
                  <c:v>0.49972724914550781</c:v>
                </c:pt>
                <c:pt idx="742">
                  <c:v>0.50808405876159668</c:v>
                </c:pt>
                <c:pt idx="743">
                  <c:v>0.51644265651702881</c:v>
                </c:pt>
                <c:pt idx="744">
                  <c:v>0.52480512857437134</c:v>
                </c:pt>
                <c:pt idx="745">
                  <c:v>0.53317081928253174</c:v>
                </c:pt>
                <c:pt idx="746">
                  <c:v>0.54154151678085327</c:v>
                </c:pt>
                <c:pt idx="747">
                  <c:v>0.54991430044174194</c:v>
                </c:pt>
                <c:pt idx="748">
                  <c:v>0.55829101800918579</c:v>
                </c:pt>
                <c:pt idx="749">
                  <c:v>0.56667053699493408</c:v>
                </c:pt>
                <c:pt idx="750">
                  <c:v>0.57505619525909424</c:v>
                </c:pt>
                <c:pt idx="751">
                  <c:v>0.58344542980194092</c:v>
                </c:pt>
                <c:pt idx="752">
                  <c:v>0.591838538646698</c:v>
                </c:pt>
                <c:pt idx="753">
                  <c:v>0.60023564100265503</c:v>
                </c:pt>
                <c:pt idx="754">
                  <c:v>0.60863810777664185</c:v>
                </c:pt>
                <c:pt idx="755">
                  <c:v>0.61704337596893311</c:v>
                </c:pt>
                <c:pt idx="756">
                  <c:v>0.62545293569564819</c:v>
                </c:pt>
                <c:pt idx="757">
                  <c:v>0.6338660717010498</c:v>
                </c:pt>
                <c:pt idx="758">
                  <c:v>0.64228355884552002</c:v>
                </c:pt>
                <c:pt idx="759">
                  <c:v>0.65070492029190063</c:v>
                </c:pt>
                <c:pt idx="760">
                  <c:v>0.65913015604019165</c:v>
                </c:pt>
                <c:pt idx="761">
                  <c:v>0.66755902767181396</c:v>
                </c:pt>
                <c:pt idx="762">
                  <c:v>0.67599141597747803</c:v>
                </c:pt>
                <c:pt idx="763">
                  <c:v>0.68442702293395996</c:v>
                </c:pt>
                <c:pt idx="764">
                  <c:v>0.69286656379699707</c:v>
                </c:pt>
                <c:pt idx="765">
                  <c:v>0.70130962133407593</c:v>
                </c:pt>
                <c:pt idx="766">
                  <c:v>0.70975625514984131</c:v>
                </c:pt>
                <c:pt idx="767">
                  <c:v>0.71820646524429321</c:v>
                </c:pt>
                <c:pt idx="768">
                  <c:v>0.72666019201278687</c:v>
                </c:pt>
                <c:pt idx="769">
                  <c:v>0.73511749505996704</c:v>
                </c:pt>
                <c:pt idx="770">
                  <c:v>0.74357837438583374</c:v>
                </c:pt>
                <c:pt idx="771">
                  <c:v>0.75204277038574219</c:v>
                </c:pt>
                <c:pt idx="772">
                  <c:v>0.76051115989685059</c:v>
                </c:pt>
                <c:pt idx="773">
                  <c:v>0.7689826488494873</c:v>
                </c:pt>
                <c:pt idx="774">
                  <c:v>0.77745777368545532</c:v>
                </c:pt>
                <c:pt idx="775">
                  <c:v>0.78593641519546509</c:v>
                </c:pt>
                <c:pt idx="776">
                  <c:v>0.79441970586776733</c:v>
                </c:pt>
                <c:pt idx="777">
                  <c:v>0.80290621519088745</c:v>
                </c:pt>
                <c:pt idx="778">
                  <c:v>0.81139630079269409</c:v>
                </c:pt>
                <c:pt idx="779">
                  <c:v>0.81989026069641113</c:v>
                </c:pt>
                <c:pt idx="780">
                  <c:v>0.8283877968788147</c:v>
                </c:pt>
                <c:pt idx="781">
                  <c:v>0.83688926696777344</c:v>
                </c:pt>
                <c:pt idx="782">
                  <c:v>0.84539467096328735</c:v>
                </c:pt>
                <c:pt idx="783">
                  <c:v>0.85390365123748779</c:v>
                </c:pt>
                <c:pt idx="784">
                  <c:v>0.86241692304611206</c:v>
                </c:pt>
                <c:pt idx="785">
                  <c:v>0.87093526124954224</c:v>
                </c:pt>
                <c:pt idx="786">
                  <c:v>0.87945634126663208</c:v>
                </c:pt>
                <c:pt idx="787">
                  <c:v>0.88798290491104126</c:v>
                </c:pt>
                <c:pt idx="788">
                  <c:v>0.89651155471801758</c:v>
                </c:pt>
                <c:pt idx="789">
                  <c:v>0.90504634380340576</c:v>
                </c:pt>
                <c:pt idx="790">
                  <c:v>0.91358429193496704</c:v>
                </c:pt>
                <c:pt idx="791">
                  <c:v>0.92212510108947754</c:v>
                </c:pt>
                <c:pt idx="792">
                  <c:v>0.93067246675491333</c:v>
                </c:pt>
                <c:pt idx="793">
                  <c:v>0.9392244815826416</c:v>
                </c:pt>
                <c:pt idx="794">
                  <c:v>0.94778198003768921</c:v>
                </c:pt>
                <c:pt idx="795">
                  <c:v>0.95634263753890991</c:v>
                </c:pt>
                <c:pt idx="796">
                  <c:v>0.96491020917892456</c:v>
                </c:pt>
                <c:pt idx="797">
                  <c:v>0.97348028421401978</c:v>
                </c:pt>
                <c:pt idx="798">
                  <c:v>0.98205572366714478</c:v>
                </c:pt>
                <c:pt idx="799">
                  <c:v>0.99063628911972046</c:v>
                </c:pt>
                <c:pt idx="800">
                  <c:v>0.9992215633392334</c:v>
                </c:pt>
                <c:pt idx="801">
                  <c:v>1.0078107118606567</c:v>
                </c:pt>
                <c:pt idx="802">
                  <c:v>1.0163533687591553</c:v>
                </c:pt>
                <c:pt idx="803">
                  <c:v>1.0249003171920776</c:v>
                </c:pt>
                <c:pt idx="804">
                  <c:v>1.0334523916244507</c:v>
                </c:pt>
                <c:pt idx="805">
                  <c:v>1.0420078039169312</c:v>
                </c:pt>
                <c:pt idx="806">
                  <c:v>1.0505659580230713</c:v>
                </c:pt>
                <c:pt idx="807">
                  <c:v>1.0591276884078979</c:v>
                </c:pt>
                <c:pt idx="808">
                  <c:v>1.0676935911178589</c:v>
                </c:pt>
                <c:pt idx="809">
                  <c:v>1.0762640237808228</c:v>
                </c:pt>
                <c:pt idx="810">
                  <c:v>1.0848369598388672</c:v>
                </c:pt>
                <c:pt idx="811">
                  <c:v>1.0934129953384399</c:v>
                </c:pt>
                <c:pt idx="812">
                  <c:v>1.1019915342330933</c:v>
                </c:pt>
                <c:pt idx="813">
                  <c:v>1.1105730533599854</c:v>
                </c:pt>
                <c:pt idx="814">
                  <c:v>1.1191564798355103</c:v>
                </c:pt>
                <c:pt idx="815">
                  <c:v>1.1277438402175903</c:v>
                </c:pt>
                <c:pt idx="816">
                  <c:v>1.1363333463668823</c:v>
                </c:pt>
                <c:pt idx="817">
                  <c:v>1.1449254751205444</c:v>
                </c:pt>
                <c:pt idx="818">
                  <c:v>1.1535192728042603</c:v>
                </c:pt>
                <c:pt idx="819">
                  <c:v>1.1621159315109253</c:v>
                </c:pt>
                <c:pt idx="820">
                  <c:v>1.1707148551940918</c:v>
                </c:pt>
                <c:pt idx="821">
                  <c:v>1.1793156862258911</c:v>
                </c:pt>
                <c:pt idx="822">
                  <c:v>1.1879186630249023</c:v>
                </c:pt>
                <c:pt idx="823">
                  <c:v>1.1965234279632568</c:v>
                </c:pt>
                <c:pt idx="824">
                  <c:v>1.2051296234130859</c:v>
                </c:pt>
                <c:pt idx="825">
                  <c:v>1.213737964630127</c:v>
                </c:pt>
                <c:pt idx="826">
                  <c:v>1.2223480939865112</c:v>
                </c:pt>
                <c:pt idx="827">
                  <c:v>1.2309596538543701</c:v>
                </c:pt>
                <c:pt idx="828">
                  <c:v>1.2395728826522827</c:v>
                </c:pt>
                <c:pt idx="829">
                  <c:v>1.2481874227523804</c:v>
                </c:pt>
                <c:pt idx="830">
                  <c:v>1.2568033933639526</c:v>
                </c:pt>
                <c:pt idx="831">
                  <c:v>1.26542067527771</c:v>
                </c:pt>
                <c:pt idx="832">
                  <c:v>1.2740391492843628</c:v>
                </c:pt>
                <c:pt idx="833">
                  <c:v>1.2826588153839111</c:v>
                </c:pt>
                <c:pt idx="834">
                  <c:v>1.2912794351577759</c:v>
                </c:pt>
                <c:pt idx="835">
                  <c:v>1.2999011278152466</c:v>
                </c:pt>
                <c:pt idx="836">
                  <c:v>1.3085240125656128</c:v>
                </c:pt>
                <c:pt idx="837">
                  <c:v>1.3171474933624268</c:v>
                </c:pt>
                <c:pt idx="838">
                  <c:v>1.3257715702056885</c:v>
                </c:pt>
                <c:pt idx="839">
                  <c:v>1.3343963623046875</c:v>
                </c:pt>
                <c:pt idx="840">
                  <c:v>1.3430217504501343</c:v>
                </c:pt>
                <c:pt idx="841">
                  <c:v>1.3516477346420288</c:v>
                </c:pt>
                <c:pt idx="842">
                  <c:v>1.360274076461792</c:v>
                </c:pt>
                <c:pt idx="843">
                  <c:v>1.3689008951187134</c:v>
                </c:pt>
                <c:pt idx="844">
                  <c:v>1.3775279521942139</c:v>
                </c:pt>
                <c:pt idx="845">
                  <c:v>1.3861551284790039</c:v>
                </c:pt>
                <c:pt idx="846">
                  <c:v>1.394782543182373</c:v>
                </c:pt>
                <c:pt idx="847">
                  <c:v>1.4034100770950317</c:v>
                </c:pt>
                <c:pt idx="848">
                  <c:v>1.4120374917984009</c:v>
                </c:pt>
                <c:pt idx="849">
                  <c:v>1.4206647872924805</c:v>
                </c:pt>
                <c:pt idx="850">
                  <c:v>1.4292920827865601</c:v>
                </c:pt>
                <c:pt idx="851">
                  <c:v>1.437919020652771</c:v>
                </c:pt>
                <c:pt idx="852">
                  <c:v>1.4465447664260864</c:v>
                </c:pt>
                <c:pt idx="853">
                  <c:v>1.4551709890365601</c:v>
                </c:pt>
                <c:pt idx="854">
                  <c:v>1.4637967348098755</c:v>
                </c:pt>
                <c:pt idx="855">
                  <c:v>1.4724216461181641</c:v>
                </c:pt>
                <c:pt idx="856">
                  <c:v>1.4810453653335571</c:v>
                </c:pt>
                <c:pt idx="857">
                  <c:v>1.4896688461303711</c:v>
                </c:pt>
                <c:pt idx="858">
                  <c:v>1.4982904195785522</c:v>
                </c:pt>
                <c:pt idx="859">
                  <c:v>1.5069108009338379</c:v>
                </c:pt>
                <c:pt idx="860">
                  <c:v>1.5155290365219116</c:v>
                </c:pt>
                <c:pt idx="861">
                  <c:v>1.5241470336914063</c:v>
                </c:pt>
                <c:pt idx="862">
                  <c:v>1.5327609777450562</c:v>
                </c:pt>
                <c:pt idx="863">
                  <c:v>1.5413721799850464</c:v>
                </c:pt>
                <c:pt idx="864">
                  <c:v>1.5499818325042725</c:v>
                </c:pt>
                <c:pt idx="865">
                  <c:v>1.558587908744812</c:v>
                </c:pt>
                <c:pt idx="866">
                  <c:v>1.5671913623809814</c:v>
                </c:pt>
                <c:pt idx="867">
                  <c:v>1.575791597366333</c:v>
                </c:pt>
                <c:pt idx="868">
                  <c:v>1.5843863487243652</c:v>
                </c:pt>
                <c:pt idx="869">
                  <c:v>1.5929807424545288</c:v>
                </c:pt>
                <c:pt idx="870">
                  <c:v>1.6015729904174805</c:v>
                </c:pt>
                <c:pt idx="871">
                  <c:v>1.6101635694503784</c:v>
                </c:pt>
                <c:pt idx="872">
                  <c:v>1.6187503337860107</c:v>
                </c:pt>
                <c:pt idx="873">
                  <c:v>1.6273363828659058</c:v>
                </c:pt>
                <c:pt idx="874">
                  <c:v>1.6359177827835083</c:v>
                </c:pt>
                <c:pt idx="875">
                  <c:v>1.6444970369338989</c:v>
                </c:pt>
                <c:pt idx="876">
                  <c:v>1.6530745029449463</c:v>
                </c:pt>
                <c:pt idx="877">
                  <c:v>1.6616494655609131</c:v>
                </c:pt>
                <c:pt idx="878">
                  <c:v>1.6702206134796143</c:v>
                </c:pt>
                <c:pt idx="879">
                  <c:v>1.6787897348403931</c:v>
                </c:pt>
                <c:pt idx="880">
                  <c:v>1.6873552799224854</c:v>
                </c:pt>
                <c:pt idx="881">
                  <c:v>1.6959185600280762</c:v>
                </c:pt>
                <c:pt idx="882">
                  <c:v>1.7044779062271118</c:v>
                </c:pt>
                <c:pt idx="883">
                  <c:v>1.7130348682403564</c:v>
                </c:pt>
                <c:pt idx="884">
                  <c:v>1.7215878963470459</c:v>
                </c:pt>
                <c:pt idx="885">
                  <c:v>1.7301392555236816</c:v>
                </c:pt>
                <c:pt idx="886">
                  <c:v>1.7386870384216309</c:v>
                </c:pt>
                <c:pt idx="887">
                  <c:v>1.7472302913665771</c:v>
                </c:pt>
                <c:pt idx="888">
                  <c:v>1.7557704448699951</c:v>
                </c:pt>
                <c:pt idx="889">
                  <c:v>1.7643074989318848</c:v>
                </c:pt>
                <c:pt idx="890">
                  <c:v>1.7728420495986938</c:v>
                </c:pt>
                <c:pt idx="891">
                  <c:v>1.7813726663589478</c:v>
                </c:pt>
                <c:pt idx="892">
                  <c:v>1.7898998260498047</c:v>
                </c:pt>
                <c:pt idx="893">
                  <c:v>1.7984236478805542</c:v>
                </c:pt>
                <c:pt idx="894">
                  <c:v>1.8069438934326172</c:v>
                </c:pt>
                <c:pt idx="895">
                  <c:v>1.8154605627059937</c:v>
                </c:pt>
                <c:pt idx="896">
                  <c:v>1.823973536491394</c:v>
                </c:pt>
                <c:pt idx="897">
                  <c:v>1.8324826955795288</c:v>
                </c:pt>
                <c:pt idx="898">
                  <c:v>1.8409881591796875</c:v>
                </c:pt>
                <c:pt idx="899">
                  <c:v>1.8494893312454224</c:v>
                </c:pt>
                <c:pt idx="900">
                  <c:v>1.8579869270324707</c:v>
                </c:pt>
                <c:pt idx="901">
                  <c:v>1.8664793968200684</c:v>
                </c:pt>
                <c:pt idx="902">
                  <c:v>1.8749672174453735</c:v>
                </c:pt>
                <c:pt idx="903">
                  <c:v>1.8834495544433594</c:v>
                </c:pt>
                <c:pt idx="904">
                  <c:v>1.8919259309768677</c:v>
                </c:pt>
                <c:pt idx="905">
                  <c:v>1.9003970623016357</c:v>
                </c:pt>
                <c:pt idx="906">
                  <c:v>1.908862829208374</c:v>
                </c:pt>
                <c:pt idx="907">
                  <c:v>1.917323112487793</c:v>
                </c:pt>
                <c:pt idx="908">
                  <c:v>1.9257799386978149</c:v>
                </c:pt>
                <c:pt idx="909">
                  <c:v>1.9342317581176758</c:v>
                </c:pt>
                <c:pt idx="910">
                  <c:v>1.9426765441894531</c:v>
                </c:pt>
                <c:pt idx="911">
                  <c:v>1.9511200189590454</c:v>
                </c:pt>
                <c:pt idx="912">
                  <c:v>1.9595581293106079</c:v>
                </c:pt>
                <c:pt idx="913">
                  <c:v>1.9679906368255615</c:v>
                </c:pt>
                <c:pt idx="914">
                  <c:v>1.9764173030853271</c:v>
                </c:pt>
                <c:pt idx="915">
                  <c:v>1.9848370552062988</c:v>
                </c:pt>
                <c:pt idx="916">
                  <c:v>1.9932550191879272</c:v>
                </c:pt>
                <c:pt idx="917">
                  <c:v>2.0016672611236572</c:v>
                </c:pt>
                <c:pt idx="918">
                  <c:v>2.0100736618041992</c:v>
                </c:pt>
                <c:pt idx="919">
                  <c:v>2.018474817276001</c:v>
                </c:pt>
                <c:pt idx="920">
                  <c:v>2.0268728733062744</c:v>
                </c:pt>
                <c:pt idx="921">
                  <c:v>2.0352654457092285</c:v>
                </c:pt>
                <c:pt idx="922">
                  <c:v>2.0436511039733887</c:v>
                </c:pt>
                <c:pt idx="923">
                  <c:v>2.0520312786102295</c:v>
                </c:pt>
                <c:pt idx="924">
                  <c:v>2.0604093074798584</c:v>
                </c:pt>
                <c:pt idx="925">
                  <c:v>2.0687830448150635</c:v>
                </c:pt>
                <c:pt idx="926">
                  <c:v>2.0771529674530029</c:v>
                </c:pt>
                <c:pt idx="927">
                  <c:v>2.085517406463623</c:v>
                </c:pt>
                <c:pt idx="928">
                  <c:v>2.0938777923583984</c:v>
                </c:pt>
                <c:pt idx="929">
                  <c:v>2.1022355556488037</c:v>
                </c:pt>
                <c:pt idx="930">
                  <c:v>2.1105895042419434</c:v>
                </c:pt>
                <c:pt idx="931">
                  <c:v>2.1189372539520264</c:v>
                </c:pt>
                <c:pt idx="932">
                  <c:v>2.1272826194763184</c:v>
                </c:pt>
                <c:pt idx="933">
                  <c:v>2.1356244087219238</c:v>
                </c:pt>
                <c:pt idx="934">
                  <c:v>2.143963098526001</c:v>
                </c:pt>
                <c:pt idx="935">
                  <c:v>2.1522984504699707</c:v>
                </c:pt>
                <c:pt idx="936">
                  <c:v>2.1606311798095703</c:v>
                </c:pt>
                <c:pt idx="937">
                  <c:v>2.1689591407775879</c:v>
                </c:pt>
                <c:pt idx="938">
                  <c:v>2.17728590965271</c:v>
                </c:pt>
                <c:pt idx="939">
                  <c:v>2.1856098175048828</c:v>
                </c:pt>
                <c:pt idx="940">
                  <c:v>2.1939301490783691</c:v>
                </c:pt>
                <c:pt idx="941">
                  <c:v>2.2022485733032227</c:v>
                </c:pt>
                <c:pt idx="942">
                  <c:v>2.2105653285980225</c:v>
                </c:pt>
                <c:pt idx="943">
                  <c:v>2.2188775539398193</c:v>
                </c:pt>
                <c:pt idx="944">
                  <c:v>2.2271883487701416</c:v>
                </c:pt>
                <c:pt idx="945">
                  <c:v>2.2354962825775146</c:v>
                </c:pt>
                <c:pt idx="946">
                  <c:v>2.243802547454834</c:v>
                </c:pt>
                <c:pt idx="947">
                  <c:v>2.2521071434020996</c:v>
                </c:pt>
                <c:pt idx="948">
                  <c:v>2.260408878326416</c:v>
                </c:pt>
                <c:pt idx="949">
                  <c:v>2.2687087059020996</c:v>
                </c:pt>
                <c:pt idx="950">
                  <c:v>2.2770071029663086</c:v>
                </c:pt>
                <c:pt idx="951">
                  <c:v>2.2853028774261475</c:v>
                </c:pt>
                <c:pt idx="952">
                  <c:v>2.2935984134674072</c:v>
                </c:pt>
                <c:pt idx="953">
                  <c:v>2.3018929958343506</c:v>
                </c:pt>
                <c:pt idx="954">
                  <c:v>2.3101856708526611</c:v>
                </c:pt>
                <c:pt idx="955">
                  <c:v>2.3184778690338135</c:v>
                </c:pt>
                <c:pt idx="956">
                  <c:v>2.3267686367034912</c:v>
                </c:pt>
                <c:pt idx="957">
                  <c:v>2.3350574970245361</c:v>
                </c:pt>
                <c:pt idx="958">
                  <c:v>2.3433480262756348</c:v>
                </c:pt>
                <c:pt idx="959">
                  <c:v>2.3516364097595215</c:v>
                </c:pt>
                <c:pt idx="960">
                  <c:v>2.35992431640625</c:v>
                </c:pt>
                <c:pt idx="961">
                  <c:v>2.3682112693786621</c:v>
                </c:pt>
                <c:pt idx="962">
                  <c:v>2.3765006065368652</c:v>
                </c:pt>
                <c:pt idx="963">
                  <c:v>2.3847866058349609</c:v>
                </c:pt>
                <c:pt idx="964">
                  <c:v>2.3930745124816895</c:v>
                </c:pt>
                <c:pt idx="965">
                  <c:v>2.4013626575469971</c:v>
                </c:pt>
                <c:pt idx="966">
                  <c:v>2.4096517562866211</c:v>
                </c:pt>
                <c:pt idx="967">
                  <c:v>2.417940616607666</c:v>
                </c:pt>
                <c:pt idx="968">
                  <c:v>2.42622971534729</c:v>
                </c:pt>
                <c:pt idx="969">
                  <c:v>2.4345190525054932</c:v>
                </c:pt>
                <c:pt idx="970">
                  <c:v>2.44281005859375</c:v>
                </c:pt>
                <c:pt idx="971">
                  <c:v>2.4511003494262695</c:v>
                </c:pt>
                <c:pt idx="972">
                  <c:v>2.4593913555145264</c:v>
                </c:pt>
                <c:pt idx="973">
                  <c:v>2.4676840305328369</c:v>
                </c:pt>
                <c:pt idx="974">
                  <c:v>2.4759771823883057</c:v>
                </c:pt>
                <c:pt idx="975">
                  <c:v>2.4842720031738281</c:v>
                </c:pt>
                <c:pt idx="976">
                  <c:v>2.4925699234008789</c:v>
                </c:pt>
                <c:pt idx="977">
                  <c:v>2.500868558883667</c:v>
                </c:pt>
                <c:pt idx="978">
                  <c:v>2.509169340133667</c:v>
                </c:pt>
                <c:pt idx="979">
                  <c:v>2.5174713134765625</c:v>
                </c:pt>
                <c:pt idx="980">
                  <c:v>2.5257749557495117</c:v>
                </c:pt>
                <c:pt idx="981">
                  <c:v>2.5340802669525146</c:v>
                </c:pt>
                <c:pt idx="982">
                  <c:v>2.5423884391784668</c:v>
                </c:pt>
                <c:pt idx="983">
                  <c:v>2.5506970882415771</c:v>
                </c:pt>
                <c:pt idx="984">
                  <c:v>2.5590097904205322</c:v>
                </c:pt>
                <c:pt idx="985">
                  <c:v>2.5673236846923828</c:v>
                </c:pt>
                <c:pt idx="986">
                  <c:v>2.5756399631500244</c:v>
                </c:pt>
                <c:pt idx="987">
                  <c:v>2.5839588642120361</c:v>
                </c:pt>
                <c:pt idx="988">
                  <c:v>2.5922808647155762</c:v>
                </c:pt>
                <c:pt idx="989">
                  <c:v>2.6006057262420654</c:v>
                </c:pt>
                <c:pt idx="990">
                  <c:v>2.6089327335357666</c:v>
                </c:pt>
                <c:pt idx="991">
                  <c:v>2.6172630786895752</c:v>
                </c:pt>
                <c:pt idx="992">
                  <c:v>2.6255970001220703</c:v>
                </c:pt>
                <c:pt idx="993">
                  <c:v>2.633934497833252</c:v>
                </c:pt>
                <c:pt idx="994">
                  <c:v>2.6422743797302246</c:v>
                </c:pt>
                <c:pt idx="995">
                  <c:v>2.6506185531616211</c:v>
                </c:pt>
                <c:pt idx="996">
                  <c:v>2.658966064453125</c:v>
                </c:pt>
                <c:pt idx="997">
                  <c:v>2.6673173904418945</c:v>
                </c:pt>
                <c:pt idx="998">
                  <c:v>2.6756718158721924</c:v>
                </c:pt>
                <c:pt idx="999">
                  <c:v>2.6840307712554932</c:v>
                </c:pt>
                <c:pt idx="1000">
                  <c:v>2.6923933029174805</c:v>
                </c:pt>
                <c:pt idx="1001">
                  <c:v>2.7007591724395752</c:v>
                </c:pt>
                <c:pt idx="1002">
                  <c:v>2.709129810333252</c:v>
                </c:pt>
                <c:pt idx="1003">
                  <c:v>2.7175049781799316</c:v>
                </c:pt>
                <c:pt idx="1004">
                  <c:v>2.7258841991424561</c:v>
                </c:pt>
                <c:pt idx="1005">
                  <c:v>2.7342681884765625</c:v>
                </c:pt>
                <c:pt idx="1006">
                  <c:v>2.7426571846008301</c:v>
                </c:pt>
                <c:pt idx="1007">
                  <c:v>2.7510509490966797</c:v>
                </c:pt>
                <c:pt idx="1008">
                  <c:v>2.7594492435455322</c:v>
                </c:pt>
                <c:pt idx="1009">
                  <c:v>2.7678530216217041</c:v>
                </c:pt>
                <c:pt idx="1010">
                  <c:v>2.776261568069458</c:v>
                </c:pt>
                <c:pt idx="1011">
                  <c:v>2.7846755981445313</c:v>
                </c:pt>
                <c:pt idx="1012">
                  <c:v>2.7930948734283447</c:v>
                </c:pt>
                <c:pt idx="1013">
                  <c:v>2.8015193939208984</c:v>
                </c:pt>
                <c:pt idx="1014">
                  <c:v>2.8099496364593506</c:v>
                </c:pt>
                <c:pt idx="1015">
                  <c:v>2.8183853626251221</c:v>
                </c:pt>
                <c:pt idx="1016">
                  <c:v>2.8268270492553711</c:v>
                </c:pt>
                <c:pt idx="1017">
                  <c:v>2.8352744579315186</c:v>
                </c:pt>
                <c:pt idx="1018">
                  <c:v>2.8437280654907227</c:v>
                </c:pt>
                <c:pt idx="1019">
                  <c:v>2.8521876335144043</c:v>
                </c:pt>
                <c:pt idx="1020">
                  <c:v>2.8606534004211426</c:v>
                </c:pt>
                <c:pt idx="1021">
                  <c:v>2.8691253662109375</c:v>
                </c:pt>
                <c:pt idx="1022">
                  <c:v>2.8776040077209473</c:v>
                </c:pt>
                <c:pt idx="1023">
                  <c:v>2.8860890865325928</c:v>
                </c:pt>
                <c:pt idx="1024">
                  <c:v>2.8945808410644531</c:v>
                </c:pt>
                <c:pt idx="1025">
                  <c:v>2.9030792713165283</c:v>
                </c:pt>
                <c:pt idx="1026">
                  <c:v>2.9115848541259766</c:v>
                </c:pt>
                <c:pt idx="1027">
                  <c:v>2.9200971126556396</c:v>
                </c:pt>
                <c:pt idx="1028">
                  <c:v>2.9286167621612549</c:v>
                </c:pt>
                <c:pt idx="1029">
                  <c:v>2.9371435642242432</c:v>
                </c:pt>
                <c:pt idx="1030">
                  <c:v>2.9456775188446045</c:v>
                </c:pt>
                <c:pt idx="1031">
                  <c:v>2.9542191028594971</c:v>
                </c:pt>
                <c:pt idx="1032">
                  <c:v>2.9627683162689209</c:v>
                </c:pt>
                <c:pt idx="1033">
                  <c:v>2.971325159072876</c:v>
                </c:pt>
                <c:pt idx="1034">
                  <c:v>2.9798896312713623</c:v>
                </c:pt>
                <c:pt idx="1035">
                  <c:v>2.9884622097015381</c:v>
                </c:pt>
                <c:pt idx="1036">
                  <c:v>2.9970426559448242</c:v>
                </c:pt>
                <c:pt idx="1037">
                  <c:v>3.0056312084197998</c:v>
                </c:pt>
                <c:pt idx="1038">
                  <c:v>3.0142281055450439</c:v>
                </c:pt>
                <c:pt idx="1039">
                  <c:v>3.0228331089019775</c:v>
                </c:pt>
                <c:pt idx="1040">
                  <c:v>3.0314462184906006</c:v>
                </c:pt>
                <c:pt idx="1041">
                  <c:v>3.0400674343109131</c:v>
                </c:pt>
                <c:pt idx="1042">
                  <c:v>3.048696756362915</c:v>
                </c:pt>
                <c:pt idx="1043">
                  <c:v>3.0573344230651855</c:v>
                </c:pt>
                <c:pt idx="1044">
                  <c:v>3.0659799575805664</c:v>
                </c:pt>
                <c:pt idx="1045">
                  <c:v>3.0746338367462158</c:v>
                </c:pt>
                <c:pt idx="1046">
                  <c:v>3.0832958221435547</c:v>
                </c:pt>
                <c:pt idx="1047">
                  <c:v>3.0919656753540039</c:v>
                </c:pt>
                <c:pt idx="1048">
                  <c:v>3.1006443500518799</c:v>
                </c:pt>
                <c:pt idx="1049">
                  <c:v>3.1093306541442871</c:v>
                </c:pt>
                <c:pt idx="1050">
                  <c:v>3.1180250644683838</c:v>
                </c:pt>
                <c:pt idx="1051">
                  <c:v>3.1267275810241699</c:v>
                </c:pt>
                <c:pt idx="1052">
                  <c:v>3.1354379653930664</c:v>
                </c:pt>
                <c:pt idx="1053">
                  <c:v>3.1441566944122314</c:v>
                </c:pt>
                <c:pt idx="1054">
                  <c:v>3.1528835296630859</c:v>
                </c:pt>
                <c:pt idx="1055">
                  <c:v>3.1616184711456299</c:v>
                </c:pt>
                <c:pt idx="1056">
                  <c:v>3.1703617572784424</c:v>
                </c:pt>
                <c:pt idx="1057">
                  <c:v>3.1791126728057861</c:v>
                </c:pt>
                <c:pt idx="1058">
                  <c:v>3.1878726482391357</c:v>
                </c:pt>
                <c:pt idx="1059">
                  <c:v>3.1966397762298584</c:v>
                </c:pt>
                <c:pt idx="1060">
                  <c:v>3.2054152488708496</c:v>
                </c:pt>
                <c:pt idx="1061">
                  <c:v>3.2141985893249512</c:v>
                </c:pt>
                <c:pt idx="1062">
                  <c:v>3.2229900360107422</c:v>
                </c:pt>
                <c:pt idx="1063">
                  <c:v>3.2317893505096436</c:v>
                </c:pt>
                <c:pt idx="1064">
                  <c:v>3.2405967712402344</c:v>
                </c:pt>
                <c:pt idx="1065">
                  <c:v>3.2494122982025146</c:v>
                </c:pt>
                <c:pt idx="1066">
                  <c:v>3.2582356929779053</c:v>
                </c:pt>
                <c:pt idx="1067">
                  <c:v>3.2670671939849854</c:v>
                </c:pt>
                <c:pt idx="1068">
                  <c:v>3.2759072780609131</c:v>
                </c:pt>
                <c:pt idx="1069">
                  <c:v>3.284754753112793</c:v>
                </c:pt>
                <c:pt idx="1070">
                  <c:v>3.2936103343963623</c:v>
                </c:pt>
                <c:pt idx="1071">
                  <c:v>3.3024740219116211</c:v>
                </c:pt>
                <c:pt idx="1072">
                  <c:v>3.3113460540771484</c:v>
                </c:pt>
                <c:pt idx="1073">
                  <c:v>3.320225715637207</c:v>
                </c:pt>
                <c:pt idx="1074">
                  <c:v>3.3291141986846924</c:v>
                </c:pt>
                <c:pt idx="1075">
                  <c:v>3.3380100727081299</c:v>
                </c:pt>
                <c:pt idx="1076">
                  <c:v>3.346914529800415</c:v>
                </c:pt>
                <c:pt idx="1077">
                  <c:v>3.3558268547058105</c:v>
                </c:pt>
                <c:pt idx="1078">
                  <c:v>3.3647472858428955</c:v>
                </c:pt>
                <c:pt idx="1079">
                  <c:v>3.3736751079559326</c:v>
                </c:pt>
                <c:pt idx="1080">
                  <c:v>3.3826107978820801</c:v>
                </c:pt>
                <c:pt idx="1081">
                  <c:v>3.3915550708770752</c:v>
                </c:pt>
                <c:pt idx="1082">
                  <c:v>3.4005076885223389</c:v>
                </c:pt>
                <c:pt idx="1083">
                  <c:v>3.4094679355621338</c:v>
                </c:pt>
                <c:pt idx="1084">
                  <c:v>3.4184360504150391</c:v>
                </c:pt>
                <c:pt idx="1085">
                  <c:v>3.4274120330810547</c:v>
                </c:pt>
                <c:pt idx="1086">
                  <c:v>3.4363973140716553</c:v>
                </c:pt>
                <c:pt idx="1087">
                  <c:v>3.4453895092010498</c:v>
                </c:pt>
                <c:pt idx="1088">
                  <c:v>3.4543900489807129</c:v>
                </c:pt>
                <c:pt idx="1089">
                  <c:v>3.4633986949920654</c:v>
                </c:pt>
                <c:pt idx="1090">
                  <c:v>3.4724149703979492</c:v>
                </c:pt>
                <c:pt idx="1091">
                  <c:v>3.4814391136169434</c:v>
                </c:pt>
                <c:pt idx="1092">
                  <c:v>3.4904708862304688</c:v>
                </c:pt>
                <c:pt idx="1093">
                  <c:v>3.4995100498199463</c:v>
                </c:pt>
                <c:pt idx="1094">
                  <c:v>3.5085577964782715</c:v>
                </c:pt>
                <c:pt idx="1095">
                  <c:v>3.5176136493682861</c:v>
                </c:pt>
                <c:pt idx="1096">
                  <c:v>3.5266764163970947</c:v>
                </c:pt>
                <c:pt idx="1097">
                  <c:v>3.5357468128204346</c:v>
                </c:pt>
                <c:pt idx="1098">
                  <c:v>3.5448250770568848</c:v>
                </c:pt>
                <c:pt idx="1099">
                  <c:v>3.5539116859436035</c:v>
                </c:pt>
                <c:pt idx="1100">
                  <c:v>3.5630061626434326</c:v>
                </c:pt>
                <c:pt idx="1101">
                  <c:v>3.5721085071563721</c:v>
                </c:pt>
                <c:pt idx="1102">
                  <c:v>3.581218957901001</c:v>
                </c:pt>
                <c:pt idx="1103">
                  <c:v>3.5903365612030029</c:v>
                </c:pt>
                <c:pt idx="1104">
                  <c:v>3.5994625091552734</c:v>
                </c:pt>
                <c:pt idx="1105">
                  <c:v>3.6085963249206543</c:v>
                </c:pt>
                <c:pt idx="1106">
                  <c:v>3.6177384853363037</c:v>
                </c:pt>
                <c:pt idx="1107">
                  <c:v>3.6268882751464844</c:v>
                </c:pt>
                <c:pt idx="1108">
                  <c:v>3.6360459327697754</c:v>
                </c:pt>
                <c:pt idx="1109">
                  <c:v>3.6452116966247559</c:v>
                </c:pt>
                <c:pt idx="1110">
                  <c:v>3.6543846130371094</c:v>
                </c:pt>
                <c:pt idx="1111">
                  <c:v>3.6635658740997314</c:v>
                </c:pt>
                <c:pt idx="1112">
                  <c:v>3.6727545261383057</c:v>
                </c:pt>
                <c:pt idx="1113">
                  <c:v>3.6819515228271484</c:v>
                </c:pt>
                <c:pt idx="1114">
                  <c:v>3.6911561489105225</c:v>
                </c:pt>
                <c:pt idx="1115">
                  <c:v>3.7003684043884277</c:v>
                </c:pt>
                <c:pt idx="1116">
                  <c:v>3.7095890045166016</c:v>
                </c:pt>
                <c:pt idx="1117">
                  <c:v>3.7188167572021484</c:v>
                </c:pt>
                <c:pt idx="1118">
                  <c:v>3.7280535697937012</c:v>
                </c:pt>
                <c:pt idx="1119">
                  <c:v>3.7372965812683105</c:v>
                </c:pt>
                <c:pt idx="1120">
                  <c:v>3.7465479373931885</c:v>
                </c:pt>
                <c:pt idx="1121">
                  <c:v>3.7558073997497559</c:v>
                </c:pt>
                <c:pt idx="1122">
                  <c:v>3.7650749683380127</c:v>
                </c:pt>
                <c:pt idx="1123">
                  <c:v>3.7743501663208008</c:v>
                </c:pt>
                <c:pt idx="1124">
                  <c:v>3.7836332321166992</c:v>
                </c:pt>
                <c:pt idx="1125">
                  <c:v>3.7929246425628662</c:v>
                </c:pt>
                <c:pt idx="1126">
                  <c:v>3.8022234439849854</c:v>
                </c:pt>
                <c:pt idx="1127">
                  <c:v>3.8115303516387939</c:v>
                </c:pt>
                <c:pt idx="1128">
                  <c:v>3.8208448886871338</c:v>
                </c:pt>
                <c:pt idx="1129">
                  <c:v>3.8301670551300049</c:v>
                </c:pt>
                <c:pt idx="1130">
                  <c:v>3.8394968509674072</c:v>
                </c:pt>
                <c:pt idx="1131">
                  <c:v>3.8488342761993408</c:v>
                </c:pt>
                <c:pt idx="1132">
                  <c:v>3.8581805229187012</c:v>
                </c:pt>
                <c:pt idx="1133">
                  <c:v>3.8675336837768555</c:v>
                </c:pt>
                <c:pt idx="1134">
                  <c:v>3.8768947124481201</c:v>
                </c:pt>
                <c:pt idx="1135">
                  <c:v>3.8862643241882324</c:v>
                </c:pt>
                <c:pt idx="1136">
                  <c:v>3.8956403732299805</c:v>
                </c:pt>
                <c:pt idx="1137">
                  <c:v>3.9050252437591553</c:v>
                </c:pt>
                <c:pt idx="1138">
                  <c:v>3.9144172668457031</c:v>
                </c:pt>
                <c:pt idx="1139">
                  <c:v>3.9238181114196777</c:v>
                </c:pt>
                <c:pt idx="1140">
                  <c:v>3.9332261085510254</c:v>
                </c:pt>
                <c:pt idx="1141">
                  <c:v>3.9426419734954834</c:v>
                </c:pt>
                <c:pt idx="1142">
                  <c:v>3.9520649909973145</c:v>
                </c:pt>
                <c:pt idx="1143">
                  <c:v>3.9614970684051514</c:v>
                </c:pt>
                <c:pt idx="1144">
                  <c:v>3.9709362983703613</c:v>
                </c:pt>
                <c:pt idx="1145">
                  <c:v>3.9803829193115234</c:v>
                </c:pt>
                <c:pt idx="1146">
                  <c:v>3.9898366928100586</c:v>
                </c:pt>
                <c:pt idx="1147">
                  <c:v>3.9992995262145996</c:v>
                </c:pt>
                <c:pt idx="1148">
                  <c:v>4.0087690353393555</c:v>
                </c:pt>
                <c:pt idx="1149">
                  <c:v>4.018247127532959</c:v>
                </c:pt>
                <c:pt idx="1150">
                  <c:v>4.0277318954467773</c:v>
                </c:pt>
                <c:pt idx="1151">
                  <c:v>4.0372257232666016</c:v>
                </c:pt>
                <c:pt idx="1152">
                  <c:v>4.0467262268066406</c:v>
                </c:pt>
                <c:pt idx="1153">
                  <c:v>4.0562353134155273</c:v>
                </c:pt>
                <c:pt idx="1154">
                  <c:v>4.0657520294189453</c:v>
                </c:pt>
                <c:pt idx="1155">
                  <c:v>4.0752763748168945</c:v>
                </c:pt>
                <c:pt idx="1156">
                  <c:v>4.084808349609375</c:v>
                </c:pt>
                <c:pt idx="1157">
                  <c:v>4.0943484306335449</c:v>
                </c:pt>
                <c:pt idx="1158">
                  <c:v>4.1038947105407715</c:v>
                </c:pt>
                <c:pt idx="1159">
                  <c:v>4.1134514808654785</c:v>
                </c:pt>
                <c:pt idx="1160">
                  <c:v>4.1230144500732422</c:v>
                </c:pt>
                <c:pt idx="1161">
                  <c:v>4.1325850486755371</c:v>
                </c:pt>
                <c:pt idx="1162">
                  <c:v>4.1421647071838379</c:v>
                </c:pt>
                <c:pt idx="1163">
                  <c:v>4.1517524719238281</c:v>
                </c:pt>
                <c:pt idx="1164">
                  <c:v>4.1613478660583496</c:v>
                </c:pt>
                <c:pt idx="1165">
                  <c:v>4.1709518432617188</c:v>
                </c:pt>
                <c:pt idx="1166">
                  <c:v>4.1805620193481445</c:v>
                </c:pt>
                <c:pt idx="1167">
                  <c:v>4.1901826858520508</c:v>
                </c:pt>
                <c:pt idx="1168">
                  <c:v>4.1998090744018555</c:v>
                </c:pt>
                <c:pt idx="1169">
                  <c:v>4.2094440460205078</c:v>
                </c:pt>
                <c:pt idx="1170">
                  <c:v>4.2190871238708496</c:v>
                </c:pt>
                <c:pt idx="1171">
                  <c:v>4.2287397384643555</c:v>
                </c:pt>
                <c:pt idx="1172">
                  <c:v>4.2383975982666016</c:v>
                </c:pt>
                <c:pt idx="1173">
                  <c:v>4.2480649948120117</c:v>
                </c:pt>
                <c:pt idx="1174">
                  <c:v>4.2577400207519531</c:v>
                </c:pt>
                <c:pt idx="1175">
                  <c:v>4.267423152923584</c:v>
                </c:pt>
                <c:pt idx="1176">
                  <c:v>4.2771139144897461</c:v>
                </c:pt>
                <c:pt idx="1177">
                  <c:v>4.2868146896362305</c:v>
                </c:pt>
                <c:pt idx="1178">
                  <c:v>4.2965211868286133</c:v>
                </c:pt>
                <c:pt idx="1179">
                  <c:v>4.3062376976013184</c:v>
                </c:pt>
                <c:pt idx="1180">
                  <c:v>4.3159594535827637</c:v>
                </c:pt>
                <c:pt idx="1181">
                  <c:v>4.3256916999816895</c:v>
                </c:pt>
                <c:pt idx="1182">
                  <c:v>4.3354310989379883</c:v>
                </c:pt>
                <c:pt idx="1183">
                  <c:v>4.3451800346374512</c:v>
                </c:pt>
                <c:pt idx="1184">
                  <c:v>4.3549356460571289</c:v>
                </c:pt>
                <c:pt idx="1185">
                  <c:v>4.3646998405456543</c:v>
                </c:pt>
                <c:pt idx="1186">
                  <c:v>4.3744711875915527</c:v>
                </c:pt>
                <c:pt idx="1187">
                  <c:v>4.3842520713806152</c:v>
                </c:pt>
                <c:pt idx="1188">
                  <c:v>4.3940420150756836</c:v>
                </c:pt>
                <c:pt idx="1189">
                  <c:v>4.4038395881652832</c:v>
                </c:pt>
                <c:pt idx="1190">
                  <c:v>4.4136452674865723</c:v>
                </c:pt>
                <c:pt idx="1191">
                  <c:v>4.423459529876709</c:v>
                </c:pt>
                <c:pt idx="1192">
                  <c:v>4.433281421661377</c:v>
                </c:pt>
                <c:pt idx="1193">
                  <c:v>4.4431123733520508</c:v>
                </c:pt>
                <c:pt idx="1194">
                  <c:v>4.4529509544372559</c:v>
                </c:pt>
                <c:pt idx="1195">
                  <c:v>4.4627976417541504</c:v>
                </c:pt>
                <c:pt idx="1196">
                  <c:v>4.4726529121398926</c:v>
                </c:pt>
                <c:pt idx="1197">
                  <c:v>4.482515811920166</c:v>
                </c:pt>
                <c:pt idx="1198">
                  <c:v>4.4923877716064453</c:v>
                </c:pt>
                <c:pt idx="1199">
                  <c:v>4.5022692680358887</c:v>
                </c:pt>
                <c:pt idx="1200">
                  <c:v>4.5121564865112305</c:v>
                </c:pt>
                <c:pt idx="1201">
                  <c:v>4.5220522880554199</c:v>
                </c:pt>
                <c:pt idx="1202">
                  <c:v>4.531956672668457</c:v>
                </c:pt>
                <c:pt idx="1203">
                  <c:v>4.5418696403503418</c:v>
                </c:pt>
                <c:pt idx="1204">
                  <c:v>4.5517926216125488</c:v>
                </c:pt>
                <c:pt idx="1205">
                  <c:v>4.5617237091064453</c:v>
                </c:pt>
                <c:pt idx="1206">
                  <c:v>4.5716633796691895</c:v>
                </c:pt>
                <c:pt idx="1207">
                  <c:v>4.581611156463623</c:v>
                </c:pt>
                <c:pt idx="1208">
                  <c:v>4.5915679931640625</c:v>
                </c:pt>
                <c:pt idx="1209">
                  <c:v>4.601531982421875</c:v>
                </c:pt>
                <c:pt idx="1210">
                  <c:v>4.6115031242370605</c:v>
                </c:pt>
                <c:pt idx="1211">
                  <c:v>4.6214842796325684</c:v>
                </c:pt>
                <c:pt idx="1212">
                  <c:v>4.6314730644226074</c:v>
                </c:pt>
                <c:pt idx="1213">
                  <c:v>4.6414718627929688</c:v>
                </c:pt>
                <c:pt idx="1214">
                  <c:v>4.6514773368835449</c:v>
                </c:pt>
                <c:pt idx="1215">
                  <c:v>4.6614928245544434</c:v>
                </c:pt>
                <c:pt idx="1216">
                  <c:v>4.6715173721313477</c:v>
                </c:pt>
                <c:pt idx="1217">
                  <c:v>4.6815509796142578</c:v>
                </c:pt>
                <c:pt idx="1218">
                  <c:v>4.691591739654541</c:v>
                </c:pt>
                <c:pt idx="1219">
                  <c:v>4.7016425132751465</c:v>
                </c:pt>
                <c:pt idx="1220">
                  <c:v>4.7117013931274414</c:v>
                </c:pt>
                <c:pt idx="1221">
                  <c:v>4.7217698097229004</c:v>
                </c:pt>
                <c:pt idx="1222">
                  <c:v>4.7318453788757324</c:v>
                </c:pt>
                <c:pt idx="1223">
                  <c:v>4.7419295310974121</c:v>
                </c:pt>
                <c:pt idx="1224">
                  <c:v>4.7520236968994141</c:v>
                </c:pt>
                <c:pt idx="1225">
                  <c:v>4.7621278762817383</c:v>
                </c:pt>
                <c:pt idx="1226">
                  <c:v>4.7722415924072266</c:v>
                </c:pt>
                <c:pt idx="1227">
                  <c:v>4.7823629379272461</c:v>
                </c:pt>
                <c:pt idx="1228">
                  <c:v>4.7924938201904297</c:v>
                </c:pt>
                <c:pt idx="1229">
                  <c:v>4.8026323318481445</c:v>
                </c:pt>
                <c:pt idx="1230">
                  <c:v>4.8127808570861816</c:v>
                </c:pt>
                <c:pt idx="1231">
                  <c:v>4.8229360580444336</c:v>
                </c:pt>
                <c:pt idx="1232">
                  <c:v>4.8331012725830078</c:v>
                </c:pt>
                <c:pt idx="1233">
                  <c:v>4.8432745933532715</c:v>
                </c:pt>
                <c:pt idx="1234">
                  <c:v>4.8534588813781738</c:v>
                </c:pt>
                <c:pt idx="1235">
                  <c:v>4.8636517524719238</c:v>
                </c:pt>
                <c:pt idx="1236">
                  <c:v>4.8738532066345215</c:v>
                </c:pt>
                <c:pt idx="1237">
                  <c:v>4.8840627670288086</c:v>
                </c:pt>
                <c:pt idx="1238">
                  <c:v>4.8942832946777344</c:v>
                </c:pt>
                <c:pt idx="1239">
                  <c:v>4.9045119285583496</c:v>
                </c:pt>
                <c:pt idx="1240">
                  <c:v>4.9147505760192871</c:v>
                </c:pt>
                <c:pt idx="1241">
                  <c:v>4.9249978065490723</c:v>
                </c:pt>
                <c:pt idx="1242">
                  <c:v>4.9352550506591797</c:v>
                </c:pt>
                <c:pt idx="1243">
                  <c:v>4.9455194473266602</c:v>
                </c:pt>
                <c:pt idx="1244">
                  <c:v>4.9557943344116211</c:v>
                </c:pt>
                <c:pt idx="1245">
                  <c:v>4.9660763740539551</c:v>
                </c:pt>
                <c:pt idx="1246">
                  <c:v>4.9763679504394531</c:v>
                </c:pt>
                <c:pt idx="1247">
                  <c:v>4.9866681098937988</c:v>
                </c:pt>
                <c:pt idx="1248">
                  <c:v>4.996976375579834</c:v>
                </c:pt>
                <c:pt idx="1249">
                  <c:v>5.0072956085205078</c:v>
                </c:pt>
                <c:pt idx="1250">
                  <c:v>5.0176239013671875</c:v>
                </c:pt>
                <c:pt idx="1251">
                  <c:v>5.0279598236083984</c:v>
                </c:pt>
                <c:pt idx="1252">
                  <c:v>5.0383038520812988</c:v>
                </c:pt>
                <c:pt idx="1253">
                  <c:v>5.0486578941345215</c:v>
                </c:pt>
                <c:pt idx="1254">
                  <c:v>5.0590200424194336</c:v>
                </c:pt>
                <c:pt idx="1255">
                  <c:v>5.069389820098877</c:v>
                </c:pt>
                <c:pt idx="1256">
                  <c:v>5.079768180847168</c:v>
                </c:pt>
                <c:pt idx="1257">
                  <c:v>5.0901570320129395</c:v>
                </c:pt>
                <c:pt idx="1258">
                  <c:v>5.1005535125732422</c:v>
                </c:pt>
                <c:pt idx="1259">
                  <c:v>5.1109585762023926</c:v>
                </c:pt>
                <c:pt idx="1260">
                  <c:v>5.1213703155517578</c:v>
                </c:pt>
                <c:pt idx="1261">
                  <c:v>5.1317920684814453</c:v>
                </c:pt>
                <c:pt idx="1262">
                  <c:v>5.1422219276428223</c:v>
                </c:pt>
                <c:pt idx="1263">
                  <c:v>5.1526594161987305</c:v>
                </c:pt>
                <c:pt idx="1264">
                  <c:v>5.1631040573120117</c:v>
                </c:pt>
                <c:pt idx="1265">
                  <c:v>5.173558235168457</c:v>
                </c:pt>
                <c:pt idx="1266">
                  <c:v>5.1840214729309082</c:v>
                </c:pt>
                <c:pt idx="1267">
                  <c:v>5.1944923400878906</c:v>
                </c:pt>
                <c:pt idx="1268">
                  <c:v>5.2049698829650879</c:v>
                </c:pt>
                <c:pt idx="1269">
                  <c:v>5.2154574394226074</c:v>
                </c:pt>
                <c:pt idx="1270">
                  <c:v>5.2259531021118164</c:v>
                </c:pt>
                <c:pt idx="1271">
                  <c:v>5.2364559173583984</c:v>
                </c:pt>
                <c:pt idx="1272">
                  <c:v>5.2469658851623535</c:v>
                </c:pt>
                <c:pt idx="1273">
                  <c:v>5.2574844360351563</c:v>
                </c:pt>
                <c:pt idx="1274">
                  <c:v>5.2680110931396484</c:v>
                </c:pt>
                <c:pt idx="1275">
                  <c:v>5.2785463333129883</c:v>
                </c:pt>
                <c:pt idx="1276">
                  <c:v>5.2890896797180176</c:v>
                </c:pt>
                <c:pt idx="1277">
                  <c:v>5.2996401786804199</c:v>
                </c:pt>
                <c:pt idx="1278">
                  <c:v>5.3101983070373535</c:v>
                </c:pt>
                <c:pt idx="1279">
                  <c:v>5.3207640647888184</c:v>
                </c:pt>
                <c:pt idx="1280">
                  <c:v>5.3313369750976563</c:v>
                </c:pt>
                <c:pt idx="1281">
                  <c:v>5.3419179916381836</c:v>
                </c:pt>
                <c:pt idx="1282">
                  <c:v>5.352506160736084</c:v>
                </c:pt>
                <c:pt idx="1283">
                  <c:v>5.3631014823913574</c:v>
                </c:pt>
                <c:pt idx="1284">
                  <c:v>5.3737044334411621</c:v>
                </c:pt>
                <c:pt idx="1285">
                  <c:v>5.3843154907226563</c:v>
                </c:pt>
                <c:pt idx="1286">
                  <c:v>5.394932746887207</c:v>
                </c:pt>
                <c:pt idx="1287">
                  <c:v>5.4055581092834473</c:v>
                </c:pt>
                <c:pt idx="1288">
                  <c:v>5.4161906242370605</c:v>
                </c:pt>
                <c:pt idx="1289">
                  <c:v>5.4268298149108887</c:v>
                </c:pt>
                <c:pt idx="1290">
                  <c:v>5.4374761581420898</c:v>
                </c:pt>
                <c:pt idx="1291">
                  <c:v>5.4481296539306641</c:v>
                </c:pt>
                <c:pt idx="1292">
                  <c:v>5.4587903022766113</c:v>
                </c:pt>
                <c:pt idx="1293">
                  <c:v>5.4694576263427734</c:v>
                </c:pt>
                <c:pt idx="1294">
                  <c:v>5.4801316261291504</c:v>
                </c:pt>
                <c:pt idx="1295">
                  <c:v>5.4908132553100586</c:v>
                </c:pt>
                <c:pt idx="1296">
                  <c:v>5.5015010833740234</c:v>
                </c:pt>
                <c:pt idx="1297">
                  <c:v>5.5121960639953613</c:v>
                </c:pt>
                <c:pt idx="1298">
                  <c:v>5.5228977203369141</c:v>
                </c:pt>
                <c:pt idx="1299">
                  <c:v>5.5336060523986816</c:v>
                </c:pt>
                <c:pt idx="1300">
                  <c:v>5.5443205833435059</c:v>
                </c:pt>
                <c:pt idx="1301">
                  <c:v>5.5550417900085449</c:v>
                </c:pt>
                <c:pt idx="1302">
                  <c:v>5.565770149230957</c:v>
                </c:pt>
                <c:pt idx="1303">
                  <c:v>5.5765047073364258</c:v>
                </c:pt>
                <c:pt idx="1304">
                  <c:v>5.5872459411621094</c:v>
                </c:pt>
                <c:pt idx="1305">
                  <c:v>5.5979933738708496</c:v>
                </c:pt>
                <c:pt idx="1306">
                  <c:v>5.6087470054626465</c:v>
                </c:pt>
                <c:pt idx="1307">
                  <c:v>5.6195073127746582</c:v>
                </c:pt>
                <c:pt idx="1308">
                  <c:v>5.6302742958068848</c:v>
                </c:pt>
                <c:pt idx="1309">
                  <c:v>5.6410470008850098</c:v>
                </c:pt>
                <c:pt idx="1310">
                  <c:v>5.6518263816833496</c:v>
                </c:pt>
                <c:pt idx="1311">
                  <c:v>5.6626114845275879</c:v>
                </c:pt>
                <c:pt idx="1312">
                  <c:v>5.673403263092041</c:v>
                </c:pt>
                <c:pt idx="1313">
                  <c:v>5.6842007637023926</c:v>
                </c:pt>
                <c:pt idx="1314">
                  <c:v>5.6950044631958008</c:v>
                </c:pt>
                <c:pt idx="1315">
                  <c:v>5.7058138847351074</c:v>
                </c:pt>
                <c:pt idx="1316">
                  <c:v>5.7166295051574707</c:v>
                </c:pt>
                <c:pt idx="1317">
                  <c:v>5.7274513244628906</c:v>
                </c:pt>
                <c:pt idx="1318">
                  <c:v>5.738278865814209</c:v>
                </c:pt>
                <c:pt idx="1319">
                  <c:v>5.7491121292114258</c:v>
                </c:pt>
                <c:pt idx="1320">
                  <c:v>5.7599515914916992</c:v>
                </c:pt>
                <c:pt idx="1321">
                  <c:v>5.7707967758178711</c:v>
                </c:pt>
                <c:pt idx="1322">
                  <c:v>5.7816472053527832</c:v>
                </c:pt>
                <c:pt idx="1323">
                  <c:v>5.792503833770752</c:v>
                </c:pt>
                <c:pt idx="1324">
                  <c:v>5.8033661842346191</c:v>
                </c:pt>
                <c:pt idx="1325">
                  <c:v>5.8142337799072266</c:v>
                </c:pt>
                <c:pt idx="1326">
                  <c:v>5.8251070976257324</c:v>
                </c:pt>
                <c:pt idx="1327">
                  <c:v>5.8359861373901367</c:v>
                </c:pt>
                <c:pt idx="1328">
                  <c:v>5.8468704223632813</c:v>
                </c:pt>
                <c:pt idx="1329">
                  <c:v>5.857759952545166</c:v>
                </c:pt>
                <c:pt idx="1330">
                  <c:v>5.8686552047729492</c:v>
                </c:pt>
                <c:pt idx="1331">
                  <c:v>5.8795566558837891</c:v>
                </c:pt>
                <c:pt idx="1332">
                  <c:v>5.8904628753662109</c:v>
                </c:pt>
                <c:pt idx="1333">
                  <c:v>5.9013738632202148</c:v>
                </c:pt>
                <c:pt idx="1334">
                  <c:v>5.9122905731201172</c:v>
                </c:pt>
                <c:pt idx="1335">
                  <c:v>5.9232120513916016</c:v>
                </c:pt>
                <c:pt idx="1336">
                  <c:v>5.9341392517089844</c:v>
                </c:pt>
                <c:pt idx="1337">
                  <c:v>5.9450712203979492</c:v>
                </c:pt>
                <c:pt idx="1338">
                  <c:v>5.9560079574584961</c:v>
                </c:pt>
                <c:pt idx="1339">
                  <c:v>5.9669504165649414</c:v>
                </c:pt>
                <c:pt idx="1340">
                  <c:v>5.9778976440429688</c:v>
                </c:pt>
                <c:pt idx="1341">
                  <c:v>5.9888501167297363</c:v>
                </c:pt>
                <c:pt idx="1342">
                  <c:v>5.9998073577880859</c:v>
                </c:pt>
                <c:pt idx="1343">
                  <c:v>6.0107693672180176</c:v>
                </c:pt>
                <c:pt idx="1344">
                  <c:v>6.0217361450195313</c:v>
                </c:pt>
                <c:pt idx="1345">
                  <c:v>6.0327081680297852</c:v>
                </c:pt>
                <c:pt idx="1346">
                  <c:v>6.0436844825744629</c:v>
                </c:pt>
                <c:pt idx="1347">
                  <c:v>6.0546655654907227</c:v>
                </c:pt>
                <c:pt idx="1348">
                  <c:v>6.0656514167785645</c:v>
                </c:pt>
                <c:pt idx="1349">
                  <c:v>6.0766420364379883</c:v>
                </c:pt>
                <c:pt idx="1350">
                  <c:v>6.0876369476318359</c:v>
                </c:pt>
                <c:pt idx="1351">
                  <c:v>6.0986366271972656</c:v>
                </c:pt>
                <c:pt idx="1352">
                  <c:v>6.1096420288085938</c:v>
                </c:pt>
                <c:pt idx="1353">
                  <c:v>6.1206507682800293</c:v>
                </c:pt>
                <c:pt idx="1354">
                  <c:v>6.1316637992858887</c:v>
                </c:pt>
                <c:pt idx="1355">
                  <c:v>6.1426820755004883</c:v>
                </c:pt>
                <c:pt idx="1356">
                  <c:v>6.1537055969238281</c:v>
                </c:pt>
                <c:pt idx="1357">
                  <c:v>6.1647319793701172</c:v>
                </c:pt>
                <c:pt idx="1358">
                  <c:v>6.1757626533508301</c:v>
                </c:pt>
                <c:pt idx="1359">
                  <c:v>6.186798095703125</c:v>
                </c:pt>
                <c:pt idx="1360">
                  <c:v>6.197838306427002</c:v>
                </c:pt>
                <c:pt idx="1361">
                  <c:v>6.2088818550109863</c:v>
                </c:pt>
                <c:pt idx="1362">
                  <c:v>6.2199301719665527</c:v>
                </c:pt>
                <c:pt idx="1363">
                  <c:v>6.230982780456543</c:v>
                </c:pt>
                <c:pt idx="1364">
                  <c:v>6.2420401573181152</c:v>
                </c:pt>
                <c:pt idx="1365">
                  <c:v>6.2531003952026367</c:v>
                </c:pt>
                <c:pt idx="1366">
                  <c:v>6.2641644477844238</c:v>
                </c:pt>
                <c:pt idx="1367">
                  <c:v>6.2752337455749512</c:v>
                </c:pt>
                <c:pt idx="1368">
                  <c:v>6.2863073348999023</c:v>
                </c:pt>
                <c:pt idx="1369">
                  <c:v>6.2973842620849609</c:v>
                </c:pt>
                <c:pt idx="1370">
                  <c:v>6.3084650039672852</c:v>
                </c:pt>
                <c:pt idx="1371">
                  <c:v>6.3195500373840332</c:v>
                </c:pt>
                <c:pt idx="1372">
                  <c:v>6.3306398391723633</c:v>
                </c:pt>
                <c:pt idx="1373">
                  <c:v>6.3417325019836426</c:v>
                </c:pt>
                <c:pt idx="1374">
                  <c:v>6.3528308868408203</c:v>
                </c:pt>
                <c:pt idx="1375">
                  <c:v>6.3639302253723145</c:v>
                </c:pt>
                <c:pt idx="1376">
                  <c:v>6.375035285949707</c:v>
                </c:pt>
                <c:pt idx="1377">
                  <c:v>6.3861446380615234</c:v>
                </c:pt>
                <c:pt idx="1378">
                  <c:v>6.3972573280334473</c:v>
                </c:pt>
                <c:pt idx="1379">
                  <c:v>6.4083714485168457</c:v>
                </c:pt>
                <c:pt idx="1380">
                  <c:v>6.4194912910461426</c:v>
                </c:pt>
                <c:pt idx="1381">
                  <c:v>6.4306139945983887</c:v>
                </c:pt>
                <c:pt idx="1382">
                  <c:v>6.4417409896850586</c:v>
                </c:pt>
                <c:pt idx="1383">
                  <c:v>6.4528703689575195</c:v>
                </c:pt>
                <c:pt idx="1384">
                  <c:v>6.4640040397644043</c:v>
                </c:pt>
                <c:pt idx="1385">
                  <c:v>6.4751415252685547</c:v>
                </c:pt>
                <c:pt idx="1386">
                  <c:v>6.4862813949584961</c:v>
                </c:pt>
                <c:pt idx="1387">
                  <c:v>6.4974241256713867</c:v>
                </c:pt>
                <c:pt idx="1388">
                  <c:v>6.5085721015930176</c:v>
                </c:pt>
                <c:pt idx="1389">
                  <c:v>6.5197229385375977</c:v>
                </c:pt>
                <c:pt idx="1390">
                  <c:v>6.5308771133422852</c:v>
                </c:pt>
                <c:pt idx="1391">
                  <c:v>6.5420327186584473</c:v>
                </c:pt>
                <c:pt idx="1392">
                  <c:v>6.5531930923461914</c:v>
                </c:pt>
                <c:pt idx="1393">
                  <c:v>6.5643572807312012</c:v>
                </c:pt>
                <c:pt idx="1394">
                  <c:v>6.575523853302002</c:v>
                </c:pt>
                <c:pt idx="1395">
                  <c:v>6.5866942405700684</c:v>
                </c:pt>
                <c:pt idx="1396">
                  <c:v>6.5978670120239258</c:v>
                </c:pt>
                <c:pt idx="1397">
                  <c:v>6.6090431213378906</c:v>
                </c:pt>
                <c:pt idx="1398">
                  <c:v>6.6202220916748047</c:v>
                </c:pt>
                <c:pt idx="1399">
                  <c:v>6.6314029693603516</c:v>
                </c:pt>
                <c:pt idx="1400">
                  <c:v>6.6425890922546387</c:v>
                </c:pt>
                <c:pt idx="1401">
                  <c:v>6.6537775993347168</c:v>
                </c:pt>
                <c:pt idx="1402">
                  <c:v>6.6649675369262695</c:v>
                </c:pt>
                <c:pt idx="1403">
                  <c:v>6.6761603355407715</c:v>
                </c:pt>
                <c:pt idx="1404">
                  <c:v>6.6873559951782227</c:v>
                </c:pt>
                <c:pt idx="1405">
                  <c:v>6.6985549926757813</c:v>
                </c:pt>
                <c:pt idx="1406">
                  <c:v>6.7097568511962891</c:v>
                </c:pt>
                <c:pt idx="1407">
                  <c:v>6.7209615707397461</c:v>
                </c:pt>
                <c:pt idx="1408">
                  <c:v>6.7321681976318359</c:v>
                </c:pt>
                <c:pt idx="1409">
                  <c:v>6.743377685546875</c:v>
                </c:pt>
                <c:pt idx="1410">
                  <c:v>6.7545890808105469</c:v>
                </c:pt>
                <c:pt idx="1411">
                  <c:v>6.765803337097168</c:v>
                </c:pt>
                <c:pt idx="1412">
                  <c:v>6.7770209312438965</c:v>
                </c:pt>
                <c:pt idx="1413">
                  <c:v>6.7882413864135742</c:v>
                </c:pt>
                <c:pt idx="1414">
                  <c:v>6.799461841583252</c:v>
                </c:pt>
                <c:pt idx="1415">
                  <c:v>6.8106870651245117</c:v>
                </c:pt>
                <c:pt idx="1416">
                  <c:v>6.8219146728515625</c:v>
                </c:pt>
                <c:pt idx="1417">
                  <c:v>6.8331437110900879</c:v>
                </c:pt>
                <c:pt idx="1418">
                  <c:v>6.8443732261657715</c:v>
                </c:pt>
                <c:pt idx="1419">
                  <c:v>6.8556070327758789</c:v>
                </c:pt>
                <c:pt idx="1420">
                  <c:v>6.8668413162231445</c:v>
                </c:pt>
                <c:pt idx="1421">
                  <c:v>6.8780794143676758</c:v>
                </c:pt>
                <c:pt idx="1422">
                  <c:v>6.8893184661865234</c:v>
                </c:pt>
                <c:pt idx="1423">
                  <c:v>6.9005622863769531</c:v>
                </c:pt>
                <c:pt idx="1424">
                  <c:v>6.9118046760559082</c:v>
                </c:pt>
                <c:pt idx="1425">
                  <c:v>6.9230532646179199</c:v>
                </c:pt>
                <c:pt idx="1426">
                  <c:v>6.9343037605285645</c:v>
                </c:pt>
                <c:pt idx="1427">
                  <c:v>6.9455547332763672</c:v>
                </c:pt>
                <c:pt idx="1428">
                  <c:v>6.9568061828613281</c:v>
                </c:pt>
                <c:pt idx="1429">
                  <c:v>6.9680619239807129</c:v>
                </c:pt>
                <c:pt idx="1430">
                  <c:v>6.9793171882629395</c:v>
                </c:pt>
                <c:pt idx="1431">
                  <c:v>6.9905757904052734</c:v>
                </c:pt>
                <c:pt idx="1432">
                  <c:v>7.0018362998962402</c:v>
                </c:pt>
                <c:pt idx="1433">
                  <c:v>7.013099193572998</c:v>
                </c:pt>
                <c:pt idx="1434">
                  <c:v>7.0243620872497559</c:v>
                </c:pt>
                <c:pt idx="1435">
                  <c:v>7.0356278419494629</c:v>
                </c:pt>
                <c:pt idx="1436">
                  <c:v>7.0468955039978027</c:v>
                </c:pt>
                <c:pt idx="1437">
                  <c:v>7.05816650390625</c:v>
                </c:pt>
                <c:pt idx="1438">
                  <c:v>7.0694370269775391</c:v>
                </c:pt>
                <c:pt idx="1439">
                  <c:v>7.080711841583252</c:v>
                </c:pt>
                <c:pt idx="1440">
                  <c:v>7.0919876098632813</c:v>
                </c:pt>
                <c:pt idx="1441">
                  <c:v>7.1032657623291016</c:v>
                </c:pt>
                <c:pt idx="1442">
                  <c:v>7.1145453453063965</c:v>
                </c:pt>
                <c:pt idx="1443">
                  <c:v>7.125826358795166</c:v>
                </c:pt>
                <c:pt idx="1444">
                  <c:v>7.1371068954467773</c:v>
                </c:pt>
                <c:pt idx="1445">
                  <c:v>7.1483931541442871</c:v>
                </c:pt>
                <c:pt idx="1446">
                  <c:v>7.1596808433532715</c:v>
                </c:pt>
                <c:pt idx="1447">
                  <c:v>7.1709713935852051</c:v>
                </c:pt>
                <c:pt idx="1448">
                  <c:v>7.1822614669799805</c:v>
                </c:pt>
                <c:pt idx="1449">
                  <c:v>7.1935524940490723</c:v>
                </c:pt>
                <c:pt idx="1450">
                  <c:v>7.2048473358154297</c:v>
                </c:pt>
                <c:pt idx="1451">
                  <c:v>7.2161445617675781</c:v>
                </c:pt>
                <c:pt idx="1452">
                  <c:v>7.227442741394043</c:v>
                </c:pt>
                <c:pt idx="1453">
                  <c:v>7.2387433052062988</c:v>
                </c:pt>
                <c:pt idx="1454">
                  <c:v>7.2500452995300293</c:v>
                </c:pt>
                <c:pt idx="1455">
                  <c:v>7.2613496780395508</c:v>
                </c:pt>
                <c:pt idx="1456">
                  <c:v>7.2726540565490723</c:v>
                </c:pt>
                <c:pt idx="1457">
                  <c:v>7.283961296081543</c:v>
                </c:pt>
                <c:pt idx="1458">
                  <c:v>7.2952718734741211</c:v>
                </c:pt>
                <c:pt idx="1459">
                  <c:v>7.3065848350524902</c:v>
                </c:pt>
                <c:pt idx="1460">
                  <c:v>7.3178963661193848</c:v>
                </c:pt>
                <c:pt idx="1461">
                  <c:v>7.3292102813720703</c:v>
                </c:pt>
                <c:pt idx="1462">
                  <c:v>7.3405265808105469</c:v>
                </c:pt>
                <c:pt idx="1463">
                  <c:v>7.3518452644348145</c:v>
                </c:pt>
                <c:pt idx="1464">
                  <c:v>7.3631649017333984</c:v>
                </c:pt>
                <c:pt idx="1465">
                  <c:v>7.3744864463806152</c:v>
                </c:pt>
                <c:pt idx="1466">
                  <c:v>7.3858132362365723</c:v>
                </c:pt>
                <c:pt idx="1467">
                  <c:v>7.3971424102783203</c:v>
                </c:pt>
                <c:pt idx="1468">
                  <c:v>7.408473014831543</c:v>
                </c:pt>
                <c:pt idx="1469">
                  <c:v>7.419804573059082</c:v>
                </c:pt>
                <c:pt idx="1470">
                  <c:v>7.4311389923095703</c:v>
                </c:pt>
                <c:pt idx="1471">
                  <c:v>7.442474365234375</c:v>
                </c:pt>
                <c:pt idx="1472">
                  <c:v>7.4538111686706543</c:v>
                </c:pt>
                <c:pt idx="1473">
                  <c:v>7.4651522636413574</c:v>
                </c:pt>
                <c:pt idx="1474">
                  <c:v>7.4764938354492188</c:v>
                </c:pt>
                <c:pt idx="1475">
                  <c:v>7.4878396987915039</c:v>
                </c:pt>
                <c:pt idx="1476">
                  <c:v>7.4991903305053711</c:v>
                </c:pt>
                <c:pt idx="1477">
                  <c:v>7.5105376243591309</c:v>
                </c:pt>
                <c:pt idx="1478">
                  <c:v>7.5218892097473145</c:v>
                </c:pt>
                <c:pt idx="1479">
                  <c:v>7.5332436561584473</c:v>
                </c:pt>
                <c:pt idx="1480">
                  <c:v>7.5446004867553711</c:v>
                </c:pt>
                <c:pt idx="1481">
                  <c:v>7.5559592247009277</c:v>
                </c:pt>
                <c:pt idx="1482">
                  <c:v>7.5673184394836426</c:v>
                </c:pt>
                <c:pt idx="1483">
                  <c:v>7.5786786079406738</c:v>
                </c:pt>
                <c:pt idx="1484">
                  <c:v>7.5900454521179199</c:v>
                </c:pt>
                <c:pt idx="1485">
                  <c:v>7.6014108657836914</c:v>
                </c:pt>
                <c:pt idx="1486">
                  <c:v>7.6127810478210449</c:v>
                </c:pt>
                <c:pt idx="1487">
                  <c:v>7.6241517066955566</c:v>
                </c:pt>
                <c:pt idx="1488">
                  <c:v>7.635526180267334</c:v>
                </c:pt>
                <c:pt idx="1489">
                  <c:v>7.6468992233276367</c:v>
                </c:pt>
                <c:pt idx="1490">
                  <c:v>7.6582779884338379</c:v>
                </c:pt>
                <c:pt idx="1491">
                  <c:v>7.6696572303771973</c:v>
                </c:pt>
                <c:pt idx="1492">
                  <c:v>7.6810398101806641</c:v>
                </c:pt>
                <c:pt idx="1493">
                  <c:v>7.6924233436584473</c:v>
                </c:pt>
                <c:pt idx="1494">
                  <c:v>7.7038092613220215</c:v>
                </c:pt>
                <c:pt idx="1495">
                  <c:v>7.7151970863342285</c:v>
                </c:pt>
                <c:pt idx="1496">
                  <c:v>7.7265892028808594</c:v>
                </c:pt>
                <c:pt idx="1497">
                  <c:v>7.7379822731018066</c:v>
                </c:pt>
                <c:pt idx="1498">
                  <c:v>7.7493782043457031</c:v>
                </c:pt>
                <c:pt idx="1499">
                  <c:v>7.760775089263916</c:v>
                </c:pt>
                <c:pt idx="1500">
                  <c:v>7.7721738815307617</c:v>
                </c:pt>
                <c:pt idx="1501">
                  <c:v>7.783574104309082</c:v>
                </c:pt>
                <c:pt idx="1502">
                  <c:v>7.794978141784668</c:v>
                </c:pt>
                <c:pt idx="1503">
                  <c:v>7.8063836097717285</c:v>
                </c:pt>
                <c:pt idx="1504">
                  <c:v>7.8177905082702637</c:v>
                </c:pt>
                <c:pt idx="1505">
                  <c:v>7.8292012214660645</c:v>
                </c:pt>
                <c:pt idx="1506">
                  <c:v>7.8406128883361816</c:v>
                </c:pt>
                <c:pt idx="1507">
                  <c:v>7.8520240783691406</c:v>
                </c:pt>
                <c:pt idx="1508">
                  <c:v>7.8634381294250488</c:v>
                </c:pt>
                <c:pt idx="1509">
                  <c:v>7.8748550415039063</c:v>
                </c:pt>
                <c:pt idx="1510">
                  <c:v>7.8862733840942383</c:v>
                </c:pt>
                <c:pt idx="1511">
                  <c:v>7.8976950645446777</c:v>
                </c:pt>
                <c:pt idx="1512">
                  <c:v>7.9091196060180664</c:v>
                </c:pt>
                <c:pt idx="1513">
                  <c:v>7.9205431938171387</c:v>
                </c:pt>
                <c:pt idx="1514">
                  <c:v>7.9319701194763184</c:v>
                </c:pt>
                <c:pt idx="1515">
                  <c:v>7.9433984756469727</c:v>
                </c:pt>
                <c:pt idx="1516">
                  <c:v>7.9548306465148926</c:v>
                </c:pt>
                <c:pt idx="1517">
                  <c:v>7.9662613868713379</c:v>
                </c:pt>
                <c:pt idx="1518">
                  <c:v>7.977696418762207</c:v>
                </c:pt>
                <c:pt idx="1519">
                  <c:v>7.9891343116760254</c:v>
                </c:pt>
                <c:pt idx="1520">
                  <c:v>8.000575065612793</c:v>
                </c:pt>
                <c:pt idx="1521">
                  <c:v>8.0120172500610352</c:v>
                </c:pt>
                <c:pt idx="1522">
                  <c:v>8.023463249206543</c:v>
                </c:pt>
                <c:pt idx="1523">
                  <c:v>8.0349102020263672</c:v>
                </c:pt>
                <c:pt idx="1524">
                  <c:v>8.0463600158691406</c:v>
                </c:pt>
                <c:pt idx="1525">
                  <c:v>8.0578107833862305</c:v>
                </c:pt>
                <c:pt idx="1526">
                  <c:v>8.0692644119262695</c:v>
                </c:pt>
                <c:pt idx="1527">
                  <c:v>8.0807209014892578</c:v>
                </c:pt>
                <c:pt idx="1528">
                  <c:v>8.0921792984008789</c:v>
                </c:pt>
                <c:pt idx="1529">
                  <c:v>8.1036405563354492</c:v>
                </c:pt>
                <c:pt idx="1530">
                  <c:v>8.1151027679443359</c:v>
                </c:pt>
                <c:pt idx="1531">
                  <c:v>8.1265678405761719</c:v>
                </c:pt>
                <c:pt idx="1532">
                  <c:v>8.1380348205566406</c:v>
                </c:pt>
                <c:pt idx="1533">
                  <c:v>8.1495037078857422</c:v>
                </c:pt>
                <c:pt idx="1534">
                  <c:v>8.160975456237793</c:v>
                </c:pt>
                <c:pt idx="1535">
                  <c:v>8.1724481582641602</c:v>
                </c:pt>
                <c:pt idx="1536">
                  <c:v>8.1839237213134766</c:v>
                </c:pt>
                <c:pt idx="1537">
                  <c:v>8.1954011917114258</c:v>
                </c:pt>
                <c:pt idx="1538">
                  <c:v>8.2068805694580078</c:v>
                </c:pt>
                <c:pt idx="1539">
                  <c:v>8.2183628082275391</c:v>
                </c:pt>
                <c:pt idx="1540">
                  <c:v>8.2298469543457031</c:v>
                </c:pt>
                <c:pt idx="1541">
                  <c:v>8.2413330078125</c:v>
                </c:pt>
                <c:pt idx="1542">
                  <c:v>8.2528200149536133</c:v>
                </c:pt>
                <c:pt idx="1543">
                  <c:v>8.2643108367919922</c:v>
                </c:pt>
                <c:pt idx="1544">
                  <c:v>8.2758035659790039</c:v>
                </c:pt>
                <c:pt idx="1545">
                  <c:v>8.2872982025146484</c:v>
                </c:pt>
                <c:pt idx="1546">
                  <c:v>8.2987937927246094</c:v>
                </c:pt>
                <c:pt idx="1547">
                  <c:v>8.3102922439575195</c:v>
                </c:pt>
                <c:pt idx="1548">
                  <c:v>8.3217935562133789</c:v>
                </c:pt>
                <c:pt idx="1549">
                  <c:v>8.3332958221435547</c:v>
                </c:pt>
                <c:pt idx="1550">
                  <c:v>8.3448009490966797</c:v>
                </c:pt>
                <c:pt idx="1551">
                  <c:v>8.3563079833984375</c:v>
                </c:pt>
                <c:pt idx="1552">
                  <c:v>8.3678159713745117</c:v>
                </c:pt>
                <c:pt idx="1553">
                  <c:v>8.3793277740478516</c:v>
                </c:pt>
                <c:pt idx="1554">
                  <c:v>8.3908395767211914</c:v>
                </c:pt>
                <c:pt idx="1555">
                  <c:v>8.4023551940917969</c:v>
                </c:pt>
                <c:pt idx="1556">
                  <c:v>8.4138727188110352</c:v>
                </c:pt>
                <c:pt idx="1557">
                  <c:v>8.4253931045532227</c:v>
                </c:pt>
                <c:pt idx="1558">
                  <c:v>8.4369144439697266</c:v>
                </c:pt>
                <c:pt idx="1559">
                  <c:v>8.4484376907348633</c:v>
                </c:pt>
                <c:pt idx="1560">
                  <c:v>8.4599637985229492</c:v>
                </c:pt>
                <c:pt idx="1561">
                  <c:v>8.471491813659668</c:v>
                </c:pt>
                <c:pt idx="1562">
                  <c:v>8.4830217361450195</c:v>
                </c:pt>
                <c:pt idx="1563">
                  <c:v>8.4945545196533203</c:v>
                </c:pt>
                <c:pt idx="1564">
                  <c:v>8.5060882568359375</c:v>
                </c:pt>
                <c:pt idx="1565">
                  <c:v>8.5176248550415039</c:v>
                </c:pt>
                <c:pt idx="1566">
                  <c:v>8.5291633605957031</c:v>
                </c:pt>
                <c:pt idx="1567">
                  <c:v>8.5407047271728516</c:v>
                </c:pt>
                <c:pt idx="1568">
                  <c:v>8.5522470474243164</c:v>
                </c:pt>
                <c:pt idx="1569">
                  <c:v>8.5637922286987305</c:v>
                </c:pt>
                <c:pt idx="1570">
                  <c:v>8.5753383636474609</c:v>
                </c:pt>
                <c:pt idx="1571">
                  <c:v>8.586888313293457</c:v>
                </c:pt>
                <c:pt idx="1572">
                  <c:v>8.5984401702880859</c:v>
                </c:pt>
                <c:pt idx="1573">
                  <c:v>8.6099939346313477</c:v>
                </c:pt>
                <c:pt idx="1574">
                  <c:v>8.6215486526489258</c:v>
                </c:pt>
                <c:pt idx="1575">
                  <c:v>8.6331071853637695</c:v>
                </c:pt>
                <c:pt idx="1576">
                  <c:v>8.6446676254272461</c:v>
                </c:pt>
                <c:pt idx="1577">
                  <c:v>8.6562299728393555</c:v>
                </c:pt>
                <c:pt idx="1578">
                  <c:v>8.6677942276000977</c:v>
                </c:pt>
                <c:pt idx="1579">
                  <c:v>8.6793613433837891</c:v>
                </c:pt>
                <c:pt idx="1580">
                  <c:v>8.6909303665161133</c:v>
                </c:pt>
                <c:pt idx="1581">
                  <c:v>8.7025012969970703</c:v>
                </c:pt>
                <c:pt idx="1582">
                  <c:v>8.7140750885009766</c:v>
                </c:pt>
                <c:pt idx="1583">
                  <c:v>8.7256507873535156</c:v>
                </c:pt>
                <c:pt idx="1584">
                  <c:v>8.7372283935546875</c:v>
                </c:pt>
                <c:pt idx="1585">
                  <c:v>8.7488088607788086</c:v>
                </c:pt>
                <c:pt idx="1586">
                  <c:v>8.7603912353515625</c:v>
                </c:pt>
                <c:pt idx="1587">
                  <c:v>8.7719755172729492</c:v>
                </c:pt>
                <c:pt idx="1588">
                  <c:v>8.7835617065429688</c:v>
                </c:pt>
                <c:pt idx="1589">
                  <c:v>8.7951507568359375</c:v>
                </c:pt>
                <c:pt idx="1590">
                  <c:v>8.8067417144775391</c:v>
                </c:pt>
                <c:pt idx="1591">
                  <c:v>8.8183355331420898</c:v>
                </c:pt>
                <c:pt idx="1592">
                  <c:v>8.8299312591552734</c:v>
                </c:pt>
                <c:pt idx="1593">
                  <c:v>8.8415288925170898</c:v>
                </c:pt>
                <c:pt idx="1594">
                  <c:v>8.8531284332275391</c:v>
                </c:pt>
                <c:pt idx="1595">
                  <c:v>8.8647308349609375</c:v>
                </c:pt>
                <c:pt idx="1596">
                  <c:v>8.8763360977172852</c:v>
                </c:pt>
                <c:pt idx="1597">
                  <c:v>8.8879423141479492</c:v>
                </c:pt>
                <c:pt idx="1598">
                  <c:v>8.8995513916015625</c:v>
                </c:pt>
                <c:pt idx="1599">
                  <c:v>8.9111623764038086</c:v>
                </c:pt>
                <c:pt idx="1600">
                  <c:v>8.9227762222290039</c:v>
                </c:pt>
                <c:pt idx="1601">
                  <c:v>8.934391975402832</c:v>
                </c:pt>
                <c:pt idx="1602">
                  <c:v>8.9460105895996094</c:v>
                </c:pt>
                <c:pt idx="1603">
                  <c:v>8.9576311111450195</c:v>
                </c:pt>
                <c:pt idx="1604">
                  <c:v>8.9692535400390625</c:v>
                </c:pt>
                <c:pt idx="1605">
                  <c:v>8.9808778762817383</c:v>
                </c:pt>
                <c:pt idx="1606">
                  <c:v>8.9925060272216797</c:v>
                </c:pt>
                <c:pt idx="1607">
                  <c:v>9.0041351318359375</c:v>
                </c:pt>
                <c:pt idx="1608">
                  <c:v>9.0157670974731445</c:v>
                </c:pt>
                <c:pt idx="1609">
                  <c:v>9.0274009704589844</c:v>
                </c:pt>
                <c:pt idx="1610">
                  <c:v>9.0390377044677734</c:v>
                </c:pt>
                <c:pt idx="1611">
                  <c:v>9.0506763458251953</c:v>
                </c:pt>
                <c:pt idx="1612">
                  <c:v>9.06231689453125</c:v>
                </c:pt>
                <c:pt idx="1613">
                  <c:v>9.0739603042602539</c:v>
                </c:pt>
                <c:pt idx="1614">
                  <c:v>9.085606575012207</c:v>
                </c:pt>
                <c:pt idx="1615">
                  <c:v>9.0972537994384766</c:v>
                </c:pt>
                <c:pt idx="1616">
                  <c:v>9.1089048385620117</c:v>
                </c:pt>
                <c:pt idx="1617">
                  <c:v>9.1205568313598633</c:v>
                </c:pt>
                <c:pt idx="1618">
                  <c:v>9.1322135925292969</c:v>
                </c:pt>
                <c:pt idx="1619">
                  <c:v>9.1438713073730469</c:v>
                </c:pt>
                <c:pt idx="1620">
                  <c:v>9.1555309295654297</c:v>
                </c:pt>
                <c:pt idx="1621">
                  <c:v>9.1671934127807617</c:v>
                </c:pt>
                <c:pt idx="1622">
                  <c:v>9.178858757019043</c:v>
                </c:pt>
                <c:pt idx="1623">
                  <c:v>9.190526008605957</c:v>
                </c:pt>
                <c:pt idx="1624">
                  <c:v>9.2021961212158203</c:v>
                </c:pt>
                <c:pt idx="1625">
                  <c:v>9.2138681411743164</c:v>
                </c:pt>
                <c:pt idx="1626">
                  <c:v>9.2255420684814453</c:v>
                </c:pt>
                <c:pt idx="1627">
                  <c:v>9.2372198104858398</c:v>
                </c:pt>
                <c:pt idx="1628">
                  <c:v>9.2489004135131836</c:v>
                </c:pt>
                <c:pt idx="1629">
                  <c:v>9.2605810165405273</c:v>
                </c:pt>
                <c:pt idx="1630">
                  <c:v>9.2722663879394531</c:v>
                </c:pt>
                <c:pt idx="1631">
                  <c:v>9.2839527130126953</c:v>
                </c:pt>
                <c:pt idx="1632">
                  <c:v>9.2956428527832031</c:v>
                </c:pt>
                <c:pt idx="1633">
                  <c:v>9.3073339462280273</c:v>
                </c:pt>
                <c:pt idx="1634">
                  <c:v>9.3190288543701172</c:v>
                </c:pt>
                <c:pt idx="1635">
                  <c:v>9.3307247161865234</c:v>
                </c:pt>
                <c:pt idx="1636">
                  <c:v>9.3424253463745117</c:v>
                </c:pt>
                <c:pt idx="1637">
                  <c:v>9.3541278839111328</c:v>
                </c:pt>
                <c:pt idx="1638">
                  <c:v>9.3658323287963867</c:v>
                </c:pt>
                <c:pt idx="1639">
                  <c:v>9.3775396347045898</c:v>
                </c:pt>
                <c:pt idx="1640">
                  <c:v>9.3892498016357422</c:v>
                </c:pt>
                <c:pt idx="1641">
                  <c:v>9.4009618759155273</c:v>
                </c:pt>
                <c:pt idx="1642">
                  <c:v>9.4126749038696289</c:v>
                </c:pt>
                <c:pt idx="1643">
                  <c:v>9.4243917465209961</c:v>
                </c:pt>
                <c:pt idx="1644">
                  <c:v>9.4361124038696289</c:v>
                </c:pt>
                <c:pt idx="1645">
                  <c:v>9.4478330612182617</c:v>
                </c:pt>
                <c:pt idx="1646">
                  <c:v>9.4595575332641602</c:v>
                </c:pt>
                <c:pt idx="1647">
                  <c:v>9.4712867736816406</c:v>
                </c:pt>
                <c:pt idx="1648">
                  <c:v>9.4830169677734375</c:v>
                </c:pt>
                <c:pt idx="1649">
                  <c:v>9.4947481155395508</c:v>
                </c:pt>
                <c:pt idx="1650">
                  <c:v>9.5064821243286133</c:v>
                </c:pt>
                <c:pt idx="1651">
                  <c:v>9.5182180404663086</c:v>
                </c:pt>
                <c:pt idx="1652">
                  <c:v>9.5299587249755859</c:v>
                </c:pt>
                <c:pt idx="1653">
                  <c:v>9.5417013168334961</c:v>
                </c:pt>
                <c:pt idx="1654">
                  <c:v>9.5534458160400391</c:v>
                </c:pt>
                <c:pt idx="1655">
                  <c:v>9.5651931762695313</c:v>
                </c:pt>
                <c:pt idx="1656">
                  <c:v>9.5769433975219727</c:v>
                </c:pt>
                <c:pt idx="1657">
                  <c:v>9.5886964797973633</c:v>
                </c:pt>
                <c:pt idx="1658">
                  <c:v>9.6004533767700195</c:v>
                </c:pt>
                <c:pt idx="1659">
                  <c:v>9.6122112274169922</c:v>
                </c:pt>
                <c:pt idx="1660">
                  <c:v>9.6239719390869141</c:v>
                </c:pt>
                <c:pt idx="1661">
                  <c:v>9.6357355117797852</c:v>
                </c:pt>
                <c:pt idx="1662">
                  <c:v>9.6475009918212891</c:v>
                </c:pt>
                <c:pt idx="1663">
                  <c:v>9.6592693328857422</c:v>
                </c:pt>
                <c:pt idx="1664">
                  <c:v>9.6710414886474609</c:v>
                </c:pt>
                <c:pt idx="1665">
                  <c:v>9.6828155517578125</c:v>
                </c:pt>
                <c:pt idx="1666">
                  <c:v>9.6945915222167969</c:v>
                </c:pt>
                <c:pt idx="1667">
                  <c:v>9.7063722610473633</c:v>
                </c:pt>
                <c:pt idx="1668">
                  <c:v>9.7181549072265625</c:v>
                </c:pt>
                <c:pt idx="1669">
                  <c:v>9.7299385070800781</c:v>
                </c:pt>
                <c:pt idx="1670">
                  <c:v>9.7417268753051758</c:v>
                </c:pt>
                <c:pt idx="1671">
                  <c:v>9.7535181045532227</c:v>
                </c:pt>
                <c:pt idx="1672">
                  <c:v>9.7653121948242188</c:v>
                </c:pt>
                <c:pt idx="1673">
                  <c:v>9.7771081924438477</c:v>
                </c:pt>
                <c:pt idx="1674">
                  <c:v>9.7889070510864258</c:v>
                </c:pt>
                <c:pt idx="1675">
                  <c:v>9.8007106781005859</c:v>
                </c:pt>
                <c:pt idx="1676">
                  <c:v>9.8125152587890625</c:v>
                </c:pt>
                <c:pt idx="1677">
                  <c:v>9.8243236541748047</c:v>
                </c:pt>
                <c:pt idx="1678">
                  <c:v>9.8361358642578125</c:v>
                </c:pt>
                <c:pt idx="1679">
                  <c:v>9.8479499816894531</c:v>
                </c:pt>
                <c:pt idx="1680">
                  <c:v>9.8597650527954102</c:v>
                </c:pt>
                <c:pt idx="1681">
                  <c:v>9.8715848922729492</c:v>
                </c:pt>
                <c:pt idx="1682">
                  <c:v>9.8834066390991211</c:v>
                </c:pt>
                <c:pt idx="1683">
                  <c:v>9.8952322006225586</c:v>
                </c:pt>
                <c:pt idx="1684">
                  <c:v>9.9070596694946289</c:v>
                </c:pt>
                <c:pt idx="1685">
                  <c:v>9.9188909530639648</c:v>
                </c:pt>
                <c:pt idx="1686">
                  <c:v>9.9307241439819336</c:v>
                </c:pt>
                <c:pt idx="1687">
                  <c:v>9.9425592422485352</c:v>
                </c:pt>
                <c:pt idx="1688">
                  <c:v>9.9543991088867188</c:v>
                </c:pt>
                <c:pt idx="1689">
                  <c:v>9.9662418365478516</c:v>
                </c:pt>
                <c:pt idx="1690">
                  <c:v>9.9780874252319336</c:v>
                </c:pt>
                <c:pt idx="1691">
                  <c:v>9.9899349212646484</c:v>
                </c:pt>
                <c:pt idx="1692">
                  <c:v>10.001785278320313</c:v>
                </c:pt>
                <c:pt idx="1693">
                  <c:v>10.013640403747559</c:v>
                </c:pt>
                <c:pt idx="1694">
                  <c:v>10.025495529174805</c:v>
                </c:pt>
                <c:pt idx="1695">
                  <c:v>10.037356376647949</c:v>
                </c:pt>
                <c:pt idx="1696">
                  <c:v>10.04921817779541</c:v>
                </c:pt>
                <c:pt idx="1697">
                  <c:v>10.061083793640137</c:v>
                </c:pt>
                <c:pt idx="1698">
                  <c:v>10.072951316833496</c:v>
                </c:pt>
                <c:pt idx="1699">
                  <c:v>10.084821701049805</c:v>
                </c:pt>
                <c:pt idx="1700">
                  <c:v>10.096693992614746</c:v>
                </c:pt>
                <c:pt idx="1701">
                  <c:v>10.108572006225586</c:v>
                </c:pt>
                <c:pt idx="1702">
                  <c:v>10.120450019836426</c:v>
                </c:pt>
                <c:pt idx="1703">
                  <c:v>10.132331848144531</c:v>
                </c:pt>
                <c:pt idx="1704">
                  <c:v>10.144218444824219</c:v>
                </c:pt>
                <c:pt idx="1705">
                  <c:v>10.156105995178223</c:v>
                </c:pt>
                <c:pt idx="1706">
                  <c:v>10.167996406555176</c:v>
                </c:pt>
                <c:pt idx="1707">
                  <c:v>10.179889678955078</c:v>
                </c:pt>
                <c:pt idx="1708">
                  <c:v>10.191784858703613</c:v>
                </c:pt>
                <c:pt idx="1709">
                  <c:v>10.203683853149414</c:v>
                </c:pt>
                <c:pt idx="1710">
                  <c:v>10.215583801269531</c:v>
                </c:pt>
                <c:pt idx="1711">
                  <c:v>10.227487564086914</c:v>
                </c:pt>
                <c:pt idx="1712">
                  <c:v>10.23939323425293</c:v>
                </c:pt>
                <c:pt idx="1713">
                  <c:v>10.251304626464844</c:v>
                </c:pt>
                <c:pt idx="1714">
                  <c:v>10.263216018676758</c:v>
                </c:pt>
                <c:pt idx="1715">
                  <c:v>10.275129318237305</c:v>
                </c:pt>
                <c:pt idx="1716">
                  <c:v>10.28704833984375</c:v>
                </c:pt>
                <c:pt idx="1717">
                  <c:v>10.298967361450195</c:v>
                </c:pt>
                <c:pt idx="1718">
                  <c:v>10.31088924407959</c:v>
                </c:pt>
                <c:pt idx="1719">
                  <c:v>10.32281494140625</c:v>
                </c:pt>
                <c:pt idx="1720">
                  <c:v>10.334743499755859</c:v>
                </c:pt>
                <c:pt idx="1721">
                  <c:v>10.346673965454102</c:v>
                </c:pt>
                <c:pt idx="1722">
                  <c:v>10.358607292175293</c:v>
                </c:pt>
                <c:pt idx="1723">
                  <c:v>10.370543479919434</c:v>
                </c:pt>
                <c:pt idx="1724">
                  <c:v>10.382481575012207</c:v>
                </c:pt>
                <c:pt idx="1725">
                  <c:v>10.394423484802246</c:v>
                </c:pt>
                <c:pt idx="1726">
                  <c:v>10.406368255615234</c:v>
                </c:pt>
                <c:pt idx="1727">
                  <c:v>10.418315887451172</c:v>
                </c:pt>
                <c:pt idx="1728">
                  <c:v>10.430264472961426</c:v>
                </c:pt>
                <c:pt idx="1729">
                  <c:v>10.442216873168945</c:v>
                </c:pt>
                <c:pt idx="1730">
                  <c:v>10.454171180725098</c:v>
                </c:pt>
                <c:pt idx="1731">
                  <c:v>10.466130256652832</c:v>
                </c:pt>
                <c:pt idx="1732">
                  <c:v>10.478090286254883</c:v>
                </c:pt>
                <c:pt idx="1733">
                  <c:v>10.490053176879883</c:v>
                </c:pt>
                <c:pt idx="1734">
                  <c:v>10.502017974853516</c:v>
                </c:pt>
                <c:pt idx="1735">
                  <c:v>10.51398754119873</c:v>
                </c:pt>
                <c:pt idx="1736">
                  <c:v>10.525958061218262</c:v>
                </c:pt>
                <c:pt idx="1737">
                  <c:v>10.537932395935059</c:v>
                </c:pt>
                <c:pt idx="1738">
                  <c:v>10.549910545349121</c:v>
                </c:pt>
                <c:pt idx="1739">
                  <c:v>10.5618896484375</c:v>
                </c:pt>
                <c:pt idx="1740">
                  <c:v>10.573871612548828</c:v>
                </c:pt>
                <c:pt idx="1741">
                  <c:v>10.585855484008789</c:v>
                </c:pt>
                <c:pt idx="1742">
                  <c:v>10.597842216491699</c:v>
                </c:pt>
                <c:pt idx="1743">
                  <c:v>10.609830856323242</c:v>
                </c:pt>
                <c:pt idx="1744">
                  <c:v>10.621822357177734</c:v>
                </c:pt>
                <c:pt idx="1745">
                  <c:v>10.633819580078125</c:v>
                </c:pt>
                <c:pt idx="1746">
                  <c:v>10.645816802978516</c:v>
                </c:pt>
                <c:pt idx="1747">
                  <c:v>10.657814979553223</c:v>
                </c:pt>
                <c:pt idx="1748">
                  <c:v>10.669817924499512</c:v>
                </c:pt>
                <c:pt idx="1749">
                  <c:v>10.681821823120117</c:v>
                </c:pt>
                <c:pt idx="1750">
                  <c:v>10.693829536437988</c:v>
                </c:pt>
                <c:pt idx="1751">
                  <c:v>10.705839157104492</c:v>
                </c:pt>
                <c:pt idx="1752">
                  <c:v>10.71784782409668</c:v>
                </c:pt>
                <c:pt idx="1753">
                  <c:v>10.729861259460449</c:v>
                </c:pt>
                <c:pt idx="1754">
                  <c:v>10.741878509521484</c:v>
                </c:pt>
                <c:pt idx="1755">
                  <c:v>10.753896713256836</c:v>
                </c:pt>
                <c:pt idx="1756">
                  <c:v>10.765915870666504</c:v>
                </c:pt>
                <c:pt idx="1757">
                  <c:v>10.777938842773438</c:v>
                </c:pt>
                <c:pt idx="1758">
                  <c:v>10.789963722229004</c:v>
                </c:pt>
                <c:pt idx="1759">
                  <c:v>10.80199146270752</c:v>
                </c:pt>
                <c:pt idx="1760">
                  <c:v>10.814021110534668</c:v>
                </c:pt>
                <c:pt idx="1761">
                  <c:v>10.826051712036133</c:v>
                </c:pt>
                <c:pt idx="1762">
                  <c:v>10.83808422088623</c:v>
                </c:pt>
                <c:pt idx="1763">
                  <c:v>10.850118637084961</c:v>
                </c:pt>
                <c:pt idx="1764">
                  <c:v>10.86215877532959</c:v>
                </c:pt>
                <c:pt idx="1765">
                  <c:v>10.874197006225586</c:v>
                </c:pt>
                <c:pt idx="1766">
                  <c:v>10.88624095916748</c:v>
                </c:pt>
                <c:pt idx="1767">
                  <c:v>10.898285865783691</c:v>
                </c:pt>
                <c:pt idx="1768">
                  <c:v>10.910332679748535</c:v>
                </c:pt>
                <c:pt idx="1769">
                  <c:v>10.922381401062012</c:v>
                </c:pt>
                <c:pt idx="1770">
                  <c:v>10.934435844421387</c:v>
                </c:pt>
                <c:pt idx="1771">
                  <c:v>10.946491241455078</c:v>
                </c:pt>
                <c:pt idx="1772">
                  <c:v>10.958547592163086</c:v>
                </c:pt>
                <c:pt idx="1773">
                  <c:v>10.970605850219727</c:v>
                </c:pt>
                <c:pt idx="1774">
                  <c:v>10.982668876647949</c:v>
                </c:pt>
                <c:pt idx="1775">
                  <c:v>10.994731903076172</c:v>
                </c:pt>
                <c:pt idx="1776">
                  <c:v>11.006800651550293</c:v>
                </c:pt>
                <c:pt idx="1777">
                  <c:v>11.018871307373047</c:v>
                </c:pt>
                <c:pt idx="1778">
                  <c:v>11.030946731567383</c:v>
                </c:pt>
                <c:pt idx="1779">
                  <c:v>11.043021202087402</c:v>
                </c:pt>
                <c:pt idx="1780">
                  <c:v>11.055100440979004</c:v>
                </c:pt>
                <c:pt idx="1781">
                  <c:v>11.067178726196289</c:v>
                </c:pt>
                <c:pt idx="1782">
                  <c:v>11.07926082611084</c:v>
                </c:pt>
                <c:pt idx="1783">
                  <c:v>11.091343879699707</c:v>
                </c:pt>
                <c:pt idx="1784">
                  <c:v>11.10343074798584</c:v>
                </c:pt>
                <c:pt idx="1785">
                  <c:v>11.115516662597656</c:v>
                </c:pt>
                <c:pt idx="1786">
                  <c:v>11.127607345581055</c:v>
                </c:pt>
                <c:pt idx="1787">
                  <c:v>11.139699935913086</c:v>
                </c:pt>
                <c:pt idx="1788">
                  <c:v>11.151798248291016</c:v>
                </c:pt>
                <c:pt idx="1789">
                  <c:v>11.163895606994629</c:v>
                </c:pt>
                <c:pt idx="1790">
                  <c:v>11.175995826721191</c:v>
                </c:pt>
                <c:pt idx="1791">
                  <c:v>11.188100814819336</c:v>
                </c:pt>
                <c:pt idx="1792">
                  <c:v>11.200209617614746</c:v>
                </c:pt>
                <c:pt idx="1793">
                  <c:v>11.212315559387207</c:v>
                </c:pt>
                <c:pt idx="1794">
                  <c:v>11.22442626953125</c:v>
                </c:pt>
                <c:pt idx="1795">
                  <c:v>11.236539840698242</c:v>
                </c:pt>
                <c:pt idx="1796">
                  <c:v>11.248656272888184</c:v>
                </c:pt>
                <c:pt idx="1797">
                  <c:v>11.260772705078125</c:v>
                </c:pt>
                <c:pt idx="1798">
                  <c:v>11.272895812988281</c:v>
                </c:pt>
                <c:pt idx="1799">
                  <c:v>11.285017967224121</c:v>
                </c:pt>
                <c:pt idx="1800">
                  <c:v>11.297143936157227</c:v>
                </c:pt>
                <c:pt idx="1801">
                  <c:v>11.309270858764648</c:v>
                </c:pt>
                <c:pt idx="1802">
                  <c:v>11.321399688720703</c:v>
                </c:pt>
                <c:pt idx="1803">
                  <c:v>11.333530426025391</c:v>
                </c:pt>
                <c:pt idx="1804">
                  <c:v>11.345666885375977</c:v>
                </c:pt>
                <c:pt idx="1805">
                  <c:v>11.357802391052246</c:v>
                </c:pt>
                <c:pt idx="1806">
                  <c:v>11.369940757751465</c:v>
                </c:pt>
                <c:pt idx="1807">
                  <c:v>11.382079124450684</c:v>
                </c:pt>
                <c:pt idx="1808">
                  <c:v>11.394224166870117</c:v>
                </c:pt>
                <c:pt idx="1809">
                  <c:v>11.406369209289551</c:v>
                </c:pt>
                <c:pt idx="1810">
                  <c:v>11.418519973754883</c:v>
                </c:pt>
                <c:pt idx="1811">
                  <c:v>11.430670738220215</c:v>
                </c:pt>
                <c:pt idx="1812">
                  <c:v>11.44282341003418</c:v>
                </c:pt>
                <c:pt idx="1813">
                  <c:v>11.454978942871094</c:v>
                </c:pt>
                <c:pt idx="1814">
                  <c:v>11.467137336730957</c:v>
                </c:pt>
                <c:pt idx="1815">
                  <c:v>11.479297637939453</c:v>
                </c:pt>
                <c:pt idx="1816">
                  <c:v>11.491459846496582</c:v>
                </c:pt>
                <c:pt idx="1817">
                  <c:v>11.503626823425293</c:v>
                </c:pt>
                <c:pt idx="1818">
                  <c:v>11.51579475402832</c:v>
                </c:pt>
                <c:pt idx="1819">
                  <c:v>11.527963638305664</c:v>
                </c:pt>
                <c:pt idx="1820">
                  <c:v>11.540136337280273</c:v>
                </c:pt>
                <c:pt idx="1821">
                  <c:v>11.552310943603516</c:v>
                </c:pt>
                <c:pt idx="1822">
                  <c:v>11.564489364624023</c:v>
                </c:pt>
                <c:pt idx="1823">
                  <c:v>11.576669692993164</c:v>
                </c:pt>
                <c:pt idx="1824">
                  <c:v>11.588852882385254</c:v>
                </c:pt>
                <c:pt idx="1825">
                  <c:v>11.601038932800293</c:v>
                </c:pt>
                <c:pt idx="1826">
                  <c:v>11.613227844238281</c:v>
                </c:pt>
                <c:pt idx="1827">
                  <c:v>11.625419616699219</c:v>
                </c:pt>
                <c:pt idx="1828">
                  <c:v>11.637612342834473</c:v>
                </c:pt>
                <c:pt idx="1829">
                  <c:v>11.649809837341309</c:v>
                </c:pt>
                <c:pt idx="1830">
                  <c:v>11.662009239196777</c:v>
                </c:pt>
                <c:pt idx="1831">
                  <c:v>11.674211502075195</c:v>
                </c:pt>
                <c:pt idx="1832">
                  <c:v>11.686415672302246</c:v>
                </c:pt>
                <c:pt idx="1833">
                  <c:v>11.698623657226563</c:v>
                </c:pt>
                <c:pt idx="1834">
                  <c:v>11.710832595825195</c:v>
                </c:pt>
                <c:pt idx="1835">
                  <c:v>11.723045349121094</c:v>
                </c:pt>
                <c:pt idx="1836">
                  <c:v>11.735258102416992</c:v>
                </c:pt>
                <c:pt idx="1837">
                  <c:v>11.747475624084473</c:v>
                </c:pt>
                <c:pt idx="1838">
                  <c:v>11.75969409942627</c:v>
                </c:pt>
                <c:pt idx="1839">
                  <c:v>11.771914482116699</c:v>
                </c:pt>
                <c:pt idx="1840">
                  <c:v>11.784137725830078</c:v>
                </c:pt>
                <c:pt idx="1841">
                  <c:v>11.796364784240723</c:v>
                </c:pt>
                <c:pt idx="1842">
                  <c:v>11.80859375</c:v>
                </c:pt>
                <c:pt idx="1843">
                  <c:v>11.820825576782227</c:v>
                </c:pt>
                <c:pt idx="1844">
                  <c:v>11.833059310913086</c:v>
                </c:pt>
                <c:pt idx="1845">
                  <c:v>11.845295906066895</c:v>
                </c:pt>
                <c:pt idx="1846">
                  <c:v>11.857535362243652</c:v>
                </c:pt>
                <c:pt idx="1847">
                  <c:v>11.869776725769043</c:v>
                </c:pt>
                <c:pt idx="1848">
                  <c:v>11.882019996643066</c:v>
                </c:pt>
                <c:pt idx="1849">
                  <c:v>11.894267082214355</c:v>
                </c:pt>
                <c:pt idx="1850">
                  <c:v>11.906515121459961</c:v>
                </c:pt>
                <c:pt idx="1851">
                  <c:v>11.918765068054199</c:v>
                </c:pt>
                <c:pt idx="1852">
                  <c:v>11.931017875671387</c:v>
                </c:pt>
                <c:pt idx="1853">
                  <c:v>11.943273544311523</c:v>
                </c:pt>
                <c:pt idx="1854">
                  <c:v>11.955531120300293</c:v>
                </c:pt>
                <c:pt idx="1855">
                  <c:v>11.967792510986328</c:v>
                </c:pt>
                <c:pt idx="1856">
                  <c:v>11.98005485534668</c:v>
                </c:pt>
                <c:pt idx="1857">
                  <c:v>11.99232006072998</c:v>
                </c:pt>
                <c:pt idx="1858">
                  <c:v>12.00458812713623</c:v>
                </c:pt>
                <c:pt idx="1859">
                  <c:v>12.01685905456543</c:v>
                </c:pt>
                <c:pt idx="1860">
                  <c:v>12.029131889343262</c:v>
                </c:pt>
                <c:pt idx="1861">
                  <c:v>12.041407585144043</c:v>
                </c:pt>
                <c:pt idx="1862">
                  <c:v>12.053685188293457</c:v>
                </c:pt>
                <c:pt idx="1863">
                  <c:v>12.065966606140137</c:v>
                </c:pt>
                <c:pt idx="1864">
                  <c:v>12.078248977661133</c:v>
                </c:pt>
                <c:pt idx="1865">
                  <c:v>12.090535163879395</c:v>
                </c:pt>
                <c:pt idx="1866">
                  <c:v>12.102822303771973</c:v>
                </c:pt>
                <c:pt idx="1867">
                  <c:v>12.115113258361816</c:v>
                </c:pt>
                <c:pt idx="1868">
                  <c:v>12.127405166625977</c:v>
                </c:pt>
                <c:pt idx="1869">
                  <c:v>12.139699935913086</c:v>
                </c:pt>
                <c:pt idx="1870">
                  <c:v>12.151997566223145</c:v>
                </c:pt>
                <c:pt idx="1871">
                  <c:v>12.164297103881836</c:v>
                </c:pt>
                <c:pt idx="1872">
                  <c:v>12.176597595214844</c:v>
                </c:pt>
                <c:pt idx="1873">
                  <c:v>12.188901901245117</c:v>
                </c:pt>
                <c:pt idx="1874">
                  <c:v>12.201208114624023</c:v>
                </c:pt>
                <c:pt idx="1875">
                  <c:v>12.213517189025879</c:v>
                </c:pt>
                <c:pt idx="1876">
                  <c:v>12.225828170776367</c:v>
                </c:pt>
                <c:pt idx="1877">
                  <c:v>12.238141059875488</c:v>
                </c:pt>
                <c:pt idx="1878">
                  <c:v>12.250456809997559</c:v>
                </c:pt>
                <c:pt idx="1879">
                  <c:v>12.262774467468262</c:v>
                </c:pt>
                <c:pt idx="1880">
                  <c:v>12.275094032287598</c:v>
                </c:pt>
                <c:pt idx="1881">
                  <c:v>12.287415504455566</c:v>
                </c:pt>
                <c:pt idx="1882">
                  <c:v>12.299739837646484</c:v>
                </c:pt>
                <c:pt idx="1883">
                  <c:v>12.312066078186035</c:v>
                </c:pt>
                <c:pt idx="1884">
                  <c:v>12.324394226074219</c:v>
                </c:pt>
                <c:pt idx="1885">
                  <c:v>12.336725234985352</c:v>
                </c:pt>
                <c:pt idx="1886">
                  <c:v>12.349057197570801</c:v>
                </c:pt>
                <c:pt idx="1887">
                  <c:v>12.361392021179199</c:v>
                </c:pt>
                <c:pt idx="1888">
                  <c:v>12.37372875213623</c:v>
                </c:pt>
                <c:pt idx="1889">
                  <c:v>12.386068344116211</c:v>
                </c:pt>
                <c:pt idx="1890">
                  <c:v>12.398408889770508</c:v>
                </c:pt>
                <c:pt idx="1891">
                  <c:v>12.410752296447754</c:v>
                </c:pt>
                <c:pt idx="1892">
                  <c:v>12.423096656799316</c:v>
                </c:pt>
                <c:pt idx="1893">
                  <c:v>12.435443878173828</c:v>
                </c:pt>
                <c:pt idx="1894">
                  <c:v>12.447793006896973</c:v>
                </c:pt>
                <c:pt idx="1895">
                  <c:v>12.46014404296875</c:v>
                </c:pt>
                <c:pt idx="1896">
                  <c:v>12.47249698638916</c:v>
                </c:pt>
                <c:pt idx="1897">
                  <c:v>12.48485279083252</c:v>
                </c:pt>
                <c:pt idx="1898">
                  <c:v>12.497209548950195</c:v>
                </c:pt>
                <c:pt idx="1899">
                  <c:v>12.50956916809082</c:v>
                </c:pt>
                <c:pt idx="1900">
                  <c:v>12.521929740905762</c:v>
                </c:pt>
                <c:pt idx="1901">
                  <c:v>12.534292221069336</c:v>
                </c:pt>
                <c:pt idx="1902">
                  <c:v>12.546657562255859</c:v>
                </c:pt>
                <c:pt idx="1903">
                  <c:v>12.559024810791016</c:v>
                </c:pt>
                <c:pt idx="1904">
                  <c:v>12.571393013000488</c:v>
                </c:pt>
                <c:pt idx="1905">
                  <c:v>12.58376407623291</c:v>
                </c:pt>
                <c:pt idx="1906">
                  <c:v>12.596136093139648</c:v>
                </c:pt>
                <c:pt idx="1907">
                  <c:v>12.608510971069336</c:v>
                </c:pt>
                <c:pt idx="1908">
                  <c:v>12.62088680267334</c:v>
                </c:pt>
                <c:pt idx="1909">
                  <c:v>12.633264541625977</c:v>
                </c:pt>
                <c:pt idx="1910">
                  <c:v>12.645645141601563</c:v>
                </c:pt>
                <c:pt idx="1911">
                  <c:v>12.658026695251465</c:v>
                </c:pt>
                <c:pt idx="1912">
                  <c:v>12.67041015625</c:v>
                </c:pt>
                <c:pt idx="1913">
                  <c:v>12.682795524597168</c:v>
                </c:pt>
                <c:pt idx="1914">
                  <c:v>12.695182800292969</c:v>
                </c:pt>
                <c:pt idx="1915">
                  <c:v>12.707571983337402</c:v>
                </c:pt>
                <c:pt idx="1916">
                  <c:v>12.719962120056152</c:v>
                </c:pt>
                <c:pt idx="1917">
                  <c:v>12.732355117797852</c:v>
                </c:pt>
                <c:pt idx="1918">
                  <c:v>12.744749069213867</c:v>
                </c:pt>
                <c:pt idx="1919">
                  <c:v>12.757144927978516</c:v>
                </c:pt>
                <c:pt idx="1920">
                  <c:v>12.769542694091797</c:v>
                </c:pt>
                <c:pt idx="1921">
                  <c:v>12.781942367553711</c:v>
                </c:pt>
                <c:pt idx="1922">
                  <c:v>12.794342994689941</c:v>
                </c:pt>
                <c:pt idx="1923">
                  <c:v>12.806745529174805</c:v>
                </c:pt>
                <c:pt idx="1924">
                  <c:v>12.819149971008301</c:v>
                </c:pt>
                <c:pt idx="1925">
                  <c:v>12.83155632019043</c:v>
                </c:pt>
                <c:pt idx="1926">
                  <c:v>12.843964576721191</c:v>
                </c:pt>
                <c:pt idx="1927">
                  <c:v>12.85637378692627</c:v>
                </c:pt>
                <c:pt idx="1928">
                  <c:v>12.86878490447998</c:v>
                </c:pt>
                <c:pt idx="1929">
                  <c:v>12.881196975708008</c:v>
                </c:pt>
                <c:pt idx="1930">
                  <c:v>12.893611907958984</c:v>
                </c:pt>
                <c:pt idx="1931">
                  <c:v>12.906027793884277</c:v>
                </c:pt>
                <c:pt idx="1932">
                  <c:v>12.918444633483887</c:v>
                </c:pt>
                <c:pt idx="1933">
                  <c:v>12.930864334106445</c:v>
                </c:pt>
                <c:pt idx="1934">
                  <c:v>12.943284034729004</c:v>
                </c:pt>
                <c:pt idx="1935">
                  <c:v>12.955706596374512</c:v>
                </c:pt>
                <c:pt idx="1936">
                  <c:v>12.968130111694336</c:v>
                </c:pt>
                <c:pt idx="1937">
                  <c:v>12.980555534362793</c:v>
                </c:pt>
                <c:pt idx="1938">
                  <c:v>12.992981910705566</c:v>
                </c:pt>
                <c:pt idx="1939">
                  <c:v>13.005410194396973</c:v>
                </c:pt>
                <c:pt idx="1940">
                  <c:v>13.017840385437012</c:v>
                </c:pt>
                <c:pt idx="1941">
                  <c:v>13.030271530151367</c:v>
                </c:pt>
                <c:pt idx="1942">
                  <c:v>13.042703628540039</c:v>
                </c:pt>
                <c:pt idx="1943">
                  <c:v>13.05513858795166</c:v>
                </c:pt>
                <c:pt idx="1944">
                  <c:v>13.067574501037598</c:v>
                </c:pt>
                <c:pt idx="1945">
                  <c:v>13.080012321472168</c:v>
                </c:pt>
                <c:pt idx="1946">
                  <c:v>13.092451095581055</c:v>
                </c:pt>
                <c:pt idx="1947">
                  <c:v>13.104891777038574</c:v>
                </c:pt>
                <c:pt idx="1948">
                  <c:v>13.117334365844727</c:v>
                </c:pt>
                <c:pt idx="1949">
                  <c:v>13.129778861999512</c:v>
                </c:pt>
                <c:pt idx="1950">
                  <c:v>13.142224311828613</c:v>
                </c:pt>
                <c:pt idx="1951">
                  <c:v>13.154672622680664</c:v>
                </c:pt>
                <c:pt idx="1952">
                  <c:v>13.167121887207031</c:v>
                </c:pt>
                <c:pt idx="1953">
                  <c:v>13.179573059082031</c:v>
                </c:pt>
                <c:pt idx="1954">
                  <c:v>13.192026138305664</c:v>
                </c:pt>
                <c:pt idx="1955">
                  <c:v>13.20448112487793</c:v>
                </c:pt>
                <c:pt idx="1956">
                  <c:v>13.216938018798828</c:v>
                </c:pt>
                <c:pt idx="1957">
                  <c:v>13.229396820068359</c:v>
                </c:pt>
                <c:pt idx="1958">
                  <c:v>13.241857528686523</c:v>
                </c:pt>
                <c:pt idx="1959">
                  <c:v>13.254319190979004</c:v>
                </c:pt>
                <c:pt idx="1960">
                  <c:v>13.266783714294434</c:v>
                </c:pt>
                <c:pt idx="1961">
                  <c:v>13.279250144958496</c:v>
                </c:pt>
                <c:pt idx="1962">
                  <c:v>13.291718482971191</c:v>
                </c:pt>
                <c:pt idx="1963">
                  <c:v>13.30418872833252</c:v>
                </c:pt>
                <c:pt idx="1964">
                  <c:v>13.31666088104248</c:v>
                </c:pt>
                <c:pt idx="1965">
                  <c:v>13.329135894775391</c:v>
                </c:pt>
                <c:pt idx="1966">
                  <c:v>13.341611862182617</c:v>
                </c:pt>
                <c:pt idx="1967">
                  <c:v>13.354090690612793</c:v>
                </c:pt>
                <c:pt idx="1968">
                  <c:v>13.366571426391602</c:v>
                </c:pt>
                <c:pt idx="1969">
                  <c:v>13.379054069519043</c:v>
                </c:pt>
                <c:pt idx="1970">
                  <c:v>13.391539573669434</c:v>
                </c:pt>
                <c:pt idx="1971">
                  <c:v>13.404026031494141</c:v>
                </c:pt>
                <c:pt idx="1972">
                  <c:v>13.416515350341797</c:v>
                </c:pt>
                <c:pt idx="1973">
                  <c:v>13.429007530212402</c:v>
                </c:pt>
                <c:pt idx="1974">
                  <c:v>13.441500663757324</c:v>
                </c:pt>
                <c:pt idx="1975">
                  <c:v>13.453996658325195</c:v>
                </c:pt>
                <c:pt idx="1976">
                  <c:v>13.466495513916016</c:v>
                </c:pt>
                <c:pt idx="1977">
                  <c:v>13.478996276855469</c:v>
                </c:pt>
                <c:pt idx="1978">
                  <c:v>13.491498947143555</c:v>
                </c:pt>
                <c:pt idx="1979">
                  <c:v>13.50400447845459</c:v>
                </c:pt>
                <c:pt idx="1980">
                  <c:v>13.516511917114258</c:v>
                </c:pt>
                <c:pt idx="1981">
                  <c:v>13.529022216796875</c:v>
                </c:pt>
                <c:pt idx="1982">
                  <c:v>13.541534423828125</c:v>
                </c:pt>
                <c:pt idx="1983">
                  <c:v>13.554049491882324</c:v>
                </c:pt>
                <c:pt idx="1984">
                  <c:v>13.566566467285156</c:v>
                </c:pt>
                <c:pt idx="1985">
                  <c:v>13.579086303710938</c:v>
                </c:pt>
                <c:pt idx="1986">
                  <c:v>13.591609001159668</c:v>
                </c:pt>
                <c:pt idx="1987">
                  <c:v>13.604133605957031</c:v>
                </c:pt>
                <c:pt idx="1988">
                  <c:v>13.616661071777344</c:v>
                </c:pt>
                <c:pt idx="1989">
                  <c:v>13.629191398620605</c:v>
                </c:pt>
                <c:pt idx="1990">
                  <c:v>13.6417236328125</c:v>
                </c:pt>
                <c:pt idx="1991">
                  <c:v>13.654258728027344</c:v>
                </c:pt>
                <c:pt idx="1992">
                  <c:v>13.666796684265137</c:v>
                </c:pt>
                <c:pt idx="1993">
                  <c:v>13.679337501525879</c:v>
                </c:pt>
                <c:pt idx="1994">
                  <c:v>13.691880226135254</c:v>
                </c:pt>
                <c:pt idx="1995">
                  <c:v>13.704425811767578</c:v>
                </c:pt>
                <c:pt idx="1996">
                  <c:v>13.716974258422852</c:v>
                </c:pt>
                <c:pt idx="1997">
                  <c:v>13.729525566101074</c:v>
                </c:pt>
                <c:pt idx="1998">
                  <c:v>13.742079734802246</c:v>
                </c:pt>
                <c:pt idx="1999">
                  <c:v>13.754636764526367</c:v>
                </c:pt>
                <c:pt idx="2000">
                  <c:v>13.767196655273438</c:v>
                </c:pt>
                <c:pt idx="2001">
                  <c:v>13.779758453369141</c:v>
                </c:pt>
                <c:pt idx="2002">
                  <c:v>13.792324066162109</c:v>
                </c:pt>
                <c:pt idx="2003">
                  <c:v>13.804891586303711</c:v>
                </c:pt>
                <c:pt idx="2004">
                  <c:v>13.817462921142578</c:v>
                </c:pt>
                <c:pt idx="2005">
                  <c:v>13.830037117004395</c:v>
                </c:pt>
                <c:pt idx="2006">
                  <c:v>13.84261417388916</c:v>
                </c:pt>
                <c:pt idx="2007">
                  <c:v>13.855193138122559</c:v>
                </c:pt>
                <c:pt idx="2008">
                  <c:v>13.867775917053223</c:v>
                </c:pt>
                <c:pt idx="2009">
                  <c:v>13.880361557006836</c:v>
                </c:pt>
                <c:pt idx="2010">
                  <c:v>13.892951011657715</c:v>
                </c:pt>
                <c:pt idx="2011">
                  <c:v>13.905542373657227</c:v>
                </c:pt>
                <c:pt idx="2012">
                  <c:v>13.918137550354004</c:v>
                </c:pt>
                <c:pt idx="2013">
                  <c:v>13.93073558807373</c:v>
                </c:pt>
                <c:pt idx="2014">
                  <c:v>13.943336486816406</c:v>
                </c:pt>
                <c:pt idx="2015">
                  <c:v>13.955940246582031</c:v>
                </c:pt>
                <c:pt idx="2016">
                  <c:v>13.968547821044922</c:v>
                </c:pt>
                <c:pt idx="2017">
                  <c:v>13.981158256530762</c:v>
                </c:pt>
                <c:pt idx="2018">
                  <c:v>13.993771553039551</c:v>
                </c:pt>
                <c:pt idx="2019">
                  <c:v>14.006388664245605</c:v>
                </c:pt>
                <c:pt idx="2020">
                  <c:v>14.019008636474609</c:v>
                </c:pt>
                <c:pt idx="2021">
                  <c:v>14.031632423400879</c:v>
                </c:pt>
                <c:pt idx="2022">
                  <c:v>14.044258117675781</c:v>
                </c:pt>
                <c:pt idx="2023">
                  <c:v>14.056888580322266</c:v>
                </c:pt>
                <c:pt idx="2024">
                  <c:v>14.069520950317383</c:v>
                </c:pt>
                <c:pt idx="2025">
                  <c:v>14.082157135009766</c:v>
                </c:pt>
                <c:pt idx="2026">
                  <c:v>14.094797134399414</c:v>
                </c:pt>
                <c:pt idx="2027">
                  <c:v>14.107439994812012</c:v>
                </c:pt>
                <c:pt idx="2028">
                  <c:v>14.120086669921875</c:v>
                </c:pt>
                <c:pt idx="2029">
                  <c:v>14.132736206054688</c:v>
                </c:pt>
                <c:pt idx="2030">
                  <c:v>14.145388603210449</c:v>
                </c:pt>
                <c:pt idx="2031">
                  <c:v>14.158044815063477</c:v>
                </c:pt>
                <c:pt idx="2032">
                  <c:v>14.170703887939453</c:v>
                </c:pt>
                <c:pt idx="2033">
                  <c:v>14.183366775512695</c:v>
                </c:pt>
                <c:pt idx="2034">
                  <c:v>14.196032524108887</c:v>
                </c:pt>
                <c:pt idx="2035">
                  <c:v>14.208702087402344</c:v>
                </c:pt>
                <c:pt idx="2036">
                  <c:v>14.22137451171875</c:v>
                </c:pt>
                <c:pt idx="2037">
                  <c:v>14.234050750732422</c:v>
                </c:pt>
                <c:pt idx="2038">
                  <c:v>14.246729850769043</c:v>
                </c:pt>
                <c:pt idx="2039">
                  <c:v>14.25941276550293</c:v>
                </c:pt>
                <c:pt idx="2040">
                  <c:v>14.272098541259766</c:v>
                </c:pt>
                <c:pt idx="2041">
                  <c:v>14.284787178039551</c:v>
                </c:pt>
                <c:pt idx="2042">
                  <c:v>14.297479629516602</c:v>
                </c:pt>
                <c:pt idx="2043">
                  <c:v>14.310175895690918</c:v>
                </c:pt>
                <c:pt idx="2044">
                  <c:v>14.322875022888184</c:v>
                </c:pt>
                <c:pt idx="2045">
                  <c:v>14.335577964782715</c:v>
                </c:pt>
                <c:pt idx="2046">
                  <c:v>14.348284721374512</c:v>
                </c:pt>
                <c:pt idx="2047">
                  <c:v>14.360995292663574</c:v>
                </c:pt>
                <c:pt idx="2048">
                  <c:v>14.37370777130127</c:v>
                </c:pt>
                <c:pt idx="2049">
                  <c:v>14.38642406463623</c:v>
                </c:pt>
                <c:pt idx="2050">
                  <c:v>14.399143218994141</c:v>
                </c:pt>
                <c:pt idx="2051">
                  <c:v>14.411866188049316</c:v>
                </c:pt>
                <c:pt idx="2052">
                  <c:v>14.424593925476074</c:v>
                </c:pt>
                <c:pt idx="2053">
                  <c:v>14.437322616577148</c:v>
                </c:pt>
                <c:pt idx="2054">
                  <c:v>14.450056076049805</c:v>
                </c:pt>
                <c:pt idx="2055">
                  <c:v>14.462793350219727</c:v>
                </c:pt>
                <c:pt idx="2056">
                  <c:v>14.475534439086914</c:v>
                </c:pt>
                <c:pt idx="2057">
                  <c:v>14.488277435302734</c:v>
                </c:pt>
                <c:pt idx="2058">
                  <c:v>14.50102424621582</c:v>
                </c:pt>
                <c:pt idx="2059">
                  <c:v>14.513773918151855</c:v>
                </c:pt>
                <c:pt idx="2060">
                  <c:v>14.526529312133789</c:v>
                </c:pt>
                <c:pt idx="2061">
                  <c:v>14.539287567138672</c:v>
                </c:pt>
                <c:pt idx="2062">
                  <c:v>14.552047729492188</c:v>
                </c:pt>
                <c:pt idx="2063">
                  <c:v>14.564812660217285</c:v>
                </c:pt>
                <c:pt idx="2064">
                  <c:v>14.577579498291016</c:v>
                </c:pt>
                <c:pt idx="2065">
                  <c:v>14.590350151062012</c:v>
                </c:pt>
                <c:pt idx="2066">
                  <c:v>14.60312557220459</c:v>
                </c:pt>
                <c:pt idx="2067">
                  <c:v>14.61590576171875</c:v>
                </c:pt>
                <c:pt idx="2068">
                  <c:v>14.628687858581543</c:v>
                </c:pt>
                <c:pt idx="2069">
                  <c:v>14.641473770141602</c:v>
                </c:pt>
                <c:pt idx="2070">
                  <c:v>14.654262542724609</c:v>
                </c:pt>
                <c:pt idx="2071">
                  <c:v>14.667055130004883</c:v>
                </c:pt>
                <c:pt idx="2072">
                  <c:v>14.679851531982422</c:v>
                </c:pt>
                <c:pt idx="2073">
                  <c:v>14.692651748657227</c:v>
                </c:pt>
                <c:pt idx="2074">
                  <c:v>14.705455780029297</c:v>
                </c:pt>
                <c:pt idx="2075">
                  <c:v>14.718262672424316</c:v>
                </c:pt>
                <c:pt idx="2076">
                  <c:v>14.731073379516602</c:v>
                </c:pt>
                <c:pt idx="2077">
                  <c:v>14.743888854980469</c:v>
                </c:pt>
                <c:pt idx="2078">
                  <c:v>14.756707191467285</c:v>
                </c:pt>
                <c:pt idx="2079">
                  <c:v>14.769528388977051</c:v>
                </c:pt>
                <c:pt idx="2080">
                  <c:v>14.782354354858398</c:v>
                </c:pt>
                <c:pt idx="2081">
                  <c:v>14.795184135437012</c:v>
                </c:pt>
                <c:pt idx="2082">
                  <c:v>14.808017730712891</c:v>
                </c:pt>
                <c:pt idx="2083">
                  <c:v>14.820853233337402</c:v>
                </c:pt>
                <c:pt idx="2084">
                  <c:v>14.833693504333496</c:v>
                </c:pt>
                <c:pt idx="2085">
                  <c:v>14.846536636352539</c:v>
                </c:pt>
                <c:pt idx="2086">
                  <c:v>14.859384536743164</c:v>
                </c:pt>
                <c:pt idx="2087">
                  <c:v>14.872234344482422</c:v>
                </c:pt>
                <c:pt idx="2088">
                  <c:v>14.885089874267578</c:v>
                </c:pt>
                <c:pt idx="2089">
                  <c:v>14.897948265075684</c:v>
                </c:pt>
                <c:pt idx="2090">
                  <c:v>14.910811424255371</c:v>
                </c:pt>
                <c:pt idx="2091">
                  <c:v>14.923675537109375</c:v>
                </c:pt>
                <c:pt idx="2092">
                  <c:v>14.936545372009277</c:v>
                </c:pt>
                <c:pt idx="2093">
                  <c:v>14.949418067932129</c:v>
                </c:pt>
                <c:pt idx="2094">
                  <c:v>14.962294578552246</c:v>
                </c:pt>
                <c:pt idx="2095">
                  <c:v>14.975173950195313</c:v>
                </c:pt>
                <c:pt idx="2096">
                  <c:v>14.988058090209961</c:v>
                </c:pt>
                <c:pt idx="2097">
                  <c:v>15.000945091247559</c:v>
                </c:pt>
                <c:pt idx="2098">
                  <c:v>15.013836860656738</c:v>
                </c:pt>
                <c:pt idx="2099">
                  <c:v>15.026731491088867</c:v>
                </c:pt>
                <c:pt idx="2100">
                  <c:v>15.039631843566895</c:v>
                </c:pt>
                <c:pt idx="2101">
                  <c:v>15.052534103393555</c:v>
                </c:pt>
                <c:pt idx="2102">
                  <c:v>15.065441131591797</c:v>
                </c:pt>
                <c:pt idx="2103">
                  <c:v>15.078350067138672</c:v>
                </c:pt>
                <c:pt idx="2104">
                  <c:v>15.091262817382813</c:v>
                </c:pt>
                <c:pt idx="2105">
                  <c:v>15.104179382324219</c:v>
                </c:pt>
                <c:pt idx="2106">
                  <c:v>15.117100715637207</c:v>
                </c:pt>
                <c:pt idx="2107">
                  <c:v>15.130024909973145</c:v>
                </c:pt>
                <c:pt idx="2108">
                  <c:v>15.142952919006348</c:v>
                </c:pt>
                <c:pt idx="2109">
                  <c:v>15.155884742736816</c:v>
                </c:pt>
                <c:pt idx="2110">
                  <c:v>15.168820381164551</c:v>
                </c:pt>
                <c:pt idx="2111">
                  <c:v>15.181758880615234</c:v>
                </c:pt>
                <c:pt idx="2112">
                  <c:v>15.194701194763184</c:v>
                </c:pt>
                <c:pt idx="2113">
                  <c:v>15.207647323608398</c:v>
                </c:pt>
                <c:pt idx="2114">
                  <c:v>15.220598220825195</c:v>
                </c:pt>
                <c:pt idx="2115">
                  <c:v>15.233551025390625</c:v>
                </c:pt>
                <c:pt idx="2116">
                  <c:v>15.246508598327637</c:v>
                </c:pt>
                <c:pt idx="2117">
                  <c:v>15.259469985961914</c:v>
                </c:pt>
                <c:pt idx="2118">
                  <c:v>15.272434234619141</c:v>
                </c:pt>
                <c:pt idx="2119">
                  <c:v>15.285400390625</c:v>
                </c:pt>
                <c:pt idx="2120">
                  <c:v>15.298373222351074</c:v>
                </c:pt>
                <c:pt idx="2121">
                  <c:v>15.311349868774414</c:v>
                </c:pt>
                <c:pt idx="2122">
                  <c:v>15.32433032989502</c:v>
                </c:pt>
                <c:pt idx="2123">
                  <c:v>15.337311744689941</c:v>
                </c:pt>
                <c:pt idx="2124">
                  <c:v>15.350299835205078</c:v>
                </c:pt>
                <c:pt idx="2125">
                  <c:v>15.363288879394531</c:v>
                </c:pt>
                <c:pt idx="2126">
                  <c:v>15.376282691955566</c:v>
                </c:pt>
                <c:pt idx="2127">
                  <c:v>15.389281272888184</c:v>
                </c:pt>
                <c:pt idx="2128">
                  <c:v>15.402281761169434</c:v>
                </c:pt>
                <c:pt idx="2129">
                  <c:v>15.415287017822266</c:v>
                </c:pt>
                <c:pt idx="2130">
                  <c:v>15.428297996520996</c:v>
                </c:pt>
                <c:pt idx="2131">
                  <c:v>15.441310882568359</c:v>
                </c:pt>
                <c:pt idx="2132">
                  <c:v>15.454325675964355</c:v>
                </c:pt>
                <c:pt idx="2133">
                  <c:v>15.467345237731934</c:v>
                </c:pt>
                <c:pt idx="2134">
                  <c:v>15.480371475219727</c:v>
                </c:pt>
                <c:pt idx="2135">
                  <c:v>15.493399620056152</c:v>
                </c:pt>
                <c:pt idx="2136">
                  <c:v>15.506430625915527</c:v>
                </c:pt>
                <c:pt idx="2137">
                  <c:v>15.519466400146484</c:v>
                </c:pt>
                <c:pt idx="2138">
                  <c:v>15.532506942749023</c:v>
                </c:pt>
                <c:pt idx="2139">
                  <c:v>15.545548439025879</c:v>
                </c:pt>
                <c:pt idx="2140">
                  <c:v>15.55859375</c:v>
                </c:pt>
                <c:pt idx="2141">
                  <c:v>15.571643829345703</c:v>
                </c:pt>
                <c:pt idx="2142">
                  <c:v>15.584697723388672</c:v>
                </c:pt>
                <c:pt idx="2143">
                  <c:v>15.59775447845459</c:v>
                </c:pt>
                <c:pt idx="2144">
                  <c:v>15.610813140869141</c:v>
                </c:pt>
                <c:pt idx="2145">
                  <c:v>15.623876571655273</c:v>
                </c:pt>
                <c:pt idx="2146">
                  <c:v>15.636944770812988</c:v>
                </c:pt>
                <c:pt idx="2147">
                  <c:v>15.650015830993652</c:v>
                </c:pt>
                <c:pt idx="2148">
                  <c:v>15.663089752197266</c:v>
                </c:pt>
                <c:pt idx="2149">
                  <c:v>15.676165580749512</c:v>
                </c:pt>
                <c:pt idx="2150">
                  <c:v>15.689249038696289</c:v>
                </c:pt>
                <c:pt idx="2151">
                  <c:v>15.702333450317383</c:v>
                </c:pt>
                <c:pt idx="2152">
                  <c:v>15.715421676635742</c:v>
                </c:pt>
                <c:pt idx="2153">
                  <c:v>15.728513717651367</c:v>
                </c:pt>
                <c:pt idx="2154">
                  <c:v>15.741609573364258</c:v>
                </c:pt>
                <c:pt idx="2155">
                  <c:v>15.754708290100098</c:v>
                </c:pt>
                <c:pt idx="2156">
                  <c:v>15.76781177520752</c:v>
                </c:pt>
                <c:pt idx="2157">
                  <c:v>15.780917167663574</c:v>
                </c:pt>
                <c:pt idx="2158">
                  <c:v>15.794026374816895</c:v>
                </c:pt>
                <c:pt idx="2159">
                  <c:v>15.807140350341797</c:v>
                </c:pt>
                <c:pt idx="2160">
                  <c:v>15.820258140563965</c:v>
                </c:pt>
                <c:pt idx="2161">
                  <c:v>15.833377838134766</c:v>
                </c:pt>
                <c:pt idx="2162">
                  <c:v>15.846502304077148</c:v>
                </c:pt>
                <c:pt idx="2163">
                  <c:v>15.85962963104248</c:v>
                </c:pt>
                <c:pt idx="2164">
                  <c:v>15.872760772705078</c:v>
                </c:pt>
                <c:pt idx="2165">
                  <c:v>15.885894775390625</c:v>
                </c:pt>
                <c:pt idx="2166">
                  <c:v>15.899032592773438</c:v>
                </c:pt>
                <c:pt idx="2167">
                  <c:v>15.912176132202148</c:v>
                </c:pt>
                <c:pt idx="2168">
                  <c:v>15.925321578979492</c:v>
                </c:pt>
                <c:pt idx="2169">
                  <c:v>15.938470840454102</c:v>
                </c:pt>
                <c:pt idx="2170">
                  <c:v>15.951623916625977</c:v>
                </c:pt>
                <c:pt idx="2171">
                  <c:v>15.964779853820801</c:v>
                </c:pt>
                <c:pt idx="2172">
                  <c:v>15.977939605712891</c:v>
                </c:pt>
                <c:pt idx="2173">
                  <c:v>15.991103172302246</c:v>
                </c:pt>
                <c:pt idx="2174">
                  <c:v>16.004573822021484</c:v>
                </c:pt>
                <c:pt idx="2175">
                  <c:v>16.01805305480957</c:v>
                </c:pt>
                <c:pt idx="2176">
                  <c:v>16.031532287597656</c:v>
                </c:pt>
                <c:pt idx="2177">
                  <c:v>16.045019149780273</c:v>
                </c:pt>
                <c:pt idx="2178">
                  <c:v>16.058506011962891</c:v>
                </c:pt>
                <c:pt idx="2179">
                  <c:v>16.071994781494141</c:v>
                </c:pt>
                <c:pt idx="2180">
                  <c:v>16.085489273071289</c:v>
                </c:pt>
                <c:pt idx="2181">
                  <c:v>16.098989486694336</c:v>
                </c:pt>
                <c:pt idx="2182">
                  <c:v>16.112489700317383</c:v>
                </c:pt>
                <c:pt idx="2183">
                  <c:v>16.125995635986328</c:v>
                </c:pt>
                <c:pt idx="2184">
                  <c:v>16.139505386352539</c:v>
                </c:pt>
                <c:pt idx="2185">
                  <c:v>16.153018951416016</c:v>
                </c:pt>
                <c:pt idx="2186">
                  <c:v>16.166536331176758</c:v>
                </c:pt>
                <c:pt idx="2187">
                  <c:v>16.180059432983398</c:v>
                </c:pt>
                <c:pt idx="2188">
                  <c:v>16.193586349487305</c:v>
                </c:pt>
                <c:pt idx="2189">
                  <c:v>16.207117080688477</c:v>
                </c:pt>
                <c:pt idx="2190">
                  <c:v>16.220647811889648</c:v>
                </c:pt>
                <c:pt idx="2191">
                  <c:v>16.234188079833984</c:v>
                </c:pt>
                <c:pt idx="2192">
                  <c:v>16.247726440429688</c:v>
                </c:pt>
                <c:pt idx="2193">
                  <c:v>16.261268615722656</c:v>
                </c:pt>
                <c:pt idx="2194">
                  <c:v>16.274816513061523</c:v>
                </c:pt>
                <c:pt idx="2195">
                  <c:v>16.288370132446289</c:v>
                </c:pt>
                <c:pt idx="2196">
                  <c:v>16.301923751831055</c:v>
                </c:pt>
                <c:pt idx="2197">
                  <c:v>16.315483093261719</c:v>
                </c:pt>
                <c:pt idx="2198">
                  <c:v>16.329044342041016</c:v>
                </c:pt>
                <c:pt idx="2199">
                  <c:v>16.342609405517578</c:v>
                </c:pt>
                <c:pt idx="2200">
                  <c:v>16.356178283691406</c:v>
                </c:pt>
                <c:pt idx="2201">
                  <c:v>16.369749069213867</c:v>
                </c:pt>
                <c:pt idx="2202">
                  <c:v>16.383323669433594</c:v>
                </c:pt>
                <c:pt idx="2203">
                  <c:v>16.396902084350586</c:v>
                </c:pt>
                <c:pt idx="2204">
                  <c:v>16.410484313964844</c:v>
                </c:pt>
                <c:pt idx="2205">
                  <c:v>16.424070358276367</c:v>
                </c:pt>
                <c:pt idx="2206">
                  <c:v>16.437658309936523</c:v>
                </c:pt>
                <c:pt idx="2207">
                  <c:v>16.451248168945313</c:v>
                </c:pt>
                <c:pt idx="2208">
                  <c:v>16.46484375</c:v>
                </c:pt>
                <c:pt idx="2209">
                  <c:v>16.478443145751953</c:v>
                </c:pt>
                <c:pt idx="2210">
                  <c:v>16.492044448852539</c:v>
                </c:pt>
                <c:pt idx="2211">
                  <c:v>16.505653381347656</c:v>
                </c:pt>
                <c:pt idx="2212">
                  <c:v>16.519262313842773</c:v>
                </c:pt>
                <c:pt idx="2213">
                  <c:v>16.532880783081055</c:v>
                </c:pt>
                <c:pt idx="2214">
                  <c:v>16.546497344970703</c:v>
                </c:pt>
                <c:pt idx="2215">
                  <c:v>16.56011962890625</c:v>
                </c:pt>
                <c:pt idx="2216">
                  <c:v>16.57374382019043</c:v>
                </c:pt>
                <c:pt idx="2217">
                  <c:v>16.587371826171875</c:v>
                </c:pt>
                <c:pt idx="2218">
                  <c:v>16.601001739501953</c:v>
                </c:pt>
                <c:pt idx="2219">
                  <c:v>16.614639282226563</c:v>
                </c:pt>
                <c:pt idx="2220">
                  <c:v>16.628278732299805</c:v>
                </c:pt>
                <c:pt idx="2221">
                  <c:v>16.641923904418945</c:v>
                </c:pt>
                <c:pt idx="2222">
                  <c:v>16.655570983886719</c:v>
                </c:pt>
                <c:pt idx="2223">
                  <c:v>16.669221878051758</c:v>
                </c:pt>
                <c:pt idx="2224">
                  <c:v>16.682876586914063</c:v>
                </c:pt>
                <c:pt idx="2225">
                  <c:v>16.696535110473633</c:v>
                </c:pt>
                <c:pt idx="2226">
                  <c:v>16.710201263427734</c:v>
                </c:pt>
                <c:pt idx="2227">
                  <c:v>16.723869323730469</c:v>
                </c:pt>
                <c:pt idx="2228">
                  <c:v>16.737541198730469</c:v>
                </c:pt>
                <c:pt idx="2229">
                  <c:v>16.751216888427734</c:v>
                </c:pt>
                <c:pt idx="2230">
                  <c:v>16.764894485473633</c:v>
                </c:pt>
                <c:pt idx="2231">
                  <c:v>16.77857780456543</c:v>
                </c:pt>
                <c:pt idx="2232">
                  <c:v>16.792261123657227</c:v>
                </c:pt>
                <c:pt idx="2233">
                  <c:v>16.805948257446289</c:v>
                </c:pt>
                <c:pt idx="2234">
                  <c:v>16.81964111328125</c:v>
                </c:pt>
                <c:pt idx="2235">
                  <c:v>16.833339691162109</c:v>
                </c:pt>
                <c:pt idx="2236">
                  <c:v>16.847040176391602</c:v>
                </c:pt>
                <c:pt idx="2237">
                  <c:v>16.860744476318359</c:v>
                </c:pt>
                <c:pt idx="2238">
                  <c:v>16.874456405639648</c:v>
                </c:pt>
                <c:pt idx="2239">
                  <c:v>16.88817024230957</c:v>
                </c:pt>
                <c:pt idx="2240">
                  <c:v>16.901887893676758</c:v>
                </c:pt>
                <c:pt idx="2241">
                  <c:v>16.915607452392578</c:v>
                </c:pt>
                <c:pt idx="2242">
                  <c:v>16.929330825805664</c:v>
                </c:pt>
                <c:pt idx="2243">
                  <c:v>16.943058013916016</c:v>
                </c:pt>
                <c:pt idx="2244">
                  <c:v>16.956787109375</c:v>
                </c:pt>
                <c:pt idx="2245">
                  <c:v>16.970521926879883</c:v>
                </c:pt>
                <c:pt idx="2246">
                  <c:v>16.984260559082031</c:v>
                </c:pt>
                <c:pt idx="2247">
                  <c:v>16.998004913330078</c:v>
                </c:pt>
                <c:pt idx="2248">
                  <c:v>17.011749267578125</c:v>
                </c:pt>
                <c:pt idx="2249">
                  <c:v>17.025495529174805</c:v>
                </c:pt>
                <c:pt idx="2250">
                  <c:v>17.039249420166016</c:v>
                </c:pt>
                <c:pt idx="2251">
                  <c:v>17.053005218505859</c:v>
                </c:pt>
                <c:pt idx="2252">
                  <c:v>17.066762924194336</c:v>
                </c:pt>
                <c:pt idx="2253">
                  <c:v>17.080524444580078</c:v>
                </c:pt>
                <c:pt idx="2254">
                  <c:v>17.094289779663086</c:v>
                </c:pt>
                <c:pt idx="2255">
                  <c:v>17.108058929443359</c:v>
                </c:pt>
                <c:pt idx="2256">
                  <c:v>17.121831893920898</c:v>
                </c:pt>
                <c:pt idx="2257">
                  <c:v>17.135608673095703</c:v>
                </c:pt>
                <c:pt idx="2258">
                  <c:v>17.149387359619141</c:v>
                </c:pt>
                <c:pt idx="2259">
                  <c:v>17.163171768188477</c:v>
                </c:pt>
                <c:pt idx="2260">
                  <c:v>17.176956176757813</c:v>
                </c:pt>
                <c:pt idx="2261">
                  <c:v>17.19074821472168</c:v>
                </c:pt>
                <c:pt idx="2262">
                  <c:v>17.20454216003418</c:v>
                </c:pt>
                <c:pt idx="2263">
                  <c:v>17.218338012695313</c:v>
                </c:pt>
                <c:pt idx="2264">
                  <c:v>17.232139587402344</c:v>
                </c:pt>
                <c:pt idx="2265">
                  <c:v>17.245946884155273</c:v>
                </c:pt>
                <c:pt idx="2266">
                  <c:v>17.259756088256836</c:v>
                </c:pt>
                <c:pt idx="2267">
                  <c:v>17.273567199707031</c:v>
                </c:pt>
                <c:pt idx="2268">
                  <c:v>17.287385940551758</c:v>
                </c:pt>
                <c:pt idx="2269">
                  <c:v>17.301206588745117</c:v>
                </c:pt>
                <c:pt idx="2270">
                  <c:v>17.315031051635742</c:v>
                </c:pt>
                <c:pt idx="2271">
                  <c:v>17.328859329223633</c:v>
                </c:pt>
                <c:pt idx="2272">
                  <c:v>17.342689514160156</c:v>
                </c:pt>
                <c:pt idx="2273">
                  <c:v>17.356523513793945</c:v>
                </c:pt>
                <c:pt idx="2274">
                  <c:v>17.370365142822266</c:v>
                </c:pt>
                <c:pt idx="2275">
                  <c:v>17.384208679199219</c:v>
                </c:pt>
                <c:pt idx="2276">
                  <c:v>17.398056030273438</c:v>
                </c:pt>
                <c:pt idx="2277">
                  <c:v>17.411907196044922</c:v>
                </c:pt>
                <c:pt idx="2278">
                  <c:v>17.425760269165039</c:v>
                </c:pt>
                <c:pt idx="2279">
                  <c:v>17.439619064331055</c:v>
                </c:pt>
                <c:pt idx="2280">
                  <c:v>17.453479766845703</c:v>
                </c:pt>
                <c:pt idx="2281">
                  <c:v>17.467344284057617</c:v>
                </c:pt>
                <c:pt idx="2282">
                  <c:v>17.481212615966797</c:v>
                </c:pt>
                <c:pt idx="2283">
                  <c:v>17.495082855224609</c:v>
                </c:pt>
                <c:pt idx="2284">
                  <c:v>17.50895881652832</c:v>
                </c:pt>
                <c:pt idx="2285">
                  <c:v>17.522838592529297</c:v>
                </c:pt>
                <c:pt idx="2286">
                  <c:v>17.536722183227539</c:v>
                </c:pt>
                <c:pt idx="2287">
                  <c:v>17.550607681274414</c:v>
                </c:pt>
                <c:pt idx="2288">
                  <c:v>17.564498901367188</c:v>
                </c:pt>
                <c:pt idx="2289">
                  <c:v>17.578392028808594</c:v>
                </c:pt>
                <c:pt idx="2290">
                  <c:v>17.592290878295898</c:v>
                </c:pt>
                <c:pt idx="2291">
                  <c:v>17.606191635131836</c:v>
                </c:pt>
                <c:pt idx="2292">
                  <c:v>17.620096206665039</c:v>
                </c:pt>
                <c:pt idx="2293">
                  <c:v>17.634004592895508</c:v>
                </c:pt>
                <c:pt idx="2294">
                  <c:v>17.647916793823242</c:v>
                </c:pt>
                <c:pt idx="2295">
                  <c:v>17.661832809448242</c:v>
                </c:pt>
                <c:pt idx="2296">
                  <c:v>17.675750732421875</c:v>
                </c:pt>
                <c:pt idx="2297">
                  <c:v>17.689672470092773</c:v>
                </c:pt>
                <c:pt idx="2298">
                  <c:v>17.703598022460938</c:v>
                </c:pt>
                <c:pt idx="2299">
                  <c:v>17.717525482177734</c:v>
                </c:pt>
                <c:pt idx="2300">
                  <c:v>17.73145866394043</c:v>
                </c:pt>
                <c:pt idx="2301">
                  <c:v>17.745393753051758</c:v>
                </c:pt>
                <c:pt idx="2302">
                  <c:v>17.759332656860352</c:v>
                </c:pt>
                <c:pt idx="2303">
                  <c:v>17.773275375366211</c:v>
                </c:pt>
                <c:pt idx="2304">
                  <c:v>17.787221908569336</c:v>
                </c:pt>
                <c:pt idx="2305">
                  <c:v>17.801172256469727</c:v>
                </c:pt>
                <c:pt idx="2306">
                  <c:v>17.81512451171875</c:v>
                </c:pt>
                <c:pt idx="2307">
                  <c:v>17.829080581665039</c:v>
                </c:pt>
                <c:pt idx="2308">
                  <c:v>17.843040466308594</c:v>
                </c:pt>
                <c:pt idx="2309">
                  <c:v>17.857002258300781</c:v>
                </c:pt>
                <c:pt idx="2310">
                  <c:v>17.8709716796875</c:v>
                </c:pt>
                <c:pt idx="2311">
                  <c:v>17.884943008422852</c:v>
                </c:pt>
                <c:pt idx="2312">
                  <c:v>17.898916244506836</c:v>
                </c:pt>
                <c:pt idx="2313">
                  <c:v>17.912895202636719</c:v>
                </c:pt>
                <c:pt idx="2314">
                  <c:v>17.926876068115234</c:v>
                </c:pt>
                <c:pt idx="2315">
                  <c:v>17.940860748291016</c:v>
                </c:pt>
                <c:pt idx="2316">
                  <c:v>17.954849243164063</c:v>
                </c:pt>
                <c:pt idx="2317">
                  <c:v>17.968841552734375</c:v>
                </c:pt>
                <c:pt idx="2318">
                  <c:v>17.982837677001953</c:v>
                </c:pt>
                <c:pt idx="2319">
                  <c:v>17.996835708618164</c:v>
                </c:pt>
                <c:pt idx="2320">
                  <c:v>18.010839462280273</c:v>
                </c:pt>
                <c:pt idx="2321">
                  <c:v>18.024845123291016</c:v>
                </c:pt>
                <c:pt idx="2322">
                  <c:v>18.038852691650391</c:v>
                </c:pt>
                <c:pt idx="2323">
                  <c:v>18.052865982055664</c:v>
                </c:pt>
                <c:pt idx="2324">
                  <c:v>18.066883087158203</c:v>
                </c:pt>
                <c:pt idx="2325">
                  <c:v>18.080902099609375</c:v>
                </c:pt>
                <c:pt idx="2326">
                  <c:v>18.094926834106445</c:v>
                </c:pt>
                <c:pt idx="2327">
                  <c:v>18.108953475952148</c:v>
                </c:pt>
                <c:pt idx="2328">
                  <c:v>18.122983932495117</c:v>
                </c:pt>
                <c:pt idx="2329">
                  <c:v>18.137018203735352</c:v>
                </c:pt>
                <c:pt idx="2330">
                  <c:v>18.151054382324219</c:v>
                </c:pt>
                <c:pt idx="2331">
                  <c:v>18.165094375610352</c:v>
                </c:pt>
                <c:pt idx="2332">
                  <c:v>18.17913818359375</c:v>
                </c:pt>
                <c:pt idx="2333">
                  <c:v>18.193185806274414</c:v>
                </c:pt>
                <c:pt idx="2334">
                  <c:v>18.207237243652344</c:v>
                </c:pt>
                <c:pt idx="2335">
                  <c:v>18.221290588378906</c:v>
                </c:pt>
                <c:pt idx="2336">
                  <c:v>18.235347747802734</c:v>
                </c:pt>
                <c:pt idx="2337">
                  <c:v>18.249410629272461</c:v>
                </c:pt>
                <c:pt idx="2338">
                  <c:v>18.26347541809082</c:v>
                </c:pt>
                <c:pt idx="2339">
                  <c:v>18.277542114257813</c:v>
                </c:pt>
                <c:pt idx="2340">
                  <c:v>18.291614532470703</c:v>
                </c:pt>
                <c:pt idx="2341">
                  <c:v>18.305688858032227</c:v>
                </c:pt>
                <c:pt idx="2342">
                  <c:v>18.319766998291016</c:v>
                </c:pt>
                <c:pt idx="2343">
                  <c:v>18.33384895324707</c:v>
                </c:pt>
                <c:pt idx="2344">
                  <c:v>18.347934722900391</c:v>
                </c:pt>
                <c:pt idx="2345">
                  <c:v>18.362024307250977</c:v>
                </c:pt>
                <c:pt idx="2346">
                  <c:v>18.376115798950195</c:v>
                </c:pt>
                <c:pt idx="2347">
                  <c:v>18.39021110534668</c:v>
                </c:pt>
                <c:pt idx="2348">
                  <c:v>18.40431022644043</c:v>
                </c:pt>
                <c:pt idx="2349">
                  <c:v>18.418413162231445</c:v>
                </c:pt>
                <c:pt idx="2350">
                  <c:v>18.432518005371094</c:v>
                </c:pt>
                <c:pt idx="2351">
                  <c:v>18.446628570556641</c:v>
                </c:pt>
                <c:pt idx="2352">
                  <c:v>18.46074104309082</c:v>
                </c:pt>
                <c:pt idx="2353">
                  <c:v>18.474857330322266</c:v>
                </c:pt>
                <c:pt idx="2354">
                  <c:v>18.488975524902344</c:v>
                </c:pt>
                <c:pt idx="2355">
                  <c:v>18.50309944152832</c:v>
                </c:pt>
                <c:pt idx="2356">
                  <c:v>18.51722526550293</c:v>
                </c:pt>
                <c:pt idx="2357">
                  <c:v>18.531356811523438</c:v>
                </c:pt>
                <c:pt idx="2358">
                  <c:v>18.545488357543945</c:v>
                </c:pt>
                <c:pt idx="2359">
                  <c:v>18.559625625610352</c:v>
                </c:pt>
                <c:pt idx="2360">
                  <c:v>18.573766708374023</c:v>
                </c:pt>
                <c:pt idx="2361">
                  <c:v>18.587909698486328</c:v>
                </c:pt>
                <c:pt idx="2362">
                  <c:v>18.602056503295898</c:v>
                </c:pt>
                <c:pt idx="2363">
                  <c:v>18.616207122802734</c:v>
                </c:pt>
                <c:pt idx="2364">
                  <c:v>18.630361557006836</c:v>
                </c:pt>
                <c:pt idx="2365">
                  <c:v>18.64451789855957</c:v>
                </c:pt>
                <c:pt idx="2366">
                  <c:v>18.658679962158203</c:v>
                </c:pt>
                <c:pt idx="2367">
                  <c:v>18.672843933105469</c:v>
                </c:pt>
                <c:pt idx="2368">
                  <c:v>18.68701171875</c:v>
                </c:pt>
                <c:pt idx="2369">
                  <c:v>18.701181411743164</c:v>
                </c:pt>
                <c:pt idx="2370">
                  <c:v>18.715356826782227</c:v>
                </c:pt>
                <c:pt idx="2371">
                  <c:v>18.729534149169922</c:v>
                </c:pt>
                <c:pt idx="2372">
                  <c:v>18.743715286254883</c:v>
                </c:pt>
                <c:pt idx="2373">
                  <c:v>18.757900238037109</c:v>
                </c:pt>
                <c:pt idx="2374">
                  <c:v>18.772089004516602</c:v>
                </c:pt>
                <c:pt idx="2375">
                  <c:v>18.786281585693359</c:v>
                </c:pt>
                <c:pt idx="2376">
                  <c:v>18.80047607421875</c:v>
                </c:pt>
                <c:pt idx="2377">
                  <c:v>18.814674377441406</c:v>
                </c:pt>
                <c:pt idx="2378">
                  <c:v>18.828876495361328</c:v>
                </c:pt>
                <c:pt idx="2379">
                  <c:v>18.843082427978516</c:v>
                </c:pt>
                <c:pt idx="2380">
                  <c:v>18.857290267944336</c:v>
                </c:pt>
                <c:pt idx="2381">
                  <c:v>18.871501922607422</c:v>
                </c:pt>
                <c:pt idx="2382">
                  <c:v>18.885719299316406</c:v>
                </c:pt>
                <c:pt idx="2383">
                  <c:v>18.899936676025391</c:v>
                </c:pt>
                <c:pt idx="2384">
                  <c:v>18.914159774780273</c:v>
                </c:pt>
                <c:pt idx="2385">
                  <c:v>18.928386688232422</c:v>
                </c:pt>
                <c:pt idx="2386">
                  <c:v>18.942615509033203</c:v>
                </c:pt>
                <c:pt idx="2387">
                  <c:v>18.95684814453125</c:v>
                </c:pt>
                <c:pt idx="2388">
                  <c:v>18.971084594726563</c:v>
                </c:pt>
                <c:pt idx="2389">
                  <c:v>18.985324859619141</c:v>
                </c:pt>
                <c:pt idx="2390">
                  <c:v>18.999568939208984</c:v>
                </c:pt>
                <c:pt idx="2391">
                  <c:v>19.013814926147461</c:v>
                </c:pt>
                <c:pt idx="2392">
                  <c:v>19.028064727783203</c:v>
                </c:pt>
                <c:pt idx="2393">
                  <c:v>19.042318344116211</c:v>
                </c:pt>
                <c:pt idx="2394">
                  <c:v>19.056575775146484</c:v>
                </c:pt>
                <c:pt idx="2395">
                  <c:v>19.070835113525391</c:v>
                </c:pt>
                <c:pt idx="2396">
                  <c:v>19.085098266601563</c:v>
                </c:pt>
                <c:pt idx="2397">
                  <c:v>19.099365234375</c:v>
                </c:pt>
                <c:pt idx="2398">
                  <c:v>19.113636016845703</c:v>
                </c:pt>
                <c:pt idx="2399">
                  <c:v>19.127910614013672</c:v>
                </c:pt>
                <c:pt idx="2400">
                  <c:v>19.142187118530273</c:v>
                </c:pt>
                <c:pt idx="2401">
                  <c:v>19.156467437744141</c:v>
                </c:pt>
                <c:pt idx="2402">
                  <c:v>19.170751571655273</c:v>
                </c:pt>
                <c:pt idx="2403">
                  <c:v>19.185039520263672</c:v>
                </c:pt>
                <c:pt idx="2404">
                  <c:v>19.199331283569336</c:v>
                </c:pt>
                <c:pt idx="2405">
                  <c:v>19.213626861572266</c:v>
                </c:pt>
                <c:pt idx="2406">
                  <c:v>19.227924346923828</c:v>
                </c:pt>
                <c:pt idx="2407">
                  <c:v>19.242225646972656</c:v>
                </c:pt>
                <c:pt idx="2408">
                  <c:v>19.25653076171875</c:v>
                </c:pt>
                <c:pt idx="2409">
                  <c:v>19.270839691162109</c:v>
                </c:pt>
                <c:pt idx="2410">
                  <c:v>19.285150527954102</c:v>
                </c:pt>
                <c:pt idx="2411">
                  <c:v>19.299467086791992</c:v>
                </c:pt>
                <c:pt idx="2412">
                  <c:v>19.313785552978516</c:v>
                </c:pt>
                <c:pt idx="2413">
                  <c:v>19.328105926513672</c:v>
                </c:pt>
                <c:pt idx="2414">
                  <c:v>19.342433929443359</c:v>
                </c:pt>
                <c:pt idx="2415">
                  <c:v>19.356761932373047</c:v>
                </c:pt>
                <c:pt idx="2416">
                  <c:v>19.37109375</c:v>
                </c:pt>
                <c:pt idx="2417">
                  <c:v>19.385431289672852</c:v>
                </c:pt>
                <c:pt idx="2418">
                  <c:v>19.399770736694336</c:v>
                </c:pt>
                <c:pt idx="2419">
                  <c:v>19.414115905761719</c:v>
                </c:pt>
                <c:pt idx="2420">
                  <c:v>19.428461074829102</c:v>
                </c:pt>
                <c:pt idx="2421">
                  <c:v>19.44281005859375</c:v>
                </c:pt>
                <c:pt idx="2422">
                  <c:v>19.457162857055664</c:v>
                </c:pt>
                <c:pt idx="2423">
                  <c:v>19.471519470214844</c:v>
                </c:pt>
                <c:pt idx="2424">
                  <c:v>19.485881805419922</c:v>
                </c:pt>
                <c:pt idx="2425">
                  <c:v>19.500244140625</c:v>
                </c:pt>
                <c:pt idx="2426">
                  <c:v>19.514612197875977</c:v>
                </c:pt>
                <c:pt idx="2427">
                  <c:v>19.528982162475586</c:v>
                </c:pt>
                <c:pt idx="2428">
                  <c:v>19.543357849121094</c:v>
                </c:pt>
                <c:pt idx="2429">
                  <c:v>19.557735443115234</c:v>
                </c:pt>
                <c:pt idx="2430">
                  <c:v>19.572116851806641</c:v>
                </c:pt>
                <c:pt idx="2431">
                  <c:v>19.586502075195313</c:v>
                </c:pt>
                <c:pt idx="2432">
                  <c:v>19.60089111328125</c:v>
                </c:pt>
                <c:pt idx="2433">
                  <c:v>19.615283966064453</c:v>
                </c:pt>
                <c:pt idx="2434">
                  <c:v>19.629678726196289</c:v>
                </c:pt>
                <c:pt idx="2435">
                  <c:v>19.644079208374023</c:v>
                </c:pt>
                <c:pt idx="2436">
                  <c:v>19.658483505249023</c:v>
                </c:pt>
                <c:pt idx="2437">
                  <c:v>19.672887802124023</c:v>
                </c:pt>
                <c:pt idx="2438">
                  <c:v>19.687297821044922</c:v>
                </c:pt>
                <c:pt idx="2439">
                  <c:v>19.701709747314453</c:v>
                </c:pt>
                <c:pt idx="2440">
                  <c:v>19.716127395629883</c:v>
                </c:pt>
                <c:pt idx="2441">
                  <c:v>19.730546951293945</c:v>
                </c:pt>
                <c:pt idx="2442">
                  <c:v>19.744970321655273</c:v>
                </c:pt>
                <c:pt idx="2443">
                  <c:v>19.759395599365234</c:v>
                </c:pt>
                <c:pt idx="2444">
                  <c:v>19.773826599121094</c:v>
                </c:pt>
                <c:pt idx="2445">
                  <c:v>19.788261413574219</c:v>
                </c:pt>
                <c:pt idx="2446">
                  <c:v>19.802698135375977</c:v>
                </c:pt>
                <c:pt idx="2447">
                  <c:v>19.817140579223633</c:v>
                </c:pt>
                <c:pt idx="2448">
                  <c:v>19.831584930419922</c:v>
                </c:pt>
                <c:pt idx="2449">
                  <c:v>19.846033096313477</c:v>
                </c:pt>
                <c:pt idx="2450">
                  <c:v>19.860485076904297</c:v>
                </c:pt>
                <c:pt idx="2451">
                  <c:v>19.87493896484375</c:v>
                </c:pt>
                <c:pt idx="2452">
                  <c:v>19.889394760131836</c:v>
                </c:pt>
                <c:pt idx="2453">
                  <c:v>19.90385627746582</c:v>
                </c:pt>
                <c:pt idx="2454">
                  <c:v>19.91832160949707</c:v>
                </c:pt>
                <c:pt idx="2455">
                  <c:v>19.932788848876953</c:v>
                </c:pt>
                <c:pt idx="2456">
                  <c:v>19.947261810302734</c:v>
                </c:pt>
                <c:pt idx="2457">
                  <c:v>19.961736679077148</c:v>
                </c:pt>
                <c:pt idx="2458">
                  <c:v>19.976215362548828</c:v>
                </c:pt>
                <c:pt idx="2459">
                  <c:v>19.990697860717773</c:v>
                </c:pt>
                <c:pt idx="2460">
                  <c:v>20.005182266235352</c:v>
                </c:pt>
                <c:pt idx="2461">
                  <c:v>20.019670486450195</c:v>
                </c:pt>
                <c:pt idx="2462">
                  <c:v>20.034162521362305</c:v>
                </c:pt>
                <c:pt idx="2463">
                  <c:v>20.04865837097168</c:v>
                </c:pt>
                <c:pt idx="2464">
                  <c:v>20.06315803527832</c:v>
                </c:pt>
                <c:pt idx="2465">
                  <c:v>20.077659606933594</c:v>
                </c:pt>
                <c:pt idx="2466">
                  <c:v>20.092166900634766</c:v>
                </c:pt>
                <c:pt idx="2467">
                  <c:v>20.106678009033203</c:v>
                </c:pt>
                <c:pt idx="2468">
                  <c:v>20.121191024780273</c:v>
                </c:pt>
                <c:pt idx="2469">
                  <c:v>20.135707855224609</c:v>
                </c:pt>
                <c:pt idx="2470">
                  <c:v>20.150228500366211</c:v>
                </c:pt>
                <c:pt idx="2471">
                  <c:v>20.164752960205078</c:v>
                </c:pt>
                <c:pt idx="2472">
                  <c:v>20.179281234741211</c:v>
                </c:pt>
                <c:pt idx="2473">
                  <c:v>20.193813323974609</c:v>
                </c:pt>
                <c:pt idx="2474">
                  <c:v>20.208347320556641</c:v>
                </c:pt>
                <c:pt idx="2475">
                  <c:v>20.222885131835938</c:v>
                </c:pt>
                <c:pt idx="2476">
                  <c:v>20.2374267578125</c:v>
                </c:pt>
                <c:pt idx="2477">
                  <c:v>20.251974105834961</c:v>
                </c:pt>
                <c:pt idx="2478">
                  <c:v>20.266525268554688</c:v>
                </c:pt>
                <c:pt idx="2479">
                  <c:v>20.281076431274414</c:v>
                </c:pt>
                <c:pt idx="2480">
                  <c:v>20.295631408691406</c:v>
                </c:pt>
                <c:pt idx="2481">
                  <c:v>20.310192108154297</c:v>
                </c:pt>
                <c:pt idx="2482">
                  <c:v>20.32475471496582</c:v>
                </c:pt>
                <c:pt idx="2483">
                  <c:v>20.339321136474609</c:v>
                </c:pt>
                <c:pt idx="2484">
                  <c:v>20.353891372680664</c:v>
                </c:pt>
                <c:pt idx="2485">
                  <c:v>20.368465423583984</c:v>
                </c:pt>
                <c:pt idx="2486">
                  <c:v>20.38304328918457</c:v>
                </c:pt>
                <c:pt idx="2487">
                  <c:v>20.397624969482422</c:v>
                </c:pt>
                <c:pt idx="2488">
                  <c:v>20.412208557128906</c:v>
                </c:pt>
                <c:pt idx="2489">
                  <c:v>20.426797866821289</c:v>
                </c:pt>
                <c:pt idx="2490">
                  <c:v>20.441389083862305</c:v>
                </c:pt>
                <c:pt idx="2491">
                  <c:v>20.455982208251953</c:v>
                </c:pt>
                <c:pt idx="2492">
                  <c:v>20.470579147338867</c:v>
                </c:pt>
                <c:pt idx="2493">
                  <c:v>20.485183715820313</c:v>
                </c:pt>
                <c:pt idx="2494">
                  <c:v>20.499788284301758</c:v>
                </c:pt>
                <c:pt idx="2495">
                  <c:v>20.514394760131836</c:v>
                </c:pt>
                <c:pt idx="2496">
                  <c:v>20.52900505065918</c:v>
                </c:pt>
                <c:pt idx="2497">
                  <c:v>20.543622970581055</c:v>
                </c:pt>
                <c:pt idx="2498">
                  <c:v>20.55824089050293</c:v>
                </c:pt>
                <c:pt idx="2499">
                  <c:v>20.57286262512207</c:v>
                </c:pt>
                <c:pt idx="2500">
                  <c:v>20.587488174438477</c:v>
                </c:pt>
                <c:pt idx="2501">
                  <c:v>20.602117538452148</c:v>
                </c:pt>
                <c:pt idx="2502">
                  <c:v>20.616748809814453</c:v>
                </c:pt>
                <c:pt idx="2503">
                  <c:v>20.631383895874023</c:v>
                </c:pt>
                <c:pt idx="2504">
                  <c:v>20.646020889282227</c:v>
                </c:pt>
                <c:pt idx="2505">
                  <c:v>20.660663604736328</c:v>
                </c:pt>
                <c:pt idx="2506">
                  <c:v>20.675308227539063</c:v>
                </c:pt>
                <c:pt idx="2507">
                  <c:v>20.689958572387695</c:v>
                </c:pt>
                <c:pt idx="2508">
                  <c:v>20.704610824584961</c:v>
                </c:pt>
                <c:pt idx="2509">
                  <c:v>20.719270706176758</c:v>
                </c:pt>
                <c:pt idx="2510">
                  <c:v>20.733930587768555</c:v>
                </c:pt>
                <c:pt idx="2511">
                  <c:v>20.748592376708984</c:v>
                </c:pt>
                <c:pt idx="2512">
                  <c:v>20.763259887695313</c:v>
                </c:pt>
                <c:pt idx="2513">
                  <c:v>20.777933120727539</c:v>
                </c:pt>
                <c:pt idx="2514">
                  <c:v>20.792606353759766</c:v>
                </c:pt>
                <c:pt idx="2515">
                  <c:v>20.807283401489258</c:v>
                </c:pt>
                <c:pt idx="2516">
                  <c:v>20.821964263916016</c:v>
                </c:pt>
                <c:pt idx="2517">
                  <c:v>20.836650848388672</c:v>
                </c:pt>
                <c:pt idx="2518">
                  <c:v>20.851337432861328</c:v>
                </c:pt>
                <c:pt idx="2519">
                  <c:v>20.866029739379883</c:v>
                </c:pt>
                <c:pt idx="2520">
                  <c:v>20.88072395324707</c:v>
                </c:pt>
                <c:pt idx="2521">
                  <c:v>20.895421981811523</c:v>
                </c:pt>
                <c:pt idx="2522">
                  <c:v>20.910123825073242</c:v>
                </c:pt>
                <c:pt idx="2523">
                  <c:v>20.924831390380859</c:v>
                </c:pt>
                <c:pt idx="2524">
                  <c:v>20.939540863037109</c:v>
                </c:pt>
                <c:pt idx="2525">
                  <c:v>20.954254150390625</c:v>
                </c:pt>
                <c:pt idx="2526">
                  <c:v>20.968973159790039</c:v>
                </c:pt>
                <c:pt idx="2527">
                  <c:v>20.983695983886719</c:v>
                </c:pt>
                <c:pt idx="2528">
                  <c:v>20.998420715332031</c:v>
                </c:pt>
                <c:pt idx="2529">
                  <c:v>21.013147354125977</c:v>
                </c:pt>
                <c:pt idx="2530">
                  <c:v>21.027877807617188</c:v>
                </c:pt>
                <c:pt idx="2531">
                  <c:v>21.04261589050293</c:v>
                </c:pt>
                <c:pt idx="2532">
                  <c:v>21.057355880737305</c:v>
                </c:pt>
                <c:pt idx="2533">
                  <c:v>21.072099685668945</c:v>
                </c:pt>
                <c:pt idx="2534">
                  <c:v>21.086847305297852</c:v>
                </c:pt>
                <c:pt idx="2535">
                  <c:v>21.101598739624023</c:v>
                </c:pt>
                <c:pt idx="2536">
                  <c:v>21.116353988647461</c:v>
                </c:pt>
                <c:pt idx="2537">
                  <c:v>21.131111145019531</c:v>
                </c:pt>
                <c:pt idx="2538">
                  <c:v>21.1458740234375</c:v>
                </c:pt>
                <c:pt idx="2539">
                  <c:v>21.160640716552734</c:v>
                </c:pt>
                <c:pt idx="2540">
                  <c:v>21.175407409667969</c:v>
                </c:pt>
                <c:pt idx="2541">
                  <c:v>21.190177917480469</c:v>
                </c:pt>
                <c:pt idx="2542">
                  <c:v>21.2049560546875</c:v>
                </c:pt>
                <c:pt idx="2543">
                  <c:v>21.219736099243164</c:v>
                </c:pt>
                <c:pt idx="2544">
                  <c:v>21.234521865844727</c:v>
                </c:pt>
                <c:pt idx="2545">
                  <c:v>21.249309539794922</c:v>
                </c:pt>
                <c:pt idx="2546">
                  <c:v>21.264102935791016</c:v>
                </c:pt>
                <c:pt idx="2547">
                  <c:v>21.278898239135742</c:v>
                </c:pt>
                <c:pt idx="2548">
                  <c:v>21.293697357177734</c:v>
                </c:pt>
                <c:pt idx="2549">
                  <c:v>21.308496475219727</c:v>
                </c:pt>
                <c:pt idx="2550">
                  <c:v>21.323301315307617</c:v>
                </c:pt>
                <c:pt idx="2551">
                  <c:v>21.338108062744141</c:v>
                </c:pt>
                <c:pt idx="2552">
                  <c:v>21.352920532226563</c:v>
                </c:pt>
                <c:pt idx="2553">
                  <c:v>21.36773681640625</c:v>
                </c:pt>
                <c:pt idx="2554">
                  <c:v>21.382558822631836</c:v>
                </c:pt>
                <c:pt idx="2555">
                  <c:v>21.397378921508789</c:v>
                </c:pt>
                <c:pt idx="2556">
                  <c:v>21.412204742431641</c:v>
                </c:pt>
                <c:pt idx="2557">
                  <c:v>21.427034378051758</c:v>
                </c:pt>
                <c:pt idx="2558">
                  <c:v>21.441869735717773</c:v>
                </c:pt>
                <c:pt idx="2559">
                  <c:v>21.456707000732422</c:v>
                </c:pt>
                <c:pt idx="2560">
                  <c:v>21.471546173095703</c:v>
                </c:pt>
                <c:pt idx="2561">
                  <c:v>21.48638916015625</c:v>
                </c:pt>
                <c:pt idx="2562">
                  <c:v>21.501237869262695</c:v>
                </c:pt>
                <c:pt idx="2563">
                  <c:v>21.516088485717773</c:v>
                </c:pt>
                <c:pt idx="2564">
                  <c:v>21.53094482421875</c:v>
                </c:pt>
                <c:pt idx="2565">
                  <c:v>21.545803070068359</c:v>
                </c:pt>
                <c:pt idx="2566">
                  <c:v>21.560665130615234</c:v>
                </c:pt>
                <c:pt idx="2567">
                  <c:v>21.575529098510742</c:v>
                </c:pt>
                <c:pt idx="2568">
                  <c:v>21.590400695800781</c:v>
                </c:pt>
                <c:pt idx="2569">
                  <c:v>21.60527229309082</c:v>
                </c:pt>
                <c:pt idx="2570">
                  <c:v>21.620147705078125</c:v>
                </c:pt>
                <c:pt idx="2571">
                  <c:v>21.635028839111328</c:v>
                </c:pt>
                <c:pt idx="2572">
                  <c:v>21.64991569519043</c:v>
                </c:pt>
                <c:pt idx="2573">
                  <c:v>21.664804458618164</c:v>
                </c:pt>
                <c:pt idx="2574">
                  <c:v>21.67970085144043</c:v>
                </c:pt>
                <c:pt idx="2575">
                  <c:v>21.69459342956543</c:v>
                </c:pt>
                <c:pt idx="2576">
                  <c:v>21.709497451782227</c:v>
                </c:pt>
                <c:pt idx="2577">
                  <c:v>21.724399566650391</c:v>
                </c:pt>
                <c:pt idx="2578">
                  <c:v>21.739311218261719</c:v>
                </c:pt>
                <c:pt idx="2579">
                  <c:v>21.754222869873047</c:v>
                </c:pt>
                <c:pt idx="2580">
                  <c:v>21.769144058227539</c:v>
                </c:pt>
                <c:pt idx="2581">
                  <c:v>21.784063339233398</c:v>
                </c:pt>
                <c:pt idx="2582">
                  <c:v>21.798988342285156</c:v>
                </c:pt>
                <c:pt idx="2583">
                  <c:v>21.81391716003418</c:v>
                </c:pt>
                <c:pt idx="2584">
                  <c:v>21.828853607177734</c:v>
                </c:pt>
                <c:pt idx="2585">
                  <c:v>21.843788146972656</c:v>
                </c:pt>
                <c:pt idx="2586">
                  <c:v>21.858728408813477</c:v>
                </c:pt>
                <c:pt idx="2587">
                  <c:v>21.873672485351563</c:v>
                </c:pt>
                <c:pt idx="2588">
                  <c:v>21.888620376586914</c:v>
                </c:pt>
                <c:pt idx="2589">
                  <c:v>21.903568267822266</c:v>
                </c:pt>
                <c:pt idx="2590">
                  <c:v>21.918523788452148</c:v>
                </c:pt>
                <c:pt idx="2591">
                  <c:v>21.933481216430664</c:v>
                </c:pt>
                <c:pt idx="2592">
                  <c:v>21.948446273803711</c:v>
                </c:pt>
                <c:pt idx="2593">
                  <c:v>21.963411331176758</c:v>
                </c:pt>
                <c:pt idx="2594">
                  <c:v>21.97838020324707</c:v>
                </c:pt>
                <c:pt idx="2595">
                  <c:v>21.993356704711914</c:v>
                </c:pt>
                <c:pt idx="2596">
                  <c:v>22.008335113525391</c:v>
                </c:pt>
                <c:pt idx="2597">
                  <c:v>22.0233154296875</c:v>
                </c:pt>
                <c:pt idx="2598">
                  <c:v>22.038301467895508</c:v>
                </c:pt>
                <c:pt idx="2599">
                  <c:v>22.053287506103516</c:v>
                </c:pt>
                <c:pt idx="2600">
                  <c:v>22.068281173706055</c:v>
                </c:pt>
                <c:pt idx="2601">
                  <c:v>22.083274841308594</c:v>
                </c:pt>
                <c:pt idx="2602">
                  <c:v>22.098270416259766</c:v>
                </c:pt>
                <c:pt idx="2603">
                  <c:v>22.113271713256836</c:v>
                </c:pt>
                <c:pt idx="2604">
                  <c:v>22.128278732299805</c:v>
                </c:pt>
                <c:pt idx="2605">
                  <c:v>22.143287658691406</c:v>
                </c:pt>
                <c:pt idx="2606">
                  <c:v>22.158302307128906</c:v>
                </c:pt>
                <c:pt idx="2607">
                  <c:v>22.173320770263672</c:v>
                </c:pt>
                <c:pt idx="2608">
                  <c:v>22.188339233398438</c:v>
                </c:pt>
                <c:pt idx="2609">
                  <c:v>22.203365325927734</c:v>
                </c:pt>
                <c:pt idx="2610">
                  <c:v>22.218391418457031</c:v>
                </c:pt>
                <c:pt idx="2611">
                  <c:v>22.233425140380859</c:v>
                </c:pt>
                <c:pt idx="2612">
                  <c:v>22.24846076965332</c:v>
                </c:pt>
                <c:pt idx="2613">
                  <c:v>22.263498306274414</c:v>
                </c:pt>
                <c:pt idx="2614">
                  <c:v>22.278537750244141</c:v>
                </c:pt>
                <c:pt idx="2615">
                  <c:v>22.293582916259766</c:v>
                </c:pt>
                <c:pt idx="2616">
                  <c:v>22.308633804321289</c:v>
                </c:pt>
                <c:pt idx="2617">
                  <c:v>22.323686599731445</c:v>
                </c:pt>
                <c:pt idx="2618">
                  <c:v>22.338741302490234</c:v>
                </c:pt>
                <c:pt idx="2619">
                  <c:v>22.353801727294922</c:v>
                </c:pt>
                <c:pt idx="2620">
                  <c:v>22.368865966796875</c:v>
                </c:pt>
                <c:pt idx="2621">
                  <c:v>22.383937835693359</c:v>
                </c:pt>
                <c:pt idx="2622">
                  <c:v>22.399007797241211</c:v>
                </c:pt>
                <c:pt idx="2623">
                  <c:v>22.414085388183594</c:v>
                </c:pt>
                <c:pt idx="2624">
                  <c:v>22.429162979125977</c:v>
                </c:pt>
                <c:pt idx="2625">
                  <c:v>22.444246292114258</c:v>
                </c:pt>
                <c:pt idx="2626">
                  <c:v>22.459331512451172</c:v>
                </c:pt>
                <c:pt idx="2627">
                  <c:v>22.474422454833984</c:v>
                </c:pt>
                <c:pt idx="2628">
                  <c:v>22.489517211914063</c:v>
                </c:pt>
                <c:pt idx="2629">
                  <c:v>22.504615783691406</c:v>
                </c:pt>
                <c:pt idx="2630">
                  <c:v>22.519718170166016</c:v>
                </c:pt>
                <c:pt idx="2631">
                  <c:v>22.534822463989258</c:v>
                </c:pt>
                <c:pt idx="2632">
                  <c:v>22.549930572509766</c:v>
                </c:pt>
                <c:pt idx="2633">
                  <c:v>22.565044403076172</c:v>
                </c:pt>
                <c:pt idx="2634">
                  <c:v>22.580158233642578</c:v>
                </c:pt>
                <c:pt idx="2635">
                  <c:v>22.595277786254883</c:v>
                </c:pt>
                <c:pt idx="2636">
                  <c:v>22.61039924621582</c:v>
                </c:pt>
                <c:pt idx="2637">
                  <c:v>22.625526428222656</c:v>
                </c:pt>
                <c:pt idx="2638">
                  <c:v>22.640655517578125</c:v>
                </c:pt>
                <c:pt idx="2639">
                  <c:v>22.655788421630859</c:v>
                </c:pt>
                <c:pt idx="2640">
                  <c:v>22.670925140380859</c:v>
                </c:pt>
                <c:pt idx="2641">
                  <c:v>22.686065673828125</c:v>
                </c:pt>
                <c:pt idx="2642">
                  <c:v>22.701210021972656</c:v>
                </c:pt>
                <c:pt idx="2643">
                  <c:v>22.716358184814453</c:v>
                </c:pt>
                <c:pt idx="2644">
                  <c:v>22.73150634765625</c:v>
                </c:pt>
                <c:pt idx="2645">
                  <c:v>22.746662139892578</c:v>
                </c:pt>
                <c:pt idx="2646">
                  <c:v>22.761819839477539</c:v>
                </c:pt>
                <c:pt idx="2647">
                  <c:v>22.776983261108398</c:v>
                </c:pt>
                <c:pt idx="2648">
                  <c:v>22.792146682739258</c:v>
                </c:pt>
                <c:pt idx="2649">
                  <c:v>22.807315826416016</c:v>
                </c:pt>
                <c:pt idx="2650">
                  <c:v>22.822484970092773</c:v>
                </c:pt>
                <c:pt idx="2651">
                  <c:v>22.83765983581543</c:v>
                </c:pt>
                <c:pt idx="2652">
                  <c:v>22.852838516235352</c:v>
                </c:pt>
                <c:pt idx="2653">
                  <c:v>22.868021011352539</c:v>
                </c:pt>
                <c:pt idx="2654">
                  <c:v>22.883205413818359</c:v>
                </c:pt>
                <c:pt idx="2655">
                  <c:v>22.898393630981445</c:v>
                </c:pt>
                <c:pt idx="2656">
                  <c:v>22.913585662841797</c:v>
                </c:pt>
                <c:pt idx="2657">
                  <c:v>22.928781509399414</c:v>
                </c:pt>
                <c:pt idx="2658">
                  <c:v>22.943981170654297</c:v>
                </c:pt>
                <c:pt idx="2659">
                  <c:v>22.959182739257813</c:v>
                </c:pt>
                <c:pt idx="2660">
                  <c:v>22.974390029907227</c:v>
                </c:pt>
                <c:pt idx="2661">
                  <c:v>22.989599227905273</c:v>
                </c:pt>
                <c:pt idx="2662">
                  <c:v>23.004812240600586</c:v>
                </c:pt>
                <c:pt idx="2663">
                  <c:v>23.020029067993164</c:v>
                </c:pt>
                <c:pt idx="2664">
                  <c:v>23.035247802734375</c:v>
                </c:pt>
                <c:pt idx="2665">
                  <c:v>23.050472259521484</c:v>
                </c:pt>
                <c:pt idx="2666">
                  <c:v>23.065698623657227</c:v>
                </c:pt>
                <c:pt idx="2667">
                  <c:v>23.080930709838867</c:v>
                </c:pt>
                <c:pt idx="2668">
                  <c:v>23.096162796020508</c:v>
                </c:pt>
                <c:pt idx="2669">
                  <c:v>23.111400604248047</c:v>
                </c:pt>
                <c:pt idx="2670">
                  <c:v>23.126640319824219</c:v>
                </c:pt>
                <c:pt idx="2671">
                  <c:v>23.141883850097656</c:v>
                </c:pt>
                <c:pt idx="2672">
                  <c:v>23.157131195068359</c:v>
                </c:pt>
                <c:pt idx="2673">
                  <c:v>23.172382354736328</c:v>
                </c:pt>
                <c:pt idx="2674">
                  <c:v>23.187637329101563</c:v>
                </c:pt>
                <c:pt idx="2675">
                  <c:v>23.202896118164063</c:v>
                </c:pt>
                <c:pt idx="2676">
                  <c:v>23.218156814575195</c:v>
                </c:pt>
                <c:pt idx="2677">
                  <c:v>23.233421325683594</c:v>
                </c:pt>
                <c:pt idx="2678">
                  <c:v>23.248689651489258</c:v>
                </c:pt>
                <c:pt idx="2679">
                  <c:v>23.263961791992188</c:v>
                </c:pt>
                <c:pt idx="2680">
                  <c:v>23.27923583984375</c:v>
                </c:pt>
                <c:pt idx="2681">
                  <c:v>23.294515609741211</c:v>
                </c:pt>
                <c:pt idx="2682">
                  <c:v>23.309797286987305</c:v>
                </c:pt>
                <c:pt idx="2683">
                  <c:v>23.325080871582031</c:v>
                </c:pt>
                <c:pt idx="2684">
                  <c:v>23.340370178222656</c:v>
                </c:pt>
                <c:pt idx="2685">
                  <c:v>23.355663299560547</c:v>
                </c:pt>
                <c:pt idx="2686">
                  <c:v>23.37095832824707</c:v>
                </c:pt>
                <c:pt idx="2687">
                  <c:v>23.386257171630859</c:v>
                </c:pt>
                <c:pt idx="2688">
                  <c:v>23.401557922363281</c:v>
                </c:pt>
                <c:pt idx="2689">
                  <c:v>23.416864395141602</c:v>
                </c:pt>
                <c:pt idx="2690">
                  <c:v>23.432172775268555</c:v>
                </c:pt>
                <c:pt idx="2691">
                  <c:v>23.447486877441406</c:v>
                </c:pt>
                <c:pt idx="2692">
                  <c:v>23.462800979614258</c:v>
                </c:pt>
                <c:pt idx="2693">
                  <c:v>23.478120803833008</c:v>
                </c:pt>
                <c:pt idx="2694">
                  <c:v>23.493444442749023</c:v>
                </c:pt>
                <c:pt idx="2695">
                  <c:v>23.508769989013672</c:v>
                </c:pt>
                <c:pt idx="2696">
                  <c:v>23.524099349975586</c:v>
                </c:pt>
                <c:pt idx="2697">
                  <c:v>23.539432525634766</c:v>
                </c:pt>
                <c:pt idx="2698">
                  <c:v>23.554769515991211</c:v>
                </c:pt>
                <c:pt idx="2699">
                  <c:v>23.570108413696289</c:v>
                </c:pt>
                <c:pt idx="2700">
                  <c:v>23.585451126098633</c:v>
                </c:pt>
                <c:pt idx="2701">
                  <c:v>23.600797653198242</c:v>
                </c:pt>
                <c:pt idx="2702">
                  <c:v>23.616147994995117</c:v>
                </c:pt>
                <c:pt idx="2703">
                  <c:v>23.631502151489258</c:v>
                </c:pt>
                <c:pt idx="2704">
                  <c:v>23.646858215332031</c:v>
                </c:pt>
                <c:pt idx="2705">
                  <c:v>23.66221809387207</c:v>
                </c:pt>
                <c:pt idx="2706">
                  <c:v>23.677581787109375</c:v>
                </c:pt>
                <c:pt idx="2707">
                  <c:v>23.692949295043945</c:v>
                </c:pt>
                <c:pt idx="2708">
                  <c:v>23.708318710327148</c:v>
                </c:pt>
                <c:pt idx="2709">
                  <c:v>23.72369384765625</c:v>
                </c:pt>
                <c:pt idx="2710">
                  <c:v>23.739070892333984</c:v>
                </c:pt>
                <c:pt idx="2711">
                  <c:v>23.754449844360352</c:v>
                </c:pt>
                <c:pt idx="2712">
                  <c:v>23.769834518432617</c:v>
                </c:pt>
                <c:pt idx="2713">
                  <c:v>23.785223007202148</c:v>
                </c:pt>
                <c:pt idx="2714">
                  <c:v>23.800613403320313</c:v>
                </c:pt>
                <c:pt idx="2715">
                  <c:v>23.816007614135742</c:v>
                </c:pt>
                <c:pt idx="2716">
                  <c:v>23.831405639648438</c:v>
                </c:pt>
                <c:pt idx="2717">
                  <c:v>23.846805572509766</c:v>
                </c:pt>
                <c:pt idx="2718">
                  <c:v>23.862209320068359</c:v>
                </c:pt>
                <c:pt idx="2719">
                  <c:v>23.877618789672852</c:v>
                </c:pt>
                <c:pt idx="2720">
                  <c:v>23.893030166625977</c:v>
                </c:pt>
                <c:pt idx="2721">
                  <c:v>23.908443450927734</c:v>
                </c:pt>
                <c:pt idx="2722">
                  <c:v>23.923862457275391</c:v>
                </c:pt>
                <c:pt idx="2723">
                  <c:v>23.93928337097168</c:v>
                </c:pt>
                <c:pt idx="2724">
                  <c:v>23.954708099365234</c:v>
                </c:pt>
                <c:pt idx="2725">
                  <c:v>23.970136642456055</c:v>
                </c:pt>
                <c:pt idx="2726">
                  <c:v>23.985569000244141</c:v>
                </c:pt>
                <c:pt idx="2727">
                  <c:v>24.001003265380859</c:v>
                </c:pt>
                <c:pt idx="2728">
                  <c:v>24.016441345214844</c:v>
                </c:pt>
                <c:pt idx="2729">
                  <c:v>24.031883239746094</c:v>
                </c:pt>
                <c:pt idx="2730">
                  <c:v>24.047328948974609</c:v>
                </c:pt>
                <c:pt idx="2731">
                  <c:v>24.062776565551758</c:v>
                </c:pt>
                <c:pt idx="2732">
                  <c:v>24.078229904174805</c:v>
                </c:pt>
                <c:pt idx="2733">
                  <c:v>24.093685150146484</c:v>
                </c:pt>
                <c:pt idx="2734">
                  <c:v>24.10914421081543</c:v>
                </c:pt>
                <c:pt idx="2735">
                  <c:v>24.124605178833008</c:v>
                </c:pt>
                <c:pt idx="2736">
                  <c:v>24.140071868896484</c:v>
                </c:pt>
                <c:pt idx="2737">
                  <c:v>24.155540466308594</c:v>
                </c:pt>
                <c:pt idx="2738">
                  <c:v>24.171012878417969</c:v>
                </c:pt>
                <c:pt idx="2739">
                  <c:v>24.186489105224609</c:v>
                </c:pt>
                <c:pt idx="2740">
                  <c:v>24.201969146728516</c:v>
                </c:pt>
                <c:pt idx="2741">
                  <c:v>24.217451095581055</c:v>
                </c:pt>
                <c:pt idx="2742">
                  <c:v>24.232936859130859</c:v>
                </c:pt>
                <c:pt idx="2743">
                  <c:v>24.24842643737793</c:v>
                </c:pt>
                <c:pt idx="2744">
                  <c:v>24.263921737670898</c:v>
                </c:pt>
                <c:pt idx="2745">
                  <c:v>24.2794189453125</c:v>
                </c:pt>
                <c:pt idx="2746">
                  <c:v>24.294918060302734</c:v>
                </c:pt>
                <c:pt idx="2747">
                  <c:v>24.310420989990234</c:v>
                </c:pt>
                <c:pt idx="2748">
                  <c:v>24.325927734375</c:v>
                </c:pt>
                <c:pt idx="2749">
                  <c:v>24.341438293457031</c:v>
                </c:pt>
                <c:pt idx="2750">
                  <c:v>24.356950759887695</c:v>
                </c:pt>
                <c:pt idx="2751">
                  <c:v>24.372467041015625</c:v>
                </c:pt>
                <c:pt idx="2752">
                  <c:v>24.387989044189453</c:v>
                </c:pt>
                <c:pt idx="2753">
                  <c:v>24.403512954711914</c:v>
                </c:pt>
                <c:pt idx="2754">
                  <c:v>24.419040679931641</c:v>
                </c:pt>
                <c:pt idx="2755">
                  <c:v>24.4345703125</c:v>
                </c:pt>
                <c:pt idx="2756">
                  <c:v>24.450105667114258</c:v>
                </c:pt>
                <c:pt idx="2757">
                  <c:v>24.465642929077148</c:v>
                </c:pt>
                <c:pt idx="2758">
                  <c:v>24.481182098388672</c:v>
                </c:pt>
                <c:pt idx="2759">
                  <c:v>24.496726989746094</c:v>
                </c:pt>
                <c:pt idx="2760">
                  <c:v>24.512275695800781</c:v>
                </c:pt>
                <c:pt idx="2761">
                  <c:v>24.527826309204102</c:v>
                </c:pt>
                <c:pt idx="2762">
                  <c:v>24.543380737304688</c:v>
                </c:pt>
                <c:pt idx="2763">
                  <c:v>24.558938980102539</c:v>
                </c:pt>
                <c:pt idx="2764">
                  <c:v>24.574501037597656</c:v>
                </c:pt>
                <c:pt idx="2765">
                  <c:v>24.590065002441406</c:v>
                </c:pt>
                <c:pt idx="2766">
                  <c:v>24.605634689331055</c:v>
                </c:pt>
                <c:pt idx="2767">
                  <c:v>24.621206283569336</c:v>
                </c:pt>
                <c:pt idx="2768">
                  <c:v>24.636783599853516</c:v>
                </c:pt>
                <c:pt idx="2769">
                  <c:v>24.652360916137695</c:v>
                </c:pt>
                <c:pt idx="2770">
                  <c:v>24.667943954467773</c:v>
                </c:pt>
                <c:pt idx="2771">
                  <c:v>24.683528900146484</c:v>
                </c:pt>
                <c:pt idx="2772">
                  <c:v>24.699119567871094</c:v>
                </c:pt>
                <c:pt idx="2773">
                  <c:v>24.714710235595703</c:v>
                </c:pt>
                <c:pt idx="2774">
                  <c:v>24.730306625366211</c:v>
                </c:pt>
                <c:pt idx="2775">
                  <c:v>24.745904922485352</c:v>
                </c:pt>
                <c:pt idx="2776">
                  <c:v>24.761508941650391</c:v>
                </c:pt>
                <c:pt idx="2777">
                  <c:v>24.777114868164063</c:v>
                </c:pt>
                <c:pt idx="2778">
                  <c:v>24.792724609375</c:v>
                </c:pt>
                <c:pt idx="2779">
                  <c:v>24.80833625793457</c:v>
                </c:pt>
                <c:pt idx="2780">
                  <c:v>24.823953628540039</c:v>
                </c:pt>
                <c:pt idx="2781">
                  <c:v>24.839574813842773</c:v>
                </c:pt>
                <c:pt idx="2782">
                  <c:v>24.855197906494141</c:v>
                </c:pt>
                <c:pt idx="2783">
                  <c:v>24.870824813842773</c:v>
                </c:pt>
                <c:pt idx="2784">
                  <c:v>24.886455535888672</c:v>
                </c:pt>
                <c:pt idx="2785">
                  <c:v>24.902088165283203</c:v>
                </c:pt>
                <c:pt idx="2786">
                  <c:v>24.917726516723633</c:v>
                </c:pt>
                <c:pt idx="2787">
                  <c:v>24.933366775512695</c:v>
                </c:pt>
                <c:pt idx="2788">
                  <c:v>24.949012756347656</c:v>
                </c:pt>
                <c:pt idx="2789">
                  <c:v>24.964658737182617</c:v>
                </c:pt>
                <c:pt idx="2790">
                  <c:v>24.980310440063477</c:v>
                </c:pt>
                <c:pt idx="2791">
                  <c:v>24.995965957641602</c:v>
                </c:pt>
                <c:pt idx="2792">
                  <c:v>25.011623382568359</c:v>
                </c:pt>
                <c:pt idx="2793">
                  <c:v>25.027284622192383</c:v>
                </c:pt>
                <c:pt idx="2794">
                  <c:v>25.042951583862305</c:v>
                </c:pt>
                <c:pt idx="2795">
                  <c:v>25.058618545532227</c:v>
                </c:pt>
                <c:pt idx="2796">
                  <c:v>25.074291229248047</c:v>
                </c:pt>
                <c:pt idx="2797">
                  <c:v>25.089967727661133</c:v>
                </c:pt>
                <c:pt idx="2798">
                  <c:v>25.105648040771484</c:v>
                </c:pt>
                <c:pt idx="2799">
                  <c:v>25.121328353881836</c:v>
                </c:pt>
                <c:pt idx="2800">
                  <c:v>25.137016296386719</c:v>
                </c:pt>
                <c:pt idx="2801">
                  <c:v>25.152704238891602</c:v>
                </c:pt>
                <c:pt idx="2802">
                  <c:v>25.168399810791016</c:v>
                </c:pt>
                <c:pt idx="2803">
                  <c:v>25.184093475341797</c:v>
                </c:pt>
                <c:pt idx="2804">
                  <c:v>25.199794769287109</c:v>
                </c:pt>
                <c:pt idx="2805">
                  <c:v>25.215497970581055</c:v>
                </c:pt>
                <c:pt idx="2806">
                  <c:v>25.231204986572266</c:v>
                </c:pt>
                <c:pt idx="2807">
                  <c:v>25.246915817260742</c:v>
                </c:pt>
                <c:pt idx="2808">
                  <c:v>25.262628555297852</c:v>
                </c:pt>
                <c:pt idx="2809">
                  <c:v>25.278347015380859</c:v>
                </c:pt>
                <c:pt idx="2810">
                  <c:v>25.2940673828125</c:v>
                </c:pt>
                <c:pt idx="2811">
                  <c:v>25.309789657592773</c:v>
                </c:pt>
                <c:pt idx="2812">
                  <c:v>25.325517654418945</c:v>
                </c:pt>
                <c:pt idx="2813">
                  <c:v>25.341249465942383</c:v>
                </c:pt>
                <c:pt idx="2814">
                  <c:v>25.356985092163086</c:v>
                </c:pt>
                <c:pt idx="2815">
                  <c:v>25.372720718383789</c:v>
                </c:pt>
                <c:pt idx="2816">
                  <c:v>25.388462066650391</c:v>
                </c:pt>
                <c:pt idx="2817">
                  <c:v>25.404205322265625</c:v>
                </c:pt>
                <c:pt idx="2818">
                  <c:v>25.419954299926758</c:v>
                </c:pt>
                <c:pt idx="2819">
                  <c:v>25.435705184936523</c:v>
                </c:pt>
                <c:pt idx="2820">
                  <c:v>25.451459884643555</c:v>
                </c:pt>
                <c:pt idx="2821">
                  <c:v>25.467218399047852</c:v>
                </c:pt>
                <c:pt idx="2822">
                  <c:v>25.482978820800781</c:v>
                </c:pt>
                <c:pt idx="2823">
                  <c:v>25.498744964599609</c:v>
                </c:pt>
                <c:pt idx="2824">
                  <c:v>25.51451301574707</c:v>
                </c:pt>
                <c:pt idx="2825">
                  <c:v>25.53028678894043</c:v>
                </c:pt>
                <c:pt idx="2826">
                  <c:v>25.546062469482422</c:v>
                </c:pt>
                <c:pt idx="2827">
                  <c:v>25.561843872070313</c:v>
                </c:pt>
                <c:pt idx="2828">
                  <c:v>25.577627182006836</c:v>
                </c:pt>
                <c:pt idx="2829">
                  <c:v>25.593414306640625</c:v>
                </c:pt>
                <c:pt idx="2830">
                  <c:v>25.609203338623047</c:v>
                </c:pt>
                <c:pt idx="2831">
                  <c:v>25.624994277954102</c:v>
                </c:pt>
                <c:pt idx="2832">
                  <c:v>25.640790939331055</c:v>
                </c:pt>
                <c:pt idx="2833">
                  <c:v>25.656593322753906</c:v>
                </c:pt>
                <c:pt idx="2834">
                  <c:v>25.672397613525391</c:v>
                </c:pt>
                <c:pt idx="2835">
                  <c:v>25.688205718994141</c:v>
                </c:pt>
                <c:pt idx="2836">
                  <c:v>25.704017639160156</c:v>
                </c:pt>
                <c:pt idx="2837">
                  <c:v>25.719831466674805</c:v>
                </c:pt>
                <c:pt idx="2838">
                  <c:v>25.735647201538086</c:v>
                </c:pt>
                <c:pt idx="2839">
                  <c:v>25.751468658447266</c:v>
                </c:pt>
                <c:pt idx="2840">
                  <c:v>25.767292022705078</c:v>
                </c:pt>
                <c:pt idx="2841">
                  <c:v>25.783121109008789</c:v>
                </c:pt>
                <c:pt idx="2842">
                  <c:v>25.798954010009766</c:v>
                </c:pt>
                <c:pt idx="2843">
                  <c:v>25.814790725708008</c:v>
                </c:pt>
                <c:pt idx="2844">
                  <c:v>25.83062744140625</c:v>
                </c:pt>
                <c:pt idx="2845">
                  <c:v>25.846471786499023</c:v>
                </c:pt>
                <c:pt idx="2846">
                  <c:v>25.86231803894043</c:v>
                </c:pt>
                <c:pt idx="2847">
                  <c:v>25.878168106079102</c:v>
                </c:pt>
                <c:pt idx="2848">
                  <c:v>25.894020080566406</c:v>
                </c:pt>
                <c:pt idx="2849">
                  <c:v>25.909875869750977</c:v>
                </c:pt>
                <c:pt idx="2850">
                  <c:v>25.925735473632813</c:v>
                </c:pt>
                <c:pt idx="2851">
                  <c:v>25.941598892211914</c:v>
                </c:pt>
                <c:pt idx="2852">
                  <c:v>25.957462310791016</c:v>
                </c:pt>
                <c:pt idx="2853">
                  <c:v>25.973333358764648</c:v>
                </c:pt>
                <c:pt idx="2854">
                  <c:v>25.989204406738281</c:v>
                </c:pt>
                <c:pt idx="2855">
                  <c:v>26.005083084106445</c:v>
                </c:pt>
                <c:pt idx="2856">
                  <c:v>26.020961761474609</c:v>
                </c:pt>
                <c:pt idx="2857">
                  <c:v>26.036846160888672</c:v>
                </c:pt>
                <c:pt idx="2858">
                  <c:v>26.052734375</c:v>
                </c:pt>
                <c:pt idx="2859">
                  <c:v>26.068624496459961</c:v>
                </c:pt>
                <c:pt idx="2860">
                  <c:v>26.084516525268555</c:v>
                </c:pt>
                <c:pt idx="2861">
                  <c:v>26.10041618347168</c:v>
                </c:pt>
                <c:pt idx="2862">
                  <c:v>26.116315841674805</c:v>
                </c:pt>
                <c:pt idx="2863">
                  <c:v>26.132221221923828</c:v>
                </c:pt>
                <c:pt idx="2864">
                  <c:v>26.148126602172852</c:v>
                </c:pt>
                <c:pt idx="2865">
                  <c:v>26.164037704467773</c:v>
                </c:pt>
                <c:pt idx="2866">
                  <c:v>26.179950714111328</c:v>
                </c:pt>
                <c:pt idx="2867">
                  <c:v>26.195869445800781</c:v>
                </c:pt>
                <c:pt idx="2868">
                  <c:v>26.2117919921875</c:v>
                </c:pt>
                <c:pt idx="2869">
                  <c:v>26.227716445922852</c:v>
                </c:pt>
                <c:pt idx="2870">
                  <c:v>26.243642807006836</c:v>
                </c:pt>
                <c:pt idx="2871">
                  <c:v>26.259574890136719</c:v>
                </c:pt>
                <c:pt idx="2872">
                  <c:v>26.275508880615234</c:v>
                </c:pt>
                <c:pt idx="2873">
                  <c:v>26.291446685791016</c:v>
                </c:pt>
                <c:pt idx="2874">
                  <c:v>26.30738639831543</c:v>
                </c:pt>
                <c:pt idx="2875">
                  <c:v>26.323333740234375</c:v>
                </c:pt>
                <c:pt idx="2876">
                  <c:v>26.339279174804688</c:v>
                </c:pt>
                <c:pt idx="2877">
                  <c:v>26.355234146118164</c:v>
                </c:pt>
                <c:pt idx="2878">
                  <c:v>26.371187210083008</c:v>
                </c:pt>
                <c:pt idx="2879">
                  <c:v>26.387147903442383</c:v>
                </c:pt>
                <c:pt idx="2880">
                  <c:v>26.403110504150391</c:v>
                </c:pt>
                <c:pt idx="2881">
                  <c:v>26.419076919555664</c:v>
                </c:pt>
                <c:pt idx="2882">
                  <c:v>26.435047149658203</c:v>
                </c:pt>
                <c:pt idx="2883">
                  <c:v>26.451019287109375</c:v>
                </c:pt>
                <c:pt idx="2884">
                  <c:v>26.466995239257813</c:v>
                </c:pt>
                <c:pt idx="2885">
                  <c:v>26.482975006103516</c:v>
                </c:pt>
                <c:pt idx="2886">
                  <c:v>26.498958587646484</c:v>
                </c:pt>
                <c:pt idx="2887">
                  <c:v>26.514945983886719</c:v>
                </c:pt>
                <c:pt idx="2888">
                  <c:v>26.530935287475586</c:v>
                </c:pt>
                <c:pt idx="2889">
                  <c:v>26.546930313110352</c:v>
                </c:pt>
                <c:pt idx="2890">
                  <c:v>26.562925338745117</c:v>
                </c:pt>
                <c:pt idx="2891">
                  <c:v>26.578924179077148</c:v>
                </c:pt>
                <c:pt idx="2892">
                  <c:v>26.594928741455078</c:v>
                </c:pt>
                <c:pt idx="2893">
                  <c:v>26.610939025878906</c:v>
                </c:pt>
                <c:pt idx="2894">
                  <c:v>26.626949310302734</c:v>
                </c:pt>
                <c:pt idx="2895">
                  <c:v>26.642965316772461</c:v>
                </c:pt>
                <c:pt idx="2896">
                  <c:v>26.658981323242188</c:v>
                </c:pt>
                <c:pt idx="2897">
                  <c:v>26.675004959106445</c:v>
                </c:pt>
                <c:pt idx="2898">
                  <c:v>26.691028594970703</c:v>
                </c:pt>
                <c:pt idx="2899">
                  <c:v>26.707057952880859</c:v>
                </c:pt>
                <c:pt idx="2900">
                  <c:v>26.723089218139648</c:v>
                </c:pt>
                <c:pt idx="2901">
                  <c:v>26.739126205444336</c:v>
                </c:pt>
                <c:pt idx="2902">
                  <c:v>26.755163192749023</c:v>
                </c:pt>
                <c:pt idx="2903">
                  <c:v>26.771207809448242</c:v>
                </c:pt>
                <c:pt idx="2904">
                  <c:v>26.787252426147461</c:v>
                </c:pt>
                <c:pt idx="2905">
                  <c:v>26.803302764892578</c:v>
                </c:pt>
                <c:pt idx="2906">
                  <c:v>26.819351196289063</c:v>
                </c:pt>
                <c:pt idx="2907">
                  <c:v>26.835407257080078</c:v>
                </c:pt>
                <c:pt idx="2908">
                  <c:v>26.851467132568359</c:v>
                </c:pt>
                <c:pt idx="2909">
                  <c:v>26.867530822753906</c:v>
                </c:pt>
                <c:pt idx="2910">
                  <c:v>26.883596420288086</c:v>
                </c:pt>
                <c:pt idx="2911">
                  <c:v>26.899667739868164</c:v>
                </c:pt>
                <c:pt idx="2912">
                  <c:v>26.915740966796875</c:v>
                </c:pt>
                <c:pt idx="2913">
                  <c:v>26.931818008422852</c:v>
                </c:pt>
                <c:pt idx="2914">
                  <c:v>26.947896957397461</c:v>
                </c:pt>
                <c:pt idx="2915">
                  <c:v>26.963981628417969</c:v>
                </c:pt>
                <c:pt idx="2916">
                  <c:v>26.980070114135742</c:v>
                </c:pt>
                <c:pt idx="2917">
                  <c:v>26.996162414550781</c:v>
                </c:pt>
                <c:pt idx="2918">
                  <c:v>27.01225471496582</c:v>
                </c:pt>
                <c:pt idx="2919">
                  <c:v>27.028350830078125</c:v>
                </c:pt>
                <c:pt idx="2920">
                  <c:v>27.044452667236328</c:v>
                </c:pt>
                <c:pt idx="2921">
                  <c:v>27.060556411743164</c:v>
                </c:pt>
                <c:pt idx="2922">
                  <c:v>27.076662063598633</c:v>
                </c:pt>
                <c:pt idx="2923">
                  <c:v>27.092775344848633</c:v>
                </c:pt>
                <c:pt idx="2924">
                  <c:v>27.108888626098633</c:v>
                </c:pt>
                <c:pt idx="2925">
                  <c:v>27.125011444091797</c:v>
                </c:pt>
                <c:pt idx="2926">
                  <c:v>27.141132354736328</c:v>
                </c:pt>
                <c:pt idx="2927">
                  <c:v>27.157260894775391</c:v>
                </c:pt>
                <c:pt idx="2928">
                  <c:v>27.173389434814453</c:v>
                </c:pt>
                <c:pt idx="2929">
                  <c:v>27.189523696899414</c:v>
                </c:pt>
                <c:pt idx="2930">
                  <c:v>27.205659866333008</c:v>
                </c:pt>
                <c:pt idx="2931">
                  <c:v>27.2218017578125</c:v>
                </c:pt>
                <c:pt idx="2932">
                  <c:v>27.237945556640625</c:v>
                </c:pt>
                <c:pt idx="2933">
                  <c:v>27.254095077514648</c:v>
                </c:pt>
                <c:pt idx="2934">
                  <c:v>27.270246505737305</c:v>
                </c:pt>
                <c:pt idx="2935">
                  <c:v>27.286401748657227</c:v>
                </c:pt>
                <c:pt idx="2936">
                  <c:v>27.302560806274414</c:v>
                </c:pt>
                <c:pt idx="2937">
                  <c:v>27.318723678588867</c:v>
                </c:pt>
                <c:pt idx="2938">
                  <c:v>27.334890365600586</c:v>
                </c:pt>
                <c:pt idx="2939">
                  <c:v>27.35106086730957</c:v>
                </c:pt>
                <c:pt idx="2940">
                  <c:v>27.36723518371582</c:v>
                </c:pt>
                <c:pt idx="2941">
                  <c:v>27.383413314819336</c:v>
                </c:pt>
                <c:pt idx="2942">
                  <c:v>27.39959716796875</c:v>
                </c:pt>
                <c:pt idx="2943">
                  <c:v>27.415782928466797</c:v>
                </c:pt>
                <c:pt idx="2944">
                  <c:v>27.431968688964844</c:v>
                </c:pt>
                <c:pt idx="2945">
                  <c:v>27.448160171508789</c:v>
                </c:pt>
                <c:pt idx="2946">
                  <c:v>27.464353561401367</c:v>
                </c:pt>
                <c:pt idx="2947">
                  <c:v>27.480552673339844</c:v>
                </c:pt>
                <c:pt idx="2948">
                  <c:v>27.496753692626953</c:v>
                </c:pt>
                <c:pt idx="2949">
                  <c:v>27.512958526611328</c:v>
                </c:pt>
                <c:pt idx="2950">
                  <c:v>27.529165267944336</c:v>
                </c:pt>
                <c:pt idx="2951">
                  <c:v>27.545377731323242</c:v>
                </c:pt>
                <c:pt idx="2952">
                  <c:v>27.561592102050781</c:v>
                </c:pt>
                <c:pt idx="2953">
                  <c:v>27.577810287475586</c:v>
                </c:pt>
                <c:pt idx="2954">
                  <c:v>27.594030380249023</c:v>
                </c:pt>
                <c:pt idx="2955">
                  <c:v>27.610256195068359</c:v>
                </c:pt>
                <c:pt idx="2956">
                  <c:v>27.626483917236328</c:v>
                </c:pt>
                <c:pt idx="2957">
                  <c:v>27.642715454101563</c:v>
                </c:pt>
                <c:pt idx="2958">
                  <c:v>27.658952713012695</c:v>
                </c:pt>
                <c:pt idx="2959">
                  <c:v>27.675191879272461</c:v>
                </c:pt>
                <c:pt idx="2960">
                  <c:v>27.691432952880859</c:v>
                </c:pt>
                <c:pt idx="2961">
                  <c:v>27.707679748535156</c:v>
                </c:pt>
                <c:pt idx="2962">
                  <c:v>27.723930358886719</c:v>
                </c:pt>
                <c:pt idx="2963">
                  <c:v>27.740184783935547</c:v>
                </c:pt>
                <c:pt idx="2964">
                  <c:v>27.756439208984375</c:v>
                </c:pt>
                <c:pt idx="2965">
                  <c:v>27.772695541381836</c:v>
                </c:pt>
                <c:pt idx="2966">
                  <c:v>27.788959503173828</c:v>
                </c:pt>
                <c:pt idx="2967">
                  <c:v>27.80522346496582</c:v>
                </c:pt>
                <c:pt idx="2968">
                  <c:v>27.821495056152344</c:v>
                </c:pt>
                <c:pt idx="2969">
                  <c:v>27.837766647338867</c:v>
                </c:pt>
                <c:pt idx="2970">
                  <c:v>27.854043960571289</c:v>
                </c:pt>
                <c:pt idx="2971">
                  <c:v>27.870325088500977</c:v>
                </c:pt>
                <c:pt idx="2972">
                  <c:v>27.886611938476563</c:v>
                </c:pt>
                <c:pt idx="2973">
                  <c:v>27.902902603149414</c:v>
                </c:pt>
                <c:pt idx="2974">
                  <c:v>27.919195175170898</c:v>
                </c:pt>
                <c:pt idx="2975">
                  <c:v>27.935489654541016</c:v>
                </c:pt>
                <c:pt idx="2976">
                  <c:v>27.951793670654297</c:v>
                </c:pt>
                <c:pt idx="2977">
                  <c:v>27.968097686767578</c:v>
                </c:pt>
                <c:pt idx="2978">
                  <c:v>27.984403610229492</c:v>
                </c:pt>
                <c:pt idx="2979">
                  <c:v>28.000717163085938</c:v>
                </c:pt>
                <c:pt idx="2980">
                  <c:v>28.017034530639648</c:v>
                </c:pt>
                <c:pt idx="2981">
                  <c:v>28.033349990844727</c:v>
                </c:pt>
                <c:pt idx="2982">
                  <c:v>28.04966926574707</c:v>
                </c:pt>
                <c:pt idx="2983">
                  <c:v>28.065996170043945</c:v>
                </c:pt>
                <c:pt idx="2984">
                  <c:v>28.082324981689453</c:v>
                </c:pt>
                <c:pt idx="2985">
                  <c:v>28.098661422729492</c:v>
                </c:pt>
                <c:pt idx="2986">
                  <c:v>28.114995956420898</c:v>
                </c:pt>
                <c:pt idx="2987">
                  <c:v>28.131338119506836</c:v>
                </c:pt>
                <c:pt idx="2988">
                  <c:v>28.147684097290039</c:v>
                </c:pt>
                <c:pt idx="2989">
                  <c:v>28.164030075073242</c:v>
                </c:pt>
                <c:pt idx="2990">
                  <c:v>28.180381774902344</c:v>
                </c:pt>
                <c:pt idx="2991">
                  <c:v>28.196739196777344</c:v>
                </c:pt>
                <c:pt idx="2992">
                  <c:v>28.213100433349609</c:v>
                </c:pt>
                <c:pt idx="2993">
                  <c:v>28.229459762573242</c:v>
                </c:pt>
                <c:pt idx="2994">
                  <c:v>28.245826721191406</c:v>
                </c:pt>
                <c:pt idx="2995">
                  <c:v>28.262195587158203</c:v>
                </c:pt>
                <c:pt idx="2996">
                  <c:v>28.278572082519531</c:v>
                </c:pt>
                <c:pt idx="2997">
                  <c:v>28.294948577880859</c:v>
                </c:pt>
                <c:pt idx="2998">
                  <c:v>28.31132698059082</c:v>
                </c:pt>
                <c:pt idx="2999">
                  <c:v>28.327709197998047</c:v>
                </c:pt>
              </c:numCache>
            </c:numRef>
          </c:xVal>
          <c:yVal>
            <c:numRef>
              <c:f>'[RB revised.xlsx]Graph Calculations'!$I$6:$DKR$6</c:f>
              <c:numCache>
                <c:formatCode>General</c:formatCode>
                <c:ptCount val="3000"/>
                <c:pt idx="0">
                  <c:v>23812.7626953125</c:v>
                </c:pt>
                <c:pt idx="1">
                  <c:v>23812.75439453125</c:v>
                </c:pt>
                <c:pt idx="2">
                  <c:v>23812.74609375</c:v>
                </c:pt>
                <c:pt idx="3">
                  <c:v>23708.22314453125</c:v>
                </c:pt>
                <c:pt idx="4">
                  <c:v>23579.3291015625</c:v>
                </c:pt>
                <c:pt idx="5">
                  <c:v>23433.94921875</c:v>
                </c:pt>
                <c:pt idx="6">
                  <c:v>23277.71240234375</c:v>
                </c:pt>
                <c:pt idx="7">
                  <c:v>23114.818359375</c:v>
                </c:pt>
                <c:pt idx="8">
                  <c:v>22952.009765625</c:v>
                </c:pt>
                <c:pt idx="9">
                  <c:v>22787.77294921875</c:v>
                </c:pt>
                <c:pt idx="10">
                  <c:v>22615.50732421875</c:v>
                </c:pt>
                <c:pt idx="11">
                  <c:v>22435.1279296875</c:v>
                </c:pt>
                <c:pt idx="12">
                  <c:v>22251.2333984375</c:v>
                </c:pt>
                <c:pt idx="13">
                  <c:v>22061.5966796875</c:v>
                </c:pt>
                <c:pt idx="14">
                  <c:v>21866.61669921875</c:v>
                </c:pt>
                <c:pt idx="15">
                  <c:v>21666.63720703125</c:v>
                </c:pt>
                <c:pt idx="16">
                  <c:v>21479.17138671875</c:v>
                </c:pt>
                <c:pt idx="17">
                  <c:v>21303.87744140625</c:v>
                </c:pt>
                <c:pt idx="18">
                  <c:v>21136.12646484375</c:v>
                </c:pt>
                <c:pt idx="19">
                  <c:v>20966.31787109375</c:v>
                </c:pt>
                <c:pt idx="20">
                  <c:v>20799.70947265625</c:v>
                </c:pt>
                <c:pt idx="21">
                  <c:v>20633.9580078125</c:v>
                </c:pt>
                <c:pt idx="22">
                  <c:v>20476.57861328125</c:v>
                </c:pt>
                <c:pt idx="23">
                  <c:v>20339.45556640625</c:v>
                </c:pt>
                <c:pt idx="24">
                  <c:v>20213.67578125</c:v>
                </c:pt>
                <c:pt idx="25">
                  <c:v>20083.353271484375</c:v>
                </c:pt>
                <c:pt idx="26">
                  <c:v>19944.287841796875</c:v>
                </c:pt>
                <c:pt idx="27">
                  <c:v>19807.079345703125</c:v>
                </c:pt>
                <c:pt idx="28">
                  <c:v>19676.099609375</c:v>
                </c:pt>
                <c:pt idx="29">
                  <c:v>19550.119873046875</c:v>
                </c:pt>
                <c:pt idx="30">
                  <c:v>19434.654296875</c:v>
                </c:pt>
                <c:pt idx="31">
                  <c:v>19324.845947265625</c:v>
                </c:pt>
                <c:pt idx="32">
                  <c:v>19207.15185546875</c:v>
                </c:pt>
                <c:pt idx="33">
                  <c:v>19069.31494140625</c:v>
                </c:pt>
                <c:pt idx="34">
                  <c:v>18933.9921875</c:v>
                </c:pt>
                <c:pt idx="35">
                  <c:v>18825.298095703125</c:v>
                </c:pt>
                <c:pt idx="36">
                  <c:v>18742.48974609375</c:v>
                </c:pt>
                <c:pt idx="37">
                  <c:v>18659.9384765625</c:v>
                </c:pt>
                <c:pt idx="38">
                  <c:v>18567.415771484375</c:v>
                </c:pt>
                <c:pt idx="39">
                  <c:v>18472.750244140625</c:v>
                </c:pt>
                <c:pt idx="40">
                  <c:v>18391.856201171875</c:v>
                </c:pt>
                <c:pt idx="41">
                  <c:v>18329.390625</c:v>
                </c:pt>
                <c:pt idx="42">
                  <c:v>18278.182373046875</c:v>
                </c:pt>
                <c:pt idx="43">
                  <c:v>18230.402587890625</c:v>
                </c:pt>
                <c:pt idx="44">
                  <c:v>18179.39404296875</c:v>
                </c:pt>
                <c:pt idx="45">
                  <c:v>18124.87158203125</c:v>
                </c:pt>
                <c:pt idx="46">
                  <c:v>18071.577392578125</c:v>
                </c:pt>
                <c:pt idx="47">
                  <c:v>18015.026123046875</c:v>
                </c:pt>
                <c:pt idx="48">
                  <c:v>17959.132080078125</c:v>
                </c:pt>
                <c:pt idx="49">
                  <c:v>17907.780883789063</c:v>
                </c:pt>
                <c:pt idx="50">
                  <c:v>17865.801025390625</c:v>
                </c:pt>
                <c:pt idx="51">
                  <c:v>17823.478393554688</c:v>
                </c:pt>
                <c:pt idx="52">
                  <c:v>17783.727172851563</c:v>
                </c:pt>
                <c:pt idx="53">
                  <c:v>17744.66162109375</c:v>
                </c:pt>
                <c:pt idx="54">
                  <c:v>17708.510375976563</c:v>
                </c:pt>
                <c:pt idx="55">
                  <c:v>17673.901977539063</c:v>
                </c:pt>
                <c:pt idx="56">
                  <c:v>17637.6650390625</c:v>
                </c:pt>
                <c:pt idx="57">
                  <c:v>17594.228149414063</c:v>
                </c:pt>
                <c:pt idx="58">
                  <c:v>17553.448364257813</c:v>
                </c:pt>
                <c:pt idx="59">
                  <c:v>17529.068481445313</c:v>
                </c:pt>
                <c:pt idx="60">
                  <c:v>17515.802978515625</c:v>
                </c:pt>
                <c:pt idx="61">
                  <c:v>17500.337524414063</c:v>
                </c:pt>
                <c:pt idx="62">
                  <c:v>17471.50048828125</c:v>
                </c:pt>
                <c:pt idx="63">
                  <c:v>17435.4921875</c:v>
                </c:pt>
                <c:pt idx="64">
                  <c:v>17392.569458007813</c:v>
                </c:pt>
                <c:pt idx="65">
                  <c:v>17349.961059570313</c:v>
                </c:pt>
                <c:pt idx="66">
                  <c:v>17313.4384765625</c:v>
                </c:pt>
                <c:pt idx="67">
                  <c:v>17291.88720703125</c:v>
                </c:pt>
                <c:pt idx="68">
                  <c:v>17278.707397460938</c:v>
                </c:pt>
                <c:pt idx="69">
                  <c:v>17259.756225585938</c:v>
                </c:pt>
                <c:pt idx="70">
                  <c:v>17232.60498046875</c:v>
                </c:pt>
                <c:pt idx="71">
                  <c:v>17209.653686523438</c:v>
                </c:pt>
                <c:pt idx="72">
                  <c:v>17202.102416992188</c:v>
                </c:pt>
                <c:pt idx="73">
                  <c:v>17198.208374023438</c:v>
                </c:pt>
                <c:pt idx="74">
                  <c:v>17184</c:v>
                </c:pt>
                <c:pt idx="75">
                  <c:v>17159.820190429688</c:v>
                </c:pt>
                <c:pt idx="76">
                  <c:v>17139.040405273438</c:v>
                </c:pt>
                <c:pt idx="77">
                  <c:v>17119.77490234375</c:v>
                </c:pt>
                <c:pt idx="78">
                  <c:v>17095.337890625</c:v>
                </c:pt>
                <c:pt idx="79">
                  <c:v>17068.32958984375</c:v>
                </c:pt>
                <c:pt idx="80">
                  <c:v>17048.6640625</c:v>
                </c:pt>
                <c:pt idx="81">
                  <c:v>17037.969970703125</c:v>
                </c:pt>
                <c:pt idx="82">
                  <c:v>17033.733032226563</c:v>
                </c:pt>
                <c:pt idx="83">
                  <c:v>17026.238891601563</c:v>
                </c:pt>
                <c:pt idx="84">
                  <c:v>17008.259094238281</c:v>
                </c:pt>
                <c:pt idx="85">
                  <c:v>16982.707885742188</c:v>
                </c:pt>
                <c:pt idx="86">
                  <c:v>16961.785217285156</c:v>
                </c:pt>
                <c:pt idx="87">
                  <c:v>16952.119689941406</c:v>
                </c:pt>
                <c:pt idx="88">
                  <c:v>16944.854125976563</c:v>
                </c:pt>
                <c:pt idx="89">
                  <c:v>16928.960083007813</c:v>
                </c:pt>
                <c:pt idx="90">
                  <c:v>16905.751708984375</c:v>
                </c:pt>
                <c:pt idx="91">
                  <c:v>16889.857604980469</c:v>
                </c:pt>
                <c:pt idx="92">
                  <c:v>16883.934936523438</c:v>
                </c:pt>
                <c:pt idx="93">
                  <c:v>16877.8408203125</c:v>
                </c:pt>
                <c:pt idx="94">
                  <c:v>16863.603881835938</c:v>
                </c:pt>
                <c:pt idx="95">
                  <c:v>16845.424072265625</c:v>
                </c:pt>
                <c:pt idx="96">
                  <c:v>16837.101440429688</c:v>
                </c:pt>
                <c:pt idx="97">
                  <c:v>16840.464477539063</c:v>
                </c:pt>
                <c:pt idx="98">
                  <c:v>16843.598937988281</c:v>
                </c:pt>
                <c:pt idx="99">
                  <c:v>16840.56201171875</c:v>
                </c:pt>
                <c:pt idx="100">
                  <c:v>16834.010803222656</c:v>
                </c:pt>
                <c:pt idx="101">
                  <c:v>16827.259521484375</c:v>
                </c:pt>
                <c:pt idx="102">
                  <c:v>16813.50830078125</c:v>
                </c:pt>
                <c:pt idx="103">
                  <c:v>16791.071350097656</c:v>
                </c:pt>
                <c:pt idx="104">
                  <c:v>16767.777282714844</c:v>
                </c:pt>
                <c:pt idx="105">
                  <c:v>16756.283203125</c:v>
                </c:pt>
                <c:pt idx="106">
                  <c:v>16753.874816894531</c:v>
                </c:pt>
                <c:pt idx="107">
                  <c:v>16748.923583984375</c:v>
                </c:pt>
                <c:pt idx="108">
                  <c:v>16741.772338867188</c:v>
                </c:pt>
                <c:pt idx="109">
                  <c:v>16735.221130371094</c:v>
                </c:pt>
                <c:pt idx="110">
                  <c:v>16724.269897460938</c:v>
                </c:pt>
                <c:pt idx="111">
                  <c:v>16708.632934570313</c:v>
                </c:pt>
                <c:pt idx="112">
                  <c:v>16703.5673828125</c:v>
                </c:pt>
                <c:pt idx="113">
                  <c:v>16713.416198730469</c:v>
                </c:pt>
                <c:pt idx="114">
                  <c:v>16723.664916992188</c:v>
                </c:pt>
                <c:pt idx="115">
                  <c:v>16712.856567382813</c:v>
                </c:pt>
                <c:pt idx="116">
                  <c:v>16687.648193359375</c:v>
                </c:pt>
                <c:pt idx="117">
                  <c:v>16668.068359375</c:v>
                </c:pt>
                <c:pt idx="118">
                  <c:v>16662.28857421875</c:v>
                </c:pt>
                <c:pt idx="119">
                  <c:v>16658.451599121094</c:v>
                </c:pt>
                <c:pt idx="120">
                  <c:v>16650.757507324219</c:v>
                </c:pt>
                <c:pt idx="121">
                  <c:v>16642.606323242188</c:v>
                </c:pt>
                <c:pt idx="122">
                  <c:v>16640.255065917969</c:v>
                </c:pt>
                <c:pt idx="123">
                  <c:v>16642.418090820313</c:v>
                </c:pt>
                <c:pt idx="124">
                  <c:v>16652.1240234375</c:v>
                </c:pt>
                <c:pt idx="125">
                  <c:v>16651.601379394531</c:v>
                </c:pt>
                <c:pt idx="126">
                  <c:v>16633.6787109375</c:v>
                </c:pt>
                <c:pt idx="127">
                  <c:v>16614.813171386719</c:v>
                </c:pt>
                <c:pt idx="128">
                  <c:v>16616.976257324219</c:v>
                </c:pt>
                <c:pt idx="129">
                  <c:v>16624.367858886719</c:v>
                </c:pt>
                <c:pt idx="130">
                  <c:v>16623.559509277344</c:v>
                </c:pt>
                <c:pt idx="131">
                  <c:v>16621.151123046875</c:v>
                </c:pt>
                <c:pt idx="132">
                  <c:v>16617.971313476563</c:v>
                </c:pt>
                <c:pt idx="133">
                  <c:v>16606.90576171875</c:v>
                </c:pt>
                <c:pt idx="134">
                  <c:v>16589.154541015625</c:v>
                </c:pt>
                <c:pt idx="135">
                  <c:v>16575.289001464844</c:v>
                </c:pt>
                <c:pt idx="136">
                  <c:v>16574.994934082031</c:v>
                </c:pt>
                <c:pt idx="137">
                  <c:v>16591.357971191406</c:v>
                </c:pt>
                <c:pt idx="138">
                  <c:v>16600.435302734375</c:v>
                </c:pt>
                <c:pt idx="139">
                  <c:v>16583.198364257813</c:v>
                </c:pt>
                <c:pt idx="140">
                  <c:v>16559.047119140625</c:v>
                </c:pt>
                <c:pt idx="141">
                  <c:v>16553.724487304688</c:v>
                </c:pt>
                <c:pt idx="142">
                  <c:v>16555.058959960938</c:v>
                </c:pt>
                <c:pt idx="143">
                  <c:v>16551.90771484375</c:v>
                </c:pt>
                <c:pt idx="144">
                  <c:v>16549.327941894531</c:v>
                </c:pt>
                <c:pt idx="145">
                  <c:v>16553.091003417969</c:v>
                </c:pt>
                <c:pt idx="146">
                  <c:v>16553.85400390625</c:v>
                </c:pt>
                <c:pt idx="147">
                  <c:v>16550.388488769531</c:v>
                </c:pt>
                <c:pt idx="148">
                  <c:v>16544.094421386719</c:v>
                </c:pt>
                <c:pt idx="149">
                  <c:v>16538.343200683594</c:v>
                </c:pt>
                <c:pt idx="150">
                  <c:v>16531.677673339844</c:v>
                </c:pt>
                <c:pt idx="151">
                  <c:v>16519.526428222656</c:v>
                </c:pt>
                <c:pt idx="152">
                  <c:v>16510.889465332031</c:v>
                </c:pt>
                <c:pt idx="153">
                  <c:v>16511.995391845703</c:v>
                </c:pt>
                <c:pt idx="154">
                  <c:v>16515.158447265625</c:v>
                </c:pt>
                <c:pt idx="155">
                  <c:v>16511.292907714844</c:v>
                </c:pt>
                <c:pt idx="156">
                  <c:v>16502.141693115234</c:v>
                </c:pt>
                <c:pt idx="157">
                  <c:v>16493.704742431641</c:v>
                </c:pt>
                <c:pt idx="158">
                  <c:v>16488.582092285156</c:v>
                </c:pt>
                <c:pt idx="159">
                  <c:v>16485.202270507813</c:v>
                </c:pt>
                <c:pt idx="160">
                  <c:v>16477.365325927734</c:v>
                </c:pt>
                <c:pt idx="161">
                  <c:v>16472.556945800781</c:v>
                </c:pt>
                <c:pt idx="162">
                  <c:v>16473.405700683594</c:v>
                </c:pt>
                <c:pt idx="163">
                  <c:v>16473.340209960938</c:v>
                </c:pt>
                <c:pt idx="164">
                  <c:v>16467.388946533203</c:v>
                </c:pt>
                <c:pt idx="165">
                  <c:v>16462.437713623047</c:v>
                </c:pt>
                <c:pt idx="166">
                  <c:v>16459.829345703125</c:v>
                </c:pt>
                <c:pt idx="167">
                  <c:v>16456.163818359375</c:v>
                </c:pt>
                <c:pt idx="168">
                  <c:v>16450.126892089844</c:v>
                </c:pt>
                <c:pt idx="169">
                  <c:v>16450.404235839844</c:v>
                </c:pt>
                <c:pt idx="170">
                  <c:v>16457.338714599609</c:v>
                </c:pt>
                <c:pt idx="171">
                  <c:v>16464.873168945313</c:v>
                </c:pt>
                <c:pt idx="172">
                  <c:v>16465.464813232422</c:v>
                </c:pt>
                <c:pt idx="173">
                  <c:v>16463.027862548828</c:v>
                </c:pt>
                <c:pt idx="174">
                  <c:v>16461.562347412109</c:v>
                </c:pt>
                <c:pt idx="175">
                  <c:v>16457.296813964844</c:v>
                </c:pt>
                <c:pt idx="176">
                  <c:v>16447.002716064453</c:v>
                </c:pt>
                <c:pt idx="177">
                  <c:v>16433.851501464844</c:v>
                </c:pt>
                <c:pt idx="178">
                  <c:v>16430.214538574219</c:v>
                </c:pt>
                <c:pt idx="179">
                  <c:v>16432.063323974609</c:v>
                </c:pt>
                <c:pt idx="180">
                  <c:v>16434.683502197266</c:v>
                </c:pt>
                <c:pt idx="181">
                  <c:v>16436.960845947266</c:v>
                </c:pt>
                <c:pt idx="182">
                  <c:v>16445.752471923828</c:v>
                </c:pt>
                <c:pt idx="183">
                  <c:v>16450.115509033203</c:v>
                </c:pt>
                <c:pt idx="184">
                  <c:v>16444.19287109375</c:v>
                </c:pt>
                <c:pt idx="185">
                  <c:v>16434.413055419922</c:v>
                </c:pt>
                <c:pt idx="186">
                  <c:v>16429.718963623047</c:v>
                </c:pt>
                <c:pt idx="187">
                  <c:v>16428.339141845703</c:v>
                </c:pt>
                <c:pt idx="188">
                  <c:v>16426.930786132813</c:v>
                </c:pt>
                <c:pt idx="189">
                  <c:v>16422.493835449219</c:v>
                </c:pt>
                <c:pt idx="190">
                  <c:v>16417.456878662109</c:v>
                </c:pt>
                <c:pt idx="191">
                  <c:v>16416.391357421875</c:v>
                </c:pt>
                <c:pt idx="192">
                  <c:v>16419.182983398438</c:v>
                </c:pt>
                <c:pt idx="193">
                  <c:v>16413.746032714844</c:v>
                </c:pt>
                <c:pt idx="194">
                  <c:v>16400.223388671875</c:v>
                </c:pt>
                <c:pt idx="195">
                  <c:v>16383.815002441406</c:v>
                </c:pt>
                <c:pt idx="196">
                  <c:v>16373.463775634766</c:v>
                </c:pt>
                <c:pt idx="197">
                  <c:v>16373.598236083984</c:v>
                </c:pt>
                <c:pt idx="198">
                  <c:v>16383.132720947266</c:v>
                </c:pt>
                <c:pt idx="199">
                  <c:v>16395.010070800781</c:v>
                </c:pt>
                <c:pt idx="200">
                  <c:v>16400.430267333984</c:v>
                </c:pt>
                <c:pt idx="201">
                  <c:v>16393.507598876953</c:v>
                </c:pt>
                <c:pt idx="202">
                  <c:v>16381.213500976563</c:v>
                </c:pt>
                <c:pt idx="203">
                  <c:v>16370.462280273438</c:v>
                </c:pt>
                <c:pt idx="204">
                  <c:v>16366.082458496094</c:v>
                </c:pt>
                <c:pt idx="205">
                  <c:v>16362.816955566406</c:v>
                </c:pt>
                <c:pt idx="206">
                  <c:v>16360.065704345703</c:v>
                </c:pt>
                <c:pt idx="207">
                  <c:v>16357.800201416016</c:v>
                </c:pt>
                <c:pt idx="208">
                  <c:v>16359.134674072266</c:v>
                </c:pt>
                <c:pt idx="209">
                  <c:v>16361.554870605469</c:v>
                </c:pt>
                <c:pt idx="210">
                  <c:v>16359.632202148438</c:v>
                </c:pt>
                <c:pt idx="211">
                  <c:v>16356.566680908203</c:v>
                </c:pt>
                <c:pt idx="212">
                  <c:v>16354.444030761719</c:v>
                </c:pt>
                <c:pt idx="213">
                  <c:v>16353.264221191406</c:v>
                </c:pt>
                <c:pt idx="214">
                  <c:v>16357.598693847656</c:v>
                </c:pt>
                <c:pt idx="215">
                  <c:v>16365.047454833984</c:v>
                </c:pt>
                <c:pt idx="216">
                  <c:v>16364.953369140625</c:v>
                </c:pt>
                <c:pt idx="217">
                  <c:v>16354.373565673828</c:v>
                </c:pt>
                <c:pt idx="218">
                  <c:v>16345.765197753906</c:v>
                </c:pt>
                <c:pt idx="219">
                  <c:v>16343.185394287109</c:v>
                </c:pt>
                <c:pt idx="220">
                  <c:v>16345.948455810547</c:v>
                </c:pt>
                <c:pt idx="221">
                  <c:v>16349.740051269531</c:v>
                </c:pt>
                <c:pt idx="222">
                  <c:v>16354.817413330078</c:v>
                </c:pt>
                <c:pt idx="223">
                  <c:v>16360.066162109375</c:v>
                </c:pt>
                <c:pt idx="224">
                  <c:v>16361.200653076172</c:v>
                </c:pt>
                <c:pt idx="225">
                  <c:v>16350.935119628906</c:v>
                </c:pt>
                <c:pt idx="226">
                  <c:v>16332.869598388672</c:v>
                </c:pt>
                <c:pt idx="227">
                  <c:v>16315.461242675781</c:v>
                </c:pt>
                <c:pt idx="228">
                  <c:v>16303.852844238281</c:v>
                </c:pt>
                <c:pt idx="229">
                  <c:v>16303.615905761719</c:v>
                </c:pt>
                <c:pt idx="230">
                  <c:v>16309.550384521484</c:v>
                </c:pt>
                <c:pt idx="231">
                  <c:v>16313.742004394531</c:v>
                </c:pt>
                <c:pt idx="232">
                  <c:v>16316.8193359375</c:v>
                </c:pt>
                <c:pt idx="233">
                  <c:v>16322.668121337891</c:v>
                </c:pt>
                <c:pt idx="234">
                  <c:v>16325.602600097656</c:v>
                </c:pt>
                <c:pt idx="235">
                  <c:v>16321.737091064453</c:v>
                </c:pt>
                <c:pt idx="236">
                  <c:v>16319.328704833984</c:v>
                </c:pt>
                <c:pt idx="237">
                  <c:v>16319.034606933594</c:v>
                </c:pt>
                <c:pt idx="238">
                  <c:v>16315.111938476563</c:v>
                </c:pt>
                <c:pt idx="239">
                  <c:v>16308.989288330078</c:v>
                </c:pt>
                <c:pt idx="240">
                  <c:v>16303.123779296875</c:v>
                </c:pt>
                <c:pt idx="241">
                  <c:v>16302.115386962891</c:v>
                </c:pt>
                <c:pt idx="242">
                  <c:v>16305.621307373047</c:v>
                </c:pt>
                <c:pt idx="243">
                  <c:v>16316.012908935547</c:v>
                </c:pt>
                <c:pt idx="244">
                  <c:v>16325.547393798828</c:v>
                </c:pt>
                <c:pt idx="245">
                  <c:v>16325.853302001953</c:v>
                </c:pt>
                <c:pt idx="246">
                  <c:v>16318.216369628906</c:v>
                </c:pt>
                <c:pt idx="247">
                  <c:v>16309.865142822266</c:v>
                </c:pt>
                <c:pt idx="248">
                  <c:v>16303.771026611328</c:v>
                </c:pt>
                <c:pt idx="249">
                  <c:v>16293.476959228516</c:v>
                </c:pt>
                <c:pt idx="250">
                  <c:v>16280.239990234375</c:v>
                </c:pt>
                <c:pt idx="251">
                  <c:v>16270.945922851563</c:v>
                </c:pt>
                <c:pt idx="252">
                  <c:v>16270.994689941406</c:v>
                </c:pt>
                <c:pt idx="253">
                  <c:v>16280.272003173828</c:v>
                </c:pt>
                <c:pt idx="254">
                  <c:v>16295.120788574219</c:v>
                </c:pt>
                <c:pt idx="255">
                  <c:v>16301.76953125</c:v>
                </c:pt>
                <c:pt idx="256">
                  <c:v>16298.132598876953</c:v>
                </c:pt>
                <c:pt idx="257">
                  <c:v>16288.409942626953</c:v>
                </c:pt>
                <c:pt idx="258">
                  <c:v>16278.972991943359</c:v>
                </c:pt>
                <c:pt idx="259">
                  <c:v>16270.336029052734</c:v>
                </c:pt>
                <c:pt idx="260">
                  <c:v>16264.641937255859</c:v>
                </c:pt>
                <c:pt idx="261">
                  <c:v>16258.747863769531</c:v>
                </c:pt>
                <c:pt idx="262">
                  <c:v>16252.653762817383</c:v>
                </c:pt>
                <c:pt idx="263">
                  <c:v>16252.988250732422</c:v>
                </c:pt>
                <c:pt idx="264">
                  <c:v>16258.122741699219</c:v>
                </c:pt>
                <c:pt idx="265">
                  <c:v>16261.457214355469</c:v>
                </c:pt>
                <c:pt idx="266">
                  <c:v>16261.534545898438</c:v>
                </c:pt>
                <c:pt idx="267">
                  <c:v>16254.154739379883</c:v>
                </c:pt>
                <c:pt idx="268">
                  <c:v>16237.632080078125</c:v>
                </c:pt>
                <c:pt idx="269">
                  <c:v>16214.509414672852</c:v>
                </c:pt>
                <c:pt idx="270">
                  <c:v>16198.95817565918</c:v>
                </c:pt>
                <c:pt idx="271">
                  <c:v>16193.721237182617</c:v>
                </c:pt>
                <c:pt idx="272">
                  <c:v>16192.284286499023</c:v>
                </c:pt>
                <c:pt idx="273">
                  <c:v>16188.16162109375</c:v>
                </c:pt>
                <c:pt idx="274">
                  <c:v>16187.381820678711</c:v>
                </c:pt>
                <c:pt idx="275">
                  <c:v>16193.402008056641</c:v>
                </c:pt>
                <c:pt idx="276">
                  <c:v>16198.022201538086</c:v>
                </c:pt>
                <c:pt idx="277">
                  <c:v>16190.242401123047</c:v>
                </c:pt>
                <c:pt idx="278">
                  <c:v>16174.462600708008</c:v>
                </c:pt>
                <c:pt idx="279">
                  <c:v>16160.825653076172</c:v>
                </c:pt>
                <c:pt idx="280">
                  <c:v>16158.302993774414</c:v>
                </c:pt>
                <c:pt idx="281">
                  <c:v>16160.351760864258</c:v>
                </c:pt>
                <c:pt idx="282">
                  <c:v>16165.400512695313</c:v>
                </c:pt>
                <c:pt idx="283">
                  <c:v>16172.420715332031</c:v>
                </c:pt>
                <c:pt idx="284">
                  <c:v>16182.383773803711</c:v>
                </c:pt>
                <c:pt idx="285">
                  <c:v>16191.518249511719</c:v>
                </c:pt>
                <c:pt idx="286">
                  <c:v>16189.909866333008</c:v>
                </c:pt>
                <c:pt idx="287">
                  <c:v>16176.130065917969</c:v>
                </c:pt>
                <c:pt idx="288">
                  <c:v>16160.493118286133</c:v>
                </c:pt>
                <c:pt idx="289">
                  <c:v>16157.027603149414</c:v>
                </c:pt>
                <c:pt idx="290">
                  <c:v>16158.076370239258</c:v>
                </c:pt>
                <c:pt idx="291">
                  <c:v>16154.182266235352</c:v>
                </c:pt>
                <c:pt idx="292">
                  <c:v>16148.459609985352</c:v>
                </c:pt>
                <c:pt idx="293">
                  <c:v>16144.365524291992</c:v>
                </c:pt>
                <c:pt idx="294">
                  <c:v>16139.585708618164</c:v>
                </c:pt>
                <c:pt idx="295">
                  <c:v>16139.605911254883</c:v>
                </c:pt>
                <c:pt idx="296">
                  <c:v>16154.168960571289</c:v>
                </c:pt>
                <c:pt idx="297">
                  <c:v>16170.674865722656</c:v>
                </c:pt>
                <c:pt idx="298">
                  <c:v>16171.03791809082</c:v>
                </c:pt>
                <c:pt idx="299">
                  <c:v>16160.772399902344</c:v>
                </c:pt>
                <c:pt idx="300">
                  <c:v>16156.506881713867</c:v>
                </c:pt>
                <c:pt idx="301">
                  <c:v>16161.355651855469</c:v>
                </c:pt>
                <c:pt idx="302">
                  <c:v>16165.175842285156</c:v>
                </c:pt>
                <c:pt idx="303">
                  <c:v>16162.453186035156</c:v>
                </c:pt>
                <c:pt idx="304">
                  <c:v>16156.016235351563</c:v>
                </c:pt>
                <c:pt idx="305">
                  <c:v>16150.693572998047</c:v>
                </c:pt>
                <c:pt idx="306">
                  <c:v>16146.828048706055</c:v>
                </c:pt>
                <c:pt idx="307">
                  <c:v>16141.876815795898</c:v>
                </c:pt>
                <c:pt idx="308">
                  <c:v>16138.954162597656</c:v>
                </c:pt>
                <c:pt idx="309">
                  <c:v>16142.145782470703</c:v>
                </c:pt>
                <c:pt idx="310">
                  <c:v>16148.537399291992</c:v>
                </c:pt>
                <c:pt idx="311">
                  <c:v>16147.443313598633</c:v>
                </c:pt>
                <c:pt idx="312">
                  <c:v>16132.120651245117</c:v>
                </c:pt>
                <c:pt idx="313">
                  <c:v>16117.740844726563</c:v>
                </c:pt>
                <c:pt idx="314">
                  <c:v>16120.218185424805</c:v>
                </c:pt>
                <c:pt idx="315">
                  <c:v>16130.552658081055</c:v>
                </c:pt>
                <c:pt idx="316">
                  <c:v>16130.287139892578</c:v>
                </c:pt>
                <c:pt idx="317">
                  <c:v>16122.10733795166</c:v>
                </c:pt>
                <c:pt idx="318">
                  <c:v>16114.098960876465</c:v>
                </c:pt>
                <c:pt idx="319">
                  <c:v>16106.490585327148</c:v>
                </c:pt>
                <c:pt idx="320">
                  <c:v>16107.539352416992</c:v>
                </c:pt>
                <c:pt idx="321">
                  <c:v>16120.273834228516</c:v>
                </c:pt>
                <c:pt idx="322">
                  <c:v>16129.551162719727</c:v>
                </c:pt>
                <c:pt idx="323">
                  <c:v>16124.199935913086</c:v>
                </c:pt>
                <c:pt idx="324">
                  <c:v>16112.22013092041</c:v>
                </c:pt>
                <c:pt idx="325">
                  <c:v>16104.011756896973</c:v>
                </c:pt>
                <c:pt idx="326">
                  <c:v>16097.803375244141</c:v>
                </c:pt>
                <c:pt idx="327">
                  <c:v>16090.823570251465</c:v>
                </c:pt>
                <c:pt idx="328">
                  <c:v>16090.729476928711</c:v>
                </c:pt>
                <c:pt idx="329">
                  <c:v>16095.892532348633</c:v>
                </c:pt>
                <c:pt idx="330">
                  <c:v>16100.912727355957</c:v>
                </c:pt>
                <c:pt idx="331">
                  <c:v>16102.218635559082</c:v>
                </c:pt>
                <c:pt idx="332">
                  <c:v>16103.695976257324</c:v>
                </c:pt>
                <c:pt idx="333">
                  <c:v>16098.887596130371</c:v>
                </c:pt>
                <c:pt idx="334">
                  <c:v>16091.736366271973</c:v>
                </c:pt>
                <c:pt idx="335">
                  <c:v>16092.299415588379</c:v>
                </c:pt>
                <c:pt idx="336">
                  <c:v>16098.576751708984</c:v>
                </c:pt>
                <c:pt idx="337">
                  <c:v>16105.282661437988</c:v>
                </c:pt>
                <c:pt idx="338">
                  <c:v>16118.559997558594</c:v>
                </c:pt>
                <c:pt idx="339">
                  <c:v>16137.665908813477</c:v>
                </c:pt>
                <c:pt idx="340">
                  <c:v>16142.543243408203</c:v>
                </c:pt>
                <c:pt idx="341">
                  <c:v>16131.36344909668</c:v>
                </c:pt>
                <c:pt idx="342">
                  <c:v>16124.269348144531</c:v>
                </c:pt>
                <c:pt idx="343">
                  <c:v>16125.375259399414</c:v>
                </c:pt>
                <c:pt idx="344">
                  <c:v>16118.28116607666</c:v>
                </c:pt>
                <c:pt idx="345">
                  <c:v>16106.529937744141</c:v>
                </c:pt>
                <c:pt idx="346">
                  <c:v>16105.350128173828</c:v>
                </c:pt>
                <c:pt idx="347">
                  <c:v>16111.51318359375</c:v>
                </c:pt>
                <c:pt idx="348">
                  <c:v>16109.133377075195</c:v>
                </c:pt>
                <c:pt idx="349">
                  <c:v>16099.839286804199</c:v>
                </c:pt>
                <c:pt idx="350">
                  <c:v>16094.488052368164</c:v>
                </c:pt>
                <c:pt idx="351">
                  <c:v>16092.479675292969</c:v>
                </c:pt>
                <c:pt idx="352">
                  <c:v>16095.185585021973</c:v>
                </c:pt>
                <c:pt idx="353">
                  <c:v>16104.948638916016</c:v>
                </c:pt>
                <c:pt idx="354">
                  <c:v>16116.797401428223</c:v>
                </c:pt>
                <c:pt idx="355">
                  <c:v>16119.503311157227</c:v>
                </c:pt>
                <c:pt idx="356">
                  <c:v>16116.466361999512</c:v>
                </c:pt>
                <c:pt idx="357">
                  <c:v>16111.372276306152</c:v>
                </c:pt>
                <c:pt idx="358">
                  <c:v>16100.278182983398</c:v>
                </c:pt>
                <c:pt idx="359">
                  <c:v>16086.784088134766</c:v>
                </c:pt>
                <c:pt idx="360">
                  <c:v>16080.204284667969</c:v>
                </c:pt>
                <c:pt idx="361">
                  <c:v>16084.224479675293</c:v>
                </c:pt>
                <c:pt idx="362">
                  <c:v>16092.873245239258</c:v>
                </c:pt>
                <c:pt idx="363">
                  <c:v>16097.807723999023</c:v>
                </c:pt>
                <c:pt idx="364">
                  <c:v>16093.942207336426</c:v>
                </c:pt>
                <c:pt idx="365">
                  <c:v>16085.105262756348</c:v>
                </c:pt>
                <c:pt idx="366">
                  <c:v>16078.839736938477</c:v>
                </c:pt>
                <c:pt idx="367">
                  <c:v>16074.54564666748</c:v>
                </c:pt>
                <c:pt idx="368">
                  <c:v>16073.937271118164</c:v>
                </c:pt>
                <c:pt idx="369">
                  <c:v>16078.643180847168</c:v>
                </c:pt>
                <c:pt idx="370">
                  <c:v>16084.749092102051</c:v>
                </c:pt>
                <c:pt idx="371">
                  <c:v>16090.855003356934</c:v>
                </c:pt>
                <c:pt idx="372">
                  <c:v>16096.246620178223</c:v>
                </c:pt>
                <c:pt idx="373">
                  <c:v>16100.038246154785</c:v>
                </c:pt>
                <c:pt idx="374">
                  <c:v>16093.71558380127</c:v>
                </c:pt>
                <c:pt idx="375">
                  <c:v>16081.192924499512</c:v>
                </c:pt>
                <c:pt idx="376">
                  <c:v>16071.784545898438</c:v>
                </c:pt>
                <c:pt idx="377">
                  <c:v>16074.090454101563</c:v>
                </c:pt>
                <c:pt idx="378">
                  <c:v>16080.767791748047</c:v>
                </c:pt>
                <c:pt idx="379">
                  <c:v>16083.645126342773</c:v>
                </c:pt>
                <c:pt idx="380">
                  <c:v>16082.122467041016</c:v>
                </c:pt>
                <c:pt idx="381">
                  <c:v>16085.085517883301</c:v>
                </c:pt>
                <c:pt idx="382">
                  <c:v>16094.277145385742</c:v>
                </c:pt>
                <c:pt idx="383">
                  <c:v>16104.44019317627</c:v>
                </c:pt>
                <c:pt idx="384">
                  <c:v>16100.831817626953</c:v>
                </c:pt>
                <c:pt idx="385">
                  <c:v>16088.423439025879</c:v>
                </c:pt>
                <c:pt idx="386">
                  <c:v>16082.129348754883</c:v>
                </c:pt>
                <c:pt idx="387">
                  <c:v>16084.578117370605</c:v>
                </c:pt>
                <c:pt idx="388">
                  <c:v>16083.712600708008</c:v>
                </c:pt>
                <c:pt idx="389">
                  <c:v>16086.504219055176</c:v>
                </c:pt>
                <c:pt idx="390">
                  <c:v>16099.010131835938</c:v>
                </c:pt>
                <c:pt idx="391">
                  <c:v>16105.344612121582</c:v>
                </c:pt>
                <c:pt idx="392">
                  <c:v>16100.650520324707</c:v>
                </c:pt>
                <c:pt idx="393">
                  <c:v>16094.07071685791</c:v>
                </c:pt>
                <c:pt idx="394">
                  <c:v>16089.319480895996</c:v>
                </c:pt>
                <c:pt idx="395">
                  <c:v>16080.853958129883</c:v>
                </c:pt>
                <c:pt idx="396">
                  <c:v>16078.731300354004</c:v>
                </c:pt>
                <c:pt idx="397">
                  <c:v>16079.98006439209</c:v>
                </c:pt>
                <c:pt idx="398">
                  <c:v>16078.828834533691</c:v>
                </c:pt>
                <c:pt idx="399">
                  <c:v>16079.449028015137</c:v>
                </c:pt>
                <c:pt idx="400">
                  <c:v>16091.326362609863</c:v>
                </c:pt>
                <c:pt idx="401">
                  <c:v>16098.689414978027</c:v>
                </c:pt>
                <c:pt idx="402">
                  <c:v>16084.82389831543</c:v>
                </c:pt>
                <c:pt idx="403">
                  <c:v>16059.844089508057</c:v>
                </c:pt>
                <c:pt idx="404">
                  <c:v>16049.150001525879</c:v>
                </c:pt>
                <c:pt idx="405">
                  <c:v>16057.570194244385</c:v>
                </c:pt>
                <c:pt idx="406">
                  <c:v>16068.70467376709</c:v>
                </c:pt>
                <c:pt idx="407">
                  <c:v>16071.324867248535</c:v>
                </c:pt>
                <c:pt idx="408">
                  <c:v>16067.059349060059</c:v>
                </c:pt>
                <c:pt idx="409">
                  <c:v>16063.650974273682</c:v>
                </c:pt>
                <c:pt idx="410">
                  <c:v>16067.671165466309</c:v>
                </c:pt>
                <c:pt idx="411">
                  <c:v>16077.262794494629</c:v>
                </c:pt>
                <c:pt idx="412">
                  <c:v>16082.654418945313</c:v>
                </c:pt>
                <c:pt idx="413">
                  <c:v>16081.903182983398</c:v>
                </c:pt>
                <c:pt idx="414">
                  <c:v>16079.923377990723</c:v>
                </c:pt>
                <c:pt idx="415">
                  <c:v>16076.286430358887</c:v>
                </c:pt>
                <c:pt idx="416">
                  <c:v>16074.249481201172</c:v>
                </c:pt>
                <c:pt idx="417">
                  <c:v>16076.955390930176</c:v>
                </c:pt>
                <c:pt idx="418">
                  <c:v>16081.547012329102</c:v>
                </c:pt>
                <c:pt idx="419">
                  <c:v>16080.138633728027</c:v>
                </c:pt>
                <c:pt idx="420">
                  <c:v>16077.158828735352</c:v>
                </c:pt>
                <c:pt idx="421">
                  <c:v>16073.521881103516</c:v>
                </c:pt>
                <c:pt idx="422">
                  <c:v>16064.22779083252</c:v>
                </c:pt>
                <c:pt idx="423">
                  <c:v>16052.647987365723</c:v>
                </c:pt>
                <c:pt idx="424">
                  <c:v>16052.153896331787</c:v>
                </c:pt>
                <c:pt idx="425">
                  <c:v>16064.974090576172</c:v>
                </c:pt>
                <c:pt idx="426">
                  <c:v>16076.365715026855</c:v>
                </c:pt>
                <c:pt idx="427">
                  <c:v>16079.35733795166</c:v>
                </c:pt>
                <c:pt idx="428">
                  <c:v>16078.406105041504</c:v>
                </c:pt>
                <c:pt idx="429">
                  <c:v>16073.683441162109</c:v>
                </c:pt>
                <c:pt idx="430">
                  <c:v>16061.960781097412</c:v>
                </c:pt>
                <c:pt idx="431">
                  <c:v>16048.638118743896</c:v>
                </c:pt>
                <c:pt idx="432">
                  <c:v>16044.144027709961</c:v>
                </c:pt>
                <c:pt idx="433">
                  <c:v>16049.764221191406</c:v>
                </c:pt>
                <c:pt idx="434">
                  <c:v>16058.241558074951</c:v>
                </c:pt>
                <c:pt idx="435">
                  <c:v>16063.004611968994</c:v>
                </c:pt>
                <c:pt idx="436">
                  <c:v>16064.681945800781</c:v>
                </c:pt>
                <c:pt idx="437">
                  <c:v>16063.216426849365</c:v>
                </c:pt>
                <c:pt idx="438">
                  <c:v>16055.693767547607</c:v>
                </c:pt>
                <c:pt idx="439">
                  <c:v>16049.056819915771</c:v>
                </c:pt>
                <c:pt idx="440">
                  <c:v>16047.762725830078</c:v>
                </c:pt>
                <c:pt idx="441">
                  <c:v>16046.0686378479</c:v>
                </c:pt>
                <c:pt idx="442">
                  <c:v>16039.803115844727</c:v>
                </c:pt>
                <c:pt idx="443">
                  <c:v>16041.823310852051</c:v>
                </c:pt>
                <c:pt idx="444">
                  <c:v>16059.186363220215</c:v>
                </c:pt>
                <c:pt idx="445">
                  <c:v>16080.377990722656</c:v>
                </c:pt>
                <c:pt idx="446">
                  <c:v>16091.055328369141</c:v>
                </c:pt>
                <c:pt idx="447">
                  <c:v>16090.246948242188</c:v>
                </c:pt>
                <c:pt idx="448">
                  <c:v>16087.495712280273</c:v>
                </c:pt>
                <c:pt idx="449">
                  <c:v>16092.801620483398</c:v>
                </c:pt>
                <c:pt idx="450">
                  <c:v>16093.99324798584</c:v>
                </c:pt>
                <c:pt idx="451">
                  <c:v>16079.099159240723</c:v>
                </c:pt>
                <c:pt idx="452">
                  <c:v>16059.376495361328</c:v>
                </c:pt>
                <c:pt idx="453">
                  <c:v>16059.539546966553</c:v>
                </c:pt>
                <c:pt idx="454">
                  <c:v>16080.274024963379</c:v>
                </c:pt>
                <c:pt idx="455">
                  <c:v>16098.665649414063</c:v>
                </c:pt>
                <c:pt idx="456">
                  <c:v>16103.685844421387</c:v>
                </c:pt>
                <c:pt idx="457">
                  <c:v>16098.591751098633</c:v>
                </c:pt>
                <c:pt idx="458">
                  <c:v>16089.240516662598</c:v>
                </c:pt>
                <c:pt idx="459">
                  <c:v>16084.232139587402</c:v>
                </c:pt>
                <c:pt idx="460">
                  <c:v>16091.738052368164</c:v>
                </c:pt>
                <c:pt idx="461">
                  <c:v>16104.443962097168</c:v>
                </c:pt>
                <c:pt idx="462">
                  <c:v>16107.549873352051</c:v>
                </c:pt>
                <c:pt idx="463">
                  <c:v>16102.370063781738</c:v>
                </c:pt>
                <c:pt idx="464">
                  <c:v>16096.90454864502</c:v>
                </c:pt>
                <c:pt idx="465">
                  <c:v>16093.781883239746</c:v>
                </c:pt>
                <c:pt idx="466">
                  <c:v>16094.916366577148</c:v>
                </c:pt>
                <c:pt idx="467">
                  <c:v>16099.479415893555</c:v>
                </c:pt>
                <c:pt idx="468">
                  <c:v>16100.78532409668</c:v>
                </c:pt>
                <c:pt idx="469">
                  <c:v>16098.319808959961</c:v>
                </c:pt>
                <c:pt idx="470">
                  <c:v>16095.968574523926</c:v>
                </c:pt>
                <c:pt idx="471">
                  <c:v>16097.217338562012</c:v>
                </c:pt>
                <c:pt idx="472">
                  <c:v>16096.294677734375</c:v>
                </c:pt>
                <c:pt idx="473">
                  <c:v>16095.400581359863</c:v>
                </c:pt>
                <c:pt idx="474">
                  <c:v>16104.592208862305</c:v>
                </c:pt>
                <c:pt idx="475">
                  <c:v>16119.412399291992</c:v>
                </c:pt>
                <c:pt idx="476">
                  <c:v>16121.804023742676</c:v>
                </c:pt>
                <c:pt idx="477">
                  <c:v>16105.995651245117</c:v>
                </c:pt>
                <c:pt idx="478">
                  <c:v>16086.158699035645</c:v>
                </c:pt>
                <c:pt idx="479">
                  <c:v>16072.721755981445</c:v>
                </c:pt>
                <c:pt idx="480">
                  <c:v>16071.05623626709</c:v>
                </c:pt>
                <c:pt idx="481">
                  <c:v>16085.533569335938</c:v>
                </c:pt>
                <c:pt idx="482">
                  <c:v>16102.496620178223</c:v>
                </c:pt>
                <c:pt idx="483">
                  <c:v>16107.031105041504</c:v>
                </c:pt>
                <c:pt idx="484">
                  <c:v>16093.90843963623</c:v>
                </c:pt>
                <c:pt idx="485">
                  <c:v>16079.128639221191</c:v>
                </c:pt>
                <c:pt idx="486">
                  <c:v>16070.834548950195</c:v>
                </c:pt>
                <c:pt idx="487">
                  <c:v>16069.79759979248</c:v>
                </c:pt>
                <c:pt idx="488">
                  <c:v>16071.903503417969</c:v>
                </c:pt>
                <c:pt idx="489">
                  <c:v>16078.009414672852</c:v>
                </c:pt>
                <c:pt idx="490">
                  <c:v>16082.572463989258</c:v>
                </c:pt>
                <c:pt idx="491">
                  <c:v>16076.249801635742</c:v>
                </c:pt>
                <c:pt idx="492">
                  <c:v>16062.755714416504</c:v>
                </c:pt>
                <c:pt idx="493">
                  <c:v>16052.575908660889</c:v>
                </c:pt>
                <c:pt idx="494">
                  <c:v>16051.710388183594</c:v>
                </c:pt>
                <c:pt idx="495">
                  <c:v>16056.416297912598</c:v>
                </c:pt>
                <c:pt idx="496">
                  <c:v>16061.722206115723</c:v>
                </c:pt>
                <c:pt idx="497">
                  <c:v>16059.628116607666</c:v>
                </c:pt>
                <c:pt idx="498">
                  <c:v>16051.734027862549</c:v>
                </c:pt>
                <c:pt idx="499">
                  <c:v>16048.611362457275</c:v>
                </c:pt>
                <c:pt idx="500">
                  <c:v>16051.745845794678</c:v>
                </c:pt>
                <c:pt idx="501">
                  <c:v>16055.366039276123</c:v>
                </c:pt>
                <c:pt idx="502">
                  <c:v>16055.786231994629</c:v>
                </c:pt>
                <c:pt idx="503">
                  <c:v>16056.834999084473</c:v>
                </c:pt>
                <c:pt idx="504">
                  <c:v>16063.998050689697</c:v>
                </c:pt>
                <c:pt idx="505">
                  <c:v>16071.418243408203</c:v>
                </c:pt>
                <c:pt idx="506">
                  <c:v>16073.667015075684</c:v>
                </c:pt>
                <c:pt idx="507">
                  <c:v>16072.715782165527</c:v>
                </c:pt>
                <c:pt idx="508">
                  <c:v>16072.250259399414</c:v>
                </c:pt>
                <c:pt idx="509">
                  <c:v>16066.956169128418</c:v>
                </c:pt>
                <c:pt idx="510">
                  <c:v>16057.833507537842</c:v>
                </c:pt>
                <c:pt idx="511">
                  <c:v>16052.853702545166</c:v>
                </c:pt>
                <c:pt idx="512">
                  <c:v>16053.959609985352</c:v>
                </c:pt>
                <c:pt idx="513">
                  <c:v>16057.779804229736</c:v>
                </c:pt>
                <c:pt idx="514">
                  <c:v>16055.31428527832</c:v>
                </c:pt>
                <c:pt idx="515">
                  <c:v>16052.963050842285</c:v>
                </c:pt>
                <c:pt idx="516">
                  <c:v>16061.61181640625</c:v>
                </c:pt>
                <c:pt idx="517">
                  <c:v>16073.203437805176</c:v>
                </c:pt>
                <c:pt idx="518">
                  <c:v>16065.023635864258</c:v>
                </c:pt>
                <c:pt idx="519">
                  <c:v>16045.900974273682</c:v>
                </c:pt>
                <c:pt idx="520">
                  <c:v>16034.692596435547</c:v>
                </c:pt>
                <c:pt idx="521">
                  <c:v>16032.08422088623</c:v>
                </c:pt>
                <c:pt idx="522">
                  <c:v>16033.332988739014</c:v>
                </c:pt>
                <c:pt idx="523">
                  <c:v>16036.724609375</c:v>
                </c:pt>
                <c:pt idx="524">
                  <c:v>16039.430519104004</c:v>
                </c:pt>
                <c:pt idx="525">
                  <c:v>16037.422142028809</c:v>
                </c:pt>
                <c:pt idx="526">
                  <c:v>16031.785194396973</c:v>
                </c:pt>
                <c:pt idx="527">
                  <c:v>16028.891103744507</c:v>
                </c:pt>
                <c:pt idx="528">
                  <c:v>16030.939870834351</c:v>
                </c:pt>
                <c:pt idx="529">
                  <c:v>16036.131492614746</c:v>
                </c:pt>
                <c:pt idx="530">
                  <c:v>16039.49454498291</c:v>
                </c:pt>
                <c:pt idx="531">
                  <c:v>16036.971881866455</c:v>
                </c:pt>
                <c:pt idx="532">
                  <c:v>16024.420648574829</c:v>
                </c:pt>
                <c:pt idx="533">
                  <c:v>16010.755129814148</c:v>
                </c:pt>
                <c:pt idx="534">
                  <c:v>16009.089610099792</c:v>
                </c:pt>
                <c:pt idx="535">
                  <c:v>16019.252662658691</c:v>
                </c:pt>
                <c:pt idx="536">
                  <c:v>16029.472856521606</c:v>
                </c:pt>
                <c:pt idx="537">
                  <c:v>16032.378765106201</c:v>
                </c:pt>
                <c:pt idx="538">
                  <c:v>16027.913246154785</c:v>
                </c:pt>
                <c:pt idx="539">
                  <c:v>16019.104869842529</c:v>
                </c:pt>
                <c:pt idx="540">
                  <c:v>16012.239350318909</c:v>
                </c:pt>
                <c:pt idx="541">
                  <c:v>16012.402402877808</c:v>
                </c:pt>
                <c:pt idx="542">
                  <c:v>16015.708312034607</c:v>
                </c:pt>
                <c:pt idx="543">
                  <c:v>16016.557077407837</c:v>
                </c:pt>
                <c:pt idx="544">
                  <c:v>16012.320129394531</c:v>
                </c:pt>
                <c:pt idx="545">
                  <c:v>16004.626039028168</c:v>
                </c:pt>
                <c:pt idx="546">
                  <c:v>15999.731948047876</c:v>
                </c:pt>
                <c:pt idx="547">
                  <c:v>16006.494999885559</c:v>
                </c:pt>
                <c:pt idx="548">
                  <c:v>16020.686622619629</c:v>
                </c:pt>
                <c:pt idx="549">
                  <c:v>16028.792531967163</c:v>
                </c:pt>
                <c:pt idx="550">
                  <c:v>16025.498441696167</c:v>
                </c:pt>
                <c:pt idx="551">
                  <c:v>16021.775779724121</c:v>
                </c:pt>
                <c:pt idx="552">
                  <c:v>16025.595973968506</c:v>
                </c:pt>
                <c:pt idx="553">
                  <c:v>16038.559024810791</c:v>
                </c:pt>
                <c:pt idx="554">
                  <c:v>16040.350650787354</c:v>
                </c:pt>
                <c:pt idx="555">
                  <c:v>16033.370845794678</c:v>
                </c:pt>
                <c:pt idx="556">
                  <c:v>16028.762468338013</c:v>
                </c:pt>
                <c:pt idx="557">
                  <c:v>16032.011234283447</c:v>
                </c:pt>
                <c:pt idx="558">
                  <c:v>16028.717142105103</c:v>
                </c:pt>
                <c:pt idx="559">
                  <c:v>16017.965909957886</c:v>
                </c:pt>
                <c:pt idx="560">
                  <c:v>16010.757532119751</c:v>
                </c:pt>
                <c:pt idx="561">
                  <c:v>16007.549155712128</c:v>
                </c:pt>
                <c:pt idx="562">
                  <c:v>16009.912207603455</c:v>
                </c:pt>
                <c:pt idx="563">
                  <c:v>16018.103830337524</c:v>
                </c:pt>
                <c:pt idx="564">
                  <c:v>16030.981168746948</c:v>
                </c:pt>
                <c:pt idx="565">
                  <c:v>16031.258506774902</c:v>
                </c:pt>
                <c:pt idx="566">
                  <c:v>16060.478702545166</c:v>
                </c:pt>
                <c:pt idx="567">
                  <c:v>16145.127471923828</c:v>
                </c:pt>
                <c:pt idx="568">
                  <c:v>16216.061950683594</c:v>
                </c:pt>
                <c:pt idx="569">
                  <c:v>16201.453567504883</c:v>
                </c:pt>
                <c:pt idx="570">
                  <c:v>16138.245193481445</c:v>
                </c:pt>
                <c:pt idx="571">
                  <c:v>16100.722534179688</c:v>
                </c:pt>
                <c:pt idx="572">
                  <c:v>16091.514152526855</c:v>
                </c:pt>
                <c:pt idx="573">
                  <c:v>16098.53434753418</c:v>
                </c:pt>
                <c:pt idx="574">
                  <c:v>16109.068832397461</c:v>
                </c:pt>
                <c:pt idx="575">
                  <c:v>16110.374740600586</c:v>
                </c:pt>
                <c:pt idx="576">
                  <c:v>16095.023506164551</c:v>
                </c:pt>
                <c:pt idx="577">
                  <c:v>16076.872276306152</c:v>
                </c:pt>
                <c:pt idx="578">
                  <c:v>16080.406753540039</c:v>
                </c:pt>
                <c:pt idx="579">
                  <c:v>16109.026947021484</c:v>
                </c:pt>
                <c:pt idx="580">
                  <c:v>16134.932861328125</c:v>
                </c:pt>
                <c:pt idx="581">
                  <c:v>16138.295913696289</c:v>
                </c:pt>
                <c:pt idx="582">
                  <c:v>16127.401817321777</c:v>
                </c:pt>
                <c:pt idx="583">
                  <c:v>16115.079154968262</c:v>
                </c:pt>
                <c:pt idx="584">
                  <c:v>16101.756492614746</c:v>
                </c:pt>
                <c:pt idx="585">
                  <c:v>16083.605262756348</c:v>
                </c:pt>
                <c:pt idx="586">
                  <c:v>16073.939743041992</c:v>
                </c:pt>
                <c:pt idx="587">
                  <c:v>16080.302795410156</c:v>
                </c:pt>
                <c:pt idx="588">
                  <c:v>16093.551559448242</c:v>
                </c:pt>
                <c:pt idx="589">
                  <c:v>16103.02889251709</c:v>
                </c:pt>
                <c:pt idx="590">
                  <c:v>16113.477661132813</c:v>
                </c:pt>
                <c:pt idx="591">
                  <c:v>16122.526428222656</c:v>
                </c:pt>
                <c:pt idx="592">
                  <c:v>16122.832336425781</c:v>
                </c:pt>
                <c:pt idx="593">
                  <c:v>16119.538246154785</c:v>
                </c:pt>
                <c:pt idx="594">
                  <c:v>16090.415580749512</c:v>
                </c:pt>
                <c:pt idx="595">
                  <c:v>16180.321487426758</c:v>
                </c:pt>
                <c:pt idx="596">
                  <c:v>17717.455932617188</c:v>
                </c:pt>
                <c:pt idx="597">
                  <c:v>23835.93310546875</c:v>
                </c:pt>
                <c:pt idx="598">
                  <c:v>38232.49609375</c:v>
                </c:pt>
                <c:pt idx="599">
                  <c:v>63068.03125</c:v>
                </c:pt>
                <c:pt idx="600">
                  <c:v>98246.3359375</c:v>
                </c:pt>
                <c:pt idx="601">
                  <c:v>142778.7578125</c:v>
                </c:pt>
                <c:pt idx="602">
                  <c:v>196857.953125</c:v>
                </c:pt>
                <c:pt idx="603">
                  <c:v>242900.546875</c:v>
                </c:pt>
                <c:pt idx="604">
                  <c:v>265425.59375</c:v>
                </c:pt>
                <c:pt idx="605">
                  <c:v>265425.578125</c:v>
                </c:pt>
                <c:pt idx="606">
                  <c:v>265425.578125</c:v>
                </c:pt>
                <c:pt idx="607">
                  <c:v>265425.5625</c:v>
                </c:pt>
                <c:pt idx="608">
                  <c:v>265425.5625</c:v>
                </c:pt>
                <c:pt idx="609">
                  <c:v>265425.546875</c:v>
                </c:pt>
                <c:pt idx="610">
                  <c:v>265425.53125</c:v>
                </c:pt>
                <c:pt idx="611">
                  <c:v>265425.53125</c:v>
                </c:pt>
                <c:pt idx="612">
                  <c:v>265425.515625</c:v>
                </c:pt>
                <c:pt idx="613">
                  <c:v>265425.515625</c:v>
                </c:pt>
                <c:pt idx="614">
                  <c:v>265425.5</c:v>
                </c:pt>
                <c:pt idx="615">
                  <c:v>265425.5</c:v>
                </c:pt>
                <c:pt idx="616">
                  <c:v>265425.484375</c:v>
                </c:pt>
                <c:pt idx="617">
                  <c:v>265425.484375</c:v>
                </c:pt>
                <c:pt idx="618">
                  <c:v>265425.46875</c:v>
                </c:pt>
                <c:pt idx="619">
                  <c:v>265425.46875</c:v>
                </c:pt>
                <c:pt idx="620">
                  <c:v>265425.453125</c:v>
                </c:pt>
                <c:pt idx="621">
                  <c:v>265425.453125</c:v>
                </c:pt>
                <c:pt idx="622">
                  <c:v>265425.4375</c:v>
                </c:pt>
                <c:pt idx="623">
                  <c:v>265425.4375</c:v>
                </c:pt>
                <c:pt idx="624">
                  <c:v>265425.421875</c:v>
                </c:pt>
                <c:pt idx="625">
                  <c:v>265425.40625</c:v>
                </c:pt>
                <c:pt idx="626">
                  <c:v>265425.40625</c:v>
                </c:pt>
                <c:pt idx="627">
                  <c:v>265425.390625</c:v>
                </c:pt>
                <c:pt idx="628">
                  <c:v>265425.390625</c:v>
                </c:pt>
                <c:pt idx="629">
                  <c:v>265425.375</c:v>
                </c:pt>
                <c:pt idx="630">
                  <c:v>265425.375</c:v>
                </c:pt>
                <c:pt idx="631">
                  <c:v>265425.359375</c:v>
                </c:pt>
                <c:pt idx="632">
                  <c:v>265425.359375</c:v>
                </c:pt>
                <c:pt idx="633">
                  <c:v>265425.34375</c:v>
                </c:pt>
                <c:pt idx="634">
                  <c:v>265425.34375</c:v>
                </c:pt>
                <c:pt idx="635">
                  <c:v>265425.328125</c:v>
                </c:pt>
                <c:pt idx="636">
                  <c:v>265425.328125</c:v>
                </c:pt>
                <c:pt idx="637">
                  <c:v>265425.3125</c:v>
                </c:pt>
                <c:pt idx="638">
                  <c:v>265425.296875</c:v>
                </c:pt>
                <c:pt idx="639">
                  <c:v>265425.296875</c:v>
                </c:pt>
                <c:pt idx="640">
                  <c:v>265425.28125</c:v>
                </c:pt>
                <c:pt idx="641">
                  <c:v>265425.28125</c:v>
                </c:pt>
                <c:pt idx="642">
                  <c:v>265425.265625</c:v>
                </c:pt>
                <c:pt idx="643">
                  <c:v>265425.265625</c:v>
                </c:pt>
                <c:pt idx="644">
                  <c:v>265425.25</c:v>
                </c:pt>
                <c:pt idx="645">
                  <c:v>265425.25</c:v>
                </c:pt>
                <c:pt idx="646">
                  <c:v>265425.234375</c:v>
                </c:pt>
                <c:pt idx="647">
                  <c:v>265425.234375</c:v>
                </c:pt>
                <c:pt idx="648">
                  <c:v>265425.21875</c:v>
                </c:pt>
                <c:pt idx="649">
                  <c:v>265425.21875</c:v>
                </c:pt>
                <c:pt idx="650">
                  <c:v>265425.203125</c:v>
                </c:pt>
                <c:pt idx="651">
                  <c:v>265425.1875</c:v>
                </c:pt>
                <c:pt idx="652">
                  <c:v>265425.1875</c:v>
                </c:pt>
                <c:pt idx="653">
                  <c:v>265425.171875</c:v>
                </c:pt>
                <c:pt idx="654">
                  <c:v>265425.171875</c:v>
                </c:pt>
                <c:pt idx="655">
                  <c:v>265425.15625</c:v>
                </c:pt>
                <c:pt idx="656">
                  <c:v>265425.15625</c:v>
                </c:pt>
                <c:pt idx="657">
                  <c:v>265425.140625</c:v>
                </c:pt>
                <c:pt idx="658">
                  <c:v>265425.140625</c:v>
                </c:pt>
                <c:pt idx="659">
                  <c:v>265425.125</c:v>
                </c:pt>
                <c:pt idx="660">
                  <c:v>265425.125</c:v>
                </c:pt>
                <c:pt idx="661">
                  <c:v>265425.109375</c:v>
                </c:pt>
                <c:pt idx="662">
                  <c:v>265425.109375</c:v>
                </c:pt>
                <c:pt idx="663">
                  <c:v>265425.09375</c:v>
                </c:pt>
                <c:pt idx="664">
                  <c:v>265425.09375</c:v>
                </c:pt>
                <c:pt idx="665">
                  <c:v>265425.078125</c:v>
                </c:pt>
                <c:pt idx="666">
                  <c:v>265425.0625</c:v>
                </c:pt>
                <c:pt idx="667">
                  <c:v>265425.0625</c:v>
                </c:pt>
                <c:pt idx="668">
                  <c:v>265425.046875</c:v>
                </c:pt>
                <c:pt idx="669">
                  <c:v>265425.046875</c:v>
                </c:pt>
                <c:pt idx="670">
                  <c:v>265425.03125</c:v>
                </c:pt>
                <c:pt idx="671">
                  <c:v>265425.03125</c:v>
                </c:pt>
                <c:pt idx="672">
                  <c:v>265425.015625</c:v>
                </c:pt>
                <c:pt idx="673">
                  <c:v>265425.015625</c:v>
                </c:pt>
                <c:pt idx="674">
                  <c:v>265425</c:v>
                </c:pt>
                <c:pt idx="675">
                  <c:v>265425</c:v>
                </c:pt>
                <c:pt idx="676">
                  <c:v>265424.984375</c:v>
                </c:pt>
                <c:pt idx="677">
                  <c:v>265424.984375</c:v>
                </c:pt>
                <c:pt idx="678">
                  <c:v>265424.96875</c:v>
                </c:pt>
                <c:pt idx="679">
                  <c:v>265424.953125</c:v>
                </c:pt>
                <c:pt idx="680">
                  <c:v>265424.953125</c:v>
                </c:pt>
                <c:pt idx="681">
                  <c:v>265424.9375</c:v>
                </c:pt>
                <c:pt idx="682">
                  <c:v>265424.9375</c:v>
                </c:pt>
                <c:pt idx="683">
                  <c:v>265424.921875</c:v>
                </c:pt>
                <c:pt idx="684">
                  <c:v>265424.921875</c:v>
                </c:pt>
                <c:pt idx="685">
                  <c:v>265424.90625</c:v>
                </c:pt>
                <c:pt idx="686">
                  <c:v>265424.90625</c:v>
                </c:pt>
                <c:pt idx="687">
                  <c:v>265424.890625</c:v>
                </c:pt>
                <c:pt idx="688">
                  <c:v>265424.890625</c:v>
                </c:pt>
                <c:pt idx="689">
                  <c:v>265424.875</c:v>
                </c:pt>
                <c:pt idx="690">
                  <c:v>259101.890625</c:v>
                </c:pt>
                <c:pt idx="691">
                  <c:v>243142.40625</c:v>
                </c:pt>
                <c:pt idx="692">
                  <c:v>229379.90625</c:v>
                </c:pt>
                <c:pt idx="693">
                  <c:v>206047.671875</c:v>
                </c:pt>
                <c:pt idx="694">
                  <c:v>154901.203125</c:v>
                </c:pt>
                <c:pt idx="695">
                  <c:v>93559.7734375</c:v>
                </c:pt>
                <c:pt idx="696">
                  <c:v>53201.07421875</c:v>
                </c:pt>
                <c:pt idx="697">
                  <c:v>33767.294921875</c:v>
                </c:pt>
                <c:pt idx="698">
                  <c:v>26613.7158203125</c:v>
                </c:pt>
                <c:pt idx="699">
                  <c:v>24961.1357421875</c:v>
                </c:pt>
                <c:pt idx="700">
                  <c:v>25368.69921875</c:v>
                </c:pt>
                <c:pt idx="701">
                  <c:v>26491.205078125</c:v>
                </c:pt>
                <c:pt idx="702">
                  <c:v>27785.33984375</c:v>
                </c:pt>
                <c:pt idx="703">
                  <c:v>29442.16015625</c:v>
                </c:pt>
                <c:pt idx="704">
                  <c:v>32133.4658203125</c:v>
                </c:pt>
                <c:pt idx="705">
                  <c:v>36061.62890625</c:v>
                </c:pt>
                <c:pt idx="706">
                  <c:v>40590.333984375</c:v>
                </c:pt>
                <c:pt idx="707">
                  <c:v>45030.26953125</c:v>
                </c:pt>
                <c:pt idx="708">
                  <c:v>49289.43359375</c:v>
                </c:pt>
                <c:pt idx="709">
                  <c:v>53730.796875</c:v>
                </c:pt>
                <c:pt idx="710">
                  <c:v>58807.84375</c:v>
                </c:pt>
                <c:pt idx="711">
                  <c:v>65029.43359375</c:v>
                </c:pt>
                <c:pt idx="712">
                  <c:v>73041.3984375</c:v>
                </c:pt>
                <c:pt idx="713">
                  <c:v>83486.90625</c:v>
                </c:pt>
                <c:pt idx="714">
                  <c:v>96503.953125</c:v>
                </c:pt>
                <c:pt idx="715">
                  <c:v>110810.1171875</c:v>
                </c:pt>
                <c:pt idx="716">
                  <c:v>122888.3046875</c:v>
                </c:pt>
                <c:pt idx="717">
                  <c:v>127836.953125</c:v>
                </c:pt>
                <c:pt idx="718">
                  <c:v>123467.6640625</c:v>
                </c:pt>
                <c:pt idx="719">
                  <c:v>112077.59375</c:v>
                </c:pt>
                <c:pt idx="720">
                  <c:v>97084.21875</c:v>
                </c:pt>
                <c:pt idx="721">
                  <c:v>81365.06640625</c:v>
                </c:pt>
                <c:pt idx="722">
                  <c:v>67907.5703125</c:v>
                </c:pt>
                <c:pt idx="723">
                  <c:v>59356.19140625</c:v>
                </c:pt>
                <c:pt idx="724">
                  <c:v>56002.61328125</c:v>
                </c:pt>
                <c:pt idx="725">
                  <c:v>56963.60546875</c:v>
                </c:pt>
                <c:pt idx="726">
                  <c:v>61073.13671875</c:v>
                </c:pt>
                <c:pt idx="727">
                  <c:v>66968.47265625</c:v>
                </c:pt>
                <c:pt idx="728">
                  <c:v>73493.3203125</c:v>
                </c:pt>
                <c:pt idx="729">
                  <c:v>80053.45703125</c:v>
                </c:pt>
                <c:pt idx="730">
                  <c:v>86438.9296875</c:v>
                </c:pt>
                <c:pt idx="731">
                  <c:v>92477.6953125</c:v>
                </c:pt>
                <c:pt idx="732">
                  <c:v>97861.890625</c:v>
                </c:pt>
                <c:pt idx="733">
                  <c:v>102275.625</c:v>
                </c:pt>
                <c:pt idx="734">
                  <c:v>105552.9296875</c:v>
                </c:pt>
                <c:pt idx="735">
                  <c:v>107864.203125</c:v>
                </c:pt>
                <c:pt idx="736">
                  <c:v>108805.0234375</c:v>
                </c:pt>
                <c:pt idx="737">
                  <c:v>104658.046875</c:v>
                </c:pt>
                <c:pt idx="738">
                  <c:v>91418.609375</c:v>
                </c:pt>
                <c:pt idx="739">
                  <c:v>72129.97265625</c:v>
                </c:pt>
                <c:pt idx="740">
                  <c:v>56573.93359375</c:v>
                </c:pt>
                <c:pt idx="741">
                  <c:v>49709.09765625</c:v>
                </c:pt>
                <c:pt idx="742">
                  <c:v>47853.43359375</c:v>
                </c:pt>
                <c:pt idx="743">
                  <c:v>46947.025390625</c:v>
                </c:pt>
                <c:pt idx="744">
                  <c:v>47090.1015625</c:v>
                </c:pt>
                <c:pt idx="745">
                  <c:v>48010.8359375</c:v>
                </c:pt>
                <c:pt idx="746">
                  <c:v>47488.341796875</c:v>
                </c:pt>
                <c:pt idx="747">
                  <c:v>45272.734375</c:v>
                </c:pt>
                <c:pt idx="748">
                  <c:v>43747.412109375</c:v>
                </c:pt>
                <c:pt idx="749">
                  <c:v>46121.974609375</c:v>
                </c:pt>
                <c:pt idx="750">
                  <c:v>58428.65234375</c:v>
                </c:pt>
                <c:pt idx="751">
                  <c:v>90540.359375</c:v>
                </c:pt>
                <c:pt idx="752">
                  <c:v>148921.640625</c:v>
                </c:pt>
                <c:pt idx="753">
                  <c:v>218592.734375</c:v>
                </c:pt>
                <c:pt idx="754">
                  <c:v>261878.328125</c:v>
                </c:pt>
                <c:pt idx="755">
                  <c:v>243229.75</c:v>
                </c:pt>
                <c:pt idx="756">
                  <c:v>177295.03125</c:v>
                </c:pt>
                <c:pt idx="757">
                  <c:v>107778.9375</c:v>
                </c:pt>
                <c:pt idx="758">
                  <c:v>65296.35546875</c:v>
                </c:pt>
                <c:pt idx="759">
                  <c:v>45785.662109375</c:v>
                </c:pt>
                <c:pt idx="760">
                  <c:v>39404.681640625</c:v>
                </c:pt>
                <c:pt idx="761">
                  <c:v>38095.16015625</c:v>
                </c:pt>
                <c:pt idx="762">
                  <c:v>37992.236328125</c:v>
                </c:pt>
                <c:pt idx="763">
                  <c:v>39311.34375</c:v>
                </c:pt>
                <c:pt idx="764">
                  <c:v>42782.5625</c:v>
                </c:pt>
                <c:pt idx="765">
                  <c:v>46117.640625</c:v>
                </c:pt>
                <c:pt idx="766">
                  <c:v>45618.259765625</c:v>
                </c:pt>
                <c:pt idx="767">
                  <c:v>41109.966796875</c:v>
                </c:pt>
                <c:pt idx="768">
                  <c:v>36221.38671875</c:v>
                </c:pt>
                <c:pt idx="769">
                  <c:v>33721.435546875</c:v>
                </c:pt>
                <c:pt idx="770">
                  <c:v>33382.427734375</c:v>
                </c:pt>
                <c:pt idx="771">
                  <c:v>33949.103515625</c:v>
                </c:pt>
                <c:pt idx="772">
                  <c:v>35213.41015625</c:v>
                </c:pt>
                <c:pt idx="773">
                  <c:v>38009.287109375</c:v>
                </c:pt>
                <c:pt idx="774">
                  <c:v>43485.3359375</c:v>
                </c:pt>
                <c:pt idx="775">
                  <c:v>53241.671875</c:v>
                </c:pt>
                <c:pt idx="776">
                  <c:v>69760.546875</c:v>
                </c:pt>
                <c:pt idx="777">
                  <c:v>94700.9375</c:v>
                </c:pt>
                <c:pt idx="778">
                  <c:v>126656.6484375</c:v>
                </c:pt>
                <c:pt idx="779">
                  <c:v>161914.953125</c:v>
                </c:pt>
                <c:pt idx="780">
                  <c:v>197212.515625</c:v>
                </c:pt>
                <c:pt idx="781">
                  <c:v>233023.84375</c:v>
                </c:pt>
                <c:pt idx="782">
                  <c:v>257836.40625</c:v>
                </c:pt>
                <c:pt idx="783">
                  <c:v>265424.09375</c:v>
                </c:pt>
                <c:pt idx="784">
                  <c:v>265424.078125</c:v>
                </c:pt>
                <c:pt idx="785">
                  <c:v>263305.984375</c:v>
                </c:pt>
                <c:pt idx="786">
                  <c:v>225450.671875</c:v>
                </c:pt>
                <c:pt idx="787">
                  <c:v>158417.71875</c:v>
                </c:pt>
                <c:pt idx="788">
                  <c:v>94855.59375</c:v>
                </c:pt>
                <c:pt idx="789">
                  <c:v>59445.125</c:v>
                </c:pt>
                <c:pt idx="790">
                  <c:v>44871.859375</c:v>
                </c:pt>
                <c:pt idx="791">
                  <c:v>41537.9375</c:v>
                </c:pt>
                <c:pt idx="792">
                  <c:v>41485.900390625</c:v>
                </c:pt>
                <c:pt idx="793">
                  <c:v>40404.86328125</c:v>
                </c:pt>
                <c:pt idx="794">
                  <c:v>37764.51171875</c:v>
                </c:pt>
                <c:pt idx="795">
                  <c:v>34944.818359375</c:v>
                </c:pt>
                <c:pt idx="796">
                  <c:v>33128.466796875</c:v>
                </c:pt>
                <c:pt idx="797">
                  <c:v>32969.4296875</c:v>
                </c:pt>
                <c:pt idx="798">
                  <c:v>34986.79296875</c:v>
                </c:pt>
                <c:pt idx="799">
                  <c:v>39314.869140625</c:v>
                </c:pt>
                <c:pt idx="800">
                  <c:v>45274.205078125</c:v>
                </c:pt>
                <c:pt idx="801">
                  <c:v>50530.59765625</c:v>
                </c:pt>
                <c:pt idx="802">
                  <c:v>51169.55859375</c:v>
                </c:pt>
                <c:pt idx="803">
                  <c:v>46173.693359375</c:v>
                </c:pt>
                <c:pt idx="804">
                  <c:v>40181.798828125</c:v>
                </c:pt>
                <c:pt idx="805">
                  <c:v>39999.048828125</c:v>
                </c:pt>
                <c:pt idx="806">
                  <c:v>48630.353515625</c:v>
                </c:pt>
                <c:pt idx="807">
                  <c:v>65857.91796875</c:v>
                </c:pt>
                <c:pt idx="808">
                  <c:v>91302.5390625</c:v>
                </c:pt>
                <c:pt idx="809">
                  <c:v>125821.15625</c:v>
                </c:pt>
                <c:pt idx="810">
                  <c:v>171395.0625</c:v>
                </c:pt>
                <c:pt idx="811">
                  <c:v>223941.34375</c:v>
                </c:pt>
                <c:pt idx="812">
                  <c:v>258997.078125</c:v>
                </c:pt>
                <c:pt idx="813">
                  <c:v>265423.84375</c:v>
                </c:pt>
                <c:pt idx="814">
                  <c:v>265423.828125</c:v>
                </c:pt>
                <c:pt idx="815">
                  <c:v>265423.828125</c:v>
                </c:pt>
                <c:pt idx="816">
                  <c:v>265423.8125</c:v>
                </c:pt>
                <c:pt idx="817">
                  <c:v>265423.8125</c:v>
                </c:pt>
                <c:pt idx="818">
                  <c:v>265423.796875</c:v>
                </c:pt>
                <c:pt idx="819">
                  <c:v>265423.78125</c:v>
                </c:pt>
                <c:pt idx="820">
                  <c:v>265423.78125</c:v>
                </c:pt>
                <c:pt idx="821">
                  <c:v>265423.765625</c:v>
                </c:pt>
                <c:pt idx="822">
                  <c:v>265423.765625</c:v>
                </c:pt>
                <c:pt idx="823">
                  <c:v>265423.75</c:v>
                </c:pt>
                <c:pt idx="824">
                  <c:v>265423.75</c:v>
                </c:pt>
                <c:pt idx="825">
                  <c:v>265423.734375</c:v>
                </c:pt>
                <c:pt idx="826">
                  <c:v>265423.734375</c:v>
                </c:pt>
                <c:pt idx="827">
                  <c:v>265423.71875</c:v>
                </c:pt>
                <c:pt idx="828">
                  <c:v>265423.71875</c:v>
                </c:pt>
                <c:pt idx="829">
                  <c:v>259109.125</c:v>
                </c:pt>
                <c:pt idx="830">
                  <c:v>209652.8125</c:v>
                </c:pt>
                <c:pt idx="831">
                  <c:v>133170.1484375</c:v>
                </c:pt>
                <c:pt idx="832">
                  <c:v>70861.53515625</c:v>
                </c:pt>
                <c:pt idx="833">
                  <c:v>39354.099609375</c:v>
                </c:pt>
                <c:pt idx="834">
                  <c:v>26980.662109375</c:v>
                </c:pt>
                <c:pt idx="835">
                  <c:v>23410.05419921875</c:v>
                </c:pt>
                <c:pt idx="836">
                  <c:v>22365.3310546875</c:v>
                </c:pt>
                <c:pt idx="837">
                  <c:v>21610.3515625</c:v>
                </c:pt>
                <c:pt idx="838">
                  <c:v>20925.48583984375</c:v>
                </c:pt>
                <c:pt idx="839">
                  <c:v>20437.50634765625</c:v>
                </c:pt>
                <c:pt idx="840">
                  <c:v>20192.7265625</c:v>
                </c:pt>
                <c:pt idx="841">
                  <c:v>20266.91796875</c:v>
                </c:pt>
                <c:pt idx="842">
                  <c:v>21013.3955078125</c:v>
                </c:pt>
                <c:pt idx="843">
                  <c:v>23259.47265625</c:v>
                </c:pt>
                <c:pt idx="844">
                  <c:v>28091.521484375</c:v>
                </c:pt>
                <c:pt idx="845">
                  <c:v>36287.19921875</c:v>
                </c:pt>
                <c:pt idx="846">
                  <c:v>47915.76171875</c:v>
                </c:pt>
                <c:pt idx="847">
                  <c:v>62441.5546875</c:v>
                </c:pt>
                <c:pt idx="848">
                  <c:v>79164.2578125</c:v>
                </c:pt>
                <c:pt idx="849">
                  <c:v>96859.8828125</c:v>
                </c:pt>
                <c:pt idx="850">
                  <c:v>109271.84375</c:v>
                </c:pt>
                <c:pt idx="851">
                  <c:v>105399.1796875</c:v>
                </c:pt>
                <c:pt idx="852">
                  <c:v>83086.96875</c:v>
                </c:pt>
                <c:pt idx="853">
                  <c:v>54330.90234375</c:v>
                </c:pt>
                <c:pt idx="854">
                  <c:v>33199.837890625</c:v>
                </c:pt>
                <c:pt idx="855">
                  <c:v>22741.20068359375</c:v>
                </c:pt>
                <c:pt idx="856">
                  <c:v>19118.449462890625</c:v>
                </c:pt>
                <c:pt idx="857">
                  <c:v>18162.783935546875</c:v>
                </c:pt>
                <c:pt idx="858">
                  <c:v>17772.632690429688</c:v>
                </c:pt>
                <c:pt idx="859">
                  <c:v>17450.2529296875</c:v>
                </c:pt>
                <c:pt idx="860">
                  <c:v>17214.81591796875</c:v>
                </c:pt>
                <c:pt idx="861">
                  <c:v>17087.893310546875</c:v>
                </c:pt>
                <c:pt idx="862">
                  <c:v>17033.999267578125</c:v>
                </c:pt>
                <c:pt idx="863">
                  <c:v>17001.762268066406</c:v>
                </c:pt>
                <c:pt idx="864">
                  <c:v>16960.411010742188</c:v>
                </c:pt>
                <c:pt idx="865">
                  <c:v>16915.688354492188</c:v>
                </c:pt>
                <c:pt idx="866">
                  <c:v>16889.108581542969</c:v>
                </c:pt>
                <c:pt idx="867">
                  <c:v>16890.443054199219</c:v>
                </c:pt>
                <c:pt idx="868">
                  <c:v>16948.834655761719</c:v>
                </c:pt>
                <c:pt idx="869">
                  <c:v>17127.42626953125</c:v>
                </c:pt>
                <c:pt idx="870">
                  <c:v>17464.47509765625</c:v>
                </c:pt>
                <c:pt idx="871">
                  <c:v>17872.838134765625</c:v>
                </c:pt>
                <c:pt idx="872">
                  <c:v>18123.8583984375</c:v>
                </c:pt>
                <c:pt idx="873">
                  <c:v>18040.478515625</c:v>
                </c:pt>
                <c:pt idx="874">
                  <c:v>17683.670166015625</c:v>
                </c:pt>
                <c:pt idx="875">
                  <c:v>17287.1474609375</c:v>
                </c:pt>
                <c:pt idx="876">
                  <c:v>17012.910522460938</c:v>
                </c:pt>
                <c:pt idx="877">
                  <c:v>16869.244995117188</c:v>
                </c:pt>
                <c:pt idx="878">
                  <c:v>16799.293762207031</c:v>
                </c:pt>
                <c:pt idx="879">
                  <c:v>16771.656799316406</c:v>
                </c:pt>
                <c:pt idx="880">
                  <c:v>16778.019897460938</c:v>
                </c:pt>
                <c:pt idx="881">
                  <c:v>16813.354370117188</c:v>
                </c:pt>
                <c:pt idx="882">
                  <c:v>16865.860229492188</c:v>
                </c:pt>
                <c:pt idx="883">
                  <c:v>16924.451904296875</c:v>
                </c:pt>
                <c:pt idx="884">
                  <c:v>16965.129211425781</c:v>
                </c:pt>
                <c:pt idx="885">
                  <c:v>16969.177978515625</c:v>
                </c:pt>
                <c:pt idx="886">
                  <c:v>16946.512451171875</c:v>
                </c:pt>
                <c:pt idx="887">
                  <c:v>16938.932678222656</c:v>
                </c:pt>
                <c:pt idx="888">
                  <c:v>16950.095703125</c:v>
                </c:pt>
                <c:pt idx="889">
                  <c:v>16946.544494628906</c:v>
                </c:pt>
                <c:pt idx="890">
                  <c:v>16899.70751953125</c:v>
                </c:pt>
                <c:pt idx="891">
                  <c:v>16815.527709960938</c:v>
                </c:pt>
                <c:pt idx="892">
                  <c:v>16714.862182617188</c:v>
                </c:pt>
                <c:pt idx="893">
                  <c:v>16627.796691894531</c:v>
                </c:pt>
                <c:pt idx="894">
                  <c:v>16590.81689453125</c:v>
                </c:pt>
                <c:pt idx="895">
                  <c:v>16602.20849609375</c:v>
                </c:pt>
                <c:pt idx="896">
                  <c:v>16620.143005371094</c:v>
                </c:pt>
                <c:pt idx="897">
                  <c:v>16612.506042480469</c:v>
                </c:pt>
                <c:pt idx="898">
                  <c:v>16585.383361816406</c:v>
                </c:pt>
                <c:pt idx="899">
                  <c:v>16559.289306640625</c:v>
                </c:pt>
                <c:pt idx="900">
                  <c:v>16541.966613769531</c:v>
                </c:pt>
                <c:pt idx="901">
                  <c:v>16538.98681640625</c:v>
                </c:pt>
                <c:pt idx="902">
                  <c:v>16539.492736816406</c:v>
                </c:pt>
                <c:pt idx="903">
                  <c:v>16534.712951660156</c:v>
                </c:pt>
                <c:pt idx="904">
                  <c:v>16522.904541015625</c:v>
                </c:pt>
                <c:pt idx="905">
                  <c:v>16509.21044921875</c:v>
                </c:pt>
                <c:pt idx="906">
                  <c:v>16493.144927978516</c:v>
                </c:pt>
                <c:pt idx="907">
                  <c:v>16482.850830078125</c:v>
                </c:pt>
                <c:pt idx="908">
                  <c:v>16479.04248046875</c:v>
                </c:pt>
                <c:pt idx="909">
                  <c:v>16486.291229248047</c:v>
                </c:pt>
                <c:pt idx="910">
                  <c:v>16506.111419677734</c:v>
                </c:pt>
                <c:pt idx="911">
                  <c:v>16533.98876953125</c:v>
                </c:pt>
                <c:pt idx="912">
                  <c:v>16552.494689941406</c:v>
                </c:pt>
                <c:pt idx="913">
                  <c:v>16553.286315917969</c:v>
                </c:pt>
                <c:pt idx="914">
                  <c:v>16540.620788574219</c:v>
                </c:pt>
                <c:pt idx="915">
                  <c:v>16536.955261230469</c:v>
                </c:pt>
                <c:pt idx="916">
                  <c:v>16573.975463867188</c:v>
                </c:pt>
                <c:pt idx="917">
                  <c:v>16662.167053222656</c:v>
                </c:pt>
                <c:pt idx="918">
                  <c:v>16779.330139160156</c:v>
                </c:pt>
                <c:pt idx="919">
                  <c:v>16938.664611816406</c:v>
                </c:pt>
                <c:pt idx="920">
                  <c:v>17308.856201171875</c:v>
                </c:pt>
                <c:pt idx="921">
                  <c:v>18265.162109375</c:v>
                </c:pt>
                <c:pt idx="922">
                  <c:v>20298.525390625</c:v>
                </c:pt>
                <c:pt idx="923">
                  <c:v>23784.9453125</c:v>
                </c:pt>
                <c:pt idx="924">
                  <c:v>28753.080078125</c:v>
                </c:pt>
                <c:pt idx="925">
                  <c:v>34603.443359375</c:v>
                </c:pt>
                <c:pt idx="926">
                  <c:v>39665.263671875</c:v>
                </c:pt>
                <c:pt idx="927">
                  <c:v>41274.94140625</c:v>
                </c:pt>
                <c:pt idx="928">
                  <c:v>37857.24609375</c:v>
                </c:pt>
                <c:pt idx="929">
                  <c:v>30919.4375</c:v>
                </c:pt>
                <c:pt idx="930">
                  <c:v>23982.0869140625</c:v>
                </c:pt>
                <c:pt idx="931">
                  <c:v>19458.564208984375</c:v>
                </c:pt>
                <c:pt idx="932">
                  <c:v>17478.641479492188</c:v>
                </c:pt>
                <c:pt idx="933">
                  <c:v>17036.490234375</c:v>
                </c:pt>
                <c:pt idx="934">
                  <c:v>17250.16748046875</c:v>
                </c:pt>
                <c:pt idx="935">
                  <c:v>17707.130615234375</c:v>
                </c:pt>
                <c:pt idx="936">
                  <c:v>18261.522216796875</c:v>
                </c:pt>
                <c:pt idx="937">
                  <c:v>18805.9423828125</c:v>
                </c:pt>
                <c:pt idx="938">
                  <c:v>19234.677001953125</c:v>
                </c:pt>
                <c:pt idx="939">
                  <c:v>19455.811279296875</c:v>
                </c:pt>
                <c:pt idx="940">
                  <c:v>19400.460205078125</c:v>
                </c:pt>
                <c:pt idx="941">
                  <c:v>19034.308837890625</c:v>
                </c:pt>
                <c:pt idx="942">
                  <c:v>18416.014892578125</c:v>
                </c:pt>
                <c:pt idx="943">
                  <c:v>17716.377807617188</c:v>
                </c:pt>
                <c:pt idx="944">
                  <c:v>17122.340942382813</c:v>
                </c:pt>
                <c:pt idx="945">
                  <c:v>16724.618225097656</c:v>
                </c:pt>
                <c:pt idx="946">
                  <c:v>16506.895599365234</c:v>
                </c:pt>
                <c:pt idx="947">
                  <c:v>16413.544342041016</c:v>
                </c:pt>
                <c:pt idx="948">
                  <c:v>16386.850250244141</c:v>
                </c:pt>
                <c:pt idx="949">
                  <c:v>16387.213317871094</c:v>
                </c:pt>
                <c:pt idx="950">
                  <c:v>16394.233520507813</c:v>
                </c:pt>
                <c:pt idx="951">
                  <c:v>16405.167999267578</c:v>
                </c:pt>
                <c:pt idx="952">
                  <c:v>16422.873901367188</c:v>
                </c:pt>
                <c:pt idx="953">
                  <c:v>16455.522674560547</c:v>
                </c:pt>
                <c:pt idx="954">
                  <c:v>16500.971435546875</c:v>
                </c:pt>
                <c:pt idx="955">
                  <c:v>16550.677368164063</c:v>
                </c:pt>
                <c:pt idx="956">
                  <c:v>16592.354675292969</c:v>
                </c:pt>
                <c:pt idx="957">
                  <c:v>16616.203430175781</c:v>
                </c:pt>
                <c:pt idx="958">
                  <c:v>16618.16650390625</c:v>
                </c:pt>
                <c:pt idx="959">
                  <c:v>16593.015258789063</c:v>
                </c:pt>
                <c:pt idx="960">
                  <c:v>16542.206909179688</c:v>
                </c:pt>
                <c:pt idx="961">
                  <c:v>16480.0556640625</c:v>
                </c:pt>
                <c:pt idx="962">
                  <c:v>16426.647277832031</c:v>
                </c:pt>
                <c:pt idx="963">
                  <c:v>16395.096038818359</c:v>
                </c:pt>
                <c:pt idx="964">
                  <c:v>16383.287658691406</c:v>
                </c:pt>
                <c:pt idx="965">
                  <c:v>16378.450714111328</c:v>
                </c:pt>
                <c:pt idx="966">
                  <c:v>16361.642333984375</c:v>
                </c:pt>
                <c:pt idx="967">
                  <c:v>16345.176818847656</c:v>
                </c:pt>
                <c:pt idx="968">
                  <c:v>16342.368438720703</c:v>
                </c:pt>
                <c:pt idx="969">
                  <c:v>16349.817199707031</c:v>
                </c:pt>
                <c:pt idx="970">
                  <c:v>16351.294555664063</c:v>
                </c:pt>
                <c:pt idx="971">
                  <c:v>16340.629028320313</c:v>
                </c:pt>
                <c:pt idx="972">
                  <c:v>16322.706359863281</c:v>
                </c:pt>
                <c:pt idx="973">
                  <c:v>16304.269409179688</c:v>
                </c:pt>
                <c:pt idx="974">
                  <c:v>16289.289611816406</c:v>
                </c:pt>
                <c:pt idx="975">
                  <c:v>16275.481231689453</c:v>
                </c:pt>
                <c:pt idx="976">
                  <c:v>16265.215728759766</c:v>
                </c:pt>
                <c:pt idx="977">
                  <c:v>16269.607330322266</c:v>
                </c:pt>
                <c:pt idx="978">
                  <c:v>16290.341827392578</c:v>
                </c:pt>
                <c:pt idx="979">
                  <c:v>16320.904876708984</c:v>
                </c:pt>
                <c:pt idx="980">
                  <c:v>16356.125061035156</c:v>
                </c:pt>
                <c:pt idx="981">
                  <c:v>16417.916687011719</c:v>
                </c:pt>
                <c:pt idx="982">
                  <c:v>16539.851196289063</c:v>
                </c:pt>
                <c:pt idx="983">
                  <c:v>16737.728515625</c:v>
                </c:pt>
                <c:pt idx="984">
                  <c:v>16991.634399414063</c:v>
                </c:pt>
                <c:pt idx="985">
                  <c:v>17231.597412109375</c:v>
                </c:pt>
                <c:pt idx="986">
                  <c:v>17363.50341796875</c:v>
                </c:pt>
                <c:pt idx="987">
                  <c:v>17329.1806640625</c:v>
                </c:pt>
                <c:pt idx="988">
                  <c:v>17156.372314453125</c:v>
                </c:pt>
                <c:pt idx="989">
                  <c:v>16926.792541503906</c:v>
                </c:pt>
                <c:pt idx="990">
                  <c:v>16722.84130859375</c:v>
                </c:pt>
                <c:pt idx="991">
                  <c:v>16580.661499023438</c:v>
                </c:pt>
                <c:pt idx="992">
                  <c:v>16493.053131103516</c:v>
                </c:pt>
                <c:pt idx="993">
                  <c:v>16443.159027099609</c:v>
                </c:pt>
                <c:pt idx="994">
                  <c:v>16433.236358642578</c:v>
                </c:pt>
                <c:pt idx="995">
                  <c:v>16455.627990722656</c:v>
                </c:pt>
                <c:pt idx="996">
                  <c:v>16496.705322265625</c:v>
                </c:pt>
                <c:pt idx="997">
                  <c:v>16564.668395996094</c:v>
                </c:pt>
                <c:pt idx="998">
                  <c:v>16715.374267578125</c:v>
                </c:pt>
                <c:pt idx="999">
                  <c:v>17021.880187988281</c:v>
                </c:pt>
                <c:pt idx="1000">
                  <c:v>17518.84326171875</c:v>
                </c:pt>
                <c:pt idx="1001">
                  <c:v>18111.94921875</c:v>
                </c:pt>
                <c:pt idx="1002">
                  <c:v>18582.5693359375</c:v>
                </c:pt>
                <c:pt idx="1003">
                  <c:v>18727.24658203125</c:v>
                </c:pt>
                <c:pt idx="1004">
                  <c:v>18493.552490234375</c:v>
                </c:pt>
                <c:pt idx="1005">
                  <c:v>18000.944213867188</c:v>
                </c:pt>
                <c:pt idx="1006">
                  <c:v>17446.821533203125</c:v>
                </c:pt>
                <c:pt idx="1007">
                  <c:v>16995.784606933594</c:v>
                </c:pt>
                <c:pt idx="1008">
                  <c:v>16709.861938476563</c:v>
                </c:pt>
                <c:pt idx="1009">
                  <c:v>16576.396423339844</c:v>
                </c:pt>
                <c:pt idx="1010">
                  <c:v>16549.759460449219</c:v>
                </c:pt>
                <c:pt idx="1011">
                  <c:v>16571.608276367188</c:v>
                </c:pt>
                <c:pt idx="1012">
                  <c:v>16593.999877929688</c:v>
                </c:pt>
                <c:pt idx="1013">
                  <c:v>16583.048645019531</c:v>
                </c:pt>
                <c:pt idx="1014">
                  <c:v>16531.897399902344</c:v>
                </c:pt>
                <c:pt idx="1015">
                  <c:v>16455.889038085938</c:v>
                </c:pt>
                <c:pt idx="1016">
                  <c:v>16392.137786865234</c:v>
                </c:pt>
                <c:pt idx="1017">
                  <c:v>16365.672271728516</c:v>
                </c:pt>
                <c:pt idx="1018">
                  <c:v>16380.063903808594</c:v>
                </c:pt>
                <c:pt idx="1019">
                  <c:v>16411.884094238281</c:v>
                </c:pt>
                <c:pt idx="1020">
                  <c:v>16439.390014648438</c:v>
                </c:pt>
                <c:pt idx="1021">
                  <c:v>16441.895904541016</c:v>
                </c:pt>
                <c:pt idx="1022">
                  <c:v>16419.373260498047</c:v>
                </c:pt>
                <c:pt idx="1023">
                  <c:v>16384.364868164063</c:v>
                </c:pt>
                <c:pt idx="1024">
                  <c:v>16354.042205810547</c:v>
                </c:pt>
                <c:pt idx="1025">
                  <c:v>16332.890960693359</c:v>
                </c:pt>
                <c:pt idx="1026">
                  <c:v>16328.825439453125</c:v>
                </c:pt>
                <c:pt idx="1027">
                  <c:v>16345.588500976563</c:v>
                </c:pt>
                <c:pt idx="1028">
                  <c:v>16387.3515625</c:v>
                </c:pt>
                <c:pt idx="1029">
                  <c:v>16555.228881835938</c:v>
                </c:pt>
                <c:pt idx="1030">
                  <c:v>17254.106201171875</c:v>
                </c:pt>
                <c:pt idx="1031">
                  <c:v>19355.78369140625</c:v>
                </c:pt>
                <c:pt idx="1032">
                  <c:v>24062.4609375</c:v>
                </c:pt>
                <c:pt idx="1033">
                  <c:v>32225.794921875</c:v>
                </c:pt>
                <c:pt idx="1034">
                  <c:v>43246.158203125</c:v>
                </c:pt>
                <c:pt idx="1035">
                  <c:v>54265.98046875</c:v>
                </c:pt>
                <c:pt idx="1036">
                  <c:v>60788.62890625</c:v>
                </c:pt>
                <c:pt idx="1037">
                  <c:v>59470.90625</c:v>
                </c:pt>
                <c:pt idx="1038">
                  <c:v>50984.5546875</c:v>
                </c:pt>
                <c:pt idx="1039">
                  <c:v>39480.74609375</c:v>
                </c:pt>
                <c:pt idx="1040">
                  <c:v>29281.6796875</c:v>
                </c:pt>
                <c:pt idx="1041">
                  <c:v>22415.81396484375</c:v>
                </c:pt>
                <c:pt idx="1042">
                  <c:v>18772.234375</c:v>
                </c:pt>
                <c:pt idx="1043">
                  <c:v>17258.054443359375</c:v>
                </c:pt>
                <c:pt idx="1044">
                  <c:v>16827.1318359375</c:v>
                </c:pt>
                <c:pt idx="1045">
                  <c:v>16886.237731933594</c:v>
                </c:pt>
                <c:pt idx="1046">
                  <c:v>17230.200805664063</c:v>
                </c:pt>
                <c:pt idx="1047">
                  <c:v>17811.649536132813</c:v>
                </c:pt>
                <c:pt idx="1048">
                  <c:v>18531.498291015625</c:v>
                </c:pt>
                <c:pt idx="1049">
                  <c:v>19163.004150390625</c:v>
                </c:pt>
                <c:pt idx="1050">
                  <c:v>19459.995849609375</c:v>
                </c:pt>
                <c:pt idx="1051">
                  <c:v>19305.558837890625</c:v>
                </c:pt>
                <c:pt idx="1052">
                  <c:v>18777.207763671875</c:v>
                </c:pt>
                <c:pt idx="1053">
                  <c:v>18096.227783203125</c:v>
                </c:pt>
                <c:pt idx="1054">
                  <c:v>17494.676635742188</c:v>
                </c:pt>
                <c:pt idx="1055">
                  <c:v>17101.69677734375</c:v>
                </c:pt>
                <c:pt idx="1056">
                  <c:v>16911.717041015625</c:v>
                </c:pt>
                <c:pt idx="1057">
                  <c:v>16841.308654785156</c:v>
                </c:pt>
                <c:pt idx="1058">
                  <c:v>16804.443115234375</c:v>
                </c:pt>
                <c:pt idx="1059">
                  <c:v>16767.69189453125</c:v>
                </c:pt>
                <c:pt idx="1060">
                  <c:v>16739.540649414063</c:v>
                </c:pt>
                <c:pt idx="1061">
                  <c:v>16735.903686523438</c:v>
                </c:pt>
                <c:pt idx="1062">
                  <c:v>16759.75244140625</c:v>
                </c:pt>
                <c:pt idx="1063">
                  <c:v>16781.344116210938</c:v>
                </c:pt>
                <c:pt idx="1064">
                  <c:v>16768.849975585938</c:v>
                </c:pt>
                <c:pt idx="1065">
                  <c:v>16703.727355957031</c:v>
                </c:pt>
                <c:pt idx="1066">
                  <c:v>16596.176086425781</c:v>
                </c:pt>
                <c:pt idx="1067">
                  <c:v>16472.282012939453</c:v>
                </c:pt>
                <c:pt idx="1068">
                  <c:v>16372.359344482422</c:v>
                </c:pt>
                <c:pt idx="1069">
                  <c:v>16314.950988769531</c:v>
                </c:pt>
                <c:pt idx="1070">
                  <c:v>16289.485443115234</c:v>
                </c:pt>
                <c:pt idx="1071">
                  <c:v>16281.36279296875</c:v>
                </c:pt>
                <c:pt idx="1072">
                  <c:v>16280.211547851563</c:v>
                </c:pt>
                <c:pt idx="1073">
                  <c:v>16283.603179931641</c:v>
                </c:pt>
                <c:pt idx="1074">
                  <c:v>16290.594818115234</c:v>
                </c:pt>
                <c:pt idx="1075">
                  <c:v>16296.872131347656</c:v>
                </c:pt>
                <c:pt idx="1076">
                  <c:v>16288.578063964844</c:v>
                </c:pt>
                <c:pt idx="1077">
                  <c:v>16261.541107177734</c:v>
                </c:pt>
                <c:pt idx="1078">
                  <c:v>16228.304153442383</c:v>
                </c:pt>
                <c:pt idx="1079">
                  <c:v>16209.524353027344</c:v>
                </c:pt>
                <c:pt idx="1080">
                  <c:v>16207.830261230469</c:v>
                </c:pt>
                <c:pt idx="1081">
                  <c:v>16207.793304443359</c:v>
                </c:pt>
                <c:pt idx="1082">
                  <c:v>16193.127792358398</c:v>
                </c:pt>
                <c:pt idx="1083">
                  <c:v>16172.490844726563</c:v>
                </c:pt>
                <c:pt idx="1084">
                  <c:v>16155.425323486328</c:v>
                </c:pt>
                <c:pt idx="1085">
                  <c:v>16148.245513916016</c:v>
                </c:pt>
                <c:pt idx="1086">
                  <c:v>16155.522857666016</c:v>
                </c:pt>
                <c:pt idx="1087">
                  <c:v>16181.543045043945</c:v>
                </c:pt>
                <c:pt idx="1088">
                  <c:v>16214.363250732422</c:v>
                </c:pt>
                <c:pt idx="1089">
                  <c:v>16233.726303100586</c:v>
                </c:pt>
                <c:pt idx="1090">
                  <c:v>16227.460784912109</c:v>
                </c:pt>
                <c:pt idx="1091">
                  <c:v>16204.652404785156</c:v>
                </c:pt>
                <c:pt idx="1092">
                  <c:v>16185.101165771484</c:v>
                </c:pt>
                <c:pt idx="1093">
                  <c:v>16181.435653686523</c:v>
                </c:pt>
                <c:pt idx="1094">
                  <c:v>16186.427276611328</c:v>
                </c:pt>
                <c:pt idx="1095">
                  <c:v>16197.190322875977</c:v>
                </c:pt>
                <c:pt idx="1096">
                  <c:v>16212.810516357422</c:v>
                </c:pt>
                <c:pt idx="1097">
                  <c:v>16228.830718994141</c:v>
                </c:pt>
                <c:pt idx="1098">
                  <c:v>16238.165191650391</c:v>
                </c:pt>
                <c:pt idx="1099">
                  <c:v>16233.099670410156</c:v>
                </c:pt>
                <c:pt idx="1100">
                  <c:v>16217.205581665039</c:v>
                </c:pt>
                <c:pt idx="1101">
                  <c:v>16204.682922363281</c:v>
                </c:pt>
                <c:pt idx="1102">
                  <c:v>16204.245971679688</c:v>
                </c:pt>
                <c:pt idx="1103">
                  <c:v>16214.380447387695</c:v>
                </c:pt>
                <c:pt idx="1104">
                  <c:v>16232.514938354492</c:v>
                </c:pt>
                <c:pt idx="1105">
                  <c:v>16255.620849609375</c:v>
                </c:pt>
                <c:pt idx="1106">
                  <c:v>16263.98388671875</c:v>
                </c:pt>
                <c:pt idx="1107">
                  <c:v>16249.204086303711</c:v>
                </c:pt>
                <c:pt idx="1108">
                  <c:v>16223.938568115234</c:v>
                </c:pt>
                <c:pt idx="1109">
                  <c:v>16199.073059082031</c:v>
                </c:pt>
                <c:pt idx="1110">
                  <c:v>16174.178955078125</c:v>
                </c:pt>
                <c:pt idx="1111">
                  <c:v>16144.970581054688</c:v>
                </c:pt>
                <c:pt idx="1112">
                  <c:v>16123.047920227051</c:v>
                </c:pt>
                <c:pt idx="1113">
                  <c:v>16122.639549255371</c:v>
                </c:pt>
                <c:pt idx="1114">
                  <c:v>16143.545455932617</c:v>
                </c:pt>
                <c:pt idx="1115">
                  <c:v>16165.165649414063</c:v>
                </c:pt>
                <c:pt idx="1116">
                  <c:v>16170.500137329102</c:v>
                </c:pt>
                <c:pt idx="1117">
                  <c:v>16170.891754150391</c:v>
                </c:pt>
                <c:pt idx="1118">
                  <c:v>16179.91194152832</c:v>
                </c:pt>
                <c:pt idx="1119">
                  <c:v>16202.646423339844</c:v>
                </c:pt>
                <c:pt idx="1120">
                  <c:v>16230.352340698242</c:v>
                </c:pt>
                <c:pt idx="1121">
                  <c:v>16254.915390014648</c:v>
                </c:pt>
                <c:pt idx="1122">
                  <c:v>16259.678436279297</c:v>
                </c:pt>
                <c:pt idx="1123">
                  <c:v>16242.441497802734</c:v>
                </c:pt>
                <c:pt idx="1124">
                  <c:v>16212.747406005859</c:v>
                </c:pt>
                <c:pt idx="1125">
                  <c:v>16180.281875610352</c:v>
                </c:pt>
                <c:pt idx="1126">
                  <c:v>16147.616363525391</c:v>
                </c:pt>
                <c:pt idx="1127">
                  <c:v>16127.122276306152</c:v>
                </c:pt>
                <c:pt idx="1128">
                  <c:v>16128.228179931641</c:v>
                </c:pt>
                <c:pt idx="1129">
                  <c:v>16138.705520629883</c:v>
                </c:pt>
                <c:pt idx="1130">
                  <c:v>16135.011428833008</c:v>
                </c:pt>
                <c:pt idx="1131">
                  <c:v>16122.517333984375</c:v>
                </c:pt>
                <c:pt idx="1132">
                  <c:v>16124.908958435059</c:v>
                </c:pt>
                <c:pt idx="1133">
                  <c:v>16142.300582885742</c:v>
                </c:pt>
                <c:pt idx="1134">
                  <c:v>16157.635070800781</c:v>
                </c:pt>
                <c:pt idx="1135">
                  <c:v>16172.455261230469</c:v>
                </c:pt>
                <c:pt idx="1136">
                  <c:v>16200.046890258789</c:v>
                </c:pt>
                <c:pt idx="1137">
                  <c:v>16238.095642089844</c:v>
                </c:pt>
                <c:pt idx="1138">
                  <c:v>16279.030120849609</c:v>
                </c:pt>
                <c:pt idx="1139">
                  <c:v>16325.907470703125</c:v>
                </c:pt>
                <c:pt idx="1140">
                  <c:v>16378.413391113281</c:v>
                </c:pt>
                <c:pt idx="1141">
                  <c:v>16428.690704345703</c:v>
                </c:pt>
                <c:pt idx="1142">
                  <c:v>16458.710906982422</c:v>
                </c:pt>
                <c:pt idx="1143">
                  <c:v>16472.073974609375</c:v>
                </c:pt>
                <c:pt idx="1144">
                  <c:v>16486.094146728516</c:v>
                </c:pt>
                <c:pt idx="1145">
                  <c:v>16498.771484375</c:v>
                </c:pt>
                <c:pt idx="1146">
                  <c:v>16485.705963134766</c:v>
                </c:pt>
                <c:pt idx="1147">
                  <c:v>16433.497589111328</c:v>
                </c:pt>
                <c:pt idx="1148">
                  <c:v>16357.432067871094</c:v>
                </c:pt>
                <c:pt idx="1149">
                  <c:v>16284.623687744141</c:v>
                </c:pt>
                <c:pt idx="1150">
                  <c:v>16236.672470092773</c:v>
                </c:pt>
                <c:pt idx="1151">
                  <c:v>16217.349807739258</c:v>
                </c:pt>
                <c:pt idx="1152">
                  <c:v>16216.770004272461</c:v>
                </c:pt>
                <c:pt idx="1153">
                  <c:v>16224.990188598633</c:v>
                </c:pt>
                <c:pt idx="1154">
                  <c:v>16221.781814575195</c:v>
                </c:pt>
                <c:pt idx="1155">
                  <c:v>16203.802017211914</c:v>
                </c:pt>
                <c:pt idx="1156">
                  <c:v>16181.05078125</c:v>
                </c:pt>
                <c:pt idx="1157">
                  <c:v>16162.499542236328</c:v>
                </c:pt>
                <c:pt idx="1158">
                  <c:v>16148.919738769531</c:v>
                </c:pt>
                <c:pt idx="1159">
                  <c:v>16143.425643920898</c:v>
                </c:pt>
                <c:pt idx="1160">
                  <c:v>16144.988708496094</c:v>
                </c:pt>
                <c:pt idx="1161">
                  <c:v>16151.723175048828</c:v>
                </c:pt>
                <c:pt idx="1162">
                  <c:v>16162.029098510742</c:v>
                </c:pt>
                <c:pt idx="1163">
                  <c:v>16173.792144775391</c:v>
                </c:pt>
                <c:pt idx="1164">
                  <c:v>16192.155197143555</c:v>
                </c:pt>
                <c:pt idx="1165">
                  <c:v>16240.489669799805</c:v>
                </c:pt>
                <c:pt idx="1166">
                  <c:v>16328.452728271484</c:v>
                </c:pt>
                <c:pt idx="1167">
                  <c:v>16445.987213134766</c:v>
                </c:pt>
                <c:pt idx="1168">
                  <c:v>16567.293090820313</c:v>
                </c:pt>
                <c:pt idx="1169">
                  <c:v>16660.94189453125</c:v>
                </c:pt>
                <c:pt idx="1170">
                  <c:v>16699.247802734375</c:v>
                </c:pt>
                <c:pt idx="1171">
                  <c:v>16670.696533203125</c:v>
                </c:pt>
                <c:pt idx="1172">
                  <c:v>16587.659606933594</c:v>
                </c:pt>
                <c:pt idx="1173">
                  <c:v>16475.508361816406</c:v>
                </c:pt>
                <c:pt idx="1174">
                  <c:v>16366.757141113281</c:v>
                </c:pt>
                <c:pt idx="1175">
                  <c:v>16286.434478759766</c:v>
                </c:pt>
                <c:pt idx="1176">
                  <c:v>16246.511825561523</c:v>
                </c:pt>
                <c:pt idx="1177">
                  <c:v>16238.503448486328</c:v>
                </c:pt>
                <c:pt idx="1178">
                  <c:v>16242.923629760742</c:v>
                </c:pt>
                <c:pt idx="1179">
                  <c:v>16245.600967407227</c:v>
                </c:pt>
                <c:pt idx="1180">
                  <c:v>16244.506881713867</c:v>
                </c:pt>
                <c:pt idx="1181">
                  <c:v>16242.784225463867</c:v>
                </c:pt>
                <c:pt idx="1182">
                  <c:v>16239.89013671875</c:v>
                </c:pt>
                <c:pt idx="1183">
                  <c:v>16233.996032714844</c:v>
                </c:pt>
                <c:pt idx="1184">
                  <c:v>16221.616226196289</c:v>
                </c:pt>
                <c:pt idx="1185">
                  <c:v>16208.52214050293</c:v>
                </c:pt>
                <c:pt idx="1186">
                  <c:v>16195.228057861328</c:v>
                </c:pt>
                <c:pt idx="1187">
                  <c:v>16190.305389404297</c:v>
                </c:pt>
                <c:pt idx="1188">
                  <c:v>16192.154159545898</c:v>
                </c:pt>
                <c:pt idx="1189">
                  <c:v>16195.402923583984</c:v>
                </c:pt>
                <c:pt idx="1190">
                  <c:v>16193.480255126953</c:v>
                </c:pt>
                <c:pt idx="1191">
                  <c:v>16188.30046081543</c:v>
                </c:pt>
                <c:pt idx="1192">
                  <c:v>16181.006362915039</c:v>
                </c:pt>
                <c:pt idx="1193">
                  <c:v>16170.997985839844</c:v>
                </c:pt>
                <c:pt idx="1194">
                  <c:v>16161.989608764648</c:v>
                </c:pt>
                <c:pt idx="1195">
                  <c:v>16150.781234741211</c:v>
                </c:pt>
                <c:pt idx="1196">
                  <c:v>16135.315719604492</c:v>
                </c:pt>
                <c:pt idx="1197">
                  <c:v>16112.907341003418</c:v>
                </c:pt>
                <c:pt idx="1198">
                  <c:v>16088.041816711426</c:v>
                </c:pt>
                <c:pt idx="1199">
                  <c:v>16069.776298522949</c:v>
                </c:pt>
                <c:pt idx="1200">
                  <c:v>16074.339347839355</c:v>
                </c:pt>
                <c:pt idx="1201">
                  <c:v>16101.98811340332</c:v>
                </c:pt>
                <c:pt idx="1202">
                  <c:v>16138.63688659668</c:v>
                </c:pt>
                <c:pt idx="1203">
                  <c:v>16166.057083129883</c:v>
                </c:pt>
                <c:pt idx="1204">
                  <c:v>16178.734420776367</c:v>
                </c:pt>
                <c:pt idx="1205">
                  <c:v>16175.183181762695</c:v>
                </c:pt>
                <c:pt idx="1206">
                  <c:v>16160.060516357422</c:v>
                </c:pt>
                <c:pt idx="1207">
                  <c:v>16143.652145385742</c:v>
                </c:pt>
                <c:pt idx="1208">
                  <c:v>16135.900909423828</c:v>
                </c:pt>
                <c:pt idx="1209">
                  <c:v>16126.463958740234</c:v>
                </c:pt>
                <c:pt idx="1210">
                  <c:v>16116.42700958252</c:v>
                </c:pt>
                <c:pt idx="1211">
                  <c:v>16122.67578125</c:v>
                </c:pt>
                <c:pt idx="1212">
                  <c:v>16153.467407226563</c:v>
                </c:pt>
                <c:pt idx="1213">
                  <c:v>16183.487594604492</c:v>
                </c:pt>
                <c:pt idx="1214">
                  <c:v>16196.25065612793</c:v>
                </c:pt>
                <c:pt idx="1215">
                  <c:v>16196.127990722656</c:v>
                </c:pt>
                <c:pt idx="1216">
                  <c:v>16198.291046142578</c:v>
                </c:pt>
                <c:pt idx="1217">
                  <c:v>16200.654098510742</c:v>
                </c:pt>
                <c:pt idx="1218">
                  <c:v>16193.245712280273</c:v>
                </c:pt>
                <c:pt idx="1219">
                  <c:v>16167.123046875</c:v>
                </c:pt>
                <c:pt idx="1220">
                  <c:v>16145.686111450195</c:v>
                </c:pt>
                <c:pt idx="1221">
                  <c:v>16141.192016601563</c:v>
                </c:pt>
                <c:pt idx="1222">
                  <c:v>16146.297927856445</c:v>
                </c:pt>
                <c:pt idx="1223">
                  <c:v>16143.232406616211</c:v>
                </c:pt>
                <c:pt idx="1224">
                  <c:v>16137.852600097656</c:v>
                </c:pt>
                <c:pt idx="1225">
                  <c:v>16131.758499145508</c:v>
                </c:pt>
                <c:pt idx="1226">
                  <c:v>16124.721557617188</c:v>
                </c:pt>
                <c:pt idx="1227">
                  <c:v>16119.313179016113</c:v>
                </c:pt>
                <c:pt idx="1228">
                  <c:v>16119.847663879395</c:v>
                </c:pt>
                <c:pt idx="1229">
                  <c:v>16124.696426391602</c:v>
                </c:pt>
                <c:pt idx="1230">
                  <c:v>16129.14518737793</c:v>
                </c:pt>
                <c:pt idx="1231">
                  <c:v>16136.136825561523</c:v>
                </c:pt>
                <c:pt idx="1232">
                  <c:v>16145.642730712891</c:v>
                </c:pt>
                <c:pt idx="1233">
                  <c:v>16153.091491699219</c:v>
                </c:pt>
                <c:pt idx="1234">
                  <c:v>16162.168838500977</c:v>
                </c:pt>
                <c:pt idx="1235">
                  <c:v>16177.446166992188</c:v>
                </c:pt>
                <c:pt idx="1236">
                  <c:v>16190.55207824707</c:v>
                </c:pt>
                <c:pt idx="1237">
                  <c:v>16193.086563110352</c:v>
                </c:pt>
                <c:pt idx="1238">
                  <c:v>16193.392471313477</c:v>
                </c:pt>
                <c:pt idx="1239">
                  <c:v>16192.869812011719</c:v>
                </c:pt>
                <c:pt idx="1240">
                  <c:v>16187.547149658203</c:v>
                </c:pt>
                <c:pt idx="1241">
                  <c:v>16178.138763427734</c:v>
                </c:pt>
                <c:pt idx="1242">
                  <c:v>16174.273239135742</c:v>
                </c:pt>
                <c:pt idx="1243">
                  <c:v>16181.264877319336</c:v>
                </c:pt>
                <c:pt idx="1244">
                  <c:v>16200.227920532227</c:v>
                </c:pt>
                <c:pt idx="1245">
                  <c:v>16220.27668762207</c:v>
                </c:pt>
                <c:pt idx="1246">
                  <c:v>16230.268310546875</c:v>
                </c:pt>
                <c:pt idx="1247">
                  <c:v>16230.059936523438</c:v>
                </c:pt>
                <c:pt idx="1248">
                  <c:v>16224.937271118164</c:v>
                </c:pt>
                <c:pt idx="1249">
                  <c:v>16219.357467651367</c:v>
                </c:pt>
                <c:pt idx="1250">
                  <c:v>16213.749084472656</c:v>
                </c:pt>
                <c:pt idx="1251">
                  <c:v>16212.11213684082</c:v>
                </c:pt>
                <c:pt idx="1252">
                  <c:v>16214.875198364258</c:v>
                </c:pt>
                <c:pt idx="1253">
                  <c:v>16227.752532958984</c:v>
                </c:pt>
                <c:pt idx="1254">
                  <c:v>16241.801300048828</c:v>
                </c:pt>
                <c:pt idx="1255">
                  <c:v>16246.707214355469</c:v>
                </c:pt>
                <c:pt idx="1256">
                  <c:v>16238.327407836914</c:v>
                </c:pt>
                <c:pt idx="1257">
                  <c:v>16226.176162719727</c:v>
                </c:pt>
                <c:pt idx="1258">
                  <c:v>16217.082077026367</c:v>
                </c:pt>
                <c:pt idx="1259">
                  <c:v>16208.130844116211</c:v>
                </c:pt>
                <c:pt idx="1260">
                  <c:v>16198.608184814453</c:v>
                </c:pt>
                <c:pt idx="1261">
                  <c:v>16188.171234130859</c:v>
                </c:pt>
                <c:pt idx="1262">
                  <c:v>16182.905715942383</c:v>
                </c:pt>
                <c:pt idx="1263">
                  <c:v>16186.697341918945</c:v>
                </c:pt>
                <c:pt idx="1264">
                  <c:v>16197.631820678711</c:v>
                </c:pt>
                <c:pt idx="1265">
                  <c:v>16205.166305541992</c:v>
                </c:pt>
                <c:pt idx="1266">
                  <c:v>16201.529357910156</c:v>
                </c:pt>
                <c:pt idx="1267">
                  <c:v>16198.035263061523</c:v>
                </c:pt>
                <c:pt idx="1268">
                  <c:v>16203.169738769531</c:v>
                </c:pt>
                <c:pt idx="1269">
                  <c:v>16209.961364746094</c:v>
                </c:pt>
                <c:pt idx="1270">
                  <c:v>16214.924407958984</c:v>
                </c:pt>
                <c:pt idx="1271">
                  <c:v>16219.887466430664</c:v>
                </c:pt>
                <c:pt idx="1272">
                  <c:v>16220.621948242188</c:v>
                </c:pt>
                <c:pt idx="1273">
                  <c:v>16210.299285888672</c:v>
                </c:pt>
                <c:pt idx="1274">
                  <c:v>16203.233764648438</c:v>
                </c:pt>
                <c:pt idx="1275">
                  <c:v>16207.596817016602</c:v>
                </c:pt>
                <c:pt idx="1276">
                  <c:v>16219.959869384766</c:v>
                </c:pt>
                <c:pt idx="1277">
                  <c:v>16232.151489257813</c:v>
                </c:pt>
                <c:pt idx="1278">
                  <c:v>16238.22883605957</c:v>
                </c:pt>
                <c:pt idx="1279">
                  <c:v>16228.620452880859</c:v>
                </c:pt>
                <c:pt idx="1280">
                  <c:v>16211.097793579102</c:v>
                </c:pt>
                <c:pt idx="1281">
                  <c:v>16202.346557617188</c:v>
                </c:pt>
                <c:pt idx="1282">
                  <c:v>16206.566757202148</c:v>
                </c:pt>
                <c:pt idx="1283">
                  <c:v>16208.72981262207</c:v>
                </c:pt>
                <c:pt idx="1284">
                  <c:v>16213.492858886719</c:v>
                </c:pt>
                <c:pt idx="1285">
                  <c:v>16232.598770141602</c:v>
                </c:pt>
                <c:pt idx="1286">
                  <c:v>16259.618957519531</c:v>
                </c:pt>
                <c:pt idx="1287">
                  <c:v>16272.067718505859</c:v>
                </c:pt>
                <c:pt idx="1288">
                  <c:v>16273.716491699219</c:v>
                </c:pt>
                <c:pt idx="1289">
                  <c:v>16276.736694335938</c:v>
                </c:pt>
                <c:pt idx="1290">
                  <c:v>16277.785461425781</c:v>
                </c:pt>
                <c:pt idx="1291">
                  <c:v>16272.719940185547</c:v>
                </c:pt>
                <c:pt idx="1292">
                  <c:v>16270.768707275391</c:v>
                </c:pt>
                <c:pt idx="1293">
                  <c:v>16272.960327148438</c:v>
                </c:pt>
                <c:pt idx="1294">
                  <c:v>16266.494812011719</c:v>
                </c:pt>
                <c:pt idx="1295">
                  <c:v>16251.572143554688</c:v>
                </c:pt>
                <c:pt idx="1296">
                  <c:v>16245.706619262695</c:v>
                </c:pt>
                <c:pt idx="1297">
                  <c:v>16259.041107177734</c:v>
                </c:pt>
                <c:pt idx="1298">
                  <c:v>16276.632720947266</c:v>
                </c:pt>
                <c:pt idx="1299">
                  <c:v>16277.281494140625</c:v>
                </c:pt>
                <c:pt idx="1300">
                  <c:v>16267.273101806641</c:v>
                </c:pt>
                <c:pt idx="1301">
                  <c:v>16260.464752197266</c:v>
                </c:pt>
                <c:pt idx="1302">
                  <c:v>16265.027801513672</c:v>
                </c:pt>
                <c:pt idx="1303">
                  <c:v>16273.962280273438</c:v>
                </c:pt>
                <c:pt idx="1304">
                  <c:v>16284.81103515625</c:v>
                </c:pt>
                <c:pt idx="1305">
                  <c:v>16292.288391113281</c:v>
                </c:pt>
                <c:pt idx="1306">
                  <c:v>16296.022857666016</c:v>
                </c:pt>
                <c:pt idx="1307">
                  <c:v>16299.957336425781</c:v>
                </c:pt>
                <c:pt idx="1308">
                  <c:v>16314.920379638672</c:v>
                </c:pt>
                <c:pt idx="1309">
                  <c:v>16343.512023925781</c:v>
                </c:pt>
                <c:pt idx="1310">
                  <c:v>16372.189361572266</c:v>
                </c:pt>
                <c:pt idx="1311">
                  <c:v>16390.780975341797</c:v>
                </c:pt>
                <c:pt idx="1312">
                  <c:v>16401.572601318359</c:v>
                </c:pt>
                <c:pt idx="1313">
                  <c:v>16410.392791748047</c:v>
                </c:pt>
                <c:pt idx="1314">
                  <c:v>16417.81298828125</c:v>
                </c:pt>
                <c:pt idx="1315">
                  <c:v>16428.176025390625</c:v>
                </c:pt>
                <c:pt idx="1316">
                  <c:v>16437.996246337891</c:v>
                </c:pt>
                <c:pt idx="1317">
                  <c:v>16440.616424560547</c:v>
                </c:pt>
                <c:pt idx="1318">
                  <c:v>16431.579467773438</c:v>
                </c:pt>
                <c:pt idx="1319">
                  <c:v>16419.456817626953</c:v>
                </c:pt>
                <c:pt idx="1320">
                  <c:v>16414.277008056641</c:v>
                </c:pt>
                <c:pt idx="1321">
                  <c:v>16422.754364013672</c:v>
                </c:pt>
                <c:pt idx="1322">
                  <c:v>16443.945983886719</c:v>
                </c:pt>
                <c:pt idx="1323">
                  <c:v>16467.023315429688</c:v>
                </c:pt>
                <c:pt idx="1324">
                  <c:v>16475.957794189453</c:v>
                </c:pt>
                <c:pt idx="1325">
                  <c:v>16477.349426269531</c:v>
                </c:pt>
                <c:pt idx="1326">
                  <c:v>16486.198181152344</c:v>
                </c:pt>
                <c:pt idx="1327">
                  <c:v>16501.961242675781</c:v>
                </c:pt>
                <c:pt idx="1328">
                  <c:v>16514.638549804688</c:v>
                </c:pt>
                <c:pt idx="1329">
                  <c:v>16531.544494628906</c:v>
                </c:pt>
                <c:pt idx="1330">
                  <c:v>16560.193237304688</c:v>
                </c:pt>
                <c:pt idx="1331">
                  <c:v>16590.699157714844</c:v>
                </c:pt>
                <c:pt idx="1332">
                  <c:v>16612.805053710938</c:v>
                </c:pt>
                <c:pt idx="1333">
                  <c:v>16629.368103027344</c:v>
                </c:pt>
                <c:pt idx="1334">
                  <c:v>16646.531188964844</c:v>
                </c:pt>
                <c:pt idx="1335">
                  <c:v>16664.979919433594</c:v>
                </c:pt>
                <c:pt idx="1336">
                  <c:v>16679.771545410156</c:v>
                </c:pt>
                <c:pt idx="1337">
                  <c:v>16691.020324707031</c:v>
                </c:pt>
                <c:pt idx="1338">
                  <c:v>16703.840515136719</c:v>
                </c:pt>
                <c:pt idx="1339">
                  <c:v>16718.31787109375</c:v>
                </c:pt>
                <c:pt idx="1340">
                  <c:v>16724.023742675781</c:v>
                </c:pt>
                <c:pt idx="1341">
                  <c:v>16717.615417480469</c:v>
                </c:pt>
                <c:pt idx="1342">
                  <c:v>16713.292724609375</c:v>
                </c:pt>
                <c:pt idx="1343">
                  <c:v>16718.027221679688</c:v>
                </c:pt>
                <c:pt idx="1344">
                  <c:v>16727.93310546875</c:v>
                </c:pt>
                <c:pt idx="1345">
                  <c:v>16731.21044921875</c:v>
                </c:pt>
                <c:pt idx="1346">
                  <c:v>16727.802062988281</c:v>
                </c:pt>
                <c:pt idx="1347">
                  <c:v>16728.679443359375</c:v>
                </c:pt>
                <c:pt idx="1348">
                  <c:v>16747.699584960938</c:v>
                </c:pt>
                <c:pt idx="1349">
                  <c:v>16778.148376464844</c:v>
                </c:pt>
                <c:pt idx="1350">
                  <c:v>16807.854309082031</c:v>
                </c:pt>
                <c:pt idx="1351">
                  <c:v>16829.731628417969</c:v>
                </c:pt>
                <c:pt idx="1352">
                  <c:v>16839.351806640625</c:v>
                </c:pt>
                <c:pt idx="1353">
                  <c:v>16842.286315917969</c:v>
                </c:pt>
                <c:pt idx="1354">
                  <c:v>16851.677917480469</c:v>
                </c:pt>
                <c:pt idx="1355">
                  <c:v>16868.983825683594</c:v>
                </c:pt>
                <c:pt idx="1356">
                  <c:v>16887.461181640625</c:v>
                </c:pt>
                <c:pt idx="1357">
                  <c:v>16910.82421875</c:v>
                </c:pt>
                <c:pt idx="1358">
                  <c:v>16946.872985839844</c:v>
                </c:pt>
                <c:pt idx="1359">
                  <c:v>16986.43603515625</c:v>
                </c:pt>
                <c:pt idx="1360">
                  <c:v>17025.341918945313</c:v>
                </c:pt>
                <c:pt idx="1361">
                  <c:v>17061.305053710938</c:v>
                </c:pt>
                <c:pt idx="1362">
                  <c:v>17087.753784179688</c:v>
                </c:pt>
                <c:pt idx="1363">
                  <c:v>17100.631103515625</c:v>
                </c:pt>
                <c:pt idx="1364">
                  <c:v>17106.279907226563</c:v>
                </c:pt>
                <c:pt idx="1365">
                  <c:v>17111.071533203125</c:v>
                </c:pt>
                <c:pt idx="1366">
                  <c:v>17109.577392578125</c:v>
                </c:pt>
                <c:pt idx="1367">
                  <c:v>17107.026123046875</c:v>
                </c:pt>
                <c:pt idx="1368">
                  <c:v>17099.189208984375</c:v>
                </c:pt>
                <c:pt idx="1369">
                  <c:v>17085.780883789063</c:v>
                </c:pt>
                <c:pt idx="1370">
                  <c:v>17069.201049804688</c:v>
                </c:pt>
                <c:pt idx="1371">
                  <c:v>17059.849853515625</c:v>
                </c:pt>
                <c:pt idx="1372">
                  <c:v>17053.212890625</c:v>
                </c:pt>
                <c:pt idx="1373">
                  <c:v>17040.204467773438</c:v>
                </c:pt>
                <c:pt idx="1374">
                  <c:v>17018.967529296875</c:v>
                </c:pt>
                <c:pt idx="1375">
                  <c:v>16999.673461914063</c:v>
                </c:pt>
                <c:pt idx="1376">
                  <c:v>16990.979370117188</c:v>
                </c:pt>
                <c:pt idx="1377">
                  <c:v>16987.828125</c:v>
                </c:pt>
                <c:pt idx="1378">
                  <c:v>16977.476867675781</c:v>
                </c:pt>
                <c:pt idx="1379">
                  <c:v>16960.3828125</c:v>
                </c:pt>
                <c:pt idx="1380">
                  <c:v>16948.203002929688</c:v>
                </c:pt>
                <c:pt idx="1381">
                  <c:v>16947.023193359375</c:v>
                </c:pt>
                <c:pt idx="1382">
                  <c:v>16942.900512695313</c:v>
                </c:pt>
                <c:pt idx="1383">
                  <c:v>16926.320739746094</c:v>
                </c:pt>
                <c:pt idx="1384">
                  <c:v>16902.998046875</c:v>
                </c:pt>
                <c:pt idx="1385">
                  <c:v>16887.732543945313</c:v>
                </c:pt>
                <c:pt idx="1386">
                  <c:v>16883.124145507813</c:v>
                </c:pt>
                <c:pt idx="1387">
                  <c:v>16883.858642578125</c:v>
                </c:pt>
                <c:pt idx="1388">
                  <c:v>16882.593139648438</c:v>
                </c:pt>
                <c:pt idx="1389">
                  <c:v>16874.670471191406</c:v>
                </c:pt>
                <c:pt idx="1390">
                  <c:v>16860.090637207031</c:v>
                </c:pt>
                <c:pt idx="1391">
                  <c:v>16841.225158691406</c:v>
                </c:pt>
                <c:pt idx="1392">
                  <c:v>16825.702453613281</c:v>
                </c:pt>
                <c:pt idx="1393">
                  <c:v>16817.72265625</c:v>
                </c:pt>
                <c:pt idx="1394">
                  <c:v>16816.742858886719</c:v>
                </c:pt>
                <c:pt idx="1395">
                  <c:v>16810.820190429688</c:v>
                </c:pt>
                <c:pt idx="1396">
                  <c:v>16794.526123046875</c:v>
                </c:pt>
                <c:pt idx="1397">
                  <c:v>16774.83203125</c:v>
                </c:pt>
                <c:pt idx="1398">
                  <c:v>16761.480773925781</c:v>
                </c:pt>
                <c:pt idx="1399">
                  <c:v>16760.729553222656</c:v>
                </c:pt>
                <c:pt idx="1400">
                  <c:v>16771.83544921875</c:v>
                </c:pt>
                <c:pt idx="1401">
                  <c:v>16792.769958496094</c:v>
                </c:pt>
                <c:pt idx="1402">
                  <c:v>16808.275817871094</c:v>
                </c:pt>
                <c:pt idx="1403">
                  <c:v>16803.896057128906</c:v>
                </c:pt>
                <c:pt idx="1404">
                  <c:v>16786.916259765625</c:v>
                </c:pt>
                <c:pt idx="1405">
                  <c:v>16770.993591308594</c:v>
                </c:pt>
                <c:pt idx="1406">
                  <c:v>16766.242309570313</c:v>
                </c:pt>
                <c:pt idx="1407">
                  <c:v>16769.462524414063</c:v>
                </c:pt>
                <c:pt idx="1408">
                  <c:v>16778.33984375</c:v>
                </c:pt>
                <c:pt idx="1409">
                  <c:v>16778.674377441406</c:v>
                </c:pt>
                <c:pt idx="1410">
                  <c:v>16774.95166015625</c:v>
                </c:pt>
                <c:pt idx="1411">
                  <c:v>16774.800476074219</c:v>
                </c:pt>
                <c:pt idx="1412">
                  <c:v>16777.192077636719</c:v>
                </c:pt>
                <c:pt idx="1413">
                  <c:v>16775.697998046875</c:v>
                </c:pt>
                <c:pt idx="1414">
                  <c:v>16772.94677734375</c:v>
                </c:pt>
                <c:pt idx="1415">
                  <c:v>16768.681213378906</c:v>
                </c:pt>
                <c:pt idx="1416">
                  <c:v>16763.901428222656</c:v>
                </c:pt>
                <c:pt idx="1417">
                  <c:v>16769.00732421875</c:v>
                </c:pt>
                <c:pt idx="1418">
                  <c:v>16780.541809082031</c:v>
                </c:pt>
                <c:pt idx="1419">
                  <c:v>16786.276306152344</c:v>
                </c:pt>
                <c:pt idx="1420">
                  <c:v>16774.010803222656</c:v>
                </c:pt>
                <c:pt idx="1421">
                  <c:v>16752.373840332031</c:v>
                </c:pt>
                <c:pt idx="1422">
                  <c:v>16736.708312988281</c:v>
                </c:pt>
                <c:pt idx="1423">
                  <c:v>16735.614196777344</c:v>
                </c:pt>
                <c:pt idx="1424">
                  <c:v>16740.605834960938</c:v>
                </c:pt>
                <c:pt idx="1425">
                  <c:v>16748.826049804688</c:v>
                </c:pt>
                <c:pt idx="1426">
                  <c:v>16766.73193359375</c:v>
                </c:pt>
                <c:pt idx="1427">
                  <c:v>16793.780700683594</c:v>
                </c:pt>
                <c:pt idx="1428">
                  <c:v>16813.143737792969</c:v>
                </c:pt>
                <c:pt idx="1429">
                  <c:v>16827.221130371094</c:v>
                </c:pt>
                <c:pt idx="1430">
                  <c:v>16848.298461914063</c:v>
                </c:pt>
                <c:pt idx="1431">
                  <c:v>16870.2900390625</c:v>
                </c:pt>
                <c:pt idx="1432">
                  <c:v>16870.681701660156</c:v>
                </c:pt>
                <c:pt idx="1433">
                  <c:v>16863.473327636719</c:v>
                </c:pt>
                <c:pt idx="1434">
                  <c:v>16867.493530273438</c:v>
                </c:pt>
                <c:pt idx="1435">
                  <c:v>16878.656555175781</c:v>
                </c:pt>
                <c:pt idx="1436">
                  <c:v>16892.248168945313</c:v>
                </c:pt>
                <c:pt idx="1437">
                  <c:v>16909.068359375</c:v>
                </c:pt>
                <c:pt idx="1438">
                  <c:v>16913.28857421875</c:v>
                </c:pt>
                <c:pt idx="1439">
                  <c:v>16885.394470214844</c:v>
                </c:pt>
                <c:pt idx="1440">
                  <c:v>16835.95751953125</c:v>
                </c:pt>
                <c:pt idx="1441">
                  <c:v>16784.320556640625</c:v>
                </c:pt>
                <c:pt idx="1442">
                  <c:v>16747.883605957031</c:v>
                </c:pt>
                <c:pt idx="1443">
                  <c:v>16728.189575195313</c:v>
                </c:pt>
                <c:pt idx="1444">
                  <c:v>16720.352600097656</c:v>
                </c:pt>
                <c:pt idx="1445">
                  <c:v>16727.258483886719</c:v>
                </c:pt>
                <c:pt idx="1446">
                  <c:v>16743.250122070313</c:v>
                </c:pt>
                <c:pt idx="1447">
                  <c:v>16755.0703125</c:v>
                </c:pt>
                <c:pt idx="1448">
                  <c:v>16762.090515136719</c:v>
                </c:pt>
                <c:pt idx="1449">
                  <c:v>16783.596435546875</c:v>
                </c:pt>
                <c:pt idx="1450">
                  <c:v>16826.616638183594</c:v>
                </c:pt>
                <c:pt idx="1451">
                  <c:v>16880.465393066406</c:v>
                </c:pt>
                <c:pt idx="1452">
                  <c:v>16933.285583496094</c:v>
                </c:pt>
                <c:pt idx="1453">
                  <c:v>16982.305786132813</c:v>
                </c:pt>
                <c:pt idx="1454">
                  <c:v>17022.983093261719</c:v>
                </c:pt>
                <c:pt idx="1455">
                  <c:v>17047.946166992188</c:v>
                </c:pt>
                <c:pt idx="1456">
                  <c:v>17054.994995117188</c:v>
                </c:pt>
                <c:pt idx="1457">
                  <c:v>17051.700805664063</c:v>
                </c:pt>
                <c:pt idx="1458">
                  <c:v>17032.006713867188</c:v>
                </c:pt>
                <c:pt idx="1459">
                  <c:v>16998.68408203125</c:v>
                </c:pt>
                <c:pt idx="1460">
                  <c:v>16959.104309082031</c:v>
                </c:pt>
                <c:pt idx="1461">
                  <c:v>16926.695922851563</c:v>
                </c:pt>
                <c:pt idx="1462">
                  <c:v>16908.887512207031</c:v>
                </c:pt>
                <c:pt idx="1463">
                  <c:v>16905.307739257813</c:v>
                </c:pt>
                <c:pt idx="1464">
                  <c:v>16907.585083007813</c:v>
                </c:pt>
                <c:pt idx="1465">
                  <c:v>16910.605285644531</c:v>
                </c:pt>
                <c:pt idx="1466">
                  <c:v>16920.025451660156</c:v>
                </c:pt>
                <c:pt idx="1467">
                  <c:v>16943.302795410156</c:v>
                </c:pt>
                <c:pt idx="1468">
                  <c:v>16974.837280273438</c:v>
                </c:pt>
                <c:pt idx="1469">
                  <c:v>17000.228881835938</c:v>
                </c:pt>
                <c:pt idx="1470">
                  <c:v>17014.277648925781</c:v>
                </c:pt>
                <c:pt idx="1471">
                  <c:v>17033.097900390625</c:v>
                </c:pt>
                <c:pt idx="1472">
                  <c:v>17066.689453125</c:v>
                </c:pt>
                <c:pt idx="1473">
                  <c:v>17108.68115234375</c:v>
                </c:pt>
                <c:pt idx="1474">
                  <c:v>17148.529907226563</c:v>
                </c:pt>
                <c:pt idx="1475">
                  <c:v>17185.607177734375</c:v>
                </c:pt>
                <c:pt idx="1476">
                  <c:v>17221.513061523438</c:v>
                </c:pt>
                <c:pt idx="1477">
                  <c:v>17247.13330078125</c:v>
                </c:pt>
                <c:pt idx="1478">
                  <c:v>17257.896362304688</c:v>
                </c:pt>
                <c:pt idx="1479">
                  <c:v>17258.887939453125</c:v>
                </c:pt>
                <c:pt idx="1480">
                  <c:v>17261.308227539063</c:v>
                </c:pt>
                <c:pt idx="1481">
                  <c:v>17265.956909179688</c:v>
                </c:pt>
                <c:pt idx="1482">
                  <c:v>17275.091430664063</c:v>
                </c:pt>
                <c:pt idx="1483">
                  <c:v>17284.111572265625</c:v>
                </c:pt>
                <c:pt idx="1484">
                  <c:v>17295.817504882813</c:v>
                </c:pt>
                <c:pt idx="1485">
                  <c:v>17313.751953125</c:v>
                </c:pt>
                <c:pt idx="1486">
                  <c:v>17333.943603515625</c:v>
                </c:pt>
                <c:pt idx="1487">
                  <c:v>17354.392456054688</c:v>
                </c:pt>
                <c:pt idx="1488">
                  <c:v>17383.926879882813</c:v>
                </c:pt>
                <c:pt idx="1489">
                  <c:v>17427.404174804688</c:v>
                </c:pt>
                <c:pt idx="1490">
                  <c:v>17466.938720703125</c:v>
                </c:pt>
                <c:pt idx="1491">
                  <c:v>17488.0732421875</c:v>
                </c:pt>
                <c:pt idx="1492">
                  <c:v>17495.493408203125</c:v>
                </c:pt>
                <c:pt idx="1493">
                  <c:v>17502.170654296875</c:v>
                </c:pt>
                <c:pt idx="1494">
                  <c:v>17511.848022460938</c:v>
                </c:pt>
                <c:pt idx="1495">
                  <c:v>17528.35400390625</c:v>
                </c:pt>
                <c:pt idx="1496">
                  <c:v>17548.402709960938</c:v>
                </c:pt>
                <c:pt idx="1497">
                  <c:v>17568.765747070313</c:v>
                </c:pt>
                <c:pt idx="1498">
                  <c:v>17587.786010742188</c:v>
                </c:pt>
                <c:pt idx="1499">
                  <c:v>17613.377563476563</c:v>
                </c:pt>
                <c:pt idx="1500">
                  <c:v>17642.96923828125</c:v>
                </c:pt>
                <c:pt idx="1501">
                  <c:v>17666.703735351563</c:v>
                </c:pt>
                <c:pt idx="1502">
                  <c:v>17683.009643554688</c:v>
                </c:pt>
                <c:pt idx="1503">
                  <c:v>17700.572631835938</c:v>
                </c:pt>
                <c:pt idx="1504">
                  <c:v>17725.907104492188</c:v>
                </c:pt>
                <c:pt idx="1505">
                  <c:v>17752.327392578125</c:v>
                </c:pt>
                <c:pt idx="1506">
                  <c:v>17774.547485351563</c:v>
                </c:pt>
                <c:pt idx="1507">
                  <c:v>17789.796264648438</c:v>
                </c:pt>
                <c:pt idx="1508">
                  <c:v>17811.502197265625</c:v>
                </c:pt>
                <c:pt idx="1509">
                  <c:v>17854.665283203125</c:v>
                </c:pt>
                <c:pt idx="1510">
                  <c:v>17915.142578125</c:v>
                </c:pt>
                <c:pt idx="1511">
                  <c:v>17975.791381835938</c:v>
                </c:pt>
                <c:pt idx="1512">
                  <c:v>18039.268676757813</c:v>
                </c:pt>
                <c:pt idx="1513">
                  <c:v>18128.403076171875</c:v>
                </c:pt>
                <c:pt idx="1514">
                  <c:v>18254.623291015625</c:v>
                </c:pt>
                <c:pt idx="1515">
                  <c:v>18432.157958984375</c:v>
                </c:pt>
                <c:pt idx="1516">
                  <c:v>18701.378173828125</c:v>
                </c:pt>
                <c:pt idx="1517">
                  <c:v>19118.4267578125</c:v>
                </c:pt>
                <c:pt idx="1518">
                  <c:v>19768.218505859375</c:v>
                </c:pt>
                <c:pt idx="1519">
                  <c:v>20770.5244140625</c:v>
                </c:pt>
                <c:pt idx="1520">
                  <c:v>22251.54443359375</c:v>
                </c:pt>
                <c:pt idx="1521">
                  <c:v>24250.193359375</c:v>
                </c:pt>
                <c:pt idx="1522">
                  <c:v>26652.0419921875</c:v>
                </c:pt>
                <c:pt idx="1523">
                  <c:v>29147.0048828125</c:v>
                </c:pt>
                <c:pt idx="1524">
                  <c:v>31274.1396484375</c:v>
                </c:pt>
                <c:pt idx="1525">
                  <c:v>32563.958984375</c:v>
                </c:pt>
                <c:pt idx="1526">
                  <c:v>32699.0078125</c:v>
                </c:pt>
                <c:pt idx="1527">
                  <c:v>31617.0576171875</c:v>
                </c:pt>
                <c:pt idx="1528">
                  <c:v>29553.677734375</c:v>
                </c:pt>
                <c:pt idx="1529">
                  <c:v>26978.2119140625</c:v>
                </c:pt>
                <c:pt idx="1530">
                  <c:v>24410.546875</c:v>
                </c:pt>
                <c:pt idx="1531">
                  <c:v>22218.68115234375</c:v>
                </c:pt>
                <c:pt idx="1532">
                  <c:v>20556.21533203125</c:v>
                </c:pt>
                <c:pt idx="1533">
                  <c:v>19422.20703125</c:v>
                </c:pt>
                <c:pt idx="1534">
                  <c:v>18730.941650390625</c:v>
                </c:pt>
                <c:pt idx="1535">
                  <c:v>18356.59033203125</c:v>
                </c:pt>
                <c:pt idx="1536">
                  <c:v>18177.410400390625</c:v>
                </c:pt>
                <c:pt idx="1537">
                  <c:v>18109.002197265625</c:v>
                </c:pt>
                <c:pt idx="1538">
                  <c:v>18090.07958984375</c:v>
                </c:pt>
                <c:pt idx="1539">
                  <c:v>18078.299560546875</c:v>
                </c:pt>
                <c:pt idx="1540">
                  <c:v>18059.662841796875</c:v>
                </c:pt>
                <c:pt idx="1541">
                  <c:v>18044.36865234375</c:v>
                </c:pt>
                <c:pt idx="1542">
                  <c:v>18038.388793945313</c:v>
                </c:pt>
                <c:pt idx="1543">
                  <c:v>18037.780395507813</c:v>
                </c:pt>
                <c:pt idx="1544">
                  <c:v>18037.286376953125</c:v>
                </c:pt>
                <c:pt idx="1545">
                  <c:v>18044.020874023438</c:v>
                </c:pt>
                <c:pt idx="1546">
                  <c:v>18060.412353515625</c:v>
                </c:pt>
                <c:pt idx="1547">
                  <c:v>18081.518310546875</c:v>
                </c:pt>
                <c:pt idx="1548">
                  <c:v>18099.4814453125</c:v>
                </c:pt>
                <c:pt idx="1549">
                  <c:v>18123.1015625</c:v>
                </c:pt>
                <c:pt idx="1550">
                  <c:v>18152.97900390625</c:v>
                </c:pt>
                <c:pt idx="1551">
                  <c:v>18173.456298828125</c:v>
                </c:pt>
                <c:pt idx="1552">
                  <c:v>18176.276611328125</c:v>
                </c:pt>
                <c:pt idx="1553">
                  <c:v>18179.125244140625</c:v>
                </c:pt>
                <c:pt idx="1554">
                  <c:v>18196.288330078125</c:v>
                </c:pt>
                <c:pt idx="1555">
                  <c:v>18216.30859375</c:v>
                </c:pt>
                <c:pt idx="1556">
                  <c:v>18231.557373046875</c:v>
                </c:pt>
                <c:pt idx="1557">
                  <c:v>18247.86328125</c:v>
                </c:pt>
                <c:pt idx="1558">
                  <c:v>18274.112060546875</c:v>
                </c:pt>
                <c:pt idx="1559">
                  <c:v>18311.04638671875</c:v>
                </c:pt>
                <c:pt idx="1560">
                  <c:v>18347.66650390625</c:v>
                </c:pt>
                <c:pt idx="1561">
                  <c:v>18375.94384765625</c:v>
                </c:pt>
                <c:pt idx="1562">
                  <c:v>18391.507080078125</c:v>
                </c:pt>
                <c:pt idx="1563">
                  <c:v>18405.184326171875</c:v>
                </c:pt>
                <c:pt idx="1564">
                  <c:v>18426.347412109375</c:v>
                </c:pt>
                <c:pt idx="1565">
                  <c:v>18454.453369140625</c:v>
                </c:pt>
                <c:pt idx="1566">
                  <c:v>18485.359130859375</c:v>
                </c:pt>
                <c:pt idx="1567">
                  <c:v>18514.92236328125</c:v>
                </c:pt>
                <c:pt idx="1568">
                  <c:v>18539.2568359375</c:v>
                </c:pt>
                <c:pt idx="1569">
                  <c:v>18542.962646484375</c:v>
                </c:pt>
                <c:pt idx="1570">
                  <c:v>18524.697021484375</c:v>
                </c:pt>
                <c:pt idx="1571">
                  <c:v>18484.83154296875</c:v>
                </c:pt>
                <c:pt idx="1572">
                  <c:v>18435.023193359375</c:v>
                </c:pt>
                <c:pt idx="1573">
                  <c:v>18390.843505859375</c:v>
                </c:pt>
                <c:pt idx="1574">
                  <c:v>18365.03515625</c:v>
                </c:pt>
                <c:pt idx="1575">
                  <c:v>18356.3125</c:v>
                </c:pt>
                <c:pt idx="1576">
                  <c:v>18358.53271484375</c:v>
                </c:pt>
                <c:pt idx="1577">
                  <c:v>18360.8671875</c:v>
                </c:pt>
                <c:pt idx="1578">
                  <c:v>18361.515869140625</c:v>
                </c:pt>
                <c:pt idx="1579">
                  <c:v>18360.307373046875</c:v>
                </c:pt>
                <c:pt idx="1580">
                  <c:v>18352.61328125</c:v>
                </c:pt>
                <c:pt idx="1581">
                  <c:v>18332.233642578125</c:v>
                </c:pt>
                <c:pt idx="1582">
                  <c:v>18313.625244140625</c:v>
                </c:pt>
                <c:pt idx="1583">
                  <c:v>18310.845458984375</c:v>
                </c:pt>
                <c:pt idx="1584">
                  <c:v>18314.09423828125</c:v>
                </c:pt>
                <c:pt idx="1585">
                  <c:v>18315.085693359375</c:v>
                </c:pt>
                <c:pt idx="1586">
                  <c:v>18321.505859375</c:v>
                </c:pt>
                <c:pt idx="1587">
                  <c:v>18338.4404296875</c:v>
                </c:pt>
                <c:pt idx="1588">
                  <c:v>18360.7177734375</c:v>
                </c:pt>
                <c:pt idx="1589">
                  <c:v>18390.93798828125</c:v>
                </c:pt>
                <c:pt idx="1590">
                  <c:v>18419.8154296875</c:v>
                </c:pt>
                <c:pt idx="1591">
                  <c:v>18421.60693359375</c:v>
                </c:pt>
                <c:pt idx="1592">
                  <c:v>18385.94140625</c:v>
                </c:pt>
                <c:pt idx="1593">
                  <c:v>18320.39013671875</c:v>
                </c:pt>
                <c:pt idx="1594">
                  <c:v>18238.3818359375</c:v>
                </c:pt>
                <c:pt idx="1595">
                  <c:v>18164.030517578125</c:v>
                </c:pt>
                <c:pt idx="1596">
                  <c:v>18122.079345703125</c:v>
                </c:pt>
                <c:pt idx="1597">
                  <c:v>18120.185302734375</c:v>
                </c:pt>
                <c:pt idx="1598">
                  <c:v>18171.348388671875</c:v>
                </c:pt>
                <c:pt idx="1599">
                  <c:v>18328.082763671875</c:v>
                </c:pt>
                <c:pt idx="1600">
                  <c:v>18658.903076171875</c:v>
                </c:pt>
                <c:pt idx="1601">
                  <c:v>19230.0947265625</c:v>
                </c:pt>
                <c:pt idx="1602">
                  <c:v>20084.514892578125</c:v>
                </c:pt>
                <c:pt idx="1603">
                  <c:v>21241.70654296875</c:v>
                </c:pt>
                <c:pt idx="1604">
                  <c:v>22639.66943359375</c:v>
                </c:pt>
                <c:pt idx="1605">
                  <c:v>24121.14697265625</c:v>
                </c:pt>
                <c:pt idx="1606">
                  <c:v>25456.82421875</c:v>
                </c:pt>
                <c:pt idx="1607">
                  <c:v>26400.2158203125</c:v>
                </c:pt>
                <c:pt idx="1608">
                  <c:v>26742.2646484375</c:v>
                </c:pt>
                <c:pt idx="1609">
                  <c:v>26391.970703125</c:v>
                </c:pt>
                <c:pt idx="1610">
                  <c:v>25419.390625</c:v>
                </c:pt>
                <c:pt idx="1611">
                  <c:v>24032.18212890625</c:v>
                </c:pt>
                <c:pt idx="1612">
                  <c:v>22495.65966796875</c:v>
                </c:pt>
                <c:pt idx="1613">
                  <c:v>21033.19384765625</c:v>
                </c:pt>
                <c:pt idx="1614">
                  <c:v>19788.528564453125</c:v>
                </c:pt>
                <c:pt idx="1615">
                  <c:v>18847.805908203125</c:v>
                </c:pt>
                <c:pt idx="1616">
                  <c:v>18231.683349609375</c:v>
                </c:pt>
                <c:pt idx="1617">
                  <c:v>17872.33203125</c:v>
                </c:pt>
                <c:pt idx="1618">
                  <c:v>17666.437866210938</c:v>
                </c:pt>
                <c:pt idx="1619">
                  <c:v>17538.658081054688</c:v>
                </c:pt>
                <c:pt idx="1620">
                  <c:v>17461.963989257813</c:v>
                </c:pt>
                <c:pt idx="1621">
                  <c:v>17426.44140625</c:v>
                </c:pt>
                <c:pt idx="1622">
                  <c:v>17431.032958984375</c:v>
                </c:pt>
                <c:pt idx="1623">
                  <c:v>17464.710327148438</c:v>
                </c:pt>
                <c:pt idx="1624">
                  <c:v>17514.187622070313</c:v>
                </c:pt>
                <c:pt idx="1625">
                  <c:v>17561.779296875</c:v>
                </c:pt>
                <c:pt idx="1626">
                  <c:v>17601.513793945313</c:v>
                </c:pt>
                <c:pt idx="1627">
                  <c:v>17619.4482421875</c:v>
                </c:pt>
                <c:pt idx="1628">
                  <c:v>17594.4970703125</c:v>
                </c:pt>
                <c:pt idx="1629">
                  <c:v>17524.517211914063</c:v>
                </c:pt>
                <c:pt idx="1630">
                  <c:v>17441.680297851563</c:v>
                </c:pt>
                <c:pt idx="1631">
                  <c:v>17370.529052734375</c:v>
                </c:pt>
                <c:pt idx="1632">
                  <c:v>17317.549194335938</c:v>
                </c:pt>
                <c:pt idx="1633">
                  <c:v>17269.28369140625</c:v>
                </c:pt>
                <c:pt idx="1634">
                  <c:v>17221.6181640625</c:v>
                </c:pt>
                <c:pt idx="1635">
                  <c:v>17186.181274414063</c:v>
                </c:pt>
                <c:pt idx="1636">
                  <c:v>17168.487182617188</c:v>
                </c:pt>
                <c:pt idx="1637">
                  <c:v>17160.793090820313</c:v>
                </c:pt>
                <c:pt idx="1638">
                  <c:v>17156.78466796875</c:v>
                </c:pt>
                <c:pt idx="1639">
                  <c:v>17166.033447265625</c:v>
                </c:pt>
                <c:pt idx="1640">
                  <c:v>17178.682250976563</c:v>
                </c:pt>
                <c:pt idx="1641">
                  <c:v>17185.416748046875</c:v>
                </c:pt>
                <c:pt idx="1642">
                  <c:v>17185.093994140625</c:v>
                </c:pt>
                <c:pt idx="1643">
                  <c:v>17175.45703125</c:v>
                </c:pt>
                <c:pt idx="1644">
                  <c:v>17159.44873046875</c:v>
                </c:pt>
                <c:pt idx="1645">
                  <c:v>17144.268920898438</c:v>
                </c:pt>
                <c:pt idx="1646">
                  <c:v>17141.489135742188</c:v>
                </c:pt>
                <c:pt idx="1647">
                  <c:v>17145.166381835938</c:v>
                </c:pt>
                <c:pt idx="1648">
                  <c:v>17144.329467773438</c:v>
                </c:pt>
                <c:pt idx="1649">
                  <c:v>17142.94970703125</c:v>
                </c:pt>
                <c:pt idx="1650">
                  <c:v>17151.712768554688</c:v>
                </c:pt>
                <c:pt idx="1651">
                  <c:v>17177.61865234375</c:v>
                </c:pt>
                <c:pt idx="1652">
                  <c:v>17204.238891601563</c:v>
                </c:pt>
                <c:pt idx="1653">
                  <c:v>17222.3447265625</c:v>
                </c:pt>
                <c:pt idx="1654">
                  <c:v>17238.650634765625</c:v>
                </c:pt>
                <c:pt idx="1655">
                  <c:v>17263.413696289063</c:v>
                </c:pt>
                <c:pt idx="1656">
                  <c:v>17292.148193359375</c:v>
                </c:pt>
                <c:pt idx="1657">
                  <c:v>17319.911254882813</c:v>
                </c:pt>
                <c:pt idx="1658">
                  <c:v>17350.302856445313</c:v>
                </c:pt>
                <c:pt idx="1659">
                  <c:v>17384.980224609375</c:v>
                </c:pt>
                <c:pt idx="1660">
                  <c:v>17428.714721679688</c:v>
                </c:pt>
                <c:pt idx="1661">
                  <c:v>17490.90625</c:v>
                </c:pt>
                <c:pt idx="1662">
                  <c:v>17569.01220703125</c:v>
                </c:pt>
                <c:pt idx="1663">
                  <c:v>17658.832397460938</c:v>
                </c:pt>
                <c:pt idx="1664">
                  <c:v>17766.3955078125</c:v>
                </c:pt>
                <c:pt idx="1665">
                  <c:v>17882.329956054688</c:v>
                </c:pt>
                <c:pt idx="1666">
                  <c:v>17973.378662109375</c:v>
                </c:pt>
                <c:pt idx="1667">
                  <c:v>18007.4560546875</c:v>
                </c:pt>
                <c:pt idx="1668">
                  <c:v>17985.561889648438</c:v>
                </c:pt>
                <c:pt idx="1669">
                  <c:v>17921.496459960938</c:v>
                </c:pt>
                <c:pt idx="1670">
                  <c:v>17821.630859375</c:v>
                </c:pt>
                <c:pt idx="1671">
                  <c:v>17704.62255859375</c:v>
                </c:pt>
                <c:pt idx="1672">
                  <c:v>17593.099853515625</c:v>
                </c:pt>
                <c:pt idx="1673">
                  <c:v>17503.805786132813</c:v>
                </c:pt>
                <c:pt idx="1674">
                  <c:v>17438.825927734375</c:v>
                </c:pt>
                <c:pt idx="1675">
                  <c:v>17404.84619140625</c:v>
                </c:pt>
                <c:pt idx="1676">
                  <c:v>17404.923461914063</c:v>
                </c:pt>
                <c:pt idx="1677">
                  <c:v>17430.972290039063</c:v>
                </c:pt>
                <c:pt idx="1678">
                  <c:v>17470.62109375</c:v>
                </c:pt>
                <c:pt idx="1679">
                  <c:v>17518.155517578125</c:v>
                </c:pt>
                <c:pt idx="1680">
                  <c:v>17593.089965820313</c:v>
                </c:pt>
                <c:pt idx="1681">
                  <c:v>17708.367309570313</c:v>
                </c:pt>
                <c:pt idx="1682">
                  <c:v>17862.158935546875</c:v>
                </c:pt>
                <c:pt idx="1683">
                  <c:v>18043.150634765625</c:v>
                </c:pt>
                <c:pt idx="1684">
                  <c:v>18243.056396484375</c:v>
                </c:pt>
                <c:pt idx="1685">
                  <c:v>18446.07666015625</c:v>
                </c:pt>
                <c:pt idx="1686">
                  <c:v>18625.01123046875</c:v>
                </c:pt>
                <c:pt idx="1687">
                  <c:v>18741.431396484375</c:v>
                </c:pt>
                <c:pt idx="1688">
                  <c:v>18766.8515625</c:v>
                </c:pt>
                <c:pt idx="1689">
                  <c:v>18689.84326171875</c:v>
                </c:pt>
                <c:pt idx="1690">
                  <c:v>18519.834716796875</c:v>
                </c:pt>
                <c:pt idx="1691">
                  <c:v>18271.540771484375</c:v>
                </c:pt>
                <c:pt idx="1692">
                  <c:v>17986.875244140625</c:v>
                </c:pt>
                <c:pt idx="1693">
                  <c:v>17720.5810546875</c:v>
                </c:pt>
                <c:pt idx="1694">
                  <c:v>17513.715576171875</c:v>
                </c:pt>
                <c:pt idx="1695">
                  <c:v>17370.1357421875</c:v>
                </c:pt>
                <c:pt idx="1696">
                  <c:v>17274.927368164063</c:v>
                </c:pt>
                <c:pt idx="1697">
                  <c:v>17213.318969726563</c:v>
                </c:pt>
                <c:pt idx="1698">
                  <c:v>17175.08203125</c:v>
                </c:pt>
                <c:pt idx="1699">
                  <c:v>17162.30224609375</c:v>
                </c:pt>
                <c:pt idx="1700">
                  <c:v>17176.69384765625</c:v>
                </c:pt>
                <c:pt idx="1701">
                  <c:v>17201.74267578125</c:v>
                </c:pt>
                <c:pt idx="1702">
                  <c:v>17215.19140625</c:v>
                </c:pt>
                <c:pt idx="1703">
                  <c:v>17212.240234375</c:v>
                </c:pt>
                <c:pt idx="1704">
                  <c:v>17204.660400390625</c:v>
                </c:pt>
                <c:pt idx="1705">
                  <c:v>17195.337768554688</c:v>
                </c:pt>
                <c:pt idx="1706">
                  <c:v>17176.615112304688</c:v>
                </c:pt>
                <c:pt idx="1707">
                  <c:v>17157.720947265625</c:v>
                </c:pt>
                <c:pt idx="1708">
                  <c:v>17152.112548828125</c:v>
                </c:pt>
                <c:pt idx="1709">
                  <c:v>17151.561401367188</c:v>
                </c:pt>
                <c:pt idx="1710">
                  <c:v>17138.067260742188</c:v>
                </c:pt>
                <c:pt idx="1711">
                  <c:v>17118.344604492188</c:v>
                </c:pt>
                <c:pt idx="1712">
                  <c:v>17115.221923828125</c:v>
                </c:pt>
                <c:pt idx="1713">
                  <c:v>17129.070678710938</c:v>
                </c:pt>
                <c:pt idx="1714">
                  <c:v>17147.176635742188</c:v>
                </c:pt>
                <c:pt idx="1715">
                  <c:v>17164.9111328125</c:v>
                </c:pt>
                <c:pt idx="1716">
                  <c:v>17190.217041015625</c:v>
                </c:pt>
                <c:pt idx="1717">
                  <c:v>17216.665771484375</c:v>
                </c:pt>
                <c:pt idx="1718">
                  <c:v>17240.885986328125</c:v>
                </c:pt>
                <c:pt idx="1719">
                  <c:v>17274.677612304688</c:v>
                </c:pt>
                <c:pt idx="1720">
                  <c:v>17318.983520507813</c:v>
                </c:pt>
                <c:pt idx="1721">
                  <c:v>17357.63232421875</c:v>
                </c:pt>
                <c:pt idx="1722">
                  <c:v>17384.0810546875</c:v>
                </c:pt>
                <c:pt idx="1723">
                  <c:v>17408.558349609375</c:v>
                </c:pt>
                <c:pt idx="1724">
                  <c:v>17432.835693359375</c:v>
                </c:pt>
                <c:pt idx="1725">
                  <c:v>17459.313110351563</c:v>
                </c:pt>
                <c:pt idx="1726">
                  <c:v>17494.3046875</c:v>
                </c:pt>
                <c:pt idx="1727">
                  <c:v>17540.124877929688</c:v>
                </c:pt>
                <c:pt idx="1728">
                  <c:v>17579.91650390625</c:v>
                </c:pt>
                <c:pt idx="1729">
                  <c:v>17600.993774414063</c:v>
                </c:pt>
                <c:pt idx="1730">
                  <c:v>17608.871215820313</c:v>
                </c:pt>
                <c:pt idx="1731">
                  <c:v>17617.405639648438</c:v>
                </c:pt>
                <c:pt idx="1732">
                  <c:v>17625.25439453125</c:v>
                </c:pt>
                <c:pt idx="1733">
                  <c:v>17631.24609375</c:v>
                </c:pt>
                <c:pt idx="1734">
                  <c:v>17642.666259765625</c:v>
                </c:pt>
                <c:pt idx="1735">
                  <c:v>17660.057861328125</c:v>
                </c:pt>
                <c:pt idx="1736">
                  <c:v>17677.706665039063</c:v>
                </c:pt>
                <c:pt idx="1737">
                  <c:v>17694.6982421875</c:v>
                </c:pt>
                <c:pt idx="1738">
                  <c:v>17713.318481445313</c:v>
                </c:pt>
                <c:pt idx="1739">
                  <c:v>17731.08154296875</c:v>
                </c:pt>
                <c:pt idx="1740">
                  <c:v>17748.673095703125</c:v>
                </c:pt>
                <c:pt idx="1741">
                  <c:v>17768.836181640625</c:v>
                </c:pt>
                <c:pt idx="1742">
                  <c:v>17786.542114257813</c:v>
                </c:pt>
                <c:pt idx="1743">
                  <c:v>17789.733642578125</c:v>
                </c:pt>
                <c:pt idx="1744">
                  <c:v>17777.58251953125</c:v>
                </c:pt>
                <c:pt idx="1745">
                  <c:v>17759.631225585938</c:v>
                </c:pt>
                <c:pt idx="1746">
                  <c:v>17741.822875976563</c:v>
                </c:pt>
                <c:pt idx="1747">
                  <c:v>17722.328735351563</c:v>
                </c:pt>
                <c:pt idx="1748">
                  <c:v>17709.634643554688</c:v>
                </c:pt>
                <c:pt idx="1749">
                  <c:v>17716.283447265625</c:v>
                </c:pt>
                <c:pt idx="1750">
                  <c:v>17741.132202148438</c:v>
                </c:pt>
                <c:pt idx="1751">
                  <c:v>17769.323852539063</c:v>
                </c:pt>
                <c:pt idx="1752">
                  <c:v>17798.486938476563</c:v>
                </c:pt>
                <c:pt idx="1753">
                  <c:v>17845.678466796875</c:v>
                </c:pt>
                <c:pt idx="1754">
                  <c:v>17925.213012695313</c:v>
                </c:pt>
                <c:pt idx="1755">
                  <c:v>18050.26171875</c:v>
                </c:pt>
                <c:pt idx="1756">
                  <c:v>18235.82470703125</c:v>
                </c:pt>
                <c:pt idx="1757">
                  <c:v>18487.64501953125</c:v>
                </c:pt>
                <c:pt idx="1758">
                  <c:v>18795.722412109375</c:v>
                </c:pt>
                <c:pt idx="1759">
                  <c:v>19149.456787109375</c:v>
                </c:pt>
                <c:pt idx="1760">
                  <c:v>19516.04833984375</c:v>
                </c:pt>
                <c:pt idx="1761">
                  <c:v>19825.125732421875</c:v>
                </c:pt>
                <c:pt idx="1762">
                  <c:v>20023.774658203125</c:v>
                </c:pt>
                <c:pt idx="1763">
                  <c:v>20097.10888671875</c:v>
                </c:pt>
                <c:pt idx="1764">
                  <c:v>20045.27197265625</c:v>
                </c:pt>
                <c:pt idx="1765">
                  <c:v>19873.892333984375</c:v>
                </c:pt>
                <c:pt idx="1766">
                  <c:v>19607.112548828125</c:v>
                </c:pt>
                <c:pt idx="1767">
                  <c:v>19290.76123046875</c:v>
                </c:pt>
                <c:pt idx="1768">
                  <c:v>18968.03857421875</c:v>
                </c:pt>
                <c:pt idx="1769">
                  <c:v>18673.2587890625</c:v>
                </c:pt>
                <c:pt idx="1770">
                  <c:v>18416.5361328125</c:v>
                </c:pt>
                <c:pt idx="1771">
                  <c:v>18211.64208984375</c:v>
                </c:pt>
                <c:pt idx="1772">
                  <c:v>18069.176513671875</c:v>
                </c:pt>
                <c:pt idx="1773">
                  <c:v>17982.253784179688</c:v>
                </c:pt>
                <c:pt idx="1774">
                  <c:v>17929.359741210938</c:v>
                </c:pt>
                <c:pt idx="1775">
                  <c:v>17897.722778320313</c:v>
                </c:pt>
                <c:pt idx="1776">
                  <c:v>17879.571533203125</c:v>
                </c:pt>
                <c:pt idx="1777">
                  <c:v>17867.277465820313</c:v>
                </c:pt>
                <c:pt idx="1778">
                  <c:v>17851.697631835938</c:v>
                </c:pt>
                <c:pt idx="1779">
                  <c:v>17837.4892578125</c:v>
                </c:pt>
                <c:pt idx="1780">
                  <c:v>17824.338012695313</c:v>
                </c:pt>
                <c:pt idx="1781">
                  <c:v>17816.186767578125</c:v>
                </c:pt>
                <c:pt idx="1782">
                  <c:v>17812.49267578125</c:v>
                </c:pt>
                <c:pt idx="1783">
                  <c:v>17812.5986328125</c:v>
                </c:pt>
                <c:pt idx="1784">
                  <c:v>17806.418823242188</c:v>
                </c:pt>
                <c:pt idx="1785">
                  <c:v>17795.667602539063</c:v>
                </c:pt>
                <c:pt idx="1786">
                  <c:v>17786.859252929688</c:v>
                </c:pt>
                <c:pt idx="1787">
                  <c:v>17775.9365234375</c:v>
                </c:pt>
                <c:pt idx="1788">
                  <c:v>17764.299560546875</c:v>
                </c:pt>
                <c:pt idx="1789">
                  <c:v>17746.60546875</c:v>
                </c:pt>
                <c:pt idx="1790">
                  <c:v>17723.7685546875</c:v>
                </c:pt>
                <c:pt idx="1791">
                  <c:v>17702.131591796875</c:v>
                </c:pt>
                <c:pt idx="1792">
                  <c:v>17697.49462890625</c:v>
                </c:pt>
                <c:pt idx="1793">
                  <c:v>17695.3720703125</c:v>
                </c:pt>
                <c:pt idx="1794">
                  <c:v>17679.163696289063</c:v>
                </c:pt>
                <c:pt idx="1795">
                  <c:v>17659.298095703125</c:v>
                </c:pt>
                <c:pt idx="1796">
                  <c:v>17653.689697265625</c:v>
                </c:pt>
                <c:pt idx="1797">
                  <c:v>17660.738525390625</c:v>
                </c:pt>
                <c:pt idx="1798">
                  <c:v>17664.473022460938</c:v>
                </c:pt>
                <c:pt idx="1799">
                  <c:v>17660.20751953125</c:v>
                </c:pt>
                <c:pt idx="1800">
                  <c:v>17661.570556640625</c:v>
                </c:pt>
                <c:pt idx="1801">
                  <c:v>17679.762084960938</c:v>
                </c:pt>
                <c:pt idx="1802">
                  <c:v>17723.38232421875</c:v>
                </c:pt>
                <c:pt idx="1803">
                  <c:v>17784.059692382813</c:v>
                </c:pt>
                <c:pt idx="1804">
                  <c:v>17858.737060546875</c:v>
                </c:pt>
                <c:pt idx="1805">
                  <c:v>17939.071533203125</c:v>
                </c:pt>
                <c:pt idx="1806">
                  <c:v>18031.77734375</c:v>
                </c:pt>
                <c:pt idx="1807">
                  <c:v>18129.11181640625</c:v>
                </c:pt>
                <c:pt idx="1808">
                  <c:v>18221.246337890625</c:v>
                </c:pt>
                <c:pt idx="1809">
                  <c:v>18300.637939453125</c:v>
                </c:pt>
                <c:pt idx="1810">
                  <c:v>18366.7724609375</c:v>
                </c:pt>
                <c:pt idx="1811">
                  <c:v>18396.021240234375</c:v>
                </c:pt>
                <c:pt idx="1812">
                  <c:v>18364.241455078125</c:v>
                </c:pt>
                <c:pt idx="1813">
                  <c:v>18281.975830078125</c:v>
                </c:pt>
                <c:pt idx="1814">
                  <c:v>18177.624755859375</c:v>
                </c:pt>
                <c:pt idx="1815">
                  <c:v>18061.55908203125</c:v>
                </c:pt>
                <c:pt idx="1816">
                  <c:v>17934.522216796875</c:v>
                </c:pt>
                <c:pt idx="1817">
                  <c:v>17811.628173828125</c:v>
                </c:pt>
                <c:pt idx="1818">
                  <c:v>17712.134033203125</c:v>
                </c:pt>
                <c:pt idx="1819">
                  <c:v>17637.525634765625</c:v>
                </c:pt>
                <c:pt idx="1820">
                  <c:v>17582.83154296875</c:v>
                </c:pt>
                <c:pt idx="1821">
                  <c:v>17546.99462890625</c:v>
                </c:pt>
                <c:pt idx="1822">
                  <c:v>17534.586181640625</c:v>
                </c:pt>
                <c:pt idx="1823">
                  <c:v>17537.349243164063</c:v>
                </c:pt>
                <c:pt idx="1824">
                  <c:v>17541.083740234375</c:v>
                </c:pt>
                <c:pt idx="1825">
                  <c:v>17538.618286132813</c:v>
                </c:pt>
                <c:pt idx="1826">
                  <c:v>17533.409912109375</c:v>
                </c:pt>
                <c:pt idx="1827">
                  <c:v>17539.372924804688</c:v>
                </c:pt>
                <c:pt idx="1828">
                  <c:v>17554.764526367188</c:v>
                </c:pt>
                <c:pt idx="1829">
                  <c:v>17569.241943359375</c:v>
                </c:pt>
                <c:pt idx="1830">
                  <c:v>17569.804931640625</c:v>
                </c:pt>
                <c:pt idx="1831">
                  <c:v>17560.653686523438</c:v>
                </c:pt>
                <c:pt idx="1832">
                  <c:v>17544.788208007813</c:v>
                </c:pt>
                <c:pt idx="1833">
                  <c:v>17528.494140625</c:v>
                </c:pt>
                <c:pt idx="1834">
                  <c:v>17515.05712890625</c:v>
                </c:pt>
                <c:pt idx="1835">
                  <c:v>17497.191650390625</c:v>
                </c:pt>
                <c:pt idx="1836">
                  <c:v>17469.84033203125</c:v>
                </c:pt>
                <c:pt idx="1837">
                  <c:v>17448.689208984375</c:v>
                </c:pt>
                <c:pt idx="1838">
                  <c:v>17451.595092773438</c:v>
                </c:pt>
                <c:pt idx="1839">
                  <c:v>17475.100952148438</c:v>
                </c:pt>
                <c:pt idx="1840">
                  <c:v>17492.378295898438</c:v>
                </c:pt>
                <c:pt idx="1841">
                  <c:v>17489.141357421875</c:v>
                </c:pt>
                <c:pt idx="1842">
                  <c:v>17472.27587890625</c:v>
                </c:pt>
                <c:pt idx="1843">
                  <c:v>17457.296020507813</c:v>
                </c:pt>
                <c:pt idx="1844">
                  <c:v>17442.83056640625</c:v>
                </c:pt>
                <c:pt idx="1845">
                  <c:v>17423.765014648438</c:v>
                </c:pt>
                <c:pt idx="1846">
                  <c:v>17408.070922851563</c:v>
                </c:pt>
                <c:pt idx="1847">
                  <c:v>17404.9482421875</c:v>
                </c:pt>
                <c:pt idx="1848">
                  <c:v>17408.368408203125</c:v>
                </c:pt>
                <c:pt idx="1849">
                  <c:v>17405.360107421875</c:v>
                </c:pt>
                <c:pt idx="1850">
                  <c:v>17403.0087890625</c:v>
                </c:pt>
                <c:pt idx="1851">
                  <c:v>17410.543334960938</c:v>
                </c:pt>
                <c:pt idx="1852">
                  <c:v>17421.763549804688</c:v>
                </c:pt>
                <c:pt idx="1853">
                  <c:v>17421.955078125</c:v>
                </c:pt>
                <c:pt idx="1854">
                  <c:v>17410.861083984375</c:v>
                </c:pt>
                <c:pt idx="1855">
                  <c:v>17396.3955078125</c:v>
                </c:pt>
                <c:pt idx="1856">
                  <c:v>17381.158569335938</c:v>
                </c:pt>
                <c:pt idx="1857">
                  <c:v>17364.493041992188</c:v>
                </c:pt>
                <c:pt idx="1858">
                  <c:v>17350.39892578125</c:v>
                </c:pt>
                <c:pt idx="1859">
                  <c:v>17339.419189453125</c:v>
                </c:pt>
                <c:pt idx="1860">
                  <c:v>17334.66796875</c:v>
                </c:pt>
                <c:pt idx="1861">
                  <c:v>17326.802368164063</c:v>
                </c:pt>
                <c:pt idx="1862">
                  <c:v>17311.536865234375</c:v>
                </c:pt>
                <c:pt idx="1863">
                  <c:v>17290.699951171875</c:v>
                </c:pt>
                <c:pt idx="1864">
                  <c:v>17273.234375</c:v>
                </c:pt>
                <c:pt idx="1865">
                  <c:v>17260.054565429688</c:v>
                </c:pt>
                <c:pt idx="1866">
                  <c:v>17248.474853515625</c:v>
                </c:pt>
                <c:pt idx="1867">
                  <c:v>17229.809326171875</c:v>
                </c:pt>
                <c:pt idx="1868">
                  <c:v>17199.972290039063</c:v>
                </c:pt>
                <c:pt idx="1869">
                  <c:v>17167.278198242188</c:v>
                </c:pt>
                <c:pt idx="1870">
                  <c:v>17140.269897460938</c:v>
                </c:pt>
                <c:pt idx="1871">
                  <c:v>17115.490112304688</c:v>
                </c:pt>
                <c:pt idx="1872">
                  <c:v>17095.595947265625</c:v>
                </c:pt>
                <c:pt idx="1873">
                  <c:v>17079.816162109375</c:v>
                </c:pt>
                <c:pt idx="1874">
                  <c:v>17063.379272460938</c:v>
                </c:pt>
                <c:pt idx="1875">
                  <c:v>17046.28515625</c:v>
                </c:pt>
                <c:pt idx="1876">
                  <c:v>17034.933837890625</c:v>
                </c:pt>
                <c:pt idx="1877">
                  <c:v>17030.354125976563</c:v>
                </c:pt>
                <c:pt idx="1878">
                  <c:v>17031.345703125</c:v>
                </c:pt>
                <c:pt idx="1879">
                  <c:v>17030.765869140625</c:v>
                </c:pt>
                <c:pt idx="1880">
                  <c:v>17027.271850585938</c:v>
                </c:pt>
                <c:pt idx="1881">
                  <c:v>17026.177734375</c:v>
                </c:pt>
                <c:pt idx="1882">
                  <c:v>17027.769409179688</c:v>
                </c:pt>
                <c:pt idx="1883">
                  <c:v>17020.246704101563</c:v>
                </c:pt>
                <c:pt idx="1884">
                  <c:v>17001.638305664063</c:v>
                </c:pt>
                <c:pt idx="1885">
                  <c:v>16983.658508300781</c:v>
                </c:pt>
                <c:pt idx="1886">
                  <c:v>16970.135864257813</c:v>
                </c:pt>
                <c:pt idx="1887">
                  <c:v>16956.670349121094</c:v>
                </c:pt>
                <c:pt idx="1888">
                  <c:v>16943.947631835938</c:v>
                </c:pt>
                <c:pt idx="1889">
                  <c:v>16937.310729980469</c:v>
                </c:pt>
                <c:pt idx="1890">
                  <c:v>16936.645202636719</c:v>
                </c:pt>
                <c:pt idx="1891">
                  <c:v>16941.322509765625</c:v>
                </c:pt>
                <c:pt idx="1892">
                  <c:v>16953.742736816406</c:v>
                </c:pt>
                <c:pt idx="1893">
                  <c:v>16969.277221679688</c:v>
                </c:pt>
                <c:pt idx="1894">
                  <c:v>16976.668823242188</c:v>
                </c:pt>
                <c:pt idx="1895">
                  <c:v>16967.231872558594</c:v>
                </c:pt>
                <c:pt idx="1896">
                  <c:v>16950.166381835938</c:v>
                </c:pt>
                <c:pt idx="1897">
                  <c:v>16937.157958984375</c:v>
                </c:pt>
                <c:pt idx="1898">
                  <c:v>16935.29248046875</c:v>
                </c:pt>
                <c:pt idx="1899">
                  <c:v>16935.169799804688</c:v>
                </c:pt>
                <c:pt idx="1900">
                  <c:v>16935.618591308594</c:v>
                </c:pt>
                <c:pt idx="1901">
                  <c:v>16935.2958984375</c:v>
                </c:pt>
                <c:pt idx="1902">
                  <c:v>16935.287536621094</c:v>
                </c:pt>
                <c:pt idx="1903">
                  <c:v>16929.8505859375</c:v>
                </c:pt>
                <c:pt idx="1904">
                  <c:v>16924.327941894531</c:v>
                </c:pt>
                <c:pt idx="1905">
                  <c:v>16923.34814453125</c:v>
                </c:pt>
                <c:pt idx="1906">
                  <c:v>16926.6826171875</c:v>
                </c:pt>
                <c:pt idx="1907">
                  <c:v>16928.502807617188</c:v>
                </c:pt>
                <c:pt idx="1908">
                  <c:v>16925.037292480469</c:v>
                </c:pt>
                <c:pt idx="1909">
                  <c:v>16922.486022949219</c:v>
                </c:pt>
                <c:pt idx="1910">
                  <c:v>16924.877685546875</c:v>
                </c:pt>
                <c:pt idx="1911">
                  <c:v>16927.840698242188</c:v>
                </c:pt>
                <c:pt idx="1912">
                  <c:v>16926.5751953125</c:v>
                </c:pt>
                <c:pt idx="1913">
                  <c:v>16931.023986816406</c:v>
                </c:pt>
                <c:pt idx="1914">
                  <c:v>16939.015563964844</c:v>
                </c:pt>
                <c:pt idx="1915">
                  <c:v>16946.350036621094</c:v>
                </c:pt>
                <c:pt idx="1916">
                  <c:v>16947.455993652344</c:v>
                </c:pt>
                <c:pt idx="1917">
                  <c:v>16946.933288574219</c:v>
                </c:pt>
                <c:pt idx="1918">
                  <c:v>16946.867797851563</c:v>
                </c:pt>
                <c:pt idx="1919">
                  <c:v>16954.345153808594</c:v>
                </c:pt>
                <c:pt idx="1920">
                  <c:v>16959.308166503906</c:v>
                </c:pt>
                <c:pt idx="1921">
                  <c:v>16957.871215820313</c:v>
                </c:pt>
                <c:pt idx="1922">
                  <c:v>16953.034301757813</c:v>
                </c:pt>
                <c:pt idx="1923">
                  <c:v>16950.368774414063</c:v>
                </c:pt>
                <c:pt idx="1924">
                  <c:v>16945.846130371094</c:v>
                </c:pt>
                <c:pt idx="1925">
                  <c:v>16945.58056640625</c:v>
                </c:pt>
                <c:pt idx="1926">
                  <c:v>16949.972229003906</c:v>
                </c:pt>
                <c:pt idx="1927">
                  <c:v>16956.335266113281</c:v>
                </c:pt>
                <c:pt idx="1928">
                  <c:v>16964.4697265625</c:v>
                </c:pt>
                <c:pt idx="1929">
                  <c:v>16973.432800292969</c:v>
                </c:pt>
                <c:pt idx="1930">
                  <c:v>16978.052978515625</c:v>
                </c:pt>
                <c:pt idx="1931">
                  <c:v>16979.930297851563</c:v>
                </c:pt>
                <c:pt idx="1932">
                  <c:v>16987.379089355469</c:v>
                </c:pt>
                <c:pt idx="1933">
                  <c:v>17000.199279785156</c:v>
                </c:pt>
                <c:pt idx="1934">
                  <c:v>17014.476623535156</c:v>
                </c:pt>
                <c:pt idx="1935">
                  <c:v>17023.211120605469</c:v>
                </c:pt>
                <c:pt idx="1936">
                  <c:v>17023.088439941406</c:v>
                </c:pt>
                <c:pt idx="1937">
                  <c:v>17022.994323730469</c:v>
                </c:pt>
                <c:pt idx="1938">
                  <c:v>17032.814575195313</c:v>
                </c:pt>
                <c:pt idx="1939">
                  <c:v>17048.549072265625</c:v>
                </c:pt>
                <c:pt idx="1940">
                  <c:v>17062.054931640625</c:v>
                </c:pt>
                <c:pt idx="1941">
                  <c:v>17078.5322265625</c:v>
                </c:pt>
                <c:pt idx="1942">
                  <c:v>17098.952514648438</c:v>
                </c:pt>
                <c:pt idx="1943">
                  <c:v>17111.372680664063</c:v>
                </c:pt>
                <c:pt idx="1944">
                  <c:v>17110.1357421875</c:v>
                </c:pt>
                <c:pt idx="1945">
                  <c:v>17109.498779296875</c:v>
                </c:pt>
                <c:pt idx="1946">
                  <c:v>17122.86181640625</c:v>
                </c:pt>
                <c:pt idx="1947">
                  <c:v>17140.167724609375</c:v>
                </c:pt>
                <c:pt idx="1948">
                  <c:v>17156.073608398438</c:v>
                </c:pt>
                <c:pt idx="1949">
                  <c:v>17171.208129882813</c:v>
                </c:pt>
                <c:pt idx="1950">
                  <c:v>17188.399780273438</c:v>
                </c:pt>
                <c:pt idx="1951">
                  <c:v>17202.648559570313</c:v>
                </c:pt>
                <c:pt idx="1952">
                  <c:v>17213.52587890625</c:v>
                </c:pt>
                <c:pt idx="1953">
                  <c:v>17220.03173828125</c:v>
                </c:pt>
                <c:pt idx="1954">
                  <c:v>17225.451904296875</c:v>
                </c:pt>
                <c:pt idx="1955">
                  <c:v>17239.500732421875</c:v>
                </c:pt>
                <c:pt idx="1956">
                  <c:v>17262.178100585938</c:v>
                </c:pt>
                <c:pt idx="1957">
                  <c:v>17276.655395507813</c:v>
                </c:pt>
                <c:pt idx="1958">
                  <c:v>17271.732788085938</c:v>
                </c:pt>
                <c:pt idx="1959">
                  <c:v>17265.69580078125</c:v>
                </c:pt>
                <c:pt idx="1960">
                  <c:v>17274.687377929688</c:v>
                </c:pt>
                <c:pt idx="1961">
                  <c:v>17294.3076171875</c:v>
                </c:pt>
                <c:pt idx="1962">
                  <c:v>17310.64208984375</c:v>
                </c:pt>
                <c:pt idx="1963">
                  <c:v>17315.119384765625</c:v>
                </c:pt>
                <c:pt idx="1964">
                  <c:v>17308.053955078125</c:v>
                </c:pt>
                <c:pt idx="1965">
                  <c:v>17306.388427734375</c:v>
                </c:pt>
                <c:pt idx="1966">
                  <c:v>17315.608520507813</c:v>
                </c:pt>
                <c:pt idx="1967">
                  <c:v>17319.02880859375</c:v>
                </c:pt>
                <c:pt idx="1968">
                  <c:v>17309.220336914063</c:v>
                </c:pt>
                <c:pt idx="1969">
                  <c:v>17296.04052734375</c:v>
                </c:pt>
                <c:pt idx="1970">
                  <c:v>17289.2607421875</c:v>
                </c:pt>
                <c:pt idx="1971">
                  <c:v>17292.023803710938</c:v>
                </c:pt>
                <c:pt idx="1972">
                  <c:v>17297.64404296875</c:v>
                </c:pt>
                <c:pt idx="1973">
                  <c:v>17292.0927734375</c:v>
                </c:pt>
                <c:pt idx="1974">
                  <c:v>17273.19873046875</c:v>
                </c:pt>
                <c:pt idx="1975">
                  <c:v>17257.733154296875</c:v>
                </c:pt>
                <c:pt idx="1976">
                  <c:v>17258.467651367188</c:v>
                </c:pt>
                <c:pt idx="1977">
                  <c:v>17270.545043945313</c:v>
                </c:pt>
                <c:pt idx="1978">
                  <c:v>17280.993774414063</c:v>
                </c:pt>
                <c:pt idx="1979">
                  <c:v>17280.271118164063</c:v>
                </c:pt>
                <c:pt idx="1980">
                  <c:v>17275.2626953125</c:v>
                </c:pt>
                <c:pt idx="1981">
                  <c:v>17278.854370117188</c:v>
                </c:pt>
                <c:pt idx="1982">
                  <c:v>17297.131713867188</c:v>
                </c:pt>
                <c:pt idx="1983">
                  <c:v>17318.609008789063</c:v>
                </c:pt>
                <c:pt idx="1984">
                  <c:v>17324.286376953125</c:v>
                </c:pt>
                <c:pt idx="1985">
                  <c:v>17310.8779296875</c:v>
                </c:pt>
                <c:pt idx="1986">
                  <c:v>17290.126708984375</c:v>
                </c:pt>
                <c:pt idx="1987">
                  <c:v>17274.575561523438</c:v>
                </c:pt>
                <c:pt idx="1988">
                  <c:v>17266.252807617188</c:v>
                </c:pt>
                <c:pt idx="1989">
                  <c:v>17267.387329101563</c:v>
                </c:pt>
                <c:pt idx="1990">
                  <c:v>17268.37890625</c:v>
                </c:pt>
                <c:pt idx="1991">
                  <c:v>17259.399169921875</c:v>
                </c:pt>
                <c:pt idx="1992">
                  <c:v>17241.419311523438</c:v>
                </c:pt>
                <c:pt idx="1993">
                  <c:v>17221.725219726563</c:v>
                </c:pt>
                <c:pt idx="1994">
                  <c:v>17203.802612304688</c:v>
                </c:pt>
                <c:pt idx="1995">
                  <c:v>17198.279907226563</c:v>
                </c:pt>
                <c:pt idx="1996">
                  <c:v>17206.642944335938</c:v>
                </c:pt>
                <c:pt idx="1997">
                  <c:v>17207.234619140625</c:v>
                </c:pt>
                <c:pt idx="1998">
                  <c:v>17189.197631835938</c:v>
                </c:pt>
                <c:pt idx="1999">
                  <c:v>17167.532104492188</c:v>
                </c:pt>
                <c:pt idx="2000">
                  <c:v>17155.695190429688</c:v>
                </c:pt>
                <c:pt idx="2001">
                  <c:v>17155.25830078125</c:v>
                </c:pt>
                <c:pt idx="2002">
                  <c:v>17164.735595703125</c:v>
                </c:pt>
                <c:pt idx="2003">
                  <c:v>17176.241455078125</c:v>
                </c:pt>
                <c:pt idx="2004">
                  <c:v>17176.6044921875</c:v>
                </c:pt>
                <c:pt idx="2005">
                  <c:v>17158.967651367188</c:v>
                </c:pt>
                <c:pt idx="2006">
                  <c:v>17134.730590820313</c:v>
                </c:pt>
                <c:pt idx="2007">
                  <c:v>17119.893676757813</c:v>
                </c:pt>
                <c:pt idx="2008">
                  <c:v>17117.37109375</c:v>
                </c:pt>
                <c:pt idx="2009">
                  <c:v>17114.134033203125</c:v>
                </c:pt>
                <c:pt idx="2010">
                  <c:v>17102.32568359375</c:v>
                </c:pt>
                <c:pt idx="2011">
                  <c:v>17082.431640625</c:v>
                </c:pt>
                <c:pt idx="2012">
                  <c:v>17059.223266601563</c:v>
                </c:pt>
                <c:pt idx="2013">
                  <c:v>17042.843383789063</c:v>
                </c:pt>
                <c:pt idx="2014">
                  <c:v>17039.54931640625</c:v>
                </c:pt>
                <c:pt idx="2015">
                  <c:v>17033.740966796875</c:v>
                </c:pt>
                <c:pt idx="2016">
                  <c:v>17014.618286132813</c:v>
                </c:pt>
                <c:pt idx="2017">
                  <c:v>16992.152770996094</c:v>
                </c:pt>
                <c:pt idx="2018">
                  <c:v>16976.944396972656</c:v>
                </c:pt>
                <c:pt idx="2019">
                  <c:v>16966.507446289063</c:v>
                </c:pt>
                <c:pt idx="2020">
                  <c:v>16956.984802246094</c:v>
                </c:pt>
                <c:pt idx="2021">
                  <c:v>16947.519287109375</c:v>
                </c:pt>
                <c:pt idx="2022">
                  <c:v>16937.168029785156</c:v>
                </c:pt>
                <c:pt idx="2023">
                  <c:v>16924.331115722656</c:v>
                </c:pt>
                <c:pt idx="2024">
                  <c:v>16908.665588378906</c:v>
                </c:pt>
                <c:pt idx="2025">
                  <c:v>16898.200073242188</c:v>
                </c:pt>
                <c:pt idx="2026">
                  <c:v>16899.591674804688</c:v>
                </c:pt>
                <c:pt idx="2027">
                  <c:v>16898.726196289063</c:v>
                </c:pt>
                <c:pt idx="2028">
                  <c:v>16884.117797851563</c:v>
                </c:pt>
                <c:pt idx="2029">
                  <c:v>16866.795104980469</c:v>
                </c:pt>
                <c:pt idx="2030">
                  <c:v>16855.529602050781</c:v>
                </c:pt>
                <c:pt idx="2031">
                  <c:v>16838.806945800781</c:v>
                </c:pt>
                <c:pt idx="2032">
                  <c:v>16819.484313964844</c:v>
                </c:pt>
                <c:pt idx="2033">
                  <c:v>16805.647338867188</c:v>
                </c:pt>
                <c:pt idx="2034">
                  <c:v>16802.210388183594</c:v>
                </c:pt>
                <c:pt idx="2035">
                  <c:v>16805.373413085938</c:v>
                </c:pt>
                <c:pt idx="2036">
                  <c:v>16816.422180175781</c:v>
                </c:pt>
                <c:pt idx="2037">
                  <c:v>16827.128112792969</c:v>
                </c:pt>
                <c:pt idx="2038">
                  <c:v>16834.348327636719</c:v>
                </c:pt>
                <c:pt idx="2039">
                  <c:v>16843.197082519531</c:v>
                </c:pt>
                <c:pt idx="2040">
                  <c:v>16851.417297363281</c:v>
                </c:pt>
                <c:pt idx="2041">
                  <c:v>16850.694580078125</c:v>
                </c:pt>
                <c:pt idx="2042">
                  <c:v>16845.543395996094</c:v>
                </c:pt>
                <c:pt idx="2043">
                  <c:v>16842.420715332031</c:v>
                </c:pt>
                <c:pt idx="2044">
                  <c:v>16834.469482421875</c:v>
                </c:pt>
                <c:pt idx="2045">
                  <c:v>16818.318237304688</c:v>
                </c:pt>
                <c:pt idx="2046">
                  <c:v>16803.367004394531</c:v>
                </c:pt>
                <c:pt idx="2047">
                  <c:v>16789.844360351563</c:v>
                </c:pt>
                <c:pt idx="2048">
                  <c:v>16776.378845214844</c:v>
                </c:pt>
                <c:pt idx="2049">
                  <c:v>16767.484741210938</c:v>
                </c:pt>
                <c:pt idx="2050">
                  <c:v>16768.476379394531</c:v>
                </c:pt>
                <c:pt idx="2051">
                  <c:v>16774.5537109375</c:v>
                </c:pt>
                <c:pt idx="2052">
                  <c:v>16781.345336914063</c:v>
                </c:pt>
                <c:pt idx="2053">
                  <c:v>16789.394104003906</c:v>
                </c:pt>
                <c:pt idx="2054">
                  <c:v>16801.700012207031</c:v>
                </c:pt>
                <c:pt idx="2055">
                  <c:v>16818.577331542969</c:v>
                </c:pt>
                <c:pt idx="2056">
                  <c:v>16838.883239746094</c:v>
                </c:pt>
                <c:pt idx="2057">
                  <c:v>16859.38916015625</c:v>
                </c:pt>
                <c:pt idx="2058">
                  <c:v>16876.580749511719</c:v>
                </c:pt>
                <c:pt idx="2059">
                  <c:v>16885.743835449219</c:v>
                </c:pt>
                <c:pt idx="2060">
                  <c:v>16883.849731445313</c:v>
                </c:pt>
                <c:pt idx="2061">
                  <c:v>16870.041381835938</c:v>
                </c:pt>
                <c:pt idx="2062">
                  <c:v>16855.547302246094</c:v>
                </c:pt>
                <c:pt idx="2063">
                  <c:v>16845.996032714844</c:v>
                </c:pt>
                <c:pt idx="2064">
                  <c:v>16831.701965332031</c:v>
                </c:pt>
                <c:pt idx="2065">
                  <c:v>16812.036437988281</c:v>
                </c:pt>
                <c:pt idx="2066">
                  <c:v>16792.1708984375</c:v>
                </c:pt>
                <c:pt idx="2067">
                  <c:v>16780.305419921875</c:v>
                </c:pt>
                <c:pt idx="2068">
                  <c:v>16778.78271484375</c:v>
                </c:pt>
                <c:pt idx="2069">
                  <c:v>16786.574340820313</c:v>
                </c:pt>
                <c:pt idx="2070">
                  <c:v>16796.966003417969</c:v>
                </c:pt>
                <c:pt idx="2071">
                  <c:v>16801.72900390625</c:v>
                </c:pt>
                <c:pt idx="2072">
                  <c:v>16799.434936523438</c:v>
                </c:pt>
                <c:pt idx="2073">
                  <c:v>16797.2265625</c:v>
                </c:pt>
                <c:pt idx="2074">
                  <c:v>16802.046752929688</c:v>
                </c:pt>
                <c:pt idx="2075">
                  <c:v>16807.666931152344</c:v>
                </c:pt>
                <c:pt idx="2076">
                  <c:v>16806.258544921875</c:v>
                </c:pt>
                <c:pt idx="2077">
                  <c:v>16808.564453125</c:v>
                </c:pt>
                <c:pt idx="2078">
                  <c:v>16812.984680175781</c:v>
                </c:pt>
                <c:pt idx="2079">
                  <c:v>16817.404846191406</c:v>
                </c:pt>
                <c:pt idx="2080">
                  <c:v>16828.482177734375</c:v>
                </c:pt>
                <c:pt idx="2081">
                  <c:v>16868.873840332031</c:v>
                </c:pt>
                <c:pt idx="2082">
                  <c:v>16939.808288574219</c:v>
                </c:pt>
                <c:pt idx="2083">
                  <c:v>17049.228515625</c:v>
                </c:pt>
                <c:pt idx="2084">
                  <c:v>17223.591552734375</c:v>
                </c:pt>
                <c:pt idx="2085">
                  <c:v>17494.240356445313</c:v>
                </c:pt>
                <c:pt idx="2086">
                  <c:v>17886.974853515625</c:v>
                </c:pt>
                <c:pt idx="2087">
                  <c:v>18435.537841796875</c:v>
                </c:pt>
                <c:pt idx="2088">
                  <c:v>19176.67236328125</c:v>
                </c:pt>
                <c:pt idx="2089">
                  <c:v>20130.349609375</c:v>
                </c:pt>
                <c:pt idx="2090">
                  <c:v>21297.85546875</c:v>
                </c:pt>
                <c:pt idx="2091">
                  <c:v>22636.0185546875</c:v>
                </c:pt>
                <c:pt idx="2092">
                  <c:v>24066.81005859375</c:v>
                </c:pt>
                <c:pt idx="2093">
                  <c:v>25489.373046875</c:v>
                </c:pt>
                <c:pt idx="2094">
                  <c:v>26790.6220703125</c:v>
                </c:pt>
                <c:pt idx="2095">
                  <c:v>27832.69921875</c:v>
                </c:pt>
                <c:pt idx="2096">
                  <c:v>28494.9765625</c:v>
                </c:pt>
                <c:pt idx="2097">
                  <c:v>28696.0830078125</c:v>
                </c:pt>
                <c:pt idx="2098">
                  <c:v>28421.5888671875</c:v>
                </c:pt>
                <c:pt idx="2099">
                  <c:v>27708.6376953125</c:v>
                </c:pt>
                <c:pt idx="2100">
                  <c:v>26639.486328125</c:v>
                </c:pt>
                <c:pt idx="2101">
                  <c:v>25332.9638671875</c:v>
                </c:pt>
                <c:pt idx="2102">
                  <c:v>23925.55517578125</c:v>
                </c:pt>
                <c:pt idx="2103">
                  <c:v>22529.689453125</c:v>
                </c:pt>
                <c:pt idx="2104">
                  <c:v>21228.79541015625</c:v>
                </c:pt>
                <c:pt idx="2105">
                  <c:v>20081.41552734375</c:v>
                </c:pt>
                <c:pt idx="2106">
                  <c:v>19137.921630859375</c:v>
                </c:pt>
                <c:pt idx="2107">
                  <c:v>18415.141845703125</c:v>
                </c:pt>
                <c:pt idx="2108">
                  <c:v>17890.990478515625</c:v>
                </c:pt>
                <c:pt idx="2109">
                  <c:v>17520.353515625</c:v>
                </c:pt>
                <c:pt idx="2110">
                  <c:v>17265.430908203125</c:v>
                </c:pt>
                <c:pt idx="2111">
                  <c:v>17100.96533203125</c:v>
                </c:pt>
                <c:pt idx="2112">
                  <c:v>17002.12841796875</c:v>
                </c:pt>
                <c:pt idx="2113">
                  <c:v>16949.40576171875</c:v>
                </c:pt>
                <c:pt idx="2114">
                  <c:v>16929.083129882813</c:v>
                </c:pt>
                <c:pt idx="2115">
                  <c:v>16924.703308105469</c:v>
                </c:pt>
                <c:pt idx="2116">
                  <c:v>16922.323486328125</c:v>
                </c:pt>
                <c:pt idx="2117">
                  <c:v>16911.715148925781</c:v>
                </c:pt>
                <c:pt idx="2118">
                  <c:v>16905.335327148438</c:v>
                </c:pt>
                <c:pt idx="2119">
                  <c:v>16908.212646484375</c:v>
                </c:pt>
                <c:pt idx="2120">
                  <c:v>16910.147155761719</c:v>
                </c:pt>
                <c:pt idx="2121">
                  <c:v>16903.367309570313</c:v>
                </c:pt>
                <c:pt idx="2122">
                  <c:v>16892.13037109375</c:v>
                </c:pt>
                <c:pt idx="2123">
                  <c:v>16872.007751464844</c:v>
                </c:pt>
                <c:pt idx="2124">
                  <c:v>16841.399353027344</c:v>
                </c:pt>
                <c:pt idx="2125">
                  <c:v>16821.419555664063</c:v>
                </c:pt>
                <c:pt idx="2126">
                  <c:v>16812.35400390625</c:v>
                </c:pt>
                <c:pt idx="2127">
                  <c:v>16793.4599609375</c:v>
                </c:pt>
                <c:pt idx="2128">
                  <c:v>16761.622985839844</c:v>
                </c:pt>
                <c:pt idx="2129">
                  <c:v>16745.157470703125</c:v>
                </c:pt>
                <c:pt idx="2130">
                  <c:v>16745.720520019531</c:v>
                </c:pt>
                <c:pt idx="2131">
                  <c:v>16750.912170410156</c:v>
                </c:pt>
                <c:pt idx="2132">
                  <c:v>16749.01806640625</c:v>
                </c:pt>
                <c:pt idx="2133">
                  <c:v>16739.238220214844</c:v>
                </c:pt>
                <c:pt idx="2134">
                  <c:v>16726.601318359375</c:v>
                </c:pt>
                <c:pt idx="2135">
                  <c:v>16716.650085449219</c:v>
                </c:pt>
                <c:pt idx="2136">
                  <c:v>16707.813110351563</c:v>
                </c:pt>
                <c:pt idx="2137">
                  <c:v>16696.947570800781</c:v>
                </c:pt>
                <c:pt idx="2138">
                  <c:v>16688.653503417969</c:v>
                </c:pt>
                <c:pt idx="2139">
                  <c:v>16682.359436035156</c:v>
                </c:pt>
                <c:pt idx="2140">
                  <c:v>16680.46533203125</c:v>
                </c:pt>
                <c:pt idx="2141">
                  <c:v>16682.171203613281</c:v>
                </c:pt>
                <c:pt idx="2142">
                  <c:v>16681.934265136719</c:v>
                </c:pt>
                <c:pt idx="2143">
                  <c:v>16674.040222167969</c:v>
                </c:pt>
                <c:pt idx="2144">
                  <c:v>16664.774658203125</c:v>
                </c:pt>
                <c:pt idx="2145">
                  <c:v>16660.537719726563</c:v>
                </c:pt>
                <c:pt idx="2146">
                  <c:v>16660.815063476563</c:v>
                </c:pt>
                <c:pt idx="2147">
                  <c:v>16664.006713867188</c:v>
                </c:pt>
                <c:pt idx="2148">
                  <c:v>16669.769714355469</c:v>
                </c:pt>
                <c:pt idx="2149">
                  <c:v>16674.875671386719</c:v>
                </c:pt>
                <c:pt idx="2150">
                  <c:v>16668.41015625</c:v>
                </c:pt>
                <c:pt idx="2151">
                  <c:v>16650.001770019531</c:v>
                </c:pt>
                <c:pt idx="2152">
                  <c:v>16632.593383789063</c:v>
                </c:pt>
                <c:pt idx="2153">
                  <c:v>16618.3564453125</c:v>
                </c:pt>
                <c:pt idx="2154">
                  <c:v>16605.490905761719</c:v>
                </c:pt>
                <c:pt idx="2155">
                  <c:v>16598.396789550781</c:v>
                </c:pt>
                <c:pt idx="2156">
                  <c:v>16596.35986328125</c:v>
                </c:pt>
                <c:pt idx="2157">
                  <c:v>16585.208618164063</c:v>
                </c:pt>
                <c:pt idx="2158">
                  <c:v>16565.285949707031</c:v>
                </c:pt>
                <c:pt idx="2159">
                  <c:v>16549.334716796875</c:v>
                </c:pt>
                <c:pt idx="2160">
                  <c:v>16539.269226074219</c:v>
                </c:pt>
                <c:pt idx="2161">
                  <c:v>16528.86083984375</c:v>
                </c:pt>
                <c:pt idx="2162">
                  <c:v>16521.909606933594</c:v>
                </c:pt>
                <c:pt idx="2163">
                  <c:v>16527.558349609375</c:v>
                </c:pt>
                <c:pt idx="2164">
                  <c:v>16544.521423339844</c:v>
                </c:pt>
                <c:pt idx="2165">
                  <c:v>16556.770202636719</c:v>
                </c:pt>
                <c:pt idx="2166">
                  <c:v>16557.618957519531</c:v>
                </c:pt>
                <c:pt idx="2167">
                  <c:v>16553.096313476563</c:v>
                </c:pt>
                <c:pt idx="2168">
                  <c:v>16551.659362792969</c:v>
                </c:pt>
                <c:pt idx="2169">
                  <c:v>16549.19384765625</c:v>
                </c:pt>
                <c:pt idx="2170">
                  <c:v>16544.728332519531</c:v>
                </c:pt>
                <c:pt idx="2171">
                  <c:v>16545.777099609375</c:v>
                </c:pt>
                <c:pt idx="2172">
                  <c:v>16553.0830078125</c:v>
                </c:pt>
                <c:pt idx="2173">
                  <c:v>16556.5888671875</c:v>
                </c:pt>
                <c:pt idx="2174">
                  <c:v>16546.551940917969</c:v>
                </c:pt>
                <c:pt idx="2175">
                  <c:v>16537.029296875</c:v>
                </c:pt>
                <c:pt idx="2176">
                  <c:v>16540.078063964844</c:v>
                </c:pt>
                <c:pt idx="2177">
                  <c:v>16556.355407714844</c:v>
                </c:pt>
                <c:pt idx="2178">
                  <c:v>16565.747009277344</c:v>
                </c:pt>
                <c:pt idx="2179">
                  <c:v>16557.110046386719</c:v>
                </c:pt>
                <c:pt idx="2180">
                  <c:v>16538.301696777344</c:v>
                </c:pt>
                <c:pt idx="2181">
                  <c:v>16523.950439453125</c:v>
                </c:pt>
                <c:pt idx="2182">
                  <c:v>16516.19921875</c:v>
                </c:pt>
                <c:pt idx="2183">
                  <c:v>16506.162261962891</c:v>
                </c:pt>
                <c:pt idx="2184">
                  <c:v>16496.896759033203</c:v>
                </c:pt>
                <c:pt idx="2185">
                  <c:v>16492.516937255859</c:v>
                </c:pt>
                <c:pt idx="2186">
                  <c:v>16492.337127685547</c:v>
                </c:pt>
                <c:pt idx="2187">
                  <c:v>16484.585906982422</c:v>
                </c:pt>
                <c:pt idx="2188">
                  <c:v>16471.377532958984</c:v>
                </c:pt>
                <c:pt idx="2189">
                  <c:v>16463.083435058594</c:v>
                </c:pt>
                <c:pt idx="2190">
                  <c:v>16465.703643798828</c:v>
                </c:pt>
                <c:pt idx="2191">
                  <c:v>16473.409545898438</c:v>
                </c:pt>
                <c:pt idx="2192">
                  <c:v>16475.115447998047</c:v>
                </c:pt>
                <c:pt idx="2193">
                  <c:v>16471.592803955078</c:v>
                </c:pt>
                <c:pt idx="2194">
                  <c:v>16467.441558837891</c:v>
                </c:pt>
                <c:pt idx="2195">
                  <c:v>16465.976043701172</c:v>
                </c:pt>
                <c:pt idx="2196">
                  <c:v>16463.624816894531</c:v>
                </c:pt>
                <c:pt idx="2197">
                  <c:v>16459.302154541016</c:v>
                </c:pt>
                <c:pt idx="2198">
                  <c:v>16453.236633300781</c:v>
                </c:pt>
                <c:pt idx="2199">
                  <c:v>16444.485382080078</c:v>
                </c:pt>
                <c:pt idx="2200">
                  <c:v>16436.134155273438</c:v>
                </c:pt>
                <c:pt idx="2201">
                  <c:v>16429.811492919922</c:v>
                </c:pt>
                <c:pt idx="2202">
                  <c:v>16422.574554443359</c:v>
                </c:pt>
                <c:pt idx="2203">
                  <c:v>16415.880462646484</c:v>
                </c:pt>
                <c:pt idx="2204">
                  <c:v>16417.243499755859</c:v>
                </c:pt>
                <c:pt idx="2205">
                  <c:v>16428.063690185547</c:v>
                </c:pt>
                <c:pt idx="2206">
                  <c:v>16435.855316162109</c:v>
                </c:pt>
                <c:pt idx="2207">
                  <c:v>16439.246948242188</c:v>
                </c:pt>
                <c:pt idx="2208">
                  <c:v>16443.724273681641</c:v>
                </c:pt>
                <c:pt idx="2209">
                  <c:v>16444.744476318359</c:v>
                </c:pt>
                <c:pt idx="2210">
                  <c:v>16434.621826171875</c:v>
                </c:pt>
                <c:pt idx="2211">
                  <c:v>16430.242004394531</c:v>
                </c:pt>
                <c:pt idx="2212">
                  <c:v>16443.519348144531</c:v>
                </c:pt>
                <c:pt idx="2213">
                  <c:v>16463.568115234375</c:v>
                </c:pt>
                <c:pt idx="2214">
                  <c:v>16470.474029541016</c:v>
                </c:pt>
                <c:pt idx="2215">
                  <c:v>16468.494232177734</c:v>
                </c:pt>
                <c:pt idx="2216">
                  <c:v>16465.800140380859</c:v>
                </c:pt>
                <c:pt idx="2217">
                  <c:v>16468.706024169922</c:v>
                </c:pt>
                <c:pt idx="2218">
                  <c:v>16472.211944580078</c:v>
                </c:pt>
                <c:pt idx="2219">
                  <c:v>16471.603576660156</c:v>
                </c:pt>
                <c:pt idx="2220">
                  <c:v>16466.252349853516</c:v>
                </c:pt>
                <c:pt idx="2221">
                  <c:v>16464.643951416016</c:v>
                </c:pt>
                <c:pt idx="2222">
                  <c:v>16471.635589599609</c:v>
                </c:pt>
                <c:pt idx="2223">
                  <c:v>16476.941497802734</c:v>
                </c:pt>
                <c:pt idx="2224">
                  <c:v>16479.733123779297</c:v>
                </c:pt>
                <c:pt idx="2225">
                  <c:v>16491.181884765625</c:v>
                </c:pt>
                <c:pt idx="2226">
                  <c:v>16510.087799072266</c:v>
                </c:pt>
                <c:pt idx="2227">
                  <c:v>16517.793701171875</c:v>
                </c:pt>
                <c:pt idx="2228">
                  <c:v>16506.15673828125</c:v>
                </c:pt>
                <c:pt idx="2229">
                  <c:v>16488.491241455078</c:v>
                </c:pt>
                <c:pt idx="2230">
                  <c:v>16478.425720214844</c:v>
                </c:pt>
                <c:pt idx="2231">
                  <c:v>16478.874481201172</c:v>
                </c:pt>
                <c:pt idx="2232">
                  <c:v>16481.066101074219</c:v>
                </c:pt>
                <c:pt idx="2233">
                  <c:v>16481.172027587891</c:v>
                </c:pt>
                <c:pt idx="2234">
                  <c:v>16477.392211914063</c:v>
                </c:pt>
                <c:pt idx="2235">
                  <c:v>16468.069549560547</c:v>
                </c:pt>
                <c:pt idx="2236">
                  <c:v>16454.546875</c:v>
                </c:pt>
                <c:pt idx="2237">
                  <c:v>16444.138519287109</c:v>
                </c:pt>
                <c:pt idx="2238">
                  <c:v>16440.930114746094</c:v>
                </c:pt>
                <c:pt idx="2239">
                  <c:v>16441.37890625</c:v>
                </c:pt>
                <c:pt idx="2240">
                  <c:v>16443.227661132813</c:v>
                </c:pt>
                <c:pt idx="2241">
                  <c:v>16438.819274902344</c:v>
                </c:pt>
                <c:pt idx="2242">
                  <c:v>16431.668060302734</c:v>
                </c:pt>
                <c:pt idx="2243">
                  <c:v>16426.831115722656</c:v>
                </c:pt>
                <c:pt idx="2244">
                  <c:v>16434.422729492188</c:v>
                </c:pt>
                <c:pt idx="2245">
                  <c:v>16448.614349365234</c:v>
                </c:pt>
                <c:pt idx="2246">
                  <c:v>16465.977416992188</c:v>
                </c:pt>
                <c:pt idx="2247">
                  <c:v>16472.397583007813</c:v>
                </c:pt>
                <c:pt idx="2248">
                  <c:v>16467.332092285156</c:v>
                </c:pt>
                <c:pt idx="2249">
                  <c:v>16459.895141601563</c:v>
                </c:pt>
                <c:pt idx="2250">
                  <c:v>16456.543884277344</c:v>
                </c:pt>
                <c:pt idx="2251">
                  <c:v>16454.735534667969</c:v>
                </c:pt>
                <c:pt idx="2252">
                  <c:v>16457.441436767578</c:v>
                </c:pt>
                <c:pt idx="2253">
                  <c:v>16465.118774414063</c:v>
                </c:pt>
                <c:pt idx="2254">
                  <c:v>16465.910400390625</c:v>
                </c:pt>
                <c:pt idx="2255">
                  <c:v>16458.644866943359</c:v>
                </c:pt>
                <c:pt idx="2256">
                  <c:v>16450.779357910156</c:v>
                </c:pt>
                <c:pt idx="2257">
                  <c:v>16450.485260009766</c:v>
                </c:pt>
                <c:pt idx="2258">
                  <c:v>16456.191162109375</c:v>
                </c:pt>
                <c:pt idx="2259">
                  <c:v>16467.4970703125</c:v>
                </c:pt>
                <c:pt idx="2260">
                  <c:v>16476.71728515625</c:v>
                </c:pt>
                <c:pt idx="2261">
                  <c:v>16478.137481689453</c:v>
                </c:pt>
                <c:pt idx="2262">
                  <c:v>16474.186248779297</c:v>
                </c:pt>
                <c:pt idx="2263">
                  <c:v>16472.434997558594</c:v>
                </c:pt>
                <c:pt idx="2264">
                  <c:v>16477.426635742188</c:v>
                </c:pt>
                <c:pt idx="2265">
                  <c:v>16484.275390625</c:v>
                </c:pt>
                <c:pt idx="2266">
                  <c:v>16490.238433837891</c:v>
                </c:pt>
                <c:pt idx="2267">
                  <c:v>16489.772918701172</c:v>
                </c:pt>
                <c:pt idx="2268">
                  <c:v>16486.621673583984</c:v>
                </c:pt>
                <c:pt idx="2269">
                  <c:v>16491.356170654297</c:v>
                </c:pt>
                <c:pt idx="2270">
                  <c:v>16501.404937744141</c:v>
                </c:pt>
                <c:pt idx="2271">
                  <c:v>16502.596557617188</c:v>
                </c:pt>
                <c:pt idx="2272">
                  <c:v>16493.045318603516</c:v>
                </c:pt>
                <c:pt idx="2273">
                  <c:v>16488.094085693359</c:v>
                </c:pt>
                <c:pt idx="2274">
                  <c:v>16491.657135009766</c:v>
                </c:pt>
                <c:pt idx="2275">
                  <c:v>16492.27734375</c:v>
                </c:pt>
                <c:pt idx="2276">
                  <c:v>16484.440399169922</c:v>
                </c:pt>
                <c:pt idx="2277">
                  <c:v>16479.432006835938</c:v>
                </c:pt>
                <c:pt idx="2278">
                  <c:v>16490.880767822266</c:v>
                </c:pt>
                <c:pt idx="2279">
                  <c:v>16509.729553222656</c:v>
                </c:pt>
                <c:pt idx="2280">
                  <c:v>16520.749755859375</c:v>
                </c:pt>
                <c:pt idx="2281">
                  <c:v>16528.684204101563</c:v>
                </c:pt>
                <c:pt idx="2282">
                  <c:v>16538.190124511719</c:v>
                </c:pt>
                <c:pt idx="2283">
                  <c:v>16540.981750488281</c:v>
                </c:pt>
                <c:pt idx="2284">
                  <c:v>16533.487670898438</c:v>
                </c:pt>
                <c:pt idx="2285">
                  <c:v>16532.364990234375</c:v>
                </c:pt>
                <c:pt idx="2286">
                  <c:v>16542.328063964844</c:v>
                </c:pt>
                <c:pt idx="2287">
                  <c:v>16552.9482421875</c:v>
                </c:pt>
                <c:pt idx="2288">
                  <c:v>16560.768432617188</c:v>
                </c:pt>
                <c:pt idx="2289">
                  <c:v>16567.988647460938</c:v>
                </c:pt>
                <c:pt idx="2290">
                  <c:v>16571.323120117188</c:v>
                </c:pt>
                <c:pt idx="2291">
                  <c:v>16567.400451660156</c:v>
                </c:pt>
                <c:pt idx="2292">
                  <c:v>16560.192077636719</c:v>
                </c:pt>
                <c:pt idx="2293">
                  <c:v>16559.383728027344</c:v>
                </c:pt>
                <c:pt idx="2294">
                  <c:v>16567.718200683594</c:v>
                </c:pt>
                <c:pt idx="2295">
                  <c:v>16576.766967773438</c:v>
                </c:pt>
                <c:pt idx="2296">
                  <c:v>16576.55859375</c:v>
                </c:pt>
                <c:pt idx="2297">
                  <c:v>16573.635925292969</c:v>
                </c:pt>
                <c:pt idx="2298">
                  <c:v>16584.713256835938</c:v>
                </c:pt>
                <c:pt idx="2299">
                  <c:v>16601.619140625</c:v>
                </c:pt>
                <c:pt idx="2300">
                  <c:v>16607.267944335938</c:v>
                </c:pt>
                <c:pt idx="2301">
                  <c:v>16607.23095703125</c:v>
                </c:pt>
                <c:pt idx="2302">
                  <c:v>16614.594055175781</c:v>
                </c:pt>
                <c:pt idx="2303">
                  <c:v>16621.614196777344</c:v>
                </c:pt>
                <c:pt idx="2304">
                  <c:v>16621.234436035156</c:v>
                </c:pt>
                <c:pt idx="2305">
                  <c:v>16621.940307617188</c:v>
                </c:pt>
                <c:pt idx="2306">
                  <c:v>16628.474792480469</c:v>
                </c:pt>
                <c:pt idx="2307">
                  <c:v>16634.637878417969</c:v>
                </c:pt>
                <c:pt idx="2308">
                  <c:v>16644.743774414063</c:v>
                </c:pt>
                <c:pt idx="2309">
                  <c:v>16654.649658203125</c:v>
                </c:pt>
                <c:pt idx="2310">
                  <c:v>16649.7841796875</c:v>
                </c:pt>
                <c:pt idx="2311">
                  <c:v>16635.090087890625</c:v>
                </c:pt>
                <c:pt idx="2312">
                  <c:v>16630.281677246094</c:v>
                </c:pt>
                <c:pt idx="2313">
                  <c:v>16637.816162109375</c:v>
                </c:pt>
                <c:pt idx="2314">
                  <c:v>16643.864929199219</c:v>
                </c:pt>
                <c:pt idx="2315">
                  <c:v>16643.113708496094</c:v>
                </c:pt>
                <c:pt idx="2316">
                  <c:v>16644.6767578125</c:v>
                </c:pt>
                <c:pt idx="2317">
                  <c:v>16651.725524902344</c:v>
                </c:pt>
                <c:pt idx="2318">
                  <c:v>16656.574279785156</c:v>
                </c:pt>
                <c:pt idx="2319">
                  <c:v>16650.165893554688</c:v>
                </c:pt>
                <c:pt idx="2320">
                  <c:v>16640.728942871094</c:v>
                </c:pt>
                <c:pt idx="2321">
                  <c:v>16639.806274414063</c:v>
                </c:pt>
                <c:pt idx="2322">
                  <c:v>16648.655090332031</c:v>
                </c:pt>
                <c:pt idx="2323">
                  <c:v>16655.189575195313</c:v>
                </c:pt>
                <c:pt idx="2324">
                  <c:v>16648.409729003906</c:v>
                </c:pt>
                <c:pt idx="2325">
                  <c:v>16633.544250488281</c:v>
                </c:pt>
                <c:pt idx="2326">
                  <c:v>16630.307250976563</c:v>
                </c:pt>
                <c:pt idx="2327">
                  <c:v>16640.098876953125</c:v>
                </c:pt>
                <c:pt idx="2328">
                  <c:v>16655.34765625</c:v>
                </c:pt>
                <c:pt idx="2329">
                  <c:v>16667.796447753906</c:v>
                </c:pt>
                <c:pt idx="2330">
                  <c:v>16672.673767089844</c:v>
                </c:pt>
                <c:pt idx="2331">
                  <c:v>16665.35107421875</c:v>
                </c:pt>
                <c:pt idx="2332">
                  <c:v>16658.371276855469</c:v>
                </c:pt>
                <c:pt idx="2333">
                  <c:v>16659.991516113281</c:v>
                </c:pt>
                <c:pt idx="2334">
                  <c:v>16665.240234375</c:v>
                </c:pt>
                <c:pt idx="2335">
                  <c:v>16666.631896972656</c:v>
                </c:pt>
                <c:pt idx="2336">
                  <c:v>16659.394958496094</c:v>
                </c:pt>
                <c:pt idx="2337">
                  <c:v>16650.157958984375</c:v>
                </c:pt>
                <c:pt idx="2338">
                  <c:v>16648.692443847656</c:v>
                </c:pt>
                <c:pt idx="2339">
                  <c:v>16655.769775390625</c:v>
                </c:pt>
                <c:pt idx="2340">
                  <c:v>16647.932861328125</c:v>
                </c:pt>
                <c:pt idx="2341">
                  <c:v>16624.438781738281</c:v>
                </c:pt>
                <c:pt idx="2342">
                  <c:v>16607.430419921875</c:v>
                </c:pt>
                <c:pt idx="2343">
                  <c:v>16611.450561523438</c:v>
                </c:pt>
                <c:pt idx="2344">
                  <c:v>16619.527893066406</c:v>
                </c:pt>
                <c:pt idx="2345">
                  <c:v>16613.376708984375</c:v>
                </c:pt>
                <c:pt idx="2346">
                  <c:v>16598.139770507813</c:v>
                </c:pt>
                <c:pt idx="2347">
                  <c:v>16592.045654296875</c:v>
                </c:pt>
                <c:pt idx="2348">
                  <c:v>16593.980102539063</c:v>
                </c:pt>
                <c:pt idx="2349">
                  <c:v>16594.000305175781</c:v>
                </c:pt>
                <c:pt idx="2350">
                  <c:v>16589.563354492188</c:v>
                </c:pt>
                <c:pt idx="2351">
                  <c:v>16581.897827148438</c:v>
                </c:pt>
                <c:pt idx="2352">
                  <c:v>16570.803771972656</c:v>
                </c:pt>
                <c:pt idx="2353">
                  <c:v>16564.138244628906</c:v>
                </c:pt>
                <c:pt idx="2354">
                  <c:v>16569.444152832031</c:v>
                </c:pt>
                <c:pt idx="2355">
                  <c:v>16578.378662109375</c:v>
                </c:pt>
                <c:pt idx="2356">
                  <c:v>16581.313110351563</c:v>
                </c:pt>
                <c:pt idx="2357">
                  <c:v>16580.104736328125</c:v>
                </c:pt>
                <c:pt idx="2358">
                  <c:v>16582.067810058594</c:v>
                </c:pt>
                <c:pt idx="2359">
                  <c:v>16588.145141601563</c:v>
                </c:pt>
                <c:pt idx="2360">
                  <c:v>16590.422485351563</c:v>
                </c:pt>
                <c:pt idx="2361">
                  <c:v>16587.156921386719</c:v>
                </c:pt>
                <c:pt idx="2362">
                  <c:v>16577.5771484375</c:v>
                </c:pt>
                <c:pt idx="2363">
                  <c:v>16564.940185546875</c:v>
                </c:pt>
                <c:pt idx="2364">
                  <c:v>16553.960388183594</c:v>
                </c:pt>
                <c:pt idx="2365">
                  <c:v>16551.351989746094</c:v>
                </c:pt>
                <c:pt idx="2366">
                  <c:v>16552.629333496094</c:v>
                </c:pt>
                <c:pt idx="2367">
                  <c:v>16550.820983886719</c:v>
                </c:pt>
                <c:pt idx="2368">
                  <c:v>16544.984008789063</c:v>
                </c:pt>
                <c:pt idx="2369">
                  <c:v>16538.6328125</c:v>
                </c:pt>
                <c:pt idx="2370">
                  <c:v>16533.624389648438</c:v>
                </c:pt>
                <c:pt idx="2371">
                  <c:v>16534.673156738281</c:v>
                </c:pt>
                <c:pt idx="2372">
                  <c:v>16539.5791015625</c:v>
                </c:pt>
                <c:pt idx="2373">
                  <c:v>16539.999267578125</c:v>
                </c:pt>
                <c:pt idx="2374">
                  <c:v>16528.905212402344</c:v>
                </c:pt>
                <c:pt idx="2375">
                  <c:v>16516.153930664063</c:v>
                </c:pt>
                <c:pt idx="2376">
                  <c:v>16508.402740478516</c:v>
                </c:pt>
                <c:pt idx="2377">
                  <c:v>16500.851501464844</c:v>
                </c:pt>
                <c:pt idx="2378">
                  <c:v>16488.157409667969</c:v>
                </c:pt>
                <c:pt idx="2379">
                  <c:v>16479.349029541016</c:v>
                </c:pt>
                <c:pt idx="2380">
                  <c:v>16481.112091064453</c:v>
                </c:pt>
                <c:pt idx="2381">
                  <c:v>16489.617980957031</c:v>
                </c:pt>
                <c:pt idx="2382">
                  <c:v>16498.6953125</c:v>
                </c:pt>
                <c:pt idx="2383">
                  <c:v>16506.858367919922</c:v>
                </c:pt>
                <c:pt idx="2384">
                  <c:v>16512.19287109375</c:v>
                </c:pt>
                <c:pt idx="2385">
                  <c:v>16506.413055419922</c:v>
                </c:pt>
                <c:pt idx="2386">
                  <c:v>16493.918975830078</c:v>
                </c:pt>
                <c:pt idx="2387">
                  <c:v>16481.453430175781</c:v>
                </c:pt>
                <c:pt idx="2388">
                  <c:v>16476.159362792969</c:v>
                </c:pt>
                <c:pt idx="2389">
                  <c:v>16474.236694335938</c:v>
                </c:pt>
                <c:pt idx="2390">
                  <c:v>16473.771179199219</c:v>
                </c:pt>
                <c:pt idx="2391">
                  <c:v>16468.077087402344</c:v>
                </c:pt>
                <c:pt idx="2392">
                  <c:v>16462.182983398438</c:v>
                </c:pt>
                <c:pt idx="2393">
                  <c:v>16464.546051025391</c:v>
                </c:pt>
                <c:pt idx="2394">
                  <c:v>16466.737670898438</c:v>
                </c:pt>
                <c:pt idx="2395">
                  <c:v>16460.129272460938</c:v>
                </c:pt>
                <c:pt idx="2396">
                  <c:v>16452.292327880859</c:v>
                </c:pt>
                <c:pt idx="2397">
                  <c:v>16450.026824951172</c:v>
                </c:pt>
                <c:pt idx="2398">
                  <c:v>16447.675598144531</c:v>
                </c:pt>
                <c:pt idx="2399">
                  <c:v>16436.152923583984</c:v>
                </c:pt>
                <c:pt idx="2400">
                  <c:v>16418.573120117188</c:v>
                </c:pt>
                <c:pt idx="2401">
                  <c:v>16402.221893310547</c:v>
                </c:pt>
                <c:pt idx="2402">
                  <c:v>16396.013519287109</c:v>
                </c:pt>
                <c:pt idx="2403">
                  <c:v>16403.090850830078</c:v>
                </c:pt>
                <c:pt idx="2404">
                  <c:v>16416.225311279297</c:v>
                </c:pt>
                <c:pt idx="2405">
                  <c:v>16418.759796142578</c:v>
                </c:pt>
                <c:pt idx="2406">
                  <c:v>16400.894287109375</c:v>
                </c:pt>
                <c:pt idx="2407">
                  <c:v>16381.571624755859</c:v>
                </c:pt>
                <c:pt idx="2408">
                  <c:v>16381.248962402344</c:v>
                </c:pt>
                <c:pt idx="2409">
                  <c:v>16398.611999511719</c:v>
                </c:pt>
                <c:pt idx="2410">
                  <c:v>16418.203643798828</c:v>
                </c:pt>
                <c:pt idx="2411">
                  <c:v>16430.109558105469</c:v>
                </c:pt>
                <c:pt idx="2412">
                  <c:v>16430.244018554688</c:v>
                </c:pt>
                <c:pt idx="2413">
                  <c:v>16422.292785644531</c:v>
                </c:pt>
                <c:pt idx="2414">
                  <c:v>16415.455841064453</c:v>
                </c:pt>
                <c:pt idx="2415">
                  <c:v>16414.247467041016</c:v>
                </c:pt>
                <c:pt idx="2416">
                  <c:v>16411.696228027344</c:v>
                </c:pt>
                <c:pt idx="2417">
                  <c:v>16407.2021484375</c:v>
                </c:pt>
                <c:pt idx="2418">
                  <c:v>16404.222351074219</c:v>
                </c:pt>
                <c:pt idx="2419">
                  <c:v>16402.099670410156</c:v>
                </c:pt>
                <c:pt idx="2420">
                  <c:v>16398.405578613281</c:v>
                </c:pt>
                <c:pt idx="2421">
                  <c:v>16397.054351806641</c:v>
                </c:pt>
                <c:pt idx="2422">
                  <c:v>16398.188842773438</c:v>
                </c:pt>
                <c:pt idx="2423">
                  <c:v>16390.694732666016</c:v>
                </c:pt>
                <c:pt idx="2424">
                  <c:v>16375.572082519531</c:v>
                </c:pt>
                <c:pt idx="2425">
                  <c:v>16361.335144042969</c:v>
                </c:pt>
                <c:pt idx="2426">
                  <c:v>16352.783905029297</c:v>
                </c:pt>
                <c:pt idx="2427">
                  <c:v>16352.318389892578</c:v>
                </c:pt>
                <c:pt idx="2428">
                  <c:v>16360.53857421875</c:v>
                </c:pt>
                <c:pt idx="2429">
                  <c:v>16368.673065185547</c:v>
                </c:pt>
                <c:pt idx="2430">
                  <c:v>16365.20751953125</c:v>
                </c:pt>
                <c:pt idx="2431">
                  <c:v>16355.570587158203</c:v>
                </c:pt>
                <c:pt idx="2432">
                  <c:v>16343.876495361328</c:v>
                </c:pt>
                <c:pt idx="2433">
                  <c:v>16338.782409667969</c:v>
                </c:pt>
                <c:pt idx="2434">
                  <c:v>16342.745452880859</c:v>
                </c:pt>
                <c:pt idx="2435">
                  <c:v>16349.022796630859</c:v>
                </c:pt>
                <c:pt idx="2436">
                  <c:v>16345.900115966797</c:v>
                </c:pt>
                <c:pt idx="2437">
                  <c:v>16344.663177490234</c:v>
                </c:pt>
                <c:pt idx="2438">
                  <c:v>16352.197662353516</c:v>
                </c:pt>
                <c:pt idx="2439">
                  <c:v>16357.503570556641</c:v>
                </c:pt>
                <c:pt idx="2440">
                  <c:v>16347.266632080078</c:v>
                </c:pt>
                <c:pt idx="2441">
                  <c:v>16330.058258056641</c:v>
                </c:pt>
                <c:pt idx="2442">
                  <c:v>16325.878448486328</c:v>
                </c:pt>
                <c:pt idx="2443">
                  <c:v>16335.984344482422</c:v>
                </c:pt>
                <c:pt idx="2444">
                  <c:v>16337.061676025391</c:v>
                </c:pt>
                <c:pt idx="2445">
                  <c:v>16314.567596435547</c:v>
                </c:pt>
                <c:pt idx="2446">
                  <c:v>16293.644927978516</c:v>
                </c:pt>
                <c:pt idx="2447">
                  <c:v>16295.550842285156</c:v>
                </c:pt>
                <c:pt idx="2448">
                  <c:v>16309.256744384766</c:v>
                </c:pt>
                <c:pt idx="2449">
                  <c:v>16310.93408203125</c:v>
                </c:pt>
                <c:pt idx="2450">
                  <c:v>16301.325714111328</c:v>
                </c:pt>
                <c:pt idx="2451">
                  <c:v>16290.374481201172</c:v>
                </c:pt>
                <c:pt idx="2452">
                  <c:v>16281.223236083984</c:v>
                </c:pt>
                <c:pt idx="2453">
                  <c:v>16281.043426513672</c:v>
                </c:pt>
                <c:pt idx="2454">
                  <c:v>16289.606506347656</c:v>
                </c:pt>
                <c:pt idx="2455">
                  <c:v>16302.683837890625</c:v>
                </c:pt>
                <c:pt idx="2456">
                  <c:v>16310.418304443359</c:v>
                </c:pt>
                <c:pt idx="2457">
                  <c:v>16309.924224853516</c:v>
                </c:pt>
                <c:pt idx="2458">
                  <c:v>16300.487274169922</c:v>
                </c:pt>
                <c:pt idx="2459">
                  <c:v>16293.450317382813</c:v>
                </c:pt>
                <c:pt idx="2460">
                  <c:v>16296.099090576172</c:v>
                </c:pt>
                <c:pt idx="2461">
                  <c:v>16302.290710449219</c:v>
                </c:pt>
                <c:pt idx="2462">
                  <c:v>16298.368041992188</c:v>
                </c:pt>
                <c:pt idx="2463">
                  <c:v>16288.416809082031</c:v>
                </c:pt>
                <c:pt idx="2464">
                  <c:v>16278.722717285156</c:v>
                </c:pt>
                <c:pt idx="2465">
                  <c:v>16279.971496582031</c:v>
                </c:pt>
                <c:pt idx="2466">
                  <c:v>16289.905975341797</c:v>
                </c:pt>
                <c:pt idx="2467">
                  <c:v>16301.440460205078</c:v>
                </c:pt>
                <c:pt idx="2468">
                  <c:v>16305.146362304688</c:v>
                </c:pt>
                <c:pt idx="2469">
                  <c:v>16302.309417724609</c:v>
                </c:pt>
                <c:pt idx="2470">
                  <c:v>16298.386749267578</c:v>
                </c:pt>
                <c:pt idx="2471">
                  <c:v>16289.864105224609</c:v>
                </c:pt>
                <c:pt idx="2472">
                  <c:v>16286.912872314453</c:v>
                </c:pt>
                <c:pt idx="2473">
                  <c:v>16295.504486083984</c:v>
                </c:pt>
                <c:pt idx="2474">
                  <c:v>16304.067535400391</c:v>
                </c:pt>
                <c:pt idx="2475">
                  <c:v>16296.002014160156</c:v>
                </c:pt>
                <c:pt idx="2476">
                  <c:v>16286.850769042969</c:v>
                </c:pt>
                <c:pt idx="2477">
                  <c:v>16288.928131103516</c:v>
                </c:pt>
                <c:pt idx="2478">
                  <c:v>16295.119750976563</c:v>
                </c:pt>
                <c:pt idx="2479">
                  <c:v>16297.311370849609</c:v>
                </c:pt>
                <c:pt idx="2480">
                  <c:v>16303.417266845703</c:v>
                </c:pt>
                <c:pt idx="2481">
                  <c:v>16312.666046142578</c:v>
                </c:pt>
                <c:pt idx="2482">
                  <c:v>16316.400512695313</c:v>
                </c:pt>
                <c:pt idx="2483">
                  <c:v>16315.16357421875</c:v>
                </c:pt>
                <c:pt idx="2484">
                  <c:v>16315.869476318359</c:v>
                </c:pt>
                <c:pt idx="2485">
                  <c:v>16307.775390625</c:v>
                </c:pt>
                <c:pt idx="2486">
                  <c:v>16285.367004394531</c:v>
                </c:pt>
                <c:pt idx="2487">
                  <c:v>16266.044342041016</c:v>
                </c:pt>
                <c:pt idx="2488">
                  <c:v>16271.578826904297</c:v>
                </c:pt>
                <c:pt idx="2489">
                  <c:v>16297.484741210938</c:v>
                </c:pt>
                <c:pt idx="2490">
                  <c:v>16322.819213867188</c:v>
                </c:pt>
                <c:pt idx="2491">
                  <c:v>16328.582275390625</c:v>
                </c:pt>
                <c:pt idx="2492">
                  <c:v>16308.402465820313</c:v>
                </c:pt>
                <c:pt idx="2493">
                  <c:v>16278.736938476563</c:v>
                </c:pt>
                <c:pt idx="2494">
                  <c:v>16260.214294433594</c:v>
                </c:pt>
                <c:pt idx="2495">
                  <c:v>16261.005920410156</c:v>
                </c:pt>
                <c:pt idx="2496">
                  <c:v>16269.454681396484</c:v>
                </c:pt>
                <c:pt idx="2497">
                  <c:v>16272.189147949219</c:v>
                </c:pt>
                <c:pt idx="2498">
                  <c:v>16273.237915039063</c:v>
                </c:pt>
                <c:pt idx="2499">
                  <c:v>16274.143829345703</c:v>
                </c:pt>
                <c:pt idx="2500">
                  <c:v>16271.621154785156</c:v>
                </c:pt>
                <c:pt idx="2501">
                  <c:v>16262.812805175781</c:v>
                </c:pt>
                <c:pt idx="2502">
                  <c:v>16252.975845336914</c:v>
                </c:pt>
                <c:pt idx="2503">
                  <c:v>16247.824615478516</c:v>
                </c:pt>
                <c:pt idx="2504">
                  <c:v>16250.016235351563</c:v>
                </c:pt>
                <c:pt idx="2505">
                  <c:v>16254.950714111328</c:v>
                </c:pt>
                <c:pt idx="2506">
                  <c:v>16252.828048706055</c:v>
                </c:pt>
                <c:pt idx="2507">
                  <c:v>16242.962539672852</c:v>
                </c:pt>
                <c:pt idx="2508">
                  <c:v>16234.582733154297</c:v>
                </c:pt>
                <c:pt idx="2509">
                  <c:v>16236.174346923828</c:v>
                </c:pt>
                <c:pt idx="2510">
                  <c:v>16246.765975952148</c:v>
                </c:pt>
                <c:pt idx="2511">
                  <c:v>16255.700454711914</c:v>
                </c:pt>
                <c:pt idx="2512">
                  <c:v>16248.94921875</c:v>
                </c:pt>
                <c:pt idx="2513">
                  <c:v>16227.855133056641</c:v>
                </c:pt>
                <c:pt idx="2514">
                  <c:v>16209.24674987793</c:v>
                </c:pt>
                <c:pt idx="2515">
                  <c:v>16208.238372802734</c:v>
                </c:pt>
                <c:pt idx="2516">
                  <c:v>16222.658569335938</c:v>
                </c:pt>
                <c:pt idx="2517">
                  <c:v>16241.907333374023</c:v>
                </c:pt>
                <c:pt idx="2518">
                  <c:v>16256.013244628906</c:v>
                </c:pt>
                <c:pt idx="2519">
                  <c:v>16258.719146728516</c:v>
                </c:pt>
                <c:pt idx="2520">
                  <c:v>16249.853637695313</c:v>
                </c:pt>
                <c:pt idx="2521">
                  <c:v>16238.816680908203</c:v>
                </c:pt>
                <c:pt idx="2522">
                  <c:v>16231.436889648438</c:v>
                </c:pt>
                <c:pt idx="2523">
                  <c:v>16228.485656738281</c:v>
                </c:pt>
                <c:pt idx="2524">
                  <c:v>16232.162994384766</c:v>
                </c:pt>
                <c:pt idx="2525">
                  <c:v>16239.697463989258</c:v>
                </c:pt>
                <c:pt idx="2526">
                  <c:v>16245.689086914063</c:v>
                </c:pt>
                <c:pt idx="2527">
                  <c:v>16234.195007324219</c:v>
                </c:pt>
                <c:pt idx="2528">
                  <c:v>16212.300903320313</c:v>
                </c:pt>
                <c:pt idx="2529">
                  <c:v>16195.178253173828</c:v>
                </c:pt>
                <c:pt idx="2530">
                  <c:v>16192.08415222168</c:v>
                </c:pt>
                <c:pt idx="2531">
                  <c:v>16192.961486816406</c:v>
                </c:pt>
                <c:pt idx="2532">
                  <c:v>16187.381683349609</c:v>
                </c:pt>
                <c:pt idx="2533">
                  <c:v>16179.573318481445</c:v>
                </c:pt>
                <c:pt idx="2534">
                  <c:v>16172.736358642578</c:v>
                </c:pt>
                <c:pt idx="2535">
                  <c:v>16167.442276000977</c:v>
                </c:pt>
                <c:pt idx="2536">
                  <c:v>16169.519607543945</c:v>
                </c:pt>
                <c:pt idx="2537">
                  <c:v>16183.539810180664</c:v>
                </c:pt>
                <c:pt idx="2538">
                  <c:v>16199.245712280273</c:v>
                </c:pt>
                <c:pt idx="2539">
                  <c:v>16201.80876159668</c:v>
                </c:pt>
                <c:pt idx="2540">
                  <c:v>16195.228958129883</c:v>
                </c:pt>
                <c:pt idx="2541">
                  <c:v>16183.134872436523</c:v>
                </c:pt>
                <c:pt idx="2542">
                  <c:v>16171.497924804688</c:v>
                </c:pt>
                <c:pt idx="2543">
                  <c:v>16169.060974121094</c:v>
                </c:pt>
                <c:pt idx="2544">
                  <c:v>16172.509735107422</c:v>
                </c:pt>
                <c:pt idx="2545">
                  <c:v>16168.301361083984</c:v>
                </c:pt>
                <c:pt idx="2546">
                  <c:v>16161.92155456543</c:v>
                </c:pt>
                <c:pt idx="2547">
                  <c:v>16160.741760253906</c:v>
                </c:pt>
                <c:pt idx="2548">
                  <c:v>16164.761947631836</c:v>
                </c:pt>
                <c:pt idx="2549">
                  <c:v>16167.296432495117</c:v>
                </c:pt>
                <c:pt idx="2550">
                  <c:v>16163.945190429688</c:v>
                </c:pt>
                <c:pt idx="2551">
                  <c:v>16158.708251953125</c:v>
                </c:pt>
                <c:pt idx="2552">
                  <c:v>16163.385589599609</c:v>
                </c:pt>
                <c:pt idx="2553">
                  <c:v>16176.520065307617</c:v>
                </c:pt>
                <c:pt idx="2554">
                  <c:v>16185.883117675781</c:v>
                </c:pt>
                <c:pt idx="2555">
                  <c:v>16186.131881713867</c:v>
                </c:pt>
                <c:pt idx="2556">
                  <c:v>16178.466369628906</c:v>
                </c:pt>
                <c:pt idx="2557">
                  <c:v>16165.686553955078</c:v>
                </c:pt>
                <c:pt idx="2558">
                  <c:v>16154.792465209961</c:v>
                </c:pt>
                <c:pt idx="2559">
                  <c:v>16148.726943969727</c:v>
                </c:pt>
                <c:pt idx="2560">
                  <c:v>16143.518569946289</c:v>
                </c:pt>
                <c:pt idx="2561">
                  <c:v>16137.853057861328</c:v>
                </c:pt>
                <c:pt idx="2562">
                  <c:v>16135.75895690918</c:v>
                </c:pt>
                <c:pt idx="2563">
                  <c:v>16132.922012329102</c:v>
                </c:pt>
                <c:pt idx="2564">
                  <c:v>16124.599349975586</c:v>
                </c:pt>
                <c:pt idx="2565">
                  <c:v>16113.790977478027</c:v>
                </c:pt>
                <c:pt idx="2566">
                  <c:v>16108.011169433594</c:v>
                </c:pt>
                <c:pt idx="2567">
                  <c:v>16112.059936523438</c:v>
                </c:pt>
                <c:pt idx="2568">
                  <c:v>16124.022987365723</c:v>
                </c:pt>
                <c:pt idx="2569">
                  <c:v>16140.986038208008</c:v>
                </c:pt>
                <c:pt idx="2570">
                  <c:v>16147.749084472656</c:v>
                </c:pt>
                <c:pt idx="2571">
                  <c:v>16134.540710449219</c:v>
                </c:pt>
                <c:pt idx="2572">
                  <c:v>16107.0751953125</c:v>
                </c:pt>
                <c:pt idx="2573">
                  <c:v>16086.323959350586</c:v>
                </c:pt>
                <c:pt idx="2574">
                  <c:v>16080.201301574707</c:v>
                </c:pt>
                <c:pt idx="2575">
                  <c:v>16081.421493530273</c:v>
                </c:pt>
                <c:pt idx="2576">
                  <c:v>16085.413116455078</c:v>
                </c:pt>
                <c:pt idx="2577">
                  <c:v>16094.319023132324</c:v>
                </c:pt>
                <c:pt idx="2578">
                  <c:v>16102.939224243164</c:v>
                </c:pt>
                <c:pt idx="2579">
                  <c:v>16108.21656036377</c:v>
                </c:pt>
                <c:pt idx="2580">
                  <c:v>16113.836753845215</c:v>
                </c:pt>
                <c:pt idx="2581">
                  <c:v>16118.48551940918</c:v>
                </c:pt>
                <c:pt idx="2582">
                  <c:v>16113.391426086426</c:v>
                </c:pt>
                <c:pt idx="2583">
                  <c:v>16099.983055114746</c:v>
                </c:pt>
                <c:pt idx="2584">
                  <c:v>16088.403244018555</c:v>
                </c:pt>
                <c:pt idx="2585">
                  <c:v>16085.852012634277</c:v>
                </c:pt>
                <c:pt idx="2586">
                  <c:v>16090.243637084961</c:v>
                </c:pt>
                <c:pt idx="2587">
                  <c:v>16097.463829040527</c:v>
                </c:pt>
                <c:pt idx="2588">
                  <c:v>16098.25545501709</c:v>
                </c:pt>
                <c:pt idx="2589">
                  <c:v>16095.018508911133</c:v>
                </c:pt>
                <c:pt idx="2590">
                  <c:v>16093.5244140625</c:v>
                </c:pt>
                <c:pt idx="2591">
                  <c:v>16095.687469482422</c:v>
                </c:pt>
                <c:pt idx="2592">
                  <c:v>16098.050521850586</c:v>
                </c:pt>
                <c:pt idx="2593">
                  <c:v>16095.613571166992</c:v>
                </c:pt>
                <c:pt idx="2594">
                  <c:v>16086.662338256836</c:v>
                </c:pt>
                <c:pt idx="2595">
                  <c:v>16083.36824798584</c:v>
                </c:pt>
                <c:pt idx="2596">
                  <c:v>16088.217010498047</c:v>
                </c:pt>
                <c:pt idx="2597">
                  <c:v>16092.065780639648</c:v>
                </c:pt>
                <c:pt idx="2598">
                  <c:v>16086.857398986816</c:v>
                </c:pt>
                <c:pt idx="2599">
                  <c:v>16092.020454406738</c:v>
                </c:pt>
                <c:pt idx="2600">
                  <c:v>16105.040649414063</c:v>
                </c:pt>
                <c:pt idx="2601">
                  <c:v>16105.746559143066</c:v>
                </c:pt>
                <c:pt idx="2602">
                  <c:v>16088.023895263672</c:v>
                </c:pt>
                <c:pt idx="2603">
                  <c:v>16074.558380126953</c:v>
                </c:pt>
                <c:pt idx="2604">
                  <c:v>16075.550003051758</c:v>
                </c:pt>
                <c:pt idx="2605">
                  <c:v>16079.313049316406</c:v>
                </c:pt>
                <c:pt idx="2606">
                  <c:v>16080.076103210449</c:v>
                </c:pt>
                <c:pt idx="2607">
                  <c:v>16081.924873352051</c:v>
                </c:pt>
                <c:pt idx="2608">
                  <c:v>16081.487922668457</c:v>
                </c:pt>
                <c:pt idx="2609">
                  <c:v>16077.993827819824</c:v>
                </c:pt>
                <c:pt idx="2610">
                  <c:v>16075.042594909668</c:v>
                </c:pt>
                <c:pt idx="2611">
                  <c:v>16080.062789916992</c:v>
                </c:pt>
                <c:pt idx="2612">
                  <c:v>16085.225845336914</c:v>
                </c:pt>
                <c:pt idx="2613">
                  <c:v>16079.874610900879</c:v>
                </c:pt>
                <c:pt idx="2614">
                  <c:v>16065.951950073242</c:v>
                </c:pt>
                <c:pt idx="2615">
                  <c:v>16062.000713348389</c:v>
                </c:pt>
                <c:pt idx="2616">
                  <c:v>16070.67805480957</c:v>
                </c:pt>
                <c:pt idx="2617">
                  <c:v>16075.412528991699</c:v>
                </c:pt>
                <c:pt idx="2618">
                  <c:v>16070.94701385498</c:v>
                </c:pt>
                <c:pt idx="2619">
                  <c:v>16068.652923583984</c:v>
                </c:pt>
                <c:pt idx="2620">
                  <c:v>16067.958831787109</c:v>
                </c:pt>
                <c:pt idx="2621">
                  <c:v>16065.179023742676</c:v>
                </c:pt>
                <c:pt idx="2622">
                  <c:v>16058.456363677979</c:v>
                </c:pt>
                <c:pt idx="2623">
                  <c:v>16053.876560211182</c:v>
                </c:pt>
                <c:pt idx="2624">
                  <c:v>16051.982467651367</c:v>
                </c:pt>
                <c:pt idx="2625">
                  <c:v>16063.40266418457</c:v>
                </c:pt>
                <c:pt idx="2626">
                  <c:v>16084.651428222656</c:v>
                </c:pt>
                <c:pt idx="2627">
                  <c:v>16095.843055725098</c:v>
                </c:pt>
                <c:pt idx="2628">
                  <c:v>16086.348960876465</c:v>
                </c:pt>
                <c:pt idx="2629">
                  <c:v>16071.112014770508</c:v>
                </c:pt>
                <c:pt idx="2630">
                  <c:v>16061.960781097412</c:v>
                </c:pt>
                <c:pt idx="2631">
                  <c:v>16057.495258331299</c:v>
                </c:pt>
                <c:pt idx="2632">
                  <c:v>16054.315456390381</c:v>
                </c:pt>
                <c:pt idx="2633">
                  <c:v>16058.392791748047</c:v>
                </c:pt>
                <c:pt idx="2634">
                  <c:v>16064.12727355957</c:v>
                </c:pt>
                <c:pt idx="2635">
                  <c:v>16068.833183288574</c:v>
                </c:pt>
                <c:pt idx="2636">
                  <c:v>16067.881950378418</c:v>
                </c:pt>
                <c:pt idx="2637">
                  <c:v>16066.673568725586</c:v>
                </c:pt>
                <c:pt idx="2638">
                  <c:v>16067.550910949707</c:v>
                </c:pt>
                <c:pt idx="2639">
                  <c:v>16068.171104431152</c:v>
                </c:pt>
                <c:pt idx="2640">
                  <c:v>16067.562728881836</c:v>
                </c:pt>
                <c:pt idx="2641">
                  <c:v>16071.668640136719</c:v>
                </c:pt>
                <c:pt idx="2642">
                  <c:v>16073.488830566406</c:v>
                </c:pt>
                <c:pt idx="2643">
                  <c:v>16066.137596130371</c:v>
                </c:pt>
                <c:pt idx="2644">
                  <c:v>16050.986362457275</c:v>
                </c:pt>
                <c:pt idx="2645">
                  <c:v>16042.377986907959</c:v>
                </c:pt>
                <c:pt idx="2646">
                  <c:v>16037.341037750244</c:v>
                </c:pt>
                <c:pt idx="2647">
                  <c:v>16034.475521087646</c:v>
                </c:pt>
                <c:pt idx="2648">
                  <c:v>16039.724285125732</c:v>
                </c:pt>
                <c:pt idx="2649">
                  <c:v>16054.573051452637</c:v>
                </c:pt>
                <c:pt idx="2650">
                  <c:v>16066.593246459961</c:v>
                </c:pt>
                <c:pt idx="2651">
                  <c:v>16064.356300354004</c:v>
                </c:pt>
                <c:pt idx="2652">
                  <c:v>16051.319351196289</c:v>
                </c:pt>
                <c:pt idx="2653">
                  <c:v>16040.168117523193</c:v>
                </c:pt>
                <c:pt idx="2654">
                  <c:v>16037.816883087158</c:v>
                </c:pt>
                <c:pt idx="2655">
                  <c:v>16041.379936218262</c:v>
                </c:pt>
                <c:pt idx="2656">
                  <c:v>16044.342987060547</c:v>
                </c:pt>
                <c:pt idx="2657">
                  <c:v>16047.220325469971</c:v>
                </c:pt>
                <c:pt idx="2658">
                  <c:v>16048.269092559814</c:v>
                </c:pt>
                <c:pt idx="2659">
                  <c:v>16046.54642868042</c:v>
                </c:pt>
                <c:pt idx="2660">
                  <c:v>16051.623767852783</c:v>
                </c:pt>
                <c:pt idx="2661">
                  <c:v>16060.786819458008</c:v>
                </c:pt>
                <c:pt idx="2662">
                  <c:v>16058.692726135254</c:v>
                </c:pt>
                <c:pt idx="2663">
                  <c:v>16044.655780792236</c:v>
                </c:pt>
                <c:pt idx="2664">
                  <c:v>16040.675975799561</c:v>
                </c:pt>
                <c:pt idx="2665">
                  <c:v>16045.781883239746</c:v>
                </c:pt>
                <c:pt idx="2666">
                  <c:v>16047.00207901001</c:v>
                </c:pt>
                <c:pt idx="2667">
                  <c:v>16046.822273254395</c:v>
                </c:pt>
                <c:pt idx="2668">
                  <c:v>16046.58532333374</c:v>
                </c:pt>
                <c:pt idx="2669">
                  <c:v>16040.234092712402</c:v>
                </c:pt>
                <c:pt idx="2670">
                  <c:v>16034.711429595947</c:v>
                </c:pt>
                <c:pt idx="2671">
                  <c:v>16037.445907592773</c:v>
                </c:pt>
                <c:pt idx="2672">
                  <c:v>16038.580390930176</c:v>
                </c:pt>
                <c:pt idx="2673">
                  <c:v>16036.7434425354</c:v>
                </c:pt>
                <c:pt idx="2674">
                  <c:v>16037.877922058105</c:v>
                </c:pt>
                <c:pt idx="2675">
                  <c:v>16038.640972137451</c:v>
                </c:pt>
                <c:pt idx="2676">
                  <c:v>16037.289741516113</c:v>
                </c:pt>
                <c:pt idx="2677">
                  <c:v>16032.652793884277</c:v>
                </c:pt>
                <c:pt idx="2678">
                  <c:v>16022.187273025513</c:v>
                </c:pt>
                <c:pt idx="2679">
                  <c:v>16017.236038208008</c:v>
                </c:pt>
                <c:pt idx="2680">
                  <c:v>16031.541948318481</c:v>
                </c:pt>
                <c:pt idx="2681">
                  <c:v>16053.876426696777</c:v>
                </c:pt>
                <c:pt idx="2682">
                  <c:v>16062.15376663208</c:v>
                </c:pt>
                <c:pt idx="2683">
                  <c:v>16054.859676361084</c:v>
                </c:pt>
                <c:pt idx="2684">
                  <c:v>16043.42272567749</c:v>
                </c:pt>
                <c:pt idx="2685">
                  <c:v>16037.100063323975</c:v>
                </c:pt>
                <c:pt idx="2686">
                  <c:v>16034.348831176758</c:v>
                </c:pt>
                <c:pt idx="2687">
                  <c:v>16038.054740905762</c:v>
                </c:pt>
                <c:pt idx="2688">
                  <c:v>16043.903507232666</c:v>
                </c:pt>
                <c:pt idx="2689">
                  <c:v>16049.237987518311</c:v>
                </c:pt>
                <c:pt idx="2690">
                  <c:v>16044.829608917236</c:v>
                </c:pt>
                <c:pt idx="2691">
                  <c:v>16030.0498046875</c:v>
                </c:pt>
                <c:pt idx="2692">
                  <c:v>16017.469999313354</c:v>
                </c:pt>
                <c:pt idx="2693">
                  <c:v>16020.175909042358</c:v>
                </c:pt>
                <c:pt idx="2694">
                  <c:v>16029.824674606323</c:v>
                </c:pt>
                <c:pt idx="2695">
                  <c:v>16031.330583572388</c:v>
                </c:pt>
                <c:pt idx="2696">
                  <c:v>16035.265064239502</c:v>
                </c:pt>
                <c:pt idx="2697">
                  <c:v>16043.799545288086</c:v>
                </c:pt>
                <c:pt idx="2698">
                  <c:v>16041.905452728271</c:v>
                </c:pt>
                <c:pt idx="2699">
                  <c:v>16027.439935684204</c:v>
                </c:pt>
                <c:pt idx="2700">
                  <c:v>16018.374416351318</c:v>
                </c:pt>
                <c:pt idx="2701">
                  <c:v>16022.851753234863</c:v>
                </c:pt>
                <c:pt idx="2702">
                  <c:v>16037.300518035889</c:v>
                </c:pt>
                <c:pt idx="2703">
                  <c:v>16054.577857971191</c:v>
                </c:pt>
                <c:pt idx="2704">
                  <c:v>16058.969482421875</c:v>
                </c:pt>
                <c:pt idx="2705">
                  <c:v>16051.675388336182</c:v>
                </c:pt>
                <c:pt idx="2706">
                  <c:v>16045.838439941406</c:v>
                </c:pt>
                <c:pt idx="2707">
                  <c:v>16042.20149230957</c:v>
                </c:pt>
                <c:pt idx="2708">
                  <c:v>16035.878829956055</c:v>
                </c:pt>
                <c:pt idx="2709">
                  <c:v>16032.384738922119</c:v>
                </c:pt>
                <c:pt idx="2710">
                  <c:v>16032.719219207764</c:v>
                </c:pt>
                <c:pt idx="2711">
                  <c:v>16031.253702163696</c:v>
                </c:pt>
                <c:pt idx="2712">
                  <c:v>16025.388181686401</c:v>
                </c:pt>
                <c:pt idx="2713">
                  <c:v>16012.694090843201</c:v>
                </c:pt>
                <c:pt idx="2714">
                  <c:v>16000</c:v>
                </c:pt>
                <c:pt idx="2715">
                  <c:v>16005.734480381012</c:v>
                </c:pt>
                <c:pt idx="2716">
                  <c:v>16022.783246994019</c:v>
                </c:pt>
                <c:pt idx="2717">
                  <c:v>16028.946298599243</c:v>
                </c:pt>
                <c:pt idx="2718">
                  <c:v>16021.737922668457</c:v>
                </c:pt>
                <c:pt idx="2719">
                  <c:v>16022.958116531372</c:v>
                </c:pt>
                <c:pt idx="2720">
                  <c:v>16034.892597198486</c:v>
                </c:pt>
                <c:pt idx="2721">
                  <c:v>16044.912792205811</c:v>
                </c:pt>
                <c:pt idx="2722">
                  <c:v>16043.932987213135</c:v>
                </c:pt>
                <c:pt idx="2723">
                  <c:v>16038.838897705078</c:v>
                </c:pt>
                <c:pt idx="2724">
                  <c:v>16039.373374938965</c:v>
                </c:pt>
                <c:pt idx="2725">
                  <c:v>16047.993572235107</c:v>
                </c:pt>
                <c:pt idx="2726">
                  <c:v>16056.013767242432</c:v>
                </c:pt>
                <c:pt idx="2727">
                  <c:v>16054.976818084717</c:v>
                </c:pt>
                <c:pt idx="2728">
                  <c:v>16047.311298370361</c:v>
                </c:pt>
                <c:pt idx="2729">
                  <c:v>16038.931491851807</c:v>
                </c:pt>
                <c:pt idx="2730">
                  <c:v>16036.608829498291</c:v>
                </c:pt>
                <c:pt idx="2731">
                  <c:v>16035.943309783936</c:v>
                </c:pt>
                <c:pt idx="2732">
                  <c:v>16032.020648956299</c:v>
                </c:pt>
                <c:pt idx="2733">
                  <c:v>16023.612272262573</c:v>
                </c:pt>
                <c:pt idx="2734">
                  <c:v>16018.661039352417</c:v>
                </c:pt>
                <c:pt idx="2735">
                  <c:v>16015.024090766907</c:v>
                </c:pt>
                <c:pt idx="2736">
                  <c:v>16017.987142562866</c:v>
                </c:pt>
                <c:pt idx="2737">
                  <c:v>16030.20733833313</c:v>
                </c:pt>
                <c:pt idx="2738">
                  <c:v>16042.313247680664</c:v>
                </c:pt>
                <c:pt idx="2739">
                  <c:v>16043.90486907959</c:v>
                </c:pt>
                <c:pt idx="2740">
                  <c:v>16039.467922210693</c:v>
                </c:pt>
                <c:pt idx="2741">
                  <c:v>16030.630973815918</c:v>
                </c:pt>
                <c:pt idx="2742">
                  <c:v>16015.508311271667</c:v>
                </c:pt>
                <c:pt idx="2743">
                  <c:v>16005.842792034149</c:v>
                </c:pt>
                <c:pt idx="2744">
                  <c:v>16010.491558074951</c:v>
                </c:pt>
                <c:pt idx="2745">
                  <c:v>16016.140325546265</c:v>
                </c:pt>
                <c:pt idx="2746">
                  <c:v>16013.874805450439</c:v>
                </c:pt>
                <c:pt idx="2747">
                  <c:v>16009.809286117554</c:v>
                </c:pt>
                <c:pt idx="2748">
                  <c:v>16009.858052253723</c:v>
                </c:pt>
                <c:pt idx="2749">
                  <c:v>16009.878246307373</c:v>
                </c:pt>
                <c:pt idx="2750">
                  <c:v>16010.355584144592</c:v>
                </c:pt>
                <c:pt idx="2751">
                  <c:v>16016.147207260132</c:v>
                </c:pt>
                <c:pt idx="2752">
                  <c:v>16024.567401885986</c:v>
                </c:pt>
                <c:pt idx="2753">
                  <c:v>16028.73045539856</c:v>
                </c:pt>
                <c:pt idx="2754">
                  <c:v>16025.179220199585</c:v>
                </c:pt>
                <c:pt idx="2755">
                  <c:v>16017.542272567749</c:v>
                </c:pt>
                <c:pt idx="2756">
                  <c:v>16014.448182106018</c:v>
                </c:pt>
                <c:pt idx="2757">
                  <c:v>16019.554090499878</c:v>
                </c:pt>
                <c:pt idx="2758">
                  <c:v>16030.888570785522</c:v>
                </c:pt>
                <c:pt idx="2759">
                  <c:v>16033.708766937256</c:v>
                </c:pt>
                <c:pt idx="2760">
                  <c:v>16026.414674758911</c:v>
                </c:pt>
                <c:pt idx="2761">
                  <c:v>16013.66344165802</c:v>
                </c:pt>
                <c:pt idx="2762">
                  <c:v>16004.940779209137</c:v>
                </c:pt>
                <c:pt idx="2763">
                  <c:v>16004.046688079834</c:v>
                </c:pt>
                <c:pt idx="2764">
                  <c:v>16010.981168746948</c:v>
                </c:pt>
                <c:pt idx="2765">
                  <c:v>16014.258506774902</c:v>
                </c:pt>
                <c:pt idx="2766">
                  <c:v>16009.164415359497</c:v>
                </c:pt>
                <c:pt idx="2767">
                  <c:v>16006.184610366821</c:v>
                </c:pt>
                <c:pt idx="2768">
                  <c:v>16013.204805374146</c:v>
                </c:pt>
                <c:pt idx="2769">
                  <c:v>16023.7678565979</c:v>
                </c:pt>
                <c:pt idx="2770">
                  <c:v>16029.788051605225</c:v>
                </c:pt>
                <c:pt idx="2771">
                  <c:v>16025.436819076538</c:v>
                </c:pt>
                <c:pt idx="2772">
                  <c:v>16022.399869918823</c:v>
                </c:pt>
                <c:pt idx="2773">
                  <c:v>16025.620065689087</c:v>
                </c:pt>
                <c:pt idx="2774">
                  <c:v>16029.954545974731</c:v>
                </c:pt>
                <c:pt idx="2775">
                  <c:v>16023.060455322266</c:v>
                </c:pt>
                <c:pt idx="2776">
                  <c:v>16016.96636390686</c:v>
                </c:pt>
                <c:pt idx="2777">
                  <c:v>16018.872272491455</c:v>
                </c:pt>
                <c:pt idx="2778">
                  <c:v>16021.406753540039</c:v>
                </c:pt>
                <c:pt idx="2779">
                  <c:v>16018.055519104004</c:v>
                </c:pt>
                <c:pt idx="2780">
                  <c:v>16017.504285812378</c:v>
                </c:pt>
                <c:pt idx="2781">
                  <c:v>16022.067337036133</c:v>
                </c:pt>
                <c:pt idx="2782">
                  <c:v>16020.287532806396</c:v>
                </c:pt>
                <c:pt idx="2783">
                  <c:v>16009.279155731201</c:v>
                </c:pt>
                <c:pt idx="2784">
                  <c:v>16002.442207813263</c:v>
                </c:pt>
                <c:pt idx="2785">
                  <c:v>16011.948117256165</c:v>
                </c:pt>
                <c:pt idx="2786">
                  <c:v>16030.368310928345</c:v>
                </c:pt>
                <c:pt idx="2787">
                  <c:v>16037.359935760498</c:v>
                </c:pt>
                <c:pt idx="2788">
                  <c:v>16032.065845489502</c:v>
                </c:pt>
                <c:pt idx="2789">
                  <c:v>16025.600324630737</c:v>
                </c:pt>
                <c:pt idx="2790">
                  <c:v>16024.763376235962</c:v>
                </c:pt>
                <c:pt idx="2791">
                  <c:v>16023.440713882446</c:v>
                </c:pt>
                <c:pt idx="2792">
                  <c:v>16024.775194168091</c:v>
                </c:pt>
                <c:pt idx="2793">
                  <c:v>16030.166818618774</c:v>
                </c:pt>
                <c:pt idx="2794">
                  <c:v>16038.52986907959</c:v>
                </c:pt>
                <c:pt idx="2795">
                  <c:v>16038.464351654053</c:v>
                </c:pt>
                <c:pt idx="2796">
                  <c:v>16029.198831558228</c:v>
                </c:pt>
                <c:pt idx="2797">
                  <c:v>16019.504739761353</c:v>
                </c:pt>
                <c:pt idx="2798">
                  <c:v>16017.353506088257</c:v>
                </c:pt>
                <c:pt idx="2799">
                  <c:v>16013.573700904846</c:v>
                </c:pt>
                <c:pt idx="2800">
                  <c:v>16010.10818195343</c:v>
                </c:pt>
                <c:pt idx="2801">
                  <c:v>16008.614090919495</c:v>
                </c:pt>
                <c:pt idx="2802">
                  <c:v>16011.462857246399</c:v>
                </c:pt>
                <c:pt idx="2803">
                  <c:v>16018.197338104248</c:v>
                </c:pt>
                <c:pt idx="2804">
                  <c:v>16028.617532730103</c:v>
                </c:pt>
                <c:pt idx="2805">
                  <c:v>16035.066299438477</c:v>
                </c:pt>
                <c:pt idx="2806">
                  <c:v>16036.315063476563</c:v>
                </c:pt>
                <c:pt idx="2807">
                  <c:v>16039.420974731445</c:v>
                </c:pt>
                <c:pt idx="2808">
                  <c:v>16043.526882171631</c:v>
                </c:pt>
                <c:pt idx="2809">
                  <c:v>16040.404220581055</c:v>
                </c:pt>
                <c:pt idx="2810">
                  <c:v>16029.081558227539</c:v>
                </c:pt>
                <c:pt idx="2811">
                  <c:v>16011.958895683289</c:v>
                </c:pt>
                <c:pt idx="2812">
                  <c:v>15996.121948003769</c:v>
                </c:pt>
                <c:pt idx="2813">
                  <c:v>15988.370714187622</c:v>
                </c:pt>
                <c:pt idx="2814">
                  <c:v>15994.733766078949</c:v>
                </c:pt>
                <c:pt idx="2815">
                  <c:v>16008.382532119751</c:v>
                </c:pt>
                <c:pt idx="2816">
                  <c:v>16023.917013168335</c:v>
                </c:pt>
                <c:pt idx="2817">
                  <c:v>16038.708637237549</c:v>
                </c:pt>
                <c:pt idx="2818">
                  <c:v>16048.871688842773</c:v>
                </c:pt>
                <c:pt idx="2819">
                  <c:v>16047.320453643799</c:v>
                </c:pt>
                <c:pt idx="2820">
                  <c:v>16038.312076568604</c:v>
                </c:pt>
                <c:pt idx="2821">
                  <c:v>16032.475128173828</c:v>
                </c:pt>
                <c:pt idx="2822">
                  <c:v>16032.80961227417</c:v>
                </c:pt>
                <c:pt idx="2823">
                  <c:v>16031.144090652466</c:v>
                </c:pt>
                <c:pt idx="2824">
                  <c:v>16025.07857131958</c:v>
                </c:pt>
                <c:pt idx="2825">
                  <c:v>16026.241622924805</c:v>
                </c:pt>
                <c:pt idx="2826">
                  <c:v>16032.490390777588</c:v>
                </c:pt>
                <c:pt idx="2827">
                  <c:v>16030.767726898193</c:v>
                </c:pt>
                <c:pt idx="2828">
                  <c:v>16013.102208137512</c:v>
                </c:pt>
                <c:pt idx="2829">
                  <c:v>15997.693831205368</c:v>
                </c:pt>
                <c:pt idx="2830">
                  <c:v>16000.399740248919</c:v>
                </c:pt>
                <c:pt idx="2831">
                  <c:v>16015.877078056335</c:v>
                </c:pt>
                <c:pt idx="2832">
                  <c:v>16025.382986068726</c:v>
                </c:pt>
                <c:pt idx="2833">
                  <c:v>16026.803182601929</c:v>
                </c:pt>
                <c:pt idx="2834">
                  <c:v>16029.509090423584</c:v>
                </c:pt>
                <c:pt idx="2835">
                  <c:v>16032.357856750488</c:v>
                </c:pt>
                <c:pt idx="2836">
                  <c:v>16027.892337799072</c:v>
                </c:pt>
                <c:pt idx="2837">
                  <c:v>16017.055389404297</c:v>
                </c:pt>
                <c:pt idx="2838">
                  <c:v>16006.618441581726</c:v>
                </c:pt>
                <c:pt idx="2839">
                  <c:v>16003.495779275894</c:v>
                </c:pt>
                <c:pt idx="2840">
                  <c:v>16008.5159740448</c:v>
                </c:pt>
                <c:pt idx="2841">
                  <c:v>16013.9647397995</c:v>
                </c:pt>
                <c:pt idx="2842">
                  <c:v>16015.956363677979</c:v>
                </c:pt>
                <c:pt idx="2843">
                  <c:v>16021.462272644043</c:v>
                </c:pt>
                <c:pt idx="2844">
                  <c:v>16029.511039733887</c:v>
                </c:pt>
                <c:pt idx="2845">
                  <c:v>16032.988376617432</c:v>
                </c:pt>
                <c:pt idx="2846">
                  <c:v>16032.922855377197</c:v>
                </c:pt>
                <c:pt idx="2847">
                  <c:v>16035.2001953125</c:v>
                </c:pt>
                <c:pt idx="2848">
                  <c:v>16038.706104278564</c:v>
                </c:pt>
                <c:pt idx="2849">
                  <c:v>16043.583442687988</c:v>
                </c:pt>
                <c:pt idx="2850">
                  <c:v>16044.289352416992</c:v>
                </c:pt>
                <c:pt idx="2851">
                  <c:v>16033.909545898438</c:v>
                </c:pt>
                <c:pt idx="2852">
                  <c:v>16017.129739761353</c:v>
                </c:pt>
                <c:pt idx="2853">
                  <c:v>16011.207077980042</c:v>
                </c:pt>
                <c:pt idx="2854">
                  <c:v>16020.570129394531</c:v>
                </c:pt>
                <c:pt idx="2855">
                  <c:v>16035.647468566895</c:v>
                </c:pt>
                <c:pt idx="2856">
                  <c:v>16041.839092254639</c:v>
                </c:pt>
                <c:pt idx="2857">
                  <c:v>16034.716426849365</c:v>
                </c:pt>
                <c:pt idx="2858">
                  <c:v>16021.136623382568</c:v>
                </c:pt>
                <c:pt idx="2859">
                  <c:v>16015.328247070313</c:v>
                </c:pt>
                <c:pt idx="2860">
                  <c:v>16020.691299438477</c:v>
                </c:pt>
                <c:pt idx="2861">
                  <c:v>16028.311492919922</c:v>
                </c:pt>
                <c:pt idx="2862">
                  <c:v>16028.588830947876</c:v>
                </c:pt>
                <c:pt idx="2863">
                  <c:v>16020.72331237793</c:v>
                </c:pt>
                <c:pt idx="2864">
                  <c:v>16016.657793045044</c:v>
                </c:pt>
                <c:pt idx="2865">
                  <c:v>16019.449415206909</c:v>
                </c:pt>
                <c:pt idx="2866">
                  <c:v>16022.355323791504</c:v>
                </c:pt>
                <c:pt idx="2867">
                  <c:v>16017.718376159668</c:v>
                </c:pt>
                <c:pt idx="2868">
                  <c:v>16013.995714187622</c:v>
                </c:pt>
                <c:pt idx="2869">
                  <c:v>16016.844480514526</c:v>
                </c:pt>
                <c:pt idx="2870">
                  <c:v>16026.63610458374</c:v>
                </c:pt>
                <c:pt idx="2871">
                  <c:v>16038.342014312744</c:v>
                </c:pt>
                <c:pt idx="2872">
                  <c:v>16046.07649230957</c:v>
                </c:pt>
                <c:pt idx="2873">
                  <c:v>16040.782402038574</c:v>
                </c:pt>
                <c:pt idx="2874">
                  <c:v>16026.516883850098</c:v>
                </c:pt>
                <c:pt idx="2875">
                  <c:v>16017.108507156372</c:v>
                </c:pt>
                <c:pt idx="2876">
                  <c:v>16021.557271957397</c:v>
                </c:pt>
                <c:pt idx="2877">
                  <c:v>16035.148895263672</c:v>
                </c:pt>
                <c:pt idx="2878">
                  <c:v>16043.569091796875</c:v>
                </c:pt>
                <c:pt idx="2879">
                  <c:v>16036.38928604126</c:v>
                </c:pt>
                <c:pt idx="2880">
                  <c:v>16026.095193862915</c:v>
                </c:pt>
                <c:pt idx="2881">
                  <c:v>16020.001104354858</c:v>
                </c:pt>
                <c:pt idx="2882">
                  <c:v>16013.564155578613</c:v>
                </c:pt>
                <c:pt idx="2883">
                  <c:v>16004.241493701935</c:v>
                </c:pt>
                <c:pt idx="2884">
                  <c:v>16001.604545474052</c:v>
                </c:pt>
                <c:pt idx="2885">
                  <c:v>16008.510454177856</c:v>
                </c:pt>
                <c:pt idx="2886">
                  <c:v>16024.444934844971</c:v>
                </c:pt>
                <c:pt idx="2887">
                  <c:v>16042.207988739014</c:v>
                </c:pt>
                <c:pt idx="2888">
                  <c:v>16051.999610900879</c:v>
                </c:pt>
                <c:pt idx="2889">
                  <c:v>16047.648376464844</c:v>
                </c:pt>
                <c:pt idx="2890">
                  <c:v>16037.725715637207</c:v>
                </c:pt>
                <c:pt idx="2891">
                  <c:v>16026.003051757813</c:v>
                </c:pt>
                <c:pt idx="2892">
                  <c:v>16020.108961105347</c:v>
                </c:pt>
                <c:pt idx="2893">
                  <c:v>16020.757726669312</c:v>
                </c:pt>
                <c:pt idx="2894">
                  <c:v>16026.235065460205</c:v>
                </c:pt>
                <c:pt idx="2895">
                  <c:v>16030.56954574585</c:v>
                </c:pt>
                <c:pt idx="2896">
                  <c:v>16025.589740753174</c:v>
                </c:pt>
                <c:pt idx="2897">
                  <c:v>16010.124220848083</c:v>
                </c:pt>
                <c:pt idx="2898">
                  <c:v>15995.858701229095</c:v>
                </c:pt>
                <c:pt idx="2899">
                  <c:v>15993.53603887558</c:v>
                </c:pt>
                <c:pt idx="2900">
                  <c:v>15995.184805393219</c:v>
                </c:pt>
                <c:pt idx="2901">
                  <c:v>15997.262142896652</c:v>
                </c:pt>
                <c:pt idx="2902">
                  <c:v>16004.682337760925</c:v>
                </c:pt>
                <c:pt idx="2903">
                  <c:v>16015.18824672699</c:v>
                </c:pt>
                <c:pt idx="2904">
                  <c:v>16018.237012863159</c:v>
                </c:pt>
                <c:pt idx="2905">
                  <c:v>16019.885778427124</c:v>
                </c:pt>
                <c:pt idx="2906">
                  <c:v>16023.334545135498</c:v>
                </c:pt>
                <c:pt idx="2907">
                  <c:v>16022.183311462402</c:v>
                </c:pt>
                <c:pt idx="2908">
                  <c:v>16018.632078170776</c:v>
                </c:pt>
                <c:pt idx="2909">
                  <c:v>16015.366558074951</c:v>
                </c:pt>
                <c:pt idx="2910">
                  <c:v>16009.415324211121</c:v>
                </c:pt>
                <c:pt idx="2911">
                  <c:v>16006.092662334442</c:v>
                </c:pt>
                <c:pt idx="2912">
                  <c:v>16021.569999694824</c:v>
                </c:pt>
                <c:pt idx="2913">
                  <c:v>16043.733051300049</c:v>
                </c:pt>
                <c:pt idx="2914">
                  <c:v>16046.753246307373</c:v>
                </c:pt>
                <c:pt idx="2915">
                  <c:v>16029.773441314697</c:v>
                </c:pt>
                <c:pt idx="2916">
                  <c:v>16019.907922744751</c:v>
                </c:pt>
                <c:pt idx="2917">
                  <c:v>16025.842403411865</c:v>
                </c:pt>
                <c:pt idx="2918">
                  <c:v>16028.69116973877</c:v>
                </c:pt>
                <c:pt idx="2919">
                  <c:v>16020.082792282104</c:v>
                </c:pt>
                <c:pt idx="2920">
                  <c:v>16014.817273139954</c:v>
                </c:pt>
                <c:pt idx="2921">
                  <c:v>16022.323181152344</c:v>
                </c:pt>
                <c:pt idx="2922">
                  <c:v>16036.800518035889</c:v>
                </c:pt>
                <c:pt idx="2923">
                  <c:v>16042.392143249512</c:v>
                </c:pt>
                <c:pt idx="2924">
                  <c:v>16034.583766937256</c:v>
                </c:pt>
                <c:pt idx="2925">
                  <c:v>16024.403961181641</c:v>
                </c:pt>
                <c:pt idx="2926">
                  <c:v>16022.852727890015</c:v>
                </c:pt>
                <c:pt idx="2927">
                  <c:v>16019.47292137146</c:v>
                </c:pt>
                <c:pt idx="2928">
                  <c:v>16011.264545440674</c:v>
                </c:pt>
                <c:pt idx="2929">
                  <c:v>16012.170454978943</c:v>
                </c:pt>
                <c:pt idx="2930">
                  <c:v>16023.133506774902</c:v>
                </c:pt>
                <c:pt idx="2931">
                  <c:v>16029.753702163696</c:v>
                </c:pt>
                <c:pt idx="2932">
                  <c:v>16022.116752624512</c:v>
                </c:pt>
                <c:pt idx="2933">
                  <c:v>16012.994091033936</c:v>
                </c:pt>
                <c:pt idx="2934">
                  <c:v>16015.01428604126</c:v>
                </c:pt>
                <c:pt idx="2935">
                  <c:v>16026.263051986694</c:v>
                </c:pt>
                <c:pt idx="2936">
                  <c:v>16031.854675292969</c:v>
                </c:pt>
                <c:pt idx="2937">
                  <c:v>16033.274871826172</c:v>
                </c:pt>
                <c:pt idx="2938">
                  <c:v>16038.552207946777</c:v>
                </c:pt>
                <c:pt idx="2939">
                  <c:v>16041.458118438721</c:v>
                </c:pt>
                <c:pt idx="2940">
                  <c:v>16033.706882476807</c:v>
                </c:pt>
                <c:pt idx="2941">
                  <c:v>16018.84136390686</c:v>
                </c:pt>
                <c:pt idx="2942">
                  <c:v>16009.11870098114</c:v>
                </c:pt>
                <c:pt idx="2943">
                  <c:v>16007.824610233307</c:v>
                </c:pt>
                <c:pt idx="2944">
                  <c:v>16013.901947975159</c:v>
                </c:pt>
                <c:pt idx="2945">
                  <c:v>16023.322143554688</c:v>
                </c:pt>
                <c:pt idx="2946">
                  <c:v>16032.885196685791</c:v>
                </c:pt>
                <c:pt idx="2947">
                  <c:v>16037.105388641357</c:v>
                </c:pt>
                <c:pt idx="2948">
                  <c:v>16032.439868927002</c:v>
                </c:pt>
                <c:pt idx="2949">
                  <c:v>16024.317207336426</c:v>
                </c:pt>
                <c:pt idx="2950">
                  <c:v>16018.59454536438</c:v>
                </c:pt>
                <c:pt idx="2951">
                  <c:v>16016.014739990234</c:v>
                </c:pt>
                <c:pt idx="2952">
                  <c:v>16012.663506507874</c:v>
                </c:pt>
                <c:pt idx="2953">
                  <c:v>16007.055130004883</c:v>
                </c:pt>
                <c:pt idx="2954">
                  <c:v>16004.046753406525</c:v>
                </c:pt>
                <c:pt idx="2955">
                  <c:v>16004.524090766907</c:v>
                </c:pt>
                <c:pt idx="2956">
                  <c:v>16005.630000114441</c:v>
                </c:pt>
                <c:pt idx="2957">
                  <c:v>16002.850194692612</c:v>
                </c:pt>
                <c:pt idx="2958">
                  <c:v>16009.15610408783</c:v>
                </c:pt>
                <c:pt idx="2959">
                  <c:v>16022.262012481689</c:v>
                </c:pt>
                <c:pt idx="2960">
                  <c:v>16034.625064849854</c:v>
                </c:pt>
                <c:pt idx="2961">
                  <c:v>16039.130973815918</c:v>
                </c:pt>
                <c:pt idx="2962">
                  <c:v>16035.008312225342</c:v>
                </c:pt>
                <c:pt idx="2963">
                  <c:v>16018.657077789307</c:v>
                </c:pt>
                <c:pt idx="2964">
                  <c:v>16001.391558408737</c:v>
                </c:pt>
                <c:pt idx="2965">
                  <c:v>15998.754610419273</c:v>
                </c:pt>
                <c:pt idx="2966">
                  <c:v>16003.317662239075</c:v>
                </c:pt>
                <c:pt idx="2967">
                  <c:v>16000.852142870426</c:v>
                </c:pt>
                <c:pt idx="2968">
                  <c:v>15996.272337675095</c:v>
                </c:pt>
                <c:pt idx="2969">
                  <c:v>16001.206818223</c:v>
                </c:pt>
                <c:pt idx="2970">
                  <c:v>16011.569869995117</c:v>
                </c:pt>
                <c:pt idx="2971">
                  <c:v>16012.704350471497</c:v>
                </c:pt>
                <c:pt idx="2972">
                  <c:v>16008.324545860291</c:v>
                </c:pt>
                <c:pt idx="2973">
                  <c:v>16008.916169166565</c:v>
                </c:pt>
                <c:pt idx="2974">
                  <c:v>16016.393507003784</c:v>
                </c:pt>
                <c:pt idx="2975">
                  <c:v>16019.956558227539</c:v>
                </c:pt>
                <c:pt idx="2976">
                  <c:v>16014.948182106018</c:v>
                </c:pt>
                <c:pt idx="2977">
                  <c:v>16007.854090690613</c:v>
                </c:pt>
                <c:pt idx="2978">
                  <c:v>16002.245714187622</c:v>
                </c:pt>
                <c:pt idx="2979">
                  <c:v>15996.665909051895</c:v>
                </c:pt>
                <c:pt idx="2980">
                  <c:v>15996.114675283432</c:v>
                </c:pt>
                <c:pt idx="2981">
                  <c:v>16003.706298589706</c:v>
                </c:pt>
                <c:pt idx="2982">
                  <c:v>16014.86935043335</c:v>
                </c:pt>
                <c:pt idx="2983">
                  <c:v>16012.546688079834</c:v>
                </c:pt>
                <c:pt idx="2984">
                  <c:v>16004.938311576843</c:v>
                </c:pt>
                <c:pt idx="2985">
                  <c:v>15997.587077856064</c:v>
                </c:pt>
                <c:pt idx="2986">
                  <c:v>15999.178701281548</c:v>
                </c:pt>
                <c:pt idx="2987">
                  <c:v>16002.198896169662</c:v>
                </c:pt>
                <c:pt idx="2988">
                  <c:v>16002.990519523621</c:v>
                </c:pt>
                <c:pt idx="2989">
                  <c:v>16000.75357145071</c:v>
                </c:pt>
                <c:pt idx="2990">
                  <c:v>15997.230909109116</c:v>
                </c:pt>
                <c:pt idx="2991">
                  <c:v>15993.251103878021</c:v>
                </c:pt>
                <c:pt idx="2992">
                  <c:v>15990.128441810608</c:v>
                </c:pt>
                <c:pt idx="2993">
                  <c:v>15992.577207565308</c:v>
                </c:pt>
                <c:pt idx="2994">
                  <c:v>15993.740259647369</c:v>
                </c:pt>
                <c:pt idx="2995">
                  <c:v>15995.760454654694</c:v>
                </c:pt>
                <c:pt idx="2996">
                  <c:v>15998.637792229652</c:v>
                </c:pt>
                <c:pt idx="2997">
                  <c:v>16002.057986974716</c:v>
                </c:pt>
                <c:pt idx="2998">
                  <c:v>16002.049610376358</c:v>
                </c:pt>
                <c:pt idx="2999">
                  <c:v>16002.041233778</c:v>
                </c:pt>
              </c:numCache>
            </c:numRef>
          </c:yVal>
          <c:smooth val="0"/>
          <c:extLst>
            <c:ext xmlns:c16="http://schemas.microsoft.com/office/drawing/2014/chart" uri="{C3380CC4-5D6E-409C-BE32-E72D297353CC}">
              <c16:uniqueId val="{00000000-951A-40BF-BA6C-3B319E7ECED3}"/>
            </c:ext>
          </c:extLst>
        </c:ser>
        <c:ser>
          <c:idx val="1"/>
          <c:order val="1"/>
          <c:tx>
            <c:v>LW RB + GlcNAc</c:v>
          </c:tx>
          <c:spPr>
            <a:ln w="19050">
              <a:solidFill>
                <a:srgbClr val="B31A19"/>
              </a:solidFill>
              <a:prstDash val="solid"/>
              <a:round/>
            </a:ln>
            <a:effectLst/>
          </c:spPr>
          <c:marker>
            <c:symbol val="none"/>
          </c:marker>
          <c:xVal>
            <c:numRef>
              <c:f>'[RB revised.xlsx]Graph Calculations'!$I$10:$DKR$10</c:f>
              <c:numCache>
                <c:formatCode>General</c:formatCode>
                <c:ptCount val="3000"/>
                <c:pt idx="0">
                  <c:v>-4.4840173721313477</c:v>
                </c:pt>
                <c:pt idx="1">
                  <c:v>-4.4824223518371582</c:v>
                </c:pt>
                <c:pt idx="2">
                  <c:v>-4.4805078506469727</c:v>
                </c:pt>
                <c:pt idx="3">
                  <c:v>-4.478327751159668</c:v>
                </c:pt>
                <c:pt idx="4">
                  <c:v>-4.4759259223937988</c:v>
                </c:pt>
                <c:pt idx="5">
                  <c:v>-4.4733290672302246</c:v>
                </c:pt>
                <c:pt idx="6">
                  <c:v>-4.4705586433410645</c:v>
                </c:pt>
                <c:pt idx="7">
                  <c:v>-4.4676370620727539</c:v>
                </c:pt>
                <c:pt idx="8">
                  <c:v>-4.4645733833312988</c:v>
                </c:pt>
                <c:pt idx="9">
                  <c:v>-4.4613847732543945</c:v>
                </c:pt>
                <c:pt idx="10">
                  <c:v>-4.4580831527709961</c:v>
                </c:pt>
                <c:pt idx="11">
                  <c:v>-4.4546761512756348</c:v>
                </c:pt>
                <c:pt idx="12">
                  <c:v>-4.4511737823486328</c:v>
                </c:pt>
                <c:pt idx="13">
                  <c:v>-4.4475836753845215</c:v>
                </c:pt>
                <c:pt idx="14">
                  <c:v>-4.4439144134521484</c:v>
                </c:pt>
                <c:pt idx="15">
                  <c:v>-4.4401659965515137</c:v>
                </c:pt>
                <c:pt idx="16">
                  <c:v>-4.4363498687744141</c:v>
                </c:pt>
                <c:pt idx="17">
                  <c:v>-4.4324684143066406</c:v>
                </c:pt>
                <c:pt idx="18">
                  <c:v>-4.4285340309143066</c:v>
                </c:pt>
                <c:pt idx="19">
                  <c:v>-4.4245476722717285</c:v>
                </c:pt>
                <c:pt idx="20">
                  <c:v>-4.4205098152160645</c:v>
                </c:pt>
                <c:pt idx="21">
                  <c:v>-4.4164223670959473</c:v>
                </c:pt>
                <c:pt idx="22">
                  <c:v>-4.4122934341430664</c:v>
                </c:pt>
                <c:pt idx="23">
                  <c:v>-4.4081196784973145</c:v>
                </c:pt>
                <c:pt idx="24">
                  <c:v>-4.4039101600646973</c:v>
                </c:pt>
                <c:pt idx="25">
                  <c:v>-4.3996634483337402</c:v>
                </c:pt>
                <c:pt idx="26">
                  <c:v>-4.3953814506530762</c:v>
                </c:pt>
                <c:pt idx="27">
                  <c:v>-4.3910651206970215</c:v>
                </c:pt>
                <c:pt idx="28">
                  <c:v>-4.386716365814209</c:v>
                </c:pt>
                <c:pt idx="29">
                  <c:v>-4.3823370933532715</c:v>
                </c:pt>
                <c:pt idx="30">
                  <c:v>-4.3779335021972656</c:v>
                </c:pt>
                <c:pt idx="31">
                  <c:v>-4.3734960556030273</c:v>
                </c:pt>
                <c:pt idx="32">
                  <c:v>-4.3690371513366699</c:v>
                </c:pt>
                <c:pt idx="33">
                  <c:v>-4.3645462989807129</c:v>
                </c:pt>
                <c:pt idx="34">
                  <c:v>-4.3600358963012695</c:v>
                </c:pt>
                <c:pt idx="35">
                  <c:v>-4.355506420135498</c:v>
                </c:pt>
                <c:pt idx="36">
                  <c:v>-4.350954532623291</c:v>
                </c:pt>
                <c:pt idx="37">
                  <c:v>-4.3463764190673828</c:v>
                </c:pt>
                <c:pt idx="38">
                  <c:v>-4.3417744636535645</c:v>
                </c:pt>
                <c:pt idx="39">
                  <c:v>-4.3371539115905762</c:v>
                </c:pt>
                <c:pt idx="40">
                  <c:v>-4.3325142860412598</c:v>
                </c:pt>
                <c:pt idx="41">
                  <c:v>-4.3278560638427734</c:v>
                </c:pt>
                <c:pt idx="42">
                  <c:v>-4.323178768157959</c:v>
                </c:pt>
                <c:pt idx="43">
                  <c:v>-4.3184823989868164</c:v>
                </c:pt>
                <c:pt idx="44">
                  <c:v>-4.3137669563293457</c:v>
                </c:pt>
                <c:pt idx="45">
                  <c:v>-4.3090329170227051</c:v>
                </c:pt>
                <c:pt idx="46">
                  <c:v>-4.3042821884155273</c:v>
                </c:pt>
                <c:pt idx="47">
                  <c:v>-4.2995157241821289</c:v>
                </c:pt>
                <c:pt idx="48">
                  <c:v>-4.294736385345459</c:v>
                </c:pt>
                <c:pt idx="49">
                  <c:v>-4.2899413108825684</c:v>
                </c:pt>
                <c:pt idx="50">
                  <c:v>-4.285128116607666</c:v>
                </c:pt>
                <c:pt idx="51">
                  <c:v>-4.2802958488464355</c:v>
                </c:pt>
                <c:pt idx="52">
                  <c:v>-4.2754464149475098</c:v>
                </c:pt>
                <c:pt idx="53">
                  <c:v>-4.2705864906311035</c:v>
                </c:pt>
                <c:pt idx="54">
                  <c:v>-4.2657127380371094</c:v>
                </c:pt>
                <c:pt idx="55">
                  <c:v>-4.2608208656311035</c:v>
                </c:pt>
                <c:pt idx="56">
                  <c:v>-4.2559108734130859</c:v>
                </c:pt>
                <c:pt idx="57">
                  <c:v>-4.2509908676147461</c:v>
                </c:pt>
                <c:pt idx="58">
                  <c:v>-4.2460575103759766</c:v>
                </c:pt>
                <c:pt idx="59">
                  <c:v>-4.2411050796508789</c:v>
                </c:pt>
                <c:pt idx="60">
                  <c:v>-4.2361478805541992</c:v>
                </c:pt>
                <c:pt idx="61">
                  <c:v>-4.2311735153198242</c:v>
                </c:pt>
                <c:pt idx="62">
                  <c:v>-4.2261829376220703</c:v>
                </c:pt>
                <c:pt idx="63">
                  <c:v>-4.2211837768554688</c:v>
                </c:pt>
                <c:pt idx="64">
                  <c:v>-4.2161684036254883</c:v>
                </c:pt>
                <c:pt idx="65">
                  <c:v>-4.2111387252807617</c:v>
                </c:pt>
                <c:pt idx="66">
                  <c:v>-4.2061004638671875</c:v>
                </c:pt>
                <c:pt idx="67">
                  <c:v>-4.2010436058044434</c:v>
                </c:pt>
                <c:pt idx="68">
                  <c:v>-4.1959795951843262</c:v>
                </c:pt>
                <c:pt idx="69">
                  <c:v>-4.1909008026123047</c:v>
                </c:pt>
                <c:pt idx="70">
                  <c:v>-4.1858067512512207</c:v>
                </c:pt>
                <c:pt idx="71">
                  <c:v>-4.1807041168212891</c:v>
                </c:pt>
                <c:pt idx="72">
                  <c:v>-4.1755843162536621</c:v>
                </c:pt>
                <c:pt idx="73">
                  <c:v>-4.1704611778259277</c:v>
                </c:pt>
                <c:pt idx="74">
                  <c:v>-4.1653242111206055</c:v>
                </c:pt>
                <c:pt idx="75">
                  <c:v>-4.1601781845092773</c:v>
                </c:pt>
                <c:pt idx="76">
                  <c:v>-4.1550145149230957</c:v>
                </c:pt>
                <c:pt idx="77">
                  <c:v>-4.1498451232910156</c:v>
                </c:pt>
                <c:pt idx="78">
                  <c:v>-4.1446595191955566</c:v>
                </c:pt>
                <c:pt idx="79">
                  <c:v>-4.1394672393798828</c:v>
                </c:pt>
                <c:pt idx="80">
                  <c:v>-4.1342587471008301</c:v>
                </c:pt>
                <c:pt idx="81">
                  <c:v>-4.1290450096130371</c:v>
                </c:pt>
                <c:pt idx="82">
                  <c:v>-4.1238136291503906</c:v>
                </c:pt>
                <c:pt idx="83">
                  <c:v>-4.1185774803161621</c:v>
                </c:pt>
                <c:pt idx="84">
                  <c:v>-4.1133241653442383</c:v>
                </c:pt>
                <c:pt idx="85">
                  <c:v>-4.1080656051635742</c:v>
                </c:pt>
                <c:pt idx="86">
                  <c:v>-4.1027927398681641</c:v>
                </c:pt>
                <c:pt idx="87">
                  <c:v>-4.0975127220153809</c:v>
                </c:pt>
                <c:pt idx="88">
                  <c:v>-4.0922222137451172</c:v>
                </c:pt>
                <c:pt idx="89">
                  <c:v>-4.0869197845458984</c:v>
                </c:pt>
                <c:pt idx="90">
                  <c:v>-4.0816140174865723</c:v>
                </c:pt>
                <c:pt idx="91">
                  <c:v>-4.0762953758239746</c:v>
                </c:pt>
                <c:pt idx="92">
                  <c:v>-4.0709676742553711</c:v>
                </c:pt>
                <c:pt idx="93">
                  <c:v>-4.0656328201293945</c:v>
                </c:pt>
                <c:pt idx="94">
                  <c:v>-4.0602817535400391</c:v>
                </c:pt>
                <c:pt idx="95">
                  <c:v>-4.0549263954162598</c:v>
                </c:pt>
                <c:pt idx="96">
                  <c:v>-4.0495562553405762</c:v>
                </c:pt>
                <c:pt idx="97">
                  <c:v>-4.0441799163818359</c:v>
                </c:pt>
                <c:pt idx="98">
                  <c:v>-4.0387964248657227</c:v>
                </c:pt>
                <c:pt idx="99">
                  <c:v>-4.0333976745605469</c:v>
                </c:pt>
                <c:pt idx="100">
                  <c:v>-4.0279941558837891</c:v>
                </c:pt>
                <c:pt idx="101">
                  <c:v>-4.022578239440918</c:v>
                </c:pt>
                <c:pt idx="102">
                  <c:v>-4.017153263092041</c:v>
                </c:pt>
                <c:pt idx="103">
                  <c:v>-4.0117225646972656</c:v>
                </c:pt>
                <c:pt idx="104">
                  <c:v>-4.0062780380249023</c:v>
                </c:pt>
                <c:pt idx="105">
                  <c:v>-4.0008273124694824</c:v>
                </c:pt>
                <c:pt idx="106">
                  <c:v>-3.9953696727752686</c:v>
                </c:pt>
                <c:pt idx="107">
                  <c:v>-3.9898977279663086</c:v>
                </c:pt>
                <c:pt idx="108">
                  <c:v>-3.9844207763671875</c:v>
                </c:pt>
                <c:pt idx="109">
                  <c:v>-3.9789364337921143</c:v>
                </c:pt>
                <c:pt idx="110">
                  <c:v>-3.9734375476837158</c:v>
                </c:pt>
                <c:pt idx="111">
                  <c:v>-3.9679346084594727</c:v>
                </c:pt>
                <c:pt idx="112">
                  <c:v>-3.962425708770752</c:v>
                </c:pt>
                <c:pt idx="113">
                  <c:v>-3.9569032192230225</c:v>
                </c:pt>
                <c:pt idx="114">
                  <c:v>-3.9513742923736572</c:v>
                </c:pt>
                <c:pt idx="115">
                  <c:v>-3.9458403587341309</c:v>
                </c:pt>
                <c:pt idx="116">
                  <c:v>-3.9402945041656494</c:v>
                </c:pt>
                <c:pt idx="117">
                  <c:v>-3.934739351272583</c:v>
                </c:pt>
                <c:pt idx="118">
                  <c:v>-3.9291796684265137</c:v>
                </c:pt>
                <c:pt idx="119">
                  <c:v>-3.9236106872558594</c:v>
                </c:pt>
                <c:pt idx="120">
                  <c:v>-3.9180295467376709</c:v>
                </c:pt>
                <c:pt idx="121">
                  <c:v>-3.9124448299407959</c:v>
                </c:pt>
                <c:pt idx="122">
                  <c:v>-3.9068529605865479</c:v>
                </c:pt>
                <c:pt idx="123">
                  <c:v>-3.901247501373291</c:v>
                </c:pt>
                <c:pt idx="124">
                  <c:v>-3.895637035369873</c:v>
                </c:pt>
                <c:pt idx="125">
                  <c:v>-3.8900213241577148</c:v>
                </c:pt>
                <c:pt idx="126">
                  <c:v>-3.884394645690918</c:v>
                </c:pt>
                <c:pt idx="127">
                  <c:v>-3.8787577152252197</c:v>
                </c:pt>
                <c:pt idx="128">
                  <c:v>-3.8731176853179932</c:v>
                </c:pt>
                <c:pt idx="129">
                  <c:v>-3.86747145652771</c:v>
                </c:pt>
                <c:pt idx="130">
                  <c:v>-3.8618123531341553</c:v>
                </c:pt>
                <c:pt idx="131">
                  <c:v>-3.8561456203460693</c:v>
                </c:pt>
                <c:pt idx="132">
                  <c:v>-3.8504753112792969</c:v>
                </c:pt>
                <c:pt idx="133">
                  <c:v>-3.8447971343994141</c:v>
                </c:pt>
                <c:pt idx="134">
                  <c:v>-3.8391063213348389</c:v>
                </c:pt>
                <c:pt idx="135">
                  <c:v>-3.8334100246429443</c:v>
                </c:pt>
                <c:pt idx="136">
                  <c:v>-3.827709436416626</c:v>
                </c:pt>
                <c:pt idx="137">
                  <c:v>-3.8220009803771973</c:v>
                </c:pt>
                <c:pt idx="138">
                  <c:v>-3.8162803649902344</c:v>
                </c:pt>
                <c:pt idx="139">
                  <c:v>-3.8105542659759521</c:v>
                </c:pt>
                <c:pt idx="140">
                  <c:v>-3.8048253059387207</c:v>
                </c:pt>
                <c:pt idx="141">
                  <c:v>-3.7990918159484863</c:v>
                </c:pt>
                <c:pt idx="142">
                  <c:v>-3.7933528423309326</c:v>
                </c:pt>
                <c:pt idx="143">
                  <c:v>-3.7876007556915283</c:v>
                </c:pt>
                <c:pt idx="144">
                  <c:v>-3.7818417549133301</c:v>
                </c:pt>
                <c:pt idx="145">
                  <c:v>-3.7760789394378662</c:v>
                </c:pt>
                <c:pt idx="146">
                  <c:v>-3.7703099250793457</c:v>
                </c:pt>
                <c:pt idx="147">
                  <c:v>-3.7645306587219238</c:v>
                </c:pt>
                <c:pt idx="148">
                  <c:v>-3.7587418556213379</c:v>
                </c:pt>
                <c:pt idx="149">
                  <c:v>-3.7529497146606445</c:v>
                </c:pt>
                <c:pt idx="150">
                  <c:v>-3.7471528053283691</c:v>
                </c:pt>
                <c:pt idx="151">
                  <c:v>-3.7413477897644043</c:v>
                </c:pt>
                <c:pt idx="152">
                  <c:v>-3.7355310916900635</c:v>
                </c:pt>
                <c:pt idx="153">
                  <c:v>-3.7297089099884033</c:v>
                </c:pt>
                <c:pt idx="154">
                  <c:v>-3.7238831520080566</c:v>
                </c:pt>
                <c:pt idx="155">
                  <c:v>-3.7180519104003906</c:v>
                </c:pt>
                <c:pt idx="156">
                  <c:v>-3.7122130393981934</c:v>
                </c:pt>
                <c:pt idx="157">
                  <c:v>-3.706362247467041</c:v>
                </c:pt>
                <c:pt idx="158">
                  <c:v>-3.7005064487457275</c:v>
                </c:pt>
                <c:pt idx="159">
                  <c:v>-3.6946475505828857</c:v>
                </c:pt>
                <c:pt idx="160">
                  <c:v>-3.6887838840484619</c:v>
                </c:pt>
                <c:pt idx="161">
                  <c:v>-3.6829128265380859</c:v>
                </c:pt>
                <c:pt idx="162">
                  <c:v>-3.6770303249359131</c:v>
                </c:pt>
                <c:pt idx="163">
                  <c:v>-3.6711411476135254</c:v>
                </c:pt>
                <c:pt idx="164">
                  <c:v>-3.6652488708496094</c:v>
                </c:pt>
                <c:pt idx="165">
                  <c:v>-3.6593518257141113</c:v>
                </c:pt>
                <c:pt idx="166">
                  <c:v>-3.6534490585327148</c:v>
                </c:pt>
                <c:pt idx="167">
                  <c:v>-3.6475365161895752</c:v>
                </c:pt>
                <c:pt idx="168">
                  <c:v>-3.6416151523590088</c:v>
                </c:pt>
                <c:pt idx="169">
                  <c:v>-3.6356890201568604</c:v>
                </c:pt>
                <c:pt idx="170">
                  <c:v>-3.6297597885131836</c:v>
                </c:pt>
                <c:pt idx="171">
                  <c:v>-3.6238248348236084</c:v>
                </c:pt>
                <c:pt idx="172">
                  <c:v>-3.6178836822509766</c:v>
                </c:pt>
                <c:pt idx="173">
                  <c:v>-3.6119327545166016</c:v>
                </c:pt>
                <c:pt idx="174">
                  <c:v>-3.6059741973876953</c:v>
                </c:pt>
                <c:pt idx="175">
                  <c:v>-3.6000113487243652</c:v>
                </c:pt>
                <c:pt idx="176">
                  <c:v>-3.5940446853637695</c:v>
                </c:pt>
                <c:pt idx="177">
                  <c:v>-3.5880732536315918</c:v>
                </c:pt>
                <c:pt idx="178">
                  <c:v>-3.5820956230163574</c:v>
                </c:pt>
                <c:pt idx="179">
                  <c:v>-3.5761091709136963</c:v>
                </c:pt>
                <c:pt idx="180">
                  <c:v>-3.5701138973236084</c:v>
                </c:pt>
                <c:pt idx="181">
                  <c:v>-3.5641136169433594</c:v>
                </c:pt>
                <c:pt idx="182">
                  <c:v>-3.5581099987030029</c:v>
                </c:pt>
                <c:pt idx="183">
                  <c:v>-3.5521032810211182</c:v>
                </c:pt>
                <c:pt idx="184">
                  <c:v>-3.5460927486419678</c:v>
                </c:pt>
                <c:pt idx="185">
                  <c:v>-3.5400779247283936</c:v>
                </c:pt>
                <c:pt idx="186">
                  <c:v>-3.5340569019317627</c:v>
                </c:pt>
                <c:pt idx="187">
                  <c:v>-3.5280272960662842</c:v>
                </c:pt>
                <c:pt idx="188">
                  <c:v>-3.5219876766204834</c:v>
                </c:pt>
                <c:pt idx="189">
                  <c:v>-3.5159437656402588</c:v>
                </c:pt>
                <c:pt idx="190">
                  <c:v>-3.5098962783813477</c:v>
                </c:pt>
                <c:pt idx="191">
                  <c:v>-3.5038444995880127</c:v>
                </c:pt>
                <c:pt idx="192">
                  <c:v>-3.4977884292602539</c:v>
                </c:pt>
                <c:pt idx="193">
                  <c:v>-3.4917268753051758</c:v>
                </c:pt>
                <c:pt idx="194">
                  <c:v>-3.4856557846069336</c:v>
                </c:pt>
                <c:pt idx="195">
                  <c:v>-3.4795758724212646</c:v>
                </c:pt>
                <c:pt idx="196">
                  <c:v>-3.4734909534454346</c:v>
                </c:pt>
                <c:pt idx="197">
                  <c:v>-3.4674026966094971</c:v>
                </c:pt>
                <c:pt idx="198">
                  <c:v>-3.461310863494873</c:v>
                </c:pt>
                <c:pt idx="199">
                  <c:v>-3.4552135467529297</c:v>
                </c:pt>
                <c:pt idx="200">
                  <c:v>-3.449110746383667</c:v>
                </c:pt>
                <c:pt idx="201">
                  <c:v>-3.4430005550384521</c:v>
                </c:pt>
                <c:pt idx="202">
                  <c:v>-3.4368822574615479</c:v>
                </c:pt>
                <c:pt idx="203">
                  <c:v>-3.4307568073272705</c:v>
                </c:pt>
                <c:pt idx="204">
                  <c:v>-3.4246275424957275</c:v>
                </c:pt>
                <c:pt idx="205">
                  <c:v>-3.4184951782226563</c:v>
                </c:pt>
                <c:pt idx="206">
                  <c:v>-3.4123580455780029</c:v>
                </c:pt>
                <c:pt idx="207">
                  <c:v>-3.4062166213989258</c:v>
                </c:pt>
                <c:pt idx="208">
                  <c:v>-3.400068998336792</c:v>
                </c:pt>
                <c:pt idx="209">
                  <c:v>-3.3939139842987061</c:v>
                </c:pt>
                <c:pt idx="210">
                  <c:v>-3.387749195098877</c:v>
                </c:pt>
                <c:pt idx="211">
                  <c:v>-3.3815793991088867</c:v>
                </c:pt>
                <c:pt idx="212">
                  <c:v>-3.3754055500030518</c:v>
                </c:pt>
                <c:pt idx="213">
                  <c:v>-3.3692286014556885</c:v>
                </c:pt>
                <c:pt idx="214">
                  <c:v>-3.3630483150482178</c:v>
                </c:pt>
                <c:pt idx="215">
                  <c:v>-3.3568630218505859</c:v>
                </c:pt>
                <c:pt idx="216">
                  <c:v>-3.3506729602813721</c:v>
                </c:pt>
                <c:pt idx="217">
                  <c:v>-3.3444771766662598</c:v>
                </c:pt>
                <c:pt idx="218">
                  <c:v>-3.3382725715637207</c:v>
                </c:pt>
                <c:pt idx="219">
                  <c:v>-3.3320603370666504</c:v>
                </c:pt>
                <c:pt idx="220">
                  <c:v>-3.3258423805236816</c:v>
                </c:pt>
                <c:pt idx="221">
                  <c:v>-3.3196206092834473</c:v>
                </c:pt>
                <c:pt idx="222">
                  <c:v>-3.3133955001831055</c:v>
                </c:pt>
                <c:pt idx="223">
                  <c:v>-3.3071670532226563</c:v>
                </c:pt>
                <c:pt idx="224">
                  <c:v>-3.3009347915649414</c:v>
                </c:pt>
                <c:pt idx="225">
                  <c:v>-3.2946972846984863</c:v>
                </c:pt>
                <c:pt idx="226">
                  <c:v>-3.288454532623291</c:v>
                </c:pt>
                <c:pt idx="227">
                  <c:v>-3.2822060585021973</c:v>
                </c:pt>
                <c:pt idx="228">
                  <c:v>-3.275949239730835</c:v>
                </c:pt>
                <c:pt idx="229">
                  <c:v>-3.2696852684020996</c:v>
                </c:pt>
                <c:pt idx="230">
                  <c:v>-3.2634165287017822</c:v>
                </c:pt>
                <c:pt idx="231">
                  <c:v>-3.2571430206298828</c:v>
                </c:pt>
                <c:pt idx="232">
                  <c:v>-3.250866174697876</c:v>
                </c:pt>
                <c:pt idx="233">
                  <c:v>-3.2445862293243408</c:v>
                </c:pt>
                <c:pt idx="234">
                  <c:v>-3.2383017539978027</c:v>
                </c:pt>
                <c:pt idx="235">
                  <c:v>-3.2320129871368408</c:v>
                </c:pt>
                <c:pt idx="236">
                  <c:v>-3.2257182598114014</c:v>
                </c:pt>
                <c:pt idx="237">
                  <c:v>-3.2194199562072754</c:v>
                </c:pt>
                <c:pt idx="238">
                  <c:v>-3.2131147384643555</c:v>
                </c:pt>
                <c:pt idx="239">
                  <c:v>-3.206801176071167</c:v>
                </c:pt>
                <c:pt idx="240">
                  <c:v>-3.2004818916320801</c:v>
                </c:pt>
                <c:pt idx="241">
                  <c:v>-3.1941571235656738</c:v>
                </c:pt>
                <c:pt idx="242">
                  <c:v>-3.1878283023834229</c:v>
                </c:pt>
                <c:pt idx="243">
                  <c:v>-3.1814963817596436</c:v>
                </c:pt>
                <c:pt idx="244">
                  <c:v>-3.1751608848571777</c:v>
                </c:pt>
                <c:pt idx="245">
                  <c:v>-3.1688215732574463</c:v>
                </c:pt>
                <c:pt idx="246">
                  <c:v>-3.1624772548675537</c:v>
                </c:pt>
                <c:pt idx="247">
                  <c:v>-3.1561286449432373</c:v>
                </c:pt>
                <c:pt idx="248">
                  <c:v>-3.1497733592987061</c:v>
                </c:pt>
                <c:pt idx="249">
                  <c:v>-3.1434121131896973</c:v>
                </c:pt>
                <c:pt idx="250">
                  <c:v>-3.1370439529418945</c:v>
                </c:pt>
                <c:pt idx="251">
                  <c:v>-3.1306688785552979</c:v>
                </c:pt>
                <c:pt idx="252">
                  <c:v>-3.1242885589599609</c:v>
                </c:pt>
                <c:pt idx="253">
                  <c:v>-3.1179041862487793</c:v>
                </c:pt>
                <c:pt idx="254">
                  <c:v>-3.1115164756774902</c:v>
                </c:pt>
                <c:pt idx="255">
                  <c:v>-3.1051254272460938</c:v>
                </c:pt>
                <c:pt idx="256">
                  <c:v>-3.0987310409545898</c:v>
                </c:pt>
                <c:pt idx="257">
                  <c:v>-3.0923330783843994</c:v>
                </c:pt>
                <c:pt idx="258">
                  <c:v>-3.0859320163726807</c:v>
                </c:pt>
                <c:pt idx="259">
                  <c:v>-3.0795261859893799</c:v>
                </c:pt>
                <c:pt idx="260">
                  <c:v>-3.0731174945831299</c:v>
                </c:pt>
                <c:pt idx="261">
                  <c:v>-3.0667026042938232</c:v>
                </c:pt>
                <c:pt idx="262">
                  <c:v>-3.0602841377258301</c:v>
                </c:pt>
                <c:pt idx="263">
                  <c:v>-3.0538599491119385</c:v>
                </c:pt>
                <c:pt idx="264">
                  <c:v>-3.0474309921264648</c:v>
                </c:pt>
                <c:pt idx="265">
                  <c:v>-3.0409934520721436</c:v>
                </c:pt>
                <c:pt idx="266">
                  <c:v>-3.0345499515533447</c:v>
                </c:pt>
                <c:pt idx="267">
                  <c:v>-3.0281007289886475</c:v>
                </c:pt>
                <c:pt idx="268">
                  <c:v>-3.0216469764709473</c:v>
                </c:pt>
                <c:pt idx="269">
                  <c:v>-3.0151898860931396</c:v>
                </c:pt>
                <c:pt idx="270">
                  <c:v>-3.0087292194366455</c:v>
                </c:pt>
                <c:pt idx="271">
                  <c:v>-3.002265453338623</c:v>
                </c:pt>
                <c:pt idx="272">
                  <c:v>-2.9957981109619141</c:v>
                </c:pt>
                <c:pt idx="273">
                  <c:v>-2.9893262386322021</c:v>
                </c:pt>
                <c:pt idx="274">
                  <c:v>-2.9828500747680664</c:v>
                </c:pt>
                <c:pt idx="275">
                  <c:v>-2.976370096206665</c:v>
                </c:pt>
                <c:pt idx="276">
                  <c:v>-2.9698843955993652</c:v>
                </c:pt>
                <c:pt idx="277">
                  <c:v>-2.9633941650390625</c:v>
                </c:pt>
                <c:pt idx="278">
                  <c:v>-2.9568967819213867</c:v>
                </c:pt>
                <c:pt idx="279">
                  <c:v>-2.950392484664917</c:v>
                </c:pt>
                <c:pt idx="280">
                  <c:v>-2.9438822269439697</c:v>
                </c:pt>
                <c:pt idx="281">
                  <c:v>-2.9373669624328613</c:v>
                </c:pt>
                <c:pt idx="282">
                  <c:v>-2.9308466911315918</c:v>
                </c:pt>
                <c:pt idx="283">
                  <c:v>-2.9243230819702148</c:v>
                </c:pt>
                <c:pt idx="284">
                  <c:v>-2.9177961349487305</c:v>
                </c:pt>
                <c:pt idx="285">
                  <c:v>-2.9112656116485596</c:v>
                </c:pt>
                <c:pt idx="286">
                  <c:v>-2.9047315120697021</c:v>
                </c:pt>
                <c:pt idx="287">
                  <c:v>-2.8981931209564209</c:v>
                </c:pt>
                <c:pt idx="288">
                  <c:v>-2.8916506767272949</c:v>
                </c:pt>
                <c:pt idx="289">
                  <c:v>-2.8851032257080078</c:v>
                </c:pt>
                <c:pt idx="290">
                  <c:v>-2.8785521984100342</c:v>
                </c:pt>
                <c:pt idx="291">
                  <c:v>-2.8719961643218994</c:v>
                </c:pt>
                <c:pt idx="292">
                  <c:v>-2.8654332160949707</c:v>
                </c:pt>
                <c:pt idx="293">
                  <c:v>-2.8588652610778809</c:v>
                </c:pt>
                <c:pt idx="294">
                  <c:v>-2.8522896766662598</c:v>
                </c:pt>
                <c:pt idx="295">
                  <c:v>-2.8457090854644775</c:v>
                </c:pt>
                <c:pt idx="296">
                  <c:v>-2.839123010635376</c:v>
                </c:pt>
                <c:pt idx="297">
                  <c:v>-2.8325326442718506</c:v>
                </c:pt>
                <c:pt idx="298">
                  <c:v>-2.8259387016296387</c:v>
                </c:pt>
                <c:pt idx="299">
                  <c:v>-2.8193414211273193</c:v>
                </c:pt>
                <c:pt idx="300">
                  <c:v>-2.8127405643463135</c:v>
                </c:pt>
                <c:pt idx="301">
                  <c:v>-2.8061363697052002</c:v>
                </c:pt>
                <c:pt idx="302">
                  <c:v>-2.7995281219482422</c:v>
                </c:pt>
                <c:pt idx="303">
                  <c:v>-2.792914867401123</c:v>
                </c:pt>
                <c:pt idx="304">
                  <c:v>-2.7862975597381592</c:v>
                </c:pt>
                <c:pt idx="305">
                  <c:v>-2.7796759605407715</c:v>
                </c:pt>
                <c:pt idx="306">
                  <c:v>-2.7730488777160645</c:v>
                </c:pt>
                <c:pt idx="307">
                  <c:v>-2.7664175033569336</c:v>
                </c:pt>
                <c:pt idx="308">
                  <c:v>-2.7597808837890625</c:v>
                </c:pt>
                <c:pt idx="309">
                  <c:v>-2.7531378269195557</c:v>
                </c:pt>
                <c:pt idx="310">
                  <c:v>-2.7464890480041504</c:v>
                </c:pt>
                <c:pt idx="311">
                  <c:v>-2.7398331165313721</c:v>
                </c:pt>
                <c:pt idx="312">
                  <c:v>-2.733173131942749</c:v>
                </c:pt>
                <c:pt idx="313">
                  <c:v>-2.7265090942382813</c:v>
                </c:pt>
                <c:pt idx="314">
                  <c:v>-2.7198410034179688</c:v>
                </c:pt>
                <c:pt idx="315">
                  <c:v>-2.7131693363189697</c:v>
                </c:pt>
                <c:pt idx="316">
                  <c:v>-2.7064943313598633</c:v>
                </c:pt>
                <c:pt idx="317">
                  <c:v>-2.6998159885406494</c:v>
                </c:pt>
                <c:pt idx="318">
                  <c:v>-2.693134069442749</c:v>
                </c:pt>
                <c:pt idx="319">
                  <c:v>-2.6864478588104248</c:v>
                </c:pt>
                <c:pt idx="320">
                  <c:v>-2.6797583103179932</c:v>
                </c:pt>
                <c:pt idx="321">
                  <c:v>-2.6730632781982422</c:v>
                </c:pt>
                <c:pt idx="322">
                  <c:v>-2.6663639545440674</c:v>
                </c:pt>
                <c:pt idx="323">
                  <c:v>-2.6596593856811523</c:v>
                </c:pt>
                <c:pt idx="324">
                  <c:v>-2.6529502868652344</c:v>
                </c:pt>
                <c:pt idx="325">
                  <c:v>-2.646235466003418</c:v>
                </c:pt>
                <c:pt idx="326">
                  <c:v>-2.639512300491333</c:v>
                </c:pt>
                <c:pt idx="327">
                  <c:v>-2.6327829360961914</c:v>
                </c:pt>
                <c:pt idx="328">
                  <c:v>-2.6260488033294678</c:v>
                </c:pt>
                <c:pt idx="329">
                  <c:v>-2.619309663772583</c:v>
                </c:pt>
                <c:pt idx="330">
                  <c:v>-2.6125669479370117</c:v>
                </c:pt>
                <c:pt idx="331">
                  <c:v>-2.605820894241333</c:v>
                </c:pt>
                <c:pt idx="332">
                  <c:v>-2.5990712642669678</c:v>
                </c:pt>
                <c:pt idx="333">
                  <c:v>-2.5923182964324951</c:v>
                </c:pt>
                <c:pt idx="334">
                  <c:v>-2.5855617523193359</c:v>
                </c:pt>
                <c:pt idx="335">
                  <c:v>-2.5788009166717529</c:v>
                </c:pt>
                <c:pt idx="336">
                  <c:v>-2.5720372200012207</c:v>
                </c:pt>
                <c:pt idx="337">
                  <c:v>-2.5652687549591064</c:v>
                </c:pt>
                <c:pt idx="338">
                  <c:v>-2.5584962368011475</c:v>
                </c:pt>
                <c:pt idx="339">
                  <c:v>-2.5517194271087646</c:v>
                </c:pt>
                <c:pt idx="340">
                  <c:v>-2.5449376106262207</c:v>
                </c:pt>
                <c:pt idx="341">
                  <c:v>-2.5381515026092529</c:v>
                </c:pt>
                <c:pt idx="342">
                  <c:v>-2.5313611030578613</c:v>
                </c:pt>
                <c:pt idx="343">
                  <c:v>-2.5245647430419922</c:v>
                </c:pt>
                <c:pt idx="344">
                  <c:v>-2.5177640914916992</c:v>
                </c:pt>
                <c:pt idx="345">
                  <c:v>-2.5109565258026123</c:v>
                </c:pt>
                <c:pt idx="346">
                  <c:v>-2.5041441917419434</c:v>
                </c:pt>
                <c:pt idx="347">
                  <c:v>-2.4973256587982178</c:v>
                </c:pt>
                <c:pt idx="348">
                  <c:v>-2.4905025959014893</c:v>
                </c:pt>
                <c:pt idx="349">
                  <c:v>-2.4836742877960205</c:v>
                </c:pt>
                <c:pt idx="350">
                  <c:v>-2.4768426418304443</c:v>
                </c:pt>
                <c:pt idx="351">
                  <c:v>-2.4700076580047607</c:v>
                </c:pt>
                <c:pt idx="352">
                  <c:v>-2.4631690979003906</c:v>
                </c:pt>
                <c:pt idx="353">
                  <c:v>-2.456326961517334</c:v>
                </c:pt>
                <c:pt idx="354">
                  <c:v>-2.4494812488555908</c:v>
                </c:pt>
                <c:pt idx="355">
                  <c:v>-2.4426321983337402</c:v>
                </c:pt>
                <c:pt idx="356">
                  <c:v>-2.4357798099517822</c:v>
                </c:pt>
                <c:pt idx="357">
                  <c:v>-2.4289233684539795</c:v>
                </c:pt>
                <c:pt idx="358">
                  <c:v>-2.4220633506774902</c:v>
                </c:pt>
                <c:pt idx="359">
                  <c:v>-2.415198802947998</c:v>
                </c:pt>
                <c:pt idx="360">
                  <c:v>-2.4083313941955566</c:v>
                </c:pt>
                <c:pt idx="361">
                  <c:v>-2.4014599323272705</c:v>
                </c:pt>
                <c:pt idx="362">
                  <c:v>-2.3945844173431396</c:v>
                </c:pt>
                <c:pt idx="363">
                  <c:v>-2.3877043724060059</c:v>
                </c:pt>
                <c:pt idx="364">
                  <c:v>-2.3808205127716064</c:v>
                </c:pt>
                <c:pt idx="365">
                  <c:v>-2.3739323616027832</c:v>
                </c:pt>
                <c:pt idx="366">
                  <c:v>-2.3670399188995361</c:v>
                </c:pt>
                <c:pt idx="367">
                  <c:v>-2.3601443767547607</c:v>
                </c:pt>
                <c:pt idx="368">
                  <c:v>-2.3532435894012451</c:v>
                </c:pt>
                <c:pt idx="369">
                  <c:v>-2.3463387489318848</c:v>
                </c:pt>
                <c:pt idx="370">
                  <c:v>-2.3394291400909424</c:v>
                </c:pt>
                <c:pt idx="371">
                  <c:v>-2.3325159549713135</c:v>
                </c:pt>
                <c:pt idx="372">
                  <c:v>-2.3255951404571533</c:v>
                </c:pt>
                <c:pt idx="373">
                  <c:v>-2.3186683654785156</c:v>
                </c:pt>
                <c:pt idx="374">
                  <c:v>-2.3117372989654541</c:v>
                </c:pt>
                <c:pt idx="375">
                  <c:v>-2.304802417755127</c:v>
                </c:pt>
                <c:pt idx="376">
                  <c:v>-2.2978625297546387</c:v>
                </c:pt>
                <c:pt idx="377">
                  <c:v>-2.2909173965454102</c:v>
                </c:pt>
                <c:pt idx="378">
                  <c:v>-2.283968448638916</c:v>
                </c:pt>
                <c:pt idx="379">
                  <c:v>-2.2770156860351563</c:v>
                </c:pt>
                <c:pt idx="380">
                  <c:v>-2.2700595855712891</c:v>
                </c:pt>
                <c:pt idx="381">
                  <c:v>-2.2631001472473145</c:v>
                </c:pt>
                <c:pt idx="382">
                  <c:v>-2.2561368942260742</c:v>
                </c:pt>
                <c:pt idx="383">
                  <c:v>-2.2491703033447266</c:v>
                </c:pt>
                <c:pt idx="384">
                  <c:v>-2.2422003746032715</c:v>
                </c:pt>
                <c:pt idx="385">
                  <c:v>-2.2352263927459717</c:v>
                </c:pt>
                <c:pt idx="386">
                  <c:v>-2.2282493114471436</c:v>
                </c:pt>
                <c:pt idx="387">
                  <c:v>-2.2212684154510498</c:v>
                </c:pt>
                <c:pt idx="388">
                  <c:v>-2.2142829895019531</c:v>
                </c:pt>
                <c:pt idx="389">
                  <c:v>-2.207294225692749</c:v>
                </c:pt>
                <c:pt idx="390">
                  <c:v>-2.2003016471862793</c:v>
                </c:pt>
                <c:pt idx="391">
                  <c:v>-2.1933050155639648</c:v>
                </c:pt>
                <c:pt idx="392">
                  <c:v>-2.1863045692443848</c:v>
                </c:pt>
                <c:pt idx="393">
                  <c:v>-2.17930006980896</c:v>
                </c:pt>
                <c:pt idx="394">
                  <c:v>-2.1722912788391113</c:v>
                </c:pt>
                <c:pt idx="395">
                  <c:v>-2.1652789115905762</c:v>
                </c:pt>
                <c:pt idx="396">
                  <c:v>-2.1582605838775635</c:v>
                </c:pt>
                <c:pt idx="397">
                  <c:v>-2.1512389183044434</c:v>
                </c:pt>
                <c:pt idx="398">
                  <c:v>-2.1442124843597412</c:v>
                </c:pt>
                <c:pt idx="399">
                  <c:v>-2.1371810436248779</c:v>
                </c:pt>
                <c:pt idx="400">
                  <c:v>-2.1301448345184326</c:v>
                </c:pt>
                <c:pt idx="401">
                  <c:v>-2.1231024265289307</c:v>
                </c:pt>
                <c:pt idx="402">
                  <c:v>-2.1160550117492676</c:v>
                </c:pt>
                <c:pt idx="403">
                  <c:v>-2.1090023517608643</c:v>
                </c:pt>
                <c:pt idx="404">
                  <c:v>-2.1019463539123535</c:v>
                </c:pt>
                <c:pt idx="405">
                  <c:v>-2.0948841571807861</c:v>
                </c:pt>
                <c:pt idx="406">
                  <c:v>-2.0878176689147949</c:v>
                </c:pt>
                <c:pt idx="407">
                  <c:v>-2.0807476043701172</c:v>
                </c:pt>
                <c:pt idx="408">
                  <c:v>-2.0736737251281738</c:v>
                </c:pt>
                <c:pt idx="409">
                  <c:v>-2.0665957927703857</c:v>
                </c:pt>
                <c:pt idx="410">
                  <c:v>-2.0595145225524902</c:v>
                </c:pt>
                <c:pt idx="411">
                  <c:v>-2.0524296760559082</c:v>
                </c:pt>
                <c:pt idx="412">
                  <c:v>-2.0453412532806396</c:v>
                </c:pt>
                <c:pt idx="413">
                  <c:v>-2.0382492542266846</c:v>
                </c:pt>
                <c:pt idx="414">
                  <c:v>-2.0311539173126221</c:v>
                </c:pt>
                <c:pt idx="415">
                  <c:v>-2.024055004119873</c:v>
                </c:pt>
                <c:pt idx="416">
                  <c:v>-2.0169525146484375</c:v>
                </c:pt>
                <c:pt idx="417">
                  <c:v>-2.0098464488983154</c:v>
                </c:pt>
                <c:pt idx="418">
                  <c:v>-2.0027370452880859</c:v>
                </c:pt>
                <c:pt idx="419">
                  <c:v>-1.9956240653991699</c:v>
                </c:pt>
                <c:pt idx="420">
                  <c:v>-1.9885072708129883</c:v>
                </c:pt>
                <c:pt idx="421">
                  <c:v>-1.9813865423202515</c:v>
                </c:pt>
                <c:pt idx="422">
                  <c:v>-1.9742627143859863</c:v>
                </c:pt>
                <c:pt idx="423">
                  <c:v>-1.9671341180801392</c:v>
                </c:pt>
                <c:pt idx="424">
                  <c:v>-1.9600015878677368</c:v>
                </c:pt>
                <c:pt idx="425">
                  <c:v>-1.9528656005859375</c:v>
                </c:pt>
                <c:pt idx="426">
                  <c:v>-1.9457244873046875</c:v>
                </c:pt>
                <c:pt idx="427">
                  <c:v>-1.9385801553726196</c:v>
                </c:pt>
                <c:pt idx="428">
                  <c:v>-1.9314308166503906</c:v>
                </c:pt>
                <c:pt idx="429">
                  <c:v>-1.9242784976959229</c:v>
                </c:pt>
                <c:pt idx="430">
                  <c:v>-1.9171206951141357</c:v>
                </c:pt>
                <c:pt idx="431">
                  <c:v>-1.9099575281143188</c:v>
                </c:pt>
                <c:pt idx="432">
                  <c:v>-1.9027905464172363</c:v>
                </c:pt>
                <c:pt idx="433">
                  <c:v>-1.8956159353256226</c:v>
                </c:pt>
                <c:pt idx="434">
                  <c:v>-1.8884373903274536</c:v>
                </c:pt>
                <c:pt idx="435">
                  <c:v>-1.8812518119812012</c:v>
                </c:pt>
                <c:pt idx="436">
                  <c:v>-1.8740637302398682</c:v>
                </c:pt>
                <c:pt idx="437">
                  <c:v>-1.8668714761734009</c:v>
                </c:pt>
                <c:pt idx="438">
                  <c:v>-1.8596737384796143</c:v>
                </c:pt>
                <c:pt idx="439">
                  <c:v>-1.8524720668792725</c:v>
                </c:pt>
                <c:pt idx="440">
                  <c:v>-1.8452650308609009</c:v>
                </c:pt>
                <c:pt idx="441">
                  <c:v>-1.8380554914474487</c:v>
                </c:pt>
                <c:pt idx="442">
                  <c:v>-1.830841064453125</c:v>
                </c:pt>
                <c:pt idx="443">
                  <c:v>-1.8236234188079834</c:v>
                </c:pt>
                <c:pt idx="444">
                  <c:v>-1.8164018392562866</c:v>
                </c:pt>
                <c:pt idx="445">
                  <c:v>-1.8091771602630615</c:v>
                </c:pt>
                <c:pt idx="446">
                  <c:v>-1.8019486665725708</c:v>
                </c:pt>
                <c:pt idx="447">
                  <c:v>-1.794716477394104</c:v>
                </c:pt>
                <c:pt idx="448">
                  <c:v>-1.7874809503555298</c:v>
                </c:pt>
                <c:pt idx="449">
                  <c:v>-1.7802417278289795</c:v>
                </c:pt>
                <c:pt idx="450">
                  <c:v>-1.7729990482330322</c:v>
                </c:pt>
                <c:pt idx="451">
                  <c:v>-1.7657527923583984</c:v>
                </c:pt>
                <c:pt idx="452">
                  <c:v>-1.7585030794143677</c:v>
                </c:pt>
                <c:pt idx="453">
                  <c:v>-1.7512494325637817</c:v>
                </c:pt>
                <c:pt idx="454">
                  <c:v>-1.7439926862716675</c:v>
                </c:pt>
                <c:pt idx="455">
                  <c:v>-1.736732006072998</c:v>
                </c:pt>
                <c:pt idx="456">
                  <c:v>-1.7294673919677734</c:v>
                </c:pt>
                <c:pt idx="457">
                  <c:v>-1.7221996784210205</c:v>
                </c:pt>
                <c:pt idx="458">
                  <c:v>-1.7149277925491333</c:v>
                </c:pt>
                <c:pt idx="459">
                  <c:v>-1.7076517343521118</c:v>
                </c:pt>
                <c:pt idx="460">
                  <c:v>-1.7003717422485352</c:v>
                </c:pt>
                <c:pt idx="461">
                  <c:v>-1.6930875778198242</c:v>
                </c:pt>
                <c:pt idx="462">
                  <c:v>-1.6857999563217163</c:v>
                </c:pt>
                <c:pt idx="463">
                  <c:v>-1.6785078048706055</c:v>
                </c:pt>
                <c:pt idx="464">
                  <c:v>-1.6712114810943604</c:v>
                </c:pt>
                <c:pt idx="465">
                  <c:v>-1.663910984992981</c:v>
                </c:pt>
                <c:pt idx="466">
                  <c:v>-1.6566058397293091</c:v>
                </c:pt>
                <c:pt idx="467">
                  <c:v>-1.6492973566055298</c:v>
                </c:pt>
                <c:pt idx="468">
                  <c:v>-1.6419829130172729</c:v>
                </c:pt>
                <c:pt idx="469">
                  <c:v>-1.6346646547317505</c:v>
                </c:pt>
                <c:pt idx="470">
                  <c:v>-1.6273412704467773</c:v>
                </c:pt>
                <c:pt idx="471">
                  <c:v>-1.6200097799301147</c:v>
                </c:pt>
                <c:pt idx="472">
                  <c:v>-1.6126754283905029</c:v>
                </c:pt>
                <c:pt idx="473">
                  <c:v>-1.6053358316421509</c:v>
                </c:pt>
                <c:pt idx="474">
                  <c:v>-1.5979914665222168</c:v>
                </c:pt>
                <c:pt idx="475">
                  <c:v>-1.5906422138214111</c:v>
                </c:pt>
                <c:pt idx="476">
                  <c:v>-1.5832887887954712</c:v>
                </c:pt>
                <c:pt idx="477">
                  <c:v>-1.5759304761886597</c:v>
                </c:pt>
                <c:pt idx="478">
                  <c:v>-1.5685679912567139</c:v>
                </c:pt>
                <c:pt idx="479">
                  <c:v>-1.5612019300460815</c:v>
                </c:pt>
                <c:pt idx="480">
                  <c:v>-1.5538326501846313</c:v>
                </c:pt>
                <c:pt idx="481">
                  <c:v>-1.5464595556259155</c:v>
                </c:pt>
                <c:pt idx="482">
                  <c:v>-1.5390828847885132</c:v>
                </c:pt>
                <c:pt idx="483">
                  <c:v>-1.5317026376724243</c:v>
                </c:pt>
                <c:pt idx="484">
                  <c:v>-1.5243188142776489</c:v>
                </c:pt>
                <c:pt idx="485">
                  <c:v>-1.5169315338134766</c:v>
                </c:pt>
                <c:pt idx="486">
                  <c:v>-1.5095406770706177</c:v>
                </c:pt>
                <c:pt idx="487">
                  <c:v>-1.5021462440490723</c:v>
                </c:pt>
                <c:pt idx="488">
                  <c:v>-1.4947482347488403</c:v>
                </c:pt>
                <c:pt idx="489">
                  <c:v>-1.4873466491699219</c:v>
                </c:pt>
                <c:pt idx="490">
                  <c:v>-1.4799410104751587</c:v>
                </c:pt>
                <c:pt idx="491">
                  <c:v>-1.4725310802459717</c:v>
                </c:pt>
                <c:pt idx="492">
                  <c:v>-1.4651181697845459</c:v>
                </c:pt>
                <c:pt idx="493">
                  <c:v>-1.4577008485794067</c:v>
                </c:pt>
                <c:pt idx="494">
                  <c:v>-1.4502799510955811</c:v>
                </c:pt>
                <c:pt idx="495">
                  <c:v>-1.4428551197052002</c:v>
                </c:pt>
                <c:pt idx="496">
                  <c:v>-1.4354261159896851</c:v>
                </c:pt>
                <c:pt idx="497">
                  <c:v>-1.4279932975769043</c:v>
                </c:pt>
                <c:pt idx="498">
                  <c:v>-1.4205561876296997</c:v>
                </c:pt>
                <c:pt idx="499">
                  <c:v>-1.4131146669387817</c:v>
                </c:pt>
                <c:pt idx="500">
                  <c:v>-1.4056688547134399</c:v>
                </c:pt>
                <c:pt idx="501">
                  <c:v>-1.3982183933258057</c:v>
                </c:pt>
                <c:pt idx="502">
                  <c:v>-1.3907622098922729</c:v>
                </c:pt>
                <c:pt idx="503">
                  <c:v>-1.3833020925521851</c:v>
                </c:pt>
                <c:pt idx="504">
                  <c:v>-1.3758381605148315</c:v>
                </c:pt>
                <c:pt idx="505">
                  <c:v>-1.3683682680130005</c:v>
                </c:pt>
                <c:pt idx="506">
                  <c:v>-1.3608925342559814</c:v>
                </c:pt>
                <c:pt idx="507">
                  <c:v>-1.3534113168716431</c:v>
                </c:pt>
                <c:pt idx="508">
                  <c:v>-1.3459271192550659</c:v>
                </c:pt>
                <c:pt idx="509">
                  <c:v>-1.3384363651275635</c:v>
                </c:pt>
                <c:pt idx="510">
                  <c:v>-1.3309425115585327</c:v>
                </c:pt>
                <c:pt idx="511">
                  <c:v>-1.3234432935714722</c:v>
                </c:pt>
                <c:pt idx="512">
                  <c:v>-1.315940260887146</c:v>
                </c:pt>
                <c:pt idx="513">
                  <c:v>-1.3084326982498169</c:v>
                </c:pt>
                <c:pt idx="514">
                  <c:v>-1.3009212017059326</c:v>
                </c:pt>
                <c:pt idx="515">
                  <c:v>-1.2934061288833618</c:v>
                </c:pt>
                <c:pt idx="516">
                  <c:v>-1.2858874797821045</c:v>
                </c:pt>
                <c:pt idx="517">
                  <c:v>-1.2783652544021606</c:v>
                </c:pt>
                <c:pt idx="518">
                  <c:v>-1.2708395719528198</c:v>
                </c:pt>
                <c:pt idx="519">
                  <c:v>-1.2633101940155029</c:v>
                </c:pt>
                <c:pt idx="520">
                  <c:v>-1.2557773590087891</c:v>
                </c:pt>
                <c:pt idx="521">
                  <c:v>-1.2482402324676514</c:v>
                </c:pt>
                <c:pt idx="522">
                  <c:v>-1.2407002449035645</c:v>
                </c:pt>
                <c:pt idx="523">
                  <c:v>-1.2331563234329224</c:v>
                </c:pt>
                <c:pt idx="524">
                  <c:v>-1.2256091833114624</c:v>
                </c:pt>
                <c:pt idx="525">
                  <c:v>-1.2180578708648682</c:v>
                </c:pt>
                <c:pt idx="526">
                  <c:v>-1.2105028629302979</c:v>
                </c:pt>
                <c:pt idx="527">
                  <c:v>-1.2029423713684082</c:v>
                </c:pt>
                <c:pt idx="528">
                  <c:v>-1.1953796148300171</c:v>
                </c:pt>
                <c:pt idx="529">
                  <c:v>-1.1878113746643066</c:v>
                </c:pt>
                <c:pt idx="530">
                  <c:v>-1.1802401542663574</c:v>
                </c:pt>
                <c:pt idx="531">
                  <c:v>-1.1726630926132202</c:v>
                </c:pt>
                <c:pt idx="532">
                  <c:v>-1.1650817394256592</c:v>
                </c:pt>
                <c:pt idx="533">
                  <c:v>-1.1574968099594116</c:v>
                </c:pt>
                <c:pt idx="534">
                  <c:v>-1.1499056816101074</c:v>
                </c:pt>
                <c:pt idx="535">
                  <c:v>-1.142309308052063</c:v>
                </c:pt>
                <c:pt idx="536">
                  <c:v>-1.1347066164016724</c:v>
                </c:pt>
                <c:pt idx="537">
                  <c:v>-1.1270980834960938</c:v>
                </c:pt>
                <c:pt idx="538">
                  <c:v>-1.1194859743118286</c:v>
                </c:pt>
                <c:pt idx="539">
                  <c:v>-1.1118682622909546</c:v>
                </c:pt>
                <c:pt idx="540">
                  <c:v>-1.1042455434799194</c:v>
                </c:pt>
                <c:pt idx="541">
                  <c:v>-1.0966184139251709</c:v>
                </c:pt>
                <c:pt idx="542">
                  <c:v>-1.088986873626709</c:v>
                </c:pt>
                <c:pt idx="543">
                  <c:v>-1.0813515186309814</c:v>
                </c:pt>
                <c:pt idx="544">
                  <c:v>-1.0737121105194092</c:v>
                </c:pt>
                <c:pt idx="545">
                  <c:v>-1.0660685300827026</c:v>
                </c:pt>
                <c:pt idx="546">
                  <c:v>-1.0584213733673096</c:v>
                </c:pt>
                <c:pt idx="547">
                  <c:v>-1.0507707595825195</c:v>
                </c:pt>
                <c:pt idx="548">
                  <c:v>-1.0431163311004639</c:v>
                </c:pt>
                <c:pt idx="549">
                  <c:v>-1.0354584455490112</c:v>
                </c:pt>
                <c:pt idx="550">
                  <c:v>-1.0277969837188721</c:v>
                </c:pt>
                <c:pt idx="551">
                  <c:v>-1.0201319456100464</c:v>
                </c:pt>
                <c:pt idx="552">
                  <c:v>-1.0124633312225342</c:v>
                </c:pt>
                <c:pt idx="553">
                  <c:v>-1.0047911405563354</c:v>
                </c:pt>
                <c:pt idx="554">
                  <c:v>-0.99711531400680542</c:v>
                </c:pt>
                <c:pt idx="555">
                  <c:v>-0.98943597078323364</c:v>
                </c:pt>
                <c:pt idx="556">
                  <c:v>-0.98175299167633057</c:v>
                </c:pt>
                <c:pt idx="557">
                  <c:v>-0.97406649589538574</c:v>
                </c:pt>
                <c:pt idx="558">
                  <c:v>-0.96637606620788574</c:v>
                </c:pt>
                <c:pt idx="559">
                  <c:v>-0.9586823582649231</c:v>
                </c:pt>
                <c:pt idx="560">
                  <c:v>-0.95098507404327393</c:v>
                </c:pt>
                <c:pt idx="561">
                  <c:v>-0.94328421354293823</c:v>
                </c:pt>
                <c:pt idx="562">
                  <c:v>-0.93557947874069214</c:v>
                </c:pt>
                <c:pt idx="563">
                  <c:v>-0.92787081003189087</c:v>
                </c:pt>
                <c:pt idx="564">
                  <c:v>-0.92015820741653442</c:v>
                </c:pt>
                <c:pt idx="565">
                  <c:v>-0.91244202852249146</c:v>
                </c:pt>
                <c:pt idx="566">
                  <c:v>-0.90472257137298584</c:v>
                </c:pt>
                <c:pt idx="567">
                  <c:v>-0.89699858427047729</c:v>
                </c:pt>
                <c:pt idx="568">
                  <c:v>-0.88927096128463745</c:v>
                </c:pt>
                <c:pt idx="569">
                  <c:v>-0.88153910636901855</c:v>
                </c:pt>
                <c:pt idx="570">
                  <c:v>-0.87380367517471313</c:v>
                </c:pt>
                <c:pt idx="571">
                  <c:v>-0.86606401205062866</c:v>
                </c:pt>
                <c:pt idx="572">
                  <c:v>-0.85832136869430542</c:v>
                </c:pt>
                <c:pt idx="573">
                  <c:v>-0.8505745530128479</c:v>
                </c:pt>
                <c:pt idx="574">
                  <c:v>-0.84282511472702026</c:v>
                </c:pt>
                <c:pt idx="575">
                  <c:v>-0.83507078886032104</c:v>
                </c:pt>
                <c:pt idx="576">
                  <c:v>-0.82731348276138306</c:v>
                </c:pt>
                <c:pt idx="577">
                  <c:v>-0.81955200433731079</c:v>
                </c:pt>
                <c:pt idx="578">
                  <c:v>-0.81178760528564453</c:v>
                </c:pt>
                <c:pt idx="579">
                  <c:v>-0.80401819944381714</c:v>
                </c:pt>
                <c:pt idx="580">
                  <c:v>-0.79624664783477783</c:v>
                </c:pt>
                <c:pt idx="581">
                  <c:v>-0.78847014904022217</c:v>
                </c:pt>
                <c:pt idx="582">
                  <c:v>-0.78069138526916504</c:v>
                </c:pt>
                <c:pt idx="583">
                  <c:v>-0.77290874719619751</c:v>
                </c:pt>
                <c:pt idx="584">
                  <c:v>-0.76512318849563599</c:v>
                </c:pt>
                <c:pt idx="585">
                  <c:v>-0.75733304023742676</c:v>
                </c:pt>
                <c:pt idx="586">
                  <c:v>-0.74954003095626831</c:v>
                </c:pt>
                <c:pt idx="587">
                  <c:v>-0.74174338579177856</c:v>
                </c:pt>
                <c:pt idx="588">
                  <c:v>-0.73394316434860229</c:v>
                </c:pt>
                <c:pt idx="589">
                  <c:v>-0.72613835334777832</c:v>
                </c:pt>
                <c:pt idx="590">
                  <c:v>-0.71833103895187378</c:v>
                </c:pt>
                <c:pt idx="591">
                  <c:v>-0.71052008867263794</c:v>
                </c:pt>
                <c:pt idx="592">
                  <c:v>-0.70270591974258423</c:v>
                </c:pt>
                <c:pt idx="593">
                  <c:v>-0.69488781690597534</c:v>
                </c:pt>
                <c:pt idx="594">
                  <c:v>-0.68706756830215454</c:v>
                </c:pt>
                <c:pt idx="595">
                  <c:v>-0.67924302816390991</c:v>
                </c:pt>
                <c:pt idx="596">
                  <c:v>-0.67141520977020264</c:v>
                </c:pt>
                <c:pt idx="597">
                  <c:v>-0.66358417272567749</c:v>
                </c:pt>
                <c:pt idx="598">
                  <c:v>-0.6557496190071106</c:v>
                </c:pt>
                <c:pt idx="599">
                  <c:v>-0.64791280031204224</c:v>
                </c:pt>
                <c:pt idx="600">
                  <c:v>-0.64007174968719482</c:v>
                </c:pt>
                <c:pt idx="601">
                  <c:v>-0.63222783803939819</c:v>
                </c:pt>
                <c:pt idx="602">
                  <c:v>-0.62437999248504639</c:v>
                </c:pt>
                <c:pt idx="603">
                  <c:v>-0.61652892827987671</c:v>
                </c:pt>
                <c:pt idx="604">
                  <c:v>-0.60867428779602051</c:v>
                </c:pt>
                <c:pt idx="605">
                  <c:v>-0.60081601142883301</c:v>
                </c:pt>
                <c:pt idx="606">
                  <c:v>-0.59295421838760376</c:v>
                </c:pt>
                <c:pt idx="607">
                  <c:v>-0.58508884906768799</c:v>
                </c:pt>
                <c:pt idx="608">
                  <c:v>-0.57721990346908569</c:v>
                </c:pt>
                <c:pt idx="609">
                  <c:v>-0.56934738159179688</c:v>
                </c:pt>
                <c:pt idx="610">
                  <c:v>-0.56147164106369019</c:v>
                </c:pt>
                <c:pt idx="611">
                  <c:v>-0.55359339714050293</c:v>
                </c:pt>
                <c:pt idx="612">
                  <c:v>-0.54571324586868286</c:v>
                </c:pt>
                <c:pt idx="613">
                  <c:v>-0.5378299355506897</c:v>
                </c:pt>
                <c:pt idx="614">
                  <c:v>-0.52994650602340698</c:v>
                </c:pt>
                <c:pt idx="615">
                  <c:v>-0.52205741405487061</c:v>
                </c:pt>
                <c:pt idx="616">
                  <c:v>-0.51416581869125366</c:v>
                </c:pt>
                <c:pt idx="617">
                  <c:v>-0.50626927614212036</c:v>
                </c:pt>
                <c:pt idx="618">
                  <c:v>-0.49837052822113037</c:v>
                </c:pt>
                <c:pt idx="619">
                  <c:v>-0.49046614766120911</c:v>
                </c:pt>
                <c:pt idx="620">
                  <c:v>-0.4825599193572998</c:v>
                </c:pt>
                <c:pt idx="621">
                  <c:v>-0.47464770078659058</c:v>
                </c:pt>
                <c:pt idx="622">
                  <c:v>-0.46673190593719482</c:v>
                </c:pt>
                <c:pt idx="623">
                  <c:v>-0.45881116390228271</c:v>
                </c:pt>
                <c:pt idx="624">
                  <c:v>-0.45088613033294678</c:v>
                </c:pt>
                <c:pt idx="625">
                  <c:v>-0.4429575502872467</c:v>
                </c:pt>
                <c:pt idx="626">
                  <c:v>-0.43502572178840637</c:v>
                </c:pt>
                <c:pt idx="627">
                  <c:v>-0.42708966135978699</c:v>
                </c:pt>
                <c:pt idx="628">
                  <c:v>-0.41914999485015869</c:v>
                </c:pt>
                <c:pt idx="629">
                  <c:v>-0.41120678186416626</c:v>
                </c:pt>
                <c:pt idx="630">
                  <c:v>-0.40325930714607239</c:v>
                </c:pt>
                <c:pt idx="631">
                  <c:v>-0.39530858397483826</c:v>
                </c:pt>
                <c:pt idx="632">
                  <c:v>-0.38735395669937134</c:v>
                </c:pt>
                <c:pt idx="633">
                  <c:v>-0.37939578294754028</c:v>
                </c:pt>
                <c:pt idx="634">
                  <c:v>-0.37143400311470032</c:v>
                </c:pt>
                <c:pt idx="635">
                  <c:v>-0.36346867680549622</c:v>
                </c:pt>
                <c:pt idx="636">
                  <c:v>-0.35549977421760559</c:v>
                </c:pt>
                <c:pt idx="637">
                  <c:v>-0.34752729535102844</c:v>
                </c:pt>
                <c:pt idx="638">
                  <c:v>-0.33955124020576477</c:v>
                </c:pt>
                <c:pt idx="639">
                  <c:v>-0.33157163858413696</c:v>
                </c:pt>
                <c:pt idx="640">
                  <c:v>-0.32358846068382263</c:v>
                </c:pt>
                <c:pt idx="641">
                  <c:v>-0.31560170650482178</c:v>
                </c:pt>
                <c:pt idx="642">
                  <c:v>-0.30761140584945679</c:v>
                </c:pt>
                <c:pt idx="643">
                  <c:v>-0.29961749911308289</c:v>
                </c:pt>
                <c:pt idx="644">
                  <c:v>-0.29162004590034485</c:v>
                </c:pt>
                <c:pt idx="645">
                  <c:v>-0.28361904621124268</c:v>
                </c:pt>
                <c:pt idx="646">
                  <c:v>-0.27561408281326294</c:v>
                </c:pt>
                <c:pt idx="647">
                  <c:v>-0.26760593056678772</c:v>
                </c:pt>
                <c:pt idx="648">
                  <c:v>-0.25959420204162598</c:v>
                </c:pt>
                <c:pt idx="649">
                  <c:v>-0.2515789270401001</c:v>
                </c:pt>
                <c:pt idx="650">
                  <c:v>-0.24355970323085785</c:v>
                </c:pt>
                <c:pt idx="651">
                  <c:v>-0.23553691804409027</c:v>
                </c:pt>
                <c:pt idx="652">
                  <c:v>-0.22751057147979736</c:v>
                </c:pt>
                <c:pt idx="653">
                  <c:v>-0.21948030591011047</c:v>
                </c:pt>
                <c:pt idx="654">
                  <c:v>-0.21144610643386841</c:v>
                </c:pt>
                <c:pt idx="655">
                  <c:v>-0.20340906083583832</c:v>
                </c:pt>
                <c:pt idx="656">
                  <c:v>-0.1953684389591217</c:v>
                </c:pt>
                <c:pt idx="657">
                  <c:v>-0.187323197722435</c:v>
                </c:pt>
                <c:pt idx="658">
                  <c:v>-0.17927402257919312</c:v>
                </c:pt>
                <c:pt idx="659">
                  <c:v>-0.17122200131416321</c:v>
                </c:pt>
                <c:pt idx="660">
                  <c:v>-0.16316604614257813</c:v>
                </c:pt>
                <c:pt idx="661">
                  <c:v>-0.15510617196559906</c:v>
                </c:pt>
                <c:pt idx="662">
                  <c:v>-0.14704309403896332</c:v>
                </c:pt>
                <c:pt idx="663">
                  <c:v>-0.13897643983364105</c:v>
                </c:pt>
                <c:pt idx="664">
                  <c:v>-0.13090622425079346</c:v>
                </c:pt>
                <c:pt idx="665">
                  <c:v>-0.12283279001712799</c:v>
                </c:pt>
                <c:pt idx="666">
                  <c:v>-0.11475579440593719</c:v>
                </c:pt>
                <c:pt idx="667">
                  <c:v>-0.10667522996664047</c:v>
                </c:pt>
                <c:pt idx="668">
                  <c:v>-9.8591454327106476E-2</c:v>
                </c:pt>
                <c:pt idx="669">
                  <c:v>-9.0503759682178497E-2</c:v>
                </c:pt>
                <c:pt idx="670">
                  <c:v>-8.2412853837013245E-2</c:v>
                </c:pt>
                <c:pt idx="671">
                  <c:v>-7.431802898645401E-2</c:v>
                </c:pt>
                <c:pt idx="672">
                  <c:v>-6.6219992935657501E-2</c:v>
                </c:pt>
                <c:pt idx="673">
                  <c:v>-5.8118753135204315E-2</c:v>
                </c:pt>
                <c:pt idx="674">
                  <c:v>-5.0013229250907898E-2</c:v>
                </c:pt>
                <c:pt idx="675">
                  <c:v>-4.1904497891664505E-2</c:v>
                </c:pt>
                <c:pt idx="676">
                  <c:v>-3.3792205154895782E-2</c:v>
                </c:pt>
                <c:pt idx="677">
                  <c:v>-2.5676701217889786E-2</c:v>
                </c:pt>
                <c:pt idx="678">
                  <c:v>-1.7556920647621155E-2</c:v>
                </c:pt>
                <c:pt idx="679">
                  <c:v>-9.4335740432143211E-3</c:v>
                </c:pt>
                <c:pt idx="680">
                  <c:v>-1.3070205459371209E-3</c:v>
                </c:pt>
                <c:pt idx="681">
                  <c:v>6.8241707049310207E-3</c:v>
                </c:pt>
                <c:pt idx="682">
                  <c:v>1.4958926476538181E-2</c:v>
                </c:pt>
                <c:pt idx="683">
                  <c:v>2.3097606375813484E-2</c:v>
                </c:pt>
                <c:pt idx="684">
                  <c:v>3.1240208074450493E-2</c:v>
                </c:pt>
                <c:pt idx="685">
                  <c:v>3.9387449622154236E-2</c:v>
                </c:pt>
                <c:pt idx="686">
                  <c:v>4.7537900507450104E-2</c:v>
                </c:pt>
                <c:pt idx="687">
                  <c:v>5.5693354457616806E-2</c:v>
                </c:pt>
                <c:pt idx="688">
                  <c:v>6.3852369785308838E-2</c:v>
                </c:pt>
                <c:pt idx="689">
                  <c:v>7.2016030550003052E-2</c:v>
                </c:pt>
                <c:pt idx="690">
                  <c:v>8.0183625221252441E-2</c:v>
                </c:pt>
                <c:pt idx="691">
                  <c:v>8.8356219232082367E-2</c:v>
                </c:pt>
                <c:pt idx="692">
                  <c:v>9.6533820033073425E-2</c:v>
                </c:pt>
                <c:pt idx="693">
                  <c:v>0.10471678525209427</c:v>
                </c:pt>
                <c:pt idx="694">
                  <c:v>0.11290440708398819</c:v>
                </c:pt>
                <c:pt idx="695">
                  <c:v>0.12109632045030594</c:v>
                </c:pt>
                <c:pt idx="696">
                  <c:v>0.12929433584213257</c:v>
                </c:pt>
                <c:pt idx="697">
                  <c:v>0.13749590516090393</c:v>
                </c:pt>
                <c:pt idx="698">
                  <c:v>0.14570215344429016</c:v>
                </c:pt>
                <c:pt idx="699">
                  <c:v>0.15391376614570618</c:v>
                </c:pt>
                <c:pt idx="700">
                  <c:v>0.16212968528270721</c:v>
                </c:pt>
                <c:pt idx="701">
                  <c:v>0.17035025358200073</c:v>
                </c:pt>
                <c:pt idx="702">
                  <c:v>0.17857405543327332</c:v>
                </c:pt>
                <c:pt idx="703">
                  <c:v>0.18680250644683838</c:v>
                </c:pt>
                <c:pt idx="704">
                  <c:v>0.19503454864025116</c:v>
                </c:pt>
                <c:pt idx="705">
                  <c:v>0.20327123999595642</c:v>
                </c:pt>
                <c:pt idx="706">
                  <c:v>0.2115107923746109</c:v>
                </c:pt>
                <c:pt idx="707">
                  <c:v>0.21975319087505341</c:v>
                </c:pt>
                <c:pt idx="708">
                  <c:v>0.22799953818321228</c:v>
                </c:pt>
                <c:pt idx="709">
                  <c:v>0.23625019192695618</c:v>
                </c:pt>
                <c:pt idx="710">
                  <c:v>0.2445036917924881</c:v>
                </c:pt>
                <c:pt idx="711">
                  <c:v>0.2527611255645752</c:v>
                </c:pt>
                <c:pt idx="712">
                  <c:v>0.26102179288864136</c:v>
                </c:pt>
                <c:pt idx="713">
                  <c:v>0.2692863941192627</c:v>
                </c:pt>
                <c:pt idx="714">
                  <c:v>0.27755239605903625</c:v>
                </c:pt>
                <c:pt idx="715">
                  <c:v>0.28582450747489929</c:v>
                </c:pt>
                <c:pt idx="716">
                  <c:v>0.2940983772277832</c:v>
                </c:pt>
                <c:pt idx="717">
                  <c:v>0.30237764120101929</c:v>
                </c:pt>
                <c:pt idx="718">
                  <c:v>0.31065976619720459</c:v>
                </c:pt>
                <c:pt idx="719">
                  <c:v>0.31894618272781372</c:v>
                </c:pt>
                <c:pt idx="720">
                  <c:v>0.32723656296730042</c:v>
                </c:pt>
                <c:pt idx="721">
                  <c:v>0.33553013205528259</c:v>
                </c:pt>
                <c:pt idx="722">
                  <c:v>0.34382656216621399</c:v>
                </c:pt>
                <c:pt idx="723">
                  <c:v>0.35212728381156921</c:v>
                </c:pt>
                <c:pt idx="724">
                  <c:v>0.360431969165802</c:v>
                </c:pt>
                <c:pt idx="725">
                  <c:v>0.36873948574066162</c:v>
                </c:pt>
                <c:pt idx="726">
                  <c:v>0.37705057859420776</c:v>
                </c:pt>
                <c:pt idx="727">
                  <c:v>0.38536599278450012</c:v>
                </c:pt>
                <c:pt idx="728">
                  <c:v>0.39368495345115662</c:v>
                </c:pt>
                <c:pt idx="729">
                  <c:v>0.40200752019882202</c:v>
                </c:pt>
                <c:pt idx="730">
                  <c:v>0.41033181548118591</c:v>
                </c:pt>
                <c:pt idx="731">
                  <c:v>0.41865968704223633</c:v>
                </c:pt>
                <c:pt idx="732">
                  <c:v>0.42699223756790161</c:v>
                </c:pt>
                <c:pt idx="733">
                  <c:v>0.43532726168632507</c:v>
                </c:pt>
                <c:pt idx="734">
                  <c:v>0.44366621971130371</c:v>
                </c:pt>
                <c:pt idx="735">
                  <c:v>0.45200949907302856</c:v>
                </c:pt>
                <c:pt idx="736">
                  <c:v>0.46035489439964294</c:v>
                </c:pt>
                <c:pt idx="737">
                  <c:v>0.46870458126068115</c:v>
                </c:pt>
                <c:pt idx="738">
                  <c:v>0.47705599665641785</c:v>
                </c:pt>
                <c:pt idx="739">
                  <c:v>0.4854128360748291</c:v>
                </c:pt>
                <c:pt idx="740">
                  <c:v>0.4937717616558075</c:v>
                </c:pt>
                <c:pt idx="741">
                  <c:v>0.50213319063186646</c:v>
                </c:pt>
                <c:pt idx="742">
                  <c:v>0.51049888134002686</c:v>
                </c:pt>
                <c:pt idx="743">
                  <c:v>0.51886707544326782</c:v>
                </c:pt>
                <c:pt idx="744">
                  <c:v>0.52723884582519531</c:v>
                </c:pt>
                <c:pt idx="745">
                  <c:v>0.53561562299728394</c:v>
                </c:pt>
                <c:pt idx="746">
                  <c:v>0.54399526119232178</c:v>
                </c:pt>
                <c:pt idx="747">
                  <c:v>0.55238032341003418</c:v>
                </c:pt>
                <c:pt idx="748">
                  <c:v>0.56076854467391968</c:v>
                </c:pt>
                <c:pt idx="749">
                  <c:v>0.56916040182113647</c:v>
                </c:pt>
                <c:pt idx="750">
                  <c:v>0.57755649089813232</c:v>
                </c:pt>
                <c:pt idx="751">
                  <c:v>0.58595806360244751</c:v>
                </c:pt>
                <c:pt idx="752">
                  <c:v>0.59436172246932983</c:v>
                </c:pt>
                <c:pt idx="753">
                  <c:v>0.60277116298675537</c:v>
                </c:pt>
                <c:pt idx="754">
                  <c:v>0.611183762550354</c:v>
                </c:pt>
                <c:pt idx="755">
                  <c:v>0.61960035562515259</c:v>
                </c:pt>
                <c:pt idx="756">
                  <c:v>0.62802010774612427</c:v>
                </c:pt>
                <c:pt idx="757">
                  <c:v>0.6364438533782959</c:v>
                </c:pt>
                <c:pt idx="758">
                  <c:v>0.6448708176612854</c:v>
                </c:pt>
                <c:pt idx="759">
                  <c:v>0.65330201387405396</c:v>
                </c:pt>
                <c:pt idx="760">
                  <c:v>0.66173684597015381</c:v>
                </c:pt>
                <c:pt idx="761">
                  <c:v>0.67017525434494019</c:v>
                </c:pt>
                <c:pt idx="762">
                  <c:v>0.67861717939376831</c:v>
                </c:pt>
                <c:pt idx="763">
                  <c:v>0.68706274032592773</c:v>
                </c:pt>
                <c:pt idx="764">
                  <c:v>0.69551181793212891</c:v>
                </c:pt>
                <c:pt idx="765">
                  <c:v>0.70396453142166138</c:v>
                </c:pt>
                <c:pt idx="766">
                  <c:v>0.7124207615852356</c:v>
                </c:pt>
                <c:pt idx="767">
                  <c:v>0.72088062763214111</c:v>
                </c:pt>
                <c:pt idx="768">
                  <c:v>0.72934401035308838</c:v>
                </c:pt>
                <c:pt idx="769">
                  <c:v>0.73781096935272217</c:v>
                </c:pt>
                <c:pt idx="770">
                  <c:v>0.74628150463104248</c:v>
                </c:pt>
                <c:pt idx="771">
                  <c:v>0.75475603342056274</c:v>
                </c:pt>
                <c:pt idx="772">
                  <c:v>0.7632337212562561</c:v>
                </c:pt>
                <c:pt idx="773">
                  <c:v>0.77171534299850464</c:v>
                </c:pt>
                <c:pt idx="774">
                  <c:v>0.78020018339157104</c:v>
                </c:pt>
                <c:pt idx="775">
                  <c:v>0.78868931531906128</c:v>
                </c:pt>
                <c:pt idx="776">
                  <c:v>0.79718202352523804</c:v>
                </c:pt>
                <c:pt idx="777">
                  <c:v>0.80567872524261475</c:v>
                </c:pt>
                <c:pt idx="778">
                  <c:v>0.81417930126190186</c:v>
                </c:pt>
                <c:pt idx="779">
                  <c:v>0.82268351316452026</c:v>
                </c:pt>
                <c:pt idx="780">
                  <c:v>0.83119165897369385</c:v>
                </c:pt>
                <c:pt idx="781">
                  <c:v>0.83970367908477783</c:v>
                </c:pt>
                <c:pt idx="782">
                  <c:v>0.84821975231170654</c:v>
                </c:pt>
                <c:pt idx="783">
                  <c:v>0.85673969984054565</c:v>
                </c:pt>
                <c:pt idx="784">
                  <c:v>0.8652651309967041</c:v>
                </c:pt>
                <c:pt idx="785">
                  <c:v>0.87379372119903564</c:v>
                </c:pt>
                <c:pt idx="786">
                  <c:v>0.88232702016830444</c:v>
                </c:pt>
                <c:pt idx="787">
                  <c:v>0.89086431264877319</c:v>
                </c:pt>
                <c:pt idx="788">
                  <c:v>0.89940589666366577</c:v>
                </c:pt>
                <c:pt idx="789">
                  <c:v>0.90795063972473145</c:v>
                </c:pt>
                <c:pt idx="790">
                  <c:v>0.91650086641311646</c:v>
                </c:pt>
                <c:pt idx="791">
                  <c:v>0.92505544424057007</c:v>
                </c:pt>
                <c:pt idx="792">
                  <c:v>0.93361622095108032</c:v>
                </c:pt>
                <c:pt idx="793">
                  <c:v>0.94218093156814575</c:v>
                </c:pt>
                <c:pt idx="794">
                  <c:v>0.95074886083602905</c:v>
                </c:pt>
                <c:pt idx="795">
                  <c:v>0.95932412147521973</c:v>
                </c:pt>
                <c:pt idx="796">
                  <c:v>0.96790260076522827</c:v>
                </c:pt>
                <c:pt idx="797">
                  <c:v>0.97648841142654419</c:v>
                </c:pt>
                <c:pt idx="798">
                  <c:v>0.98507779836654663</c:v>
                </c:pt>
                <c:pt idx="799">
                  <c:v>0.99367225170135498</c:v>
                </c:pt>
                <c:pt idx="800">
                  <c:v>1.0022710561752319</c:v>
                </c:pt>
                <c:pt idx="801">
                  <c:v>1.0108742713928223</c:v>
                </c:pt>
                <c:pt idx="802">
                  <c:v>1.0194293260574341</c:v>
                </c:pt>
                <c:pt idx="803">
                  <c:v>1.0279903411865234</c:v>
                </c:pt>
                <c:pt idx="804">
                  <c:v>1.0365548133850098</c:v>
                </c:pt>
                <c:pt idx="805">
                  <c:v>1.0451236963272095</c:v>
                </c:pt>
                <c:pt idx="806">
                  <c:v>1.0536949634552002</c:v>
                </c:pt>
                <c:pt idx="807">
                  <c:v>1.0622694492340088</c:v>
                </c:pt>
                <c:pt idx="808">
                  <c:v>1.0708469152450562</c:v>
                </c:pt>
                <c:pt idx="809">
                  <c:v>1.0794277191162109</c:v>
                </c:pt>
                <c:pt idx="810">
                  <c:v>1.0880115032196045</c:v>
                </c:pt>
                <c:pt idx="811">
                  <c:v>1.0965980291366577</c:v>
                </c:pt>
                <c:pt idx="812">
                  <c:v>1.1051877737045288</c:v>
                </c:pt>
                <c:pt idx="813">
                  <c:v>1.1137800216674805</c:v>
                </c:pt>
                <c:pt idx="814">
                  <c:v>1.1223745346069336</c:v>
                </c:pt>
                <c:pt idx="815">
                  <c:v>1.1309720277786255</c:v>
                </c:pt>
                <c:pt idx="816">
                  <c:v>1.1395719051361084</c:v>
                </c:pt>
                <c:pt idx="817">
                  <c:v>1.1481740474700928</c:v>
                </c:pt>
                <c:pt idx="818">
                  <c:v>1.1567785739898682</c:v>
                </c:pt>
                <c:pt idx="819">
                  <c:v>1.1653852462768555</c:v>
                </c:pt>
                <c:pt idx="820">
                  <c:v>1.1739940643310547</c:v>
                </c:pt>
                <c:pt idx="821">
                  <c:v>1.1826049089431763</c:v>
                </c:pt>
                <c:pt idx="822">
                  <c:v>1.1912177801132202</c:v>
                </c:pt>
                <c:pt idx="823">
                  <c:v>1.1998324394226074</c:v>
                </c:pt>
                <c:pt idx="824">
                  <c:v>1.2084490060806274</c:v>
                </c:pt>
                <c:pt idx="825">
                  <c:v>1.2170672416687012</c:v>
                </c:pt>
                <c:pt idx="826">
                  <c:v>1.2256871461868286</c:v>
                </c:pt>
                <c:pt idx="827">
                  <c:v>1.2343087196350098</c:v>
                </c:pt>
                <c:pt idx="828">
                  <c:v>1.2429317235946655</c:v>
                </c:pt>
                <c:pt idx="829">
                  <c:v>1.2515561580657959</c:v>
                </c:pt>
                <c:pt idx="830">
                  <c:v>1.2601819038391113</c:v>
                </c:pt>
                <c:pt idx="831">
                  <c:v>1.2688089609146118</c:v>
                </c:pt>
                <c:pt idx="832">
                  <c:v>1.2774372100830078</c:v>
                </c:pt>
                <c:pt idx="833">
                  <c:v>1.2860666513442993</c:v>
                </c:pt>
                <c:pt idx="834">
                  <c:v>1.2946970462799072</c:v>
                </c:pt>
                <c:pt idx="835">
                  <c:v>1.3033283948898315</c:v>
                </c:pt>
                <c:pt idx="836">
                  <c:v>1.3119606971740723</c:v>
                </c:pt>
                <c:pt idx="837">
                  <c:v>1.3205938339233398</c:v>
                </c:pt>
                <c:pt idx="838">
                  <c:v>1.3292276859283447</c:v>
                </c:pt>
                <c:pt idx="839">
                  <c:v>1.3378621339797974</c:v>
                </c:pt>
                <c:pt idx="840">
                  <c:v>1.3464971780776978</c:v>
                </c:pt>
                <c:pt idx="841">
                  <c:v>1.3551326990127563</c:v>
                </c:pt>
                <c:pt idx="842">
                  <c:v>1.3637690544128418</c:v>
                </c:pt>
                <c:pt idx="843">
                  <c:v>1.3724054098129272</c:v>
                </c:pt>
                <c:pt idx="844">
                  <c:v>1.3810420036315918</c:v>
                </c:pt>
                <c:pt idx="845">
                  <c:v>1.3896788358688354</c:v>
                </c:pt>
                <c:pt idx="846">
                  <c:v>1.3983157873153687</c:v>
                </c:pt>
                <c:pt idx="847">
                  <c:v>1.4069527387619019</c:v>
                </c:pt>
                <c:pt idx="848">
                  <c:v>1.4155900478363037</c:v>
                </c:pt>
                <c:pt idx="849">
                  <c:v>1.4242268800735474</c:v>
                </c:pt>
                <c:pt idx="850">
                  <c:v>1.4328634738922119</c:v>
                </c:pt>
                <c:pt idx="851">
                  <c:v>1.4414998292922974</c:v>
                </c:pt>
                <c:pt idx="852">
                  <c:v>1.4501358270645142</c:v>
                </c:pt>
                <c:pt idx="853">
                  <c:v>1.4587713479995728</c:v>
                </c:pt>
                <c:pt idx="854">
                  <c:v>1.4674065113067627</c:v>
                </c:pt>
                <c:pt idx="855">
                  <c:v>1.4760409593582153</c:v>
                </c:pt>
                <c:pt idx="856">
                  <c:v>1.4846748113632202</c:v>
                </c:pt>
                <c:pt idx="857">
                  <c:v>1.4933079481124878</c:v>
                </c:pt>
                <c:pt idx="858">
                  <c:v>1.5019398927688599</c:v>
                </c:pt>
                <c:pt idx="859">
                  <c:v>1.5105710029602051</c:v>
                </c:pt>
                <c:pt idx="860">
                  <c:v>1.5192010402679443</c:v>
                </c:pt>
                <c:pt idx="861">
                  <c:v>1.5278301239013672</c:v>
                </c:pt>
                <c:pt idx="862">
                  <c:v>1.5364561080932617</c:v>
                </c:pt>
                <c:pt idx="863">
                  <c:v>1.5450822114944458</c:v>
                </c:pt>
                <c:pt idx="864">
                  <c:v>1.5537049770355225</c:v>
                </c:pt>
                <c:pt idx="865">
                  <c:v>1.5623253583908081</c:v>
                </c:pt>
                <c:pt idx="866">
                  <c:v>1.570941686630249</c:v>
                </c:pt>
                <c:pt idx="867">
                  <c:v>1.5795575380325317</c:v>
                </c:pt>
                <c:pt idx="868">
                  <c:v>1.5881658792495728</c:v>
                </c:pt>
                <c:pt idx="869">
                  <c:v>1.5967737436294556</c:v>
                </c:pt>
                <c:pt idx="870">
                  <c:v>1.6053760051727295</c:v>
                </c:pt>
                <c:pt idx="871">
                  <c:v>1.6139764785766602</c:v>
                </c:pt>
                <c:pt idx="872">
                  <c:v>1.6225748062133789</c:v>
                </c:pt>
                <c:pt idx="873">
                  <c:v>1.6311695575714111</c:v>
                </c:pt>
                <c:pt idx="874">
                  <c:v>1.639762282371521</c:v>
                </c:pt>
                <c:pt idx="875">
                  <c:v>1.6483519077301025</c:v>
                </c:pt>
                <c:pt idx="876">
                  <c:v>1.6569387912750244</c:v>
                </c:pt>
                <c:pt idx="877">
                  <c:v>1.6655235290527344</c:v>
                </c:pt>
                <c:pt idx="878">
                  <c:v>1.6741044521331787</c:v>
                </c:pt>
                <c:pt idx="879">
                  <c:v>1.6826825141906738</c:v>
                </c:pt>
                <c:pt idx="880">
                  <c:v>1.691258430480957</c:v>
                </c:pt>
                <c:pt idx="881">
                  <c:v>1.699831485748291</c:v>
                </c:pt>
                <c:pt idx="882">
                  <c:v>1.7084003686904907</c:v>
                </c:pt>
                <c:pt idx="883">
                  <c:v>1.7169665098190308</c:v>
                </c:pt>
                <c:pt idx="884">
                  <c:v>1.7255295515060425</c:v>
                </c:pt>
                <c:pt idx="885">
                  <c:v>1.7340893745422363</c:v>
                </c:pt>
                <c:pt idx="886">
                  <c:v>1.7426453828811646</c:v>
                </c:pt>
                <c:pt idx="887">
                  <c:v>1.751198410987854</c:v>
                </c:pt>
                <c:pt idx="888">
                  <c:v>1.7597476243972778</c:v>
                </c:pt>
                <c:pt idx="889">
                  <c:v>1.7682933807373047</c:v>
                </c:pt>
                <c:pt idx="890">
                  <c:v>1.7768354415893555</c:v>
                </c:pt>
                <c:pt idx="891">
                  <c:v>1.7853745222091675</c:v>
                </c:pt>
                <c:pt idx="892">
                  <c:v>1.7939101457595825</c:v>
                </c:pt>
                <c:pt idx="893">
                  <c:v>1.8024420738220215</c:v>
                </c:pt>
                <c:pt idx="894">
                  <c:v>1.8109703063964844</c:v>
                </c:pt>
                <c:pt idx="895">
                  <c:v>1.8194949626922607</c:v>
                </c:pt>
                <c:pt idx="896">
                  <c:v>1.828015923500061</c:v>
                </c:pt>
                <c:pt idx="897">
                  <c:v>1.8365331888198853</c:v>
                </c:pt>
                <c:pt idx="898">
                  <c:v>1.8450465202331543</c:v>
                </c:pt>
                <c:pt idx="899">
                  <c:v>1.8535559177398682</c:v>
                </c:pt>
                <c:pt idx="900">
                  <c:v>1.8620612621307373</c:v>
                </c:pt>
                <c:pt idx="901">
                  <c:v>1.8705625534057617</c:v>
                </c:pt>
                <c:pt idx="902">
                  <c:v>1.8790593147277832</c:v>
                </c:pt>
                <c:pt idx="903">
                  <c:v>1.8875515460968018</c:v>
                </c:pt>
                <c:pt idx="904">
                  <c:v>1.896038293838501</c:v>
                </c:pt>
                <c:pt idx="905">
                  <c:v>1.9045209884643555</c:v>
                </c:pt>
                <c:pt idx="906">
                  <c:v>1.9129999876022339</c:v>
                </c:pt>
                <c:pt idx="907">
                  <c:v>1.9214733839035034</c:v>
                </c:pt>
                <c:pt idx="908">
                  <c:v>1.9299416542053223</c:v>
                </c:pt>
                <c:pt idx="909">
                  <c:v>1.9384061098098755</c:v>
                </c:pt>
                <c:pt idx="910">
                  <c:v>1.9468635320663452</c:v>
                </c:pt>
                <c:pt idx="911">
                  <c:v>1.9553169012069702</c:v>
                </c:pt>
                <c:pt idx="912">
                  <c:v>1.9637649059295654</c:v>
                </c:pt>
                <c:pt idx="913">
                  <c:v>1.9722083806991577</c:v>
                </c:pt>
                <c:pt idx="914">
                  <c:v>1.9806466102600098</c:v>
                </c:pt>
                <c:pt idx="915">
                  <c:v>1.9890798330307007</c:v>
                </c:pt>
                <c:pt idx="916">
                  <c:v>1.9975063800811768</c:v>
                </c:pt>
                <c:pt idx="917">
                  <c:v>2.005929708480835</c:v>
                </c:pt>
                <c:pt idx="918">
                  <c:v>2.0143475532531738</c:v>
                </c:pt>
                <c:pt idx="919">
                  <c:v>2.0227606296539307</c:v>
                </c:pt>
                <c:pt idx="920">
                  <c:v>2.03116774559021</c:v>
                </c:pt>
                <c:pt idx="921">
                  <c:v>2.0395705699920654</c:v>
                </c:pt>
                <c:pt idx="922">
                  <c:v>2.0479679107666016</c:v>
                </c:pt>
                <c:pt idx="923">
                  <c:v>2.0563607215881348</c:v>
                </c:pt>
                <c:pt idx="924">
                  <c:v>2.0647487640380859</c:v>
                </c:pt>
                <c:pt idx="925">
                  <c:v>2.0731327533721924</c:v>
                </c:pt>
                <c:pt idx="926">
                  <c:v>2.0815126895904541</c:v>
                </c:pt>
                <c:pt idx="927">
                  <c:v>2.0898869037628174</c:v>
                </c:pt>
                <c:pt idx="928">
                  <c:v>2.0982568264007568</c:v>
                </c:pt>
                <c:pt idx="929">
                  <c:v>2.1066246032714844</c:v>
                </c:pt>
                <c:pt idx="930">
                  <c:v>2.1149873733520508</c:v>
                </c:pt>
                <c:pt idx="931">
                  <c:v>2.1233475208282471</c:v>
                </c:pt>
                <c:pt idx="932">
                  <c:v>2.1317031383514404</c:v>
                </c:pt>
                <c:pt idx="933">
                  <c:v>2.1400556564331055</c:v>
                </c:pt>
                <c:pt idx="934">
                  <c:v>2.1484043598175049</c:v>
                </c:pt>
                <c:pt idx="935">
                  <c:v>2.1567506790161133</c:v>
                </c:pt>
                <c:pt idx="936">
                  <c:v>2.1650938987731934</c:v>
                </c:pt>
                <c:pt idx="937">
                  <c:v>2.1734347343444824</c:v>
                </c:pt>
                <c:pt idx="938">
                  <c:v>2.1817710399627686</c:v>
                </c:pt>
                <c:pt idx="939">
                  <c:v>2.1901049613952637</c:v>
                </c:pt>
                <c:pt idx="940">
                  <c:v>2.1984364986419678</c:v>
                </c:pt>
                <c:pt idx="941">
                  <c:v>2.2067651748657227</c:v>
                </c:pt>
                <c:pt idx="942">
                  <c:v>2.2150905132293701</c:v>
                </c:pt>
                <c:pt idx="943">
                  <c:v>2.2234153747558594</c:v>
                </c:pt>
                <c:pt idx="944">
                  <c:v>2.2317366600036621</c:v>
                </c:pt>
                <c:pt idx="945">
                  <c:v>2.240056037902832</c:v>
                </c:pt>
                <c:pt idx="946">
                  <c:v>2.2483735084533691</c:v>
                </c:pt>
                <c:pt idx="947">
                  <c:v>2.2566888332366943</c:v>
                </c:pt>
                <c:pt idx="948">
                  <c:v>2.2650008201599121</c:v>
                </c:pt>
                <c:pt idx="949">
                  <c:v>2.2733132839202881</c:v>
                </c:pt>
                <c:pt idx="950">
                  <c:v>2.2816231250762939</c:v>
                </c:pt>
                <c:pt idx="951">
                  <c:v>2.2899320125579834</c:v>
                </c:pt>
                <c:pt idx="952">
                  <c:v>2.2982380390167236</c:v>
                </c:pt>
                <c:pt idx="953">
                  <c:v>2.3065447807312012</c:v>
                </c:pt>
                <c:pt idx="954">
                  <c:v>2.3148486614227295</c:v>
                </c:pt>
                <c:pt idx="955">
                  <c:v>2.3231534957885742</c:v>
                </c:pt>
                <c:pt idx="956">
                  <c:v>2.331456184387207</c:v>
                </c:pt>
                <c:pt idx="957">
                  <c:v>2.3397591114044189</c:v>
                </c:pt>
                <c:pt idx="958">
                  <c:v>2.3480594158172607</c:v>
                </c:pt>
                <c:pt idx="959">
                  <c:v>2.3563604354858398</c:v>
                </c:pt>
                <c:pt idx="960">
                  <c:v>2.3646612167358398</c:v>
                </c:pt>
                <c:pt idx="961">
                  <c:v>2.3729619979858398</c:v>
                </c:pt>
                <c:pt idx="962">
                  <c:v>2.3812599182128906</c:v>
                </c:pt>
                <c:pt idx="963">
                  <c:v>2.3895602226257324</c:v>
                </c:pt>
                <c:pt idx="964">
                  <c:v>2.3978602886199951</c:v>
                </c:pt>
                <c:pt idx="965">
                  <c:v>2.4061603546142578</c:v>
                </c:pt>
                <c:pt idx="966">
                  <c:v>2.4144601821899414</c:v>
                </c:pt>
                <c:pt idx="967">
                  <c:v>2.4227609634399414</c:v>
                </c:pt>
                <c:pt idx="968">
                  <c:v>2.4310615062713623</c:v>
                </c:pt>
                <c:pt idx="969">
                  <c:v>2.4393637180328369</c:v>
                </c:pt>
                <c:pt idx="970">
                  <c:v>2.4476661682128906</c:v>
                </c:pt>
                <c:pt idx="971">
                  <c:v>2.455970287322998</c:v>
                </c:pt>
                <c:pt idx="972">
                  <c:v>2.4642734527587891</c:v>
                </c:pt>
                <c:pt idx="973">
                  <c:v>2.4725782871246338</c:v>
                </c:pt>
                <c:pt idx="974">
                  <c:v>2.4808847904205322</c:v>
                </c:pt>
                <c:pt idx="975">
                  <c:v>2.4891917705535889</c:v>
                </c:pt>
                <c:pt idx="976">
                  <c:v>2.4974997043609619</c:v>
                </c:pt>
                <c:pt idx="977">
                  <c:v>2.5058088302612305</c:v>
                </c:pt>
                <c:pt idx="978">
                  <c:v>2.51412034034729</c:v>
                </c:pt>
                <c:pt idx="979">
                  <c:v>2.5224335193634033</c:v>
                </c:pt>
                <c:pt idx="980">
                  <c:v>2.5307490825653076</c:v>
                </c:pt>
                <c:pt idx="981">
                  <c:v>2.5390660762786865</c:v>
                </c:pt>
                <c:pt idx="982">
                  <c:v>2.5473859310150146</c:v>
                </c:pt>
                <c:pt idx="983">
                  <c:v>2.5557076930999756</c:v>
                </c:pt>
                <c:pt idx="984">
                  <c:v>2.5640318393707275</c:v>
                </c:pt>
                <c:pt idx="985">
                  <c:v>2.5723583698272705</c:v>
                </c:pt>
                <c:pt idx="986">
                  <c:v>2.5806870460510254</c:v>
                </c:pt>
                <c:pt idx="987">
                  <c:v>2.5890183448791504</c:v>
                </c:pt>
                <c:pt idx="988">
                  <c:v>2.5973527431488037</c:v>
                </c:pt>
                <c:pt idx="989">
                  <c:v>2.605689525604248</c:v>
                </c:pt>
                <c:pt idx="990">
                  <c:v>2.6140294075012207</c:v>
                </c:pt>
                <c:pt idx="991">
                  <c:v>2.6223723888397217</c:v>
                </c:pt>
                <c:pt idx="992">
                  <c:v>2.630718469619751</c:v>
                </c:pt>
                <c:pt idx="993">
                  <c:v>2.6390678882598877</c:v>
                </c:pt>
                <c:pt idx="994">
                  <c:v>2.6474204063415527</c:v>
                </c:pt>
                <c:pt idx="995">
                  <c:v>2.6557767391204834</c:v>
                </c:pt>
                <c:pt idx="996">
                  <c:v>2.6641364097595215</c:v>
                </c:pt>
                <c:pt idx="997">
                  <c:v>2.6724998950958252</c:v>
                </c:pt>
                <c:pt idx="998">
                  <c:v>2.6808671951293945</c:v>
                </c:pt>
                <c:pt idx="999">
                  <c:v>2.6892383098602295</c:v>
                </c:pt>
                <c:pt idx="1000">
                  <c:v>2.6976134777069092</c:v>
                </c:pt>
                <c:pt idx="1001">
                  <c:v>2.7059929370880127</c:v>
                </c:pt>
                <c:pt idx="1002">
                  <c:v>2.71437668800354</c:v>
                </c:pt>
                <c:pt idx="1003">
                  <c:v>2.7227647304534912</c:v>
                </c:pt>
                <c:pt idx="1004">
                  <c:v>2.7311573028564453</c:v>
                </c:pt>
                <c:pt idx="1005">
                  <c:v>2.7395544052124023</c:v>
                </c:pt>
                <c:pt idx="1006">
                  <c:v>2.7479562759399414</c:v>
                </c:pt>
                <c:pt idx="1007">
                  <c:v>2.7563631534576416</c:v>
                </c:pt>
                <c:pt idx="1008">
                  <c:v>2.7647747993469238</c:v>
                </c:pt>
                <c:pt idx="1009">
                  <c:v>2.7731914520263672</c:v>
                </c:pt>
                <c:pt idx="1010">
                  <c:v>2.7816135883331299</c:v>
                </c:pt>
                <c:pt idx="1011">
                  <c:v>2.7900407314300537</c:v>
                </c:pt>
                <c:pt idx="1012">
                  <c:v>2.7984733581542969</c:v>
                </c:pt>
                <c:pt idx="1013">
                  <c:v>2.8069114685058594</c:v>
                </c:pt>
                <c:pt idx="1014">
                  <c:v>2.8153553009033203</c:v>
                </c:pt>
                <c:pt idx="1015">
                  <c:v>2.8238048553466797</c:v>
                </c:pt>
                <c:pt idx="1016">
                  <c:v>2.8322601318359375</c:v>
                </c:pt>
                <c:pt idx="1017">
                  <c:v>2.840721607208252</c:v>
                </c:pt>
                <c:pt idx="1018">
                  <c:v>2.8491890430450439</c:v>
                </c:pt>
                <c:pt idx="1019">
                  <c:v>2.8576626777648926</c:v>
                </c:pt>
                <c:pt idx="1020">
                  <c:v>2.8661425113677979</c:v>
                </c:pt>
                <c:pt idx="1021">
                  <c:v>2.8746287822723389</c:v>
                </c:pt>
                <c:pt idx="1022">
                  <c:v>2.8831217288970947</c:v>
                </c:pt>
                <c:pt idx="1023">
                  <c:v>2.8916213512420654</c:v>
                </c:pt>
                <c:pt idx="1024">
                  <c:v>2.900127649307251</c:v>
                </c:pt>
                <c:pt idx="1025">
                  <c:v>2.9086408615112305</c:v>
                </c:pt>
                <c:pt idx="1026">
                  <c:v>2.9171609878540039</c:v>
                </c:pt>
                <c:pt idx="1027">
                  <c:v>2.9256882667541504</c:v>
                </c:pt>
                <c:pt idx="1028">
                  <c:v>2.9342226982116699</c:v>
                </c:pt>
                <c:pt idx="1029">
                  <c:v>2.9427645206451416</c:v>
                </c:pt>
                <c:pt idx="1030">
                  <c:v>2.9513137340545654</c:v>
                </c:pt>
                <c:pt idx="1031">
                  <c:v>2.9598705768585205</c:v>
                </c:pt>
                <c:pt idx="1032">
                  <c:v>2.968435525894165</c:v>
                </c:pt>
                <c:pt idx="1033">
                  <c:v>2.9770076274871826</c:v>
                </c:pt>
                <c:pt idx="1034">
                  <c:v>2.9855878353118896</c:v>
                </c:pt>
                <c:pt idx="1035">
                  <c:v>2.994175910949707</c:v>
                </c:pt>
                <c:pt idx="1036">
                  <c:v>3.002772331237793</c:v>
                </c:pt>
                <c:pt idx="1037">
                  <c:v>3.0113766193389893</c:v>
                </c:pt>
                <c:pt idx="1038">
                  <c:v>3.0199892520904541</c:v>
                </c:pt>
                <c:pt idx="1039">
                  <c:v>3.0286102294921875</c:v>
                </c:pt>
                <c:pt idx="1040">
                  <c:v>3.0372397899627686</c:v>
                </c:pt>
                <c:pt idx="1041">
                  <c:v>3.0458774566650391</c:v>
                </c:pt>
                <c:pt idx="1042">
                  <c:v>3.0545227527618408</c:v>
                </c:pt>
                <c:pt idx="1043">
                  <c:v>3.0631763935089111</c:v>
                </c:pt>
                <c:pt idx="1044">
                  <c:v>3.0718379020690918</c:v>
                </c:pt>
                <c:pt idx="1045">
                  <c:v>3.0805087089538574</c:v>
                </c:pt>
                <c:pt idx="1046">
                  <c:v>3.0891866683959961</c:v>
                </c:pt>
                <c:pt idx="1047">
                  <c:v>3.0978739261627197</c:v>
                </c:pt>
                <c:pt idx="1048">
                  <c:v>3.1065680980682373</c:v>
                </c:pt>
                <c:pt idx="1049">
                  <c:v>3.1152713298797607</c:v>
                </c:pt>
                <c:pt idx="1050">
                  <c:v>3.1239819526672363</c:v>
                </c:pt>
                <c:pt idx="1051">
                  <c:v>3.1327013969421387</c:v>
                </c:pt>
                <c:pt idx="1052">
                  <c:v>3.1414284706115723</c:v>
                </c:pt>
                <c:pt idx="1053">
                  <c:v>3.1501646041870117</c:v>
                </c:pt>
                <c:pt idx="1054">
                  <c:v>3.1589088439941406</c:v>
                </c:pt>
                <c:pt idx="1055">
                  <c:v>3.167661190032959</c:v>
                </c:pt>
                <c:pt idx="1056">
                  <c:v>3.1764211654663086</c:v>
                </c:pt>
                <c:pt idx="1057">
                  <c:v>3.1851890087127686</c:v>
                </c:pt>
                <c:pt idx="1058">
                  <c:v>3.1939647197723389</c:v>
                </c:pt>
                <c:pt idx="1059">
                  <c:v>3.2027490139007568</c:v>
                </c:pt>
                <c:pt idx="1060">
                  <c:v>3.2115411758422852</c:v>
                </c:pt>
                <c:pt idx="1061">
                  <c:v>3.220341682434082</c:v>
                </c:pt>
                <c:pt idx="1062">
                  <c:v>3.2291498184204102</c:v>
                </c:pt>
                <c:pt idx="1063">
                  <c:v>3.2379672527313232</c:v>
                </c:pt>
                <c:pt idx="1064">
                  <c:v>3.2467913627624512</c:v>
                </c:pt>
                <c:pt idx="1065">
                  <c:v>3.2556238174438477</c:v>
                </c:pt>
                <c:pt idx="1066">
                  <c:v>3.2644646167755127</c:v>
                </c:pt>
                <c:pt idx="1067">
                  <c:v>3.2733142375946045</c:v>
                </c:pt>
                <c:pt idx="1068">
                  <c:v>3.2821712493896484</c:v>
                </c:pt>
                <c:pt idx="1069">
                  <c:v>3.2910370826721191</c:v>
                </c:pt>
                <c:pt idx="1070">
                  <c:v>3.2999100685119629</c:v>
                </c:pt>
                <c:pt idx="1071">
                  <c:v>3.3087911605834961</c:v>
                </c:pt>
                <c:pt idx="1072">
                  <c:v>3.3176803588867188</c:v>
                </c:pt>
                <c:pt idx="1073">
                  <c:v>3.32657790184021</c:v>
                </c:pt>
                <c:pt idx="1074">
                  <c:v>3.3354830741882324</c:v>
                </c:pt>
                <c:pt idx="1075">
                  <c:v>3.3443973064422607</c:v>
                </c:pt>
                <c:pt idx="1076">
                  <c:v>3.353318452835083</c:v>
                </c:pt>
                <c:pt idx="1077">
                  <c:v>3.3622481822967529</c:v>
                </c:pt>
                <c:pt idx="1078">
                  <c:v>3.3711857795715332</c:v>
                </c:pt>
                <c:pt idx="1079">
                  <c:v>3.380131721496582</c:v>
                </c:pt>
                <c:pt idx="1080">
                  <c:v>3.3890855312347412</c:v>
                </c:pt>
                <c:pt idx="1081">
                  <c:v>3.398047924041748</c:v>
                </c:pt>
                <c:pt idx="1082">
                  <c:v>3.4070174694061279</c:v>
                </c:pt>
                <c:pt idx="1083">
                  <c:v>3.415996789932251</c:v>
                </c:pt>
                <c:pt idx="1084">
                  <c:v>3.4249827861785889</c:v>
                </c:pt>
                <c:pt idx="1085">
                  <c:v>3.4339776039123535</c:v>
                </c:pt>
                <c:pt idx="1086">
                  <c:v>3.442979097366333</c:v>
                </c:pt>
                <c:pt idx="1087">
                  <c:v>3.4519894123077393</c:v>
                </c:pt>
                <c:pt idx="1088">
                  <c:v>3.4610068798065186</c:v>
                </c:pt>
                <c:pt idx="1089">
                  <c:v>3.470034122467041</c:v>
                </c:pt>
                <c:pt idx="1090">
                  <c:v>3.4790678024291992</c:v>
                </c:pt>
                <c:pt idx="1091">
                  <c:v>3.4881107807159424</c:v>
                </c:pt>
                <c:pt idx="1092">
                  <c:v>3.4971604347229004</c:v>
                </c:pt>
                <c:pt idx="1093">
                  <c:v>3.5062189102172852</c:v>
                </c:pt>
                <c:pt idx="1094">
                  <c:v>3.5152852535247803</c:v>
                </c:pt>
                <c:pt idx="1095">
                  <c:v>3.5243592262268066</c:v>
                </c:pt>
                <c:pt idx="1096">
                  <c:v>3.5334405899047852</c:v>
                </c:pt>
                <c:pt idx="1097">
                  <c:v>3.5425307750701904</c:v>
                </c:pt>
                <c:pt idx="1098">
                  <c:v>3.5516276359558105</c:v>
                </c:pt>
                <c:pt idx="1099">
                  <c:v>3.5607337951660156</c:v>
                </c:pt>
                <c:pt idx="1100">
                  <c:v>3.569847583770752</c:v>
                </c:pt>
                <c:pt idx="1101">
                  <c:v>3.5789687633514404</c:v>
                </c:pt>
                <c:pt idx="1102">
                  <c:v>3.5880975723266602</c:v>
                </c:pt>
                <c:pt idx="1103">
                  <c:v>3.5972356796264648</c:v>
                </c:pt>
                <c:pt idx="1104">
                  <c:v>3.606379508972168</c:v>
                </c:pt>
                <c:pt idx="1105">
                  <c:v>3.6155328750610352</c:v>
                </c:pt>
                <c:pt idx="1106">
                  <c:v>3.6246933937072754</c:v>
                </c:pt>
                <c:pt idx="1107">
                  <c:v>3.6338624954223633</c:v>
                </c:pt>
                <c:pt idx="1108">
                  <c:v>3.6430387496948242</c:v>
                </c:pt>
                <c:pt idx="1109">
                  <c:v>3.6522231101989746</c:v>
                </c:pt>
                <c:pt idx="1110">
                  <c:v>3.6614155769348145</c:v>
                </c:pt>
                <c:pt idx="1111">
                  <c:v>3.670616626739502</c:v>
                </c:pt>
                <c:pt idx="1112">
                  <c:v>3.6798250675201416</c:v>
                </c:pt>
                <c:pt idx="1113">
                  <c:v>3.6890406608581543</c:v>
                </c:pt>
                <c:pt idx="1114">
                  <c:v>3.6982636451721191</c:v>
                </c:pt>
                <c:pt idx="1115">
                  <c:v>3.7074956893920898</c:v>
                </c:pt>
                <c:pt idx="1116">
                  <c:v>3.7167351245880127</c:v>
                </c:pt>
                <c:pt idx="1117">
                  <c:v>3.725982666015625</c:v>
                </c:pt>
                <c:pt idx="1118">
                  <c:v>3.7352371215820313</c:v>
                </c:pt>
                <c:pt idx="1119">
                  <c:v>3.7445003986358643</c:v>
                </c:pt>
                <c:pt idx="1120">
                  <c:v>3.7537710666656494</c:v>
                </c:pt>
                <c:pt idx="1121">
                  <c:v>3.7630505561828613</c:v>
                </c:pt>
                <c:pt idx="1122">
                  <c:v>3.772336483001709</c:v>
                </c:pt>
                <c:pt idx="1123">
                  <c:v>3.7816319465637207</c:v>
                </c:pt>
                <c:pt idx="1124">
                  <c:v>3.7909338474273682</c:v>
                </c:pt>
                <c:pt idx="1125">
                  <c:v>3.8002445697784424</c:v>
                </c:pt>
                <c:pt idx="1126">
                  <c:v>3.8095619678497314</c:v>
                </c:pt>
                <c:pt idx="1127">
                  <c:v>3.8188877105712891</c:v>
                </c:pt>
                <c:pt idx="1128">
                  <c:v>3.828221321105957</c:v>
                </c:pt>
                <c:pt idx="1129">
                  <c:v>3.8375623226165771</c:v>
                </c:pt>
                <c:pt idx="1130">
                  <c:v>3.8469114303588867</c:v>
                </c:pt>
                <c:pt idx="1131">
                  <c:v>3.8562686443328857</c:v>
                </c:pt>
                <c:pt idx="1132">
                  <c:v>3.8656337261199951</c:v>
                </c:pt>
                <c:pt idx="1133">
                  <c:v>3.8750069141387939</c:v>
                </c:pt>
                <c:pt idx="1134">
                  <c:v>3.8843879699707031</c:v>
                </c:pt>
                <c:pt idx="1135">
                  <c:v>3.8937761783599854</c:v>
                </c:pt>
                <c:pt idx="1136">
                  <c:v>3.9031736850738525</c:v>
                </c:pt>
                <c:pt idx="1137">
                  <c:v>3.9125773906707764</c:v>
                </c:pt>
                <c:pt idx="1138">
                  <c:v>3.9219894409179688</c:v>
                </c:pt>
                <c:pt idx="1139">
                  <c:v>3.9314086437225342</c:v>
                </c:pt>
                <c:pt idx="1140">
                  <c:v>3.9408364295959473</c:v>
                </c:pt>
                <c:pt idx="1141">
                  <c:v>3.9502732753753662</c:v>
                </c:pt>
                <c:pt idx="1142">
                  <c:v>3.9597163200378418</c:v>
                </c:pt>
                <c:pt idx="1143">
                  <c:v>3.9691684246063232</c:v>
                </c:pt>
                <c:pt idx="1144">
                  <c:v>3.9786276817321777</c:v>
                </c:pt>
                <c:pt idx="1145">
                  <c:v>3.9880940914154053</c:v>
                </c:pt>
                <c:pt idx="1146">
                  <c:v>3.9975686073303223</c:v>
                </c:pt>
                <c:pt idx="1147">
                  <c:v>4.0070514678955078</c:v>
                </c:pt>
                <c:pt idx="1148">
                  <c:v>4.0165410041809082</c:v>
                </c:pt>
                <c:pt idx="1149">
                  <c:v>4.0260400772094727</c:v>
                </c:pt>
                <c:pt idx="1150">
                  <c:v>4.0355448722839355</c:v>
                </c:pt>
                <c:pt idx="1151">
                  <c:v>4.0450577735900879</c:v>
                </c:pt>
                <c:pt idx="1152">
                  <c:v>4.0545787811279297</c:v>
                </c:pt>
                <c:pt idx="1153">
                  <c:v>4.0641074180603027</c:v>
                </c:pt>
                <c:pt idx="1154">
                  <c:v>4.0736441612243652</c:v>
                </c:pt>
                <c:pt idx="1155">
                  <c:v>4.0831899642944336</c:v>
                </c:pt>
                <c:pt idx="1156">
                  <c:v>4.0927438735961914</c:v>
                </c:pt>
                <c:pt idx="1157">
                  <c:v>4.1023039817810059</c:v>
                </c:pt>
                <c:pt idx="1158">
                  <c:v>4.1118731498718262</c:v>
                </c:pt>
                <c:pt idx="1159">
                  <c:v>4.1214499473571777</c:v>
                </c:pt>
                <c:pt idx="1160">
                  <c:v>4.1310338973999023</c:v>
                </c:pt>
                <c:pt idx="1161">
                  <c:v>4.140625</c:v>
                </c:pt>
                <c:pt idx="1162">
                  <c:v>4.1502256393432617</c:v>
                </c:pt>
                <c:pt idx="1163">
                  <c:v>4.1598329544067383</c:v>
                </c:pt>
                <c:pt idx="1164">
                  <c:v>4.1694483757019043</c:v>
                </c:pt>
                <c:pt idx="1165">
                  <c:v>4.179072380065918</c:v>
                </c:pt>
                <c:pt idx="1166">
                  <c:v>4.1887040138244629</c:v>
                </c:pt>
                <c:pt idx="1167">
                  <c:v>4.1983432769775391</c:v>
                </c:pt>
                <c:pt idx="1168">
                  <c:v>4.2079916000366211</c:v>
                </c:pt>
                <c:pt idx="1169">
                  <c:v>4.2176470756530762</c:v>
                </c:pt>
                <c:pt idx="1170">
                  <c:v>4.2273101806640625</c:v>
                </c:pt>
                <c:pt idx="1171">
                  <c:v>4.2369823455810547</c:v>
                </c:pt>
                <c:pt idx="1172">
                  <c:v>4.2466630935668945</c:v>
                </c:pt>
                <c:pt idx="1173">
                  <c:v>4.2563490867614746</c:v>
                </c:pt>
                <c:pt idx="1174">
                  <c:v>4.2660460472106934</c:v>
                </c:pt>
                <c:pt idx="1175">
                  <c:v>4.275749683380127</c:v>
                </c:pt>
                <c:pt idx="1176">
                  <c:v>4.2854623794555664</c:v>
                </c:pt>
                <c:pt idx="1177">
                  <c:v>4.2951817512512207</c:v>
                </c:pt>
                <c:pt idx="1178">
                  <c:v>4.3049101829528809</c:v>
                </c:pt>
                <c:pt idx="1179">
                  <c:v>4.3146457672119141</c:v>
                </c:pt>
                <c:pt idx="1180">
                  <c:v>4.3243899345397949</c:v>
                </c:pt>
                <c:pt idx="1181">
                  <c:v>4.3341422080993652</c:v>
                </c:pt>
                <c:pt idx="1182">
                  <c:v>4.3439044952392578</c:v>
                </c:pt>
                <c:pt idx="1183">
                  <c:v>4.3536744117736816</c:v>
                </c:pt>
                <c:pt idx="1184">
                  <c:v>4.3634538650512695</c:v>
                </c:pt>
                <c:pt idx="1185">
                  <c:v>4.3732404708862305</c:v>
                </c:pt>
                <c:pt idx="1186">
                  <c:v>4.3830347061157227</c:v>
                </c:pt>
                <c:pt idx="1187">
                  <c:v>4.3928384780883789</c:v>
                </c:pt>
                <c:pt idx="1188">
                  <c:v>4.4026503562927246</c:v>
                </c:pt>
                <c:pt idx="1189">
                  <c:v>4.4124703407287598</c:v>
                </c:pt>
                <c:pt idx="1190">
                  <c:v>4.422299861907959</c:v>
                </c:pt>
                <c:pt idx="1191">
                  <c:v>4.432136058807373</c:v>
                </c:pt>
                <c:pt idx="1192">
                  <c:v>4.4419817924499512</c:v>
                </c:pt>
                <c:pt idx="1193">
                  <c:v>4.4518351554870605</c:v>
                </c:pt>
                <c:pt idx="1194">
                  <c:v>4.4616971015930176</c:v>
                </c:pt>
                <c:pt idx="1195">
                  <c:v>4.4715685844421387</c:v>
                </c:pt>
                <c:pt idx="1196">
                  <c:v>4.4814486503601074</c:v>
                </c:pt>
                <c:pt idx="1197">
                  <c:v>4.4913363456726074</c:v>
                </c:pt>
                <c:pt idx="1198">
                  <c:v>4.5012326240539551</c:v>
                </c:pt>
                <c:pt idx="1199">
                  <c:v>4.5111379623413086</c:v>
                </c:pt>
                <c:pt idx="1200">
                  <c:v>4.521052360534668</c:v>
                </c:pt>
                <c:pt idx="1201">
                  <c:v>4.5309748649597168</c:v>
                </c:pt>
                <c:pt idx="1202">
                  <c:v>4.5409059524536133</c:v>
                </c:pt>
                <c:pt idx="1203">
                  <c:v>4.550844669342041</c:v>
                </c:pt>
                <c:pt idx="1204">
                  <c:v>4.560791015625</c:v>
                </c:pt>
                <c:pt idx="1205">
                  <c:v>4.5707473754882813</c:v>
                </c:pt>
                <c:pt idx="1206">
                  <c:v>4.5807113647460938</c:v>
                </c:pt>
                <c:pt idx="1207">
                  <c:v>4.5906839370727539</c:v>
                </c:pt>
                <c:pt idx="1208">
                  <c:v>4.6006646156311035</c:v>
                </c:pt>
                <c:pt idx="1209">
                  <c:v>4.6106538772583008</c:v>
                </c:pt>
                <c:pt idx="1210">
                  <c:v>4.6206517219543457</c:v>
                </c:pt>
                <c:pt idx="1211">
                  <c:v>4.6306591033935547</c:v>
                </c:pt>
                <c:pt idx="1212">
                  <c:v>4.6406755447387695</c:v>
                </c:pt>
                <c:pt idx="1213">
                  <c:v>4.6507015228271484</c:v>
                </c:pt>
                <c:pt idx="1214">
                  <c:v>4.660733699798584</c:v>
                </c:pt>
                <c:pt idx="1215">
                  <c:v>4.6707758903503418</c:v>
                </c:pt>
                <c:pt idx="1216">
                  <c:v>4.6808252334594727</c:v>
                </c:pt>
                <c:pt idx="1217">
                  <c:v>4.690885066986084</c:v>
                </c:pt>
                <c:pt idx="1218">
                  <c:v>4.700953483581543</c:v>
                </c:pt>
                <c:pt idx="1219">
                  <c:v>4.7110309600830078</c:v>
                </c:pt>
                <c:pt idx="1220">
                  <c:v>4.7211136817932129</c:v>
                </c:pt>
                <c:pt idx="1221">
                  <c:v>4.7312049865722656</c:v>
                </c:pt>
                <c:pt idx="1222">
                  <c:v>4.7413067817687988</c:v>
                </c:pt>
                <c:pt idx="1223">
                  <c:v>4.7514185905456543</c:v>
                </c:pt>
                <c:pt idx="1224">
                  <c:v>4.761538028717041</c:v>
                </c:pt>
                <c:pt idx="1225">
                  <c:v>4.7716670036315918</c:v>
                </c:pt>
                <c:pt idx="1226">
                  <c:v>4.7818050384521484</c:v>
                </c:pt>
                <c:pt idx="1227">
                  <c:v>4.7919511795043945</c:v>
                </c:pt>
                <c:pt idx="1228">
                  <c:v>4.8021073341369629</c:v>
                </c:pt>
                <c:pt idx="1229">
                  <c:v>4.8122744560241699</c:v>
                </c:pt>
                <c:pt idx="1230">
                  <c:v>4.8224482536315918</c:v>
                </c:pt>
                <c:pt idx="1231">
                  <c:v>4.8326311111450195</c:v>
                </c:pt>
                <c:pt idx="1232">
                  <c:v>4.8428201675415039</c:v>
                </c:pt>
                <c:pt idx="1233">
                  <c:v>4.853020191192627</c:v>
                </c:pt>
                <c:pt idx="1234">
                  <c:v>4.8632297515869141</c:v>
                </c:pt>
                <c:pt idx="1235">
                  <c:v>4.873448371887207</c:v>
                </c:pt>
                <c:pt idx="1236">
                  <c:v>4.8836746215820313</c:v>
                </c:pt>
                <c:pt idx="1237">
                  <c:v>4.8939132690429688</c:v>
                </c:pt>
                <c:pt idx="1238">
                  <c:v>4.9041571617126465</c:v>
                </c:pt>
                <c:pt idx="1239">
                  <c:v>4.9144120216369629</c:v>
                </c:pt>
                <c:pt idx="1240">
                  <c:v>4.9246745109558105</c:v>
                </c:pt>
                <c:pt idx="1241">
                  <c:v>4.9349460601806641</c:v>
                </c:pt>
                <c:pt idx="1242">
                  <c:v>4.9452271461486816</c:v>
                </c:pt>
                <c:pt idx="1243">
                  <c:v>4.9555191993713379</c:v>
                </c:pt>
                <c:pt idx="1244">
                  <c:v>4.965817928314209</c:v>
                </c:pt>
                <c:pt idx="1245">
                  <c:v>4.9761261940002441</c:v>
                </c:pt>
                <c:pt idx="1246">
                  <c:v>4.986443042755127</c:v>
                </c:pt>
                <c:pt idx="1247">
                  <c:v>4.9967694282531738</c:v>
                </c:pt>
                <c:pt idx="1248">
                  <c:v>5.0071039199829102</c:v>
                </c:pt>
                <c:pt idx="1249">
                  <c:v>5.0174493789672852</c:v>
                </c:pt>
                <c:pt idx="1250">
                  <c:v>5.0278029441833496</c:v>
                </c:pt>
                <c:pt idx="1251">
                  <c:v>5.0381650924682617</c:v>
                </c:pt>
                <c:pt idx="1252">
                  <c:v>5.0485358238220215</c:v>
                </c:pt>
                <c:pt idx="1253">
                  <c:v>5.0589151382446289</c:v>
                </c:pt>
                <c:pt idx="1254">
                  <c:v>5.0693020820617676</c:v>
                </c:pt>
                <c:pt idx="1255">
                  <c:v>5.0796990394592285</c:v>
                </c:pt>
                <c:pt idx="1256">
                  <c:v>5.0901036262512207</c:v>
                </c:pt>
                <c:pt idx="1257">
                  <c:v>5.1005172729492188</c:v>
                </c:pt>
                <c:pt idx="1258">
                  <c:v>5.1109390258789063</c:v>
                </c:pt>
                <c:pt idx="1259">
                  <c:v>5.1213693618774414</c:v>
                </c:pt>
                <c:pt idx="1260">
                  <c:v>5.1318087577819824</c:v>
                </c:pt>
                <c:pt idx="1261">
                  <c:v>5.1422548294067383</c:v>
                </c:pt>
                <c:pt idx="1262">
                  <c:v>5.1527094841003418</c:v>
                </c:pt>
                <c:pt idx="1263">
                  <c:v>5.163172721862793</c:v>
                </c:pt>
                <c:pt idx="1264">
                  <c:v>5.1736431121826172</c:v>
                </c:pt>
                <c:pt idx="1265">
                  <c:v>5.1841230392456055</c:v>
                </c:pt>
                <c:pt idx="1266">
                  <c:v>5.194610595703125</c:v>
                </c:pt>
                <c:pt idx="1267">
                  <c:v>5.205106258392334</c:v>
                </c:pt>
                <c:pt idx="1268">
                  <c:v>5.2156100273132324</c:v>
                </c:pt>
                <c:pt idx="1269">
                  <c:v>5.2261223793029785</c:v>
                </c:pt>
                <c:pt idx="1270">
                  <c:v>5.2366423606872559</c:v>
                </c:pt>
                <c:pt idx="1271">
                  <c:v>5.2471704483032227</c:v>
                </c:pt>
                <c:pt idx="1272">
                  <c:v>5.2577052116394043</c:v>
                </c:pt>
                <c:pt idx="1273">
                  <c:v>5.2682490348815918</c:v>
                </c:pt>
                <c:pt idx="1274">
                  <c:v>5.2787995338439941</c:v>
                </c:pt>
                <c:pt idx="1275">
                  <c:v>5.2893576622009277</c:v>
                </c:pt>
                <c:pt idx="1276">
                  <c:v>5.2999238967895508</c:v>
                </c:pt>
                <c:pt idx="1277">
                  <c:v>5.3104982376098633</c:v>
                </c:pt>
                <c:pt idx="1278">
                  <c:v>5.3210797309875488</c:v>
                </c:pt>
                <c:pt idx="1279">
                  <c:v>5.3316688537597656</c:v>
                </c:pt>
                <c:pt idx="1280">
                  <c:v>5.3422656059265137</c:v>
                </c:pt>
                <c:pt idx="1281">
                  <c:v>5.3528695106506348</c:v>
                </c:pt>
                <c:pt idx="1282">
                  <c:v>5.3634805679321289</c:v>
                </c:pt>
                <c:pt idx="1283">
                  <c:v>5.3740992546081543</c:v>
                </c:pt>
                <c:pt idx="1284">
                  <c:v>5.3847255706787109</c:v>
                </c:pt>
                <c:pt idx="1285">
                  <c:v>5.3953585624694824</c:v>
                </c:pt>
                <c:pt idx="1286">
                  <c:v>5.4059991836547852</c:v>
                </c:pt>
                <c:pt idx="1287">
                  <c:v>5.4166469573974609</c:v>
                </c:pt>
                <c:pt idx="1288">
                  <c:v>5.4273018836975098</c:v>
                </c:pt>
                <c:pt idx="1289">
                  <c:v>5.4379634857177734</c:v>
                </c:pt>
                <c:pt idx="1290">
                  <c:v>5.4486327171325684</c:v>
                </c:pt>
                <c:pt idx="1291">
                  <c:v>5.4593086242675781</c:v>
                </c:pt>
                <c:pt idx="1292">
                  <c:v>5.4699912071228027</c:v>
                </c:pt>
                <c:pt idx="1293">
                  <c:v>5.4806809425354004</c:v>
                </c:pt>
                <c:pt idx="1294">
                  <c:v>5.4913778305053711</c:v>
                </c:pt>
                <c:pt idx="1295">
                  <c:v>5.5020813941955566</c:v>
                </c:pt>
                <c:pt idx="1296">
                  <c:v>5.512791633605957</c:v>
                </c:pt>
                <c:pt idx="1297">
                  <c:v>5.5235085487365723</c:v>
                </c:pt>
                <c:pt idx="1298">
                  <c:v>5.5342321395874023</c:v>
                </c:pt>
                <c:pt idx="1299">
                  <c:v>5.5449628829956055</c:v>
                </c:pt>
                <c:pt idx="1300">
                  <c:v>5.5556998252868652</c:v>
                </c:pt>
                <c:pt idx="1301">
                  <c:v>5.5664434432983398</c:v>
                </c:pt>
                <c:pt idx="1302">
                  <c:v>5.5771937370300293</c:v>
                </c:pt>
                <c:pt idx="1303">
                  <c:v>5.5879502296447754</c:v>
                </c:pt>
                <c:pt idx="1304">
                  <c:v>5.5987133979797363</c:v>
                </c:pt>
                <c:pt idx="1305">
                  <c:v>5.6094827651977539</c:v>
                </c:pt>
                <c:pt idx="1306">
                  <c:v>5.6202588081359863</c:v>
                </c:pt>
                <c:pt idx="1307">
                  <c:v>5.6310410499572754</c:v>
                </c:pt>
                <c:pt idx="1308">
                  <c:v>5.6418299674987793</c:v>
                </c:pt>
                <c:pt idx="1309">
                  <c:v>5.6526246070861816</c:v>
                </c:pt>
                <c:pt idx="1310">
                  <c:v>5.6634254455566406</c:v>
                </c:pt>
                <c:pt idx="1311">
                  <c:v>5.6742329597473145</c:v>
                </c:pt>
                <c:pt idx="1312">
                  <c:v>5.6850461959838867</c:v>
                </c:pt>
                <c:pt idx="1313">
                  <c:v>5.6958656311035156</c:v>
                </c:pt>
                <c:pt idx="1314">
                  <c:v>5.7066912651062012</c:v>
                </c:pt>
                <c:pt idx="1315">
                  <c:v>5.7175226211547852</c:v>
                </c:pt>
                <c:pt idx="1316">
                  <c:v>5.7283601760864258</c:v>
                </c:pt>
                <c:pt idx="1317">
                  <c:v>5.7392034530639648</c:v>
                </c:pt>
                <c:pt idx="1318">
                  <c:v>5.7500524520874023</c:v>
                </c:pt>
                <c:pt idx="1319">
                  <c:v>5.7609076499938965</c:v>
                </c:pt>
                <c:pt idx="1320">
                  <c:v>5.7717685699462891</c:v>
                </c:pt>
                <c:pt idx="1321">
                  <c:v>5.7826352119445801</c:v>
                </c:pt>
                <c:pt idx="1322">
                  <c:v>5.7935075759887695</c:v>
                </c:pt>
                <c:pt idx="1323">
                  <c:v>5.8043856620788574</c:v>
                </c:pt>
                <c:pt idx="1324">
                  <c:v>5.8152694702148438</c:v>
                </c:pt>
                <c:pt idx="1325">
                  <c:v>5.8261585235595703</c:v>
                </c:pt>
                <c:pt idx="1326">
                  <c:v>5.8370537757873535</c:v>
                </c:pt>
                <c:pt idx="1327">
                  <c:v>5.8479537963867188</c:v>
                </c:pt>
                <c:pt idx="1328">
                  <c:v>5.8588595390319824</c:v>
                </c:pt>
                <c:pt idx="1329">
                  <c:v>5.8697710037231445</c:v>
                </c:pt>
                <c:pt idx="1330">
                  <c:v>5.8806881904602051</c:v>
                </c:pt>
                <c:pt idx="1331">
                  <c:v>5.8916106224060059</c:v>
                </c:pt>
                <c:pt idx="1332">
                  <c:v>5.9025387763977051</c:v>
                </c:pt>
                <c:pt idx="1333">
                  <c:v>5.9134716987609863</c:v>
                </c:pt>
                <c:pt idx="1334">
                  <c:v>5.924410343170166</c:v>
                </c:pt>
                <c:pt idx="1335">
                  <c:v>5.9353547096252441</c:v>
                </c:pt>
                <c:pt idx="1336">
                  <c:v>5.9463024139404297</c:v>
                </c:pt>
                <c:pt idx="1337">
                  <c:v>5.9572558403015137</c:v>
                </c:pt>
                <c:pt idx="1338">
                  <c:v>5.9682149887084961</c:v>
                </c:pt>
                <c:pt idx="1339">
                  <c:v>5.979179859161377</c:v>
                </c:pt>
                <c:pt idx="1340">
                  <c:v>5.9901485443115234</c:v>
                </c:pt>
                <c:pt idx="1341">
                  <c:v>6.0011224746704102</c:v>
                </c:pt>
                <c:pt idx="1342">
                  <c:v>6.0121011734008789</c:v>
                </c:pt>
                <c:pt idx="1343">
                  <c:v>6.0230860710144043</c:v>
                </c:pt>
                <c:pt idx="1344">
                  <c:v>6.0340747833251953</c:v>
                </c:pt>
                <c:pt idx="1345">
                  <c:v>6.0450687408447266</c:v>
                </c:pt>
                <c:pt idx="1346">
                  <c:v>6.0560665130615234</c:v>
                </c:pt>
                <c:pt idx="1347">
                  <c:v>6.067070484161377</c:v>
                </c:pt>
                <c:pt idx="1348">
                  <c:v>6.0780797004699707</c:v>
                </c:pt>
                <c:pt idx="1349">
                  <c:v>6.0890922546386719</c:v>
                </c:pt>
                <c:pt idx="1350">
                  <c:v>6.1001095771789551</c:v>
                </c:pt>
                <c:pt idx="1351">
                  <c:v>6.1111316680908203</c:v>
                </c:pt>
                <c:pt idx="1352">
                  <c:v>6.1221580505371094</c:v>
                </c:pt>
                <c:pt idx="1353">
                  <c:v>6.1331896781921387</c:v>
                </c:pt>
                <c:pt idx="1354">
                  <c:v>6.1442255973815918</c:v>
                </c:pt>
                <c:pt idx="1355">
                  <c:v>6.1552658081054688</c:v>
                </c:pt>
                <c:pt idx="1356">
                  <c:v>6.1663103103637695</c:v>
                </c:pt>
                <c:pt idx="1357">
                  <c:v>6.1773600578308105</c:v>
                </c:pt>
                <c:pt idx="1358">
                  <c:v>6.188413143157959</c:v>
                </c:pt>
                <c:pt idx="1359">
                  <c:v>6.1994709968566895</c:v>
                </c:pt>
                <c:pt idx="1360">
                  <c:v>6.2105326652526855</c:v>
                </c:pt>
                <c:pt idx="1361">
                  <c:v>6.2215991020202637</c:v>
                </c:pt>
                <c:pt idx="1362">
                  <c:v>6.2326698303222656</c:v>
                </c:pt>
                <c:pt idx="1363">
                  <c:v>6.2437458038330078</c:v>
                </c:pt>
                <c:pt idx="1364">
                  <c:v>6.2548251152038574</c:v>
                </c:pt>
                <c:pt idx="1365">
                  <c:v>6.2659077644348145</c:v>
                </c:pt>
                <c:pt idx="1366">
                  <c:v>6.2769947052001953</c:v>
                </c:pt>
                <c:pt idx="1367">
                  <c:v>6.2880864143371582</c:v>
                </c:pt>
                <c:pt idx="1368">
                  <c:v>6.2991814613342285</c:v>
                </c:pt>
                <c:pt idx="1369">
                  <c:v>6.3102817535400391</c:v>
                </c:pt>
                <c:pt idx="1370">
                  <c:v>6.321385383605957</c:v>
                </c:pt>
                <c:pt idx="1371">
                  <c:v>6.3324933052062988</c:v>
                </c:pt>
                <c:pt idx="1372">
                  <c:v>6.343604564666748</c:v>
                </c:pt>
                <c:pt idx="1373">
                  <c:v>6.3547205924987793</c:v>
                </c:pt>
                <c:pt idx="1374">
                  <c:v>6.3658413887023926</c:v>
                </c:pt>
                <c:pt idx="1375">
                  <c:v>6.3769650459289551</c:v>
                </c:pt>
                <c:pt idx="1376">
                  <c:v>6.3880910873413086</c:v>
                </c:pt>
                <c:pt idx="1377">
                  <c:v>6.3992214202880859</c:v>
                </c:pt>
                <c:pt idx="1378">
                  <c:v>6.4103546142578125</c:v>
                </c:pt>
                <c:pt idx="1379">
                  <c:v>6.4214925765991211</c:v>
                </c:pt>
                <c:pt idx="1380">
                  <c:v>6.4326338768005371</c:v>
                </c:pt>
                <c:pt idx="1381">
                  <c:v>6.443781852722168</c:v>
                </c:pt>
                <c:pt idx="1382">
                  <c:v>6.4549312591552734</c:v>
                </c:pt>
                <c:pt idx="1383">
                  <c:v>6.4660835266113281</c:v>
                </c:pt>
                <c:pt idx="1384">
                  <c:v>6.4772391319274902</c:v>
                </c:pt>
                <c:pt idx="1385">
                  <c:v>6.4883999824523926</c:v>
                </c:pt>
                <c:pt idx="1386">
                  <c:v>6.4995622634887695</c:v>
                </c:pt>
                <c:pt idx="1387">
                  <c:v>6.5107302665710449</c:v>
                </c:pt>
                <c:pt idx="1388">
                  <c:v>6.5219006538391113</c:v>
                </c:pt>
                <c:pt idx="1389">
                  <c:v>6.5330729484558105</c:v>
                </c:pt>
                <c:pt idx="1390">
                  <c:v>6.5442495346069336</c:v>
                </c:pt>
                <c:pt idx="1391">
                  <c:v>6.5554289817810059</c:v>
                </c:pt>
                <c:pt idx="1392">
                  <c:v>6.5666112899780273</c:v>
                </c:pt>
                <c:pt idx="1393">
                  <c:v>6.5777978897094727</c:v>
                </c:pt>
                <c:pt idx="1394">
                  <c:v>6.588986873626709</c:v>
                </c:pt>
                <c:pt idx="1395">
                  <c:v>6.6001801490783691</c:v>
                </c:pt>
                <c:pt idx="1396">
                  <c:v>6.6113753318786621</c:v>
                </c:pt>
                <c:pt idx="1397">
                  <c:v>6.6225748062133789</c:v>
                </c:pt>
                <c:pt idx="1398">
                  <c:v>6.6337771415710449</c:v>
                </c:pt>
                <c:pt idx="1399">
                  <c:v>6.6449813842773438</c:v>
                </c:pt>
                <c:pt idx="1400">
                  <c:v>6.6561903953552246</c:v>
                </c:pt>
                <c:pt idx="1401">
                  <c:v>6.6674008369445801</c:v>
                </c:pt>
                <c:pt idx="1402">
                  <c:v>6.678614616394043</c:v>
                </c:pt>
                <c:pt idx="1403">
                  <c:v>6.6898303031921387</c:v>
                </c:pt>
                <c:pt idx="1404">
                  <c:v>6.7010502815246582</c:v>
                </c:pt>
                <c:pt idx="1405">
                  <c:v>6.7122716903686523</c:v>
                </c:pt>
                <c:pt idx="1406">
                  <c:v>6.7234959602355957</c:v>
                </c:pt>
                <c:pt idx="1407">
                  <c:v>6.7347230911254883</c:v>
                </c:pt>
                <c:pt idx="1408">
                  <c:v>6.7459535598754883</c:v>
                </c:pt>
                <c:pt idx="1409">
                  <c:v>6.7571868896484375</c:v>
                </c:pt>
                <c:pt idx="1410">
                  <c:v>6.7684226036071777</c:v>
                </c:pt>
                <c:pt idx="1411">
                  <c:v>6.7796597480773926</c:v>
                </c:pt>
                <c:pt idx="1412">
                  <c:v>6.790900707244873</c:v>
                </c:pt>
                <c:pt idx="1413">
                  <c:v>6.8021430969238281</c:v>
                </c:pt>
                <c:pt idx="1414">
                  <c:v>6.8133869171142578</c:v>
                </c:pt>
                <c:pt idx="1415">
                  <c:v>6.8246340751647949</c:v>
                </c:pt>
                <c:pt idx="1416">
                  <c:v>6.8358840942382813</c:v>
                </c:pt>
                <c:pt idx="1417">
                  <c:v>6.8471369743347168</c:v>
                </c:pt>
                <c:pt idx="1418">
                  <c:v>6.858391284942627</c:v>
                </c:pt>
                <c:pt idx="1419">
                  <c:v>6.8696484565734863</c:v>
                </c:pt>
                <c:pt idx="1420">
                  <c:v>6.8809080123901367</c:v>
                </c:pt>
                <c:pt idx="1421">
                  <c:v>6.8921685218811035</c:v>
                </c:pt>
                <c:pt idx="1422">
                  <c:v>6.9034314155578613</c:v>
                </c:pt>
                <c:pt idx="1423">
                  <c:v>6.9146971702575684</c:v>
                </c:pt>
                <c:pt idx="1424">
                  <c:v>6.9259648323059082</c:v>
                </c:pt>
                <c:pt idx="1425">
                  <c:v>6.9372353553771973</c:v>
                </c:pt>
                <c:pt idx="1426">
                  <c:v>6.9485073089599609</c:v>
                </c:pt>
                <c:pt idx="1427">
                  <c:v>6.959780216217041</c:v>
                </c:pt>
                <c:pt idx="1428">
                  <c:v>6.9710564613342285</c:v>
                </c:pt>
                <c:pt idx="1429">
                  <c:v>6.982335090637207</c:v>
                </c:pt>
                <c:pt idx="1430">
                  <c:v>6.9936156272888184</c:v>
                </c:pt>
                <c:pt idx="1431">
                  <c:v>7.0048975944519043</c:v>
                </c:pt>
                <c:pt idx="1432">
                  <c:v>7.0161838531494141</c:v>
                </c:pt>
                <c:pt idx="1433">
                  <c:v>7.0274720191955566</c:v>
                </c:pt>
                <c:pt idx="1434">
                  <c:v>7.0387601852416992</c:v>
                </c:pt>
                <c:pt idx="1435">
                  <c:v>7.050051212310791</c:v>
                </c:pt>
                <c:pt idx="1436">
                  <c:v>7.061345100402832</c:v>
                </c:pt>
                <c:pt idx="1437">
                  <c:v>7.0726423263549805</c:v>
                </c:pt>
                <c:pt idx="1438">
                  <c:v>7.0839395523071289</c:v>
                </c:pt>
                <c:pt idx="1439">
                  <c:v>7.0952396392822266</c:v>
                </c:pt>
                <c:pt idx="1440">
                  <c:v>7.1065421104431152</c:v>
                </c:pt>
                <c:pt idx="1441">
                  <c:v>7.1178460121154785</c:v>
                </c:pt>
                <c:pt idx="1442">
                  <c:v>7.129152774810791</c:v>
                </c:pt>
                <c:pt idx="1443">
                  <c:v>7.1404604911804199</c:v>
                </c:pt>
                <c:pt idx="1444">
                  <c:v>7.1517696380615234</c:v>
                </c:pt>
                <c:pt idx="1445">
                  <c:v>7.163081169128418</c:v>
                </c:pt>
                <c:pt idx="1446">
                  <c:v>7.1743941307067871</c:v>
                </c:pt>
                <c:pt idx="1447">
                  <c:v>7.1857113838195801</c:v>
                </c:pt>
                <c:pt idx="1448">
                  <c:v>7.1970291137695313</c:v>
                </c:pt>
                <c:pt idx="1449">
                  <c:v>7.2083516120910645</c:v>
                </c:pt>
                <c:pt idx="1450">
                  <c:v>7.2196741104125977</c:v>
                </c:pt>
                <c:pt idx="1451">
                  <c:v>7.2310004234313965</c:v>
                </c:pt>
                <c:pt idx="1452">
                  <c:v>7.2423257827758789</c:v>
                </c:pt>
                <c:pt idx="1453">
                  <c:v>7.2536559104919434</c:v>
                </c:pt>
                <c:pt idx="1454">
                  <c:v>7.2649855613708496</c:v>
                </c:pt>
                <c:pt idx="1455">
                  <c:v>7.2763190269470215</c:v>
                </c:pt>
                <c:pt idx="1456">
                  <c:v>7.287653923034668</c:v>
                </c:pt>
                <c:pt idx="1457">
                  <c:v>7.2989912033081055</c:v>
                </c:pt>
                <c:pt idx="1458">
                  <c:v>7.3103280067443848</c:v>
                </c:pt>
                <c:pt idx="1459">
                  <c:v>7.3216676712036133</c:v>
                </c:pt>
                <c:pt idx="1460">
                  <c:v>7.333010196685791</c:v>
                </c:pt>
                <c:pt idx="1461">
                  <c:v>7.3443551063537598</c:v>
                </c:pt>
                <c:pt idx="1462">
                  <c:v>7.3556995391845703</c:v>
                </c:pt>
                <c:pt idx="1463">
                  <c:v>7.3670477867126465</c:v>
                </c:pt>
                <c:pt idx="1464">
                  <c:v>7.3783965110778809</c:v>
                </c:pt>
                <c:pt idx="1465">
                  <c:v>7.3897495269775391</c:v>
                </c:pt>
                <c:pt idx="1466">
                  <c:v>7.4011039733886719</c:v>
                </c:pt>
                <c:pt idx="1467">
                  <c:v>7.4124603271484375</c:v>
                </c:pt>
                <c:pt idx="1468">
                  <c:v>7.4238190650939941</c:v>
                </c:pt>
                <c:pt idx="1469">
                  <c:v>7.4351797103881836</c:v>
                </c:pt>
                <c:pt idx="1470">
                  <c:v>7.4465389251708984</c:v>
                </c:pt>
                <c:pt idx="1471">
                  <c:v>7.4579048156738281</c:v>
                </c:pt>
                <c:pt idx="1472">
                  <c:v>7.469268798828125</c:v>
                </c:pt>
                <c:pt idx="1473">
                  <c:v>7.4806370735168457</c:v>
                </c:pt>
                <c:pt idx="1474">
                  <c:v>7.4920058250427246</c:v>
                </c:pt>
                <c:pt idx="1475">
                  <c:v>7.5033788681030273</c:v>
                </c:pt>
                <c:pt idx="1476">
                  <c:v>7.5147514343261719</c:v>
                </c:pt>
                <c:pt idx="1477">
                  <c:v>7.526127815246582</c:v>
                </c:pt>
                <c:pt idx="1478">
                  <c:v>7.5375070571899414</c:v>
                </c:pt>
                <c:pt idx="1479">
                  <c:v>7.548886775970459</c:v>
                </c:pt>
                <c:pt idx="1480">
                  <c:v>7.560269832611084</c:v>
                </c:pt>
                <c:pt idx="1481">
                  <c:v>7.571652889251709</c:v>
                </c:pt>
                <c:pt idx="1482">
                  <c:v>7.5830397605895996</c:v>
                </c:pt>
                <c:pt idx="1483">
                  <c:v>7.5944314002990723</c:v>
                </c:pt>
                <c:pt idx="1484">
                  <c:v>7.6058216094970703</c:v>
                </c:pt>
                <c:pt idx="1485">
                  <c:v>7.6172151565551758</c:v>
                </c:pt>
                <c:pt idx="1486">
                  <c:v>7.6286110877990723</c:v>
                </c:pt>
                <c:pt idx="1487">
                  <c:v>7.6400094032287598</c:v>
                </c:pt>
                <c:pt idx="1488">
                  <c:v>7.6514091491699219</c:v>
                </c:pt>
                <c:pt idx="1489">
                  <c:v>7.6628122329711914</c:v>
                </c:pt>
                <c:pt idx="1490">
                  <c:v>7.6742162704467773</c:v>
                </c:pt>
                <c:pt idx="1491">
                  <c:v>7.6856222152709961</c:v>
                </c:pt>
                <c:pt idx="1492">
                  <c:v>7.6970305442810059</c:v>
                </c:pt>
                <c:pt idx="1493">
                  <c:v>7.7084407806396484</c:v>
                </c:pt>
                <c:pt idx="1494">
                  <c:v>7.7198529243469238</c:v>
                </c:pt>
                <c:pt idx="1495">
                  <c:v>7.7312684059143066</c:v>
                </c:pt>
                <c:pt idx="1496">
                  <c:v>7.7426838874816895</c:v>
                </c:pt>
                <c:pt idx="1497">
                  <c:v>7.7541017532348633</c:v>
                </c:pt>
                <c:pt idx="1498">
                  <c:v>7.7655224800109863</c:v>
                </c:pt>
                <c:pt idx="1499">
                  <c:v>7.7769441604614258</c:v>
                </c:pt>
                <c:pt idx="1500">
                  <c:v>7.7883687019348145</c:v>
                </c:pt>
                <c:pt idx="1501">
                  <c:v>7.7997961044311523</c:v>
                </c:pt>
                <c:pt idx="1502">
                  <c:v>7.8112244606018066</c:v>
                </c:pt>
                <c:pt idx="1503">
                  <c:v>7.8226556777954102</c:v>
                </c:pt>
                <c:pt idx="1504">
                  <c:v>7.8340883255004883</c:v>
                </c:pt>
                <c:pt idx="1505">
                  <c:v>7.8455228805541992</c:v>
                </c:pt>
                <c:pt idx="1506">
                  <c:v>7.8569588661193848</c:v>
                </c:pt>
                <c:pt idx="1507">
                  <c:v>7.8683972358703613</c:v>
                </c:pt>
                <c:pt idx="1508">
                  <c:v>7.8798384666442871</c:v>
                </c:pt>
                <c:pt idx="1509">
                  <c:v>7.8912796974182129</c:v>
                </c:pt>
                <c:pt idx="1510">
                  <c:v>7.9027237892150879</c:v>
                </c:pt>
                <c:pt idx="1511">
                  <c:v>7.9141688346862793</c:v>
                </c:pt>
                <c:pt idx="1512">
                  <c:v>7.9256172180175781</c:v>
                </c:pt>
                <c:pt idx="1513">
                  <c:v>7.9370670318603516</c:v>
                </c:pt>
                <c:pt idx="1514">
                  <c:v>7.9485187530517578</c:v>
                </c:pt>
                <c:pt idx="1515">
                  <c:v>7.9599728584289551</c:v>
                </c:pt>
                <c:pt idx="1516">
                  <c:v>7.971428394317627</c:v>
                </c:pt>
                <c:pt idx="1517">
                  <c:v>7.9828863143920898</c:v>
                </c:pt>
                <c:pt idx="1518">
                  <c:v>7.9943451881408691</c:v>
                </c:pt>
                <c:pt idx="1519">
                  <c:v>8.0058069229125977</c:v>
                </c:pt>
                <c:pt idx="1520">
                  <c:v>8.0172710418701172</c:v>
                </c:pt>
                <c:pt idx="1521">
                  <c:v>8.0287380218505859</c:v>
                </c:pt>
                <c:pt idx="1522">
                  <c:v>8.0402059555053711</c:v>
                </c:pt>
                <c:pt idx="1523">
                  <c:v>8.0516757965087891</c:v>
                </c:pt>
                <c:pt idx="1524">
                  <c:v>8.0631484985351563</c:v>
                </c:pt>
                <c:pt idx="1525">
                  <c:v>8.0746231079101563</c:v>
                </c:pt>
                <c:pt idx="1526">
                  <c:v>8.0860996246337891</c:v>
                </c:pt>
                <c:pt idx="1527">
                  <c:v>8.0975780487060547</c:v>
                </c:pt>
                <c:pt idx="1528">
                  <c:v>8.1090574264526367</c:v>
                </c:pt>
                <c:pt idx="1529">
                  <c:v>8.120539665222168</c:v>
                </c:pt>
                <c:pt idx="1530">
                  <c:v>8.1320247650146484</c:v>
                </c:pt>
                <c:pt idx="1531">
                  <c:v>8.1435108184814453</c:v>
                </c:pt>
                <c:pt idx="1532">
                  <c:v>8.1549997329711914</c:v>
                </c:pt>
                <c:pt idx="1533">
                  <c:v>8.1664896011352539</c:v>
                </c:pt>
                <c:pt idx="1534">
                  <c:v>8.1779823303222656</c:v>
                </c:pt>
                <c:pt idx="1535">
                  <c:v>8.1894769668579102</c:v>
                </c:pt>
                <c:pt idx="1536">
                  <c:v>8.2009735107421875</c:v>
                </c:pt>
                <c:pt idx="1537">
                  <c:v>8.2124719619750977</c:v>
                </c:pt>
                <c:pt idx="1538">
                  <c:v>8.223973274230957</c:v>
                </c:pt>
                <c:pt idx="1539">
                  <c:v>8.2354755401611328</c:v>
                </c:pt>
                <c:pt idx="1540">
                  <c:v>8.2469806671142578</c:v>
                </c:pt>
                <c:pt idx="1541">
                  <c:v>8.2584877014160156</c:v>
                </c:pt>
                <c:pt idx="1542">
                  <c:v>8.2699966430664063</c:v>
                </c:pt>
                <c:pt idx="1543">
                  <c:v>8.2815074920654297</c:v>
                </c:pt>
                <c:pt idx="1544">
                  <c:v>8.2930202484130859</c:v>
                </c:pt>
                <c:pt idx="1545">
                  <c:v>8.3045358657836914</c:v>
                </c:pt>
                <c:pt idx="1546">
                  <c:v>8.3160524368286133</c:v>
                </c:pt>
                <c:pt idx="1547">
                  <c:v>8.3275718688964844</c:v>
                </c:pt>
                <c:pt idx="1548">
                  <c:v>8.3390932083129883</c:v>
                </c:pt>
                <c:pt idx="1549">
                  <c:v>8.350616455078125</c:v>
                </c:pt>
                <c:pt idx="1550">
                  <c:v>8.3621425628662109</c:v>
                </c:pt>
                <c:pt idx="1551">
                  <c:v>8.3736696243286133</c:v>
                </c:pt>
                <c:pt idx="1552">
                  <c:v>8.3851995468139648</c:v>
                </c:pt>
                <c:pt idx="1553">
                  <c:v>8.3967313766479492</c:v>
                </c:pt>
                <c:pt idx="1554">
                  <c:v>8.4082651138305664</c:v>
                </c:pt>
                <c:pt idx="1555">
                  <c:v>8.4198017120361328</c:v>
                </c:pt>
                <c:pt idx="1556">
                  <c:v>8.4313392639160156</c:v>
                </c:pt>
                <c:pt idx="1557">
                  <c:v>8.4428796768188477</c:v>
                </c:pt>
                <c:pt idx="1558">
                  <c:v>8.4544219970703125</c:v>
                </c:pt>
                <c:pt idx="1559">
                  <c:v>8.4659671783447266</c:v>
                </c:pt>
                <c:pt idx="1560">
                  <c:v>8.477513313293457</c:v>
                </c:pt>
                <c:pt idx="1561">
                  <c:v>8.4890632629394531</c:v>
                </c:pt>
                <c:pt idx="1562">
                  <c:v>8.5006141662597656</c:v>
                </c:pt>
                <c:pt idx="1563">
                  <c:v>8.5121669769287109</c:v>
                </c:pt>
                <c:pt idx="1564">
                  <c:v>8.5237216949462891</c:v>
                </c:pt>
                <c:pt idx="1565">
                  <c:v>8.5352792739868164</c:v>
                </c:pt>
                <c:pt idx="1566">
                  <c:v>8.5468387603759766</c:v>
                </c:pt>
                <c:pt idx="1567">
                  <c:v>8.5584001541137695</c:v>
                </c:pt>
                <c:pt idx="1568">
                  <c:v>8.5699644088745117</c:v>
                </c:pt>
                <c:pt idx="1569">
                  <c:v>8.5815305709838867</c:v>
                </c:pt>
                <c:pt idx="1570">
                  <c:v>8.5930986404418945</c:v>
                </c:pt>
                <c:pt idx="1571">
                  <c:v>8.6046686172485352</c:v>
                </c:pt>
                <c:pt idx="1572">
                  <c:v>8.616241455078125</c:v>
                </c:pt>
                <c:pt idx="1573">
                  <c:v>8.6278162002563477</c:v>
                </c:pt>
                <c:pt idx="1574">
                  <c:v>8.6393928527832031</c:v>
                </c:pt>
                <c:pt idx="1575">
                  <c:v>8.6509714126586914</c:v>
                </c:pt>
                <c:pt idx="1576">
                  <c:v>8.6625528335571289</c:v>
                </c:pt>
                <c:pt idx="1577">
                  <c:v>8.6741361618041992</c:v>
                </c:pt>
                <c:pt idx="1578">
                  <c:v>8.6857223510742188</c:v>
                </c:pt>
                <c:pt idx="1579">
                  <c:v>8.6973104476928711</c:v>
                </c:pt>
                <c:pt idx="1580">
                  <c:v>8.7089004516601563</c:v>
                </c:pt>
                <c:pt idx="1581">
                  <c:v>8.7204933166503906</c:v>
                </c:pt>
                <c:pt idx="1582">
                  <c:v>8.7320871353149414</c:v>
                </c:pt>
                <c:pt idx="1583">
                  <c:v>8.7436838150024414</c:v>
                </c:pt>
                <c:pt idx="1584">
                  <c:v>8.7552833557128906</c:v>
                </c:pt>
                <c:pt idx="1585">
                  <c:v>8.7668848037719727</c:v>
                </c:pt>
                <c:pt idx="1586">
                  <c:v>8.7784881591796875</c:v>
                </c:pt>
                <c:pt idx="1587">
                  <c:v>8.7900943756103516</c:v>
                </c:pt>
                <c:pt idx="1588">
                  <c:v>8.8017034530639648</c:v>
                </c:pt>
                <c:pt idx="1589">
                  <c:v>8.8133144378662109</c:v>
                </c:pt>
                <c:pt idx="1590">
                  <c:v>8.8249273300170898</c:v>
                </c:pt>
                <c:pt idx="1591">
                  <c:v>8.836543083190918</c:v>
                </c:pt>
                <c:pt idx="1592">
                  <c:v>8.8481597900390625</c:v>
                </c:pt>
                <c:pt idx="1593">
                  <c:v>8.8597803115844727</c:v>
                </c:pt>
                <c:pt idx="1594">
                  <c:v>8.8714008331298828</c:v>
                </c:pt>
                <c:pt idx="1595">
                  <c:v>8.8830251693725586</c:v>
                </c:pt>
                <c:pt idx="1596">
                  <c:v>8.8946514129638672</c:v>
                </c:pt>
                <c:pt idx="1597">
                  <c:v>8.9062814712524414</c:v>
                </c:pt>
                <c:pt idx="1598">
                  <c:v>8.917912483215332</c:v>
                </c:pt>
                <c:pt idx="1599">
                  <c:v>8.9295463562011719</c:v>
                </c:pt>
                <c:pt idx="1600">
                  <c:v>8.9411821365356445</c:v>
                </c:pt>
                <c:pt idx="1601">
                  <c:v>8.9528207778930664</c:v>
                </c:pt>
                <c:pt idx="1602">
                  <c:v>8.9644613265991211</c:v>
                </c:pt>
                <c:pt idx="1603">
                  <c:v>8.976104736328125</c:v>
                </c:pt>
                <c:pt idx="1604">
                  <c:v>8.9877510070800781</c:v>
                </c:pt>
                <c:pt idx="1605">
                  <c:v>8.9993991851806641</c:v>
                </c:pt>
                <c:pt idx="1606">
                  <c:v>9.0110492706298828</c:v>
                </c:pt>
                <c:pt idx="1607">
                  <c:v>9.0227022171020508</c:v>
                </c:pt>
                <c:pt idx="1608">
                  <c:v>9.0343561172485352</c:v>
                </c:pt>
                <c:pt idx="1609">
                  <c:v>9.0460138320922852</c:v>
                </c:pt>
                <c:pt idx="1610">
                  <c:v>9.0576725006103516</c:v>
                </c:pt>
                <c:pt idx="1611">
                  <c:v>9.0693359375</c:v>
                </c:pt>
                <c:pt idx="1612">
                  <c:v>9.0810003280639648</c:v>
                </c:pt>
                <c:pt idx="1613">
                  <c:v>9.0926666259765625</c:v>
                </c:pt>
                <c:pt idx="1614">
                  <c:v>9.104334831237793</c:v>
                </c:pt>
                <c:pt idx="1615">
                  <c:v>9.1160078048706055</c:v>
                </c:pt>
                <c:pt idx="1616">
                  <c:v>9.1276817321777344</c:v>
                </c:pt>
                <c:pt idx="1617">
                  <c:v>9.1393575668334961</c:v>
                </c:pt>
                <c:pt idx="1618">
                  <c:v>9.151036262512207</c:v>
                </c:pt>
                <c:pt idx="1619">
                  <c:v>9.1627187728881836</c:v>
                </c:pt>
                <c:pt idx="1620">
                  <c:v>9.174403190612793</c:v>
                </c:pt>
                <c:pt idx="1621">
                  <c:v>9.1860895156860352</c:v>
                </c:pt>
                <c:pt idx="1622">
                  <c:v>9.1977787017822266</c:v>
                </c:pt>
                <c:pt idx="1623">
                  <c:v>9.2094707489013672</c:v>
                </c:pt>
                <c:pt idx="1624">
                  <c:v>9.2211637496948242</c:v>
                </c:pt>
                <c:pt idx="1625">
                  <c:v>9.2328596115112305</c:v>
                </c:pt>
                <c:pt idx="1626">
                  <c:v>9.2445583343505859</c:v>
                </c:pt>
                <c:pt idx="1627">
                  <c:v>9.2562599182128906</c:v>
                </c:pt>
                <c:pt idx="1628">
                  <c:v>9.2679634094238281</c:v>
                </c:pt>
                <c:pt idx="1629">
                  <c:v>9.2796707153320313</c:v>
                </c:pt>
                <c:pt idx="1630">
                  <c:v>9.2913780212402344</c:v>
                </c:pt>
                <c:pt idx="1631">
                  <c:v>9.3030891418457031</c:v>
                </c:pt>
                <c:pt idx="1632">
                  <c:v>9.3148031234741211</c:v>
                </c:pt>
                <c:pt idx="1633">
                  <c:v>9.3265190124511719</c:v>
                </c:pt>
                <c:pt idx="1634">
                  <c:v>9.3382396697998047</c:v>
                </c:pt>
                <c:pt idx="1635">
                  <c:v>9.3499622344970703</c:v>
                </c:pt>
                <c:pt idx="1636">
                  <c:v>9.3616857528686523</c:v>
                </c:pt>
                <c:pt idx="1637">
                  <c:v>9.3734130859375</c:v>
                </c:pt>
                <c:pt idx="1638">
                  <c:v>9.3851423263549805</c:v>
                </c:pt>
                <c:pt idx="1639">
                  <c:v>9.396876335144043</c:v>
                </c:pt>
                <c:pt idx="1640">
                  <c:v>9.4086103439331055</c:v>
                </c:pt>
                <c:pt idx="1641">
                  <c:v>9.42034912109375</c:v>
                </c:pt>
                <c:pt idx="1642">
                  <c:v>9.4320878982543945</c:v>
                </c:pt>
                <c:pt idx="1643">
                  <c:v>9.4438314437866211</c:v>
                </c:pt>
                <c:pt idx="1644">
                  <c:v>9.4555778503417969</c:v>
                </c:pt>
                <c:pt idx="1645">
                  <c:v>9.4673261642456055</c:v>
                </c:pt>
                <c:pt idx="1646">
                  <c:v>9.4790763854980469</c:v>
                </c:pt>
                <c:pt idx="1647">
                  <c:v>9.4908323287963867</c:v>
                </c:pt>
                <c:pt idx="1648">
                  <c:v>9.5025882720947266</c:v>
                </c:pt>
                <c:pt idx="1649">
                  <c:v>9.514348030090332</c:v>
                </c:pt>
                <c:pt idx="1650">
                  <c:v>9.5261116027832031</c:v>
                </c:pt>
                <c:pt idx="1651">
                  <c:v>9.5378761291503906</c:v>
                </c:pt>
                <c:pt idx="1652">
                  <c:v>9.5496425628662109</c:v>
                </c:pt>
                <c:pt idx="1653">
                  <c:v>9.5614128112792969</c:v>
                </c:pt>
                <c:pt idx="1654">
                  <c:v>9.5731849670410156</c:v>
                </c:pt>
                <c:pt idx="1655">
                  <c:v>9.5849590301513672</c:v>
                </c:pt>
                <c:pt idx="1656">
                  <c:v>9.5967369079589844</c:v>
                </c:pt>
                <c:pt idx="1657">
                  <c:v>9.6085166931152344</c:v>
                </c:pt>
                <c:pt idx="1658">
                  <c:v>9.62030029296875</c:v>
                </c:pt>
                <c:pt idx="1659">
                  <c:v>9.6320867538452148</c:v>
                </c:pt>
                <c:pt idx="1660">
                  <c:v>9.6438760757446289</c:v>
                </c:pt>
                <c:pt idx="1661">
                  <c:v>9.6556663513183594</c:v>
                </c:pt>
                <c:pt idx="1662">
                  <c:v>9.6674604415893555</c:v>
                </c:pt>
                <c:pt idx="1663">
                  <c:v>9.6792564392089844</c:v>
                </c:pt>
                <c:pt idx="1664">
                  <c:v>9.6910581588745117</c:v>
                </c:pt>
                <c:pt idx="1665">
                  <c:v>9.7028598785400391</c:v>
                </c:pt>
                <c:pt idx="1666">
                  <c:v>9.714665412902832</c:v>
                </c:pt>
                <c:pt idx="1667">
                  <c:v>9.7264738082885742</c:v>
                </c:pt>
                <c:pt idx="1668">
                  <c:v>9.7382841110229492</c:v>
                </c:pt>
                <c:pt idx="1669">
                  <c:v>9.750096321105957</c:v>
                </c:pt>
                <c:pt idx="1670">
                  <c:v>9.7619152069091797</c:v>
                </c:pt>
                <c:pt idx="1671">
                  <c:v>9.7737340927124023</c:v>
                </c:pt>
                <c:pt idx="1672">
                  <c:v>9.7855558395385742</c:v>
                </c:pt>
                <c:pt idx="1673">
                  <c:v>9.7973794937133789</c:v>
                </c:pt>
                <c:pt idx="1674">
                  <c:v>9.8092079162597656</c:v>
                </c:pt>
                <c:pt idx="1675">
                  <c:v>9.8210372924804688</c:v>
                </c:pt>
                <c:pt idx="1676">
                  <c:v>9.8328714370727539</c:v>
                </c:pt>
                <c:pt idx="1677">
                  <c:v>9.8447074890136719</c:v>
                </c:pt>
                <c:pt idx="1678">
                  <c:v>9.8565464019775391</c:v>
                </c:pt>
                <c:pt idx="1679">
                  <c:v>9.8683872222900391</c:v>
                </c:pt>
                <c:pt idx="1680">
                  <c:v>9.8802318572998047</c:v>
                </c:pt>
                <c:pt idx="1681">
                  <c:v>9.8920783996582031</c:v>
                </c:pt>
                <c:pt idx="1682">
                  <c:v>9.9039306640625</c:v>
                </c:pt>
                <c:pt idx="1683">
                  <c:v>9.9157838821411133</c:v>
                </c:pt>
                <c:pt idx="1684">
                  <c:v>9.9276409149169922</c:v>
                </c:pt>
                <c:pt idx="1685">
                  <c:v>9.9395017623901367</c:v>
                </c:pt>
                <c:pt idx="1686">
                  <c:v>9.9513654708862305</c:v>
                </c:pt>
                <c:pt idx="1687">
                  <c:v>9.9632320404052734</c:v>
                </c:pt>
                <c:pt idx="1688">
                  <c:v>9.975102424621582</c:v>
                </c:pt>
                <c:pt idx="1689">
                  <c:v>9.9869747161865234</c:v>
                </c:pt>
                <c:pt idx="1690">
                  <c:v>9.9988517761230469</c:v>
                </c:pt>
                <c:pt idx="1691">
                  <c:v>10.010730743408203</c:v>
                </c:pt>
                <c:pt idx="1692">
                  <c:v>10.022612571716309</c:v>
                </c:pt>
                <c:pt idx="1693">
                  <c:v>10.034496307373047</c:v>
                </c:pt>
                <c:pt idx="1694">
                  <c:v>10.046383857727051</c:v>
                </c:pt>
                <c:pt idx="1695">
                  <c:v>10.058272361755371</c:v>
                </c:pt>
                <c:pt idx="1696">
                  <c:v>10.070167541503906</c:v>
                </c:pt>
                <c:pt idx="1697">
                  <c:v>10.082064628601074</c:v>
                </c:pt>
                <c:pt idx="1698">
                  <c:v>10.093964576721191</c:v>
                </c:pt>
                <c:pt idx="1699">
                  <c:v>10.105866432189941</c:v>
                </c:pt>
                <c:pt idx="1700">
                  <c:v>10.11777400970459</c:v>
                </c:pt>
                <c:pt idx="1701">
                  <c:v>10.129683494567871</c:v>
                </c:pt>
                <c:pt idx="1702">
                  <c:v>10.141593933105469</c:v>
                </c:pt>
                <c:pt idx="1703">
                  <c:v>10.153509140014648</c:v>
                </c:pt>
                <c:pt idx="1704">
                  <c:v>10.165426254272461</c:v>
                </c:pt>
                <c:pt idx="1705">
                  <c:v>10.177347183227539</c:v>
                </c:pt>
                <c:pt idx="1706">
                  <c:v>10.189270973205566</c:v>
                </c:pt>
                <c:pt idx="1707">
                  <c:v>10.20119571685791</c:v>
                </c:pt>
                <c:pt idx="1708">
                  <c:v>10.21312427520752</c:v>
                </c:pt>
                <c:pt idx="1709">
                  <c:v>10.225055694580078</c:v>
                </c:pt>
                <c:pt idx="1710">
                  <c:v>10.236992835998535</c:v>
                </c:pt>
                <c:pt idx="1711">
                  <c:v>10.248929023742676</c:v>
                </c:pt>
                <c:pt idx="1712">
                  <c:v>10.260868072509766</c:v>
                </c:pt>
                <c:pt idx="1713">
                  <c:v>10.272809982299805</c:v>
                </c:pt>
                <c:pt idx="1714">
                  <c:v>10.284754753112793</c:v>
                </c:pt>
                <c:pt idx="1715">
                  <c:v>10.296703338623047</c:v>
                </c:pt>
                <c:pt idx="1716">
                  <c:v>10.308653831481934</c:v>
                </c:pt>
                <c:pt idx="1717">
                  <c:v>10.320608139038086</c:v>
                </c:pt>
                <c:pt idx="1718">
                  <c:v>10.332564353942871</c:v>
                </c:pt>
                <c:pt idx="1719">
                  <c:v>10.344526290893555</c:v>
                </c:pt>
                <c:pt idx="1720">
                  <c:v>10.356491088867188</c:v>
                </c:pt>
                <c:pt idx="1721">
                  <c:v>10.368456840515137</c:v>
                </c:pt>
                <c:pt idx="1722">
                  <c:v>10.380426406860352</c:v>
                </c:pt>
                <c:pt idx="1723">
                  <c:v>10.392398834228516</c:v>
                </c:pt>
                <c:pt idx="1724">
                  <c:v>10.404373168945313</c:v>
                </c:pt>
                <c:pt idx="1725">
                  <c:v>10.416349411010742</c:v>
                </c:pt>
                <c:pt idx="1726">
                  <c:v>10.428330421447754</c:v>
                </c:pt>
                <c:pt idx="1727">
                  <c:v>10.440309524536133</c:v>
                </c:pt>
                <c:pt idx="1728">
                  <c:v>10.452295303344727</c:v>
                </c:pt>
                <c:pt idx="1729">
                  <c:v>10.464285850524902</c:v>
                </c:pt>
                <c:pt idx="1730">
                  <c:v>10.476276397705078</c:v>
                </c:pt>
                <c:pt idx="1731">
                  <c:v>10.48827075958252</c:v>
                </c:pt>
                <c:pt idx="1732">
                  <c:v>10.500265121459961</c:v>
                </c:pt>
                <c:pt idx="1733">
                  <c:v>10.512265205383301</c:v>
                </c:pt>
                <c:pt idx="1734">
                  <c:v>10.524267196655273</c:v>
                </c:pt>
                <c:pt idx="1735">
                  <c:v>10.536273002624512</c:v>
                </c:pt>
                <c:pt idx="1736">
                  <c:v>10.548280715942383</c:v>
                </c:pt>
                <c:pt idx="1737">
                  <c:v>10.560295104980469</c:v>
                </c:pt>
                <c:pt idx="1738">
                  <c:v>10.572310447692871</c:v>
                </c:pt>
                <c:pt idx="1739">
                  <c:v>10.584330558776855</c:v>
                </c:pt>
                <c:pt idx="1740">
                  <c:v>10.59635066986084</c:v>
                </c:pt>
                <c:pt idx="1741">
                  <c:v>10.608373641967773</c:v>
                </c:pt>
                <c:pt idx="1742">
                  <c:v>10.62039852142334</c:v>
                </c:pt>
                <c:pt idx="1743">
                  <c:v>10.632430076599121</c:v>
                </c:pt>
                <c:pt idx="1744">
                  <c:v>10.64445972442627</c:v>
                </c:pt>
                <c:pt idx="1745">
                  <c:v>10.656494140625</c:v>
                </c:pt>
                <c:pt idx="1746">
                  <c:v>10.668530464172363</c:v>
                </c:pt>
                <c:pt idx="1747">
                  <c:v>10.680566787719727</c:v>
                </c:pt>
                <c:pt idx="1748">
                  <c:v>10.692605018615723</c:v>
                </c:pt>
                <c:pt idx="1749">
                  <c:v>10.704647064208984</c:v>
                </c:pt>
                <c:pt idx="1750">
                  <c:v>10.716692924499512</c:v>
                </c:pt>
                <c:pt idx="1751">
                  <c:v>10.728741645812988</c:v>
                </c:pt>
                <c:pt idx="1752">
                  <c:v>10.740789413452148</c:v>
                </c:pt>
                <c:pt idx="1753">
                  <c:v>10.752843856811523</c:v>
                </c:pt>
                <c:pt idx="1754">
                  <c:v>10.764900207519531</c:v>
                </c:pt>
                <c:pt idx="1755">
                  <c:v>10.776959419250488</c:v>
                </c:pt>
                <c:pt idx="1756">
                  <c:v>10.789020538330078</c:v>
                </c:pt>
                <c:pt idx="1757">
                  <c:v>10.801082611083984</c:v>
                </c:pt>
                <c:pt idx="1758">
                  <c:v>10.813146591186523</c:v>
                </c:pt>
                <c:pt idx="1759">
                  <c:v>10.825215339660645</c:v>
                </c:pt>
                <c:pt idx="1760">
                  <c:v>10.837283134460449</c:v>
                </c:pt>
                <c:pt idx="1761">
                  <c:v>10.84935474395752</c:v>
                </c:pt>
                <c:pt idx="1762">
                  <c:v>10.861429214477539</c:v>
                </c:pt>
                <c:pt idx="1763">
                  <c:v>10.873505592346191</c:v>
                </c:pt>
                <c:pt idx="1764">
                  <c:v>10.885585784912109</c:v>
                </c:pt>
                <c:pt idx="1765">
                  <c:v>10.89766788482666</c:v>
                </c:pt>
                <c:pt idx="1766">
                  <c:v>10.909749984741211</c:v>
                </c:pt>
                <c:pt idx="1767">
                  <c:v>10.921836853027344</c:v>
                </c:pt>
                <c:pt idx="1768">
                  <c:v>10.93392276763916</c:v>
                </c:pt>
                <c:pt idx="1769">
                  <c:v>10.946013450622559</c:v>
                </c:pt>
                <c:pt idx="1770">
                  <c:v>10.958107948303223</c:v>
                </c:pt>
                <c:pt idx="1771">
                  <c:v>10.970202445983887</c:v>
                </c:pt>
                <c:pt idx="1772">
                  <c:v>10.982297897338867</c:v>
                </c:pt>
                <c:pt idx="1773">
                  <c:v>10.994396209716797</c:v>
                </c:pt>
                <c:pt idx="1774">
                  <c:v>11.006495475769043</c:v>
                </c:pt>
                <c:pt idx="1775">
                  <c:v>11.018600463867188</c:v>
                </c:pt>
                <c:pt idx="1776">
                  <c:v>11.030707359313965</c:v>
                </c:pt>
                <c:pt idx="1777">
                  <c:v>11.042815208435059</c:v>
                </c:pt>
                <c:pt idx="1778">
                  <c:v>11.054924964904785</c:v>
                </c:pt>
                <c:pt idx="1779">
                  <c:v>11.067038536071777</c:v>
                </c:pt>
                <c:pt idx="1780">
                  <c:v>11.079154014587402</c:v>
                </c:pt>
                <c:pt idx="1781">
                  <c:v>11.09127140045166</c:v>
                </c:pt>
                <c:pt idx="1782">
                  <c:v>11.103390693664551</c:v>
                </c:pt>
                <c:pt idx="1783">
                  <c:v>11.115511894226074</c:v>
                </c:pt>
                <c:pt idx="1784">
                  <c:v>11.12763500213623</c:v>
                </c:pt>
                <c:pt idx="1785">
                  <c:v>11.139761924743652</c:v>
                </c:pt>
                <c:pt idx="1786">
                  <c:v>11.151889801025391</c:v>
                </c:pt>
                <c:pt idx="1787">
                  <c:v>11.164020538330078</c:v>
                </c:pt>
                <c:pt idx="1788">
                  <c:v>11.176153182983398</c:v>
                </c:pt>
                <c:pt idx="1789">
                  <c:v>11.188286781311035</c:v>
                </c:pt>
                <c:pt idx="1790">
                  <c:v>11.200424194335938</c:v>
                </c:pt>
                <c:pt idx="1791">
                  <c:v>11.212563514709473</c:v>
                </c:pt>
                <c:pt idx="1792">
                  <c:v>11.224702835083008</c:v>
                </c:pt>
                <c:pt idx="1793">
                  <c:v>11.236846923828125</c:v>
                </c:pt>
                <c:pt idx="1794">
                  <c:v>11.248992919921875</c:v>
                </c:pt>
                <c:pt idx="1795">
                  <c:v>11.261140823364258</c:v>
                </c:pt>
                <c:pt idx="1796">
                  <c:v>11.27329158782959</c:v>
                </c:pt>
                <c:pt idx="1797">
                  <c:v>11.285444259643555</c:v>
                </c:pt>
                <c:pt idx="1798">
                  <c:v>11.297598838806152</c:v>
                </c:pt>
                <c:pt idx="1799">
                  <c:v>11.309755325317383</c:v>
                </c:pt>
                <c:pt idx="1800">
                  <c:v>11.321914672851563</c:v>
                </c:pt>
                <c:pt idx="1801">
                  <c:v>11.334076881408691</c:v>
                </c:pt>
                <c:pt idx="1802">
                  <c:v>11.346240043640137</c:v>
                </c:pt>
                <c:pt idx="1803">
                  <c:v>11.358405113220215</c:v>
                </c:pt>
                <c:pt idx="1804">
                  <c:v>11.370573043823242</c:v>
                </c:pt>
                <c:pt idx="1805">
                  <c:v>11.382742881774902</c:v>
                </c:pt>
                <c:pt idx="1806">
                  <c:v>11.394915580749512</c:v>
                </c:pt>
                <c:pt idx="1807">
                  <c:v>11.407090187072754</c:v>
                </c:pt>
                <c:pt idx="1808">
                  <c:v>11.419266700744629</c:v>
                </c:pt>
                <c:pt idx="1809">
                  <c:v>11.431446075439453</c:v>
                </c:pt>
                <c:pt idx="1810">
                  <c:v>11.44362735748291</c:v>
                </c:pt>
                <c:pt idx="1811">
                  <c:v>11.455810546875</c:v>
                </c:pt>
                <c:pt idx="1812">
                  <c:v>11.467996597290039</c:v>
                </c:pt>
                <c:pt idx="1813">
                  <c:v>11.480184555053711</c:v>
                </c:pt>
                <c:pt idx="1814">
                  <c:v>11.492374420166016</c:v>
                </c:pt>
                <c:pt idx="1815">
                  <c:v>11.50456714630127</c:v>
                </c:pt>
                <c:pt idx="1816">
                  <c:v>11.516761779785156</c:v>
                </c:pt>
                <c:pt idx="1817">
                  <c:v>11.528959274291992</c:v>
                </c:pt>
                <c:pt idx="1818">
                  <c:v>11.541158676147461</c:v>
                </c:pt>
                <c:pt idx="1819">
                  <c:v>11.553359985351563</c:v>
                </c:pt>
                <c:pt idx="1820">
                  <c:v>11.565564155578613</c:v>
                </c:pt>
                <c:pt idx="1821">
                  <c:v>11.577770233154297</c:v>
                </c:pt>
                <c:pt idx="1822">
                  <c:v>11.589978218078613</c:v>
                </c:pt>
                <c:pt idx="1823">
                  <c:v>11.602189064025879</c:v>
                </c:pt>
                <c:pt idx="1824">
                  <c:v>11.614402770996094</c:v>
                </c:pt>
                <c:pt idx="1825">
                  <c:v>11.626618385314941</c:v>
                </c:pt>
                <c:pt idx="1826">
                  <c:v>11.638835906982422</c:v>
                </c:pt>
                <c:pt idx="1827">
                  <c:v>11.651056289672852</c:v>
                </c:pt>
                <c:pt idx="1828">
                  <c:v>11.663278579711914</c:v>
                </c:pt>
                <c:pt idx="1829">
                  <c:v>11.675503730773926</c:v>
                </c:pt>
                <c:pt idx="1830">
                  <c:v>11.68773078918457</c:v>
                </c:pt>
                <c:pt idx="1831">
                  <c:v>11.699959754943848</c:v>
                </c:pt>
                <c:pt idx="1832">
                  <c:v>11.712191581726074</c:v>
                </c:pt>
                <c:pt idx="1833">
                  <c:v>11.724425315856934</c:v>
                </c:pt>
                <c:pt idx="1834">
                  <c:v>11.736661911010742</c:v>
                </c:pt>
                <c:pt idx="1835">
                  <c:v>11.748900413513184</c:v>
                </c:pt>
                <c:pt idx="1836">
                  <c:v>11.761141777038574</c:v>
                </c:pt>
                <c:pt idx="1837">
                  <c:v>11.773386001586914</c:v>
                </c:pt>
                <c:pt idx="1838">
                  <c:v>11.78563117980957</c:v>
                </c:pt>
                <c:pt idx="1839">
                  <c:v>11.797879219055176</c:v>
                </c:pt>
                <c:pt idx="1840">
                  <c:v>11.81013011932373</c:v>
                </c:pt>
                <c:pt idx="1841">
                  <c:v>11.822382926940918</c:v>
                </c:pt>
                <c:pt idx="1842">
                  <c:v>11.834638595581055</c:v>
                </c:pt>
                <c:pt idx="1843">
                  <c:v>11.846896171569824</c:v>
                </c:pt>
                <c:pt idx="1844">
                  <c:v>11.859156608581543</c:v>
                </c:pt>
                <c:pt idx="1845">
                  <c:v>11.871418952941895</c:v>
                </c:pt>
                <c:pt idx="1846">
                  <c:v>11.883684158325195</c:v>
                </c:pt>
                <c:pt idx="1847">
                  <c:v>11.895951271057129</c:v>
                </c:pt>
                <c:pt idx="1848">
                  <c:v>11.908221244812012</c:v>
                </c:pt>
                <c:pt idx="1849">
                  <c:v>11.920493125915527</c:v>
                </c:pt>
                <c:pt idx="1850">
                  <c:v>11.932767868041992</c:v>
                </c:pt>
                <c:pt idx="1851">
                  <c:v>11.945045471191406</c:v>
                </c:pt>
                <c:pt idx="1852">
                  <c:v>11.957324028015137</c:v>
                </c:pt>
                <c:pt idx="1853">
                  <c:v>11.969606399536133</c:v>
                </c:pt>
                <c:pt idx="1854">
                  <c:v>11.981890678405762</c:v>
                </c:pt>
                <c:pt idx="1855">
                  <c:v>11.99417781829834</c:v>
                </c:pt>
                <c:pt idx="1856">
                  <c:v>12.006466865539551</c:v>
                </c:pt>
                <c:pt idx="1857">
                  <c:v>12.018758773803711</c:v>
                </c:pt>
                <c:pt idx="1858">
                  <c:v>12.031052589416504</c:v>
                </c:pt>
                <c:pt idx="1859">
                  <c:v>12.043349266052246</c:v>
                </c:pt>
                <c:pt idx="1860">
                  <c:v>12.055647850036621</c:v>
                </c:pt>
                <c:pt idx="1861">
                  <c:v>12.067949295043945</c:v>
                </c:pt>
                <c:pt idx="1862">
                  <c:v>12.080252647399902</c:v>
                </c:pt>
                <c:pt idx="1863">
                  <c:v>12.092558860778809</c:v>
                </c:pt>
                <c:pt idx="1864">
                  <c:v>12.104866981506348</c:v>
                </c:pt>
                <c:pt idx="1865">
                  <c:v>12.117177963256836</c:v>
                </c:pt>
                <c:pt idx="1866">
                  <c:v>12.129490852355957</c:v>
                </c:pt>
                <c:pt idx="1867">
                  <c:v>12.141806602478027</c:v>
                </c:pt>
                <c:pt idx="1868">
                  <c:v>12.15412425994873</c:v>
                </c:pt>
                <c:pt idx="1869">
                  <c:v>12.166444778442383</c:v>
                </c:pt>
                <c:pt idx="1870">
                  <c:v>12.178766250610352</c:v>
                </c:pt>
                <c:pt idx="1871">
                  <c:v>12.191091537475586</c:v>
                </c:pt>
                <c:pt idx="1872">
                  <c:v>12.203417778015137</c:v>
                </c:pt>
                <c:pt idx="1873">
                  <c:v>12.215746879577637</c:v>
                </c:pt>
                <c:pt idx="1874">
                  <c:v>12.228078842163086</c:v>
                </c:pt>
                <c:pt idx="1875">
                  <c:v>12.240412712097168</c:v>
                </c:pt>
                <c:pt idx="1876">
                  <c:v>12.252748489379883</c:v>
                </c:pt>
                <c:pt idx="1877">
                  <c:v>12.26508617401123</c:v>
                </c:pt>
                <c:pt idx="1878">
                  <c:v>12.277426719665527</c:v>
                </c:pt>
                <c:pt idx="1879">
                  <c:v>12.289768218994141</c:v>
                </c:pt>
                <c:pt idx="1880">
                  <c:v>12.30211353302002</c:v>
                </c:pt>
                <c:pt idx="1881">
                  <c:v>12.314459800720215</c:v>
                </c:pt>
                <c:pt idx="1882">
                  <c:v>12.326808929443359</c:v>
                </c:pt>
                <c:pt idx="1883">
                  <c:v>12.339159965515137</c:v>
                </c:pt>
                <c:pt idx="1884">
                  <c:v>12.351512908935547</c:v>
                </c:pt>
                <c:pt idx="1885">
                  <c:v>12.363868713378906</c:v>
                </c:pt>
                <c:pt idx="1886">
                  <c:v>12.376225471496582</c:v>
                </c:pt>
                <c:pt idx="1887">
                  <c:v>12.388585090637207</c:v>
                </c:pt>
                <c:pt idx="1888">
                  <c:v>12.400946617126465</c:v>
                </c:pt>
                <c:pt idx="1889">
                  <c:v>12.413310050964355</c:v>
                </c:pt>
                <c:pt idx="1890">
                  <c:v>12.425676345825195</c:v>
                </c:pt>
                <c:pt idx="1891">
                  <c:v>12.438043594360352</c:v>
                </c:pt>
                <c:pt idx="1892">
                  <c:v>12.450413703918457</c:v>
                </c:pt>
                <c:pt idx="1893">
                  <c:v>12.462784767150879</c:v>
                </c:pt>
                <c:pt idx="1894">
                  <c:v>12.47515869140625</c:v>
                </c:pt>
                <c:pt idx="1895">
                  <c:v>12.487534523010254</c:v>
                </c:pt>
                <c:pt idx="1896">
                  <c:v>12.499912261962891</c:v>
                </c:pt>
                <c:pt idx="1897">
                  <c:v>12.51229190826416</c:v>
                </c:pt>
                <c:pt idx="1898">
                  <c:v>12.524673461914063</c:v>
                </c:pt>
                <c:pt idx="1899">
                  <c:v>12.537056922912598</c:v>
                </c:pt>
                <c:pt idx="1900">
                  <c:v>12.549443244934082</c:v>
                </c:pt>
                <c:pt idx="1901">
                  <c:v>12.561830520629883</c:v>
                </c:pt>
                <c:pt idx="1902">
                  <c:v>12.574219703674316</c:v>
                </c:pt>
                <c:pt idx="1903">
                  <c:v>12.586610794067383</c:v>
                </c:pt>
                <c:pt idx="1904">
                  <c:v>12.599004745483398</c:v>
                </c:pt>
                <c:pt idx="1905">
                  <c:v>12.61139965057373</c:v>
                </c:pt>
                <c:pt idx="1906">
                  <c:v>12.623796463012695</c:v>
                </c:pt>
                <c:pt idx="1907">
                  <c:v>12.636195182800293</c:v>
                </c:pt>
                <c:pt idx="1908">
                  <c:v>12.648595809936523</c:v>
                </c:pt>
                <c:pt idx="1909">
                  <c:v>12.660998344421387</c:v>
                </c:pt>
                <c:pt idx="1910">
                  <c:v>12.673402786254883</c:v>
                </c:pt>
                <c:pt idx="1911">
                  <c:v>12.685809135437012</c:v>
                </c:pt>
                <c:pt idx="1912">
                  <c:v>12.698216438293457</c:v>
                </c:pt>
                <c:pt idx="1913">
                  <c:v>12.710626602172852</c:v>
                </c:pt>
                <c:pt idx="1914">
                  <c:v>12.723037719726563</c:v>
                </c:pt>
                <c:pt idx="1915">
                  <c:v>12.735450744628906</c:v>
                </c:pt>
                <c:pt idx="1916">
                  <c:v>12.747865676879883</c:v>
                </c:pt>
                <c:pt idx="1917">
                  <c:v>12.760282516479492</c:v>
                </c:pt>
                <c:pt idx="1918">
                  <c:v>12.772701263427734</c:v>
                </c:pt>
                <c:pt idx="1919">
                  <c:v>12.785121917724609</c:v>
                </c:pt>
                <c:pt idx="1920">
                  <c:v>12.797543525695801</c:v>
                </c:pt>
                <c:pt idx="1921">
                  <c:v>12.809967041015625</c:v>
                </c:pt>
                <c:pt idx="1922">
                  <c:v>12.822392463684082</c:v>
                </c:pt>
                <c:pt idx="1923">
                  <c:v>12.834818840026855</c:v>
                </c:pt>
                <c:pt idx="1924">
                  <c:v>12.847248077392578</c:v>
                </c:pt>
                <c:pt idx="1925">
                  <c:v>12.859678268432617</c:v>
                </c:pt>
                <c:pt idx="1926">
                  <c:v>12.872109413146973</c:v>
                </c:pt>
                <c:pt idx="1927">
                  <c:v>12.884543418884277</c:v>
                </c:pt>
                <c:pt idx="1928">
                  <c:v>12.896978378295898</c:v>
                </c:pt>
                <c:pt idx="1929">
                  <c:v>12.909415245056152</c:v>
                </c:pt>
                <c:pt idx="1930">
                  <c:v>12.921854019165039</c:v>
                </c:pt>
                <c:pt idx="1931">
                  <c:v>12.934293746948242</c:v>
                </c:pt>
                <c:pt idx="1932">
                  <c:v>12.946735382080078</c:v>
                </c:pt>
                <c:pt idx="1933">
                  <c:v>12.95917797088623</c:v>
                </c:pt>
                <c:pt idx="1934">
                  <c:v>12.971622467041016</c:v>
                </c:pt>
                <c:pt idx="1935">
                  <c:v>12.984068870544434</c:v>
                </c:pt>
                <c:pt idx="1936">
                  <c:v>12.996516227722168</c:v>
                </c:pt>
                <c:pt idx="1937">
                  <c:v>13.008965492248535</c:v>
                </c:pt>
                <c:pt idx="1938">
                  <c:v>13.021415710449219</c:v>
                </c:pt>
                <c:pt idx="1939">
                  <c:v>13.033867835998535</c:v>
                </c:pt>
                <c:pt idx="1940">
                  <c:v>13.046321868896484</c:v>
                </c:pt>
                <c:pt idx="1941">
                  <c:v>13.05877685546875</c:v>
                </c:pt>
                <c:pt idx="1942">
                  <c:v>13.071233749389648</c:v>
                </c:pt>
                <c:pt idx="1943">
                  <c:v>13.08369255065918</c:v>
                </c:pt>
                <c:pt idx="1944">
                  <c:v>13.096153259277344</c:v>
                </c:pt>
                <c:pt idx="1945">
                  <c:v>13.108614921569824</c:v>
                </c:pt>
                <c:pt idx="1946">
                  <c:v>13.121079444885254</c:v>
                </c:pt>
                <c:pt idx="1947">
                  <c:v>13.133543968200684</c:v>
                </c:pt>
                <c:pt idx="1948">
                  <c:v>13.146012306213379</c:v>
                </c:pt>
                <c:pt idx="1949">
                  <c:v>13.158480644226074</c:v>
                </c:pt>
                <c:pt idx="1950">
                  <c:v>13.170951843261719</c:v>
                </c:pt>
                <c:pt idx="1951">
                  <c:v>13.18342399597168</c:v>
                </c:pt>
                <c:pt idx="1952">
                  <c:v>13.195899963378906</c:v>
                </c:pt>
                <c:pt idx="1953">
                  <c:v>13.208375930786133</c:v>
                </c:pt>
                <c:pt idx="1954">
                  <c:v>13.220854759216309</c:v>
                </c:pt>
                <c:pt idx="1955">
                  <c:v>13.233335494995117</c:v>
                </c:pt>
                <c:pt idx="1956">
                  <c:v>13.245817184448242</c:v>
                </c:pt>
                <c:pt idx="1957">
                  <c:v>13.258301734924316</c:v>
                </c:pt>
                <c:pt idx="1958">
                  <c:v>13.270787239074707</c:v>
                </c:pt>
                <c:pt idx="1959">
                  <c:v>13.28327465057373</c:v>
                </c:pt>
                <c:pt idx="1960">
                  <c:v>13.295764923095703</c:v>
                </c:pt>
                <c:pt idx="1961">
                  <c:v>13.308256149291992</c:v>
                </c:pt>
                <c:pt idx="1962">
                  <c:v>13.32075023651123</c:v>
                </c:pt>
                <c:pt idx="1963">
                  <c:v>13.333247184753418</c:v>
                </c:pt>
                <c:pt idx="1964">
                  <c:v>13.345745086669922</c:v>
                </c:pt>
                <c:pt idx="1965">
                  <c:v>13.358244895935059</c:v>
                </c:pt>
                <c:pt idx="1966">
                  <c:v>13.370747566223145</c:v>
                </c:pt>
                <c:pt idx="1967">
                  <c:v>13.383252143859863</c:v>
                </c:pt>
                <c:pt idx="1968">
                  <c:v>13.395758628845215</c:v>
                </c:pt>
                <c:pt idx="1969">
                  <c:v>13.408267021179199</c:v>
                </c:pt>
                <c:pt idx="1970">
                  <c:v>13.420778274536133</c:v>
                </c:pt>
                <c:pt idx="1971">
                  <c:v>13.433291435241699</c:v>
                </c:pt>
                <c:pt idx="1972">
                  <c:v>13.445807456970215</c:v>
                </c:pt>
                <c:pt idx="1973">
                  <c:v>13.458325386047363</c:v>
                </c:pt>
                <c:pt idx="1974">
                  <c:v>13.470845222473145</c:v>
                </c:pt>
                <c:pt idx="1975">
                  <c:v>13.483368873596191</c:v>
                </c:pt>
                <c:pt idx="1976">
                  <c:v>13.495893478393555</c:v>
                </c:pt>
                <c:pt idx="1977">
                  <c:v>13.508420944213867</c:v>
                </c:pt>
                <c:pt idx="1978">
                  <c:v>13.520951271057129</c:v>
                </c:pt>
                <c:pt idx="1979">
                  <c:v>13.533482551574707</c:v>
                </c:pt>
                <c:pt idx="1980">
                  <c:v>13.546017646789551</c:v>
                </c:pt>
                <c:pt idx="1981">
                  <c:v>13.558555603027344</c:v>
                </c:pt>
                <c:pt idx="1982">
                  <c:v>13.571096420288086</c:v>
                </c:pt>
                <c:pt idx="1983">
                  <c:v>13.583638191223145</c:v>
                </c:pt>
                <c:pt idx="1984">
                  <c:v>13.596183776855469</c:v>
                </c:pt>
                <c:pt idx="1985">
                  <c:v>13.608731269836426</c:v>
                </c:pt>
                <c:pt idx="1986">
                  <c:v>13.621283531188965</c:v>
                </c:pt>
                <c:pt idx="1987">
                  <c:v>13.63383674621582</c:v>
                </c:pt>
                <c:pt idx="1988">
                  <c:v>13.646391868591309</c:v>
                </c:pt>
                <c:pt idx="1989">
                  <c:v>13.658949851989746</c:v>
                </c:pt>
                <c:pt idx="1990">
                  <c:v>13.671511650085449</c:v>
                </c:pt>
                <c:pt idx="1991">
                  <c:v>13.684075355529785</c:v>
                </c:pt>
                <c:pt idx="1992">
                  <c:v>13.69664192199707</c:v>
                </c:pt>
                <c:pt idx="1993">
                  <c:v>13.709211349487305</c:v>
                </c:pt>
                <c:pt idx="1994">
                  <c:v>13.721784591674805</c:v>
                </c:pt>
                <c:pt idx="1995">
                  <c:v>13.734358787536621</c:v>
                </c:pt>
                <c:pt idx="1996">
                  <c:v>13.746936798095703</c:v>
                </c:pt>
                <c:pt idx="1997">
                  <c:v>13.759517669677734</c:v>
                </c:pt>
                <c:pt idx="1998">
                  <c:v>13.772102355957031</c:v>
                </c:pt>
                <c:pt idx="1999">
                  <c:v>13.784689903259277</c:v>
                </c:pt>
                <c:pt idx="2000">
                  <c:v>13.797280311584473</c:v>
                </c:pt>
                <c:pt idx="2001">
                  <c:v>13.809873580932617</c:v>
                </c:pt>
                <c:pt idx="2002">
                  <c:v>13.822469711303711</c:v>
                </c:pt>
                <c:pt idx="2003">
                  <c:v>13.835067749023438</c:v>
                </c:pt>
                <c:pt idx="2004">
                  <c:v>13.847668647766113</c:v>
                </c:pt>
                <c:pt idx="2005">
                  <c:v>13.860274314880371</c:v>
                </c:pt>
                <c:pt idx="2006">
                  <c:v>13.872882843017578</c:v>
                </c:pt>
                <c:pt idx="2007">
                  <c:v>13.885493278503418</c:v>
                </c:pt>
                <c:pt idx="2008">
                  <c:v>13.898107528686523</c:v>
                </c:pt>
                <c:pt idx="2009">
                  <c:v>13.910725593566895</c:v>
                </c:pt>
                <c:pt idx="2010">
                  <c:v>13.923345565795898</c:v>
                </c:pt>
                <c:pt idx="2011">
                  <c:v>13.935968399047852</c:v>
                </c:pt>
                <c:pt idx="2012">
                  <c:v>13.948594093322754</c:v>
                </c:pt>
                <c:pt idx="2013">
                  <c:v>13.961224555969238</c:v>
                </c:pt>
                <c:pt idx="2014">
                  <c:v>13.973856925964355</c:v>
                </c:pt>
                <c:pt idx="2015">
                  <c:v>13.986493110656738</c:v>
                </c:pt>
                <c:pt idx="2016">
                  <c:v>13.99913215637207</c:v>
                </c:pt>
                <c:pt idx="2017">
                  <c:v>14.011774063110352</c:v>
                </c:pt>
                <c:pt idx="2018">
                  <c:v>14.024419784545898</c:v>
                </c:pt>
                <c:pt idx="2019">
                  <c:v>14.037068367004395</c:v>
                </c:pt>
                <c:pt idx="2020">
                  <c:v>14.04971981048584</c:v>
                </c:pt>
                <c:pt idx="2021">
                  <c:v>14.062376976013184</c:v>
                </c:pt>
                <c:pt idx="2022">
                  <c:v>14.07503604888916</c:v>
                </c:pt>
                <c:pt idx="2023">
                  <c:v>14.087698936462402</c:v>
                </c:pt>
                <c:pt idx="2024">
                  <c:v>14.100363731384277</c:v>
                </c:pt>
                <c:pt idx="2025">
                  <c:v>14.113031387329102</c:v>
                </c:pt>
                <c:pt idx="2026">
                  <c:v>14.125704765319824</c:v>
                </c:pt>
                <c:pt idx="2027">
                  <c:v>14.13838005065918</c:v>
                </c:pt>
                <c:pt idx="2028">
                  <c:v>14.151059150695801</c:v>
                </c:pt>
                <c:pt idx="2029">
                  <c:v>14.163741111755371</c:v>
                </c:pt>
                <c:pt idx="2030">
                  <c:v>14.176424980163574</c:v>
                </c:pt>
                <c:pt idx="2031">
                  <c:v>14.189116477966309</c:v>
                </c:pt>
                <c:pt idx="2032">
                  <c:v>14.201808929443359</c:v>
                </c:pt>
                <c:pt idx="2033">
                  <c:v>14.214505195617676</c:v>
                </c:pt>
                <c:pt idx="2034">
                  <c:v>14.227204322814941</c:v>
                </c:pt>
                <c:pt idx="2035">
                  <c:v>14.239908218383789</c:v>
                </c:pt>
                <c:pt idx="2036">
                  <c:v>14.252614974975586</c:v>
                </c:pt>
                <c:pt idx="2037">
                  <c:v>14.265325546264648</c:v>
                </c:pt>
                <c:pt idx="2038">
                  <c:v>14.278038024902344</c:v>
                </c:pt>
                <c:pt idx="2039">
                  <c:v>14.290754318237305</c:v>
                </c:pt>
                <c:pt idx="2040">
                  <c:v>14.303474426269531</c:v>
                </c:pt>
                <c:pt idx="2041">
                  <c:v>14.316198348999023</c:v>
                </c:pt>
                <c:pt idx="2042">
                  <c:v>14.328926086425781</c:v>
                </c:pt>
                <c:pt idx="2043">
                  <c:v>14.341656684875488</c:v>
                </c:pt>
                <c:pt idx="2044">
                  <c:v>14.354390144348145</c:v>
                </c:pt>
                <c:pt idx="2045">
                  <c:v>14.367128372192383</c:v>
                </c:pt>
                <c:pt idx="2046">
                  <c:v>14.379870414733887</c:v>
                </c:pt>
                <c:pt idx="2047">
                  <c:v>14.392617225646973</c:v>
                </c:pt>
                <c:pt idx="2048">
                  <c:v>14.405364990234375</c:v>
                </c:pt>
                <c:pt idx="2049">
                  <c:v>14.418117523193359</c:v>
                </c:pt>
                <c:pt idx="2050">
                  <c:v>14.430872917175293</c:v>
                </c:pt>
                <c:pt idx="2051">
                  <c:v>14.443632125854492</c:v>
                </c:pt>
                <c:pt idx="2052">
                  <c:v>14.456394195556641</c:v>
                </c:pt>
                <c:pt idx="2053">
                  <c:v>14.469161987304688</c:v>
                </c:pt>
                <c:pt idx="2054">
                  <c:v>14.481931686401367</c:v>
                </c:pt>
                <c:pt idx="2055">
                  <c:v>14.494705200195313</c:v>
                </c:pt>
                <c:pt idx="2056">
                  <c:v>14.507482528686523</c:v>
                </c:pt>
                <c:pt idx="2057">
                  <c:v>14.520261764526367</c:v>
                </c:pt>
                <c:pt idx="2058">
                  <c:v>14.53304386138916</c:v>
                </c:pt>
                <c:pt idx="2059">
                  <c:v>14.545832633972168</c:v>
                </c:pt>
                <c:pt idx="2060">
                  <c:v>14.558622360229492</c:v>
                </c:pt>
                <c:pt idx="2061">
                  <c:v>14.571416854858398</c:v>
                </c:pt>
                <c:pt idx="2062">
                  <c:v>14.584213256835938</c:v>
                </c:pt>
                <c:pt idx="2063">
                  <c:v>14.597015380859375</c:v>
                </c:pt>
                <c:pt idx="2064">
                  <c:v>14.609819412231445</c:v>
                </c:pt>
                <c:pt idx="2065">
                  <c:v>14.622628211975098</c:v>
                </c:pt>
                <c:pt idx="2066">
                  <c:v>14.635438919067383</c:v>
                </c:pt>
                <c:pt idx="2067">
                  <c:v>14.648253440856934</c:v>
                </c:pt>
                <c:pt idx="2068">
                  <c:v>14.66107177734375</c:v>
                </c:pt>
                <c:pt idx="2069">
                  <c:v>14.673893928527832</c:v>
                </c:pt>
                <c:pt idx="2070">
                  <c:v>14.68671989440918</c:v>
                </c:pt>
                <c:pt idx="2071">
                  <c:v>14.699549674987793</c:v>
                </c:pt>
                <c:pt idx="2072">
                  <c:v>14.712382316589355</c:v>
                </c:pt>
                <c:pt idx="2073">
                  <c:v>14.725220680236816</c:v>
                </c:pt>
                <c:pt idx="2074">
                  <c:v>14.73806095123291</c:v>
                </c:pt>
                <c:pt idx="2075">
                  <c:v>14.75090503692627</c:v>
                </c:pt>
                <c:pt idx="2076">
                  <c:v>14.763751983642578</c:v>
                </c:pt>
                <c:pt idx="2077">
                  <c:v>14.776606559753418</c:v>
                </c:pt>
                <c:pt idx="2078">
                  <c:v>14.789463043212891</c:v>
                </c:pt>
                <c:pt idx="2079">
                  <c:v>14.802323341369629</c:v>
                </c:pt>
                <c:pt idx="2080">
                  <c:v>14.815185546875</c:v>
                </c:pt>
                <c:pt idx="2081">
                  <c:v>14.828052520751953</c:v>
                </c:pt>
                <c:pt idx="2082">
                  <c:v>14.840922355651855</c:v>
                </c:pt>
                <c:pt idx="2083">
                  <c:v>14.853798866271973</c:v>
                </c:pt>
                <c:pt idx="2084">
                  <c:v>14.86667537689209</c:v>
                </c:pt>
                <c:pt idx="2085">
                  <c:v>14.879558563232422</c:v>
                </c:pt>
                <c:pt idx="2086">
                  <c:v>14.892443656921387</c:v>
                </c:pt>
                <c:pt idx="2087">
                  <c:v>14.90533447265625</c:v>
                </c:pt>
                <c:pt idx="2088">
                  <c:v>14.918227195739746</c:v>
                </c:pt>
                <c:pt idx="2089">
                  <c:v>14.931125640869141</c:v>
                </c:pt>
                <c:pt idx="2090">
                  <c:v>14.944024085998535</c:v>
                </c:pt>
                <c:pt idx="2091">
                  <c:v>14.956929206848145</c:v>
                </c:pt>
                <c:pt idx="2092">
                  <c:v>14.969837188720703</c:v>
                </c:pt>
                <c:pt idx="2093">
                  <c:v>14.98275089263916</c:v>
                </c:pt>
                <c:pt idx="2094">
                  <c:v>14.995665550231934</c:v>
                </c:pt>
                <c:pt idx="2095">
                  <c:v>15.008587837219238</c:v>
                </c:pt>
                <c:pt idx="2096">
                  <c:v>15.021511077880859</c:v>
                </c:pt>
                <c:pt idx="2097">
                  <c:v>15.034438133239746</c:v>
                </c:pt>
                <c:pt idx="2098">
                  <c:v>15.047370910644531</c:v>
                </c:pt>
                <c:pt idx="2099">
                  <c:v>15.060306549072266</c:v>
                </c:pt>
                <c:pt idx="2100">
                  <c:v>15.073245048522949</c:v>
                </c:pt>
                <c:pt idx="2101">
                  <c:v>15.086191177368164</c:v>
                </c:pt>
                <c:pt idx="2102">
                  <c:v>15.099139213562012</c:v>
                </c:pt>
                <c:pt idx="2103">
                  <c:v>15.112091064453125</c:v>
                </c:pt>
                <c:pt idx="2104">
                  <c:v>15.125045776367188</c:v>
                </c:pt>
                <c:pt idx="2105">
                  <c:v>15.138005256652832</c:v>
                </c:pt>
                <c:pt idx="2106">
                  <c:v>15.150967597961426</c:v>
                </c:pt>
                <c:pt idx="2107">
                  <c:v>15.163933753967285</c:v>
                </c:pt>
                <c:pt idx="2108">
                  <c:v>15.176902770996094</c:v>
                </c:pt>
                <c:pt idx="2109">
                  <c:v>15.189878463745117</c:v>
                </c:pt>
                <c:pt idx="2110">
                  <c:v>15.202853202819824</c:v>
                </c:pt>
                <c:pt idx="2111">
                  <c:v>15.21583366394043</c:v>
                </c:pt>
                <c:pt idx="2112">
                  <c:v>15.228816986083984</c:v>
                </c:pt>
                <c:pt idx="2113">
                  <c:v>15.241806983947754</c:v>
                </c:pt>
                <c:pt idx="2114">
                  <c:v>15.25479793548584</c:v>
                </c:pt>
                <c:pt idx="2115">
                  <c:v>15.267795562744141</c:v>
                </c:pt>
                <c:pt idx="2116">
                  <c:v>15.280793190002441</c:v>
                </c:pt>
                <c:pt idx="2117">
                  <c:v>15.293795585632324</c:v>
                </c:pt>
                <c:pt idx="2118">
                  <c:v>15.306802749633789</c:v>
                </c:pt>
                <c:pt idx="2119">
                  <c:v>15.319815635681152</c:v>
                </c:pt>
                <c:pt idx="2120">
                  <c:v>15.332830429077148</c:v>
                </c:pt>
                <c:pt idx="2121">
                  <c:v>15.34584903717041</c:v>
                </c:pt>
                <c:pt idx="2122">
                  <c:v>15.358871459960938</c:v>
                </c:pt>
                <c:pt idx="2123">
                  <c:v>15.371898651123047</c:v>
                </c:pt>
                <c:pt idx="2124">
                  <c:v>15.384927749633789</c:v>
                </c:pt>
                <c:pt idx="2125">
                  <c:v>15.39796257019043</c:v>
                </c:pt>
                <c:pt idx="2126">
                  <c:v>15.411001205444336</c:v>
                </c:pt>
                <c:pt idx="2127">
                  <c:v>15.424042701721191</c:v>
                </c:pt>
                <c:pt idx="2128">
                  <c:v>15.437085151672363</c:v>
                </c:pt>
                <c:pt idx="2129">
                  <c:v>15.450136184692383</c:v>
                </c:pt>
                <c:pt idx="2130">
                  <c:v>15.463189125061035</c:v>
                </c:pt>
                <c:pt idx="2131">
                  <c:v>15.47624683380127</c:v>
                </c:pt>
                <c:pt idx="2132">
                  <c:v>15.489307403564453</c:v>
                </c:pt>
                <c:pt idx="2133">
                  <c:v>15.502374649047852</c:v>
                </c:pt>
                <c:pt idx="2134">
                  <c:v>15.515445709228516</c:v>
                </c:pt>
                <c:pt idx="2135">
                  <c:v>15.528519630432129</c:v>
                </c:pt>
                <c:pt idx="2136">
                  <c:v>15.541597366333008</c:v>
                </c:pt>
                <c:pt idx="2137">
                  <c:v>15.554678916931152</c:v>
                </c:pt>
                <c:pt idx="2138">
                  <c:v>15.567768096923828</c:v>
                </c:pt>
                <c:pt idx="2139">
                  <c:v>15.580856323242188</c:v>
                </c:pt>
                <c:pt idx="2140">
                  <c:v>15.593950271606445</c:v>
                </c:pt>
                <c:pt idx="2141">
                  <c:v>15.607049942016602</c:v>
                </c:pt>
                <c:pt idx="2142">
                  <c:v>15.620151519775391</c:v>
                </c:pt>
                <c:pt idx="2143">
                  <c:v>15.633255004882813</c:v>
                </c:pt>
                <c:pt idx="2144">
                  <c:v>15.646364212036133</c:v>
                </c:pt>
                <c:pt idx="2145">
                  <c:v>15.659477233886719</c:v>
                </c:pt>
                <c:pt idx="2146">
                  <c:v>15.67259407043457</c:v>
                </c:pt>
                <c:pt idx="2147">
                  <c:v>15.685714721679688</c:v>
                </c:pt>
                <c:pt idx="2148">
                  <c:v>15.698837280273438</c:v>
                </c:pt>
                <c:pt idx="2149">
                  <c:v>15.711963653564453</c:v>
                </c:pt>
                <c:pt idx="2150">
                  <c:v>15.725095748901367</c:v>
                </c:pt>
                <c:pt idx="2151">
                  <c:v>15.73823070526123</c:v>
                </c:pt>
                <c:pt idx="2152">
                  <c:v>15.751370429992676</c:v>
                </c:pt>
                <c:pt idx="2153">
                  <c:v>15.76451301574707</c:v>
                </c:pt>
                <c:pt idx="2154">
                  <c:v>15.777658462524414</c:v>
                </c:pt>
                <c:pt idx="2155">
                  <c:v>15.79080867767334</c:v>
                </c:pt>
                <c:pt idx="2156">
                  <c:v>15.803964614868164</c:v>
                </c:pt>
                <c:pt idx="2157">
                  <c:v>15.817123413085938</c:v>
                </c:pt>
                <c:pt idx="2158">
                  <c:v>15.830283164978027</c:v>
                </c:pt>
                <c:pt idx="2159">
                  <c:v>15.843447685241699</c:v>
                </c:pt>
                <c:pt idx="2160">
                  <c:v>15.856616973876953</c:v>
                </c:pt>
                <c:pt idx="2161">
                  <c:v>15.869789123535156</c:v>
                </c:pt>
                <c:pt idx="2162">
                  <c:v>15.882965087890625</c:v>
                </c:pt>
                <c:pt idx="2163">
                  <c:v>15.896143913269043</c:v>
                </c:pt>
                <c:pt idx="2164">
                  <c:v>15.909327507019043</c:v>
                </c:pt>
                <c:pt idx="2165">
                  <c:v>15.922513961791992</c:v>
                </c:pt>
                <c:pt idx="2166">
                  <c:v>15.935705184936523</c:v>
                </c:pt>
                <c:pt idx="2167">
                  <c:v>15.948899269104004</c:v>
                </c:pt>
                <c:pt idx="2168">
                  <c:v>15.96209716796875</c:v>
                </c:pt>
                <c:pt idx="2169">
                  <c:v>15.975297927856445</c:v>
                </c:pt>
                <c:pt idx="2170">
                  <c:v>15.988502502441406</c:v>
                </c:pt>
                <c:pt idx="2171">
                  <c:v>16.002017974853516</c:v>
                </c:pt>
                <c:pt idx="2172">
                  <c:v>16.015537261962891</c:v>
                </c:pt>
                <c:pt idx="2173">
                  <c:v>16.029062271118164</c:v>
                </c:pt>
                <c:pt idx="2174">
                  <c:v>16.042591094970703</c:v>
                </c:pt>
                <c:pt idx="2175">
                  <c:v>16.056118011474609</c:v>
                </c:pt>
                <c:pt idx="2176">
                  <c:v>16.069650650024414</c:v>
                </c:pt>
                <c:pt idx="2177">
                  <c:v>16.083185195922852</c:v>
                </c:pt>
                <c:pt idx="2178">
                  <c:v>16.096725463867188</c:v>
                </c:pt>
                <c:pt idx="2179">
                  <c:v>16.110269546508789</c:v>
                </c:pt>
                <c:pt idx="2180">
                  <c:v>16.123819351196289</c:v>
                </c:pt>
                <c:pt idx="2181">
                  <c:v>16.137371063232422</c:v>
                </c:pt>
                <c:pt idx="2182">
                  <c:v>16.150928497314453</c:v>
                </c:pt>
                <c:pt idx="2183">
                  <c:v>16.164487838745117</c:v>
                </c:pt>
                <c:pt idx="2184">
                  <c:v>16.17805290222168</c:v>
                </c:pt>
                <c:pt idx="2185">
                  <c:v>16.191621780395508</c:v>
                </c:pt>
                <c:pt idx="2186">
                  <c:v>16.205194473266602</c:v>
                </c:pt>
                <c:pt idx="2187">
                  <c:v>16.218769073486328</c:v>
                </c:pt>
                <c:pt idx="2188">
                  <c:v>16.232349395751953</c:v>
                </c:pt>
                <c:pt idx="2189">
                  <c:v>16.245931625366211</c:v>
                </c:pt>
                <c:pt idx="2190">
                  <c:v>16.259517669677734</c:v>
                </c:pt>
                <c:pt idx="2191">
                  <c:v>16.273109436035156</c:v>
                </c:pt>
                <c:pt idx="2192">
                  <c:v>16.286703109741211</c:v>
                </c:pt>
                <c:pt idx="2193">
                  <c:v>16.300300598144531</c:v>
                </c:pt>
                <c:pt idx="2194">
                  <c:v>16.313899993896484</c:v>
                </c:pt>
                <c:pt idx="2195">
                  <c:v>16.327505111694336</c:v>
                </c:pt>
                <c:pt idx="2196">
                  <c:v>16.341114044189453</c:v>
                </c:pt>
                <c:pt idx="2197">
                  <c:v>16.354724884033203</c:v>
                </c:pt>
                <c:pt idx="2198">
                  <c:v>16.368339538574219</c:v>
                </c:pt>
                <c:pt idx="2199">
                  <c:v>16.3819580078125</c:v>
                </c:pt>
                <c:pt idx="2200">
                  <c:v>16.395580291748047</c:v>
                </c:pt>
                <c:pt idx="2201">
                  <c:v>16.409206390380859</c:v>
                </c:pt>
                <c:pt idx="2202">
                  <c:v>16.422834396362305</c:v>
                </c:pt>
                <c:pt idx="2203">
                  <c:v>16.436468124389648</c:v>
                </c:pt>
                <c:pt idx="2204">
                  <c:v>16.450103759765625</c:v>
                </c:pt>
                <c:pt idx="2205">
                  <c:v>16.4637451171875</c:v>
                </c:pt>
                <c:pt idx="2206">
                  <c:v>16.477388381958008</c:v>
                </c:pt>
                <c:pt idx="2207">
                  <c:v>16.491033554077148</c:v>
                </c:pt>
                <c:pt idx="2208">
                  <c:v>16.504684448242188</c:v>
                </c:pt>
                <c:pt idx="2209">
                  <c:v>16.518337249755859</c:v>
                </c:pt>
                <c:pt idx="2210">
                  <c:v>16.531993865966797</c:v>
                </c:pt>
                <c:pt idx="2211">
                  <c:v>16.545654296875</c:v>
                </c:pt>
                <c:pt idx="2212">
                  <c:v>16.559318542480469</c:v>
                </c:pt>
                <c:pt idx="2213">
                  <c:v>16.572982788085938</c:v>
                </c:pt>
                <c:pt idx="2214">
                  <c:v>16.586652755737305</c:v>
                </c:pt>
                <c:pt idx="2215">
                  <c:v>16.60032844543457</c:v>
                </c:pt>
                <c:pt idx="2216">
                  <c:v>16.614006042480469</c:v>
                </c:pt>
                <c:pt idx="2217">
                  <c:v>16.627689361572266</c:v>
                </c:pt>
                <c:pt idx="2218">
                  <c:v>16.641372680664063</c:v>
                </c:pt>
                <c:pt idx="2219">
                  <c:v>16.655061721801758</c:v>
                </c:pt>
                <c:pt idx="2220">
                  <c:v>16.668754577636719</c:v>
                </c:pt>
                <c:pt idx="2221">
                  <c:v>16.682451248168945</c:v>
                </c:pt>
                <c:pt idx="2222">
                  <c:v>16.696149826049805</c:v>
                </c:pt>
                <c:pt idx="2223">
                  <c:v>16.70985221862793</c:v>
                </c:pt>
                <c:pt idx="2224">
                  <c:v>16.723560333251953</c:v>
                </c:pt>
                <c:pt idx="2225">
                  <c:v>16.737268447875977</c:v>
                </c:pt>
                <c:pt idx="2226">
                  <c:v>16.750982284545898</c:v>
                </c:pt>
                <c:pt idx="2227">
                  <c:v>16.764698028564453</c:v>
                </c:pt>
                <c:pt idx="2228">
                  <c:v>16.778417587280273</c:v>
                </c:pt>
                <c:pt idx="2229">
                  <c:v>16.792140960693359</c:v>
                </c:pt>
                <c:pt idx="2230">
                  <c:v>16.805868148803711</c:v>
                </c:pt>
                <c:pt idx="2231">
                  <c:v>16.819599151611328</c:v>
                </c:pt>
                <c:pt idx="2232">
                  <c:v>16.833333969116211</c:v>
                </c:pt>
                <c:pt idx="2233">
                  <c:v>16.847070693969727</c:v>
                </c:pt>
                <c:pt idx="2234">
                  <c:v>16.860813140869141</c:v>
                </c:pt>
                <c:pt idx="2235">
                  <c:v>16.874557495117188</c:v>
                </c:pt>
                <c:pt idx="2236">
                  <c:v>16.888303756713867</c:v>
                </c:pt>
                <c:pt idx="2237">
                  <c:v>16.902055740356445</c:v>
                </c:pt>
                <c:pt idx="2238">
                  <c:v>16.915811538696289</c:v>
                </c:pt>
                <c:pt idx="2239">
                  <c:v>16.929569244384766</c:v>
                </c:pt>
                <c:pt idx="2240">
                  <c:v>16.943330764770508</c:v>
                </c:pt>
                <c:pt idx="2241">
                  <c:v>16.957096099853516</c:v>
                </c:pt>
                <c:pt idx="2242">
                  <c:v>16.970865249633789</c:v>
                </c:pt>
                <c:pt idx="2243">
                  <c:v>16.984638214111328</c:v>
                </c:pt>
                <c:pt idx="2244">
                  <c:v>16.9984130859375</c:v>
                </c:pt>
                <c:pt idx="2245">
                  <c:v>17.012191772460938</c:v>
                </c:pt>
                <c:pt idx="2246">
                  <c:v>17.025974273681641</c:v>
                </c:pt>
                <c:pt idx="2247">
                  <c:v>17.039760589599609</c:v>
                </c:pt>
                <c:pt idx="2248">
                  <c:v>17.053550720214844</c:v>
                </c:pt>
                <c:pt idx="2249">
                  <c:v>17.067342758178711</c:v>
                </c:pt>
                <c:pt idx="2250">
                  <c:v>17.081140518188477</c:v>
                </c:pt>
                <c:pt idx="2251">
                  <c:v>17.094940185546875</c:v>
                </c:pt>
                <c:pt idx="2252">
                  <c:v>17.108743667602539</c:v>
                </c:pt>
                <c:pt idx="2253">
                  <c:v>17.122549057006836</c:v>
                </c:pt>
                <c:pt idx="2254">
                  <c:v>17.136360168457031</c:v>
                </c:pt>
                <c:pt idx="2255">
                  <c:v>17.150173187255859</c:v>
                </c:pt>
                <c:pt idx="2256">
                  <c:v>17.163990020751953</c:v>
                </c:pt>
                <c:pt idx="2257">
                  <c:v>17.177810668945313</c:v>
                </c:pt>
                <c:pt idx="2258">
                  <c:v>17.191635131835938</c:v>
                </c:pt>
                <c:pt idx="2259">
                  <c:v>17.205463409423828</c:v>
                </c:pt>
                <c:pt idx="2260">
                  <c:v>17.219293594360352</c:v>
                </c:pt>
                <c:pt idx="2261">
                  <c:v>17.233129501342773</c:v>
                </c:pt>
                <c:pt idx="2262">
                  <c:v>17.246967315673828</c:v>
                </c:pt>
                <c:pt idx="2263">
                  <c:v>17.260807037353516</c:v>
                </c:pt>
                <c:pt idx="2264">
                  <c:v>17.274652481079102</c:v>
                </c:pt>
                <c:pt idx="2265">
                  <c:v>17.288501739501953</c:v>
                </c:pt>
                <c:pt idx="2266">
                  <c:v>17.302352905273438</c:v>
                </c:pt>
                <c:pt idx="2267">
                  <c:v>17.316207885742188</c:v>
                </c:pt>
                <c:pt idx="2268">
                  <c:v>17.330066680908203</c:v>
                </c:pt>
                <c:pt idx="2269">
                  <c:v>17.343929290771484</c:v>
                </c:pt>
                <c:pt idx="2270">
                  <c:v>17.357793807983398</c:v>
                </c:pt>
                <c:pt idx="2271">
                  <c:v>17.371664047241211</c:v>
                </c:pt>
                <c:pt idx="2272">
                  <c:v>17.385536193847656</c:v>
                </c:pt>
                <c:pt idx="2273">
                  <c:v>17.399412155151367</c:v>
                </c:pt>
                <c:pt idx="2274">
                  <c:v>17.413291931152344</c:v>
                </c:pt>
                <c:pt idx="2275">
                  <c:v>17.427173614501953</c:v>
                </c:pt>
                <c:pt idx="2276">
                  <c:v>17.441061019897461</c:v>
                </c:pt>
                <c:pt idx="2277">
                  <c:v>17.454950332641602</c:v>
                </c:pt>
                <c:pt idx="2278">
                  <c:v>17.468843460083008</c:v>
                </c:pt>
                <c:pt idx="2279">
                  <c:v>17.48274040222168</c:v>
                </c:pt>
                <c:pt idx="2280">
                  <c:v>17.496641159057617</c:v>
                </c:pt>
                <c:pt idx="2281">
                  <c:v>17.510543823242188</c:v>
                </c:pt>
                <c:pt idx="2282">
                  <c:v>17.524452209472656</c:v>
                </c:pt>
                <c:pt idx="2283">
                  <c:v>17.538362503051758</c:v>
                </c:pt>
                <c:pt idx="2284">
                  <c:v>17.552276611328125</c:v>
                </c:pt>
                <c:pt idx="2285">
                  <c:v>17.566192626953125</c:v>
                </c:pt>
                <c:pt idx="2286">
                  <c:v>17.580114364624023</c:v>
                </c:pt>
                <c:pt idx="2287">
                  <c:v>17.594038009643555</c:v>
                </c:pt>
                <c:pt idx="2288">
                  <c:v>17.607967376708984</c:v>
                </c:pt>
                <c:pt idx="2289">
                  <c:v>17.621898651123047</c:v>
                </c:pt>
                <c:pt idx="2290">
                  <c:v>17.635833740234375</c:v>
                </c:pt>
                <c:pt idx="2291">
                  <c:v>17.649770736694336</c:v>
                </c:pt>
                <c:pt idx="2292">
                  <c:v>17.663713455200195</c:v>
                </c:pt>
                <c:pt idx="2293">
                  <c:v>17.677658081054688</c:v>
                </c:pt>
                <c:pt idx="2294">
                  <c:v>17.691606521606445</c:v>
                </c:pt>
                <c:pt idx="2295">
                  <c:v>17.705558776855469</c:v>
                </c:pt>
                <c:pt idx="2296">
                  <c:v>17.719514846801758</c:v>
                </c:pt>
                <c:pt idx="2297">
                  <c:v>17.73347282409668</c:v>
                </c:pt>
                <c:pt idx="2298">
                  <c:v>17.747434616088867</c:v>
                </c:pt>
                <c:pt idx="2299">
                  <c:v>17.761402130126953</c:v>
                </c:pt>
                <c:pt idx="2300">
                  <c:v>17.775371551513672</c:v>
                </c:pt>
                <c:pt idx="2301">
                  <c:v>17.789342880249023</c:v>
                </c:pt>
                <c:pt idx="2302">
                  <c:v>17.803319931030273</c:v>
                </c:pt>
                <c:pt idx="2303">
                  <c:v>17.817300796508789</c:v>
                </c:pt>
                <c:pt idx="2304">
                  <c:v>17.831283569335938</c:v>
                </c:pt>
                <c:pt idx="2305">
                  <c:v>17.845270156860352</c:v>
                </c:pt>
                <c:pt idx="2306">
                  <c:v>17.859260559082031</c:v>
                </c:pt>
                <c:pt idx="2307">
                  <c:v>17.873252868652344</c:v>
                </c:pt>
                <c:pt idx="2308">
                  <c:v>17.887250900268555</c:v>
                </c:pt>
                <c:pt idx="2309">
                  <c:v>17.901250839233398</c:v>
                </c:pt>
                <c:pt idx="2310">
                  <c:v>17.915254592895508</c:v>
                </c:pt>
                <c:pt idx="2311">
                  <c:v>17.929262161254883</c:v>
                </c:pt>
                <c:pt idx="2312">
                  <c:v>17.943271636962891</c:v>
                </c:pt>
                <c:pt idx="2313">
                  <c:v>17.957286834716797</c:v>
                </c:pt>
                <c:pt idx="2314">
                  <c:v>17.971303939819336</c:v>
                </c:pt>
                <c:pt idx="2315">
                  <c:v>17.985324859619141</c:v>
                </c:pt>
                <c:pt idx="2316">
                  <c:v>17.999349594116211</c:v>
                </c:pt>
                <c:pt idx="2317">
                  <c:v>18.01338005065918</c:v>
                </c:pt>
                <c:pt idx="2318">
                  <c:v>18.027410507202148</c:v>
                </c:pt>
                <c:pt idx="2319">
                  <c:v>18.041444778442383</c:v>
                </c:pt>
                <c:pt idx="2320">
                  <c:v>18.055484771728516</c:v>
                </c:pt>
                <c:pt idx="2321">
                  <c:v>18.069526672363281</c:v>
                </c:pt>
                <c:pt idx="2322">
                  <c:v>18.083572387695313</c:v>
                </c:pt>
                <c:pt idx="2323">
                  <c:v>18.097621917724609</c:v>
                </c:pt>
                <c:pt idx="2324">
                  <c:v>18.111675262451172</c:v>
                </c:pt>
                <c:pt idx="2325">
                  <c:v>18.125730514526367</c:v>
                </c:pt>
                <c:pt idx="2326">
                  <c:v>18.139789581298828</c:v>
                </c:pt>
                <c:pt idx="2327">
                  <c:v>18.153854370117188</c:v>
                </c:pt>
                <c:pt idx="2328">
                  <c:v>18.167919158935547</c:v>
                </c:pt>
                <c:pt idx="2329">
                  <c:v>18.181989669799805</c:v>
                </c:pt>
                <c:pt idx="2330">
                  <c:v>18.196062088012695</c:v>
                </c:pt>
                <c:pt idx="2331">
                  <c:v>18.210140228271484</c:v>
                </c:pt>
                <c:pt idx="2332">
                  <c:v>18.224220275878906</c:v>
                </c:pt>
                <c:pt idx="2333">
                  <c:v>18.238304138183594</c:v>
                </c:pt>
                <c:pt idx="2334">
                  <c:v>18.252391815185547</c:v>
                </c:pt>
                <c:pt idx="2335">
                  <c:v>18.266483306884766</c:v>
                </c:pt>
                <c:pt idx="2336">
                  <c:v>18.28057861328125</c:v>
                </c:pt>
                <c:pt idx="2337">
                  <c:v>18.294675827026367</c:v>
                </c:pt>
                <c:pt idx="2338">
                  <c:v>18.30877685546875</c:v>
                </c:pt>
                <c:pt idx="2339">
                  <c:v>18.322883605957031</c:v>
                </c:pt>
                <c:pt idx="2340">
                  <c:v>18.336992263793945</c:v>
                </c:pt>
                <c:pt idx="2341">
                  <c:v>18.351106643676758</c:v>
                </c:pt>
                <c:pt idx="2342">
                  <c:v>18.365222930908203</c:v>
                </c:pt>
                <c:pt idx="2343">
                  <c:v>18.379343032836914</c:v>
                </c:pt>
                <c:pt idx="2344">
                  <c:v>18.393465042114258</c:v>
                </c:pt>
                <c:pt idx="2345">
                  <c:v>18.4075927734375</c:v>
                </c:pt>
                <c:pt idx="2346">
                  <c:v>18.421722412109375</c:v>
                </c:pt>
                <c:pt idx="2347">
                  <c:v>18.435855865478516</c:v>
                </c:pt>
                <c:pt idx="2348">
                  <c:v>18.449993133544922</c:v>
                </c:pt>
                <c:pt idx="2349">
                  <c:v>18.464134216308594</c:v>
                </c:pt>
                <c:pt idx="2350">
                  <c:v>18.478279113769531</c:v>
                </c:pt>
                <c:pt idx="2351">
                  <c:v>18.492427825927734</c:v>
                </c:pt>
                <c:pt idx="2352">
                  <c:v>18.506576538085938</c:v>
                </c:pt>
                <c:pt idx="2353">
                  <c:v>18.520734786987305</c:v>
                </c:pt>
                <c:pt idx="2354">
                  <c:v>18.534891128540039</c:v>
                </c:pt>
                <c:pt idx="2355">
                  <c:v>18.549053192138672</c:v>
                </c:pt>
                <c:pt idx="2356">
                  <c:v>18.56321907043457</c:v>
                </c:pt>
                <c:pt idx="2357">
                  <c:v>18.577386856079102</c:v>
                </c:pt>
                <c:pt idx="2358">
                  <c:v>18.591558456420898</c:v>
                </c:pt>
                <c:pt idx="2359">
                  <c:v>18.605735778808594</c:v>
                </c:pt>
                <c:pt idx="2360">
                  <c:v>18.619915008544922</c:v>
                </c:pt>
                <c:pt idx="2361">
                  <c:v>18.634098052978516</c:v>
                </c:pt>
                <c:pt idx="2362">
                  <c:v>18.648284912109375</c:v>
                </c:pt>
                <c:pt idx="2363">
                  <c:v>18.6624755859375</c:v>
                </c:pt>
                <c:pt idx="2364">
                  <c:v>18.676668167114258</c:v>
                </c:pt>
                <c:pt idx="2365">
                  <c:v>18.690864562988281</c:v>
                </c:pt>
                <c:pt idx="2366">
                  <c:v>18.70506477355957</c:v>
                </c:pt>
                <c:pt idx="2367">
                  <c:v>18.719268798828125</c:v>
                </c:pt>
                <c:pt idx="2368">
                  <c:v>18.733474731445313</c:v>
                </c:pt>
                <c:pt idx="2369">
                  <c:v>18.747684478759766</c:v>
                </c:pt>
                <c:pt idx="2370">
                  <c:v>18.761898040771484</c:v>
                </c:pt>
                <c:pt idx="2371">
                  <c:v>18.776115417480469</c:v>
                </c:pt>
                <c:pt idx="2372">
                  <c:v>18.790336608886719</c:v>
                </c:pt>
                <c:pt idx="2373">
                  <c:v>18.804561614990234</c:v>
                </c:pt>
                <c:pt idx="2374">
                  <c:v>18.818788528442383</c:v>
                </c:pt>
                <c:pt idx="2375">
                  <c:v>18.83302116394043</c:v>
                </c:pt>
                <c:pt idx="2376">
                  <c:v>18.847255706787109</c:v>
                </c:pt>
                <c:pt idx="2377">
                  <c:v>18.861495971679688</c:v>
                </c:pt>
                <c:pt idx="2378">
                  <c:v>18.875736236572266</c:v>
                </c:pt>
                <c:pt idx="2379">
                  <c:v>18.889982223510742</c:v>
                </c:pt>
                <c:pt idx="2380">
                  <c:v>18.904232025146484</c:v>
                </c:pt>
                <c:pt idx="2381">
                  <c:v>18.918485641479492</c:v>
                </c:pt>
                <c:pt idx="2382">
                  <c:v>18.932741165161133</c:v>
                </c:pt>
                <c:pt idx="2383">
                  <c:v>18.947000503540039</c:v>
                </c:pt>
                <c:pt idx="2384">
                  <c:v>18.961263656616211</c:v>
                </c:pt>
                <c:pt idx="2385">
                  <c:v>18.975532531738281</c:v>
                </c:pt>
                <c:pt idx="2386">
                  <c:v>18.989805221557617</c:v>
                </c:pt>
                <c:pt idx="2387">
                  <c:v>19.004079818725586</c:v>
                </c:pt>
                <c:pt idx="2388">
                  <c:v>19.01835823059082</c:v>
                </c:pt>
                <c:pt idx="2389">
                  <c:v>19.03264045715332</c:v>
                </c:pt>
                <c:pt idx="2390">
                  <c:v>19.046926498413086</c:v>
                </c:pt>
                <c:pt idx="2391">
                  <c:v>19.061214447021484</c:v>
                </c:pt>
                <c:pt idx="2392">
                  <c:v>19.075508117675781</c:v>
                </c:pt>
                <c:pt idx="2393">
                  <c:v>19.089801788330078</c:v>
                </c:pt>
                <c:pt idx="2394">
                  <c:v>19.104103088378906</c:v>
                </c:pt>
                <c:pt idx="2395">
                  <c:v>19.118406295776367</c:v>
                </c:pt>
                <c:pt idx="2396">
                  <c:v>19.132715225219727</c:v>
                </c:pt>
                <c:pt idx="2397">
                  <c:v>19.147026062011719</c:v>
                </c:pt>
                <c:pt idx="2398">
                  <c:v>19.161338806152344</c:v>
                </c:pt>
                <c:pt idx="2399">
                  <c:v>19.175657272338867</c:v>
                </c:pt>
                <c:pt idx="2400">
                  <c:v>19.189977645874023</c:v>
                </c:pt>
                <c:pt idx="2401">
                  <c:v>19.204303741455078</c:v>
                </c:pt>
                <c:pt idx="2402">
                  <c:v>19.218631744384766</c:v>
                </c:pt>
                <c:pt idx="2403">
                  <c:v>19.232965469360352</c:v>
                </c:pt>
                <c:pt idx="2404">
                  <c:v>19.24730110168457</c:v>
                </c:pt>
                <c:pt idx="2405">
                  <c:v>19.261642456054688</c:v>
                </c:pt>
                <c:pt idx="2406">
                  <c:v>19.275985717773438</c:v>
                </c:pt>
                <c:pt idx="2407">
                  <c:v>19.290332794189453</c:v>
                </c:pt>
                <c:pt idx="2408">
                  <c:v>19.304681777954102</c:v>
                </c:pt>
                <c:pt idx="2409">
                  <c:v>19.319034576416016</c:v>
                </c:pt>
                <c:pt idx="2410">
                  <c:v>19.333391189575195</c:v>
                </c:pt>
                <c:pt idx="2411">
                  <c:v>19.347749710083008</c:v>
                </c:pt>
                <c:pt idx="2412">
                  <c:v>19.362113952636719</c:v>
                </c:pt>
                <c:pt idx="2413">
                  <c:v>19.376480102539063</c:v>
                </c:pt>
                <c:pt idx="2414">
                  <c:v>19.390850067138672</c:v>
                </c:pt>
                <c:pt idx="2415">
                  <c:v>19.405221939086914</c:v>
                </c:pt>
                <c:pt idx="2416">
                  <c:v>19.419599533081055</c:v>
                </c:pt>
                <c:pt idx="2417">
                  <c:v>19.433977127075195</c:v>
                </c:pt>
                <c:pt idx="2418">
                  <c:v>19.448362350463867</c:v>
                </c:pt>
                <c:pt idx="2419">
                  <c:v>19.462751388549805</c:v>
                </c:pt>
                <c:pt idx="2420">
                  <c:v>19.477142333984375</c:v>
                </c:pt>
                <c:pt idx="2421">
                  <c:v>19.491537094116211</c:v>
                </c:pt>
                <c:pt idx="2422">
                  <c:v>19.505935668945313</c:v>
                </c:pt>
                <c:pt idx="2423">
                  <c:v>19.52033805847168</c:v>
                </c:pt>
                <c:pt idx="2424">
                  <c:v>19.534744262695313</c:v>
                </c:pt>
                <c:pt idx="2425">
                  <c:v>19.549154281616211</c:v>
                </c:pt>
                <c:pt idx="2426">
                  <c:v>19.563568115234375</c:v>
                </c:pt>
                <c:pt idx="2427">
                  <c:v>19.577983856201172</c:v>
                </c:pt>
                <c:pt idx="2428">
                  <c:v>19.592403411865234</c:v>
                </c:pt>
                <c:pt idx="2429">
                  <c:v>19.606826782226563</c:v>
                </c:pt>
                <c:pt idx="2430">
                  <c:v>19.621253967285156</c:v>
                </c:pt>
                <c:pt idx="2431">
                  <c:v>19.635684967041016</c:v>
                </c:pt>
                <c:pt idx="2432">
                  <c:v>19.650119781494141</c:v>
                </c:pt>
                <c:pt idx="2433">
                  <c:v>19.664558410644531</c:v>
                </c:pt>
                <c:pt idx="2434">
                  <c:v>19.67900276184082</c:v>
                </c:pt>
                <c:pt idx="2435">
                  <c:v>19.693447113037109</c:v>
                </c:pt>
                <c:pt idx="2436">
                  <c:v>19.707895278930664</c:v>
                </c:pt>
                <c:pt idx="2437">
                  <c:v>19.722349166870117</c:v>
                </c:pt>
                <c:pt idx="2438">
                  <c:v>19.736804962158203</c:v>
                </c:pt>
                <c:pt idx="2439">
                  <c:v>19.75126838684082</c:v>
                </c:pt>
                <c:pt idx="2440">
                  <c:v>19.76573371887207</c:v>
                </c:pt>
                <c:pt idx="2441">
                  <c:v>19.780200958251953</c:v>
                </c:pt>
                <c:pt idx="2442">
                  <c:v>19.794673919677734</c:v>
                </c:pt>
                <c:pt idx="2443">
                  <c:v>19.809146881103516</c:v>
                </c:pt>
                <c:pt idx="2444">
                  <c:v>19.823627471923828</c:v>
                </c:pt>
                <c:pt idx="2445">
                  <c:v>19.838108062744141</c:v>
                </c:pt>
                <c:pt idx="2446">
                  <c:v>19.852596282958984</c:v>
                </c:pt>
                <c:pt idx="2447">
                  <c:v>19.867084503173828</c:v>
                </c:pt>
                <c:pt idx="2448">
                  <c:v>19.881580352783203</c:v>
                </c:pt>
                <c:pt idx="2449">
                  <c:v>19.896078109741211</c:v>
                </c:pt>
                <c:pt idx="2450">
                  <c:v>19.910579681396484</c:v>
                </c:pt>
                <c:pt idx="2451">
                  <c:v>19.925083160400391</c:v>
                </c:pt>
                <c:pt idx="2452">
                  <c:v>19.939592361450195</c:v>
                </c:pt>
                <c:pt idx="2453">
                  <c:v>19.954103469848633</c:v>
                </c:pt>
                <c:pt idx="2454">
                  <c:v>19.968620300292969</c:v>
                </c:pt>
                <c:pt idx="2455">
                  <c:v>19.983137130737305</c:v>
                </c:pt>
                <c:pt idx="2456">
                  <c:v>19.997661590576172</c:v>
                </c:pt>
                <c:pt idx="2457">
                  <c:v>20.012189865112305</c:v>
                </c:pt>
                <c:pt idx="2458">
                  <c:v>20.02672004699707</c:v>
                </c:pt>
                <c:pt idx="2459">
                  <c:v>20.041252136230469</c:v>
                </c:pt>
                <c:pt idx="2460">
                  <c:v>20.055788040161133</c:v>
                </c:pt>
                <c:pt idx="2461">
                  <c:v>20.070329666137695</c:v>
                </c:pt>
                <c:pt idx="2462">
                  <c:v>20.084873199462891</c:v>
                </c:pt>
                <c:pt idx="2463">
                  <c:v>20.099420547485352</c:v>
                </c:pt>
                <c:pt idx="2464">
                  <c:v>20.113971710205078</c:v>
                </c:pt>
                <c:pt idx="2465">
                  <c:v>20.12852668762207</c:v>
                </c:pt>
                <c:pt idx="2466">
                  <c:v>20.143083572387695</c:v>
                </c:pt>
                <c:pt idx="2467">
                  <c:v>20.157646179199219</c:v>
                </c:pt>
                <c:pt idx="2468">
                  <c:v>20.172210693359375</c:v>
                </c:pt>
                <c:pt idx="2469">
                  <c:v>20.186779022216797</c:v>
                </c:pt>
                <c:pt idx="2470">
                  <c:v>20.201351165771484</c:v>
                </c:pt>
                <c:pt idx="2471">
                  <c:v>20.21592903137207</c:v>
                </c:pt>
                <c:pt idx="2472">
                  <c:v>20.230506896972656</c:v>
                </c:pt>
                <c:pt idx="2473">
                  <c:v>20.245090484619141</c:v>
                </c:pt>
                <c:pt idx="2474">
                  <c:v>20.259679794311523</c:v>
                </c:pt>
                <c:pt idx="2475">
                  <c:v>20.274274826049805</c:v>
                </c:pt>
                <c:pt idx="2476">
                  <c:v>20.288867950439453</c:v>
                </c:pt>
                <c:pt idx="2477">
                  <c:v>20.303464889526367</c:v>
                </c:pt>
                <c:pt idx="2478">
                  <c:v>20.31806755065918</c:v>
                </c:pt>
                <c:pt idx="2479">
                  <c:v>20.332674026489258</c:v>
                </c:pt>
                <c:pt idx="2480">
                  <c:v>20.347280502319336</c:v>
                </c:pt>
                <c:pt idx="2481">
                  <c:v>20.361896514892578</c:v>
                </c:pt>
                <c:pt idx="2482">
                  <c:v>20.376516342163086</c:v>
                </c:pt>
                <c:pt idx="2483">
                  <c:v>20.391138076782227</c:v>
                </c:pt>
                <c:pt idx="2484">
                  <c:v>20.405763626098633</c:v>
                </c:pt>
                <c:pt idx="2485">
                  <c:v>20.420392990112305</c:v>
                </c:pt>
                <c:pt idx="2486">
                  <c:v>20.435026168823242</c:v>
                </c:pt>
                <c:pt idx="2487">
                  <c:v>20.449663162231445</c:v>
                </c:pt>
                <c:pt idx="2488">
                  <c:v>20.464300155639648</c:v>
                </c:pt>
                <c:pt idx="2489">
                  <c:v>20.478944778442383</c:v>
                </c:pt>
                <c:pt idx="2490">
                  <c:v>20.493593215942383</c:v>
                </c:pt>
                <c:pt idx="2491">
                  <c:v>20.508247375488281</c:v>
                </c:pt>
                <c:pt idx="2492">
                  <c:v>20.522903442382813</c:v>
                </c:pt>
                <c:pt idx="2493">
                  <c:v>20.537567138671875</c:v>
                </c:pt>
                <c:pt idx="2494">
                  <c:v>20.552230834960938</c:v>
                </c:pt>
                <c:pt idx="2495">
                  <c:v>20.566904067993164</c:v>
                </c:pt>
                <c:pt idx="2496">
                  <c:v>20.581575393676758</c:v>
                </c:pt>
                <c:pt idx="2497">
                  <c:v>20.596254348754883</c:v>
                </c:pt>
                <c:pt idx="2498">
                  <c:v>20.610935211181641</c:v>
                </c:pt>
                <c:pt idx="2499">
                  <c:v>20.625619888305664</c:v>
                </c:pt>
                <c:pt idx="2500">
                  <c:v>20.640304565429688</c:v>
                </c:pt>
                <c:pt idx="2501">
                  <c:v>20.654998779296875</c:v>
                </c:pt>
                <c:pt idx="2502">
                  <c:v>20.669694900512695</c:v>
                </c:pt>
                <c:pt idx="2503">
                  <c:v>20.684394836425781</c:v>
                </c:pt>
                <c:pt idx="2504">
                  <c:v>20.699098587036133</c:v>
                </c:pt>
                <c:pt idx="2505">
                  <c:v>20.713804244995117</c:v>
                </c:pt>
                <c:pt idx="2506">
                  <c:v>20.728515625</c:v>
                </c:pt>
                <c:pt idx="2507">
                  <c:v>20.743232727050781</c:v>
                </c:pt>
                <c:pt idx="2508">
                  <c:v>20.757949829101563</c:v>
                </c:pt>
                <c:pt idx="2509">
                  <c:v>20.772668838500977</c:v>
                </c:pt>
                <c:pt idx="2510">
                  <c:v>20.787391662597656</c:v>
                </c:pt>
                <c:pt idx="2511">
                  <c:v>20.802118301391602</c:v>
                </c:pt>
                <c:pt idx="2512">
                  <c:v>20.81684684753418</c:v>
                </c:pt>
                <c:pt idx="2513">
                  <c:v>20.831579208374023</c:v>
                </c:pt>
                <c:pt idx="2514">
                  <c:v>20.846317291259766</c:v>
                </c:pt>
                <c:pt idx="2515">
                  <c:v>20.861059188842773</c:v>
                </c:pt>
                <c:pt idx="2516">
                  <c:v>20.875802993774414</c:v>
                </c:pt>
                <c:pt idx="2517">
                  <c:v>20.89055061340332</c:v>
                </c:pt>
                <c:pt idx="2518">
                  <c:v>20.905302047729492</c:v>
                </c:pt>
                <c:pt idx="2519">
                  <c:v>20.920061111450195</c:v>
                </c:pt>
                <c:pt idx="2520">
                  <c:v>20.934818267822266</c:v>
                </c:pt>
                <c:pt idx="2521">
                  <c:v>20.9495849609375</c:v>
                </c:pt>
                <c:pt idx="2522">
                  <c:v>20.964349746704102</c:v>
                </c:pt>
                <c:pt idx="2523">
                  <c:v>20.979120254516602</c:v>
                </c:pt>
                <c:pt idx="2524">
                  <c:v>20.993890762329102</c:v>
                </c:pt>
                <c:pt idx="2525">
                  <c:v>21.008668899536133</c:v>
                </c:pt>
                <c:pt idx="2526">
                  <c:v>21.023448944091797</c:v>
                </c:pt>
                <c:pt idx="2527">
                  <c:v>21.038234710693359</c:v>
                </c:pt>
                <c:pt idx="2528">
                  <c:v>21.053024291992188</c:v>
                </c:pt>
                <c:pt idx="2529">
                  <c:v>21.067815780639648</c:v>
                </c:pt>
                <c:pt idx="2530">
                  <c:v>21.082612991333008</c:v>
                </c:pt>
                <c:pt idx="2531">
                  <c:v>21.097414016723633</c:v>
                </c:pt>
                <c:pt idx="2532">
                  <c:v>21.112216949462891</c:v>
                </c:pt>
                <c:pt idx="2533">
                  <c:v>21.127025604248047</c:v>
                </c:pt>
                <c:pt idx="2534">
                  <c:v>21.141836166381836</c:v>
                </c:pt>
                <c:pt idx="2535">
                  <c:v>21.156652450561523</c:v>
                </c:pt>
                <c:pt idx="2536">
                  <c:v>21.171470642089844</c:v>
                </c:pt>
                <c:pt idx="2537">
                  <c:v>21.186294555664063</c:v>
                </c:pt>
                <c:pt idx="2538">
                  <c:v>21.201120376586914</c:v>
                </c:pt>
                <c:pt idx="2539">
                  <c:v>21.215951919555664</c:v>
                </c:pt>
                <c:pt idx="2540">
                  <c:v>21.230783462524414</c:v>
                </c:pt>
                <c:pt idx="2541">
                  <c:v>21.245620727539063</c:v>
                </c:pt>
                <c:pt idx="2542">
                  <c:v>21.260459899902344</c:v>
                </c:pt>
                <c:pt idx="2543">
                  <c:v>21.275304794311523</c:v>
                </c:pt>
                <c:pt idx="2544">
                  <c:v>21.290153503417969</c:v>
                </c:pt>
                <c:pt idx="2545">
                  <c:v>21.305004119873047</c:v>
                </c:pt>
                <c:pt idx="2546">
                  <c:v>21.319858551025391</c:v>
                </c:pt>
                <c:pt idx="2547">
                  <c:v>21.334718704223633</c:v>
                </c:pt>
                <c:pt idx="2548">
                  <c:v>21.349580764770508</c:v>
                </c:pt>
                <c:pt idx="2549">
                  <c:v>21.364446640014648</c:v>
                </c:pt>
                <c:pt idx="2550">
                  <c:v>21.379318237304688</c:v>
                </c:pt>
                <c:pt idx="2551">
                  <c:v>21.394191741943359</c:v>
                </c:pt>
                <c:pt idx="2552">
                  <c:v>21.409067153930664</c:v>
                </c:pt>
                <c:pt idx="2553">
                  <c:v>21.423948287963867</c:v>
                </c:pt>
                <c:pt idx="2554">
                  <c:v>21.438831329345703</c:v>
                </c:pt>
                <c:pt idx="2555">
                  <c:v>21.453718185424805</c:v>
                </c:pt>
                <c:pt idx="2556">
                  <c:v>21.468605041503906</c:v>
                </c:pt>
                <c:pt idx="2557">
                  <c:v>21.483499526977539</c:v>
                </c:pt>
                <c:pt idx="2558">
                  <c:v>21.498397827148438</c:v>
                </c:pt>
                <c:pt idx="2559">
                  <c:v>21.513298034667969</c:v>
                </c:pt>
                <c:pt idx="2560">
                  <c:v>21.528202056884766</c:v>
                </c:pt>
                <c:pt idx="2561">
                  <c:v>21.543107986450195</c:v>
                </c:pt>
                <c:pt idx="2562">
                  <c:v>21.558019638061523</c:v>
                </c:pt>
                <c:pt idx="2563">
                  <c:v>21.572935104370117</c:v>
                </c:pt>
                <c:pt idx="2564">
                  <c:v>21.587852478027344</c:v>
                </c:pt>
                <c:pt idx="2565">
                  <c:v>21.602773666381836</c:v>
                </c:pt>
                <c:pt idx="2566">
                  <c:v>21.617698669433594</c:v>
                </c:pt>
                <c:pt idx="2567">
                  <c:v>21.632627487182617</c:v>
                </c:pt>
                <c:pt idx="2568">
                  <c:v>21.647558212280273</c:v>
                </c:pt>
                <c:pt idx="2569">
                  <c:v>21.662492752075195</c:v>
                </c:pt>
                <c:pt idx="2570">
                  <c:v>21.677431106567383</c:v>
                </c:pt>
                <c:pt idx="2571">
                  <c:v>21.692373275756836</c:v>
                </c:pt>
                <c:pt idx="2572">
                  <c:v>21.707319259643555</c:v>
                </c:pt>
                <c:pt idx="2573">
                  <c:v>21.722267150878906</c:v>
                </c:pt>
                <c:pt idx="2574">
                  <c:v>21.737218856811523</c:v>
                </c:pt>
                <c:pt idx="2575">
                  <c:v>21.752176284790039</c:v>
                </c:pt>
                <c:pt idx="2576">
                  <c:v>21.767135620117188</c:v>
                </c:pt>
                <c:pt idx="2577">
                  <c:v>21.782098770141602</c:v>
                </c:pt>
                <c:pt idx="2578">
                  <c:v>21.797065734863281</c:v>
                </c:pt>
                <c:pt idx="2579">
                  <c:v>21.812034606933594</c:v>
                </c:pt>
                <c:pt idx="2580">
                  <c:v>21.827007293701172</c:v>
                </c:pt>
                <c:pt idx="2581">
                  <c:v>21.841985702514648</c:v>
                </c:pt>
                <c:pt idx="2582">
                  <c:v>21.856966018676758</c:v>
                </c:pt>
                <c:pt idx="2583">
                  <c:v>21.871950149536133</c:v>
                </c:pt>
                <c:pt idx="2584">
                  <c:v>21.886938095092773</c:v>
                </c:pt>
                <c:pt idx="2585">
                  <c:v>21.901927947998047</c:v>
                </c:pt>
                <c:pt idx="2586">
                  <c:v>21.916923522949219</c:v>
                </c:pt>
                <c:pt idx="2587">
                  <c:v>21.931921005249023</c:v>
                </c:pt>
                <c:pt idx="2588">
                  <c:v>21.946922302246094</c:v>
                </c:pt>
                <c:pt idx="2589">
                  <c:v>21.96192741394043</c:v>
                </c:pt>
                <c:pt idx="2590">
                  <c:v>21.976934432983398</c:v>
                </c:pt>
                <c:pt idx="2591">
                  <c:v>21.991947174072266</c:v>
                </c:pt>
                <c:pt idx="2592">
                  <c:v>22.006961822509766</c:v>
                </c:pt>
                <c:pt idx="2593">
                  <c:v>22.021980285644531</c:v>
                </c:pt>
                <c:pt idx="2594">
                  <c:v>22.037002563476563</c:v>
                </c:pt>
                <c:pt idx="2595">
                  <c:v>22.052026748657227</c:v>
                </c:pt>
                <c:pt idx="2596">
                  <c:v>22.067056655883789</c:v>
                </c:pt>
                <c:pt idx="2597">
                  <c:v>22.082088470458984</c:v>
                </c:pt>
                <c:pt idx="2598">
                  <c:v>22.097124099731445</c:v>
                </c:pt>
                <c:pt idx="2599">
                  <c:v>22.112163543701172</c:v>
                </c:pt>
                <c:pt idx="2600">
                  <c:v>22.127204895019531</c:v>
                </c:pt>
                <c:pt idx="2601">
                  <c:v>22.142251968383789</c:v>
                </c:pt>
                <c:pt idx="2602">
                  <c:v>22.15730094909668</c:v>
                </c:pt>
                <c:pt idx="2603">
                  <c:v>22.172353744506836</c:v>
                </c:pt>
                <c:pt idx="2604">
                  <c:v>22.187410354614258</c:v>
                </c:pt>
                <c:pt idx="2605">
                  <c:v>22.202468872070313</c:v>
                </c:pt>
                <c:pt idx="2606">
                  <c:v>22.217533111572266</c:v>
                </c:pt>
                <c:pt idx="2607">
                  <c:v>22.232599258422852</c:v>
                </c:pt>
                <c:pt idx="2608">
                  <c:v>22.247669219970703</c:v>
                </c:pt>
                <c:pt idx="2609">
                  <c:v>22.26274299621582</c:v>
                </c:pt>
                <c:pt idx="2610">
                  <c:v>22.27781867980957</c:v>
                </c:pt>
                <c:pt idx="2611">
                  <c:v>22.292900085449219</c:v>
                </c:pt>
                <c:pt idx="2612">
                  <c:v>22.3079833984375</c:v>
                </c:pt>
                <c:pt idx="2613">
                  <c:v>22.323070526123047</c:v>
                </c:pt>
                <c:pt idx="2614">
                  <c:v>22.338161468505859</c:v>
                </c:pt>
                <c:pt idx="2615">
                  <c:v>22.353254318237305</c:v>
                </c:pt>
                <c:pt idx="2616">
                  <c:v>22.368352890014648</c:v>
                </c:pt>
                <c:pt idx="2617">
                  <c:v>22.383453369140625</c:v>
                </c:pt>
                <c:pt idx="2618">
                  <c:v>22.398557662963867</c:v>
                </c:pt>
                <c:pt idx="2619">
                  <c:v>22.413663864135742</c:v>
                </c:pt>
                <c:pt idx="2620">
                  <c:v>22.428775787353516</c:v>
                </c:pt>
                <c:pt idx="2621">
                  <c:v>22.443889617919922</c:v>
                </c:pt>
                <c:pt idx="2622">
                  <c:v>22.459009170532227</c:v>
                </c:pt>
                <c:pt idx="2623">
                  <c:v>22.474130630493164</c:v>
                </c:pt>
                <c:pt idx="2624">
                  <c:v>22.489253997802734</c:v>
                </c:pt>
                <c:pt idx="2625">
                  <c:v>22.504383087158203</c:v>
                </c:pt>
                <c:pt idx="2626">
                  <c:v>22.519514083862305</c:v>
                </c:pt>
                <c:pt idx="2627">
                  <c:v>22.534650802612305</c:v>
                </c:pt>
                <c:pt idx="2628">
                  <c:v>22.549789428710938</c:v>
                </c:pt>
                <c:pt idx="2629">
                  <c:v>22.564929962158203</c:v>
                </c:pt>
                <c:pt idx="2630">
                  <c:v>22.580076217651367</c:v>
                </c:pt>
                <c:pt idx="2631">
                  <c:v>22.595224380493164</c:v>
                </c:pt>
                <c:pt idx="2632">
                  <c:v>22.610376358032227</c:v>
                </c:pt>
                <c:pt idx="2633">
                  <c:v>22.625532150268555</c:v>
                </c:pt>
                <c:pt idx="2634">
                  <c:v>22.640691757202148</c:v>
                </c:pt>
                <c:pt idx="2635">
                  <c:v>22.655855178833008</c:v>
                </c:pt>
                <c:pt idx="2636">
                  <c:v>22.6710205078125</c:v>
                </c:pt>
                <c:pt idx="2637">
                  <c:v>22.686189651489258</c:v>
                </c:pt>
                <c:pt idx="2638">
                  <c:v>22.701362609863281</c:v>
                </c:pt>
                <c:pt idx="2639">
                  <c:v>22.71653938293457</c:v>
                </c:pt>
                <c:pt idx="2640">
                  <c:v>22.731719970703125</c:v>
                </c:pt>
                <c:pt idx="2641">
                  <c:v>22.746902465820313</c:v>
                </c:pt>
                <c:pt idx="2642">
                  <c:v>22.762088775634766</c:v>
                </c:pt>
                <c:pt idx="2643">
                  <c:v>22.777278900146484</c:v>
                </c:pt>
                <c:pt idx="2644">
                  <c:v>22.792472839355469</c:v>
                </c:pt>
                <c:pt idx="2645">
                  <c:v>22.807670593261719</c:v>
                </c:pt>
                <c:pt idx="2646">
                  <c:v>22.822872161865234</c:v>
                </c:pt>
                <c:pt idx="2647">
                  <c:v>22.838075637817383</c:v>
                </c:pt>
                <c:pt idx="2648">
                  <c:v>22.853282928466797</c:v>
                </c:pt>
                <c:pt idx="2649">
                  <c:v>22.868494033813477</c:v>
                </c:pt>
                <c:pt idx="2650">
                  <c:v>22.883708953857422</c:v>
                </c:pt>
                <c:pt idx="2651">
                  <c:v>22.89892578125</c:v>
                </c:pt>
                <c:pt idx="2652">
                  <c:v>22.914148330688477</c:v>
                </c:pt>
                <c:pt idx="2653">
                  <c:v>22.929372787475586</c:v>
                </c:pt>
                <c:pt idx="2654">
                  <c:v>22.944601058959961</c:v>
                </c:pt>
                <c:pt idx="2655">
                  <c:v>22.959831237792969</c:v>
                </c:pt>
                <c:pt idx="2656">
                  <c:v>22.975067138671875</c:v>
                </c:pt>
                <c:pt idx="2657">
                  <c:v>22.990304946899414</c:v>
                </c:pt>
                <c:pt idx="2658">
                  <c:v>23.005546569824219</c:v>
                </c:pt>
                <c:pt idx="2659">
                  <c:v>23.020790100097656</c:v>
                </c:pt>
                <c:pt idx="2660">
                  <c:v>23.036039352416992</c:v>
                </c:pt>
                <c:pt idx="2661">
                  <c:v>23.051292419433594</c:v>
                </c:pt>
                <c:pt idx="2662">
                  <c:v>23.066547393798828</c:v>
                </c:pt>
                <c:pt idx="2663">
                  <c:v>23.081804275512695</c:v>
                </c:pt>
                <c:pt idx="2664">
                  <c:v>23.097068786621094</c:v>
                </c:pt>
                <c:pt idx="2665">
                  <c:v>23.112333297729492</c:v>
                </c:pt>
                <c:pt idx="2666">
                  <c:v>23.127601623535156</c:v>
                </c:pt>
                <c:pt idx="2667">
                  <c:v>23.142875671386719</c:v>
                </c:pt>
                <c:pt idx="2668">
                  <c:v>23.158151626586914</c:v>
                </c:pt>
                <c:pt idx="2669">
                  <c:v>23.173429489135742</c:v>
                </c:pt>
                <c:pt idx="2670">
                  <c:v>23.188713073730469</c:v>
                </c:pt>
                <c:pt idx="2671">
                  <c:v>23.203998565673828</c:v>
                </c:pt>
                <c:pt idx="2672">
                  <c:v>23.219289779663086</c:v>
                </c:pt>
                <c:pt idx="2673">
                  <c:v>23.234582901000977</c:v>
                </c:pt>
                <c:pt idx="2674">
                  <c:v>23.249879837036133</c:v>
                </c:pt>
                <c:pt idx="2675">
                  <c:v>23.265180587768555</c:v>
                </c:pt>
                <c:pt idx="2676">
                  <c:v>23.280485153198242</c:v>
                </c:pt>
                <c:pt idx="2677">
                  <c:v>23.295791625976563</c:v>
                </c:pt>
                <c:pt idx="2678">
                  <c:v>23.311101913452148</c:v>
                </c:pt>
                <c:pt idx="2679">
                  <c:v>23.326416015625</c:v>
                </c:pt>
                <c:pt idx="2680">
                  <c:v>23.341733932495117</c:v>
                </c:pt>
                <c:pt idx="2681">
                  <c:v>23.3570556640625</c:v>
                </c:pt>
                <c:pt idx="2682">
                  <c:v>23.372379302978516</c:v>
                </c:pt>
                <c:pt idx="2683">
                  <c:v>23.38770866394043</c:v>
                </c:pt>
                <c:pt idx="2684">
                  <c:v>23.403039932250977</c:v>
                </c:pt>
                <c:pt idx="2685">
                  <c:v>23.418375015258789</c:v>
                </c:pt>
                <c:pt idx="2686">
                  <c:v>23.433713912963867</c:v>
                </c:pt>
                <c:pt idx="2687">
                  <c:v>23.449056625366211</c:v>
                </c:pt>
                <c:pt idx="2688">
                  <c:v>23.46440315246582</c:v>
                </c:pt>
                <c:pt idx="2689">
                  <c:v>23.479753494262695</c:v>
                </c:pt>
                <c:pt idx="2690">
                  <c:v>23.495105743408203</c:v>
                </c:pt>
                <c:pt idx="2691">
                  <c:v>23.510461807250977</c:v>
                </c:pt>
                <c:pt idx="2692">
                  <c:v>23.525821685791016</c:v>
                </c:pt>
                <c:pt idx="2693">
                  <c:v>23.541187286376953</c:v>
                </c:pt>
                <c:pt idx="2694">
                  <c:v>23.556552886962891</c:v>
                </c:pt>
                <c:pt idx="2695">
                  <c:v>23.571922302246094</c:v>
                </c:pt>
                <c:pt idx="2696">
                  <c:v>23.587295532226563</c:v>
                </c:pt>
                <c:pt idx="2697">
                  <c:v>23.602672576904297</c:v>
                </c:pt>
                <c:pt idx="2698">
                  <c:v>23.618053436279297</c:v>
                </c:pt>
                <c:pt idx="2699">
                  <c:v>23.633440017700195</c:v>
                </c:pt>
                <c:pt idx="2700">
                  <c:v>23.648826599121094</c:v>
                </c:pt>
                <c:pt idx="2701">
                  <c:v>23.664218902587891</c:v>
                </c:pt>
                <c:pt idx="2702">
                  <c:v>23.679615020751953</c:v>
                </c:pt>
                <c:pt idx="2703">
                  <c:v>23.695013046264648</c:v>
                </c:pt>
                <c:pt idx="2704">
                  <c:v>23.710414886474609</c:v>
                </c:pt>
                <c:pt idx="2705">
                  <c:v>23.725822448730469</c:v>
                </c:pt>
                <c:pt idx="2706">
                  <c:v>23.741230010986328</c:v>
                </c:pt>
                <c:pt idx="2707">
                  <c:v>23.756643295288086</c:v>
                </c:pt>
                <c:pt idx="2708">
                  <c:v>23.772058486938477</c:v>
                </c:pt>
                <c:pt idx="2709">
                  <c:v>23.787477493286133</c:v>
                </c:pt>
                <c:pt idx="2710">
                  <c:v>23.802900314331055</c:v>
                </c:pt>
                <c:pt idx="2711">
                  <c:v>23.818326950073242</c:v>
                </c:pt>
                <c:pt idx="2712">
                  <c:v>23.833755493164063</c:v>
                </c:pt>
                <c:pt idx="2713">
                  <c:v>23.849187850952148</c:v>
                </c:pt>
                <c:pt idx="2714">
                  <c:v>23.864622116088867</c:v>
                </c:pt>
                <c:pt idx="2715">
                  <c:v>23.880064010620117</c:v>
                </c:pt>
                <c:pt idx="2716">
                  <c:v>23.8955078125</c:v>
                </c:pt>
                <c:pt idx="2717">
                  <c:v>23.910955429077148</c:v>
                </c:pt>
                <c:pt idx="2718">
                  <c:v>23.92640495300293</c:v>
                </c:pt>
                <c:pt idx="2719">
                  <c:v>23.941858291625977</c:v>
                </c:pt>
                <c:pt idx="2720">
                  <c:v>23.957315444946289</c:v>
                </c:pt>
                <c:pt idx="2721">
                  <c:v>23.972776412963867</c:v>
                </c:pt>
                <c:pt idx="2722">
                  <c:v>23.988241195678711</c:v>
                </c:pt>
                <c:pt idx="2723">
                  <c:v>24.00370979309082</c:v>
                </c:pt>
                <c:pt idx="2724">
                  <c:v>24.019180297851563</c:v>
                </c:pt>
                <c:pt idx="2725">
                  <c:v>24.034656524658203</c:v>
                </c:pt>
                <c:pt idx="2726">
                  <c:v>24.050134658813477</c:v>
                </c:pt>
                <c:pt idx="2727">
                  <c:v>24.065614700317383</c:v>
                </c:pt>
                <c:pt idx="2728">
                  <c:v>24.081100463867188</c:v>
                </c:pt>
                <c:pt idx="2729">
                  <c:v>24.096588134765625</c:v>
                </c:pt>
                <c:pt idx="2730">
                  <c:v>24.112081527709961</c:v>
                </c:pt>
                <c:pt idx="2731">
                  <c:v>24.12757682800293</c:v>
                </c:pt>
                <c:pt idx="2732">
                  <c:v>24.143074035644531</c:v>
                </c:pt>
                <c:pt idx="2733">
                  <c:v>24.158576965332031</c:v>
                </c:pt>
                <c:pt idx="2734">
                  <c:v>24.174083709716797</c:v>
                </c:pt>
                <c:pt idx="2735">
                  <c:v>24.189592361450195</c:v>
                </c:pt>
                <c:pt idx="2736">
                  <c:v>24.205106735229492</c:v>
                </c:pt>
                <c:pt idx="2737">
                  <c:v>24.220624923706055</c:v>
                </c:pt>
                <c:pt idx="2738">
                  <c:v>24.23614501953125</c:v>
                </c:pt>
                <c:pt idx="2739">
                  <c:v>24.251670837402344</c:v>
                </c:pt>
                <c:pt idx="2740">
                  <c:v>24.26719856262207</c:v>
                </c:pt>
                <c:pt idx="2741">
                  <c:v>24.282732009887695</c:v>
                </c:pt>
                <c:pt idx="2742">
                  <c:v>24.29826545715332</c:v>
                </c:pt>
                <c:pt idx="2743">
                  <c:v>24.313804626464844</c:v>
                </c:pt>
                <c:pt idx="2744">
                  <c:v>24.329345703125</c:v>
                </c:pt>
                <c:pt idx="2745">
                  <c:v>24.344890594482422</c:v>
                </c:pt>
                <c:pt idx="2746">
                  <c:v>24.360439300537109</c:v>
                </c:pt>
                <c:pt idx="2747">
                  <c:v>24.375993728637695</c:v>
                </c:pt>
                <c:pt idx="2748">
                  <c:v>24.391548156738281</c:v>
                </c:pt>
                <c:pt idx="2749">
                  <c:v>24.407108306884766</c:v>
                </c:pt>
                <c:pt idx="2750">
                  <c:v>24.422672271728516</c:v>
                </c:pt>
                <c:pt idx="2751">
                  <c:v>24.438238143920898</c:v>
                </c:pt>
                <c:pt idx="2752">
                  <c:v>24.453807830810547</c:v>
                </c:pt>
                <c:pt idx="2753">
                  <c:v>24.469383239746094</c:v>
                </c:pt>
                <c:pt idx="2754">
                  <c:v>24.484960556030273</c:v>
                </c:pt>
                <c:pt idx="2755">
                  <c:v>24.500541687011719</c:v>
                </c:pt>
                <c:pt idx="2756">
                  <c:v>24.516124725341797</c:v>
                </c:pt>
                <c:pt idx="2757">
                  <c:v>24.531711578369141</c:v>
                </c:pt>
                <c:pt idx="2758">
                  <c:v>24.54730224609375</c:v>
                </c:pt>
                <c:pt idx="2759">
                  <c:v>24.562896728515625</c:v>
                </c:pt>
                <c:pt idx="2760">
                  <c:v>24.578495025634766</c:v>
                </c:pt>
                <c:pt idx="2761">
                  <c:v>24.594095230102539</c:v>
                </c:pt>
                <c:pt idx="2762">
                  <c:v>24.609699249267578</c:v>
                </c:pt>
                <c:pt idx="2763">
                  <c:v>24.625307083129883</c:v>
                </c:pt>
                <c:pt idx="2764">
                  <c:v>24.64091682434082</c:v>
                </c:pt>
                <c:pt idx="2765">
                  <c:v>24.656530380249023</c:v>
                </c:pt>
                <c:pt idx="2766">
                  <c:v>24.672147750854492</c:v>
                </c:pt>
                <c:pt idx="2767">
                  <c:v>24.687770843505859</c:v>
                </c:pt>
                <c:pt idx="2768">
                  <c:v>24.703395843505859</c:v>
                </c:pt>
                <c:pt idx="2769">
                  <c:v>24.719024658203125</c:v>
                </c:pt>
                <c:pt idx="2770">
                  <c:v>24.734655380249023</c:v>
                </c:pt>
                <c:pt idx="2771">
                  <c:v>24.75029182434082</c:v>
                </c:pt>
                <c:pt idx="2772">
                  <c:v>24.765932083129883</c:v>
                </c:pt>
                <c:pt idx="2773">
                  <c:v>24.781576156616211</c:v>
                </c:pt>
                <c:pt idx="2774">
                  <c:v>24.797222137451172</c:v>
                </c:pt>
                <c:pt idx="2775">
                  <c:v>24.812875747680664</c:v>
                </c:pt>
                <c:pt idx="2776">
                  <c:v>24.828527450561523</c:v>
                </c:pt>
                <c:pt idx="2777">
                  <c:v>24.844184875488281</c:v>
                </c:pt>
                <c:pt idx="2778">
                  <c:v>24.859844207763672</c:v>
                </c:pt>
                <c:pt idx="2779">
                  <c:v>24.875511169433594</c:v>
                </c:pt>
                <c:pt idx="2780">
                  <c:v>24.891176223754883</c:v>
                </c:pt>
                <c:pt idx="2781">
                  <c:v>24.906848907470703</c:v>
                </c:pt>
                <c:pt idx="2782">
                  <c:v>24.922523498535156</c:v>
                </c:pt>
                <c:pt idx="2783">
                  <c:v>24.938203811645508</c:v>
                </c:pt>
                <c:pt idx="2784">
                  <c:v>24.953887939453125</c:v>
                </c:pt>
                <c:pt idx="2785">
                  <c:v>24.969572067260742</c:v>
                </c:pt>
                <c:pt idx="2786">
                  <c:v>24.985261917114258</c:v>
                </c:pt>
                <c:pt idx="2787">
                  <c:v>25.000955581665039</c:v>
                </c:pt>
                <c:pt idx="2788">
                  <c:v>25.016653060913086</c:v>
                </c:pt>
                <c:pt idx="2789">
                  <c:v>25.032352447509766</c:v>
                </c:pt>
                <c:pt idx="2790">
                  <c:v>25.048055648803711</c:v>
                </c:pt>
                <c:pt idx="2791">
                  <c:v>25.063762664794922</c:v>
                </c:pt>
                <c:pt idx="2792">
                  <c:v>25.079471588134766</c:v>
                </c:pt>
                <c:pt idx="2793">
                  <c:v>25.095186233520508</c:v>
                </c:pt>
                <c:pt idx="2794">
                  <c:v>25.110904693603516</c:v>
                </c:pt>
                <c:pt idx="2795">
                  <c:v>25.126625061035156</c:v>
                </c:pt>
                <c:pt idx="2796">
                  <c:v>25.142351150512695</c:v>
                </c:pt>
                <c:pt idx="2797">
                  <c:v>25.1580810546875</c:v>
                </c:pt>
                <c:pt idx="2798">
                  <c:v>25.173810958862305</c:v>
                </c:pt>
                <c:pt idx="2799">
                  <c:v>25.189546585083008</c:v>
                </c:pt>
                <c:pt idx="2800">
                  <c:v>25.205287933349609</c:v>
                </c:pt>
                <c:pt idx="2801">
                  <c:v>25.221029281616211</c:v>
                </c:pt>
                <c:pt idx="2802">
                  <c:v>25.236776351928711</c:v>
                </c:pt>
                <c:pt idx="2803">
                  <c:v>25.252527236938477</c:v>
                </c:pt>
                <c:pt idx="2804">
                  <c:v>25.268281936645508</c:v>
                </c:pt>
                <c:pt idx="2805">
                  <c:v>25.284040451049805</c:v>
                </c:pt>
                <c:pt idx="2806">
                  <c:v>25.299798965454102</c:v>
                </c:pt>
                <c:pt idx="2807">
                  <c:v>25.315561294555664</c:v>
                </c:pt>
                <c:pt idx="2808">
                  <c:v>25.331327438354492</c:v>
                </c:pt>
                <c:pt idx="2809">
                  <c:v>25.347099304199219</c:v>
                </c:pt>
                <c:pt idx="2810">
                  <c:v>25.362873077392578</c:v>
                </c:pt>
                <c:pt idx="2811">
                  <c:v>25.378650665283203</c:v>
                </c:pt>
                <c:pt idx="2812">
                  <c:v>25.394430160522461</c:v>
                </c:pt>
                <c:pt idx="2813">
                  <c:v>25.410213470458984</c:v>
                </c:pt>
                <c:pt idx="2814">
                  <c:v>25.426002502441406</c:v>
                </c:pt>
                <c:pt idx="2815">
                  <c:v>25.441793441772461</c:v>
                </c:pt>
                <c:pt idx="2816">
                  <c:v>25.457588195800781</c:v>
                </c:pt>
                <c:pt idx="2817">
                  <c:v>25.473386764526367</c:v>
                </c:pt>
                <c:pt idx="2818">
                  <c:v>25.489189147949219</c:v>
                </c:pt>
                <c:pt idx="2819">
                  <c:v>25.504993438720703</c:v>
                </c:pt>
                <c:pt idx="2820">
                  <c:v>25.520801544189453</c:v>
                </c:pt>
                <c:pt idx="2821">
                  <c:v>25.536613464355469</c:v>
                </c:pt>
                <c:pt idx="2822">
                  <c:v>25.55242919921875</c:v>
                </c:pt>
                <c:pt idx="2823">
                  <c:v>25.568248748779297</c:v>
                </c:pt>
                <c:pt idx="2824">
                  <c:v>25.584070205688477</c:v>
                </c:pt>
                <c:pt idx="2825">
                  <c:v>25.599895477294922</c:v>
                </c:pt>
                <c:pt idx="2826">
                  <c:v>25.615728378295898</c:v>
                </c:pt>
                <c:pt idx="2827">
                  <c:v>25.631561279296875</c:v>
                </c:pt>
                <c:pt idx="2828">
                  <c:v>25.64739990234375</c:v>
                </c:pt>
                <c:pt idx="2829">
                  <c:v>25.663242340087891</c:v>
                </c:pt>
                <c:pt idx="2830">
                  <c:v>25.679088592529297</c:v>
                </c:pt>
                <c:pt idx="2831">
                  <c:v>25.694936752319336</c:v>
                </c:pt>
                <c:pt idx="2832">
                  <c:v>25.710788726806641</c:v>
                </c:pt>
                <c:pt idx="2833">
                  <c:v>25.726644515991211</c:v>
                </c:pt>
                <c:pt idx="2834">
                  <c:v>25.742504119873047</c:v>
                </c:pt>
                <c:pt idx="2835">
                  <c:v>25.758367538452148</c:v>
                </c:pt>
                <c:pt idx="2836">
                  <c:v>25.774236679077148</c:v>
                </c:pt>
                <c:pt idx="2837">
                  <c:v>25.790107727050781</c:v>
                </c:pt>
                <c:pt idx="2838">
                  <c:v>25.805984497070313</c:v>
                </c:pt>
                <c:pt idx="2839">
                  <c:v>25.821865081787109</c:v>
                </c:pt>
                <c:pt idx="2840">
                  <c:v>25.837745666503906</c:v>
                </c:pt>
                <c:pt idx="2841">
                  <c:v>25.853631973266602</c:v>
                </c:pt>
                <c:pt idx="2842">
                  <c:v>25.86952018737793</c:v>
                </c:pt>
                <c:pt idx="2843">
                  <c:v>25.885412216186523</c:v>
                </c:pt>
                <c:pt idx="2844">
                  <c:v>25.90130615234375</c:v>
                </c:pt>
                <c:pt idx="2845">
                  <c:v>25.917205810546875</c:v>
                </c:pt>
                <c:pt idx="2846">
                  <c:v>25.933111190795898</c:v>
                </c:pt>
                <c:pt idx="2847">
                  <c:v>25.949020385742188</c:v>
                </c:pt>
                <c:pt idx="2848">
                  <c:v>25.964933395385742</c:v>
                </c:pt>
                <c:pt idx="2849">
                  <c:v>25.980850219726563</c:v>
                </c:pt>
                <c:pt idx="2850">
                  <c:v>25.996772766113281</c:v>
                </c:pt>
                <c:pt idx="2851">
                  <c:v>26.0126953125</c:v>
                </c:pt>
                <c:pt idx="2852">
                  <c:v>26.028621673583984</c:v>
                </c:pt>
                <c:pt idx="2853">
                  <c:v>26.044548034667969</c:v>
                </c:pt>
                <c:pt idx="2854">
                  <c:v>26.060480117797852</c:v>
                </c:pt>
                <c:pt idx="2855">
                  <c:v>26.076417922973633</c:v>
                </c:pt>
                <c:pt idx="2856">
                  <c:v>26.09235954284668</c:v>
                </c:pt>
                <c:pt idx="2857">
                  <c:v>26.108303070068359</c:v>
                </c:pt>
                <c:pt idx="2858">
                  <c:v>26.12425422668457</c:v>
                </c:pt>
                <c:pt idx="2859">
                  <c:v>26.140205383300781</c:v>
                </c:pt>
                <c:pt idx="2860">
                  <c:v>26.156162261962891</c:v>
                </c:pt>
                <c:pt idx="2861">
                  <c:v>26.172119140625</c:v>
                </c:pt>
                <c:pt idx="2862">
                  <c:v>26.188079833984375</c:v>
                </c:pt>
                <c:pt idx="2863">
                  <c:v>26.204044342041016</c:v>
                </c:pt>
                <c:pt idx="2864">
                  <c:v>26.220012664794922</c:v>
                </c:pt>
                <c:pt idx="2865">
                  <c:v>26.235984802246094</c:v>
                </c:pt>
                <c:pt idx="2866">
                  <c:v>26.251958847045898</c:v>
                </c:pt>
                <c:pt idx="2867">
                  <c:v>26.267938613891602</c:v>
                </c:pt>
                <c:pt idx="2868">
                  <c:v>26.28392219543457</c:v>
                </c:pt>
                <c:pt idx="2869">
                  <c:v>26.299907684326172</c:v>
                </c:pt>
                <c:pt idx="2870">
                  <c:v>26.315898895263672</c:v>
                </c:pt>
                <c:pt idx="2871">
                  <c:v>26.331890106201172</c:v>
                </c:pt>
                <c:pt idx="2872">
                  <c:v>26.347888946533203</c:v>
                </c:pt>
                <c:pt idx="2873">
                  <c:v>26.363887786865234</c:v>
                </c:pt>
                <c:pt idx="2874">
                  <c:v>26.379894256591797</c:v>
                </c:pt>
                <c:pt idx="2875">
                  <c:v>26.395898818969727</c:v>
                </c:pt>
                <c:pt idx="2876">
                  <c:v>26.411909103393555</c:v>
                </c:pt>
                <c:pt idx="2877">
                  <c:v>26.427925109863281</c:v>
                </c:pt>
                <c:pt idx="2878">
                  <c:v>26.443943023681641</c:v>
                </c:pt>
                <c:pt idx="2879">
                  <c:v>26.459962844848633</c:v>
                </c:pt>
                <c:pt idx="2880">
                  <c:v>26.475988388061523</c:v>
                </c:pt>
                <c:pt idx="2881">
                  <c:v>26.492015838623047</c:v>
                </c:pt>
                <c:pt idx="2882">
                  <c:v>26.508050918579102</c:v>
                </c:pt>
                <c:pt idx="2883">
                  <c:v>26.524089813232422</c:v>
                </c:pt>
                <c:pt idx="2884">
                  <c:v>26.540132522583008</c:v>
                </c:pt>
                <c:pt idx="2885">
                  <c:v>26.556177139282227</c:v>
                </c:pt>
                <c:pt idx="2886">
                  <c:v>26.572225570678711</c:v>
                </c:pt>
                <c:pt idx="2887">
                  <c:v>26.588277816772461</c:v>
                </c:pt>
                <c:pt idx="2888">
                  <c:v>26.604333877563477</c:v>
                </c:pt>
                <c:pt idx="2889">
                  <c:v>26.620395660400391</c:v>
                </c:pt>
                <c:pt idx="2890">
                  <c:v>26.636459350585938</c:v>
                </c:pt>
                <c:pt idx="2891">
                  <c:v>26.652523040771484</c:v>
                </c:pt>
                <c:pt idx="2892">
                  <c:v>26.668596267700195</c:v>
                </c:pt>
                <c:pt idx="2893">
                  <c:v>26.684673309326172</c:v>
                </c:pt>
                <c:pt idx="2894">
                  <c:v>26.700748443603516</c:v>
                </c:pt>
                <c:pt idx="2895">
                  <c:v>26.716833114624023</c:v>
                </c:pt>
                <c:pt idx="2896">
                  <c:v>26.732919692993164</c:v>
                </c:pt>
                <c:pt idx="2897">
                  <c:v>26.74901008605957</c:v>
                </c:pt>
                <c:pt idx="2898">
                  <c:v>26.765100479125977</c:v>
                </c:pt>
                <c:pt idx="2899">
                  <c:v>26.781196594238281</c:v>
                </c:pt>
                <c:pt idx="2900">
                  <c:v>26.797296524047852</c:v>
                </c:pt>
                <c:pt idx="2901">
                  <c:v>26.81340217590332</c:v>
                </c:pt>
                <c:pt idx="2902">
                  <c:v>26.829507827758789</c:v>
                </c:pt>
                <c:pt idx="2903">
                  <c:v>26.845619201660156</c:v>
                </c:pt>
                <c:pt idx="2904">
                  <c:v>26.861730575561523</c:v>
                </c:pt>
                <c:pt idx="2905">
                  <c:v>26.877847671508789</c:v>
                </c:pt>
                <c:pt idx="2906">
                  <c:v>26.893970489501953</c:v>
                </c:pt>
                <c:pt idx="2907">
                  <c:v>26.91009521484375</c:v>
                </c:pt>
                <c:pt idx="2908">
                  <c:v>26.92622184753418</c:v>
                </c:pt>
                <c:pt idx="2909">
                  <c:v>26.942356109619141</c:v>
                </c:pt>
                <c:pt idx="2910">
                  <c:v>26.958490371704102</c:v>
                </c:pt>
                <c:pt idx="2911">
                  <c:v>26.974630355834961</c:v>
                </c:pt>
                <c:pt idx="2912">
                  <c:v>26.99077033996582</c:v>
                </c:pt>
                <c:pt idx="2913">
                  <c:v>27.006914138793945</c:v>
                </c:pt>
                <c:pt idx="2914">
                  <c:v>27.023059844970703</c:v>
                </c:pt>
                <c:pt idx="2915">
                  <c:v>27.039211273193359</c:v>
                </c:pt>
                <c:pt idx="2916">
                  <c:v>27.055366516113281</c:v>
                </c:pt>
                <c:pt idx="2917">
                  <c:v>27.071523666381836</c:v>
                </c:pt>
                <c:pt idx="2918">
                  <c:v>27.087686538696289</c:v>
                </c:pt>
                <c:pt idx="2919">
                  <c:v>27.103855133056641</c:v>
                </c:pt>
                <c:pt idx="2920">
                  <c:v>27.120023727416992</c:v>
                </c:pt>
                <c:pt idx="2921">
                  <c:v>27.136198043823242</c:v>
                </c:pt>
                <c:pt idx="2922">
                  <c:v>27.152374267578125</c:v>
                </c:pt>
                <c:pt idx="2923">
                  <c:v>27.168558120727539</c:v>
                </c:pt>
                <c:pt idx="2924">
                  <c:v>27.184741973876953</c:v>
                </c:pt>
                <c:pt idx="2925">
                  <c:v>27.200929641723633</c:v>
                </c:pt>
                <c:pt idx="2926">
                  <c:v>27.217121124267578</c:v>
                </c:pt>
                <c:pt idx="2927">
                  <c:v>27.233318328857422</c:v>
                </c:pt>
                <c:pt idx="2928">
                  <c:v>27.249517440795898</c:v>
                </c:pt>
                <c:pt idx="2929">
                  <c:v>27.265718460083008</c:v>
                </c:pt>
                <c:pt idx="2930">
                  <c:v>27.28192138671875</c:v>
                </c:pt>
                <c:pt idx="2931">
                  <c:v>27.298133850097656</c:v>
                </c:pt>
                <c:pt idx="2932">
                  <c:v>27.314346313476563</c:v>
                </c:pt>
                <c:pt idx="2933">
                  <c:v>27.330562591552734</c:v>
                </c:pt>
                <c:pt idx="2934">
                  <c:v>27.346782684326172</c:v>
                </c:pt>
                <c:pt idx="2935">
                  <c:v>27.363010406494141</c:v>
                </c:pt>
                <c:pt idx="2936">
                  <c:v>27.379240036010742</c:v>
                </c:pt>
                <c:pt idx="2937">
                  <c:v>27.395473480224609</c:v>
                </c:pt>
                <c:pt idx="2938">
                  <c:v>27.411708831787109</c:v>
                </c:pt>
                <c:pt idx="2939">
                  <c:v>27.427949905395508</c:v>
                </c:pt>
                <c:pt idx="2940">
                  <c:v>27.444190979003906</c:v>
                </c:pt>
                <c:pt idx="2941">
                  <c:v>27.460439682006836</c:v>
                </c:pt>
                <c:pt idx="2942">
                  <c:v>27.476690292358398</c:v>
                </c:pt>
                <c:pt idx="2943">
                  <c:v>27.492946624755859</c:v>
                </c:pt>
                <c:pt idx="2944">
                  <c:v>27.509204864501953</c:v>
                </c:pt>
                <c:pt idx="2945">
                  <c:v>27.525466918945313</c:v>
                </c:pt>
                <c:pt idx="2946">
                  <c:v>27.541732788085938</c:v>
                </c:pt>
                <c:pt idx="2947">
                  <c:v>27.558000564575195</c:v>
                </c:pt>
                <c:pt idx="2948">
                  <c:v>27.574272155761719</c:v>
                </c:pt>
                <c:pt idx="2949">
                  <c:v>27.590545654296875</c:v>
                </c:pt>
                <c:pt idx="2950">
                  <c:v>27.606822967529297</c:v>
                </c:pt>
                <c:pt idx="2951">
                  <c:v>27.62310791015625</c:v>
                </c:pt>
                <c:pt idx="2952">
                  <c:v>27.639392852783203</c:v>
                </c:pt>
                <c:pt idx="2953">
                  <c:v>27.655681610107422</c:v>
                </c:pt>
                <c:pt idx="2954">
                  <c:v>27.671974182128906</c:v>
                </c:pt>
                <c:pt idx="2955">
                  <c:v>27.688270568847656</c:v>
                </c:pt>
                <c:pt idx="2956">
                  <c:v>27.704572677612305</c:v>
                </c:pt>
                <c:pt idx="2957">
                  <c:v>27.720876693725586</c:v>
                </c:pt>
                <c:pt idx="2958">
                  <c:v>27.737184524536133</c:v>
                </c:pt>
                <c:pt idx="2959">
                  <c:v>27.753496170043945</c:v>
                </c:pt>
                <c:pt idx="2960">
                  <c:v>27.769809722900391</c:v>
                </c:pt>
                <c:pt idx="2961">
                  <c:v>27.786125183105469</c:v>
                </c:pt>
                <c:pt idx="2962">
                  <c:v>27.802446365356445</c:v>
                </c:pt>
                <c:pt idx="2963">
                  <c:v>27.818771362304688</c:v>
                </c:pt>
                <c:pt idx="2964">
                  <c:v>27.835098266601563</c:v>
                </c:pt>
                <c:pt idx="2965">
                  <c:v>27.851428985595703</c:v>
                </c:pt>
                <c:pt idx="2966">
                  <c:v>27.867761611938477</c:v>
                </c:pt>
                <c:pt idx="2967">
                  <c:v>27.884099960327148</c:v>
                </c:pt>
                <c:pt idx="2968">
                  <c:v>27.900440216064453</c:v>
                </c:pt>
                <c:pt idx="2969">
                  <c:v>27.916786193847656</c:v>
                </c:pt>
                <c:pt idx="2970">
                  <c:v>27.933132171630859</c:v>
                </c:pt>
                <c:pt idx="2971">
                  <c:v>27.949483871459961</c:v>
                </c:pt>
                <c:pt idx="2972">
                  <c:v>27.965837478637695</c:v>
                </c:pt>
                <c:pt idx="2973">
                  <c:v>27.982196807861328</c:v>
                </c:pt>
                <c:pt idx="2974">
                  <c:v>27.998559951782227</c:v>
                </c:pt>
                <c:pt idx="2975">
                  <c:v>28.014926910400391</c:v>
                </c:pt>
                <c:pt idx="2976">
                  <c:v>28.03129768371582</c:v>
                </c:pt>
                <c:pt idx="2977">
                  <c:v>28.047670364379883</c:v>
                </c:pt>
                <c:pt idx="2978">
                  <c:v>28.064044952392578</c:v>
                </c:pt>
                <c:pt idx="2979">
                  <c:v>28.080425262451172</c:v>
                </c:pt>
                <c:pt idx="2980">
                  <c:v>28.096805572509766</c:v>
                </c:pt>
                <c:pt idx="2981">
                  <c:v>28.113191604614258</c:v>
                </c:pt>
                <c:pt idx="2982">
                  <c:v>28.129581451416016</c:v>
                </c:pt>
                <c:pt idx="2983">
                  <c:v>28.145975112915039</c:v>
                </c:pt>
                <c:pt idx="2984">
                  <c:v>28.162372589111328</c:v>
                </c:pt>
                <c:pt idx="2985">
                  <c:v>28.17877197265625</c:v>
                </c:pt>
                <c:pt idx="2986">
                  <c:v>28.195175170898438</c:v>
                </c:pt>
                <c:pt idx="2987">
                  <c:v>28.211584091186523</c:v>
                </c:pt>
                <c:pt idx="2988">
                  <c:v>28.227993011474609</c:v>
                </c:pt>
                <c:pt idx="2989">
                  <c:v>28.244409561157227</c:v>
                </c:pt>
                <c:pt idx="2990">
                  <c:v>28.260826110839844</c:v>
                </c:pt>
                <c:pt idx="2991">
                  <c:v>28.277248382568359</c:v>
                </c:pt>
                <c:pt idx="2992">
                  <c:v>28.293674468994141</c:v>
                </c:pt>
                <c:pt idx="2993">
                  <c:v>28.310102462768555</c:v>
                </c:pt>
                <c:pt idx="2994">
                  <c:v>28.326534271240234</c:v>
                </c:pt>
                <c:pt idx="2995">
                  <c:v>28.34296989440918</c:v>
                </c:pt>
                <c:pt idx="2996">
                  <c:v>28.359407424926758</c:v>
                </c:pt>
                <c:pt idx="2997">
                  <c:v>28.375848770141602</c:v>
                </c:pt>
                <c:pt idx="2998">
                  <c:v>28.392293930053711</c:v>
                </c:pt>
                <c:pt idx="2999">
                  <c:v>28.408742904663086</c:v>
                </c:pt>
              </c:numCache>
            </c:numRef>
          </c:xVal>
          <c:yVal>
            <c:numRef>
              <c:f>'[RB revised.xlsx]Graph Calculations'!$I$11:$DKR$11</c:f>
              <c:numCache>
                <c:formatCode>General</c:formatCode>
                <c:ptCount val="3000"/>
                <c:pt idx="0">
                  <c:v>38852.9248046875</c:v>
                </c:pt>
                <c:pt idx="1">
                  <c:v>38853.0126953125</c:v>
                </c:pt>
                <c:pt idx="2">
                  <c:v>38853.10009765625</c:v>
                </c:pt>
                <c:pt idx="3">
                  <c:v>38776.5595703125</c:v>
                </c:pt>
                <c:pt idx="4">
                  <c:v>38677.3046875</c:v>
                </c:pt>
                <c:pt idx="5">
                  <c:v>38550.47802734375</c:v>
                </c:pt>
                <c:pt idx="6">
                  <c:v>38408.22314453125</c:v>
                </c:pt>
                <c:pt idx="7">
                  <c:v>38258.25390625</c:v>
                </c:pt>
                <c:pt idx="8">
                  <c:v>38101.94140625</c:v>
                </c:pt>
                <c:pt idx="9">
                  <c:v>37953.08642578125</c:v>
                </c:pt>
                <c:pt idx="10">
                  <c:v>37816.7744140625</c:v>
                </c:pt>
                <c:pt idx="11">
                  <c:v>37675.46240234375</c:v>
                </c:pt>
                <c:pt idx="12">
                  <c:v>37513.66455078125</c:v>
                </c:pt>
                <c:pt idx="13">
                  <c:v>37340.6376953125</c:v>
                </c:pt>
                <c:pt idx="14">
                  <c:v>37179.92578125</c:v>
                </c:pt>
                <c:pt idx="15">
                  <c:v>37035.1279296875</c:v>
                </c:pt>
                <c:pt idx="16">
                  <c:v>36893.4443359375</c:v>
                </c:pt>
                <c:pt idx="17">
                  <c:v>36739.38916015625</c:v>
                </c:pt>
                <c:pt idx="18">
                  <c:v>36582.90576171875</c:v>
                </c:pt>
                <c:pt idx="19">
                  <c:v>36436.9365234375</c:v>
                </c:pt>
                <c:pt idx="20">
                  <c:v>36300.3955078125</c:v>
                </c:pt>
                <c:pt idx="21">
                  <c:v>36165.0263671875</c:v>
                </c:pt>
                <c:pt idx="22">
                  <c:v>36029.51416015625</c:v>
                </c:pt>
                <c:pt idx="23">
                  <c:v>35897.51611328125</c:v>
                </c:pt>
                <c:pt idx="24">
                  <c:v>35776.60400390625</c:v>
                </c:pt>
                <c:pt idx="25">
                  <c:v>35667.86328125</c:v>
                </c:pt>
                <c:pt idx="26">
                  <c:v>35556.436767578125</c:v>
                </c:pt>
                <c:pt idx="27">
                  <c:v>35435.181884765625</c:v>
                </c:pt>
                <c:pt idx="28">
                  <c:v>35314.64111328125</c:v>
                </c:pt>
                <c:pt idx="29">
                  <c:v>35209.757568359375</c:v>
                </c:pt>
                <c:pt idx="30">
                  <c:v>35116.702392578125</c:v>
                </c:pt>
                <c:pt idx="31">
                  <c:v>35028.3046875</c:v>
                </c:pt>
                <c:pt idx="32">
                  <c:v>34938.220947265625</c:v>
                </c:pt>
                <c:pt idx="33">
                  <c:v>34849.594482421875</c:v>
                </c:pt>
                <c:pt idx="34">
                  <c:v>34764.196533203125</c:v>
                </c:pt>
                <c:pt idx="35">
                  <c:v>34691.512939453125</c:v>
                </c:pt>
                <c:pt idx="36">
                  <c:v>34631.715087890625</c:v>
                </c:pt>
                <c:pt idx="37">
                  <c:v>34577.917236328125</c:v>
                </c:pt>
                <c:pt idx="38">
                  <c:v>34514.290771484375</c:v>
                </c:pt>
                <c:pt idx="39">
                  <c:v>34444.978759765625</c:v>
                </c:pt>
                <c:pt idx="40">
                  <c:v>34378.2666015625</c:v>
                </c:pt>
                <c:pt idx="41">
                  <c:v>34321.697265625</c:v>
                </c:pt>
                <c:pt idx="42">
                  <c:v>34277.3564453125</c:v>
                </c:pt>
                <c:pt idx="43">
                  <c:v>34232.1298828125</c:v>
                </c:pt>
                <c:pt idx="44">
                  <c:v>34182.646484375</c:v>
                </c:pt>
                <c:pt idx="45">
                  <c:v>34130.19140625</c:v>
                </c:pt>
                <c:pt idx="46">
                  <c:v>34080.936279296875</c:v>
                </c:pt>
                <c:pt idx="47">
                  <c:v>34027.967041015625</c:v>
                </c:pt>
                <c:pt idx="48">
                  <c:v>33978.340576171875</c:v>
                </c:pt>
                <c:pt idx="49">
                  <c:v>33938.057006835938</c:v>
                </c:pt>
                <c:pt idx="50">
                  <c:v>33907.087646484375</c:v>
                </c:pt>
                <c:pt idx="51">
                  <c:v>33876.175537109375</c:v>
                </c:pt>
                <c:pt idx="52">
                  <c:v>33844.206176757813</c:v>
                </c:pt>
                <c:pt idx="53">
                  <c:v>33813.00830078125</c:v>
                </c:pt>
                <c:pt idx="54">
                  <c:v>33781.3818359375</c:v>
                </c:pt>
                <c:pt idx="55">
                  <c:v>33740.212524414063</c:v>
                </c:pt>
                <c:pt idx="56">
                  <c:v>33696.414672851563</c:v>
                </c:pt>
                <c:pt idx="57">
                  <c:v>33660.3310546875</c:v>
                </c:pt>
                <c:pt idx="58">
                  <c:v>33634.76171875</c:v>
                </c:pt>
                <c:pt idx="59">
                  <c:v>33616.992431640625</c:v>
                </c:pt>
                <c:pt idx="60">
                  <c:v>33602.166015625</c:v>
                </c:pt>
                <c:pt idx="61">
                  <c:v>33576.282348632813</c:v>
                </c:pt>
                <c:pt idx="62">
                  <c:v>33537.08447265625</c:v>
                </c:pt>
                <c:pt idx="63">
                  <c:v>33500.600952148438</c:v>
                </c:pt>
                <c:pt idx="64">
                  <c:v>33473.917358398438</c:v>
                </c:pt>
                <c:pt idx="65">
                  <c:v>33447.8623046875</c:v>
                </c:pt>
                <c:pt idx="66">
                  <c:v>33419.321533203125</c:v>
                </c:pt>
                <c:pt idx="67">
                  <c:v>33396.152221679688</c:v>
                </c:pt>
                <c:pt idx="68">
                  <c:v>33383.840087890625</c:v>
                </c:pt>
                <c:pt idx="69">
                  <c:v>33377.870727539063</c:v>
                </c:pt>
                <c:pt idx="70">
                  <c:v>33373.187133789063</c:v>
                </c:pt>
                <c:pt idx="71">
                  <c:v>33362.389282226563</c:v>
                </c:pt>
                <c:pt idx="72">
                  <c:v>33337.419921875</c:v>
                </c:pt>
                <c:pt idx="73">
                  <c:v>33302.650634765625</c:v>
                </c:pt>
                <c:pt idx="74">
                  <c:v>33275.82421875</c:v>
                </c:pt>
                <c:pt idx="75">
                  <c:v>33259.769165039063</c:v>
                </c:pt>
                <c:pt idx="76">
                  <c:v>33244.314086914063</c:v>
                </c:pt>
                <c:pt idx="77">
                  <c:v>33219.05908203125</c:v>
                </c:pt>
                <c:pt idx="78">
                  <c:v>33182.746948242188</c:v>
                </c:pt>
                <c:pt idx="79">
                  <c:v>33138.891967773438</c:v>
                </c:pt>
                <c:pt idx="80">
                  <c:v>33102.236938476563</c:v>
                </c:pt>
                <c:pt idx="81">
                  <c:v>33078.524658203125</c:v>
                </c:pt>
                <c:pt idx="82">
                  <c:v>33062.269653320313</c:v>
                </c:pt>
                <c:pt idx="83">
                  <c:v>33052.18603515625</c:v>
                </c:pt>
                <c:pt idx="84">
                  <c:v>33046.702514648438</c:v>
                </c:pt>
                <c:pt idx="85">
                  <c:v>33036.333129882813</c:v>
                </c:pt>
                <c:pt idx="86">
                  <c:v>33015.421020507813</c:v>
                </c:pt>
                <c:pt idx="87">
                  <c:v>32990.565979003906</c:v>
                </c:pt>
                <c:pt idx="88">
                  <c:v>32970.739501953125</c:v>
                </c:pt>
                <c:pt idx="89">
                  <c:v>32961.227355957031</c:v>
                </c:pt>
                <c:pt idx="90">
                  <c:v>32953.800903320313</c:v>
                </c:pt>
                <c:pt idx="91">
                  <c:v>32943.374450683594</c:v>
                </c:pt>
                <c:pt idx="92">
                  <c:v>32934.91943359375</c:v>
                </c:pt>
                <c:pt idx="93">
                  <c:v>32926.950134277344</c:v>
                </c:pt>
                <c:pt idx="94">
                  <c:v>32915.523681640625</c:v>
                </c:pt>
                <c:pt idx="95">
                  <c:v>32901.411499023438</c:v>
                </c:pt>
                <c:pt idx="96">
                  <c:v>32893.3564453125</c:v>
                </c:pt>
                <c:pt idx="97">
                  <c:v>32886.701416015625</c:v>
                </c:pt>
                <c:pt idx="98">
                  <c:v>32883.303588867188</c:v>
                </c:pt>
                <c:pt idx="99">
                  <c:v>32877.905700683594</c:v>
                </c:pt>
                <c:pt idx="100">
                  <c:v>32865.936340332031</c:v>
                </c:pt>
                <c:pt idx="101">
                  <c:v>32855.367065429688</c:v>
                </c:pt>
                <c:pt idx="102">
                  <c:v>32856.397766113281</c:v>
                </c:pt>
                <c:pt idx="103">
                  <c:v>32862.51416015625</c:v>
                </c:pt>
                <c:pt idx="104">
                  <c:v>32856.573425292969</c:v>
                </c:pt>
                <c:pt idx="105">
                  <c:v>32842.804077148438</c:v>
                </c:pt>
                <c:pt idx="106">
                  <c:v>32837.634765625</c:v>
                </c:pt>
                <c:pt idx="107">
                  <c:v>32837.208312988281</c:v>
                </c:pt>
                <c:pt idx="108">
                  <c:v>32828.353271484375</c:v>
                </c:pt>
                <c:pt idx="109">
                  <c:v>32810.412536621094</c:v>
                </c:pt>
                <c:pt idx="110">
                  <c:v>32797.7861328125</c:v>
                </c:pt>
                <c:pt idx="111">
                  <c:v>32792.502502441406</c:v>
                </c:pt>
                <c:pt idx="112">
                  <c:v>32791.59033203125</c:v>
                </c:pt>
                <c:pt idx="113">
                  <c:v>32788.506713867188</c:v>
                </c:pt>
                <c:pt idx="114">
                  <c:v>32781.537414550781</c:v>
                </c:pt>
                <c:pt idx="115">
                  <c:v>32766.882385253906</c:v>
                </c:pt>
                <c:pt idx="116">
                  <c:v>32748.655944824219</c:v>
                </c:pt>
                <c:pt idx="117">
                  <c:v>32735.143798828125</c:v>
                </c:pt>
                <c:pt idx="118">
                  <c:v>32730.517333984375</c:v>
                </c:pt>
                <c:pt idx="119">
                  <c:v>32728.9765625</c:v>
                </c:pt>
                <c:pt idx="120">
                  <c:v>32722.921569824219</c:v>
                </c:pt>
                <c:pt idx="121">
                  <c:v>32711.037963867188</c:v>
                </c:pt>
                <c:pt idx="122">
                  <c:v>32701.86865234375</c:v>
                </c:pt>
                <c:pt idx="123">
                  <c:v>32706.099365234375</c:v>
                </c:pt>
                <c:pt idx="124">
                  <c:v>32712.530029296875</c:v>
                </c:pt>
                <c:pt idx="125">
                  <c:v>32712.560729980469</c:v>
                </c:pt>
                <c:pt idx="126">
                  <c:v>32707.734252929688</c:v>
                </c:pt>
                <c:pt idx="127">
                  <c:v>32702.793518066406</c:v>
                </c:pt>
                <c:pt idx="128">
                  <c:v>32697.167053222656</c:v>
                </c:pt>
                <c:pt idx="129">
                  <c:v>32684.797729492188</c:v>
                </c:pt>
                <c:pt idx="130">
                  <c:v>32665.856994628906</c:v>
                </c:pt>
                <c:pt idx="131">
                  <c:v>32654.030578613281</c:v>
                </c:pt>
                <c:pt idx="132">
                  <c:v>32668.489807128906</c:v>
                </c:pt>
                <c:pt idx="133">
                  <c:v>32688.977661132813</c:v>
                </c:pt>
                <c:pt idx="134">
                  <c:v>32686.294067382813</c:v>
                </c:pt>
                <c:pt idx="135">
                  <c:v>32667.067626953125</c:v>
                </c:pt>
                <c:pt idx="136">
                  <c:v>32654.012573242188</c:v>
                </c:pt>
                <c:pt idx="137">
                  <c:v>32654.386108398438</c:v>
                </c:pt>
                <c:pt idx="138">
                  <c:v>32660.245361328125</c:v>
                </c:pt>
                <c:pt idx="139">
                  <c:v>32660.704650878906</c:v>
                </c:pt>
                <c:pt idx="140">
                  <c:v>32650.763916015625</c:v>
                </c:pt>
                <c:pt idx="141">
                  <c:v>32633.966003417969</c:v>
                </c:pt>
                <c:pt idx="142">
                  <c:v>32621.911010742188</c:v>
                </c:pt>
                <c:pt idx="143">
                  <c:v>32616.998840332031</c:v>
                </c:pt>
                <c:pt idx="144">
                  <c:v>32619.829528808594</c:v>
                </c:pt>
                <c:pt idx="145">
                  <c:v>32623.031616210938</c:v>
                </c:pt>
                <c:pt idx="146">
                  <c:v>32623.262329101563</c:v>
                </c:pt>
                <c:pt idx="147">
                  <c:v>32625.807312011719</c:v>
                </c:pt>
                <c:pt idx="148">
                  <c:v>32629.952270507813</c:v>
                </c:pt>
                <c:pt idx="149">
                  <c:v>32626.982971191406</c:v>
                </c:pt>
                <c:pt idx="150">
                  <c:v>32617.385070800781</c:v>
                </c:pt>
                <c:pt idx="151">
                  <c:v>32613.472900390625</c:v>
                </c:pt>
                <c:pt idx="152">
                  <c:v>32615.646423339844</c:v>
                </c:pt>
                <c:pt idx="153">
                  <c:v>32617.19140625</c:v>
                </c:pt>
                <c:pt idx="154">
                  <c:v>32618.56494140625</c:v>
                </c:pt>
                <c:pt idx="155">
                  <c:v>32625.82421875</c:v>
                </c:pt>
                <c:pt idx="156">
                  <c:v>32629.712036132813</c:v>
                </c:pt>
                <c:pt idx="157">
                  <c:v>32620.542724609375</c:v>
                </c:pt>
                <c:pt idx="158">
                  <c:v>32603.516296386719</c:v>
                </c:pt>
                <c:pt idx="159">
                  <c:v>32589.861267089844</c:v>
                </c:pt>
                <c:pt idx="160">
                  <c:v>32583.57763671875</c:v>
                </c:pt>
                <c:pt idx="161">
                  <c:v>32586.865478515625</c:v>
                </c:pt>
                <c:pt idx="162">
                  <c:v>32595.524780273438</c:v>
                </c:pt>
                <c:pt idx="163">
                  <c:v>32596.783996582031</c:v>
                </c:pt>
                <c:pt idx="164">
                  <c:v>32587.528991699219</c:v>
                </c:pt>
                <c:pt idx="165">
                  <c:v>32576.931091308594</c:v>
                </c:pt>
                <c:pt idx="166">
                  <c:v>32567.533203125</c:v>
                </c:pt>
                <c:pt idx="167">
                  <c:v>32563.078186035156</c:v>
                </c:pt>
                <c:pt idx="168">
                  <c:v>32568.10888671875</c:v>
                </c:pt>
                <c:pt idx="169">
                  <c:v>32577.53955078125</c:v>
                </c:pt>
                <c:pt idx="170">
                  <c:v>32581.284545898438</c:v>
                </c:pt>
                <c:pt idx="171">
                  <c:v>32583.086669921875</c:v>
                </c:pt>
                <c:pt idx="172">
                  <c:v>32582.460205078125</c:v>
                </c:pt>
                <c:pt idx="173">
                  <c:v>32572.090881347656</c:v>
                </c:pt>
                <c:pt idx="174">
                  <c:v>32558.721557617188</c:v>
                </c:pt>
                <c:pt idx="175">
                  <c:v>32552.352294921875</c:v>
                </c:pt>
                <c:pt idx="176">
                  <c:v>32545.725830078125</c:v>
                </c:pt>
                <c:pt idx="177">
                  <c:v>32534.013671875</c:v>
                </c:pt>
                <c:pt idx="178">
                  <c:v>32531.044311523438</c:v>
                </c:pt>
                <c:pt idx="179">
                  <c:v>32540.275024414063</c:v>
                </c:pt>
                <c:pt idx="180">
                  <c:v>32545.505737304688</c:v>
                </c:pt>
                <c:pt idx="181">
                  <c:v>32538.993530273438</c:v>
                </c:pt>
                <c:pt idx="182">
                  <c:v>32536.338500976563</c:v>
                </c:pt>
                <c:pt idx="183">
                  <c:v>32544.712036132813</c:v>
                </c:pt>
                <c:pt idx="184">
                  <c:v>32553.314208984375</c:v>
                </c:pt>
                <c:pt idx="185">
                  <c:v>32545.430603027344</c:v>
                </c:pt>
                <c:pt idx="186">
                  <c:v>32531.346984863281</c:v>
                </c:pt>
                <c:pt idx="187">
                  <c:v>32528.149108886719</c:v>
                </c:pt>
                <c:pt idx="188">
                  <c:v>32535.008361816406</c:v>
                </c:pt>
                <c:pt idx="189">
                  <c:v>32540.210510253906</c:v>
                </c:pt>
                <c:pt idx="190">
                  <c:v>32548.126892089844</c:v>
                </c:pt>
                <c:pt idx="191">
                  <c:v>32557.014709472656</c:v>
                </c:pt>
                <c:pt idx="192">
                  <c:v>32553.359680175781</c:v>
                </c:pt>
                <c:pt idx="193">
                  <c:v>32532.961791992188</c:v>
                </c:pt>
                <c:pt idx="194">
                  <c:v>32512.906799316406</c:v>
                </c:pt>
                <c:pt idx="195">
                  <c:v>32506.194610595703</c:v>
                </c:pt>
                <c:pt idx="196">
                  <c:v>32508.139587402344</c:v>
                </c:pt>
                <c:pt idx="197">
                  <c:v>32511.6845703125</c:v>
                </c:pt>
                <c:pt idx="198">
                  <c:v>32512.800964355469</c:v>
                </c:pt>
                <c:pt idx="199">
                  <c:v>32516.174499511719</c:v>
                </c:pt>
                <c:pt idx="200">
                  <c:v>32515.605224609375</c:v>
                </c:pt>
                <c:pt idx="201">
                  <c:v>32512.864440917969</c:v>
                </c:pt>
                <c:pt idx="202">
                  <c:v>32513.552307128906</c:v>
                </c:pt>
                <c:pt idx="203">
                  <c:v>32513.75439453125</c:v>
                </c:pt>
                <c:pt idx="204">
                  <c:v>32502.556518554688</c:v>
                </c:pt>
                <c:pt idx="205">
                  <c:v>32488.787200927734</c:v>
                </c:pt>
                <c:pt idx="206">
                  <c:v>32485.303619384766</c:v>
                </c:pt>
                <c:pt idx="207">
                  <c:v>32492.534301757813</c:v>
                </c:pt>
                <c:pt idx="208">
                  <c:v>32504.079284667969</c:v>
                </c:pt>
                <c:pt idx="209">
                  <c:v>32510.081390380859</c:v>
                </c:pt>
                <c:pt idx="210">
                  <c:v>32504.997802734375</c:v>
                </c:pt>
                <c:pt idx="211">
                  <c:v>32493.628479003906</c:v>
                </c:pt>
                <c:pt idx="212">
                  <c:v>32490.487731933594</c:v>
                </c:pt>
                <c:pt idx="213">
                  <c:v>32494.461273193359</c:v>
                </c:pt>
                <c:pt idx="214">
                  <c:v>32501.234832763672</c:v>
                </c:pt>
                <c:pt idx="215">
                  <c:v>32499.151245117188</c:v>
                </c:pt>
                <c:pt idx="216">
                  <c:v>32485.639068603516</c:v>
                </c:pt>
                <c:pt idx="217">
                  <c:v>32476.269744873047</c:v>
                </c:pt>
                <c:pt idx="218">
                  <c:v>32480.271881103516</c:v>
                </c:pt>
                <c:pt idx="219">
                  <c:v>32485.245422363281</c:v>
                </c:pt>
                <c:pt idx="220">
                  <c:v>32487.876098632813</c:v>
                </c:pt>
                <c:pt idx="221">
                  <c:v>32492.706787109375</c:v>
                </c:pt>
                <c:pt idx="222">
                  <c:v>32490.651763916016</c:v>
                </c:pt>
                <c:pt idx="223">
                  <c:v>32478.339599609375</c:v>
                </c:pt>
                <c:pt idx="224">
                  <c:v>32477.370300292969</c:v>
                </c:pt>
                <c:pt idx="225">
                  <c:v>32487.315246582031</c:v>
                </c:pt>
                <c:pt idx="226">
                  <c:v>32487.831665039063</c:v>
                </c:pt>
                <c:pt idx="227">
                  <c:v>32477.176635742188</c:v>
                </c:pt>
                <c:pt idx="228">
                  <c:v>32471.121612548828</c:v>
                </c:pt>
                <c:pt idx="229">
                  <c:v>32471.295166015625</c:v>
                </c:pt>
                <c:pt idx="230">
                  <c:v>32463.868713378906</c:v>
                </c:pt>
                <c:pt idx="231">
                  <c:v>32450.527954101563</c:v>
                </c:pt>
                <c:pt idx="232">
                  <c:v>32441.730072021484</c:v>
                </c:pt>
                <c:pt idx="233">
                  <c:v>32447.846466064453</c:v>
                </c:pt>
                <c:pt idx="234">
                  <c:v>32455.734313964844</c:v>
                </c:pt>
                <c:pt idx="235">
                  <c:v>32455.050720214844</c:v>
                </c:pt>
                <c:pt idx="236">
                  <c:v>32449.367126464844</c:v>
                </c:pt>
                <c:pt idx="237">
                  <c:v>32451.254943847656</c:v>
                </c:pt>
                <c:pt idx="238">
                  <c:v>32460.142791748047</c:v>
                </c:pt>
                <c:pt idx="239">
                  <c:v>32468.087738037109</c:v>
                </c:pt>
                <c:pt idx="240">
                  <c:v>32469.318450927734</c:v>
                </c:pt>
                <c:pt idx="241">
                  <c:v>32462.320556640625</c:v>
                </c:pt>
                <c:pt idx="242">
                  <c:v>32451.951232910156</c:v>
                </c:pt>
                <c:pt idx="243">
                  <c:v>32450.610504150391</c:v>
                </c:pt>
                <c:pt idx="244">
                  <c:v>32450.29833984375</c:v>
                </c:pt>
                <c:pt idx="245">
                  <c:v>32440.871887207031</c:v>
                </c:pt>
                <c:pt idx="246">
                  <c:v>32429.016845703125</c:v>
                </c:pt>
                <c:pt idx="247">
                  <c:v>32433.476104736328</c:v>
                </c:pt>
                <c:pt idx="248">
                  <c:v>32446.563934326172</c:v>
                </c:pt>
                <c:pt idx="249">
                  <c:v>32455.137481689453</c:v>
                </c:pt>
                <c:pt idx="250">
                  <c:v>32456.739624023438</c:v>
                </c:pt>
                <c:pt idx="251">
                  <c:v>32451.256011962891</c:v>
                </c:pt>
                <c:pt idx="252">
                  <c:v>32437.058135986328</c:v>
                </c:pt>
                <c:pt idx="253">
                  <c:v>32419.831665039063</c:v>
                </c:pt>
                <c:pt idx="254">
                  <c:v>32410.233795166016</c:v>
                </c:pt>
                <c:pt idx="255">
                  <c:v>32415.89306640625</c:v>
                </c:pt>
                <c:pt idx="256">
                  <c:v>32429.2666015625</c:v>
                </c:pt>
                <c:pt idx="257">
                  <c:v>32435.697296142578</c:v>
                </c:pt>
                <c:pt idx="258">
                  <c:v>32430.785125732422</c:v>
                </c:pt>
                <c:pt idx="259">
                  <c:v>32427.872955322266</c:v>
                </c:pt>
                <c:pt idx="260">
                  <c:v>32434.789337158203</c:v>
                </c:pt>
                <c:pt idx="261">
                  <c:v>32437.391479492188</c:v>
                </c:pt>
                <c:pt idx="262">
                  <c:v>32434.307861328125</c:v>
                </c:pt>
                <c:pt idx="263">
                  <c:v>32426.624267578125</c:v>
                </c:pt>
                <c:pt idx="264">
                  <c:v>32417.483520507813</c:v>
                </c:pt>
                <c:pt idx="265">
                  <c:v>32413.342803955078</c:v>
                </c:pt>
                <c:pt idx="266">
                  <c:v>32421.830627441406</c:v>
                </c:pt>
                <c:pt idx="267">
                  <c:v>32427.947021484375</c:v>
                </c:pt>
                <c:pt idx="268">
                  <c:v>32417.320556640625</c:v>
                </c:pt>
                <c:pt idx="269">
                  <c:v>32405.122680664063</c:v>
                </c:pt>
                <c:pt idx="270">
                  <c:v>32401.839080810547</c:v>
                </c:pt>
                <c:pt idx="271">
                  <c:v>32404.2412109375</c:v>
                </c:pt>
                <c:pt idx="272">
                  <c:v>32408.757598876953</c:v>
                </c:pt>
                <c:pt idx="273">
                  <c:v>32413.531158447266</c:v>
                </c:pt>
                <c:pt idx="274">
                  <c:v>32412.476135253906</c:v>
                </c:pt>
                <c:pt idx="275">
                  <c:v>32407.449676513672</c:v>
                </c:pt>
                <c:pt idx="276">
                  <c:v>32404.251800537109</c:v>
                </c:pt>
                <c:pt idx="277">
                  <c:v>32398.596771240234</c:v>
                </c:pt>
                <c:pt idx="278">
                  <c:v>32393.256011962891</c:v>
                </c:pt>
                <c:pt idx="279">
                  <c:v>32395.429565429688</c:v>
                </c:pt>
                <c:pt idx="280">
                  <c:v>32407.203125</c:v>
                </c:pt>
                <c:pt idx="281">
                  <c:v>32410.948089599609</c:v>
                </c:pt>
                <c:pt idx="282">
                  <c:v>32396.635925292969</c:v>
                </c:pt>
                <c:pt idx="283">
                  <c:v>32380.009460449219</c:v>
                </c:pt>
                <c:pt idx="284">
                  <c:v>32378.097290039063</c:v>
                </c:pt>
                <c:pt idx="285">
                  <c:v>32384.470855712891</c:v>
                </c:pt>
                <c:pt idx="286">
                  <c:v>32384.472961425781</c:v>
                </c:pt>
                <c:pt idx="287">
                  <c:v>32387.132232666016</c:v>
                </c:pt>
                <c:pt idx="288">
                  <c:v>32392.277191162109</c:v>
                </c:pt>
                <c:pt idx="289">
                  <c:v>32396.450744628906</c:v>
                </c:pt>
                <c:pt idx="290">
                  <c:v>32398.824279785156</c:v>
                </c:pt>
                <c:pt idx="291">
                  <c:v>32401.254974365234</c:v>
                </c:pt>
                <c:pt idx="292">
                  <c:v>32401.971374511719</c:v>
                </c:pt>
                <c:pt idx="293">
                  <c:v>32401.544921875</c:v>
                </c:pt>
                <c:pt idx="294">
                  <c:v>32400.061309814453</c:v>
                </c:pt>
                <c:pt idx="295">
                  <c:v>32395.349151611328</c:v>
                </c:pt>
                <c:pt idx="296">
                  <c:v>32396.408416748047</c:v>
                </c:pt>
                <c:pt idx="297">
                  <c:v>32397.410522460938</c:v>
                </c:pt>
                <c:pt idx="298">
                  <c:v>32390.612640380859</c:v>
                </c:pt>
                <c:pt idx="299">
                  <c:v>32378.386199951172</c:v>
                </c:pt>
                <c:pt idx="300">
                  <c:v>32371.502593994141</c:v>
                </c:pt>
                <c:pt idx="301">
                  <c:v>32373.24755859375</c:v>
                </c:pt>
                <c:pt idx="302">
                  <c:v>32379.278259277344</c:v>
                </c:pt>
                <c:pt idx="303">
                  <c:v>32375.766082763672</c:v>
                </c:pt>
                <c:pt idx="304">
                  <c:v>32357.225341796875</c:v>
                </c:pt>
                <c:pt idx="305">
                  <c:v>32343.313171386719</c:v>
                </c:pt>
                <c:pt idx="306">
                  <c:v>32350.543884277344</c:v>
                </c:pt>
                <c:pt idx="307">
                  <c:v>32369.288848876953</c:v>
                </c:pt>
                <c:pt idx="308">
                  <c:v>32378.51953125</c:v>
                </c:pt>
                <c:pt idx="309">
                  <c:v>32369.521636962891</c:v>
                </c:pt>
                <c:pt idx="310">
                  <c:v>32353.15234375</c:v>
                </c:pt>
                <c:pt idx="311">
                  <c:v>32341.554443359375</c:v>
                </c:pt>
                <c:pt idx="312">
                  <c:v>32335.528015136719</c:v>
                </c:pt>
                <c:pt idx="313">
                  <c:v>32336.330108642578</c:v>
                </c:pt>
                <c:pt idx="314">
                  <c:v>32350.103668212891</c:v>
                </c:pt>
                <c:pt idx="315">
                  <c:v>32368.534362792969</c:v>
                </c:pt>
                <c:pt idx="316">
                  <c:v>32372.450744628906</c:v>
                </c:pt>
                <c:pt idx="317">
                  <c:v>32365.4814453125</c:v>
                </c:pt>
                <c:pt idx="318">
                  <c:v>32369.112121582031</c:v>
                </c:pt>
                <c:pt idx="319">
                  <c:v>32386.971374511719</c:v>
                </c:pt>
                <c:pt idx="320">
                  <c:v>32402.173492431641</c:v>
                </c:pt>
                <c:pt idx="321">
                  <c:v>32399.918487548828</c:v>
                </c:pt>
                <c:pt idx="322">
                  <c:v>32387.663452148438</c:v>
                </c:pt>
                <c:pt idx="323">
                  <c:v>32375.465576171875</c:v>
                </c:pt>
                <c:pt idx="324">
                  <c:v>32369.410552978516</c:v>
                </c:pt>
                <c:pt idx="325">
                  <c:v>32361.326934814453</c:v>
                </c:pt>
                <c:pt idx="326">
                  <c:v>32345.786193847656</c:v>
                </c:pt>
                <c:pt idx="327">
                  <c:v>32331.388336181641</c:v>
                </c:pt>
                <c:pt idx="328">
                  <c:v>32330.504730224609</c:v>
                </c:pt>
                <c:pt idx="329">
                  <c:v>32334.992553710938</c:v>
                </c:pt>
                <c:pt idx="330">
                  <c:v>32331.051818847656</c:v>
                </c:pt>
                <c:pt idx="331">
                  <c:v>32327.596801757813</c:v>
                </c:pt>
                <c:pt idx="332">
                  <c:v>32335.056060791016</c:v>
                </c:pt>
                <c:pt idx="333">
                  <c:v>32347.401031494141</c:v>
                </c:pt>
                <c:pt idx="334">
                  <c:v>32352.0888671875</c:v>
                </c:pt>
                <c:pt idx="335">
                  <c:v>32349.090972900391</c:v>
                </c:pt>
                <c:pt idx="336">
                  <c:v>32342.093078613281</c:v>
                </c:pt>
                <c:pt idx="337">
                  <c:v>32338.809478759766</c:v>
                </c:pt>
                <c:pt idx="338">
                  <c:v>32345.983032226563</c:v>
                </c:pt>
                <c:pt idx="339">
                  <c:v>32356.128021240234</c:v>
                </c:pt>
                <c:pt idx="340">
                  <c:v>32359.815856933594</c:v>
                </c:pt>
                <c:pt idx="341">
                  <c:v>32353.360809326172</c:v>
                </c:pt>
                <c:pt idx="342">
                  <c:v>32339.591491699219</c:v>
                </c:pt>
                <c:pt idx="343">
                  <c:v>32324.593627929688</c:v>
                </c:pt>
                <c:pt idx="344">
                  <c:v>32321.538604736328</c:v>
                </c:pt>
                <c:pt idx="345">
                  <c:v>32327.569274902344</c:v>
                </c:pt>
                <c:pt idx="346">
                  <c:v>32328.628540039063</c:v>
                </c:pt>
                <c:pt idx="347">
                  <c:v>32321.259246826172</c:v>
                </c:pt>
                <c:pt idx="348">
                  <c:v>32315.318481445313</c:v>
                </c:pt>
                <c:pt idx="349">
                  <c:v>32317.263458251953</c:v>
                </c:pt>
                <c:pt idx="350">
                  <c:v>32329.294158935547</c:v>
                </c:pt>
                <c:pt idx="351">
                  <c:v>32342.267700195313</c:v>
                </c:pt>
                <c:pt idx="352">
                  <c:v>32345.098388671875</c:v>
                </c:pt>
                <c:pt idx="353">
                  <c:v>32333.071929931641</c:v>
                </c:pt>
                <c:pt idx="354">
                  <c:v>32313.388336181641</c:v>
                </c:pt>
                <c:pt idx="355">
                  <c:v>32306.933319091797</c:v>
                </c:pt>
                <c:pt idx="356">
                  <c:v>32323.849700927734</c:v>
                </c:pt>
                <c:pt idx="357">
                  <c:v>32342.966125488281</c:v>
                </c:pt>
                <c:pt idx="358">
                  <c:v>32343.511077880859</c:v>
                </c:pt>
                <c:pt idx="359">
                  <c:v>32334.656066894531</c:v>
                </c:pt>
                <c:pt idx="360">
                  <c:v>32328.601043701172</c:v>
                </c:pt>
                <c:pt idx="361">
                  <c:v>32319.860290527344</c:v>
                </c:pt>
                <c:pt idx="362">
                  <c:v>32309.576690673828</c:v>
                </c:pt>
                <c:pt idx="363">
                  <c:v>32306.007385253906</c:v>
                </c:pt>
                <c:pt idx="364">
                  <c:v>32308.180938720703</c:v>
                </c:pt>
                <c:pt idx="365">
                  <c:v>32312.183044433594</c:v>
                </c:pt>
                <c:pt idx="366">
                  <c:v>32314.470886230469</c:v>
                </c:pt>
                <c:pt idx="367">
                  <c:v>32315.587280273438</c:v>
                </c:pt>
                <c:pt idx="368">
                  <c:v>32308.846557617188</c:v>
                </c:pt>
                <c:pt idx="369">
                  <c:v>32300.905792236328</c:v>
                </c:pt>
                <c:pt idx="370">
                  <c:v>32299.250793457031</c:v>
                </c:pt>
                <c:pt idx="371">
                  <c:v>32308.024322509766</c:v>
                </c:pt>
                <c:pt idx="372">
                  <c:v>32316.569305419922</c:v>
                </c:pt>
                <c:pt idx="373">
                  <c:v>32317.914276123047</c:v>
                </c:pt>
                <c:pt idx="374">
                  <c:v>32314.002105712891</c:v>
                </c:pt>
                <c:pt idx="375">
                  <c:v>32303.347076416016</c:v>
                </c:pt>
                <c:pt idx="376">
                  <c:v>32289.749206542969</c:v>
                </c:pt>
                <c:pt idx="377">
                  <c:v>32282.094177246094</c:v>
                </c:pt>
                <c:pt idx="378">
                  <c:v>32285.153442382813</c:v>
                </c:pt>
                <c:pt idx="379">
                  <c:v>32289.641265869141</c:v>
                </c:pt>
                <c:pt idx="380">
                  <c:v>32288.614807128906</c:v>
                </c:pt>
                <c:pt idx="381">
                  <c:v>32286.159790039063</c:v>
                </c:pt>
                <c:pt idx="382">
                  <c:v>32282.01904296875</c:v>
                </c:pt>
                <c:pt idx="383">
                  <c:v>32282.964019775391</c:v>
                </c:pt>
                <c:pt idx="384">
                  <c:v>32290.823272705078</c:v>
                </c:pt>
                <c:pt idx="385">
                  <c:v>32297.511108398438</c:v>
                </c:pt>
                <c:pt idx="386">
                  <c:v>32290.456085205078</c:v>
                </c:pt>
                <c:pt idx="387">
                  <c:v>32280.772491455078</c:v>
                </c:pt>
                <c:pt idx="388">
                  <c:v>32279.288879394531</c:v>
                </c:pt>
                <c:pt idx="389">
                  <c:v>32285.433868408203</c:v>
                </c:pt>
                <c:pt idx="390">
                  <c:v>32289.750274658203</c:v>
                </c:pt>
                <c:pt idx="391">
                  <c:v>32293.866668701172</c:v>
                </c:pt>
                <c:pt idx="392">
                  <c:v>32296.611633300781</c:v>
                </c:pt>
                <c:pt idx="393">
                  <c:v>32292.470886230469</c:v>
                </c:pt>
                <c:pt idx="394">
                  <c:v>32280.215881347656</c:v>
                </c:pt>
                <c:pt idx="395">
                  <c:v>32267.989410400391</c:v>
                </c:pt>
                <c:pt idx="396">
                  <c:v>32261.248687744141</c:v>
                </c:pt>
                <c:pt idx="397">
                  <c:v>32258.965087890625</c:v>
                </c:pt>
                <c:pt idx="398">
                  <c:v>32265.795776367188</c:v>
                </c:pt>
                <c:pt idx="399">
                  <c:v>32278.740753173828</c:v>
                </c:pt>
                <c:pt idx="400">
                  <c:v>32281.971435546875</c:v>
                </c:pt>
                <c:pt idx="401">
                  <c:v>32277.259246826172</c:v>
                </c:pt>
                <c:pt idx="402">
                  <c:v>32279.061370849609</c:v>
                </c:pt>
                <c:pt idx="403">
                  <c:v>32288.120635986328</c:v>
                </c:pt>
                <c:pt idx="404">
                  <c:v>32292.008453369141</c:v>
                </c:pt>
                <c:pt idx="405">
                  <c:v>32286.724884033203</c:v>
                </c:pt>
                <c:pt idx="406">
                  <c:v>32272.241271972656</c:v>
                </c:pt>
                <c:pt idx="407">
                  <c:v>32251.271957397461</c:v>
                </c:pt>
                <c:pt idx="408">
                  <c:v>32228.816940307617</c:v>
                </c:pt>
                <c:pt idx="409">
                  <c:v>32212.990478515625</c:v>
                </c:pt>
                <c:pt idx="410">
                  <c:v>32206.278305053711</c:v>
                </c:pt>
                <c:pt idx="411">
                  <c:v>32199.023284912109</c:v>
                </c:pt>
                <c:pt idx="412">
                  <c:v>32181.939682006836</c:v>
                </c:pt>
                <c:pt idx="413">
                  <c:v>32167.198944091797</c:v>
                </c:pt>
                <c:pt idx="414">
                  <c:v>32168.629638671875</c:v>
                </c:pt>
                <c:pt idx="415">
                  <c:v>32176.803176879883</c:v>
                </c:pt>
                <c:pt idx="416">
                  <c:v>32178.97673034668</c:v>
                </c:pt>
                <c:pt idx="417">
                  <c:v>32177.235992431641</c:v>
                </c:pt>
                <c:pt idx="418">
                  <c:v>32178.380966186523</c:v>
                </c:pt>
                <c:pt idx="419">
                  <c:v>32182.068786621094</c:v>
                </c:pt>
                <c:pt idx="420">
                  <c:v>32185.899475097656</c:v>
                </c:pt>
                <c:pt idx="421">
                  <c:v>32184.24446105957</c:v>
                </c:pt>
                <c:pt idx="422">
                  <c:v>32184.018005371094</c:v>
                </c:pt>
                <c:pt idx="423">
                  <c:v>32189.277252197266</c:v>
                </c:pt>
                <c:pt idx="424">
                  <c:v>32198.907943725586</c:v>
                </c:pt>
                <c:pt idx="425">
                  <c:v>32205.881500244141</c:v>
                </c:pt>
                <c:pt idx="426">
                  <c:v>32206.94075012207</c:v>
                </c:pt>
                <c:pt idx="427">
                  <c:v>32198.514297485352</c:v>
                </c:pt>
                <c:pt idx="428">
                  <c:v>32185.059265136719</c:v>
                </c:pt>
                <c:pt idx="429">
                  <c:v>32175.089965820313</c:v>
                </c:pt>
                <c:pt idx="430">
                  <c:v>32166.234939575195</c:v>
                </c:pt>
                <c:pt idx="431">
                  <c:v>32160.494201660156</c:v>
                </c:pt>
                <c:pt idx="432">
                  <c:v>32167.782028198242</c:v>
                </c:pt>
                <c:pt idx="433">
                  <c:v>32175.869857788086</c:v>
                </c:pt>
                <c:pt idx="434">
                  <c:v>32174.27197265625</c:v>
                </c:pt>
                <c:pt idx="435">
                  <c:v>32169.759811401367</c:v>
                </c:pt>
                <c:pt idx="436">
                  <c:v>32177.733352661133</c:v>
                </c:pt>
                <c:pt idx="437">
                  <c:v>32184.992614746094</c:v>
                </c:pt>
                <c:pt idx="438">
                  <c:v>32179.28044128418</c:v>
                </c:pt>
                <c:pt idx="439">
                  <c:v>32167.882553100586</c:v>
                </c:pt>
                <c:pt idx="440">
                  <c:v>32164.741821289063</c:v>
                </c:pt>
                <c:pt idx="441">
                  <c:v>32170.886795043945</c:v>
                </c:pt>
                <c:pt idx="442">
                  <c:v>32178.574630737305</c:v>
                </c:pt>
                <c:pt idx="443">
                  <c:v>32188.54817199707</c:v>
                </c:pt>
                <c:pt idx="444">
                  <c:v>32197.55029296875</c:v>
                </c:pt>
                <c:pt idx="445">
                  <c:v>32195.952407836914</c:v>
                </c:pt>
                <c:pt idx="446">
                  <c:v>32185.583084106445</c:v>
                </c:pt>
                <c:pt idx="447">
                  <c:v>32176.585205078125</c:v>
                </c:pt>
                <c:pt idx="448">
                  <c:v>32174.530181884766</c:v>
                </c:pt>
                <c:pt idx="449">
                  <c:v>32175.103729248047</c:v>
                </c:pt>
                <c:pt idx="450">
                  <c:v>32178.87727355957</c:v>
                </c:pt>
                <c:pt idx="451">
                  <c:v>32184.19367980957</c:v>
                </c:pt>
                <c:pt idx="452">
                  <c:v>32189.881500244141</c:v>
                </c:pt>
                <c:pt idx="453">
                  <c:v>32193.026473999023</c:v>
                </c:pt>
                <c:pt idx="454">
                  <c:v>32194.228591918945</c:v>
                </c:pt>
                <c:pt idx="455">
                  <c:v>32195.573577880859</c:v>
                </c:pt>
                <c:pt idx="456">
                  <c:v>32195.775695800781</c:v>
                </c:pt>
                <c:pt idx="457">
                  <c:v>32192.063522338867</c:v>
                </c:pt>
                <c:pt idx="458">
                  <c:v>32186.922775268555</c:v>
                </c:pt>
                <c:pt idx="459">
                  <c:v>32185.239181518555</c:v>
                </c:pt>
                <c:pt idx="460">
                  <c:v>32187.098434448242</c:v>
                </c:pt>
                <c:pt idx="461">
                  <c:v>32183.757705688477</c:v>
                </c:pt>
                <c:pt idx="462">
                  <c:v>32173.331253051758</c:v>
                </c:pt>
                <c:pt idx="463">
                  <c:v>32171.304794311523</c:v>
                </c:pt>
                <c:pt idx="464">
                  <c:v>32184.53547668457</c:v>
                </c:pt>
                <c:pt idx="465">
                  <c:v>32198.22331237793</c:v>
                </c:pt>
                <c:pt idx="466">
                  <c:v>32197.196853637695</c:v>
                </c:pt>
                <c:pt idx="467">
                  <c:v>32185.48469543457</c:v>
                </c:pt>
                <c:pt idx="468">
                  <c:v>32177.086807250977</c:v>
                </c:pt>
                <c:pt idx="469">
                  <c:v>32186.203201293945</c:v>
                </c:pt>
                <c:pt idx="470">
                  <c:v>32206.119613647461</c:v>
                </c:pt>
                <c:pt idx="471">
                  <c:v>32213.921722412109</c:v>
                </c:pt>
                <c:pt idx="472">
                  <c:v>32198.438125610352</c:v>
                </c:pt>
                <c:pt idx="473">
                  <c:v>32178.211669921875</c:v>
                </c:pt>
                <c:pt idx="474">
                  <c:v>32169.328079223633</c:v>
                </c:pt>
                <c:pt idx="475">
                  <c:v>32170.701629638672</c:v>
                </c:pt>
                <c:pt idx="476">
                  <c:v>32167.275161743164</c:v>
                </c:pt>
                <c:pt idx="477">
                  <c:v>32153.962997436523</c:v>
                </c:pt>
                <c:pt idx="478">
                  <c:v>32145.850830078125</c:v>
                </c:pt>
                <c:pt idx="479">
                  <c:v>32152.252944946289</c:v>
                </c:pt>
                <c:pt idx="480">
                  <c:v>32155.169357299805</c:v>
                </c:pt>
                <c:pt idx="481">
                  <c:v>32146.114318847656</c:v>
                </c:pt>
                <c:pt idx="482">
                  <c:v>32136.83073425293</c:v>
                </c:pt>
                <c:pt idx="483">
                  <c:v>32144.404266357422</c:v>
                </c:pt>
                <c:pt idx="484">
                  <c:v>32156.977813720703</c:v>
                </c:pt>
                <c:pt idx="485">
                  <c:v>32161.065643310547</c:v>
                </c:pt>
                <c:pt idx="486">
                  <c:v>32148.610626220703</c:v>
                </c:pt>
                <c:pt idx="487">
                  <c:v>32127.86988067627</c:v>
                </c:pt>
                <c:pt idx="488">
                  <c:v>32111.729141235352</c:v>
                </c:pt>
                <c:pt idx="489">
                  <c:v>32107.988403320313</c:v>
                </c:pt>
                <c:pt idx="490">
                  <c:v>32111.476234436035</c:v>
                </c:pt>
                <c:pt idx="491">
                  <c:v>32118.592636108398</c:v>
                </c:pt>
                <c:pt idx="492">
                  <c:v>32131.509033203125</c:v>
                </c:pt>
                <c:pt idx="493">
                  <c:v>32146.911163330078</c:v>
                </c:pt>
                <c:pt idx="494">
                  <c:v>32154.913269042969</c:v>
                </c:pt>
                <c:pt idx="495">
                  <c:v>32151.886825561523</c:v>
                </c:pt>
                <c:pt idx="496">
                  <c:v>32143.746078491211</c:v>
                </c:pt>
                <c:pt idx="497">
                  <c:v>32134.948196411133</c:v>
                </c:pt>
                <c:pt idx="498">
                  <c:v>32122.493171691895</c:v>
                </c:pt>
                <c:pt idx="499">
                  <c:v>32108.46671295166</c:v>
                </c:pt>
                <c:pt idx="500">
                  <c:v>32101.611686706543</c:v>
                </c:pt>
                <c:pt idx="501">
                  <c:v>32113.728088378906</c:v>
                </c:pt>
                <c:pt idx="502">
                  <c:v>32133.644500732422</c:v>
                </c:pt>
                <c:pt idx="503">
                  <c:v>32140.332321166992</c:v>
                </c:pt>
                <c:pt idx="504">
                  <c:v>32133.048721313477</c:v>
                </c:pt>
                <c:pt idx="505">
                  <c:v>32123.336555480957</c:v>
                </c:pt>
                <c:pt idx="506">
                  <c:v>32118.967247009277</c:v>
                </c:pt>
                <c:pt idx="507">
                  <c:v>32109.397933959961</c:v>
                </c:pt>
                <c:pt idx="508">
                  <c:v>32097.142906188965</c:v>
                </c:pt>
                <c:pt idx="509">
                  <c:v>32092.516456604004</c:v>
                </c:pt>
                <c:pt idx="510">
                  <c:v>32103.632858276367</c:v>
                </c:pt>
                <c:pt idx="511">
                  <c:v>32124.663543701172</c:v>
                </c:pt>
                <c:pt idx="512">
                  <c:v>32136.894241333008</c:v>
                </c:pt>
                <c:pt idx="513">
                  <c:v>32130.896347045898</c:v>
                </c:pt>
                <c:pt idx="514">
                  <c:v>32112.355613708496</c:v>
                </c:pt>
                <c:pt idx="515">
                  <c:v>32095.07201385498</c:v>
                </c:pt>
                <c:pt idx="516">
                  <c:v>32083.845558166504</c:v>
                </c:pt>
                <c:pt idx="517">
                  <c:v>32075.476249694824</c:v>
                </c:pt>
                <c:pt idx="518">
                  <c:v>32068.07836151123</c:v>
                </c:pt>
                <c:pt idx="519">
                  <c:v>32064.794769287109</c:v>
                </c:pt>
                <c:pt idx="520">
                  <c:v>32070.454025268555</c:v>
                </c:pt>
                <c:pt idx="521">
                  <c:v>32077.027572631836</c:v>
                </c:pt>
                <c:pt idx="522">
                  <c:v>32077.45825958252</c:v>
                </c:pt>
                <c:pt idx="523">
                  <c:v>32077.08895111084</c:v>
                </c:pt>
                <c:pt idx="524">
                  <c:v>32077.376777648926</c:v>
                </c:pt>
                <c:pt idx="525">
                  <c:v>32071.521751403809</c:v>
                </c:pt>
                <c:pt idx="526">
                  <c:v>32064.466728210449</c:v>
                </c:pt>
                <c:pt idx="527">
                  <c:v>32059.783130645752</c:v>
                </c:pt>
                <c:pt idx="528">
                  <c:v>32056.670959472656</c:v>
                </c:pt>
                <c:pt idx="529">
                  <c:v>32054.815933227539</c:v>
                </c:pt>
                <c:pt idx="530">
                  <c:v>32062.58948135376</c:v>
                </c:pt>
                <c:pt idx="531">
                  <c:v>32071.105880737305</c:v>
                </c:pt>
                <c:pt idx="532">
                  <c:v>32068.850860595703</c:v>
                </c:pt>
                <c:pt idx="533">
                  <c:v>32057.195831298828</c:v>
                </c:pt>
                <c:pt idx="534">
                  <c:v>32051.05509185791</c:v>
                </c:pt>
                <c:pt idx="535">
                  <c:v>32050.914352416992</c:v>
                </c:pt>
                <c:pt idx="536">
                  <c:v>32050.459323883057</c:v>
                </c:pt>
                <c:pt idx="537">
                  <c:v>32046.57572555542</c:v>
                </c:pt>
                <c:pt idx="538">
                  <c:v>32045.20641708374</c:v>
                </c:pt>
                <c:pt idx="539">
                  <c:v>32039.437103271484</c:v>
                </c:pt>
                <c:pt idx="540">
                  <c:v>32034.096363067627</c:v>
                </c:pt>
                <c:pt idx="541">
                  <c:v>32033.841339111328</c:v>
                </c:pt>
                <c:pt idx="542">
                  <c:v>32044.072025299072</c:v>
                </c:pt>
                <c:pt idx="543">
                  <c:v>32051.645572662354</c:v>
                </c:pt>
                <c:pt idx="544">
                  <c:v>32046.676258087158</c:v>
                </c:pt>
                <c:pt idx="545">
                  <c:v>32026.678377151489</c:v>
                </c:pt>
                <c:pt idx="546">
                  <c:v>32012.823350906372</c:v>
                </c:pt>
                <c:pt idx="547">
                  <c:v>32019.911182403564</c:v>
                </c:pt>
                <c:pt idx="548">
                  <c:v>32036.027584075928</c:v>
                </c:pt>
                <c:pt idx="549">
                  <c:v>32043.658271789551</c:v>
                </c:pt>
                <c:pt idx="550">
                  <c:v>32049.831817626953</c:v>
                </c:pt>
                <c:pt idx="551">
                  <c:v>32058.576793670654</c:v>
                </c:pt>
                <c:pt idx="552">
                  <c:v>32056.093193054199</c:v>
                </c:pt>
                <c:pt idx="553">
                  <c:v>32042.323883056641</c:v>
                </c:pt>
                <c:pt idx="554">
                  <c:v>32035.383144378662</c:v>
                </c:pt>
                <c:pt idx="555">
                  <c:v>32033.242401123047</c:v>
                </c:pt>
                <c:pt idx="556">
                  <c:v>32022.473091125488</c:v>
                </c:pt>
                <c:pt idx="557">
                  <c:v>32015.246636390686</c:v>
                </c:pt>
                <c:pt idx="558">
                  <c:v>32021.677324295044</c:v>
                </c:pt>
                <c:pt idx="559">
                  <c:v>32037.308013916016</c:v>
                </c:pt>
                <c:pt idx="560">
                  <c:v>32047.167274475098</c:v>
                </c:pt>
                <c:pt idx="561">
                  <c:v>32049.740818023682</c:v>
                </c:pt>
                <c:pt idx="562">
                  <c:v>32047.228649139404</c:v>
                </c:pt>
                <c:pt idx="563">
                  <c:v>32045.459339141846</c:v>
                </c:pt>
                <c:pt idx="564">
                  <c:v>32092.747169494629</c:v>
                </c:pt>
                <c:pt idx="565">
                  <c:v>32179.97785949707</c:v>
                </c:pt>
                <c:pt idx="566">
                  <c:v>32235.894256591797</c:v>
                </c:pt>
                <c:pt idx="567">
                  <c:v>32204.982086181641</c:v>
                </c:pt>
                <c:pt idx="568">
                  <c:v>32143.955642700195</c:v>
                </c:pt>
                <c:pt idx="569">
                  <c:v>32109.32918548584</c:v>
                </c:pt>
                <c:pt idx="570">
                  <c:v>32100.102729797363</c:v>
                </c:pt>
                <c:pt idx="571">
                  <c:v>32105.219131469727</c:v>
                </c:pt>
                <c:pt idx="572">
                  <c:v>32117.02124786377</c:v>
                </c:pt>
                <c:pt idx="573">
                  <c:v>32134.651931762695</c:v>
                </c:pt>
                <c:pt idx="574">
                  <c:v>32146.854049682617</c:v>
                </c:pt>
                <c:pt idx="575">
                  <c:v>32149.084747314453</c:v>
                </c:pt>
                <c:pt idx="576">
                  <c:v>32141.801147460938</c:v>
                </c:pt>
                <c:pt idx="577">
                  <c:v>32132.888977050781</c:v>
                </c:pt>
                <c:pt idx="578">
                  <c:v>32132.205383300781</c:v>
                </c:pt>
                <c:pt idx="579">
                  <c:v>32137.807495117188</c:v>
                </c:pt>
                <c:pt idx="580">
                  <c:v>32143.181045532227</c:v>
                </c:pt>
                <c:pt idx="581">
                  <c:v>32140.897445678711</c:v>
                </c:pt>
                <c:pt idx="582">
                  <c:v>32135.385269165039</c:v>
                </c:pt>
                <c:pt idx="583">
                  <c:v>32121.787391662598</c:v>
                </c:pt>
                <c:pt idx="584">
                  <c:v>32105.30379486084</c:v>
                </c:pt>
                <c:pt idx="585">
                  <c:v>32097.648765563965</c:v>
                </c:pt>
                <c:pt idx="586">
                  <c:v>32104.279457092285</c:v>
                </c:pt>
                <c:pt idx="587">
                  <c:v>32119.367286682129</c:v>
                </c:pt>
                <c:pt idx="588">
                  <c:v>32135.940826416016</c:v>
                </c:pt>
                <c:pt idx="589">
                  <c:v>32147.228668212891</c:v>
                </c:pt>
                <c:pt idx="590">
                  <c:v>32148.65934753418</c:v>
                </c:pt>
                <c:pt idx="591">
                  <c:v>32144.947189331055</c:v>
                </c:pt>
                <c:pt idx="592">
                  <c:v>32143.520721435547</c:v>
                </c:pt>
                <c:pt idx="593">
                  <c:v>32123.494270324707</c:v>
                </c:pt>
                <c:pt idx="594">
                  <c:v>32165.896392822266</c:v>
                </c:pt>
                <c:pt idx="595">
                  <c:v>33326.127075195313</c:v>
                </c:pt>
                <c:pt idx="596">
                  <c:v>38449.47216796875</c:v>
                </c:pt>
                <c:pt idx="597">
                  <c:v>51240.33203125</c:v>
                </c:pt>
                <c:pt idx="598">
                  <c:v>74211.7890625</c:v>
                </c:pt>
                <c:pt idx="599">
                  <c:v>107586.875</c:v>
                </c:pt>
                <c:pt idx="600">
                  <c:v>150451.8203125</c:v>
                </c:pt>
                <c:pt idx="601">
                  <c:v>203156.828125</c:v>
                </c:pt>
                <c:pt idx="602">
                  <c:v>252218.59375</c:v>
                </c:pt>
                <c:pt idx="603">
                  <c:v>279246.59375</c:v>
                </c:pt>
                <c:pt idx="604">
                  <c:v>281287.96875</c:v>
                </c:pt>
                <c:pt idx="605">
                  <c:v>281288.0625</c:v>
                </c:pt>
                <c:pt idx="606">
                  <c:v>281288.15625</c:v>
                </c:pt>
                <c:pt idx="607">
                  <c:v>281288.234375</c:v>
                </c:pt>
                <c:pt idx="608">
                  <c:v>281288.328125</c:v>
                </c:pt>
                <c:pt idx="609">
                  <c:v>281288.40625</c:v>
                </c:pt>
                <c:pt idx="610">
                  <c:v>281288.5</c:v>
                </c:pt>
                <c:pt idx="611">
                  <c:v>281288.59375</c:v>
                </c:pt>
                <c:pt idx="612">
                  <c:v>281288.671875</c:v>
                </c:pt>
                <c:pt idx="613">
                  <c:v>281288.765625</c:v>
                </c:pt>
                <c:pt idx="614">
                  <c:v>281288.859375</c:v>
                </c:pt>
                <c:pt idx="615">
                  <c:v>281288.9375</c:v>
                </c:pt>
                <c:pt idx="616">
                  <c:v>281289.03125</c:v>
                </c:pt>
                <c:pt idx="617">
                  <c:v>281289.109375</c:v>
                </c:pt>
                <c:pt idx="618">
                  <c:v>281289.203125</c:v>
                </c:pt>
                <c:pt idx="619">
                  <c:v>281289.296875</c:v>
                </c:pt>
                <c:pt idx="620">
                  <c:v>281289.375</c:v>
                </c:pt>
                <c:pt idx="621">
                  <c:v>281289.46875</c:v>
                </c:pt>
                <c:pt idx="622">
                  <c:v>281289.5625</c:v>
                </c:pt>
                <c:pt idx="623">
                  <c:v>281289.640625</c:v>
                </c:pt>
                <c:pt idx="624">
                  <c:v>281289.734375</c:v>
                </c:pt>
                <c:pt idx="625">
                  <c:v>281289.8125</c:v>
                </c:pt>
                <c:pt idx="626">
                  <c:v>281289.90625</c:v>
                </c:pt>
                <c:pt idx="627">
                  <c:v>281290</c:v>
                </c:pt>
                <c:pt idx="628">
                  <c:v>281290.078125</c:v>
                </c:pt>
                <c:pt idx="629">
                  <c:v>281290.171875</c:v>
                </c:pt>
                <c:pt idx="630">
                  <c:v>281290.265625</c:v>
                </c:pt>
                <c:pt idx="631">
                  <c:v>281290.34375</c:v>
                </c:pt>
                <c:pt idx="632">
                  <c:v>281290.4375</c:v>
                </c:pt>
                <c:pt idx="633">
                  <c:v>281290.515625</c:v>
                </c:pt>
                <c:pt idx="634">
                  <c:v>281290.609375</c:v>
                </c:pt>
                <c:pt idx="635">
                  <c:v>281290.703125</c:v>
                </c:pt>
                <c:pt idx="636">
                  <c:v>281290.78125</c:v>
                </c:pt>
                <c:pt idx="637">
                  <c:v>281290.875</c:v>
                </c:pt>
                <c:pt idx="638">
                  <c:v>281290.96875</c:v>
                </c:pt>
                <c:pt idx="639">
                  <c:v>281291.046875</c:v>
                </c:pt>
                <c:pt idx="640">
                  <c:v>281291.140625</c:v>
                </c:pt>
                <c:pt idx="641">
                  <c:v>281291.21875</c:v>
                </c:pt>
                <c:pt idx="642">
                  <c:v>281291.3125</c:v>
                </c:pt>
                <c:pt idx="643">
                  <c:v>281291.40625</c:v>
                </c:pt>
                <c:pt idx="644">
                  <c:v>281291.484375</c:v>
                </c:pt>
                <c:pt idx="645">
                  <c:v>281291.578125</c:v>
                </c:pt>
                <c:pt idx="646">
                  <c:v>281291.65625</c:v>
                </c:pt>
                <c:pt idx="647">
                  <c:v>281291.75</c:v>
                </c:pt>
                <c:pt idx="648">
                  <c:v>281291.84375</c:v>
                </c:pt>
                <c:pt idx="649">
                  <c:v>281291.921875</c:v>
                </c:pt>
                <c:pt idx="650">
                  <c:v>281292.015625</c:v>
                </c:pt>
                <c:pt idx="651">
                  <c:v>281292.109375</c:v>
                </c:pt>
                <c:pt idx="652">
                  <c:v>281292.1875</c:v>
                </c:pt>
                <c:pt idx="653">
                  <c:v>281292.28125</c:v>
                </c:pt>
                <c:pt idx="654">
                  <c:v>281292.359375</c:v>
                </c:pt>
                <c:pt idx="655">
                  <c:v>281292.453125</c:v>
                </c:pt>
                <c:pt idx="656">
                  <c:v>281292.546875</c:v>
                </c:pt>
                <c:pt idx="657">
                  <c:v>281292.625</c:v>
                </c:pt>
                <c:pt idx="658">
                  <c:v>281292.71875</c:v>
                </c:pt>
                <c:pt idx="659">
                  <c:v>281292.8125</c:v>
                </c:pt>
                <c:pt idx="660">
                  <c:v>281292.890625</c:v>
                </c:pt>
                <c:pt idx="661">
                  <c:v>281292.984375</c:v>
                </c:pt>
                <c:pt idx="662">
                  <c:v>281293.0625</c:v>
                </c:pt>
                <c:pt idx="663">
                  <c:v>281293.15625</c:v>
                </c:pt>
                <c:pt idx="664">
                  <c:v>281293.25</c:v>
                </c:pt>
                <c:pt idx="665">
                  <c:v>281293.328125</c:v>
                </c:pt>
                <c:pt idx="666">
                  <c:v>281293.421875</c:v>
                </c:pt>
                <c:pt idx="667">
                  <c:v>281293.515625</c:v>
                </c:pt>
                <c:pt idx="668">
                  <c:v>281293.59375</c:v>
                </c:pt>
                <c:pt idx="669">
                  <c:v>281293.6875</c:v>
                </c:pt>
                <c:pt idx="670">
                  <c:v>281293.765625</c:v>
                </c:pt>
                <c:pt idx="671">
                  <c:v>281293.859375</c:v>
                </c:pt>
                <c:pt idx="672">
                  <c:v>281293.953125</c:v>
                </c:pt>
                <c:pt idx="673">
                  <c:v>281294.03125</c:v>
                </c:pt>
                <c:pt idx="674">
                  <c:v>281294.125</c:v>
                </c:pt>
                <c:pt idx="675">
                  <c:v>281294.203125</c:v>
                </c:pt>
                <c:pt idx="676">
                  <c:v>281294.296875</c:v>
                </c:pt>
                <c:pt idx="677">
                  <c:v>281294.390625</c:v>
                </c:pt>
                <c:pt idx="678">
                  <c:v>281294.46875</c:v>
                </c:pt>
                <c:pt idx="679">
                  <c:v>281294.5625</c:v>
                </c:pt>
                <c:pt idx="680">
                  <c:v>281294.65625</c:v>
                </c:pt>
                <c:pt idx="681">
                  <c:v>281294.734375</c:v>
                </c:pt>
                <c:pt idx="682">
                  <c:v>281294.828125</c:v>
                </c:pt>
                <c:pt idx="683">
                  <c:v>281294.90625</c:v>
                </c:pt>
                <c:pt idx="684">
                  <c:v>281295</c:v>
                </c:pt>
                <c:pt idx="685">
                  <c:v>281295.09375</c:v>
                </c:pt>
                <c:pt idx="686">
                  <c:v>281295.171875</c:v>
                </c:pt>
                <c:pt idx="687">
                  <c:v>281295.265625</c:v>
                </c:pt>
                <c:pt idx="688">
                  <c:v>281295.359375</c:v>
                </c:pt>
                <c:pt idx="689">
                  <c:v>281295.4375</c:v>
                </c:pt>
                <c:pt idx="690">
                  <c:v>279004.296875</c:v>
                </c:pt>
                <c:pt idx="691">
                  <c:v>263202.984375</c:v>
                </c:pt>
                <c:pt idx="692">
                  <c:v>252176.9375</c:v>
                </c:pt>
                <c:pt idx="693">
                  <c:v>235986.015625</c:v>
                </c:pt>
                <c:pt idx="694">
                  <c:v>195374.5625</c:v>
                </c:pt>
                <c:pt idx="695">
                  <c:v>130670.9921875</c:v>
                </c:pt>
                <c:pt idx="696">
                  <c:v>80638.96875</c:v>
                </c:pt>
                <c:pt idx="697">
                  <c:v>54417.828125</c:v>
                </c:pt>
                <c:pt idx="698">
                  <c:v>43804.6591796875</c:v>
                </c:pt>
                <c:pt idx="699">
                  <c:v>40764.119140625</c:v>
                </c:pt>
                <c:pt idx="700">
                  <c:v>40669.40625</c:v>
                </c:pt>
                <c:pt idx="701">
                  <c:v>41675.208984375</c:v>
                </c:pt>
                <c:pt idx="702">
                  <c:v>43009.0673828125</c:v>
                </c:pt>
                <c:pt idx="703">
                  <c:v>44504.1552734375</c:v>
                </c:pt>
                <c:pt idx="704">
                  <c:v>46733.2724609375</c:v>
                </c:pt>
                <c:pt idx="705">
                  <c:v>50256.044921875</c:v>
                </c:pt>
                <c:pt idx="706">
                  <c:v>54752.84765625</c:v>
                </c:pt>
                <c:pt idx="707">
                  <c:v>59405.421875</c:v>
                </c:pt>
                <c:pt idx="708">
                  <c:v>63804.765625</c:v>
                </c:pt>
                <c:pt idx="709">
                  <c:v>68165.99609375</c:v>
                </c:pt>
                <c:pt idx="710">
                  <c:v>72965.37109375</c:v>
                </c:pt>
                <c:pt idx="711">
                  <c:v>78772.45703125</c:v>
                </c:pt>
                <c:pt idx="712">
                  <c:v>86255.03125</c:v>
                </c:pt>
                <c:pt idx="713">
                  <c:v>96076.60546875</c:v>
                </c:pt>
                <c:pt idx="714">
                  <c:v>108547.953125</c:v>
                </c:pt>
                <c:pt idx="715">
                  <c:v>122872.4921875</c:v>
                </c:pt>
                <c:pt idx="716">
                  <c:v>136105.7265625</c:v>
                </c:pt>
                <c:pt idx="717">
                  <c:v>143249.84375</c:v>
                </c:pt>
                <c:pt idx="718">
                  <c:v>140758.0703125</c:v>
                </c:pt>
                <c:pt idx="719">
                  <c:v>130034.046875</c:v>
                </c:pt>
                <c:pt idx="720">
                  <c:v>115030.703125</c:v>
                </c:pt>
                <c:pt idx="721">
                  <c:v>99209.3046875</c:v>
                </c:pt>
                <c:pt idx="722">
                  <c:v>85243.96875</c:v>
                </c:pt>
                <c:pt idx="723">
                  <c:v>75414.45703125</c:v>
                </c:pt>
                <c:pt idx="724">
                  <c:v>70274.85546875</c:v>
                </c:pt>
                <c:pt idx="725">
                  <c:v>69248.31640625</c:v>
                </c:pt>
                <c:pt idx="726">
                  <c:v>71656.77734375</c:v>
                </c:pt>
                <c:pt idx="727">
                  <c:v>76446.9765625</c:v>
                </c:pt>
                <c:pt idx="728">
                  <c:v>82437.23828125</c:v>
                </c:pt>
                <c:pt idx="729">
                  <c:v>88833.953125</c:v>
                </c:pt>
                <c:pt idx="730">
                  <c:v>95311.95703125</c:v>
                </c:pt>
                <c:pt idx="731">
                  <c:v>101671.46875</c:v>
                </c:pt>
                <c:pt idx="732">
                  <c:v>107615.6484375</c:v>
                </c:pt>
                <c:pt idx="733">
                  <c:v>112807.421875</c:v>
                </c:pt>
                <c:pt idx="734">
                  <c:v>117018.5078125</c:v>
                </c:pt>
                <c:pt idx="735">
                  <c:v>120189.5390625</c:v>
                </c:pt>
                <c:pt idx="736">
                  <c:v>122417.171875</c:v>
                </c:pt>
                <c:pt idx="737">
                  <c:v>121751.3984375</c:v>
                </c:pt>
                <c:pt idx="738">
                  <c:v>113410.9453125</c:v>
                </c:pt>
                <c:pt idx="739">
                  <c:v>96443.83203125</c:v>
                </c:pt>
                <c:pt idx="740">
                  <c:v>78426.0625</c:v>
                </c:pt>
                <c:pt idx="741">
                  <c:v>67669.3203125</c:v>
                </c:pt>
                <c:pt idx="742">
                  <c:v>63708.58203125</c:v>
                </c:pt>
                <c:pt idx="743">
                  <c:v>62118.26953125</c:v>
                </c:pt>
                <c:pt idx="744">
                  <c:v>61777.5859375</c:v>
                </c:pt>
                <c:pt idx="745">
                  <c:v>62754.90234375</c:v>
                </c:pt>
                <c:pt idx="746">
                  <c:v>62837.875</c:v>
                </c:pt>
                <c:pt idx="747">
                  <c:v>60819.10546875</c:v>
                </c:pt>
                <c:pt idx="748">
                  <c:v>58530.96484375</c:v>
                </c:pt>
                <c:pt idx="749">
                  <c:v>58897.08203125</c:v>
                </c:pt>
                <c:pt idx="750">
                  <c:v>66743.19921875</c:v>
                </c:pt>
                <c:pt idx="751">
                  <c:v>91402.6875</c:v>
                </c:pt>
                <c:pt idx="752">
                  <c:v>141716.6875</c:v>
                </c:pt>
                <c:pt idx="753">
                  <c:v>212599.203125</c:v>
                </c:pt>
                <c:pt idx="754">
                  <c:v>271593.296875</c:v>
                </c:pt>
                <c:pt idx="755">
                  <c:v>274999.859375</c:v>
                </c:pt>
                <c:pt idx="756">
                  <c:v>219389.671875</c:v>
                </c:pt>
                <c:pt idx="757">
                  <c:v>145558.46875</c:v>
                </c:pt>
                <c:pt idx="758">
                  <c:v>92940.38671875</c:v>
                </c:pt>
                <c:pt idx="759">
                  <c:v>66381.55859375</c:v>
                </c:pt>
                <c:pt idx="760">
                  <c:v>56423.84765625</c:v>
                </c:pt>
                <c:pt idx="761">
                  <c:v>53991.421875</c:v>
                </c:pt>
                <c:pt idx="762">
                  <c:v>53610.39453125</c:v>
                </c:pt>
                <c:pt idx="763">
                  <c:v>54280.68359375</c:v>
                </c:pt>
                <c:pt idx="764">
                  <c:v>57107.3125</c:v>
                </c:pt>
                <c:pt idx="765">
                  <c:v>61060.115234375</c:v>
                </c:pt>
                <c:pt idx="766">
                  <c:v>62354.318359375</c:v>
                </c:pt>
                <c:pt idx="767">
                  <c:v>59005.576171875</c:v>
                </c:pt>
                <c:pt idx="768">
                  <c:v>53744.20703125</c:v>
                </c:pt>
                <c:pt idx="769">
                  <c:v>50262.837890625</c:v>
                </c:pt>
                <c:pt idx="770">
                  <c:v>49329.7265625</c:v>
                </c:pt>
                <c:pt idx="771">
                  <c:v>49547.328125</c:v>
                </c:pt>
                <c:pt idx="772">
                  <c:v>50142.2734375</c:v>
                </c:pt>
                <c:pt idx="773">
                  <c:v>51744.388671875</c:v>
                </c:pt>
                <c:pt idx="774">
                  <c:v>55887.36328125</c:v>
                </c:pt>
                <c:pt idx="775">
                  <c:v>64554.05078125</c:v>
                </c:pt>
                <c:pt idx="776">
                  <c:v>80200.73828125</c:v>
                </c:pt>
                <c:pt idx="777">
                  <c:v>104578.515625</c:v>
                </c:pt>
                <c:pt idx="778">
                  <c:v>136681.625</c:v>
                </c:pt>
                <c:pt idx="779">
                  <c:v>172910.34375</c:v>
                </c:pt>
                <c:pt idx="780">
                  <c:v>209469.6875</c:v>
                </c:pt>
                <c:pt idx="781">
                  <c:v>245905.265625</c:v>
                </c:pt>
                <c:pt idx="782">
                  <c:v>271859.921875</c:v>
                </c:pt>
                <c:pt idx="783">
                  <c:v>281303.703125</c:v>
                </c:pt>
                <c:pt idx="784">
                  <c:v>281303.78125</c:v>
                </c:pt>
                <c:pt idx="785">
                  <c:v>276141.46875</c:v>
                </c:pt>
                <c:pt idx="786">
                  <c:v>232225.109375</c:v>
                </c:pt>
                <c:pt idx="787">
                  <c:v>162206.1328125</c:v>
                </c:pt>
                <c:pt idx="788">
                  <c:v>102698.28125</c:v>
                </c:pt>
                <c:pt idx="789">
                  <c:v>71270.65234375</c:v>
                </c:pt>
                <c:pt idx="790">
                  <c:v>59341.68359375</c:v>
                </c:pt>
                <c:pt idx="791">
                  <c:v>57379.828125</c:v>
                </c:pt>
                <c:pt idx="792">
                  <c:v>57772.029296875</c:v>
                </c:pt>
                <c:pt idx="793">
                  <c:v>56638.57421875</c:v>
                </c:pt>
                <c:pt idx="794">
                  <c:v>53803.634765625</c:v>
                </c:pt>
                <c:pt idx="795">
                  <c:v>50835.607421875</c:v>
                </c:pt>
                <c:pt idx="796">
                  <c:v>48932.095703125</c:v>
                </c:pt>
                <c:pt idx="797">
                  <c:v>48734.7265625</c:v>
                </c:pt>
                <c:pt idx="798">
                  <c:v>50768.5859375</c:v>
                </c:pt>
                <c:pt idx="799">
                  <c:v>55158.1015625</c:v>
                </c:pt>
                <c:pt idx="800">
                  <c:v>61212.33203125</c:v>
                </c:pt>
                <c:pt idx="801">
                  <c:v>66633.078125</c:v>
                </c:pt>
                <c:pt idx="802">
                  <c:v>67465.48046875</c:v>
                </c:pt>
                <c:pt idx="803">
                  <c:v>62649.5390625</c:v>
                </c:pt>
                <c:pt idx="804">
                  <c:v>57067.912109375</c:v>
                </c:pt>
                <c:pt idx="805">
                  <c:v>57889.228515625</c:v>
                </c:pt>
                <c:pt idx="806">
                  <c:v>67938.40234375</c:v>
                </c:pt>
                <c:pt idx="807">
                  <c:v>86291.48828125</c:v>
                </c:pt>
                <c:pt idx="808">
                  <c:v>111874.8671875</c:v>
                </c:pt>
                <c:pt idx="809">
                  <c:v>145255.953125</c:v>
                </c:pt>
                <c:pt idx="810">
                  <c:v>189004.640625</c:v>
                </c:pt>
                <c:pt idx="811">
                  <c:v>240192.40625</c:v>
                </c:pt>
                <c:pt idx="812">
                  <c:v>274822.734375</c:v>
                </c:pt>
                <c:pt idx="813">
                  <c:v>281306.328125</c:v>
                </c:pt>
                <c:pt idx="814">
                  <c:v>281306.421875</c:v>
                </c:pt>
                <c:pt idx="815">
                  <c:v>281306.5</c:v>
                </c:pt>
                <c:pt idx="816">
                  <c:v>281306.59375</c:v>
                </c:pt>
                <c:pt idx="817">
                  <c:v>281306.6875</c:v>
                </c:pt>
                <c:pt idx="818">
                  <c:v>281306.765625</c:v>
                </c:pt>
                <c:pt idx="819">
                  <c:v>281306.859375</c:v>
                </c:pt>
                <c:pt idx="820">
                  <c:v>281306.953125</c:v>
                </c:pt>
                <c:pt idx="821">
                  <c:v>281307.03125</c:v>
                </c:pt>
                <c:pt idx="822">
                  <c:v>281307.125</c:v>
                </c:pt>
                <c:pt idx="823">
                  <c:v>281307.203125</c:v>
                </c:pt>
                <c:pt idx="824">
                  <c:v>281307.296875</c:v>
                </c:pt>
                <c:pt idx="825">
                  <c:v>281307.390625</c:v>
                </c:pt>
                <c:pt idx="826">
                  <c:v>281307.46875</c:v>
                </c:pt>
                <c:pt idx="827">
                  <c:v>281307.5625</c:v>
                </c:pt>
                <c:pt idx="828">
                  <c:v>281307.65625</c:v>
                </c:pt>
                <c:pt idx="829">
                  <c:v>281307.734375</c:v>
                </c:pt>
                <c:pt idx="830">
                  <c:v>252618.375</c:v>
                </c:pt>
                <c:pt idx="831">
                  <c:v>184448.171875</c:v>
                </c:pt>
                <c:pt idx="832">
                  <c:v>109288.9140625</c:v>
                </c:pt>
                <c:pt idx="833">
                  <c:v>65666.4609375</c:v>
                </c:pt>
                <c:pt idx="834">
                  <c:v>46439.0615234375</c:v>
                </c:pt>
                <c:pt idx="835">
                  <c:v>40114.32080078125</c:v>
                </c:pt>
                <c:pt idx="836">
                  <c:v>38460.123046875</c:v>
                </c:pt>
                <c:pt idx="837">
                  <c:v>37649.896484375</c:v>
                </c:pt>
                <c:pt idx="838">
                  <c:v>36899.126953125</c:v>
                </c:pt>
                <c:pt idx="839">
                  <c:v>36313.15771484375</c:v>
                </c:pt>
                <c:pt idx="840">
                  <c:v>35992.388671875</c:v>
                </c:pt>
                <c:pt idx="841">
                  <c:v>35996.10498046875</c:v>
                </c:pt>
                <c:pt idx="842">
                  <c:v>36605.021484375</c:v>
                </c:pt>
                <c:pt idx="843">
                  <c:v>38567.16650390625</c:v>
                </c:pt>
                <c:pt idx="844">
                  <c:v>42971.939453125</c:v>
                </c:pt>
                <c:pt idx="845">
                  <c:v>50683.685546875</c:v>
                </c:pt>
                <c:pt idx="846">
                  <c:v>61880.80078125</c:v>
                </c:pt>
                <c:pt idx="847">
                  <c:v>76105.08984375</c:v>
                </c:pt>
                <c:pt idx="848">
                  <c:v>92655.08984375</c:v>
                </c:pt>
                <c:pt idx="849">
                  <c:v>110411.3515625</c:v>
                </c:pt>
                <c:pt idx="850">
                  <c:v>123746.4921875</c:v>
                </c:pt>
                <c:pt idx="851">
                  <c:v>121635.5</c:v>
                </c:pt>
                <c:pt idx="852">
                  <c:v>100757.2421875</c:v>
                </c:pt>
                <c:pt idx="853">
                  <c:v>72098.33203125</c:v>
                </c:pt>
                <c:pt idx="854">
                  <c:v>50215.388671875</c:v>
                </c:pt>
                <c:pt idx="855">
                  <c:v>39070.1630859375</c:v>
                </c:pt>
                <c:pt idx="856">
                  <c:v>35102.4794921875</c:v>
                </c:pt>
                <c:pt idx="857">
                  <c:v>34033.995971679688</c:v>
                </c:pt>
                <c:pt idx="858">
                  <c:v>33623.626708984375</c:v>
                </c:pt>
                <c:pt idx="859">
                  <c:v>33300.885986328125</c:v>
                </c:pt>
                <c:pt idx="860">
                  <c:v>33069.34521484375</c:v>
                </c:pt>
                <c:pt idx="861">
                  <c:v>32948.118713378906</c:v>
                </c:pt>
                <c:pt idx="862">
                  <c:v>32907.920837402344</c:v>
                </c:pt>
                <c:pt idx="863">
                  <c:v>32899.322998046875</c:v>
                </c:pt>
                <c:pt idx="864">
                  <c:v>32881.582214355469</c:v>
                </c:pt>
                <c:pt idx="865">
                  <c:v>32842.812927246094</c:v>
                </c:pt>
                <c:pt idx="866">
                  <c:v>32806.47216796875</c:v>
                </c:pt>
                <c:pt idx="867">
                  <c:v>32807.074279785156</c:v>
                </c:pt>
                <c:pt idx="868">
                  <c:v>32889.390686035156</c:v>
                </c:pt>
                <c:pt idx="869">
                  <c:v>33104.907104492188</c:v>
                </c:pt>
                <c:pt idx="870">
                  <c:v>33474.9091796875</c:v>
                </c:pt>
                <c:pt idx="871">
                  <c:v>33874.654174804688</c:v>
                </c:pt>
                <c:pt idx="872">
                  <c:v>34067.0849609375</c:v>
                </c:pt>
                <c:pt idx="873">
                  <c:v>33909.258422851563</c:v>
                </c:pt>
                <c:pt idx="874">
                  <c:v>33511.432006835938</c:v>
                </c:pt>
                <c:pt idx="875">
                  <c:v>33105.748413085938</c:v>
                </c:pt>
                <c:pt idx="876">
                  <c:v>32846.493347167969</c:v>
                </c:pt>
                <c:pt idx="877">
                  <c:v>32732.352600097656</c:v>
                </c:pt>
                <c:pt idx="878">
                  <c:v>32699.240417480469</c:v>
                </c:pt>
                <c:pt idx="879">
                  <c:v>32688.213989257813</c:v>
                </c:pt>
                <c:pt idx="880">
                  <c:v>32682.930419921875</c:v>
                </c:pt>
                <c:pt idx="881">
                  <c:v>32697.361083984375</c:v>
                </c:pt>
                <c:pt idx="882">
                  <c:v>32742.734619140625</c:v>
                </c:pt>
                <c:pt idx="883">
                  <c:v>32799.651000976563</c:v>
                </c:pt>
                <c:pt idx="884">
                  <c:v>32833.481689453125</c:v>
                </c:pt>
                <c:pt idx="885">
                  <c:v>32843.283813476563</c:v>
                </c:pt>
                <c:pt idx="886">
                  <c:v>32855.285949707031</c:v>
                </c:pt>
                <c:pt idx="887">
                  <c:v>32875.859497070313</c:v>
                </c:pt>
                <c:pt idx="888">
                  <c:v>32882.890197753906</c:v>
                </c:pt>
                <c:pt idx="889">
                  <c:v>32850.09228515625</c:v>
                </c:pt>
                <c:pt idx="890">
                  <c:v>32782.637268066406</c:v>
                </c:pt>
                <c:pt idx="891">
                  <c:v>32698.010803222656</c:v>
                </c:pt>
                <c:pt idx="892">
                  <c:v>32615.841491699219</c:v>
                </c:pt>
                <c:pt idx="893">
                  <c:v>32551.586486816406</c:v>
                </c:pt>
                <c:pt idx="894">
                  <c:v>32517.474304199219</c:v>
                </c:pt>
                <c:pt idx="895">
                  <c:v>32510.619293212891</c:v>
                </c:pt>
                <c:pt idx="896">
                  <c:v>32510.049987792969</c:v>
                </c:pt>
                <c:pt idx="897">
                  <c:v>32503.480651855469</c:v>
                </c:pt>
                <c:pt idx="898">
                  <c:v>32490.454193115234</c:v>
                </c:pt>
                <c:pt idx="899">
                  <c:v>32477.799194335938</c:v>
                </c:pt>
                <c:pt idx="900">
                  <c:v>32469.744140625</c:v>
                </c:pt>
                <c:pt idx="901">
                  <c:v>32470.746276855469</c:v>
                </c:pt>
                <c:pt idx="902">
                  <c:v>32478.062683105469</c:v>
                </c:pt>
                <c:pt idx="903">
                  <c:v>32481.721923828125</c:v>
                </c:pt>
                <c:pt idx="904">
                  <c:v>32470.181182861328</c:v>
                </c:pt>
                <c:pt idx="905">
                  <c:v>32444.154754638672</c:v>
                </c:pt>
                <c:pt idx="906">
                  <c:v>32422.499725341797</c:v>
                </c:pt>
                <c:pt idx="907">
                  <c:v>32421.673248291016</c:v>
                </c:pt>
                <c:pt idx="908">
                  <c:v>32438.475372314453</c:v>
                </c:pt>
                <c:pt idx="909">
                  <c:v>32463.563201904297</c:v>
                </c:pt>
                <c:pt idx="910">
                  <c:v>32488.308197021484</c:v>
                </c:pt>
                <c:pt idx="911">
                  <c:v>32503.824584960938</c:v>
                </c:pt>
                <c:pt idx="912">
                  <c:v>32507.312408447266</c:v>
                </c:pt>
                <c:pt idx="913">
                  <c:v>32503.571685791016</c:v>
                </c:pt>
                <c:pt idx="914">
                  <c:v>32497.488067626953</c:v>
                </c:pt>
                <c:pt idx="915">
                  <c:v>32505.947326660156</c:v>
                </c:pt>
                <c:pt idx="916">
                  <c:v>32553.578002929688</c:v>
                </c:pt>
                <c:pt idx="917">
                  <c:v>32642.065856933594</c:v>
                </c:pt>
                <c:pt idx="918">
                  <c:v>32771.867980957031</c:v>
                </c:pt>
                <c:pt idx="919">
                  <c:v>33036.898681640625</c:v>
                </c:pt>
                <c:pt idx="920">
                  <c:v>33710.643676757813</c:v>
                </c:pt>
                <c:pt idx="921">
                  <c:v>35240.302978515625</c:v>
                </c:pt>
                <c:pt idx="922">
                  <c:v>38085.84765625</c:v>
                </c:pt>
                <c:pt idx="923">
                  <c:v>42454.078125</c:v>
                </c:pt>
                <c:pt idx="924">
                  <c:v>48027.1953125</c:v>
                </c:pt>
                <c:pt idx="925">
                  <c:v>53606.939453125</c:v>
                </c:pt>
                <c:pt idx="926">
                  <c:v>56818.255859375</c:v>
                </c:pt>
                <c:pt idx="927">
                  <c:v>55360.859375</c:v>
                </c:pt>
                <c:pt idx="928">
                  <c:v>49471.4609375</c:v>
                </c:pt>
                <c:pt idx="929">
                  <c:v>42204.5771484375</c:v>
                </c:pt>
                <c:pt idx="930">
                  <c:v>36697.0361328125</c:v>
                </c:pt>
                <c:pt idx="931">
                  <c:v>33877.95263671875</c:v>
                </c:pt>
                <c:pt idx="932">
                  <c:v>32985.926208496094</c:v>
                </c:pt>
                <c:pt idx="933">
                  <c:v>33013.985412597656</c:v>
                </c:pt>
                <c:pt idx="934">
                  <c:v>33397.301879882813</c:v>
                </c:pt>
                <c:pt idx="935">
                  <c:v>33918.989624023438</c:v>
                </c:pt>
                <c:pt idx="936">
                  <c:v>34461.163330078125</c:v>
                </c:pt>
                <c:pt idx="937">
                  <c:v>34921.19384765625</c:v>
                </c:pt>
                <c:pt idx="938">
                  <c:v>35211.99609375</c:v>
                </c:pt>
                <c:pt idx="939">
                  <c:v>35263.026611328125</c:v>
                </c:pt>
                <c:pt idx="940">
                  <c:v>35027.828857421875</c:v>
                </c:pt>
                <c:pt idx="941">
                  <c:v>34517.716552734375</c:v>
                </c:pt>
                <c:pt idx="942">
                  <c:v>33856.233032226563</c:v>
                </c:pt>
                <c:pt idx="943">
                  <c:v>33229.378051757813</c:v>
                </c:pt>
                <c:pt idx="944">
                  <c:v>32762.665893554688</c:v>
                </c:pt>
                <c:pt idx="945">
                  <c:v>32484.696563720703</c:v>
                </c:pt>
                <c:pt idx="946">
                  <c:v>32363.841522216797</c:v>
                </c:pt>
                <c:pt idx="947">
                  <c:v>32337.043640136719</c:v>
                </c:pt>
                <c:pt idx="948">
                  <c:v>32331.417205810547</c:v>
                </c:pt>
                <c:pt idx="949">
                  <c:v>32328.790740966797</c:v>
                </c:pt>
                <c:pt idx="950">
                  <c:v>32336.907135009766</c:v>
                </c:pt>
                <c:pt idx="951">
                  <c:v>32359.62353515625</c:v>
                </c:pt>
                <c:pt idx="952">
                  <c:v>32391.225677490234</c:v>
                </c:pt>
                <c:pt idx="953">
                  <c:v>32431.370635986328</c:v>
                </c:pt>
                <c:pt idx="954">
                  <c:v>32474.6298828125</c:v>
                </c:pt>
                <c:pt idx="955">
                  <c:v>32514.374877929688</c:v>
                </c:pt>
                <c:pt idx="956">
                  <c:v>32551.062683105469</c:v>
                </c:pt>
                <c:pt idx="957">
                  <c:v>32571.807678222656</c:v>
                </c:pt>
                <c:pt idx="958">
                  <c:v>32558.609802246094</c:v>
                </c:pt>
                <c:pt idx="959">
                  <c:v>32503.126190185547</c:v>
                </c:pt>
                <c:pt idx="960">
                  <c:v>32425.842590332031</c:v>
                </c:pt>
                <c:pt idx="961">
                  <c:v>32354.444702148438</c:v>
                </c:pt>
                <c:pt idx="962">
                  <c:v>32315.961120605469</c:v>
                </c:pt>
                <c:pt idx="963">
                  <c:v>32306.334655761719</c:v>
                </c:pt>
                <c:pt idx="964">
                  <c:v>32302.708221435547</c:v>
                </c:pt>
                <c:pt idx="965">
                  <c:v>32292.481750488281</c:v>
                </c:pt>
                <c:pt idx="966">
                  <c:v>32283.341003417969</c:v>
                </c:pt>
                <c:pt idx="967">
                  <c:v>32279.285980224609</c:v>
                </c:pt>
                <c:pt idx="968">
                  <c:v>32275.345245361328</c:v>
                </c:pt>
                <c:pt idx="969">
                  <c:v>32269.433074951172</c:v>
                </c:pt>
                <c:pt idx="970">
                  <c:v>32265.435180664063</c:v>
                </c:pt>
                <c:pt idx="971">
                  <c:v>32262.580169677734</c:v>
                </c:pt>
                <c:pt idx="972">
                  <c:v>32252.5537109375</c:v>
                </c:pt>
                <c:pt idx="973">
                  <c:v>32242.8701171875</c:v>
                </c:pt>
                <c:pt idx="974">
                  <c:v>32240.729370117188</c:v>
                </c:pt>
                <c:pt idx="975">
                  <c:v>32241.617202758789</c:v>
                </c:pt>
                <c:pt idx="976">
                  <c:v>32237.533615112305</c:v>
                </c:pt>
                <c:pt idx="977">
                  <c:v>32232.078582763672</c:v>
                </c:pt>
                <c:pt idx="978">
                  <c:v>32229.137847900391</c:v>
                </c:pt>
                <c:pt idx="979">
                  <c:v>32243.625671386719</c:v>
                </c:pt>
                <c:pt idx="980">
                  <c:v>32300.342071533203</c:v>
                </c:pt>
                <c:pt idx="981">
                  <c:v>32412.57275390625</c:v>
                </c:pt>
                <c:pt idx="982">
                  <c:v>32591.574890136719</c:v>
                </c:pt>
                <c:pt idx="983">
                  <c:v>32833.691284179688</c:v>
                </c:pt>
                <c:pt idx="984">
                  <c:v>33092.236206054688</c:v>
                </c:pt>
                <c:pt idx="985">
                  <c:v>33278.381225585938</c:v>
                </c:pt>
                <c:pt idx="986">
                  <c:v>33313.126220703125</c:v>
                </c:pt>
                <c:pt idx="987">
                  <c:v>33186.58544921875</c:v>
                </c:pt>
                <c:pt idx="988">
                  <c:v>32961.501892089844</c:v>
                </c:pt>
                <c:pt idx="989">
                  <c:v>32734.21826171875</c:v>
                </c:pt>
                <c:pt idx="990">
                  <c:v>32560.363220214844</c:v>
                </c:pt>
                <c:pt idx="991">
                  <c:v>32453.736785888672</c:v>
                </c:pt>
                <c:pt idx="992">
                  <c:v>32405.853179931641</c:v>
                </c:pt>
                <c:pt idx="993">
                  <c:v>32404.026733398438</c:v>
                </c:pt>
                <c:pt idx="994">
                  <c:v>32423.228851318359</c:v>
                </c:pt>
                <c:pt idx="995">
                  <c:v>32449.202392578125</c:v>
                </c:pt>
                <c:pt idx="996">
                  <c:v>32493.775939941406</c:v>
                </c:pt>
                <c:pt idx="997">
                  <c:v>32590.263793945313</c:v>
                </c:pt>
                <c:pt idx="998">
                  <c:v>32798.694458007813</c:v>
                </c:pt>
                <c:pt idx="999">
                  <c:v>33181.439453125</c:v>
                </c:pt>
                <c:pt idx="1000">
                  <c:v>33723.270141601563</c:v>
                </c:pt>
                <c:pt idx="1001">
                  <c:v>34274.614990234375</c:v>
                </c:pt>
                <c:pt idx="1002">
                  <c:v>34609.474365234375</c:v>
                </c:pt>
                <c:pt idx="1003">
                  <c:v>34567.64794921875</c:v>
                </c:pt>
                <c:pt idx="1004">
                  <c:v>34175.53564453125</c:v>
                </c:pt>
                <c:pt idx="1005">
                  <c:v>33621.137817382813</c:v>
                </c:pt>
                <c:pt idx="1006">
                  <c:v>33104.254272460938</c:v>
                </c:pt>
                <c:pt idx="1007">
                  <c:v>32736.884948730469</c:v>
                </c:pt>
                <c:pt idx="1008">
                  <c:v>32538.144226074219</c:v>
                </c:pt>
                <c:pt idx="1009">
                  <c:v>32478.060607910156</c:v>
                </c:pt>
                <c:pt idx="1010">
                  <c:v>32500.834167480469</c:v>
                </c:pt>
                <c:pt idx="1011">
                  <c:v>32541.664855957031</c:v>
                </c:pt>
                <c:pt idx="1012">
                  <c:v>32543.181274414063</c:v>
                </c:pt>
                <c:pt idx="1013">
                  <c:v>32491.15478515625</c:v>
                </c:pt>
                <c:pt idx="1014">
                  <c:v>32420.814056396484</c:v>
                </c:pt>
                <c:pt idx="1015">
                  <c:v>32368.759033203125</c:v>
                </c:pt>
                <c:pt idx="1016">
                  <c:v>32347.075439453125</c:v>
                </c:pt>
                <c:pt idx="1017">
                  <c:v>32356.334686279297</c:v>
                </c:pt>
                <c:pt idx="1018">
                  <c:v>32382.593933105469</c:v>
                </c:pt>
                <c:pt idx="1019">
                  <c:v>32404.796051025391</c:v>
                </c:pt>
                <c:pt idx="1020">
                  <c:v>32415.112457275391</c:v>
                </c:pt>
                <c:pt idx="1021">
                  <c:v>32411.514587402344</c:v>
                </c:pt>
                <c:pt idx="1022">
                  <c:v>32384.773834228516</c:v>
                </c:pt>
                <c:pt idx="1023">
                  <c:v>32341.518829345703</c:v>
                </c:pt>
                <c:pt idx="1024">
                  <c:v>32311.920928955078</c:v>
                </c:pt>
                <c:pt idx="1025">
                  <c:v>32309.665924072266</c:v>
                </c:pt>
                <c:pt idx="1026">
                  <c:v>32322.896606445313</c:v>
                </c:pt>
                <c:pt idx="1027">
                  <c:v>32344.470153808594</c:v>
                </c:pt>
                <c:pt idx="1028">
                  <c:v>32437.615112304688</c:v>
                </c:pt>
                <c:pt idx="1029">
                  <c:v>32887.674377441406</c:v>
                </c:pt>
                <c:pt idx="1030">
                  <c:v>34419.847900390625</c:v>
                </c:pt>
                <c:pt idx="1031">
                  <c:v>38261.478515625</c:v>
                </c:pt>
                <c:pt idx="1032">
                  <c:v>45632.166015625</c:v>
                </c:pt>
                <c:pt idx="1033">
                  <c:v>56619.42578125</c:v>
                </c:pt>
                <c:pt idx="1034">
                  <c:v>69006.3984375</c:v>
                </c:pt>
                <c:pt idx="1035">
                  <c:v>78304.03125</c:v>
                </c:pt>
                <c:pt idx="1036">
                  <c:v>79968.8046875</c:v>
                </c:pt>
                <c:pt idx="1037">
                  <c:v>73082.34765625</c:v>
                </c:pt>
                <c:pt idx="1038">
                  <c:v>61191.693359375</c:v>
                </c:pt>
                <c:pt idx="1039">
                  <c:v>49385.009765625</c:v>
                </c:pt>
                <c:pt idx="1040">
                  <c:v>40768.498046875</c:v>
                </c:pt>
                <c:pt idx="1041">
                  <c:v>35848.95703125</c:v>
                </c:pt>
                <c:pt idx="1042">
                  <c:v>33626.759033203125</c:v>
                </c:pt>
                <c:pt idx="1043">
                  <c:v>32855.218322753906</c:v>
                </c:pt>
                <c:pt idx="1044">
                  <c:v>32705.648986816406</c:v>
                </c:pt>
                <c:pt idx="1045">
                  <c:v>32829.536804199219</c:v>
                </c:pt>
                <c:pt idx="1046">
                  <c:v>33144.738891601563</c:v>
                </c:pt>
                <c:pt idx="1047">
                  <c:v>33605.512451171875</c:v>
                </c:pt>
                <c:pt idx="1048">
                  <c:v>34072.057373046875</c:v>
                </c:pt>
                <c:pt idx="1049">
                  <c:v>34360.5166015625</c:v>
                </c:pt>
                <c:pt idx="1050">
                  <c:v>34364.290283203125</c:v>
                </c:pt>
                <c:pt idx="1051">
                  <c:v>34098.2353515625</c:v>
                </c:pt>
                <c:pt idx="1052">
                  <c:v>33677.351684570313</c:v>
                </c:pt>
                <c:pt idx="1053">
                  <c:v>33261.096557617188</c:v>
                </c:pt>
                <c:pt idx="1054">
                  <c:v>32969.6416015625</c:v>
                </c:pt>
                <c:pt idx="1055">
                  <c:v>32827.986572265625</c:v>
                </c:pt>
                <c:pt idx="1056">
                  <c:v>32784.160095214844</c:v>
                </c:pt>
                <c:pt idx="1057">
                  <c:v>32773.619384765625</c:v>
                </c:pt>
                <c:pt idx="1058">
                  <c:v>32752.592895507813</c:v>
                </c:pt>
                <c:pt idx="1059">
                  <c:v>32719.4521484375</c:v>
                </c:pt>
                <c:pt idx="1060">
                  <c:v>32696.940002441406</c:v>
                </c:pt>
                <c:pt idx="1061">
                  <c:v>32707.627807617188</c:v>
                </c:pt>
                <c:pt idx="1062">
                  <c:v>32735.372802734375</c:v>
                </c:pt>
                <c:pt idx="1063">
                  <c:v>32742.917785644531</c:v>
                </c:pt>
                <c:pt idx="1064">
                  <c:v>32701.491333007813</c:v>
                </c:pt>
                <c:pt idx="1065">
                  <c:v>32609.721984863281</c:v>
                </c:pt>
                <c:pt idx="1066">
                  <c:v>32494.409851074219</c:v>
                </c:pt>
                <c:pt idx="1067">
                  <c:v>32388.469116210938</c:v>
                </c:pt>
                <c:pt idx="1068">
                  <c:v>32312.2998046875</c:v>
                </c:pt>
                <c:pt idx="1069">
                  <c:v>32275.616180419922</c:v>
                </c:pt>
                <c:pt idx="1070">
                  <c:v>32274.018310546875</c:v>
                </c:pt>
                <c:pt idx="1071">
                  <c:v>32282.420440673828</c:v>
                </c:pt>
                <c:pt idx="1072">
                  <c:v>32276.651123046875</c:v>
                </c:pt>
                <c:pt idx="1073">
                  <c:v>32263.310363769531</c:v>
                </c:pt>
                <c:pt idx="1074">
                  <c:v>32250.741058349609</c:v>
                </c:pt>
                <c:pt idx="1075">
                  <c:v>32234.543182373047</c:v>
                </c:pt>
                <c:pt idx="1076">
                  <c:v>32212.631011962891</c:v>
                </c:pt>
                <c:pt idx="1077">
                  <c:v>32194.404556274414</c:v>
                </c:pt>
                <c:pt idx="1078">
                  <c:v>32177.835250854492</c:v>
                </c:pt>
                <c:pt idx="1079">
                  <c:v>32161.865936279297</c:v>
                </c:pt>
                <c:pt idx="1080">
                  <c:v>32145.982330322266</c:v>
                </c:pt>
                <c:pt idx="1081">
                  <c:v>32138.013031005859</c:v>
                </c:pt>
                <c:pt idx="1082">
                  <c:v>32128.386566162109</c:v>
                </c:pt>
                <c:pt idx="1083">
                  <c:v>32114.588691711426</c:v>
                </c:pt>
                <c:pt idx="1084">
                  <c:v>32107.99080657959</c:v>
                </c:pt>
                <c:pt idx="1085">
                  <c:v>32123.592918395996</c:v>
                </c:pt>
                <c:pt idx="1086">
                  <c:v>32168.423614501953</c:v>
                </c:pt>
                <c:pt idx="1087">
                  <c:v>32225.482864379883</c:v>
                </c:pt>
                <c:pt idx="1088">
                  <c:v>32256.170715332031</c:v>
                </c:pt>
                <c:pt idx="1089">
                  <c:v>32238.287109375</c:v>
                </c:pt>
                <c:pt idx="1090">
                  <c:v>32197.432083129883</c:v>
                </c:pt>
                <c:pt idx="1091">
                  <c:v>32165.519912719727</c:v>
                </c:pt>
                <c:pt idx="1092">
                  <c:v>32148.807739257813</c:v>
                </c:pt>
                <c:pt idx="1093">
                  <c:v>32144.92414855957</c:v>
                </c:pt>
                <c:pt idx="1094">
                  <c:v>32152.154830932617</c:v>
                </c:pt>
                <c:pt idx="1095">
                  <c:v>32162.185516357422</c:v>
                </c:pt>
                <c:pt idx="1096">
                  <c:v>32174.730499267578</c:v>
                </c:pt>
                <c:pt idx="1097">
                  <c:v>32184.475463867188</c:v>
                </c:pt>
                <c:pt idx="1098">
                  <c:v>32181.563293457031</c:v>
                </c:pt>
                <c:pt idx="1099">
                  <c:v>32169.165420532227</c:v>
                </c:pt>
                <c:pt idx="1100">
                  <c:v>32163.824676513672</c:v>
                </c:pt>
                <c:pt idx="1101">
                  <c:v>32172.112503051758</c:v>
                </c:pt>
                <c:pt idx="1102">
                  <c:v>32186.286056518555</c:v>
                </c:pt>
                <c:pt idx="1103">
                  <c:v>32200.059600830078</c:v>
                </c:pt>
                <c:pt idx="1104">
                  <c:v>32212.318862915039</c:v>
                </c:pt>
                <c:pt idx="1105">
                  <c:v>32220.406692504883</c:v>
                </c:pt>
                <c:pt idx="1106">
                  <c:v>32212.808807373047</c:v>
                </c:pt>
                <c:pt idx="1107">
                  <c:v>32188.353775024414</c:v>
                </c:pt>
                <c:pt idx="1108">
                  <c:v>32159.098754882813</c:v>
                </c:pt>
                <c:pt idx="1109">
                  <c:v>32141.015151977539</c:v>
                </c:pt>
                <c:pt idx="1110">
                  <c:v>32135.96012878418</c:v>
                </c:pt>
                <c:pt idx="1111">
                  <c:v>32129.90510559082</c:v>
                </c:pt>
                <c:pt idx="1112">
                  <c:v>32111.907218933105</c:v>
                </c:pt>
                <c:pt idx="1113">
                  <c:v>32089.966484069824</c:v>
                </c:pt>
                <c:pt idx="1114">
                  <c:v>32091.56859588623</c:v>
                </c:pt>
                <c:pt idx="1115">
                  <c:v>32113.084999084473</c:v>
                </c:pt>
                <c:pt idx="1116">
                  <c:v>32130.458541870117</c:v>
                </c:pt>
                <c:pt idx="1117">
                  <c:v>32134.832092285156</c:v>
                </c:pt>
                <c:pt idx="1118">
                  <c:v>32146.434204101563</c:v>
                </c:pt>
                <c:pt idx="1119">
                  <c:v>32171.436325073242</c:v>
                </c:pt>
                <c:pt idx="1120">
                  <c:v>32194.667007446289</c:v>
                </c:pt>
                <c:pt idx="1121">
                  <c:v>32205.583419799805</c:v>
                </c:pt>
                <c:pt idx="1122">
                  <c:v>32202.956954956055</c:v>
                </c:pt>
                <c:pt idx="1123">
                  <c:v>32185.359085083008</c:v>
                </c:pt>
                <c:pt idx="1124">
                  <c:v>32151.275482177734</c:v>
                </c:pt>
                <c:pt idx="1125">
                  <c:v>32118.420455932617</c:v>
                </c:pt>
                <c:pt idx="1126">
                  <c:v>32101.822570800781</c:v>
                </c:pt>
                <c:pt idx="1127">
                  <c:v>32098.796119689941</c:v>
                </c:pt>
                <c:pt idx="1128">
                  <c:v>32093.626808166504</c:v>
                </c:pt>
                <c:pt idx="1129">
                  <c:v>32088.486068725586</c:v>
                </c:pt>
                <c:pt idx="1130">
                  <c:v>32085.602470397949</c:v>
                </c:pt>
                <c:pt idx="1131">
                  <c:v>32090.404586791992</c:v>
                </c:pt>
                <c:pt idx="1132">
                  <c:v>32104.635269165039</c:v>
                </c:pt>
                <c:pt idx="1133">
                  <c:v>32123.037391662598</c:v>
                </c:pt>
                <c:pt idx="1134">
                  <c:v>32129.2109375</c:v>
                </c:pt>
                <c:pt idx="1135">
                  <c:v>32127.984481811523</c:v>
                </c:pt>
                <c:pt idx="1136">
                  <c:v>32146.386596679688</c:v>
                </c:pt>
                <c:pt idx="1137">
                  <c:v>32195.102996826172</c:v>
                </c:pt>
                <c:pt idx="1138">
                  <c:v>32257.505126953125</c:v>
                </c:pt>
                <c:pt idx="1139">
                  <c:v>32312.107238769531</c:v>
                </c:pt>
                <c:pt idx="1140">
                  <c:v>32354.537933349609</c:v>
                </c:pt>
                <c:pt idx="1141">
                  <c:v>32394.025756835938</c:v>
                </c:pt>
                <c:pt idx="1142">
                  <c:v>32438.170715332031</c:v>
                </c:pt>
                <c:pt idx="1143">
                  <c:v>32482.258544921875</c:v>
                </c:pt>
                <c:pt idx="1144">
                  <c:v>32500.717803955078</c:v>
                </c:pt>
                <c:pt idx="1145">
                  <c:v>32473.605651855469</c:v>
                </c:pt>
                <c:pt idx="1146">
                  <c:v>32407.864898681641</c:v>
                </c:pt>
                <c:pt idx="1147">
                  <c:v>32332.438446044922</c:v>
                </c:pt>
                <c:pt idx="1148">
                  <c:v>32271.983428955078</c:v>
                </c:pt>
                <c:pt idx="1149">
                  <c:v>32228.614120483398</c:v>
                </c:pt>
                <c:pt idx="1150">
                  <c:v>32199.616226196289</c:v>
                </c:pt>
                <c:pt idx="1151">
                  <c:v>32186.589782714844</c:v>
                </c:pt>
                <c:pt idx="1152">
                  <c:v>32186.563323974609</c:v>
                </c:pt>
                <c:pt idx="1153">
                  <c:v>32179.679733276367</c:v>
                </c:pt>
                <c:pt idx="1154">
                  <c:v>32162.196136474609</c:v>
                </c:pt>
                <c:pt idx="1155">
                  <c:v>32148.655395507813</c:v>
                </c:pt>
                <c:pt idx="1156">
                  <c:v>32142.82893371582</c:v>
                </c:pt>
                <c:pt idx="1157">
                  <c:v>32131.088195800781</c:v>
                </c:pt>
                <c:pt idx="1158">
                  <c:v>32113.833168029785</c:v>
                </c:pt>
                <c:pt idx="1159">
                  <c:v>32103.149574279785</c:v>
                </c:pt>
                <c:pt idx="1160">
                  <c:v>32107.15168762207</c:v>
                </c:pt>
                <c:pt idx="1161">
                  <c:v>32122.953804016113</c:v>
                </c:pt>
                <c:pt idx="1162">
                  <c:v>32151.984497070313</c:v>
                </c:pt>
                <c:pt idx="1163">
                  <c:v>32183.872329711914</c:v>
                </c:pt>
                <c:pt idx="1164">
                  <c:v>32209.16015625</c:v>
                </c:pt>
                <c:pt idx="1165">
                  <c:v>32247.933700561523</c:v>
                </c:pt>
                <c:pt idx="1166">
                  <c:v>32333.078674316406</c:v>
                </c:pt>
                <c:pt idx="1167">
                  <c:v>32454.537933349609</c:v>
                </c:pt>
                <c:pt idx="1168">
                  <c:v>32561.254333496094</c:v>
                </c:pt>
                <c:pt idx="1169">
                  <c:v>32623.313598632813</c:v>
                </c:pt>
                <c:pt idx="1170">
                  <c:v>32629.429992675781</c:v>
                </c:pt>
                <c:pt idx="1171">
                  <c:v>32583.203552246094</c:v>
                </c:pt>
                <c:pt idx="1172">
                  <c:v>32494.434234619141</c:v>
                </c:pt>
                <c:pt idx="1173">
                  <c:v>32386.093505859375</c:v>
                </c:pt>
                <c:pt idx="1174">
                  <c:v>32285.724182128906</c:v>
                </c:pt>
                <c:pt idx="1175">
                  <c:v>32210.554870605469</c:v>
                </c:pt>
                <c:pt idx="1176">
                  <c:v>32174.499847412109</c:v>
                </c:pt>
                <c:pt idx="1177">
                  <c:v>32173.216247558594</c:v>
                </c:pt>
                <c:pt idx="1178">
                  <c:v>32189.904083251953</c:v>
                </c:pt>
                <c:pt idx="1179">
                  <c:v>32198.991912841797</c:v>
                </c:pt>
                <c:pt idx="1180">
                  <c:v>32188.308319091797</c:v>
                </c:pt>
                <c:pt idx="1181">
                  <c:v>32167.710433959961</c:v>
                </c:pt>
                <c:pt idx="1182">
                  <c:v>32154.45539855957</c:v>
                </c:pt>
                <c:pt idx="1183">
                  <c:v>32162.028945922852</c:v>
                </c:pt>
                <c:pt idx="1184">
                  <c:v>32174.145355224609</c:v>
                </c:pt>
                <c:pt idx="1185">
                  <c:v>32179.118896484375</c:v>
                </c:pt>
                <c:pt idx="1186">
                  <c:v>32181.321014404297</c:v>
                </c:pt>
                <c:pt idx="1187">
                  <c:v>32183.265991210938</c:v>
                </c:pt>
                <c:pt idx="1188">
                  <c:v>32180.496673583984</c:v>
                </c:pt>
                <c:pt idx="1189">
                  <c:v>32165.098785400391</c:v>
                </c:pt>
                <c:pt idx="1190">
                  <c:v>32144.47233581543</c:v>
                </c:pt>
                <c:pt idx="1191">
                  <c:v>32132.131591796875</c:v>
                </c:pt>
                <c:pt idx="1192">
                  <c:v>32135.933715820313</c:v>
                </c:pt>
                <c:pt idx="1193">
                  <c:v>32134.678695678711</c:v>
                </c:pt>
                <c:pt idx="1194">
                  <c:v>32114.566520690918</c:v>
                </c:pt>
                <c:pt idx="1195">
                  <c:v>32090.11149597168</c:v>
                </c:pt>
                <c:pt idx="1196">
                  <c:v>32077.799324035645</c:v>
                </c:pt>
                <c:pt idx="1197">
                  <c:v>32073.858581542969</c:v>
                </c:pt>
                <c:pt idx="1198">
                  <c:v>32073.43212890625</c:v>
                </c:pt>
                <c:pt idx="1199">
                  <c:v>32074.348533630371</c:v>
                </c:pt>
                <c:pt idx="1200">
                  <c:v>32081.379219055176</c:v>
                </c:pt>
                <c:pt idx="1201">
                  <c:v>32095.067054748535</c:v>
                </c:pt>
                <c:pt idx="1202">
                  <c:v>32115.183456420898</c:v>
                </c:pt>
                <c:pt idx="1203">
                  <c:v>32128.871292114258</c:v>
                </c:pt>
                <c:pt idx="1204">
                  <c:v>32128.3876953125</c:v>
                </c:pt>
                <c:pt idx="1205">
                  <c:v>32119.646949768066</c:v>
                </c:pt>
                <c:pt idx="1206">
                  <c:v>32116.877639770508</c:v>
                </c:pt>
                <c:pt idx="1207">
                  <c:v>32121.822608947754</c:v>
                </c:pt>
                <c:pt idx="1208">
                  <c:v>32126.367584228516</c:v>
                </c:pt>
                <c:pt idx="1209">
                  <c:v>32122.369697570801</c:v>
                </c:pt>
                <c:pt idx="1210">
                  <c:v>32120.05753326416</c:v>
                </c:pt>
                <c:pt idx="1211">
                  <c:v>32127.202507019043</c:v>
                </c:pt>
                <c:pt idx="1212">
                  <c:v>32139.147476196289</c:v>
                </c:pt>
                <c:pt idx="1213">
                  <c:v>32142.635314941406</c:v>
                </c:pt>
                <c:pt idx="1214">
                  <c:v>32142.180282592773</c:v>
                </c:pt>
                <c:pt idx="1215">
                  <c:v>32141.496688842773</c:v>
                </c:pt>
                <c:pt idx="1216">
                  <c:v>32143.813095092773</c:v>
                </c:pt>
                <c:pt idx="1217">
                  <c:v>32143.072357177734</c:v>
                </c:pt>
                <c:pt idx="1218">
                  <c:v>32136.988754272461</c:v>
                </c:pt>
                <c:pt idx="1219">
                  <c:v>32124.848014831543</c:v>
                </c:pt>
                <c:pt idx="1220">
                  <c:v>32115.907272338867</c:v>
                </c:pt>
                <c:pt idx="1221">
                  <c:v>32113.280815124512</c:v>
                </c:pt>
                <c:pt idx="1222">
                  <c:v>32112.140075683594</c:v>
                </c:pt>
                <c:pt idx="1223">
                  <c:v>32105.027908325195</c:v>
                </c:pt>
                <c:pt idx="1224">
                  <c:v>32099.630027770996</c:v>
                </c:pt>
                <c:pt idx="1225">
                  <c:v>32103.974998474121</c:v>
                </c:pt>
                <c:pt idx="1226">
                  <c:v>32118.66283416748</c:v>
                </c:pt>
                <c:pt idx="1227">
                  <c:v>32120.722091674805</c:v>
                </c:pt>
                <c:pt idx="1228">
                  <c:v>32106.809921264648</c:v>
                </c:pt>
                <c:pt idx="1229">
                  <c:v>32090.01203918457</c:v>
                </c:pt>
                <c:pt idx="1230">
                  <c:v>32091.385581970215</c:v>
                </c:pt>
                <c:pt idx="1231">
                  <c:v>32108.359130859375</c:v>
                </c:pt>
                <c:pt idx="1232">
                  <c:v>32133.01838684082</c:v>
                </c:pt>
                <c:pt idx="1233">
                  <c:v>32151.049072265625</c:v>
                </c:pt>
                <c:pt idx="1234">
                  <c:v>32152.279769897461</c:v>
                </c:pt>
                <c:pt idx="1235">
                  <c:v>32142.453308105469</c:v>
                </c:pt>
                <c:pt idx="1236">
                  <c:v>32141.369720458984</c:v>
                </c:pt>
                <c:pt idx="1237">
                  <c:v>32148.514694213867</c:v>
                </c:pt>
                <c:pt idx="1238">
                  <c:v>32149.945373535156</c:v>
                </c:pt>
                <c:pt idx="1239">
                  <c:v>32147.404632568359</c:v>
                </c:pt>
                <c:pt idx="1240">
                  <c:v>32151.66389465332</c:v>
                </c:pt>
                <c:pt idx="1241">
                  <c:v>32162.894577026367</c:v>
                </c:pt>
                <c:pt idx="1242">
                  <c:v>32173.496704101563</c:v>
                </c:pt>
                <c:pt idx="1243">
                  <c:v>32190.441680908203</c:v>
                </c:pt>
                <c:pt idx="1244">
                  <c:v>32212.386642456055</c:v>
                </c:pt>
                <c:pt idx="1245">
                  <c:v>32225.903045654297</c:v>
                </c:pt>
                <c:pt idx="1246">
                  <c:v>32217.30517578125</c:v>
                </c:pt>
                <c:pt idx="1247">
                  <c:v>32202.792999267578</c:v>
                </c:pt>
                <c:pt idx="1248">
                  <c:v>32202.852264404297</c:v>
                </c:pt>
                <c:pt idx="1249">
                  <c:v>32213.282943725586</c:v>
                </c:pt>
                <c:pt idx="1250">
                  <c:v>32214.027923583984</c:v>
                </c:pt>
                <c:pt idx="1251">
                  <c:v>32202.087188720703</c:v>
                </c:pt>
                <c:pt idx="1252">
                  <c:v>32188.117874145508</c:v>
                </c:pt>
                <c:pt idx="1253">
                  <c:v>32178.834274291992</c:v>
                </c:pt>
                <c:pt idx="1254">
                  <c:v>32176.32209777832</c:v>
                </c:pt>
                <c:pt idx="1255">
                  <c:v>32181.067077636719</c:v>
                </c:pt>
                <c:pt idx="1256">
                  <c:v>32189.097763061523</c:v>
                </c:pt>
                <c:pt idx="1257">
                  <c:v>32190.757019042969</c:v>
                </c:pt>
                <c:pt idx="1258">
                  <c:v>32183.359146118164</c:v>
                </c:pt>
                <c:pt idx="1259">
                  <c:v>32172.446975708008</c:v>
                </c:pt>
                <c:pt idx="1260">
                  <c:v>32164.734802246094</c:v>
                </c:pt>
                <c:pt idx="1261">
                  <c:v>32158.936920166016</c:v>
                </c:pt>
                <c:pt idx="1262">
                  <c:v>32154.767608642578</c:v>
                </c:pt>
                <c:pt idx="1263">
                  <c:v>32155.455444335938</c:v>
                </c:pt>
                <c:pt idx="1264">
                  <c:v>32159.60041809082</c:v>
                </c:pt>
                <c:pt idx="1265">
                  <c:v>32162.059677124023</c:v>
                </c:pt>
                <c:pt idx="1266">
                  <c:v>32168.718933105469</c:v>
                </c:pt>
                <c:pt idx="1267">
                  <c:v>32182.749618530273</c:v>
                </c:pt>
                <c:pt idx="1268">
                  <c:v>32200.380310058594</c:v>
                </c:pt>
                <c:pt idx="1269">
                  <c:v>32208.696716308594</c:v>
                </c:pt>
                <c:pt idx="1270">
                  <c:v>32204.155975341797</c:v>
                </c:pt>
                <c:pt idx="1271">
                  <c:v>32198.843811035156</c:v>
                </c:pt>
                <c:pt idx="1272">
                  <c:v>32203.474487304688</c:v>
                </c:pt>
                <c:pt idx="1273">
                  <c:v>32211.933746337891</c:v>
                </c:pt>
                <c:pt idx="1274">
                  <c:v>32205.278732299805</c:v>
                </c:pt>
                <c:pt idx="1275">
                  <c:v>32186.080841064453</c:v>
                </c:pt>
                <c:pt idx="1276">
                  <c:v>32176.882965087891</c:v>
                </c:pt>
                <c:pt idx="1277">
                  <c:v>32179.970794677734</c:v>
                </c:pt>
                <c:pt idx="1278">
                  <c:v>32184.25862121582</c:v>
                </c:pt>
                <c:pt idx="1279">
                  <c:v>32183.803604125977</c:v>
                </c:pt>
                <c:pt idx="1280">
                  <c:v>32186.748565673828</c:v>
                </c:pt>
                <c:pt idx="1281">
                  <c:v>32189.922119140625</c:v>
                </c:pt>
                <c:pt idx="1282">
                  <c:v>32188.409942626953</c:v>
                </c:pt>
                <c:pt idx="1283">
                  <c:v>32191.612060546875</c:v>
                </c:pt>
                <c:pt idx="1284">
                  <c:v>32203.414184570313</c:v>
                </c:pt>
                <c:pt idx="1285">
                  <c:v>32220.302017211914</c:v>
                </c:pt>
                <c:pt idx="1286">
                  <c:v>32228.561279296875</c:v>
                </c:pt>
                <c:pt idx="1287">
                  <c:v>32231.449096679688</c:v>
                </c:pt>
                <c:pt idx="1288">
                  <c:v>32230.765502929688</c:v>
                </c:pt>
                <c:pt idx="1289">
                  <c:v>32230.424758911133</c:v>
                </c:pt>
                <c:pt idx="1290">
                  <c:v>32221.22688293457</c:v>
                </c:pt>
                <c:pt idx="1291">
                  <c:v>32208.029006958008</c:v>
                </c:pt>
                <c:pt idx="1292">
                  <c:v>32202.059692382813</c:v>
                </c:pt>
                <c:pt idx="1293">
                  <c:v>32202.261810302734</c:v>
                </c:pt>
                <c:pt idx="1294">
                  <c:v>32208.378204345703</c:v>
                </c:pt>
                <c:pt idx="1295">
                  <c:v>32220.980331420898</c:v>
                </c:pt>
                <c:pt idx="1296">
                  <c:v>32237.782440185547</c:v>
                </c:pt>
                <c:pt idx="1297">
                  <c:v>32243.584564208984</c:v>
                </c:pt>
                <c:pt idx="1298">
                  <c:v>32245.843811035156</c:v>
                </c:pt>
                <c:pt idx="1299">
                  <c:v>32246.445938110352</c:v>
                </c:pt>
                <c:pt idx="1300">
                  <c:v>32239.162338256836</c:v>
                </c:pt>
                <c:pt idx="1301">
                  <c:v>32224.707305908203</c:v>
                </c:pt>
                <c:pt idx="1302">
                  <c:v>32223.366577148438</c:v>
                </c:pt>
                <c:pt idx="1303">
                  <c:v>32241.540115356445</c:v>
                </c:pt>
                <c:pt idx="1304">
                  <c:v>32261.199371337891</c:v>
                </c:pt>
                <c:pt idx="1305">
                  <c:v>32263.772918701172</c:v>
                </c:pt>
                <c:pt idx="1306">
                  <c:v>32256.775024414063</c:v>
                </c:pt>
                <c:pt idx="1307">
                  <c:v>32256.462860107422</c:v>
                </c:pt>
                <c:pt idx="1308">
                  <c:v>32267.807830810547</c:v>
                </c:pt>
                <c:pt idx="1309">
                  <c:v>32288.324249267578</c:v>
                </c:pt>
                <c:pt idx="1310">
                  <c:v>32316.640655517578</c:v>
                </c:pt>
                <c:pt idx="1311">
                  <c:v>32352.642761230469</c:v>
                </c:pt>
                <c:pt idx="1312">
                  <c:v>32382.473449707031</c:v>
                </c:pt>
                <c:pt idx="1313">
                  <c:v>32394.161285400391</c:v>
                </c:pt>
                <c:pt idx="1314">
                  <c:v>32387.791961669922</c:v>
                </c:pt>
                <c:pt idx="1315">
                  <c:v>32373.879791259766</c:v>
                </c:pt>
                <c:pt idx="1316">
                  <c:v>32358.024780273438</c:v>
                </c:pt>
                <c:pt idx="1317">
                  <c:v>32348.91259765625</c:v>
                </c:pt>
                <c:pt idx="1318">
                  <c:v>32348.029022216797</c:v>
                </c:pt>
                <c:pt idx="1319">
                  <c:v>32351.631134033203</c:v>
                </c:pt>
                <c:pt idx="1320">
                  <c:v>32360.661804199219</c:v>
                </c:pt>
                <c:pt idx="1321">
                  <c:v>32374.635375976563</c:v>
                </c:pt>
                <c:pt idx="1322">
                  <c:v>32385.694610595703</c:v>
                </c:pt>
                <c:pt idx="1323">
                  <c:v>32396.096740722656</c:v>
                </c:pt>
                <c:pt idx="1324">
                  <c:v>32412.613128662109</c:v>
                </c:pt>
                <c:pt idx="1325">
                  <c:v>32431.443817138672</c:v>
                </c:pt>
                <c:pt idx="1326">
                  <c:v>32446.703094482422</c:v>
                </c:pt>
                <c:pt idx="1327">
                  <c:v>32467.476623535156</c:v>
                </c:pt>
                <c:pt idx="1328">
                  <c:v>32497.478759765625</c:v>
                </c:pt>
                <c:pt idx="1329">
                  <c:v>32521.538024902344</c:v>
                </c:pt>
                <c:pt idx="1330">
                  <c:v>32530.197265625</c:v>
                </c:pt>
                <c:pt idx="1331">
                  <c:v>32537.227966308594</c:v>
                </c:pt>
                <c:pt idx="1332">
                  <c:v>32553.030090332031</c:v>
                </c:pt>
                <c:pt idx="1333">
                  <c:v>32573.117919921875</c:v>
                </c:pt>
                <c:pt idx="1334">
                  <c:v>32590.748596191406</c:v>
                </c:pt>
                <c:pt idx="1335">
                  <c:v>32603.065002441406</c:v>
                </c:pt>
                <c:pt idx="1336">
                  <c:v>32608.295715332031</c:v>
                </c:pt>
                <c:pt idx="1337">
                  <c:v>32608.154968261719</c:v>
                </c:pt>
                <c:pt idx="1338">
                  <c:v>32608.985656738281</c:v>
                </c:pt>
                <c:pt idx="1339">
                  <c:v>32612.787780761719</c:v>
                </c:pt>
                <c:pt idx="1340">
                  <c:v>32615.904174804688</c:v>
                </c:pt>
                <c:pt idx="1341">
                  <c:v>32613.477722167969</c:v>
                </c:pt>
                <c:pt idx="1342">
                  <c:v>32607.022705078125</c:v>
                </c:pt>
                <c:pt idx="1343">
                  <c:v>32604.48193359375</c:v>
                </c:pt>
                <c:pt idx="1344">
                  <c:v>32612.85546875</c:v>
                </c:pt>
                <c:pt idx="1345">
                  <c:v>32630.429016113281</c:v>
                </c:pt>
                <c:pt idx="1346">
                  <c:v>32647.54541015625</c:v>
                </c:pt>
                <c:pt idx="1347">
                  <c:v>32659.318969726563</c:v>
                </c:pt>
                <c:pt idx="1348">
                  <c:v>32673.949645996094</c:v>
                </c:pt>
                <c:pt idx="1349">
                  <c:v>32691.951782226563</c:v>
                </c:pt>
                <c:pt idx="1350">
                  <c:v>32709.582458496094</c:v>
                </c:pt>
                <c:pt idx="1351">
                  <c:v>32725.270324707031</c:v>
                </c:pt>
                <c:pt idx="1352">
                  <c:v>32740.901000976563</c:v>
                </c:pt>
                <c:pt idx="1353">
                  <c:v>32754.903076171875</c:v>
                </c:pt>
                <c:pt idx="1354">
                  <c:v>32774.619506835938</c:v>
                </c:pt>
                <c:pt idx="1355">
                  <c:v>32796.907348632813</c:v>
                </c:pt>
                <c:pt idx="1356">
                  <c:v>32814.995178222656</c:v>
                </c:pt>
                <c:pt idx="1357">
                  <c:v>32837.054443359375</c:v>
                </c:pt>
                <c:pt idx="1358">
                  <c:v>32881.799377441406</c:v>
                </c:pt>
                <c:pt idx="1359">
                  <c:v>32941.058654785156</c:v>
                </c:pt>
                <c:pt idx="1360">
                  <c:v>32996.660766601563</c:v>
                </c:pt>
                <c:pt idx="1361">
                  <c:v>33039.119995117188</c:v>
                </c:pt>
                <c:pt idx="1362">
                  <c:v>33059.72216796875</c:v>
                </c:pt>
                <c:pt idx="1363">
                  <c:v>33057.181396484375</c:v>
                </c:pt>
                <c:pt idx="1364">
                  <c:v>33044.612060546875</c:v>
                </c:pt>
                <c:pt idx="1365">
                  <c:v>33026.385620117188</c:v>
                </c:pt>
                <c:pt idx="1366">
                  <c:v>33003.644897460938</c:v>
                </c:pt>
                <c:pt idx="1367">
                  <c:v>32979.046997070313</c:v>
                </c:pt>
                <c:pt idx="1368">
                  <c:v>32958.649169921875</c:v>
                </c:pt>
                <c:pt idx="1369">
                  <c:v>32942.879821777344</c:v>
                </c:pt>
                <c:pt idx="1370">
                  <c:v>32933.396240234375</c:v>
                </c:pt>
                <c:pt idx="1371">
                  <c:v>32926.084045410156</c:v>
                </c:pt>
                <c:pt idx="1372">
                  <c:v>32915.600463867188</c:v>
                </c:pt>
                <c:pt idx="1373">
                  <c:v>32902.002563476563</c:v>
                </c:pt>
                <c:pt idx="1374">
                  <c:v>32885.74755859375</c:v>
                </c:pt>
                <c:pt idx="1375">
                  <c:v>32876.12109375</c:v>
                </c:pt>
                <c:pt idx="1376">
                  <c:v>32873.808959960938</c:v>
                </c:pt>
                <c:pt idx="1377">
                  <c:v>32869.411071777344</c:v>
                </c:pt>
                <c:pt idx="1378">
                  <c:v>32857.756042480469</c:v>
                </c:pt>
                <c:pt idx="1379">
                  <c:v>32846.472412109375</c:v>
                </c:pt>
                <c:pt idx="1380">
                  <c:v>32833.074523925781</c:v>
                </c:pt>
                <c:pt idx="1381">
                  <c:v>32813.419494628906</c:v>
                </c:pt>
                <c:pt idx="1382">
                  <c:v>32789.193054199219</c:v>
                </c:pt>
                <c:pt idx="1383">
                  <c:v>32769.509460449219</c:v>
                </c:pt>
                <c:pt idx="1384">
                  <c:v>32758.740173339844</c:v>
                </c:pt>
                <c:pt idx="1385">
                  <c:v>32760.256530761719</c:v>
                </c:pt>
                <c:pt idx="1386">
                  <c:v>32767.230102539063</c:v>
                </c:pt>
                <c:pt idx="1387">
                  <c:v>32769.632202148438</c:v>
                </c:pt>
                <c:pt idx="1388">
                  <c:v>32762.262939453125</c:v>
                </c:pt>
                <c:pt idx="1389">
                  <c:v>32746.236450195313</c:v>
                </c:pt>
                <c:pt idx="1390">
                  <c:v>32726.667114257813</c:v>
                </c:pt>
                <c:pt idx="1391">
                  <c:v>32714.012145996094</c:v>
                </c:pt>
                <c:pt idx="1392">
                  <c:v>32710.042785644531</c:v>
                </c:pt>
                <c:pt idx="1393">
                  <c:v>32710.216369628906</c:v>
                </c:pt>
                <c:pt idx="1394">
                  <c:v>32706.018493652344</c:v>
                </c:pt>
                <c:pt idx="1395">
                  <c:v>32694.992004394531</c:v>
                </c:pt>
                <c:pt idx="1396">
                  <c:v>32676.451293945313</c:v>
                </c:pt>
                <c:pt idx="1397">
                  <c:v>32663.796264648438</c:v>
                </c:pt>
                <c:pt idx="1398">
                  <c:v>32661.998352050781</c:v>
                </c:pt>
                <c:pt idx="1399">
                  <c:v>32663.371887207031</c:v>
                </c:pt>
                <c:pt idx="1400">
                  <c:v>32658.545471191406</c:v>
                </c:pt>
                <c:pt idx="1401">
                  <c:v>32652.147583007813</c:v>
                </c:pt>
                <c:pt idx="1402">
                  <c:v>32651.692565917969</c:v>
                </c:pt>
                <c:pt idx="1403">
                  <c:v>32656.694641113281</c:v>
                </c:pt>
                <c:pt idx="1404">
                  <c:v>32661.896789550781</c:v>
                </c:pt>
                <c:pt idx="1405">
                  <c:v>32667.213195800781</c:v>
                </c:pt>
                <c:pt idx="1406">
                  <c:v>32672.358154296875</c:v>
                </c:pt>
                <c:pt idx="1407">
                  <c:v>32675.017395019531</c:v>
                </c:pt>
                <c:pt idx="1408">
                  <c:v>32674.933837890625</c:v>
                </c:pt>
                <c:pt idx="1409">
                  <c:v>32678.793090820313</c:v>
                </c:pt>
                <c:pt idx="1410">
                  <c:v>32681.052368164063</c:v>
                </c:pt>
                <c:pt idx="1411">
                  <c:v>32674.483032226563</c:v>
                </c:pt>
                <c:pt idx="1412">
                  <c:v>32666.799438476563</c:v>
                </c:pt>
                <c:pt idx="1413">
                  <c:v>32663.887268066406</c:v>
                </c:pt>
                <c:pt idx="1414">
                  <c:v>32662.0322265625</c:v>
                </c:pt>
                <c:pt idx="1415">
                  <c:v>32653.29150390625</c:v>
                </c:pt>
                <c:pt idx="1416">
                  <c:v>32642.893615722656</c:v>
                </c:pt>
                <c:pt idx="1417">
                  <c:v>32630.095703125</c:v>
                </c:pt>
                <c:pt idx="1418">
                  <c:v>32615.554992675781</c:v>
                </c:pt>
                <c:pt idx="1419">
                  <c:v>32605.585693359375</c:v>
                </c:pt>
                <c:pt idx="1420">
                  <c:v>32608.587768554688</c:v>
                </c:pt>
                <c:pt idx="1421">
                  <c:v>32622.41845703125</c:v>
                </c:pt>
                <c:pt idx="1422">
                  <c:v>32628.534912109375</c:v>
                </c:pt>
                <c:pt idx="1423">
                  <c:v>32618.308410644531</c:v>
                </c:pt>
                <c:pt idx="1424">
                  <c:v>32613.996276855469</c:v>
                </c:pt>
                <c:pt idx="1425">
                  <c:v>32634.055541992188</c:v>
                </c:pt>
                <c:pt idx="1426">
                  <c:v>32662.514770507813</c:v>
                </c:pt>
                <c:pt idx="1427">
                  <c:v>32675.088317871094</c:v>
                </c:pt>
                <c:pt idx="1428">
                  <c:v>32675.233276367188</c:v>
                </c:pt>
                <c:pt idx="1429">
                  <c:v>32667.635437011719</c:v>
                </c:pt>
                <c:pt idx="1430">
                  <c:v>32652.123229980469</c:v>
                </c:pt>
                <c:pt idx="1431">
                  <c:v>32628.953918457031</c:v>
                </c:pt>
                <c:pt idx="1432">
                  <c:v>32601.0703125</c:v>
                </c:pt>
                <c:pt idx="1433">
                  <c:v>32573.758178710938</c:v>
                </c:pt>
                <c:pt idx="1434">
                  <c:v>32552.445983886719</c:v>
                </c:pt>
                <c:pt idx="1435">
                  <c:v>32538.933837890625</c:v>
                </c:pt>
                <c:pt idx="1436">
                  <c:v>32534.021667480469</c:v>
                </c:pt>
                <c:pt idx="1437">
                  <c:v>32540.309509277344</c:v>
                </c:pt>
                <c:pt idx="1438">
                  <c:v>32552.568725585938</c:v>
                </c:pt>
                <c:pt idx="1439">
                  <c:v>32550.627990722656</c:v>
                </c:pt>
                <c:pt idx="1440">
                  <c:v>32528.65869140625</c:v>
                </c:pt>
                <c:pt idx="1441">
                  <c:v>32501.289398193359</c:v>
                </c:pt>
                <c:pt idx="1442">
                  <c:v>32491.120086669922</c:v>
                </c:pt>
                <c:pt idx="1443">
                  <c:v>32498.807922363281</c:v>
                </c:pt>
                <c:pt idx="1444">
                  <c:v>32512.92431640625</c:v>
                </c:pt>
                <c:pt idx="1445">
                  <c:v>32519.269287109375</c:v>
                </c:pt>
                <c:pt idx="1446">
                  <c:v>32518.957092285156</c:v>
                </c:pt>
                <c:pt idx="1447">
                  <c:v>32522.702087402344</c:v>
                </c:pt>
                <c:pt idx="1448">
                  <c:v>32544.218505859375</c:v>
                </c:pt>
                <c:pt idx="1449">
                  <c:v>32582.106323242188</c:v>
                </c:pt>
                <c:pt idx="1450">
                  <c:v>32625.994140625</c:v>
                </c:pt>
                <c:pt idx="1451">
                  <c:v>32669.596252441406</c:v>
                </c:pt>
                <c:pt idx="1452">
                  <c:v>32703.369812011719</c:v>
                </c:pt>
                <c:pt idx="1453">
                  <c:v>32723.914794921875</c:v>
                </c:pt>
                <c:pt idx="1454">
                  <c:v>32729.459777832031</c:v>
                </c:pt>
                <c:pt idx="1455">
                  <c:v>32725.290466308594</c:v>
                </c:pt>
                <c:pt idx="1456">
                  <c:v>32711.064025878906</c:v>
                </c:pt>
                <c:pt idx="1457">
                  <c:v>32689.466125488281</c:v>
                </c:pt>
                <c:pt idx="1458">
                  <c:v>32665.753967285156</c:v>
                </c:pt>
                <c:pt idx="1459">
                  <c:v>32642.813232421875</c:v>
                </c:pt>
                <c:pt idx="1460">
                  <c:v>32621.558166503906</c:v>
                </c:pt>
                <c:pt idx="1461">
                  <c:v>32605.131713867188</c:v>
                </c:pt>
                <c:pt idx="1462">
                  <c:v>32592.105285644531</c:v>
                </c:pt>
                <c:pt idx="1463">
                  <c:v>32583.135986328125</c:v>
                </c:pt>
                <c:pt idx="1464">
                  <c:v>32574.023803710938</c:v>
                </c:pt>
                <c:pt idx="1465">
                  <c:v>32574.597351074219</c:v>
                </c:pt>
                <c:pt idx="1466">
                  <c:v>32588.028015136719</c:v>
                </c:pt>
                <c:pt idx="1467">
                  <c:v>32607.172973632813</c:v>
                </c:pt>
                <c:pt idx="1468">
                  <c:v>32623.8037109375</c:v>
                </c:pt>
                <c:pt idx="1469">
                  <c:v>32651.1201171875</c:v>
                </c:pt>
                <c:pt idx="1470">
                  <c:v>32698.950805664063</c:v>
                </c:pt>
                <c:pt idx="1471">
                  <c:v>32748.781494140625</c:v>
                </c:pt>
                <c:pt idx="1472">
                  <c:v>32785.069274902344</c:v>
                </c:pt>
                <c:pt idx="1473">
                  <c:v>32812.242858886719</c:v>
                </c:pt>
                <c:pt idx="1474">
                  <c:v>32838.616394042969</c:v>
                </c:pt>
                <c:pt idx="1475">
                  <c:v>32865.18994140625</c:v>
                </c:pt>
                <c:pt idx="1476">
                  <c:v>32886.792053222656</c:v>
                </c:pt>
                <c:pt idx="1477">
                  <c:v>32894.194152832031</c:v>
                </c:pt>
                <c:pt idx="1478">
                  <c:v>32879.110595703125</c:v>
                </c:pt>
                <c:pt idx="1479">
                  <c:v>32856.341247558594</c:v>
                </c:pt>
                <c:pt idx="1480">
                  <c:v>32839.114807128906</c:v>
                </c:pt>
                <c:pt idx="1481">
                  <c:v>32834.20263671875</c:v>
                </c:pt>
                <c:pt idx="1482">
                  <c:v>32838.261901855469</c:v>
                </c:pt>
                <c:pt idx="1483">
                  <c:v>32849.892578125</c:v>
                </c:pt>
                <c:pt idx="1484">
                  <c:v>32866.466125488281</c:v>
                </c:pt>
                <c:pt idx="1485">
                  <c:v>32888.439697265625</c:v>
                </c:pt>
                <c:pt idx="1486">
                  <c:v>32914.013244628906</c:v>
                </c:pt>
                <c:pt idx="1487">
                  <c:v>32937.386779785156</c:v>
                </c:pt>
                <c:pt idx="1488">
                  <c:v>32950.64599609375</c:v>
                </c:pt>
                <c:pt idx="1489">
                  <c:v>32949.505310058594</c:v>
                </c:pt>
                <c:pt idx="1490">
                  <c:v>32943.335998535156</c:v>
                </c:pt>
                <c:pt idx="1491">
                  <c:v>32952.59521484375</c:v>
                </c:pt>
                <c:pt idx="1492">
                  <c:v>32985.568786621094</c:v>
                </c:pt>
                <c:pt idx="1493">
                  <c:v>33030.885131835938</c:v>
                </c:pt>
                <c:pt idx="1494">
                  <c:v>33065.973022460938</c:v>
                </c:pt>
                <c:pt idx="1495">
                  <c:v>33080.63232421875</c:v>
                </c:pt>
                <c:pt idx="1496">
                  <c:v>33090.94873046875</c:v>
                </c:pt>
                <c:pt idx="1497">
                  <c:v>33108.865112304688</c:v>
                </c:pt>
                <c:pt idx="1498">
                  <c:v>33121.9814453125</c:v>
                </c:pt>
                <c:pt idx="1499">
                  <c:v>33123.726440429688</c:v>
                </c:pt>
                <c:pt idx="1500">
                  <c:v>33131.300048828125</c:v>
                </c:pt>
                <c:pt idx="1501">
                  <c:v>33155.587890625</c:v>
                </c:pt>
                <c:pt idx="1502">
                  <c:v>33184.618530273438</c:v>
                </c:pt>
                <c:pt idx="1503">
                  <c:v>33213.477783203125</c:v>
                </c:pt>
                <c:pt idx="1504">
                  <c:v>33247.565551757813</c:v>
                </c:pt>
                <c:pt idx="1505">
                  <c:v>33284.739135742188</c:v>
                </c:pt>
                <c:pt idx="1506">
                  <c:v>33308.541259765625</c:v>
                </c:pt>
                <c:pt idx="1507">
                  <c:v>33317.0576171875</c:v>
                </c:pt>
                <c:pt idx="1508">
                  <c:v>33331.402709960938</c:v>
                </c:pt>
                <c:pt idx="1509">
                  <c:v>33358.976196289063</c:v>
                </c:pt>
                <c:pt idx="1510">
                  <c:v>33388.121215820313</c:v>
                </c:pt>
                <c:pt idx="1511">
                  <c:v>33409.26611328125</c:v>
                </c:pt>
                <c:pt idx="1512">
                  <c:v>33421.096801757813</c:v>
                </c:pt>
                <c:pt idx="1513">
                  <c:v>33415.89892578125</c:v>
                </c:pt>
                <c:pt idx="1514">
                  <c:v>33403.9296875</c:v>
                </c:pt>
                <c:pt idx="1515">
                  <c:v>33404.160278320313</c:v>
                </c:pt>
                <c:pt idx="1516">
                  <c:v>33421.476684570313</c:v>
                </c:pt>
                <c:pt idx="1517">
                  <c:v>33442.478881835938</c:v>
                </c:pt>
                <c:pt idx="1518">
                  <c:v>33462.395263671875</c:v>
                </c:pt>
                <c:pt idx="1519">
                  <c:v>33489.597412109375</c:v>
                </c:pt>
                <c:pt idx="1520">
                  <c:v>33524.28515625</c:v>
                </c:pt>
                <c:pt idx="1521">
                  <c:v>33557.801635742188</c:v>
                </c:pt>
                <c:pt idx="1522">
                  <c:v>33589.517944335938</c:v>
                </c:pt>
                <c:pt idx="1523">
                  <c:v>33630.920166015625</c:v>
                </c:pt>
                <c:pt idx="1524">
                  <c:v>33667.293701171875</c:v>
                </c:pt>
                <c:pt idx="1525">
                  <c:v>33680.9814453125</c:v>
                </c:pt>
                <c:pt idx="1526">
                  <c:v>33677.35498046875</c:v>
                </c:pt>
                <c:pt idx="1527">
                  <c:v>33667.55712890625</c:v>
                </c:pt>
                <c:pt idx="1528">
                  <c:v>33648.102172851563</c:v>
                </c:pt>
                <c:pt idx="1529">
                  <c:v>33630.0185546875</c:v>
                </c:pt>
                <c:pt idx="1530">
                  <c:v>33619.44921875</c:v>
                </c:pt>
                <c:pt idx="1531">
                  <c:v>33613.59423828125</c:v>
                </c:pt>
                <c:pt idx="1532">
                  <c:v>33606.482055664063</c:v>
                </c:pt>
                <c:pt idx="1533">
                  <c:v>33604.884155273438</c:v>
                </c:pt>
                <c:pt idx="1534">
                  <c:v>33612.486206054688</c:v>
                </c:pt>
                <c:pt idx="1535">
                  <c:v>33624.85986328125</c:v>
                </c:pt>
                <c:pt idx="1536">
                  <c:v>33629.261962890625</c:v>
                </c:pt>
                <c:pt idx="1537">
                  <c:v>33625.0068359375</c:v>
                </c:pt>
                <c:pt idx="1538">
                  <c:v>33624.26611328125</c:v>
                </c:pt>
                <c:pt idx="1539">
                  <c:v>33626.953979492188</c:v>
                </c:pt>
                <c:pt idx="1540">
                  <c:v>33625.698974609375</c:v>
                </c:pt>
                <c:pt idx="1541">
                  <c:v>33625.2724609375</c:v>
                </c:pt>
                <c:pt idx="1542">
                  <c:v>33636.703247070313</c:v>
                </c:pt>
                <c:pt idx="1543">
                  <c:v>33666.819580078125</c:v>
                </c:pt>
                <c:pt idx="1544">
                  <c:v>33714.16455078125</c:v>
                </c:pt>
                <c:pt idx="1545">
                  <c:v>33775.509521484375</c:v>
                </c:pt>
                <c:pt idx="1546">
                  <c:v>33841.940185546875</c:v>
                </c:pt>
                <c:pt idx="1547">
                  <c:v>33902.256591796875</c:v>
                </c:pt>
                <c:pt idx="1548">
                  <c:v>33949.287353515625</c:v>
                </c:pt>
                <c:pt idx="1549">
                  <c:v>33976.718017578125</c:v>
                </c:pt>
                <c:pt idx="1550">
                  <c:v>33984.434448242188</c:v>
                </c:pt>
                <c:pt idx="1551">
                  <c:v>33973.807983398438</c:v>
                </c:pt>
                <c:pt idx="1552">
                  <c:v>33954.552978515625</c:v>
                </c:pt>
                <c:pt idx="1553">
                  <c:v>33932.583618164063</c:v>
                </c:pt>
                <c:pt idx="1554">
                  <c:v>33920.271484375</c:v>
                </c:pt>
                <c:pt idx="1555">
                  <c:v>33929.473510742188</c:v>
                </c:pt>
                <c:pt idx="1556">
                  <c:v>33956.218505859375</c:v>
                </c:pt>
                <c:pt idx="1557">
                  <c:v>33986.649291992188</c:v>
                </c:pt>
                <c:pt idx="1558">
                  <c:v>34012.537109375</c:v>
                </c:pt>
                <c:pt idx="1559">
                  <c:v>34034.824951171875</c:v>
                </c:pt>
                <c:pt idx="1560">
                  <c:v>34058.3984375</c:v>
                </c:pt>
                <c:pt idx="1561">
                  <c:v>34083.171875</c:v>
                </c:pt>
                <c:pt idx="1562">
                  <c:v>34110.1455078125</c:v>
                </c:pt>
                <c:pt idx="1563">
                  <c:v>34132.40478515625</c:v>
                </c:pt>
                <c:pt idx="1564">
                  <c:v>34150.235595703125</c:v>
                </c:pt>
                <c:pt idx="1565">
                  <c:v>34166.666259765625</c:v>
                </c:pt>
                <c:pt idx="1566">
                  <c:v>34181.8681640625</c:v>
                </c:pt>
                <c:pt idx="1567">
                  <c:v>34182.21337890625</c:v>
                </c:pt>
                <c:pt idx="1568">
                  <c:v>34168.529541015625</c:v>
                </c:pt>
                <c:pt idx="1569">
                  <c:v>34160.674560546875</c:v>
                </c:pt>
                <c:pt idx="1570">
                  <c:v>34160.27685546875</c:v>
                </c:pt>
                <c:pt idx="1571">
                  <c:v>34155.021728515625</c:v>
                </c:pt>
                <c:pt idx="1572">
                  <c:v>34140.166748046875</c:v>
                </c:pt>
                <c:pt idx="1573">
                  <c:v>34126.597412109375</c:v>
                </c:pt>
                <c:pt idx="1574">
                  <c:v>34111.370849609375</c:v>
                </c:pt>
                <c:pt idx="1575">
                  <c:v>34097.373046875</c:v>
                </c:pt>
                <c:pt idx="1576">
                  <c:v>34093.232421875</c:v>
                </c:pt>
                <c:pt idx="1577">
                  <c:v>34101.262939453125</c:v>
                </c:pt>
                <c:pt idx="1578">
                  <c:v>34104.522216796875</c:v>
                </c:pt>
                <c:pt idx="1579">
                  <c:v>34092.010009765625</c:v>
                </c:pt>
                <c:pt idx="1580">
                  <c:v>34079.8408203125</c:v>
                </c:pt>
                <c:pt idx="1581">
                  <c:v>34075.357177734375</c:v>
                </c:pt>
                <c:pt idx="1582">
                  <c:v>34069.445068359375</c:v>
                </c:pt>
                <c:pt idx="1583">
                  <c:v>34052.96142578125</c:v>
                </c:pt>
                <c:pt idx="1584">
                  <c:v>34038.135009765625</c:v>
                </c:pt>
                <c:pt idx="1585">
                  <c:v>34037.022827148438</c:v>
                </c:pt>
                <c:pt idx="1586">
                  <c:v>34053.56787109375</c:v>
                </c:pt>
                <c:pt idx="1587">
                  <c:v>34077.68408203125</c:v>
                </c:pt>
                <c:pt idx="1588">
                  <c:v>34097.857666015625</c:v>
                </c:pt>
                <c:pt idx="1589">
                  <c:v>34105.3740234375</c:v>
                </c:pt>
                <c:pt idx="1590">
                  <c:v>34094.74755859375</c:v>
                </c:pt>
                <c:pt idx="1591">
                  <c:v>34056.521240234375</c:v>
                </c:pt>
                <c:pt idx="1592">
                  <c:v>33993.80908203125</c:v>
                </c:pt>
                <c:pt idx="1593">
                  <c:v>33924.696899414063</c:v>
                </c:pt>
                <c:pt idx="1594">
                  <c:v>33877.927612304688</c:v>
                </c:pt>
                <c:pt idx="1595">
                  <c:v>33876.87255859375</c:v>
                </c:pt>
                <c:pt idx="1596">
                  <c:v>33949.103271484375</c:v>
                </c:pt>
                <c:pt idx="1597">
                  <c:v>34133.990966796875</c:v>
                </c:pt>
                <c:pt idx="1598">
                  <c:v>34483.250244140625</c:v>
                </c:pt>
                <c:pt idx="1599">
                  <c:v>35060.452392578125</c:v>
                </c:pt>
                <c:pt idx="1600">
                  <c:v>35933.711669921875</c:v>
                </c:pt>
                <c:pt idx="1601">
                  <c:v>37140.37109375</c:v>
                </c:pt>
                <c:pt idx="1602">
                  <c:v>38641.3447265625</c:v>
                </c:pt>
                <c:pt idx="1603">
                  <c:v>40300.1181640625</c:v>
                </c:pt>
                <c:pt idx="1604">
                  <c:v>41886.3203125</c:v>
                </c:pt>
                <c:pt idx="1605">
                  <c:v>43099.72265625</c:v>
                </c:pt>
                <c:pt idx="1606">
                  <c:v>43668.3818359375</c:v>
                </c:pt>
                <c:pt idx="1607">
                  <c:v>43460.2412109375</c:v>
                </c:pt>
                <c:pt idx="1608">
                  <c:v>42533.814453125</c:v>
                </c:pt>
                <c:pt idx="1609">
                  <c:v>41083.73046875</c:v>
                </c:pt>
                <c:pt idx="1610">
                  <c:v>39393.447265625</c:v>
                </c:pt>
                <c:pt idx="1611">
                  <c:v>37764.1064453125</c:v>
                </c:pt>
                <c:pt idx="1612">
                  <c:v>36420.27978515625</c:v>
                </c:pt>
                <c:pt idx="1613">
                  <c:v>35458.167724609375</c:v>
                </c:pt>
                <c:pt idx="1614">
                  <c:v>34885.11279296875</c:v>
                </c:pt>
                <c:pt idx="1615">
                  <c:v>34659.77197265625</c:v>
                </c:pt>
                <c:pt idx="1616">
                  <c:v>34736.116943359375</c:v>
                </c:pt>
                <c:pt idx="1617">
                  <c:v>35111.804931640625</c:v>
                </c:pt>
                <c:pt idx="1618">
                  <c:v>35854.06396484375</c:v>
                </c:pt>
                <c:pt idx="1619">
                  <c:v>37069.69482421875</c:v>
                </c:pt>
                <c:pt idx="1620">
                  <c:v>38818.611328125</c:v>
                </c:pt>
                <c:pt idx="1621">
                  <c:v>41024.927734375</c:v>
                </c:pt>
                <c:pt idx="1622">
                  <c:v>43430.8720703125</c:v>
                </c:pt>
                <c:pt idx="1623">
                  <c:v>45675.845703125</c:v>
                </c:pt>
                <c:pt idx="1624">
                  <c:v>47368.9912109375</c:v>
                </c:pt>
                <c:pt idx="1625">
                  <c:v>48165.4501953125</c:v>
                </c:pt>
                <c:pt idx="1626">
                  <c:v>47857.509765625</c:v>
                </c:pt>
                <c:pt idx="1627">
                  <c:v>46491.826171875</c:v>
                </c:pt>
                <c:pt idx="1628">
                  <c:v>44361.970703125</c:v>
                </c:pt>
                <c:pt idx="1629">
                  <c:v>41884.515625</c:v>
                </c:pt>
                <c:pt idx="1630">
                  <c:v>39451.00390625</c:v>
                </c:pt>
                <c:pt idx="1631">
                  <c:v>37344.8056640625</c:v>
                </c:pt>
                <c:pt idx="1632">
                  <c:v>35711.6650390625</c:v>
                </c:pt>
                <c:pt idx="1633">
                  <c:v>34568.095947265625</c:v>
                </c:pt>
                <c:pt idx="1634">
                  <c:v>33842.469360351563</c:v>
                </c:pt>
                <c:pt idx="1635">
                  <c:v>33416.242919921875</c:v>
                </c:pt>
                <c:pt idx="1636">
                  <c:v>33175.930786132813</c:v>
                </c:pt>
                <c:pt idx="1637">
                  <c:v>33046.561401367188</c:v>
                </c:pt>
                <c:pt idx="1638">
                  <c:v>32988.363586425781</c:v>
                </c:pt>
                <c:pt idx="1639">
                  <c:v>32965.537109375</c:v>
                </c:pt>
                <c:pt idx="1640">
                  <c:v>32951.739196777344</c:v>
                </c:pt>
                <c:pt idx="1641">
                  <c:v>32938.369934082031</c:v>
                </c:pt>
                <c:pt idx="1642">
                  <c:v>32928.143432617188</c:v>
                </c:pt>
                <c:pt idx="1643">
                  <c:v>32923.374145507813</c:v>
                </c:pt>
                <c:pt idx="1644">
                  <c:v>32918.576232910156</c:v>
                </c:pt>
                <c:pt idx="1645">
                  <c:v>32905.892639160156</c:v>
                </c:pt>
                <c:pt idx="1646">
                  <c:v>32888.723327636719</c:v>
                </c:pt>
                <c:pt idx="1647">
                  <c:v>32877.582580566406</c:v>
                </c:pt>
                <c:pt idx="1648">
                  <c:v>32867.270446777344</c:v>
                </c:pt>
                <c:pt idx="1649">
                  <c:v>32853.101135253906</c:v>
                </c:pt>
                <c:pt idx="1650">
                  <c:v>32845.274658203125</c:v>
                </c:pt>
                <c:pt idx="1651">
                  <c:v>32864.048217773438</c:v>
                </c:pt>
                <c:pt idx="1652">
                  <c:v>32904.450317382813</c:v>
                </c:pt>
                <c:pt idx="1653">
                  <c:v>32945.395324707031</c:v>
                </c:pt>
                <c:pt idx="1654">
                  <c:v>32970.426025390625</c:v>
                </c:pt>
                <c:pt idx="1655">
                  <c:v>32991.228088378906</c:v>
                </c:pt>
                <c:pt idx="1656">
                  <c:v>33027.887329101563</c:v>
                </c:pt>
                <c:pt idx="1657">
                  <c:v>33078.860961914063</c:v>
                </c:pt>
                <c:pt idx="1658">
                  <c:v>33131.348754882813</c:v>
                </c:pt>
                <c:pt idx="1659">
                  <c:v>33185.836547851563</c:v>
                </c:pt>
                <c:pt idx="1660">
                  <c:v>33266.152954101563</c:v>
                </c:pt>
                <c:pt idx="1661">
                  <c:v>33375.697998046875</c:v>
                </c:pt>
                <c:pt idx="1662">
                  <c:v>33497.32861328125</c:v>
                </c:pt>
                <c:pt idx="1663">
                  <c:v>33605.730712890625</c:v>
                </c:pt>
                <c:pt idx="1664">
                  <c:v>33681.475708007813</c:v>
                </c:pt>
                <c:pt idx="1665">
                  <c:v>33703.3349609375</c:v>
                </c:pt>
                <c:pt idx="1666">
                  <c:v>33665.822875976563</c:v>
                </c:pt>
                <c:pt idx="1667">
                  <c:v>33585.91064453125</c:v>
                </c:pt>
                <c:pt idx="1668">
                  <c:v>33480.94140625</c:v>
                </c:pt>
                <c:pt idx="1669">
                  <c:v>33362.42919921875</c:v>
                </c:pt>
                <c:pt idx="1670">
                  <c:v>33249.374145507813</c:v>
                </c:pt>
                <c:pt idx="1671">
                  <c:v>33157.06201171875</c:v>
                </c:pt>
                <c:pt idx="1672">
                  <c:v>33081.5498046875</c:v>
                </c:pt>
                <c:pt idx="1673">
                  <c:v>33024.609130859375</c:v>
                </c:pt>
                <c:pt idx="1674">
                  <c:v>33000.12548828125</c:v>
                </c:pt>
                <c:pt idx="1675">
                  <c:v>33011.156188964844</c:v>
                </c:pt>
                <c:pt idx="1676">
                  <c:v>33056.786865234375</c:v>
                </c:pt>
                <c:pt idx="1677">
                  <c:v>33137.18896484375</c:v>
                </c:pt>
                <c:pt idx="1678">
                  <c:v>33248.362548828125</c:v>
                </c:pt>
                <c:pt idx="1679">
                  <c:v>33383.05029296875</c:v>
                </c:pt>
                <c:pt idx="1680">
                  <c:v>33547.995361328125</c:v>
                </c:pt>
                <c:pt idx="1681">
                  <c:v>33757.026000976563</c:v>
                </c:pt>
                <c:pt idx="1682">
                  <c:v>34003.485229492188</c:v>
                </c:pt>
                <c:pt idx="1683">
                  <c:v>34253.74462890625</c:v>
                </c:pt>
                <c:pt idx="1684">
                  <c:v>34456.718017578125</c:v>
                </c:pt>
                <c:pt idx="1685">
                  <c:v>34566.548828125</c:v>
                </c:pt>
                <c:pt idx="1686">
                  <c:v>34561.26513671875</c:v>
                </c:pt>
                <c:pt idx="1687">
                  <c:v>34447.610107421875</c:v>
                </c:pt>
                <c:pt idx="1688">
                  <c:v>34241.32666015625</c:v>
                </c:pt>
                <c:pt idx="1689">
                  <c:v>33966.21435546875</c:v>
                </c:pt>
                <c:pt idx="1690">
                  <c:v>33664.587890625</c:v>
                </c:pt>
                <c:pt idx="1691">
                  <c:v>33379.67578125</c:v>
                </c:pt>
                <c:pt idx="1692">
                  <c:v>33140.192138671875</c:v>
                </c:pt>
                <c:pt idx="1693">
                  <c:v>32961.47998046875</c:v>
                </c:pt>
                <c:pt idx="1694">
                  <c:v>32845.882080078125</c:v>
                </c:pt>
                <c:pt idx="1695">
                  <c:v>32778.712768554688</c:v>
                </c:pt>
                <c:pt idx="1696">
                  <c:v>32742.000610351563</c:v>
                </c:pt>
                <c:pt idx="1697">
                  <c:v>32728.631286621094</c:v>
                </c:pt>
                <c:pt idx="1698">
                  <c:v>32730.861999511719</c:v>
                </c:pt>
                <c:pt idx="1699">
                  <c:v>32735.3212890625</c:v>
                </c:pt>
                <c:pt idx="1700">
                  <c:v>32737.066223144531</c:v>
                </c:pt>
                <c:pt idx="1701">
                  <c:v>32744.782653808594</c:v>
                </c:pt>
                <c:pt idx="1702">
                  <c:v>32752.156188964844</c:v>
                </c:pt>
                <c:pt idx="1703">
                  <c:v>32743.244018554688</c:v>
                </c:pt>
                <c:pt idx="1704">
                  <c:v>32719.874694824219</c:v>
                </c:pt>
                <c:pt idx="1705">
                  <c:v>32695.4482421875</c:v>
                </c:pt>
                <c:pt idx="1706">
                  <c:v>32668.87890625</c:v>
                </c:pt>
                <c:pt idx="1707">
                  <c:v>32636.423889160156</c:v>
                </c:pt>
                <c:pt idx="1708">
                  <c:v>32606.654602050781</c:v>
                </c:pt>
                <c:pt idx="1709">
                  <c:v>32592.370971679688</c:v>
                </c:pt>
                <c:pt idx="1710">
                  <c:v>32595.716003417969</c:v>
                </c:pt>
                <c:pt idx="1711">
                  <c:v>32605.660949707031</c:v>
                </c:pt>
                <c:pt idx="1712">
                  <c:v>32613.948791503906</c:v>
                </c:pt>
                <c:pt idx="1713">
                  <c:v>32620.379455566406</c:v>
                </c:pt>
                <c:pt idx="1714">
                  <c:v>32635.095886230469</c:v>
                </c:pt>
                <c:pt idx="1715">
                  <c:v>32661.297973632813</c:v>
                </c:pt>
                <c:pt idx="1716">
                  <c:v>32691.500122070313</c:v>
                </c:pt>
                <c:pt idx="1717">
                  <c:v>32724.4736328125</c:v>
                </c:pt>
                <c:pt idx="1718">
                  <c:v>32760.161499023438</c:v>
                </c:pt>
                <c:pt idx="1719">
                  <c:v>32802.677856445313</c:v>
                </c:pt>
                <c:pt idx="1720">
                  <c:v>32856.108581542969</c:v>
                </c:pt>
                <c:pt idx="1721">
                  <c:v>32928.996398925781</c:v>
                </c:pt>
                <c:pt idx="1722">
                  <c:v>33016.455688476563</c:v>
                </c:pt>
                <c:pt idx="1723">
                  <c:v>33120.172119140625</c:v>
                </c:pt>
                <c:pt idx="1724">
                  <c:v>33242.717041015625</c:v>
                </c:pt>
                <c:pt idx="1725">
                  <c:v>33369.633422851563</c:v>
                </c:pt>
                <c:pt idx="1726">
                  <c:v>33471.064086914063</c:v>
                </c:pt>
                <c:pt idx="1727">
                  <c:v>33531.894775390625</c:v>
                </c:pt>
                <c:pt idx="1728">
                  <c:v>33547.582641601563</c:v>
                </c:pt>
                <c:pt idx="1729">
                  <c:v>33511.699096679688</c:v>
                </c:pt>
                <c:pt idx="1730">
                  <c:v>33431.75830078125</c:v>
                </c:pt>
                <c:pt idx="1731">
                  <c:v>33330.703247070313</c:v>
                </c:pt>
                <c:pt idx="1732">
                  <c:v>33233.819702148438</c:v>
                </c:pt>
                <c:pt idx="1733">
                  <c:v>33157.050415039063</c:v>
                </c:pt>
                <c:pt idx="1734">
                  <c:v>33102.02392578125</c:v>
                </c:pt>
                <c:pt idx="1735">
                  <c:v>33050.940307617188</c:v>
                </c:pt>
                <c:pt idx="1736">
                  <c:v>33003.685302734375</c:v>
                </c:pt>
                <c:pt idx="1737">
                  <c:v>32976.944580078125</c:v>
                </c:pt>
                <c:pt idx="1738">
                  <c:v>32970.40380859375</c:v>
                </c:pt>
                <c:pt idx="1739">
                  <c:v>32967.77734375</c:v>
                </c:pt>
                <c:pt idx="1740">
                  <c:v>32966.465209960938</c:v>
                </c:pt>
                <c:pt idx="1741">
                  <c:v>32963.981567382813</c:v>
                </c:pt>
                <c:pt idx="1742">
                  <c:v>32938.78369140625</c:v>
                </c:pt>
                <c:pt idx="1743">
                  <c:v>32892.185852050781</c:v>
                </c:pt>
                <c:pt idx="1744">
                  <c:v>32847.959350585938</c:v>
                </c:pt>
                <c:pt idx="1745">
                  <c:v>32830.247192382813</c:v>
                </c:pt>
                <c:pt idx="1746">
                  <c:v>32830.477905273438</c:v>
                </c:pt>
                <c:pt idx="1747">
                  <c:v>32832.280029296875</c:v>
                </c:pt>
                <c:pt idx="1748">
                  <c:v>32838.56787109375</c:v>
                </c:pt>
                <c:pt idx="1749">
                  <c:v>32861.084228515625</c:v>
                </c:pt>
                <c:pt idx="1750">
                  <c:v>32901.543518066406</c:v>
                </c:pt>
                <c:pt idx="1751">
                  <c:v>32965.717041015625</c:v>
                </c:pt>
                <c:pt idx="1752">
                  <c:v>33074.719116210938</c:v>
                </c:pt>
                <c:pt idx="1753">
                  <c:v>33245.778442382813</c:v>
                </c:pt>
                <c:pt idx="1754">
                  <c:v>33470.209106445313</c:v>
                </c:pt>
                <c:pt idx="1755">
                  <c:v>33751.439819335938</c:v>
                </c:pt>
                <c:pt idx="1756">
                  <c:v>34091.470458984375</c:v>
                </c:pt>
                <c:pt idx="1757">
                  <c:v>34474.129638671875</c:v>
                </c:pt>
                <c:pt idx="1758">
                  <c:v>34854.61767578125</c:v>
                </c:pt>
                <c:pt idx="1759">
                  <c:v>35183.305419921875</c:v>
                </c:pt>
                <c:pt idx="1760">
                  <c:v>35412.021728515625</c:v>
                </c:pt>
                <c:pt idx="1761">
                  <c:v>35499.8525390625</c:v>
                </c:pt>
                <c:pt idx="1762">
                  <c:v>35435.483154296875</c:v>
                </c:pt>
                <c:pt idx="1763">
                  <c:v>35235.399658203125</c:v>
                </c:pt>
                <c:pt idx="1764">
                  <c:v>34936.344482421875</c:v>
                </c:pt>
                <c:pt idx="1765">
                  <c:v>34590.8037109375</c:v>
                </c:pt>
                <c:pt idx="1766">
                  <c:v>34242.348876953125</c:v>
                </c:pt>
                <c:pt idx="1767">
                  <c:v>33915.350952148438</c:v>
                </c:pt>
                <c:pt idx="1768">
                  <c:v>33627.181640625</c:v>
                </c:pt>
                <c:pt idx="1769">
                  <c:v>33399.8408203125</c:v>
                </c:pt>
                <c:pt idx="1770">
                  <c:v>33242.271606445313</c:v>
                </c:pt>
                <c:pt idx="1771">
                  <c:v>33135.645141601563</c:v>
                </c:pt>
                <c:pt idx="1772">
                  <c:v>33056.532958984375</c:v>
                </c:pt>
                <c:pt idx="1773">
                  <c:v>32997.020751953125</c:v>
                </c:pt>
                <c:pt idx="1774">
                  <c:v>32963.080017089844</c:v>
                </c:pt>
                <c:pt idx="1775">
                  <c:v>32953.424987792969</c:v>
                </c:pt>
                <c:pt idx="1776">
                  <c:v>32954.627136230469</c:v>
                </c:pt>
                <c:pt idx="1777">
                  <c:v>32953.886352539063</c:v>
                </c:pt>
                <c:pt idx="1778">
                  <c:v>32948.51708984375</c:v>
                </c:pt>
                <c:pt idx="1779">
                  <c:v>32948.06201171875</c:v>
                </c:pt>
                <c:pt idx="1780">
                  <c:v>32954.064147949219</c:v>
                </c:pt>
                <c:pt idx="1781">
                  <c:v>32957.466247558594</c:v>
                </c:pt>
                <c:pt idx="1782">
                  <c:v>32958.754089355469</c:v>
                </c:pt>
                <c:pt idx="1783">
                  <c:v>32966.870483398438</c:v>
                </c:pt>
                <c:pt idx="1784">
                  <c:v>32982.701171875</c:v>
                </c:pt>
                <c:pt idx="1785">
                  <c:v>32991.731872558594</c:v>
                </c:pt>
                <c:pt idx="1786">
                  <c:v>32986.676879882813</c:v>
                </c:pt>
                <c:pt idx="1787">
                  <c:v>32979.47900390625</c:v>
                </c:pt>
                <c:pt idx="1788">
                  <c:v>32981.02392578125</c:v>
                </c:pt>
                <c:pt idx="1789">
                  <c:v>32987.626037597656</c:v>
                </c:pt>
                <c:pt idx="1790">
                  <c:v>32985.085327148438</c:v>
                </c:pt>
                <c:pt idx="1791">
                  <c:v>32980.144592285156</c:v>
                </c:pt>
                <c:pt idx="1792">
                  <c:v>32979.718139648438</c:v>
                </c:pt>
                <c:pt idx="1793">
                  <c:v>32983.205932617188</c:v>
                </c:pt>
                <c:pt idx="1794">
                  <c:v>32984.493774414063</c:v>
                </c:pt>
                <c:pt idx="1795">
                  <c:v>32990.524475097656</c:v>
                </c:pt>
                <c:pt idx="1796">
                  <c:v>33008.926574707031</c:v>
                </c:pt>
                <c:pt idx="1797">
                  <c:v>33039.243041992188</c:v>
                </c:pt>
                <c:pt idx="1798">
                  <c:v>33077.2451171875</c:v>
                </c:pt>
                <c:pt idx="1799">
                  <c:v>33124.704345703125</c:v>
                </c:pt>
                <c:pt idx="1800">
                  <c:v>33185.077880859375</c:v>
                </c:pt>
                <c:pt idx="1801">
                  <c:v>33264.565795898438</c:v>
                </c:pt>
                <c:pt idx="1802">
                  <c:v>33365.539306640625</c:v>
                </c:pt>
                <c:pt idx="1803">
                  <c:v>33485.541381835938</c:v>
                </c:pt>
                <c:pt idx="1804">
                  <c:v>33612.886352539063</c:v>
                </c:pt>
                <c:pt idx="1805">
                  <c:v>33729.374267578125</c:v>
                </c:pt>
                <c:pt idx="1806">
                  <c:v>33827.176391601563</c:v>
                </c:pt>
                <c:pt idx="1807">
                  <c:v>33909.0927734375</c:v>
                </c:pt>
                <c:pt idx="1808">
                  <c:v>33975.80908203125</c:v>
                </c:pt>
                <c:pt idx="1809">
                  <c:v>34008.439819335938</c:v>
                </c:pt>
                <c:pt idx="1810">
                  <c:v>33987.356201171875</c:v>
                </c:pt>
                <c:pt idx="1811">
                  <c:v>33907.558349609375</c:v>
                </c:pt>
                <c:pt idx="1812">
                  <c:v>33778.7890625</c:v>
                </c:pt>
                <c:pt idx="1813">
                  <c:v>33622.734008789063</c:v>
                </c:pt>
                <c:pt idx="1814">
                  <c:v>33476.164672851563</c:v>
                </c:pt>
                <c:pt idx="1815">
                  <c:v>33356.0810546875</c:v>
                </c:pt>
                <c:pt idx="1816">
                  <c:v>33259.854614257813</c:v>
                </c:pt>
                <c:pt idx="1817">
                  <c:v>33177.856811523438</c:v>
                </c:pt>
                <c:pt idx="1818">
                  <c:v>33115.601684570313</c:v>
                </c:pt>
                <c:pt idx="1819">
                  <c:v>33072.375244140625</c:v>
                </c:pt>
                <c:pt idx="1820">
                  <c:v>33043.177368164063</c:v>
                </c:pt>
                <c:pt idx="1821">
                  <c:v>33021.008117675781</c:v>
                </c:pt>
                <c:pt idx="1822">
                  <c:v>33002.438781738281</c:v>
                </c:pt>
                <c:pt idx="1823">
                  <c:v>32996.869445800781</c:v>
                </c:pt>
                <c:pt idx="1824">
                  <c:v>33007.357299804688</c:v>
                </c:pt>
                <c:pt idx="1825">
                  <c:v>33025.045166015625</c:v>
                </c:pt>
                <c:pt idx="1826">
                  <c:v>33032.590087890625</c:v>
                </c:pt>
                <c:pt idx="1827">
                  <c:v>33025.192260742188</c:v>
                </c:pt>
                <c:pt idx="1828">
                  <c:v>33016.508605957031</c:v>
                </c:pt>
                <c:pt idx="1829">
                  <c:v>33015.939331054688</c:v>
                </c:pt>
                <c:pt idx="1830">
                  <c:v>33018.798583984375</c:v>
                </c:pt>
                <c:pt idx="1831">
                  <c:v>33016.686401367188</c:v>
                </c:pt>
                <c:pt idx="1832">
                  <c:v>33013.431396484375</c:v>
                </c:pt>
                <c:pt idx="1833">
                  <c:v>33004.519226074219</c:v>
                </c:pt>
                <c:pt idx="1834">
                  <c:v>32987.435607910156</c:v>
                </c:pt>
                <c:pt idx="1835">
                  <c:v>32973.009155273438</c:v>
                </c:pt>
                <c:pt idx="1836">
                  <c:v>32963.811279296875</c:v>
                </c:pt>
                <c:pt idx="1837">
                  <c:v>32963.299133300781</c:v>
                </c:pt>
                <c:pt idx="1838">
                  <c:v>32972.786926269531</c:v>
                </c:pt>
                <c:pt idx="1839">
                  <c:v>32985.589050292969</c:v>
                </c:pt>
                <c:pt idx="1840">
                  <c:v>32990.019714355469</c:v>
                </c:pt>
                <c:pt idx="1841">
                  <c:v>32987.421875</c:v>
                </c:pt>
                <c:pt idx="1842">
                  <c:v>32985.966857910156</c:v>
                </c:pt>
                <c:pt idx="1843">
                  <c:v>32986.311828613281</c:v>
                </c:pt>
                <c:pt idx="1844">
                  <c:v>32993.4853515625</c:v>
                </c:pt>
                <c:pt idx="1845">
                  <c:v>33003.687438964844</c:v>
                </c:pt>
                <c:pt idx="1846">
                  <c:v>33013.918151855469</c:v>
                </c:pt>
                <c:pt idx="1847">
                  <c:v>33022.634582519531</c:v>
                </c:pt>
                <c:pt idx="1848">
                  <c:v>33032.008056640625</c:v>
                </c:pt>
                <c:pt idx="1849">
                  <c:v>33038.981689453125</c:v>
                </c:pt>
                <c:pt idx="1850">
                  <c:v>33040.155151367188</c:v>
                </c:pt>
                <c:pt idx="1851">
                  <c:v>33030.900146484375</c:v>
                </c:pt>
                <c:pt idx="1852">
                  <c:v>33011.816589355469</c:v>
                </c:pt>
                <c:pt idx="1853">
                  <c:v>32992.904418945313</c:v>
                </c:pt>
                <c:pt idx="1854">
                  <c:v>32981.763671875</c:v>
                </c:pt>
                <c:pt idx="1855">
                  <c:v>32973.880065917969</c:v>
                </c:pt>
                <c:pt idx="1856">
                  <c:v>32963.45361328125</c:v>
                </c:pt>
                <c:pt idx="1857">
                  <c:v>32957.655700683594</c:v>
                </c:pt>
                <c:pt idx="1858">
                  <c:v>32962.457824707031</c:v>
                </c:pt>
                <c:pt idx="1859">
                  <c:v>32966.888549804688</c:v>
                </c:pt>
                <c:pt idx="1860">
                  <c:v>32961.376342773438</c:v>
                </c:pt>
                <c:pt idx="1861">
                  <c:v>32950.921325683594</c:v>
                </c:pt>
                <c:pt idx="1862">
                  <c:v>32942.952026367188</c:v>
                </c:pt>
                <c:pt idx="1863">
                  <c:v>32935.125549316406</c:v>
                </c:pt>
                <c:pt idx="1864">
                  <c:v>32924.499145507813</c:v>
                </c:pt>
                <c:pt idx="1865">
                  <c:v>32909.015502929688</c:v>
                </c:pt>
                <c:pt idx="1866">
                  <c:v>32889.560485839844</c:v>
                </c:pt>
                <c:pt idx="1867">
                  <c:v>32878.448303222656</c:v>
                </c:pt>
                <c:pt idx="1868">
                  <c:v>32874.36474609375</c:v>
                </c:pt>
                <c:pt idx="1869">
                  <c:v>32869.79541015625</c:v>
                </c:pt>
                <c:pt idx="1870">
                  <c:v>32858.854675292969</c:v>
                </c:pt>
                <c:pt idx="1871">
                  <c:v>32843.42822265625</c:v>
                </c:pt>
                <c:pt idx="1872">
                  <c:v>32822.887451171875</c:v>
                </c:pt>
                <c:pt idx="1873">
                  <c:v>32806.632446289063</c:v>
                </c:pt>
                <c:pt idx="1874">
                  <c:v>32801.3203125</c:v>
                </c:pt>
                <c:pt idx="1875">
                  <c:v>32804.065246582031</c:v>
                </c:pt>
                <c:pt idx="1876">
                  <c:v>32808.495971679688</c:v>
                </c:pt>
                <c:pt idx="1877">
                  <c:v>32810.44091796875</c:v>
                </c:pt>
                <c:pt idx="1878">
                  <c:v>32807.814453125</c:v>
                </c:pt>
                <c:pt idx="1879">
                  <c:v>32802.788024902344</c:v>
                </c:pt>
                <c:pt idx="1880">
                  <c:v>32790.904418945313</c:v>
                </c:pt>
                <c:pt idx="1881">
                  <c:v>32773.6494140625</c:v>
                </c:pt>
                <c:pt idx="1882">
                  <c:v>32769.451477050781</c:v>
                </c:pt>
                <c:pt idx="1883">
                  <c:v>32777.367919921875</c:v>
                </c:pt>
                <c:pt idx="1884">
                  <c:v>32775.741455078125</c:v>
                </c:pt>
                <c:pt idx="1885">
                  <c:v>32757.715026855469</c:v>
                </c:pt>
                <c:pt idx="1886">
                  <c:v>32745.202819824219</c:v>
                </c:pt>
                <c:pt idx="1887">
                  <c:v>32746.71923828125</c:v>
                </c:pt>
                <c:pt idx="1888">
                  <c:v>32753.407043457031</c:v>
                </c:pt>
                <c:pt idx="1889">
                  <c:v>32759.952026367188</c:v>
                </c:pt>
                <c:pt idx="1890">
                  <c:v>32762.897033691406</c:v>
                </c:pt>
                <c:pt idx="1891">
                  <c:v>32754.870544433594</c:v>
                </c:pt>
                <c:pt idx="1892">
                  <c:v>32741.272705078125</c:v>
                </c:pt>
                <c:pt idx="1893">
                  <c:v>32730.474792480469</c:v>
                </c:pt>
                <c:pt idx="1894">
                  <c:v>32727.962646484375</c:v>
                </c:pt>
                <c:pt idx="1895">
                  <c:v>32732.821899414063</c:v>
                </c:pt>
                <c:pt idx="1896">
                  <c:v>32742.652587890625</c:v>
                </c:pt>
                <c:pt idx="1897">
                  <c:v>32749.368957519531</c:v>
                </c:pt>
                <c:pt idx="1898">
                  <c:v>32752.342529296875</c:v>
                </c:pt>
                <c:pt idx="1899">
                  <c:v>32751.401794433594</c:v>
                </c:pt>
                <c:pt idx="1900">
                  <c:v>32744.632446289063</c:v>
                </c:pt>
                <c:pt idx="1901">
                  <c:v>32740.148864746094</c:v>
                </c:pt>
                <c:pt idx="1902">
                  <c:v>32742.665283203125</c:v>
                </c:pt>
                <c:pt idx="1903">
                  <c:v>32746.753112792969</c:v>
                </c:pt>
                <c:pt idx="1904">
                  <c:v>32742.612365722656</c:v>
                </c:pt>
                <c:pt idx="1905">
                  <c:v>32734.985900878906</c:v>
                </c:pt>
                <c:pt idx="1906">
                  <c:v>32737.0166015625</c:v>
                </c:pt>
                <c:pt idx="1907">
                  <c:v>32754.132995605469</c:v>
                </c:pt>
                <c:pt idx="1908">
                  <c:v>32773.020812988281</c:v>
                </c:pt>
                <c:pt idx="1909">
                  <c:v>32785.680114746094</c:v>
                </c:pt>
                <c:pt idx="1910">
                  <c:v>32793.225036621094</c:v>
                </c:pt>
                <c:pt idx="1911">
                  <c:v>32792.398620605469</c:v>
                </c:pt>
                <c:pt idx="1912">
                  <c:v>32779.886413574219</c:v>
                </c:pt>
                <c:pt idx="1913">
                  <c:v>32764.345703125</c:v>
                </c:pt>
                <c:pt idx="1914">
                  <c:v>32756.490661621094</c:v>
                </c:pt>
                <c:pt idx="1915">
                  <c:v>32758.435668945313</c:v>
                </c:pt>
                <c:pt idx="1916">
                  <c:v>32771.494934082031</c:v>
                </c:pt>
                <c:pt idx="1917">
                  <c:v>32788.439880371094</c:v>
                </c:pt>
                <c:pt idx="1918">
                  <c:v>32801.784851074219</c:v>
                </c:pt>
                <c:pt idx="1919">
                  <c:v>32804.615539550781</c:v>
                </c:pt>
                <c:pt idx="1920">
                  <c:v>32802.846252441406</c:v>
                </c:pt>
                <c:pt idx="1921">
                  <c:v>32805.534057617188</c:v>
                </c:pt>
                <c:pt idx="1922">
                  <c:v>32804.850463867188</c:v>
                </c:pt>
                <c:pt idx="1923">
                  <c:v>32798.909729003906</c:v>
                </c:pt>
                <c:pt idx="1924">
                  <c:v>32795.340393066406</c:v>
                </c:pt>
                <c:pt idx="1925">
                  <c:v>32804.171081542969</c:v>
                </c:pt>
                <c:pt idx="1926">
                  <c:v>32813.458923339844</c:v>
                </c:pt>
                <c:pt idx="1927">
                  <c:v>32817.575317382813</c:v>
                </c:pt>
                <c:pt idx="1928">
                  <c:v>32825.863159179688</c:v>
                </c:pt>
                <c:pt idx="1929">
                  <c:v>32840.950988769531</c:v>
                </c:pt>
                <c:pt idx="1930">
                  <c:v>32854.153137207031</c:v>
                </c:pt>
                <c:pt idx="1931">
                  <c:v>32862.755249023438</c:v>
                </c:pt>
                <c:pt idx="1932">
                  <c:v>32876.128784179688</c:v>
                </c:pt>
                <c:pt idx="1933">
                  <c:v>32889.216613769531</c:v>
                </c:pt>
                <c:pt idx="1934">
                  <c:v>32893.790161132813</c:v>
                </c:pt>
                <c:pt idx="1935">
                  <c:v>32898.53515625</c:v>
                </c:pt>
                <c:pt idx="1936">
                  <c:v>32911.02294921875</c:v>
                </c:pt>
                <c:pt idx="1937">
                  <c:v>32923.425048828125</c:v>
                </c:pt>
                <c:pt idx="1938">
                  <c:v>32930.512939453125</c:v>
                </c:pt>
                <c:pt idx="1939">
                  <c:v>32936.372192382813</c:v>
                </c:pt>
                <c:pt idx="1940">
                  <c:v>32947.345703125</c:v>
                </c:pt>
                <c:pt idx="1941">
                  <c:v>32963.919250488281</c:v>
                </c:pt>
                <c:pt idx="1942">
                  <c:v>32982.721374511719</c:v>
                </c:pt>
                <c:pt idx="1943">
                  <c:v>32993.266357421875</c:v>
                </c:pt>
                <c:pt idx="1944">
                  <c:v>33000.66845703125</c:v>
                </c:pt>
                <c:pt idx="1945">
                  <c:v>33014.842041015625</c:v>
                </c:pt>
                <c:pt idx="1946">
                  <c:v>33034.786987304688</c:v>
                </c:pt>
                <c:pt idx="1947">
                  <c:v>33055.074829101563</c:v>
                </c:pt>
                <c:pt idx="1948">
                  <c:v>33074.81982421875</c:v>
                </c:pt>
                <c:pt idx="1949">
                  <c:v>33094.450439453125</c:v>
                </c:pt>
                <c:pt idx="1950">
                  <c:v>33109.109741210938</c:v>
                </c:pt>
                <c:pt idx="1951">
                  <c:v>33117.740478515625</c:v>
                </c:pt>
                <c:pt idx="1952">
                  <c:v>33125.599731445313</c:v>
                </c:pt>
                <c:pt idx="1953">
                  <c:v>33139.916137695313</c:v>
                </c:pt>
                <c:pt idx="1954">
                  <c:v>33150.575317382813</c:v>
                </c:pt>
                <c:pt idx="1955">
                  <c:v>33150.606079101563</c:v>
                </c:pt>
                <c:pt idx="1956">
                  <c:v>33152.293823242188</c:v>
                </c:pt>
                <c:pt idx="1957">
                  <c:v>33167.381713867188</c:v>
                </c:pt>
                <c:pt idx="1958">
                  <c:v>33179.240966796875</c:v>
                </c:pt>
                <c:pt idx="1959">
                  <c:v>33176.243041992188</c:v>
                </c:pt>
                <c:pt idx="1960">
                  <c:v>33166.359497070313</c:v>
                </c:pt>
                <c:pt idx="1961">
                  <c:v>33161.075927734375</c:v>
                </c:pt>
                <c:pt idx="1962">
                  <c:v>33162.106567382813</c:v>
                </c:pt>
                <c:pt idx="1963">
                  <c:v>33161.880126953125</c:v>
                </c:pt>
                <c:pt idx="1964">
                  <c:v>33154.996459960938</c:v>
                </c:pt>
                <c:pt idx="1965">
                  <c:v>33142.941528320313</c:v>
                </c:pt>
                <c:pt idx="1966">
                  <c:v>33135.80078125</c:v>
                </c:pt>
                <c:pt idx="1967">
                  <c:v>33135.2314453125</c:v>
                </c:pt>
                <c:pt idx="1968">
                  <c:v>33141.662109375</c:v>
                </c:pt>
                <c:pt idx="1969">
                  <c:v>33151.178588867188</c:v>
                </c:pt>
                <c:pt idx="1970">
                  <c:v>33157.494995117188</c:v>
                </c:pt>
                <c:pt idx="1971">
                  <c:v>33156.411376953125</c:v>
                </c:pt>
                <c:pt idx="1972">
                  <c:v>33149.842041015625</c:v>
                </c:pt>
                <c:pt idx="1973">
                  <c:v>33143.41552734375</c:v>
                </c:pt>
                <c:pt idx="1974">
                  <c:v>33137.189086914063</c:v>
                </c:pt>
                <c:pt idx="1975">
                  <c:v>33137.362670898438</c:v>
                </c:pt>
                <c:pt idx="1976">
                  <c:v>33141.107666015625</c:v>
                </c:pt>
                <c:pt idx="1977">
                  <c:v>33143.938354492188</c:v>
                </c:pt>
                <c:pt idx="1978">
                  <c:v>33150.854736328125</c:v>
                </c:pt>
                <c:pt idx="1979">
                  <c:v>33164.342529296875</c:v>
                </c:pt>
                <c:pt idx="1980">
                  <c:v>33177.230346679688</c:v>
                </c:pt>
                <c:pt idx="1981">
                  <c:v>33180.432495117188</c:v>
                </c:pt>
                <c:pt idx="1982">
                  <c:v>33180.177490234375</c:v>
                </c:pt>
                <c:pt idx="1983">
                  <c:v>33178.7509765625</c:v>
                </c:pt>
                <c:pt idx="1984">
                  <c:v>33177.381713867188</c:v>
                </c:pt>
                <c:pt idx="1985">
                  <c:v>33172.812377929688</c:v>
                </c:pt>
                <c:pt idx="1986">
                  <c:v>33161.75732421875</c:v>
                </c:pt>
                <c:pt idx="1987">
                  <c:v>33148.159545898438</c:v>
                </c:pt>
                <c:pt idx="1988">
                  <c:v>33140.475952148438</c:v>
                </c:pt>
                <c:pt idx="1989">
                  <c:v>33130.935180664063</c:v>
                </c:pt>
                <c:pt idx="1990">
                  <c:v>33114.308715820313</c:v>
                </c:pt>
                <c:pt idx="1991">
                  <c:v>33105.99658203125</c:v>
                </c:pt>
                <c:pt idx="1992">
                  <c:v>33115.684326171875</c:v>
                </c:pt>
                <c:pt idx="1993">
                  <c:v>33125.9150390625</c:v>
                </c:pt>
                <c:pt idx="1994">
                  <c:v>33116.602905273438</c:v>
                </c:pt>
                <c:pt idx="1995">
                  <c:v>33096.71923828125</c:v>
                </c:pt>
                <c:pt idx="1996">
                  <c:v>33079.892822265625</c:v>
                </c:pt>
                <c:pt idx="1997">
                  <c:v>33068.9521484375</c:v>
                </c:pt>
                <c:pt idx="1998">
                  <c:v>33066.011352539063</c:v>
                </c:pt>
                <c:pt idx="1999">
                  <c:v>33067.75634765625</c:v>
                </c:pt>
                <c:pt idx="2000">
                  <c:v>33066.758422851563</c:v>
                </c:pt>
                <c:pt idx="2001">
                  <c:v>33053.73193359375</c:v>
                </c:pt>
                <c:pt idx="2002">
                  <c:v>33038.219848632813</c:v>
                </c:pt>
                <c:pt idx="2003">
                  <c:v>33026.450561523438</c:v>
                </c:pt>
                <c:pt idx="2004">
                  <c:v>33015.109741210938</c:v>
                </c:pt>
                <c:pt idx="2005">
                  <c:v>33004.169006347656</c:v>
                </c:pt>
                <c:pt idx="2006">
                  <c:v>33002.428283691406</c:v>
                </c:pt>
                <c:pt idx="2007">
                  <c:v>33005.601806640625</c:v>
                </c:pt>
                <c:pt idx="2008">
                  <c:v>33000.489685058594</c:v>
                </c:pt>
                <c:pt idx="2009">
                  <c:v>32980.406066894531</c:v>
                </c:pt>
                <c:pt idx="2010">
                  <c:v>32959.379638671875</c:v>
                </c:pt>
                <c:pt idx="2011">
                  <c:v>32941.610290527344</c:v>
                </c:pt>
                <c:pt idx="2012">
                  <c:v>32927.21240234375</c:v>
                </c:pt>
                <c:pt idx="2013">
                  <c:v>32909.900268554688</c:v>
                </c:pt>
                <c:pt idx="2014">
                  <c:v>32891.559509277344</c:v>
                </c:pt>
                <c:pt idx="2015">
                  <c:v>32875.333068847656</c:v>
                </c:pt>
                <c:pt idx="2016">
                  <c:v>32863.335144042969</c:v>
                </c:pt>
                <c:pt idx="2017">
                  <c:v>32854.223022460938</c:v>
                </c:pt>
                <c:pt idx="2018">
                  <c:v>32847.025146484375</c:v>
                </c:pt>
                <c:pt idx="2019">
                  <c:v>32841.855834960938</c:v>
                </c:pt>
                <c:pt idx="2020">
                  <c:v>32833.200805664063</c:v>
                </c:pt>
                <c:pt idx="2021">
                  <c:v>32817.031494140625</c:v>
                </c:pt>
                <c:pt idx="2022">
                  <c:v>32797.605041503906</c:v>
                </c:pt>
                <c:pt idx="2023">
                  <c:v>32786.064270019531</c:v>
                </c:pt>
                <c:pt idx="2024">
                  <c:v>32781.152099609375</c:v>
                </c:pt>
                <c:pt idx="2025">
                  <c:v>32780.897094726563</c:v>
                </c:pt>
                <c:pt idx="2026">
                  <c:v>32782.556335449219</c:v>
                </c:pt>
                <c:pt idx="2027">
                  <c:v>32779.644165039063</c:v>
                </c:pt>
                <c:pt idx="2028">
                  <c:v>32765.046264648438</c:v>
                </c:pt>
                <c:pt idx="2029">
                  <c:v>32744.248413085938</c:v>
                </c:pt>
                <c:pt idx="2030">
                  <c:v>32727.793395996094</c:v>
                </c:pt>
                <c:pt idx="2031">
                  <c:v>32721.709777832031</c:v>
                </c:pt>
                <c:pt idx="2032">
                  <c:v>32716.88330078125</c:v>
                </c:pt>
                <c:pt idx="2033">
                  <c:v>32706.542602539063</c:v>
                </c:pt>
                <c:pt idx="2034">
                  <c:v>32702.116149902344</c:v>
                </c:pt>
                <c:pt idx="2035">
                  <c:v>32718.746826171875</c:v>
                </c:pt>
                <c:pt idx="2036">
                  <c:v>32742.14892578125</c:v>
                </c:pt>
                <c:pt idx="2037">
                  <c:v>32753.779602050781</c:v>
                </c:pt>
                <c:pt idx="2038">
                  <c:v>32756.696044921875</c:v>
                </c:pt>
                <c:pt idx="2039">
                  <c:v>32759.241027832031</c:v>
                </c:pt>
                <c:pt idx="2040">
                  <c:v>32762.4716796875</c:v>
                </c:pt>
                <c:pt idx="2041">
                  <c:v>32762.902404785156</c:v>
                </c:pt>
                <c:pt idx="2042">
                  <c:v>32758.961608886719</c:v>
                </c:pt>
                <c:pt idx="2043">
                  <c:v>32746.763732910156</c:v>
                </c:pt>
                <c:pt idx="2044">
                  <c:v>32727.537292480469</c:v>
                </c:pt>
                <c:pt idx="2045">
                  <c:v>32700.510864257813</c:v>
                </c:pt>
                <c:pt idx="2046">
                  <c:v>32672.227233886719</c:v>
                </c:pt>
                <c:pt idx="2047">
                  <c:v>32652.229370117188</c:v>
                </c:pt>
                <c:pt idx="2048">
                  <c:v>32649.488647460938</c:v>
                </c:pt>
                <c:pt idx="2049">
                  <c:v>32664.405029296875</c:v>
                </c:pt>
                <c:pt idx="2050">
                  <c:v>32689.721435546875</c:v>
                </c:pt>
                <c:pt idx="2051">
                  <c:v>32712.00927734375</c:v>
                </c:pt>
                <c:pt idx="2052">
                  <c:v>32727.782775878906</c:v>
                </c:pt>
                <c:pt idx="2053">
                  <c:v>32739.64208984375</c:v>
                </c:pt>
                <c:pt idx="2054">
                  <c:v>32750.729919433594</c:v>
                </c:pt>
                <c:pt idx="2055">
                  <c:v>32762.874877929688</c:v>
                </c:pt>
                <c:pt idx="2056">
                  <c:v>32780.962707519531</c:v>
                </c:pt>
                <c:pt idx="2057">
                  <c:v>32794.421936035156</c:v>
                </c:pt>
                <c:pt idx="2058">
                  <c:v>32791.28125</c:v>
                </c:pt>
                <c:pt idx="2059">
                  <c:v>32770.940490722656</c:v>
                </c:pt>
                <c:pt idx="2060">
                  <c:v>32741.485473632813</c:v>
                </c:pt>
                <c:pt idx="2061">
                  <c:v>32711.487548828125</c:v>
                </c:pt>
                <c:pt idx="2062">
                  <c:v>32693.089660644531</c:v>
                </c:pt>
                <c:pt idx="2063">
                  <c:v>32685.320373535156</c:v>
                </c:pt>
                <c:pt idx="2064">
                  <c:v>32673.151062011719</c:v>
                </c:pt>
                <c:pt idx="2065">
                  <c:v>32654.8388671875</c:v>
                </c:pt>
                <c:pt idx="2066">
                  <c:v>32644.326721191406</c:v>
                </c:pt>
                <c:pt idx="2067">
                  <c:v>32650.157409667969</c:v>
                </c:pt>
                <c:pt idx="2068">
                  <c:v>32663.61669921875</c:v>
                </c:pt>
                <c:pt idx="2069">
                  <c:v>32672.875915527344</c:v>
                </c:pt>
                <c:pt idx="2070">
                  <c:v>32672.392333984375</c:v>
                </c:pt>
                <c:pt idx="2071">
                  <c:v>32669.137329101563</c:v>
                </c:pt>
                <c:pt idx="2072">
                  <c:v>32661.310852050781</c:v>
                </c:pt>
                <c:pt idx="2073">
                  <c:v>32650.884399414063</c:v>
                </c:pt>
                <c:pt idx="2074">
                  <c:v>32644.543640136719</c:v>
                </c:pt>
                <c:pt idx="2075">
                  <c:v>32646.260070800781</c:v>
                </c:pt>
                <c:pt idx="2076">
                  <c:v>32653.462158203125</c:v>
                </c:pt>
                <c:pt idx="2077">
                  <c:v>32672.207153320313</c:v>
                </c:pt>
                <c:pt idx="2078">
                  <c:v>32710.409301757813</c:v>
                </c:pt>
                <c:pt idx="2079">
                  <c:v>32764.868530273438</c:v>
                </c:pt>
                <c:pt idx="2080">
                  <c:v>32846.013488769531</c:v>
                </c:pt>
                <c:pt idx="2081">
                  <c:v>32988.415649414063</c:v>
                </c:pt>
                <c:pt idx="2082">
                  <c:v>33230.38916015625</c:v>
                </c:pt>
                <c:pt idx="2083">
                  <c:v>33610.991333007813</c:v>
                </c:pt>
                <c:pt idx="2084">
                  <c:v>34172.764892578125</c:v>
                </c:pt>
                <c:pt idx="2085">
                  <c:v>34959.052734375</c:v>
                </c:pt>
                <c:pt idx="2086">
                  <c:v>35985.854736328125</c:v>
                </c:pt>
                <c:pt idx="2087">
                  <c:v>37239.31396484375</c:v>
                </c:pt>
                <c:pt idx="2088">
                  <c:v>38689.7734375</c:v>
                </c:pt>
                <c:pt idx="2089">
                  <c:v>40291.318359375</c:v>
                </c:pt>
                <c:pt idx="2090">
                  <c:v>41949.9775390625</c:v>
                </c:pt>
                <c:pt idx="2091">
                  <c:v>43522.0654296875</c:v>
                </c:pt>
                <c:pt idx="2092">
                  <c:v>44844.353515625</c:v>
                </c:pt>
                <c:pt idx="2093">
                  <c:v>45784.8125</c:v>
                </c:pt>
                <c:pt idx="2094">
                  <c:v>46240.3291015625</c:v>
                </c:pt>
                <c:pt idx="2095">
                  <c:v>46153.2451171875</c:v>
                </c:pt>
                <c:pt idx="2096">
                  <c:v>45522.8759765625</c:v>
                </c:pt>
                <c:pt idx="2097">
                  <c:v>44432.44921875</c:v>
                </c:pt>
                <c:pt idx="2098">
                  <c:v>43014.8232421875</c:v>
                </c:pt>
                <c:pt idx="2099">
                  <c:v>41405.9677734375</c:v>
                </c:pt>
                <c:pt idx="2100">
                  <c:v>39737.169921875</c:v>
                </c:pt>
                <c:pt idx="2101">
                  <c:v>38147.08642578125</c:v>
                </c:pt>
                <c:pt idx="2102">
                  <c:v>36746.26025390625</c:v>
                </c:pt>
                <c:pt idx="2103">
                  <c:v>35589.405029296875</c:v>
                </c:pt>
                <c:pt idx="2104">
                  <c:v>34676.1787109375</c:v>
                </c:pt>
                <c:pt idx="2105">
                  <c:v>33995.409301757813</c:v>
                </c:pt>
                <c:pt idx="2106">
                  <c:v>33517.668579101563</c:v>
                </c:pt>
                <c:pt idx="2107">
                  <c:v>33196.64208984375</c:v>
                </c:pt>
                <c:pt idx="2108">
                  <c:v>32977.187072753906</c:v>
                </c:pt>
                <c:pt idx="2109">
                  <c:v>32833.38916015625</c:v>
                </c:pt>
                <c:pt idx="2110">
                  <c:v>32756.791320800781</c:v>
                </c:pt>
                <c:pt idx="2111">
                  <c:v>32719.707702636719</c:v>
                </c:pt>
                <c:pt idx="2112">
                  <c:v>32693.681274414063</c:v>
                </c:pt>
                <c:pt idx="2113">
                  <c:v>32672.7119140625</c:v>
                </c:pt>
                <c:pt idx="2114">
                  <c:v>32665.456909179688</c:v>
                </c:pt>
                <c:pt idx="2115">
                  <c:v>32662.030456542969</c:v>
                </c:pt>
                <c:pt idx="2116">
                  <c:v>32655.232543945313</c:v>
                </c:pt>
                <c:pt idx="2117">
                  <c:v>32643.234680175781</c:v>
                </c:pt>
                <c:pt idx="2118">
                  <c:v>32638.751098632813</c:v>
                </c:pt>
                <c:pt idx="2119">
                  <c:v>32631.067504882813</c:v>
                </c:pt>
                <c:pt idx="2120">
                  <c:v>32609.098205566406</c:v>
                </c:pt>
                <c:pt idx="2121">
                  <c:v>32576.728881835938</c:v>
                </c:pt>
                <c:pt idx="2122">
                  <c:v>32553.445251464844</c:v>
                </c:pt>
                <c:pt idx="2123">
                  <c:v>32541.733093261719</c:v>
                </c:pt>
                <c:pt idx="2124">
                  <c:v>32532.392333984375</c:v>
                </c:pt>
                <c:pt idx="2125">
                  <c:v>32520.623046875</c:v>
                </c:pt>
                <c:pt idx="2126">
                  <c:v>32503.996612548828</c:v>
                </c:pt>
                <c:pt idx="2127">
                  <c:v>32483.884429931641</c:v>
                </c:pt>
                <c:pt idx="2128">
                  <c:v>32468.715118408203</c:v>
                </c:pt>
                <c:pt idx="2129">
                  <c:v>32460.545806884766</c:v>
                </c:pt>
                <c:pt idx="2130">
                  <c:v>32462.3193359375</c:v>
                </c:pt>
                <c:pt idx="2131">
                  <c:v>32464.778625488281</c:v>
                </c:pt>
                <c:pt idx="2132">
                  <c:v>32461.923583984375</c:v>
                </c:pt>
                <c:pt idx="2133">
                  <c:v>32452.297119140625</c:v>
                </c:pt>
                <c:pt idx="2134">
                  <c:v>32443.52783203125</c:v>
                </c:pt>
                <c:pt idx="2135">
                  <c:v>32434.158508300781</c:v>
                </c:pt>
                <c:pt idx="2136">
                  <c:v>32422.874908447266</c:v>
                </c:pt>
                <c:pt idx="2137">
                  <c:v>32415.562744140625</c:v>
                </c:pt>
                <c:pt idx="2138">
                  <c:v>32417.022003173828</c:v>
                </c:pt>
                <c:pt idx="2139">
                  <c:v>32428.938415527344</c:v>
                </c:pt>
                <c:pt idx="2140">
                  <c:v>32443.59765625</c:v>
                </c:pt>
                <c:pt idx="2141">
                  <c:v>32448.171203613281</c:v>
                </c:pt>
                <c:pt idx="2142">
                  <c:v>32434.973327636719</c:v>
                </c:pt>
                <c:pt idx="2143">
                  <c:v>32415.861145019531</c:v>
                </c:pt>
                <c:pt idx="2144">
                  <c:v>32401.463287353516</c:v>
                </c:pt>
                <c:pt idx="2145">
                  <c:v>32394.579681396484</c:v>
                </c:pt>
                <c:pt idx="2146">
                  <c:v>32396.467498779297</c:v>
                </c:pt>
                <c:pt idx="2147">
                  <c:v>32400.155334472656</c:v>
                </c:pt>
                <c:pt idx="2148">
                  <c:v>32400.814605712891</c:v>
                </c:pt>
                <c:pt idx="2149">
                  <c:v>32395.845275878906</c:v>
                </c:pt>
                <c:pt idx="2150">
                  <c:v>32381.333129882813</c:v>
                </c:pt>
                <c:pt idx="2151">
                  <c:v>32355.135223388672</c:v>
                </c:pt>
                <c:pt idx="2152">
                  <c:v>32334.365936279297</c:v>
                </c:pt>
                <c:pt idx="2153">
                  <c:v>32326.368041992188</c:v>
                </c:pt>
                <c:pt idx="2154">
                  <c:v>32319.998718261719</c:v>
                </c:pt>
                <c:pt idx="2155">
                  <c:v>32315.143707275391</c:v>
                </c:pt>
                <c:pt idx="2156">
                  <c:v>32313.460113525391</c:v>
                </c:pt>
                <c:pt idx="2157">
                  <c:v>32305.662231445313</c:v>
                </c:pt>
                <c:pt idx="2158">
                  <c:v>32290.864349365234</c:v>
                </c:pt>
                <c:pt idx="2159">
                  <c:v>32284.837890625</c:v>
                </c:pt>
                <c:pt idx="2160">
                  <c:v>32285.468566894531</c:v>
                </c:pt>
                <c:pt idx="2161">
                  <c:v>32287.213531494141</c:v>
                </c:pt>
                <c:pt idx="2162">
                  <c:v>32289.044219970703</c:v>
                </c:pt>
                <c:pt idx="2163">
                  <c:v>32291.360626220703</c:v>
                </c:pt>
                <c:pt idx="2164">
                  <c:v>32295.162750244141</c:v>
                </c:pt>
                <c:pt idx="2165">
                  <c:v>32301.707733154297</c:v>
                </c:pt>
                <c:pt idx="2166">
                  <c:v>32302.1669921875</c:v>
                </c:pt>
                <c:pt idx="2167">
                  <c:v>32296.511962890625</c:v>
                </c:pt>
                <c:pt idx="2168">
                  <c:v>32298.7998046875</c:v>
                </c:pt>
                <c:pt idx="2169">
                  <c:v>32306.259063720703</c:v>
                </c:pt>
                <c:pt idx="2170">
                  <c:v>32304.089752197266</c:v>
                </c:pt>
                <c:pt idx="2171">
                  <c:v>32296.491851806641</c:v>
                </c:pt>
                <c:pt idx="2172">
                  <c:v>32297.465393066406</c:v>
                </c:pt>
                <c:pt idx="2173">
                  <c:v>32304.238952636719</c:v>
                </c:pt>
                <c:pt idx="2174">
                  <c:v>32307.955352783203</c:v>
                </c:pt>
                <c:pt idx="2175">
                  <c:v>32306.871765136719</c:v>
                </c:pt>
                <c:pt idx="2176">
                  <c:v>32306.645294189453</c:v>
                </c:pt>
                <c:pt idx="2177">
                  <c:v>32310.247406005859</c:v>
                </c:pt>
                <c:pt idx="2178">
                  <c:v>32310.220947265625</c:v>
                </c:pt>
                <c:pt idx="2179">
                  <c:v>32304.365936279297</c:v>
                </c:pt>
                <c:pt idx="2180">
                  <c:v>32295.739471435547</c:v>
                </c:pt>
                <c:pt idx="2181">
                  <c:v>32285.170166015625</c:v>
                </c:pt>
                <c:pt idx="2182">
                  <c:v>32270.429443359375</c:v>
                </c:pt>
                <c:pt idx="2183">
                  <c:v>32261.631530761719</c:v>
                </c:pt>
                <c:pt idx="2184">
                  <c:v>32265.490814208984</c:v>
                </c:pt>
                <c:pt idx="2185">
                  <c:v>32271.292907714844</c:v>
                </c:pt>
                <c:pt idx="2186">
                  <c:v>32269.78076171875</c:v>
                </c:pt>
                <c:pt idx="2187">
                  <c:v>32258.468597412109</c:v>
                </c:pt>
                <c:pt idx="2188">
                  <c:v>32242.870697021484</c:v>
                </c:pt>
                <c:pt idx="2189">
                  <c:v>32230.301391601563</c:v>
                </c:pt>
                <c:pt idx="2190">
                  <c:v>32225.674942016602</c:v>
                </c:pt>
                <c:pt idx="2191">
                  <c:v>32224.934188842773</c:v>
                </c:pt>
                <c:pt idx="2192">
                  <c:v>32227.250595092773</c:v>
                </c:pt>
                <c:pt idx="2193">
                  <c:v>32228.395568847656</c:v>
                </c:pt>
                <c:pt idx="2194">
                  <c:v>32223.540542602539</c:v>
                </c:pt>
                <c:pt idx="2195">
                  <c:v>32213.656951904297</c:v>
                </c:pt>
                <c:pt idx="2196">
                  <c:v>32206.287643432617</c:v>
                </c:pt>
                <c:pt idx="2197">
                  <c:v>32205.17546081543</c:v>
                </c:pt>
                <c:pt idx="2198">
                  <c:v>32206.777587890625</c:v>
                </c:pt>
                <c:pt idx="2199">
                  <c:v>32208.236846923828</c:v>
                </c:pt>
                <c:pt idx="2200">
                  <c:v>32206.724670410156</c:v>
                </c:pt>
                <c:pt idx="2201">
                  <c:v>32206.926788330078</c:v>
                </c:pt>
                <c:pt idx="2202">
                  <c:v>32212.871765136719</c:v>
                </c:pt>
                <c:pt idx="2203">
                  <c:v>32217.502456665039</c:v>
                </c:pt>
                <c:pt idx="2204">
                  <c:v>32212.990280151367</c:v>
                </c:pt>
                <c:pt idx="2205">
                  <c:v>32207.592407226563</c:v>
                </c:pt>
                <c:pt idx="2206">
                  <c:v>32213.165954589844</c:v>
                </c:pt>
                <c:pt idx="2207">
                  <c:v>32223.796630859375</c:v>
                </c:pt>
                <c:pt idx="2208">
                  <c:v>32234.427322387695</c:v>
                </c:pt>
                <c:pt idx="2209">
                  <c:v>32245.172302246094</c:v>
                </c:pt>
                <c:pt idx="2210">
                  <c:v>32251.602981567383</c:v>
                </c:pt>
                <c:pt idx="2211">
                  <c:v>32240.376525878906</c:v>
                </c:pt>
                <c:pt idx="2212">
                  <c:v>32218.835784912109</c:v>
                </c:pt>
                <c:pt idx="2213">
                  <c:v>32206.695053100586</c:v>
                </c:pt>
                <c:pt idx="2214">
                  <c:v>32215.554306030273</c:v>
                </c:pt>
                <c:pt idx="2215">
                  <c:v>32232.270721435547</c:v>
                </c:pt>
                <c:pt idx="2216">
                  <c:v>32237.758544921875</c:v>
                </c:pt>
                <c:pt idx="2217">
                  <c:v>32228.217803955078</c:v>
                </c:pt>
                <c:pt idx="2218">
                  <c:v>32218.962783813477</c:v>
                </c:pt>
                <c:pt idx="2219">
                  <c:v>32226.536331176758</c:v>
                </c:pt>
                <c:pt idx="2220">
                  <c:v>32246.195587158203</c:v>
                </c:pt>
                <c:pt idx="2221">
                  <c:v>32259.283416748047</c:v>
                </c:pt>
                <c:pt idx="2222">
                  <c:v>32259.342681884766</c:v>
                </c:pt>
                <c:pt idx="2223">
                  <c:v>32259.316223144531</c:v>
                </c:pt>
                <c:pt idx="2224">
                  <c:v>32267.518341064453</c:v>
                </c:pt>
                <c:pt idx="2225">
                  <c:v>32273.006164550781</c:v>
                </c:pt>
                <c:pt idx="2226">
                  <c:v>32270.836853027344</c:v>
                </c:pt>
                <c:pt idx="2227">
                  <c:v>32268.410400390625</c:v>
                </c:pt>
                <c:pt idx="2228">
                  <c:v>32261.241088867188</c:v>
                </c:pt>
                <c:pt idx="2229">
                  <c:v>32239.471786499023</c:v>
                </c:pt>
                <c:pt idx="2230">
                  <c:v>32211.759613037109</c:v>
                </c:pt>
                <c:pt idx="2231">
                  <c:v>32193.104583740234</c:v>
                </c:pt>
                <c:pt idx="2232">
                  <c:v>32182.878128051758</c:v>
                </c:pt>
                <c:pt idx="2233">
                  <c:v>32178.994537353516</c:v>
                </c:pt>
                <c:pt idx="2234">
                  <c:v>32180.110931396484</c:v>
                </c:pt>
                <c:pt idx="2235">
                  <c:v>32184.684478759766</c:v>
                </c:pt>
                <c:pt idx="2236">
                  <c:v>32185.858032226563</c:v>
                </c:pt>
                <c:pt idx="2237">
                  <c:v>32178.545852661133</c:v>
                </c:pt>
                <c:pt idx="2238">
                  <c:v>32162.490829467773</c:v>
                </c:pt>
                <c:pt idx="2239">
                  <c:v>32151.635803222656</c:v>
                </c:pt>
                <c:pt idx="2240">
                  <c:v>32153.923629760742</c:v>
                </c:pt>
                <c:pt idx="2241">
                  <c:v>32162.211471557617</c:v>
                </c:pt>
                <c:pt idx="2242">
                  <c:v>32165.585006713867</c:v>
                </c:pt>
                <c:pt idx="2243">
                  <c:v>32166.072845458984</c:v>
                </c:pt>
                <c:pt idx="2244">
                  <c:v>32161.246383666992</c:v>
                </c:pt>
                <c:pt idx="2245">
                  <c:v>32153.67707824707</c:v>
                </c:pt>
                <c:pt idx="2246">
                  <c:v>32148.450622558594</c:v>
                </c:pt>
                <c:pt idx="2247">
                  <c:v>32151.424163818359</c:v>
                </c:pt>
                <c:pt idx="2248">
                  <c:v>32157.05485534668</c:v>
                </c:pt>
                <c:pt idx="2249">
                  <c:v>32162.942687988281</c:v>
                </c:pt>
                <c:pt idx="2250">
                  <c:v>32168.116226196289</c:v>
                </c:pt>
                <c:pt idx="2251">
                  <c:v>32174.432632446289</c:v>
                </c:pt>
                <c:pt idx="2252">
                  <c:v>32178.720474243164</c:v>
                </c:pt>
                <c:pt idx="2253">
                  <c:v>32182.951156616211</c:v>
                </c:pt>
                <c:pt idx="2254">
                  <c:v>32191.181838989258</c:v>
                </c:pt>
                <c:pt idx="2255">
                  <c:v>32202.612533569336</c:v>
                </c:pt>
                <c:pt idx="2256">
                  <c:v>32200.414642333984</c:v>
                </c:pt>
                <c:pt idx="2257">
                  <c:v>32184.702484130859</c:v>
                </c:pt>
                <c:pt idx="2258">
                  <c:v>32172.533172607422</c:v>
                </c:pt>
                <c:pt idx="2259">
                  <c:v>32177.621002197266</c:v>
                </c:pt>
                <c:pt idx="2260">
                  <c:v>32191.737396240234</c:v>
                </c:pt>
                <c:pt idx="2261">
                  <c:v>32195.682373046875</c:v>
                </c:pt>
                <c:pt idx="2262">
                  <c:v>32181.255920410156</c:v>
                </c:pt>
                <c:pt idx="2263">
                  <c:v>32164.000900268555</c:v>
                </c:pt>
                <c:pt idx="2264">
                  <c:v>32164.574447631836</c:v>
                </c:pt>
                <c:pt idx="2265">
                  <c:v>32180.490844726563</c:v>
                </c:pt>
                <c:pt idx="2266">
                  <c:v>32193.492965698242</c:v>
                </c:pt>
                <c:pt idx="2267">
                  <c:v>32193.695083618164</c:v>
                </c:pt>
                <c:pt idx="2268">
                  <c:v>32190.182907104492</c:v>
                </c:pt>
                <c:pt idx="2269">
                  <c:v>32189.527877807617</c:v>
                </c:pt>
                <c:pt idx="2270">
                  <c:v>32188.872863769531</c:v>
                </c:pt>
                <c:pt idx="2271">
                  <c:v>32181.703552246094</c:v>
                </c:pt>
                <c:pt idx="2272">
                  <c:v>32171.648513793945</c:v>
                </c:pt>
                <c:pt idx="2273">
                  <c:v>32168.107772827148</c:v>
                </c:pt>
                <c:pt idx="2274">
                  <c:v>32175.652755737305</c:v>
                </c:pt>
                <c:pt idx="2275">
                  <c:v>32188.740585327148</c:v>
                </c:pt>
                <c:pt idx="2276">
                  <c:v>32193.342697143555</c:v>
                </c:pt>
                <c:pt idx="2277">
                  <c:v>32189.487670898438</c:v>
                </c:pt>
                <c:pt idx="2278">
                  <c:v>32179.118362426758</c:v>
                </c:pt>
                <c:pt idx="2279">
                  <c:v>32167.94905090332</c:v>
                </c:pt>
                <c:pt idx="2280">
                  <c:v>32155.836883544922</c:v>
                </c:pt>
                <c:pt idx="2281">
                  <c:v>32149.696136474609</c:v>
                </c:pt>
                <c:pt idx="2282">
                  <c:v>32152.64111328125</c:v>
                </c:pt>
                <c:pt idx="2283">
                  <c:v>32160.386093139648</c:v>
                </c:pt>
                <c:pt idx="2284">
                  <c:v>32168.902496337891</c:v>
                </c:pt>
                <c:pt idx="2285">
                  <c:v>32175.447463989258</c:v>
                </c:pt>
                <c:pt idx="2286">
                  <c:v>32178.506729125977</c:v>
                </c:pt>
                <c:pt idx="2287">
                  <c:v>32174.708847045898</c:v>
                </c:pt>
                <c:pt idx="2288">
                  <c:v>32170.482391357422</c:v>
                </c:pt>
                <c:pt idx="2289">
                  <c:v>32177.884506225586</c:v>
                </c:pt>
                <c:pt idx="2290">
                  <c:v>32189.800903320313</c:v>
                </c:pt>
                <c:pt idx="2291">
                  <c:v>32191.945877075195</c:v>
                </c:pt>
                <c:pt idx="2292">
                  <c:v>32184.890853881836</c:v>
                </c:pt>
                <c:pt idx="2293">
                  <c:v>32179.864395141602</c:v>
                </c:pt>
                <c:pt idx="2294">
                  <c:v>32180.92366027832</c:v>
                </c:pt>
                <c:pt idx="2295">
                  <c:v>32186.754348754883</c:v>
                </c:pt>
                <c:pt idx="2296">
                  <c:v>32202.385040283203</c:v>
                </c:pt>
                <c:pt idx="2297">
                  <c:v>32218.61572265625</c:v>
                </c:pt>
                <c:pt idx="2298">
                  <c:v>32222.217849731445</c:v>
                </c:pt>
                <c:pt idx="2299">
                  <c:v>32211.277099609375</c:v>
                </c:pt>
                <c:pt idx="2300">
                  <c:v>32203.336364746094</c:v>
                </c:pt>
                <c:pt idx="2301">
                  <c:v>32208.024200439453</c:v>
                </c:pt>
                <c:pt idx="2302">
                  <c:v>32215.626312255859</c:v>
                </c:pt>
                <c:pt idx="2303">
                  <c:v>32219.085571289063</c:v>
                </c:pt>
                <c:pt idx="2304">
                  <c:v>32220.116256713867</c:v>
                </c:pt>
                <c:pt idx="2305">
                  <c:v>32218.318374633789</c:v>
                </c:pt>
                <c:pt idx="2306">
                  <c:v>32213.149063110352</c:v>
                </c:pt>
                <c:pt idx="2307">
                  <c:v>32219.494033813477</c:v>
                </c:pt>
                <c:pt idx="2308">
                  <c:v>32238.324722290039</c:v>
                </c:pt>
                <c:pt idx="2309">
                  <c:v>32250.583984375</c:v>
                </c:pt>
                <c:pt idx="2310">
                  <c:v>32243.900390625</c:v>
                </c:pt>
                <c:pt idx="2311">
                  <c:v>32232.016784667969</c:v>
                </c:pt>
                <c:pt idx="2312">
                  <c:v>32231.533187866211</c:v>
                </c:pt>
                <c:pt idx="2313">
                  <c:v>32244.421020507813</c:v>
                </c:pt>
                <c:pt idx="2314">
                  <c:v>32255.337432861328</c:v>
                </c:pt>
                <c:pt idx="2315">
                  <c:v>32254.282409667969</c:v>
                </c:pt>
                <c:pt idx="2316">
                  <c:v>32242.655944824219</c:v>
                </c:pt>
                <c:pt idx="2317">
                  <c:v>32230.429489135742</c:v>
                </c:pt>
                <c:pt idx="2318">
                  <c:v>32227.431610107422</c:v>
                </c:pt>
                <c:pt idx="2319">
                  <c:v>32233.805160522461</c:v>
                </c:pt>
                <c:pt idx="2320">
                  <c:v>32237.635848999023</c:v>
                </c:pt>
                <c:pt idx="2321">
                  <c:v>32237.037963867188</c:v>
                </c:pt>
                <c:pt idx="2322">
                  <c:v>32237.068649291992</c:v>
                </c:pt>
                <c:pt idx="2323">
                  <c:v>32236.413619995117</c:v>
                </c:pt>
                <c:pt idx="2324">
                  <c:v>32238.987167358398</c:v>
                </c:pt>
                <c:pt idx="2325">
                  <c:v>32251.18928527832</c:v>
                </c:pt>
                <c:pt idx="2326">
                  <c:v>32262.219970703125</c:v>
                </c:pt>
                <c:pt idx="2327">
                  <c:v>32264.050659179688</c:v>
                </c:pt>
                <c:pt idx="2328">
                  <c:v>32261.624206542969</c:v>
                </c:pt>
                <c:pt idx="2329">
                  <c:v>32256.512023925781</c:v>
                </c:pt>
                <c:pt idx="2330">
                  <c:v>32252.171295166016</c:v>
                </c:pt>
                <c:pt idx="2331">
                  <c:v>32253.373413085938</c:v>
                </c:pt>
                <c:pt idx="2332">
                  <c:v>32254.261245727539</c:v>
                </c:pt>
                <c:pt idx="2333">
                  <c:v>32252.320510864258</c:v>
                </c:pt>
                <c:pt idx="2334">
                  <c:v>32259.808349609375</c:v>
                </c:pt>
                <c:pt idx="2335">
                  <c:v>32272.410461425781</c:v>
                </c:pt>
                <c:pt idx="2336">
                  <c:v>32278.212585449219</c:v>
                </c:pt>
                <c:pt idx="2337">
                  <c:v>32276.957550048828</c:v>
                </c:pt>
                <c:pt idx="2338">
                  <c:v>32273.731079101563</c:v>
                </c:pt>
                <c:pt idx="2339">
                  <c:v>32267.533203125</c:v>
                </c:pt>
                <c:pt idx="2340">
                  <c:v>32265.506744384766</c:v>
                </c:pt>
                <c:pt idx="2341">
                  <c:v>32273.22314453125</c:v>
                </c:pt>
                <c:pt idx="2342">
                  <c:v>32274.482421875</c:v>
                </c:pt>
                <c:pt idx="2343">
                  <c:v>32265.141662597656</c:v>
                </c:pt>
                <c:pt idx="2344">
                  <c:v>32257.000946044922</c:v>
                </c:pt>
                <c:pt idx="2345">
                  <c:v>32256.060180664063</c:v>
                </c:pt>
                <c:pt idx="2346">
                  <c:v>32255.262313842773</c:v>
                </c:pt>
                <c:pt idx="2347">
                  <c:v>32258.692993164063</c:v>
                </c:pt>
                <c:pt idx="2348">
                  <c:v>32268.895111083984</c:v>
                </c:pt>
                <c:pt idx="2349">
                  <c:v>32268.8115234375</c:v>
                </c:pt>
                <c:pt idx="2350">
                  <c:v>32251.156494140625</c:v>
                </c:pt>
                <c:pt idx="2351">
                  <c:v>32235.358612060547</c:v>
                </c:pt>
                <c:pt idx="2352">
                  <c:v>32239.332153320313</c:v>
                </c:pt>
                <c:pt idx="2353">
                  <c:v>32255.219985961914</c:v>
                </c:pt>
                <c:pt idx="2354">
                  <c:v>32265.250671386719</c:v>
                </c:pt>
                <c:pt idx="2355">
                  <c:v>32265.681365966797</c:v>
                </c:pt>
                <c:pt idx="2356">
                  <c:v>32260.769195556641</c:v>
                </c:pt>
                <c:pt idx="2357">
                  <c:v>32257.399871826172</c:v>
                </c:pt>
                <c:pt idx="2358">
                  <c:v>32256.173431396484</c:v>
                </c:pt>
                <c:pt idx="2359">
                  <c:v>32252.861267089844</c:v>
                </c:pt>
                <c:pt idx="2360">
                  <c:v>32241.491943359375</c:v>
                </c:pt>
                <c:pt idx="2361">
                  <c:v>32231.265487670898</c:v>
                </c:pt>
                <c:pt idx="2362">
                  <c:v>32236.296188354492</c:v>
                </c:pt>
                <c:pt idx="2363">
                  <c:v>32250.526870727539</c:v>
                </c:pt>
                <c:pt idx="2364">
                  <c:v>32258.157562255859</c:v>
                </c:pt>
                <c:pt idx="2365">
                  <c:v>32253.388244628906</c:v>
                </c:pt>
                <c:pt idx="2366">
                  <c:v>32248.361785888672</c:v>
                </c:pt>
                <c:pt idx="2367">
                  <c:v>32241.849624633789</c:v>
                </c:pt>
                <c:pt idx="2368">
                  <c:v>32234.10888671875</c:v>
                </c:pt>
                <c:pt idx="2369">
                  <c:v>32224.139572143555</c:v>
                </c:pt>
                <c:pt idx="2370">
                  <c:v>32216.655975341797</c:v>
                </c:pt>
                <c:pt idx="2371">
                  <c:v>32220.029525756836</c:v>
                </c:pt>
                <c:pt idx="2372">
                  <c:v>32231.603057861328</c:v>
                </c:pt>
                <c:pt idx="2373">
                  <c:v>32236.633758544922</c:v>
                </c:pt>
                <c:pt idx="2374">
                  <c:v>32227.550155639648</c:v>
                </c:pt>
                <c:pt idx="2375">
                  <c:v>32216.695129394531</c:v>
                </c:pt>
                <c:pt idx="2376">
                  <c:v>32213.868682861328</c:v>
                </c:pt>
                <c:pt idx="2377">
                  <c:v>32221.470794677734</c:v>
                </c:pt>
                <c:pt idx="2378">
                  <c:v>32239.244338989258</c:v>
                </c:pt>
                <c:pt idx="2379">
                  <c:v>32251.932174682617</c:v>
                </c:pt>
                <c:pt idx="2380">
                  <c:v>32249.562850952148</c:v>
                </c:pt>
                <c:pt idx="2381">
                  <c:v>32238.76496887207</c:v>
                </c:pt>
                <c:pt idx="2382">
                  <c:v>32233.738525390625</c:v>
                </c:pt>
                <c:pt idx="2383">
                  <c:v>32227.226348876953</c:v>
                </c:pt>
                <c:pt idx="2384">
                  <c:v>32215.171325683594</c:v>
                </c:pt>
                <c:pt idx="2385">
                  <c:v>32210.002014160156</c:v>
                </c:pt>
                <c:pt idx="2386">
                  <c:v>32214.661270141602</c:v>
                </c:pt>
                <c:pt idx="2387">
                  <c:v>32214.777679443359</c:v>
                </c:pt>
                <c:pt idx="2388">
                  <c:v>32208.579788208008</c:v>
                </c:pt>
                <c:pt idx="2389">
                  <c:v>32207.839050292969</c:v>
                </c:pt>
                <c:pt idx="2390">
                  <c:v>32210.384033203125</c:v>
                </c:pt>
                <c:pt idx="2391">
                  <c:v>32205.500427246094</c:v>
                </c:pt>
                <c:pt idx="2392">
                  <c:v>32194.159683227539</c:v>
                </c:pt>
                <c:pt idx="2393">
                  <c:v>32193.390380859375</c:v>
                </c:pt>
                <c:pt idx="2394">
                  <c:v>32206.306777954102</c:v>
                </c:pt>
                <c:pt idx="2395">
                  <c:v>32221.937469482422</c:v>
                </c:pt>
                <c:pt idx="2396">
                  <c:v>32221.053863525391</c:v>
                </c:pt>
                <c:pt idx="2397">
                  <c:v>32209.513122558594</c:v>
                </c:pt>
                <c:pt idx="2398">
                  <c:v>32197.972396850586</c:v>
                </c:pt>
                <c:pt idx="2399">
                  <c:v>32191.860214233398</c:v>
                </c:pt>
                <c:pt idx="2400">
                  <c:v>32187.233764648438</c:v>
                </c:pt>
                <c:pt idx="2401">
                  <c:v>32182.035888671875</c:v>
                </c:pt>
                <c:pt idx="2402">
                  <c:v>32178.06657409668</c:v>
                </c:pt>
                <c:pt idx="2403">
                  <c:v>32179.268692016602</c:v>
                </c:pt>
                <c:pt idx="2404">
                  <c:v>32186.985092163086</c:v>
                </c:pt>
                <c:pt idx="2405">
                  <c:v>32192.444351196289</c:v>
                </c:pt>
                <c:pt idx="2406">
                  <c:v>32190.103607177734</c:v>
                </c:pt>
                <c:pt idx="2407">
                  <c:v>32181.734298706055</c:v>
                </c:pt>
                <c:pt idx="2408">
                  <c:v>32174.364990234375</c:v>
                </c:pt>
                <c:pt idx="2409">
                  <c:v>32168.995681762695</c:v>
                </c:pt>
                <c:pt idx="2410">
                  <c:v>32166.083511352539</c:v>
                </c:pt>
                <c:pt idx="2411">
                  <c:v>32168.057052612305</c:v>
                </c:pt>
                <c:pt idx="2412">
                  <c:v>32178.71630859375</c:v>
                </c:pt>
                <c:pt idx="2413">
                  <c:v>32189.889862060547</c:v>
                </c:pt>
                <c:pt idx="2414">
                  <c:v>32189.091979980469</c:v>
                </c:pt>
                <c:pt idx="2415">
                  <c:v>32175.865524291992</c:v>
                </c:pt>
                <c:pt idx="2416">
                  <c:v>32167.467636108398</c:v>
                </c:pt>
                <c:pt idx="2417">
                  <c:v>32168.241180419922</c:v>
                </c:pt>
                <c:pt idx="2418">
                  <c:v>32171.129013061523</c:v>
                </c:pt>
                <c:pt idx="2419">
                  <c:v>32168.159698486328</c:v>
                </c:pt>
                <c:pt idx="2420">
                  <c:v>32158.590393066406</c:v>
                </c:pt>
                <c:pt idx="2421">
                  <c:v>32143.306793212891</c:v>
                </c:pt>
                <c:pt idx="2422">
                  <c:v>32135.337478637695</c:v>
                </c:pt>
                <c:pt idx="2423">
                  <c:v>32140.511032104492</c:v>
                </c:pt>
                <c:pt idx="2424">
                  <c:v>32152.255996704102</c:v>
                </c:pt>
                <c:pt idx="2425">
                  <c:v>32159.743835449219</c:v>
                </c:pt>
                <c:pt idx="2426">
                  <c:v>32162.917373657227</c:v>
                </c:pt>
                <c:pt idx="2427">
                  <c:v>32156.948059082031</c:v>
                </c:pt>
                <c:pt idx="2428">
                  <c:v>32149.835891723633</c:v>
                </c:pt>
                <c:pt idx="2429">
                  <c:v>32153.580871582031</c:v>
                </c:pt>
                <c:pt idx="2430">
                  <c:v>32159.725845336914</c:v>
                </c:pt>
                <c:pt idx="2431">
                  <c:v>32151.842239379883</c:v>
                </c:pt>
                <c:pt idx="2432">
                  <c:v>32140.672927856445</c:v>
                </c:pt>
                <c:pt idx="2433">
                  <c:v>32135.989334106445</c:v>
                </c:pt>
                <c:pt idx="2434">
                  <c:v>32137.02001953125</c:v>
                </c:pt>
                <c:pt idx="2435">
                  <c:v>32138.879287719727</c:v>
                </c:pt>
                <c:pt idx="2436">
                  <c:v>32146.709976196289</c:v>
                </c:pt>
                <c:pt idx="2437">
                  <c:v>32151.28352355957</c:v>
                </c:pt>
                <c:pt idx="2438">
                  <c:v>32148.285629272461</c:v>
                </c:pt>
                <c:pt idx="2439">
                  <c:v>32142.516326904297</c:v>
                </c:pt>
                <c:pt idx="2440">
                  <c:v>32139.889877319336</c:v>
                </c:pt>
                <c:pt idx="2441">
                  <c:v>32143.177703857422</c:v>
                </c:pt>
                <c:pt idx="2442">
                  <c:v>32147.236953735352</c:v>
                </c:pt>
                <c:pt idx="2443">
                  <c:v>32143.696228027344</c:v>
                </c:pt>
                <c:pt idx="2444">
                  <c:v>32127.98405456543</c:v>
                </c:pt>
                <c:pt idx="2445">
                  <c:v>32112.414741516113</c:v>
                </c:pt>
                <c:pt idx="2446">
                  <c:v>32108.588287353516</c:v>
                </c:pt>
                <c:pt idx="2447">
                  <c:v>32113.933258056641</c:v>
                </c:pt>
                <c:pt idx="2448">
                  <c:v>32110.992523193359</c:v>
                </c:pt>
                <c:pt idx="2449">
                  <c:v>32105.051780700684</c:v>
                </c:pt>
                <c:pt idx="2450">
                  <c:v>32107.111038208008</c:v>
                </c:pt>
                <c:pt idx="2451">
                  <c:v>32120.513153076172</c:v>
                </c:pt>
                <c:pt idx="2452">
                  <c:v>32130.25813293457</c:v>
                </c:pt>
                <c:pt idx="2453">
                  <c:v>32133.460250854492</c:v>
                </c:pt>
                <c:pt idx="2454">
                  <c:v>32137.605224609375</c:v>
                </c:pt>
                <c:pt idx="2455">
                  <c:v>32143.864486694336</c:v>
                </c:pt>
                <c:pt idx="2456">
                  <c:v>32138.180877685547</c:v>
                </c:pt>
                <c:pt idx="2457">
                  <c:v>32123.925857543945</c:v>
                </c:pt>
                <c:pt idx="2458">
                  <c:v>32119.013687133789</c:v>
                </c:pt>
                <c:pt idx="2459">
                  <c:v>32127.158660888672</c:v>
                </c:pt>
                <c:pt idx="2460">
                  <c:v>32136.789352416992</c:v>
                </c:pt>
                <c:pt idx="2461">
                  <c:v>32144.162902832031</c:v>
                </c:pt>
                <c:pt idx="2462">
                  <c:v>32143.736434936523</c:v>
                </c:pt>
                <c:pt idx="2463">
                  <c:v>32136.338562011719</c:v>
                </c:pt>
                <c:pt idx="2464">
                  <c:v>32131.340667724609</c:v>
                </c:pt>
                <c:pt idx="2465">
                  <c:v>32133.142791748047</c:v>
                </c:pt>
                <c:pt idx="2466">
                  <c:v>32137.573486328125</c:v>
                </c:pt>
                <c:pt idx="2467">
                  <c:v>32140.804168701172</c:v>
                </c:pt>
                <c:pt idx="2468">
                  <c:v>32139.520568847656</c:v>
                </c:pt>
                <c:pt idx="2469">
                  <c:v>32133.236968994141</c:v>
                </c:pt>
                <c:pt idx="2470">
                  <c:v>32123.724807739258</c:v>
                </c:pt>
                <c:pt idx="2471">
                  <c:v>32112.298347473145</c:v>
                </c:pt>
                <c:pt idx="2472">
                  <c:v>32108.471893310547</c:v>
                </c:pt>
                <c:pt idx="2473">
                  <c:v>32112.445442199707</c:v>
                </c:pt>
                <c:pt idx="2474">
                  <c:v>32118.533271789551</c:v>
                </c:pt>
                <c:pt idx="2475">
                  <c:v>32117.163963317871</c:v>
                </c:pt>
                <c:pt idx="2476">
                  <c:v>32112.823219299316</c:v>
                </c:pt>
                <c:pt idx="2477">
                  <c:v>32108.511054992676</c:v>
                </c:pt>
                <c:pt idx="2478">
                  <c:v>32111.741737365723</c:v>
                </c:pt>
                <c:pt idx="2479">
                  <c:v>32119.915283203125</c:v>
                </c:pt>
                <c:pt idx="2480">
                  <c:v>32122.688827514648</c:v>
                </c:pt>
                <c:pt idx="2481">
                  <c:v>32118.54808807373</c:v>
                </c:pt>
                <c:pt idx="2482">
                  <c:v>32108.293067932129</c:v>
                </c:pt>
                <c:pt idx="2483">
                  <c:v>32099.123756408691</c:v>
                </c:pt>
                <c:pt idx="2484">
                  <c:v>32094.183013916016</c:v>
                </c:pt>
                <c:pt idx="2485">
                  <c:v>32099.21369934082</c:v>
                </c:pt>
                <c:pt idx="2486">
                  <c:v>32108.415817260742</c:v>
                </c:pt>
                <c:pt idx="2487">
                  <c:v>32114.446502685547</c:v>
                </c:pt>
                <c:pt idx="2488">
                  <c:v>32108.905769348145</c:v>
                </c:pt>
                <c:pt idx="2489">
                  <c:v>32092.765022277832</c:v>
                </c:pt>
                <c:pt idx="2490">
                  <c:v>32080.795715332031</c:v>
                </c:pt>
                <c:pt idx="2491">
                  <c:v>32086.140686035156</c:v>
                </c:pt>
                <c:pt idx="2492">
                  <c:v>32102.342803955078</c:v>
                </c:pt>
                <c:pt idx="2493">
                  <c:v>32110.744918823242</c:v>
                </c:pt>
                <c:pt idx="2494">
                  <c:v>32113.804183959961</c:v>
                </c:pt>
                <c:pt idx="2495">
                  <c:v>32120.977729797363</c:v>
                </c:pt>
                <c:pt idx="2496">
                  <c:v>32133.665557861328</c:v>
                </c:pt>
                <c:pt idx="2497">
                  <c:v>32135.410537719727</c:v>
                </c:pt>
                <c:pt idx="2498">
                  <c:v>32120.555503845215</c:v>
                </c:pt>
                <c:pt idx="2499">
                  <c:v>32104.357620239258</c:v>
                </c:pt>
                <c:pt idx="2500">
                  <c:v>32102.331169128418</c:v>
                </c:pt>
                <c:pt idx="2501">
                  <c:v>32105.333282470703</c:v>
                </c:pt>
                <c:pt idx="2502">
                  <c:v>32103.221115112305</c:v>
                </c:pt>
                <c:pt idx="2503">
                  <c:v>32104.394660949707</c:v>
                </c:pt>
                <c:pt idx="2504">
                  <c:v>32112.968208312988</c:v>
                </c:pt>
                <c:pt idx="2505">
                  <c:v>32123.227470397949</c:v>
                </c:pt>
                <c:pt idx="2506">
                  <c:v>32129.172439575195</c:v>
                </c:pt>
                <c:pt idx="2507">
                  <c:v>32128.488845825195</c:v>
                </c:pt>
                <c:pt idx="2508">
                  <c:v>32126.20524597168</c:v>
                </c:pt>
                <c:pt idx="2509">
                  <c:v>32128.178787231445</c:v>
                </c:pt>
                <c:pt idx="2510">
                  <c:v>32134.495193481445</c:v>
                </c:pt>
                <c:pt idx="2511">
                  <c:v>32130.040176391602</c:v>
                </c:pt>
                <c:pt idx="2512">
                  <c:v>32116.099426269531</c:v>
                </c:pt>
                <c:pt idx="2513">
                  <c:v>32102.84440612793</c:v>
                </c:pt>
                <c:pt idx="2514">
                  <c:v>32101.132232666016</c:v>
                </c:pt>
                <c:pt idx="2515">
                  <c:v>32108.762924194336</c:v>
                </c:pt>
                <c:pt idx="2516">
                  <c:v>32118.450752258301</c:v>
                </c:pt>
                <c:pt idx="2517">
                  <c:v>32128.110015869141</c:v>
                </c:pt>
                <c:pt idx="2518">
                  <c:v>32133.626419067383</c:v>
                </c:pt>
                <c:pt idx="2519">
                  <c:v>32138.971389770508</c:v>
                </c:pt>
                <c:pt idx="2520">
                  <c:v>32142.48779296875</c:v>
                </c:pt>
                <c:pt idx="2521">
                  <c:v>32141.48991394043</c:v>
                </c:pt>
                <c:pt idx="2522">
                  <c:v>32132.177734375</c:v>
                </c:pt>
                <c:pt idx="2523">
                  <c:v>32123.579856872559</c:v>
                </c:pt>
                <c:pt idx="2524">
                  <c:v>32119.410545349121</c:v>
                </c:pt>
                <c:pt idx="2525">
                  <c:v>32115.841232299805</c:v>
                </c:pt>
                <c:pt idx="2526">
                  <c:v>32112.500495910645</c:v>
                </c:pt>
                <c:pt idx="2527">
                  <c:v>32113.616897583008</c:v>
                </c:pt>
                <c:pt idx="2528">
                  <c:v>32116.533302307129</c:v>
                </c:pt>
                <c:pt idx="2529">
                  <c:v>32112.592559814453</c:v>
                </c:pt>
                <c:pt idx="2530">
                  <c:v>32106.366104125977</c:v>
                </c:pt>
                <c:pt idx="2531">
                  <c:v>32102.282508850098</c:v>
                </c:pt>
                <c:pt idx="2532">
                  <c:v>32102.170333862305</c:v>
                </c:pt>
                <c:pt idx="2533">
                  <c:v>32097.086738586426</c:v>
                </c:pt>
                <c:pt idx="2534">
                  <c:v>32089.860282897949</c:v>
                </c:pt>
                <c:pt idx="2535">
                  <c:v>32088.290977478027</c:v>
                </c:pt>
                <c:pt idx="2536">
                  <c:v>32093.864517211914</c:v>
                </c:pt>
                <c:pt idx="2537">
                  <c:v>32097.923782348633</c:v>
                </c:pt>
                <c:pt idx="2538">
                  <c:v>32094.81160736084</c:v>
                </c:pt>
                <c:pt idx="2539">
                  <c:v>32093.928016662598</c:v>
                </c:pt>
                <c:pt idx="2540">
                  <c:v>32092.587272644043</c:v>
                </c:pt>
                <c:pt idx="2541">
                  <c:v>32088.932243347168</c:v>
                </c:pt>
                <c:pt idx="2542">
                  <c:v>32093.934364318848</c:v>
                </c:pt>
                <c:pt idx="2543">
                  <c:v>32109.850769042969</c:v>
                </c:pt>
                <c:pt idx="2544">
                  <c:v>32113.681457519531</c:v>
                </c:pt>
                <c:pt idx="2545">
                  <c:v>32097.140716552734</c:v>
                </c:pt>
                <c:pt idx="2546">
                  <c:v>32076.599975585938</c:v>
                </c:pt>
                <c:pt idx="2547">
                  <c:v>32063.059234619141</c:v>
                </c:pt>
                <c:pt idx="2548">
                  <c:v>32051.518493652344</c:v>
                </c:pt>
                <c:pt idx="2549">
                  <c:v>32049.034896850586</c:v>
                </c:pt>
                <c:pt idx="2550">
                  <c:v>32057.29415512085</c:v>
                </c:pt>
                <c:pt idx="2551">
                  <c:v>32073.581985473633</c:v>
                </c:pt>
                <c:pt idx="2552">
                  <c:v>32083.584106445313</c:v>
                </c:pt>
                <c:pt idx="2553">
                  <c:v>32085.357650756836</c:v>
                </c:pt>
                <c:pt idx="2554">
                  <c:v>32083.331192016602</c:v>
                </c:pt>
                <c:pt idx="2555">
                  <c:v>32085.847595214844</c:v>
                </c:pt>
                <c:pt idx="2556">
                  <c:v>32091.078285217285</c:v>
                </c:pt>
                <c:pt idx="2557">
                  <c:v>32098.223258972168</c:v>
                </c:pt>
                <c:pt idx="2558">
                  <c:v>32094.539665222168</c:v>
                </c:pt>
                <c:pt idx="2559">
                  <c:v>32082.513206481934</c:v>
                </c:pt>
                <c:pt idx="2560">
                  <c:v>32078.115325927734</c:v>
                </c:pt>
                <c:pt idx="2561">
                  <c:v>32086.43172454834</c:v>
                </c:pt>
                <c:pt idx="2562">
                  <c:v>32091.805274963379</c:v>
                </c:pt>
                <c:pt idx="2563">
                  <c:v>32081.550247192383</c:v>
                </c:pt>
                <c:pt idx="2564">
                  <c:v>32067.095222473145</c:v>
                </c:pt>
                <c:pt idx="2565">
                  <c:v>32060.840194702148</c:v>
                </c:pt>
                <c:pt idx="2566">
                  <c:v>32067.442314147949</c:v>
                </c:pt>
                <c:pt idx="2567">
                  <c:v>32075.044425964355</c:v>
                </c:pt>
                <c:pt idx="2568">
                  <c:v>32070.989402770996</c:v>
                </c:pt>
                <c:pt idx="2569">
                  <c:v>32062.648662567139</c:v>
                </c:pt>
                <c:pt idx="2570">
                  <c:v>32059.479351043701</c:v>
                </c:pt>
                <c:pt idx="2571">
                  <c:v>32063.138610839844</c:v>
                </c:pt>
                <c:pt idx="2572">
                  <c:v>32063.226440429688</c:v>
                </c:pt>
                <c:pt idx="2573">
                  <c:v>32058.314273834229</c:v>
                </c:pt>
                <c:pt idx="2574">
                  <c:v>32057.230674743652</c:v>
                </c:pt>
                <c:pt idx="2575">
                  <c:v>32064.575653076172</c:v>
                </c:pt>
                <c:pt idx="2576">
                  <c:v>32076.606338500977</c:v>
                </c:pt>
                <c:pt idx="2577">
                  <c:v>32078.265594482422</c:v>
                </c:pt>
                <c:pt idx="2578">
                  <c:v>32069.210571289063</c:v>
                </c:pt>
                <c:pt idx="2579">
                  <c:v>32064.384117126465</c:v>
                </c:pt>
                <c:pt idx="2580">
                  <c:v>32065.900520324707</c:v>
                </c:pt>
                <c:pt idx="2581">
                  <c:v>32068.274063110352</c:v>
                </c:pt>
                <c:pt idx="2582">
                  <c:v>32065.761894226074</c:v>
                </c:pt>
                <c:pt idx="2583">
                  <c:v>32062.935440063477</c:v>
                </c:pt>
                <c:pt idx="2584">
                  <c:v>32058.823272705078</c:v>
                </c:pt>
                <c:pt idx="2585">
                  <c:v>32060.911102294922</c:v>
                </c:pt>
                <c:pt idx="2586">
                  <c:v>32070.398933410645</c:v>
                </c:pt>
                <c:pt idx="2587">
                  <c:v>32074.315338134766</c:v>
                </c:pt>
                <c:pt idx="2588">
                  <c:v>32066.746025085449</c:v>
                </c:pt>
                <c:pt idx="2589">
                  <c:v>32057.633857727051</c:v>
                </c:pt>
                <c:pt idx="2590">
                  <c:v>32054.864543914795</c:v>
                </c:pt>
                <c:pt idx="2591">
                  <c:v>32054.152378082275</c:v>
                </c:pt>
                <c:pt idx="2592">
                  <c:v>32053.783065795898</c:v>
                </c:pt>
                <c:pt idx="2593">
                  <c:v>32058.185180664063</c:v>
                </c:pt>
                <c:pt idx="2594">
                  <c:v>32060.873012542725</c:v>
                </c:pt>
                <c:pt idx="2595">
                  <c:v>32054.589416503906</c:v>
                </c:pt>
                <c:pt idx="2596">
                  <c:v>32044.562961578369</c:v>
                </c:pt>
                <c:pt idx="2597">
                  <c:v>32038.507934570313</c:v>
                </c:pt>
                <c:pt idx="2598">
                  <c:v>32035.595767974854</c:v>
                </c:pt>
                <c:pt idx="2599">
                  <c:v>32034.569313049316</c:v>
                </c:pt>
                <c:pt idx="2600">
                  <c:v>32033.571430206299</c:v>
                </c:pt>
                <c:pt idx="2601">
                  <c:v>32031.973545074463</c:v>
                </c:pt>
                <c:pt idx="2602">
                  <c:v>32030.975662231445</c:v>
                </c:pt>
                <c:pt idx="2603">
                  <c:v>32034.377780914307</c:v>
                </c:pt>
                <c:pt idx="2604">
                  <c:v>32039.46561050415</c:v>
                </c:pt>
                <c:pt idx="2605">
                  <c:v>32043.210582733154</c:v>
                </c:pt>
                <c:pt idx="2606">
                  <c:v>32048.612701416016</c:v>
                </c:pt>
                <c:pt idx="2607">
                  <c:v>32054.214817047119</c:v>
                </c:pt>
                <c:pt idx="2608">
                  <c:v>32049.81693649292</c:v>
                </c:pt>
                <c:pt idx="2609">
                  <c:v>32036.647624969482</c:v>
                </c:pt>
                <c:pt idx="2610">
                  <c:v>32029.449739456177</c:v>
                </c:pt>
                <c:pt idx="2611">
                  <c:v>32034.137573242188</c:v>
                </c:pt>
                <c:pt idx="2612">
                  <c:v>32039.568260192871</c:v>
                </c:pt>
                <c:pt idx="2613">
                  <c:v>32041.513233184814</c:v>
                </c:pt>
                <c:pt idx="2614">
                  <c:v>32046.458206176758</c:v>
                </c:pt>
                <c:pt idx="2615">
                  <c:v>32059.888896942139</c:v>
                </c:pt>
                <c:pt idx="2616">
                  <c:v>32073.805297851563</c:v>
                </c:pt>
                <c:pt idx="2617">
                  <c:v>32074.207412719727</c:v>
                </c:pt>
                <c:pt idx="2618">
                  <c:v>32067.980964660645</c:v>
                </c:pt>
                <c:pt idx="2619">
                  <c:v>32068.61164855957</c:v>
                </c:pt>
                <c:pt idx="2620">
                  <c:v>32073.985191345215</c:v>
                </c:pt>
                <c:pt idx="2621">
                  <c:v>32073.815879821777</c:v>
                </c:pt>
                <c:pt idx="2622">
                  <c:v>32074.103713989258</c:v>
                </c:pt>
                <c:pt idx="2623">
                  <c:v>32074.391548156738</c:v>
                </c:pt>
                <c:pt idx="2624">
                  <c:v>32072.450805664063</c:v>
                </c:pt>
                <c:pt idx="2625">
                  <c:v>32067.481491088867</c:v>
                </c:pt>
                <c:pt idx="2626">
                  <c:v>32056.797897338867</c:v>
                </c:pt>
                <c:pt idx="2627">
                  <c:v>32045.685726165771</c:v>
                </c:pt>
                <c:pt idx="2628">
                  <c:v>32047.944988250732</c:v>
                </c:pt>
                <c:pt idx="2629">
                  <c:v>32062.947105407715</c:v>
                </c:pt>
                <c:pt idx="2630">
                  <c:v>32069.97779083252</c:v>
                </c:pt>
                <c:pt idx="2631">
                  <c:v>32061.4084815979</c:v>
                </c:pt>
                <c:pt idx="2632">
                  <c:v>32047.296310424805</c:v>
                </c:pt>
                <c:pt idx="2633">
                  <c:v>32038.184143066406</c:v>
                </c:pt>
                <c:pt idx="2634">
                  <c:v>32040.814830780029</c:v>
                </c:pt>
                <c:pt idx="2635">
                  <c:v>32048.302661895752</c:v>
                </c:pt>
                <c:pt idx="2636">
                  <c:v>32054.876209259033</c:v>
                </c:pt>
                <c:pt idx="2637">
                  <c:v>32059.306896209717</c:v>
                </c:pt>
                <c:pt idx="2638">
                  <c:v>32063.25186920166</c:v>
                </c:pt>
                <c:pt idx="2639">
                  <c:v>32067.168273925781</c:v>
                </c:pt>
                <c:pt idx="2640">
                  <c:v>32070.198959350586</c:v>
                </c:pt>
                <c:pt idx="2641">
                  <c:v>32071.715362548828</c:v>
                </c:pt>
                <c:pt idx="2642">
                  <c:v>32065.746055603027</c:v>
                </c:pt>
                <c:pt idx="2643">
                  <c:v>32065.976737976074</c:v>
                </c:pt>
                <c:pt idx="2644">
                  <c:v>32070.607429504395</c:v>
                </c:pt>
                <c:pt idx="2645">
                  <c:v>32070.466690063477</c:v>
                </c:pt>
                <c:pt idx="2646">
                  <c:v>32062.154518127441</c:v>
                </c:pt>
                <c:pt idx="2647">
                  <c:v>32059.070922851563</c:v>
                </c:pt>
                <c:pt idx="2648">
                  <c:v>32056.358753204346</c:v>
                </c:pt>
                <c:pt idx="2649">
                  <c:v>32048.446582794189</c:v>
                </c:pt>
                <c:pt idx="2650">
                  <c:v>32045.24870300293</c:v>
                </c:pt>
                <c:pt idx="2651">
                  <c:v>32046.850818634033</c:v>
                </c:pt>
                <c:pt idx="2652">
                  <c:v>32044.852935791016</c:v>
                </c:pt>
                <c:pt idx="2653">
                  <c:v>32039.226482391357</c:v>
                </c:pt>
                <c:pt idx="2654">
                  <c:v>32039.114311218262</c:v>
                </c:pt>
                <c:pt idx="2655">
                  <c:v>32041.573570251465</c:v>
                </c:pt>
                <c:pt idx="2656">
                  <c:v>32046.347118377686</c:v>
                </c:pt>
                <c:pt idx="2657">
                  <c:v>32053.177806854248</c:v>
                </c:pt>
                <c:pt idx="2658">
                  <c:v>32060.808494567871</c:v>
                </c:pt>
                <c:pt idx="2659">
                  <c:v>32061.610610961914</c:v>
                </c:pt>
                <c:pt idx="2660">
                  <c:v>32054.527011871338</c:v>
                </c:pt>
                <c:pt idx="2661">
                  <c:v>32047.814846038818</c:v>
                </c:pt>
                <c:pt idx="2662">
                  <c:v>32045.702674865723</c:v>
                </c:pt>
                <c:pt idx="2663">
                  <c:v>32038.819076538086</c:v>
                </c:pt>
                <c:pt idx="2664">
                  <c:v>32023.621194839478</c:v>
                </c:pt>
                <c:pt idx="2665">
                  <c:v>32015.79474067688</c:v>
                </c:pt>
                <c:pt idx="2666">
                  <c:v>32024.568284988403</c:v>
                </c:pt>
                <c:pt idx="2667">
                  <c:v>32041.341831207275</c:v>
                </c:pt>
                <c:pt idx="2668">
                  <c:v>32052.715377807617</c:v>
                </c:pt>
                <c:pt idx="2669">
                  <c:v>32053.488922119141</c:v>
                </c:pt>
                <c:pt idx="2670">
                  <c:v>32053.548183441162</c:v>
                </c:pt>
                <c:pt idx="2671">
                  <c:v>32053.921726226807</c:v>
                </c:pt>
                <c:pt idx="2672">
                  <c:v>32048.438129425049</c:v>
                </c:pt>
                <c:pt idx="2673">
                  <c:v>32035.725959777832</c:v>
                </c:pt>
                <c:pt idx="2674">
                  <c:v>32029.785221099854</c:v>
                </c:pt>
                <c:pt idx="2675">
                  <c:v>32038.787338256836</c:v>
                </c:pt>
                <c:pt idx="2676">
                  <c:v>32051.36088180542</c:v>
                </c:pt>
                <c:pt idx="2677">
                  <c:v>32054.963001251221</c:v>
                </c:pt>
                <c:pt idx="2678">
                  <c:v>32046.907974243164</c:v>
                </c:pt>
                <c:pt idx="2679">
                  <c:v>32039.481517791748</c:v>
                </c:pt>
                <c:pt idx="2680">
                  <c:v>32036.82649230957</c:v>
                </c:pt>
                <c:pt idx="2681">
                  <c:v>32035.714324951172</c:v>
                </c:pt>
                <c:pt idx="2682">
                  <c:v>32030.859298706055</c:v>
                </c:pt>
                <c:pt idx="2683">
                  <c:v>32027.718559265137</c:v>
                </c:pt>
                <c:pt idx="2684">
                  <c:v>32037.377819061279</c:v>
                </c:pt>
                <c:pt idx="2685">
                  <c:v>32055.179935455322</c:v>
                </c:pt>
                <c:pt idx="2686">
                  <c:v>32066.924911499023</c:v>
                </c:pt>
                <c:pt idx="2687">
                  <c:v>32068.269882202148</c:v>
                </c:pt>
                <c:pt idx="2688">
                  <c:v>32064.586288452148</c:v>
                </c:pt>
                <c:pt idx="2689">
                  <c:v>32058.531261444092</c:v>
                </c:pt>
                <c:pt idx="2690">
                  <c:v>32051.504806518555</c:v>
                </c:pt>
                <c:pt idx="2691">
                  <c:v>32049.164066314697</c:v>
                </c:pt>
                <c:pt idx="2692">
                  <c:v>32050.423324584961</c:v>
                </c:pt>
                <c:pt idx="2693">
                  <c:v>32048.054012298584</c:v>
                </c:pt>
                <c:pt idx="2694">
                  <c:v>32046.170413970947</c:v>
                </c:pt>
                <c:pt idx="2695">
                  <c:v>32047.143962860107</c:v>
                </c:pt>
                <c:pt idx="2696">
                  <c:v>32043.060363769531</c:v>
                </c:pt>
                <c:pt idx="2697">
                  <c:v>32032.119625091553</c:v>
                </c:pt>
                <c:pt idx="2698">
                  <c:v>32036.578884124756</c:v>
                </c:pt>
                <c:pt idx="2699">
                  <c:v>32055.63814163208</c:v>
                </c:pt>
                <c:pt idx="2700">
                  <c:v>32067.78311920166</c:v>
                </c:pt>
                <c:pt idx="2701">
                  <c:v>32062.899520874023</c:v>
                </c:pt>
                <c:pt idx="2702">
                  <c:v>32060.273063659668</c:v>
                </c:pt>
                <c:pt idx="2703">
                  <c:v>32064.360893249512</c:v>
                </c:pt>
                <c:pt idx="2704">
                  <c:v>32061.334442138672</c:v>
                </c:pt>
                <c:pt idx="2705">
                  <c:v>32047.765129089355</c:v>
                </c:pt>
                <c:pt idx="2706">
                  <c:v>32035.567245483398</c:v>
                </c:pt>
                <c:pt idx="2707">
                  <c:v>32033.026508331299</c:v>
                </c:pt>
                <c:pt idx="2708">
                  <c:v>32037.971481323242</c:v>
                </c:pt>
                <c:pt idx="2709">
                  <c:v>32047.745025634766</c:v>
                </c:pt>
                <c:pt idx="2710">
                  <c:v>32054.261428833008</c:v>
                </c:pt>
                <c:pt idx="2711">
                  <c:v>32054.720687866211</c:v>
                </c:pt>
                <c:pt idx="2712">
                  <c:v>32052.779949188232</c:v>
                </c:pt>
                <c:pt idx="2713">
                  <c:v>32051.039207458496</c:v>
                </c:pt>
                <c:pt idx="2714">
                  <c:v>32053.441326141357</c:v>
                </c:pt>
                <c:pt idx="2715">
                  <c:v>32055.043441772461</c:v>
                </c:pt>
                <c:pt idx="2716">
                  <c:v>32053.588417053223</c:v>
                </c:pt>
                <c:pt idx="2717">
                  <c:v>32055.133388519287</c:v>
                </c:pt>
                <c:pt idx="2718">
                  <c:v>32062.249794006348</c:v>
                </c:pt>
                <c:pt idx="2719">
                  <c:v>32063.537624359131</c:v>
                </c:pt>
                <c:pt idx="2720">
                  <c:v>32059.054027557373</c:v>
                </c:pt>
                <c:pt idx="2721">
                  <c:v>32058.913284301758</c:v>
                </c:pt>
                <c:pt idx="2722">
                  <c:v>32062.658260345459</c:v>
                </c:pt>
                <c:pt idx="2723">
                  <c:v>32059.031806945801</c:v>
                </c:pt>
                <c:pt idx="2724">
                  <c:v>32050.291065216064</c:v>
                </c:pt>
                <c:pt idx="2725">
                  <c:v>32050.436038970947</c:v>
                </c:pt>
                <c:pt idx="2726">
                  <c:v>32060.466728210449</c:v>
                </c:pt>
                <c:pt idx="2727">
                  <c:v>32060.583129882813</c:v>
                </c:pt>
                <c:pt idx="2728">
                  <c:v>32048.956676483154</c:v>
                </c:pt>
                <c:pt idx="2729">
                  <c:v>32043.901649475098</c:v>
                </c:pt>
                <c:pt idx="2730">
                  <c:v>32051.0751953125</c:v>
                </c:pt>
                <c:pt idx="2731">
                  <c:v>32058.220169067383</c:v>
                </c:pt>
                <c:pt idx="2732">
                  <c:v>32057.679428100586</c:v>
                </c:pt>
                <c:pt idx="2733">
                  <c:v>32051.795829772949</c:v>
                </c:pt>
                <c:pt idx="2734">
                  <c:v>32049.797946929932</c:v>
                </c:pt>
                <c:pt idx="2735">
                  <c:v>32055.714351654053</c:v>
                </c:pt>
                <c:pt idx="2736">
                  <c:v>32055.030754089355</c:v>
                </c:pt>
                <c:pt idx="2737">
                  <c:v>32045.09001159668</c:v>
                </c:pt>
                <c:pt idx="2738">
                  <c:v>32034.606414794922</c:v>
                </c:pt>
                <c:pt idx="2739">
                  <c:v>32036.722816467285</c:v>
                </c:pt>
                <c:pt idx="2740">
                  <c:v>32046.924934387207</c:v>
                </c:pt>
                <c:pt idx="2741">
                  <c:v>32053.89847946167</c:v>
                </c:pt>
                <c:pt idx="2742">
                  <c:v>32050.900596618652</c:v>
                </c:pt>
                <c:pt idx="2743">
                  <c:v>32045.359855651855</c:v>
                </c:pt>
                <c:pt idx="2744">
                  <c:v>32045.161975860596</c:v>
                </c:pt>
                <c:pt idx="2745">
                  <c:v>32046.87837600708</c:v>
                </c:pt>
                <c:pt idx="2746">
                  <c:v>32045.709064483643</c:v>
                </c:pt>
                <c:pt idx="2747">
                  <c:v>32048.368324279785</c:v>
                </c:pt>
                <c:pt idx="2748">
                  <c:v>32058.027584075928</c:v>
                </c:pt>
                <c:pt idx="2749">
                  <c:v>32070.172561645508</c:v>
                </c:pt>
                <c:pt idx="2750">
                  <c:v>32069.574676513672</c:v>
                </c:pt>
                <c:pt idx="2751">
                  <c:v>32062.205364227295</c:v>
                </c:pt>
                <c:pt idx="2752">
                  <c:v>32059.321765899658</c:v>
                </c:pt>
                <c:pt idx="2753">
                  <c:v>32058.581024169922</c:v>
                </c:pt>
                <c:pt idx="2754">
                  <c:v>32048.526000976563</c:v>
                </c:pt>
                <c:pt idx="2755">
                  <c:v>32038.156688690186</c:v>
                </c:pt>
                <c:pt idx="2756">
                  <c:v>32039.55880355835</c:v>
                </c:pt>
                <c:pt idx="2757">
                  <c:v>32051.246635437012</c:v>
                </c:pt>
                <c:pt idx="2758">
                  <c:v>32057.791610717773</c:v>
                </c:pt>
                <c:pt idx="2759">
                  <c:v>32051.793727874756</c:v>
                </c:pt>
                <c:pt idx="2760">
                  <c:v>32040.738700866699</c:v>
                </c:pt>
                <c:pt idx="2761">
                  <c:v>32037.626533508301</c:v>
                </c:pt>
                <c:pt idx="2762">
                  <c:v>32037.914363861084</c:v>
                </c:pt>
                <c:pt idx="2763">
                  <c:v>32035.487907409668</c:v>
                </c:pt>
                <c:pt idx="2764">
                  <c:v>32036.31859588623</c:v>
                </c:pt>
                <c:pt idx="2765">
                  <c:v>32042.549285888672</c:v>
                </c:pt>
                <c:pt idx="2766">
                  <c:v>32045.808544158936</c:v>
                </c:pt>
                <c:pt idx="2767">
                  <c:v>32039.296375274658</c:v>
                </c:pt>
                <c:pt idx="2768">
                  <c:v>32035.384208679199</c:v>
                </c:pt>
                <c:pt idx="2769">
                  <c:v>32043.500610351563</c:v>
                </c:pt>
                <c:pt idx="2770">
                  <c:v>32057.988441467285</c:v>
                </c:pt>
                <c:pt idx="2771">
                  <c:v>32055.990558624268</c:v>
                </c:pt>
                <c:pt idx="2772">
                  <c:v>32034.99267578125</c:v>
                </c:pt>
                <c:pt idx="2773">
                  <c:v>32015.194791793823</c:v>
                </c:pt>
                <c:pt idx="2774">
                  <c:v>32015.454051971436</c:v>
                </c:pt>
                <c:pt idx="2775">
                  <c:v>32031.456169128418</c:v>
                </c:pt>
                <c:pt idx="2776">
                  <c:v>32044.858283996582</c:v>
                </c:pt>
                <c:pt idx="2777">
                  <c:v>32046.174686431885</c:v>
                </c:pt>
                <c:pt idx="2778">
                  <c:v>32042.776805877686</c:v>
                </c:pt>
                <c:pt idx="2779">
                  <c:v>32043.693206787109</c:v>
                </c:pt>
                <c:pt idx="2780">
                  <c:v>32045.63818359375</c:v>
                </c:pt>
                <c:pt idx="2781">
                  <c:v>32045.211727142334</c:v>
                </c:pt>
                <c:pt idx="2782">
                  <c:v>32039.556701660156</c:v>
                </c:pt>
                <c:pt idx="2783">
                  <c:v>32034.730247497559</c:v>
                </c:pt>
                <c:pt idx="2784">
                  <c:v>32036.218078613281</c:v>
                </c:pt>
                <c:pt idx="2785">
                  <c:v>32046.705909729004</c:v>
                </c:pt>
                <c:pt idx="2786">
                  <c:v>32055.250885009766</c:v>
                </c:pt>
                <c:pt idx="2787">
                  <c:v>32052.767284393311</c:v>
                </c:pt>
                <c:pt idx="2788">
                  <c:v>32042.397975921631</c:v>
                </c:pt>
                <c:pt idx="2789">
                  <c:v>32037.257232666016</c:v>
                </c:pt>
                <c:pt idx="2790">
                  <c:v>32045.602207183838</c:v>
                </c:pt>
                <c:pt idx="2791">
                  <c:v>32054.2900390625</c:v>
                </c:pt>
                <c:pt idx="2792">
                  <c:v>32051.149299621582</c:v>
                </c:pt>
                <c:pt idx="2793">
                  <c:v>32041.865699768066</c:v>
                </c:pt>
                <c:pt idx="2794">
                  <c:v>32043.439247131348</c:v>
                </c:pt>
                <c:pt idx="2795">
                  <c:v>32054.898506164551</c:v>
                </c:pt>
                <c:pt idx="2796">
                  <c:v>32061.672050476074</c:v>
                </c:pt>
                <c:pt idx="2797">
                  <c:v>32063.245597839355</c:v>
                </c:pt>
                <c:pt idx="2798">
                  <c:v>32067.93342590332</c:v>
                </c:pt>
                <c:pt idx="2799">
                  <c:v>32078.335548400879</c:v>
                </c:pt>
                <c:pt idx="2800">
                  <c:v>32083.166236877441</c:v>
                </c:pt>
                <c:pt idx="2801">
                  <c:v>32077.425491333008</c:v>
                </c:pt>
                <c:pt idx="2802">
                  <c:v>32063.856182098389</c:v>
                </c:pt>
                <c:pt idx="2803">
                  <c:v>32052.22972869873</c:v>
                </c:pt>
                <c:pt idx="2804">
                  <c:v>32051.403274536133</c:v>
                </c:pt>
                <c:pt idx="2805">
                  <c:v>32058.176818847656</c:v>
                </c:pt>
                <c:pt idx="2806">
                  <c:v>32061.007507324219</c:v>
                </c:pt>
                <c:pt idx="2807">
                  <c:v>32058.181053161621</c:v>
                </c:pt>
                <c:pt idx="2808">
                  <c:v>32054.126026153564</c:v>
                </c:pt>
                <c:pt idx="2809">
                  <c:v>32046.985286712646</c:v>
                </c:pt>
                <c:pt idx="2810">
                  <c:v>32043.673118591309</c:v>
                </c:pt>
                <c:pt idx="2811">
                  <c:v>32055.189517974854</c:v>
                </c:pt>
                <c:pt idx="2812">
                  <c:v>32070.534492492676</c:v>
                </c:pt>
                <c:pt idx="2813">
                  <c:v>32069.736610412598</c:v>
                </c:pt>
                <c:pt idx="2814">
                  <c:v>32060.167297363281</c:v>
                </c:pt>
                <c:pt idx="2815">
                  <c:v>32055.883701324463</c:v>
                </c:pt>
                <c:pt idx="2816">
                  <c:v>32054.742961883545</c:v>
                </c:pt>
                <c:pt idx="2817">
                  <c:v>32052.373649597168</c:v>
                </c:pt>
                <c:pt idx="2818">
                  <c:v>32050.832908630371</c:v>
                </c:pt>
                <c:pt idx="2819">
                  <c:v>32050.035026550293</c:v>
                </c:pt>
                <c:pt idx="2820">
                  <c:v>32044.294284820557</c:v>
                </c:pt>
                <c:pt idx="2821">
                  <c:v>32040.782115936279</c:v>
                </c:pt>
                <c:pt idx="2822">
                  <c:v>32043.241374969482</c:v>
                </c:pt>
                <c:pt idx="2823">
                  <c:v>32055.500637054443</c:v>
                </c:pt>
                <c:pt idx="2824">
                  <c:v>32068.017036437988</c:v>
                </c:pt>
                <c:pt idx="2825">
                  <c:v>32072.990585327148</c:v>
                </c:pt>
                <c:pt idx="2826">
                  <c:v>32070.53556060791</c:v>
                </c:pt>
                <c:pt idx="2827">
                  <c:v>32068.737678527832</c:v>
                </c:pt>
                <c:pt idx="2828">
                  <c:v>32065.254081726074</c:v>
                </c:pt>
                <c:pt idx="2829">
                  <c:v>32050.456195831299</c:v>
                </c:pt>
                <c:pt idx="2830">
                  <c:v>32032.801170349121</c:v>
                </c:pt>
                <c:pt idx="2831">
                  <c:v>32025.146142959595</c:v>
                </c:pt>
                <c:pt idx="2832">
                  <c:v>32030.919689178467</c:v>
                </c:pt>
                <c:pt idx="2833">
                  <c:v>32044.664661407471</c:v>
                </c:pt>
                <c:pt idx="2834">
                  <c:v>32065.381065368652</c:v>
                </c:pt>
                <c:pt idx="2835">
                  <c:v>32082.097465515137</c:v>
                </c:pt>
                <c:pt idx="2836">
                  <c:v>32087.956726074219</c:v>
                </c:pt>
                <c:pt idx="2837">
                  <c:v>32081.758842468262</c:v>
                </c:pt>
                <c:pt idx="2838">
                  <c:v>32070.846672058105</c:v>
                </c:pt>
                <c:pt idx="2839">
                  <c:v>32060.220222473145</c:v>
                </c:pt>
                <c:pt idx="2840">
                  <c:v>32056.050910949707</c:v>
                </c:pt>
                <c:pt idx="2841">
                  <c:v>32055.738739013672</c:v>
                </c:pt>
                <c:pt idx="2842">
                  <c:v>32056.312286376953</c:v>
                </c:pt>
                <c:pt idx="2843">
                  <c:v>32061.171546936035</c:v>
                </c:pt>
                <c:pt idx="2844">
                  <c:v>32068.745094299316</c:v>
                </c:pt>
                <c:pt idx="2845">
                  <c:v>32071.375778198242</c:v>
                </c:pt>
                <c:pt idx="2846">
                  <c:v>32071.377899169922</c:v>
                </c:pt>
                <c:pt idx="2847">
                  <c:v>32071.780014038086</c:v>
                </c:pt>
                <c:pt idx="2848">
                  <c:v>32062.982128143311</c:v>
                </c:pt>
                <c:pt idx="2849">
                  <c:v>32046.555675506592</c:v>
                </c:pt>
                <c:pt idx="2850">
                  <c:v>32041.043506622314</c:v>
                </c:pt>
                <c:pt idx="2851">
                  <c:v>32056.102767944336</c:v>
                </c:pt>
                <c:pt idx="2852">
                  <c:v>32072.84774017334</c:v>
                </c:pt>
                <c:pt idx="2853">
                  <c:v>32071.707000732422</c:v>
                </c:pt>
                <c:pt idx="2854">
                  <c:v>32054.794830322266</c:v>
                </c:pt>
                <c:pt idx="2855">
                  <c:v>32042.568378448486</c:v>
                </c:pt>
                <c:pt idx="2856">
                  <c:v>32046.627635955811</c:v>
                </c:pt>
                <c:pt idx="2857">
                  <c:v>32055.886894226074</c:v>
                </c:pt>
                <c:pt idx="2858">
                  <c:v>32054.574726104736</c:v>
                </c:pt>
                <c:pt idx="2859">
                  <c:v>32043.062557220459</c:v>
                </c:pt>
                <c:pt idx="2860">
                  <c:v>32035.064674377441</c:v>
                </c:pt>
                <c:pt idx="2861">
                  <c:v>32039.152507781982</c:v>
                </c:pt>
                <c:pt idx="2862">
                  <c:v>32046.726051330566</c:v>
                </c:pt>
                <c:pt idx="2863">
                  <c:v>32052.585311889648</c:v>
                </c:pt>
                <c:pt idx="2864">
                  <c:v>32059.930286407471</c:v>
                </c:pt>
                <c:pt idx="2865">
                  <c:v>32068.503829956055</c:v>
                </c:pt>
                <c:pt idx="2866">
                  <c:v>32071.163093566895</c:v>
                </c:pt>
                <c:pt idx="2867">
                  <c:v>32065.565208435059</c:v>
                </c:pt>
                <c:pt idx="2868">
                  <c:v>32056.653038024902</c:v>
                </c:pt>
                <c:pt idx="2869">
                  <c:v>32046.055156707764</c:v>
                </c:pt>
                <c:pt idx="2870">
                  <c:v>32043.914417266846</c:v>
                </c:pt>
                <c:pt idx="2871">
                  <c:v>32053.65938949585</c:v>
                </c:pt>
                <c:pt idx="2872">
                  <c:v>32065.80436706543</c:v>
                </c:pt>
                <c:pt idx="2873">
                  <c:v>32065.235054016113</c:v>
                </c:pt>
                <c:pt idx="2874">
                  <c:v>32053.180027008057</c:v>
                </c:pt>
                <c:pt idx="2875">
                  <c:v>32045.43928527832</c:v>
                </c:pt>
                <c:pt idx="2876">
                  <c:v>32047.555686950684</c:v>
                </c:pt>
                <c:pt idx="2877">
                  <c:v>32056.386375427246</c:v>
                </c:pt>
                <c:pt idx="2878">
                  <c:v>32064.359924316406</c:v>
                </c:pt>
                <c:pt idx="2879">
                  <c:v>32072.047752380371</c:v>
                </c:pt>
                <c:pt idx="2880">
                  <c:v>32075.192726135254</c:v>
                </c:pt>
                <c:pt idx="2881">
                  <c:v>32073.309127807617</c:v>
                </c:pt>
                <c:pt idx="2882">
                  <c:v>32067.568389892578</c:v>
                </c:pt>
                <c:pt idx="2883">
                  <c:v>32056.08479309082</c:v>
                </c:pt>
                <c:pt idx="2884">
                  <c:v>32041.172622680664</c:v>
                </c:pt>
                <c:pt idx="2885">
                  <c:v>32033.460453033447</c:v>
                </c:pt>
                <c:pt idx="2886">
                  <c:v>32037.034000396729</c:v>
                </c:pt>
                <c:pt idx="2887">
                  <c:v>32042.636116027832</c:v>
                </c:pt>
                <c:pt idx="2888">
                  <c:v>32044.838233947754</c:v>
                </c:pt>
                <c:pt idx="2889">
                  <c:v>32051.983207702637</c:v>
                </c:pt>
                <c:pt idx="2890">
                  <c:v>32061.528182983398</c:v>
                </c:pt>
                <c:pt idx="2891">
                  <c:v>32064.501724243164</c:v>
                </c:pt>
                <c:pt idx="2892">
                  <c:v>32057.189559936523</c:v>
                </c:pt>
                <c:pt idx="2893">
                  <c:v>32048.877388000488</c:v>
                </c:pt>
                <c:pt idx="2894">
                  <c:v>32042.42236328125</c:v>
                </c:pt>
                <c:pt idx="2895">
                  <c:v>32037.624481201172</c:v>
                </c:pt>
                <c:pt idx="2896">
                  <c:v>32033.540882110596</c:v>
                </c:pt>
                <c:pt idx="2897">
                  <c:v>32028.257286071777</c:v>
                </c:pt>
                <c:pt idx="2898">
                  <c:v>32020.71654510498</c:v>
                </c:pt>
                <c:pt idx="2899">
                  <c:v>32016.004377365112</c:v>
                </c:pt>
                <c:pt idx="2900">
                  <c:v>32014.749350547791</c:v>
                </c:pt>
                <c:pt idx="2901">
                  <c:v>32015.322896003723</c:v>
                </c:pt>
                <c:pt idx="2902">
                  <c:v>32020.525012969971</c:v>
                </c:pt>
                <c:pt idx="2903">
                  <c:v>32029.755701065063</c:v>
                </c:pt>
                <c:pt idx="2904">
                  <c:v>32037.414962768555</c:v>
                </c:pt>
                <c:pt idx="2905">
                  <c:v>32042.845649719238</c:v>
                </c:pt>
                <c:pt idx="2906">
                  <c:v>32050.504909515381</c:v>
                </c:pt>
                <c:pt idx="2907">
                  <c:v>32053.278453826904</c:v>
                </c:pt>
                <c:pt idx="2908">
                  <c:v>32047.852001190186</c:v>
                </c:pt>
                <c:pt idx="2909">
                  <c:v>32039.768402099609</c:v>
                </c:pt>
                <c:pt idx="2910">
                  <c:v>32040.827663421631</c:v>
                </c:pt>
                <c:pt idx="2911">
                  <c:v>32044.172637939453</c:v>
                </c:pt>
                <c:pt idx="2912">
                  <c:v>32043.546180725098</c:v>
                </c:pt>
                <c:pt idx="2913">
                  <c:v>32040.634014129639</c:v>
                </c:pt>
                <c:pt idx="2914">
                  <c:v>32044.778987884521</c:v>
                </c:pt>
                <c:pt idx="2915">
                  <c:v>32055.838245391846</c:v>
                </c:pt>
                <c:pt idx="2916">
                  <c:v>32059.583221435547</c:v>
                </c:pt>
                <c:pt idx="2917">
                  <c:v>32050.72819519043</c:v>
                </c:pt>
                <c:pt idx="2918">
                  <c:v>32043.673168182373</c:v>
                </c:pt>
                <c:pt idx="2919">
                  <c:v>32048.132427215576</c:v>
                </c:pt>
                <c:pt idx="2920">
                  <c:v>32053.791687011719</c:v>
                </c:pt>
                <c:pt idx="2921">
                  <c:v>32055.87952041626</c:v>
                </c:pt>
                <c:pt idx="2922">
                  <c:v>32059.624492645264</c:v>
                </c:pt>
                <c:pt idx="2923">
                  <c:v>32057.683753967285</c:v>
                </c:pt>
                <c:pt idx="2924">
                  <c:v>32046.343013763428</c:v>
                </c:pt>
                <c:pt idx="2925">
                  <c:v>32039.059413909912</c:v>
                </c:pt>
                <c:pt idx="2926">
                  <c:v>32043.232959747314</c:v>
                </c:pt>
                <c:pt idx="2927">
                  <c:v>32052.263648986816</c:v>
                </c:pt>
                <c:pt idx="2928">
                  <c:v>32050.408622741699</c:v>
                </c:pt>
                <c:pt idx="2929">
                  <c:v>32043.867881774902</c:v>
                </c:pt>
                <c:pt idx="2930">
                  <c:v>32044.127143859863</c:v>
                </c:pt>
                <c:pt idx="2931">
                  <c:v>32050.614974975586</c:v>
                </c:pt>
                <c:pt idx="2932">
                  <c:v>32050.53137588501</c:v>
                </c:pt>
                <c:pt idx="2933">
                  <c:v>32048.076351165771</c:v>
                </c:pt>
                <c:pt idx="2934">
                  <c:v>32052.621326446533</c:v>
                </c:pt>
                <c:pt idx="2935">
                  <c:v>32061.966297149658</c:v>
                </c:pt>
                <c:pt idx="2936">
                  <c:v>32064.99698638916</c:v>
                </c:pt>
                <c:pt idx="2937">
                  <c:v>32057.199104309082</c:v>
                </c:pt>
                <c:pt idx="2938">
                  <c:v>32049.658363342285</c:v>
                </c:pt>
                <c:pt idx="2939">
                  <c:v>32047.746192932129</c:v>
                </c:pt>
                <c:pt idx="2940">
                  <c:v>32044.17688369751</c:v>
                </c:pt>
                <c:pt idx="2941">
                  <c:v>32042.036144256592</c:v>
                </c:pt>
                <c:pt idx="2942">
                  <c:v>32047.009689331055</c:v>
                </c:pt>
                <c:pt idx="2943">
                  <c:v>32051.468948364258</c:v>
                </c:pt>
                <c:pt idx="2944">
                  <c:v>32042.64249420166</c:v>
                </c:pt>
                <c:pt idx="2945">
                  <c:v>32032.558895111084</c:v>
                </c:pt>
                <c:pt idx="2946">
                  <c:v>32032.446727752686</c:v>
                </c:pt>
                <c:pt idx="2947">
                  <c:v>32041.248844146729</c:v>
                </c:pt>
                <c:pt idx="2948">
                  <c:v>32045.13667678833</c:v>
                </c:pt>
                <c:pt idx="2949">
                  <c:v>32038.424507141113</c:v>
                </c:pt>
                <c:pt idx="2950">
                  <c:v>32033.369480133057</c:v>
                </c:pt>
                <c:pt idx="2951">
                  <c:v>32035.371597290039</c:v>
                </c:pt>
                <c:pt idx="2952">
                  <c:v>32043.830856323242</c:v>
                </c:pt>
                <c:pt idx="2953">
                  <c:v>32052.261547088623</c:v>
                </c:pt>
                <c:pt idx="2954">
                  <c:v>32065.606521606445</c:v>
                </c:pt>
                <c:pt idx="2955">
                  <c:v>32073.894348144531</c:v>
                </c:pt>
                <c:pt idx="2956">
                  <c:v>32070.125038146973</c:v>
                </c:pt>
                <c:pt idx="2957">
                  <c:v>32053.898586273193</c:v>
                </c:pt>
                <c:pt idx="2958">
                  <c:v>32040.443557739258</c:v>
                </c:pt>
                <c:pt idx="2959">
                  <c:v>32035.30281829834</c:v>
                </c:pt>
                <c:pt idx="2960">
                  <c:v>32033.533508300781</c:v>
                </c:pt>
                <c:pt idx="2961">
                  <c:v>32033.707050323486</c:v>
                </c:pt>
                <c:pt idx="2962">
                  <c:v>32039.509170532227</c:v>
                </c:pt>
                <c:pt idx="2963">
                  <c:v>32046.79700088501</c:v>
                </c:pt>
                <c:pt idx="2964">
                  <c:v>32046.170543670654</c:v>
                </c:pt>
                <c:pt idx="2965">
                  <c:v>32034.715518951416</c:v>
                </c:pt>
                <c:pt idx="2966">
                  <c:v>32025.689064025879</c:v>
                </c:pt>
                <c:pt idx="2967">
                  <c:v>32027.09118270874</c:v>
                </c:pt>
                <c:pt idx="2968">
                  <c:v>32035.150440216064</c:v>
                </c:pt>
                <c:pt idx="2969">
                  <c:v>32040.981128692627</c:v>
                </c:pt>
                <c:pt idx="2970">
                  <c:v>32042.583248138428</c:v>
                </c:pt>
                <c:pt idx="2971">
                  <c:v>32041.299648284912</c:v>
                </c:pt>
                <c:pt idx="2972">
                  <c:v>32037.387481689453</c:v>
                </c:pt>
                <c:pt idx="2973">
                  <c:v>32031.589597702026</c:v>
                </c:pt>
                <c:pt idx="2974">
                  <c:v>32027.020286560059</c:v>
                </c:pt>
                <c:pt idx="2975">
                  <c:v>32026.136688232422</c:v>
                </c:pt>
                <c:pt idx="2976">
                  <c:v>32024.910234451294</c:v>
                </c:pt>
                <c:pt idx="2977">
                  <c:v>32023.740922927856</c:v>
                </c:pt>
                <c:pt idx="2978">
                  <c:v>32024.885896682739</c:v>
                </c:pt>
                <c:pt idx="2979">
                  <c:v>32020.059440612793</c:v>
                </c:pt>
                <c:pt idx="2980">
                  <c:v>32003.604415655136</c:v>
                </c:pt>
                <c:pt idx="2981">
                  <c:v>31994.149389743805</c:v>
                </c:pt>
                <c:pt idx="2982">
                  <c:v>32010.465792655945</c:v>
                </c:pt>
                <c:pt idx="2983">
                  <c:v>32043.153621673584</c:v>
                </c:pt>
                <c:pt idx="2984">
                  <c:v>32065.527168273926</c:v>
                </c:pt>
                <c:pt idx="2985">
                  <c:v>32058.443572998047</c:v>
                </c:pt>
                <c:pt idx="2986">
                  <c:v>32035.617115020752</c:v>
                </c:pt>
                <c:pt idx="2987">
                  <c:v>32022.647804260254</c:v>
                </c:pt>
                <c:pt idx="2988">
                  <c:v>32027.678493499756</c:v>
                </c:pt>
                <c:pt idx="2989">
                  <c:v>32035.823467254639</c:v>
                </c:pt>
                <c:pt idx="2990">
                  <c:v>32043.19701385498</c:v>
                </c:pt>
                <c:pt idx="2991">
                  <c:v>32046.999130249023</c:v>
                </c:pt>
                <c:pt idx="2992">
                  <c:v>32038.115531921387</c:v>
                </c:pt>
                <c:pt idx="2993">
                  <c:v>32024.289077758789</c:v>
                </c:pt>
                <c:pt idx="2994">
                  <c:v>32019.091194152832</c:v>
                </c:pt>
                <c:pt idx="2995">
                  <c:v>32024.464740753174</c:v>
                </c:pt>
                <c:pt idx="2996">
                  <c:v>32030.095428466797</c:v>
                </c:pt>
                <c:pt idx="2997">
                  <c:v>32036.38325881958</c:v>
                </c:pt>
                <c:pt idx="2998">
                  <c:v>32036.471092224121</c:v>
                </c:pt>
                <c:pt idx="2999">
                  <c:v>32036.558921813965</c:v>
                </c:pt>
              </c:numCache>
            </c:numRef>
          </c:yVal>
          <c:smooth val="0"/>
          <c:extLst>
            <c:ext xmlns:c16="http://schemas.microsoft.com/office/drawing/2014/chart" uri="{C3380CC4-5D6E-409C-BE32-E72D297353CC}">
              <c16:uniqueId val="{00000001-951A-40BF-BA6C-3B319E7ECED3}"/>
            </c:ext>
          </c:extLst>
        </c:ser>
        <c:ser>
          <c:idx val="2"/>
          <c:order val="2"/>
          <c:tx>
            <c:v>LW RB + GlcNAc + ST3Gal1</c:v>
          </c:tx>
          <c:spPr>
            <a:ln w="19050">
              <a:solidFill>
                <a:srgbClr val="4C8613"/>
              </a:solidFill>
              <a:prstDash val="solid"/>
              <a:round/>
            </a:ln>
            <a:effectLst/>
          </c:spPr>
          <c:marker>
            <c:symbol val="none"/>
          </c:marker>
          <c:xVal>
            <c:numRef>
              <c:f>'[RB revised.xlsx]Graph Calculations'!$I$15:$DKR$15</c:f>
              <c:numCache>
                <c:formatCode>General</c:formatCode>
                <c:ptCount val="3000"/>
                <c:pt idx="0">
                  <c:v>-4.4850726127624512</c:v>
                </c:pt>
                <c:pt idx="1">
                  <c:v>-4.4834833145141602</c:v>
                </c:pt>
                <c:pt idx="2">
                  <c:v>-4.4815726280212402</c:v>
                </c:pt>
                <c:pt idx="3">
                  <c:v>-4.4793987274169922</c:v>
                </c:pt>
                <c:pt idx="4">
                  <c:v>-4.4770035743713379</c:v>
                </c:pt>
                <c:pt idx="5">
                  <c:v>-4.4744124412536621</c:v>
                </c:pt>
                <c:pt idx="6">
                  <c:v>-4.4716529846191406</c:v>
                </c:pt>
                <c:pt idx="7">
                  <c:v>-4.4687366485595703</c:v>
                </c:pt>
                <c:pt idx="8">
                  <c:v>-4.4656844139099121</c:v>
                </c:pt>
                <c:pt idx="9">
                  <c:v>-4.4625020027160645</c:v>
                </c:pt>
                <c:pt idx="10">
                  <c:v>-4.459205150604248</c:v>
                </c:pt>
                <c:pt idx="11">
                  <c:v>-4.4558072090148926</c:v>
                </c:pt>
                <c:pt idx="12">
                  <c:v>-4.4523100852966309</c:v>
                </c:pt>
                <c:pt idx="13">
                  <c:v>-4.4487299919128418</c:v>
                </c:pt>
                <c:pt idx="14">
                  <c:v>-4.4450669288635254</c:v>
                </c:pt>
                <c:pt idx="15">
                  <c:v>-4.4413328170776367</c:v>
                </c:pt>
                <c:pt idx="16">
                  <c:v>-4.4375338554382324</c:v>
                </c:pt>
                <c:pt idx="17">
                  <c:v>-4.4336695671081543</c:v>
                </c:pt>
                <c:pt idx="18">
                  <c:v>-4.429750919342041</c:v>
                </c:pt>
                <c:pt idx="19">
                  <c:v>-4.4257731437683105</c:v>
                </c:pt>
                <c:pt idx="20">
                  <c:v>-4.4217448234558105</c:v>
                </c:pt>
                <c:pt idx="21">
                  <c:v>-4.4176759719848633</c:v>
                </c:pt>
                <c:pt idx="22">
                  <c:v>-4.4135570526123047</c:v>
                </c:pt>
                <c:pt idx="23">
                  <c:v>-4.4094014167785645</c:v>
                </c:pt>
                <c:pt idx="24">
                  <c:v>-4.405205249786377</c:v>
                </c:pt>
                <c:pt idx="25">
                  <c:v>-4.4009671211242676</c:v>
                </c:pt>
                <c:pt idx="26">
                  <c:v>-4.396693229675293</c:v>
                </c:pt>
                <c:pt idx="27">
                  <c:v>-4.3923869132995605</c:v>
                </c:pt>
                <c:pt idx="28">
                  <c:v>-4.3880581855773926</c:v>
                </c:pt>
                <c:pt idx="29">
                  <c:v>-4.3836956024169922</c:v>
                </c:pt>
                <c:pt idx="30">
                  <c:v>-4.3793058395385742</c:v>
                </c:pt>
                <c:pt idx="31">
                  <c:v>-4.3748893737792969</c:v>
                </c:pt>
                <c:pt idx="32">
                  <c:v>-4.3704442977905273</c:v>
                </c:pt>
                <c:pt idx="33">
                  <c:v>-4.3659744262695313</c:v>
                </c:pt>
                <c:pt idx="34">
                  <c:v>-4.3614859580993652</c:v>
                </c:pt>
                <c:pt idx="35">
                  <c:v>-4.3569746017456055</c:v>
                </c:pt>
                <c:pt idx="36">
                  <c:v>-4.3524351119995117</c:v>
                </c:pt>
                <c:pt idx="37">
                  <c:v>-4.3478736877441406</c:v>
                </c:pt>
                <c:pt idx="38">
                  <c:v>-4.3432936668395996</c:v>
                </c:pt>
                <c:pt idx="39">
                  <c:v>-4.3386950492858887</c:v>
                </c:pt>
                <c:pt idx="40">
                  <c:v>-4.3340773582458496</c:v>
                </c:pt>
                <c:pt idx="41">
                  <c:v>-4.3294410705566406</c:v>
                </c:pt>
                <c:pt idx="42">
                  <c:v>-4.3247857093811035</c:v>
                </c:pt>
                <c:pt idx="43">
                  <c:v>-4.3201117515563965</c:v>
                </c:pt>
                <c:pt idx="44">
                  <c:v>-4.3154187202453613</c:v>
                </c:pt>
                <c:pt idx="45">
                  <c:v>-4.310706615447998</c:v>
                </c:pt>
                <c:pt idx="46">
                  <c:v>-4.3059759140014648</c:v>
                </c:pt>
                <c:pt idx="47">
                  <c:v>-4.3012266159057617</c:v>
                </c:pt>
                <c:pt idx="48">
                  <c:v>-4.2964615821838379</c:v>
                </c:pt>
                <c:pt idx="49">
                  <c:v>-4.2916855812072754</c:v>
                </c:pt>
                <c:pt idx="50">
                  <c:v>-4.2868928909301758</c:v>
                </c:pt>
                <c:pt idx="51">
                  <c:v>-4.2820835113525391</c:v>
                </c:pt>
                <c:pt idx="52">
                  <c:v>-4.2772550582885742</c:v>
                </c:pt>
                <c:pt idx="53">
                  <c:v>-4.2724113464355469</c:v>
                </c:pt>
                <c:pt idx="54">
                  <c:v>-4.2675576210021973</c:v>
                </c:pt>
                <c:pt idx="55">
                  <c:v>-4.2626876831054688</c:v>
                </c:pt>
                <c:pt idx="56">
                  <c:v>-4.2577996253967285</c:v>
                </c:pt>
                <c:pt idx="57">
                  <c:v>-4.252896785736084</c:v>
                </c:pt>
                <c:pt idx="58">
                  <c:v>-4.2479844093322754</c:v>
                </c:pt>
                <c:pt idx="59">
                  <c:v>-4.2430548667907715</c:v>
                </c:pt>
                <c:pt idx="60">
                  <c:v>-4.2381172180175781</c:v>
                </c:pt>
                <c:pt idx="61">
                  <c:v>-4.2331657409667969</c:v>
                </c:pt>
                <c:pt idx="62">
                  <c:v>-4.2281956672668457</c:v>
                </c:pt>
                <c:pt idx="63">
                  <c:v>-4.2232184410095215</c:v>
                </c:pt>
                <c:pt idx="64">
                  <c:v>-4.2182259559631348</c:v>
                </c:pt>
                <c:pt idx="65">
                  <c:v>-4.2132172584533691</c:v>
                </c:pt>
                <c:pt idx="66">
                  <c:v>-4.2082009315490723</c:v>
                </c:pt>
                <c:pt idx="67">
                  <c:v>-4.2031674385070801</c:v>
                </c:pt>
                <c:pt idx="68">
                  <c:v>-4.198124885559082</c:v>
                </c:pt>
                <c:pt idx="69">
                  <c:v>-4.1930689811706543</c:v>
                </c:pt>
                <c:pt idx="70">
                  <c:v>-4.1879992485046387</c:v>
                </c:pt>
                <c:pt idx="71">
                  <c:v>-4.1829204559326172</c:v>
                </c:pt>
                <c:pt idx="72">
                  <c:v>-4.177823543548584</c:v>
                </c:pt>
                <c:pt idx="73">
                  <c:v>-4.1727228164672852</c:v>
                </c:pt>
                <c:pt idx="74">
                  <c:v>-4.167607307434082</c:v>
                </c:pt>
                <c:pt idx="75">
                  <c:v>-4.1624846458435059</c:v>
                </c:pt>
                <c:pt idx="76">
                  <c:v>-4.1573452949523926</c:v>
                </c:pt>
                <c:pt idx="77">
                  <c:v>-4.1521992683410645</c:v>
                </c:pt>
                <c:pt idx="78">
                  <c:v>-4.1470365524291992</c:v>
                </c:pt>
                <c:pt idx="79">
                  <c:v>-4.1418681144714355</c:v>
                </c:pt>
                <c:pt idx="80">
                  <c:v>-4.136683464050293</c:v>
                </c:pt>
                <c:pt idx="81">
                  <c:v>-4.131493091583252</c:v>
                </c:pt>
                <c:pt idx="82">
                  <c:v>-4.126286506652832</c:v>
                </c:pt>
                <c:pt idx="83">
                  <c:v>-4.1210741996765137</c:v>
                </c:pt>
                <c:pt idx="84">
                  <c:v>-4.1158485412597656</c:v>
                </c:pt>
                <c:pt idx="85">
                  <c:v>-4.1106138229370117</c:v>
                </c:pt>
                <c:pt idx="86">
                  <c:v>-4.105370044708252</c:v>
                </c:pt>
                <c:pt idx="87">
                  <c:v>-4.1001129150390625</c:v>
                </c:pt>
                <c:pt idx="88">
                  <c:v>-4.0948486328125</c:v>
                </c:pt>
                <c:pt idx="89">
                  <c:v>-4.089569091796875</c:v>
                </c:pt>
                <c:pt idx="90">
                  <c:v>-4.084287166595459</c:v>
                </c:pt>
                <c:pt idx="91">
                  <c:v>-4.0789952278137207</c:v>
                </c:pt>
                <c:pt idx="92">
                  <c:v>-4.0736904144287109</c:v>
                </c:pt>
                <c:pt idx="93">
                  <c:v>-4.0683808326721191</c:v>
                </c:pt>
                <c:pt idx="94">
                  <c:v>-4.063054084777832</c:v>
                </c:pt>
                <c:pt idx="95">
                  <c:v>-4.0577225685119629</c:v>
                </c:pt>
                <c:pt idx="96">
                  <c:v>-4.0523819923400879</c:v>
                </c:pt>
                <c:pt idx="97">
                  <c:v>-4.0470285415649414</c:v>
                </c:pt>
                <c:pt idx="98">
                  <c:v>-4.0416707992553711</c:v>
                </c:pt>
                <c:pt idx="99">
                  <c:v>-4.0362973213195801</c:v>
                </c:pt>
                <c:pt idx="100">
                  <c:v>-4.0309181213378906</c:v>
                </c:pt>
                <c:pt idx="101">
                  <c:v>-4.0255322456359863</c:v>
                </c:pt>
                <c:pt idx="102">
                  <c:v>-4.0201301574707031</c:v>
                </c:pt>
                <c:pt idx="103">
                  <c:v>-4.0147247314453125</c:v>
                </c:pt>
                <c:pt idx="104">
                  <c:v>-4.009310245513916</c:v>
                </c:pt>
                <c:pt idx="105">
                  <c:v>-4.0038824081420898</c:v>
                </c:pt>
                <c:pt idx="106">
                  <c:v>-3.998450756072998</c:v>
                </c:pt>
                <c:pt idx="107">
                  <c:v>-3.9930076599121094</c:v>
                </c:pt>
                <c:pt idx="108">
                  <c:v>-3.9875540733337402</c:v>
                </c:pt>
                <c:pt idx="109">
                  <c:v>-3.9820957183837891</c:v>
                </c:pt>
                <c:pt idx="110">
                  <c:v>-3.9766263961791992</c:v>
                </c:pt>
                <c:pt idx="111">
                  <c:v>-3.9711465835571289</c:v>
                </c:pt>
                <c:pt idx="112">
                  <c:v>-3.9656634330749512</c:v>
                </c:pt>
                <c:pt idx="113">
                  <c:v>-3.960172176361084</c:v>
                </c:pt>
                <c:pt idx="114">
                  <c:v>-3.9546668529510498</c:v>
                </c:pt>
                <c:pt idx="115">
                  <c:v>-3.94915771484375</c:v>
                </c:pt>
                <c:pt idx="116">
                  <c:v>-3.943641185760498</c:v>
                </c:pt>
                <c:pt idx="117">
                  <c:v>-3.9381108283996582</c:v>
                </c:pt>
                <c:pt idx="118">
                  <c:v>-3.9325757026672363</c:v>
                </c:pt>
                <c:pt idx="119">
                  <c:v>-3.9270355701446533</c:v>
                </c:pt>
                <c:pt idx="120">
                  <c:v>-3.9214832782745361</c:v>
                </c:pt>
                <c:pt idx="121">
                  <c:v>-3.9159219264984131</c:v>
                </c:pt>
                <c:pt idx="122">
                  <c:v>-3.9103567600250244</c:v>
                </c:pt>
                <c:pt idx="123">
                  <c:v>-3.9047830104827881</c:v>
                </c:pt>
                <c:pt idx="124">
                  <c:v>-3.8991951942443848</c:v>
                </c:pt>
                <c:pt idx="125">
                  <c:v>-3.8936045169830322</c:v>
                </c:pt>
                <c:pt idx="126">
                  <c:v>-3.8880083560943604</c:v>
                </c:pt>
                <c:pt idx="127">
                  <c:v>-3.8823995590209961</c:v>
                </c:pt>
                <c:pt idx="128">
                  <c:v>-3.8767824172973633</c:v>
                </c:pt>
                <c:pt idx="129">
                  <c:v>-3.871161937713623</c:v>
                </c:pt>
                <c:pt idx="130">
                  <c:v>-3.8655345439910889</c:v>
                </c:pt>
                <c:pt idx="131">
                  <c:v>-3.859893798828125</c:v>
                </c:pt>
                <c:pt idx="132">
                  <c:v>-3.8542468547821045</c:v>
                </c:pt>
                <c:pt idx="133">
                  <c:v>-3.8485956192016602</c:v>
                </c:pt>
                <c:pt idx="134">
                  <c:v>-3.8429374694824219</c:v>
                </c:pt>
                <c:pt idx="135">
                  <c:v>-3.8372666835784912</c:v>
                </c:pt>
                <c:pt idx="136">
                  <c:v>-3.8315901756286621</c:v>
                </c:pt>
                <c:pt idx="137">
                  <c:v>-3.8259098529815674</c:v>
                </c:pt>
                <c:pt idx="138">
                  <c:v>-3.8202219009399414</c:v>
                </c:pt>
                <c:pt idx="139">
                  <c:v>-3.8145225048065186</c:v>
                </c:pt>
                <c:pt idx="140">
                  <c:v>-3.8088161945343018</c:v>
                </c:pt>
                <c:pt idx="141">
                  <c:v>-3.8031065464019775</c:v>
                </c:pt>
                <c:pt idx="142">
                  <c:v>-3.7973928451538086</c:v>
                </c:pt>
                <c:pt idx="143">
                  <c:v>-3.791672945022583</c:v>
                </c:pt>
                <c:pt idx="144">
                  <c:v>-3.7859418392181396</c:v>
                </c:pt>
                <c:pt idx="145">
                  <c:v>-3.7802023887634277</c:v>
                </c:pt>
                <c:pt idx="146">
                  <c:v>-3.7744596004486084</c:v>
                </c:pt>
                <c:pt idx="147">
                  <c:v>-3.7687110900878906</c:v>
                </c:pt>
                <c:pt idx="148">
                  <c:v>-3.7629532814025879</c:v>
                </c:pt>
                <c:pt idx="149">
                  <c:v>-3.7571845054626465</c:v>
                </c:pt>
                <c:pt idx="150">
                  <c:v>-3.7514116764068604</c:v>
                </c:pt>
                <c:pt idx="151">
                  <c:v>-3.7456340789794922</c:v>
                </c:pt>
                <c:pt idx="152">
                  <c:v>-3.7398498058319092</c:v>
                </c:pt>
                <c:pt idx="153">
                  <c:v>-3.7340545654296875</c:v>
                </c:pt>
                <c:pt idx="154">
                  <c:v>-3.7282514572143555</c:v>
                </c:pt>
                <c:pt idx="155">
                  <c:v>-3.7224454879760742</c:v>
                </c:pt>
                <c:pt idx="156">
                  <c:v>-3.7166345119476318</c:v>
                </c:pt>
                <c:pt idx="157">
                  <c:v>-3.7108180522918701</c:v>
                </c:pt>
                <c:pt idx="158">
                  <c:v>-3.7049891948699951</c:v>
                </c:pt>
                <c:pt idx="159">
                  <c:v>-3.699152946472168</c:v>
                </c:pt>
                <c:pt idx="160">
                  <c:v>-3.6933131217956543</c:v>
                </c:pt>
                <c:pt idx="161">
                  <c:v>-3.6874692440032959</c:v>
                </c:pt>
                <c:pt idx="162">
                  <c:v>-3.6816186904907227</c:v>
                </c:pt>
                <c:pt idx="163">
                  <c:v>-3.6757576465606689</c:v>
                </c:pt>
                <c:pt idx="164">
                  <c:v>-3.6698884963989258</c:v>
                </c:pt>
                <c:pt idx="165">
                  <c:v>-3.6640150547027588</c:v>
                </c:pt>
                <c:pt idx="166">
                  <c:v>-3.6581382751464844</c:v>
                </c:pt>
                <c:pt idx="167">
                  <c:v>-3.6522567272186279</c:v>
                </c:pt>
                <c:pt idx="168">
                  <c:v>-3.6463675498962402</c:v>
                </c:pt>
                <c:pt idx="169">
                  <c:v>-3.6404674053192139</c:v>
                </c:pt>
                <c:pt idx="170">
                  <c:v>-3.6345603466033936</c:v>
                </c:pt>
                <c:pt idx="171">
                  <c:v>-3.6286499500274658</c:v>
                </c:pt>
                <c:pt idx="172">
                  <c:v>-3.6227357387542725</c:v>
                </c:pt>
                <c:pt idx="173">
                  <c:v>-3.6168158054351807</c:v>
                </c:pt>
                <c:pt idx="174">
                  <c:v>-3.6108887195587158</c:v>
                </c:pt>
                <c:pt idx="175">
                  <c:v>-3.6049506664276123</c:v>
                </c:pt>
                <c:pt idx="176">
                  <c:v>-3.5990066528320313</c:v>
                </c:pt>
                <c:pt idx="177">
                  <c:v>-3.5930593013763428</c:v>
                </c:pt>
                <c:pt idx="178">
                  <c:v>-3.5871081352233887</c:v>
                </c:pt>
                <c:pt idx="179">
                  <c:v>-3.5811519622802734</c:v>
                </c:pt>
                <c:pt idx="180">
                  <c:v>-3.5751893520355225</c:v>
                </c:pt>
                <c:pt idx="181">
                  <c:v>-3.5692145824432373</c:v>
                </c:pt>
                <c:pt idx="182">
                  <c:v>-3.5632333755493164</c:v>
                </c:pt>
                <c:pt idx="183">
                  <c:v>-3.5572483539581299</c:v>
                </c:pt>
                <c:pt idx="184">
                  <c:v>-3.551260232925415</c:v>
                </c:pt>
                <c:pt idx="185">
                  <c:v>-3.5452687740325928</c:v>
                </c:pt>
                <c:pt idx="186">
                  <c:v>-3.5392739772796631</c:v>
                </c:pt>
                <c:pt idx="187">
                  <c:v>-3.5332739353179932</c:v>
                </c:pt>
                <c:pt idx="188">
                  <c:v>-3.5272679328918457</c:v>
                </c:pt>
                <c:pt idx="189">
                  <c:v>-3.5212538242340088</c:v>
                </c:pt>
                <c:pt idx="190">
                  <c:v>-3.5152297019958496</c:v>
                </c:pt>
                <c:pt idx="191">
                  <c:v>-3.5092005729675293</c:v>
                </c:pt>
                <c:pt idx="192">
                  <c:v>-3.5031683444976807</c:v>
                </c:pt>
                <c:pt idx="193">
                  <c:v>-3.4971325397491455</c:v>
                </c:pt>
                <c:pt idx="194">
                  <c:v>-3.491091251373291</c:v>
                </c:pt>
                <c:pt idx="195">
                  <c:v>-3.4850437641143799</c:v>
                </c:pt>
                <c:pt idx="196">
                  <c:v>-3.4789879322052002</c:v>
                </c:pt>
                <c:pt idx="197">
                  <c:v>-3.4729228019714355</c:v>
                </c:pt>
                <c:pt idx="198">
                  <c:v>-3.466853141784668</c:v>
                </c:pt>
                <c:pt idx="199">
                  <c:v>-3.4607799053192139</c:v>
                </c:pt>
                <c:pt idx="200">
                  <c:v>-3.4547030925750732</c:v>
                </c:pt>
                <c:pt idx="201">
                  <c:v>-3.4486210346221924</c:v>
                </c:pt>
                <c:pt idx="202">
                  <c:v>-3.4425337314605713</c:v>
                </c:pt>
                <c:pt idx="203">
                  <c:v>-3.4364404678344727</c:v>
                </c:pt>
                <c:pt idx="204">
                  <c:v>-3.4303381443023682</c:v>
                </c:pt>
                <c:pt idx="205">
                  <c:v>-3.4242274761199951</c:v>
                </c:pt>
                <c:pt idx="206">
                  <c:v>-3.4181129932403564</c:v>
                </c:pt>
                <c:pt idx="207">
                  <c:v>-3.4119951725006104</c:v>
                </c:pt>
                <c:pt idx="208">
                  <c:v>-3.4058740139007568</c:v>
                </c:pt>
                <c:pt idx="209">
                  <c:v>-3.3997480869293213</c:v>
                </c:pt>
                <c:pt idx="210">
                  <c:v>-3.3936161994934082</c:v>
                </c:pt>
                <c:pt idx="211">
                  <c:v>-3.3874790668487549</c:v>
                </c:pt>
                <c:pt idx="212">
                  <c:v>-3.3813350200653076</c:v>
                </c:pt>
                <c:pt idx="213">
                  <c:v>-3.3751823902130127</c:v>
                </c:pt>
                <c:pt idx="214">
                  <c:v>-3.3690230846405029</c:v>
                </c:pt>
                <c:pt idx="215">
                  <c:v>-3.3628604412078857</c:v>
                </c:pt>
                <c:pt idx="216">
                  <c:v>-3.3566944599151611</c:v>
                </c:pt>
                <c:pt idx="217">
                  <c:v>-3.3505246639251709</c:v>
                </c:pt>
                <c:pt idx="218">
                  <c:v>-3.3443508148193359</c:v>
                </c:pt>
                <c:pt idx="219">
                  <c:v>-3.338172435760498</c:v>
                </c:pt>
                <c:pt idx="220">
                  <c:v>-3.3319883346557617</c:v>
                </c:pt>
                <c:pt idx="221">
                  <c:v>-3.3257980346679688</c:v>
                </c:pt>
                <c:pt idx="222">
                  <c:v>-3.3195986747741699</c:v>
                </c:pt>
                <c:pt idx="223">
                  <c:v>-3.313392162322998</c:v>
                </c:pt>
                <c:pt idx="224">
                  <c:v>-3.3071811199188232</c:v>
                </c:pt>
                <c:pt idx="225">
                  <c:v>-3.300966739654541</c:v>
                </c:pt>
                <c:pt idx="226">
                  <c:v>-3.2947490215301514</c:v>
                </c:pt>
                <c:pt idx="227">
                  <c:v>-3.2885277271270752</c:v>
                </c:pt>
                <c:pt idx="228">
                  <c:v>-3.282301664352417</c:v>
                </c:pt>
                <c:pt idx="229">
                  <c:v>-3.2760710716247559</c:v>
                </c:pt>
                <c:pt idx="230">
                  <c:v>-3.2698352336883545</c:v>
                </c:pt>
                <c:pt idx="231">
                  <c:v>-3.2635927200317383</c:v>
                </c:pt>
                <c:pt idx="232">
                  <c:v>-3.2573428153991699</c:v>
                </c:pt>
                <c:pt idx="233">
                  <c:v>-3.2510864734649658</c:v>
                </c:pt>
                <c:pt idx="234">
                  <c:v>-3.2448234558105469</c:v>
                </c:pt>
                <c:pt idx="235">
                  <c:v>-3.2385571002960205</c:v>
                </c:pt>
                <c:pt idx="236">
                  <c:v>-3.2322874069213867</c:v>
                </c:pt>
                <c:pt idx="237">
                  <c:v>-3.2260141372680664</c:v>
                </c:pt>
                <c:pt idx="238">
                  <c:v>-3.2197368144989014</c:v>
                </c:pt>
                <c:pt idx="239">
                  <c:v>-3.2134547233581543</c:v>
                </c:pt>
                <c:pt idx="240">
                  <c:v>-3.2071676254272461</c:v>
                </c:pt>
                <c:pt idx="241">
                  <c:v>-3.2008757591247559</c:v>
                </c:pt>
                <c:pt idx="242">
                  <c:v>-3.1945772171020508</c:v>
                </c:pt>
                <c:pt idx="243">
                  <c:v>-3.1882710456848145</c:v>
                </c:pt>
                <c:pt idx="244">
                  <c:v>-3.1819577217102051</c:v>
                </c:pt>
                <c:pt idx="245">
                  <c:v>-3.1756396293640137</c:v>
                </c:pt>
                <c:pt idx="246">
                  <c:v>-3.1693174839019775</c:v>
                </c:pt>
                <c:pt idx="247">
                  <c:v>-3.1629922389984131</c:v>
                </c:pt>
                <c:pt idx="248">
                  <c:v>-3.1566634178161621</c:v>
                </c:pt>
                <c:pt idx="249">
                  <c:v>-3.1503305435180664</c:v>
                </c:pt>
                <c:pt idx="250">
                  <c:v>-3.143993616104126</c:v>
                </c:pt>
                <c:pt idx="251">
                  <c:v>-3.1376516819000244</c:v>
                </c:pt>
                <c:pt idx="252">
                  <c:v>-3.1313047409057617</c:v>
                </c:pt>
                <c:pt idx="253">
                  <c:v>-3.1249518394470215</c:v>
                </c:pt>
                <c:pt idx="254">
                  <c:v>-3.1185920238494873</c:v>
                </c:pt>
                <c:pt idx="255">
                  <c:v>-3.1122233867645264</c:v>
                </c:pt>
                <c:pt idx="256">
                  <c:v>-3.1058495044708252</c:v>
                </c:pt>
                <c:pt idx="257">
                  <c:v>-3.0994718074798584</c:v>
                </c:pt>
                <c:pt idx="258">
                  <c:v>-3.093090295791626</c:v>
                </c:pt>
                <c:pt idx="259">
                  <c:v>-3.0867056846618652</c:v>
                </c:pt>
                <c:pt idx="260">
                  <c:v>-3.0803172588348389</c:v>
                </c:pt>
                <c:pt idx="261">
                  <c:v>-3.0739257335662842</c:v>
                </c:pt>
                <c:pt idx="262">
                  <c:v>-3.067530632019043</c:v>
                </c:pt>
                <c:pt idx="263">
                  <c:v>-3.0611321926116943</c:v>
                </c:pt>
                <c:pt idx="264">
                  <c:v>-3.0547304153442383</c:v>
                </c:pt>
                <c:pt idx="265">
                  <c:v>-3.0483231544494629</c:v>
                </c:pt>
                <c:pt idx="266">
                  <c:v>-3.041912317276001</c:v>
                </c:pt>
                <c:pt idx="267">
                  <c:v>-3.0354962348937988</c:v>
                </c:pt>
                <c:pt idx="268">
                  <c:v>-3.029076099395752</c:v>
                </c:pt>
                <c:pt idx="269">
                  <c:v>-3.0226500034332275</c:v>
                </c:pt>
                <c:pt idx="270">
                  <c:v>-3.0162172317504883</c:v>
                </c:pt>
                <c:pt idx="271">
                  <c:v>-3.0097763538360596</c:v>
                </c:pt>
                <c:pt idx="272">
                  <c:v>-3.0033302307128906</c:v>
                </c:pt>
                <c:pt idx="273">
                  <c:v>-2.9968793392181396</c:v>
                </c:pt>
                <c:pt idx="274">
                  <c:v>-2.990424633026123</c:v>
                </c:pt>
                <c:pt idx="275">
                  <c:v>-2.9839663505554199</c:v>
                </c:pt>
                <c:pt idx="276">
                  <c:v>-2.9775047302246094</c:v>
                </c:pt>
                <c:pt idx="277">
                  <c:v>-2.9710395336151123</c:v>
                </c:pt>
                <c:pt idx="278">
                  <c:v>-2.9645700454711914</c:v>
                </c:pt>
                <c:pt idx="279">
                  <c:v>-2.9580967426300049</c:v>
                </c:pt>
                <c:pt idx="280">
                  <c:v>-2.9516189098358154</c:v>
                </c:pt>
                <c:pt idx="281">
                  <c:v>-2.9451367855072021</c:v>
                </c:pt>
                <c:pt idx="282">
                  <c:v>-2.9386487007141113</c:v>
                </c:pt>
                <c:pt idx="283">
                  <c:v>-2.9321544170379639</c:v>
                </c:pt>
                <c:pt idx="284">
                  <c:v>-2.9256558418273926</c:v>
                </c:pt>
                <c:pt idx="285">
                  <c:v>-2.9191486835479736</c:v>
                </c:pt>
                <c:pt idx="286">
                  <c:v>-2.9126367568969727</c:v>
                </c:pt>
                <c:pt idx="287">
                  <c:v>-2.9061193466186523</c:v>
                </c:pt>
                <c:pt idx="288">
                  <c:v>-2.8995974063873291</c:v>
                </c:pt>
                <c:pt idx="289">
                  <c:v>-2.8930721282958984</c:v>
                </c:pt>
                <c:pt idx="290">
                  <c:v>-2.8865435123443604</c:v>
                </c:pt>
                <c:pt idx="291">
                  <c:v>-2.8800110816955566</c:v>
                </c:pt>
                <c:pt idx="292">
                  <c:v>-2.8734755516052246</c:v>
                </c:pt>
                <c:pt idx="293">
                  <c:v>-2.8669345378875732</c:v>
                </c:pt>
                <c:pt idx="294">
                  <c:v>-2.8603901863098145</c:v>
                </c:pt>
                <c:pt idx="295">
                  <c:v>-2.8538413047790527</c:v>
                </c:pt>
                <c:pt idx="296">
                  <c:v>-2.8472874164581299</c:v>
                </c:pt>
                <c:pt idx="297">
                  <c:v>-2.8407282829284668</c:v>
                </c:pt>
                <c:pt idx="298">
                  <c:v>-2.8341643810272217</c:v>
                </c:pt>
                <c:pt idx="299">
                  <c:v>-2.8275926113128662</c:v>
                </c:pt>
                <c:pt idx="300">
                  <c:v>-2.8210163116455078</c:v>
                </c:pt>
                <c:pt idx="301">
                  <c:v>-2.8144330978393555</c:v>
                </c:pt>
                <c:pt idx="302">
                  <c:v>-2.8078444004058838</c:v>
                </c:pt>
                <c:pt idx="303">
                  <c:v>-2.8012521266937256</c:v>
                </c:pt>
                <c:pt idx="304">
                  <c:v>-2.7946560382843018</c:v>
                </c:pt>
                <c:pt idx="305">
                  <c:v>-2.7880561351776123</c:v>
                </c:pt>
                <c:pt idx="306">
                  <c:v>-2.7814528942108154</c:v>
                </c:pt>
                <c:pt idx="307">
                  <c:v>-2.774846076965332</c:v>
                </c:pt>
                <c:pt idx="308">
                  <c:v>-2.768235445022583</c:v>
                </c:pt>
                <c:pt idx="309">
                  <c:v>-2.7616207599639893</c:v>
                </c:pt>
                <c:pt idx="310">
                  <c:v>-2.7550017833709717</c:v>
                </c:pt>
                <c:pt idx="311">
                  <c:v>-2.7483785152435303</c:v>
                </c:pt>
                <c:pt idx="312">
                  <c:v>-2.7417497634887695</c:v>
                </c:pt>
                <c:pt idx="313">
                  <c:v>-2.7351160049438477</c:v>
                </c:pt>
                <c:pt idx="314">
                  <c:v>-2.7284765243530273</c:v>
                </c:pt>
                <c:pt idx="315">
                  <c:v>-2.7218286991119385</c:v>
                </c:pt>
                <c:pt idx="316">
                  <c:v>-2.7151768207550049</c:v>
                </c:pt>
                <c:pt idx="317">
                  <c:v>-2.7085189819335938</c:v>
                </c:pt>
                <c:pt idx="318">
                  <c:v>-2.7018556594848633</c:v>
                </c:pt>
                <c:pt idx="319">
                  <c:v>-2.6951885223388672</c:v>
                </c:pt>
                <c:pt idx="320">
                  <c:v>-2.6885175704956055</c:v>
                </c:pt>
                <c:pt idx="321">
                  <c:v>-2.6818430423736572</c:v>
                </c:pt>
                <c:pt idx="322">
                  <c:v>-2.6751651763916016</c:v>
                </c:pt>
                <c:pt idx="323">
                  <c:v>-2.6684839725494385</c:v>
                </c:pt>
                <c:pt idx="324">
                  <c:v>-2.6617987155914307</c:v>
                </c:pt>
                <c:pt idx="325">
                  <c:v>-2.6551101207733154</c:v>
                </c:pt>
                <c:pt idx="326">
                  <c:v>-2.6484169960021973</c:v>
                </c:pt>
                <c:pt idx="327">
                  <c:v>-2.6417200565338135</c:v>
                </c:pt>
                <c:pt idx="328">
                  <c:v>-2.6350188255310059</c:v>
                </c:pt>
                <c:pt idx="329">
                  <c:v>-2.6283130645751953</c:v>
                </c:pt>
                <c:pt idx="330">
                  <c:v>-2.6216020584106445</c:v>
                </c:pt>
                <c:pt idx="331">
                  <c:v>-2.6148879528045654</c:v>
                </c:pt>
                <c:pt idx="332">
                  <c:v>-2.6081645488739014</c:v>
                </c:pt>
                <c:pt idx="333">
                  <c:v>-2.6014358997344971</c:v>
                </c:pt>
                <c:pt idx="334">
                  <c:v>-2.5946998596191406</c:v>
                </c:pt>
                <c:pt idx="335">
                  <c:v>-2.587958812713623</c:v>
                </c:pt>
                <c:pt idx="336">
                  <c:v>-2.5812137126922607</c:v>
                </c:pt>
                <c:pt idx="337">
                  <c:v>-2.5744643211364746</c:v>
                </c:pt>
                <c:pt idx="338">
                  <c:v>-2.5677111148834229</c:v>
                </c:pt>
                <c:pt idx="339">
                  <c:v>-2.5609545707702637</c:v>
                </c:pt>
                <c:pt idx="340">
                  <c:v>-2.554194450378418</c:v>
                </c:pt>
                <c:pt idx="341">
                  <c:v>-2.5474305152893066</c:v>
                </c:pt>
                <c:pt idx="342">
                  <c:v>-2.5406632423400879</c:v>
                </c:pt>
                <c:pt idx="343">
                  <c:v>-2.5338926315307617</c:v>
                </c:pt>
                <c:pt idx="344">
                  <c:v>-2.5271179676055908</c:v>
                </c:pt>
                <c:pt idx="345">
                  <c:v>-2.5203382968902588</c:v>
                </c:pt>
                <c:pt idx="346">
                  <c:v>-2.5135540962219238</c:v>
                </c:pt>
                <c:pt idx="347">
                  <c:v>-2.5067670345306396</c:v>
                </c:pt>
                <c:pt idx="348">
                  <c:v>-2.4999749660491943</c:v>
                </c:pt>
                <c:pt idx="349">
                  <c:v>-2.4931795597076416</c:v>
                </c:pt>
                <c:pt idx="350">
                  <c:v>-2.4863796234130859</c:v>
                </c:pt>
                <c:pt idx="351">
                  <c:v>-2.4795753955841064</c:v>
                </c:pt>
                <c:pt idx="352">
                  <c:v>-2.4727659225463867</c:v>
                </c:pt>
                <c:pt idx="353">
                  <c:v>-2.4659509658813477</c:v>
                </c:pt>
                <c:pt idx="354">
                  <c:v>-2.4591305255889893</c:v>
                </c:pt>
                <c:pt idx="355">
                  <c:v>-2.4523036479949951</c:v>
                </c:pt>
                <c:pt idx="356">
                  <c:v>-2.445472240447998</c:v>
                </c:pt>
                <c:pt idx="357">
                  <c:v>-2.4386353492736816</c:v>
                </c:pt>
                <c:pt idx="358">
                  <c:v>-2.4317939281463623</c:v>
                </c:pt>
                <c:pt idx="359">
                  <c:v>-2.4249491691589355</c:v>
                </c:pt>
                <c:pt idx="360">
                  <c:v>-2.4180996417999268</c:v>
                </c:pt>
                <c:pt idx="361">
                  <c:v>-2.4112465381622314</c:v>
                </c:pt>
                <c:pt idx="362">
                  <c:v>-2.4043896198272705</c:v>
                </c:pt>
                <c:pt idx="363">
                  <c:v>-2.397529125213623</c:v>
                </c:pt>
                <c:pt idx="364">
                  <c:v>-2.3906650543212891</c:v>
                </c:pt>
                <c:pt idx="365">
                  <c:v>-2.3837976455688477</c:v>
                </c:pt>
                <c:pt idx="366">
                  <c:v>-2.3769264221191406</c:v>
                </c:pt>
                <c:pt idx="367">
                  <c:v>-2.3700516223907471</c:v>
                </c:pt>
                <c:pt idx="368">
                  <c:v>-2.3631737232208252</c:v>
                </c:pt>
                <c:pt idx="369">
                  <c:v>-2.3562917709350586</c:v>
                </c:pt>
                <c:pt idx="370">
                  <c:v>-2.3494064807891846</c:v>
                </c:pt>
                <c:pt idx="371">
                  <c:v>-2.3425166606903076</c:v>
                </c:pt>
                <c:pt idx="372">
                  <c:v>-2.3356239795684814</c:v>
                </c:pt>
                <c:pt idx="373">
                  <c:v>-2.3287267684936523</c:v>
                </c:pt>
                <c:pt idx="374">
                  <c:v>-2.3218250274658203</c:v>
                </c:pt>
                <c:pt idx="375">
                  <c:v>-2.3149192333221436</c:v>
                </c:pt>
                <c:pt idx="376">
                  <c:v>-2.3080089092254639</c:v>
                </c:pt>
                <c:pt idx="377">
                  <c:v>-2.3010964393615723</c:v>
                </c:pt>
                <c:pt idx="378">
                  <c:v>-2.2941772937774658</c:v>
                </c:pt>
                <c:pt idx="379">
                  <c:v>-2.2872545719146729</c:v>
                </c:pt>
                <c:pt idx="380">
                  <c:v>-2.2803261280059814</c:v>
                </c:pt>
                <c:pt idx="381">
                  <c:v>-2.2733936309814453</c:v>
                </c:pt>
                <c:pt idx="382">
                  <c:v>-2.2664575576782227</c:v>
                </c:pt>
                <c:pt idx="383">
                  <c:v>-2.2595160007476807</c:v>
                </c:pt>
                <c:pt idx="384">
                  <c:v>-2.2525696754455566</c:v>
                </c:pt>
                <c:pt idx="385">
                  <c:v>-2.2456161975860596</c:v>
                </c:pt>
                <c:pt idx="386">
                  <c:v>-2.2386586666107178</c:v>
                </c:pt>
                <c:pt idx="387">
                  <c:v>-2.2316963672637939</c:v>
                </c:pt>
                <c:pt idx="388">
                  <c:v>-2.2247288227081299</c:v>
                </c:pt>
                <c:pt idx="389">
                  <c:v>-2.2177584171295166</c:v>
                </c:pt>
                <c:pt idx="390">
                  <c:v>-2.2107832431793213</c:v>
                </c:pt>
                <c:pt idx="391">
                  <c:v>-2.2038040161132813</c:v>
                </c:pt>
                <c:pt idx="392">
                  <c:v>-2.1968214511871338</c:v>
                </c:pt>
                <c:pt idx="393">
                  <c:v>-2.1898353099822998</c:v>
                </c:pt>
                <c:pt idx="394">
                  <c:v>-2.1828455924987793</c:v>
                </c:pt>
                <c:pt idx="395">
                  <c:v>-2.1758520603179932</c:v>
                </c:pt>
                <c:pt idx="396">
                  <c:v>-2.1688554286956787</c:v>
                </c:pt>
                <c:pt idx="397">
                  <c:v>-2.1618547439575195</c:v>
                </c:pt>
                <c:pt idx="398">
                  <c:v>-2.1548504829406738</c:v>
                </c:pt>
                <c:pt idx="399">
                  <c:v>-2.1478431224822998</c:v>
                </c:pt>
                <c:pt idx="400">
                  <c:v>-2.1408324241638184</c:v>
                </c:pt>
                <c:pt idx="401">
                  <c:v>-2.1338169574737549</c:v>
                </c:pt>
                <c:pt idx="402">
                  <c:v>-2.1267976760864258</c:v>
                </c:pt>
                <c:pt idx="403">
                  <c:v>-2.119774341583252</c:v>
                </c:pt>
                <c:pt idx="404">
                  <c:v>-2.1127457618713379</c:v>
                </c:pt>
                <c:pt idx="405">
                  <c:v>-2.1057136058807373</c:v>
                </c:pt>
                <c:pt idx="406">
                  <c:v>-2.098677396774292</c:v>
                </c:pt>
                <c:pt idx="407">
                  <c:v>-2.091637134552002</c:v>
                </c:pt>
                <c:pt idx="408">
                  <c:v>-2.0845935344696045</c:v>
                </c:pt>
                <c:pt idx="409">
                  <c:v>-2.0775456428527832</c:v>
                </c:pt>
                <c:pt idx="410">
                  <c:v>-2.0704922676086426</c:v>
                </c:pt>
                <c:pt idx="411">
                  <c:v>-2.0634350776672363</c:v>
                </c:pt>
                <c:pt idx="412">
                  <c:v>-2.0563716888427734</c:v>
                </c:pt>
                <c:pt idx="413">
                  <c:v>-2.049302339553833</c:v>
                </c:pt>
                <c:pt idx="414">
                  <c:v>-2.0422296524047852</c:v>
                </c:pt>
                <c:pt idx="415">
                  <c:v>-2.0351505279541016</c:v>
                </c:pt>
                <c:pt idx="416">
                  <c:v>-2.0280685424804688</c:v>
                </c:pt>
                <c:pt idx="417">
                  <c:v>-2.0209805965423584</c:v>
                </c:pt>
                <c:pt idx="418">
                  <c:v>-2.0138883590698242</c:v>
                </c:pt>
                <c:pt idx="419">
                  <c:v>-2.0067915916442871</c:v>
                </c:pt>
                <c:pt idx="420">
                  <c:v>-1.9996898174285889</c:v>
                </c:pt>
                <c:pt idx="421">
                  <c:v>-1.9925847053527832</c:v>
                </c:pt>
                <c:pt idx="422">
                  <c:v>-1.9854755401611328</c:v>
                </c:pt>
                <c:pt idx="423">
                  <c:v>-1.9783629179000854</c:v>
                </c:pt>
                <c:pt idx="424">
                  <c:v>-1.9712468385696411</c:v>
                </c:pt>
                <c:pt idx="425">
                  <c:v>-1.9641270637512207</c:v>
                </c:pt>
                <c:pt idx="426">
                  <c:v>-1.9570038318634033</c:v>
                </c:pt>
                <c:pt idx="427">
                  <c:v>-1.9498769044876099</c:v>
                </c:pt>
                <c:pt idx="428">
                  <c:v>-1.9427465200424194</c:v>
                </c:pt>
                <c:pt idx="429">
                  <c:v>-1.9356125593185425</c:v>
                </c:pt>
                <c:pt idx="430">
                  <c:v>-1.9284751415252686</c:v>
                </c:pt>
                <c:pt idx="431">
                  <c:v>-1.9213340282440186</c:v>
                </c:pt>
                <c:pt idx="432">
                  <c:v>-1.9141894578933716</c:v>
                </c:pt>
                <c:pt idx="433">
                  <c:v>-1.9070409536361694</c:v>
                </c:pt>
                <c:pt idx="434">
                  <c:v>-1.8998885154724121</c:v>
                </c:pt>
                <c:pt idx="435">
                  <c:v>-1.8927326202392578</c:v>
                </c:pt>
                <c:pt idx="436">
                  <c:v>-1.8855725526809692</c:v>
                </c:pt>
                <c:pt idx="437">
                  <c:v>-1.8784083127975464</c:v>
                </c:pt>
                <c:pt idx="438">
                  <c:v>-1.8712403774261475</c:v>
                </c:pt>
                <c:pt idx="439">
                  <c:v>-1.8640686273574829</c:v>
                </c:pt>
                <c:pt idx="440">
                  <c:v>-1.856892466545105</c:v>
                </c:pt>
                <c:pt idx="441">
                  <c:v>-1.8497120141983032</c:v>
                </c:pt>
                <c:pt idx="442">
                  <c:v>-1.8425283432006836</c:v>
                </c:pt>
                <c:pt idx="443">
                  <c:v>-1.8353385925292969</c:v>
                </c:pt>
                <c:pt idx="444">
                  <c:v>-1.8281458616256714</c:v>
                </c:pt>
                <c:pt idx="445">
                  <c:v>-1.8209476470947266</c:v>
                </c:pt>
                <c:pt idx="446">
                  <c:v>-1.8137456178665161</c:v>
                </c:pt>
                <c:pt idx="447">
                  <c:v>-1.8065377473831177</c:v>
                </c:pt>
                <c:pt idx="448">
                  <c:v>-1.7993230819702148</c:v>
                </c:pt>
                <c:pt idx="449">
                  <c:v>-1.7921059131622314</c:v>
                </c:pt>
                <c:pt idx="450">
                  <c:v>-1.7848827838897705</c:v>
                </c:pt>
                <c:pt idx="451">
                  <c:v>-1.7776548862457275</c:v>
                </c:pt>
                <c:pt idx="452">
                  <c:v>-1.7704212665557861</c:v>
                </c:pt>
                <c:pt idx="453">
                  <c:v>-1.7631839513778687</c:v>
                </c:pt>
                <c:pt idx="454">
                  <c:v>-1.7559430599212646</c:v>
                </c:pt>
                <c:pt idx="455">
                  <c:v>-1.748698353767395</c:v>
                </c:pt>
                <c:pt idx="456">
                  <c:v>-1.7414497137069702</c:v>
                </c:pt>
                <c:pt idx="457">
                  <c:v>-1.7341955900192261</c:v>
                </c:pt>
                <c:pt idx="458">
                  <c:v>-1.7269382476806641</c:v>
                </c:pt>
                <c:pt idx="459">
                  <c:v>-1.7196769714355469</c:v>
                </c:pt>
                <c:pt idx="460">
                  <c:v>-1.7124121189117432</c:v>
                </c:pt>
                <c:pt idx="461">
                  <c:v>-1.7051436901092529</c:v>
                </c:pt>
                <c:pt idx="462">
                  <c:v>-1.6978716850280762</c:v>
                </c:pt>
                <c:pt idx="463">
                  <c:v>-1.6905961036682129</c:v>
                </c:pt>
                <c:pt idx="464">
                  <c:v>-1.6833169460296631</c:v>
                </c:pt>
                <c:pt idx="465">
                  <c:v>-1.6760343313217163</c:v>
                </c:pt>
                <c:pt idx="466">
                  <c:v>-1.6687480211257935</c:v>
                </c:pt>
                <c:pt idx="467">
                  <c:v>-1.6614581346511841</c:v>
                </c:pt>
                <c:pt idx="468">
                  <c:v>-1.6541647911071777</c:v>
                </c:pt>
                <c:pt idx="469">
                  <c:v>-1.6468675136566162</c:v>
                </c:pt>
                <c:pt idx="470">
                  <c:v>-1.6395663022994995</c:v>
                </c:pt>
                <c:pt idx="471">
                  <c:v>-1.6322609186172485</c:v>
                </c:pt>
                <c:pt idx="472">
                  <c:v>-1.6249516010284424</c:v>
                </c:pt>
                <c:pt idx="473">
                  <c:v>-1.6176387071609497</c:v>
                </c:pt>
                <c:pt idx="474">
                  <c:v>-1.6103205680847168</c:v>
                </c:pt>
                <c:pt idx="475">
                  <c:v>-1.6029989719390869</c:v>
                </c:pt>
                <c:pt idx="476">
                  <c:v>-1.5956724882125854</c:v>
                </c:pt>
                <c:pt idx="477">
                  <c:v>-1.5883426666259766</c:v>
                </c:pt>
                <c:pt idx="478">
                  <c:v>-1.5810080766677856</c:v>
                </c:pt>
                <c:pt idx="479">
                  <c:v>-1.5736684799194336</c:v>
                </c:pt>
                <c:pt idx="480">
                  <c:v>-1.5663257837295532</c:v>
                </c:pt>
                <c:pt idx="481">
                  <c:v>-1.5589780807495117</c:v>
                </c:pt>
                <c:pt idx="482">
                  <c:v>-1.5516262054443359</c:v>
                </c:pt>
                <c:pt idx="483">
                  <c:v>-1.5442682504653931</c:v>
                </c:pt>
                <c:pt idx="484">
                  <c:v>-1.5369079113006592</c:v>
                </c:pt>
                <c:pt idx="485">
                  <c:v>-1.5295400619506836</c:v>
                </c:pt>
                <c:pt idx="486">
                  <c:v>-1.5221693515777588</c:v>
                </c:pt>
                <c:pt idx="487">
                  <c:v>-1.5147932767868042</c:v>
                </c:pt>
                <c:pt idx="488">
                  <c:v>-1.5074124336242676</c:v>
                </c:pt>
                <c:pt idx="489">
                  <c:v>-1.5000261068344116</c:v>
                </c:pt>
                <c:pt idx="490">
                  <c:v>-1.4926354885101318</c:v>
                </c:pt>
                <c:pt idx="491">
                  <c:v>-1.485241174697876</c:v>
                </c:pt>
                <c:pt idx="492">
                  <c:v>-1.4778420925140381</c:v>
                </c:pt>
                <c:pt idx="493">
                  <c:v>-1.470439076423645</c:v>
                </c:pt>
                <c:pt idx="494">
                  <c:v>-1.4630317687988281</c:v>
                </c:pt>
                <c:pt idx="495">
                  <c:v>-1.4556212425231934</c:v>
                </c:pt>
                <c:pt idx="496">
                  <c:v>-1.4482067823410034</c:v>
                </c:pt>
                <c:pt idx="497">
                  <c:v>-1.440788745880127</c:v>
                </c:pt>
                <c:pt idx="498">
                  <c:v>-1.433367133140564</c:v>
                </c:pt>
                <c:pt idx="499">
                  <c:v>-1.4259419441223145</c:v>
                </c:pt>
                <c:pt idx="500">
                  <c:v>-1.4185131788253784</c:v>
                </c:pt>
                <c:pt idx="501">
                  <c:v>-1.4110807180404663</c:v>
                </c:pt>
                <c:pt idx="502">
                  <c:v>-1.4036448001861572</c:v>
                </c:pt>
                <c:pt idx="503">
                  <c:v>-1.3962042331695557</c:v>
                </c:pt>
                <c:pt idx="504">
                  <c:v>-1.3887600898742676</c:v>
                </c:pt>
                <c:pt idx="505">
                  <c:v>-1.3813117742538452</c:v>
                </c:pt>
                <c:pt idx="506">
                  <c:v>-1.3738604784011841</c:v>
                </c:pt>
                <c:pt idx="507">
                  <c:v>-1.3664045333862305</c:v>
                </c:pt>
                <c:pt idx="508">
                  <c:v>-1.3589441776275635</c:v>
                </c:pt>
                <c:pt idx="509">
                  <c:v>-1.3514797687530518</c:v>
                </c:pt>
                <c:pt idx="510">
                  <c:v>-1.3440104722976685</c:v>
                </c:pt>
                <c:pt idx="511">
                  <c:v>-1.3365389108657837</c:v>
                </c:pt>
                <c:pt idx="512">
                  <c:v>-1.3290618658065796</c:v>
                </c:pt>
                <c:pt idx="513">
                  <c:v>-1.3215814828872681</c:v>
                </c:pt>
                <c:pt idx="514">
                  <c:v>-1.3140958547592163</c:v>
                </c:pt>
                <c:pt idx="515">
                  <c:v>-1.3066046237945557</c:v>
                </c:pt>
                <c:pt idx="516">
                  <c:v>-1.2991101741790771</c:v>
                </c:pt>
                <c:pt idx="517">
                  <c:v>-1.2916104793548584</c:v>
                </c:pt>
                <c:pt idx="518">
                  <c:v>-1.2841042280197144</c:v>
                </c:pt>
                <c:pt idx="519">
                  <c:v>-1.2765936851501465</c:v>
                </c:pt>
                <c:pt idx="520">
                  <c:v>-1.2690790891647339</c:v>
                </c:pt>
                <c:pt idx="521">
                  <c:v>-1.2615574598312378</c:v>
                </c:pt>
                <c:pt idx="522">
                  <c:v>-1.254033088684082</c:v>
                </c:pt>
                <c:pt idx="523">
                  <c:v>-1.2465028762817383</c:v>
                </c:pt>
                <c:pt idx="524">
                  <c:v>-1.2389680147171021</c:v>
                </c:pt>
                <c:pt idx="525">
                  <c:v>-1.2314292192459106</c:v>
                </c:pt>
                <c:pt idx="526">
                  <c:v>-1.2238857746124268</c:v>
                </c:pt>
                <c:pt idx="527">
                  <c:v>-1.2163394689559937</c:v>
                </c:pt>
                <c:pt idx="528">
                  <c:v>-1.2087888717651367</c:v>
                </c:pt>
                <c:pt idx="529">
                  <c:v>-1.2012349367141724</c:v>
                </c:pt>
                <c:pt idx="530">
                  <c:v>-1.1936771869659424</c:v>
                </c:pt>
                <c:pt idx="531">
                  <c:v>-1.1861157417297363</c:v>
                </c:pt>
                <c:pt idx="532">
                  <c:v>-1.1785507202148438</c:v>
                </c:pt>
                <c:pt idx="533">
                  <c:v>-1.1709821224212646</c:v>
                </c:pt>
                <c:pt idx="534">
                  <c:v>-1.163409948348999</c:v>
                </c:pt>
                <c:pt idx="535">
                  <c:v>-1.1558334827423096</c:v>
                </c:pt>
                <c:pt idx="536">
                  <c:v>-1.1482536792755127</c:v>
                </c:pt>
                <c:pt idx="537">
                  <c:v>-1.1406704187393188</c:v>
                </c:pt>
                <c:pt idx="538">
                  <c:v>-1.1330820322036743</c:v>
                </c:pt>
                <c:pt idx="539">
                  <c:v>-1.1254901885986328</c:v>
                </c:pt>
                <c:pt idx="540">
                  <c:v>-1.1178942918777466</c:v>
                </c:pt>
                <c:pt idx="541">
                  <c:v>-1.1102938652038574</c:v>
                </c:pt>
                <c:pt idx="542">
                  <c:v>-1.1026885509490967</c:v>
                </c:pt>
                <c:pt idx="543">
                  <c:v>-1.0950791835784912</c:v>
                </c:pt>
                <c:pt idx="544">
                  <c:v>-1.0874662399291992</c:v>
                </c:pt>
                <c:pt idx="545">
                  <c:v>-1.0798490047454834</c:v>
                </c:pt>
                <c:pt idx="546">
                  <c:v>-1.0722272396087646</c:v>
                </c:pt>
                <c:pt idx="547">
                  <c:v>-1.0646017789840698</c:v>
                </c:pt>
                <c:pt idx="548">
                  <c:v>-1.0569710731506348</c:v>
                </c:pt>
                <c:pt idx="549">
                  <c:v>-1.0493366718292236</c:v>
                </c:pt>
                <c:pt idx="550">
                  <c:v>-1.0416967868804932</c:v>
                </c:pt>
                <c:pt idx="551">
                  <c:v>-1.0340515375137329</c:v>
                </c:pt>
                <c:pt idx="552">
                  <c:v>-1.0264036655426025</c:v>
                </c:pt>
                <c:pt idx="553">
                  <c:v>-1.0187498331069946</c:v>
                </c:pt>
                <c:pt idx="554">
                  <c:v>-1.0110917091369629</c:v>
                </c:pt>
                <c:pt idx="555">
                  <c:v>-1.0034276247024536</c:v>
                </c:pt>
                <c:pt idx="556">
                  <c:v>-0.99576026201248169</c:v>
                </c:pt>
                <c:pt idx="557">
                  <c:v>-0.98808658123016357</c:v>
                </c:pt>
                <c:pt idx="558">
                  <c:v>-0.98040896654129028</c:v>
                </c:pt>
                <c:pt idx="559">
                  <c:v>-0.97272801399230957</c:v>
                </c:pt>
                <c:pt idx="560">
                  <c:v>-0.96504181623458862</c:v>
                </c:pt>
                <c:pt idx="561">
                  <c:v>-0.95735299587249756</c:v>
                </c:pt>
                <c:pt idx="562">
                  <c:v>-0.94965952634811401</c:v>
                </c:pt>
                <c:pt idx="563">
                  <c:v>-0.94196242094039917</c:v>
                </c:pt>
                <c:pt idx="564">
                  <c:v>-0.93426072597503662</c:v>
                </c:pt>
                <c:pt idx="565">
                  <c:v>-0.92655575275421143</c:v>
                </c:pt>
                <c:pt idx="566">
                  <c:v>-0.9188464879989624</c:v>
                </c:pt>
                <c:pt idx="567">
                  <c:v>-0.91113460063934326</c:v>
                </c:pt>
                <c:pt idx="568">
                  <c:v>-0.90341806411743164</c:v>
                </c:pt>
                <c:pt idx="569">
                  <c:v>-0.8956979513168335</c:v>
                </c:pt>
                <c:pt idx="570">
                  <c:v>-0.88797414302825928</c:v>
                </c:pt>
                <c:pt idx="571">
                  <c:v>-0.88024681806564331</c:v>
                </c:pt>
                <c:pt idx="572">
                  <c:v>-0.87251579761505127</c:v>
                </c:pt>
                <c:pt idx="573">
                  <c:v>-0.86478120088577271</c:v>
                </c:pt>
                <c:pt idx="574">
                  <c:v>-0.85704296827316284</c:v>
                </c:pt>
                <c:pt idx="575">
                  <c:v>-0.84930115938186646</c:v>
                </c:pt>
                <c:pt idx="576">
                  <c:v>-0.84155565500259399</c:v>
                </c:pt>
                <c:pt idx="577">
                  <c:v>-0.83380657434463501</c:v>
                </c:pt>
                <c:pt idx="578">
                  <c:v>-0.8260539174079895</c:v>
                </c:pt>
                <c:pt idx="579">
                  <c:v>-0.8182976245880127</c:v>
                </c:pt>
                <c:pt idx="580">
                  <c:v>-0.81053769588470459</c:v>
                </c:pt>
                <c:pt idx="581">
                  <c:v>-0.80277413129806519</c:v>
                </c:pt>
                <c:pt idx="582">
                  <c:v>-0.79500699043273926</c:v>
                </c:pt>
                <c:pt idx="583">
                  <c:v>-0.78723621368408203</c:v>
                </c:pt>
                <c:pt idx="584">
                  <c:v>-0.77946180105209351</c:v>
                </c:pt>
                <c:pt idx="585">
                  <c:v>-0.77168381214141846</c:v>
                </c:pt>
                <c:pt idx="586">
                  <c:v>-0.76390218734741211</c:v>
                </c:pt>
                <c:pt idx="587">
                  <c:v>-0.75611728429794312</c:v>
                </c:pt>
                <c:pt idx="588">
                  <c:v>-0.74832844734191895</c:v>
                </c:pt>
                <c:pt idx="589">
                  <c:v>-0.74053633213043213</c:v>
                </c:pt>
                <c:pt idx="590">
                  <c:v>-0.73274022340774536</c:v>
                </c:pt>
                <c:pt idx="591">
                  <c:v>-0.72494053840637207</c:v>
                </c:pt>
                <c:pt idx="592">
                  <c:v>-0.71713721752166748</c:v>
                </c:pt>
                <c:pt idx="593">
                  <c:v>-0.70933133363723755</c:v>
                </c:pt>
                <c:pt idx="594">
                  <c:v>-0.70152074098587036</c:v>
                </c:pt>
                <c:pt idx="595">
                  <c:v>-0.69370764493942261</c:v>
                </c:pt>
                <c:pt idx="596">
                  <c:v>-0.68589127063751221</c:v>
                </c:pt>
                <c:pt idx="597">
                  <c:v>-0.67807161808013916</c:v>
                </c:pt>
                <c:pt idx="598">
                  <c:v>-0.67024797201156616</c:v>
                </c:pt>
                <c:pt idx="599">
                  <c:v>-0.66242212057113647</c:v>
                </c:pt>
                <c:pt idx="600">
                  <c:v>-0.65459161996841431</c:v>
                </c:pt>
                <c:pt idx="601">
                  <c:v>-0.64676058292388916</c:v>
                </c:pt>
                <c:pt idx="602">
                  <c:v>-0.63892668485641479</c:v>
                </c:pt>
                <c:pt idx="603">
                  <c:v>-0.63108915090560913</c:v>
                </c:pt>
                <c:pt idx="604">
                  <c:v>-0.6232525110244751</c:v>
                </c:pt>
                <c:pt idx="605">
                  <c:v>-0.61541467905044556</c:v>
                </c:pt>
                <c:pt idx="606">
                  <c:v>-0.60757428407669067</c:v>
                </c:pt>
                <c:pt idx="607">
                  <c:v>-0.59973198175430298</c:v>
                </c:pt>
                <c:pt idx="608">
                  <c:v>-0.59188574552536011</c:v>
                </c:pt>
                <c:pt idx="609">
                  <c:v>-0.58403629064559937</c:v>
                </c:pt>
                <c:pt idx="610">
                  <c:v>-0.57618564367294312</c:v>
                </c:pt>
                <c:pt idx="611">
                  <c:v>-0.56833279132843018</c:v>
                </c:pt>
                <c:pt idx="612">
                  <c:v>-0.56047672033309937</c:v>
                </c:pt>
                <c:pt idx="613">
                  <c:v>-0.55261701345443726</c:v>
                </c:pt>
                <c:pt idx="614">
                  <c:v>-0.54475337266921997</c:v>
                </c:pt>
                <c:pt idx="615">
                  <c:v>-0.536887526512146</c:v>
                </c:pt>
                <c:pt idx="616">
                  <c:v>-0.52901631593704224</c:v>
                </c:pt>
                <c:pt idx="617">
                  <c:v>-0.52114260196685791</c:v>
                </c:pt>
                <c:pt idx="618">
                  <c:v>-0.51326459646224976</c:v>
                </c:pt>
                <c:pt idx="619">
                  <c:v>-0.50538301467895508</c:v>
                </c:pt>
                <c:pt idx="620">
                  <c:v>-0.49749639630317688</c:v>
                </c:pt>
                <c:pt idx="621">
                  <c:v>-0.4896082878112793</c:v>
                </c:pt>
                <c:pt idx="622">
                  <c:v>-0.48171451687812805</c:v>
                </c:pt>
                <c:pt idx="623">
                  <c:v>-0.47381749749183655</c:v>
                </c:pt>
                <c:pt idx="624">
                  <c:v>-0.46591651439666748</c:v>
                </c:pt>
                <c:pt idx="625">
                  <c:v>-0.45801299810409546</c:v>
                </c:pt>
                <c:pt idx="626">
                  <c:v>-0.45010414719581604</c:v>
                </c:pt>
                <c:pt idx="627">
                  <c:v>-0.44219169020652771</c:v>
                </c:pt>
                <c:pt idx="628">
                  <c:v>-0.4342745840549469</c:v>
                </c:pt>
                <c:pt idx="629">
                  <c:v>-0.42635422945022583</c:v>
                </c:pt>
                <c:pt idx="630">
                  <c:v>-0.41842925548553467</c:v>
                </c:pt>
                <c:pt idx="631">
                  <c:v>-0.41050103306770325</c:v>
                </c:pt>
                <c:pt idx="632">
                  <c:v>-0.40256920456886292</c:v>
                </c:pt>
                <c:pt idx="633">
                  <c:v>-0.39463168382644653</c:v>
                </c:pt>
                <c:pt idx="634">
                  <c:v>-0.38669019937515259</c:v>
                </c:pt>
                <c:pt idx="635">
                  <c:v>-0.3787437379360199</c:v>
                </c:pt>
                <c:pt idx="636">
                  <c:v>-0.37079507112503052</c:v>
                </c:pt>
                <c:pt idx="637">
                  <c:v>-0.36284035444259644</c:v>
                </c:pt>
                <c:pt idx="638">
                  <c:v>-0.35488414764404297</c:v>
                </c:pt>
                <c:pt idx="639">
                  <c:v>-0.34692010283470154</c:v>
                </c:pt>
                <c:pt idx="640">
                  <c:v>-0.33895108103752136</c:v>
                </c:pt>
                <c:pt idx="641">
                  <c:v>-0.33097881078720093</c:v>
                </c:pt>
                <c:pt idx="642">
                  <c:v>-0.32300081849098206</c:v>
                </c:pt>
                <c:pt idx="643">
                  <c:v>-0.31501922011375427</c:v>
                </c:pt>
                <c:pt idx="644">
                  <c:v>-0.30703368782997131</c:v>
                </c:pt>
                <c:pt idx="645">
                  <c:v>-0.29904276132583618</c:v>
                </c:pt>
                <c:pt idx="646">
                  <c:v>-0.29104650020599365</c:v>
                </c:pt>
                <c:pt idx="647">
                  <c:v>-0.28304696083068848</c:v>
                </c:pt>
                <c:pt idx="648">
                  <c:v>-0.27504277229309082</c:v>
                </c:pt>
                <c:pt idx="649">
                  <c:v>-0.26703569293022156</c:v>
                </c:pt>
                <c:pt idx="650">
                  <c:v>-0.25902357697486877</c:v>
                </c:pt>
                <c:pt idx="651">
                  <c:v>-0.25100821256637573</c:v>
                </c:pt>
                <c:pt idx="652">
                  <c:v>-0.24298888444900513</c:v>
                </c:pt>
                <c:pt idx="653">
                  <c:v>-0.23496595025062561</c:v>
                </c:pt>
                <c:pt idx="654">
                  <c:v>-0.22693906724452972</c:v>
                </c:pt>
                <c:pt idx="655">
                  <c:v>-0.21890856325626373</c:v>
                </c:pt>
                <c:pt idx="656">
                  <c:v>-0.21087446808815002</c:v>
                </c:pt>
                <c:pt idx="657">
                  <c:v>-0.20283675193786621</c:v>
                </c:pt>
                <c:pt idx="658">
                  <c:v>-0.19479542970657349</c:v>
                </c:pt>
                <c:pt idx="659">
                  <c:v>-0.18675121665000916</c:v>
                </c:pt>
                <c:pt idx="660">
                  <c:v>-0.1787026971578598</c:v>
                </c:pt>
                <c:pt idx="661">
                  <c:v>-0.17065055668354034</c:v>
                </c:pt>
                <c:pt idx="662">
                  <c:v>-0.16259481012821198</c:v>
                </c:pt>
                <c:pt idx="663">
                  <c:v>-0.15453547239303589</c:v>
                </c:pt>
                <c:pt idx="664">
                  <c:v>-0.1464725136756897</c:v>
                </c:pt>
                <c:pt idx="665">
                  <c:v>-0.13840630650520325</c:v>
                </c:pt>
                <c:pt idx="666">
                  <c:v>-0.13033615052700043</c:v>
                </c:pt>
                <c:pt idx="667">
                  <c:v>-0.12226273119449615</c:v>
                </c:pt>
                <c:pt idx="668">
                  <c:v>-0.11418535560369492</c:v>
                </c:pt>
                <c:pt idx="669">
                  <c:v>-0.10610473155975342</c:v>
                </c:pt>
                <c:pt idx="670">
                  <c:v>-9.8020151257514954E-2</c:v>
                </c:pt>
                <c:pt idx="671">
                  <c:v>-8.9932315051555634E-2</c:v>
                </c:pt>
                <c:pt idx="672">
                  <c:v>-8.1840522587299347E-2</c:v>
                </c:pt>
                <c:pt idx="673">
                  <c:v>-7.3746554553508759E-2</c:v>
                </c:pt>
                <c:pt idx="674">
                  <c:v>-6.5647907555103302E-2</c:v>
                </c:pt>
                <c:pt idx="675">
                  <c:v>-5.7546015828847885E-2</c:v>
                </c:pt>
                <c:pt idx="676">
                  <c:v>-4.9439806491136551E-2</c:v>
                </c:pt>
                <c:pt idx="677">
                  <c:v>-4.1330348700284958E-2</c:v>
                </c:pt>
                <c:pt idx="678">
                  <c:v>-3.32169309258461E-2</c:v>
                </c:pt>
                <c:pt idx="679">
                  <c:v>-2.5099910795688629E-2</c:v>
                </c:pt>
                <c:pt idx="680">
                  <c:v>-1.6979284584522247E-2</c:v>
                </c:pt>
                <c:pt idx="681">
                  <c:v>-8.8550569489598274E-3</c:v>
                </c:pt>
                <c:pt idx="682">
                  <c:v>-7.2722556069493294E-4</c:v>
                </c:pt>
                <c:pt idx="683">
                  <c:v>7.4042091146111488E-3</c:v>
                </c:pt>
                <c:pt idx="684">
                  <c:v>1.5539247542619705E-2</c:v>
                </c:pt>
                <c:pt idx="685">
                  <c:v>2.36778873950243E-2</c:v>
                </c:pt>
                <c:pt idx="686">
                  <c:v>3.1820133328437805E-2</c:v>
                </c:pt>
                <c:pt idx="687">
                  <c:v>3.9965979754924774E-2</c:v>
                </c:pt>
                <c:pt idx="688">
                  <c:v>4.8115428537130356E-2</c:v>
                </c:pt>
                <c:pt idx="689">
                  <c:v>5.626847967505455E-2</c:v>
                </c:pt>
                <c:pt idx="690">
                  <c:v>6.4425133168697357E-2</c:v>
                </c:pt>
                <c:pt idx="691">
                  <c:v>7.2585746645927429E-2</c:v>
                </c:pt>
                <c:pt idx="692">
                  <c:v>8.0750323832035065E-2</c:v>
                </c:pt>
                <c:pt idx="693">
                  <c:v>8.8918507099151611E-2</c:v>
                </c:pt>
                <c:pt idx="694">
                  <c:v>9.7090646624565125E-2</c:v>
                </c:pt>
                <c:pt idx="695">
                  <c:v>0.1052667573094368</c:v>
                </c:pt>
                <c:pt idx="696">
                  <c:v>0.11344610154628754</c:v>
                </c:pt>
                <c:pt idx="697">
                  <c:v>0.12162940949201584</c:v>
                </c:pt>
                <c:pt idx="698">
                  <c:v>0.12981632351875305</c:v>
                </c:pt>
                <c:pt idx="699">
                  <c:v>0.13800720870494843</c:v>
                </c:pt>
                <c:pt idx="700">
                  <c:v>0.14620168507099152</c:v>
                </c:pt>
                <c:pt idx="701">
                  <c:v>0.15440048277378082</c:v>
                </c:pt>
                <c:pt idx="702">
                  <c:v>0.16260217130184174</c:v>
                </c:pt>
                <c:pt idx="703">
                  <c:v>0.17080853879451752</c:v>
                </c:pt>
                <c:pt idx="704">
                  <c:v>0.17901815474033356</c:v>
                </c:pt>
                <c:pt idx="705">
                  <c:v>0.18723209202289581</c:v>
                </c:pt>
                <c:pt idx="706">
                  <c:v>0.19544962048530579</c:v>
                </c:pt>
                <c:pt idx="707">
                  <c:v>0.20367076992988586</c:v>
                </c:pt>
                <c:pt idx="708">
                  <c:v>0.21189551055431366</c:v>
                </c:pt>
                <c:pt idx="709">
                  <c:v>0.22012349963188171</c:v>
                </c:pt>
                <c:pt idx="710">
                  <c:v>0.22835618257522583</c:v>
                </c:pt>
                <c:pt idx="711">
                  <c:v>0.23659172654151917</c:v>
                </c:pt>
                <c:pt idx="712">
                  <c:v>0.2448316216468811</c:v>
                </c:pt>
                <c:pt idx="713">
                  <c:v>0.25307402014732361</c:v>
                </c:pt>
                <c:pt idx="714">
                  <c:v>0.26132073998451233</c:v>
                </c:pt>
                <c:pt idx="715">
                  <c:v>0.26957070827484131</c:v>
                </c:pt>
                <c:pt idx="716">
                  <c:v>0.27782353758811951</c:v>
                </c:pt>
                <c:pt idx="717">
                  <c:v>0.28608071804046631</c:v>
                </c:pt>
                <c:pt idx="718">
                  <c:v>0.29434219002723694</c:v>
                </c:pt>
                <c:pt idx="719">
                  <c:v>0.30260619521141052</c:v>
                </c:pt>
                <c:pt idx="720">
                  <c:v>0.31087416410446167</c:v>
                </c:pt>
                <c:pt idx="721">
                  <c:v>0.31914573907852173</c:v>
                </c:pt>
                <c:pt idx="722">
                  <c:v>0.32742127776145935</c:v>
                </c:pt>
                <c:pt idx="723">
                  <c:v>0.33569970726966858</c:v>
                </c:pt>
                <c:pt idx="724">
                  <c:v>0.34398317337036133</c:v>
                </c:pt>
                <c:pt idx="725">
                  <c:v>0.35226914286613464</c:v>
                </c:pt>
                <c:pt idx="726">
                  <c:v>0.36055836081504822</c:v>
                </c:pt>
                <c:pt idx="727">
                  <c:v>0.36885154247283936</c:v>
                </c:pt>
                <c:pt idx="728">
                  <c:v>0.37714794278144836</c:v>
                </c:pt>
                <c:pt idx="729">
                  <c:v>0.38544833660125732</c:v>
                </c:pt>
                <c:pt idx="730">
                  <c:v>0.39375302195549011</c:v>
                </c:pt>
                <c:pt idx="731">
                  <c:v>0.40206098556518555</c:v>
                </c:pt>
                <c:pt idx="732">
                  <c:v>0.41037142276763916</c:v>
                </c:pt>
                <c:pt idx="733">
                  <c:v>0.41868582367897034</c:v>
                </c:pt>
                <c:pt idx="734">
                  <c:v>0.42700237035751343</c:v>
                </c:pt>
                <c:pt idx="735">
                  <c:v>0.43532362580299377</c:v>
                </c:pt>
                <c:pt idx="736">
                  <c:v>0.44364809989929199</c:v>
                </c:pt>
                <c:pt idx="737">
                  <c:v>0.45197582244873047</c:v>
                </c:pt>
                <c:pt idx="738">
                  <c:v>0.46030747890472412</c:v>
                </c:pt>
                <c:pt idx="739">
                  <c:v>0.46864348649978638</c:v>
                </c:pt>
                <c:pt idx="740">
                  <c:v>0.47698235511779785</c:v>
                </c:pt>
                <c:pt idx="741">
                  <c:v>0.48532554507255554</c:v>
                </c:pt>
                <c:pt idx="742">
                  <c:v>0.49367162585258484</c:v>
                </c:pt>
                <c:pt idx="743">
                  <c:v>0.5020216703414917</c:v>
                </c:pt>
                <c:pt idx="744">
                  <c:v>0.51037490367889404</c:v>
                </c:pt>
                <c:pt idx="745">
                  <c:v>0.51873248815536499</c:v>
                </c:pt>
                <c:pt idx="746">
                  <c:v>0.52709442377090454</c:v>
                </c:pt>
                <c:pt idx="747">
                  <c:v>0.53545922040939331</c:v>
                </c:pt>
                <c:pt idx="748">
                  <c:v>0.54382795095443726</c:v>
                </c:pt>
                <c:pt idx="749">
                  <c:v>0.5522003173828125</c:v>
                </c:pt>
                <c:pt idx="750">
                  <c:v>0.56057846546173096</c:v>
                </c:pt>
                <c:pt idx="751">
                  <c:v>0.56895875930786133</c:v>
                </c:pt>
                <c:pt idx="752">
                  <c:v>0.57734519243240356</c:v>
                </c:pt>
                <c:pt idx="753">
                  <c:v>0.58573454618453979</c:v>
                </c:pt>
                <c:pt idx="754">
                  <c:v>0.59412932395935059</c:v>
                </c:pt>
                <c:pt idx="755">
                  <c:v>0.6025276780128479</c:v>
                </c:pt>
                <c:pt idx="756">
                  <c:v>0.61093258857727051</c:v>
                </c:pt>
                <c:pt idx="757">
                  <c:v>0.61934041976928711</c:v>
                </c:pt>
                <c:pt idx="758">
                  <c:v>0.62775439023971558</c:v>
                </c:pt>
                <c:pt idx="759">
                  <c:v>0.63617491722106934</c:v>
                </c:pt>
                <c:pt idx="760">
                  <c:v>0.64459800720214844</c:v>
                </c:pt>
                <c:pt idx="761">
                  <c:v>0.65302687883377075</c:v>
                </c:pt>
                <c:pt idx="762">
                  <c:v>0.66145783662796021</c:v>
                </c:pt>
                <c:pt idx="763">
                  <c:v>0.66989469528198242</c:v>
                </c:pt>
                <c:pt idx="764">
                  <c:v>0.6783369779586792</c:v>
                </c:pt>
                <c:pt idx="765">
                  <c:v>0.68678325414657593</c:v>
                </c:pt>
                <c:pt idx="766">
                  <c:v>0.69523310661315918</c:v>
                </c:pt>
                <c:pt idx="767">
                  <c:v>0.70368880033493042</c:v>
                </c:pt>
                <c:pt idx="768">
                  <c:v>0.71214741468429565</c:v>
                </c:pt>
                <c:pt idx="769">
                  <c:v>0.7206110954284668</c:v>
                </c:pt>
                <c:pt idx="770">
                  <c:v>0.72907763719558716</c:v>
                </c:pt>
                <c:pt idx="771">
                  <c:v>0.73754817247390747</c:v>
                </c:pt>
                <c:pt idx="772">
                  <c:v>0.74602305889129639</c:v>
                </c:pt>
                <c:pt idx="773">
                  <c:v>0.75450193881988525</c:v>
                </c:pt>
                <c:pt idx="774">
                  <c:v>0.76298403739929199</c:v>
                </c:pt>
                <c:pt idx="775">
                  <c:v>0.77147012948989868</c:v>
                </c:pt>
                <c:pt idx="776">
                  <c:v>0.77996021509170532</c:v>
                </c:pt>
                <c:pt idx="777">
                  <c:v>0.78845387697219849</c:v>
                </c:pt>
                <c:pt idx="778">
                  <c:v>0.79695117473602295</c:v>
                </c:pt>
                <c:pt idx="779">
                  <c:v>0.80545210838317871</c:v>
                </c:pt>
                <c:pt idx="780">
                  <c:v>0.813956618309021</c:v>
                </c:pt>
                <c:pt idx="781">
                  <c:v>0.82246476411819458</c:v>
                </c:pt>
                <c:pt idx="782">
                  <c:v>0.83097648620605469</c:v>
                </c:pt>
                <c:pt idx="783">
                  <c:v>0.83949184417724609</c:v>
                </c:pt>
                <c:pt idx="784">
                  <c:v>0.84801077842712402</c:v>
                </c:pt>
                <c:pt idx="785">
                  <c:v>0.85653340816497803</c:v>
                </c:pt>
                <c:pt idx="786">
                  <c:v>0.86505955457687378</c:v>
                </c:pt>
                <c:pt idx="787">
                  <c:v>0.87358933687210083</c:v>
                </c:pt>
                <c:pt idx="788">
                  <c:v>0.88212352991104126</c:v>
                </c:pt>
                <c:pt idx="789">
                  <c:v>0.89066165685653687</c:v>
                </c:pt>
                <c:pt idx="790">
                  <c:v>0.8992045521736145</c:v>
                </c:pt>
                <c:pt idx="791">
                  <c:v>0.90775066614151001</c:v>
                </c:pt>
                <c:pt idx="792">
                  <c:v>0.91630184650421143</c:v>
                </c:pt>
                <c:pt idx="793">
                  <c:v>0.92485594749450684</c:v>
                </c:pt>
                <c:pt idx="794">
                  <c:v>0.93341439962387085</c:v>
                </c:pt>
                <c:pt idx="795">
                  <c:v>0.94197607040405273</c:v>
                </c:pt>
                <c:pt idx="796">
                  <c:v>0.95054250955581665</c:v>
                </c:pt>
                <c:pt idx="797">
                  <c:v>0.95911216735839844</c:v>
                </c:pt>
                <c:pt idx="798">
                  <c:v>0.96768730878829956</c:v>
                </c:pt>
                <c:pt idx="799">
                  <c:v>0.97626757621765137</c:v>
                </c:pt>
                <c:pt idx="800">
                  <c:v>0.98485112190246582</c:v>
                </c:pt>
                <c:pt idx="801">
                  <c:v>0.9934389591217041</c:v>
                </c:pt>
                <c:pt idx="802">
                  <c:v>1.0020312070846558</c:v>
                </c:pt>
                <c:pt idx="803">
                  <c:v>1.0106278657913208</c:v>
                </c:pt>
                <c:pt idx="804">
                  <c:v>1.0191781520843506</c:v>
                </c:pt>
                <c:pt idx="805">
                  <c:v>1.0277347564697266</c:v>
                </c:pt>
                <c:pt idx="806">
                  <c:v>1.0362931489944458</c:v>
                </c:pt>
                <c:pt idx="807">
                  <c:v>1.0448541641235352</c:v>
                </c:pt>
                <c:pt idx="808">
                  <c:v>1.053419828414917</c:v>
                </c:pt>
                <c:pt idx="809">
                  <c:v>1.0619907379150391</c:v>
                </c:pt>
                <c:pt idx="810">
                  <c:v>1.0705642700195313</c:v>
                </c:pt>
                <c:pt idx="811">
                  <c:v>1.0791442394256592</c:v>
                </c:pt>
                <c:pt idx="812">
                  <c:v>1.0877271890640259</c:v>
                </c:pt>
                <c:pt idx="813">
                  <c:v>1.0963137149810791</c:v>
                </c:pt>
                <c:pt idx="814">
                  <c:v>1.1049011945724487</c:v>
                </c:pt>
                <c:pt idx="815">
                  <c:v>1.1134933233261108</c:v>
                </c:pt>
                <c:pt idx="816">
                  <c:v>1.1220895051956177</c:v>
                </c:pt>
                <c:pt idx="817">
                  <c:v>1.1306890249252319</c:v>
                </c:pt>
                <c:pt idx="818">
                  <c:v>1.1392899751663208</c:v>
                </c:pt>
                <c:pt idx="819">
                  <c:v>1.1478947401046753</c:v>
                </c:pt>
                <c:pt idx="820">
                  <c:v>1.1565027236938477</c:v>
                </c:pt>
                <c:pt idx="821">
                  <c:v>1.1651132106781006</c:v>
                </c:pt>
                <c:pt idx="822">
                  <c:v>1.1737252473831177</c:v>
                </c:pt>
                <c:pt idx="823">
                  <c:v>1.1823405027389526</c:v>
                </c:pt>
                <c:pt idx="824">
                  <c:v>1.1909576654434204</c:v>
                </c:pt>
                <c:pt idx="825">
                  <c:v>1.1995775699615479</c:v>
                </c:pt>
                <c:pt idx="826">
                  <c:v>1.208200216293335</c:v>
                </c:pt>
                <c:pt idx="827">
                  <c:v>1.2168231010437012</c:v>
                </c:pt>
                <c:pt idx="828">
                  <c:v>1.2254494428634644</c:v>
                </c:pt>
                <c:pt idx="829">
                  <c:v>1.2340772151947021</c:v>
                </c:pt>
                <c:pt idx="830">
                  <c:v>1.2427072525024414</c:v>
                </c:pt>
                <c:pt idx="831">
                  <c:v>1.2513383626937866</c:v>
                </c:pt>
                <c:pt idx="832">
                  <c:v>1.2599716186523438</c:v>
                </c:pt>
                <c:pt idx="833">
                  <c:v>1.2686059474945068</c:v>
                </c:pt>
                <c:pt idx="834">
                  <c:v>1.2772417068481445</c:v>
                </c:pt>
                <c:pt idx="835">
                  <c:v>1.2858768701553345</c:v>
                </c:pt>
                <c:pt idx="836">
                  <c:v>1.2945150136947632</c:v>
                </c:pt>
                <c:pt idx="837">
                  <c:v>1.303153395652771</c:v>
                </c:pt>
                <c:pt idx="838">
                  <c:v>1.3117927312850952</c:v>
                </c:pt>
                <c:pt idx="839">
                  <c:v>1.3204332590103149</c:v>
                </c:pt>
                <c:pt idx="840">
                  <c:v>1.3290746212005615</c:v>
                </c:pt>
                <c:pt idx="841">
                  <c:v>1.3377163410186768</c:v>
                </c:pt>
                <c:pt idx="842">
                  <c:v>1.3463586568832397</c:v>
                </c:pt>
                <c:pt idx="843">
                  <c:v>1.3550007343292236</c:v>
                </c:pt>
                <c:pt idx="844">
                  <c:v>1.3636436462402344</c:v>
                </c:pt>
                <c:pt idx="845">
                  <c:v>1.3722858428955078</c:v>
                </c:pt>
                <c:pt idx="846">
                  <c:v>1.3809287548065186</c:v>
                </c:pt>
                <c:pt idx="847">
                  <c:v>1.3895715475082397</c:v>
                </c:pt>
                <c:pt idx="848">
                  <c:v>1.3982136249542236</c:v>
                </c:pt>
                <c:pt idx="849">
                  <c:v>1.4068566560745239</c:v>
                </c:pt>
                <c:pt idx="850">
                  <c:v>1.4154984951019287</c:v>
                </c:pt>
                <c:pt idx="851">
                  <c:v>1.4241392612457275</c:v>
                </c:pt>
                <c:pt idx="852">
                  <c:v>1.4327785968780518</c:v>
                </c:pt>
                <c:pt idx="853">
                  <c:v>1.4414176940917969</c:v>
                </c:pt>
                <c:pt idx="854">
                  <c:v>1.4500551223754883</c:v>
                </c:pt>
                <c:pt idx="855">
                  <c:v>1.4586927890777588</c:v>
                </c:pt>
                <c:pt idx="856">
                  <c:v>1.467327356338501</c:v>
                </c:pt>
                <c:pt idx="857">
                  <c:v>1.475961446762085</c:v>
                </c:pt>
                <c:pt idx="858">
                  <c:v>1.484593391418457</c:v>
                </c:pt>
                <c:pt idx="859">
                  <c:v>1.4932239055633545</c:v>
                </c:pt>
                <c:pt idx="860">
                  <c:v>1.501850962638855</c:v>
                </c:pt>
                <c:pt idx="861">
                  <c:v>1.5104790925979614</c:v>
                </c:pt>
                <c:pt idx="862">
                  <c:v>1.5191024541854858</c:v>
                </c:pt>
                <c:pt idx="863">
                  <c:v>1.5277237892150879</c:v>
                </c:pt>
                <c:pt idx="864">
                  <c:v>1.5363435745239258</c:v>
                </c:pt>
                <c:pt idx="865">
                  <c:v>1.5449603796005249</c:v>
                </c:pt>
                <c:pt idx="866">
                  <c:v>1.5535759925842285</c:v>
                </c:pt>
                <c:pt idx="867">
                  <c:v>1.5621891021728516</c:v>
                </c:pt>
                <c:pt idx="868">
                  <c:v>1.5708011388778687</c:v>
                </c:pt>
                <c:pt idx="869">
                  <c:v>1.5794103145599365</c:v>
                </c:pt>
                <c:pt idx="870">
                  <c:v>1.5880191326141357</c:v>
                </c:pt>
                <c:pt idx="871">
                  <c:v>1.5966247320175171</c:v>
                </c:pt>
                <c:pt idx="872">
                  <c:v>1.6052281856536865</c:v>
                </c:pt>
                <c:pt idx="873">
                  <c:v>1.6138296127319336</c:v>
                </c:pt>
                <c:pt idx="874">
                  <c:v>1.6224292516708374</c:v>
                </c:pt>
                <c:pt idx="875">
                  <c:v>1.6310268640518188</c:v>
                </c:pt>
                <c:pt idx="876">
                  <c:v>1.6396224498748779</c:v>
                </c:pt>
                <c:pt idx="877">
                  <c:v>1.6482152938842773</c:v>
                </c:pt>
                <c:pt idx="878">
                  <c:v>1.6568063497543335</c:v>
                </c:pt>
                <c:pt idx="879">
                  <c:v>1.6653944253921509</c:v>
                </c:pt>
                <c:pt idx="880">
                  <c:v>1.6739801168441772</c:v>
                </c:pt>
                <c:pt idx="881">
                  <c:v>1.6825635433197021</c:v>
                </c:pt>
                <c:pt idx="882">
                  <c:v>1.6911444664001465</c:v>
                </c:pt>
                <c:pt idx="883">
                  <c:v>1.6997227668762207</c:v>
                </c:pt>
                <c:pt idx="884">
                  <c:v>1.7082985639572144</c:v>
                </c:pt>
                <c:pt idx="885">
                  <c:v>1.7168716192245483</c:v>
                </c:pt>
                <c:pt idx="886">
                  <c:v>1.7254419326782227</c:v>
                </c:pt>
                <c:pt idx="887">
                  <c:v>1.7340093851089478</c:v>
                </c:pt>
                <c:pt idx="888">
                  <c:v>1.7425739765167236</c:v>
                </c:pt>
                <c:pt idx="889">
                  <c:v>1.7511354684829712</c:v>
                </c:pt>
                <c:pt idx="890">
                  <c:v>1.75969398021698</c:v>
                </c:pt>
                <c:pt idx="891">
                  <c:v>1.7682489156723022</c:v>
                </c:pt>
                <c:pt idx="892">
                  <c:v>1.776800274848938</c:v>
                </c:pt>
                <c:pt idx="893">
                  <c:v>1.7853482961654663</c:v>
                </c:pt>
                <c:pt idx="894">
                  <c:v>1.793891429901123</c:v>
                </c:pt>
                <c:pt idx="895">
                  <c:v>1.8024308681488037</c:v>
                </c:pt>
                <c:pt idx="896">
                  <c:v>1.8109673261642456</c:v>
                </c:pt>
                <c:pt idx="897">
                  <c:v>1.8194977045059204</c:v>
                </c:pt>
                <c:pt idx="898">
                  <c:v>1.828021764755249</c:v>
                </c:pt>
                <c:pt idx="899">
                  <c:v>1.8365411758422852</c:v>
                </c:pt>
                <c:pt idx="900">
                  <c:v>1.8450554609298706</c:v>
                </c:pt>
                <c:pt idx="901">
                  <c:v>1.8535641431808472</c:v>
                </c:pt>
                <c:pt idx="902">
                  <c:v>1.8620674610137939</c:v>
                </c:pt>
                <c:pt idx="903">
                  <c:v>1.8705648183822632</c:v>
                </c:pt>
                <c:pt idx="904">
                  <c:v>1.8790565729141235</c:v>
                </c:pt>
                <c:pt idx="905">
                  <c:v>1.8875422477722168</c:v>
                </c:pt>
                <c:pt idx="906">
                  <c:v>1.8960244655609131</c:v>
                </c:pt>
                <c:pt idx="907">
                  <c:v>1.9045014381408691</c:v>
                </c:pt>
                <c:pt idx="908">
                  <c:v>1.9129748344421387</c:v>
                </c:pt>
                <c:pt idx="909">
                  <c:v>1.9214414358139038</c:v>
                </c:pt>
                <c:pt idx="910">
                  <c:v>1.9299052953720093</c:v>
                </c:pt>
                <c:pt idx="911">
                  <c:v>1.9383633136749268</c:v>
                </c:pt>
                <c:pt idx="912">
                  <c:v>1.9468170404434204</c:v>
                </c:pt>
                <c:pt idx="913">
                  <c:v>1.9552652835845947</c:v>
                </c:pt>
                <c:pt idx="914">
                  <c:v>1.9637099504470825</c:v>
                </c:pt>
                <c:pt idx="915">
                  <c:v>1.9721479415893555</c:v>
                </c:pt>
                <c:pt idx="916">
                  <c:v>1.980581521987915</c:v>
                </c:pt>
                <c:pt idx="917">
                  <c:v>1.9890090227127075</c:v>
                </c:pt>
                <c:pt idx="918">
                  <c:v>1.9974318742752075</c:v>
                </c:pt>
                <c:pt idx="919">
                  <c:v>2.0058488845825195</c:v>
                </c:pt>
                <c:pt idx="920">
                  <c:v>2.0142607688903809</c:v>
                </c:pt>
                <c:pt idx="921">
                  <c:v>2.0226669311523438</c:v>
                </c:pt>
                <c:pt idx="922">
                  <c:v>2.0310688018798828</c:v>
                </c:pt>
                <c:pt idx="923">
                  <c:v>2.0394661426544189</c:v>
                </c:pt>
                <c:pt idx="924">
                  <c:v>2.047858715057373</c:v>
                </c:pt>
                <c:pt idx="925">
                  <c:v>2.0562455654144287</c:v>
                </c:pt>
                <c:pt idx="926">
                  <c:v>2.064629077911377</c:v>
                </c:pt>
                <c:pt idx="927">
                  <c:v>2.0730085372924805</c:v>
                </c:pt>
                <c:pt idx="928">
                  <c:v>2.081383228302002</c:v>
                </c:pt>
                <c:pt idx="929">
                  <c:v>2.0897519588470459</c:v>
                </c:pt>
                <c:pt idx="930">
                  <c:v>2.0981185436248779</c:v>
                </c:pt>
                <c:pt idx="931">
                  <c:v>2.1064798831939697</c:v>
                </c:pt>
                <c:pt idx="932">
                  <c:v>2.1148388385772705</c:v>
                </c:pt>
                <c:pt idx="933">
                  <c:v>2.1231935024261475</c:v>
                </c:pt>
                <c:pt idx="934">
                  <c:v>2.131544828414917</c:v>
                </c:pt>
                <c:pt idx="935">
                  <c:v>2.1398918628692627</c:v>
                </c:pt>
                <c:pt idx="936">
                  <c:v>2.1482350826263428</c:v>
                </c:pt>
                <c:pt idx="937">
                  <c:v>2.1565747261047363</c:v>
                </c:pt>
                <c:pt idx="938">
                  <c:v>2.164912223815918</c:v>
                </c:pt>
                <c:pt idx="939">
                  <c:v>2.1732461452484131</c:v>
                </c:pt>
                <c:pt idx="940">
                  <c:v>2.181577205657959</c:v>
                </c:pt>
                <c:pt idx="941">
                  <c:v>2.1899054050445557</c:v>
                </c:pt>
                <c:pt idx="942">
                  <c:v>2.1982309818267822</c:v>
                </c:pt>
                <c:pt idx="943">
                  <c:v>2.206554651260376</c:v>
                </c:pt>
                <c:pt idx="944">
                  <c:v>2.2148749828338623</c:v>
                </c:pt>
                <c:pt idx="945">
                  <c:v>2.2231926918029785</c:v>
                </c:pt>
                <c:pt idx="946">
                  <c:v>2.2315108776092529</c:v>
                </c:pt>
                <c:pt idx="947">
                  <c:v>2.2398240566253662</c:v>
                </c:pt>
                <c:pt idx="948">
                  <c:v>2.2481358051300049</c:v>
                </c:pt>
                <c:pt idx="949">
                  <c:v>2.2564456462860107</c:v>
                </c:pt>
                <c:pt idx="950">
                  <c:v>2.2647547721862793</c:v>
                </c:pt>
                <c:pt idx="951">
                  <c:v>2.2730607986450195</c:v>
                </c:pt>
                <c:pt idx="952">
                  <c:v>2.2813653945922852</c:v>
                </c:pt>
                <c:pt idx="953">
                  <c:v>2.2896697521209717</c:v>
                </c:pt>
                <c:pt idx="954">
                  <c:v>2.2979729175567627</c:v>
                </c:pt>
                <c:pt idx="955">
                  <c:v>2.3062746524810791</c:v>
                </c:pt>
                <c:pt idx="956">
                  <c:v>2.3145754337310791</c:v>
                </c:pt>
                <c:pt idx="957">
                  <c:v>2.3228745460510254</c:v>
                </c:pt>
                <c:pt idx="958">
                  <c:v>2.331174373626709</c:v>
                </c:pt>
                <c:pt idx="959">
                  <c:v>2.3394737243652344</c:v>
                </c:pt>
                <c:pt idx="960">
                  <c:v>2.3477725982666016</c:v>
                </c:pt>
                <c:pt idx="961">
                  <c:v>2.3560683727264404</c:v>
                </c:pt>
                <c:pt idx="962">
                  <c:v>2.3643655776977539</c:v>
                </c:pt>
                <c:pt idx="963">
                  <c:v>2.3726620674133301</c:v>
                </c:pt>
                <c:pt idx="964">
                  <c:v>2.3809592723846436</c:v>
                </c:pt>
                <c:pt idx="965">
                  <c:v>2.3892552852630615</c:v>
                </c:pt>
                <c:pt idx="966">
                  <c:v>2.3975508213043213</c:v>
                </c:pt>
                <c:pt idx="967">
                  <c:v>2.4058468341827393</c:v>
                </c:pt>
                <c:pt idx="968">
                  <c:v>2.4141430854797363</c:v>
                </c:pt>
                <c:pt idx="969">
                  <c:v>2.4224376678466797</c:v>
                </c:pt>
                <c:pt idx="970">
                  <c:v>2.4307351112365723</c:v>
                </c:pt>
                <c:pt idx="971">
                  <c:v>2.4390325546264648</c:v>
                </c:pt>
                <c:pt idx="972">
                  <c:v>2.4473326206207275</c:v>
                </c:pt>
                <c:pt idx="973">
                  <c:v>2.4556314945220947</c:v>
                </c:pt>
                <c:pt idx="974">
                  <c:v>2.4639320373535156</c:v>
                </c:pt>
                <c:pt idx="975">
                  <c:v>2.472233772277832</c:v>
                </c:pt>
                <c:pt idx="976">
                  <c:v>2.480536937713623</c:v>
                </c:pt>
                <c:pt idx="977">
                  <c:v>2.4888405799865723</c:v>
                </c:pt>
                <c:pt idx="978">
                  <c:v>2.4971461296081543</c:v>
                </c:pt>
                <c:pt idx="979">
                  <c:v>2.5054523944854736</c:v>
                </c:pt>
                <c:pt idx="980">
                  <c:v>2.5137612819671631</c:v>
                </c:pt>
                <c:pt idx="981">
                  <c:v>2.522071361541748</c:v>
                </c:pt>
                <c:pt idx="982">
                  <c:v>2.5303843021392822</c:v>
                </c:pt>
                <c:pt idx="983">
                  <c:v>2.5386974811553955</c:v>
                </c:pt>
                <c:pt idx="984">
                  <c:v>2.5470149517059326</c:v>
                </c:pt>
                <c:pt idx="985">
                  <c:v>2.5553333759307861</c:v>
                </c:pt>
                <c:pt idx="986">
                  <c:v>2.5636553764343262</c:v>
                </c:pt>
                <c:pt idx="987">
                  <c:v>2.5719802379608154</c:v>
                </c:pt>
                <c:pt idx="988">
                  <c:v>2.5803086757659912</c:v>
                </c:pt>
                <c:pt idx="989">
                  <c:v>2.5886402130126953</c:v>
                </c:pt>
                <c:pt idx="990">
                  <c:v>2.5969760417938232</c:v>
                </c:pt>
                <c:pt idx="991">
                  <c:v>2.6053133010864258</c:v>
                </c:pt>
                <c:pt idx="992">
                  <c:v>2.6136548519134521</c:v>
                </c:pt>
                <c:pt idx="993">
                  <c:v>2.6220004558563232</c:v>
                </c:pt>
                <c:pt idx="994">
                  <c:v>2.6303496360778809</c:v>
                </c:pt>
                <c:pt idx="995">
                  <c:v>2.6387007236480713</c:v>
                </c:pt>
                <c:pt idx="996">
                  <c:v>2.6470556259155273</c:v>
                </c:pt>
                <c:pt idx="997">
                  <c:v>2.6554141044616699</c:v>
                </c:pt>
                <c:pt idx="998">
                  <c:v>2.6637768745422363</c:v>
                </c:pt>
                <c:pt idx="999">
                  <c:v>2.6721439361572266</c:v>
                </c:pt>
                <c:pt idx="1000">
                  <c:v>2.6805157661437988</c:v>
                </c:pt>
                <c:pt idx="1001">
                  <c:v>2.6888914108276367</c:v>
                </c:pt>
                <c:pt idx="1002">
                  <c:v>2.6972720623016357</c:v>
                </c:pt>
                <c:pt idx="1003">
                  <c:v>2.7056572437286377</c:v>
                </c:pt>
                <c:pt idx="1004">
                  <c:v>2.7140464782714844</c:v>
                </c:pt>
                <c:pt idx="1005">
                  <c:v>2.7224407196044922</c:v>
                </c:pt>
                <c:pt idx="1006">
                  <c:v>2.7308404445648193</c:v>
                </c:pt>
                <c:pt idx="1007">
                  <c:v>2.7392442226409912</c:v>
                </c:pt>
                <c:pt idx="1008">
                  <c:v>2.7476530075073242</c:v>
                </c:pt>
                <c:pt idx="1009">
                  <c:v>2.7560667991638184</c:v>
                </c:pt>
                <c:pt idx="1010">
                  <c:v>2.7644863128662109</c:v>
                </c:pt>
                <c:pt idx="1011">
                  <c:v>2.7729108333587646</c:v>
                </c:pt>
                <c:pt idx="1012">
                  <c:v>2.7813413143157959</c:v>
                </c:pt>
                <c:pt idx="1013">
                  <c:v>2.789778470993042</c:v>
                </c:pt>
                <c:pt idx="1014">
                  <c:v>2.7982199192047119</c:v>
                </c:pt>
                <c:pt idx="1015">
                  <c:v>2.806666374206543</c:v>
                </c:pt>
                <c:pt idx="1016">
                  <c:v>2.8151187896728516</c:v>
                </c:pt>
                <c:pt idx="1017">
                  <c:v>2.823577880859375</c:v>
                </c:pt>
                <c:pt idx="1018">
                  <c:v>2.8320424556732178</c:v>
                </c:pt>
                <c:pt idx="1019">
                  <c:v>2.8405137062072754</c:v>
                </c:pt>
                <c:pt idx="1020">
                  <c:v>2.8489899635314941</c:v>
                </c:pt>
                <c:pt idx="1021">
                  <c:v>2.8574733734130859</c:v>
                </c:pt>
                <c:pt idx="1022">
                  <c:v>2.8659617900848389</c:v>
                </c:pt>
                <c:pt idx="1023">
                  <c:v>2.8744583129882813</c:v>
                </c:pt>
                <c:pt idx="1024">
                  <c:v>2.8829615116119385</c:v>
                </c:pt>
                <c:pt idx="1025">
                  <c:v>2.8914721012115479</c:v>
                </c:pt>
                <c:pt idx="1026">
                  <c:v>2.8999886512756348</c:v>
                </c:pt>
                <c:pt idx="1027">
                  <c:v>2.9085121154785156</c:v>
                </c:pt>
                <c:pt idx="1028">
                  <c:v>2.9170429706573486</c:v>
                </c:pt>
                <c:pt idx="1029">
                  <c:v>2.9255819320678711</c:v>
                </c:pt>
                <c:pt idx="1030">
                  <c:v>2.9341273307800293</c:v>
                </c:pt>
                <c:pt idx="1031">
                  <c:v>2.9426803588867188</c:v>
                </c:pt>
                <c:pt idx="1032">
                  <c:v>2.9512405395507813</c:v>
                </c:pt>
                <c:pt idx="1033">
                  <c:v>2.9598093032836914</c:v>
                </c:pt>
                <c:pt idx="1034">
                  <c:v>2.9683847427368164</c:v>
                </c:pt>
                <c:pt idx="1035">
                  <c:v>2.9769690036773682</c:v>
                </c:pt>
                <c:pt idx="1036">
                  <c:v>2.9855611324310303</c:v>
                </c:pt>
                <c:pt idx="1037">
                  <c:v>2.9941613674163818</c:v>
                </c:pt>
                <c:pt idx="1038">
                  <c:v>3.0027701854705811</c:v>
                </c:pt>
                <c:pt idx="1039">
                  <c:v>3.0113871097564697</c:v>
                </c:pt>
                <c:pt idx="1040">
                  <c:v>3.0200119018554688</c:v>
                </c:pt>
                <c:pt idx="1041">
                  <c:v>3.0286455154418945</c:v>
                </c:pt>
                <c:pt idx="1042">
                  <c:v>3.0372867584228516</c:v>
                </c:pt>
                <c:pt idx="1043">
                  <c:v>3.045936107635498</c:v>
                </c:pt>
                <c:pt idx="1044">
                  <c:v>3.0545940399169922</c:v>
                </c:pt>
                <c:pt idx="1045">
                  <c:v>3.0632600784301758</c:v>
                </c:pt>
                <c:pt idx="1046">
                  <c:v>3.071934700012207</c:v>
                </c:pt>
                <c:pt idx="1047">
                  <c:v>3.0806176662445068</c:v>
                </c:pt>
                <c:pt idx="1048">
                  <c:v>3.0893087387084961</c:v>
                </c:pt>
                <c:pt idx="1049">
                  <c:v>3.0980081558227539</c:v>
                </c:pt>
                <c:pt idx="1050">
                  <c:v>3.1067156791687012</c:v>
                </c:pt>
                <c:pt idx="1051">
                  <c:v>3.1154313087463379</c:v>
                </c:pt>
                <c:pt idx="1052">
                  <c:v>3.1241552829742432</c:v>
                </c:pt>
                <c:pt idx="1053">
                  <c:v>3.1328873634338379</c:v>
                </c:pt>
                <c:pt idx="1054">
                  <c:v>3.141627311706543</c:v>
                </c:pt>
                <c:pt idx="1055">
                  <c:v>3.1503758430480957</c:v>
                </c:pt>
                <c:pt idx="1056">
                  <c:v>3.1591324806213379</c:v>
                </c:pt>
                <c:pt idx="1057">
                  <c:v>3.1678974628448486</c:v>
                </c:pt>
                <c:pt idx="1058">
                  <c:v>3.1766705513000488</c:v>
                </c:pt>
                <c:pt idx="1059">
                  <c:v>3.1854517459869385</c:v>
                </c:pt>
                <c:pt idx="1060">
                  <c:v>3.1942405700683594</c:v>
                </c:pt>
                <c:pt idx="1061">
                  <c:v>3.203038215637207</c:v>
                </c:pt>
                <c:pt idx="1062">
                  <c:v>3.211843729019165</c:v>
                </c:pt>
                <c:pt idx="1063">
                  <c:v>3.2206575870513916</c:v>
                </c:pt>
                <c:pt idx="1064">
                  <c:v>3.2294795513153076</c:v>
                </c:pt>
                <c:pt idx="1065">
                  <c:v>3.2383096218109131</c:v>
                </c:pt>
                <c:pt idx="1066">
                  <c:v>3.2471480369567871</c:v>
                </c:pt>
                <c:pt idx="1067">
                  <c:v>3.2559943199157715</c:v>
                </c:pt>
                <c:pt idx="1068">
                  <c:v>3.2648487091064453</c:v>
                </c:pt>
                <c:pt idx="1069">
                  <c:v>3.2737114429473877</c:v>
                </c:pt>
                <c:pt idx="1070">
                  <c:v>3.2825820446014404</c:v>
                </c:pt>
                <c:pt idx="1071">
                  <c:v>3.2914609909057617</c:v>
                </c:pt>
                <c:pt idx="1072">
                  <c:v>3.3003478050231934</c:v>
                </c:pt>
                <c:pt idx="1073">
                  <c:v>3.3092429637908936</c:v>
                </c:pt>
                <c:pt idx="1074">
                  <c:v>3.3181459903717041</c:v>
                </c:pt>
                <c:pt idx="1075">
                  <c:v>3.3270573616027832</c:v>
                </c:pt>
                <c:pt idx="1076">
                  <c:v>3.3359766006469727</c:v>
                </c:pt>
                <c:pt idx="1077">
                  <c:v>3.3449039459228516</c:v>
                </c:pt>
                <c:pt idx="1078">
                  <c:v>3.3538393974304199</c:v>
                </c:pt>
                <c:pt idx="1079">
                  <c:v>3.3627829551696777</c:v>
                </c:pt>
                <c:pt idx="1080">
                  <c:v>3.371734619140625</c:v>
                </c:pt>
                <c:pt idx="1081">
                  <c:v>3.3806943893432617</c:v>
                </c:pt>
                <c:pt idx="1082">
                  <c:v>3.3896620273590088</c:v>
                </c:pt>
                <c:pt idx="1083">
                  <c:v>3.3986380100250244</c:v>
                </c:pt>
                <c:pt idx="1084">
                  <c:v>3.4076218605041504</c:v>
                </c:pt>
                <c:pt idx="1085">
                  <c:v>3.4166135787963867</c:v>
                </c:pt>
                <c:pt idx="1086">
                  <c:v>3.4256136417388916</c:v>
                </c:pt>
                <c:pt idx="1087">
                  <c:v>3.4346215724945068</c:v>
                </c:pt>
                <c:pt idx="1088">
                  <c:v>3.4436376094818115</c:v>
                </c:pt>
                <c:pt idx="1089">
                  <c:v>3.4526617527008057</c:v>
                </c:pt>
                <c:pt idx="1090">
                  <c:v>3.4616937637329102</c:v>
                </c:pt>
                <c:pt idx="1091">
                  <c:v>3.4707338809967041</c:v>
                </c:pt>
                <c:pt idx="1092">
                  <c:v>3.4797818660736084</c:v>
                </c:pt>
                <c:pt idx="1093">
                  <c:v>3.4888379573822021</c:v>
                </c:pt>
                <c:pt idx="1094">
                  <c:v>3.4979021549224854</c:v>
                </c:pt>
                <c:pt idx="1095">
                  <c:v>3.5069742202758789</c:v>
                </c:pt>
                <c:pt idx="1096">
                  <c:v>3.5160543918609619</c:v>
                </c:pt>
                <c:pt idx="1097">
                  <c:v>3.5251424312591553</c:v>
                </c:pt>
                <c:pt idx="1098">
                  <c:v>3.5342385768890381</c:v>
                </c:pt>
                <c:pt idx="1099">
                  <c:v>3.5433425903320313</c:v>
                </c:pt>
                <c:pt idx="1100">
                  <c:v>3.5524547100067139</c:v>
                </c:pt>
                <c:pt idx="1101">
                  <c:v>3.5615746974945068</c:v>
                </c:pt>
                <c:pt idx="1102">
                  <c:v>3.5707027912139893</c:v>
                </c:pt>
                <c:pt idx="1103">
                  <c:v>3.579838752746582</c:v>
                </c:pt>
                <c:pt idx="1104">
                  <c:v>3.5889825820922852</c:v>
                </c:pt>
                <c:pt idx="1105">
                  <c:v>3.5981345176696777</c:v>
                </c:pt>
                <c:pt idx="1106">
                  <c:v>3.6072943210601807</c:v>
                </c:pt>
                <c:pt idx="1107">
                  <c:v>3.6164619922637939</c:v>
                </c:pt>
                <c:pt idx="1108">
                  <c:v>3.6256377696990967</c:v>
                </c:pt>
                <c:pt idx="1109">
                  <c:v>3.6348214149475098</c:v>
                </c:pt>
                <c:pt idx="1110">
                  <c:v>3.6440129280090332</c:v>
                </c:pt>
                <c:pt idx="1111">
                  <c:v>3.6532125473022461</c:v>
                </c:pt>
                <c:pt idx="1112">
                  <c:v>3.6624200344085693</c:v>
                </c:pt>
                <c:pt idx="1113">
                  <c:v>3.6716353893280029</c:v>
                </c:pt>
                <c:pt idx="1114">
                  <c:v>3.6808586120605469</c:v>
                </c:pt>
                <c:pt idx="1115">
                  <c:v>3.6900897026062012</c:v>
                </c:pt>
                <c:pt idx="1116">
                  <c:v>3.6993286609649658</c:v>
                </c:pt>
                <c:pt idx="1117">
                  <c:v>3.7085757255554199</c:v>
                </c:pt>
                <c:pt idx="1118">
                  <c:v>3.7178306579589844</c:v>
                </c:pt>
                <c:pt idx="1119">
                  <c:v>3.7270934581756592</c:v>
                </c:pt>
                <c:pt idx="1120">
                  <c:v>3.7363641262054443</c:v>
                </c:pt>
                <c:pt idx="1121">
                  <c:v>3.7456426620483398</c:v>
                </c:pt>
                <c:pt idx="1122">
                  <c:v>3.7549290657043457</c:v>
                </c:pt>
                <c:pt idx="1123">
                  <c:v>3.7642233371734619</c:v>
                </c:pt>
                <c:pt idx="1124">
                  <c:v>3.7735254764556885</c:v>
                </c:pt>
                <c:pt idx="1125">
                  <c:v>3.7828354835510254</c:v>
                </c:pt>
                <c:pt idx="1126">
                  <c:v>3.7921533584594727</c:v>
                </c:pt>
                <c:pt idx="1127">
                  <c:v>3.8014791011810303</c:v>
                </c:pt>
                <c:pt idx="1128">
                  <c:v>3.8108124732971191</c:v>
                </c:pt>
                <c:pt idx="1129">
                  <c:v>3.8201539516448975</c:v>
                </c:pt>
                <c:pt idx="1130">
                  <c:v>3.8295032978057861</c:v>
                </c:pt>
                <c:pt idx="1131">
                  <c:v>3.8388602733612061</c:v>
                </c:pt>
                <c:pt idx="1132">
                  <c:v>3.8482253551483154</c:v>
                </c:pt>
                <c:pt idx="1133">
                  <c:v>3.8575980663299561</c:v>
                </c:pt>
                <c:pt idx="1134">
                  <c:v>3.866978645324707</c:v>
                </c:pt>
                <c:pt idx="1135">
                  <c:v>3.8763670921325684</c:v>
                </c:pt>
                <c:pt idx="1136">
                  <c:v>3.8857631683349609</c:v>
                </c:pt>
                <c:pt idx="1137">
                  <c:v>3.8951671123504639</c:v>
                </c:pt>
                <c:pt idx="1138">
                  <c:v>3.9045789241790771</c:v>
                </c:pt>
                <c:pt idx="1139">
                  <c:v>3.9139986038208008</c:v>
                </c:pt>
                <c:pt idx="1140">
                  <c:v>3.9234261512756348</c:v>
                </c:pt>
                <c:pt idx="1141">
                  <c:v>3.932861328125</c:v>
                </c:pt>
                <c:pt idx="1142">
                  <c:v>3.9423041343688965</c:v>
                </c:pt>
                <c:pt idx="1143">
                  <c:v>3.9517550468444824</c:v>
                </c:pt>
                <c:pt idx="1144">
                  <c:v>3.9612135887145996</c:v>
                </c:pt>
                <c:pt idx="1145">
                  <c:v>3.970679759979248</c:v>
                </c:pt>
                <c:pt idx="1146">
                  <c:v>3.9801540374755859</c:v>
                </c:pt>
                <c:pt idx="1147">
                  <c:v>3.989635705947876</c:v>
                </c:pt>
                <c:pt idx="1148">
                  <c:v>3.9991254806518555</c:v>
                </c:pt>
                <c:pt idx="1149">
                  <c:v>4.0086226463317871</c:v>
                </c:pt>
                <c:pt idx="1150">
                  <c:v>4.0181279182434082</c:v>
                </c:pt>
                <c:pt idx="1151">
                  <c:v>4.0276412963867188</c:v>
                </c:pt>
                <c:pt idx="1152">
                  <c:v>4.0371618270874023</c:v>
                </c:pt>
                <c:pt idx="1153">
                  <c:v>4.0466909408569336</c:v>
                </c:pt>
                <c:pt idx="1154">
                  <c:v>4.0562272071838379</c:v>
                </c:pt>
                <c:pt idx="1155">
                  <c:v>4.0657711029052734</c:v>
                </c:pt>
                <c:pt idx="1156">
                  <c:v>4.0753231048583984</c:v>
                </c:pt>
                <c:pt idx="1157">
                  <c:v>4.0848827362060547</c:v>
                </c:pt>
                <c:pt idx="1158">
                  <c:v>4.0944504737854004</c:v>
                </c:pt>
                <c:pt idx="1159">
                  <c:v>4.1040258407592773</c:v>
                </c:pt>
                <c:pt idx="1160">
                  <c:v>4.1136093139648438</c:v>
                </c:pt>
                <c:pt idx="1161">
                  <c:v>4.1232004165649414</c:v>
                </c:pt>
                <c:pt idx="1162">
                  <c:v>4.1327996253967285</c:v>
                </c:pt>
                <c:pt idx="1163">
                  <c:v>4.1424069404602051</c:v>
                </c:pt>
                <c:pt idx="1164">
                  <c:v>4.1520218849182129</c:v>
                </c:pt>
                <c:pt idx="1165">
                  <c:v>4.1616454124450684</c:v>
                </c:pt>
                <c:pt idx="1166">
                  <c:v>4.1712760925292969</c:v>
                </c:pt>
                <c:pt idx="1167">
                  <c:v>4.180915355682373</c:v>
                </c:pt>
                <c:pt idx="1168">
                  <c:v>4.1905622482299805</c:v>
                </c:pt>
                <c:pt idx="1169">
                  <c:v>4.2002167701721191</c:v>
                </c:pt>
                <c:pt idx="1170">
                  <c:v>4.2098793983459473</c:v>
                </c:pt>
                <c:pt idx="1171">
                  <c:v>4.2195496559143066</c:v>
                </c:pt>
                <c:pt idx="1172">
                  <c:v>4.2292284965515137</c:v>
                </c:pt>
                <c:pt idx="1173">
                  <c:v>4.2389154434204102</c:v>
                </c:pt>
                <c:pt idx="1174">
                  <c:v>4.2486100196838379</c:v>
                </c:pt>
                <c:pt idx="1175">
                  <c:v>4.2583136558532715</c:v>
                </c:pt>
                <c:pt idx="1176">
                  <c:v>4.2680239677429199</c:v>
                </c:pt>
                <c:pt idx="1177">
                  <c:v>4.2777438163757324</c:v>
                </c:pt>
                <c:pt idx="1178">
                  <c:v>4.2874712944030762</c:v>
                </c:pt>
                <c:pt idx="1179">
                  <c:v>4.2972068786621094</c:v>
                </c:pt>
                <c:pt idx="1180">
                  <c:v>4.306950569152832</c:v>
                </c:pt>
                <c:pt idx="1181">
                  <c:v>4.3167028427124023</c:v>
                </c:pt>
                <c:pt idx="1182">
                  <c:v>4.3264622688293457</c:v>
                </c:pt>
                <c:pt idx="1183">
                  <c:v>4.3362312316894531</c:v>
                </c:pt>
                <c:pt idx="1184">
                  <c:v>4.3460068702697754</c:v>
                </c:pt>
                <c:pt idx="1185">
                  <c:v>4.3557910919189453</c:v>
                </c:pt>
                <c:pt idx="1186">
                  <c:v>4.3655829429626465</c:v>
                </c:pt>
                <c:pt idx="1187">
                  <c:v>4.3753833770751953</c:v>
                </c:pt>
                <c:pt idx="1188">
                  <c:v>4.3851919174194336</c:v>
                </c:pt>
                <c:pt idx="1189">
                  <c:v>4.3950095176696777</c:v>
                </c:pt>
                <c:pt idx="1190">
                  <c:v>4.4048357009887695</c:v>
                </c:pt>
                <c:pt idx="1191">
                  <c:v>4.4146690368652344</c:v>
                </c:pt>
                <c:pt idx="1192">
                  <c:v>4.4245109558105469</c:v>
                </c:pt>
                <c:pt idx="1193">
                  <c:v>4.434361457824707</c:v>
                </c:pt>
                <c:pt idx="1194">
                  <c:v>4.4442200660705566</c:v>
                </c:pt>
                <c:pt idx="1195">
                  <c:v>4.4540872573852539</c:v>
                </c:pt>
                <c:pt idx="1196">
                  <c:v>4.4639630317687988</c:v>
                </c:pt>
                <c:pt idx="1197">
                  <c:v>4.4738473892211914</c:v>
                </c:pt>
                <c:pt idx="1198">
                  <c:v>4.4837393760681152</c:v>
                </c:pt>
                <c:pt idx="1199">
                  <c:v>4.4936399459838867</c:v>
                </c:pt>
                <c:pt idx="1200">
                  <c:v>4.5035495758056641</c:v>
                </c:pt>
                <c:pt idx="1201">
                  <c:v>4.5134668350219727</c:v>
                </c:pt>
                <c:pt idx="1202">
                  <c:v>4.5233922004699707</c:v>
                </c:pt>
                <c:pt idx="1203">
                  <c:v>4.5333261489868164</c:v>
                </c:pt>
                <c:pt idx="1204">
                  <c:v>4.5432682037353516</c:v>
                </c:pt>
                <c:pt idx="1205">
                  <c:v>4.5532188415527344</c:v>
                </c:pt>
                <c:pt idx="1206">
                  <c:v>4.5631790161132813</c:v>
                </c:pt>
                <c:pt idx="1207">
                  <c:v>4.5731453895568848</c:v>
                </c:pt>
                <c:pt idx="1208">
                  <c:v>4.5831217765808105</c:v>
                </c:pt>
                <c:pt idx="1209">
                  <c:v>4.5931053161621094</c:v>
                </c:pt>
                <c:pt idx="1210">
                  <c:v>4.6030979156494141</c:v>
                </c:pt>
                <c:pt idx="1211">
                  <c:v>4.6130986213684082</c:v>
                </c:pt>
                <c:pt idx="1212">
                  <c:v>4.6231083869934082</c:v>
                </c:pt>
                <c:pt idx="1213">
                  <c:v>4.6331257820129395</c:v>
                </c:pt>
                <c:pt idx="1214">
                  <c:v>4.6431527137756348</c:v>
                </c:pt>
                <c:pt idx="1215">
                  <c:v>4.6531872749328613</c:v>
                </c:pt>
                <c:pt idx="1216">
                  <c:v>4.663231372833252</c:v>
                </c:pt>
                <c:pt idx="1217">
                  <c:v>4.6732840538024902</c:v>
                </c:pt>
                <c:pt idx="1218">
                  <c:v>4.6833457946777344</c:v>
                </c:pt>
                <c:pt idx="1219">
                  <c:v>4.6934151649475098</c:v>
                </c:pt>
                <c:pt idx="1220">
                  <c:v>4.703493595123291</c:v>
                </c:pt>
                <c:pt idx="1221">
                  <c:v>4.7135801315307617</c:v>
                </c:pt>
                <c:pt idx="1222">
                  <c:v>4.7236757278442383</c:v>
                </c:pt>
                <c:pt idx="1223">
                  <c:v>4.7337784767150879</c:v>
                </c:pt>
                <c:pt idx="1224">
                  <c:v>4.7438907623291016</c:v>
                </c:pt>
                <c:pt idx="1225">
                  <c:v>4.7540111541748047</c:v>
                </c:pt>
                <c:pt idx="1226">
                  <c:v>4.7641420364379883</c:v>
                </c:pt>
                <c:pt idx="1227">
                  <c:v>4.7742791175842285</c:v>
                </c:pt>
                <c:pt idx="1228">
                  <c:v>4.7844271659851074</c:v>
                </c:pt>
                <c:pt idx="1229">
                  <c:v>4.7945818901062012</c:v>
                </c:pt>
                <c:pt idx="1230">
                  <c:v>4.8047456741333008</c:v>
                </c:pt>
                <c:pt idx="1231">
                  <c:v>4.8149175643920898</c:v>
                </c:pt>
                <c:pt idx="1232">
                  <c:v>4.8251008987426758</c:v>
                </c:pt>
                <c:pt idx="1233">
                  <c:v>4.8352913856506348</c:v>
                </c:pt>
                <c:pt idx="1234">
                  <c:v>4.8454904556274414</c:v>
                </c:pt>
                <c:pt idx="1235">
                  <c:v>4.8556976318359375</c:v>
                </c:pt>
                <c:pt idx="1236">
                  <c:v>4.8659138679504395</c:v>
                </c:pt>
                <c:pt idx="1237">
                  <c:v>4.8761377334594727</c:v>
                </c:pt>
                <c:pt idx="1238">
                  <c:v>4.8863720893859863</c:v>
                </c:pt>
                <c:pt idx="1239">
                  <c:v>4.8966145515441895</c:v>
                </c:pt>
                <c:pt idx="1240">
                  <c:v>4.906867504119873</c:v>
                </c:pt>
                <c:pt idx="1241">
                  <c:v>4.9171285629272461</c:v>
                </c:pt>
                <c:pt idx="1242">
                  <c:v>4.9273991584777832</c:v>
                </c:pt>
                <c:pt idx="1243">
                  <c:v>4.9376778602600098</c:v>
                </c:pt>
                <c:pt idx="1244">
                  <c:v>4.947965145111084</c:v>
                </c:pt>
                <c:pt idx="1245">
                  <c:v>4.9582610130310059</c:v>
                </c:pt>
                <c:pt idx="1246">
                  <c:v>4.9685678482055664</c:v>
                </c:pt>
                <c:pt idx="1247">
                  <c:v>4.9788827896118164</c:v>
                </c:pt>
                <c:pt idx="1248">
                  <c:v>4.9892067909240723</c:v>
                </c:pt>
                <c:pt idx="1249">
                  <c:v>4.999539852142334</c:v>
                </c:pt>
                <c:pt idx="1250">
                  <c:v>5.0098800659179688</c:v>
                </c:pt>
                <c:pt idx="1251">
                  <c:v>5.0202312469482422</c:v>
                </c:pt>
                <c:pt idx="1252">
                  <c:v>5.0305924415588379</c:v>
                </c:pt>
                <c:pt idx="1253">
                  <c:v>5.0409603118896484</c:v>
                </c:pt>
                <c:pt idx="1254">
                  <c:v>5.0513381958007813</c:v>
                </c:pt>
                <c:pt idx="1255">
                  <c:v>5.0617241859436035</c:v>
                </c:pt>
                <c:pt idx="1256">
                  <c:v>5.0721187591552734</c:v>
                </c:pt>
                <c:pt idx="1257">
                  <c:v>5.0825233459472656</c:v>
                </c:pt>
                <c:pt idx="1258">
                  <c:v>5.0929355621337891</c:v>
                </c:pt>
                <c:pt idx="1259">
                  <c:v>5.1033568382263184</c:v>
                </c:pt>
                <c:pt idx="1260">
                  <c:v>5.1137866973876953</c:v>
                </c:pt>
                <c:pt idx="1261">
                  <c:v>5.1242265701293945</c:v>
                </c:pt>
                <c:pt idx="1262">
                  <c:v>5.134671688079834</c:v>
                </c:pt>
                <c:pt idx="1263">
                  <c:v>5.1451263427734375</c:v>
                </c:pt>
                <c:pt idx="1264">
                  <c:v>5.1555871963500977</c:v>
                </c:pt>
                <c:pt idx="1265">
                  <c:v>5.1660590171813965</c:v>
                </c:pt>
                <c:pt idx="1266">
                  <c:v>5.1765365600585938</c:v>
                </c:pt>
                <c:pt idx="1267">
                  <c:v>5.1870255470275879</c:v>
                </c:pt>
                <c:pt idx="1268">
                  <c:v>5.1975235939025879</c:v>
                </c:pt>
                <c:pt idx="1269">
                  <c:v>5.2080283164978027</c:v>
                </c:pt>
                <c:pt idx="1270">
                  <c:v>5.2185401916503906</c:v>
                </c:pt>
                <c:pt idx="1271">
                  <c:v>5.2290596961975098</c:v>
                </c:pt>
                <c:pt idx="1272">
                  <c:v>5.2395877838134766</c:v>
                </c:pt>
                <c:pt idx="1273">
                  <c:v>5.2501254081726074</c:v>
                </c:pt>
                <c:pt idx="1274">
                  <c:v>5.2606692314147949</c:v>
                </c:pt>
                <c:pt idx="1275">
                  <c:v>5.2712225914001465</c:v>
                </c:pt>
                <c:pt idx="1276">
                  <c:v>5.2817821502685547</c:v>
                </c:pt>
                <c:pt idx="1277">
                  <c:v>5.2923488616943359</c:v>
                </c:pt>
                <c:pt idx="1278">
                  <c:v>5.3029255867004395</c:v>
                </c:pt>
                <c:pt idx="1279">
                  <c:v>5.3135108947753906</c:v>
                </c:pt>
                <c:pt idx="1280">
                  <c:v>5.3241024017333984</c:v>
                </c:pt>
                <c:pt idx="1281">
                  <c:v>5.3347043991088867</c:v>
                </c:pt>
                <c:pt idx="1282">
                  <c:v>5.3453121185302734</c:v>
                </c:pt>
                <c:pt idx="1283">
                  <c:v>5.3559274673461914</c:v>
                </c:pt>
                <c:pt idx="1284">
                  <c:v>5.3665509223937988</c:v>
                </c:pt>
                <c:pt idx="1285">
                  <c:v>5.3771834373474121</c:v>
                </c:pt>
                <c:pt idx="1286">
                  <c:v>5.3878211975097656</c:v>
                </c:pt>
                <c:pt idx="1287">
                  <c:v>5.3984675407409668</c:v>
                </c:pt>
                <c:pt idx="1288">
                  <c:v>5.4091224670410156</c:v>
                </c:pt>
                <c:pt idx="1289">
                  <c:v>5.4197854995727539</c:v>
                </c:pt>
                <c:pt idx="1290">
                  <c:v>5.4304542541503906</c:v>
                </c:pt>
                <c:pt idx="1291">
                  <c:v>5.4411320686340332</c:v>
                </c:pt>
                <c:pt idx="1292">
                  <c:v>5.4518160820007324</c:v>
                </c:pt>
                <c:pt idx="1293">
                  <c:v>5.4625091552734375</c:v>
                </c:pt>
                <c:pt idx="1294">
                  <c:v>5.4732089042663574</c:v>
                </c:pt>
                <c:pt idx="1295">
                  <c:v>5.483917236328125</c:v>
                </c:pt>
                <c:pt idx="1296">
                  <c:v>5.4946303367614746</c:v>
                </c:pt>
                <c:pt idx="1297">
                  <c:v>5.5053544044494629</c:v>
                </c:pt>
                <c:pt idx="1298">
                  <c:v>5.516082763671875</c:v>
                </c:pt>
                <c:pt idx="1299">
                  <c:v>5.526820182800293</c:v>
                </c:pt>
                <c:pt idx="1300">
                  <c:v>5.5375638008117676</c:v>
                </c:pt>
                <c:pt idx="1301">
                  <c:v>5.5483150482177734</c:v>
                </c:pt>
                <c:pt idx="1302">
                  <c:v>5.5590715408325195</c:v>
                </c:pt>
                <c:pt idx="1303">
                  <c:v>5.5698351860046387</c:v>
                </c:pt>
                <c:pt idx="1304">
                  <c:v>5.5806059837341309</c:v>
                </c:pt>
                <c:pt idx="1305">
                  <c:v>5.5913839340209961</c:v>
                </c:pt>
                <c:pt idx="1306">
                  <c:v>5.6021676063537598</c:v>
                </c:pt>
                <c:pt idx="1307">
                  <c:v>5.6129608154296875</c:v>
                </c:pt>
                <c:pt idx="1308">
                  <c:v>5.6237602233886719</c:v>
                </c:pt>
                <c:pt idx="1309">
                  <c:v>5.6345648765563965</c:v>
                </c:pt>
                <c:pt idx="1310">
                  <c:v>5.6453776359558105</c:v>
                </c:pt>
                <c:pt idx="1311">
                  <c:v>5.6561956405639648</c:v>
                </c:pt>
                <c:pt idx="1312">
                  <c:v>5.667020320892334</c:v>
                </c:pt>
                <c:pt idx="1313">
                  <c:v>5.6778502464294434</c:v>
                </c:pt>
                <c:pt idx="1314">
                  <c:v>5.6886858940124512</c:v>
                </c:pt>
                <c:pt idx="1315">
                  <c:v>5.699528694152832</c:v>
                </c:pt>
                <c:pt idx="1316">
                  <c:v>5.7103796005249023</c:v>
                </c:pt>
                <c:pt idx="1317">
                  <c:v>5.7212343215942383</c:v>
                </c:pt>
                <c:pt idx="1318">
                  <c:v>5.7320952415466309</c:v>
                </c:pt>
                <c:pt idx="1319">
                  <c:v>5.7429614067077637</c:v>
                </c:pt>
                <c:pt idx="1320">
                  <c:v>5.7538352012634277</c:v>
                </c:pt>
                <c:pt idx="1321">
                  <c:v>5.7647137641906738</c:v>
                </c:pt>
                <c:pt idx="1322">
                  <c:v>5.7755985260009766</c:v>
                </c:pt>
                <c:pt idx="1323">
                  <c:v>5.7864904403686523</c:v>
                </c:pt>
                <c:pt idx="1324">
                  <c:v>5.797386646270752</c:v>
                </c:pt>
                <c:pt idx="1325">
                  <c:v>5.8082890510559082</c:v>
                </c:pt>
                <c:pt idx="1326">
                  <c:v>5.8191986083984375</c:v>
                </c:pt>
                <c:pt idx="1327">
                  <c:v>5.8301124572753906</c:v>
                </c:pt>
                <c:pt idx="1328">
                  <c:v>5.8410329818725586</c:v>
                </c:pt>
                <c:pt idx="1329">
                  <c:v>5.8519597053527832</c:v>
                </c:pt>
                <c:pt idx="1330">
                  <c:v>5.8628926277160645</c:v>
                </c:pt>
                <c:pt idx="1331">
                  <c:v>5.8738303184509277</c:v>
                </c:pt>
                <c:pt idx="1332">
                  <c:v>5.8847737312316895</c:v>
                </c:pt>
                <c:pt idx="1333">
                  <c:v>5.8957223892211914</c:v>
                </c:pt>
                <c:pt idx="1334">
                  <c:v>5.9066767692565918</c:v>
                </c:pt>
                <c:pt idx="1335">
                  <c:v>5.917635440826416</c:v>
                </c:pt>
                <c:pt idx="1336">
                  <c:v>5.9285998344421387</c:v>
                </c:pt>
                <c:pt idx="1337">
                  <c:v>5.9395689964294434</c:v>
                </c:pt>
                <c:pt idx="1338">
                  <c:v>5.9505448341369629</c:v>
                </c:pt>
                <c:pt idx="1339">
                  <c:v>5.9615254402160645</c:v>
                </c:pt>
                <c:pt idx="1340">
                  <c:v>5.9725117683410645</c:v>
                </c:pt>
                <c:pt idx="1341">
                  <c:v>5.9835019111633301</c:v>
                </c:pt>
                <c:pt idx="1342">
                  <c:v>5.9944982528686523</c:v>
                </c:pt>
                <c:pt idx="1343">
                  <c:v>6.0054993629455566</c:v>
                </c:pt>
                <c:pt idx="1344">
                  <c:v>6.0165057182312012</c:v>
                </c:pt>
                <c:pt idx="1345">
                  <c:v>6.0275158882141113</c:v>
                </c:pt>
                <c:pt idx="1346">
                  <c:v>6.0385317802429199</c:v>
                </c:pt>
                <c:pt idx="1347">
                  <c:v>6.0495524406433105</c:v>
                </c:pt>
                <c:pt idx="1348">
                  <c:v>6.0605778694152832</c:v>
                </c:pt>
                <c:pt idx="1349">
                  <c:v>6.0716075897216797</c:v>
                </c:pt>
                <c:pt idx="1350">
                  <c:v>6.0826425552368164</c:v>
                </c:pt>
                <c:pt idx="1351">
                  <c:v>6.0936822891235352</c:v>
                </c:pt>
                <c:pt idx="1352">
                  <c:v>6.1047267913818359</c:v>
                </c:pt>
                <c:pt idx="1353">
                  <c:v>6.1157755851745605</c:v>
                </c:pt>
                <c:pt idx="1354">
                  <c:v>6.126828670501709</c:v>
                </c:pt>
                <c:pt idx="1355">
                  <c:v>6.1378865242004395</c:v>
                </c:pt>
                <c:pt idx="1356">
                  <c:v>6.148949146270752</c:v>
                </c:pt>
                <c:pt idx="1357">
                  <c:v>6.1600160598754883</c:v>
                </c:pt>
                <c:pt idx="1358">
                  <c:v>6.1710872650146484</c:v>
                </c:pt>
                <c:pt idx="1359">
                  <c:v>6.1821627616882324</c:v>
                </c:pt>
                <c:pt idx="1360">
                  <c:v>6.1932425498962402</c:v>
                </c:pt>
                <c:pt idx="1361">
                  <c:v>6.2043271064758301</c:v>
                </c:pt>
                <c:pt idx="1362">
                  <c:v>6.2154154777526855</c:v>
                </c:pt>
                <c:pt idx="1363">
                  <c:v>6.2265081405639648</c:v>
                </c:pt>
                <c:pt idx="1364">
                  <c:v>6.237605094909668</c:v>
                </c:pt>
                <c:pt idx="1365">
                  <c:v>6.2487058639526367</c:v>
                </c:pt>
                <c:pt idx="1366">
                  <c:v>6.2598109245300293</c:v>
                </c:pt>
                <c:pt idx="1367">
                  <c:v>6.2709202766418457</c:v>
                </c:pt>
                <c:pt idx="1368">
                  <c:v>6.2820339202880859</c:v>
                </c:pt>
                <c:pt idx="1369">
                  <c:v>6.2931509017944336</c:v>
                </c:pt>
                <c:pt idx="1370">
                  <c:v>6.3042721748352051</c:v>
                </c:pt>
                <c:pt idx="1371">
                  <c:v>6.3153977394104004</c:v>
                </c:pt>
                <c:pt idx="1372">
                  <c:v>6.3265266418457031</c:v>
                </c:pt>
                <c:pt idx="1373">
                  <c:v>6.3376598358154297</c:v>
                </c:pt>
                <c:pt idx="1374">
                  <c:v>6.3487968444824219</c:v>
                </c:pt>
                <c:pt idx="1375">
                  <c:v>6.3599376678466797</c:v>
                </c:pt>
                <c:pt idx="1376">
                  <c:v>6.3710818290710449</c:v>
                </c:pt>
                <c:pt idx="1377">
                  <c:v>6.382230281829834</c:v>
                </c:pt>
                <c:pt idx="1378">
                  <c:v>6.3933820724487305</c:v>
                </c:pt>
                <c:pt idx="1379">
                  <c:v>6.4045372009277344</c:v>
                </c:pt>
                <c:pt idx="1380">
                  <c:v>6.4156966209411621</c:v>
                </c:pt>
                <c:pt idx="1381">
                  <c:v>6.4268593788146973</c:v>
                </c:pt>
                <c:pt idx="1382">
                  <c:v>6.4380254745483398</c:v>
                </c:pt>
                <c:pt idx="1383">
                  <c:v>6.4491949081420898</c:v>
                </c:pt>
                <c:pt idx="1384">
                  <c:v>6.4603681564331055</c:v>
                </c:pt>
                <c:pt idx="1385">
                  <c:v>6.4715447425842285</c:v>
                </c:pt>
                <c:pt idx="1386">
                  <c:v>6.4827251434326172</c:v>
                </c:pt>
                <c:pt idx="1387">
                  <c:v>6.4939084053039551</c:v>
                </c:pt>
                <c:pt idx="1388">
                  <c:v>6.5050950050354004</c:v>
                </c:pt>
                <c:pt idx="1389">
                  <c:v>6.5162849426269531</c:v>
                </c:pt>
                <c:pt idx="1390">
                  <c:v>6.5274782180786133</c:v>
                </c:pt>
                <c:pt idx="1391">
                  <c:v>6.5386748313903809</c:v>
                </c:pt>
                <c:pt idx="1392">
                  <c:v>6.5498747825622559</c:v>
                </c:pt>
                <c:pt idx="1393">
                  <c:v>6.5610780715942383</c:v>
                </c:pt>
                <c:pt idx="1394">
                  <c:v>6.5722837448120117</c:v>
                </c:pt>
                <c:pt idx="1395">
                  <c:v>6.5834932327270508</c:v>
                </c:pt>
                <c:pt idx="1396">
                  <c:v>6.5947051048278809</c:v>
                </c:pt>
                <c:pt idx="1397">
                  <c:v>6.6059207916259766</c:v>
                </c:pt>
                <c:pt idx="1398">
                  <c:v>6.6171388626098633</c:v>
                </c:pt>
                <c:pt idx="1399">
                  <c:v>6.628359317779541</c:v>
                </c:pt>
                <c:pt idx="1400">
                  <c:v>6.6395831108093262</c:v>
                </c:pt>
                <c:pt idx="1401">
                  <c:v>6.6508097648620605</c:v>
                </c:pt>
                <c:pt idx="1402">
                  <c:v>6.6620392799377441</c:v>
                </c:pt>
                <c:pt idx="1403">
                  <c:v>6.6732721328735352</c:v>
                </c:pt>
                <c:pt idx="1404">
                  <c:v>6.684506893157959</c:v>
                </c:pt>
                <c:pt idx="1405">
                  <c:v>6.695744514465332</c:v>
                </c:pt>
                <c:pt idx="1406">
                  <c:v>6.7069849967956543</c:v>
                </c:pt>
                <c:pt idx="1407">
                  <c:v>6.7182292938232422</c:v>
                </c:pt>
                <c:pt idx="1408">
                  <c:v>6.7294750213623047</c:v>
                </c:pt>
                <c:pt idx="1409">
                  <c:v>6.7407240867614746</c:v>
                </c:pt>
                <c:pt idx="1410">
                  <c:v>6.7519750595092773</c:v>
                </c:pt>
                <c:pt idx="1411">
                  <c:v>6.7632293701171875</c:v>
                </c:pt>
                <c:pt idx="1412">
                  <c:v>6.7744851112365723</c:v>
                </c:pt>
                <c:pt idx="1413">
                  <c:v>6.7857441902160645</c:v>
                </c:pt>
                <c:pt idx="1414">
                  <c:v>6.7970046997070313</c:v>
                </c:pt>
                <c:pt idx="1415">
                  <c:v>6.8082685470581055</c:v>
                </c:pt>
                <c:pt idx="1416">
                  <c:v>6.8195333480834961</c:v>
                </c:pt>
                <c:pt idx="1417">
                  <c:v>6.8308005332946777</c:v>
                </c:pt>
                <c:pt idx="1418">
                  <c:v>6.8420705795288086</c:v>
                </c:pt>
                <c:pt idx="1419">
                  <c:v>6.8533425331115723</c:v>
                </c:pt>
                <c:pt idx="1420">
                  <c:v>6.8646163940429688</c:v>
                </c:pt>
                <c:pt idx="1421">
                  <c:v>6.8758935928344727</c:v>
                </c:pt>
                <c:pt idx="1422">
                  <c:v>6.887171745300293</c:v>
                </c:pt>
                <c:pt idx="1423">
                  <c:v>6.8984527587890625</c:v>
                </c:pt>
                <c:pt idx="1424">
                  <c:v>6.9097356796264648</c:v>
                </c:pt>
                <c:pt idx="1425">
                  <c:v>6.9210209846496582</c:v>
                </c:pt>
                <c:pt idx="1426">
                  <c:v>6.9323077201843262</c:v>
                </c:pt>
                <c:pt idx="1427">
                  <c:v>6.9435973167419434</c:v>
                </c:pt>
                <c:pt idx="1428">
                  <c:v>6.9548873901367188</c:v>
                </c:pt>
                <c:pt idx="1429">
                  <c:v>6.9661808013916016</c:v>
                </c:pt>
                <c:pt idx="1430">
                  <c:v>6.9774746894836426</c:v>
                </c:pt>
                <c:pt idx="1431">
                  <c:v>6.9887714385986328</c:v>
                </c:pt>
                <c:pt idx="1432">
                  <c:v>7.0000700950622559</c:v>
                </c:pt>
                <c:pt idx="1433">
                  <c:v>7.0113716125488281</c:v>
                </c:pt>
                <c:pt idx="1434">
                  <c:v>7.0226736068725586</c:v>
                </c:pt>
                <c:pt idx="1435">
                  <c:v>7.0339770317077637</c:v>
                </c:pt>
                <c:pt idx="1436">
                  <c:v>7.0452818870544434</c:v>
                </c:pt>
                <c:pt idx="1437">
                  <c:v>7.0565900802612305</c:v>
                </c:pt>
                <c:pt idx="1438">
                  <c:v>7.0678997039794922</c:v>
                </c:pt>
                <c:pt idx="1439">
                  <c:v>7.0792112350463867</c:v>
                </c:pt>
                <c:pt idx="1440">
                  <c:v>7.0905241966247559</c:v>
                </c:pt>
                <c:pt idx="1441">
                  <c:v>7.1018400192260742</c:v>
                </c:pt>
                <c:pt idx="1442">
                  <c:v>7.1131572723388672</c:v>
                </c:pt>
                <c:pt idx="1443">
                  <c:v>7.124476432800293</c:v>
                </c:pt>
                <c:pt idx="1444">
                  <c:v>7.1357989311218262</c:v>
                </c:pt>
                <c:pt idx="1445">
                  <c:v>7.147120475769043</c:v>
                </c:pt>
                <c:pt idx="1446">
                  <c:v>7.1584453582763672</c:v>
                </c:pt>
                <c:pt idx="1447">
                  <c:v>7.1697711944580078</c:v>
                </c:pt>
                <c:pt idx="1448">
                  <c:v>7.1810989379882813</c:v>
                </c:pt>
                <c:pt idx="1449">
                  <c:v>7.1924285888671875</c:v>
                </c:pt>
                <c:pt idx="1450">
                  <c:v>7.203761100769043</c:v>
                </c:pt>
                <c:pt idx="1451">
                  <c:v>7.2150955200195313</c:v>
                </c:pt>
                <c:pt idx="1452">
                  <c:v>7.2264308929443359</c:v>
                </c:pt>
                <c:pt idx="1453">
                  <c:v>7.2377691268920898</c:v>
                </c:pt>
                <c:pt idx="1454">
                  <c:v>7.249107837677002</c:v>
                </c:pt>
                <c:pt idx="1455">
                  <c:v>7.2604498863220215</c:v>
                </c:pt>
                <c:pt idx="1456">
                  <c:v>7.2717928886413574</c:v>
                </c:pt>
                <c:pt idx="1457">
                  <c:v>7.2831387519836426</c:v>
                </c:pt>
                <c:pt idx="1458">
                  <c:v>7.2944846153259277</c:v>
                </c:pt>
                <c:pt idx="1459">
                  <c:v>7.3058338165283203</c:v>
                </c:pt>
                <c:pt idx="1460">
                  <c:v>7.3171863555908203</c:v>
                </c:pt>
                <c:pt idx="1461">
                  <c:v>7.3285384178161621</c:v>
                </c:pt>
                <c:pt idx="1462">
                  <c:v>7.3398942947387695</c:v>
                </c:pt>
                <c:pt idx="1463">
                  <c:v>7.3512496948242188</c:v>
                </c:pt>
                <c:pt idx="1464">
                  <c:v>7.3626089096069336</c:v>
                </c:pt>
                <c:pt idx="1465">
                  <c:v>7.3739686012268066</c:v>
                </c:pt>
                <c:pt idx="1466">
                  <c:v>7.3853306770324707</c:v>
                </c:pt>
                <c:pt idx="1467">
                  <c:v>7.396693229675293</c:v>
                </c:pt>
                <c:pt idx="1468">
                  <c:v>7.4080595970153809</c:v>
                </c:pt>
                <c:pt idx="1469">
                  <c:v>7.4194259643554688</c:v>
                </c:pt>
                <c:pt idx="1470">
                  <c:v>7.4307956695556641</c:v>
                </c:pt>
                <c:pt idx="1471">
                  <c:v>7.4421658515930176</c:v>
                </c:pt>
                <c:pt idx="1472">
                  <c:v>7.4535398483276367</c:v>
                </c:pt>
                <c:pt idx="1473">
                  <c:v>7.4649147987365723</c:v>
                </c:pt>
                <c:pt idx="1474">
                  <c:v>7.4762930870056152</c:v>
                </c:pt>
                <c:pt idx="1475">
                  <c:v>7.4876713752746582</c:v>
                </c:pt>
                <c:pt idx="1476">
                  <c:v>7.4990520477294922</c:v>
                </c:pt>
                <c:pt idx="1477">
                  <c:v>7.510434627532959</c:v>
                </c:pt>
                <c:pt idx="1478">
                  <c:v>7.5218191146850586</c:v>
                </c:pt>
                <c:pt idx="1479">
                  <c:v>7.5332050323486328</c:v>
                </c:pt>
                <c:pt idx="1480">
                  <c:v>7.5445961952209473</c:v>
                </c:pt>
                <c:pt idx="1481">
                  <c:v>7.5559864044189453</c:v>
                </c:pt>
                <c:pt idx="1482">
                  <c:v>7.567380428314209</c:v>
                </c:pt>
                <c:pt idx="1483">
                  <c:v>7.5787758827209473</c:v>
                </c:pt>
                <c:pt idx="1484">
                  <c:v>7.5901727676391602</c:v>
                </c:pt>
                <c:pt idx="1485">
                  <c:v>7.6015691757202148</c:v>
                </c:pt>
                <c:pt idx="1486">
                  <c:v>7.6129703521728516</c:v>
                </c:pt>
                <c:pt idx="1487">
                  <c:v>7.6243720054626465</c:v>
                </c:pt>
                <c:pt idx="1488">
                  <c:v>7.635777473449707</c:v>
                </c:pt>
                <c:pt idx="1489">
                  <c:v>7.6471834182739258</c:v>
                </c:pt>
                <c:pt idx="1490">
                  <c:v>7.6585936546325684</c:v>
                </c:pt>
                <c:pt idx="1491">
                  <c:v>7.6700029373168945</c:v>
                </c:pt>
                <c:pt idx="1492">
                  <c:v>7.6814160346984863</c:v>
                </c:pt>
                <c:pt idx="1493">
                  <c:v>7.6928310394287109</c:v>
                </c:pt>
                <c:pt idx="1494">
                  <c:v>7.7042489051818848</c:v>
                </c:pt>
                <c:pt idx="1495">
                  <c:v>7.7156682014465332</c:v>
                </c:pt>
                <c:pt idx="1496">
                  <c:v>7.7270908355712891</c:v>
                </c:pt>
                <c:pt idx="1497">
                  <c:v>7.7385134696960449</c:v>
                </c:pt>
                <c:pt idx="1498">
                  <c:v>7.7499384880065918</c:v>
                </c:pt>
                <c:pt idx="1499">
                  <c:v>7.7613649368286133</c:v>
                </c:pt>
                <c:pt idx="1500">
                  <c:v>7.7727971076965332</c:v>
                </c:pt>
                <c:pt idx="1501">
                  <c:v>7.7842302322387695</c:v>
                </c:pt>
                <c:pt idx="1502">
                  <c:v>7.7956652641296387</c:v>
                </c:pt>
                <c:pt idx="1503">
                  <c:v>7.8071002960205078</c:v>
                </c:pt>
                <c:pt idx="1504">
                  <c:v>7.8185410499572754</c:v>
                </c:pt>
                <c:pt idx="1505">
                  <c:v>7.8299808502197266</c:v>
                </c:pt>
                <c:pt idx="1506">
                  <c:v>7.8414249420166016</c:v>
                </c:pt>
                <c:pt idx="1507">
                  <c:v>7.8528709411621094</c:v>
                </c:pt>
                <c:pt idx="1508">
                  <c:v>7.8643183708190918</c:v>
                </c:pt>
                <c:pt idx="1509">
                  <c:v>7.8757681846618652</c:v>
                </c:pt>
                <c:pt idx="1510">
                  <c:v>7.8872194290161133</c:v>
                </c:pt>
                <c:pt idx="1511">
                  <c:v>7.8986716270446777</c:v>
                </c:pt>
                <c:pt idx="1512">
                  <c:v>7.9101276397705078</c:v>
                </c:pt>
                <c:pt idx="1513">
                  <c:v>7.9215850830078125</c:v>
                </c:pt>
                <c:pt idx="1514">
                  <c:v>7.9330449104309082</c:v>
                </c:pt>
                <c:pt idx="1515">
                  <c:v>7.9445056915283203</c:v>
                </c:pt>
                <c:pt idx="1516">
                  <c:v>7.9559698104858398</c:v>
                </c:pt>
                <c:pt idx="1517">
                  <c:v>7.967435359954834</c:v>
                </c:pt>
                <c:pt idx="1518">
                  <c:v>7.9789037704467773</c:v>
                </c:pt>
                <c:pt idx="1519">
                  <c:v>7.9903736114501953</c:v>
                </c:pt>
                <c:pt idx="1520">
                  <c:v>8.0018453598022461</c:v>
                </c:pt>
                <c:pt idx="1521">
                  <c:v>8.0133180618286133</c:v>
                </c:pt>
                <c:pt idx="1522">
                  <c:v>8.0247945785522461</c:v>
                </c:pt>
                <c:pt idx="1523">
                  <c:v>8.0362730026245117</c:v>
                </c:pt>
                <c:pt idx="1524">
                  <c:v>8.0477542877197266</c:v>
                </c:pt>
                <c:pt idx="1525">
                  <c:v>8.0592355728149414</c:v>
                </c:pt>
                <c:pt idx="1526">
                  <c:v>8.0707206726074219</c:v>
                </c:pt>
                <c:pt idx="1527">
                  <c:v>8.0822086334228516</c:v>
                </c:pt>
                <c:pt idx="1528">
                  <c:v>8.0936994552612305</c:v>
                </c:pt>
                <c:pt idx="1529">
                  <c:v>8.1051902770996094</c:v>
                </c:pt>
                <c:pt idx="1530">
                  <c:v>8.1166849136352539</c:v>
                </c:pt>
                <c:pt idx="1531">
                  <c:v>8.1281814575195313</c:v>
                </c:pt>
                <c:pt idx="1532">
                  <c:v>8.139678955078125</c:v>
                </c:pt>
                <c:pt idx="1533">
                  <c:v>8.1511802673339844</c:v>
                </c:pt>
                <c:pt idx="1534">
                  <c:v>8.162684440612793</c:v>
                </c:pt>
                <c:pt idx="1535">
                  <c:v>8.1741905212402344</c:v>
                </c:pt>
                <c:pt idx="1536">
                  <c:v>8.1856975555419922</c:v>
                </c:pt>
                <c:pt idx="1537">
                  <c:v>8.1972084045410156</c:v>
                </c:pt>
                <c:pt idx="1538">
                  <c:v>8.2087202072143555</c:v>
                </c:pt>
                <c:pt idx="1539">
                  <c:v>8.2202367782592773</c:v>
                </c:pt>
                <c:pt idx="1540">
                  <c:v>8.2317562103271484</c:v>
                </c:pt>
                <c:pt idx="1541">
                  <c:v>8.2432756423950195</c:v>
                </c:pt>
                <c:pt idx="1542">
                  <c:v>8.2547979354858398</c:v>
                </c:pt>
                <c:pt idx="1543">
                  <c:v>8.2663240432739258</c:v>
                </c:pt>
                <c:pt idx="1544">
                  <c:v>8.2778501510620117</c:v>
                </c:pt>
                <c:pt idx="1545">
                  <c:v>8.2893819808959961</c:v>
                </c:pt>
                <c:pt idx="1546">
                  <c:v>8.3009157180786133</c:v>
                </c:pt>
                <c:pt idx="1547">
                  <c:v>8.3124513626098633</c:v>
                </c:pt>
                <c:pt idx="1548">
                  <c:v>8.3239870071411133</c:v>
                </c:pt>
                <c:pt idx="1549">
                  <c:v>8.3355293273925781</c:v>
                </c:pt>
                <c:pt idx="1550">
                  <c:v>8.347071647644043</c:v>
                </c:pt>
                <c:pt idx="1551">
                  <c:v>8.358616828918457</c:v>
                </c:pt>
                <c:pt idx="1552">
                  <c:v>8.3701620101928711</c:v>
                </c:pt>
                <c:pt idx="1553">
                  <c:v>8.3817138671875</c:v>
                </c:pt>
                <c:pt idx="1554">
                  <c:v>8.3932647705078125</c:v>
                </c:pt>
                <c:pt idx="1555">
                  <c:v>8.4048194885253906</c:v>
                </c:pt>
                <c:pt idx="1556">
                  <c:v>8.4163751602172852</c:v>
                </c:pt>
                <c:pt idx="1557">
                  <c:v>8.4279336929321289</c:v>
                </c:pt>
                <c:pt idx="1558">
                  <c:v>8.4394931793212891</c:v>
                </c:pt>
                <c:pt idx="1559">
                  <c:v>8.4510583877563477</c:v>
                </c:pt>
                <c:pt idx="1560">
                  <c:v>8.4626255035400391</c:v>
                </c:pt>
                <c:pt idx="1561">
                  <c:v>8.4741954803466797</c:v>
                </c:pt>
                <c:pt idx="1562">
                  <c:v>8.4857692718505859</c:v>
                </c:pt>
                <c:pt idx="1563">
                  <c:v>8.4973440170288086</c:v>
                </c:pt>
                <c:pt idx="1564">
                  <c:v>8.5089187622070313</c:v>
                </c:pt>
                <c:pt idx="1565">
                  <c:v>8.5204973220825195</c:v>
                </c:pt>
                <c:pt idx="1566">
                  <c:v>8.5320758819580078</c:v>
                </c:pt>
                <c:pt idx="1567">
                  <c:v>8.5436601638793945</c:v>
                </c:pt>
                <c:pt idx="1568">
                  <c:v>8.5552425384521484</c:v>
                </c:pt>
                <c:pt idx="1569">
                  <c:v>8.5668296813964844</c:v>
                </c:pt>
                <c:pt idx="1570">
                  <c:v>8.5784187316894531</c:v>
                </c:pt>
                <c:pt idx="1571">
                  <c:v>8.5900096893310547</c:v>
                </c:pt>
                <c:pt idx="1572">
                  <c:v>8.6016025543212891</c:v>
                </c:pt>
                <c:pt idx="1573">
                  <c:v>8.6132011413574219</c:v>
                </c:pt>
                <c:pt idx="1574">
                  <c:v>8.6247987747192383</c:v>
                </c:pt>
                <c:pt idx="1575">
                  <c:v>8.6364030838012695</c:v>
                </c:pt>
                <c:pt idx="1576">
                  <c:v>8.6480064392089844</c:v>
                </c:pt>
                <c:pt idx="1577">
                  <c:v>8.6596126556396484</c:v>
                </c:pt>
                <c:pt idx="1578">
                  <c:v>8.6712198257446289</c:v>
                </c:pt>
                <c:pt idx="1579">
                  <c:v>8.6828317642211914</c:v>
                </c:pt>
                <c:pt idx="1580">
                  <c:v>8.6944456100463867</c:v>
                </c:pt>
                <c:pt idx="1581">
                  <c:v>8.7060613632202148</c:v>
                </c:pt>
                <c:pt idx="1582">
                  <c:v>8.7176809310913086</c:v>
                </c:pt>
                <c:pt idx="1583">
                  <c:v>8.7293014526367188</c:v>
                </c:pt>
                <c:pt idx="1584">
                  <c:v>8.7409238815307617</c:v>
                </c:pt>
                <c:pt idx="1585">
                  <c:v>8.7525501251220703</c:v>
                </c:pt>
                <c:pt idx="1586">
                  <c:v>8.7641763687133789</c:v>
                </c:pt>
                <c:pt idx="1587">
                  <c:v>8.7758073806762695</c:v>
                </c:pt>
                <c:pt idx="1588">
                  <c:v>8.7874412536621094</c:v>
                </c:pt>
                <c:pt idx="1589">
                  <c:v>8.7990760803222656</c:v>
                </c:pt>
                <c:pt idx="1590">
                  <c:v>8.8107128143310547</c:v>
                </c:pt>
                <c:pt idx="1591">
                  <c:v>8.8223552703857422</c:v>
                </c:pt>
                <c:pt idx="1592">
                  <c:v>8.8339996337890625</c:v>
                </c:pt>
                <c:pt idx="1593">
                  <c:v>8.8456459045410156</c:v>
                </c:pt>
                <c:pt idx="1594">
                  <c:v>8.8572940826416016</c:v>
                </c:pt>
                <c:pt idx="1595">
                  <c:v>8.8689460754394531</c:v>
                </c:pt>
                <c:pt idx="1596">
                  <c:v>8.8805999755859375</c:v>
                </c:pt>
                <c:pt idx="1597">
                  <c:v>8.8922557830810547</c:v>
                </c:pt>
                <c:pt idx="1598">
                  <c:v>8.9039144515991211</c:v>
                </c:pt>
                <c:pt idx="1599">
                  <c:v>8.9155750274658203</c:v>
                </c:pt>
                <c:pt idx="1600">
                  <c:v>8.9272394180297852</c:v>
                </c:pt>
                <c:pt idx="1601">
                  <c:v>8.9389047622680664</c:v>
                </c:pt>
                <c:pt idx="1602">
                  <c:v>8.9505739212036133</c:v>
                </c:pt>
                <c:pt idx="1603">
                  <c:v>8.9622440338134766</c:v>
                </c:pt>
                <c:pt idx="1604">
                  <c:v>8.9739170074462891</c:v>
                </c:pt>
                <c:pt idx="1605">
                  <c:v>8.9855928421020508</c:v>
                </c:pt>
                <c:pt idx="1606">
                  <c:v>8.9972705841064453</c:v>
                </c:pt>
                <c:pt idx="1607">
                  <c:v>9.0089511871337891</c:v>
                </c:pt>
                <c:pt idx="1608">
                  <c:v>9.020634651184082</c:v>
                </c:pt>
                <c:pt idx="1609">
                  <c:v>9.032318115234375</c:v>
                </c:pt>
                <c:pt idx="1610">
                  <c:v>9.0440044403076172</c:v>
                </c:pt>
                <c:pt idx="1611">
                  <c:v>9.055694580078125</c:v>
                </c:pt>
                <c:pt idx="1612">
                  <c:v>9.067387580871582</c:v>
                </c:pt>
                <c:pt idx="1613">
                  <c:v>9.0790815353393555</c:v>
                </c:pt>
                <c:pt idx="1614">
                  <c:v>9.0907793045043945</c:v>
                </c:pt>
                <c:pt idx="1615">
                  <c:v>9.10247802734375</c:v>
                </c:pt>
                <c:pt idx="1616">
                  <c:v>9.1141805648803711</c:v>
                </c:pt>
                <c:pt idx="1617">
                  <c:v>9.1258840560913086</c:v>
                </c:pt>
                <c:pt idx="1618">
                  <c:v>9.1375904083251953</c:v>
                </c:pt>
                <c:pt idx="1619">
                  <c:v>9.1492996215820313</c:v>
                </c:pt>
                <c:pt idx="1620">
                  <c:v>9.1610107421875</c:v>
                </c:pt>
                <c:pt idx="1621">
                  <c:v>9.172724723815918</c:v>
                </c:pt>
                <c:pt idx="1622">
                  <c:v>9.1844415664672852</c:v>
                </c:pt>
                <c:pt idx="1623">
                  <c:v>9.1961593627929688</c:v>
                </c:pt>
                <c:pt idx="1624">
                  <c:v>9.207880973815918</c:v>
                </c:pt>
                <c:pt idx="1625">
                  <c:v>9.2196044921875</c:v>
                </c:pt>
                <c:pt idx="1626">
                  <c:v>9.2313318252563477</c:v>
                </c:pt>
                <c:pt idx="1627">
                  <c:v>9.2430601119995117</c:v>
                </c:pt>
                <c:pt idx="1628">
                  <c:v>9.2547922134399414</c:v>
                </c:pt>
                <c:pt idx="1629">
                  <c:v>9.2665262222290039</c:v>
                </c:pt>
                <c:pt idx="1630">
                  <c:v>9.2782621383666992</c:v>
                </c:pt>
                <c:pt idx="1631">
                  <c:v>9.2900009155273438</c:v>
                </c:pt>
                <c:pt idx="1632">
                  <c:v>9.3017425537109375</c:v>
                </c:pt>
                <c:pt idx="1633">
                  <c:v>9.3134870529174805</c:v>
                </c:pt>
                <c:pt idx="1634">
                  <c:v>9.3252334594726563</c:v>
                </c:pt>
                <c:pt idx="1635">
                  <c:v>9.3369827270507813</c:v>
                </c:pt>
                <c:pt idx="1636">
                  <c:v>9.3487339019775391</c:v>
                </c:pt>
                <c:pt idx="1637">
                  <c:v>9.3604869842529297</c:v>
                </c:pt>
                <c:pt idx="1638">
                  <c:v>9.3722438812255859</c:v>
                </c:pt>
                <c:pt idx="1639">
                  <c:v>9.384002685546875</c:v>
                </c:pt>
                <c:pt idx="1640">
                  <c:v>9.3957643508911133</c:v>
                </c:pt>
                <c:pt idx="1641">
                  <c:v>9.4075288772583008</c:v>
                </c:pt>
                <c:pt idx="1642">
                  <c:v>9.4192953109741211</c:v>
                </c:pt>
                <c:pt idx="1643">
                  <c:v>9.4310646057128906</c:v>
                </c:pt>
                <c:pt idx="1644">
                  <c:v>9.4428367614746094</c:v>
                </c:pt>
                <c:pt idx="1645">
                  <c:v>9.4546108245849609</c:v>
                </c:pt>
                <c:pt idx="1646">
                  <c:v>9.4663877487182617</c:v>
                </c:pt>
                <c:pt idx="1647">
                  <c:v>9.4781675338745117</c:v>
                </c:pt>
                <c:pt idx="1648">
                  <c:v>9.4899501800537109</c:v>
                </c:pt>
                <c:pt idx="1649">
                  <c:v>9.501734733581543</c:v>
                </c:pt>
                <c:pt idx="1650">
                  <c:v>9.5135221481323242</c:v>
                </c:pt>
                <c:pt idx="1651">
                  <c:v>9.5253124237060547</c:v>
                </c:pt>
                <c:pt idx="1652">
                  <c:v>9.537104606628418</c:v>
                </c:pt>
                <c:pt idx="1653">
                  <c:v>9.5489006042480469</c:v>
                </c:pt>
                <c:pt idx="1654">
                  <c:v>9.5606985092163086</c:v>
                </c:pt>
                <c:pt idx="1655">
                  <c:v>9.5724992752075195</c:v>
                </c:pt>
                <c:pt idx="1656">
                  <c:v>9.5843019485473633</c:v>
                </c:pt>
                <c:pt idx="1657">
                  <c:v>9.5961074829101563</c:v>
                </c:pt>
                <c:pt idx="1658">
                  <c:v>9.6079168319702148</c:v>
                </c:pt>
                <c:pt idx="1659">
                  <c:v>9.6197271347045898</c:v>
                </c:pt>
                <c:pt idx="1660">
                  <c:v>9.6315412521362305</c:v>
                </c:pt>
                <c:pt idx="1661">
                  <c:v>9.6433582305908203</c:v>
                </c:pt>
                <c:pt idx="1662">
                  <c:v>9.655177116394043</c:v>
                </c:pt>
                <c:pt idx="1663">
                  <c:v>9.6669988632202148</c:v>
                </c:pt>
                <c:pt idx="1664">
                  <c:v>9.6788234710693359</c:v>
                </c:pt>
                <c:pt idx="1665">
                  <c:v>9.6906509399414063</c:v>
                </c:pt>
                <c:pt idx="1666">
                  <c:v>9.7024803161621094</c:v>
                </c:pt>
                <c:pt idx="1667">
                  <c:v>9.7143135070800781</c:v>
                </c:pt>
                <c:pt idx="1668">
                  <c:v>9.7261486053466797</c:v>
                </c:pt>
                <c:pt idx="1669">
                  <c:v>9.7379865646362305</c:v>
                </c:pt>
                <c:pt idx="1670">
                  <c:v>9.7498273849487305</c:v>
                </c:pt>
                <c:pt idx="1671">
                  <c:v>9.7616710662841797</c:v>
                </c:pt>
                <c:pt idx="1672">
                  <c:v>9.7735176086425781</c:v>
                </c:pt>
                <c:pt idx="1673">
                  <c:v>9.7853670120239258</c:v>
                </c:pt>
                <c:pt idx="1674">
                  <c:v>9.7972183227539063</c:v>
                </c:pt>
                <c:pt idx="1675">
                  <c:v>9.8090734481811523</c:v>
                </c:pt>
                <c:pt idx="1676">
                  <c:v>9.8209304809570313</c:v>
                </c:pt>
                <c:pt idx="1677">
                  <c:v>9.8327903747558594</c:v>
                </c:pt>
                <c:pt idx="1678">
                  <c:v>9.8446531295776367</c:v>
                </c:pt>
                <c:pt idx="1679">
                  <c:v>9.8565187454223633</c:v>
                </c:pt>
                <c:pt idx="1680">
                  <c:v>9.8683872222900391</c:v>
                </c:pt>
                <c:pt idx="1681">
                  <c:v>9.8802585601806641</c:v>
                </c:pt>
                <c:pt idx="1682">
                  <c:v>9.8921327590942383</c:v>
                </c:pt>
                <c:pt idx="1683">
                  <c:v>9.9040098190307617</c:v>
                </c:pt>
                <c:pt idx="1684">
                  <c:v>9.9158897399902344</c:v>
                </c:pt>
                <c:pt idx="1685">
                  <c:v>9.9277725219726563</c:v>
                </c:pt>
                <c:pt idx="1686">
                  <c:v>9.9396572113037109</c:v>
                </c:pt>
                <c:pt idx="1687">
                  <c:v>9.9515457153320313</c:v>
                </c:pt>
                <c:pt idx="1688">
                  <c:v>9.9634370803833008</c:v>
                </c:pt>
                <c:pt idx="1689">
                  <c:v>9.9753303527832031</c:v>
                </c:pt>
                <c:pt idx="1690">
                  <c:v>9.9872274398803711</c:v>
                </c:pt>
                <c:pt idx="1691">
                  <c:v>9.9991273880004883</c:v>
                </c:pt>
                <c:pt idx="1692">
                  <c:v>10.011030197143555</c:v>
                </c:pt>
                <c:pt idx="1693">
                  <c:v>10.02293586730957</c:v>
                </c:pt>
                <c:pt idx="1694">
                  <c:v>10.034844398498535</c:v>
                </c:pt>
                <c:pt idx="1695">
                  <c:v>10.046756744384766</c:v>
                </c:pt>
                <c:pt idx="1696">
                  <c:v>10.058670997619629</c:v>
                </c:pt>
                <c:pt idx="1697">
                  <c:v>10.070587158203125</c:v>
                </c:pt>
                <c:pt idx="1698">
                  <c:v>10.082507133483887</c:v>
                </c:pt>
                <c:pt idx="1699">
                  <c:v>10.094429016113281</c:v>
                </c:pt>
                <c:pt idx="1700">
                  <c:v>10.106353759765625</c:v>
                </c:pt>
                <c:pt idx="1701">
                  <c:v>10.118281364440918</c:v>
                </c:pt>
                <c:pt idx="1702">
                  <c:v>10.13021183013916</c:v>
                </c:pt>
                <c:pt idx="1703">
                  <c:v>10.142145156860352</c:v>
                </c:pt>
                <c:pt idx="1704">
                  <c:v>10.154082298278809</c:v>
                </c:pt>
                <c:pt idx="1705">
                  <c:v>10.166022300720215</c:v>
                </c:pt>
                <c:pt idx="1706">
                  <c:v>10.177964210510254</c:v>
                </c:pt>
                <c:pt idx="1707">
                  <c:v>10.189908981323242</c:v>
                </c:pt>
                <c:pt idx="1708">
                  <c:v>10.20185661315918</c:v>
                </c:pt>
                <c:pt idx="1709">
                  <c:v>10.213807106018066</c:v>
                </c:pt>
                <c:pt idx="1710">
                  <c:v>10.225759506225586</c:v>
                </c:pt>
                <c:pt idx="1711">
                  <c:v>10.237715721130371</c:v>
                </c:pt>
                <c:pt idx="1712">
                  <c:v>10.249674797058105</c:v>
                </c:pt>
                <c:pt idx="1713">
                  <c:v>10.261636734008789</c:v>
                </c:pt>
                <c:pt idx="1714">
                  <c:v>10.273600578308105</c:v>
                </c:pt>
                <c:pt idx="1715">
                  <c:v>10.285567283630371</c:v>
                </c:pt>
                <c:pt idx="1716">
                  <c:v>10.297536849975586</c:v>
                </c:pt>
                <c:pt idx="1717">
                  <c:v>10.30950927734375</c:v>
                </c:pt>
                <c:pt idx="1718">
                  <c:v>10.321483612060547</c:v>
                </c:pt>
                <c:pt idx="1719">
                  <c:v>10.333460807800293</c:v>
                </c:pt>
                <c:pt idx="1720">
                  <c:v>10.345439910888672</c:v>
                </c:pt>
                <c:pt idx="1721">
                  <c:v>10.357422828674316</c:v>
                </c:pt>
                <c:pt idx="1722">
                  <c:v>10.369407653808594</c:v>
                </c:pt>
                <c:pt idx="1723">
                  <c:v>10.381396293640137</c:v>
                </c:pt>
                <c:pt idx="1724">
                  <c:v>10.393385887145996</c:v>
                </c:pt>
                <c:pt idx="1725">
                  <c:v>10.405377388000488</c:v>
                </c:pt>
                <c:pt idx="1726">
                  <c:v>10.417372703552246</c:v>
                </c:pt>
                <c:pt idx="1727">
                  <c:v>10.429372787475586</c:v>
                </c:pt>
                <c:pt idx="1728">
                  <c:v>10.441371917724609</c:v>
                </c:pt>
                <c:pt idx="1729">
                  <c:v>10.453375816345215</c:v>
                </c:pt>
                <c:pt idx="1730">
                  <c:v>10.465381622314453</c:v>
                </c:pt>
                <c:pt idx="1731">
                  <c:v>10.477390289306641</c:v>
                </c:pt>
                <c:pt idx="1732">
                  <c:v>10.489400863647461</c:v>
                </c:pt>
                <c:pt idx="1733">
                  <c:v>10.501413345336914</c:v>
                </c:pt>
                <c:pt idx="1734">
                  <c:v>10.513428688049316</c:v>
                </c:pt>
                <c:pt idx="1735">
                  <c:v>10.525446891784668</c:v>
                </c:pt>
                <c:pt idx="1736">
                  <c:v>10.537467002868652</c:v>
                </c:pt>
                <c:pt idx="1737">
                  <c:v>10.549489974975586</c:v>
                </c:pt>
                <c:pt idx="1738">
                  <c:v>10.561515808105469</c:v>
                </c:pt>
                <c:pt idx="1739">
                  <c:v>10.573544502258301</c:v>
                </c:pt>
                <c:pt idx="1740">
                  <c:v>10.585576057434082</c:v>
                </c:pt>
                <c:pt idx="1741">
                  <c:v>10.597610473632813</c:v>
                </c:pt>
                <c:pt idx="1742">
                  <c:v>10.609646797180176</c:v>
                </c:pt>
                <c:pt idx="1743">
                  <c:v>10.621685981750488</c:v>
                </c:pt>
                <c:pt idx="1744">
                  <c:v>10.633727073669434</c:v>
                </c:pt>
                <c:pt idx="1745">
                  <c:v>10.645769119262695</c:v>
                </c:pt>
                <c:pt idx="1746">
                  <c:v>10.657816886901855</c:v>
                </c:pt>
                <c:pt idx="1747">
                  <c:v>10.669865608215332</c:v>
                </c:pt>
                <c:pt idx="1748">
                  <c:v>10.681917190551758</c:v>
                </c:pt>
                <c:pt idx="1749">
                  <c:v>10.6939697265625</c:v>
                </c:pt>
                <c:pt idx="1750">
                  <c:v>10.706027984619141</c:v>
                </c:pt>
                <c:pt idx="1751">
                  <c:v>10.718085289001465</c:v>
                </c:pt>
                <c:pt idx="1752">
                  <c:v>10.730146408081055</c:v>
                </c:pt>
                <c:pt idx="1753">
                  <c:v>10.742209434509277</c:v>
                </c:pt>
                <c:pt idx="1754">
                  <c:v>10.754274368286133</c:v>
                </c:pt>
                <c:pt idx="1755">
                  <c:v>10.766342163085938</c:v>
                </c:pt>
                <c:pt idx="1756">
                  <c:v>10.778412818908691</c:v>
                </c:pt>
                <c:pt idx="1757">
                  <c:v>10.790485382080078</c:v>
                </c:pt>
                <c:pt idx="1758">
                  <c:v>10.802560806274414</c:v>
                </c:pt>
                <c:pt idx="1759">
                  <c:v>10.81463623046875</c:v>
                </c:pt>
                <c:pt idx="1760">
                  <c:v>10.826716423034668</c:v>
                </c:pt>
                <c:pt idx="1761">
                  <c:v>10.838798522949219</c:v>
                </c:pt>
                <c:pt idx="1762">
                  <c:v>10.850882530212402</c:v>
                </c:pt>
                <c:pt idx="1763">
                  <c:v>10.862967491149902</c:v>
                </c:pt>
                <c:pt idx="1764">
                  <c:v>10.875058174133301</c:v>
                </c:pt>
                <c:pt idx="1765">
                  <c:v>10.887147903442383</c:v>
                </c:pt>
                <c:pt idx="1766">
                  <c:v>10.899240493774414</c:v>
                </c:pt>
                <c:pt idx="1767">
                  <c:v>10.911334991455078</c:v>
                </c:pt>
                <c:pt idx="1768">
                  <c:v>10.923433303833008</c:v>
                </c:pt>
                <c:pt idx="1769">
                  <c:v>10.935532569885254</c:v>
                </c:pt>
                <c:pt idx="1770">
                  <c:v>10.947635650634766</c:v>
                </c:pt>
                <c:pt idx="1771">
                  <c:v>10.959738731384277</c:v>
                </c:pt>
                <c:pt idx="1772">
                  <c:v>10.971845626831055</c:v>
                </c:pt>
                <c:pt idx="1773">
                  <c:v>10.983953475952148</c:v>
                </c:pt>
                <c:pt idx="1774">
                  <c:v>10.996065139770508</c:v>
                </c:pt>
                <c:pt idx="1775">
                  <c:v>11.008176803588867</c:v>
                </c:pt>
                <c:pt idx="1776">
                  <c:v>11.020294189453125</c:v>
                </c:pt>
                <c:pt idx="1777">
                  <c:v>11.032410621643066</c:v>
                </c:pt>
                <c:pt idx="1778">
                  <c:v>11.044529914855957</c:v>
                </c:pt>
                <c:pt idx="1779">
                  <c:v>11.05665111541748</c:v>
                </c:pt>
                <c:pt idx="1780">
                  <c:v>11.06877613067627</c:v>
                </c:pt>
                <c:pt idx="1781">
                  <c:v>11.080902099609375</c:v>
                </c:pt>
                <c:pt idx="1782">
                  <c:v>11.093031883239746</c:v>
                </c:pt>
                <c:pt idx="1783">
                  <c:v>11.105161666870117</c:v>
                </c:pt>
                <c:pt idx="1784">
                  <c:v>11.117294311523438</c:v>
                </c:pt>
                <c:pt idx="1785">
                  <c:v>11.129426956176758</c:v>
                </c:pt>
                <c:pt idx="1786">
                  <c:v>11.14156436920166</c:v>
                </c:pt>
                <c:pt idx="1787">
                  <c:v>11.153703689575195</c:v>
                </c:pt>
                <c:pt idx="1788">
                  <c:v>11.165843963623047</c:v>
                </c:pt>
                <c:pt idx="1789">
                  <c:v>11.177988052368164</c:v>
                </c:pt>
                <c:pt idx="1790">
                  <c:v>11.190134048461914</c:v>
                </c:pt>
                <c:pt idx="1791">
                  <c:v>11.20228385925293</c:v>
                </c:pt>
                <c:pt idx="1792">
                  <c:v>11.214435577392578</c:v>
                </c:pt>
                <c:pt idx="1793">
                  <c:v>11.226587295532227</c:v>
                </c:pt>
                <c:pt idx="1794">
                  <c:v>11.238744735717773</c:v>
                </c:pt>
                <c:pt idx="1795">
                  <c:v>11.250903129577637</c:v>
                </c:pt>
                <c:pt idx="1796">
                  <c:v>11.263064384460449</c:v>
                </c:pt>
                <c:pt idx="1797">
                  <c:v>11.275227546691895</c:v>
                </c:pt>
                <c:pt idx="1798">
                  <c:v>11.287393569946289</c:v>
                </c:pt>
                <c:pt idx="1799">
                  <c:v>11.299559593200684</c:v>
                </c:pt>
                <c:pt idx="1800">
                  <c:v>11.311731338500977</c:v>
                </c:pt>
                <c:pt idx="1801">
                  <c:v>11.32390308380127</c:v>
                </c:pt>
                <c:pt idx="1802">
                  <c:v>11.336077690124512</c:v>
                </c:pt>
                <c:pt idx="1803">
                  <c:v>11.348255157470703</c:v>
                </c:pt>
                <c:pt idx="1804">
                  <c:v>11.360433578491211</c:v>
                </c:pt>
                <c:pt idx="1805">
                  <c:v>11.372615814208984</c:v>
                </c:pt>
                <c:pt idx="1806">
                  <c:v>11.384800910949707</c:v>
                </c:pt>
                <c:pt idx="1807">
                  <c:v>11.396987915039063</c:v>
                </c:pt>
                <c:pt idx="1808">
                  <c:v>11.409178733825684</c:v>
                </c:pt>
                <c:pt idx="1809">
                  <c:v>11.421367645263672</c:v>
                </c:pt>
                <c:pt idx="1810">
                  <c:v>11.433562278747559</c:v>
                </c:pt>
                <c:pt idx="1811">
                  <c:v>11.445757865905762</c:v>
                </c:pt>
                <c:pt idx="1812">
                  <c:v>11.457955360412598</c:v>
                </c:pt>
                <c:pt idx="1813">
                  <c:v>11.470155715942383</c:v>
                </c:pt>
                <c:pt idx="1814">
                  <c:v>11.482358932495117</c:v>
                </c:pt>
                <c:pt idx="1815">
                  <c:v>11.494563102722168</c:v>
                </c:pt>
                <c:pt idx="1816">
                  <c:v>11.506770133972168</c:v>
                </c:pt>
                <c:pt idx="1817">
                  <c:v>11.518977165222168</c:v>
                </c:pt>
                <c:pt idx="1818">
                  <c:v>11.53118896484375</c:v>
                </c:pt>
                <c:pt idx="1819">
                  <c:v>11.543402671813965</c:v>
                </c:pt>
                <c:pt idx="1820">
                  <c:v>11.555619239807129</c:v>
                </c:pt>
                <c:pt idx="1821">
                  <c:v>11.567839622497559</c:v>
                </c:pt>
                <c:pt idx="1822">
                  <c:v>11.580061912536621</c:v>
                </c:pt>
                <c:pt idx="1823">
                  <c:v>11.592286109924316</c:v>
                </c:pt>
                <c:pt idx="1824">
                  <c:v>11.604512214660645</c:v>
                </c:pt>
                <c:pt idx="1825">
                  <c:v>11.616742134094238</c:v>
                </c:pt>
                <c:pt idx="1826">
                  <c:v>11.628973960876465</c:v>
                </c:pt>
                <c:pt idx="1827">
                  <c:v>11.641206741333008</c:v>
                </c:pt>
                <c:pt idx="1828">
                  <c:v>11.653444290161133</c:v>
                </c:pt>
                <c:pt idx="1829">
                  <c:v>11.665684700012207</c:v>
                </c:pt>
                <c:pt idx="1830">
                  <c:v>11.677925109863281</c:v>
                </c:pt>
                <c:pt idx="1831">
                  <c:v>11.690170288085938</c:v>
                </c:pt>
                <c:pt idx="1832">
                  <c:v>11.70241641998291</c:v>
                </c:pt>
                <c:pt idx="1833">
                  <c:v>11.714668273925781</c:v>
                </c:pt>
                <c:pt idx="1834">
                  <c:v>11.726919174194336</c:v>
                </c:pt>
                <c:pt idx="1835">
                  <c:v>11.739174842834473</c:v>
                </c:pt>
                <c:pt idx="1836">
                  <c:v>11.751431465148926</c:v>
                </c:pt>
                <c:pt idx="1837">
                  <c:v>11.763692855834961</c:v>
                </c:pt>
                <c:pt idx="1838">
                  <c:v>11.775954246520996</c:v>
                </c:pt>
                <c:pt idx="1839">
                  <c:v>11.788220405578613</c:v>
                </c:pt>
                <c:pt idx="1840">
                  <c:v>11.800488471984863</c:v>
                </c:pt>
                <c:pt idx="1841">
                  <c:v>11.812760353088379</c:v>
                </c:pt>
                <c:pt idx="1842">
                  <c:v>11.825033187866211</c:v>
                </c:pt>
                <c:pt idx="1843">
                  <c:v>11.837309837341309</c:v>
                </c:pt>
                <c:pt idx="1844">
                  <c:v>11.849587440490723</c:v>
                </c:pt>
                <c:pt idx="1845">
                  <c:v>11.861871719360352</c:v>
                </c:pt>
                <c:pt idx="1846">
                  <c:v>11.87415885925293</c:v>
                </c:pt>
                <c:pt idx="1847">
                  <c:v>11.886446952819824</c:v>
                </c:pt>
                <c:pt idx="1848">
                  <c:v>11.898737907409668</c:v>
                </c:pt>
                <c:pt idx="1849">
                  <c:v>11.911031723022461</c:v>
                </c:pt>
                <c:pt idx="1850">
                  <c:v>11.923327445983887</c:v>
                </c:pt>
                <c:pt idx="1851">
                  <c:v>11.935628890991211</c:v>
                </c:pt>
                <c:pt idx="1852">
                  <c:v>11.947930335998535</c:v>
                </c:pt>
                <c:pt idx="1853">
                  <c:v>11.960235595703125</c:v>
                </c:pt>
                <c:pt idx="1854">
                  <c:v>11.972540855407715</c:v>
                </c:pt>
                <c:pt idx="1855">
                  <c:v>11.98485279083252</c:v>
                </c:pt>
                <c:pt idx="1856">
                  <c:v>11.997164726257324</c:v>
                </c:pt>
                <c:pt idx="1857">
                  <c:v>12.009481430053711</c:v>
                </c:pt>
                <c:pt idx="1858">
                  <c:v>12.021799087524414</c:v>
                </c:pt>
                <c:pt idx="1859">
                  <c:v>12.034121513366699</c:v>
                </c:pt>
                <c:pt idx="1860">
                  <c:v>12.046443939208984</c:v>
                </c:pt>
                <c:pt idx="1861">
                  <c:v>12.058771133422852</c:v>
                </c:pt>
                <c:pt idx="1862">
                  <c:v>12.071098327636719</c:v>
                </c:pt>
                <c:pt idx="1863">
                  <c:v>12.083433151245117</c:v>
                </c:pt>
                <c:pt idx="1864">
                  <c:v>12.095765113830566</c:v>
                </c:pt>
                <c:pt idx="1865">
                  <c:v>12.108100891113281</c:v>
                </c:pt>
                <c:pt idx="1866">
                  <c:v>12.120437622070313</c:v>
                </c:pt>
                <c:pt idx="1867">
                  <c:v>12.132780075073242</c:v>
                </c:pt>
                <c:pt idx="1868">
                  <c:v>12.145123481750488</c:v>
                </c:pt>
                <c:pt idx="1869">
                  <c:v>12.157470703125</c:v>
                </c:pt>
                <c:pt idx="1870">
                  <c:v>12.169818878173828</c:v>
                </c:pt>
                <c:pt idx="1871">
                  <c:v>12.182170867919922</c:v>
                </c:pt>
                <c:pt idx="1872">
                  <c:v>12.194524765014648</c:v>
                </c:pt>
                <c:pt idx="1873">
                  <c:v>12.206883430480957</c:v>
                </c:pt>
                <c:pt idx="1874">
                  <c:v>12.219241142272949</c:v>
                </c:pt>
                <c:pt idx="1875">
                  <c:v>12.231602668762207</c:v>
                </c:pt>
                <c:pt idx="1876">
                  <c:v>12.24396800994873</c:v>
                </c:pt>
                <c:pt idx="1877">
                  <c:v>12.25633430480957</c:v>
                </c:pt>
                <c:pt idx="1878">
                  <c:v>12.268701553344727</c:v>
                </c:pt>
                <c:pt idx="1879">
                  <c:v>12.281071662902832</c:v>
                </c:pt>
                <c:pt idx="1880">
                  <c:v>12.293444633483887</c:v>
                </c:pt>
                <c:pt idx="1881">
                  <c:v>12.305822372436523</c:v>
                </c:pt>
                <c:pt idx="1882">
                  <c:v>12.318199157714844</c:v>
                </c:pt>
                <c:pt idx="1883">
                  <c:v>12.33057975769043</c:v>
                </c:pt>
                <c:pt idx="1884">
                  <c:v>12.342961311340332</c:v>
                </c:pt>
                <c:pt idx="1885">
                  <c:v>12.355347633361816</c:v>
                </c:pt>
                <c:pt idx="1886">
                  <c:v>12.367733955383301</c:v>
                </c:pt>
                <c:pt idx="1887">
                  <c:v>12.380124092102051</c:v>
                </c:pt>
                <c:pt idx="1888">
                  <c:v>12.392516136169434</c:v>
                </c:pt>
                <c:pt idx="1889">
                  <c:v>12.404911041259766</c:v>
                </c:pt>
                <c:pt idx="1890">
                  <c:v>12.417308807373047</c:v>
                </c:pt>
                <c:pt idx="1891">
                  <c:v>12.429710388183594</c:v>
                </c:pt>
                <c:pt idx="1892">
                  <c:v>12.442112922668457</c:v>
                </c:pt>
                <c:pt idx="1893">
                  <c:v>12.454520225524902</c:v>
                </c:pt>
                <c:pt idx="1894">
                  <c:v>12.466927528381348</c:v>
                </c:pt>
                <c:pt idx="1895">
                  <c:v>12.479336738586426</c:v>
                </c:pt>
                <c:pt idx="1896">
                  <c:v>12.491748809814453</c:v>
                </c:pt>
                <c:pt idx="1897">
                  <c:v>12.504164695739746</c:v>
                </c:pt>
                <c:pt idx="1898">
                  <c:v>12.516580581665039</c:v>
                </c:pt>
                <c:pt idx="1899">
                  <c:v>12.528998374938965</c:v>
                </c:pt>
                <c:pt idx="1900">
                  <c:v>12.541419982910156</c:v>
                </c:pt>
                <c:pt idx="1901">
                  <c:v>12.55384349822998</c:v>
                </c:pt>
                <c:pt idx="1902">
                  <c:v>12.566269874572754</c:v>
                </c:pt>
                <c:pt idx="1903">
                  <c:v>12.578697204589844</c:v>
                </c:pt>
                <c:pt idx="1904">
                  <c:v>12.591126441955566</c:v>
                </c:pt>
                <c:pt idx="1905">
                  <c:v>12.603556632995605</c:v>
                </c:pt>
                <c:pt idx="1906">
                  <c:v>12.61599063873291</c:v>
                </c:pt>
                <c:pt idx="1907">
                  <c:v>12.628425598144531</c:v>
                </c:pt>
                <c:pt idx="1908">
                  <c:v>12.640863418579102</c:v>
                </c:pt>
                <c:pt idx="1909">
                  <c:v>12.653303146362305</c:v>
                </c:pt>
                <c:pt idx="1910">
                  <c:v>12.665744781494141</c:v>
                </c:pt>
                <c:pt idx="1911">
                  <c:v>12.678188323974609</c:v>
                </c:pt>
                <c:pt idx="1912">
                  <c:v>12.690634727478027</c:v>
                </c:pt>
                <c:pt idx="1913">
                  <c:v>12.703081130981445</c:v>
                </c:pt>
                <c:pt idx="1914">
                  <c:v>12.715530395507813</c:v>
                </c:pt>
                <c:pt idx="1915">
                  <c:v>12.727980613708496</c:v>
                </c:pt>
                <c:pt idx="1916">
                  <c:v>12.740434646606445</c:v>
                </c:pt>
                <c:pt idx="1917">
                  <c:v>12.752889633178711</c:v>
                </c:pt>
                <c:pt idx="1918">
                  <c:v>12.765346527099609</c:v>
                </c:pt>
                <c:pt idx="1919">
                  <c:v>12.777803421020508</c:v>
                </c:pt>
                <c:pt idx="1920">
                  <c:v>12.790265083312988</c:v>
                </c:pt>
                <c:pt idx="1921">
                  <c:v>12.802725791931152</c:v>
                </c:pt>
                <c:pt idx="1922">
                  <c:v>12.815190315246582</c:v>
                </c:pt>
                <c:pt idx="1923">
                  <c:v>12.827653884887695</c:v>
                </c:pt>
                <c:pt idx="1924">
                  <c:v>12.840122222900391</c:v>
                </c:pt>
                <c:pt idx="1925">
                  <c:v>12.852590560913086</c:v>
                </c:pt>
                <c:pt idx="1926">
                  <c:v>12.865060806274414</c:v>
                </c:pt>
                <c:pt idx="1927">
                  <c:v>12.877532958984375</c:v>
                </c:pt>
                <c:pt idx="1928">
                  <c:v>12.890007972717285</c:v>
                </c:pt>
                <c:pt idx="1929">
                  <c:v>12.902482986450195</c:v>
                </c:pt>
                <c:pt idx="1930">
                  <c:v>12.914960861206055</c:v>
                </c:pt>
                <c:pt idx="1931">
                  <c:v>12.927440643310547</c:v>
                </c:pt>
                <c:pt idx="1932">
                  <c:v>12.939921379089355</c:v>
                </c:pt>
                <c:pt idx="1933">
                  <c:v>12.95240306854248</c:v>
                </c:pt>
                <c:pt idx="1934">
                  <c:v>12.964887619018555</c:v>
                </c:pt>
                <c:pt idx="1935">
                  <c:v>12.977374076843262</c:v>
                </c:pt>
                <c:pt idx="1936">
                  <c:v>12.989862442016602</c:v>
                </c:pt>
                <c:pt idx="1937">
                  <c:v>13.002351760864258</c:v>
                </c:pt>
                <c:pt idx="1938">
                  <c:v>13.01484203338623</c:v>
                </c:pt>
                <c:pt idx="1939">
                  <c:v>13.02733325958252</c:v>
                </c:pt>
                <c:pt idx="1940">
                  <c:v>13.039827346801758</c:v>
                </c:pt>
                <c:pt idx="1941">
                  <c:v>13.052322387695313</c:v>
                </c:pt>
                <c:pt idx="1942">
                  <c:v>13.064820289611816</c:v>
                </c:pt>
                <c:pt idx="1943">
                  <c:v>13.07731819152832</c:v>
                </c:pt>
                <c:pt idx="1944">
                  <c:v>13.08981990814209</c:v>
                </c:pt>
                <c:pt idx="1945">
                  <c:v>13.102320671081543</c:v>
                </c:pt>
                <c:pt idx="1946">
                  <c:v>13.114825248718262</c:v>
                </c:pt>
                <c:pt idx="1947">
                  <c:v>13.127330780029297</c:v>
                </c:pt>
                <c:pt idx="1948">
                  <c:v>13.139839172363281</c:v>
                </c:pt>
                <c:pt idx="1949">
                  <c:v>13.152347564697266</c:v>
                </c:pt>
                <c:pt idx="1950">
                  <c:v>13.164859771728516</c:v>
                </c:pt>
                <c:pt idx="1951">
                  <c:v>13.177372932434082</c:v>
                </c:pt>
                <c:pt idx="1952">
                  <c:v>13.189888000488281</c:v>
                </c:pt>
                <c:pt idx="1953">
                  <c:v>13.202404975891113</c:v>
                </c:pt>
                <c:pt idx="1954">
                  <c:v>13.214923858642578</c:v>
                </c:pt>
                <c:pt idx="1955">
                  <c:v>13.227443695068359</c:v>
                </c:pt>
                <c:pt idx="1956">
                  <c:v>13.23996639251709</c:v>
                </c:pt>
                <c:pt idx="1957">
                  <c:v>13.252490997314453</c:v>
                </c:pt>
                <c:pt idx="1958">
                  <c:v>13.265018463134766</c:v>
                </c:pt>
                <c:pt idx="1959">
                  <c:v>13.277546882629395</c:v>
                </c:pt>
                <c:pt idx="1960">
                  <c:v>13.290077209472656</c:v>
                </c:pt>
                <c:pt idx="1961">
                  <c:v>13.302610397338867</c:v>
                </c:pt>
                <c:pt idx="1962">
                  <c:v>13.315145492553711</c:v>
                </c:pt>
                <c:pt idx="1963">
                  <c:v>13.327681541442871</c:v>
                </c:pt>
                <c:pt idx="1964">
                  <c:v>13.340221405029297</c:v>
                </c:pt>
                <c:pt idx="1965">
                  <c:v>13.352762222290039</c:v>
                </c:pt>
                <c:pt idx="1966">
                  <c:v>13.365304946899414</c:v>
                </c:pt>
                <c:pt idx="1967">
                  <c:v>13.377849578857422</c:v>
                </c:pt>
                <c:pt idx="1968">
                  <c:v>13.390397071838379</c:v>
                </c:pt>
                <c:pt idx="1969">
                  <c:v>13.402946472167969</c:v>
                </c:pt>
                <c:pt idx="1970">
                  <c:v>13.415498733520508</c:v>
                </c:pt>
                <c:pt idx="1971">
                  <c:v>13.42805290222168</c:v>
                </c:pt>
                <c:pt idx="1972">
                  <c:v>13.440609931945801</c:v>
                </c:pt>
                <c:pt idx="1973">
                  <c:v>13.453168869018555</c:v>
                </c:pt>
                <c:pt idx="1974">
                  <c:v>13.465729713439941</c:v>
                </c:pt>
                <c:pt idx="1975">
                  <c:v>13.478293418884277</c:v>
                </c:pt>
                <c:pt idx="1976">
                  <c:v>13.490859031677246</c:v>
                </c:pt>
                <c:pt idx="1977">
                  <c:v>13.503427505493164</c:v>
                </c:pt>
                <c:pt idx="1978">
                  <c:v>13.515998840332031</c:v>
                </c:pt>
                <c:pt idx="1979">
                  <c:v>13.528572082519531</c:v>
                </c:pt>
                <c:pt idx="1980">
                  <c:v>13.54114818572998</c:v>
                </c:pt>
                <c:pt idx="1981">
                  <c:v>13.553726196289063</c:v>
                </c:pt>
                <c:pt idx="1982">
                  <c:v>13.566307067871094</c:v>
                </c:pt>
                <c:pt idx="1983">
                  <c:v>13.578889846801758</c:v>
                </c:pt>
                <c:pt idx="1984">
                  <c:v>13.591475486755371</c:v>
                </c:pt>
                <c:pt idx="1985">
                  <c:v>13.604063987731934</c:v>
                </c:pt>
                <c:pt idx="1986">
                  <c:v>13.616655349731445</c:v>
                </c:pt>
                <c:pt idx="1987">
                  <c:v>13.62924861907959</c:v>
                </c:pt>
                <c:pt idx="1988">
                  <c:v>13.641844749450684</c:v>
                </c:pt>
                <c:pt idx="1989">
                  <c:v>13.654443740844727</c:v>
                </c:pt>
                <c:pt idx="1990">
                  <c:v>13.667045593261719</c:v>
                </c:pt>
                <c:pt idx="1991">
                  <c:v>13.679649353027344</c:v>
                </c:pt>
                <c:pt idx="1992">
                  <c:v>13.692256927490234</c:v>
                </c:pt>
                <c:pt idx="1993">
                  <c:v>13.704866409301758</c:v>
                </c:pt>
                <c:pt idx="1994">
                  <c:v>13.71747875213623</c:v>
                </c:pt>
                <c:pt idx="1995">
                  <c:v>13.730093955993652</c:v>
                </c:pt>
                <c:pt idx="1996">
                  <c:v>13.742712020874023</c:v>
                </c:pt>
                <c:pt idx="1997">
                  <c:v>13.755332946777344</c:v>
                </c:pt>
                <c:pt idx="1998">
                  <c:v>13.767956733703613</c:v>
                </c:pt>
                <c:pt idx="1999">
                  <c:v>13.780583381652832</c:v>
                </c:pt>
                <c:pt idx="2000">
                  <c:v>13.793212890625</c:v>
                </c:pt>
                <c:pt idx="2001">
                  <c:v>13.805845260620117</c:v>
                </c:pt>
                <c:pt idx="2002">
                  <c:v>13.818480491638184</c:v>
                </c:pt>
                <c:pt idx="2003">
                  <c:v>13.831118583679199</c:v>
                </c:pt>
                <c:pt idx="2004">
                  <c:v>13.84376049041748</c:v>
                </c:pt>
                <c:pt idx="2005">
                  <c:v>13.856404304504395</c:v>
                </c:pt>
                <c:pt idx="2006">
                  <c:v>13.869051933288574</c:v>
                </c:pt>
                <c:pt idx="2007">
                  <c:v>13.881702423095703</c:v>
                </c:pt>
                <c:pt idx="2008">
                  <c:v>13.894355773925781</c:v>
                </c:pt>
                <c:pt idx="2009">
                  <c:v>13.907011985778809</c:v>
                </c:pt>
                <c:pt idx="2010">
                  <c:v>13.919672012329102</c:v>
                </c:pt>
                <c:pt idx="2011">
                  <c:v>13.932334899902344</c:v>
                </c:pt>
                <c:pt idx="2012">
                  <c:v>13.945000648498535</c:v>
                </c:pt>
                <c:pt idx="2013">
                  <c:v>13.957669258117676</c:v>
                </c:pt>
                <c:pt idx="2014">
                  <c:v>13.970341682434082</c:v>
                </c:pt>
                <c:pt idx="2015">
                  <c:v>13.983017921447754</c:v>
                </c:pt>
                <c:pt idx="2016">
                  <c:v>13.995696067810059</c:v>
                </c:pt>
                <c:pt idx="2017">
                  <c:v>14.008378028869629</c:v>
                </c:pt>
                <c:pt idx="2018">
                  <c:v>14.021063804626465</c:v>
                </c:pt>
                <c:pt idx="2019">
                  <c:v>14.03375244140625</c:v>
                </c:pt>
                <c:pt idx="2020">
                  <c:v>14.046443939208984</c:v>
                </c:pt>
                <c:pt idx="2021">
                  <c:v>14.059139251708984</c:v>
                </c:pt>
                <c:pt idx="2022">
                  <c:v>14.071837425231934</c:v>
                </c:pt>
                <c:pt idx="2023">
                  <c:v>14.084539413452148</c:v>
                </c:pt>
                <c:pt idx="2024">
                  <c:v>14.097244262695313</c:v>
                </c:pt>
                <c:pt idx="2025">
                  <c:v>14.109952926635742</c:v>
                </c:pt>
                <c:pt idx="2026">
                  <c:v>14.122664451599121</c:v>
                </c:pt>
                <c:pt idx="2027">
                  <c:v>14.135379791259766</c:v>
                </c:pt>
                <c:pt idx="2028">
                  <c:v>14.148097991943359</c:v>
                </c:pt>
                <c:pt idx="2029">
                  <c:v>14.160820007324219</c:v>
                </c:pt>
                <c:pt idx="2030">
                  <c:v>14.173544883728027</c:v>
                </c:pt>
                <c:pt idx="2031">
                  <c:v>14.186273574829102</c:v>
                </c:pt>
                <c:pt idx="2032">
                  <c:v>14.199005126953125</c:v>
                </c:pt>
                <c:pt idx="2033">
                  <c:v>14.211739540100098</c:v>
                </c:pt>
                <c:pt idx="2034">
                  <c:v>14.224478721618652</c:v>
                </c:pt>
                <c:pt idx="2035">
                  <c:v>14.23721981048584</c:v>
                </c:pt>
                <c:pt idx="2036">
                  <c:v>14.249965667724609</c:v>
                </c:pt>
                <c:pt idx="2037">
                  <c:v>14.262714385986328</c:v>
                </c:pt>
                <c:pt idx="2038">
                  <c:v>14.275465965270996</c:v>
                </c:pt>
                <c:pt idx="2039">
                  <c:v>14.28822135925293</c:v>
                </c:pt>
                <c:pt idx="2040">
                  <c:v>14.300979614257813</c:v>
                </c:pt>
                <c:pt idx="2041">
                  <c:v>14.313741683959961</c:v>
                </c:pt>
                <c:pt idx="2042">
                  <c:v>14.326507568359375</c:v>
                </c:pt>
                <c:pt idx="2043">
                  <c:v>14.339276313781738</c:v>
                </c:pt>
                <c:pt idx="2044">
                  <c:v>14.352048873901367</c:v>
                </c:pt>
                <c:pt idx="2045">
                  <c:v>14.364824295043945</c:v>
                </c:pt>
                <c:pt idx="2046">
                  <c:v>14.377603530883789</c:v>
                </c:pt>
                <c:pt idx="2047">
                  <c:v>14.390386581420898</c:v>
                </c:pt>
                <c:pt idx="2048">
                  <c:v>14.403172492980957</c:v>
                </c:pt>
                <c:pt idx="2049">
                  <c:v>14.415962219238281</c:v>
                </c:pt>
                <c:pt idx="2050">
                  <c:v>14.428754806518555</c:v>
                </c:pt>
                <c:pt idx="2051">
                  <c:v>14.44155216217041</c:v>
                </c:pt>
                <c:pt idx="2052">
                  <c:v>14.454351425170898</c:v>
                </c:pt>
                <c:pt idx="2053">
                  <c:v>14.467154502868652</c:v>
                </c:pt>
                <c:pt idx="2054">
                  <c:v>14.479961395263672</c:v>
                </c:pt>
                <c:pt idx="2055">
                  <c:v>14.492772102355957</c:v>
                </c:pt>
                <c:pt idx="2056">
                  <c:v>14.505585670471191</c:v>
                </c:pt>
                <c:pt idx="2057">
                  <c:v>14.518403053283691</c:v>
                </c:pt>
                <c:pt idx="2058">
                  <c:v>14.531224250793457</c:v>
                </c:pt>
                <c:pt idx="2059">
                  <c:v>14.544048309326172</c:v>
                </c:pt>
                <c:pt idx="2060">
                  <c:v>14.556876182556152</c:v>
                </c:pt>
                <c:pt idx="2061">
                  <c:v>14.569707870483398</c:v>
                </c:pt>
                <c:pt idx="2062">
                  <c:v>14.582542419433594</c:v>
                </c:pt>
                <c:pt idx="2063">
                  <c:v>14.595380783081055</c:v>
                </c:pt>
                <c:pt idx="2064">
                  <c:v>14.608222007751465</c:v>
                </c:pt>
                <c:pt idx="2065">
                  <c:v>14.621068000793457</c:v>
                </c:pt>
                <c:pt idx="2066">
                  <c:v>14.633916854858398</c:v>
                </c:pt>
                <c:pt idx="2067">
                  <c:v>14.646769523620605</c:v>
                </c:pt>
                <c:pt idx="2068">
                  <c:v>14.659625053405762</c:v>
                </c:pt>
                <c:pt idx="2069">
                  <c:v>14.6724853515625</c:v>
                </c:pt>
                <c:pt idx="2070">
                  <c:v>14.685347557067871</c:v>
                </c:pt>
                <c:pt idx="2071">
                  <c:v>14.698214530944824</c:v>
                </c:pt>
                <c:pt idx="2072">
                  <c:v>14.711085319519043</c:v>
                </c:pt>
                <c:pt idx="2073">
                  <c:v>14.723958969116211</c:v>
                </c:pt>
                <c:pt idx="2074">
                  <c:v>14.736836433410645</c:v>
                </c:pt>
                <c:pt idx="2075">
                  <c:v>14.749717712402344</c:v>
                </c:pt>
                <c:pt idx="2076">
                  <c:v>14.762601852416992</c:v>
                </c:pt>
                <c:pt idx="2077">
                  <c:v>14.775489807128906</c:v>
                </c:pt>
                <c:pt idx="2078">
                  <c:v>14.788382530212402</c:v>
                </c:pt>
                <c:pt idx="2079">
                  <c:v>14.801277160644531</c:v>
                </c:pt>
                <c:pt idx="2080">
                  <c:v>14.814176559448242</c:v>
                </c:pt>
                <c:pt idx="2081">
                  <c:v>14.827078819274902</c:v>
                </c:pt>
                <c:pt idx="2082">
                  <c:v>14.839985847473145</c:v>
                </c:pt>
                <c:pt idx="2083">
                  <c:v>14.852895736694336</c:v>
                </c:pt>
                <c:pt idx="2084">
                  <c:v>14.865809440612793</c:v>
                </c:pt>
                <c:pt idx="2085">
                  <c:v>14.878726005554199</c:v>
                </c:pt>
                <c:pt idx="2086">
                  <c:v>14.891647338867188</c:v>
                </c:pt>
                <c:pt idx="2087">
                  <c:v>14.904571533203125</c:v>
                </c:pt>
                <c:pt idx="2088">
                  <c:v>14.917499542236328</c:v>
                </c:pt>
                <c:pt idx="2089">
                  <c:v>14.930431365966797</c:v>
                </c:pt>
                <c:pt idx="2090">
                  <c:v>14.943367004394531</c:v>
                </c:pt>
                <c:pt idx="2091">
                  <c:v>14.956306457519531</c:v>
                </c:pt>
                <c:pt idx="2092">
                  <c:v>14.969249725341797</c:v>
                </c:pt>
                <c:pt idx="2093">
                  <c:v>14.982195854187012</c:v>
                </c:pt>
                <c:pt idx="2094">
                  <c:v>14.995145797729492</c:v>
                </c:pt>
                <c:pt idx="2095">
                  <c:v>15.008100509643555</c:v>
                </c:pt>
                <c:pt idx="2096">
                  <c:v>15.021058082580566</c:v>
                </c:pt>
                <c:pt idx="2097">
                  <c:v>15.034019470214844</c:v>
                </c:pt>
                <c:pt idx="2098">
                  <c:v>15.04698371887207</c:v>
                </c:pt>
                <c:pt idx="2099">
                  <c:v>15.059952735900879</c:v>
                </c:pt>
                <c:pt idx="2100">
                  <c:v>15.072925567626953</c:v>
                </c:pt>
                <c:pt idx="2101">
                  <c:v>15.085901260375977</c:v>
                </c:pt>
                <c:pt idx="2102">
                  <c:v>15.098880767822266</c:v>
                </c:pt>
                <c:pt idx="2103">
                  <c:v>15.11186408996582</c:v>
                </c:pt>
                <c:pt idx="2104">
                  <c:v>15.124851226806641</c:v>
                </c:pt>
                <c:pt idx="2105">
                  <c:v>15.137842178344727</c:v>
                </c:pt>
                <c:pt idx="2106">
                  <c:v>15.150836944580078</c:v>
                </c:pt>
                <c:pt idx="2107">
                  <c:v>15.163835525512695</c:v>
                </c:pt>
                <c:pt idx="2108">
                  <c:v>15.176836967468262</c:v>
                </c:pt>
                <c:pt idx="2109">
                  <c:v>15.189842224121094</c:v>
                </c:pt>
                <c:pt idx="2110">
                  <c:v>15.202851295471191</c:v>
                </c:pt>
                <c:pt idx="2111">
                  <c:v>15.215864181518555</c:v>
                </c:pt>
                <c:pt idx="2112">
                  <c:v>15.2288818359375</c:v>
                </c:pt>
                <c:pt idx="2113">
                  <c:v>15.241901397705078</c:v>
                </c:pt>
                <c:pt idx="2114">
                  <c:v>15.254925727844238</c:v>
                </c:pt>
                <c:pt idx="2115">
                  <c:v>15.267952919006348</c:v>
                </c:pt>
                <c:pt idx="2116">
                  <c:v>15.280983924865723</c:v>
                </c:pt>
                <c:pt idx="2117">
                  <c:v>15.294018745422363</c:v>
                </c:pt>
                <c:pt idx="2118">
                  <c:v>15.307056427001953</c:v>
                </c:pt>
                <c:pt idx="2119">
                  <c:v>15.320098876953125</c:v>
                </c:pt>
                <c:pt idx="2120">
                  <c:v>15.333144187927246</c:v>
                </c:pt>
                <c:pt idx="2121">
                  <c:v>15.346193313598633</c:v>
                </c:pt>
                <c:pt idx="2122">
                  <c:v>15.359246253967285</c:v>
                </c:pt>
                <c:pt idx="2123">
                  <c:v>15.372303009033203</c:v>
                </c:pt>
                <c:pt idx="2124">
                  <c:v>15.38536262512207</c:v>
                </c:pt>
                <c:pt idx="2125">
                  <c:v>15.39842700958252</c:v>
                </c:pt>
                <c:pt idx="2126">
                  <c:v>15.411494255065918</c:v>
                </c:pt>
                <c:pt idx="2127">
                  <c:v>15.424565315246582</c:v>
                </c:pt>
                <c:pt idx="2128">
                  <c:v>15.437640190124512</c:v>
                </c:pt>
                <c:pt idx="2129">
                  <c:v>15.450717926025391</c:v>
                </c:pt>
                <c:pt idx="2130">
                  <c:v>15.463800430297852</c:v>
                </c:pt>
                <c:pt idx="2131">
                  <c:v>15.476885795593262</c:v>
                </c:pt>
                <c:pt idx="2132">
                  <c:v>15.489974975585938</c:v>
                </c:pt>
                <c:pt idx="2133">
                  <c:v>15.503067016601563</c:v>
                </c:pt>
                <c:pt idx="2134">
                  <c:v>15.516162872314453</c:v>
                </c:pt>
                <c:pt idx="2135">
                  <c:v>15.529263496398926</c:v>
                </c:pt>
                <c:pt idx="2136">
                  <c:v>15.542366027832031</c:v>
                </c:pt>
                <c:pt idx="2137">
                  <c:v>15.555473327636719</c:v>
                </c:pt>
                <c:pt idx="2138">
                  <c:v>15.568584442138672</c:v>
                </c:pt>
                <c:pt idx="2139">
                  <c:v>15.581698417663574</c:v>
                </c:pt>
                <c:pt idx="2140">
                  <c:v>15.594816207885742</c:v>
                </c:pt>
                <c:pt idx="2141">
                  <c:v>15.607937812805176</c:v>
                </c:pt>
                <c:pt idx="2142">
                  <c:v>15.621062278747559</c:v>
                </c:pt>
                <c:pt idx="2143">
                  <c:v>15.634190559387207</c:v>
                </c:pt>
                <c:pt idx="2144">
                  <c:v>15.647322654724121</c:v>
                </c:pt>
                <c:pt idx="2145">
                  <c:v>15.660459518432617</c:v>
                </c:pt>
                <c:pt idx="2146">
                  <c:v>15.673599243164063</c:v>
                </c:pt>
                <c:pt idx="2147">
                  <c:v>15.686741828918457</c:v>
                </c:pt>
                <c:pt idx="2148">
                  <c:v>15.699888229370117</c:v>
                </c:pt>
                <c:pt idx="2149">
                  <c:v>15.713038444519043</c:v>
                </c:pt>
                <c:pt idx="2150">
                  <c:v>15.726192474365234</c:v>
                </c:pt>
                <c:pt idx="2151">
                  <c:v>15.739349365234375</c:v>
                </c:pt>
                <c:pt idx="2152">
                  <c:v>15.752509117126465</c:v>
                </c:pt>
                <c:pt idx="2153">
                  <c:v>15.765673637390137</c:v>
                </c:pt>
                <c:pt idx="2154">
                  <c:v>15.778841018676758</c:v>
                </c:pt>
                <c:pt idx="2155">
                  <c:v>15.792013168334961</c:v>
                </c:pt>
                <c:pt idx="2156">
                  <c:v>15.805188179016113</c:v>
                </c:pt>
                <c:pt idx="2157">
                  <c:v>15.818367004394531</c:v>
                </c:pt>
                <c:pt idx="2158">
                  <c:v>15.831549644470215</c:v>
                </c:pt>
                <c:pt idx="2159">
                  <c:v>15.844735145568848</c:v>
                </c:pt>
                <c:pt idx="2160">
                  <c:v>15.85792350769043</c:v>
                </c:pt>
                <c:pt idx="2161">
                  <c:v>15.87111759185791</c:v>
                </c:pt>
                <c:pt idx="2162">
                  <c:v>15.88431453704834</c:v>
                </c:pt>
                <c:pt idx="2163">
                  <c:v>15.897514343261719</c:v>
                </c:pt>
                <c:pt idx="2164">
                  <c:v>15.91071891784668</c:v>
                </c:pt>
                <c:pt idx="2165">
                  <c:v>15.92392635345459</c:v>
                </c:pt>
                <c:pt idx="2166">
                  <c:v>15.937136650085449</c:v>
                </c:pt>
                <c:pt idx="2167">
                  <c:v>15.950350761413574</c:v>
                </c:pt>
                <c:pt idx="2168">
                  <c:v>15.963568687438965</c:v>
                </c:pt>
                <c:pt idx="2169">
                  <c:v>15.976788520812988</c:v>
                </c:pt>
                <c:pt idx="2170">
                  <c:v>15.990012168884277</c:v>
                </c:pt>
                <c:pt idx="2171">
                  <c:v>16.003547668457031</c:v>
                </c:pt>
                <c:pt idx="2172">
                  <c:v>16.017086029052734</c:v>
                </c:pt>
                <c:pt idx="2173">
                  <c:v>16.030628204345703</c:v>
                </c:pt>
                <c:pt idx="2174">
                  <c:v>16.044174194335938</c:v>
                </c:pt>
                <c:pt idx="2175">
                  <c:v>16.057722091674805</c:v>
                </c:pt>
                <c:pt idx="2176">
                  <c:v>16.07127571105957</c:v>
                </c:pt>
                <c:pt idx="2177">
                  <c:v>16.084831237792969</c:v>
                </c:pt>
                <c:pt idx="2178">
                  <c:v>16.098392486572266</c:v>
                </c:pt>
                <c:pt idx="2179">
                  <c:v>16.111955642700195</c:v>
                </c:pt>
                <c:pt idx="2180">
                  <c:v>16.125522613525391</c:v>
                </c:pt>
                <c:pt idx="2181">
                  <c:v>16.139093399047852</c:v>
                </c:pt>
                <c:pt idx="2182">
                  <c:v>16.152666091918945</c:v>
                </c:pt>
                <c:pt idx="2183">
                  <c:v>16.166242599487305</c:v>
                </c:pt>
                <c:pt idx="2184">
                  <c:v>16.17982292175293</c:v>
                </c:pt>
                <c:pt idx="2185">
                  <c:v>16.19340705871582</c:v>
                </c:pt>
                <c:pt idx="2186">
                  <c:v>16.206995010375977</c:v>
                </c:pt>
                <c:pt idx="2187">
                  <c:v>16.220584869384766</c:v>
                </c:pt>
                <c:pt idx="2188">
                  <c:v>16.234180450439453</c:v>
                </c:pt>
                <c:pt idx="2189">
                  <c:v>16.247777938842773</c:v>
                </c:pt>
                <c:pt idx="2190">
                  <c:v>16.261379241943359</c:v>
                </c:pt>
                <c:pt idx="2191">
                  <c:v>16.274986267089844</c:v>
                </c:pt>
                <c:pt idx="2192">
                  <c:v>16.288595199584961</c:v>
                </c:pt>
                <c:pt idx="2193">
                  <c:v>16.302207946777344</c:v>
                </c:pt>
                <c:pt idx="2194">
                  <c:v>16.315824508666992</c:v>
                </c:pt>
                <c:pt idx="2195">
                  <c:v>16.329444885253906</c:v>
                </c:pt>
                <c:pt idx="2196">
                  <c:v>16.343069076538086</c:v>
                </c:pt>
                <c:pt idx="2197">
                  <c:v>16.356697082519531</c:v>
                </c:pt>
                <c:pt idx="2198">
                  <c:v>16.370326995849609</c:v>
                </c:pt>
                <c:pt idx="2199">
                  <c:v>16.383960723876953</c:v>
                </c:pt>
                <c:pt idx="2200">
                  <c:v>16.397598266601563</c:v>
                </c:pt>
                <c:pt idx="2201">
                  <c:v>16.411239624023438</c:v>
                </c:pt>
                <c:pt idx="2202">
                  <c:v>16.424882888793945</c:v>
                </c:pt>
                <c:pt idx="2203">
                  <c:v>16.438529968261719</c:v>
                </c:pt>
                <c:pt idx="2204">
                  <c:v>16.452180862426758</c:v>
                </c:pt>
                <c:pt idx="2205">
                  <c:v>16.465835571289063</c:v>
                </c:pt>
                <c:pt idx="2206">
                  <c:v>16.479494094848633</c:v>
                </c:pt>
                <c:pt idx="2207">
                  <c:v>16.493156433105469</c:v>
                </c:pt>
                <c:pt idx="2208">
                  <c:v>16.50682258605957</c:v>
                </c:pt>
                <c:pt idx="2209">
                  <c:v>16.520492553710938</c:v>
                </c:pt>
                <c:pt idx="2210">
                  <c:v>16.534164428710938</c:v>
                </c:pt>
                <c:pt idx="2211">
                  <c:v>16.547840118408203</c:v>
                </c:pt>
                <c:pt idx="2212">
                  <c:v>16.561519622802734</c:v>
                </c:pt>
                <c:pt idx="2213">
                  <c:v>16.575202941894531</c:v>
                </c:pt>
                <c:pt idx="2214">
                  <c:v>16.588890075683594</c:v>
                </c:pt>
                <c:pt idx="2215">
                  <c:v>16.602581024169922</c:v>
                </c:pt>
                <c:pt idx="2216">
                  <c:v>16.616275787353516</c:v>
                </c:pt>
                <c:pt idx="2217">
                  <c:v>16.629974365234375</c:v>
                </c:pt>
                <c:pt idx="2218">
                  <c:v>16.643674850463867</c:v>
                </c:pt>
                <c:pt idx="2219">
                  <c:v>16.657379150390625</c:v>
                </c:pt>
                <c:pt idx="2220">
                  <c:v>16.671087265014648</c:v>
                </c:pt>
                <c:pt idx="2221">
                  <c:v>16.684799194335938</c:v>
                </c:pt>
                <c:pt idx="2222">
                  <c:v>16.698513031005859</c:v>
                </c:pt>
                <c:pt idx="2223">
                  <c:v>16.71223258972168</c:v>
                </c:pt>
                <c:pt idx="2224">
                  <c:v>16.725955963134766</c:v>
                </c:pt>
                <c:pt idx="2225">
                  <c:v>16.739683151245117</c:v>
                </c:pt>
                <c:pt idx="2226">
                  <c:v>16.753410339355469</c:v>
                </c:pt>
                <c:pt idx="2227">
                  <c:v>16.767143249511719</c:v>
                </c:pt>
                <c:pt idx="2228">
                  <c:v>16.780879974365234</c:v>
                </c:pt>
                <c:pt idx="2229">
                  <c:v>16.794620513916016</c:v>
                </c:pt>
                <c:pt idx="2230">
                  <c:v>16.808364868164063</c:v>
                </c:pt>
                <c:pt idx="2231">
                  <c:v>16.822111129760742</c:v>
                </c:pt>
                <c:pt idx="2232">
                  <c:v>16.83586311340332</c:v>
                </c:pt>
                <c:pt idx="2233">
                  <c:v>16.849618911743164</c:v>
                </c:pt>
                <c:pt idx="2234">
                  <c:v>16.863374710083008</c:v>
                </c:pt>
                <c:pt idx="2235">
                  <c:v>16.877138137817383</c:v>
                </c:pt>
                <c:pt idx="2236">
                  <c:v>16.890903472900391</c:v>
                </c:pt>
                <c:pt idx="2237">
                  <c:v>16.904672622680664</c:v>
                </c:pt>
                <c:pt idx="2238">
                  <c:v>16.918441772460938</c:v>
                </c:pt>
                <c:pt idx="2239">
                  <c:v>16.932216644287109</c:v>
                </c:pt>
                <c:pt idx="2240">
                  <c:v>16.945995330810547</c:v>
                </c:pt>
                <c:pt idx="2241">
                  <c:v>16.95977783203125</c:v>
                </c:pt>
                <c:pt idx="2242">
                  <c:v>16.973564147949219</c:v>
                </c:pt>
                <c:pt idx="2243">
                  <c:v>16.987354278564453</c:v>
                </c:pt>
                <c:pt idx="2244">
                  <c:v>17.001144409179688</c:v>
                </c:pt>
                <c:pt idx="2245">
                  <c:v>17.014942169189453</c:v>
                </c:pt>
                <c:pt idx="2246">
                  <c:v>17.028741836547852</c:v>
                </c:pt>
                <c:pt idx="2247">
                  <c:v>17.042545318603516</c:v>
                </c:pt>
                <c:pt idx="2248">
                  <c:v>17.056352615356445</c:v>
                </c:pt>
                <c:pt idx="2249">
                  <c:v>17.070163726806641</c:v>
                </c:pt>
                <c:pt idx="2250">
                  <c:v>17.083978652954102</c:v>
                </c:pt>
                <c:pt idx="2251">
                  <c:v>17.097797393798828</c:v>
                </c:pt>
                <c:pt idx="2252">
                  <c:v>17.111618041992188</c:v>
                </c:pt>
                <c:pt idx="2253">
                  <c:v>17.125444412231445</c:v>
                </c:pt>
                <c:pt idx="2254">
                  <c:v>17.139272689819336</c:v>
                </c:pt>
                <c:pt idx="2255">
                  <c:v>17.153104782104492</c:v>
                </c:pt>
                <c:pt idx="2256">
                  <c:v>17.166942596435547</c:v>
                </c:pt>
                <c:pt idx="2257">
                  <c:v>17.180784225463867</c:v>
                </c:pt>
                <c:pt idx="2258">
                  <c:v>17.19462776184082</c:v>
                </c:pt>
                <c:pt idx="2259">
                  <c:v>17.208475112915039</c:v>
                </c:pt>
                <c:pt idx="2260">
                  <c:v>17.222326278686523</c:v>
                </c:pt>
                <c:pt idx="2261">
                  <c:v>17.236181259155273</c:v>
                </c:pt>
                <c:pt idx="2262">
                  <c:v>17.250040054321289</c:v>
                </c:pt>
                <c:pt idx="2263">
                  <c:v>17.26390266418457</c:v>
                </c:pt>
                <c:pt idx="2264">
                  <c:v>17.277767181396484</c:v>
                </c:pt>
                <c:pt idx="2265">
                  <c:v>17.291635513305664</c:v>
                </c:pt>
                <c:pt idx="2266">
                  <c:v>17.305507659912109</c:v>
                </c:pt>
                <c:pt idx="2267">
                  <c:v>17.31938362121582</c:v>
                </c:pt>
                <c:pt idx="2268">
                  <c:v>17.333261489868164</c:v>
                </c:pt>
                <c:pt idx="2269">
                  <c:v>17.347143173217773</c:v>
                </c:pt>
                <c:pt idx="2270">
                  <c:v>17.361028671264648</c:v>
                </c:pt>
                <c:pt idx="2271">
                  <c:v>17.374916076660156</c:v>
                </c:pt>
                <c:pt idx="2272">
                  <c:v>17.388811111450195</c:v>
                </c:pt>
                <c:pt idx="2273">
                  <c:v>17.402706146240234</c:v>
                </c:pt>
                <c:pt idx="2274">
                  <c:v>17.416606903076172</c:v>
                </c:pt>
                <c:pt idx="2275">
                  <c:v>17.430511474609375</c:v>
                </c:pt>
                <c:pt idx="2276">
                  <c:v>17.444417953491211</c:v>
                </c:pt>
                <c:pt idx="2277">
                  <c:v>17.458332061767578</c:v>
                </c:pt>
                <c:pt idx="2278">
                  <c:v>17.472248077392578</c:v>
                </c:pt>
                <c:pt idx="2279">
                  <c:v>17.486164093017578</c:v>
                </c:pt>
                <c:pt idx="2280">
                  <c:v>17.500085830688477</c:v>
                </c:pt>
                <c:pt idx="2281">
                  <c:v>17.514013290405273</c:v>
                </c:pt>
                <c:pt idx="2282">
                  <c:v>17.527942657470703</c:v>
                </c:pt>
                <c:pt idx="2283">
                  <c:v>17.541875839233398</c:v>
                </c:pt>
                <c:pt idx="2284">
                  <c:v>17.555810928344727</c:v>
                </c:pt>
                <c:pt idx="2285">
                  <c:v>17.569751739501953</c:v>
                </c:pt>
                <c:pt idx="2286">
                  <c:v>17.583696365356445</c:v>
                </c:pt>
                <c:pt idx="2287">
                  <c:v>17.597640991210938</c:v>
                </c:pt>
                <c:pt idx="2288">
                  <c:v>17.611589431762695</c:v>
                </c:pt>
                <c:pt idx="2289">
                  <c:v>17.625543594360352</c:v>
                </c:pt>
                <c:pt idx="2290">
                  <c:v>17.639501571655273</c:v>
                </c:pt>
                <c:pt idx="2291">
                  <c:v>17.653461456298828</c:v>
                </c:pt>
                <c:pt idx="2292">
                  <c:v>17.667427062988281</c:v>
                </c:pt>
                <c:pt idx="2293">
                  <c:v>17.681392669677734</c:v>
                </c:pt>
                <c:pt idx="2294">
                  <c:v>17.695363998413086</c:v>
                </c:pt>
                <c:pt idx="2295">
                  <c:v>17.709339141845703</c:v>
                </c:pt>
                <c:pt idx="2296">
                  <c:v>17.723318099975586</c:v>
                </c:pt>
                <c:pt idx="2297">
                  <c:v>17.737300872802734</c:v>
                </c:pt>
                <c:pt idx="2298">
                  <c:v>17.751287460327148</c:v>
                </c:pt>
                <c:pt idx="2299">
                  <c:v>17.765277862548828</c:v>
                </c:pt>
                <c:pt idx="2300">
                  <c:v>17.779273986816406</c:v>
                </c:pt>
                <c:pt idx="2301">
                  <c:v>17.793272018432617</c:v>
                </c:pt>
                <c:pt idx="2302">
                  <c:v>17.807271957397461</c:v>
                </c:pt>
                <c:pt idx="2303">
                  <c:v>17.821277618408203</c:v>
                </c:pt>
                <c:pt idx="2304">
                  <c:v>17.835287094116211</c:v>
                </c:pt>
                <c:pt idx="2305">
                  <c:v>17.849294662475586</c:v>
                </c:pt>
                <c:pt idx="2306">
                  <c:v>17.863311767578125</c:v>
                </c:pt>
                <c:pt idx="2307">
                  <c:v>17.877330780029297</c:v>
                </c:pt>
                <c:pt idx="2308">
                  <c:v>17.891353607177734</c:v>
                </c:pt>
                <c:pt idx="2309">
                  <c:v>17.905376434326172</c:v>
                </c:pt>
                <c:pt idx="2310">
                  <c:v>17.919406890869141</c:v>
                </c:pt>
                <c:pt idx="2311">
                  <c:v>17.933439254760742</c:v>
                </c:pt>
                <c:pt idx="2312">
                  <c:v>17.947477340698242</c:v>
                </c:pt>
                <c:pt idx="2313">
                  <c:v>17.961519241333008</c:v>
                </c:pt>
                <c:pt idx="2314">
                  <c:v>17.975561141967773</c:v>
                </c:pt>
                <c:pt idx="2315">
                  <c:v>17.989604949951172</c:v>
                </c:pt>
                <c:pt idx="2316">
                  <c:v>18.003656387329102</c:v>
                </c:pt>
                <c:pt idx="2317">
                  <c:v>18.017707824707031</c:v>
                </c:pt>
                <c:pt idx="2318">
                  <c:v>18.031764984130859</c:v>
                </c:pt>
                <c:pt idx="2319">
                  <c:v>18.045827865600586</c:v>
                </c:pt>
                <c:pt idx="2320">
                  <c:v>18.059892654418945</c:v>
                </c:pt>
                <c:pt idx="2321">
                  <c:v>18.07396125793457</c:v>
                </c:pt>
                <c:pt idx="2322">
                  <c:v>18.088035583496094</c:v>
                </c:pt>
                <c:pt idx="2323">
                  <c:v>18.102108001708984</c:v>
                </c:pt>
                <c:pt idx="2324">
                  <c:v>18.116188049316406</c:v>
                </c:pt>
                <c:pt idx="2325">
                  <c:v>18.130271911621094</c:v>
                </c:pt>
                <c:pt idx="2326">
                  <c:v>18.144357681274414</c:v>
                </c:pt>
                <c:pt idx="2327">
                  <c:v>18.158449172973633</c:v>
                </c:pt>
                <c:pt idx="2328">
                  <c:v>18.172540664672852</c:v>
                </c:pt>
                <c:pt idx="2329">
                  <c:v>18.186637878417969</c:v>
                </c:pt>
                <c:pt idx="2330">
                  <c:v>18.200738906860352</c:v>
                </c:pt>
                <c:pt idx="2331">
                  <c:v>18.21484375</c:v>
                </c:pt>
                <c:pt idx="2332">
                  <c:v>18.228950500488281</c:v>
                </c:pt>
                <c:pt idx="2333">
                  <c:v>18.243061065673828</c:v>
                </c:pt>
                <c:pt idx="2334">
                  <c:v>18.257175445556641</c:v>
                </c:pt>
                <c:pt idx="2335">
                  <c:v>18.271291732788086</c:v>
                </c:pt>
                <c:pt idx="2336">
                  <c:v>18.285415649414063</c:v>
                </c:pt>
                <c:pt idx="2337">
                  <c:v>18.299541473388672</c:v>
                </c:pt>
                <c:pt idx="2338">
                  <c:v>18.313671112060547</c:v>
                </c:pt>
                <c:pt idx="2339">
                  <c:v>18.327802658081055</c:v>
                </c:pt>
                <c:pt idx="2340">
                  <c:v>18.341938018798828</c:v>
                </c:pt>
                <c:pt idx="2341">
                  <c:v>18.3560791015625</c:v>
                </c:pt>
                <c:pt idx="2342">
                  <c:v>18.370223999023438</c:v>
                </c:pt>
                <c:pt idx="2343">
                  <c:v>18.384372711181641</c:v>
                </c:pt>
                <c:pt idx="2344">
                  <c:v>18.398525238037109</c:v>
                </c:pt>
                <c:pt idx="2345">
                  <c:v>18.412683486938477</c:v>
                </c:pt>
                <c:pt idx="2346">
                  <c:v>18.426845550537109</c:v>
                </c:pt>
                <c:pt idx="2347">
                  <c:v>18.441009521484375</c:v>
                </c:pt>
                <c:pt idx="2348">
                  <c:v>18.455177307128906</c:v>
                </c:pt>
                <c:pt idx="2349">
                  <c:v>18.469348907470703</c:v>
                </c:pt>
                <c:pt idx="2350">
                  <c:v>18.483522415161133</c:v>
                </c:pt>
                <c:pt idx="2351">
                  <c:v>18.497699737548828</c:v>
                </c:pt>
                <c:pt idx="2352">
                  <c:v>18.511882781982422</c:v>
                </c:pt>
                <c:pt idx="2353">
                  <c:v>18.526069641113281</c:v>
                </c:pt>
                <c:pt idx="2354">
                  <c:v>18.540262222290039</c:v>
                </c:pt>
                <c:pt idx="2355">
                  <c:v>18.55445671081543</c:v>
                </c:pt>
                <c:pt idx="2356">
                  <c:v>18.568653106689453</c:v>
                </c:pt>
                <c:pt idx="2357">
                  <c:v>18.582853317260742</c:v>
                </c:pt>
                <c:pt idx="2358">
                  <c:v>18.597057342529297</c:v>
                </c:pt>
                <c:pt idx="2359">
                  <c:v>18.61126708984375</c:v>
                </c:pt>
                <c:pt idx="2360">
                  <c:v>18.625476837158203</c:v>
                </c:pt>
                <c:pt idx="2361">
                  <c:v>18.639692306518555</c:v>
                </c:pt>
                <c:pt idx="2362">
                  <c:v>18.653909683227539</c:v>
                </c:pt>
                <c:pt idx="2363">
                  <c:v>18.668130874633789</c:v>
                </c:pt>
                <c:pt idx="2364">
                  <c:v>18.682355880737305</c:v>
                </c:pt>
                <c:pt idx="2365">
                  <c:v>18.696586608886719</c:v>
                </c:pt>
                <c:pt idx="2366">
                  <c:v>18.710821151733398</c:v>
                </c:pt>
                <c:pt idx="2367">
                  <c:v>18.725053787231445</c:v>
                </c:pt>
                <c:pt idx="2368">
                  <c:v>18.739292144775391</c:v>
                </c:pt>
                <c:pt idx="2369">
                  <c:v>18.753536224365234</c:v>
                </c:pt>
                <c:pt idx="2370">
                  <c:v>18.767787933349609</c:v>
                </c:pt>
                <c:pt idx="2371">
                  <c:v>18.782035827636719</c:v>
                </c:pt>
                <c:pt idx="2372">
                  <c:v>18.796291351318359</c:v>
                </c:pt>
                <c:pt idx="2373">
                  <c:v>18.810546875</c:v>
                </c:pt>
                <c:pt idx="2374">
                  <c:v>18.824808120727539</c:v>
                </c:pt>
                <c:pt idx="2375">
                  <c:v>18.839075088500977</c:v>
                </c:pt>
                <c:pt idx="2376">
                  <c:v>18.853342056274414</c:v>
                </c:pt>
                <c:pt idx="2377">
                  <c:v>18.867610931396484</c:v>
                </c:pt>
                <c:pt idx="2378">
                  <c:v>18.881885528564453</c:v>
                </c:pt>
                <c:pt idx="2379">
                  <c:v>18.896162033081055</c:v>
                </c:pt>
                <c:pt idx="2380">
                  <c:v>18.910444259643555</c:v>
                </c:pt>
                <c:pt idx="2381">
                  <c:v>18.92473030090332</c:v>
                </c:pt>
                <c:pt idx="2382">
                  <c:v>18.939018249511719</c:v>
                </c:pt>
                <c:pt idx="2383">
                  <c:v>18.953311920166016</c:v>
                </c:pt>
                <c:pt idx="2384">
                  <c:v>18.967611312866211</c:v>
                </c:pt>
                <c:pt idx="2385">
                  <c:v>18.981910705566406</c:v>
                </c:pt>
                <c:pt idx="2386">
                  <c:v>18.9962158203125</c:v>
                </c:pt>
                <c:pt idx="2387">
                  <c:v>19.010522842407227</c:v>
                </c:pt>
                <c:pt idx="2388">
                  <c:v>19.024835586547852</c:v>
                </c:pt>
                <c:pt idx="2389">
                  <c:v>19.039154052734375</c:v>
                </c:pt>
                <c:pt idx="2390">
                  <c:v>19.053474426269531</c:v>
                </c:pt>
                <c:pt idx="2391">
                  <c:v>19.067798614501953</c:v>
                </c:pt>
                <c:pt idx="2392">
                  <c:v>19.082128524780273</c:v>
                </c:pt>
                <c:pt idx="2393">
                  <c:v>19.096460342407227</c:v>
                </c:pt>
                <c:pt idx="2394">
                  <c:v>19.110795974731445</c:v>
                </c:pt>
                <c:pt idx="2395">
                  <c:v>19.125133514404297</c:v>
                </c:pt>
                <c:pt idx="2396">
                  <c:v>19.139476776123047</c:v>
                </c:pt>
                <c:pt idx="2397">
                  <c:v>19.153825759887695</c:v>
                </c:pt>
                <c:pt idx="2398">
                  <c:v>19.168174743652344</c:v>
                </c:pt>
                <c:pt idx="2399">
                  <c:v>19.182529449462891</c:v>
                </c:pt>
                <c:pt idx="2400">
                  <c:v>19.196887969970703</c:v>
                </c:pt>
                <c:pt idx="2401">
                  <c:v>19.211248397827148</c:v>
                </c:pt>
                <c:pt idx="2402">
                  <c:v>19.225612640380859</c:v>
                </c:pt>
                <c:pt idx="2403">
                  <c:v>19.239982604980469</c:v>
                </c:pt>
                <c:pt idx="2404">
                  <c:v>19.254356384277344</c:v>
                </c:pt>
                <c:pt idx="2405">
                  <c:v>19.268733978271484</c:v>
                </c:pt>
                <c:pt idx="2406">
                  <c:v>19.283113479614258</c:v>
                </c:pt>
                <c:pt idx="2407">
                  <c:v>19.297496795654297</c:v>
                </c:pt>
                <c:pt idx="2408">
                  <c:v>19.311885833740234</c:v>
                </c:pt>
                <c:pt idx="2409">
                  <c:v>19.326276779174805</c:v>
                </c:pt>
                <c:pt idx="2410">
                  <c:v>19.340671539306641</c:v>
                </c:pt>
                <c:pt idx="2411">
                  <c:v>19.355070114135742</c:v>
                </c:pt>
                <c:pt idx="2412">
                  <c:v>19.369474411010742</c:v>
                </c:pt>
                <c:pt idx="2413">
                  <c:v>19.383880615234375</c:v>
                </c:pt>
                <c:pt idx="2414">
                  <c:v>19.398288726806641</c:v>
                </c:pt>
                <c:pt idx="2415">
                  <c:v>19.412702560424805</c:v>
                </c:pt>
                <c:pt idx="2416">
                  <c:v>19.427118301391602</c:v>
                </c:pt>
                <c:pt idx="2417">
                  <c:v>19.441539764404297</c:v>
                </c:pt>
                <c:pt idx="2418">
                  <c:v>19.455963134765625</c:v>
                </c:pt>
                <c:pt idx="2419">
                  <c:v>19.470390319824219</c:v>
                </c:pt>
                <c:pt idx="2420">
                  <c:v>19.484817504882813</c:v>
                </c:pt>
                <c:pt idx="2421">
                  <c:v>19.49925422668457</c:v>
                </c:pt>
                <c:pt idx="2422">
                  <c:v>19.513690948486328</c:v>
                </c:pt>
                <c:pt idx="2423">
                  <c:v>19.528133392333984</c:v>
                </c:pt>
                <c:pt idx="2424">
                  <c:v>19.542577743530273</c:v>
                </c:pt>
                <c:pt idx="2425">
                  <c:v>19.557024002075195</c:v>
                </c:pt>
                <c:pt idx="2426">
                  <c:v>19.571475982666016</c:v>
                </c:pt>
                <c:pt idx="2427">
                  <c:v>19.585931777954102</c:v>
                </c:pt>
                <c:pt idx="2428">
                  <c:v>19.60038948059082</c:v>
                </c:pt>
                <c:pt idx="2429">
                  <c:v>19.61485481262207</c:v>
                </c:pt>
                <c:pt idx="2430">
                  <c:v>19.62932014465332</c:v>
                </c:pt>
                <c:pt idx="2431">
                  <c:v>19.643791198730469</c:v>
                </c:pt>
                <c:pt idx="2432">
                  <c:v>19.658262252807617</c:v>
                </c:pt>
                <c:pt idx="2433">
                  <c:v>19.672740936279297</c:v>
                </c:pt>
                <c:pt idx="2434">
                  <c:v>19.687219619750977</c:v>
                </c:pt>
                <c:pt idx="2435">
                  <c:v>19.701702117919922</c:v>
                </c:pt>
                <c:pt idx="2436">
                  <c:v>19.716192245483398</c:v>
                </c:pt>
                <c:pt idx="2437">
                  <c:v>19.730684280395508</c:v>
                </c:pt>
                <c:pt idx="2438">
                  <c:v>19.74517822265625</c:v>
                </c:pt>
                <c:pt idx="2439">
                  <c:v>19.759677886962891</c:v>
                </c:pt>
                <c:pt idx="2440">
                  <c:v>19.774181365966797</c:v>
                </c:pt>
                <c:pt idx="2441">
                  <c:v>19.788686752319336</c:v>
                </c:pt>
                <c:pt idx="2442">
                  <c:v>19.803197860717773</c:v>
                </c:pt>
                <c:pt idx="2443">
                  <c:v>19.817712783813477</c:v>
                </c:pt>
                <c:pt idx="2444">
                  <c:v>19.832229614257813</c:v>
                </c:pt>
                <c:pt idx="2445">
                  <c:v>19.846752166748047</c:v>
                </c:pt>
                <c:pt idx="2446">
                  <c:v>19.861276626586914</c:v>
                </c:pt>
                <c:pt idx="2447">
                  <c:v>19.87580680847168</c:v>
                </c:pt>
                <c:pt idx="2448">
                  <c:v>19.890338897705078</c:v>
                </c:pt>
                <c:pt idx="2449">
                  <c:v>19.904874801635742</c:v>
                </c:pt>
                <c:pt idx="2450">
                  <c:v>19.919414520263672</c:v>
                </c:pt>
                <c:pt idx="2451">
                  <c:v>19.933958053588867</c:v>
                </c:pt>
                <c:pt idx="2452">
                  <c:v>19.948505401611328</c:v>
                </c:pt>
                <c:pt idx="2453">
                  <c:v>19.963054656982422</c:v>
                </c:pt>
                <c:pt idx="2454">
                  <c:v>19.977607727050781</c:v>
                </c:pt>
                <c:pt idx="2455">
                  <c:v>19.992166519165039</c:v>
                </c:pt>
                <c:pt idx="2456">
                  <c:v>20.00672721862793</c:v>
                </c:pt>
                <c:pt idx="2457">
                  <c:v>20.021293640136719</c:v>
                </c:pt>
                <c:pt idx="2458">
                  <c:v>20.035860061645508</c:v>
                </c:pt>
                <c:pt idx="2459">
                  <c:v>20.050434112548828</c:v>
                </c:pt>
                <c:pt idx="2460">
                  <c:v>20.065006256103516</c:v>
                </c:pt>
                <c:pt idx="2461">
                  <c:v>20.079586029052734</c:v>
                </c:pt>
                <c:pt idx="2462">
                  <c:v>20.094169616699219</c:v>
                </c:pt>
                <c:pt idx="2463">
                  <c:v>20.108757019042969</c:v>
                </c:pt>
                <c:pt idx="2464">
                  <c:v>20.123346328735352</c:v>
                </c:pt>
                <c:pt idx="2465">
                  <c:v>20.137941360473633</c:v>
                </c:pt>
                <c:pt idx="2466">
                  <c:v>20.152538299560547</c:v>
                </c:pt>
                <c:pt idx="2467">
                  <c:v>20.167137145996094</c:v>
                </c:pt>
                <c:pt idx="2468">
                  <c:v>20.181741714477539</c:v>
                </c:pt>
                <c:pt idx="2469">
                  <c:v>20.196346282958984</c:v>
                </c:pt>
                <c:pt idx="2470">
                  <c:v>20.210956573486328</c:v>
                </c:pt>
                <c:pt idx="2471">
                  <c:v>20.225570678710938</c:v>
                </c:pt>
                <c:pt idx="2472">
                  <c:v>20.24018669128418</c:v>
                </c:pt>
                <c:pt idx="2473">
                  <c:v>20.25480842590332</c:v>
                </c:pt>
                <c:pt idx="2474">
                  <c:v>20.269433975219727</c:v>
                </c:pt>
                <c:pt idx="2475">
                  <c:v>20.284061431884766</c:v>
                </c:pt>
                <c:pt idx="2476">
                  <c:v>20.298694610595703</c:v>
                </c:pt>
                <c:pt idx="2477">
                  <c:v>20.313329696655273</c:v>
                </c:pt>
                <c:pt idx="2478">
                  <c:v>20.327966690063477</c:v>
                </c:pt>
                <c:pt idx="2479">
                  <c:v>20.342611312866211</c:v>
                </c:pt>
                <c:pt idx="2480">
                  <c:v>20.357254028320313</c:v>
                </c:pt>
                <c:pt idx="2481">
                  <c:v>20.371904373168945</c:v>
                </c:pt>
                <c:pt idx="2482">
                  <c:v>20.386554718017578</c:v>
                </c:pt>
                <c:pt idx="2483">
                  <c:v>20.401210784912109</c:v>
                </c:pt>
                <c:pt idx="2484">
                  <c:v>20.415870666503906</c:v>
                </c:pt>
                <c:pt idx="2485">
                  <c:v>20.430532455444336</c:v>
                </c:pt>
                <c:pt idx="2486">
                  <c:v>20.445199966430664</c:v>
                </c:pt>
                <c:pt idx="2487">
                  <c:v>20.459869384765625</c:v>
                </c:pt>
                <c:pt idx="2488">
                  <c:v>20.474542617797852</c:v>
                </c:pt>
                <c:pt idx="2489">
                  <c:v>20.489221572875977</c:v>
                </c:pt>
                <c:pt idx="2490">
                  <c:v>20.503904342651367</c:v>
                </c:pt>
                <c:pt idx="2491">
                  <c:v>20.518590927124023</c:v>
                </c:pt>
                <c:pt idx="2492">
                  <c:v>20.533279418945313</c:v>
                </c:pt>
                <c:pt idx="2493">
                  <c:v>20.547971725463867</c:v>
                </c:pt>
                <c:pt idx="2494">
                  <c:v>20.562667846679688</c:v>
                </c:pt>
                <c:pt idx="2495">
                  <c:v>20.577367782592773</c:v>
                </c:pt>
                <c:pt idx="2496">
                  <c:v>20.592071533203125</c:v>
                </c:pt>
                <c:pt idx="2497">
                  <c:v>20.606779098510742</c:v>
                </c:pt>
                <c:pt idx="2498">
                  <c:v>20.621488571166992</c:v>
                </c:pt>
                <c:pt idx="2499">
                  <c:v>20.636201858520508</c:v>
                </c:pt>
                <c:pt idx="2500">
                  <c:v>20.650918960571289</c:v>
                </c:pt>
                <c:pt idx="2501">
                  <c:v>20.665641784667969</c:v>
                </c:pt>
                <c:pt idx="2502">
                  <c:v>20.680364608764648</c:v>
                </c:pt>
                <c:pt idx="2503">
                  <c:v>20.695091247558594</c:v>
                </c:pt>
                <c:pt idx="2504">
                  <c:v>20.709823608398438</c:v>
                </c:pt>
                <c:pt idx="2505">
                  <c:v>20.724557876586914</c:v>
                </c:pt>
                <c:pt idx="2506">
                  <c:v>20.739294052124023</c:v>
                </c:pt>
                <c:pt idx="2507">
                  <c:v>20.754035949707031</c:v>
                </c:pt>
                <c:pt idx="2508">
                  <c:v>20.768781661987305</c:v>
                </c:pt>
                <c:pt idx="2509">
                  <c:v>20.783529281616211</c:v>
                </c:pt>
                <c:pt idx="2510">
                  <c:v>20.798282623291016</c:v>
                </c:pt>
                <c:pt idx="2511">
                  <c:v>20.813037872314453</c:v>
                </c:pt>
                <c:pt idx="2512">
                  <c:v>20.827796936035156</c:v>
                </c:pt>
                <c:pt idx="2513">
                  <c:v>20.842559814453125</c:v>
                </c:pt>
                <c:pt idx="2514">
                  <c:v>20.857324600219727</c:v>
                </c:pt>
                <c:pt idx="2515">
                  <c:v>20.872093200683594</c:v>
                </c:pt>
                <c:pt idx="2516">
                  <c:v>20.886865615844727</c:v>
                </c:pt>
                <c:pt idx="2517">
                  <c:v>20.901643753051758</c:v>
                </c:pt>
                <c:pt idx="2518">
                  <c:v>20.916421890258789</c:v>
                </c:pt>
                <c:pt idx="2519">
                  <c:v>20.931205749511719</c:v>
                </c:pt>
                <c:pt idx="2520">
                  <c:v>20.945991516113281</c:v>
                </c:pt>
                <c:pt idx="2521">
                  <c:v>20.960781097412109</c:v>
                </c:pt>
                <c:pt idx="2522">
                  <c:v>20.975574493408203</c:v>
                </c:pt>
                <c:pt idx="2523">
                  <c:v>20.990371704101563</c:v>
                </c:pt>
                <c:pt idx="2524">
                  <c:v>21.005172729492188</c:v>
                </c:pt>
                <c:pt idx="2525">
                  <c:v>21.019975662231445</c:v>
                </c:pt>
                <c:pt idx="2526">
                  <c:v>21.034784317016602</c:v>
                </c:pt>
                <c:pt idx="2527">
                  <c:v>21.049594879150391</c:v>
                </c:pt>
                <c:pt idx="2528">
                  <c:v>21.064409255981445</c:v>
                </c:pt>
                <c:pt idx="2529">
                  <c:v>21.079227447509766</c:v>
                </c:pt>
                <c:pt idx="2530">
                  <c:v>21.094049453735352</c:v>
                </c:pt>
                <c:pt idx="2531">
                  <c:v>21.10887336730957</c:v>
                </c:pt>
                <c:pt idx="2532">
                  <c:v>21.123701095581055</c:v>
                </c:pt>
                <c:pt idx="2533">
                  <c:v>21.138532638549805</c:v>
                </c:pt>
                <c:pt idx="2534">
                  <c:v>21.153366088867188</c:v>
                </c:pt>
                <c:pt idx="2535">
                  <c:v>21.168205261230469</c:v>
                </c:pt>
                <c:pt idx="2536">
                  <c:v>21.183048248291016</c:v>
                </c:pt>
                <c:pt idx="2537">
                  <c:v>21.197893142700195</c:v>
                </c:pt>
                <c:pt idx="2538">
                  <c:v>21.212741851806641</c:v>
                </c:pt>
                <c:pt idx="2539">
                  <c:v>21.227594375610352</c:v>
                </c:pt>
                <c:pt idx="2540">
                  <c:v>21.242450714111328</c:v>
                </c:pt>
                <c:pt idx="2541">
                  <c:v>21.25731086730957</c:v>
                </c:pt>
                <c:pt idx="2542">
                  <c:v>21.272172927856445</c:v>
                </c:pt>
                <c:pt idx="2543">
                  <c:v>21.287040710449219</c:v>
                </c:pt>
                <c:pt idx="2544">
                  <c:v>21.301908493041992</c:v>
                </c:pt>
                <c:pt idx="2545">
                  <c:v>21.316781997680664</c:v>
                </c:pt>
                <c:pt idx="2546">
                  <c:v>21.331659317016602</c:v>
                </c:pt>
                <c:pt idx="2547">
                  <c:v>21.346540451049805</c:v>
                </c:pt>
                <c:pt idx="2548">
                  <c:v>21.361423492431641</c:v>
                </c:pt>
                <c:pt idx="2549">
                  <c:v>21.376310348510742</c:v>
                </c:pt>
                <c:pt idx="2550">
                  <c:v>21.391201019287109</c:v>
                </c:pt>
                <c:pt idx="2551">
                  <c:v>21.406095504760742</c:v>
                </c:pt>
                <c:pt idx="2552">
                  <c:v>21.420993804931641</c:v>
                </c:pt>
                <c:pt idx="2553">
                  <c:v>21.435894012451172</c:v>
                </c:pt>
                <c:pt idx="2554">
                  <c:v>21.450799942016602</c:v>
                </c:pt>
                <c:pt idx="2555">
                  <c:v>21.465707778930664</c:v>
                </c:pt>
                <c:pt idx="2556">
                  <c:v>21.480619430541992</c:v>
                </c:pt>
                <c:pt idx="2557">
                  <c:v>21.495532989501953</c:v>
                </c:pt>
                <c:pt idx="2558">
                  <c:v>21.510452270507813</c:v>
                </c:pt>
                <c:pt idx="2559">
                  <c:v>21.525373458862305</c:v>
                </c:pt>
                <c:pt idx="2560">
                  <c:v>21.540298461914063</c:v>
                </c:pt>
                <c:pt idx="2561">
                  <c:v>21.555227279663086</c:v>
                </c:pt>
                <c:pt idx="2562">
                  <c:v>21.570159912109375</c:v>
                </c:pt>
                <c:pt idx="2563">
                  <c:v>21.58509635925293</c:v>
                </c:pt>
                <c:pt idx="2564">
                  <c:v>21.600034713745117</c:v>
                </c:pt>
                <c:pt idx="2565">
                  <c:v>21.61497688293457</c:v>
                </c:pt>
                <c:pt idx="2566">
                  <c:v>21.629922866821289</c:v>
                </c:pt>
                <c:pt idx="2567">
                  <c:v>21.644872665405273</c:v>
                </c:pt>
                <c:pt idx="2568">
                  <c:v>21.659826278686523</c:v>
                </c:pt>
                <c:pt idx="2569">
                  <c:v>21.674781799316406</c:v>
                </c:pt>
                <c:pt idx="2570">
                  <c:v>21.689743041992188</c:v>
                </c:pt>
                <c:pt idx="2571">
                  <c:v>21.704706192016602</c:v>
                </c:pt>
                <c:pt idx="2572">
                  <c:v>21.719673156738281</c:v>
                </c:pt>
                <c:pt idx="2573">
                  <c:v>21.734643936157227</c:v>
                </c:pt>
                <c:pt idx="2574">
                  <c:v>21.749616622924805</c:v>
                </c:pt>
                <c:pt idx="2575">
                  <c:v>21.764593124389648</c:v>
                </c:pt>
                <c:pt idx="2576">
                  <c:v>21.779575347900391</c:v>
                </c:pt>
                <c:pt idx="2577">
                  <c:v>21.794559478759766</c:v>
                </c:pt>
                <c:pt idx="2578">
                  <c:v>21.809545516967773</c:v>
                </c:pt>
                <c:pt idx="2579">
                  <c:v>21.82453727722168</c:v>
                </c:pt>
                <c:pt idx="2580">
                  <c:v>21.839530944824219</c:v>
                </c:pt>
                <c:pt idx="2581">
                  <c:v>21.854530334472656</c:v>
                </c:pt>
                <c:pt idx="2582">
                  <c:v>21.869531631469727</c:v>
                </c:pt>
                <c:pt idx="2583">
                  <c:v>21.88453483581543</c:v>
                </c:pt>
                <c:pt idx="2584">
                  <c:v>21.899543762207031</c:v>
                </c:pt>
                <c:pt idx="2585">
                  <c:v>21.914556503295898</c:v>
                </c:pt>
                <c:pt idx="2586">
                  <c:v>21.929571151733398</c:v>
                </c:pt>
                <c:pt idx="2587">
                  <c:v>21.944589614868164</c:v>
                </c:pt>
                <c:pt idx="2588">
                  <c:v>21.959611892700195</c:v>
                </c:pt>
                <c:pt idx="2589">
                  <c:v>21.974637985229492</c:v>
                </c:pt>
                <c:pt idx="2590">
                  <c:v>21.989665985107422</c:v>
                </c:pt>
                <c:pt idx="2591">
                  <c:v>22.00469970703125</c:v>
                </c:pt>
                <c:pt idx="2592">
                  <c:v>22.019735336303711</c:v>
                </c:pt>
                <c:pt idx="2593">
                  <c:v>22.034774780273438</c:v>
                </c:pt>
                <c:pt idx="2594">
                  <c:v>22.049816131591797</c:v>
                </c:pt>
                <c:pt idx="2595">
                  <c:v>22.064863204956055</c:v>
                </c:pt>
                <c:pt idx="2596">
                  <c:v>22.079912185668945</c:v>
                </c:pt>
                <c:pt idx="2597">
                  <c:v>22.094966888427734</c:v>
                </c:pt>
                <c:pt idx="2598">
                  <c:v>22.110023498535156</c:v>
                </c:pt>
                <c:pt idx="2599">
                  <c:v>22.125082015991211</c:v>
                </c:pt>
                <c:pt idx="2600">
                  <c:v>22.140146255493164</c:v>
                </c:pt>
                <c:pt idx="2601">
                  <c:v>22.155214309692383</c:v>
                </c:pt>
                <c:pt idx="2602">
                  <c:v>22.170284271240234</c:v>
                </c:pt>
                <c:pt idx="2603">
                  <c:v>22.185358047485352</c:v>
                </c:pt>
                <c:pt idx="2604">
                  <c:v>22.200435638427734</c:v>
                </c:pt>
                <c:pt idx="2605">
                  <c:v>22.21551513671875</c:v>
                </c:pt>
                <c:pt idx="2606">
                  <c:v>22.230600357055664</c:v>
                </c:pt>
                <c:pt idx="2607">
                  <c:v>22.245687484741211</c:v>
                </c:pt>
                <c:pt idx="2608">
                  <c:v>22.260778427124023</c:v>
                </c:pt>
                <c:pt idx="2609">
                  <c:v>22.275873184204102</c:v>
                </c:pt>
                <c:pt idx="2610">
                  <c:v>22.290971755981445</c:v>
                </c:pt>
                <c:pt idx="2611">
                  <c:v>22.306074142456055</c:v>
                </c:pt>
                <c:pt idx="2612">
                  <c:v>22.321178436279297</c:v>
                </c:pt>
                <c:pt idx="2613">
                  <c:v>22.336286544799805</c:v>
                </c:pt>
                <c:pt idx="2614">
                  <c:v>22.351398468017578</c:v>
                </c:pt>
                <c:pt idx="2615">
                  <c:v>22.366514205932617</c:v>
                </c:pt>
                <c:pt idx="2616">
                  <c:v>22.381633758544922</c:v>
                </c:pt>
                <c:pt idx="2617">
                  <c:v>22.396755218505859</c:v>
                </c:pt>
                <c:pt idx="2618">
                  <c:v>22.411880493164063</c:v>
                </c:pt>
                <c:pt idx="2619">
                  <c:v>22.427009582519531</c:v>
                </c:pt>
                <c:pt idx="2620">
                  <c:v>22.442142486572266</c:v>
                </c:pt>
                <c:pt idx="2621">
                  <c:v>22.457279205322266</c:v>
                </c:pt>
                <c:pt idx="2622">
                  <c:v>22.472417831420898</c:v>
                </c:pt>
                <c:pt idx="2623">
                  <c:v>22.487560272216797</c:v>
                </c:pt>
                <c:pt idx="2624">
                  <c:v>22.502706527709961</c:v>
                </c:pt>
                <c:pt idx="2625">
                  <c:v>22.517856597900391</c:v>
                </c:pt>
                <c:pt idx="2626">
                  <c:v>22.533010482788086</c:v>
                </c:pt>
                <c:pt idx="2627">
                  <c:v>22.548168182373047</c:v>
                </c:pt>
                <c:pt idx="2628">
                  <c:v>22.563329696655273</c:v>
                </c:pt>
                <c:pt idx="2629">
                  <c:v>22.578493118286133</c:v>
                </c:pt>
                <c:pt idx="2630">
                  <c:v>22.593660354614258</c:v>
                </c:pt>
                <c:pt idx="2631">
                  <c:v>22.608829498291016</c:v>
                </c:pt>
                <c:pt idx="2632">
                  <c:v>22.624004364013672</c:v>
                </c:pt>
                <c:pt idx="2633">
                  <c:v>22.639183044433594</c:v>
                </c:pt>
                <c:pt idx="2634">
                  <c:v>22.654363632202148</c:v>
                </c:pt>
                <c:pt idx="2635">
                  <c:v>22.669548034667969</c:v>
                </c:pt>
                <c:pt idx="2636">
                  <c:v>22.684736251831055</c:v>
                </c:pt>
                <c:pt idx="2637">
                  <c:v>22.699926376342773</c:v>
                </c:pt>
                <c:pt idx="2638">
                  <c:v>22.715122222900391</c:v>
                </c:pt>
                <c:pt idx="2639">
                  <c:v>22.730321884155273</c:v>
                </c:pt>
                <c:pt idx="2640">
                  <c:v>22.745523452758789</c:v>
                </c:pt>
                <c:pt idx="2641">
                  <c:v>22.76072883605957</c:v>
                </c:pt>
                <c:pt idx="2642">
                  <c:v>22.775938034057617</c:v>
                </c:pt>
                <c:pt idx="2643">
                  <c:v>22.79115104675293</c:v>
                </c:pt>
                <c:pt idx="2644">
                  <c:v>22.806365966796875</c:v>
                </c:pt>
                <c:pt idx="2645">
                  <c:v>22.821584701538086</c:v>
                </c:pt>
                <c:pt idx="2646">
                  <c:v>22.836807250976563</c:v>
                </c:pt>
                <c:pt idx="2647">
                  <c:v>22.852033615112305</c:v>
                </c:pt>
                <c:pt idx="2648">
                  <c:v>22.867263793945313</c:v>
                </c:pt>
                <c:pt idx="2649">
                  <c:v>22.882497787475586</c:v>
                </c:pt>
                <c:pt idx="2650">
                  <c:v>22.897733688354492</c:v>
                </c:pt>
                <c:pt idx="2651">
                  <c:v>22.912975311279297</c:v>
                </c:pt>
                <c:pt idx="2652">
                  <c:v>22.928218841552734</c:v>
                </c:pt>
                <c:pt idx="2653">
                  <c:v>22.94346809387207</c:v>
                </c:pt>
                <c:pt idx="2654">
                  <c:v>22.958719253540039</c:v>
                </c:pt>
                <c:pt idx="2655">
                  <c:v>22.973972320556641</c:v>
                </c:pt>
                <c:pt idx="2656">
                  <c:v>22.989229202270508</c:v>
                </c:pt>
                <c:pt idx="2657">
                  <c:v>23.004489898681641</c:v>
                </c:pt>
                <c:pt idx="2658">
                  <c:v>23.019752502441406</c:v>
                </c:pt>
                <c:pt idx="2659">
                  <c:v>23.035022735595703</c:v>
                </c:pt>
                <c:pt idx="2660">
                  <c:v>23.05029296875</c:v>
                </c:pt>
                <c:pt idx="2661">
                  <c:v>23.065567016601563</c:v>
                </c:pt>
                <c:pt idx="2662">
                  <c:v>23.080846786499023</c:v>
                </c:pt>
                <c:pt idx="2663">
                  <c:v>23.096128463745117</c:v>
                </c:pt>
                <c:pt idx="2664">
                  <c:v>23.111413955688477</c:v>
                </c:pt>
                <c:pt idx="2665">
                  <c:v>23.126701354980469</c:v>
                </c:pt>
                <c:pt idx="2666">
                  <c:v>23.141994476318359</c:v>
                </c:pt>
                <c:pt idx="2667">
                  <c:v>23.157289505004883</c:v>
                </c:pt>
                <c:pt idx="2668">
                  <c:v>23.172588348388672</c:v>
                </c:pt>
                <c:pt idx="2669">
                  <c:v>23.187889099121094</c:v>
                </c:pt>
                <c:pt idx="2670">
                  <c:v>23.203195571899414</c:v>
                </c:pt>
                <c:pt idx="2671">
                  <c:v>23.218505859375</c:v>
                </c:pt>
                <c:pt idx="2672">
                  <c:v>23.233818054199219</c:v>
                </c:pt>
                <c:pt idx="2673">
                  <c:v>23.249134063720703</c:v>
                </c:pt>
                <c:pt idx="2674">
                  <c:v>23.264453887939453</c:v>
                </c:pt>
                <c:pt idx="2675">
                  <c:v>23.279775619506836</c:v>
                </c:pt>
                <c:pt idx="2676">
                  <c:v>23.295103073120117</c:v>
                </c:pt>
                <c:pt idx="2677">
                  <c:v>23.310432434082031</c:v>
                </c:pt>
                <c:pt idx="2678">
                  <c:v>23.325767517089844</c:v>
                </c:pt>
                <c:pt idx="2679">
                  <c:v>23.341104507446289</c:v>
                </c:pt>
                <c:pt idx="2680">
                  <c:v>23.3564453125</c:v>
                </c:pt>
                <c:pt idx="2681">
                  <c:v>23.371789932250977</c:v>
                </c:pt>
                <c:pt idx="2682">
                  <c:v>23.387136459350586</c:v>
                </c:pt>
                <c:pt idx="2683">
                  <c:v>23.402488708496094</c:v>
                </c:pt>
                <c:pt idx="2684">
                  <c:v>23.417840957641602</c:v>
                </c:pt>
                <c:pt idx="2685">
                  <c:v>23.433198928833008</c:v>
                </c:pt>
                <c:pt idx="2686">
                  <c:v>23.44856071472168</c:v>
                </c:pt>
                <c:pt idx="2687">
                  <c:v>23.463924407958984</c:v>
                </c:pt>
                <c:pt idx="2688">
                  <c:v>23.479293823242188</c:v>
                </c:pt>
                <c:pt idx="2689">
                  <c:v>23.494665145874023</c:v>
                </c:pt>
                <c:pt idx="2690">
                  <c:v>23.510042190551758</c:v>
                </c:pt>
                <c:pt idx="2691">
                  <c:v>23.525421142578125</c:v>
                </c:pt>
                <c:pt idx="2692">
                  <c:v>23.540805816650391</c:v>
                </c:pt>
                <c:pt idx="2693">
                  <c:v>23.556190490722656</c:v>
                </c:pt>
                <c:pt idx="2694">
                  <c:v>23.57158088684082</c:v>
                </c:pt>
                <c:pt idx="2695">
                  <c:v>23.58697509765625</c:v>
                </c:pt>
                <c:pt idx="2696">
                  <c:v>23.602371215820313</c:v>
                </c:pt>
                <c:pt idx="2697">
                  <c:v>23.617771148681641</c:v>
                </c:pt>
                <c:pt idx="2698">
                  <c:v>23.633174896240234</c:v>
                </c:pt>
                <c:pt idx="2699">
                  <c:v>23.648582458496094</c:v>
                </c:pt>
                <c:pt idx="2700">
                  <c:v>23.663991928100586</c:v>
                </c:pt>
                <c:pt idx="2701">
                  <c:v>23.679407119750977</c:v>
                </c:pt>
                <c:pt idx="2702">
                  <c:v>23.69482421875</c:v>
                </c:pt>
                <c:pt idx="2703">
                  <c:v>23.710245132446289</c:v>
                </c:pt>
                <c:pt idx="2704">
                  <c:v>23.725669860839844</c:v>
                </c:pt>
                <c:pt idx="2705">
                  <c:v>23.741098403930664</c:v>
                </c:pt>
                <c:pt idx="2706">
                  <c:v>23.75653076171875</c:v>
                </c:pt>
                <c:pt idx="2707">
                  <c:v>23.771965026855469</c:v>
                </c:pt>
                <c:pt idx="2708">
                  <c:v>23.787403106689453</c:v>
                </c:pt>
                <c:pt idx="2709">
                  <c:v>23.802845001220703</c:v>
                </c:pt>
                <c:pt idx="2710">
                  <c:v>23.818290710449219</c:v>
                </c:pt>
                <c:pt idx="2711">
                  <c:v>23.833740234375</c:v>
                </c:pt>
                <c:pt idx="2712">
                  <c:v>23.849193572998047</c:v>
                </c:pt>
                <c:pt idx="2713">
                  <c:v>23.864650726318359</c:v>
                </c:pt>
                <c:pt idx="2714">
                  <c:v>23.880109786987305</c:v>
                </c:pt>
                <c:pt idx="2715">
                  <c:v>23.895570755004883</c:v>
                </c:pt>
                <c:pt idx="2716">
                  <c:v>23.911037445068359</c:v>
                </c:pt>
                <c:pt idx="2717">
                  <c:v>23.926507949829102</c:v>
                </c:pt>
                <c:pt idx="2718">
                  <c:v>23.941982269287109</c:v>
                </c:pt>
                <c:pt idx="2719">
                  <c:v>23.95745849609375</c:v>
                </c:pt>
                <c:pt idx="2720">
                  <c:v>23.972938537597656</c:v>
                </c:pt>
                <c:pt idx="2721">
                  <c:v>23.988420486450195</c:v>
                </c:pt>
                <c:pt idx="2722">
                  <c:v>24.003908157348633</c:v>
                </c:pt>
                <c:pt idx="2723">
                  <c:v>24.019399642944336</c:v>
                </c:pt>
                <c:pt idx="2724">
                  <c:v>24.034893035888672</c:v>
                </c:pt>
                <c:pt idx="2725">
                  <c:v>24.050392150878906</c:v>
                </c:pt>
                <c:pt idx="2726">
                  <c:v>24.065891265869141</c:v>
                </c:pt>
                <c:pt idx="2727">
                  <c:v>24.081396102905273</c:v>
                </c:pt>
                <c:pt idx="2728">
                  <c:v>24.096904754638672</c:v>
                </c:pt>
                <c:pt idx="2729">
                  <c:v>24.112415313720703</c:v>
                </c:pt>
                <c:pt idx="2730">
                  <c:v>24.1279296875</c:v>
                </c:pt>
                <c:pt idx="2731">
                  <c:v>24.143449783325195</c:v>
                </c:pt>
                <c:pt idx="2732">
                  <c:v>24.158971786499023</c:v>
                </c:pt>
                <c:pt idx="2733">
                  <c:v>24.174497604370117</c:v>
                </c:pt>
                <c:pt idx="2734">
                  <c:v>24.190025329589844</c:v>
                </c:pt>
                <c:pt idx="2735">
                  <c:v>24.205556869506836</c:v>
                </c:pt>
                <c:pt idx="2736">
                  <c:v>24.221092224121094</c:v>
                </c:pt>
                <c:pt idx="2737">
                  <c:v>24.236631393432617</c:v>
                </c:pt>
                <c:pt idx="2738">
                  <c:v>24.252174377441406</c:v>
                </c:pt>
                <c:pt idx="2739">
                  <c:v>24.267721176147461</c:v>
                </c:pt>
                <c:pt idx="2740">
                  <c:v>24.283273696899414</c:v>
                </c:pt>
                <c:pt idx="2741">
                  <c:v>24.298826217651367</c:v>
                </c:pt>
                <c:pt idx="2742">
                  <c:v>24.314382553100586</c:v>
                </c:pt>
                <c:pt idx="2743">
                  <c:v>24.329944610595703</c:v>
                </c:pt>
                <c:pt idx="2744">
                  <c:v>24.345510482788086</c:v>
                </c:pt>
                <c:pt idx="2745">
                  <c:v>24.361078262329102</c:v>
                </c:pt>
                <c:pt idx="2746">
                  <c:v>24.376649856567383</c:v>
                </c:pt>
                <c:pt idx="2747">
                  <c:v>24.392223358154297</c:v>
                </c:pt>
                <c:pt idx="2748">
                  <c:v>24.407802581787109</c:v>
                </c:pt>
                <c:pt idx="2749">
                  <c:v>24.423383712768555</c:v>
                </c:pt>
                <c:pt idx="2750">
                  <c:v>24.438970565795898</c:v>
                </c:pt>
                <c:pt idx="2751">
                  <c:v>24.454557418823242</c:v>
                </c:pt>
                <c:pt idx="2752">
                  <c:v>24.470151901245117</c:v>
                </c:pt>
                <c:pt idx="2753">
                  <c:v>24.485746383666992</c:v>
                </c:pt>
                <c:pt idx="2754">
                  <c:v>24.501346588134766</c:v>
                </c:pt>
                <c:pt idx="2755">
                  <c:v>24.516948699951172</c:v>
                </c:pt>
                <c:pt idx="2756">
                  <c:v>24.532554626464844</c:v>
                </c:pt>
                <c:pt idx="2757">
                  <c:v>24.548162460327148</c:v>
                </c:pt>
                <c:pt idx="2758">
                  <c:v>24.563777923583984</c:v>
                </c:pt>
                <c:pt idx="2759">
                  <c:v>24.579395294189453</c:v>
                </c:pt>
                <c:pt idx="2760">
                  <c:v>24.595016479492188</c:v>
                </c:pt>
                <c:pt idx="2761">
                  <c:v>24.610639572143555</c:v>
                </c:pt>
                <c:pt idx="2762">
                  <c:v>24.626264572143555</c:v>
                </c:pt>
                <c:pt idx="2763">
                  <c:v>24.641895294189453</c:v>
                </c:pt>
                <c:pt idx="2764">
                  <c:v>24.657527923583984</c:v>
                </c:pt>
                <c:pt idx="2765">
                  <c:v>24.673164367675781</c:v>
                </c:pt>
                <c:pt idx="2766">
                  <c:v>24.688806533813477</c:v>
                </c:pt>
                <c:pt idx="2767">
                  <c:v>24.704450607299805</c:v>
                </c:pt>
                <c:pt idx="2768">
                  <c:v>24.720098495483398</c:v>
                </c:pt>
                <c:pt idx="2769">
                  <c:v>24.735748291015625</c:v>
                </c:pt>
                <c:pt idx="2770">
                  <c:v>24.751401901245117</c:v>
                </c:pt>
                <c:pt idx="2771">
                  <c:v>24.767059326171875</c:v>
                </c:pt>
                <c:pt idx="2772">
                  <c:v>24.782722473144531</c:v>
                </c:pt>
                <c:pt idx="2773">
                  <c:v>24.79838752746582</c:v>
                </c:pt>
                <c:pt idx="2774">
                  <c:v>24.814056396484375</c:v>
                </c:pt>
                <c:pt idx="2775">
                  <c:v>24.829727172851563</c:v>
                </c:pt>
                <c:pt idx="2776">
                  <c:v>24.845401763916016</c:v>
                </c:pt>
                <c:pt idx="2777">
                  <c:v>24.861080169677734</c:v>
                </c:pt>
                <c:pt idx="2778">
                  <c:v>24.876762390136719</c:v>
                </c:pt>
                <c:pt idx="2779">
                  <c:v>24.892446517944336</c:v>
                </c:pt>
                <c:pt idx="2780">
                  <c:v>24.908138275146484</c:v>
                </c:pt>
                <c:pt idx="2781">
                  <c:v>24.923830032348633</c:v>
                </c:pt>
                <c:pt idx="2782">
                  <c:v>24.93952751159668</c:v>
                </c:pt>
                <c:pt idx="2783">
                  <c:v>24.955226898193359</c:v>
                </c:pt>
                <c:pt idx="2784">
                  <c:v>24.970932006835938</c:v>
                </c:pt>
                <c:pt idx="2785">
                  <c:v>24.986637115478516</c:v>
                </c:pt>
                <c:pt idx="2786">
                  <c:v>25.002349853515625</c:v>
                </c:pt>
                <c:pt idx="2787">
                  <c:v>25.018062591552734</c:v>
                </c:pt>
                <c:pt idx="2788">
                  <c:v>25.033781051635742</c:v>
                </c:pt>
                <c:pt idx="2789">
                  <c:v>25.049501419067383</c:v>
                </c:pt>
                <c:pt idx="2790">
                  <c:v>25.065227508544922</c:v>
                </c:pt>
                <c:pt idx="2791">
                  <c:v>25.080953598022461</c:v>
                </c:pt>
                <c:pt idx="2792">
                  <c:v>25.096687316894531</c:v>
                </c:pt>
                <c:pt idx="2793">
                  <c:v>25.112421035766602</c:v>
                </c:pt>
                <c:pt idx="2794">
                  <c:v>25.128162384033203</c:v>
                </c:pt>
                <c:pt idx="2795">
                  <c:v>25.143903732299805</c:v>
                </c:pt>
                <c:pt idx="2796">
                  <c:v>25.159650802612305</c:v>
                </c:pt>
                <c:pt idx="2797">
                  <c:v>25.175399780273438</c:v>
                </c:pt>
                <c:pt idx="2798">
                  <c:v>25.191152572631836</c:v>
                </c:pt>
                <c:pt idx="2799">
                  <c:v>25.206907272338867</c:v>
                </c:pt>
                <c:pt idx="2800">
                  <c:v>25.222667694091797</c:v>
                </c:pt>
                <c:pt idx="2801">
                  <c:v>25.238430023193359</c:v>
                </c:pt>
                <c:pt idx="2802">
                  <c:v>25.25419807434082</c:v>
                </c:pt>
                <c:pt idx="2803">
                  <c:v>25.269968032836914</c:v>
                </c:pt>
                <c:pt idx="2804">
                  <c:v>25.285741806030273</c:v>
                </c:pt>
                <c:pt idx="2805">
                  <c:v>25.301517486572266</c:v>
                </c:pt>
                <c:pt idx="2806">
                  <c:v>25.317300796508789</c:v>
                </c:pt>
                <c:pt idx="2807">
                  <c:v>25.333086013793945</c:v>
                </c:pt>
                <c:pt idx="2808">
                  <c:v>25.348873138427734</c:v>
                </c:pt>
                <c:pt idx="2809">
                  <c:v>25.364665985107422</c:v>
                </c:pt>
                <c:pt idx="2810">
                  <c:v>25.380464553833008</c:v>
                </c:pt>
                <c:pt idx="2811">
                  <c:v>25.396259307861328</c:v>
                </c:pt>
                <c:pt idx="2812">
                  <c:v>25.412063598632813</c:v>
                </c:pt>
                <c:pt idx="2813">
                  <c:v>25.427867889404297</c:v>
                </c:pt>
                <c:pt idx="2814">
                  <c:v>25.44367790222168</c:v>
                </c:pt>
                <c:pt idx="2815">
                  <c:v>25.459491729736328</c:v>
                </c:pt>
                <c:pt idx="2816">
                  <c:v>25.475307464599609</c:v>
                </c:pt>
                <c:pt idx="2817">
                  <c:v>25.491123199462891</c:v>
                </c:pt>
                <c:pt idx="2818">
                  <c:v>25.506946563720703</c:v>
                </c:pt>
                <c:pt idx="2819">
                  <c:v>25.522771835327148</c:v>
                </c:pt>
                <c:pt idx="2820">
                  <c:v>25.538602828979492</c:v>
                </c:pt>
                <c:pt idx="2821">
                  <c:v>25.554435729980469</c:v>
                </c:pt>
                <c:pt idx="2822">
                  <c:v>25.570274353027344</c:v>
                </c:pt>
                <c:pt idx="2823">
                  <c:v>25.586114883422852</c:v>
                </c:pt>
                <c:pt idx="2824">
                  <c:v>25.601957321166992</c:v>
                </c:pt>
                <c:pt idx="2825">
                  <c:v>25.617803573608398</c:v>
                </c:pt>
                <c:pt idx="2826">
                  <c:v>25.633655548095703</c:v>
                </c:pt>
                <c:pt idx="2827">
                  <c:v>25.649509429931641</c:v>
                </c:pt>
                <c:pt idx="2828">
                  <c:v>25.665367126464844</c:v>
                </c:pt>
                <c:pt idx="2829">
                  <c:v>25.681228637695313</c:v>
                </c:pt>
                <c:pt idx="2830">
                  <c:v>25.69709587097168</c:v>
                </c:pt>
                <c:pt idx="2831">
                  <c:v>25.712961196899414</c:v>
                </c:pt>
                <c:pt idx="2832">
                  <c:v>25.728836059570313</c:v>
                </c:pt>
                <c:pt idx="2833">
                  <c:v>25.744712829589844</c:v>
                </c:pt>
                <c:pt idx="2834">
                  <c:v>25.760591506958008</c:v>
                </c:pt>
                <c:pt idx="2835">
                  <c:v>25.776473999023438</c:v>
                </c:pt>
                <c:pt idx="2836">
                  <c:v>25.792360305786133</c:v>
                </c:pt>
                <c:pt idx="2837">
                  <c:v>25.808252334594727</c:v>
                </c:pt>
                <c:pt idx="2838">
                  <c:v>25.824142456054688</c:v>
                </c:pt>
                <c:pt idx="2839">
                  <c:v>25.84004020690918</c:v>
                </c:pt>
                <c:pt idx="2840">
                  <c:v>25.855941772460938</c:v>
                </c:pt>
                <c:pt idx="2841">
                  <c:v>25.871847152709961</c:v>
                </c:pt>
                <c:pt idx="2842">
                  <c:v>25.887754440307617</c:v>
                </c:pt>
                <c:pt idx="2843">
                  <c:v>25.903663635253906</c:v>
                </c:pt>
                <c:pt idx="2844">
                  <c:v>25.919578552246094</c:v>
                </c:pt>
                <c:pt idx="2845">
                  <c:v>25.935501098632813</c:v>
                </c:pt>
                <c:pt idx="2846">
                  <c:v>25.951423645019531</c:v>
                </c:pt>
                <c:pt idx="2847">
                  <c:v>25.967350006103516</c:v>
                </c:pt>
                <c:pt idx="2848">
                  <c:v>25.983280181884766</c:v>
                </c:pt>
                <c:pt idx="2849">
                  <c:v>25.999214172363281</c:v>
                </c:pt>
                <c:pt idx="2850">
                  <c:v>26.01515007019043</c:v>
                </c:pt>
                <c:pt idx="2851">
                  <c:v>26.031089782714844</c:v>
                </c:pt>
                <c:pt idx="2852">
                  <c:v>26.047035217285156</c:v>
                </c:pt>
                <c:pt idx="2853">
                  <c:v>26.062980651855469</c:v>
                </c:pt>
                <c:pt idx="2854">
                  <c:v>26.07893180847168</c:v>
                </c:pt>
                <c:pt idx="2855">
                  <c:v>26.094888687133789</c:v>
                </c:pt>
                <c:pt idx="2856">
                  <c:v>26.110845565795898</c:v>
                </c:pt>
                <c:pt idx="2857">
                  <c:v>26.126808166503906</c:v>
                </c:pt>
                <c:pt idx="2858">
                  <c:v>26.14277458190918</c:v>
                </c:pt>
                <c:pt idx="2859">
                  <c:v>26.158742904663086</c:v>
                </c:pt>
                <c:pt idx="2860">
                  <c:v>26.174715042114258</c:v>
                </c:pt>
                <c:pt idx="2861">
                  <c:v>26.190689086914063</c:v>
                </c:pt>
                <c:pt idx="2862">
                  <c:v>26.206666946411133</c:v>
                </c:pt>
                <c:pt idx="2863">
                  <c:v>26.222652435302734</c:v>
                </c:pt>
                <c:pt idx="2864">
                  <c:v>26.238636016845703</c:v>
                </c:pt>
                <c:pt idx="2865">
                  <c:v>26.254629135131836</c:v>
                </c:pt>
                <c:pt idx="2866">
                  <c:v>26.270622253417969</c:v>
                </c:pt>
                <c:pt idx="2867">
                  <c:v>26.286617279052734</c:v>
                </c:pt>
                <c:pt idx="2868">
                  <c:v>26.302618026733398</c:v>
                </c:pt>
                <c:pt idx="2869">
                  <c:v>26.318618774414063</c:v>
                </c:pt>
                <c:pt idx="2870">
                  <c:v>26.334625244140625</c:v>
                </c:pt>
                <c:pt idx="2871">
                  <c:v>26.35063362121582</c:v>
                </c:pt>
                <c:pt idx="2872">
                  <c:v>26.366645812988281</c:v>
                </c:pt>
                <c:pt idx="2873">
                  <c:v>26.382661819458008</c:v>
                </c:pt>
                <c:pt idx="2874">
                  <c:v>26.398681640625</c:v>
                </c:pt>
                <c:pt idx="2875">
                  <c:v>26.414703369140625</c:v>
                </c:pt>
                <c:pt idx="2876">
                  <c:v>26.430728912353516</c:v>
                </c:pt>
                <c:pt idx="2877">
                  <c:v>26.446760177612305</c:v>
                </c:pt>
                <c:pt idx="2878">
                  <c:v>26.462795257568359</c:v>
                </c:pt>
                <c:pt idx="2879">
                  <c:v>26.478832244873047</c:v>
                </c:pt>
                <c:pt idx="2880">
                  <c:v>26.494871139526367</c:v>
                </c:pt>
                <c:pt idx="2881">
                  <c:v>26.510915756225586</c:v>
                </c:pt>
                <c:pt idx="2882">
                  <c:v>26.526962280273438</c:v>
                </c:pt>
                <c:pt idx="2883">
                  <c:v>26.543012619018555</c:v>
                </c:pt>
                <c:pt idx="2884">
                  <c:v>26.559066772460938</c:v>
                </c:pt>
                <c:pt idx="2885">
                  <c:v>26.575124740600586</c:v>
                </c:pt>
                <c:pt idx="2886">
                  <c:v>26.591188430786133</c:v>
                </c:pt>
                <c:pt idx="2887">
                  <c:v>26.607255935668945</c:v>
                </c:pt>
                <c:pt idx="2888">
                  <c:v>26.623327255249023</c:v>
                </c:pt>
                <c:pt idx="2889">
                  <c:v>26.639400482177734</c:v>
                </c:pt>
                <c:pt idx="2890">
                  <c:v>26.655477523803711</c:v>
                </c:pt>
                <c:pt idx="2891">
                  <c:v>26.671560287475586</c:v>
                </c:pt>
                <c:pt idx="2892">
                  <c:v>26.687644958496094</c:v>
                </c:pt>
                <c:pt idx="2893">
                  <c:v>26.703737258911133</c:v>
                </c:pt>
                <c:pt idx="2894">
                  <c:v>26.719829559326172</c:v>
                </c:pt>
                <c:pt idx="2895">
                  <c:v>26.735929489135742</c:v>
                </c:pt>
                <c:pt idx="2896">
                  <c:v>26.75202751159668</c:v>
                </c:pt>
                <c:pt idx="2897">
                  <c:v>26.768133163452148</c:v>
                </c:pt>
                <c:pt idx="2898">
                  <c:v>26.78424072265625</c:v>
                </c:pt>
                <c:pt idx="2899">
                  <c:v>26.800352096557617</c:v>
                </c:pt>
                <c:pt idx="2900">
                  <c:v>26.81646728515625</c:v>
                </c:pt>
                <c:pt idx="2901">
                  <c:v>26.832584381103516</c:v>
                </c:pt>
                <c:pt idx="2902">
                  <c:v>26.848705291748047</c:v>
                </c:pt>
                <c:pt idx="2903">
                  <c:v>26.864835739135742</c:v>
                </c:pt>
                <c:pt idx="2904">
                  <c:v>26.880964279174805</c:v>
                </c:pt>
                <c:pt idx="2905">
                  <c:v>26.897102355957031</c:v>
                </c:pt>
                <c:pt idx="2906">
                  <c:v>26.913238525390625</c:v>
                </c:pt>
                <c:pt idx="2907">
                  <c:v>26.929378509521484</c:v>
                </c:pt>
                <c:pt idx="2908">
                  <c:v>26.945522308349609</c:v>
                </c:pt>
                <c:pt idx="2909">
                  <c:v>26.961671829223633</c:v>
                </c:pt>
                <c:pt idx="2910">
                  <c:v>26.977817535400391</c:v>
                </c:pt>
                <c:pt idx="2911">
                  <c:v>26.99397087097168</c:v>
                </c:pt>
                <c:pt idx="2912">
                  <c:v>27.010128021240234</c:v>
                </c:pt>
                <c:pt idx="2913">
                  <c:v>27.026290893554688</c:v>
                </c:pt>
                <c:pt idx="2914">
                  <c:v>27.042449951171875</c:v>
                </c:pt>
                <c:pt idx="2915">
                  <c:v>27.058618545532227</c:v>
                </c:pt>
                <c:pt idx="2916">
                  <c:v>27.074787139892578</c:v>
                </c:pt>
                <c:pt idx="2917">
                  <c:v>27.090965270996094</c:v>
                </c:pt>
                <c:pt idx="2918">
                  <c:v>27.107143402099609</c:v>
                </c:pt>
                <c:pt idx="2919">
                  <c:v>27.123323440551758</c:v>
                </c:pt>
                <c:pt idx="2920">
                  <c:v>27.139503479003906</c:v>
                </c:pt>
                <c:pt idx="2921">
                  <c:v>27.155693054199219</c:v>
                </c:pt>
                <c:pt idx="2922">
                  <c:v>27.171882629394531</c:v>
                </c:pt>
                <c:pt idx="2923">
                  <c:v>27.188079833984375</c:v>
                </c:pt>
                <c:pt idx="2924">
                  <c:v>27.204275131225586</c:v>
                </c:pt>
                <c:pt idx="2925">
                  <c:v>27.220476150512695</c:v>
                </c:pt>
                <c:pt idx="2926">
                  <c:v>27.236679077148438</c:v>
                </c:pt>
                <c:pt idx="2927">
                  <c:v>27.252887725830078</c:v>
                </c:pt>
                <c:pt idx="2928">
                  <c:v>27.269098281860352</c:v>
                </c:pt>
                <c:pt idx="2929">
                  <c:v>27.285314559936523</c:v>
                </c:pt>
                <c:pt idx="2930">
                  <c:v>27.301534652709961</c:v>
                </c:pt>
                <c:pt idx="2931">
                  <c:v>27.317756652832031</c:v>
                </c:pt>
                <c:pt idx="2932">
                  <c:v>27.333982467651367</c:v>
                </c:pt>
                <c:pt idx="2933">
                  <c:v>27.350212097167969</c:v>
                </c:pt>
                <c:pt idx="2934">
                  <c:v>27.366443634033203</c:v>
                </c:pt>
                <c:pt idx="2935">
                  <c:v>27.382684707641602</c:v>
                </c:pt>
                <c:pt idx="2936">
                  <c:v>27.398923873901367</c:v>
                </c:pt>
                <c:pt idx="2937">
                  <c:v>27.415168762207031</c:v>
                </c:pt>
                <c:pt idx="2938">
                  <c:v>27.431419372558594</c:v>
                </c:pt>
                <c:pt idx="2939">
                  <c:v>27.447675704956055</c:v>
                </c:pt>
                <c:pt idx="2940">
                  <c:v>27.463930130004883</c:v>
                </c:pt>
                <c:pt idx="2941">
                  <c:v>27.480190277099609</c:v>
                </c:pt>
                <c:pt idx="2942">
                  <c:v>27.496454238891602</c:v>
                </c:pt>
                <c:pt idx="2943">
                  <c:v>27.512727737426758</c:v>
                </c:pt>
                <c:pt idx="2944">
                  <c:v>27.528997421264648</c:v>
                </c:pt>
                <c:pt idx="2945">
                  <c:v>27.54527473449707</c:v>
                </c:pt>
                <c:pt idx="2946">
                  <c:v>27.561550140380859</c:v>
                </c:pt>
                <c:pt idx="2947">
                  <c:v>27.57783317565918</c:v>
                </c:pt>
                <c:pt idx="2948">
                  <c:v>27.594121932983398</c:v>
                </c:pt>
                <c:pt idx="2949">
                  <c:v>27.610414505004883</c:v>
                </c:pt>
                <c:pt idx="2950">
                  <c:v>27.626705169677734</c:v>
                </c:pt>
                <c:pt idx="2951">
                  <c:v>27.643007278442383</c:v>
                </c:pt>
                <c:pt idx="2952">
                  <c:v>27.659307479858398</c:v>
                </c:pt>
                <c:pt idx="2953">
                  <c:v>27.675615310668945</c:v>
                </c:pt>
                <c:pt idx="2954">
                  <c:v>27.691921234130859</c:v>
                </c:pt>
                <c:pt idx="2955">
                  <c:v>27.708232879638672</c:v>
                </c:pt>
                <c:pt idx="2956">
                  <c:v>27.72454833984375</c:v>
                </c:pt>
                <c:pt idx="2957">
                  <c:v>27.740869522094727</c:v>
                </c:pt>
                <c:pt idx="2958">
                  <c:v>27.757192611694336</c:v>
                </c:pt>
                <c:pt idx="2959">
                  <c:v>27.773523330688477</c:v>
                </c:pt>
                <c:pt idx="2960">
                  <c:v>27.789852142333984</c:v>
                </c:pt>
                <c:pt idx="2961">
                  <c:v>27.806192398071289</c:v>
                </c:pt>
                <c:pt idx="2962">
                  <c:v>27.822530746459961</c:v>
                </c:pt>
                <c:pt idx="2963">
                  <c:v>27.838871002197266</c:v>
                </c:pt>
                <c:pt idx="2964">
                  <c:v>27.855216979980469</c:v>
                </c:pt>
                <c:pt idx="2965">
                  <c:v>27.871564865112305</c:v>
                </c:pt>
                <c:pt idx="2966">
                  <c:v>27.887912750244141</c:v>
                </c:pt>
                <c:pt idx="2967">
                  <c:v>27.904270172119141</c:v>
                </c:pt>
                <c:pt idx="2968">
                  <c:v>27.920627593994141</c:v>
                </c:pt>
                <c:pt idx="2969">
                  <c:v>27.936986923217773</c:v>
                </c:pt>
                <c:pt idx="2970">
                  <c:v>27.953350067138672</c:v>
                </c:pt>
                <c:pt idx="2971">
                  <c:v>27.969718933105469</c:v>
                </c:pt>
                <c:pt idx="2972">
                  <c:v>27.986089706420898</c:v>
                </c:pt>
                <c:pt idx="2973">
                  <c:v>28.002464294433594</c:v>
                </c:pt>
                <c:pt idx="2974">
                  <c:v>28.018840789794922</c:v>
                </c:pt>
                <c:pt idx="2975">
                  <c:v>28.035223007202148</c:v>
                </c:pt>
                <c:pt idx="2976">
                  <c:v>28.051605224609375</c:v>
                </c:pt>
                <c:pt idx="2977">
                  <c:v>28.067996978759766</c:v>
                </c:pt>
                <c:pt idx="2978">
                  <c:v>28.084390640258789</c:v>
                </c:pt>
                <c:pt idx="2979">
                  <c:v>28.100790023803711</c:v>
                </c:pt>
                <c:pt idx="2980">
                  <c:v>28.117185592651367</c:v>
                </c:pt>
                <c:pt idx="2981">
                  <c:v>28.133588790893555</c:v>
                </c:pt>
                <c:pt idx="2982">
                  <c:v>28.149993896484375</c:v>
                </c:pt>
                <c:pt idx="2983">
                  <c:v>28.166406631469727</c:v>
                </c:pt>
                <c:pt idx="2984">
                  <c:v>28.182821273803711</c:v>
                </c:pt>
                <c:pt idx="2985">
                  <c:v>28.199239730834961</c:v>
                </c:pt>
                <c:pt idx="2986">
                  <c:v>28.215658187866211</c:v>
                </c:pt>
                <c:pt idx="2987">
                  <c:v>28.232082366943359</c:v>
                </c:pt>
                <c:pt idx="2988">
                  <c:v>28.248512268066406</c:v>
                </c:pt>
                <c:pt idx="2989">
                  <c:v>28.264945983886719</c:v>
                </c:pt>
                <c:pt idx="2990">
                  <c:v>28.281379699707031</c:v>
                </c:pt>
                <c:pt idx="2991">
                  <c:v>28.297819137573242</c:v>
                </c:pt>
                <c:pt idx="2992">
                  <c:v>28.314266204833984</c:v>
                </c:pt>
                <c:pt idx="2993">
                  <c:v>28.330717086791992</c:v>
                </c:pt>
                <c:pt idx="2994">
                  <c:v>28.34716796875</c:v>
                </c:pt>
                <c:pt idx="2995">
                  <c:v>28.363628387451172</c:v>
                </c:pt>
                <c:pt idx="2996">
                  <c:v>28.380086898803711</c:v>
                </c:pt>
                <c:pt idx="2997">
                  <c:v>28.396551132202148</c:v>
                </c:pt>
                <c:pt idx="2998">
                  <c:v>28.413015365600586</c:v>
                </c:pt>
                <c:pt idx="2999">
                  <c:v>28.429485321044922</c:v>
                </c:pt>
              </c:numCache>
            </c:numRef>
          </c:xVal>
          <c:yVal>
            <c:numRef>
              <c:f>'[RB revised.xlsx]Graph Calculations'!$I$16:$DKR$16</c:f>
              <c:numCache>
                <c:formatCode>General</c:formatCode>
                <c:ptCount val="3000"/>
                <c:pt idx="0">
                  <c:v>56776.337890625</c:v>
                </c:pt>
                <c:pt idx="1">
                  <c:v>56776.431640625</c:v>
                </c:pt>
                <c:pt idx="2">
                  <c:v>56776.5244140625</c:v>
                </c:pt>
                <c:pt idx="3">
                  <c:v>56649.8759765625</c:v>
                </c:pt>
                <c:pt idx="4">
                  <c:v>56501.8837890625</c:v>
                </c:pt>
                <c:pt idx="5">
                  <c:v>56336.1767578125</c:v>
                </c:pt>
                <c:pt idx="6">
                  <c:v>56165.61328125</c:v>
                </c:pt>
                <c:pt idx="7">
                  <c:v>55989.1357421875</c:v>
                </c:pt>
                <c:pt idx="8">
                  <c:v>55797.029296875</c:v>
                </c:pt>
                <c:pt idx="9">
                  <c:v>55586.580078125</c:v>
                </c:pt>
                <c:pt idx="10">
                  <c:v>55365.130859375</c:v>
                </c:pt>
                <c:pt idx="11">
                  <c:v>55150.45263671875</c:v>
                </c:pt>
                <c:pt idx="12">
                  <c:v>54948.46044921875</c:v>
                </c:pt>
                <c:pt idx="13">
                  <c:v>54745.46875</c:v>
                </c:pt>
                <c:pt idx="14">
                  <c:v>54526.76220703125</c:v>
                </c:pt>
                <c:pt idx="15">
                  <c:v>54297.11279296875</c:v>
                </c:pt>
                <c:pt idx="16">
                  <c:v>54083.54931640625</c:v>
                </c:pt>
                <c:pt idx="17">
                  <c:v>53894.3857421875</c:v>
                </c:pt>
                <c:pt idx="18">
                  <c:v>53713.13623046875</c:v>
                </c:pt>
                <c:pt idx="19">
                  <c:v>53519.0302734375</c:v>
                </c:pt>
                <c:pt idx="20">
                  <c:v>53319.32373046875</c:v>
                </c:pt>
                <c:pt idx="21">
                  <c:v>53130.44580078125</c:v>
                </c:pt>
                <c:pt idx="22">
                  <c:v>52948.11083984375</c:v>
                </c:pt>
                <c:pt idx="23">
                  <c:v>52759.68994140625</c:v>
                </c:pt>
                <c:pt idx="24">
                  <c:v>52566.12646484375</c:v>
                </c:pt>
                <c:pt idx="25">
                  <c:v>52377.10595703125</c:v>
                </c:pt>
                <c:pt idx="26">
                  <c:v>52203.7138671875</c:v>
                </c:pt>
                <c:pt idx="27">
                  <c:v>52047.77880859375</c:v>
                </c:pt>
                <c:pt idx="28">
                  <c:v>51904.072265625</c:v>
                </c:pt>
                <c:pt idx="29">
                  <c:v>51763.5087890625</c:v>
                </c:pt>
                <c:pt idx="30">
                  <c:v>51623.145263671875</c:v>
                </c:pt>
                <c:pt idx="31">
                  <c:v>51482.35302734375</c:v>
                </c:pt>
                <c:pt idx="32">
                  <c:v>51347.646728515625</c:v>
                </c:pt>
                <c:pt idx="33">
                  <c:v>51225.940185546875</c:v>
                </c:pt>
                <c:pt idx="34">
                  <c:v>51121.8623046875</c:v>
                </c:pt>
                <c:pt idx="35">
                  <c:v>51028.927490234375</c:v>
                </c:pt>
                <c:pt idx="36">
                  <c:v>50941.106689453125</c:v>
                </c:pt>
                <c:pt idx="37">
                  <c:v>50846.428955078125</c:v>
                </c:pt>
                <c:pt idx="38">
                  <c:v>50746.865234375</c:v>
                </c:pt>
                <c:pt idx="39">
                  <c:v>50650.387451171875</c:v>
                </c:pt>
                <c:pt idx="40">
                  <c:v>50567.1953125</c:v>
                </c:pt>
                <c:pt idx="41">
                  <c:v>50495.80322265625</c:v>
                </c:pt>
                <c:pt idx="42">
                  <c:v>50429.125244140625</c:v>
                </c:pt>
                <c:pt idx="43">
                  <c:v>50357.733154296875</c:v>
                </c:pt>
                <c:pt idx="44">
                  <c:v>50287.941162109375</c:v>
                </c:pt>
                <c:pt idx="45">
                  <c:v>50226.7490234375</c:v>
                </c:pt>
                <c:pt idx="46">
                  <c:v>50163.2998046875</c:v>
                </c:pt>
                <c:pt idx="47">
                  <c:v>50086.3076171875</c:v>
                </c:pt>
                <c:pt idx="48">
                  <c:v>50011.172607421875</c:v>
                </c:pt>
                <c:pt idx="49">
                  <c:v>49954.351928710938</c:v>
                </c:pt>
                <c:pt idx="50">
                  <c:v>49915.616943359375</c:v>
                </c:pt>
                <c:pt idx="51">
                  <c:v>49877.853271484375</c:v>
                </c:pt>
                <c:pt idx="52">
                  <c:v>49835.118286132813</c:v>
                </c:pt>
                <c:pt idx="53">
                  <c:v>49789.15478515625</c:v>
                </c:pt>
                <c:pt idx="54">
                  <c:v>49756.248413085938</c:v>
                </c:pt>
                <c:pt idx="55">
                  <c:v>49731.056274414063</c:v>
                </c:pt>
                <c:pt idx="56">
                  <c:v>49702.435546875</c:v>
                </c:pt>
                <c:pt idx="57">
                  <c:v>49656.471923828125</c:v>
                </c:pt>
                <c:pt idx="58">
                  <c:v>49601.594116210938</c:v>
                </c:pt>
                <c:pt idx="59">
                  <c:v>49554.859130859375</c:v>
                </c:pt>
                <c:pt idx="60">
                  <c:v>49525.72412109375</c:v>
                </c:pt>
                <c:pt idx="61">
                  <c:v>49505.560546875</c:v>
                </c:pt>
                <c:pt idx="62">
                  <c:v>49486.197021484375</c:v>
                </c:pt>
                <c:pt idx="63">
                  <c:v>49461.204956054688</c:v>
                </c:pt>
                <c:pt idx="64">
                  <c:v>49432.84130859375</c:v>
                </c:pt>
                <c:pt idx="65">
                  <c:v>49401.077758789063</c:v>
                </c:pt>
                <c:pt idx="66">
                  <c:v>49368.971435546875</c:v>
                </c:pt>
                <c:pt idx="67">
                  <c:v>49336.750732421875</c:v>
                </c:pt>
                <c:pt idx="68">
                  <c:v>49305.501342773438</c:v>
                </c:pt>
                <c:pt idx="69">
                  <c:v>49280.652099609375</c:v>
                </c:pt>
                <c:pt idx="70">
                  <c:v>49268.374267578125</c:v>
                </c:pt>
                <c:pt idx="71">
                  <c:v>49263.125</c:v>
                </c:pt>
                <c:pt idx="72">
                  <c:v>49244.704345703125</c:v>
                </c:pt>
                <c:pt idx="73">
                  <c:v>49215.969360351563</c:v>
                </c:pt>
                <c:pt idx="74">
                  <c:v>49188.17724609375</c:v>
                </c:pt>
                <c:pt idx="75">
                  <c:v>49164.870727539063</c:v>
                </c:pt>
                <c:pt idx="76">
                  <c:v>49143.764404296875</c:v>
                </c:pt>
                <c:pt idx="77">
                  <c:v>49131.85791015625</c:v>
                </c:pt>
                <c:pt idx="78">
                  <c:v>49125.122924804688</c:v>
                </c:pt>
                <c:pt idx="79">
                  <c:v>49115.18798828125</c:v>
                </c:pt>
                <c:pt idx="80">
                  <c:v>49099.624389648438</c:v>
                </c:pt>
                <c:pt idx="81">
                  <c:v>49078.74658203125</c:v>
                </c:pt>
                <c:pt idx="82">
                  <c:v>49052.554443359375</c:v>
                </c:pt>
                <c:pt idx="83">
                  <c:v>49025.390869140625</c:v>
                </c:pt>
                <c:pt idx="84">
                  <c:v>49006.427307128906</c:v>
                </c:pt>
                <c:pt idx="85">
                  <c:v>48997.578063964844</c:v>
                </c:pt>
                <c:pt idx="86">
                  <c:v>48995.185913085938</c:v>
                </c:pt>
                <c:pt idx="87">
                  <c:v>48984.822387695313</c:v>
                </c:pt>
                <c:pt idx="88">
                  <c:v>48967.601684570313</c:v>
                </c:pt>
                <c:pt idx="89">
                  <c:v>48953.552368164063</c:v>
                </c:pt>
                <c:pt idx="90">
                  <c:v>48948.588806152344</c:v>
                </c:pt>
                <c:pt idx="91">
                  <c:v>48946.939575195313</c:v>
                </c:pt>
                <c:pt idx="92">
                  <c:v>48940.404541015625</c:v>
                </c:pt>
                <c:pt idx="93">
                  <c:v>48929.298156738281</c:v>
                </c:pt>
                <c:pt idx="94">
                  <c:v>48911.734619140625</c:v>
                </c:pt>
                <c:pt idx="95">
                  <c:v>48887.799621582031</c:v>
                </c:pt>
                <c:pt idx="96">
                  <c:v>48856.950317382813</c:v>
                </c:pt>
                <c:pt idx="97">
                  <c:v>48831.21533203125</c:v>
                </c:pt>
                <c:pt idx="98">
                  <c:v>48825.9375</c:v>
                </c:pt>
                <c:pt idx="99">
                  <c:v>48842.345397949219</c:v>
                </c:pt>
                <c:pt idx="100">
                  <c:v>48855.153259277344</c:v>
                </c:pt>
                <c:pt idx="101">
                  <c:v>48846.361145019531</c:v>
                </c:pt>
                <c:pt idx="102">
                  <c:v>48822.11181640625</c:v>
                </c:pt>
                <c:pt idx="103">
                  <c:v>48800.576843261719</c:v>
                </c:pt>
                <c:pt idx="104">
                  <c:v>48786.727600097656</c:v>
                </c:pt>
                <c:pt idx="105">
                  <c:v>48779.249755859375</c:v>
                </c:pt>
                <c:pt idx="106">
                  <c:v>48776.286193847656</c:v>
                </c:pt>
                <c:pt idx="107">
                  <c:v>48778.522644042969</c:v>
                </c:pt>
                <c:pt idx="108">
                  <c:v>48784.530517578125</c:v>
                </c:pt>
                <c:pt idx="109">
                  <c:v>48784.881225585938</c:v>
                </c:pt>
                <c:pt idx="110">
                  <c:v>48770.889099121094</c:v>
                </c:pt>
                <c:pt idx="111">
                  <c:v>48749.182678222656</c:v>
                </c:pt>
                <c:pt idx="112">
                  <c:v>48737.133422851563</c:v>
                </c:pt>
                <c:pt idx="113">
                  <c:v>48734.112670898438</c:v>
                </c:pt>
                <c:pt idx="114">
                  <c:v>48723.120544433594</c:v>
                </c:pt>
                <c:pt idx="115">
                  <c:v>48704.328430175781</c:v>
                </c:pt>
                <c:pt idx="116">
                  <c:v>48695.736328125</c:v>
                </c:pt>
                <c:pt idx="117">
                  <c:v>48699.45849609375</c:v>
                </c:pt>
                <c:pt idx="118">
                  <c:v>48698.866333007813</c:v>
                </c:pt>
                <c:pt idx="119">
                  <c:v>48694.988464355469</c:v>
                </c:pt>
                <c:pt idx="120">
                  <c:v>48693.424926757813</c:v>
                </c:pt>
                <c:pt idx="121">
                  <c:v>48692.918518066406</c:v>
                </c:pt>
                <c:pt idx="122">
                  <c:v>48687.297790527344</c:v>
                </c:pt>
                <c:pt idx="123">
                  <c:v>48677.962829589844</c:v>
                </c:pt>
                <c:pt idx="124">
                  <c:v>48666.8564453125</c:v>
                </c:pt>
                <c:pt idx="125">
                  <c:v>48662.578552246094</c:v>
                </c:pt>
                <c:pt idx="126">
                  <c:v>48667.6435546875</c:v>
                </c:pt>
                <c:pt idx="127">
                  <c:v>48672.222900390625</c:v>
                </c:pt>
                <c:pt idx="128">
                  <c:v>48657.516479492188</c:v>
                </c:pt>
                <c:pt idx="129">
                  <c:v>48632.610046386719</c:v>
                </c:pt>
                <c:pt idx="130">
                  <c:v>48617.417907714844</c:v>
                </c:pt>
                <c:pt idx="131">
                  <c:v>48616.740051269531</c:v>
                </c:pt>
                <c:pt idx="132">
                  <c:v>48619.833679199219</c:v>
                </c:pt>
                <c:pt idx="133">
                  <c:v>48619.212951660156</c:v>
                </c:pt>
                <c:pt idx="134">
                  <c:v>48614.049377441406</c:v>
                </c:pt>
                <c:pt idx="135">
                  <c:v>48607.457275390625</c:v>
                </c:pt>
                <c:pt idx="136">
                  <c:v>48609.322265625</c:v>
                </c:pt>
                <c:pt idx="137">
                  <c:v>48614.015869140625</c:v>
                </c:pt>
                <c:pt idx="138">
                  <c:v>48612.566589355469</c:v>
                </c:pt>
                <c:pt idx="139">
                  <c:v>48603.031616210938</c:v>
                </c:pt>
                <c:pt idx="140">
                  <c:v>48595.153747558594</c:v>
                </c:pt>
                <c:pt idx="141">
                  <c:v>48594.133056640625</c:v>
                </c:pt>
                <c:pt idx="142">
                  <c:v>48591.112365722656</c:v>
                </c:pt>
                <c:pt idx="143">
                  <c:v>48581.205932617188</c:v>
                </c:pt>
                <c:pt idx="144">
                  <c:v>48575.356689453125</c:v>
                </c:pt>
                <c:pt idx="145">
                  <c:v>48584.678833007813</c:v>
                </c:pt>
                <c:pt idx="146">
                  <c:v>48588.829528808594</c:v>
                </c:pt>
                <c:pt idx="147">
                  <c:v>48576.408874511719</c:v>
                </c:pt>
                <c:pt idx="148">
                  <c:v>48564.045288085938</c:v>
                </c:pt>
                <c:pt idx="149">
                  <c:v>48569.681762695313</c:v>
                </c:pt>
                <c:pt idx="150">
                  <c:v>48579.489624023438</c:v>
                </c:pt>
                <c:pt idx="151">
                  <c:v>48573.526062011719</c:v>
                </c:pt>
                <c:pt idx="152">
                  <c:v>48559.876770019531</c:v>
                </c:pt>
                <c:pt idx="153">
                  <c:v>48556.4560546875</c:v>
                </c:pt>
                <c:pt idx="154">
                  <c:v>48557.263977050781</c:v>
                </c:pt>
                <c:pt idx="155">
                  <c:v>48551.100402832031</c:v>
                </c:pt>
                <c:pt idx="156">
                  <c:v>48540.708251953125</c:v>
                </c:pt>
                <c:pt idx="157">
                  <c:v>48534.830444335938</c:v>
                </c:pt>
                <c:pt idx="158">
                  <c:v>48529.895446777344</c:v>
                </c:pt>
                <c:pt idx="159">
                  <c:v>48524.07470703125</c:v>
                </c:pt>
                <c:pt idx="160">
                  <c:v>48517.196899414063</c:v>
                </c:pt>
                <c:pt idx="161">
                  <c:v>48509.833312988281</c:v>
                </c:pt>
                <c:pt idx="162">
                  <c:v>48502.698333740234</c:v>
                </c:pt>
                <c:pt idx="163">
                  <c:v>48498.220489501953</c:v>
                </c:pt>
                <c:pt idx="164">
                  <c:v>48502.599792480469</c:v>
                </c:pt>
                <c:pt idx="165">
                  <c:v>48509.664794921875</c:v>
                </c:pt>
                <c:pt idx="166">
                  <c:v>48511.158386230469</c:v>
                </c:pt>
                <c:pt idx="167">
                  <c:v>48505.337677001953</c:v>
                </c:pt>
                <c:pt idx="168">
                  <c:v>48501.202697753906</c:v>
                </c:pt>
                <c:pt idx="169">
                  <c:v>48499.667724609375</c:v>
                </c:pt>
                <c:pt idx="170">
                  <c:v>48497.847015380859</c:v>
                </c:pt>
                <c:pt idx="171">
                  <c:v>48497.2548828125</c:v>
                </c:pt>
                <c:pt idx="172">
                  <c:v>48497.834167480469</c:v>
                </c:pt>
                <c:pt idx="173">
                  <c:v>48500.527770996094</c:v>
                </c:pt>
                <c:pt idx="174">
                  <c:v>48500.621337890625</c:v>
                </c:pt>
                <c:pt idx="175">
                  <c:v>48496.400634765625</c:v>
                </c:pt>
                <c:pt idx="176">
                  <c:v>48487.551391601563</c:v>
                </c:pt>
                <c:pt idx="177">
                  <c:v>48474.530670166016</c:v>
                </c:pt>
                <c:pt idx="178">
                  <c:v>48462.167114257813</c:v>
                </c:pt>
                <c:pt idx="179">
                  <c:v>48455.203552246094</c:v>
                </c:pt>
                <c:pt idx="180">
                  <c:v>48461.097137451172</c:v>
                </c:pt>
                <c:pt idx="181">
                  <c:v>48467.733581542969</c:v>
                </c:pt>
                <c:pt idx="182">
                  <c:v>48466.312896728516</c:v>
                </c:pt>
                <c:pt idx="183">
                  <c:v>48459.463623046875</c:v>
                </c:pt>
                <c:pt idx="184">
                  <c:v>48455.985778808594</c:v>
                </c:pt>
                <c:pt idx="185">
                  <c:v>48456.707916259766</c:v>
                </c:pt>
                <c:pt idx="186">
                  <c:v>48454.915802001953</c:v>
                </c:pt>
                <c:pt idx="187">
                  <c:v>48447.095092773438</c:v>
                </c:pt>
                <c:pt idx="188">
                  <c:v>48436.845825195313</c:v>
                </c:pt>
                <c:pt idx="189">
                  <c:v>48431.310821533203</c:v>
                </c:pt>
                <c:pt idx="190">
                  <c:v>48428.604400634766</c:v>
                </c:pt>
                <c:pt idx="191">
                  <c:v>48426.869415283203</c:v>
                </c:pt>
                <c:pt idx="192">
                  <c:v>48432.934448242188</c:v>
                </c:pt>
                <c:pt idx="193">
                  <c:v>48432.170867919922</c:v>
                </c:pt>
                <c:pt idx="194">
                  <c:v>48408.9501953125</c:v>
                </c:pt>
                <c:pt idx="195">
                  <c:v>48373.958038330078</c:v>
                </c:pt>
                <c:pt idx="196">
                  <c:v>48353.051635742188</c:v>
                </c:pt>
                <c:pt idx="197">
                  <c:v>48344.602355957031</c:v>
                </c:pt>
                <c:pt idx="198">
                  <c:v>48340.524505615234</c:v>
                </c:pt>
                <c:pt idx="199">
                  <c:v>48334.418090820313</c:v>
                </c:pt>
                <c:pt idx="200">
                  <c:v>48330.825988769531</c:v>
                </c:pt>
                <c:pt idx="201">
                  <c:v>48332.005279541016</c:v>
                </c:pt>
                <c:pt idx="202">
                  <c:v>48339.441711425781</c:v>
                </c:pt>
                <c:pt idx="203">
                  <c:v>48342.249572753906</c:v>
                </c:pt>
                <c:pt idx="204">
                  <c:v>48339.314605712891</c:v>
                </c:pt>
                <c:pt idx="205">
                  <c:v>48334.151031494141</c:v>
                </c:pt>
                <c:pt idx="206">
                  <c:v>48329.044616699219</c:v>
                </c:pt>
                <c:pt idx="207">
                  <c:v>48323.166778564453</c:v>
                </c:pt>
                <c:pt idx="208">
                  <c:v>48317.660369873047</c:v>
                </c:pt>
                <c:pt idx="209">
                  <c:v>48318.896820068359</c:v>
                </c:pt>
                <c:pt idx="210">
                  <c:v>48325.847534179688</c:v>
                </c:pt>
                <c:pt idx="211">
                  <c:v>48328.226837158203</c:v>
                </c:pt>
                <c:pt idx="212">
                  <c:v>48318.548980712891</c:v>
                </c:pt>
                <c:pt idx="213">
                  <c:v>48305.185424804688</c:v>
                </c:pt>
                <c:pt idx="214">
                  <c:v>48293.993286132813</c:v>
                </c:pt>
                <c:pt idx="215">
                  <c:v>48292.944030761719</c:v>
                </c:pt>
                <c:pt idx="216">
                  <c:v>48297.494750976563</c:v>
                </c:pt>
                <c:pt idx="217">
                  <c:v>48305.474060058594</c:v>
                </c:pt>
                <c:pt idx="218">
                  <c:v>48305.996215820313</c:v>
                </c:pt>
                <c:pt idx="219">
                  <c:v>48297.718353271484</c:v>
                </c:pt>
                <c:pt idx="220">
                  <c:v>48287.554809570313</c:v>
                </c:pt>
                <c:pt idx="221">
                  <c:v>48287.562683105469</c:v>
                </c:pt>
                <c:pt idx="222">
                  <c:v>48295.084838867188</c:v>
                </c:pt>
                <c:pt idx="223">
                  <c:v>48299.606994628906</c:v>
                </c:pt>
                <c:pt idx="224">
                  <c:v>48299.386291503906</c:v>
                </c:pt>
                <c:pt idx="225">
                  <c:v>48301.736999511719</c:v>
                </c:pt>
                <c:pt idx="226">
                  <c:v>48303.316314697266</c:v>
                </c:pt>
                <c:pt idx="227">
                  <c:v>48299.609893798828</c:v>
                </c:pt>
                <c:pt idx="228">
                  <c:v>48282.303466796875</c:v>
                </c:pt>
                <c:pt idx="229">
                  <c:v>48265.05419921875</c:v>
                </c:pt>
                <c:pt idx="230">
                  <c:v>48265.033508300781</c:v>
                </c:pt>
                <c:pt idx="231">
                  <c:v>48281.669952392578</c:v>
                </c:pt>
                <c:pt idx="232">
                  <c:v>48299.534973144531</c:v>
                </c:pt>
                <c:pt idx="233">
                  <c:v>48305.542816162109</c:v>
                </c:pt>
                <c:pt idx="234">
                  <c:v>48297.064971923828</c:v>
                </c:pt>
                <c:pt idx="235">
                  <c:v>48282.701416015625</c:v>
                </c:pt>
                <c:pt idx="236">
                  <c:v>48273.509307861328</c:v>
                </c:pt>
                <c:pt idx="237">
                  <c:v>48270.374298095703</c:v>
                </c:pt>
                <c:pt idx="238">
                  <c:v>48268.410766601563</c:v>
                </c:pt>
                <c:pt idx="239">
                  <c:v>48270.075775146484</c:v>
                </c:pt>
                <c:pt idx="240">
                  <c:v>48273.912200927734</c:v>
                </c:pt>
                <c:pt idx="241">
                  <c:v>48273.205780029297</c:v>
                </c:pt>
                <c:pt idx="242">
                  <c:v>48272.870819091797</c:v>
                </c:pt>
                <c:pt idx="243">
                  <c:v>48270.421539306641</c:v>
                </c:pt>
                <c:pt idx="244">
                  <c:v>48266.486541748047</c:v>
                </c:pt>
                <c:pt idx="245">
                  <c:v>48264.180114746094</c:v>
                </c:pt>
                <c:pt idx="246">
                  <c:v>48272.730865478516</c:v>
                </c:pt>
                <c:pt idx="247">
                  <c:v>48281.881591796875</c:v>
                </c:pt>
                <c:pt idx="248">
                  <c:v>48273.975158691406</c:v>
                </c:pt>
                <c:pt idx="249">
                  <c:v>48254.583038330078</c:v>
                </c:pt>
                <c:pt idx="250">
                  <c:v>48246.190902709961</c:v>
                </c:pt>
                <c:pt idx="251">
                  <c:v>48252.65592956543</c:v>
                </c:pt>
                <c:pt idx="252">
                  <c:v>48266.406646728516</c:v>
                </c:pt>
                <c:pt idx="253">
                  <c:v>48274.128814697266</c:v>
                </c:pt>
                <c:pt idx="254">
                  <c:v>48269.079528808594</c:v>
                </c:pt>
                <c:pt idx="255">
                  <c:v>48252.144546508789</c:v>
                </c:pt>
                <c:pt idx="256">
                  <c:v>48244.895278930664</c:v>
                </c:pt>
                <c:pt idx="257">
                  <c:v>48244.874572753906</c:v>
                </c:pt>
                <c:pt idx="258">
                  <c:v>48244.253875732422</c:v>
                </c:pt>
                <c:pt idx="259">
                  <c:v>48245.89030456543</c:v>
                </c:pt>
                <c:pt idx="260">
                  <c:v>48253.412460327148</c:v>
                </c:pt>
                <c:pt idx="261">
                  <c:v>48254.02033996582</c:v>
                </c:pt>
                <c:pt idx="262">
                  <c:v>48246.342498779297</c:v>
                </c:pt>
                <c:pt idx="263">
                  <c:v>48235.293228149414</c:v>
                </c:pt>
                <c:pt idx="264">
                  <c:v>48224.158233642578</c:v>
                </c:pt>
                <c:pt idx="265">
                  <c:v>48215.851821899414</c:v>
                </c:pt>
                <c:pt idx="266">
                  <c:v>48217.54541015625</c:v>
                </c:pt>
                <c:pt idx="267">
                  <c:v>48227.667556762695</c:v>
                </c:pt>
                <c:pt idx="268">
                  <c:v>48239.875427246094</c:v>
                </c:pt>
                <c:pt idx="269">
                  <c:v>48247.711868286133</c:v>
                </c:pt>
                <c:pt idx="270">
                  <c:v>48246.434020996094</c:v>
                </c:pt>
                <c:pt idx="271">
                  <c:v>48234.384750366211</c:v>
                </c:pt>
                <c:pt idx="272">
                  <c:v>48221.449768066406</c:v>
                </c:pt>
                <c:pt idx="273">
                  <c:v>48221.371917724609</c:v>
                </c:pt>
                <c:pt idx="274">
                  <c:v>48235.436935424805</c:v>
                </c:pt>
                <c:pt idx="275">
                  <c:v>48247.016235351563</c:v>
                </c:pt>
                <c:pt idx="276">
                  <c:v>48249.59553527832</c:v>
                </c:pt>
                <c:pt idx="277">
                  <c:v>48245.689117431641</c:v>
                </c:pt>
                <c:pt idx="278">
                  <c:v>48241.896987915039</c:v>
                </c:pt>
                <c:pt idx="279">
                  <c:v>48236.247711181641</c:v>
                </c:pt>
                <c:pt idx="280">
                  <c:v>48225.341293334961</c:v>
                </c:pt>
                <c:pt idx="281">
                  <c:v>48210.86344909668</c:v>
                </c:pt>
                <c:pt idx="282">
                  <c:v>48205.099899291992</c:v>
                </c:pt>
                <c:pt idx="283">
                  <c:v>48209.022048950195</c:v>
                </c:pt>
                <c:pt idx="284">
                  <c:v>48211.715637207031</c:v>
                </c:pt>
                <c:pt idx="285">
                  <c:v>48203.837799072266</c:v>
                </c:pt>
                <c:pt idx="286">
                  <c:v>48193.474227905273</c:v>
                </c:pt>
                <c:pt idx="287">
                  <c:v>48192.882110595703</c:v>
                </c:pt>
                <c:pt idx="288">
                  <c:v>48209.918548583984</c:v>
                </c:pt>
                <c:pt idx="289">
                  <c:v>48232.61213684082</c:v>
                </c:pt>
                <c:pt idx="290">
                  <c:v>48245.362854003906</c:v>
                </c:pt>
                <c:pt idx="291">
                  <c:v>48238.599304199219</c:v>
                </c:pt>
                <c:pt idx="292">
                  <c:v>48223.121459960938</c:v>
                </c:pt>
                <c:pt idx="293">
                  <c:v>48209.615036010742</c:v>
                </c:pt>
                <c:pt idx="294">
                  <c:v>48205.737197875977</c:v>
                </c:pt>
                <c:pt idx="295">
                  <c:v>48200.259353637695</c:v>
                </c:pt>
                <c:pt idx="296">
                  <c:v>48189.552932739258</c:v>
                </c:pt>
                <c:pt idx="297">
                  <c:v>48184.360809326172</c:v>
                </c:pt>
                <c:pt idx="298">
                  <c:v>48189.197250366211</c:v>
                </c:pt>
                <c:pt idx="299">
                  <c:v>48193.976547241211</c:v>
                </c:pt>
                <c:pt idx="300">
                  <c:v>48193.012985229492</c:v>
                </c:pt>
                <c:pt idx="301">
                  <c:v>48190.477996826172</c:v>
                </c:pt>
                <c:pt idx="302">
                  <c:v>48192.114440917969</c:v>
                </c:pt>
                <c:pt idx="303">
                  <c:v>48195.122314453125</c:v>
                </c:pt>
                <c:pt idx="304">
                  <c:v>48196.444473266602</c:v>
                </c:pt>
                <c:pt idx="305">
                  <c:v>48193.709487915039</c:v>
                </c:pt>
                <c:pt idx="306">
                  <c:v>48191.403060913086</c:v>
                </c:pt>
                <c:pt idx="307">
                  <c:v>48193.268081665039</c:v>
                </c:pt>
                <c:pt idx="308">
                  <c:v>48201.418807983398</c:v>
                </c:pt>
                <c:pt idx="309">
                  <c:v>48212.655242919922</c:v>
                </c:pt>
                <c:pt idx="310">
                  <c:v>48217.86311340332</c:v>
                </c:pt>
                <c:pt idx="311">
                  <c:v>48213.842422485352</c:v>
                </c:pt>
                <c:pt idx="312">
                  <c:v>48203.850280761719</c:v>
                </c:pt>
                <c:pt idx="313">
                  <c:v>48195.058151245117</c:v>
                </c:pt>
                <c:pt idx="314">
                  <c:v>48190.408889770508</c:v>
                </c:pt>
                <c:pt idx="315">
                  <c:v>48190.759613037109</c:v>
                </c:pt>
                <c:pt idx="316">
                  <c:v>48191.138916015625</c:v>
                </c:pt>
                <c:pt idx="317">
                  <c:v>48185.718200683594</c:v>
                </c:pt>
                <c:pt idx="318">
                  <c:v>48173.72607421875</c:v>
                </c:pt>
                <c:pt idx="319">
                  <c:v>48164.276809692383</c:v>
                </c:pt>
                <c:pt idx="320">
                  <c:v>48168.084671020508</c:v>
                </c:pt>
                <c:pt idx="321">
                  <c:v>48175.921112060547</c:v>
                </c:pt>
                <c:pt idx="322">
                  <c:v>48180.386123657227</c:v>
                </c:pt>
                <c:pt idx="323">
                  <c:v>48179.965423583984</c:v>
                </c:pt>
                <c:pt idx="324">
                  <c:v>48184.430435180664</c:v>
                </c:pt>
                <c:pt idx="325">
                  <c:v>48192.066879272461</c:v>
                </c:pt>
                <c:pt idx="326">
                  <c:v>48205.017608642578</c:v>
                </c:pt>
                <c:pt idx="327">
                  <c:v>48215.625473022461</c:v>
                </c:pt>
                <c:pt idx="328">
                  <c:v>48214.40478515625</c:v>
                </c:pt>
                <c:pt idx="329">
                  <c:v>48196.241226196289</c:v>
                </c:pt>
                <c:pt idx="330">
                  <c:v>48179.334808349609</c:v>
                </c:pt>
                <c:pt idx="331">
                  <c:v>48183.828384399414</c:v>
                </c:pt>
                <c:pt idx="332">
                  <c:v>48197.493408203125</c:v>
                </c:pt>
                <c:pt idx="333">
                  <c:v>48199.61555480957</c:v>
                </c:pt>
                <c:pt idx="334">
                  <c:v>48186.880569458008</c:v>
                </c:pt>
                <c:pt idx="335">
                  <c:v>48176.602722167969</c:v>
                </c:pt>
                <c:pt idx="336">
                  <c:v>48175.496307373047</c:v>
                </c:pt>
                <c:pt idx="337">
                  <c:v>48176.104187011719</c:v>
                </c:pt>
                <c:pt idx="338">
                  <c:v>48168.397766113281</c:v>
                </c:pt>
                <c:pt idx="339">
                  <c:v>48157.891357421875</c:v>
                </c:pt>
                <c:pt idx="340">
                  <c:v>48157.470642089844</c:v>
                </c:pt>
                <c:pt idx="341">
                  <c:v>48166.764236450195</c:v>
                </c:pt>
                <c:pt idx="342">
                  <c:v>48173.514953613281</c:v>
                </c:pt>
                <c:pt idx="343">
                  <c:v>48170.894256591797</c:v>
                </c:pt>
                <c:pt idx="344">
                  <c:v>48160.044982910156</c:v>
                </c:pt>
                <c:pt idx="345">
                  <c:v>48146.481430053711</c:v>
                </c:pt>
                <c:pt idx="346">
                  <c:v>48140.975006103516</c:v>
                </c:pt>
                <c:pt idx="347">
                  <c:v>48151.697174072266</c:v>
                </c:pt>
                <c:pt idx="348">
                  <c:v>48172.419326782227</c:v>
                </c:pt>
                <c:pt idx="349">
                  <c:v>48185.227188110352</c:v>
                </c:pt>
                <c:pt idx="350">
                  <c:v>48183.806488037109</c:v>
                </c:pt>
                <c:pt idx="351">
                  <c:v>48174.214370727539</c:v>
                </c:pt>
                <c:pt idx="352">
                  <c:v>48169.022232055664</c:v>
                </c:pt>
                <c:pt idx="353">
                  <c:v>48171.915817260742</c:v>
                </c:pt>
                <c:pt idx="354">
                  <c:v>48175.866546630859</c:v>
                </c:pt>
                <c:pt idx="355">
                  <c:v>48173.188705444336</c:v>
                </c:pt>
                <c:pt idx="356">
                  <c:v>48163.73942565918</c:v>
                </c:pt>
                <c:pt idx="357">
                  <c:v>48160.204437255859</c:v>
                </c:pt>
                <c:pt idx="358">
                  <c:v>48163.412307739258</c:v>
                </c:pt>
                <c:pt idx="359">
                  <c:v>48166.791610717773</c:v>
                </c:pt>
                <c:pt idx="360">
                  <c:v>48159.11376953125</c:v>
                </c:pt>
                <c:pt idx="361">
                  <c:v>48147.035919189453</c:v>
                </c:pt>
                <c:pt idx="362">
                  <c:v>48134.958084106445</c:v>
                </c:pt>
                <c:pt idx="363">
                  <c:v>48128.880233764648</c:v>
                </c:pt>
                <c:pt idx="364">
                  <c:v>48130.459533691406</c:v>
                </c:pt>
                <c:pt idx="365">
                  <c:v>48135.895980834961</c:v>
                </c:pt>
                <c:pt idx="366">
                  <c:v>48136.703842163086</c:v>
                </c:pt>
                <c:pt idx="367">
                  <c:v>48133.225997924805</c:v>
                </c:pt>
                <c:pt idx="368">
                  <c:v>48134.262435913086</c:v>
                </c:pt>
                <c:pt idx="369">
                  <c:v>48139.213165283203</c:v>
                </c:pt>
                <c:pt idx="370">
                  <c:v>48140.278182983398</c:v>
                </c:pt>
                <c:pt idx="371">
                  <c:v>48138.286056518555</c:v>
                </c:pt>
                <c:pt idx="372">
                  <c:v>48149.893920898438</c:v>
                </c:pt>
                <c:pt idx="373">
                  <c:v>48169.987503051758</c:v>
                </c:pt>
                <c:pt idx="374">
                  <c:v>48178.59538269043</c:v>
                </c:pt>
                <c:pt idx="375">
                  <c:v>48169.00325012207</c:v>
                </c:pt>
                <c:pt idx="376">
                  <c:v>48158.011123657227</c:v>
                </c:pt>
                <c:pt idx="377">
                  <c:v>48145.990417480469</c:v>
                </c:pt>
                <c:pt idx="378">
                  <c:v>48132.369720458984</c:v>
                </c:pt>
                <c:pt idx="379">
                  <c:v>48124.291870117188</c:v>
                </c:pt>
                <c:pt idx="380">
                  <c:v>48127.928314208984</c:v>
                </c:pt>
                <c:pt idx="381">
                  <c:v>48132.564758300781</c:v>
                </c:pt>
                <c:pt idx="382">
                  <c:v>48130.601196289063</c:v>
                </c:pt>
                <c:pt idx="383">
                  <c:v>48132.409057617188</c:v>
                </c:pt>
                <c:pt idx="384">
                  <c:v>48140.245513916016</c:v>
                </c:pt>
                <c:pt idx="385">
                  <c:v>48140.053375244141</c:v>
                </c:pt>
                <c:pt idx="386">
                  <c:v>48131.861251831055</c:v>
                </c:pt>
                <c:pt idx="387">
                  <c:v>48131.840545654297</c:v>
                </c:pt>
                <c:pt idx="388">
                  <c:v>48142.991271972656</c:v>
                </c:pt>
                <c:pt idx="389">
                  <c:v>48151.199142456055</c:v>
                </c:pt>
                <c:pt idx="390">
                  <c:v>48147.807006835938</c:v>
                </c:pt>
                <c:pt idx="391">
                  <c:v>48136.757736206055</c:v>
                </c:pt>
                <c:pt idx="392">
                  <c:v>48126.651321411133</c:v>
                </c:pt>
                <c:pt idx="393">
                  <c:v>48124.230621337891</c:v>
                </c:pt>
                <c:pt idx="394">
                  <c:v>48125.40991973877</c:v>
                </c:pt>
                <c:pt idx="395">
                  <c:v>48126.074935913086</c:v>
                </c:pt>
                <c:pt idx="396">
                  <c:v>48124.168518066406</c:v>
                </c:pt>
                <c:pt idx="397">
                  <c:v>48123.662101745605</c:v>
                </c:pt>
                <c:pt idx="398">
                  <c:v>48122.469970703125</c:v>
                </c:pt>
                <c:pt idx="399">
                  <c:v>48117.277847290039</c:v>
                </c:pt>
                <c:pt idx="400">
                  <c:v>48114.800003051758</c:v>
                </c:pt>
                <c:pt idx="401">
                  <c:v>48125.236442565918</c:v>
                </c:pt>
                <c:pt idx="402">
                  <c:v>48139.930023193359</c:v>
                </c:pt>
                <c:pt idx="403">
                  <c:v>48146.680755615234</c:v>
                </c:pt>
                <c:pt idx="404">
                  <c:v>48147.1171875</c:v>
                </c:pt>
                <c:pt idx="405">
                  <c:v>48146.182205200195</c:v>
                </c:pt>
                <c:pt idx="406">
                  <c:v>48140.161499023438</c:v>
                </c:pt>
                <c:pt idx="407">
                  <c:v>48131.340805053711</c:v>
                </c:pt>
                <c:pt idx="408">
                  <c:v>48123.605819702148</c:v>
                </c:pt>
                <c:pt idx="409">
                  <c:v>48121.327972412109</c:v>
                </c:pt>
                <c:pt idx="410">
                  <c:v>48127.135841369629</c:v>
                </c:pt>
                <c:pt idx="411">
                  <c:v>48135.600860595703</c:v>
                </c:pt>
                <c:pt idx="412">
                  <c:v>48133.808731079102</c:v>
                </c:pt>
                <c:pt idx="413">
                  <c:v>48119.273742675781</c:v>
                </c:pt>
                <c:pt idx="414">
                  <c:v>48111.281608581543</c:v>
                </c:pt>
                <c:pt idx="415">
                  <c:v>48118.860908508301</c:v>
                </c:pt>
                <c:pt idx="416">
                  <c:v>48133.954498291016</c:v>
                </c:pt>
                <c:pt idx="417">
                  <c:v>48140.276641845703</c:v>
                </c:pt>
                <c:pt idx="418">
                  <c:v>48134.141662597656</c:v>
                </c:pt>
                <c:pt idx="419">
                  <c:v>48124.892387390137</c:v>
                </c:pt>
                <c:pt idx="420">
                  <c:v>48119.128829956055</c:v>
                </c:pt>
                <c:pt idx="421">
                  <c:v>48120.136703491211</c:v>
                </c:pt>
                <c:pt idx="422">
                  <c:v>48129.258850097656</c:v>
                </c:pt>
                <c:pt idx="423">
                  <c:v>48137.695297241211</c:v>
                </c:pt>
                <c:pt idx="424">
                  <c:v>48129.417449951172</c:v>
                </c:pt>
                <c:pt idx="425">
                  <c:v>48109.453895568848</c:v>
                </c:pt>
                <c:pt idx="426">
                  <c:v>48103.061767578125</c:v>
                </c:pt>
                <c:pt idx="427">
                  <c:v>48114.269638061523</c:v>
                </c:pt>
                <c:pt idx="428">
                  <c:v>48131.963226318359</c:v>
                </c:pt>
                <c:pt idx="429">
                  <c:v>48141.713943481445</c:v>
                </c:pt>
                <c:pt idx="430">
                  <c:v>48138.636108398438</c:v>
                </c:pt>
                <c:pt idx="431">
                  <c:v>48135.186828613281</c:v>
                </c:pt>
                <c:pt idx="432">
                  <c:v>48141.308990478516</c:v>
                </c:pt>
                <c:pt idx="433">
                  <c:v>48154.916854858398</c:v>
                </c:pt>
                <c:pt idx="434">
                  <c:v>48161.039016723633</c:v>
                </c:pt>
                <c:pt idx="435">
                  <c:v>48160.504028320313</c:v>
                </c:pt>
                <c:pt idx="436">
                  <c:v>48153.511901855469</c:v>
                </c:pt>
                <c:pt idx="437">
                  <c:v>48142.748336791992</c:v>
                </c:pt>
                <c:pt idx="438">
                  <c:v>48131.213348388672</c:v>
                </c:pt>
                <c:pt idx="439">
                  <c:v>48122.364074707031</c:v>
                </c:pt>
                <c:pt idx="440">
                  <c:v>48120.314804077148</c:v>
                </c:pt>
                <c:pt idx="441">
                  <c:v>48126.094100952148</c:v>
                </c:pt>
                <c:pt idx="442">
                  <c:v>48130.816253662109</c:v>
                </c:pt>
                <c:pt idx="443">
                  <c:v>48128.85270690918</c:v>
                </c:pt>
                <c:pt idx="444">
                  <c:v>48125.546287536621</c:v>
                </c:pt>
                <c:pt idx="445">
                  <c:v>48128.582733154297</c:v>
                </c:pt>
                <c:pt idx="446">
                  <c:v>48133.533447265625</c:v>
                </c:pt>
                <c:pt idx="447">
                  <c:v>48131.484176635742</c:v>
                </c:pt>
                <c:pt idx="448">
                  <c:v>48124.577766418457</c:v>
                </c:pt>
                <c:pt idx="449">
                  <c:v>48119.899925231934</c:v>
                </c:pt>
                <c:pt idx="450">
                  <c:v>48126.622077941895</c:v>
                </c:pt>
                <c:pt idx="451">
                  <c:v>48135.515655517578</c:v>
                </c:pt>
                <c:pt idx="452">
                  <c:v>48132.780670166016</c:v>
                </c:pt>
                <c:pt idx="453">
                  <c:v>48119.302833557129</c:v>
                </c:pt>
                <c:pt idx="454">
                  <c:v>48115.939270019531</c:v>
                </c:pt>
                <c:pt idx="455">
                  <c:v>48128.575714111328</c:v>
                </c:pt>
                <c:pt idx="456">
                  <c:v>48144.955017089844</c:v>
                </c:pt>
                <c:pt idx="457">
                  <c:v>48151.620025634766</c:v>
                </c:pt>
                <c:pt idx="458">
                  <c:v>48147.970748901367</c:v>
                </c:pt>
                <c:pt idx="459">
                  <c:v>48139.435760498047</c:v>
                </c:pt>
                <c:pt idx="460">
                  <c:v>48132.500778198242</c:v>
                </c:pt>
                <c:pt idx="461">
                  <c:v>48129.337219238281</c:v>
                </c:pt>
                <c:pt idx="462">
                  <c:v>48130.802230834961</c:v>
                </c:pt>
                <c:pt idx="463">
                  <c:v>48136.267242431641</c:v>
                </c:pt>
                <c:pt idx="464">
                  <c:v>48142.10368347168</c:v>
                </c:pt>
                <c:pt idx="465">
                  <c:v>48150.568695068359</c:v>
                </c:pt>
                <c:pt idx="466">
                  <c:v>48152.833709716797</c:v>
                </c:pt>
                <c:pt idx="467">
                  <c:v>48145.69873046875</c:v>
                </c:pt>
                <c:pt idx="468">
                  <c:v>48137.649459838867</c:v>
                </c:pt>
                <c:pt idx="469">
                  <c:v>48144.771606445313</c:v>
                </c:pt>
                <c:pt idx="470">
                  <c:v>48156.236618041992</c:v>
                </c:pt>
                <c:pt idx="471">
                  <c:v>48153.787353515625</c:v>
                </c:pt>
                <c:pt idx="472">
                  <c:v>48142.480941772461</c:v>
                </c:pt>
                <c:pt idx="473">
                  <c:v>48131.917373657227</c:v>
                </c:pt>
                <c:pt idx="474">
                  <c:v>48127.725250244141</c:v>
                </c:pt>
                <c:pt idx="475">
                  <c:v>48132.075973510742</c:v>
                </c:pt>
                <c:pt idx="476">
                  <c:v>48145.626693725586</c:v>
                </c:pt>
                <c:pt idx="477">
                  <c:v>48154.891708374023</c:v>
                </c:pt>
                <c:pt idx="478">
                  <c:v>48145.89958190918</c:v>
                </c:pt>
                <c:pt idx="479">
                  <c:v>48127.478881835938</c:v>
                </c:pt>
                <c:pt idx="480">
                  <c:v>48117.858184814453</c:v>
                </c:pt>
                <c:pt idx="481">
                  <c:v>48124.066055297852</c:v>
                </c:pt>
                <c:pt idx="482">
                  <c:v>48127.445350646973</c:v>
                </c:pt>
                <c:pt idx="483">
                  <c:v>48116.538932800293</c:v>
                </c:pt>
                <c:pt idx="484">
                  <c:v>48095.80394744873</c:v>
                </c:pt>
                <c:pt idx="485">
                  <c:v>48083.154678344727</c:v>
                </c:pt>
                <c:pt idx="486">
                  <c:v>48082.619689941406</c:v>
                </c:pt>
                <c:pt idx="487">
                  <c:v>48086.370414733887</c:v>
                </c:pt>
                <c:pt idx="488">
                  <c:v>48084.978286743164</c:v>
                </c:pt>
                <c:pt idx="489">
                  <c:v>48082.671867370605</c:v>
                </c:pt>
                <c:pt idx="490">
                  <c:v>48083.251167297363</c:v>
                </c:pt>
                <c:pt idx="491">
                  <c:v>48087.287612915039</c:v>
                </c:pt>
                <c:pt idx="492">
                  <c:v>48095.924049377441</c:v>
                </c:pt>
                <c:pt idx="493">
                  <c:v>48106.960494995117</c:v>
                </c:pt>
                <c:pt idx="494">
                  <c:v>48114.711219787598</c:v>
                </c:pt>
                <c:pt idx="495">
                  <c:v>48120.890518188477</c:v>
                </c:pt>
                <c:pt idx="496">
                  <c:v>48122.812675476074</c:v>
                </c:pt>
                <c:pt idx="497">
                  <c:v>48115.134834289551</c:v>
                </c:pt>
                <c:pt idx="498">
                  <c:v>48102.685562133789</c:v>
                </c:pt>
                <c:pt idx="499">
                  <c:v>48090.493431091309</c:v>
                </c:pt>
                <c:pt idx="500">
                  <c:v>48086.672729492188</c:v>
                </c:pt>
                <c:pt idx="501">
                  <c:v>48095.423454284668</c:v>
                </c:pt>
                <c:pt idx="502">
                  <c:v>48113.745613098145</c:v>
                </c:pt>
                <c:pt idx="503">
                  <c:v>48123.982055664063</c:v>
                </c:pt>
                <c:pt idx="504">
                  <c:v>48123.389923095703</c:v>
                </c:pt>
                <c:pt idx="505">
                  <c:v>48119.740646362305</c:v>
                </c:pt>
                <c:pt idx="506">
                  <c:v>48119.062805175781</c:v>
                </c:pt>
                <c:pt idx="507">
                  <c:v>48115.61353302002</c:v>
                </c:pt>
                <c:pt idx="508">
                  <c:v>48104.821403503418</c:v>
                </c:pt>
                <c:pt idx="509">
                  <c:v>48091.429275512695</c:v>
                </c:pt>
                <c:pt idx="510">
                  <c:v>48089.008567810059</c:v>
                </c:pt>
                <c:pt idx="511">
                  <c:v>48097.159301757813</c:v>
                </c:pt>
                <c:pt idx="512">
                  <c:v>48100.452880859375</c:v>
                </c:pt>
                <c:pt idx="513">
                  <c:v>48093.51789855957</c:v>
                </c:pt>
                <c:pt idx="514">
                  <c:v>48089.01148223877</c:v>
                </c:pt>
                <c:pt idx="515">
                  <c:v>48092.705062866211</c:v>
                </c:pt>
                <c:pt idx="516">
                  <c:v>48095.22721862793</c:v>
                </c:pt>
                <c:pt idx="517">
                  <c:v>48092.520805358887</c:v>
                </c:pt>
                <c:pt idx="518">
                  <c:v>48086.328674316406</c:v>
                </c:pt>
                <c:pt idx="519">
                  <c:v>48079.022262573242</c:v>
                </c:pt>
                <c:pt idx="520">
                  <c:v>48075.658699035645</c:v>
                </c:pt>
                <c:pt idx="521">
                  <c:v>48079.72371673584</c:v>
                </c:pt>
                <c:pt idx="522">
                  <c:v>48082.331581115723</c:v>
                </c:pt>
                <c:pt idx="523">
                  <c:v>48073.796600341797</c:v>
                </c:pt>
                <c:pt idx="524">
                  <c:v>48060.718753814697</c:v>
                </c:pt>
                <c:pt idx="525">
                  <c:v>48052.726623535156</c:v>
                </c:pt>
                <c:pt idx="526">
                  <c:v>48051.848777770996</c:v>
                </c:pt>
                <c:pt idx="527">
                  <c:v>48057.485221862793</c:v>
                </c:pt>
                <c:pt idx="528">
                  <c:v>48066.407379150391</c:v>
                </c:pt>
                <c:pt idx="529">
                  <c:v>48070.272392272949</c:v>
                </c:pt>
                <c:pt idx="530">
                  <c:v>48066.480262756348</c:v>
                </c:pt>
                <c:pt idx="531">
                  <c:v>48064.859558105469</c:v>
                </c:pt>
                <c:pt idx="532">
                  <c:v>48067.467430114746</c:v>
                </c:pt>
                <c:pt idx="533">
                  <c:v>48067.903869628906</c:v>
                </c:pt>
                <c:pt idx="534">
                  <c:v>48060.083168029785</c:v>
                </c:pt>
                <c:pt idx="535">
                  <c:v>48047.605323791504</c:v>
                </c:pt>
                <c:pt idx="536">
                  <c:v>48039.584625244141</c:v>
                </c:pt>
                <c:pt idx="537">
                  <c:v>48038.449634552002</c:v>
                </c:pt>
                <c:pt idx="538">
                  <c:v>48034.743221282959</c:v>
                </c:pt>
                <c:pt idx="539">
                  <c:v>48021.551090240479</c:v>
                </c:pt>
                <c:pt idx="540">
                  <c:v>48013.101818084717</c:v>
                </c:pt>
                <c:pt idx="541">
                  <c:v>48015.33825969696</c:v>
                </c:pt>
                <c:pt idx="542">
                  <c:v>48022.431844711304</c:v>
                </c:pt>
                <c:pt idx="543">
                  <c:v>48028.039714813232</c:v>
                </c:pt>
                <c:pt idx="544">
                  <c:v>48038.133296966553</c:v>
                </c:pt>
                <c:pt idx="545">
                  <c:v>48046.312599182129</c:v>
                </c:pt>
                <c:pt idx="546">
                  <c:v>48050.263324737549</c:v>
                </c:pt>
                <c:pt idx="547">
                  <c:v>48051.728336334229</c:v>
                </c:pt>
                <c:pt idx="548">
                  <c:v>48051.707637786865</c:v>
                </c:pt>
                <c:pt idx="549">
                  <c:v>48046.915508270264</c:v>
                </c:pt>
                <c:pt idx="550">
                  <c:v>48044.494804382324</c:v>
                </c:pt>
                <c:pt idx="551">
                  <c:v>48043.188388824463</c:v>
                </c:pt>
                <c:pt idx="552">
                  <c:v>48038.110546112061</c:v>
                </c:pt>
                <c:pt idx="553">
                  <c:v>48034.11841583252</c:v>
                </c:pt>
                <c:pt idx="554">
                  <c:v>48037.669143676758</c:v>
                </c:pt>
                <c:pt idx="555">
                  <c:v>48043.819869995117</c:v>
                </c:pt>
                <c:pt idx="556">
                  <c:v>48043.027740478516</c:v>
                </c:pt>
                <c:pt idx="557">
                  <c:v>48042.664180755615</c:v>
                </c:pt>
                <c:pt idx="558">
                  <c:v>48041.272052764893</c:v>
                </c:pt>
                <c:pt idx="559">
                  <c:v>48034.794208526611</c:v>
                </c:pt>
                <c:pt idx="560">
                  <c:v>48027.087791442871</c:v>
                </c:pt>
                <c:pt idx="561">
                  <c:v>48062.724235534668</c:v>
                </c:pt>
                <c:pt idx="562">
                  <c:v>48143.474960327148</c:v>
                </c:pt>
                <c:pt idx="563">
                  <c:v>48195.197113037109</c:v>
                </c:pt>
                <c:pt idx="564">
                  <c:v>48179.462127685547</c:v>
                </c:pt>
                <c:pt idx="565">
                  <c:v>48143.355712890625</c:v>
                </c:pt>
                <c:pt idx="566">
                  <c:v>48130.935012817383</c:v>
                </c:pt>
                <c:pt idx="567">
                  <c:v>48125.171455383301</c:v>
                </c:pt>
                <c:pt idx="568">
                  <c:v>48118.722183227539</c:v>
                </c:pt>
                <c:pt idx="569">
                  <c:v>48116.10147857666</c:v>
                </c:pt>
                <c:pt idx="570">
                  <c:v>48119.509353637695</c:v>
                </c:pt>
                <c:pt idx="571">
                  <c:v>48121.831504821777</c:v>
                </c:pt>
                <c:pt idx="572">
                  <c:v>48118.553665161133</c:v>
                </c:pt>
                <c:pt idx="573">
                  <c:v>48113.790100097656</c:v>
                </c:pt>
                <c:pt idx="574">
                  <c:v>48120.397972106934</c:v>
                </c:pt>
                <c:pt idx="575">
                  <c:v>48129.834411621094</c:v>
                </c:pt>
                <c:pt idx="576">
                  <c:v>48128.185150146484</c:v>
                </c:pt>
                <c:pt idx="577">
                  <c:v>48116.135871887207</c:v>
                </c:pt>
                <c:pt idx="578">
                  <c:v>48112.886596679688</c:v>
                </c:pt>
                <c:pt idx="579">
                  <c:v>48114.951606750488</c:v>
                </c:pt>
                <c:pt idx="580">
                  <c:v>48112.988052368164</c:v>
                </c:pt>
                <c:pt idx="581">
                  <c:v>48107.453063964844</c:v>
                </c:pt>
                <c:pt idx="582">
                  <c:v>48110.518081665039</c:v>
                </c:pt>
                <c:pt idx="583">
                  <c:v>48117.983093261719</c:v>
                </c:pt>
                <c:pt idx="584">
                  <c:v>48122.133819580078</c:v>
                </c:pt>
                <c:pt idx="585">
                  <c:v>48113.427406311035</c:v>
                </c:pt>
                <c:pt idx="586">
                  <c:v>48100.206703186035</c:v>
                </c:pt>
                <c:pt idx="587">
                  <c:v>48098.700286865234</c:v>
                </c:pt>
                <c:pt idx="588">
                  <c:v>48114.851013183594</c:v>
                </c:pt>
                <c:pt idx="589">
                  <c:v>48132.287460327148</c:v>
                </c:pt>
                <c:pt idx="590">
                  <c:v>48144.866760253906</c:v>
                </c:pt>
                <c:pt idx="591">
                  <c:v>48154.560333251953</c:v>
                </c:pt>
                <c:pt idx="592">
                  <c:v>48152.396774291992</c:v>
                </c:pt>
                <c:pt idx="593">
                  <c:v>48130.804641723633</c:v>
                </c:pt>
                <c:pt idx="594">
                  <c:v>48544.526794433594</c:v>
                </c:pt>
                <c:pt idx="595">
                  <c:v>51375.163330078125</c:v>
                </c:pt>
                <c:pt idx="596">
                  <c:v>60067.142578125</c:v>
                </c:pt>
                <c:pt idx="597">
                  <c:v>77879.064453125</c:v>
                </c:pt>
                <c:pt idx="598">
                  <c:v>106086.16015625</c:v>
                </c:pt>
                <c:pt idx="599">
                  <c:v>144052.5078125</c:v>
                </c:pt>
                <c:pt idx="600">
                  <c:v>191021.0625</c:v>
                </c:pt>
                <c:pt idx="601">
                  <c:v>246356.984375</c:v>
                </c:pt>
                <c:pt idx="602">
                  <c:v>286326.84375</c:v>
                </c:pt>
                <c:pt idx="603">
                  <c:v>297475.96875</c:v>
                </c:pt>
                <c:pt idx="604">
                  <c:v>297476.0625</c:v>
                </c:pt>
                <c:pt idx="605">
                  <c:v>297476.15625</c:v>
                </c:pt>
                <c:pt idx="606">
                  <c:v>297476.25</c:v>
                </c:pt>
                <c:pt idx="607">
                  <c:v>297476.34375</c:v>
                </c:pt>
                <c:pt idx="608">
                  <c:v>297476.4375</c:v>
                </c:pt>
                <c:pt idx="609">
                  <c:v>297476.53125</c:v>
                </c:pt>
                <c:pt idx="610">
                  <c:v>297476.625</c:v>
                </c:pt>
                <c:pt idx="611">
                  <c:v>297476.71875</c:v>
                </c:pt>
                <c:pt idx="612">
                  <c:v>297476.8125</c:v>
                </c:pt>
                <c:pt idx="613">
                  <c:v>297476.90625</c:v>
                </c:pt>
                <c:pt idx="614">
                  <c:v>297477</c:v>
                </c:pt>
                <c:pt idx="615">
                  <c:v>297477.09375</c:v>
                </c:pt>
                <c:pt idx="616">
                  <c:v>297477.1875</c:v>
                </c:pt>
                <c:pt idx="617">
                  <c:v>297477.28125</c:v>
                </c:pt>
                <c:pt idx="618">
                  <c:v>297477.375</c:v>
                </c:pt>
                <c:pt idx="619">
                  <c:v>297477.46875</c:v>
                </c:pt>
                <c:pt idx="620">
                  <c:v>297477.5625</c:v>
                </c:pt>
                <c:pt idx="621">
                  <c:v>297477.65625</c:v>
                </c:pt>
                <c:pt idx="622">
                  <c:v>297477.75</c:v>
                </c:pt>
                <c:pt idx="623">
                  <c:v>297477.84375</c:v>
                </c:pt>
                <c:pt idx="624">
                  <c:v>297477.9375</c:v>
                </c:pt>
                <c:pt idx="625">
                  <c:v>297478.03125</c:v>
                </c:pt>
                <c:pt idx="626">
                  <c:v>297478.125</c:v>
                </c:pt>
                <c:pt idx="627">
                  <c:v>297478.21875</c:v>
                </c:pt>
                <c:pt idx="628">
                  <c:v>297478.3125</c:v>
                </c:pt>
                <c:pt idx="629">
                  <c:v>297478.40625</c:v>
                </c:pt>
                <c:pt idx="630">
                  <c:v>297478.5</c:v>
                </c:pt>
                <c:pt idx="631">
                  <c:v>297478.59375</c:v>
                </c:pt>
                <c:pt idx="632">
                  <c:v>297478.6875</c:v>
                </c:pt>
                <c:pt idx="633">
                  <c:v>297478.78125</c:v>
                </c:pt>
                <c:pt idx="634">
                  <c:v>297478.875</c:v>
                </c:pt>
                <c:pt idx="635">
                  <c:v>297478.96875</c:v>
                </c:pt>
                <c:pt idx="636">
                  <c:v>297479.0625</c:v>
                </c:pt>
                <c:pt idx="637">
                  <c:v>297479.15625</c:v>
                </c:pt>
                <c:pt idx="638">
                  <c:v>297479.25</c:v>
                </c:pt>
                <c:pt idx="639">
                  <c:v>297479.34375</c:v>
                </c:pt>
                <c:pt idx="640">
                  <c:v>297479.4375</c:v>
                </c:pt>
                <c:pt idx="641">
                  <c:v>297479.53125</c:v>
                </c:pt>
                <c:pt idx="642">
                  <c:v>297479.625</c:v>
                </c:pt>
                <c:pt idx="643">
                  <c:v>297479.71875</c:v>
                </c:pt>
                <c:pt idx="644">
                  <c:v>297479.8125</c:v>
                </c:pt>
                <c:pt idx="645">
                  <c:v>297479.90625</c:v>
                </c:pt>
                <c:pt idx="646">
                  <c:v>297480</c:v>
                </c:pt>
                <c:pt idx="647">
                  <c:v>297480.09375</c:v>
                </c:pt>
                <c:pt idx="648">
                  <c:v>297480.1875</c:v>
                </c:pt>
                <c:pt idx="649">
                  <c:v>297480.28125</c:v>
                </c:pt>
                <c:pt idx="650">
                  <c:v>297480.375</c:v>
                </c:pt>
                <c:pt idx="651">
                  <c:v>297480.46875</c:v>
                </c:pt>
                <c:pt idx="652">
                  <c:v>297480.5625</c:v>
                </c:pt>
                <c:pt idx="653">
                  <c:v>297480.640625</c:v>
                </c:pt>
                <c:pt idx="654">
                  <c:v>297480.734375</c:v>
                </c:pt>
                <c:pt idx="655">
                  <c:v>297480.828125</c:v>
                </c:pt>
                <c:pt idx="656">
                  <c:v>297480.921875</c:v>
                </c:pt>
                <c:pt idx="657">
                  <c:v>297481.015625</c:v>
                </c:pt>
                <c:pt idx="658">
                  <c:v>297481.109375</c:v>
                </c:pt>
                <c:pt idx="659">
                  <c:v>297481.203125</c:v>
                </c:pt>
                <c:pt idx="660">
                  <c:v>297481.296875</c:v>
                </c:pt>
                <c:pt idx="661">
                  <c:v>297481.390625</c:v>
                </c:pt>
                <c:pt idx="662">
                  <c:v>297481.484375</c:v>
                </c:pt>
                <c:pt idx="663">
                  <c:v>297481.578125</c:v>
                </c:pt>
                <c:pt idx="664">
                  <c:v>297481.671875</c:v>
                </c:pt>
                <c:pt idx="665">
                  <c:v>297481.765625</c:v>
                </c:pt>
                <c:pt idx="666">
                  <c:v>297481.859375</c:v>
                </c:pt>
                <c:pt idx="667">
                  <c:v>297481.953125</c:v>
                </c:pt>
                <c:pt idx="668">
                  <c:v>297482.046875</c:v>
                </c:pt>
                <c:pt idx="669">
                  <c:v>297482.140625</c:v>
                </c:pt>
                <c:pt idx="670">
                  <c:v>297482.234375</c:v>
                </c:pt>
                <c:pt idx="671">
                  <c:v>297482.328125</c:v>
                </c:pt>
                <c:pt idx="672">
                  <c:v>297482.421875</c:v>
                </c:pt>
                <c:pt idx="673">
                  <c:v>297482.515625</c:v>
                </c:pt>
                <c:pt idx="674">
                  <c:v>297482.609375</c:v>
                </c:pt>
                <c:pt idx="675">
                  <c:v>297482.703125</c:v>
                </c:pt>
                <c:pt idx="676">
                  <c:v>297482.796875</c:v>
                </c:pt>
                <c:pt idx="677">
                  <c:v>297482.890625</c:v>
                </c:pt>
                <c:pt idx="678">
                  <c:v>297482.984375</c:v>
                </c:pt>
                <c:pt idx="679">
                  <c:v>297483.078125</c:v>
                </c:pt>
                <c:pt idx="680">
                  <c:v>297483.171875</c:v>
                </c:pt>
                <c:pt idx="681">
                  <c:v>297483.265625</c:v>
                </c:pt>
                <c:pt idx="682">
                  <c:v>297483.359375</c:v>
                </c:pt>
                <c:pt idx="683">
                  <c:v>297483.453125</c:v>
                </c:pt>
                <c:pt idx="684">
                  <c:v>297483.546875</c:v>
                </c:pt>
                <c:pt idx="685">
                  <c:v>297483.640625</c:v>
                </c:pt>
                <c:pt idx="686">
                  <c:v>297483.734375</c:v>
                </c:pt>
                <c:pt idx="687">
                  <c:v>297483.828125</c:v>
                </c:pt>
                <c:pt idx="688">
                  <c:v>297483.921875</c:v>
                </c:pt>
                <c:pt idx="689">
                  <c:v>297484.015625</c:v>
                </c:pt>
                <c:pt idx="690">
                  <c:v>290440.875</c:v>
                </c:pt>
                <c:pt idx="691">
                  <c:v>274008.03125</c:v>
                </c:pt>
                <c:pt idx="692">
                  <c:v>264467.5</c:v>
                </c:pt>
                <c:pt idx="693">
                  <c:v>247435.3125</c:v>
                </c:pt>
                <c:pt idx="694">
                  <c:v>198112.546875</c:v>
                </c:pt>
                <c:pt idx="695">
                  <c:v>132745.265625</c:v>
                </c:pt>
                <c:pt idx="696">
                  <c:v>88263.55859375</c:v>
                </c:pt>
                <c:pt idx="697">
                  <c:v>66507.908203125</c:v>
                </c:pt>
                <c:pt idx="698">
                  <c:v>58341.57421875</c:v>
                </c:pt>
                <c:pt idx="699">
                  <c:v>56343.267578125</c:v>
                </c:pt>
                <c:pt idx="700">
                  <c:v>56673.4462890625</c:v>
                </c:pt>
                <c:pt idx="701">
                  <c:v>57872.3115234375</c:v>
                </c:pt>
                <c:pt idx="702">
                  <c:v>59280.7763671875</c:v>
                </c:pt>
                <c:pt idx="703">
                  <c:v>60937.927734375</c:v>
                </c:pt>
                <c:pt idx="704">
                  <c:v>63551.2783203125</c:v>
                </c:pt>
                <c:pt idx="705">
                  <c:v>67497.9140625</c:v>
                </c:pt>
                <c:pt idx="706">
                  <c:v>72194.037109375</c:v>
                </c:pt>
                <c:pt idx="707">
                  <c:v>76825.73046875</c:v>
                </c:pt>
                <c:pt idx="708">
                  <c:v>81173.8515625</c:v>
                </c:pt>
                <c:pt idx="709">
                  <c:v>85589.17578125</c:v>
                </c:pt>
                <c:pt idx="710">
                  <c:v>90614.78125</c:v>
                </c:pt>
                <c:pt idx="711">
                  <c:v>96881.078125</c:v>
                </c:pt>
                <c:pt idx="712">
                  <c:v>105083.02734375</c:v>
                </c:pt>
                <c:pt idx="713">
                  <c:v>115808.3515625</c:v>
                </c:pt>
                <c:pt idx="714">
                  <c:v>129033.2734375</c:v>
                </c:pt>
                <c:pt idx="715">
                  <c:v>143183.109375</c:v>
                </c:pt>
                <c:pt idx="716">
                  <c:v>154354.140625</c:v>
                </c:pt>
                <c:pt idx="717">
                  <c:v>157507.4921875</c:v>
                </c:pt>
                <c:pt idx="718">
                  <c:v>151062.8203125</c:v>
                </c:pt>
                <c:pt idx="719">
                  <c:v>138302.96875</c:v>
                </c:pt>
                <c:pt idx="720">
                  <c:v>123340.890625</c:v>
                </c:pt>
                <c:pt idx="721">
                  <c:v>108737.328125</c:v>
                </c:pt>
                <c:pt idx="722">
                  <c:v>96503.5625</c:v>
                </c:pt>
                <c:pt idx="723">
                  <c:v>88340.76953125</c:v>
                </c:pt>
                <c:pt idx="724">
                  <c:v>84406.63671875</c:v>
                </c:pt>
                <c:pt idx="725">
                  <c:v>84310.4140625</c:v>
                </c:pt>
                <c:pt idx="726">
                  <c:v>87446.1953125</c:v>
                </c:pt>
                <c:pt idx="727">
                  <c:v>92686.23046875</c:v>
                </c:pt>
                <c:pt idx="728">
                  <c:v>98828.4375</c:v>
                </c:pt>
                <c:pt idx="729">
                  <c:v>105168.41796875</c:v>
                </c:pt>
                <c:pt idx="730">
                  <c:v>111451.11328125</c:v>
                </c:pt>
                <c:pt idx="731">
                  <c:v>117493.890625</c:v>
                </c:pt>
                <c:pt idx="732">
                  <c:v>123000.1015625</c:v>
                </c:pt>
                <c:pt idx="733">
                  <c:v>127678.703125</c:v>
                </c:pt>
                <c:pt idx="734">
                  <c:v>131349.515625</c:v>
                </c:pt>
                <c:pt idx="735">
                  <c:v>134045.8671875</c:v>
                </c:pt>
                <c:pt idx="736">
                  <c:v>135272.5859375</c:v>
                </c:pt>
                <c:pt idx="737">
                  <c:v>131518.3359375</c:v>
                </c:pt>
                <c:pt idx="738">
                  <c:v>119035.4609375</c:v>
                </c:pt>
                <c:pt idx="739">
                  <c:v>100935.41015625</c:v>
                </c:pt>
                <c:pt idx="740">
                  <c:v>86436.10546875</c:v>
                </c:pt>
                <c:pt idx="741">
                  <c:v>79777.083984375</c:v>
                </c:pt>
                <c:pt idx="742">
                  <c:v>77444.578125</c:v>
                </c:pt>
                <c:pt idx="743">
                  <c:v>76291.44140625</c:v>
                </c:pt>
                <c:pt idx="744">
                  <c:v>76567.6796875</c:v>
                </c:pt>
                <c:pt idx="745">
                  <c:v>77340.916015625</c:v>
                </c:pt>
                <c:pt idx="746">
                  <c:v>76400.5234375</c:v>
                </c:pt>
                <c:pt idx="747">
                  <c:v>74032.931640625</c:v>
                </c:pt>
                <c:pt idx="748">
                  <c:v>72715.625</c:v>
                </c:pt>
                <c:pt idx="749">
                  <c:v>75786.8046875</c:v>
                </c:pt>
                <c:pt idx="750">
                  <c:v>90105.984375</c:v>
                </c:pt>
                <c:pt idx="751">
                  <c:v>125827.6484375</c:v>
                </c:pt>
                <c:pt idx="752">
                  <c:v>188019.171875</c:v>
                </c:pt>
                <c:pt idx="753">
                  <c:v>257322.515625</c:v>
                </c:pt>
                <c:pt idx="754">
                  <c:v>293324.296875</c:v>
                </c:pt>
                <c:pt idx="755">
                  <c:v>265916.65625</c:v>
                </c:pt>
                <c:pt idx="756">
                  <c:v>197007.40625</c:v>
                </c:pt>
                <c:pt idx="757">
                  <c:v>130540.609375</c:v>
                </c:pt>
                <c:pt idx="758">
                  <c:v>91797.50390625</c:v>
                </c:pt>
                <c:pt idx="759">
                  <c:v>74548.197265625</c:v>
                </c:pt>
                <c:pt idx="760">
                  <c:v>69082.546875</c:v>
                </c:pt>
                <c:pt idx="761">
                  <c:v>67923.955078125</c:v>
                </c:pt>
                <c:pt idx="762">
                  <c:v>67901.763671875</c:v>
                </c:pt>
                <c:pt idx="763">
                  <c:v>69559.685546875</c:v>
                </c:pt>
                <c:pt idx="764">
                  <c:v>73304.349609375</c:v>
                </c:pt>
                <c:pt idx="765">
                  <c:v>76386.7578125</c:v>
                </c:pt>
                <c:pt idx="766">
                  <c:v>75338.337890625</c:v>
                </c:pt>
                <c:pt idx="767">
                  <c:v>70663.087890625</c:v>
                </c:pt>
                <c:pt idx="768">
                  <c:v>66144.810546875</c:v>
                </c:pt>
                <c:pt idx="769">
                  <c:v>64125.7041015625</c:v>
                </c:pt>
                <c:pt idx="770">
                  <c:v>63997.9404296875</c:v>
                </c:pt>
                <c:pt idx="771">
                  <c:v>64447.548828125</c:v>
                </c:pt>
                <c:pt idx="772">
                  <c:v>65371.013671875</c:v>
                </c:pt>
                <c:pt idx="773">
                  <c:v>67861.05078125</c:v>
                </c:pt>
                <c:pt idx="774">
                  <c:v>73658.2578125</c:v>
                </c:pt>
                <c:pt idx="775">
                  <c:v>85044.46484375</c:v>
                </c:pt>
                <c:pt idx="776">
                  <c:v>104375.90234375</c:v>
                </c:pt>
                <c:pt idx="777">
                  <c:v>132232.25</c:v>
                </c:pt>
                <c:pt idx="778">
                  <c:v>166241.8359375</c:v>
                </c:pt>
                <c:pt idx="779">
                  <c:v>202653.09375</c:v>
                </c:pt>
                <c:pt idx="780">
                  <c:v>238922.984375</c:v>
                </c:pt>
                <c:pt idx="781">
                  <c:v>273086.109375</c:v>
                </c:pt>
                <c:pt idx="782">
                  <c:v>293851.65625</c:v>
                </c:pt>
                <c:pt idx="783">
                  <c:v>297492.8125</c:v>
                </c:pt>
                <c:pt idx="784">
                  <c:v>297492.90625</c:v>
                </c:pt>
                <c:pt idx="785">
                  <c:v>276389.625</c:v>
                </c:pt>
                <c:pt idx="786">
                  <c:v>216615.234375</c:v>
                </c:pt>
                <c:pt idx="787">
                  <c:v>145133.15625</c:v>
                </c:pt>
                <c:pt idx="788">
                  <c:v>99823.39453125</c:v>
                </c:pt>
                <c:pt idx="789">
                  <c:v>78855.26171875</c:v>
                </c:pt>
                <c:pt idx="790">
                  <c:v>72653.041015625</c:v>
                </c:pt>
                <c:pt idx="791">
                  <c:v>72321.591796875</c:v>
                </c:pt>
                <c:pt idx="792">
                  <c:v>71959.599609375</c:v>
                </c:pt>
                <c:pt idx="793">
                  <c:v>69739.408203125</c:v>
                </c:pt>
                <c:pt idx="794">
                  <c:v>66681.244140625</c:v>
                </c:pt>
                <c:pt idx="795">
                  <c:v>64255.537109375</c:v>
                </c:pt>
                <c:pt idx="796">
                  <c:v>63188.1455078125</c:v>
                </c:pt>
                <c:pt idx="797">
                  <c:v>63962.8388671875</c:v>
                </c:pt>
                <c:pt idx="798">
                  <c:v>66994.6171875</c:v>
                </c:pt>
                <c:pt idx="799">
                  <c:v>72171.51171875</c:v>
                </c:pt>
                <c:pt idx="800">
                  <c:v>78177.3203125</c:v>
                </c:pt>
                <c:pt idx="801">
                  <c:v>81446.83984375</c:v>
                </c:pt>
                <c:pt idx="802">
                  <c:v>78987.021484375</c:v>
                </c:pt>
                <c:pt idx="803">
                  <c:v>72902.572265625</c:v>
                </c:pt>
                <c:pt idx="804">
                  <c:v>69880.208984375</c:v>
                </c:pt>
                <c:pt idx="805">
                  <c:v>74927.701171875</c:v>
                </c:pt>
                <c:pt idx="806">
                  <c:v>88535.48046875</c:v>
                </c:pt>
                <c:pt idx="807">
                  <c:v>109485.74609375</c:v>
                </c:pt>
                <c:pt idx="808">
                  <c:v>137424.7265625</c:v>
                </c:pt>
                <c:pt idx="809">
                  <c:v>173610.9921875</c:v>
                </c:pt>
                <c:pt idx="810">
                  <c:v>221351.65625</c:v>
                </c:pt>
                <c:pt idx="811">
                  <c:v>268394.15625</c:v>
                </c:pt>
                <c:pt idx="812">
                  <c:v>295294.640625</c:v>
                </c:pt>
                <c:pt idx="813">
                  <c:v>297495.625</c:v>
                </c:pt>
                <c:pt idx="814">
                  <c:v>297495.71875</c:v>
                </c:pt>
                <c:pt idx="815">
                  <c:v>297495.8125</c:v>
                </c:pt>
                <c:pt idx="816">
                  <c:v>297495.90625</c:v>
                </c:pt>
                <c:pt idx="817">
                  <c:v>297496</c:v>
                </c:pt>
                <c:pt idx="818">
                  <c:v>297496.09375</c:v>
                </c:pt>
                <c:pt idx="819">
                  <c:v>297496.1875</c:v>
                </c:pt>
                <c:pt idx="820">
                  <c:v>297496.28125</c:v>
                </c:pt>
                <c:pt idx="821">
                  <c:v>297496.375</c:v>
                </c:pt>
                <c:pt idx="822">
                  <c:v>297496.46875</c:v>
                </c:pt>
                <c:pt idx="823">
                  <c:v>297496.5625</c:v>
                </c:pt>
                <c:pt idx="824">
                  <c:v>297496.65625</c:v>
                </c:pt>
                <c:pt idx="825">
                  <c:v>297496.75</c:v>
                </c:pt>
                <c:pt idx="826">
                  <c:v>297496.84375</c:v>
                </c:pt>
                <c:pt idx="827">
                  <c:v>297496.9375</c:v>
                </c:pt>
                <c:pt idx="828">
                  <c:v>297497.03125</c:v>
                </c:pt>
                <c:pt idx="829">
                  <c:v>269836.6875</c:v>
                </c:pt>
                <c:pt idx="830">
                  <c:v>202262.671875</c:v>
                </c:pt>
                <c:pt idx="831">
                  <c:v>126869.7890625</c:v>
                </c:pt>
                <c:pt idx="832">
                  <c:v>82636.54296875</c:v>
                </c:pt>
                <c:pt idx="833">
                  <c:v>62866.63671875</c:v>
                </c:pt>
                <c:pt idx="834">
                  <c:v>56185.75830078125</c:v>
                </c:pt>
                <c:pt idx="835">
                  <c:v>54352.42333984375</c:v>
                </c:pt>
                <c:pt idx="836">
                  <c:v>53457.1455078125</c:v>
                </c:pt>
                <c:pt idx="837">
                  <c:v>52641.21044921875</c:v>
                </c:pt>
                <c:pt idx="838">
                  <c:v>51999.875732421875</c:v>
                </c:pt>
                <c:pt idx="839">
                  <c:v>51615.74072265625</c:v>
                </c:pt>
                <c:pt idx="840">
                  <c:v>51503.719970703125</c:v>
                </c:pt>
                <c:pt idx="841">
                  <c:v>51805.842041015625</c:v>
                </c:pt>
                <c:pt idx="842">
                  <c:v>53073.1357421875</c:v>
                </c:pt>
                <c:pt idx="843">
                  <c:v>56290.8291015625</c:v>
                </c:pt>
                <c:pt idx="844">
                  <c:v>62471.3515625</c:v>
                </c:pt>
                <c:pt idx="845">
                  <c:v>72089.958984375</c:v>
                </c:pt>
                <c:pt idx="846">
                  <c:v>84933.65234375</c:v>
                </c:pt>
                <c:pt idx="847">
                  <c:v>100371.2890625</c:v>
                </c:pt>
                <c:pt idx="848">
                  <c:v>117331.265625</c:v>
                </c:pt>
                <c:pt idx="849">
                  <c:v>130912.1640625</c:v>
                </c:pt>
                <c:pt idx="850">
                  <c:v>130882.2578125</c:v>
                </c:pt>
                <c:pt idx="851">
                  <c:v>113152.94921875</c:v>
                </c:pt>
                <c:pt idx="852">
                  <c:v>86941.95703125</c:v>
                </c:pt>
                <c:pt idx="853">
                  <c:v>66038.537109375</c:v>
                </c:pt>
                <c:pt idx="854">
                  <c:v>55064.65869140625</c:v>
                </c:pt>
                <c:pt idx="855">
                  <c:v>51076.43798828125</c:v>
                </c:pt>
                <c:pt idx="856">
                  <c:v>50018.617309570313</c:v>
                </c:pt>
                <c:pt idx="857">
                  <c:v>49632.853759765625</c:v>
                </c:pt>
                <c:pt idx="858">
                  <c:v>49305.633056640625</c:v>
                </c:pt>
                <c:pt idx="859">
                  <c:v>49047.469482421875</c:v>
                </c:pt>
                <c:pt idx="860">
                  <c:v>48900.963134765625</c:v>
                </c:pt>
                <c:pt idx="861">
                  <c:v>48838.913818359375</c:v>
                </c:pt>
                <c:pt idx="862">
                  <c:v>48813.521728515625</c:v>
                </c:pt>
                <c:pt idx="863">
                  <c:v>48780.358154296875</c:v>
                </c:pt>
                <c:pt idx="864">
                  <c:v>48736.766052246094</c:v>
                </c:pt>
                <c:pt idx="865">
                  <c:v>48701.9453125</c:v>
                </c:pt>
                <c:pt idx="866">
                  <c:v>48702.467468261719</c:v>
                </c:pt>
                <c:pt idx="867">
                  <c:v>48750.761047363281</c:v>
                </c:pt>
                <c:pt idx="868">
                  <c:v>48894.797485351563</c:v>
                </c:pt>
                <c:pt idx="869">
                  <c:v>49191.262573242188</c:v>
                </c:pt>
                <c:pt idx="870">
                  <c:v>49599.498901367188</c:v>
                </c:pt>
                <c:pt idx="871">
                  <c:v>49925.135375976563</c:v>
                </c:pt>
                <c:pt idx="872">
                  <c:v>49953.22900390625</c:v>
                </c:pt>
                <c:pt idx="873">
                  <c:v>49663.693969726563</c:v>
                </c:pt>
                <c:pt idx="874">
                  <c:v>49250.530395507813</c:v>
                </c:pt>
                <c:pt idx="875">
                  <c:v>48927.109741210938</c:v>
                </c:pt>
                <c:pt idx="876">
                  <c:v>48761.431884765625</c:v>
                </c:pt>
                <c:pt idx="877">
                  <c:v>48696.154052734375</c:v>
                </c:pt>
                <c:pt idx="878">
                  <c:v>48667.561950683594</c:v>
                </c:pt>
                <c:pt idx="879">
                  <c:v>48658.198364257813</c:v>
                </c:pt>
                <c:pt idx="880">
                  <c:v>48670.891967773438</c:v>
                </c:pt>
                <c:pt idx="881">
                  <c:v>48698.042663574219</c:v>
                </c:pt>
                <c:pt idx="882">
                  <c:v>48723.650573730469</c:v>
                </c:pt>
                <c:pt idx="883">
                  <c:v>48739.286987304688</c:v>
                </c:pt>
                <c:pt idx="884">
                  <c:v>48753.5234375</c:v>
                </c:pt>
                <c:pt idx="885">
                  <c:v>48773.531311035156</c:v>
                </c:pt>
                <c:pt idx="886">
                  <c:v>48793.424865722656</c:v>
                </c:pt>
                <c:pt idx="887">
                  <c:v>48793.575622558594</c:v>
                </c:pt>
                <c:pt idx="888">
                  <c:v>48772.012023925781</c:v>
                </c:pt>
                <c:pt idx="889">
                  <c:v>48736.991333007813</c:v>
                </c:pt>
                <c:pt idx="890">
                  <c:v>48694.913513183594</c:v>
                </c:pt>
                <c:pt idx="891">
                  <c:v>48641.978515625</c:v>
                </c:pt>
                <c:pt idx="892">
                  <c:v>48575.014953613281</c:v>
                </c:pt>
                <c:pt idx="893">
                  <c:v>48512.051391601563</c:v>
                </c:pt>
                <c:pt idx="894">
                  <c:v>48478.687835693359</c:v>
                </c:pt>
                <c:pt idx="895">
                  <c:v>48477.581420898438</c:v>
                </c:pt>
                <c:pt idx="896">
                  <c:v>48484.446441650391</c:v>
                </c:pt>
                <c:pt idx="897">
                  <c:v>48482.054321289063</c:v>
                </c:pt>
                <c:pt idx="898">
                  <c:v>48469.490753173828</c:v>
                </c:pt>
                <c:pt idx="899">
                  <c:v>48449.384338378906</c:v>
                </c:pt>
                <c:pt idx="900">
                  <c:v>48432.992218017578</c:v>
                </c:pt>
                <c:pt idx="901">
                  <c:v>48431.6572265625</c:v>
                </c:pt>
                <c:pt idx="902">
                  <c:v>48439.636505126953</c:v>
                </c:pt>
                <c:pt idx="903">
                  <c:v>48438.330108642578</c:v>
                </c:pt>
                <c:pt idx="904">
                  <c:v>48426.195129394531</c:v>
                </c:pt>
                <c:pt idx="905">
                  <c:v>48413.888702392578</c:v>
                </c:pt>
                <c:pt idx="906">
                  <c:v>48407.010864257813</c:v>
                </c:pt>
                <c:pt idx="907">
                  <c:v>48397.504455566406</c:v>
                </c:pt>
                <c:pt idx="908">
                  <c:v>48391.512298583984</c:v>
                </c:pt>
                <c:pt idx="909">
                  <c:v>48397.034454345703</c:v>
                </c:pt>
                <c:pt idx="910">
                  <c:v>48414.328063964844</c:v>
                </c:pt>
                <c:pt idx="911">
                  <c:v>48432.735931396484</c:v>
                </c:pt>
                <c:pt idx="912">
                  <c:v>48445.429504394531</c:v>
                </c:pt>
                <c:pt idx="913">
                  <c:v>48450.437377929688</c:v>
                </c:pt>
                <c:pt idx="914">
                  <c:v>48456.788116455078</c:v>
                </c:pt>
                <c:pt idx="915">
                  <c:v>48481.738830566406</c:v>
                </c:pt>
                <c:pt idx="916">
                  <c:v>48538.661010742188</c:v>
                </c:pt>
                <c:pt idx="917">
                  <c:v>48630.840270996094</c:v>
                </c:pt>
                <c:pt idx="918">
                  <c:v>48775.933898925781</c:v>
                </c:pt>
                <c:pt idx="919">
                  <c:v>49087.827514648438</c:v>
                </c:pt>
                <c:pt idx="920">
                  <c:v>49885.863891601563</c:v>
                </c:pt>
                <c:pt idx="921">
                  <c:v>51651.643310546875</c:v>
                </c:pt>
                <c:pt idx="922">
                  <c:v>54787.5654296875</c:v>
                </c:pt>
                <c:pt idx="923">
                  <c:v>59330.2021484375</c:v>
                </c:pt>
                <c:pt idx="924">
                  <c:v>64700.466796875</c:v>
                </c:pt>
                <c:pt idx="925">
                  <c:v>69331.58984375</c:v>
                </c:pt>
                <c:pt idx="926">
                  <c:v>70809.33984375</c:v>
                </c:pt>
                <c:pt idx="927">
                  <c:v>67736.689453125</c:v>
                </c:pt>
                <c:pt idx="928">
                  <c:v>61484.7265625</c:v>
                </c:pt>
                <c:pt idx="929">
                  <c:v>55215.30615234375</c:v>
                </c:pt>
                <c:pt idx="930">
                  <c:v>51102.228271484375</c:v>
                </c:pt>
                <c:pt idx="931">
                  <c:v>49275.407592773438</c:v>
                </c:pt>
                <c:pt idx="932">
                  <c:v>48841.415466308594</c:v>
                </c:pt>
                <c:pt idx="933">
                  <c:v>49013.451904296875</c:v>
                </c:pt>
                <c:pt idx="934">
                  <c:v>49432.488403320313</c:v>
                </c:pt>
                <c:pt idx="935">
                  <c:v>49956.381958007813</c:v>
                </c:pt>
                <c:pt idx="936">
                  <c:v>50474.189697265625</c:v>
                </c:pt>
                <c:pt idx="937">
                  <c:v>50883.511962890625</c:v>
                </c:pt>
                <c:pt idx="938">
                  <c:v>51110.20556640625</c:v>
                </c:pt>
                <c:pt idx="939">
                  <c:v>51079.356201171875</c:v>
                </c:pt>
                <c:pt idx="940">
                  <c:v>50748.507080078125</c:v>
                </c:pt>
                <c:pt idx="941">
                  <c:v>50179.2578125</c:v>
                </c:pt>
                <c:pt idx="942">
                  <c:v>49536.665649414063</c:v>
                </c:pt>
                <c:pt idx="943">
                  <c:v>48988.844909667969</c:v>
                </c:pt>
                <c:pt idx="944">
                  <c:v>48623.76708984375</c:v>
                </c:pt>
                <c:pt idx="945">
                  <c:v>48431.632080078125</c:v>
                </c:pt>
                <c:pt idx="946">
                  <c:v>48348.039947509766</c:v>
                </c:pt>
                <c:pt idx="947">
                  <c:v>48314.304962158203</c:v>
                </c:pt>
                <c:pt idx="948">
                  <c:v>48303.912841796875</c:v>
                </c:pt>
                <c:pt idx="949">
                  <c:v>48312.692138671875</c:v>
                </c:pt>
                <c:pt idx="950">
                  <c:v>48336.44287109375</c:v>
                </c:pt>
                <c:pt idx="951">
                  <c:v>48368.850738525391</c:v>
                </c:pt>
                <c:pt idx="952">
                  <c:v>48404.030029296875</c:v>
                </c:pt>
                <c:pt idx="953">
                  <c:v>48445.037902832031</c:v>
                </c:pt>
                <c:pt idx="954">
                  <c:v>48491.388610839844</c:v>
                </c:pt>
                <c:pt idx="955">
                  <c:v>48531.196472167969</c:v>
                </c:pt>
                <c:pt idx="956">
                  <c:v>48553.375793457031</c:v>
                </c:pt>
                <c:pt idx="957">
                  <c:v>48553.726501464844</c:v>
                </c:pt>
                <c:pt idx="958">
                  <c:v>48532.277221679688</c:v>
                </c:pt>
                <c:pt idx="959">
                  <c:v>48489.799407958984</c:v>
                </c:pt>
                <c:pt idx="960">
                  <c:v>48427.092987060547</c:v>
                </c:pt>
                <c:pt idx="961">
                  <c:v>48362.9580078125</c:v>
                </c:pt>
                <c:pt idx="962">
                  <c:v>48315.965881347656</c:v>
                </c:pt>
                <c:pt idx="963">
                  <c:v>48293.402313232422</c:v>
                </c:pt>
                <c:pt idx="964">
                  <c:v>48280.238739013672</c:v>
                </c:pt>
                <c:pt idx="965">
                  <c:v>48274.475189208984</c:v>
                </c:pt>
                <c:pt idx="966">
                  <c:v>48267.940216064453</c:v>
                </c:pt>
                <c:pt idx="967">
                  <c:v>48257.376647949219</c:v>
                </c:pt>
                <c:pt idx="968">
                  <c:v>48250.09880065918</c:v>
                </c:pt>
                <c:pt idx="969">
                  <c:v>48258.420959472656</c:v>
                </c:pt>
                <c:pt idx="970">
                  <c:v>48272.343109130859</c:v>
                </c:pt>
                <c:pt idx="971">
                  <c:v>48273.436706542969</c:v>
                </c:pt>
                <c:pt idx="972">
                  <c:v>48260.958862304688</c:v>
                </c:pt>
                <c:pt idx="973">
                  <c:v>48250.823867797852</c:v>
                </c:pt>
                <c:pt idx="974">
                  <c:v>48244.34602355957</c:v>
                </c:pt>
                <c:pt idx="975">
                  <c:v>48236.382461547852</c:v>
                </c:pt>
                <c:pt idx="976">
                  <c:v>48232.847473144531</c:v>
                </c:pt>
                <c:pt idx="977">
                  <c:v>48243.712493896484</c:v>
                </c:pt>
                <c:pt idx="978">
                  <c:v>48261.091796875</c:v>
                </c:pt>
                <c:pt idx="979">
                  <c:v>48276.842529296875</c:v>
                </c:pt>
                <c:pt idx="980">
                  <c:v>48308.050384521484</c:v>
                </c:pt>
                <c:pt idx="981">
                  <c:v>48385.258270263672</c:v>
                </c:pt>
                <c:pt idx="982">
                  <c:v>48543.808959960938</c:v>
                </c:pt>
                <c:pt idx="983">
                  <c:v>48783.016845703125</c:v>
                </c:pt>
                <c:pt idx="984">
                  <c:v>49049.71044921875</c:v>
                </c:pt>
                <c:pt idx="985">
                  <c:v>49256.061157226563</c:v>
                </c:pt>
                <c:pt idx="986">
                  <c:v>49333.240478515625</c:v>
                </c:pt>
                <c:pt idx="987">
                  <c:v>49260.476928710938</c:v>
                </c:pt>
                <c:pt idx="988">
                  <c:v>49069.570434570313</c:v>
                </c:pt>
                <c:pt idx="989">
                  <c:v>48837.5498046875</c:v>
                </c:pt>
                <c:pt idx="990">
                  <c:v>48637.614807128906</c:v>
                </c:pt>
                <c:pt idx="991">
                  <c:v>48502.451232910156</c:v>
                </c:pt>
                <c:pt idx="992">
                  <c:v>48426.201965332031</c:v>
                </c:pt>
                <c:pt idx="993">
                  <c:v>48392.695556640625</c:v>
                </c:pt>
                <c:pt idx="994">
                  <c:v>48394.874847412109</c:v>
                </c:pt>
                <c:pt idx="995">
                  <c:v>48418.482727050781</c:v>
                </c:pt>
                <c:pt idx="996">
                  <c:v>48449.776306152344</c:v>
                </c:pt>
                <c:pt idx="997">
                  <c:v>48488.698455810547</c:v>
                </c:pt>
                <c:pt idx="998">
                  <c:v>48571.306335449219</c:v>
                </c:pt>
                <c:pt idx="999">
                  <c:v>48751.028503417969</c:v>
                </c:pt>
                <c:pt idx="1000">
                  <c:v>49061.95068359375</c:v>
                </c:pt>
                <c:pt idx="1001">
                  <c:v>49475.529907226563</c:v>
                </c:pt>
                <c:pt idx="1002">
                  <c:v>49898.73779296875</c:v>
                </c:pt>
                <c:pt idx="1003">
                  <c:v>50197.40283203125</c:v>
                </c:pt>
                <c:pt idx="1004">
                  <c:v>50257.039306640625</c:v>
                </c:pt>
                <c:pt idx="1005">
                  <c:v>50055.047119140625</c:v>
                </c:pt>
                <c:pt idx="1006">
                  <c:v>49670.426391601563</c:v>
                </c:pt>
                <c:pt idx="1007">
                  <c:v>49228.977172851563</c:v>
                </c:pt>
                <c:pt idx="1008">
                  <c:v>48841.156494140625</c:v>
                </c:pt>
                <c:pt idx="1009">
                  <c:v>48580.250061035156</c:v>
                </c:pt>
                <c:pt idx="1010">
                  <c:v>48465.686492919922</c:v>
                </c:pt>
                <c:pt idx="1011">
                  <c:v>48456.437225341797</c:v>
                </c:pt>
                <c:pt idx="1012">
                  <c:v>48489.702239990234</c:v>
                </c:pt>
                <c:pt idx="1013">
                  <c:v>48523.567260742188</c:v>
                </c:pt>
                <c:pt idx="1014">
                  <c:v>48536.689392089844</c:v>
                </c:pt>
                <c:pt idx="1015">
                  <c:v>48501.268707275391</c:v>
                </c:pt>
                <c:pt idx="1016">
                  <c:v>48421.847991943359</c:v>
                </c:pt>
                <c:pt idx="1017">
                  <c:v>48346.741577148438</c:v>
                </c:pt>
                <c:pt idx="1018">
                  <c:v>48320.635162353516</c:v>
                </c:pt>
                <c:pt idx="1019">
                  <c:v>48336.328765869141</c:v>
                </c:pt>
                <c:pt idx="1020">
                  <c:v>48366.308044433594</c:v>
                </c:pt>
                <c:pt idx="1021">
                  <c:v>48394.630218505859</c:v>
                </c:pt>
                <c:pt idx="1022">
                  <c:v>48415.666656494141</c:v>
                </c:pt>
                <c:pt idx="1023">
                  <c:v>48414.017364501953</c:v>
                </c:pt>
                <c:pt idx="1024">
                  <c:v>48383.110961914063</c:v>
                </c:pt>
                <c:pt idx="1025">
                  <c:v>48340.575988769531</c:v>
                </c:pt>
                <c:pt idx="1026">
                  <c:v>48317.069549560547</c:v>
                </c:pt>
                <c:pt idx="1027">
                  <c:v>48317.648864746094</c:v>
                </c:pt>
                <c:pt idx="1028">
                  <c:v>48329.085296630859</c:v>
                </c:pt>
                <c:pt idx="1029">
                  <c:v>48349.664611816406</c:v>
                </c:pt>
                <c:pt idx="1030">
                  <c:v>48453.529602050781</c:v>
                </c:pt>
                <c:pt idx="1031">
                  <c:v>48904.251770019531</c:v>
                </c:pt>
                <c:pt idx="1032">
                  <c:v>50383.345458984375</c:v>
                </c:pt>
                <c:pt idx="1033">
                  <c:v>54042.98193359375</c:v>
                </c:pt>
                <c:pt idx="1034">
                  <c:v>61071.0185546875</c:v>
                </c:pt>
                <c:pt idx="1035">
                  <c:v>71602.740234375</c:v>
                </c:pt>
                <c:pt idx="1036">
                  <c:v>83584.60546875</c:v>
                </c:pt>
                <c:pt idx="1037">
                  <c:v>92672.7578125</c:v>
                </c:pt>
                <c:pt idx="1038">
                  <c:v>94357.13671875</c:v>
                </c:pt>
                <c:pt idx="1039">
                  <c:v>87624.23046875</c:v>
                </c:pt>
                <c:pt idx="1040">
                  <c:v>75944.80859375</c:v>
                </c:pt>
                <c:pt idx="1041">
                  <c:v>64395.38671875</c:v>
                </c:pt>
                <c:pt idx="1042">
                  <c:v>56078.052734375</c:v>
                </c:pt>
                <c:pt idx="1043">
                  <c:v>51457.1748046875</c:v>
                </c:pt>
                <c:pt idx="1044">
                  <c:v>49500.411254882813</c:v>
                </c:pt>
                <c:pt idx="1045">
                  <c:v>48964.190490722656</c:v>
                </c:pt>
                <c:pt idx="1046">
                  <c:v>49053.084106445313</c:v>
                </c:pt>
                <c:pt idx="1047">
                  <c:v>49419.40625</c:v>
                </c:pt>
                <c:pt idx="1048">
                  <c:v>49885.785522460938</c:v>
                </c:pt>
                <c:pt idx="1049">
                  <c:v>50277.193359375</c:v>
                </c:pt>
                <c:pt idx="1050">
                  <c:v>50447.829833984375</c:v>
                </c:pt>
                <c:pt idx="1051">
                  <c:v>50324.837646484375</c:v>
                </c:pt>
                <c:pt idx="1052">
                  <c:v>49952.674194335938</c:v>
                </c:pt>
                <c:pt idx="1053">
                  <c:v>49486.396362304688</c:v>
                </c:pt>
                <c:pt idx="1054">
                  <c:v>49110.718505859375</c:v>
                </c:pt>
                <c:pt idx="1055">
                  <c:v>48899.869201660156</c:v>
                </c:pt>
                <c:pt idx="1056">
                  <c:v>48817.077087402344</c:v>
                </c:pt>
                <c:pt idx="1057">
                  <c:v>48794.656372070313</c:v>
                </c:pt>
                <c:pt idx="1058">
                  <c:v>48785.235717773438</c:v>
                </c:pt>
                <c:pt idx="1059">
                  <c:v>48764.757873535156</c:v>
                </c:pt>
                <c:pt idx="1060">
                  <c:v>48737.537170410156</c:v>
                </c:pt>
                <c:pt idx="1061">
                  <c:v>48719.687866210938</c:v>
                </c:pt>
                <c:pt idx="1062">
                  <c:v>48721.667175292969</c:v>
                </c:pt>
                <c:pt idx="1063">
                  <c:v>48726.875061035156</c:v>
                </c:pt>
                <c:pt idx="1064">
                  <c:v>48708.054321289063</c:v>
                </c:pt>
                <c:pt idx="1065">
                  <c:v>48648.119323730469</c:v>
                </c:pt>
                <c:pt idx="1066">
                  <c:v>48549.527221679688</c:v>
                </c:pt>
                <c:pt idx="1067">
                  <c:v>48438.963653564453</c:v>
                </c:pt>
                <c:pt idx="1068">
                  <c:v>48358.228668212891</c:v>
                </c:pt>
                <c:pt idx="1069">
                  <c:v>48324.693695068359</c:v>
                </c:pt>
                <c:pt idx="1070">
                  <c:v>48314.530120849609</c:v>
                </c:pt>
                <c:pt idx="1071">
                  <c:v>48304.052276611328</c:v>
                </c:pt>
                <c:pt idx="1072">
                  <c:v>48286.860168457031</c:v>
                </c:pt>
                <c:pt idx="1073">
                  <c:v>48270.182312011719</c:v>
                </c:pt>
                <c:pt idx="1074">
                  <c:v>48265.475891113281</c:v>
                </c:pt>
                <c:pt idx="1075">
                  <c:v>48265.826629638672</c:v>
                </c:pt>
                <c:pt idx="1076">
                  <c:v>48254.491638183594</c:v>
                </c:pt>
                <c:pt idx="1077">
                  <c:v>48236.013793945313</c:v>
                </c:pt>
                <c:pt idx="1078">
                  <c:v>48220.678802490234</c:v>
                </c:pt>
                <c:pt idx="1079">
                  <c:v>48201.572387695313</c:v>
                </c:pt>
                <c:pt idx="1080">
                  <c:v>48178.237396240234</c:v>
                </c:pt>
                <c:pt idx="1081">
                  <c:v>48163.959564208984</c:v>
                </c:pt>
                <c:pt idx="1082">
                  <c:v>48164.424575805664</c:v>
                </c:pt>
                <c:pt idx="1083">
                  <c:v>48166.203872680664</c:v>
                </c:pt>
                <c:pt idx="1084">
                  <c:v>48163.011734008789</c:v>
                </c:pt>
                <c:pt idx="1085">
                  <c:v>48160.105331420898</c:v>
                </c:pt>
                <c:pt idx="1086">
                  <c:v>48168.913192749023</c:v>
                </c:pt>
                <c:pt idx="1087">
                  <c:v>48189.806777954102</c:v>
                </c:pt>
                <c:pt idx="1088">
                  <c:v>48214.586074829102</c:v>
                </c:pt>
                <c:pt idx="1089">
                  <c:v>48229.136810302734</c:v>
                </c:pt>
                <c:pt idx="1090">
                  <c:v>48227.401824951172</c:v>
                </c:pt>
                <c:pt idx="1091">
                  <c:v>48218.152542114258</c:v>
                </c:pt>
                <c:pt idx="1092">
                  <c:v>48212.76042175293</c:v>
                </c:pt>
                <c:pt idx="1093">
                  <c:v>48206.996856689453</c:v>
                </c:pt>
                <c:pt idx="1094">
                  <c:v>48203.490447998047</c:v>
                </c:pt>
                <c:pt idx="1095">
                  <c:v>48208.212600708008</c:v>
                </c:pt>
                <c:pt idx="1096">
                  <c:v>48216.591903686523</c:v>
                </c:pt>
                <c:pt idx="1097">
                  <c:v>48221.114059448242</c:v>
                </c:pt>
                <c:pt idx="1098">
                  <c:v>48217.807632446289</c:v>
                </c:pt>
                <c:pt idx="1099">
                  <c:v>48212.072647094727</c:v>
                </c:pt>
                <c:pt idx="1100">
                  <c:v>48207.623382568359</c:v>
                </c:pt>
                <c:pt idx="1101">
                  <c:v>48206.174102783203</c:v>
                </c:pt>
                <c:pt idx="1102">
                  <c:v>48201.324829101563</c:v>
                </c:pt>
                <c:pt idx="1103">
                  <c:v>48194.27555847168</c:v>
                </c:pt>
                <c:pt idx="1104">
                  <c:v>48200.854858398438</c:v>
                </c:pt>
                <c:pt idx="1105">
                  <c:v>48219.1484375</c:v>
                </c:pt>
                <c:pt idx="1106">
                  <c:v>48233.156311035156</c:v>
                </c:pt>
                <c:pt idx="1107">
                  <c:v>48234.421325683594</c:v>
                </c:pt>
                <c:pt idx="1108">
                  <c:v>48231.600616455078</c:v>
                </c:pt>
                <c:pt idx="1109">
                  <c:v>48223.579925537109</c:v>
                </c:pt>
                <c:pt idx="1110">
                  <c:v>48204.98779296875</c:v>
                </c:pt>
                <c:pt idx="1111">
                  <c:v>48187.795669555664</c:v>
                </c:pt>
                <c:pt idx="1112">
                  <c:v>48179.203536987305</c:v>
                </c:pt>
                <c:pt idx="1113">
                  <c:v>48168.211395263672</c:v>
                </c:pt>
                <c:pt idx="1114">
                  <c:v>48151.247848510742</c:v>
                </c:pt>
                <c:pt idx="1115">
                  <c:v>48150.8271484375</c:v>
                </c:pt>
                <c:pt idx="1116">
                  <c:v>48170.492156982422</c:v>
                </c:pt>
                <c:pt idx="1117">
                  <c:v>48190.757171630859</c:v>
                </c:pt>
                <c:pt idx="1118">
                  <c:v>48204.679321289063</c:v>
                </c:pt>
                <c:pt idx="1119">
                  <c:v>48216.372909545898</c:v>
                </c:pt>
                <c:pt idx="1120">
                  <c:v>48223.066497802734</c:v>
                </c:pt>
                <c:pt idx="1121">
                  <c:v>48222.474365234375</c:v>
                </c:pt>
                <c:pt idx="1122">
                  <c:v>48230.996520996094</c:v>
                </c:pt>
                <c:pt idx="1123">
                  <c:v>48238.718673706055</c:v>
                </c:pt>
                <c:pt idx="1124">
                  <c:v>48228.640838623047</c:v>
                </c:pt>
                <c:pt idx="1125">
                  <c:v>48203.391555786133</c:v>
                </c:pt>
                <c:pt idx="1126">
                  <c:v>48183.913711547852</c:v>
                </c:pt>
                <c:pt idx="1127">
                  <c:v>48169.893005371094</c:v>
                </c:pt>
                <c:pt idx="1128">
                  <c:v>48154.672317504883</c:v>
                </c:pt>
                <c:pt idx="1129">
                  <c:v>48143.565902709961</c:v>
                </c:pt>
                <c:pt idx="1130">
                  <c:v>48144.14518737793</c:v>
                </c:pt>
                <c:pt idx="1131">
                  <c:v>48151.581634521484</c:v>
                </c:pt>
                <c:pt idx="1132">
                  <c:v>48159.189498901367</c:v>
                </c:pt>
                <c:pt idx="1133">
                  <c:v>48157.540237426758</c:v>
                </c:pt>
                <c:pt idx="1134">
                  <c:v>48154.062393188477</c:v>
                </c:pt>
                <c:pt idx="1135">
                  <c:v>48162.98454284668</c:v>
                </c:pt>
                <c:pt idx="1136">
                  <c:v>48191.878128051758</c:v>
                </c:pt>
                <c:pt idx="1137">
                  <c:v>48230.628860473633</c:v>
                </c:pt>
                <c:pt idx="1138">
                  <c:v>48270.693878173828</c:v>
                </c:pt>
                <c:pt idx="1139">
                  <c:v>48311.987457275391</c:v>
                </c:pt>
                <c:pt idx="1140">
                  <c:v>48345.738189697266</c:v>
                </c:pt>
                <c:pt idx="1141">
                  <c:v>48370.488922119141</c:v>
                </c:pt>
                <c:pt idx="1142">
                  <c:v>48397.925354003906</c:v>
                </c:pt>
                <c:pt idx="1143">
                  <c:v>48433.790374755859</c:v>
                </c:pt>
                <c:pt idx="1144">
                  <c:v>48467.25537109375</c:v>
                </c:pt>
                <c:pt idx="1145">
                  <c:v>48486.577545166016</c:v>
                </c:pt>
                <c:pt idx="1146">
                  <c:v>48481.699676513672</c:v>
                </c:pt>
                <c:pt idx="1147">
                  <c:v>48441.650421142578</c:v>
                </c:pt>
                <c:pt idx="1148">
                  <c:v>48376.629699707031</c:v>
                </c:pt>
                <c:pt idx="1149">
                  <c:v>48313.666168212891</c:v>
                </c:pt>
                <c:pt idx="1150">
                  <c:v>48268.416870117188</c:v>
                </c:pt>
                <c:pt idx="1151">
                  <c:v>48239.253326416016</c:v>
                </c:pt>
                <c:pt idx="1152">
                  <c:v>48223.604049682617</c:v>
                </c:pt>
                <c:pt idx="1153">
                  <c:v>48217.183349609375</c:v>
                </c:pt>
                <c:pt idx="1154">
                  <c:v>48215.962646484375</c:v>
                </c:pt>
                <c:pt idx="1155">
                  <c:v>48214.284805297852</c:v>
                </c:pt>
                <c:pt idx="1156">
                  <c:v>48204.406967163086</c:v>
                </c:pt>
                <c:pt idx="1157">
                  <c:v>48189.443405151367</c:v>
                </c:pt>
                <c:pt idx="1158">
                  <c:v>48183.222702026367</c:v>
                </c:pt>
                <c:pt idx="1159">
                  <c:v>48188.030578613281</c:v>
                </c:pt>
                <c:pt idx="1160">
                  <c:v>48191.409866333008</c:v>
                </c:pt>
                <c:pt idx="1161">
                  <c:v>48187.274887084961</c:v>
                </c:pt>
                <c:pt idx="1162">
                  <c:v>48182.768463134766</c:v>
                </c:pt>
                <c:pt idx="1163">
                  <c:v>48188.062057495117</c:v>
                </c:pt>
                <c:pt idx="1164">
                  <c:v>48213.241348266602</c:v>
                </c:pt>
                <c:pt idx="1165">
                  <c:v>48263.563507080078</c:v>
                </c:pt>
                <c:pt idx="1166">
                  <c:v>48336.142791748047</c:v>
                </c:pt>
                <c:pt idx="1167">
                  <c:v>48431.179260253906</c:v>
                </c:pt>
                <c:pt idx="1168">
                  <c:v>48540.129943847656</c:v>
                </c:pt>
                <c:pt idx="1169">
                  <c:v>48627.56640625</c:v>
                </c:pt>
                <c:pt idx="1170">
                  <c:v>48650.688598632813</c:v>
                </c:pt>
                <c:pt idx="1171">
                  <c:v>48604.153564453125</c:v>
                </c:pt>
                <c:pt idx="1172">
                  <c:v>48516.647155761719</c:v>
                </c:pt>
                <c:pt idx="1173">
                  <c:v>48418.055053710938</c:v>
                </c:pt>
                <c:pt idx="1174">
                  <c:v>48331.891479492188</c:v>
                </c:pt>
                <c:pt idx="1175">
                  <c:v>48272.585052490234</c:v>
                </c:pt>
                <c:pt idx="1176">
                  <c:v>48242.021499633789</c:v>
                </c:pt>
                <c:pt idx="1177">
                  <c:v>48229.00080871582</c:v>
                </c:pt>
                <c:pt idx="1178">
                  <c:v>48225.637252807617</c:v>
                </c:pt>
                <c:pt idx="1179">
                  <c:v>48219.273681640625</c:v>
                </c:pt>
                <c:pt idx="1180">
                  <c:v>48211.081558227539</c:v>
                </c:pt>
                <c:pt idx="1181">
                  <c:v>48220.575149536133</c:v>
                </c:pt>
                <c:pt idx="1182">
                  <c:v>48244.668731689453</c:v>
                </c:pt>
                <c:pt idx="1183">
                  <c:v>48255.019454956055</c:v>
                </c:pt>
                <c:pt idx="1184">
                  <c:v>48240.39875793457</c:v>
                </c:pt>
                <c:pt idx="1185">
                  <c:v>48223.892333984375</c:v>
                </c:pt>
                <c:pt idx="1186">
                  <c:v>48213.414489746094</c:v>
                </c:pt>
                <c:pt idx="1187">
                  <c:v>48201.336654663086</c:v>
                </c:pt>
                <c:pt idx="1188">
                  <c:v>48190.373092651367</c:v>
                </c:pt>
                <c:pt idx="1189">
                  <c:v>48184.695251464844</c:v>
                </c:pt>
                <c:pt idx="1190">
                  <c:v>48181.645980834961</c:v>
                </c:pt>
                <c:pt idx="1191">
                  <c:v>48173.396697998047</c:v>
                </c:pt>
                <c:pt idx="1192">
                  <c:v>48162.833145141602</c:v>
                </c:pt>
                <c:pt idx="1193">
                  <c:v>48160.098159790039</c:v>
                </c:pt>
                <c:pt idx="1194">
                  <c:v>48165.220306396484</c:v>
                </c:pt>
                <c:pt idx="1195">
                  <c:v>48171.056747436523</c:v>
                </c:pt>
                <c:pt idx="1196">
                  <c:v>48166.864624023438</c:v>
                </c:pt>
                <c:pt idx="1197">
                  <c:v>48149.672500610352</c:v>
                </c:pt>
                <c:pt idx="1198">
                  <c:v>48123.080360412598</c:v>
                </c:pt>
                <c:pt idx="1199">
                  <c:v>48104.973945617676</c:v>
                </c:pt>
                <c:pt idx="1200">
                  <c:v>48108.067535400391</c:v>
                </c:pt>
                <c:pt idx="1201">
                  <c:v>48135.446838378906</c:v>
                </c:pt>
                <c:pt idx="1202">
                  <c:v>48169.283279418945</c:v>
                </c:pt>
                <c:pt idx="1203">
                  <c:v>48184.434005737305</c:v>
                </c:pt>
                <c:pt idx="1204">
                  <c:v>48173.527587890625</c:v>
                </c:pt>
                <c:pt idx="1205">
                  <c:v>48155.392593383789</c:v>
                </c:pt>
                <c:pt idx="1206">
                  <c:v>48147.657608032227</c:v>
                </c:pt>
                <c:pt idx="1207">
                  <c:v>48155.894058227539</c:v>
                </c:pt>
                <c:pt idx="1208">
                  <c:v>48175.987640380859</c:v>
                </c:pt>
                <c:pt idx="1209">
                  <c:v>48188.509796142578</c:v>
                </c:pt>
                <c:pt idx="1210">
                  <c:v>48180.431945800781</c:v>
                </c:pt>
                <c:pt idx="1211">
                  <c:v>48164.839813232422</c:v>
                </c:pt>
                <c:pt idx="1212">
                  <c:v>48162.076263427734</c:v>
                </c:pt>
                <c:pt idx="1213">
                  <c:v>48174.712707519531</c:v>
                </c:pt>
                <c:pt idx="1214">
                  <c:v>48192.320571899414</c:v>
                </c:pt>
                <c:pt idx="1215">
                  <c:v>48200.842727661133</c:v>
                </c:pt>
                <c:pt idx="1216">
                  <c:v>48199.47917175293</c:v>
                </c:pt>
                <c:pt idx="1217">
                  <c:v>48190.744186401367</c:v>
                </c:pt>
                <c:pt idx="1218">
                  <c:v>48176.409194946289</c:v>
                </c:pt>
                <c:pt idx="1219">
                  <c:v>48156.13134765625</c:v>
                </c:pt>
                <c:pt idx="1220">
                  <c:v>48139.91064453125</c:v>
                </c:pt>
                <c:pt idx="1221">
                  <c:v>48133.032806396484</c:v>
                </c:pt>
                <c:pt idx="1222">
                  <c:v>48134.754959106445</c:v>
                </c:pt>
                <c:pt idx="1223">
                  <c:v>48140.134262084961</c:v>
                </c:pt>
                <c:pt idx="1224">
                  <c:v>48148.713562011719</c:v>
                </c:pt>
                <c:pt idx="1225">
                  <c:v>48151.350006103516</c:v>
                </c:pt>
                <c:pt idx="1226">
                  <c:v>48145.786437988281</c:v>
                </c:pt>
                <c:pt idx="1227">
                  <c:v>48138.251449584961</c:v>
                </c:pt>
                <c:pt idx="1228">
                  <c:v>48136.345031738281</c:v>
                </c:pt>
                <c:pt idx="1229">
                  <c:v>48135.8671875</c:v>
                </c:pt>
                <c:pt idx="1230">
                  <c:v>48135.246490478516</c:v>
                </c:pt>
                <c:pt idx="1231">
                  <c:v>48141.68293762207</c:v>
                </c:pt>
                <c:pt idx="1232">
                  <c:v>48156.405090332031</c:v>
                </c:pt>
                <c:pt idx="1233">
                  <c:v>48174.098678588867</c:v>
                </c:pt>
                <c:pt idx="1234">
                  <c:v>48186.735122680664</c:v>
                </c:pt>
                <c:pt idx="1235">
                  <c:v>48194.057266235352</c:v>
                </c:pt>
                <c:pt idx="1236">
                  <c:v>48198.122283935547</c:v>
                </c:pt>
                <c:pt idx="1237">
                  <c:v>48200.701583862305</c:v>
                </c:pt>
                <c:pt idx="1238">
                  <c:v>48201.823745727539</c:v>
                </c:pt>
                <c:pt idx="1239">
                  <c:v>48205.603042602539</c:v>
                </c:pt>
                <c:pt idx="1240">
                  <c:v>48210.296630859375</c:v>
                </c:pt>
                <c:pt idx="1241">
                  <c:v>48208.361633300781</c:v>
                </c:pt>
                <c:pt idx="1242">
                  <c:v>48208.969512939453</c:v>
                </c:pt>
                <c:pt idx="1243">
                  <c:v>48224.291656494141</c:v>
                </c:pt>
                <c:pt idx="1244">
                  <c:v>48247.07096862793</c:v>
                </c:pt>
                <c:pt idx="1245">
                  <c:v>48252.707397460938</c:v>
                </c:pt>
                <c:pt idx="1246">
                  <c:v>48248.115280151367</c:v>
                </c:pt>
                <c:pt idx="1247">
                  <c:v>48246.380279541016</c:v>
                </c:pt>
                <c:pt idx="1248">
                  <c:v>48244.245300292969</c:v>
                </c:pt>
                <c:pt idx="1249">
                  <c:v>48235.338882446289</c:v>
                </c:pt>
                <c:pt idx="1250">
                  <c:v>48225.889617919922</c:v>
                </c:pt>
                <c:pt idx="1251">
                  <c:v>48225.754623413086</c:v>
                </c:pt>
                <c:pt idx="1252">
                  <c:v>48229.848205566406</c:v>
                </c:pt>
                <c:pt idx="1253">
                  <c:v>48233.113220214844</c:v>
                </c:pt>
                <c:pt idx="1254">
                  <c:v>48226.606811523438</c:v>
                </c:pt>
                <c:pt idx="1255">
                  <c:v>48218.900390625</c:v>
                </c:pt>
                <c:pt idx="1256">
                  <c:v>48214.708267211914</c:v>
                </c:pt>
                <c:pt idx="1257">
                  <c:v>48211.316131591797</c:v>
                </c:pt>
                <c:pt idx="1258">
                  <c:v>48205.038284301758</c:v>
                </c:pt>
                <c:pt idx="1259">
                  <c:v>48203.731872558594</c:v>
                </c:pt>
                <c:pt idx="1260">
                  <c:v>48205.911163330078</c:v>
                </c:pt>
                <c:pt idx="1261">
                  <c:v>48203.776184082031</c:v>
                </c:pt>
                <c:pt idx="1262">
                  <c:v>48198.698333740234</c:v>
                </c:pt>
                <c:pt idx="1263">
                  <c:v>48193.07763671875</c:v>
                </c:pt>
                <c:pt idx="1264">
                  <c:v>48193.342651367188</c:v>
                </c:pt>
                <c:pt idx="1265">
                  <c:v>48195.093383789063</c:v>
                </c:pt>
                <c:pt idx="1266">
                  <c:v>48198.701248168945</c:v>
                </c:pt>
                <c:pt idx="1267">
                  <c:v>48202.309112548828</c:v>
                </c:pt>
                <c:pt idx="1268">
                  <c:v>48208.059844970703</c:v>
                </c:pt>
                <c:pt idx="1269">
                  <c:v>48216.182006835938</c:v>
                </c:pt>
                <c:pt idx="1270">
                  <c:v>48227.732727050781</c:v>
                </c:pt>
                <c:pt idx="1271">
                  <c:v>48240.197738647461</c:v>
                </c:pt>
                <c:pt idx="1272">
                  <c:v>48244.405609130859</c:v>
                </c:pt>
                <c:pt idx="1273">
                  <c:v>48239.756332397461</c:v>
                </c:pt>
                <c:pt idx="1274">
                  <c:v>48231.764205932617</c:v>
                </c:pt>
                <c:pt idx="1275">
                  <c:v>48225.114929199219</c:v>
                </c:pt>
                <c:pt idx="1276">
                  <c:v>48224.494232177734</c:v>
                </c:pt>
                <c:pt idx="1277">
                  <c:v>48223.959243774414</c:v>
                </c:pt>
                <c:pt idx="1278">
                  <c:v>48222.795684814453</c:v>
                </c:pt>
                <c:pt idx="1279">
                  <c:v>48220.203552246094</c:v>
                </c:pt>
                <c:pt idx="1280">
                  <c:v>48216.697143554688</c:v>
                </c:pt>
                <c:pt idx="1281">
                  <c:v>48214.419296264648</c:v>
                </c:pt>
                <c:pt idx="1282">
                  <c:v>48219.255737304688</c:v>
                </c:pt>
                <c:pt idx="1283">
                  <c:v>48222.749328613281</c:v>
                </c:pt>
                <c:pt idx="1284">
                  <c:v>48223.642913818359</c:v>
                </c:pt>
                <c:pt idx="1285">
                  <c:v>48230.707916259766</c:v>
                </c:pt>
                <c:pt idx="1286">
                  <c:v>48244.601501464844</c:v>
                </c:pt>
                <c:pt idx="1287">
                  <c:v>48251.466522216797</c:v>
                </c:pt>
                <c:pt idx="1288">
                  <c:v>48251.674392700195</c:v>
                </c:pt>
                <c:pt idx="1289">
                  <c:v>48252.453689575195</c:v>
                </c:pt>
                <c:pt idx="1290">
                  <c:v>48251.20442199707</c:v>
                </c:pt>
                <c:pt idx="1291">
                  <c:v>48244.383712768555</c:v>
                </c:pt>
                <c:pt idx="1292">
                  <c:v>48229.477294921875</c:v>
                </c:pt>
                <c:pt idx="1293">
                  <c:v>48217.599456787109</c:v>
                </c:pt>
                <c:pt idx="1294">
                  <c:v>48217.835891723633</c:v>
                </c:pt>
                <c:pt idx="1295">
                  <c:v>48229.843765258789</c:v>
                </c:pt>
                <c:pt idx="1296">
                  <c:v>48245.451629638672</c:v>
                </c:pt>
                <c:pt idx="1297">
                  <c:v>48254.916656494141</c:v>
                </c:pt>
                <c:pt idx="1298">
                  <c:v>48262.753082275391</c:v>
                </c:pt>
                <c:pt idx="1299">
                  <c:v>48270.760955810547</c:v>
                </c:pt>
                <c:pt idx="1300">
                  <c:v>48279.425964355469</c:v>
                </c:pt>
                <c:pt idx="1301">
                  <c:v>48279.433837890625</c:v>
                </c:pt>
                <c:pt idx="1302">
                  <c:v>48273.727416992188</c:v>
                </c:pt>
                <c:pt idx="1303">
                  <c:v>48274.049591064453</c:v>
                </c:pt>
                <c:pt idx="1304">
                  <c:v>48279.314605712891</c:v>
                </c:pt>
                <c:pt idx="1305">
                  <c:v>48286.036743164063</c:v>
                </c:pt>
                <c:pt idx="1306">
                  <c:v>48294.958923339844</c:v>
                </c:pt>
                <c:pt idx="1307">
                  <c:v>48307.366790771484</c:v>
                </c:pt>
                <c:pt idx="1308">
                  <c:v>48320.660369873047</c:v>
                </c:pt>
                <c:pt idx="1309">
                  <c:v>48336.382507324219</c:v>
                </c:pt>
                <c:pt idx="1310">
                  <c:v>48355.104675292969</c:v>
                </c:pt>
                <c:pt idx="1311">
                  <c:v>48370.226837158203</c:v>
                </c:pt>
                <c:pt idx="1312">
                  <c:v>48383.291839599609</c:v>
                </c:pt>
                <c:pt idx="1313">
                  <c:v>48389.071136474609</c:v>
                </c:pt>
                <c:pt idx="1314">
                  <c:v>48384.450439453125</c:v>
                </c:pt>
                <c:pt idx="1315">
                  <c:v>48374.029754638672</c:v>
                </c:pt>
                <c:pt idx="1316">
                  <c:v>48372.666168212891</c:v>
                </c:pt>
                <c:pt idx="1317">
                  <c:v>48375.302612304688</c:v>
                </c:pt>
                <c:pt idx="1318">
                  <c:v>48375.139068603516</c:v>
                </c:pt>
                <c:pt idx="1319">
                  <c:v>48372.175506591797</c:v>
                </c:pt>
                <c:pt idx="1320">
                  <c:v>48370.783386230469</c:v>
                </c:pt>
                <c:pt idx="1321">
                  <c:v>48370.419830322266</c:v>
                </c:pt>
                <c:pt idx="1322">
                  <c:v>48371.741973876953</c:v>
                </c:pt>
                <c:pt idx="1323">
                  <c:v>48384.321258544922</c:v>
                </c:pt>
                <c:pt idx="1324">
                  <c:v>48411.129150390625</c:v>
                </c:pt>
                <c:pt idx="1325">
                  <c:v>48441.051300048828</c:v>
                </c:pt>
                <c:pt idx="1326">
                  <c:v>48459.859161376953</c:v>
                </c:pt>
                <c:pt idx="1327">
                  <c:v>48472.381317138672</c:v>
                </c:pt>
                <c:pt idx="1328">
                  <c:v>48486.017761230469</c:v>
                </c:pt>
                <c:pt idx="1329">
                  <c:v>48501.768493652344</c:v>
                </c:pt>
                <c:pt idx="1330">
                  <c:v>48515.062072753906</c:v>
                </c:pt>
                <c:pt idx="1331">
                  <c:v>48531.727111816406</c:v>
                </c:pt>
                <c:pt idx="1332">
                  <c:v>48550.3349609375</c:v>
                </c:pt>
                <c:pt idx="1333">
                  <c:v>48567.771423339844</c:v>
                </c:pt>
                <c:pt idx="1334">
                  <c:v>48581.150695800781</c:v>
                </c:pt>
                <c:pt idx="1335">
                  <c:v>48592.987121582031</c:v>
                </c:pt>
                <c:pt idx="1336">
                  <c:v>48598.766418457031</c:v>
                </c:pt>
                <c:pt idx="1337">
                  <c:v>48594.831481933594</c:v>
                </c:pt>
                <c:pt idx="1338">
                  <c:v>48587.639343261719</c:v>
                </c:pt>
                <c:pt idx="1339">
                  <c:v>48580.961486816406</c:v>
                </c:pt>
                <c:pt idx="1340">
                  <c:v>48573.026489257813</c:v>
                </c:pt>
                <c:pt idx="1341">
                  <c:v>48564.691528320313</c:v>
                </c:pt>
                <c:pt idx="1342">
                  <c:v>48569.785095214844</c:v>
                </c:pt>
                <c:pt idx="1343">
                  <c:v>48591.135803222656</c:v>
                </c:pt>
                <c:pt idx="1344">
                  <c:v>48616.6865234375</c:v>
                </c:pt>
                <c:pt idx="1345">
                  <c:v>48628.437255859375</c:v>
                </c:pt>
                <c:pt idx="1346">
                  <c:v>48630.730834960938</c:v>
                </c:pt>
                <c:pt idx="1347">
                  <c:v>48636.510131835938</c:v>
                </c:pt>
                <c:pt idx="1348">
                  <c:v>48652.089477539063</c:v>
                </c:pt>
                <c:pt idx="1349">
                  <c:v>48679.125915527344</c:v>
                </c:pt>
                <c:pt idx="1350">
                  <c:v>48708.962341308594</c:v>
                </c:pt>
                <c:pt idx="1351">
                  <c:v>48726.513061523438</c:v>
                </c:pt>
                <c:pt idx="1352">
                  <c:v>48725.149536132813</c:v>
                </c:pt>
                <c:pt idx="1353">
                  <c:v>48722.871643066406</c:v>
                </c:pt>
                <c:pt idx="1354">
                  <c:v>48733.593811035156</c:v>
                </c:pt>
                <c:pt idx="1355">
                  <c:v>48758.173095703125</c:v>
                </c:pt>
                <c:pt idx="1356">
                  <c:v>48788.666687011719</c:v>
                </c:pt>
                <c:pt idx="1357">
                  <c:v>48821.445983886719</c:v>
                </c:pt>
                <c:pt idx="1358">
                  <c:v>48861.539611816406</c:v>
                </c:pt>
                <c:pt idx="1359">
                  <c:v>48902.033142089844</c:v>
                </c:pt>
                <c:pt idx="1360">
                  <c:v>48935.612487792969</c:v>
                </c:pt>
                <c:pt idx="1361">
                  <c:v>48957.077453613281</c:v>
                </c:pt>
                <c:pt idx="1362">
                  <c:v>48964.999633789063</c:v>
                </c:pt>
                <c:pt idx="1363">
                  <c:v>48959.893249511719</c:v>
                </c:pt>
                <c:pt idx="1364">
                  <c:v>48954.901062011719</c:v>
                </c:pt>
                <c:pt idx="1365">
                  <c:v>48958.623229980469</c:v>
                </c:pt>
                <c:pt idx="1366">
                  <c:v>48953.745422363281</c:v>
                </c:pt>
                <c:pt idx="1367">
                  <c:v>48937.039001464844</c:v>
                </c:pt>
                <c:pt idx="1368">
                  <c:v>48924.046875</c:v>
                </c:pt>
                <c:pt idx="1369">
                  <c:v>48921.99755859375</c:v>
                </c:pt>
                <c:pt idx="1370">
                  <c:v>48920.948303222656</c:v>
                </c:pt>
                <c:pt idx="1371">
                  <c:v>48912.213317871094</c:v>
                </c:pt>
                <c:pt idx="1372">
                  <c:v>48902.506896972656</c:v>
                </c:pt>
                <c:pt idx="1373">
                  <c:v>48887.286193847656</c:v>
                </c:pt>
                <c:pt idx="1374">
                  <c:v>48865.694091796875</c:v>
                </c:pt>
                <c:pt idx="1375">
                  <c:v>48845.387634277344</c:v>
                </c:pt>
                <c:pt idx="1376">
                  <c:v>48836.366943359375</c:v>
                </c:pt>
                <c:pt idx="1377">
                  <c:v>48831.089111328125</c:v>
                </c:pt>
                <c:pt idx="1378">
                  <c:v>48826.754150390625</c:v>
                </c:pt>
                <c:pt idx="1379">
                  <c:v>48826.390563964844</c:v>
                </c:pt>
                <c:pt idx="1380">
                  <c:v>48827.512756347656</c:v>
                </c:pt>
                <c:pt idx="1381">
                  <c:v>48819.434875488281</c:v>
                </c:pt>
                <c:pt idx="1382">
                  <c:v>48800.671325683594</c:v>
                </c:pt>
                <c:pt idx="1383">
                  <c:v>48777.336364746094</c:v>
                </c:pt>
                <c:pt idx="1384">
                  <c:v>48758.487060546875</c:v>
                </c:pt>
                <c:pt idx="1385">
                  <c:v>48747.209228515625</c:v>
                </c:pt>
                <c:pt idx="1386">
                  <c:v>48743.988525390625</c:v>
                </c:pt>
                <c:pt idx="1387">
                  <c:v>48740.424987792969</c:v>
                </c:pt>
                <c:pt idx="1388">
                  <c:v>48726.289978027344</c:v>
                </c:pt>
                <c:pt idx="1389">
                  <c:v>48707.35498046875</c:v>
                </c:pt>
                <c:pt idx="1390">
                  <c:v>48708.991455078125</c:v>
                </c:pt>
                <c:pt idx="1391">
                  <c:v>48723.484985351563</c:v>
                </c:pt>
                <c:pt idx="1392">
                  <c:v>48724.778625488281</c:v>
                </c:pt>
                <c:pt idx="1393">
                  <c:v>48708.47216796875</c:v>
                </c:pt>
                <c:pt idx="1394">
                  <c:v>48689.537170410156</c:v>
                </c:pt>
                <c:pt idx="1395">
                  <c:v>48673.602233886719</c:v>
                </c:pt>
                <c:pt idx="1396">
                  <c:v>48662.038635253906</c:v>
                </c:pt>
                <c:pt idx="1397">
                  <c:v>48658.103637695313</c:v>
                </c:pt>
                <c:pt idx="1398">
                  <c:v>48657.025817871094</c:v>
                </c:pt>
                <c:pt idx="1399">
                  <c:v>48653.719421386719</c:v>
                </c:pt>
                <c:pt idx="1400">
                  <c:v>48643.155822753906</c:v>
                </c:pt>
                <c:pt idx="1401">
                  <c:v>48633.335144042969</c:v>
                </c:pt>
                <c:pt idx="1402">
                  <c:v>48628.200134277344</c:v>
                </c:pt>
                <c:pt idx="1403">
                  <c:v>48625.636596679688</c:v>
                </c:pt>
                <c:pt idx="1404">
                  <c:v>48623.015869140625</c:v>
                </c:pt>
                <c:pt idx="1405">
                  <c:v>48619.280883789063</c:v>
                </c:pt>
                <c:pt idx="1406">
                  <c:v>48608.060180664063</c:v>
                </c:pt>
                <c:pt idx="1407">
                  <c:v>48596.725219726563</c:v>
                </c:pt>
                <c:pt idx="1408">
                  <c:v>48606.361633300781</c:v>
                </c:pt>
                <c:pt idx="1409">
                  <c:v>48634.026672363281</c:v>
                </c:pt>
                <c:pt idx="1410">
                  <c:v>48651.834533691406</c:v>
                </c:pt>
                <c:pt idx="1411">
                  <c:v>48644.38525390625</c:v>
                </c:pt>
                <c:pt idx="1412">
                  <c:v>48627.621704101563</c:v>
                </c:pt>
                <c:pt idx="1413">
                  <c:v>48617.001037597656</c:v>
                </c:pt>
                <c:pt idx="1414">
                  <c:v>48607.60888671875</c:v>
                </c:pt>
                <c:pt idx="1415">
                  <c:v>48598.645324707031</c:v>
                </c:pt>
                <c:pt idx="1416">
                  <c:v>48600.910339355469</c:v>
                </c:pt>
                <c:pt idx="1417">
                  <c:v>48610.489624023438</c:v>
                </c:pt>
                <c:pt idx="1418">
                  <c:v>48612.097534179688</c:v>
                </c:pt>
                <c:pt idx="1419">
                  <c:v>48600.276794433594</c:v>
                </c:pt>
                <c:pt idx="1420">
                  <c:v>48586.570373535156</c:v>
                </c:pt>
                <c:pt idx="1421">
                  <c:v>48579.606811523438</c:v>
                </c:pt>
                <c:pt idx="1422">
                  <c:v>48584.7861328125</c:v>
                </c:pt>
                <c:pt idx="1423">
                  <c:v>48594.336853027344</c:v>
                </c:pt>
                <c:pt idx="1424">
                  <c:v>48608.259033203125</c:v>
                </c:pt>
                <c:pt idx="1425">
                  <c:v>48629.781188964844</c:v>
                </c:pt>
                <c:pt idx="1426">
                  <c:v>48648.303344726563</c:v>
                </c:pt>
                <c:pt idx="1427">
                  <c:v>48648.454040527344</c:v>
                </c:pt>
                <c:pt idx="1428">
                  <c:v>48640.804809570313</c:v>
                </c:pt>
                <c:pt idx="1429">
                  <c:v>48644.555480957031</c:v>
                </c:pt>
                <c:pt idx="1430">
                  <c:v>48644.96337890625</c:v>
                </c:pt>
                <c:pt idx="1431">
                  <c:v>48621.285522460938</c:v>
                </c:pt>
                <c:pt idx="1432">
                  <c:v>48586.207702636719</c:v>
                </c:pt>
                <c:pt idx="1433">
                  <c:v>48567.3583984375</c:v>
                </c:pt>
                <c:pt idx="1434">
                  <c:v>48563.766296386719</c:v>
                </c:pt>
                <c:pt idx="1435">
                  <c:v>48561.574157714844</c:v>
                </c:pt>
                <c:pt idx="1436">
                  <c:v>48555.610595703125</c:v>
                </c:pt>
                <c:pt idx="1437">
                  <c:v>48549.275634765625</c:v>
                </c:pt>
                <c:pt idx="1438">
                  <c:v>48538.654907226563</c:v>
                </c:pt>
                <c:pt idx="1439">
                  <c:v>48521.462768554688</c:v>
                </c:pt>
                <c:pt idx="1440">
                  <c:v>48503.156372070313</c:v>
                </c:pt>
                <c:pt idx="1441">
                  <c:v>48490.821380615234</c:v>
                </c:pt>
                <c:pt idx="1442">
                  <c:v>48481.114959716797</c:v>
                </c:pt>
                <c:pt idx="1443">
                  <c:v>48469.894256591797</c:v>
                </c:pt>
                <c:pt idx="1444">
                  <c:v>48465.330688476563</c:v>
                </c:pt>
                <c:pt idx="1445">
                  <c:v>48473.224273681641</c:v>
                </c:pt>
                <c:pt idx="1446">
                  <c:v>48492.203582763672</c:v>
                </c:pt>
                <c:pt idx="1447">
                  <c:v>48516.525756835938</c:v>
                </c:pt>
                <c:pt idx="1448">
                  <c:v>48551.533630371094</c:v>
                </c:pt>
                <c:pt idx="1449">
                  <c:v>48589.827209472656</c:v>
                </c:pt>
                <c:pt idx="1450">
                  <c:v>48619.692199707031</c:v>
                </c:pt>
                <c:pt idx="1451">
                  <c:v>48641.500061035156</c:v>
                </c:pt>
                <c:pt idx="1452">
                  <c:v>48661.022216796875</c:v>
                </c:pt>
                <c:pt idx="1453">
                  <c:v>48681.65869140625</c:v>
                </c:pt>
                <c:pt idx="1454">
                  <c:v>48696.923706054688</c:v>
                </c:pt>
                <c:pt idx="1455">
                  <c:v>48702.760131835938</c:v>
                </c:pt>
                <c:pt idx="1456">
                  <c:v>48691.625122070313</c:v>
                </c:pt>
                <c:pt idx="1457">
                  <c:v>48666.375854492188</c:v>
                </c:pt>
                <c:pt idx="1458">
                  <c:v>48638.126586914063</c:v>
                </c:pt>
                <c:pt idx="1459">
                  <c:v>48609.33447265625</c:v>
                </c:pt>
                <c:pt idx="1460">
                  <c:v>48585.742309570313</c:v>
                </c:pt>
                <c:pt idx="1461">
                  <c:v>48569.435913085938</c:v>
                </c:pt>
                <c:pt idx="1462">
                  <c:v>48558.643798828125</c:v>
                </c:pt>
                <c:pt idx="1463">
                  <c:v>48544.280212402344</c:v>
                </c:pt>
                <c:pt idx="1464">
                  <c:v>48531.516662597656</c:v>
                </c:pt>
                <c:pt idx="1465">
                  <c:v>48524.610229492188</c:v>
                </c:pt>
                <c:pt idx="1466">
                  <c:v>48517.418151855469</c:v>
                </c:pt>
                <c:pt idx="1467">
                  <c:v>48515.197448730469</c:v>
                </c:pt>
                <c:pt idx="1468">
                  <c:v>48522.776733398438</c:v>
                </c:pt>
                <c:pt idx="1469">
                  <c:v>48536.156005859375</c:v>
                </c:pt>
                <c:pt idx="1470">
                  <c:v>48548.992492675781</c:v>
                </c:pt>
                <c:pt idx="1471">
                  <c:v>48564.428894042969</c:v>
                </c:pt>
                <c:pt idx="1472">
                  <c:v>48578.779663085938</c:v>
                </c:pt>
                <c:pt idx="1473">
                  <c:v>48585.101806640625</c:v>
                </c:pt>
                <c:pt idx="1474">
                  <c:v>48591.02392578125</c:v>
                </c:pt>
                <c:pt idx="1475">
                  <c:v>48609.317504882813</c:v>
                </c:pt>
                <c:pt idx="1476">
                  <c:v>48634.239685058594</c:v>
                </c:pt>
                <c:pt idx="1477">
                  <c:v>48649.818969726563</c:v>
                </c:pt>
                <c:pt idx="1478">
                  <c:v>48655.055419921875</c:v>
                </c:pt>
                <c:pt idx="1479">
                  <c:v>48667.920471191406</c:v>
                </c:pt>
                <c:pt idx="1480">
                  <c:v>48690.671142578125</c:v>
                </c:pt>
                <c:pt idx="1481">
                  <c:v>48713.707580566406</c:v>
                </c:pt>
                <c:pt idx="1482">
                  <c:v>48729.715454101563</c:v>
                </c:pt>
                <c:pt idx="1483">
                  <c:v>48743.666198730469</c:v>
                </c:pt>
                <c:pt idx="1484">
                  <c:v>48764.474060058594</c:v>
                </c:pt>
                <c:pt idx="1485">
                  <c:v>48792.081970214844</c:v>
                </c:pt>
                <c:pt idx="1486">
                  <c:v>48812.375549316406</c:v>
                </c:pt>
                <c:pt idx="1487">
                  <c:v>48813.669128417969</c:v>
                </c:pt>
                <c:pt idx="1488">
                  <c:v>48806.162719726563</c:v>
                </c:pt>
                <c:pt idx="1489">
                  <c:v>48811.5419921875</c:v>
                </c:pt>
                <c:pt idx="1490">
                  <c:v>48832.921325683594</c:v>
                </c:pt>
                <c:pt idx="1491">
                  <c:v>48861.186340332031</c:v>
                </c:pt>
                <c:pt idx="1492">
                  <c:v>48882.679870605469</c:v>
                </c:pt>
                <c:pt idx="1493">
                  <c:v>48899.802062988281</c:v>
                </c:pt>
                <c:pt idx="1494">
                  <c:v>48918.581359863281</c:v>
                </c:pt>
                <c:pt idx="1495">
                  <c:v>48933.989196777344</c:v>
                </c:pt>
                <c:pt idx="1496">
                  <c:v>48938.739929199219</c:v>
                </c:pt>
                <c:pt idx="1497">
                  <c:v>48939.919250488281</c:v>
                </c:pt>
                <c:pt idx="1498">
                  <c:v>48952.212829589844</c:v>
                </c:pt>
                <c:pt idx="1499">
                  <c:v>48978.563537597656</c:v>
                </c:pt>
                <c:pt idx="1500">
                  <c:v>49006.142883300781</c:v>
                </c:pt>
                <c:pt idx="1501">
                  <c:v>49024.579345703125</c:v>
                </c:pt>
                <c:pt idx="1502">
                  <c:v>49037.930053710938</c:v>
                </c:pt>
                <c:pt idx="1503">
                  <c:v>49059.28076171875</c:v>
                </c:pt>
                <c:pt idx="1504">
                  <c:v>49079.774291992188</c:v>
                </c:pt>
                <c:pt idx="1505">
                  <c:v>49094.95361328125</c:v>
                </c:pt>
                <c:pt idx="1506">
                  <c:v>49112.304321289063</c:v>
                </c:pt>
                <c:pt idx="1507">
                  <c:v>49140.597900390625</c:v>
                </c:pt>
                <c:pt idx="1508">
                  <c:v>49170.034423828125</c:v>
                </c:pt>
                <c:pt idx="1509">
                  <c:v>49195.270874023438</c:v>
                </c:pt>
                <c:pt idx="1510">
                  <c:v>49214.450073242188</c:v>
                </c:pt>
                <c:pt idx="1511">
                  <c:v>49226.143676757813</c:v>
                </c:pt>
                <c:pt idx="1512">
                  <c:v>49229.29443359375</c:v>
                </c:pt>
                <c:pt idx="1513">
                  <c:v>49231.416625976563</c:v>
                </c:pt>
                <c:pt idx="1514">
                  <c:v>49239.424438476563</c:v>
                </c:pt>
                <c:pt idx="1515">
                  <c:v>49259.718017578125</c:v>
                </c:pt>
                <c:pt idx="1516">
                  <c:v>49294.668823242188</c:v>
                </c:pt>
                <c:pt idx="1517">
                  <c:v>49335.619506835938</c:v>
                </c:pt>
                <c:pt idx="1518">
                  <c:v>49382.656005859375</c:v>
                </c:pt>
                <c:pt idx="1519">
                  <c:v>49460.378051757813</c:v>
                </c:pt>
                <c:pt idx="1520">
                  <c:v>49588.5859375</c:v>
                </c:pt>
                <c:pt idx="1521">
                  <c:v>49744.593872070313</c:v>
                </c:pt>
                <c:pt idx="1522">
                  <c:v>49885.401733398438</c:v>
                </c:pt>
                <c:pt idx="1523">
                  <c:v>49982.838134765625</c:v>
                </c:pt>
                <c:pt idx="1524">
                  <c:v>50025.703125</c:v>
                </c:pt>
                <c:pt idx="1525">
                  <c:v>50012.911010742188</c:v>
                </c:pt>
                <c:pt idx="1526">
                  <c:v>49944.86181640625</c:v>
                </c:pt>
                <c:pt idx="1527">
                  <c:v>49841.555297851563</c:v>
                </c:pt>
                <c:pt idx="1528">
                  <c:v>49736.391845703125</c:v>
                </c:pt>
                <c:pt idx="1529">
                  <c:v>49649.085327148438</c:v>
                </c:pt>
                <c:pt idx="1530">
                  <c:v>49573.893188476563</c:v>
                </c:pt>
                <c:pt idx="1531">
                  <c:v>49514.672485351563</c:v>
                </c:pt>
                <c:pt idx="1532">
                  <c:v>49486.76611328125</c:v>
                </c:pt>
                <c:pt idx="1533">
                  <c:v>49490.259765625</c:v>
                </c:pt>
                <c:pt idx="1534">
                  <c:v>49494.581909179688</c:v>
                </c:pt>
                <c:pt idx="1535">
                  <c:v>49501.475463867188</c:v>
                </c:pt>
                <c:pt idx="1536">
                  <c:v>49519.340454101563</c:v>
                </c:pt>
                <c:pt idx="1537">
                  <c:v>49542.291137695313</c:v>
                </c:pt>
                <c:pt idx="1538">
                  <c:v>49545.784790039063</c:v>
                </c:pt>
                <c:pt idx="1539">
                  <c:v>49539.649780273438</c:v>
                </c:pt>
                <c:pt idx="1540">
                  <c:v>49534.857666015625</c:v>
                </c:pt>
                <c:pt idx="1541">
                  <c:v>49530.636962890625</c:v>
                </c:pt>
                <c:pt idx="1542">
                  <c:v>49530.159057617188</c:v>
                </c:pt>
                <c:pt idx="1543">
                  <c:v>49544.10986328125</c:v>
                </c:pt>
                <c:pt idx="1544">
                  <c:v>49571.603393554688</c:v>
                </c:pt>
                <c:pt idx="1545">
                  <c:v>49601.439819335938</c:v>
                </c:pt>
                <c:pt idx="1546">
                  <c:v>49628.704833984375</c:v>
                </c:pt>
                <c:pt idx="1547">
                  <c:v>49658.712768554688</c:v>
                </c:pt>
                <c:pt idx="1548">
                  <c:v>49690.777709960938</c:v>
                </c:pt>
                <c:pt idx="1549">
                  <c:v>49718.242797851563</c:v>
                </c:pt>
                <c:pt idx="1550">
                  <c:v>49734.850708007813</c:v>
                </c:pt>
                <c:pt idx="1551">
                  <c:v>49741.630004882813</c:v>
                </c:pt>
                <c:pt idx="1552">
                  <c:v>49747.580688476563</c:v>
                </c:pt>
                <c:pt idx="1553">
                  <c:v>49768.217163085938</c:v>
                </c:pt>
                <c:pt idx="1554">
                  <c:v>49800.110717773438</c:v>
                </c:pt>
                <c:pt idx="1555">
                  <c:v>49825.861450195313</c:v>
                </c:pt>
                <c:pt idx="1556">
                  <c:v>49846.155029296875</c:v>
                </c:pt>
                <c:pt idx="1557">
                  <c:v>49876.19140625</c:v>
                </c:pt>
                <c:pt idx="1558">
                  <c:v>49908.8564453125</c:v>
                </c:pt>
                <c:pt idx="1559">
                  <c:v>49926.807250976563</c:v>
                </c:pt>
                <c:pt idx="1560">
                  <c:v>49935.443603515625</c:v>
                </c:pt>
                <c:pt idx="1561">
                  <c:v>49947.594360351563</c:v>
                </c:pt>
                <c:pt idx="1562">
                  <c:v>49967.887939453125</c:v>
                </c:pt>
                <c:pt idx="1563">
                  <c:v>49993.41015625</c:v>
                </c:pt>
                <c:pt idx="1564">
                  <c:v>50024.646606445313</c:v>
                </c:pt>
                <c:pt idx="1565">
                  <c:v>50058.768798828125</c:v>
                </c:pt>
                <c:pt idx="1566">
                  <c:v>50088.833740234375</c:v>
                </c:pt>
                <c:pt idx="1567">
                  <c:v>50104.298828125</c:v>
                </c:pt>
                <c:pt idx="1568">
                  <c:v>50100.70654296875</c:v>
                </c:pt>
                <c:pt idx="1569">
                  <c:v>50085.400146484375</c:v>
                </c:pt>
                <c:pt idx="1570">
                  <c:v>50066.293701171875</c:v>
                </c:pt>
                <c:pt idx="1571">
                  <c:v>50040.501586914063</c:v>
                </c:pt>
                <c:pt idx="1572">
                  <c:v>50011.7666015625</c:v>
                </c:pt>
                <c:pt idx="1573">
                  <c:v>49994.888793945313</c:v>
                </c:pt>
                <c:pt idx="1574">
                  <c:v>49999.03955078125</c:v>
                </c:pt>
                <c:pt idx="1575">
                  <c:v>50006.590209960938</c:v>
                </c:pt>
                <c:pt idx="1576">
                  <c:v>49996.969604492188</c:v>
                </c:pt>
                <c:pt idx="1577">
                  <c:v>49976.005981445313</c:v>
                </c:pt>
                <c:pt idx="1578">
                  <c:v>49971.2138671875</c:v>
                </c:pt>
                <c:pt idx="1579">
                  <c:v>49991.87890625</c:v>
                </c:pt>
                <c:pt idx="1580">
                  <c:v>50021.115356445313</c:v>
                </c:pt>
                <c:pt idx="1581">
                  <c:v>50036.237426757813</c:v>
                </c:pt>
                <c:pt idx="1582">
                  <c:v>50043.27392578125</c:v>
                </c:pt>
                <c:pt idx="1583">
                  <c:v>50056.767578125</c:v>
                </c:pt>
                <c:pt idx="1584">
                  <c:v>50079.461181640625</c:v>
                </c:pt>
                <c:pt idx="1585">
                  <c:v>50108.811767578125</c:v>
                </c:pt>
                <c:pt idx="1586">
                  <c:v>50139.191162109375</c:v>
                </c:pt>
                <c:pt idx="1587">
                  <c:v>50170.141845703125</c:v>
                </c:pt>
                <c:pt idx="1588">
                  <c:v>50192.49267578125</c:v>
                </c:pt>
                <c:pt idx="1589">
                  <c:v>50194.157470703125</c:v>
                </c:pt>
                <c:pt idx="1590">
                  <c:v>50157.936767578125</c:v>
                </c:pt>
                <c:pt idx="1591">
                  <c:v>50080.087646484375</c:v>
                </c:pt>
                <c:pt idx="1592">
                  <c:v>49981.06689453125</c:v>
                </c:pt>
                <c:pt idx="1593">
                  <c:v>49890.074829101563</c:v>
                </c:pt>
                <c:pt idx="1594">
                  <c:v>49834.854125976563</c:v>
                </c:pt>
                <c:pt idx="1595">
                  <c:v>49826.147705078125</c:v>
                </c:pt>
                <c:pt idx="1596">
                  <c:v>49887.18408203125</c:v>
                </c:pt>
                <c:pt idx="1597">
                  <c:v>50053.592041015625</c:v>
                </c:pt>
                <c:pt idx="1598">
                  <c:v>50372.828369140625</c:v>
                </c:pt>
                <c:pt idx="1599">
                  <c:v>50903.1220703125</c:v>
                </c:pt>
                <c:pt idx="1600">
                  <c:v>51703.1298828125</c:v>
                </c:pt>
                <c:pt idx="1601">
                  <c:v>52800.85205078125</c:v>
                </c:pt>
                <c:pt idx="1602">
                  <c:v>54161.716796875</c:v>
                </c:pt>
                <c:pt idx="1603">
                  <c:v>55657.72509765625</c:v>
                </c:pt>
                <c:pt idx="1604">
                  <c:v>57061.533203125</c:v>
                </c:pt>
                <c:pt idx="1605">
                  <c:v>58107.59765625</c:v>
                </c:pt>
                <c:pt idx="1606">
                  <c:v>58568.77734375</c:v>
                </c:pt>
                <c:pt idx="1607">
                  <c:v>58325.78515625</c:v>
                </c:pt>
                <c:pt idx="1608">
                  <c:v>57418.70703125</c:v>
                </c:pt>
                <c:pt idx="1609">
                  <c:v>56037.88623046875</c:v>
                </c:pt>
                <c:pt idx="1610">
                  <c:v>54448.6943359375</c:v>
                </c:pt>
                <c:pt idx="1611">
                  <c:v>52905.359375</c:v>
                </c:pt>
                <c:pt idx="1612">
                  <c:v>51600.167236328125</c:v>
                </c:pt>
                <c:pt idx="1613">
                  <c:v>50625.060791015625</c:v>
                </c:pt>
                <c:pt idx="1614">
                  <c:v>49966.725708007813</c:v>
                </c:pt>
                <c:pt idx="1615">
                  <c:v>49551.8193359375</c:v>
                </c:pt>
                <c:pt idx="1616">
                  <c:v>49300.198608398438</c:v>
                </c:pt>
                <c:pt idx="1617">
                  <c:v>49156.20654296875</c:v>
                </c:pt>
                <c:pt idx="1618">
                  <c:v>49078.843017578125</c:v>
                </c:pt>
                <c:pt idx="1619">
                  <c:v>49037.850830078125</c:v>
                </c:pt>
                <c:pt idx="1620">
                  <c:v>49008.858703613281</c:v>
                </c:pt>
                <c:pt idx="1621">
                  <c:v>48983.980834960938</c:v>
                </c:pt>
                <c:pt idx="1622">
                  <c:v>48969.903015136719</c:v>
                </c:pt>
                <c:pt idx="1623">
                  <c:v>48966.539428710938</c:v>
                </c:pt>
                <c:pt idx="1624">
                  <c:v>48965.833068847656</c:v>
                </c:pt>
                <c:pt idx="1625">
                  <c:v>48965.012329101563</c:v>
                </c:pt>
                <c:pt idx="1626">
                  <c:v>48963.991638183594</c:v>
                </c:pt>
                <c:pt idx="1627">
                  <c:v>48956.456665039063</c:v>
                </c:pt>
                <c:pt idx="1628">
                  <c:v>48936.378784179688</c:v>
                </c:pt>
                <c:pt idx="1629">
                  <c:v>48911.67236328125</c:v>
                </c:pt>
                <c:pt idx="1630">
                  <c:v>48889.308837890625</c:v>
                </c:pt>
                <c:pt idx="1631">
                  <c:v>48879.145263671875</c:v>
                </c:pt>
                <c:pt idx="1632">
                  <c:v>48886.153137207031</c:v>
                </c:pt>
                <c:pt idx="1633">
                  <c:v>48895.475280761719</c:v>
                </c:pt>
                <c:pt idx="1634">
                  <c:v>48894.51171875</c:v>
                </c:pt>
                <c:pt idx="1635">
                  <c:v>48884.719604492188</c:v>
                </c:pt>
                <c:pt idx="1636">
                  <c:v>48876.727478027344</c:v>
                </c:pt>
                <c:pt idx="1637">
                  <c:v>48865.79248046875</c:v>
                </c:pt>
                <c:pt idx="1638">
                  <c:v>48852.086059570313</c:v>
                </c:pt>
                <c:pt idx="1639">
                  <c:v>48841.122497558594</c:v>
                </c:pt>
                <c:pt idx="1640">
                  <c:v>48834.901794433594</c:v>
                </c:pt>
                <c:pt idx="1641">
                  <c:v>48832.566833496094</c:v>
                </c:pt>
                <c:pt idx="1642">
                  <c:v>48828.346130371094</c:v>
                </c:pt>
                <c:pt idx="1643">
                  <c:v>48814.554016113281</c:v>
                </c:pt>
                <c:pt idx="1644">
                  <c:v>48795.13330078125</c:v>
                </c:pt>
                <c:pt idx="1645">
                  <c:v>48784.084045410156</c:v>
                </c:pt>
                <c:pt idx="1646">
                  <c:v>48786.034729003906</c:v>
                </c:pt>
                <c:pt idx="1647">
                  <c:v>48796.042602539063</c:v>
                </c:pt>
                <c:pt idx="1648">
                  <c:v>48812.679077148438</c:v>
                </c:pt>
                <c:pt idx="1649">
                  <c:v>48831.715515136719</c:v>
                </c:pt>
                <c:pt idx="1650">
                  <c:v>48853.523376464844</c:v>
                </c:pt>
                <c:pt idx="1651">
                  <c:v>48880.674133300781</c:v>
                </c:pt>
                <c:pt idx="1652">
                  <c:v>48914.281982421875</c:v>
                </c:pt>
                <c:pt idx="1653">
                  <c:v>48957.489868164063</c:v>
                </c:pt>
                <c:pt idx="1654">
                  <c:v>49013.669128417969</c:v>
                </c:pt>
                <c:pt idx="1655">
                  <c:v>49063.191284179688</c:v>
                </c:pt>
                <c:pt idx="1656">
                  <c:v>49092.713500976563</c:v>
                </c:pt>
                <c:pt idx="1657">
                  <c:v>49118.178466796875</c:v>
                </c:pt>
                <c:pt idx="1658">
                  <c:v>49159.1005859375</c:v>
                </c:pt>
                <c:pt idx="1659">
                  <c:v>49211.59423828125</c:v>
                </c:pt>
                <c:pt idx="1660">
                  <c:v>49272.4306640625</c:v>
                </c:pt>
                <c:pt idx="1661">
                  <c:v>49344.238525390625</c:v>
                </c:pt>
                <c:pt idx="1662">
                  <c:v>49426.646362304688</c:v>
                </c:pt>
                <c:pt idx="1663">
                  <c:v>49498.111450195313</c:v>
                </c:pt>
                <c:pt idx="1664">
                  <c:v>49527.319213867188</c:v>
                </c:pt>
                <c:pt idx="1665">
                  <c:v>49500.955688476563</c:v>
                </c:pt>
                <c:pt idx="1666">
                  <c:v>49439.963623046875</c:v>
                </c:pt>
                <c:pt idx="1667">
                  <c:v>49357.857177734375</c:v>
                </c:pt>
                <c:pt idx="1668">
                  <c:v>49257.579345703125</c:v>
                </c:pt>
                <c:pt idx="1669">
                  <c:v>49145.472900390625</c:v>
                </c:pt>
                <c:pt idx="1670">
                  <c:v>49042.16650390625</c:v>
                </c:pt>
                <c:pt idx="1671">
                  <c:v>48963.745788574219</c:v>
                </c:pt>
                <c:pt idx="1672">
                  <c:v>48913.125061035156</c:v>
                </c:pt>
                <c:pt idx="1673">
                  <c:v>48881.132934570313</c:v>
                </c:pt>
                <c:pt idx="1674">
                  <c:v>48870.2265625</c:v>
                </c:pt>
                <c:pt idx="1675">
                  <c:v>48886.234436035156</c:v>
                </c:pt>
                <c:pt idx="1676">
                  <c:v>48925.270874023438</c:v>
                </c:pt>
                <c:pt idx="1677">
                  <c:v>48983.793029785156</c:v>
                </c:pt>
                <c:pt idx="1678">
                  <c:v>49064.915161132813</c:v>
                </c:pt>
                <c:pt idx="1679">
                  <c:v>49171.494506835938</c:v>
                </c:pt>
                <c:pt idx="1680">
                  <c:v>49316.302368164063</c:v>
                </c:pt>
                <c:pt idx="1681">
                  <c:v>49508.881591796875</c:v>
                </c:pt>
                <c:pt idx="1682">
                  <c:v>49724.889526367188</c:v>
                </c:pt>
                <c:pt idx="1683">
                  <c:v>49924.983032226563</c:v>
                </c:pt>
                <c:pt idx="1684">
                  <c:v>50077.61962890625</c:v>
                </c:pt>
                <c:pt idx="1685">
                  <c:v>50154.827392578125</c:v>
                </c:pt>
                <c:pt idx="1686">
                  <c:v>50132.492431640625</c:v>
                </c:pt>
                <c:pt idx="1687">
                  <c:v>50016.214599609375</c:v>
                </c:pt>
                <c:pt idx="1688">
                  <c:v>49828.051025390625</c:v>
                </c:pt>
                <c:pt idx="1689">
                  <c:v>49594.258911132813</c:v>
                </c:pt>
                <c:pt idx="1690">
                  <c:v>49340.86669921875</c:v>
                </c:pt>
                <c:pt idx="1691">
                  <c:v>49105.017456054688</c:v>
                </c:pt>
                <c:pt idx="1692">
                  <c:v>48914.653930664063</c:v>
                </c:pt>
                <c:pt idx="1693">
                  <c:v>48783.376098632813</c:v>
                </c:pt>
                <c:pt idx="1694">
                  <c:v>48699.498229980469</c:v>
                </c:pt>
                <c:pt idx="1695">
                  <c:v>48647.591796875</c:v>
                </c:pt>
                <c:pt idx="1696">
                  <c:v>48616.685424804688</c:v>
                </c:pt>
                <c:pt idx="1697">
                  <c:v>48604.950439453125</c:v>
                </c:pt>
                <c:pt idx="1698">
                  <c:v>48599.986877441406</c:v>
                </c:pt>
                <c:pt idx="1699">
                  <c:v>48589.5947265625</c:v>
                </c:pt>
                <c:pt idx="1700">
                  <c:v>48572.831176757813</c:v>
                </c:pt>
                <c:pt idx="1701">
                  <c:v>48555.467590332031</c:v>
                </c:pt>
                <c:pt idx="1702">
                  <c:v>48539.218322753906</c:v>
                </c:pt>
                <c:pt idx="1703">
                  <c:v>48525.883361816406</c:v>
                </c:pt>
                <c:pt idx="1704">
                  <c:v>48512.348388671875</c:v>
                </c:pt>
                <c:pt idx="1705">
                  <c:v>48498.641937255859</c:v>
                </c:pt>
                <c:pt idx="1706">
                  <c:v>48483.821258544922</c:v>
                </c:pt>
                <c:pt idx="1707">
                  <c:v>48476.200531005859</c:v>
                </c:pt>
                <c:pt idx="1708">
                  <c:v>48486.636993408203</c:v>
                </c:pt>
                <c:pt idx="1709">
                  <c:v>48519.101989746094</c:v>
                </c:pt>
                <c:pt idx="1710">
                  <c:v>48562.538452148438</c:v>
                </c:pt>
                <c:pt idx="1711">
                  <c:v>48603.717712402344</c:v>
                </c:pt>
                <c:pt idx="1712">
                  <c:v>48648.954162597656</c:v>
                </c:pt>
                <c:pt idx="1713">
                  <c:v>48707.076354980469</c:v>
                </c:pt>
                <c:pt idx="1714">
                  <c:v>48784.22705078125</c:v>
                </c:pt>
                <c:pt idx="1715">
                  <c:v>48892.977783203125</c:v>
                </c:pt>
                <c:pt idx="1716">
                  <c:v>49054.757080078125</c:v>
                </c:pt>
                <c:pt idx="1717">
                  <c:v>49294.222045898438</c:v>
                </c:pt>
                <c:pt idx="1718">
                  <c:v>49651.601440429688</c:v>
                </c:pt>
                <c:pt idx="1719">
                  <c:v>50185.580810546875</c:v>
                </c:pt>
                <c:pt idx="1720">
                  <c:v>50957.07421875</c:v>
                </c:pt>
                <c:pt idx="1721">
                  <c:v>52029.539306640625</c:v>
                </c:pt>
                <c:pt idx="1722">
                  <c:v>53436.11865234375</c:v>
                </c:pt>
                <c:pt idx="1723">
                  <c:v>55136.9833984375</c:v>
                </c:pt>
                <c:pt idx="1724">
                  <c:v>56993.3056640625</c:v>
                </c:pt>
                <c:pt idx="1725">
                  <c:v>58779.7705078125</c:v>
                </c:pt>
                <c:pt idx="1726">
                  <c:v>60219.978515625</c:v>
                </c:pt>
                <c:pt idx="1727">
                  <c:v>61073.5009765625</c:v>
                </c:pt>
                <c:pt idx="1728">
                  <c:v>61179.5087890625</c:v>
                </c:pt>
                <c:pt idx="1729">
                  <c:v>60500.259765625</c:v>
                </c:pt>
                <c:pt idx="1730">
                  <c:v>59163.5244140625</c:v>
                </c:pt>
                <c:pt idx="1731">
                  <c:v>57419.2177734375</c:v>
                </c:pt>
                <c:pt idx="1732">
                  <c:v>55531.3115234375</c:v>
                </c:pt>
                <c:pt idx="1733">
                  <c:v>53731.60498046875</c:v>
                </c:pt>
                <c:pt idx="1734">
                  <c:v>52191.755859375</c:v>
                </c:pt>
                <c:pt idx="1735">
                  <c:v>50997.735107421875</c:v>
                </c:pt>
                <c:pt idx="1736">
                  <c:v>50154.285888671875</c:v>
                </c:pt>
                <c:pt idx="1737">
                  <c:v>49608.436645507813</c:v>
                </c:pt>
                <c:pt idx="1738">
                  <c:v>49272.558837890625</c:v>
                </c:pt>
                <c:pt idx="1739">
                  <c:v>49068.59521484375</c:v>
                </c:pt>
                <c:pt idx="1740">
                  <c:v>48942.803100585938</c:v>
                </c:pt>
                <c:pt idx="1741">
                  <c:v>48858.010986328125</c:v>
                </c:pt>
                <c:pt idx="1742">
                  <c:v>48800.618835449219</c:v>
                </c:pt>
                <c:pt idx="1743">
                  <c:v>48765.112426757813</c:v>
                </c:pt>
                <c:pt idx="1744">
                  <c:v>48745.120300292969</c:v>
                </c:pt>
                <c:pt idx="1745">
                  <c:v>48726.728210449219</c:v>
                </c:pt>
                <c:pt idx="1746">
                  <c:v>48696.650329589844</c:v>
                </c:pt>
                <c:pt idx="1747">
                  <c:v>48661.115356445313</c:v>
                </c:pt>
                <c:pt idx="1748">
                  <c:v>48646.266052246094</c:v>
                </c:pt>
                <c:pt idx="1749">
                  <c:v>48667.616821289063</c:v>
                </c:pt>
                <c:pt idx="1750">
                  <c:v>48711.396118164063</c:v>
                </c:pt>
                <c:pt idx="1751">
                  <c:v>48774.775390625</c:v>
                </c:pt>
                <c:pt idx="1752">
                  <c:v>48869.211853027344</c:v>
                </c:pt>
                <c:pt idx="1753">
                  <c:v>49017.934020996094</c:v>
                </c:pt>
                <c:pt idx="1754">
                  <c:v>49229.513305664063</c:v>
                </c:pt>
                <c:pt idx="1755">
                  <c:v>49501.635498046875</c:v>
                </c:pt>
                <c:pt idx="1756">
                  <c:v>49815.643310546875</c:v>
                </c:pt>
                <c:pt idx="1757">
                  <c:v>50148.27978515625</c:v>
                </c:pt>
                <c:pt idx="1758">
                  <c:v>50474.23046875</c:v>
                </c:pt>
                <c:pt idx="1759">
                  <c:v>50754.152587890625</c:v>
                </c:pt>
                <c:pt idx="1760">
                  <c:v>50944.189208984375</c:v>
                </c:pt>
                <c:pt idx="1761">
                  <c:v>51012.425537109375</c:v>
                </c:pt>
                <c:pt idx="1762">
                  <c:v>50949.319091796875</c:v>
                </c:pt>
                <c:pt idx="1763">
                  <c:v>50767.641357421875</c:v>
                </c:pt>
                <c:pt idx="1764">
                  <c:v>50496.19189453125</c:v>
                </c:pt>
                <c:pt idx="1765">
                  <c:v>50172.97119140625</c:v>
                </c:pt>
                <c:pt idx="1766">
                  <c:v>49848.17919921875</c:v>
                </c:pt>
                <c:pt idx="1767">
                  <c:v>49558.501342773438</c:v>
                </c:pt>
                <c:pt idx="1768">
                  <c:v>49319.423461914063</c:v>
                </c:pt>
                <c:pt idx="1769">
                  <c:v>49126.51708984375</c:v>
                </c:pt>
                <c:pt idx="1770">
                  <c:v>48991.096374511719</c:v>
                </c:pt>
                <c:pt idx="1771">
                  <c:v>48903.018493652344</c:v>
                </c:pt>
                <c:pt idx="1772">
                  <c:v>48848.569274902344</c:v>
                </c:pt>
                <c:pt idx="1773">
                  <c:v>48817.919982910156</c:v>
                </c:pt>
                <c:pt idx="1774">
                  <c:v>48800.52783203125</c:v>
                </c:pt>
                <c:pt idx="1775">
                  <c:v>48788.392883300781</c:v>
                </c:pt>
                <c:pt idx="1776">
                  <c:v>48778.600708007813</c:v>
                </c:pt>
                <c:pt idx="1777">
                  <c:v>48781.237182617188</c:v>
                </c:pt>
                <c:pt idx="1778">
                  <c:v>48794.702209472656</c:v>
                </c:pt>
                <c:pt idx="1779">
                  <c:v>48808.42431640625</c:v>
                </c:pt>
                <c:pt idx="1780">
                  <c:v>48811.146484375</c:v>
                </c:pt>
                <c:pt idx="1781">
                  <c:v>48808.754333496094</c:v>
                </c:pt>
                <c:pt idx="1782">
                  <c:v>48808.676513671875</c:v>
                </c:pt>
                <c:pt idx="1783">
                  <c:v>48809.084411621094</c:v>
                </c:pt>
                <c:pt idx="1784">
                  <c:v>48810.349426269531</c:v>
                </c:pt>
                <c:pt idx="1785">
                  <c:v>48811.271545410156</c:v>
                </c:pt>
                <c:pt idx="1786">
                  <c:v>48812.307983398438</c:v>
                </c:pt>
                <c:pt idx="1787">
                  <c:v>48819.315856933594</c:v>
                </c:pt>
                <c:pt idx="1788">
                  <c:v>48831.066589355469</c:v>
                </c:pt>
                <c:pt idx="1789">
                  <c:v>48833.98876953125</c:v>
                </c:pt>
                <c:pt idx="1790">
                  <c:v>48830.539489746094</c:v>
                </c:pt>
                <c:pt idx="1791">
                  <c:v>48834.175903320313</c:v>
                </c:pt>
                <c:pt idx="1792">
                  <c:v>48844.26953125</c:v>
                </c:pt>
                <c:pt idx="1793">
                  <c:v>48850.763061523438</c:v>
                </c:pt>
                <c:pt idx="1794">
                  <c:v>48849.199523925781</c:v>
                </c:pt>
                <c:pt idx="1795">
                  <c:v>48853.435974121094</c:v>
                </c:pt>
                <c:pt idx="1796">
                  <c:v>48874.786682128906</c:v>
                </c:pt>
                <c:pt idx="1797">
                  <c:v>48916.451721191406</c:v>
                </c:pt>
                <c:pt idx="1798">
                  <c:v>48965.830993652344</c:v>
                </c:pt>
                <c:pt idx="1799">
                  <c:v>49023.267456054688</c:v>
                </c:pt>
                <c:pt idx="1800">
                  <c:v>49096.50390625</c:v>
                </c:pt>
                <c:pt idx="1801">
                  <c:v>49191.683227539063</c:v>
                </c:pt>
                <c:pt idx="1802">
                  <c:v>49301.148193359375</c:v>
                </c:pt>
                <c:pt idx="1803">
                  <c:v>49418.984619140625</c:v>
                </c:pt>
                <c:pt idx="1804">
                  <c:v>49532.849609375</c:v>
                </c:pt>
                <c:pt idx="1805">
                  <c:v>49642.543212890625</c:v>
                </c:pt>
                <c:pt idx="1806">
                  <c:v>49749.1796875</c:v>
                </c:pt>
                <c:pt idx="1807">
                  <c:v>49843.416137695313</c:v>
                </c:pt>
                <c:pt idx="1808">
                  <c:v>49898.281127929688</c:v>
                </c:pt>
                <c:pt idx="1809">
                  <c:v>49902.34619140625</c:v>
                </c:pt>
                <c:pt idx="1810">
                  <c:v>49859.982543945313</c:v>
                </c:pt>
                <c:pt idx="1811">
                  <c:v>49780.104736328125</c:v>
                </c:pt>
                <c:pt idx="1812">
                  <c:v>49674.312622070313</c:v>
                </c:pt>
                <c:pt idx="1813">
                  <c:v>49551.149047851563</c:v>
                </c:pt>
                <c:pt idx="1814">
                  <c:v>49419.556884765625</c:v>
                </c:pt>
                <c:pt idx="1815">
                  <c:v>49298.0791015625</c:v>
                </c:pt>
                <c:pt idx="1816">
                  <c:v>49194.97265625</c:v>
                </c:pt>
                <c:pt idx="1817">
                  <c:v>49108.237670898438</c:v>
                </c:pt>
                <c:pt idx="1818">
                  <c:v>49046.53125</c:v>
                </c:pt>
                <c:pt idx="1819">
                  <c:v>49022.682006835938</c:v>
                </c:pt>
                <c:pt idx="1820">
                  <c:v>49024.489868164063</c:v>
                </c:pt>
                <c:pt idx="1821">
                  <c:v>49027.212036132813</c:v>
                </c:pt>
                <c:pt idx="1822">
                  <c:v>49033.419921875</c:v>
                </c:pt>
                <c:pt idx="1823">
                  <c:v>49048.37060546875</c:v>
                </c:pt>
                <c:pt idx="1824">
                  <c:v>49063.0927734375</c:v>
                </c:pt>
                <c:pt idx="1825">
                  <c:v>49060.129272460938</c:v>
                </c:pt>
                <c:pt idx="1826">
                  <c:v>49048.308471679688</c:v>
                </c:pt>
                <c:pt idx="1827">
                  <c:v>49044.116333007813</c:v>
                </c:pt>
                <c:pt idx="1828">
                  <c:v>49055.581420898438</c:v>
                </c:pt>
                <c:pt idx="1829">
                  <c:v>49067.446411132813</c:v>
                </c:pt>
                <c:pt idx="1830">
                  <c:v>49064.254272460938</c:v>
                </c:pt>
                <c:pt idx="1831">
                  <c:v>49051.233642578125</c:v>
                </c:pt>
                <c:pt idx="1832">
                  <c:v>49044.070068359375</c:v>
                </c:pt>
                <c:pt idx="1833">
                  <c:v>49039.506469726563</c:v>
                </c:pt>
                <c:pt idx="1834">
                  <c:v>49031.057250976563</c:v>
                </c:pt>
                <c:pt idx="1835">
                  <c:v>49022.865051269531</c:v>
                </c:pt>
                <c:pt idx="1836">
                  <c:v>49013.958679199219</c:v>
                </c:pt>
                <c:pt idx="1837">
                  <c:v>48999.966491699219</c:v>
                </c:pt>
                <c:pt idx="1838">
                  <c:v>48989.260131835938</c:v>
                </c:pt>
                <c:pt idx="1839">
                  <c:v>48991.153686523438</c:v>
                </c:pt>
                <c:pt idx="1840">
                  <c:v>48996.3330078125</c:v>
                </c:pt>
                <c:pt idx="1841">
                  <c:v>48997.197998046875</c:v>
                </c:pt>
                <c:pt idx="1842">
                  <c:v>48993.491577148438</c:v>
                </c:pt>
                <c:pt idx="1843">
                  <c:v>48989.185180664063</c:v>
                </c:pt>
                <c:pt idx="1844">
                  <c:v>48981.335876464844</c:v>
                </c:pt>
                <c:pt idx="1845">
                  <c:v>48973.572326660156</c:v>
                </c:pt>
                <c:pt idx="1846">
                  <c:v>48964.894470214844</c:v>
                </c:pt>
                <c:pt idx="1847">
                  <c:v>48963.159484863281</c:v>
                </c:pt>
                <c:pt idx="1848">
                  <c:v>48967.024536132813</c:v>
                </c:pt>
                <c:pt idx="1849">
                  <c:v>48968.432373046875</c:v>
                </c:pt>
                <c:pt idx="1850">
                  <c:v>48959.440246582031</c:v>
                </c:pt>
                <c:pt idx="1851">
                  <c:v>48952.390991210938</c:v>
                </c:pt>
                <c:pt idx="1852">
                  <c:v>48955.941711425781</c:v>
                </c:pt>
                <c:pt idx="1853">
                  <c:v>48963.349609375</c:v>
                </c:pt>
                <c:pt idx="1854">
                  <c:v>48962.671752929688</c:v>
                </c:pt>
                <c:pt idx="1855">
                  <c:v>48952.222473144531</c:v>
                </c:pt>
                <c:pt idx="1856">
                  <c:v>48942.287475585938</c:v>
                </c:pt>
                <c:pt idx="1857">
                  <c:v>48937.438232421875</c:v>
                </c:pt>
                <c:pt idx="1858">
                  <c:v>48938.046081542969</c:v>
                </c:pt>
                <c:pt idx="1859">
                  <c:v>48940.511108398438</c:v>
                </c:pt>
                <c:pt idx="1860">
                  <c:v>48940.404663085938</c:v>
                </c:pt>
                <c:pt idx="1861">
                  <c:v>48929.012573242188</c:v>
                </c:pt>
                <c:pt idx="1862">
                  <c:v>48909.30615234375</c:v>
                </c:pt>
                <c:pt idx="1863">
                  <c:v>48892.856872558594</c:v>
                </c:pt>
                <c:pt idx="1864">
                  <c:v>48880.350463867188</c:v>
                </c:pt>
                <c:pt idx="1865">
                  <c:v>48863.015441894531</c:v>
                </c:pt>
                <c:pt idx="1866">
                  <c:v>48845.5947265625</c:v>
                </c:pt>
                <c:pt idx="1867">
                  <c:v>48839.688354492188</c:v>
                </c:pt>
                <c:pt idx="1868">
                  <c:v>48839.181945800781</c:v>
                </c:pt>
                <c:pt idx="1869">
                  <c:v>48834.161193847656</c:v>
                </c:pt>
                <c:pt idx="1870">
                  <c:v>48829.169067382813</c:v>
                </c:pt>
                <c:pt idx="1871">
                  <c:v>48821.862670898438</c:v>
                </c:pt>
                <c:pt idx="1872">
                  <c:v>48806.499145507813</c:v>
                </c:pt>
                <c:pt idx="1873">
                  <c:v>48793.8212890625</c:v>
                </c:pt>
                <c:pt idx="1874">
                  <c:v>48793.029113769531</c:v>
                </c:pt>
                <c:pt idx="1875">
                  <c:v>48796.751281738281</c:v>
                </c:pt>
                <c:pt idx="1876">
                  <c:v>48799.21630859375</c:v>
                </c:pt>
                <c:pt idx="1877">
                  <c:v>48801.167053222656</c:v>
                </c:pt>
                <c:pt idx="1878">
                  <c:v>48799.77490234375</c:v>
                </c:pt>
                <c:pt idx="1879">
                  <c:v>48796.754211425781</c:v>
                </c:pt>
                <c:pt idx="1880">
                  <c:v>48797.076354980469</c:v>
                </c:pt>
                <c:pt idx="1881">
                  <c:v>48794.427062988281</c:v>
                </c:pt>
                <c:pt idx="1882">
                  <c:v>48781.663513183594</c:v>
                </c:pt>
                <c:pt idx="1883">
                  <c:v>48764.385681152344</c:v>
                </c:pt>
                <c:pt idx="1884">
                  <c:v>48750.765014648438</c:v>
                </c:pt>
                <c:pt idx="1885">
                  <c:v>48737.001403808594</c:v>
                </c:pt>
                <c:pt idx="1886">
                  <c:v>48715.323608398438</c:v>
                </c:pt>
                <c:pt idx="1887">
                  <c:v>48695.131469726563</c:v>
                </c:pt>
                <c:pt idx="1888">
                  <c:v>48687.56787109375</c:v>
                </c:pt>
                <c:pt idx="1889">
                  <c:v>48690.547180175781</c:v>
                </c:pt>
                <c:pt idx="1890">
                  <c:v>48687.697937011719</c:v>
                </c:pt>
                <c:pt idx="1891">
                  <c:v>48674.90576171875</c:v>
                </c:pt>
                <c:pt idx="1892">
                  <c:v>48667.113647460938</c:v>
                </c:pt>
                <c:pt idx="1893">
                  <c:v>48674.264404296875</c:v>
                </c:pt>
                <c:pt idx="1894">
                  <c:v>48686.472290039063</c:v>
                </c:pt>
                <c:pt idx="1895">
                  <c:v>48691.480102539063</c:v>
                </c:pt>
                <c:pt idx="1896">
                  <c:v>48694.68798828125</c:v>
                </c:pt>
                <c:pt idx="1897">
                  <c:v>48698.35302734375</c:v>
                </c:pt>
                <c:pt idx="1898">
                  <c:v>48696.560913085938</c:v>
                </c:pt>
                <c:pt idx="1899">
                  <c:v>48690.368774414063</c:v>
                </c:pt>
                <c:pt idx="1900">
                  <c:v>48689.462341308594</c:v>
                </c:pt>
                <c:pt idx="1901">
                  <c:v>48692.58447265625</c:v>
                </c:pt>
                <c:pt idx="1902">
                  <c:v>48688.478088378906</c:v>
                </c:pt>
                <c:pt idx="1903">
                  <c:v>48677.428833007813</c:v>
                </c:pt>
                <c:pt idx="1904">
                  <c:v>48668.465270996094</c:v>
                </c:pt>
                <c:pt idx="1905">
                  <c:v>48668.987426757813</c:v>
                </c:pt>
                <c:pt idx="1906">
                  <c:v>48679.709533691406</c:v>
                </c:pt>
                <c:pt idx="1907">
                  <c:v>48693.945983886719</c:v>
                </c:pt>
                <c:pt idx="1908">
                  <c:v>48700.382446289063</c:v>
                </c:pt>
                <c:pt idx="1909">
                  <c:v>48701.76171875</c:v>
                </c:pt>
                <c:pt idx="1910">
                  <c:v>48710.883911132813</c:v>
                </c:pt>
                <c:pt idx="1911">
                  <c:v>48727.26318359375</c:v>
                </c:pt>
                <c:pt idx="1912">
                  <c:v>48740.242492675781</c:v>
                </c:pt>
                <c:pt idx="1913">
                  <c:v>48740.507507324219</c:v>
                </c:pt>
                <c:pt idx="1914">
                  <c:v>48726.458251953125</c:v>
                </c:pt>
                <c:pt idx="1915">
                  <c:v>48712.180419921875</c:v>
                </c:pt>
                <c:pt idx="1916">
                  <c:v>48715.131103515625</c:v>
                </c:pt>
                <c:pt idx="1917">
                  <c:v>48727.081848144531</c:v>
                </c:pt>
                <c:pt idx="1918">
                  <c:v>48735.261169433594</c:v>
                </c:pt>
                <c:pt idx="1919">
                  <c:v>48736.583312988281</c:v>
                </c:pt>
                <c:pt idx="1920">
                  <c:v>48739.334045410156</c:v>
                </c:pt>
                <c:pt idx="1921">
                  <c:v>48743.399047851563</c:v>
                </c:pt>
                <c:pt idx="1922">
                  <c:v>48751.264038085938</c:v>
                </c:pt>
                <c:pt idx="1923">
                  <c:v>48751.129089355469</c:v>
                </c:pt>
                <c:pt idx="1924">
                  <c:v>48749.136962890625</c:v>
                </c:pt>
                <c:pt idx="1925">
                  <c:v>48754.859069824219</c:v>
                </c:pt>
                <c:pt idx="1926">
                  <c:v>48767.552673339844</c:v>
                </c:pt>
                <c:pt idx="1927">
                  <c:v>48772.046264648438</c:v>
                </c:pt>
                <c:pt idx="1928">
                  <c:v>48770.254150390625</c:v>
                </c:pt>
                <c:pt idx="1929">
                  <c:v>48765.347717285156</c:v>
                </c:pt>
                <c:pt idx="1930">
                  <c:v>48758.184143066406</c:v>
                </c:pt>
                <c:pt idx="1931">
                  <c:v>48748.792053222656</c:v>
                </c:pt>
                <c:pt idx="1932">
                  <c:v>48747.228454589844</c:v>
                </c:pt>
                <c:pt idx="1933">
                  <c:v>48758.950622558594</c:v>
                </c:pt>
                <c:pt idx="1934">
                  <c:v>48782.84423828125</c:v>
                </c:pt>
                <c:pt idx="1935">
                  <c:v>48808.794921875</c:v>
                </c:pt>
                <c:pt idx="1936">
                  <c:v>48827.659973144531</c:v>
                </c:pt>
                <c:pt idx="1937">
                  <c:v>48843.210693359375</c:v>
                </c:pt>
                <c:pt idx="1938">
                  <c:v>48859.304260253906</c:v>
                </c:pt>
                <c:pt idx="1939">
                  <c:v>48876.397827148438</c:v>
                </c:pt>
                <c:pt idx="1940">
                  <c:v>48888.5771484375</c:v>
                </c:pt>
                <c:pt idx="1941">
                  <c:v>48903.184997558594</c:v>
                </c:pt>
                <c:pt idx="1942">
                  <c:v>48916.421447753906</c:v>
                </c:pt>
                <c:pt idx="1943">
                  <c:v>48925.743591308594</c:v>
                </c:pt>
                <c:pt idx="1944">
                  <c:v>48933.922912597656</c:v>
                </c:pt>
                <c:pt idx="1945">
                  <c:v>48947.102233886719</c:v>
                </c:pt>
                <c:pt idx="1946">
                  <c:v>48959.738647460938</c:v>
                </c:pt>
                <c:pt idx="1947">
                  <c:v>48969.746520996094</c:v>
                </c:pt>
                <c:pt idx="1948">
                  <c:v>48982.440124511719</c:v>
                </c:pt>
                <c:pt idx="1949">
                  <c:v>48999.105102539063</c:v>
                </c:pt>
                <c:pt idx="1950">
                  <c:v>49016.084411621094</c:v>
                </c:pt>
                <c:pt idx="1951">
                  <c:v>49029.692260742188</c:v>
                </c:pt>
                <c:pt idx="1952">
                  <c:v>49045.87158203125</c:v>
                </c:pt>
                <c:pt idx="1953">
                  <c:v>49064.850830078125</c:v>
                </c:pt>
                <c:pt idx="1954">
                  <c:v>49075.4873046875</c:v>
                </c:pt>
                <c:pt idx="1955">
                  <c:v>49079.523803710938</c:v>
                </c:pt>
                <c:pt idx="1956">
                  <c:v>49086.8173828125</c:v>
                </c:pt>
                <c:pt idx="1957">
                  <c:v>49096.65380859375</c:v>
                </c:pt>
                <c:pt idx="1958">
                  <c:v>49097.6044921875</c:v>
                </c:pt>
                <c:pt idx="1959">
                  <c:v>49091.698120117188</c:v>
                </c:pt>
                <c:pt idx="1960">
                  <c:v>49087.420288085938</c:v>
                </c:pt>
                <c:pt idx="1961">
                  <c:v>49088.399536132813</c:v>
                </c:pt>
                <c:pt idx="1962">
                  <c:v>49086.321655273438</c:v>
                </c:pt>
                <c:pt idx="1963">
                  <c:v>49077.44384765625</c:v>
                </c:pt>
                <c:pt idx="1964">
                  <c:v>49071.908935546875</c:v>
                </c:pt>
                <c:pt idx="1965">
                  <c:v>49070.916748046875</c:v>
                </c:pt>
                <c:pt idx="1966">
                  <c:v>49068.724609375</c:v>
                </c:pt>
                <c:pt idx="1967">
                  <c:v>49067.418212890625</c:v>
                </c:pt>
                <c:pt idx="1968">
                  <c:v>49070.083251953125</c:v>
                </c:pt>
                <c:pt idx="1969">
                  <c:v>49066.091064453125</c:v>
                </c:pt>
                <c:pt idx="1970">
                  <c:v>49058.070434570313</c:v>
                </c:pt>
                <c:pt idx="1971">
                  <c:v>49052.021118164063</c:v>
                </c:pt>
                <c:pt idx="1972">
                  <c:v>49049.686157226563</c:v>
                </c:pt>
                <c:pt idx="1973">
                  <c:v>49047.522583007813</c:v>
                </c:pt>
                <c:pt idx="1974">
                  <c:v>49047.8447265625</c:v>
                </c:pt>
                <c:pt idx="1975">
                  <c:v>49048.281127929688</c:v>
                </c:pt>
                <c:pt idx="1976">
                  <c:v>49047.860473632813</c:v>
                </c:pt>
                <c:pt idx="1977">
                  <c:v>49053.982666015625</c:v>
                </c:pt>
                <c:pt idx="1978">
                  <c:v>49058.676147460938</c:v>
                </c:pt>
                <c:pt idx="1979">
                  <c:v>49057.85546875</c:v>
                </c:pt>
                <c:pt idx="1980">
                  <c:v>49060.5205078125</c:v>
                </c:pt>
                <c:pt idx="1981">
                  <c:v>49075.699829101563</c:v>
                </c:pt>
                <c:pt idx="1982">
                  <c:v>49091.02197265625</c:v>
                </c:pt>
                <c:pt idx="1983">
                  <c:v>49092.8583984375</c:v>
                </c:pt>
                <c:pt idx="1984">
                  <c:v>49079.751953125</c:v>
                </c:pt>
                <c:pt idx="1985">
                  <c:v>49055.217041015625</c:v>
                </c:pt>
                <c:pt idx="1986">
                  <c:v>49036.339111328125</c:v>
                </c:pt>
                <c:pt idx="1987">
                  <c:v>49028.861328125</c:v>
                </c:pt>
                <c:pt idx="1988">
                  <c:v>49018.154907226563</c:v>
                </c:pt>
                <c:pt idx="1989">
                  <c:v>48998.991333007813</c:v>
                </c:pt>
                <c:pt idx="1990">
                  <c:v>48988.570678710938</c:v>
                </c:pt>
                <c:pt idx="1991">
                  <c:v>48995.435668945313</c:v>
                </c:pt>
                <c:pt idx="1992">
                  <c:v>49005.672119140625</c:v>
                </c:pt>
                <c:pt idx="1993">
                  <c:v>49007.879943847656</c:v>
                </c:pt>
                <c:pt idx="1994">
                  <c:v>49001.459289550781</c:v>
                </c:pt>
                <c:pt idx="1995">
                  <c:v>48996.295715332031</c:v>
                </c:pt>
                <c:pt idx="1996">
                  <c:v>48996.560729980469</c:v>
                </c:pt>
                <c:pt idx="1997">
                  <c:v>49000.425720214844</c:v>
                </c:pt>
                <c:pt idx="1998">
                  <c:v>49002.119323730469</c:v>
                </c:pt>
                <c:pt idx="1999">
                  <c:v>48996.127197265625</c:v>
                </c:pt>
                <c:pt idx="2000">
                  <c:v>48985.449340820313</c:v>
                </c:pt>
                <c:pt idx="2001">
                  <c:v>48973.114379882813</c:v>
                </c:pt>
                <c:pt idx="2002">
                  <c:v>48958.522216796875</c:v>
                </c:pt>
                <c:pt idx="2003">
                  <c:v>48937.072937011719</c:v>
                </c:pt>
                <c:pt idx="2004">
                  <c:v>48918.109375</c:v>
                </c:pt>
                <c:pt idx="2005">
                  <c:v>48913.574401855469</c:v>
                </c:pt>
                <c:pt idx="2006">
                  <c:v>48914.839416503906</c:v>
                </c:pt>
                <c:pt idx="2007">
                  <c:v>48909.875854492188</c:v>
                </c:pt>
                <c:pt idx="2008">
                  <c:v>48895.540893554688</c:v>
                </c:pt>
                <c:pt idx="2009">
                  <c:v>48882.83447265625</c:v>
                </c:pt>
                <c:pt idx="2010">
                  <c:v>48871.213745117188</c:v>
                </c:pt>
                <c:pt idx="2011">
                  <c:v>48851.993041992188</c:v>
                </c:pt>
                <c:pt idx="2012">
                  <c:v>48826.543762207031</c:v>
                </c:pt>
                <c:pt idx="2013">
                  <c:v>48809.723083496094</c:v>
                </c:pt>
                <c:pt idx="2014">
                  <c:v>48810.359558105469</c:v>
                </c:pt>
                <c:pt idx="2015">
                  <c:v>48814.053100585938</c:v>
                </c:pt>
                <c:pt idx="2016">
                  <c:v>48806.089538574219</c:v>
                </c:pt>
                <c:pt idx="2017">
                  <c:v>48791.983154296875</c:v>
                </c:pt>
                <c:pt idx="2018">
                  <c:v>48773.276733398438</c:v>
                </c:pt>
                <c:pt idx="2019">
                  <c:v>48750.256042480469</c:v>
                </c:pt>
                <c:pt idx="2020">
                  <c:v>48730.2353515625</c:v>
                </c:pt>
                <c:pt idx="2021">
                  <c:v>48723.871765136719</c:v>
                </c:pt>
                <c:pt idx="2022">
                  <c:v>48728.308227539063</c:v>
                </c:pt>
                <c:pt idx="2023">
                  <c:v>48735.030334472656</c:v>
                </c:pt>
                <c:pt idx="2024">
                  <c:v>48733.209655761719</c:v>
                </c:pt>
                <c:pt idx="2025">
                  <c:v>48714.30322265625</c:v>
                </c:pt>
                <c:pt idx="2026">
                  <c:v>48686.425415039063</c:v>
                </c:pt>
                <c:pt idx="2027">
                  <c:v>48661.461853027344</c:v>
                </c:pt>
                <c:pt idx="2028">
                  <c:v>48643.669738769531</c:v>
                </c:pt>
                <c:pt idx="2029">
                  <c:v>48636.277587890625</c:v>
                </c:pt>
                <c:pt idx="2030">
                  <c:v>48642.97119140625</c:v>
                </c:pt>
                <c:pt idx="2031">
                  <c:v>48652.293334960938</c:v>
                </c:pt>
                <c:pt idx="2032">
                  <c:v>48648.558349609375</c:v>
                </c:pt>
                <c:pt idx="2033">
                  <c:v>48635.794799804688</c:v>
                </c:pt>
                <c:pt idx="2034">
                  <c:v>48628.374084472656</c:v>
                </c:pt>
                <c:pt idx="2035">
                  <c:v>48631.639099121094</c:v>
                </c:pt>
                <c:pt idx="2036">
                  <c:v>48641.246948242188</c:v>
                </c:pt>
                <c:pt idx="2037">
                  <c:v>48661.4833984375</c:v>
                </c:pt>
                <c:pt idx="2038">
                  <c:v>48686.234130859375</c:v>
                </c:pt>
                <c:pt idx="2039">
                  <c:v>48695.841979980469</c:v>
                </c:pt>
                <c:pt idx="2040">
                  <c:v>48683.249877929688</c:v>
                </c:pt>
                <c:pt idx="2041">
                  <c:v>48661.314880371094</c:v>
                </c:pt>
                <c:pt idx="2042">
                  <c:v>48641.951354980469</c:v>
                </c:pt>
                <c:pt idx="2043">
                  <c:v>48625.844909667969</c:v>
                </c:pt>
                <c:pt idx="2044">
                  <c:v>48610.624206542969</c:v>
                </c:pt>
                <c:pt idx="2045">
                  <c:v>48596.346374511719</c:v>
                </c:pt>
                <c:pt idx="2046">
                  <c:v>48583.868530273438</c:v>
                </c:pt>
                <c:pt idx="2047">
                  <c:v>48571.876403808594</c:v>
                </c:pt>
                <c:pt idx="2048">
                  <c:v>48561.655700683594</c:v>
                </c:pt>
                <c:pt idx="2049">
                  <c:v>48558.463562011719</c:v>
                </c:pt>
                <c:pt idx="2050">
                  <c:v>48568.55712890625</c:v>
                </c:pt>
                <c:pt idx="2051">
                  <c:v>48588.479309082031</c:v>
                </c:pt>
                <c:pt idx="2052">
                  <c:v>48615.00146484375</c:v>
                </c:pt>
                <c:pt idx="2053">
                  <c:v>48641.637878417969</c:v>
                </c:pt>
                <c:pt idx="2054">
                  <c:v>48663.760070800781</c:v>
                </c:pt>
                <c:pt idx="2055">
                  <c:v>48682.053649902344</c:v>
                </c:pt>
                <c:pt idx="2056">
                  <c:v>48696.690063476563</c:v>
                </c:pt>
                <c:pt idx="2057">
                  <c:v>48699.669372558594</c:v>
                </c:pt>
                <c:pt idx="2058">
                  <c:v>48684.020080566406</c:v>
                </c:pt>
                <c:pt idx="2059">
                  <c:v>48660.056518554688</c:v>
                </c:pt>
                <c:pt idx="2060">
                  <c:v>48636.864440917969</c:v>
                </c:pt>
                <c:pt idx="2061">
                  <c:v>48616.586547851563</c:v>
                </c:pt>
                <c:pt idx="2062">
                  <c:v>48596.423034667969</c:v>
                </c:pt>
                <c:pt idx="2063">
                  <c:v>48582.030883789063</c:v>
                </c:pt>
                <c:pt idx="2064">
                  <c:v>48575.867309570313</c:v>
                </c:pt>
                <c:pt idx="2065">
                  <c:v>48579.246643066406</c:v>
                </c:pt>
                <c:pt idx="2066">
                  <c:v>48582.225952148438</c:v>
                </c:pt>
                <c:pt idx="2067">
                  <c:v>48576.462341308594</c:v>
                </c:pt>
                <c:pt idx="2068">
                  <c:v>48567.47021484375</c:v>
                </c:pt>
                <c:pt idx="2069">
                  <c:v>48565.392395019531</c:v>
                </c:pt>
                <c:pt idx="2070">
                  <c:v>48568.400268554688</c:v>
                </c:pt>
                <c:pt idx="2071">
                  <c:v>48573.80810546875</c:v>
                </c:pt>
                <c:pt idx="2072">
                  <c:v>48583.616027832031</c:v>
                </c:pt>
                <c:pt idx="2073">
                  <c:v>48591.995300292969</c:v>
                </c:pt>
                <c:pt idx="2074">
                  <c:v>48590.946044921875</c:v>
                </c:pt>
                <c:pt idx="2075">
                  <c:v>48586.268188476563</c:v>
                </c:pt>
                <c:pt idx="2076">
                  <c:v>48587.733215332031</c:v>
                </c:pt>
                <c:pt idx="2077">
                  <c:v>48595.4267578125</c:v>
                </c:pt>
                <c:pt idx="2078">
                  <c:v>48615.663208007813</c:v>
                </c:pt>
                <c:pt idx="2079">
                  <c:v>48656.499633789063</c:v>
                </c:pt>
                <c:pt idx="2080">
                  <c:v>48736.907531738281</c:v>
                </c:pt>
                <c:pt idx="2081">
                  <c:v>48875.4296875</c:v>
                </c:pt>
                <c:pt idx="2082">
                  <c:v>49099.3232421875</c:v>
                </c:pt>
                <c:pt idx="2083">
                  <c:v>49439.331176757813</c:v>
                </c:pt>
                <c:pt idx="2084">
                  <c:v>49942.6533203125</c:v>
                </c:pt>
                <c:pt idx="2085">
                  <c:v>50648.03271484375</c:v>
                </c:pt>
                <c:pt idx="2086">
                  <c:v>51565.754638671875</c:v>
                </c:pt>
                <c:pt idx="2087">
                  <c:v>52689.93408203125</c:v>
                </c:pt>
                <c:pt idx="2088">
                  <c:v>54003.5419921875</c:v>
                </c:pt>
                <c:pt idx="2089">
                  <c:v>55463.06396484375</c:v>
                </c:pt>
                <c:pt idx="2090">
                  <c:v>56975.7001953125</c:v>
                </c:pt>
                <c:pt idx="2091">
                  <c:v>58415.7080078125</c:v>
                </c:pt>
                <c:pt idx="2092">
                  <c:v>59647.859375</c:v>
                </c:pt>
                <c:pt idx="2093">
                  <c:v>60550.9814453125</c:v>
                </c:pt>
                <c:pt idx="2094">
                  <c:v>61003.8466796875</c:v>
                </c:pt>
                <c:pt idx="2095">
                  <c:v>60933.42578125</c:v>
                </c:pt>
                <c:pt idx="2096">
                  <c:v>60358.71875</c:v>
                </c:pt>
                <c:pt idx="2097">
                  <c:v>59373.7265625</c:v>
                </c:pt>
                <c:pt idx="2098">
                  <c:v>58084.8779296875</c:v>
                </c:pt>
                <c:pt idx="2099">
                  <c:v>56615.314453125</c:v>
                </c:pt>
                <c:pt idx="2100">
                  <c:v>55104.75048828125</c:v>
                </c:pt>
                <c:pt idx="2101">
                  <c:v>53669.75830078125</c:v>
                </c:pt>
                <c:pt idx="2102">
                  <c:v>52392.73779296875</c:v>
                </c:pt>
                <c:pt idx="2103">
                  <c:v>51320.031494140625</c:v>
                </c:pt>
                <c:pt idx="2104">
                  <c:v>50466.210693359375</c:v>
                </c:pt>
                <c:pt idx="2105">
                  <c:v>49818.818603515625</c:v>
                </c:pt>
                <c:pt idx="2106">
                  <c:v>49360.426391601563</c:v>
                </c:pt>
                <c:pt idx="2107">
                  <c:v>49055.69140625</c:v>
                </c:pt>
                <c:pt idx="2108">
                  <c:v>48856.756469726563</c:v>
                </c:pt>
                <c:pt idx="2109">
                  <c:v>48722.364318847656</c:v>
                </c:pt>
                <c:pt idx="2110">
                  <c:v>48636.372192382813</c:v>
                </c:pt>
                <c:pt idx="2111">
                  <c:v>48594.63720703125</c:v>
                </c:pt>
                <c:pt idx="2112">
                  <c:v>48581.216491699219</c:v>
                </c:pt>
                <c:pt idx="2113">
                  <c:v>48568.938659667969</c:v>
                </c:pt>
                <c:pt idx="2114">
                  <c:v>48554.317993164063</c:v>
                </c:pt>
                <c:pt idx="2115">
                  <c:v>48545.868713378906</c:v>
                </c:pt>
                <c:pt idx="2116">
                  <c:v>48542.619445800781</c:v>
                </c:pt>
                <c:pt idx="2117">
                  <c:v>48530.19873046875</c:v>
                </c:pt>
                <c:pt idx="2118">
                  <c:v>48513.892333984375</c:v>
                </c:pt>
                <c:pt idx="2119">
                  <c:v>48502.785888671875</c:v>
                </c:pt>
                <c:pt idx="2120">
                  <c:v>48492.879486083984</c:v>
                </c:pt>
                <c:pt idx="2121">
                  <c:v>48469.944488525391</c:v>
                </c:pt>
                <c:pt idx="2122">
                  <c:v>48448.895233154297</c:v>
                </c:pt>
                <c:pt idx="2123">
                  <c:v>48443.103088378906</c:v>
                </c:pt>
                <c:pt idx="2124">
                  <c:v>48438.196685791016</c:v>
                </c:pt>
                <c:pt idx="2125">
                  <c:v>48412.318817138672</c:v>
                </c:pt>
                <c:pt idx="2126">
                  <c:v>48380.983856201172</c:v>
                </c:pt>
                <c:pt idx="2127">
                  <c:v>48367.734558105469</c:v>
                </c:pt>
                <c:pt idx="2128">
                  <c:v>48365.999572753906</c:v>
                </c:pt>
                <c:pt idx="2129">
                  <c:v>48363.4931640625</c:v>
                </c:pt>
                <c:pt idx="2130">
                  <c:v>48354.158172607422</c:v>
                </c:pt>
                <c:pt idx="2131">
                  <c:v>48347.508911132813</c:v>
                </c:pt>
                <c:pt idx="2132">
                  <c:v>48347.602508544922</c:v>
                </c:pt>
                <c:pt idx="2133">
                  <c:v>48350.096069335938</c:v>
                </c:pt>
                <c:pt idx="2134">
                  <c:v>48339.932525634766</c:v>
                </c:pt>
                <c:pt idx="2135">
                  <c:v>48321.597534179688</c:v>
                </c:pt>
                <c:pt idx="2136">
                  <c:v>48309.005401611328</c:v>
                </c:pt>
                <c:pt idx="2137">
                  <c:v>48306.098999023438</c:v>
                </c:pt>
                <c:pt idx="2138">
                  <c:v>48305.963989257813</c:v>
                </c:pt>
                <c:pt idx="2139">
                  <c:v>48306.343292236328</c:v>
                </c:pt>
                <c:pt idx="2140">
                  <c:v>48313.494018554688</c:v>
                </c:pt>
                <c:pt idx="2141">
                  <c:v>48321.901885986328</c:v>
                </c:pt>
                <c:pt idx="2142">
                  <c:v>48322.052612304688</c:v>
                </c:pt>
                <c:pt idx="2143">
                  <c:v>48311.146209716797</c:v>
                </c:pt>
                <c:pt idx="2144">
                  <c:v>48297.039794921875</c:v>
                </c:pt>
                <c:pt idx="2145">
                  <c:v>48286.819091796875</c:v>
                </c:pt>
                <c:pt idx="2146">
                  <c:v>48285.741241455078</c:v>
                </c:pt>
                <c:pt idx="2147">
                  <c:v>48295.377685546875</c:v>
                </c:pt>
                <c:pt idx="2148">
                  <c:v>48299.756988525391</c:v>
                </c:pt>
                <c:pt idx="2149">
                  <c:v>48284.936279296875</c:v>
                </c:pt>
                <c:pt idx="2150">
                  <c:v>48257.201293945313</c:v>
                </c:pt>
                <c:pt idx="2151">
                  <c:v>48234.523452758789</c:v>
                </c:pt>
                <c:pt idx="2152">
                  <c:v>48230.988464355469</c:v>
                </c:pt>
                <c:pt idx="2153">
                  <c:v>48240.33918762207</c:v>
                </c:pt>
                <c:pt idx="2154">
                  <c:v>48242.261352539063</c:v>
                </c:pt>
                <c:pt idx="2155">
                  <c:v>48230.440643310547</c:v>
                </c:pt>
                <c:pt idx="2156">
                  <c:v>48217.334228515625</c:v>
                </c:pt>
                <c:pt idx="2157">
                  <c:v>48212.627822875977</c:v>
                </c:pt>
                <c:pt idx="2158">
                  <c:v>48211.949966430664</c:v>
                </c:pt>
                <c:pt idx="2159">
                  <c:v>48204.672134399414</c:v>
                </c:pt>
                <c:pt idx="2160">
                  <c:v>48186.994293212891</c:v>
                </c:pt>
                <c:pt idx="2161">
                  <c:v>48171.545013427734</c:v>
                </c:pt>
                <c:pt idx="2162">
                  <c:v>48172.010025024414</c:v>
                </c:pt>
                <c:pt idx="2163">
                  <c:v>48182.932174682617</c:v>
                </c:pt>
                <c:pt idx="2164">
                  <c:v>48192.397201538086</c:v>
                </c:pt>
                <c:pt idx="2165">
                  <c:v>48200.233642578125</c:v>
                </c:pt>
                <c:pt idx="2166">
                  <c:v>48207.070083618164</c:v>
                </c:pt>
                <c:pt idx="2167">
                  <c:v>48210.649383544922</c:v>
                </c:pt>
                <c:pt idx="2168">
                  <c:v>48213.628677368164</c:v>
                </c:pt>
                <c:pt idx="2169">
                  <c:v>48217.665115356445</c:v>
                </c:pt>
                <c:pt idx="2170">
                  <c:v>48224.558700561523</c:v>
                </c:pt>
                <c:pt idx="2171">
                  <c:v>48232.309432983398</c:v>
                </c:pt>
                <c:pt idx="2172">
                  <c:v>48233.231582641602</c:v>
                </c:pt>
                <c:pt idx="2173">
                  <c:v>48222.839447021484</c:v>
                </c:pt>
                <c:pt idx="2174">
                  <c:v>48205.390182495117</c:v>
                </c:pt>
                <c:pt idx="2175">
                  <c:v>48194.540908813477</c:v>
                </c:pt>
                <c:pt idx="2176">
                  <c:v>48196.03450012207</c:v>
                </c:pt>
                <c:pt idx="2177">
                  <c:v>48206.585220336914</c:v>
                </c:pt>
                <c:pt idx="2178">
                  <c:v>48213.250228881836</c:v>
                </c:pt>
                <c:pt idx="2179">
                  <c:v>48209.886672973633</c:v>
                </c:pt>
                <c:pt idx="2180">
                  <c:v>48197.437408447266</c:v>
                </c:pt>
                <c:pt idx="2181">
                  <c:v>48184.273849487305</c:v>
                </c:pt>
                <c:pt idx="2182">
                  <c:v>48175.567428588867</c:v>
                </c:pt>
                <c:pt idx="2183">
                  <c:v>48172.832443237305</c:v>
                </c:pt>
                <c:pt idx="2184">
                  <c:v>48169.811737060547</c:v>
                </c:pt>
                <c:pt idx="2185">
                  <c:v>48167.36247253418</c:v>
                </c:pt>
                <c:pt idx="2186">
                  <c:v>48174.541763305664</c:v>
                </c:pt>
                <c:pt idx="2187">
                  <c:v>48185.778213500977</c:v>
                </c:pt>
                <c:pt idx="2188">
                  <c:v>48186.271789550781</c:v>
                </c:pt>
                <c:pt idx="2189">
                  <c:v>48172.593948364258</c:v>
                </c:pt>
                <c:pt idx="2190">
                  <c:v>48160.516098022461</c:v>
                </c:pt>
                <c:pt idx="2191">
                  <c:v>48153.3525390625</c:v>
                </c:pt>
                <c:pt idx="2192">
                  <c:v>48155.446136474609</c:v>
                </c:pt>
                <c:pt idx="2193">
                  <c:v>48163.711135864258</c:v>
                </c:pt>
                <c:pt idx="2194">
                  <c:v>48170.919006347656</c:v>
                </c:pt>
                <c:pt idx="2195">
                  <c:v>48168.812591552734</c:v>
                </c:pt>
                <c:pt idx="2196">
                  <c:v>48163.220474243164</c:v>
                </c:pt>
                <c:pt idx="2197">
                  <c:v>48155.799758911133</c:v>
                </c:pt>
                <c:pt idx="2198">
                  <c:v>48142.693344116211</c:v>
                </c:pt>
                <c:pt idx="2199">
                  <c:v>48129.358367919922</c:v>
                </c:pt>
                <c:pt idx="2200">
                  <c:v>48130.337661743164</c:v>
                </c:pt>
                <c:pt idx="2201">
                  <c:v>48147.402679443359</c:v>
                </c:pt>
                <c:pt idx="2202">
                  <c:v>48161.610549926758</c:v>
                </c:pt>
                <c:pt idx="2203">
                  <c:v>48164.361267089844</c:v>
                </c:pt>
                <c:pt idx="2204">
                  <c:v>48158.997711181641</c:v>
                </c:pt>
                <c:pt idx="2205">
                  <c:v>48152.491302490234</c:v>
                </c:pt>
                <c:pt idx="2206">
                  <c:v>48146.070602416992</c:v>
                </c:pt>
                <c:pt idx="2207">
                  <c:v>48147.678466796875</c:v>
                </c:pt>
                <c:pt idx="2208">
                  <c:v>48159.886337280273</c:v>
                </c:pt>
                <c:pt idx="2209">
                  <c:v>48173.294204711914</c:v>
                </c:pt>
                <c:pt idx="2210">
                  <c:v>48170.930648803711</c:v>
                </c:pt>
                <c:pt idx="2211">
                  <c:v>48159.76708984375</c:v>
                </c:pt>
                <c:pt idx="2212">
                  <c:v>48152.489242553711</c:v>
                </c:pt>
                <c:pt idx="2213">
                  <c:v>48150.782836914063</c:v>
                </c:pt>
                <c:pt idx="2214">
                  <c:v>48148.019271850586</c:v>
                </c:pt>
                <c:pt idx="2215">
                  <c:v>48151.427139282227</c:v>
                </c:pt>
                <c:pt idx="2216">
                  <c:v>48159.063583374023</c:v>
                </c:pt>
                <c:pt idx="2217">
                  <c:v>48161.214309692383</c:v>
                </c:pt>
                <c:pt idx="2218">
                  <c:v>48161.593612670898</c:v>
                </c:pt>
                <c:pt idx="2219">
                  <c:v>48168.372909545898</c:v>
                </c:pt>
                <c:pt idx="2220">
                  <c:v>48180.009353637695</c:v>
                </c:pt>
                <c:pt idx="2221">
                  <c:v>48187.731506347656</c:v>
                </c:pt>
                <c:pt idx="2222">
                  <c:v>48190.567947387695</c:v>
                </c:pt>
                <c:pt idx="2223">
                  <c:v>48189.804382324219</c:v>
                </c:pt>
                <c:pt idx="2224">
                  <c:v>48188.126541137695</c:v>
                </c:pt>
                <c:pt idx="2225">
                  <c:v>48185.134414672852</c:v>
                </c:pt>
                <c:pt idx="2226">
                  <c:v>48183.570861816406</c:v>
                </c:pt>
                <c:pt idx="2227">
                  <c:v>48181.43586730957</c:v>
                </c:pt>
                <c:pt idx="2228">
                  <c:v>48176.015167236328</c:v>
                </c:pt>
                <c:pt idx="2229">
                  <c:v>48161.765899658203</c:v>
                </c:pt>
                <c:pt idx="2230">
                  <c:v>48151.316619873047</c:v>
                </c:pt>
                <c:pt idx="2231">
                  <c:v>48157.524490356445</c:v>
                </c:pt>
                <c:pt idx="2232">
                  <c:v>48173.189498901367</c:v>
                </c:pt>
                <c:pt idx="2233">
                  <c:v>48178.568801879883</c:v>
                </c:pt>
                <c:pt idx="2234">
                  <c:v>48169.462387084961</c:v>
                </c:pt>
                <c:pt idx="2235">
                  <c:v>48151.727401733398</c:v>
                </c:pt>
                <c:pt idx="2236">
                  <c:v>48139.649551391602</c:v>
                </c:pt>
                <c:pt idx="2237">
                  <c:v>48138.371719360352</c:v>
                </c:pt>
                <c:pt idx="2238">
                  <c:v>48139.322448730469</c:v>
                </c:pt>
                <c:pt idx="2239">
                  <c:v>48131.187454223633</c:v>
                </c:pt>
                <c:pt idx="2240">
                  <c:v>48118.48104095459</c:v>
                </c:pt>
                <c:pt idx="2241">
                  <c:v>48113.631767272949</c:v>
                </c:pt>
                <c:pt idx="2242">
                  <c:v>48122.411064147949</c:v>
                </c:pt>
                <c:pt idx="2243">
                  <c:v>48135.704650878906</c:v>
                </c:pt>
                <c:pt idx="2244">
                  <c:v>48135.826812744141</c:v>
                </c:pt>
                <c:pt idx="2245">
                  <c:v>48122.006103515625</c:v>
                </c:pt>
                <c:pt idx="2246">
                  <c:v>48112.013977050781</c:v>
                </c:pt>
                <c:pt idx="2247">
                  <c:v>48117.136131286621</c:v>
                </c:pt>
                <c:pt idx="2248">
                  <c:v>48118.65828704834</c:v>
                </c:pt>
                <c:pt idx="2249">
                  <c:v>48107.723297119141</c:v>
                </c:pt>
                <c:pt idx="2250">
                  <c:v>48101.159736633301</c:v>
                </c:pt>
                <c:pt idx="2251">
                  <c:v>48108.910469055176</c:v>
                </c:pt>
                <c:pt idx="2252">
                  <c:v>48116.546905517578</c:v>
                </c:pt>
                <c:pt idx="2253">
                  <c:v>48113.611923217773</c:v>
                </c:pt>
                <c:pt idx="2254">
                  <c:v>48116.305503845215</c:v>
                </c:pt>
                <c:pt idx="2255">
                  <c:v>48127.113380432129</c:v>
                </c:pt>
                <c:pt idx="2256">
                  <c:v>48142.264099121094</c:v>
                </c:pt>
                <c:pt idx="2257">
                  <c:v>48150.643402099609</c:v>
                </c:pt>
                <c:pt idx="2258">
                  <c:v>48151.022705078125</c:v>
                </c:pt>
                <c:pt idx="2259">
                  <c:v>48143.687713623047</c:v>
                </c:pt>
                <c:pt idx="2260">
                  <c:v>48134.124160766602</c:v>
                </c:pt>
                <c:pt idx="2261">
                  <c:v>48128.589172363281</c:v>
                </c:pt>
                <c:pt idx="2262">
                  <c:v>48127.282752990723</c:v>
                </c:pt>
                <c:pt idx="2263">
                  <c:v>48124.376335144043</c:v>
                </c:pt>
                <c:pt idx="2264">
                  <c:v>48118.441352844238</c:v>
                </c:pt>
                <c:pt idx="2265">
                  <c:v>48113.649223327637</c:v>
                </c:pt>
                <c:pt idx="2266">
                  <c:v>48117.085662841797</c:v>
                </c:pt>
                <c:pt idx="2267">
                  <c:v>48124.150672912598</c:v>
                </c:pt>
                <c:pt idx="2268">
                  <c:v>48124.815689086914</c:v>
                </c:pt>
                <c:pt idx="2269">
                  <c:v>48116.852127075195</c:v>
                </c:pt>
                <c:pt idx="2270">
                  <c:v>48110.831428527832</c:v>
                </c:pt>
                <c:pt idx="2271">
                  <c:v>48106.239295959473</c:v>
                </c:pt>
                <c:pt idx="2272">
                  <c:v>48102.50431060791</c:v>
                </c:pt>
                <c:pt idx="2273">
                  <c:v>48097.769325256348</c:v>
                </c:pt>
                <c:pt idx="2274">
                  <c:v>48093.605766296387</c:v>
                </c:pt>
                <c:pt idx="2275">
                  <c:v>48090.242210388184</c:v>
                </c:pt>
                <c:pt idx="2276">
                  <c:v>48090.478652954102</c:v>
                </c:pt>
                <c:pt idx="2277">
                  <c:v>48092.486518859863</c:v>
                </c:pt>
                <c:pt idx="2278">
                  <c:v>48096.49439239502</c:v>
                </c:pt>
                <c:pt idx="2279">
                  <c:v>48104.645118713379</c:v>
                </c:pt>
                <c:pt idx="2280">
                  <c:v>48108.36727142334</c:v>
                </c:pt>
                <c:pt idx="2281">
                  <c:v>48103.746574401855</c:v>
                </c:pt>
                <c:pt idx="2282">
                  <c:v>48100.754440307617</c:v>
                </c:pt>
                <c:pt idx="2283">
                  <c:v>48105.162315368652</c:v>
                </c:pt>
                <c:pt idx="2284">
                  <c:v>48109.998756408691</c:v>
                </c:pt>
                <c:pt idx="2285">
                  <c:v>48109.578048706055</c:v>
                </c:pt>
                <c:pt idx="2286">
                  <c:v>48107.814491271973</c:v>
                </c:pt>
                <c:pt idx="2287">
                  <c:v>48102.76522064209</c:v>
                </c:pt>
                <c:pt idx="2288">
                  <c:v>48092.601661682129</c:v>
                </c:pt>
                <c:pt idx="2289">
                  <c:v>48082.180961608887</c:v>
                </c:pt>
                <c:pt idx="2290">
                  <c:v>48074.788833618164</c:v>
                </c:pt>
                <c:pt idx="2291">
                  <c:v>48078.482414245605</c:v>
                </c:pt>
                <c:pt idx="2292">
                  <c:v>48091.461715698242</c:v>
                </c:pt>
                <c:pt idx="2293">
                  <c:v>48104.269584655762</c:v>
                </c:pt>
                <c:pt idx="2294">
                  <c:v>48105.13459777832</c:v>
                </c:pt>
                <c:pt idx="2295">
                  <c:v>48103.856750488281</c:v>
                </c:pt>
                <c:pt idx="2296">
                  <c:v>48104.893196105957</c:v>
                </c:pt>
                <c:pt idx="2297">
                  <c:v>48105.415351867676</c:v>
                </c:pt>
                <c:pt idx="2298">
                  <c:v>48098.051795959473</c:v>
                </c:pt>
                <c:pt idx="2299">
                  <c:v>48086.973945617676</c:v>
                </c:pt>
                <c:pt idx="2300">
                  <c:v>48079.953247070313</c:v>
                </c:pt>
                <c:pt idx="2301">
                  <c:v>48083.046829223633</c:v>
                </c:pt>
                <c:pt idx="2302">
                  <c:v>48094.483276367188</c:v>
                </c:pt>
                <c:pt idx="2303">
                  <c:v>48109.976860046387</c:v>
                </c:pt>
                <c:pt idx="2304">
                  <c:v>48120.099014282227</c:v>
                </c:pt>
                <c:pt idx="2305">
                  <c:v>48124.564025878906</c:v>
                </c:pt>
                <c:pt idx="2306">
                  <c:v>48124.800468444824</c:v>
                </c:pt>
                <c:pt idx="2307">
                  <c:v>48124.294052124023</c:v>
                </c:pt>
                <c:pt idx="2308">
                  <c:v>48119.844779968262</c:v>
                </c:pt>
                <c:pt idx="2309">
                  <c:v>48113.681221008301</c:v>
                </c:pt>
                <c:pt idx="2310">
                  <c:v>48114.660522460938</c:v>
                </c:pt>
                <c:pt idx="2311">
                  <c:v>48122.068389892578</c:v>
                </c:pt>
                <c:pt idx="2312">
                  <c:v>48125.104827880859</c:v>
                </c:pt>
                <c:pt idx="2313">
                  <c:v>48121.141273498535</c:v>
                </c:pt>
                <c:pt idx="2314">
                  <c:v>48125.206283569336</c:v>
                </c:pt>
                <c:pt idx="2315">
                  <c:v>48140.01416015625</c:v>
                </c:pt>
                <c:pt idx="2316">
                  <c:v>48150.307739257813</c:v>
                </c:pt>
                <c:pt idx="2317">
                  <c:v>48147.029891967773</c:v>
                </c:pt>
                <c:pt idx="2318">
                  <c:v>48136.323486328125</c:v>
                </c:pt>
                <c:pt idx="2319">
                  <c:v>48131.674209594727</c:v>
                </c:pt>
                <c:pt idx="2320">
                  <c:v>48137.167785644531</c:v>
                </c:pt>
                <c:pt idx="2321">
                  <c:v>48142.432800292969</c:v>
                </c:pt>
                <c:pt idx="2322">
                  <c:v>48140.440673828125</c:v>
                </c:pt>
                <c:pt idx="2323">
                  <c:v>48135.562835693359</c:v>
                </c:pt>
                <c:pt idx="2324">
                  <c:v>48129.627838134766</c:v>
                </c:pt>
                <c:pt idx="2325">
                  <c:v>48120.978569030762</c:v>
                </c:pt>
                <c:pt idx="2326">
                  <c:v>48112.815010070801</c:v>
                </c:pt>
                <c:pt idx="2327">
                  <c:v>48112.222885131836</c:v>
                </c:pt>
                <c:pt idx="2328">
                  <c:v>48118.002182006836</c:v>
                </c:pt>
                <c:pt idx="2329">
                  <c:v>48124.124336242676</c:v>
                </c:pt>
                <c:pt idx="2330">
                  <c:v>48128.189346313477</c:v>
                </c:pt>
                <c:pt idx="2331">
                  <c:v>48130.68293762207</c:v>
                </c:pt>
                <c:pt idx="2332">
                  <c:v>48135.290802001953</c:v>
                </c:pt>
                <c:pt idx="2333">
                  <c:v>48139.184387207031</c:v>
                </c:pt>
                <c:pt idx="2334">
                  <c:v>48137.906539916992</c:v>
                </c:pt>
                <c:pt idx="2335">
                  <c:v>48140.914413452148</c:v>
                </c:pt>
                <c:pt idx="2336">
                  <c:v>48157.836578369141</c:v>
                </c:pt>
                <c:pt idx="2337">
                  <c:v>48178.587295532227</c:v>
                </c:pt>
                <c:pt idx="2338">
                  <c:v>48180.280883789063</c:v>
                </c:pt>
                <c:pt idx="2339">
                  <c:v>48166.831604003906</c:v>
                </c:pt>
                <c:pt idx="2340">
                  <c:v>48156.468048095703</c:v>
                </c:pt>
                <c:pt idx="2341">
                  <c:v>48154.504486083984</c:v>
                </c:pt>
                <c:pt idx="2342">
                  <c:v>48154.312362670898</c:v>
                </c:pt>
                <c:pt idx="2343">
                  <c:v>48150.091659545898</c:v>
                </c:pt>
                <c:pt idx="2344">
                  <c:v>48145.75666809082</c:v>
                </c:pt>
                <c:pt idx="2345">
                  <c:v>48149.535980224609</c:v>
                </c:pt>
                <c:pt idx="2346">
                  <c:v>48166.772415161133</c:v>
                </c:pt>
                <c:pt idx="2347">
                  <c:v>48184.208862304688</c:v>
                </c:pt>
                <c:pt idx="2348">
                  <c:v>48186.159591674805</c:v>
                </c:pt>
                <c:pt idx="2349">
                  <c:v>48171.453170776367</c:v>
                </c:pt>
                <c:pt idx="2350">
                  <c:v>48154.832473754883</c:v>
                </c:pt>
                <c:pt idx="2351">
                  <c:v>48147.383193969727</c:v>
                </c:pt>
                <c:pt idx="2352">
                  <c:v>48152.591064453125</c:v>
                </c:pt>
                <c:pt idx="2353">
                  <c:v>48165.741790771484</c:v>
                </c:pt>
                <c:pt idx="2354">
                  <c:v>48177.721084594727</c:v>
                </c:pt>
                <c:pt idx="2355">
                  <c:v>48179.328964233398</c:v>
                </c:pt>
                <c:pt idx="2356">
                  <c:v>48170.6796875</c:v>
                </c:pt>
                <c:pt idx="2357">
                  <c:v>48163.258987426758</c:v>
                </c:pt>
                <c:pt idx="2358">
                  <c:v>48162.438278198242</c:v>
                </c:pt>
                <c:pt idx="2359">
                  <c:v>48163.931869506836</c:v>
                </c:pt>
                <c:pt idx="2360">
                  <c:v>48167.225448608398</c:v>
                </c:pt>
                <c:pt idx="2361">
                  <c:v>48171.004760742188</c:v>
                </c:pt>
                <c:pt idx="2362">
                  <c:v>48172.326904296875</c:v>
                </c:pt>
                <c:pt idx="2363">
                  <c:v>48172.991928100586</c:v>
                </c:pt>
                <c:pt idx="2364">
                  <c:v>48178.571228027344</c:v>
                </c:pt>
                <c:pt idx="2365">
                  <c:v>48183.750518798828</c:v>
                </c:pt>
                <c:pt idx="2366">
                  <c:v>48187.529815673828</c:v>
                </c:pt>
                <c:pt idx="2367">
                  <c:v>48190.851974487305</c:v>
                </c:pt>
                <c:pt idx="2368">
                  <c:v>48185.659851074219</c:v>
                </c:pt>
                <c:pt idx="2369">
                  <c:v>48171.296279907227</c:v>
                </c:pt>
                <c:pt idx="2370">
                  <c:v>48160.589874267578</c:v>
                </c:pt>
                <c:pt idx="2371">
                  <c:v>48163.626312255859</c:v>
                </c:pt>
                <c:pt idx="2372">
                  <c:v>48171.977035522461</c:v>
                </c:pt>
                <c:pt idx="2373">
                  <c:v>48177.013473510742</c:v>
                </c:pt>
                <c:pt idx="2374">
                  <c:v>48177.90705871582</c:v>
                </c:pt>
                <c:pt idx="2375">
                  <c:v>48179.286361694336</c:v>
                </c:pt>
                <c:pt idx="2376">
                  <c:v>48183.265655517578</c:v>
                </c:pt>
                <c:pt idx="2377">
                  <c:v>48181.844955444336</c:v>
                </c:pt>
                <c:pt idx="2378">
                  <c:v>48170.481399536133</c:v>
                </c:pt>
                <c:pt idx="2379">
                  <c:v>48154.032135009766</c:v>
                </c:pt>
                <c:pt idx="2380">
                  <c:v>48149.839996337891</c:v>
                </c:pt>
                <c:pt idx="2381">
                  <c:v>48157.705017089844</c:v>
                </c:pt>
                <c:pt idx="2382">
                  <c:v>48170.912887573242</c:v>
                </c:pt>
                <c:pt idx="2383">
                  <c:v>48182.206466674805</c:v>
                </c:pt>
                <c:pt idx="2384">
                  <c:v>48189.700057983398</c:v>
                </c:pt>
                <c:pt idx="2385">
                  <c:v>48188.479354858398</c:v>
                </c:pt>
                <c:pt idx="2386">
                  <c:v>48185.14436340332</c:v>
                </c:pt>
                <c:pt idx="2387">
                  <c:v>48178.152236938477</c:v>
                </c:pt>
                <c:pt idx="2388">
                  <c:v>48171.188674926758</c:v>
                </c:pt>
                <c:pt idx="2389">
                  <c:v>48166.682266235352</c:v>
                </c:pt>
                <c:pt idx="2390">
                  <c:v>48166.318695068359</c:v>
                </c:pt>
                <c:pt idx="2391">
                  <c:v>48168.298004150391</c:v>
                </c:pt>
                <c:pt idx="2392">
                  <c:v>48172.505874633789</c:v>
                </c:pt>
                <c:pt idx="2393">
                  <c:v>48176.91374206543</c:v>
                </c:pt>
                <c:pt idx="2394">
                  <c:v>48173.635894775391</c:v>
                </c:pt>
                <c:pt idx="2395">
                  <c:v>48167.443771362305</c:v>
                </c:pt>
                <c:pt idx="2396">
                  <c:v>48162.108779907227</c:v>
                </c:pt>
                <c:pt idx="2397">
                  <c:v>48159.430938720703</c:v>
                </c:pt>
                <c:pt idx="2398">
                  <c:v>48157.38166809082</c:v>
                </c:pt>
                <c:pt idx="2399">
                  <c:v>48152.418106079102</c:v>
                </c:pt>
                <c:pt idx="2400">
                  <c:v>48148.254547119141</c:v>
                </c:pt>
                <c:pt idx="2401">
                  <c:v>48153.290985107422</c:v>
                </c:pt>
                <c:pt idx="2402">
                  <c:v>48167.127426147461</c:v>
                </c:pt>
                <c:pt idx="2403">
                  <c:v>48175.221008300781</c:v>
                </c:pt>
                <c:pt idx="2404">
                  <c:v>48165.800308227539</c:v>
                </c:pt>
                <c:pt idx="2405">
                  <c:v>48150.865325927734</c:v>
                </c:pt>
                <c:pt idx="2406">
                  <c:v>48141.330337524414</c:v>
                </c:pt>
                <c:pt idx="2407">
                  <c:v>48141.309631347656</c:v>
                </c:pt>
                <c:pt idx="2408">
                  <c:v>48146.917510986328</c:v>
                </c:pt>
                <c:pt idx="2409">
                  <c:v>48153.753952026367</c:v>
                </c:pt>
                <c:pt idx="2410">
                  <c:v>48159.218963623047</c:v>
                </c:pt>
                <c:pt idx="2411">
                  <c:v>48160.741119384766</c:v>
                </c:pt>
                <c:pt idx="2412">
                  <c:v>48152.263275146484</c:v>
                </c:pt>
                <c:pt idx="2413">
                  <c:v>48132.299713134766</c:v>
                </c:pt>
                <c:pt idx="2414">
                  <c:v>48119.879013061523</c:v>
                </c:pt>
                <c:pt idx="2415">
                  <c:v>48125.772598266602</c:v>
                </c:pt>
                <c:pt idx="2416">
                  <c:v>48134.723327636719</c:v>
                </c:pt>
                <c:pt idx="2417">
                  <c:v>48137.045486450195</c:v>
                </c:pt>
                <c:pt idx="2418">
                  <c:v>48135.710494995117</c:v>
                </c:pt>
                <c:pt idx="2419">
                  <c:v>48136.775512695313</c:v>
                </c:pt>
                <c:pt idx="2420">
                  <c:v>48137.35481262207</c:v>
                </c:pt>
                <c:pt idx="2421">
                  <c:v>48132.191253662109</c:v>
                </c:pt>
                <c:pt idx="2422">
                  <c:v>48123.599113464355</c:v>
                </c:pt>
                <c:pt idx="2423">
                  <c:v>48120.978416442871</c:v>
                </c:pt>
                <c:pt idx="2424">
                  <c:v>48128.357711791992</c:v>
                </c:pt>
                <c:pt idx="2425">
                  <c:v>48138.337005615234</c:v>
                </c:pt>
                <c:pt idx="2426">
                  <c:v>48144.887741088867</c:v>
                </c:pt>
                <c:pt idx="2427">
                  <c:v>48142.695617675781</c:v>
                </c:pt>
                <c:pt idx="2428">
                  <c:v>48136.846343994141</c:v>
                </c:pt>
                <c:pt idx="2429">
                  <c:v>48133.568496704102</c:v>
                </c:pt>
                <c:pt idx="2430">
                  <c:v>48133.519226074219</c:v>
                </c:pt>
                <c:pt idx="2431">
                  <c:v>48132.641372680664</c:v>
                </c:pt>
                <c:pt idx="2432">
                  <c:v>48135.734954833984</c:v>
                </c:pt>
                <c:pt idx="2433">
                  <c:v>48140.685684204102</c:v>
                </c:pt>
                <c:pt idx="2434">
                  <c:v>48147.722137451172</c:v>
                </c:pt>
                <c:pt idx="2435">
                  <c:v>48152.272857666016</c:v>
                </c:pt>
                <c:pt idx="2436">
                  <c:v>48151.680725097656</c:v>
                </c:pt>
                <c:pt idx="2437">
                  <c:v>48143.602890014648</c:v>
                </c:pt>
                <c:pt idx="2438">
                  <c:v>48137.325042724609</c:v>
                </c:pt>
                <c:pt idx="2439">
                  <c:v>48130.218627929688</c:v>
                </c:pt>
                <c:pt idx="2440">
                  <c:v>48122.683639526367</c:v>
                </c:pt>
                <c:pt idx="2441">
                  <c:v>48115.720077514648</c:v>
                </c:pt>
                <c:pt idx="2442">
                  <c:v>48113.499374389648</c:v>
                </c:pt>
                <c:pt idx="2443">
                  <c:v>48108.021530151367</c:v>
                </c:pt>
                <c:pt idx="2444">
                  <c:v>48101.286544799805</c:v>
                </c:pt>
                <c:pt idx="2445">
                  <c:v>48103.837272644043</c:v>
                </c:pt>
                <c:pt idx="2446">
                  <c:v>48117.388000488281</c:v>
                </c:pt>
                <c:pt idx="2447">
                  <c:v>48132.053009033203</c:v>
                </c:pt>
                <c:pt idx="2448">
                  <c:v>48139.060882568359</c:v>
                </c:pt>
                <c:pt idx="2449">
                  <c:v>48132.811614990234</c:v>
                </c:pt>
                <c:pt idx="2450">
                  <c:v>48113.676620483398</c:v>
                </c:pt>
                <c:pt idx="2451">
                  <c:v>48096.655921936035</c:v>
                </c:pt>
                <c:pt idx="2452">
                  <c:v>48091.892364501953</c:v>
                </c:pt>
                <c:pt idx="2453">
                  <c:v>48090.728805541992</c:v>
                </c:pt>
                <c:pt idx="2454">
                  <c:v>48087.30810546875</c:v>
                </c:pt>
                <c:pt idx="2455">
                  <c:v>48087.315971374512</c:v>
                </c:pt>
                <c:pt idx="2456">
                  <c:v>48088.923843383789</c:v>
                </c:pt>
                <c:pt idx="2457">
                  <c:v>48083.103141784668</c:v>
                </c:pt>
                <c:pt idx="2458">
                  <c:v>48072.168159484863</c:v>
                </c:pt>
                <c:pt idx="2459">
                  <c:v>48073.918884277344</c:v>
                </c:pt>
                <c:pt idx="2460">
                  <c:v>48092.983894348145</c:v>
                </c:pt>
                <c:pt idx="2461">
                  <c:v>48113.134620666504</c:v>
                </c:pt>
                <c:pt idx="2462">
                  <c:v>48115.742492675781</c:v>
                </c:pt>
                <c:pt idx="2463">
                  <c:v>48103.636077880859</c:v>
                </c:pt>
                <c:pt idx="2464">
                  <c:v>48092.01537322998</c:v>
                </c:pt>
                <c:pt idx="2465">
                  <c:v>48087.708961486816</c:v>
                </c:pt>
                <c:pt idx="2466">
                  <c:v>48084.888259887695</c:v>
                </c:pt>
                <c:pt idx="2467">
                  <c:v>48072.667556762695</c:v>
                </c:pt>
                <c:pt idx="2468">
                  <c:v>48061.961143493652</c:v>
                </c:pt>
                <c:pt idx="2469">
                  <c:v>48061.826156616211</c:v>
                </c:pt>
                <c:pt idx="2470">
                  <c:v>48067.034027099609</c:v>
                </c:pt>
                <c:pt idx="2471">
                  <c:v>48069.013320922852</c:v>
                </c:pt>
                <c:pt idx="2472">
                  <c:v>48073.135482788086</c:v>
                </c:pt>
                <c:pt idx="2473">
                  <c:v>48079.943351745605</c:v>
                </c:pt>
                <c:pt idx="2474">
                  <c:v>48079.779792785645</c:v>
                </c:pt>
                <c:pt idx="2475">
                  <c:v>48077.044807434082</c:v>
                </c:pt>
                <c:pt idx="2476">
                  <c:v>48081.452674865723</c:v>
                </c:pt>
                <c:pt idx="2477">
                  <c:v>48089.117691040039</c:v>
                </c:pt>
                <c:pt idx="2478">
                  <c:v>48089.096984863281</c:v>
                </c:pt>
                <c:pt idx="2479">
                  <c:v>48083.247711181641</c:v>
                </c:pt>
                <c:pt idx="2480">
                  <c:v>48077.08415222168</c:v>
                </c:pt>
                <c:pt idx="2481">
                  <c:v>48072.663452148438</c:v>
                </c:pt>
                <c:pt idx="2482">
                  <c:v>48069.471321105957</c:v>
                </c:pt>
                <c:pt idx="2483">
                  <c:v>48071.764907836914</c:v>
                </c:pt>
                <c:pt idx="2484">
                  <c:v>48076.315635681152</c:v>
                </c:pt>
                <c:pt idx="2485">
                  <c:v>48080.609222412109</c:v>
                </c:pt>
                <c:pt idx="2486">
                  <c:v>48077.788520812988</c:v>
                </c:pt>
                <c:pt idx="2487">
                  <c:v>48072.910675048828</c:v>
                </c:pt>
                <c:pt idx="2488">
                  <c:v>48078.289970397949</c:v>
                </c:pt>
                <c:pt idx="2489">
                  <c:v>48093.326416015625</c:v>
                </c:pt>
                <c:pt idx="2490">
                  <c:v>48097.905715942383</c:v>
                </c:pt>
                <c:pt idx="2491">
                  <c:v>48086.713584899902</c:v>
                </c:pt>
                <c:pt idx="2492">
                  <c:v>48071.97859954834</c:v>
                </c:pt>
                <c:pt idx="2493">
                  <c:v>48067.900756835938</c:v>
                </c:pt>
                <c:pt idx="2494">
                  <c:v>48073.765769958496</c:v>
                </c:pt>
                <c:pt idx="2495">
                  <c:v>48080.373634338379</c:v>
                </c:pt>
                <c:pt idx="2496">
                  <c:v>48082.581504821777</c:v>
                </c:pt>
                <c:pt idx="2497">
                  <c:v>48089.703659057617</c:v>
                </c:pt>
                <c:pt idx="2498">
                  <c:v>48100.825820922852</c:v>
                </c:pt>
                <c:pt idx="2499">
                  <c:v>48100.69083404541</c:v>
                </c:pt>
                <c:pt idx="2500">
                  <c:v>48087.355842590332</c:v>
                </c:pt>
                <c:pt idx="2501">
                  <c:v>48080.763717651367</c:v>
                </c:pt>
                <c:pt idx="2502">
                  <c:v>48084.257301330566</c:v>
                </c:pt>
                <c:pt idx="2503">
                  <c:v>48094.17945098877</c:v>
                </c:pt>
                <c:pt idx="2504">
                  <c:v>48105.215896606445</c:v>
                </c:pt>
                <c:pt idx="2505">
                  <c:v>48110.623764038086</c:v>
                </c:pt>
                <c:pt idx="2506">
                  <c:v>48102.831634521484</c:v>
                </c:pt>
                <c:pt idx="2507">
                  <c:v>48093.125221252441</c:v>
                </c:pt>
                <c:pt idx="2508">
                  <c:v>48094.33309173584</c:v>
                </c:pt>
                <c:pt idx="2509">
                  <c:v>48100.226676940918</c:v>
                </c:pt>
                <c:pt idx="2510">
                  <c:v>48101.434547424316</c:v>
                </c:pt>
                <c:pt idx="2511">
                  <c:v>48096.699562072754</c:v>
                </c:pt>
                <c:pt idx="2512">
                  <c:v>48088.793144226074</c:v>
                </c:pt>
                <c:pt idx="2513">
                  <c:v>48076.343872070313</c:v>
                </c:pt>
                <c:pt idx="2514">
                  <c:v>48062.494598388672</c:v>
                </c:pt>
                <c:pt idx="2515">
                  <c:v>48057.04532623291</c:v>
                </c:pt>
                <c:pt idx="2516">
                  <c:v>48061.453193664551</c:v>
                </c:pt>
                <c:pt idx="2517">
                  <c:v>48066.403923034668</c:v>
                </c:pt>
                <c:pt idx="2518">
                  <c:v>48066.268936157227</c:v>
                </c:pt>
                <c:pt idx="2519">
                  <c:v>48069.419662475586</c:v>
                </c:pt>
                <c:pt idx="2520">
                  <c:v>48074.313247680664</c:v>
                </c:pt>
                <c:pt idx="2521">
                  <c:v>48073.006828308105</c:v>
                </c:pt>
                <c:pt idx="2522">
                  <c:v>48070.071846008301</c:v>
                </c:pt>
                <c:pt idx="2523">
                  <c:v>48073.708282470703</c:v>
                </c:pt>
                <c:pt idx="2524">
                  <c:v>48078.03044128418</c:v>
                </c:pt>
                <c:pt idx="2525">
                  <c:v>48074.09545135498</c:v>
                </c:pt>
                <c:pt idx="2526">
                  <c:v>48070.903327941895</c:v>
                </c:pt>
                <c:pt idx="2527">
                  <c:v>48072.568336486816</c:v>
                </c:pt>
                <c:pt idx="2528">
                  <c:v>48075.547637939453</c:v>
                </c:pt>
                <c:pt idx="2529">
                  <c:v>48075.041221618652</c:v>
                </c:pt>
                <c:pt idx="2530">
                  <c:v>48072.049087524414</c:v>
                </c:pt>
                <c:pt idx="2531">
                  <c:v>48064.599815368652</c:v>
                </c:pt>
                <c:pt idx="2532">
                  <c:v>48065.121971130371</c:v>
                </c:pt>
                <c:pt idx="2533">
                  <c:v>48077.044128417969</c:v>
                </c:pt>
                <c:pt idx="2534">
                  <c:v>48088.537712097168</c:v>
                </c:pt>
                <c:pt idx="2535">
                  <c:v>48085.374153137207</c:v>
                </c:pt>
                <c:pt idx="2536">
                  <c:v>48073.010597229004</c:v>
                </c:pt>
                <c:pt idx="2537">
                  <c:v>48066.961326599121</c:v>
                </c:pt>
                <c:pt idx="2538">
                  <c:v>48069.426338195801</c:v>
                </c:pt>
                <c:pt idx="2539">
                  <c:v>48076.062782287598</c:v>
                </c:pt>
                <c:pt idx="2540">
                  <c:v>48080.099220275879</c:v>
                </c:pt>
                <c:pt idx="2541">
                  <c:v>48079.449951171875</c:v>
                </c:pt>
                <c:pt idx="2542">
                  <c:v>48073.343528747559</c:v>
                </c:pt>
                <c:pt idx="2543">
                  <c:v>48071.779975891113</c:v>
                </c:pt>
                <c:pt idx="2544">
                  <c:v>48079.244987487793</c:v>
                </c:pt>
                <c:pt idx="2545">
                  <c:v>48082.709999084473</c:v>
                </c:pt>
                <c:pt idx="2546">
                  <c:v>48079.146438598633</c:v>
                </c:pt>
                <c:pt idx="2547">
                  <c:v>48077.297172546387</c:v>
                </c:pt>
                <c:pt idx="2548">
                  <c:v>48078.705039978027</c:v>
                </c:pt>
                <c:pt idx="2549">
                  <c:v>48077.855766296387</c:v>
                </c:pt>
                <c:pt idx="2550">
                  <c:v>48080.635063171387</c:v>
                </c:pt>
                <c:pt idx="2551">
                  <c:v>48085.985794067383</c:v>
                </c:pt>
                <c:pt idx="2552">
                  <c:v>48083.565093994141</c:v>
                </c:pt>
                <c:pt idx="2553">
                  <c:v>48074.430107116699</c:v>
                </c:pt>
                <c:pt idx="2554">
                  <c:v>48068.980834960938</c:v>
                </c:pt>
                <c:pt idx="2555">
                  <c:v>48069.2744140625</c:v>
                </c:pt>
                <c:pt idx="2556">
                  <c:v>48072.625144958496</c:v>
                </c:pt>
                <c:pt idx="2557">
                  <c:v>48075.547302246094</c:v>
                </c:pt>
                <c:pt idx="2558">
                  <c:v>48073.726600646973</c:v>
                </c:pt>
                <c:pt idx="2559">
                  <c:v>48068.505897521973</c:v>
                </c:pt>
                <c:pt idx="2560">
                  <c:v>48063.399478912354</c:v>
                </c:pt>
                <c:pt idx="2561">
                  <c:v>48057.607349395752</c:v>
                </c:pt>
                <c:pt idx="2562">
                  <c:v>48053.70093536377</c:v>
                </c:pt>
                <c:pt idx="2563">
                  <c:v>48056.194519042969</c:v>
                </c:pt>
                <c:pt idx="2564">
                  <c:v>48060.973819732666</c:v>
                </c:pt>
                <c:pt idx="2565">
                  <c:v>48062.067401885986</c:v>
                </c:pt>
                <c:pt idx="2566">
                  <c:v>48068.332412719727</c:v>
                </c:pt>
                <c:pt idx="2567">
                  <c:v>48081.254570007324</c:v>
                </c:pt>
                <c:pt idx="2568">
                  <c:v>48087.60530090332</c:v>
                </c:pt>
                <c:pt idx="2569">
                  <c:v>48080.41316986084</c:v>
                </c:pt>
                <c:pt idx="2570">
                  <c:v>48071.592468261719</c:v>
                </c:pt>
                <c:pt idx="2571">
                  <c:v>48070.28604888916</c:v>
                </c:pt>
                <c:pt idx="2572">
                  <c:v>48071.065353393555</c:v>
                </c:pt>
                <c:pt idx="2573">
                  <c:v>48069.844650268555</c:v>
                </c:pt>
                <c:pt idx="2574">
                  <c:v>48063.766803741455</c:v>
                </c:pt>
                <c:pt idx="2575">
                  <c:v>48062.231819152832</c:v>
                </c:pt>
                <c:pt idx="2576">
                  <c:v>48066.039688110352</c:v>
                </c:pt>
                <c:pt idx="2577">
                  <c:v>48069.59041595459</c:v>
                </c:pt>
                <c:pt idx="2578">
                  <c:v>48066.941139221191</c:v>
                </c:pt>
                <c:pt idx="2579">
                  <c:v>48064.034729003906</c:v>
                </c:pt>
                <c:pt idx="2580">
                  <c:v>48058.014026641846</c:v>
                </c:pt>
                <c:pt idx="2581">
                  <c:v>48051.479038238525</c:v>
                </c:pt>
                <c:pt idx="2582">
                  <c:v>48054.601196289063</c:v>
                </c:pt>
                <c:pt idx="2583">
                  <c:v>48067.723350524902</c:v>
                </c:pt>
                <c:pt idx="2584">
                  <c:v>48085.67407989502</c:v>
                </c:pt>
                <c:pt idx="2585">
                  <c:v>48101.824806213379</c:v>
                </c:pt>
                <c:pt idx="2586">
                  <c:v>48109.461250305176</c:v>
                </c:pt>
                <c:pt idx="2587">
                  <c:v>48098.326263427734</c:v>
                </c:pt>
                <c:pt idx="2588">
                  <c:v>48079.648414611816</c:v>
                </c:pt>
                <c:pt idx="2589">
                  <c:v>48064.484855651855</c:v>
                </c:pt>
                <c:pt idx="2590">
                  <c:v>48057.321300506592</c:v>
                </c:pt>
                <c:pt idx="2591">
                  <c:v>48053.01488494873</c:v>
                </c:pt>
                <c:pt idx="2592">
                  <c:v>48055.565608978271</c:v>
                </c:pt>
                <c:pt idx="2593">
                  <c:v>48064.94490814209</c:v>
                </c:pt>
                <c:pt idx="2594">
                  <c:v>48071.838493347168</c:v>
                </c:pt>
                <c:pt idx="2595">
                  <c:v>48068.560646057129</c:v>
                </c:pt>
                <c:pt idx="2596">
                  <c:v>48056.797092437744</c:v>
                </c:pt>
                <c:pt idx="2597">
                  <c:v>48046.519245147705</c:v>
                </c:pt>
                <c:pt idx="2598">
                  <c:v>48047.641403198242</c:v>
                </c:pt>
                <c:pt idx="2599">
                  <c:v>48058.734985351563</c:v>
                </c:pt>
                <c:pt idx="2600">
                  <c:v>48063.257141113281</c:v>
                </c:pt>
                <c:pt idx="2601">
                  <c:v>48063.265014648438</c:v>
                </c:pt>
                <c:pt idx="2602">
                  <c:v>48062.872882843018</c:v>
                </c:pt>
                <c:pt idx="2603">
                  <c:v>48061.366466522217</c:v>
                </c:pt>
                <c:pt idx="2604">
                  <c:v>48056.460052490234</c:v>
                </c:pt>
                <c:pt idx="2605">
                  <c:v>48059.839351654053</c:v>
                </c:pt>
                <c:pt idx="2606">
                  <c:v>48066.790077209473</c:v>
                </c:pt>
                <c:pt idx="2607">
                  <c:v>48065.140808105469</c:v>
                </c:pt>
                <c:pt idx="2608">
                  <c:v>48060.091533660889</c:v>
                </c:pt>
                <c:pt idx="2609">
                  <c:v>48062.127975463867</c:v>
                </c:pt>
                <c:pt idx="2610">
                  <c:v>48068.335845947266</c:v>
                </c:pt>
                <c:pt idx="2611">
                  <c:v>48067.372283935547</c:v>
                </c:pt>
                <c:pt idx="2612">
                  <c:v>48060.265869140625</c:v>
                </c:pt>
                <c:pt idx="2613">
                  <c:v>48050.616596221924</c:v>
                </c:pt>
                <c:pt idx="2614">
                  <c:v>48042.538753509521</c:v>
                </c:pt>
                <c:pt idx="2615">
                  <c:v>48036.5751953125</c:v>
                </c:pt>
                <c:pt idx="2616">
                  <c:v>48035.440208435059</c:v>
                </c:pt>
                <c:pt idx="2617">
                  <c:v>48039.905220031738</c:v>
                </c:pt>
                <c:pt idx="2618">
                  <c:v>48047.427375793457</c:v>
                </c:pt>
                <c:pt idx="2619">
                  <c:v>48048.578102111816</c:v>
                </c:pt>
                <c:pt idx="2620">
                  <c:v>48046.157402038574</c:v>
                </c:pt>
                <c:pt idx="2621">
                  <c:v>48044.936702728271</c:v>
                </c:pt>
                <c:pt idx="2622">
                  <c:v>48044.487426757813</c:v>
                </c:pt>
                <c:pt idx="2623">
                  <c:v>48041.352439880371</c:v>
                </c:pt>
                <c:pt idx="2624">
                  <c:v>48046.417453765869</c:v>
                </c:pt>
                <c:pt idx="2625">
                  <c:v>48057.139610290527</c:v>
                </c:pt>
                <c:pt idx="2626">
                  <c:v>48063.347480773926</c:v>
                </c:pt>
                <c:pt idx="2627">
                  <c:v>48062.241065979004</c:v>
                </c:pt>
                <c:pt idx="2628">
                  <c:v>48065.877510070801</c:v>
                </c:pt>
                <c:pt idx="2629">
                  <c:v>48069.799659729004</c:v>
                </c:pt>
                <c:pt idx="2630">
                  <c:v>48067.778961181641</c:v>
                </c:pt>
                <c:pt idx="2631">
                  <c:v>48063.815402984619</c:v>
                </c:pt>
                <c:pt idx="2632">
                  <c:v>48062.451843261719</c:v>
                </c:pt>
                <c:pt idx="2633">
                  <c:v>48058.116855621338</c:v>
                </c:pt>
                <c:pt idx="2634">
                  <c:v>48053.610443115234</c:v>
                </c:pt>
                <c:pt idx="2635">
                  <c:v>48048.961170196533</c:v>
                </c:pt>
                <c:pt idx="2636">
                  <c:v>48039.654754638672</c:v>
                </c:pt>
                <c:pt idx="2637">
                  <c:v>48028.605480194092</c:v>
                </c:pt>
                <c:pt idx="2638">
                  <c:v>48026.32763671875</c:v>
                </c:pt>
                <c:pt idx="2639">
                  <c:v>48030.221220016479</c:v>
                </c:pt>
                <c:pt idx="2640">
                  <c:v>48040.743377685547</c:v>
                </c:pt>
                <c:pt idx="2641">
                  <c:v>48059.894104003906</c:v>
                </c:pt>
                <c:pt idx="2642">
                  <c:v>48073.416259765625</c:v>
                </c:pt>
                <c:pt idx="2643">
                  <c:v>48068.738418579102</c:v>
                </c:pt>
                <c:pt idx="2644">
                  <c:v>48053.517715454102</c:v>
                </c:pt>
                <c:pt idx="2645">
                  <c:v>48042.21129989624</c:v>
                </c:pt>
                <c:pt idx="2646">
                  <c:v>48037.19059753418</c:v>
                </c:pt>
                <c:pt idx="2647">
                  <c:v>48035.998466491699</c:v>
                </c:pt>
                <c:pt idx="2648">
                  <c:v>48034.720623016357</c:v>
                </c:pt>
                <c:pt idx="2649">
                  <c:v>48034.242778778076</c:v>
                </c:pt>
                <c:pt idx="2650">
                  <c:v>48039.193508148193</c:v>
                </c:pt>
                <c:pt idx="2651">
                  <c:v>48053.172805786133</c:v>
                </c:pt>
                <c:pt idx="2652">
                  <c:v>48064.752105712891</c:v>
                </c:pt>
                <c:pt idx="2653">
                  <c:v>48062.93140411377</c:v>
                </c:pt>
                <c:pt idx="2654">
                  <c:v>48051.224987030029</c:v>
                </c:pt>
                <c:pt idx="2655">
                  <c:v>48044.432857513428</c:v>
                </c:pt>
                <c:pt idx="2656">
                  <c:v>48048.869297027588</c:v>
                </c:pt>
                <c:pt idx="2657">
                  <c:v>48051.877170562744</c:v>
                </c:pt>
                <c:pt idx="2658">
                  <c:v>48045.685039520264</c:v>
                </c:pt>
                <c:pt idx="2659">
                  <c:v>48037.778621673584</c:v>
                </c:pt>
                <c:pt idx="2660">
                  <c:v>48041.4436378479</c:v>
                </c:pt>
                <c:pt idx="2661">
                  <c:v>48043.080078125</c:v>
                </c:pt>
                <c:pt idx="2662">
                  <c:v>48030.516519546509</c:v>
                </c:pt>
                <c:pt idx="2663">
                  <c:v>48017.267246246338</c:v>
                </c:pt>
                <c:pt idx="2664">
                  <c:v>48021.589403152466</c:v>
                </c:pt>
                <c:pt idx="2665">
                  <c:v>48031.111558914185</c:v>
                </c:pt>
                <c:pt idx="2666">
                  <c:v>48034.490856170654</c:v>
                </c:pt>
                <c:pt idx="2667">
                  <c:v>48034.698726654053</c:v>
                </c:pt>
                <c:pt idx="2668">
                  <c:v>48038.96374130249</c:v>
                </c:pt>
                <c:pt idx="2669">
                  <c:v>48051.885894775391</c:v>
                </c:pt>
                <c:pt idx="2670">
                  <c:v>48069.836624145508</c:v>
                </c:pt>
                <c:pt idx="2671">
                  <c:v>48087.558776855469</c:v>
                </c:pt>
                <c:pt idx="2672">
                  <c:v>48094.480934143066</c:v>
                </c:pt>
                <c:pt idx="2673">
                  <c:v>48082.688804626465</c:v>
                </c:pt>
                <c:pt idx="2674">
                  <c:v>48052.639533996582</c:v>
                </c:pt>
                <c:pt idx="2675">
                  <c:v>48028.133117675781</c:v>
                </c:pt>
                <c:pt idx="2676">
                  <c:v>48026.48384475708</c:v>
                </c:pt>
                <c:pt idx="2677">
                  <c:v>48036.006000518799</c:v>
                </c:pt>
                <c:pt idx="2678">
                  <c:v>48036.956726074219</c:v>
                </c:pt>
                <c:pt idx="2679">
                  <c:v>48027.850311279297</c:v>
                </c:pt>
                <c:pt idx="2680">
                  <c:v>48022.315324783325</c:v>
                </c:pt>
                <c:pt idx="2681">
                  <c:v>48024.151765823364</c:v>
                </c:pt>
                <c:pt idx="2682">
                  <c:v>48027.702493667603</c:v>
                </c:pt>
                <c:pt idx="2683">
                  <c:v>48025.253221511841</c:v>
                </c:pt>
                <c:pt idx="2684">
                  <c:v>48021.91823387146</c:v>
                </c:pt>
                <c:pt idx="2685">
                  <c:v>48025.183246612549</c:v>
                </c:pt>
                <c:pt idx="2686">
                  <c:v>48035.905403137207</c:v>
                </c:pt>
                <c:pt idx="2687">
                  <c:v>48037.313274383545</c:v>
                </c:pt>
                <c:pt idx="2688">
                  <c:v>48024.464000701904</c:v>
                </c:pt>
                <c:pt idx="2689">
                  <c:v>48009.871870040894</c:v>
                </c:pt>
                <c:pt idx="2690">
                  <c:v>48011.822597503662</c:v>
                </c:pt>
                <c:pt idx="2691">
                  <c:v>48029.54475402832</c:v>
                </c:pt>
                <c:pt idx="2692">
                  <c:v>48049.924053192139</c:v>
                </c:pt>
                <c:pt idx="2693">
                  <c:v>48058.874778747559</c:v>
                </c:pt>
                <c:pt idx="2694">
                  <c:v>48053.796936035156</c:v>
                </c:pt>
                <c:pt idx="2695">
                  <c:v>48049.433376312256</c:v>
                </c:pt>
                <c:pt idx="2696">
                  <c:v>48049.955532073975</c:v>
                </c:pt>
                <c:pt idx="2697">
                  <c:v>48048.249114990234</c:v>
                </c:pt>
                <c:pt idx="2698">
                  <c:v>48034.256988525391</c:v>
                </c:pt>
                <c:pt idx="2699">
                  <c:v>48016.72200012207</c:v>
                </c:pt>
                <c:pt idx="2700">
                  <c:v>48009.358441352844</c:v>
                </c:pt>
                <c:pt idx="2701">
                  <c:v>48014.680597305298</c:v>
                </c:pt>
                <c:pt idx="2702">
                  <c:v>48026.917039871216</c:v>
                </c:pt>
                <c:pt idx="2703">
                  <c:v>48039.924907684326</c:v>
                </c:pt>
                <c:pt idx="2704">
                  <c:v>48050.304206848145</c:v>
                </c:pt>
                <c:pt idx="2705">
                  <c:v>48053.683506011963</c:v>
                </c:pt>
                <c:pt idx="2706">
                  <c:v>48053.662803649902</c:v>
                </c:pt>
                <c:pt idx="2707">
                  <c:v>48049.042102813721</c:v>
                </c:pt>
                <c:pt idx="2708">
                  <c:v>48038.992832183838</c:v>
                </c:pt>
                <c:pt idx="2709">
                  <c:v>48027.914987564087</c:v>
                </c:pt>
                <c:pt idx="2710">
                  <c:v>48023.379999160767</c:v>
                </c:pt>
                <c:pt idx="2711">
                  <c:v>48025.273584365845</c:v>
                </c:pt>
                <c:pt idx="2712">
                  <c:v>48031.252883911133</c:v>
                </c:pt>
                <c:pt idx="2713">
                  <c:v>48037.175037384033</c:v>
                </c:pt>
                <c:pt idx="2714">
                  <c:v>48032.525764465332</c:v>
                </c:pt>
                <c:pt idx="2715">
                  <c:v>48024.79077911377</c:v>
                </c:pt>
                <c:pt idx="2716">
                  <c:v>48029.370077133179</c:v>
                </c:pt>
                <c:pt idx="2717">
                  <c:v>48039.920806884766</c:v>
                </c:pt>
                <c:pt idx="2718">
                  <c:v>48038.557247161865</c:v>
                </c:pt>
                <c:pt idx="2719">
                  <c:v>48033.365116119385</c:v>
                </c:pt>
                <c:pt idx="2720">
                  <c:v>48037.630130767822</c:v>
                </c:pt>
                <c:pt idx="2721">
                  <c:v>48038.580856323242</c:v>
                </c:pt>
                <c:pt idx="2722">
                  <c:v>48031.531583786011</c:v>
                </c:pt>
                <c:pt idx="2723">
                  <c:v>48030.310882568359</c:v>
                </c:pt>
                <c:pt idx="2724">
                  <c:v>48036.375896453857</c:v>
                </c:pt>
                <c:pt idx="2725">
                  <c:v>48045.412338256836</c:v>
                </c:pt>
                <c:pt idx="2726">
                  <c:v>48051.991638183594</c:v>
                </c:pt>
                <c:pt idx="2727">
                  <c:v>48050.685222625732</c:v>
                </c:pt>
                <c:pt idx="2728">
                  <c:v>48044.864521026611</c:v>
                </c:pt>
                <c:pt idx="2729">
                  <c:v>48047.415245056152</c:v>
                </c:pt>
                <c:pt idx="2730">
                  <c:v>48053.623115539551</c:v>
                </c:pt>
                <c:pt idx="2731">
                  <c:v>48054.745273590088</c:v>
                </c:pt>
                <c:pt idx="2732">
                  <c:v>48055.810287475586</c:v>
                </c:pt>
                <c:pt idx="2733">
                  <c:v>48059.132442474365</c:v>
                </c:pt>
                <c:pt idx="2734">
                  <c:v>48052.397453308105</c:v>
                </c:pt>
                <c:pt idx="2735">
                  <c:v>48037.291038513184</c:v>
                </c:pt>
                <c:pt idx="2736">
                  <c:v>48028.213193893433</c:v>
                </c:pt>
                <c:pt idx="2737">
                  <c:v>48034.5924949646</c:v>
                </c:pt>
                <c:pt idx="2738">
                  <c:v>48046.943222045898</c:v>
                </c:pt>
                <c:pt idx="2739">
                  <c:v>48047.265377044678</c:v>
                </c:pt>
                <c:pt idx="2740">
                  <c:v>48034.673248291016</c:v>
                </c:pt>
                <c:pt idx="2741">
                  <c:v>48022.166831970215</c:v>
                </c:pt>
                <c:pt idx="2742">
                  <c:v>48023.231843948364</c:v>
                </c:pt>
                <c:pt idx="2743">
                  <c:v>48034.839714050293</c:v>
                </c:pt>
                <c:pt idx="2744">
                  <c:v>48046.961868286133</c:v>
                </c:pt>
                <c:pt idx="2745">
                  <c:v>48051.56974029541</c:v>
                </c:pt>
                <c:pt idx="2746">
                  <c:v>48050.977611541748</c:v>
                </c:pt>
                <c:pt idx="2747">
                  <c:v>48052.356910705566</c:v>
                </c:pt>
                <c:pt idx="2748">
                  <c:v>48057.621921539307</c:v>
                </c:pt>
                <c:pt idx="2749">
                  <c:v>48064.658363342285</c:v>
                </c:pt>
                <c:pt idx="2750">
                  <c:v>48069.780517578125</c:v>
                </c:pt>
                <c:pt idx="2751">
                  <c:v>48068.559814453125</c:v>
                </c:pt>
                <c:pt idx="2752">
                  <c:v>48061.510543823242</c:v>
                </c:pt>
                <c:pt idx="2753">
                  <c:v>48055.60412979126</c:v>
                </c:pt>
                <c:pt idx="2754">
                  <c:v>48054.697715759277</c:v>
                </c:pt>
                <c:pt idx="2755">
                  <c:v>48056.019870758057</c:v>
                </c:pt>
                <c:pt idx="2756">
                  <c:v>48052.742027282715</c:v>
                </c:pt>
                <c:pt idx="2757">
                  <c:v>48047.092754364014</c:v>
                </c:pt>
                <c:pt idx="2758">
                  <c:v>48048.443481445313</c:v>
                </c:pt>
                <c:pt idx="2759">
                  <c:v>48054.594207763672</c:v>
                </c:pt>
                <c:pt idx="2760">
                  <c:v>48051.773506164551</c:v>
                </c:pt>
                <c:pt idx="2761">
                  <c:v>48044.26708984375</c:v>
                </c:pt>
                <c:pt idx="2762">
                  <c:v>48045.532104492188</c:v>
                </c:pt>
                <c:pt idx="2763">
                  <c:v>48052.225688934326</c:v>
                </c:pt>
                <c:pt idx="2764">
                  <c:v>48048.319271087646</c:v>
                </c:pt>
                <c:pt idx="2765">
                  <c:v>48039.955715179443</c:v>
                </c:pt>
                <c:pt idx="2766">
                  <c:v>48042.677871704102</c:v>
                </c:pt>
                <c:pt idx="2767">
                  <c:v>48057.057167053223</c:v>
                </c:pt>
                <c:pt idx="2768">
                  <c:v>48061.293609619141</c:v>
                </c:pt>
                <c:pt idx="2769">
                  <c:v>48054.78719329834</c:v>
                </c:pt>
                <c:pt idx="2770">
                  <c:v>48046.909351348877</c:v>
                </c:pt>
                <c:pt idx="2771">
                  <c:v>48042.060077667236</c:v>
                </c:pt>
                <c:pt idx="2772">
                  <c:v>48038.525089263916</c:v>
                </c:pt>
                <c:pt idx="2773">
                  <c:v>48041.704391479492</c:v>
                </c:pt>
                <c:pt idx="2774">
                  <c:v>48048.597972869873</c:v>
                </c:pt>
                <c:pt idx="2775">
                  <c:v>48053.177272796631</c:v>
                </c:pt>
                <c:pt idx="2776">
                  <c:v>48059.956569671631</c:v>
                </c:pt>
                <c:pt idx="2777">
                  <c:v>48064.335868835449</c:v>
                </c:pt>
                <c:pt idx="2778">
                  <c:v>48061.058025360107</c:v>
                </c:pt>
                <c:pt idx="2779">
                  <c:v>48049.494468688965</c:v>
                </c:pt>
                <c:pt idx="2780">
                  <c:v>48039.902336120605</c:v>
                </c:pt>
                <c:pt idx="2781">
                  <c:v>48034.710208892822</c:v>
                </c:pt>
                <c:pt idx="2782">
                  <c:v>48035.546649932861</c:v>
                </c:pt>
                <c:pt idx="2783">
                  <c:v>48041.611663818359</c:v>
                </c:pt>
                <c:pt idx="2784">
                  <c:v>48048.133819580078</c:v>
                </c:pt>
                <c:pt idx="2785">
                  <c:v>48042.484546661377</c:v>
                </c:pt>
                <c:pt idx="2786">
                  <c:v>48029.035272598267</c:v>
                </c:pt>
                <c:pt idx="2787">
                  <c:v>48024.986000061035</c:v>
                </c:pt>
                <c:pt idx="2788">
                  <c:v>48029.508155822754</c:v>
                </c:pt>
                <c:pt idx="2789">
                  <c:v>48031.516025543213</c:v>
                </c:pt>
                <c:pt idx="2790">
                  <c:v>48031.123895645142</c:v>
                </c:pt>
                <c:pt idx="2791">
                  <c:v>48038.44605255127</c:v>
                </c:pt>
                <c:pt idx="2792">
                  <c:v>48045.596778869629</c:v>
                </c:pt>
                <c:pt idx="2793">
                  <c:v>48048.347507476807</c:v>
                </c:pt>
                <c:pt idx="2794">
                  <c:v>48046.441089630127</c:v>
                </c:pt>
                <c:pt idx="2795">
                  <c:v>48046.448959350586</c:v>
                </c:pt>
                <c:pt idx="2796">
                  <c:v>48045.485401153564</c:v>
                </c:pt>
                <c:pt idx="2797">
                  <c:v>48046.350414276123</c:v>
                </c:pt>
                <c:pt idx="2798">
                  <c:v>48052.98685836792</c:v>
                </c:pt>
                <c:pt idx="2799">
                  <c:v>48060.42329788208</c:v>
                </c:pt>
                <c:pt idx="2800">
                  <c:v>48058.231170654297</c:v>
                </c:pt>
                <c:pt idx="2801">
                  <c:v>48049.867610931396</c:v>
                </c:pt>
                <c:pt idx="2802">
                  <c:v>48044.161193847656</c:v>
                </c:pt>
                <c:pt idx="2803">
                  <c:v>48045.883350372314</c:v>
                </c:pt>
                <c:pt idx="2804">
                  <c:v>48054.548362731934</c:v>
                </c:pt>
                <c:pt idx="2805">
                  <c:v>48062.899089813232</c:v>
                </c:pt>
                <c:pt idx="2806">
                  <c:v>48065.249816894531</c:v>
                </c:pt>
                <c:pt idx="2807">
                  <c:v>48062.229118347168</c:v>
                </c:pt>
                <c:pt idx="2808">
                  <c:v>48054.836986541748</c:v>
                </c:pt>
                <c:pt idx="2809">
                  <c:v>48051.187713623047</c:v>
                </c:pt>
                <c:pt idx="2810">
                  <c:v>48060.452728271484</c:v>
                </c:pt>
                <c:pt idx="2811">
                  <c:v>48071.460594177246</c:v>
                </c:pt>
                <c:pt idx="2812">
                  <c:v>48073.868469238281</c:v>
                </c:pt>
                <c:pt idx="2813">
                  <c:v>48075.247764587402</c:v>
                </c:pt>
                <c:pt idx="2814">
                  <c:v>48078.312782287598</c:v>
                </c:pt>
                <c:pt idx="2815">
                  <c:v>48067.92064666748</c:v>
                </c:pt>
                <c:pt idx="2816">
                  <c:v>48052.242805480957</c:v>
                </c:pt>
                <c:pt idx="2817">
                  <c:v>48052.393531799316</c:v>
                </c:pt>
                <c:pt idx="2818">
                  <c:v>48065.258544921875</c:v>
                </c:pt>
                <c:pt idx="2819">
                  <c:v>48072.952133178711</c:v>
                </c:pt>
                <c:pt idx="2820">
                  <c:v>48064.388572692871</c:v>
                </c:pt>
                <c:pt idx="2821">
                  <c:v>48049.42501449585</c:v>
                </c:pt>
                <c:pt idx="2822">
                  <c:v>48036.20431137085</c:v>
                </c:pt>
                <c:pt idx="2823">
                  <c:v>48032.983612060547</c:v>
                </c:pt>
                <c:pt idx="2824">
                  <c:v>48042.734336853027</c:v>
                </c:pt>
                <c:pt idx="2825">
                  <c:v>48054.885063171387</c:v>
                </c:pt>
                <c:pt idx="2826">
                  <c:v>48056.835792541504</c:v>
                </c:pt>
                <c:pt idx="2827">
                  <c:v>48049.900806427002</c:v>
                </c:pt>
                <c:pt idx="2828">
                  <c:v>48047.93724822998</c:v>
                </c:pt>
                <c:pt idx="2829">
                  <c:v>48052.459403991699</c:v>
                </c:pt>
                <c:pt idx="2830">
                  <c:v>48058.3815574646</c:v>
                </c:pt>
                <c:pt idx="2831">
                  <c:v>48061.789428710938</c:v>
                </c:pt>
                <c:pt idx="2832">
                  <c:v>48059.797298431396</c:v>
                </c:pt>
                <c:pt idx="2833">
                  <c:v>48059.405170440674</c:v>
                </c:pt>
                <c:pt idx="2834">
                  <c:v>48061.784465789795</c:v>
                </c:pt>
                <c:pt idx="2835">
                  <c:v>48062.592338562012</c:v>
                </c:pt>
                <c:pt idx="2836">
                  <c:v>48059.48592376709</c:v>
                </c:pt>
                <c:pt idx="2837">
                  <c:v>48052.95093536377</c:v>
                </c:pt>
                <c:pt idx="2838">
                  <c:v>48050.073089599609</c:v>
                </c:pt>
                <c:pt idx="2839">
                  <c:v>48050.223819732666</c:v>
                </c:pt>
                <c:pt idx="2840">
                  <c:v>48057.860260009766</c:v>
                </c:pt>
                <c:pt idx="2841">
                  <c:v>48071.639556884766</c:v>
                </c:pt>
                <c:pt idx="2842">
                  <c:v>48085.676002502441</c:v>
                </c:pt>
                <c:pt idx="2843">
                  <c:v>48081.969581604004</c:v>
                </c:pt>
                <c:pt idx="2844">
                  <c:v>48056.920310974121</c:v>
                </c:pt>
                <c:pt idx="2845">
                  <c:v>48037.92818069458</c:v>
                </c:pt>
                <c:pt idx="2846">
                  <c:v>48037.564624786377</c:v>
                </c:pt>
                <c:pt idx="2847">
                  <c:v>48050.486778259277</c:v>
                </c:pt>
                <c:pt idx="2848">
                  <c:v>48060.380363464355</c:v>
                </c:pt>
                <c:pt idx="2849">
                  <c:v>48064.816802978516</c:v>
                </c:pt>
                <c:pt idx="2850">
                  <c:v>48062.081817626953</c:v>
                </c:pt>
                <c:pt idx="2851">
                  <c:v>48056.603973388672</c:v>
                </c:pt>
                <c:pt idx="2852">
                  <c:v>48054.040416717529</c:v>
                </c:pt>
                <c:pt idx="2853">
                  <c:v>48056.019714355469</c:v>
                </c:pt>
                <c:pt idx="2854">
                  <c:v>48062.056156158447</c:v>
                </c:pt>
                <c:pt idx="2855">
                  <c:v>48072.264022827148</c:v>
                </c:pt>
                <c:pt idx="2856">
                  <c:v>48078.329040527344</c:v>
                </c:pt>
                <c:pt idx="2857">
                  <c:v>48069.879768371582</c:v>
                </c:pt>
                <c:pt idx="2858">
                  <c:v>48049.087635040283</c:v>
                </c:pt>
                <c:pt idx="2859">
                  <c:v>48038.266933441162</c:v>
                </c:pt>
                <c:pt idx="2860">
                  <c:v>48049.8176612854</c:v>
                </c:pt>
                <c:pt idx="2861">
                  <c:v>48065.225532531738</c:v>
                </c:pt>
                <c:pt idx="2862">
                  <c:v>48064.976257324219</c:v>
                </c:pt>
                <c:pt idx="2863">
                  <c:v>48054.012702941895</c:v>
                </c:pt>
                <c:pt idx="2864">
                  <c:v>48049.477714538574</c:v>
                </c:pt>
                <c:pt idx="2865">
                  <c:v>48052.828441619873</c:v>
                </c:pt>
                <c:pt idx="2866">
                  <c:v>48060.864883422852</c:v>
                </c:pt>
                <c:pt idx="2867">
                  <c:v>48063.92989730835</c:v>
                </c:pt>
                <c:pt idx="2868">
                  <c:v>48057.109195709229</c:v>
                </c:pt>
                <c:pt idx="2869">
                  <c:v>48048.059921264648</c:v>
                </c:pt>
                <c:pt idx="2870">
                  <c:v>48055.467792510986</c:v>
                </c:pt>
                <c:pt idx="2871">
                  <c:v>48071.447090148926</c:v>
                </c:pt>
                <c:pt idx="2872">
                  <c:v>48079.712104797363</c:v>
                </c:pt>
                <c:pt idx="2873">
                  <c:v>48078.234260559082</c:v>
                </c:pt>
                <c:pt idx="2874">
                  <c:v>48073.356414794922</c:v>
                </c:pt>
                <c:pt idx="2875">
                  <c:v>48060.707141876221</c:v>
                </c:pt>
                <c:pt idx="2876">
                  <c:v>48047.629299163818</c:v>
                </c:pt>
                <c:pt idx="2877">
                  <c:v>48047.694313049316</c:v>
                </c:pt>
                <c:pt idx="2878">
                  <c:v>48055.387897491455</c:v>
                </c:pt>
                <c:pt idx="2879">
                  <c:v>48059.767196655273</c:v>
                </c:pt>
                <c:pt idx="2880">
                  <c:v>48059.689350128174</c:v>
                </c:pt>
                <c:pt idx="2881">
                  <c:v>48059.840076446533</c:v>
                </c:pt>
                <c:pt idx="2882">
                  <c:v>48061.61937713623</c:v>
                </c:pt>
                <c:pt idx="2883">
                  <c:v>48061.77010345459</c:v>
                </c:pt>
                <c:pt idx="2884">
                  <c:v>48055.777973175049</c:v>
                </c:pt>
                <c:pt idx="2885">
                  <c:v>48048.300128936768</c:v>
                </c:pt>
                <c:pt idx="2886">
                  <c:v>48053.022285461426</c:v>
                </c:pt>
                <c:pt idx="2887">
                  <c:v>48062.801586151123</c:v>
                </c:pt>
                <c:pt idx="2888">
                  <c:v>48065.038024902344</c:v>
                </c:pt>
                <c:pt idx="2889">
                  <c:v>48060.388751983643</c:v>
                </c:pt>
                <c:pt idx="2890">
                  <c:v>48056.196624755859</c:v>
                </c:pt>
                <c:pt idx="2891">
                  <c:v>48053.690208435059</c:v>
                </c:pt>
                <c:pt idx="2892">
                  <c:v>48051.783790588379</c:v>
                </c:pt>
                <c:pt idx="2893">
                  <c:v>48054.048805236816</c:v>
                </c:pt>
                <c:pt idx="2894">
                  <c:v>48050.713817596436</c:v>
                </c:pt>
                <c:pt idx="2895">
                  <c:v>48035.693115234375</c:v>
                </c:pt>
                <c:pt idx="2896">
                  <c:v>48022.072416305542</c:v>
                </c:pt>
                <c:pt idx="2897">
                  <c:v>48023.537427902222</c:v>
                </c:pt>
                <c:pt idx="2898">
                  <c:v>48040.202442169189</c:v>
                </c:pt>
                <c:pt idx="2899">
                  <c:v>48056.038883209229</c:v>
                </c:pt>
                <c:pt idx="2900">
                  <c:v>48060.732467651367</c:v>
                </c:pt>
                <c:pt idx="2901">
                  <c:v>48053.483196258545</c:v>
                </c:pt>
                <c:pt idx="2902">
                  <c:v>48041.576778411865</c:v>
                </c:pt>
                <c:pt idx="2903">
                  <c:v>48036.041793823242</c:v>
                </c:pt>
                <c:pt idx="2904">
                  <c:v>48037.621089935303</c:v>
                </c:pt>
                <c:pt idx="2905">
                  <c:v>48039.171817779541</c:v>
                </c:pt>
                <c:pt idx="2906">
                  <c:v>48034.265403747559</c:v>
                </c:pt>
                <c:pt idx="2907">
                  <c:v>48033.901844024658</c:v>
                </c:pt>
                <c:pt idx="2908">
                  <c:v>48043.595428466797</c:v>
                </c:pt>
                <c:pt idx="2909">
                  <c:v>48047.174728393555</c:v>
                </c:pt>
                <c:pt idx="2910">
                  <c:v>48035.211170196533</c:v>
                </c:pt>
                <c:pt idx="2911">
                  <c:v>48023.304752349854</c:v>
                </c:pt>
                <c:pt idx="2912">
                  <c:v>48024.855480194092</c:v>
                </c:pt>
                <c:pt idx="2913">
                  <c:v>48032.777637481689</c:v>
                </c:pt>
                <c:pt idx="2914">
                  <c:v>48041.642650604248</c:v>
                </c:pt>
                <c:pt idx="2915">
                  <c:v>48050.364803314209</c:v>
                </c:pt>
                <c:pt idx="2916">
                  <c:v>48056.429817199707</c:v>
                </c:pt>
                <c:pt idx="2917">
                  <c:v>48058.294830322266</c:v>
                </c:pt>
                <c:pt idx="2918">
                  <c:v>48061.616985321045</c:v>
                </c:pt>
                <c:pt idx="2919">
                  <c:v>48067.16771697998</c:v>
                </c:pt>
                <c:pt idx="2920">
                  <c:v>48061.575584411621</c:v>
                </c:pt>
                <c:pt idx="2921">
                  <c:v>48048.7548828125</c:v>
                </c:pt>
                <c:pt idx="2922">
                  <c:v>48042.191326141357</c:v>
                </c:pt>
                <c:pt idx="2923">
                  <c:v>48049.713481903076</c:v>
                </c:pt>
                <c:pt idx="2924">
                  <c:v>48056.749923706055</c:v>
                </c:pt>
                <c:pt idx="2925">
                  <c:v>48058.214935302734</c:v>
                </c:pt>
                <c:pt idx="2926">
                  <c:v>48051.622806549072</c:v>
                </c:pt>
                <c:pt idx="2927">
                  <c:v>48043.802104949951</c:v>
                </c:pt>
                <c:pt idx="2928">
                  <c:v>48038.695690155029</c:v>
                </c:pt>
                <c:pt idx="2929">
                  <c:v>48036.303558349609</c:v>
                </c:pt>
                <c:pt idx="2930">
                  <c:v>48023.825714111328</c:v>
                </c:pt>
                <c:pt idx="2931">
                  <c:v>48012.519298553467</c:v>
                </c:pt>
                <c:pt idx="2932">
                  <c:v>48017.812883377075</c:v>
                </c:pt>
                <c:pt idx="2933">
                  <c:v>48033.820755004883</c:v>
                </c:pt>
                <c:pt idx="2934">
                  <c:v>48045.342910766602</c:v>
                </c:pt>
                <c:pt idx="2935">
                  <c:v>48046.493637084961</c:v>
                </c:pt>
                <c:pt idx="2936">
                  <c:v>48044.81579208374</c:v>
                </c:pt>
                <c:pt idx="2937">
                  <c:v>48043.509376525879</c:v>
                </c:pt>
                <c:pt idx="2938">
                  <c:v>48046.460102081299</c:v>
                </c:pt>
                <c:pt idx="2939">
                  <c:v>48051.667972564697</c:v>
                </c:pt>
                <c:pt idx="2940">
                  <c:v>48060.904415130615</c:v>
                </c:pt>
                <c:pt idx="2941">
                  <c:v>48069.283714294434</c:v>
                </c:pt>
                <c:pt idx="2942">
                  <c:v>48066.491584777832</c:v>
                </c:pt>
                <c:pt idx="2943">
                  <c:v>48055.956596374512</c:v>
                </c:pt>
                <c:pt idx="2944">
                  <c:v>48047.935897827148</c:v>
                </c:pt>
                <c:pt idx="2945">
                  <c:v>48041.772338867188</c:v>
                </c:pt>
                <c:pt idx="2946">
                  <c:v>48037.465923309326</c:v>
                </c:pt>
                <c:pt idx="2947">
                  <c:v>48041.245220184326</c:v>
                </c:pt>
                <c:pt idx="2948">
                  <c:v>48050.395946502686</c:v>
                </c:pt>
                <c:pt idx="2949">
                  <c:v>48056.603816986084</c:v>
                </c:pt>
                <c:pt idx="2950">
                  <c:v>48061.497402191162</c:v>
                </c:pt>
                <c:pt idx="2951">
                  <c:v>48058.59098815918</c:v>
                </c:pt>
                <c:pt idx="2952">
                  <c:v>48047.770286560059</c:v>
                </c:pt>
                <c:pt idx="2953">
                  <c:v>48038.178153991699</c:v>
                </c:pt>
                <c:pt idx="2954">
                  <c:v>48041.586025238037</c:v>
                </c:pt>
                <c:pt idx="2955">
                  <c:v>48044.651039123535</c:v>
                </c:pt>
                <c:pt idx="2956">
                  <c:v>48042.544624328613</c:v>
                </c:pt>
                <c:pt idx="2957">
                  <c:v>48046.952491760254</c:v>
                </c:pt>
                <c:pt idx="2958">
                  <c:v>48056.988933563232</c:v>
                </c:pt>
                <c:pt idx="2959">
                  <c:v>48060.311092376709</c:v>
                </c:pt>
                <c:pt idx="2960">
                  <c:v>48052.976104736328</c:v>
                </c:pt>
                <c:pt idx="2961">
                  <c:v>48044.783973693848</c:v>
                </c:pt>
                <c:pt idx="2962">
                  <c:v>48038.991844177246</c:v>
                </c:pt>
                <c:pt idx="2963">
                  <c:v>48045.513999938965</c:v>
                </c:pt>
                <c:pt idx="2964">
                  <c:v>48058.236156463623</c:v>
                </c:pt>
                <c:pt idx="2965">
                  <c:v>48061.901168823242</c:v>
                </c:pt>
                <c:pt idx="2966">
                  <c:v>48053.737609863281</c:v>
                </c:pt>
                <c:pt idx="2967">
                  <c:v>48050.74547958374</c:v>
                </c:pt>
                <c:pt idx="2968">
                  <c:v>48053.581920623779</c:v>
                </c:pt>
                <c:pt idx="2969">
                  <c:v>48052.532649993896</c:v>
                </c:pt>
                <c:pt idx="2970">
                  <c:v>48048.111949920654</c:v>
                </c:pt>
                <c:pt idx="2971">
                  <c:v>48047.662673950195</c:v>
                </c:pt>
                <c:pt idx="2972">
                  <c:v>48049.127689361572</c:v>
                </c:pt>
                <c:pt idx="2973">
                  <c:v>48050.049842834473</c:v>
                </c:pt>
                <c:pt idx="2974">
                  <c:v>48053.286285400391</c:v>
                </c:pt>
                <c:pt idx="2975">
                  <c:v>48057.75129699707</c:v>
                </c:pt>
                <c:pt idx="2976">
                  <c:v>48058.644882202148</c:v>
                </c:pt>
                <c:pt idx="2977">
                  <c:v>48054.881324768066</c:v>
                </c:pt>
                <c:pt idx="2978">
                  <c:v>48048.746337890625</c:v>
                </c:pt>
                <c:pt idx="2979">
                  <c:v>48035.754207611084</c:v>
                </c:pt>
                <c:pt idx="2980">
                  <c:v>48024.362077713013</c:v>
                </c:pt>
                <c:pt idx="2981">
                  <c:v>48016.512805938721</c:v>
                </c:pt>
                <c:pt idx="2982">
                  <c:v>48016.57781791687</c:v>
                </c:pt>
                <c:pt idx="2983">
                  <c:v>48019.357116699219</c:v>
                </c:pt>
                <c:pt idx="2984">
                  <c:v>48023.822130203247</c:v>
                </c:pt>
                <c:pt idx="2985">
                  <c:v>48031.315713882446</c:v>
                </c:pt>
                <c:pt idx="2986">
                  <c:v>48043.123584747314</c:v>
                </c:pt>
                <c:pt idx="2987">
                  <c:v>48049.160026550293</c:v>
                </c:pt>
                <c:pt idx="2988">
                  <c:v>48041.367897033691</c:v>
                </c:pt>
                <c:pt idx="2989">
                  <c:v>48032.147193908691</c:v>
                </c:pt>
                <c:pt idx="2990">
                  <c:v>48028.383636474609</c:v>
                </c:pt>
                <c:pt idx="2991">
                  <c:v>48027.391506195068</c:v>
                </c:pt>
                <c:pt idx="2992">
                  <c:v>48027.456520080566</c:v>
                </c:pt>
                <c:pt idx="2993">
                  <c:v>48031.807247161865</c:v>
                </c:pt>
                <c:pt idx="2994">
                  <c:v>48039.357975006104</c:v>
                </c:pt>
                <c:pt idx="2995">
                  <c:v>48038.451557159424</c:v>
                </c:pt>
                <c:pt idx="2996">
                  <c:v>48025.773714065552</c:v>
                </c:pt>
                <c:pt idx="2997">
                  <c:v>48016.781583786011</c:v>
                </c:pt>
                <c:pt idx="2998">
                  <c:v>48016.875169754028</c:v>
                </c:pt>
                <c:pt idx="2999">
                  <c:v>48016.968753814697</c:v>
                </c:pt>
              </c:numCache>
            </c:numRef>
          </c:yVal>
          <c:smooth val="0"/>
          <c:extLst>
            <c:ext xmlns:c16="http://schemas.microsoft.com/office/drawing/2014/chart" uri="{C3380CC4-5D6E-409C-BE32-E72D297353CC}">
              <c16:uniqueId val="{00000002-951A-40BF-BA6C-3B319E7ECED3}"/>
            </c:ext>
          </c:extLst>
        </c:ser>
        <c:ser>
          <c:idx val="3"/>
          <c:order val="3"/>
          <c:tx>
            <c:v>LW RB + GlcNAc + ST6Gal1</c:v>
          </c:tx>
          <c:spPr>
            <a:ln w="19050">
              <a:solidFill>
                <a:srgbClr val="19B2B3"/>
              </a:solidFill>
              <a:prstDash val="solid"/>
              <a:round/>
            </a:ln>
            <a:effectLst/>
          </c:spPr>
          <c:marker>
            <c:symbol val="none"/>
          </c:marker>
          <c:xVal>
            <c:numRef>
              <c:f>'[RB revised.xlsx]Graph Calculations'!$I$20:$DKR$20</c:f>
              <c:numCache>
                <c:formatCode>General</c:formatCode>
                <c:ptCount val="3000"/>
                <c:pt idx="0">
                  <c:v>-4.484992504119873</c:v>
                </c:pt>
                <c:pt idx="1">
                  <c:v>-4.483391284942627</c:v>
                </c:pt>
                <c:pt idx="2">
                  <c:v>-4.4814701080322266</c:v>
                </c:pt>
                <c:pt idx="3">
                  <c:v>-4.4792828559875488</c:v>
                </c:pt>
                <c:pt idx="4">
                  <c:v>-4.4768719673156738</c:v>
                </c:pt>
                <c:pt idx="5">
                  <c:v>-4.4742674827575684</c:v>
                </c:pt>
                <c:pt idx="6">
                  <c:v>-4.471491813659668</c:v>
                </c:pt>
                <c:pt idx="7">
                  <c:v>-4.4685587882995605</c:v>
                </c:pt>
                <c:pt idx="8">
                  <c:v>-4.465489387512207</c:v>
                </c:pt>
                <c:pt idx="9">
                  <c:v>-4.4622888565063477</c:v>
                </c:pt>
                <c:pt idx="10">
                  <c:v>-4.4589748382568359</c:v>
                </c:pt>
                <c:pt idx="11">
                  <c:v>-4.4555597305297852</c:v>
                </c:pt>
                <c:pt idx="12">
                  <c:v>-4.4520449638366699</c:v>
                </c:pt>
                <c:pt idx="13">
                  <c:v>-4.4484472274780273</c:v>
                </c:pt>
                <c:pt idx="14">
                  <c:v>-4.4447660446166992</c:v>
                </c:pt>
                <c:pt idx="15">
                  <c:v>-4.4410147666931152</c:v>
                </c:pt>
                <c:pt idx="16">
                  <c:v>-4.4371976852416992</c:v>
                </c:pt>
                <c:pt idx="17">
                  <c:v>-4.4333152770996094</c:v>
                </c:pt>
                <c:pt idx="18">
                  <c:v>-4.429379940032959</c:v>
                </c:pt>
                <c:pt idx="19">
                  <c:v>-4.4253835678100586</c:v>
                </c:pt>
                <c:pt idx="20">
                  <c:v>-4.4213376045227051</c:v>
                </c:pt>
                <c:pt idx="21">
                  <c:v>-4.4172511100769043</c:v>
                </c:pt>
                <c:pt idx="22">
                  <c:v>-4.413114070892334</c:v>
                </c:pt>
                <c:pt idx="23">
                  <c:v>-4.4089407920837402</c:v>
                </c:pt>
                <c:pt idx="24">
                  <c:v>-4.4047284126281738</c:v>
                </c:pt>
                <c:pt idx="25">
                  <c:v>-4.4004745483398438</c:v>
                </c:pt>
                <c:pt idx="26">
                  <c:v>-4.3961844444274902</c:v>
                </c:pt>
                <c:pt idx="27">
                  <c:v>-4.3918642997741699</c:v>
                </c:pt>
                <c:pt idx="28">
                  <c:v>-4.3875179290771484</c:v>
                </c:pt>
                <c:pt idx="29">
                  <c:v>-4.3831372261047363</c:v>
                </c:pt>
                <c:pt idx="30">
                  <c:v>-4.3787331581115723</c:v>
                </c:pt>
                <c:pt idx="31">
                  <c:v>-4.374298095703125</c:v>
                </c:pt>
                <c:pt idx="32">
                  <c:v>-4.3698406219482422</c:v>
                </c:pt>
                <c:pt idx="33">
                  <c:v>-4.3653564453125</c:v>
                </c:pt>
                <c:pt idx="34">
                  <c:v>-4.3608493804931641</c:v>
                </c:pt>
                <c:pt idx="35">
                  <c:v>-4.3563213348388672</c:v>
                </c:pt>
                <c:pt idx="36">
                  <c:v>-4.351768970489502</c:v>
                </c:pt>
                <c:pt idx="37">
                  <c:v>-4.3471894264221191</c:v>
                </c:pt>
                <c:pt idx="38">
                  <c:v>-4.3425908088684082</c:v>
                </c:pt>
                <c:pt idx="39">
                  <c:v>-4.3379731178283691</c:v>
                </c:pt>
                <c:pt idx="40">
                  <c:v>-4.333336353302002</c:v>
                </c:pt>
                <c:pt idx="41">
                  <c:v>-4.328681468963623</c:v>
                </c:pt>
                <c:pt idx="42">
                  <c:v>-4.3240070343017578</c:v>
                </c:pt>
                <c:pt idx="43">
                  <c:v>-4.3193140029907227</c:v>
                </c:pt>
                <c:pt idx="44">
                  <c:v>-4.3146018981933594</c:v>
                </c:pt>
                <c:pt idx="45">
                  <c:v>-4.309870719909668</c:v>
                </c:pt>
                <c:pt idx="46">
                  <c:v>-4.305121898651123</c:v>
                </c:pt>
                <c:pt idx="47">
                  <c:v>-4.3003597259521484</c:v>
                </c:pt>
                <c:pt idx="48">
                  <c:v>-4.2955842018127441</c:v>
                </c:pt>
                <c:pt idx="49">
                  <c:v>-4.2907929420471191</c:v>
                </c:pt>
                <c:pt idx="50">
                  <c:v>-4.2859835624694824</c:v>
                </c:pt>
                <c:pt idx="51">
                  <c:v>-4.2811546325683594</c:v>
                </c:pt>
                <c:pt idx="52">
                  <c:v>-4.2763090133666992</c:v>
                </c:pt>
                <c:pt idx="53">
                  <c:v>-4.2714524269104004</c:v>
                </c:pt>
                <c:pt idx="54">
                  <c:v>-4.2665815353393555</c:v>
                </c:pt>
                <c:pt idx="55">
                  <c:v>-4.261693000793457</c:v>
                </c:pt>
                <c:pt idx="56">
                  <c:v>-4.2567868232727051</c:v>
                </c:pt>
                <c:pt idx="57">
                  <c:v>-4.2518711090087891</c:v>
                </c:pt>
                <c:pt idx="58">
                  <c:v>-4.2469415664672852</c:v>
                </c:pt>
                <c:pt idx="59">
                  <c:v>-4.2419977188110352</c:v>
                </c:pt>
                <c:pt idx="60">
                  <c:v>-4.2370443344116211</c:v>
                </c:pt>
                <c:pt idx="61">
                  <c:v>-4.2320737838745117</c:v>
                </c:pt>
                <c:pt idx="62">
                  <c:v>-4.2270898818969727</c:v>
                </c:pt>
                <c:pt idx="63">
                  <c:v>-4.2220959663391113</c:v>
                </c:pt>
                <c:pt idx="64">
                  <c:v>-4.2170839309692383</c:v>
                </c:pt>
                <c:pt idx="65">
                  <c:v>-4.2120623588562012</c:v>
                </c:pt>
                <c:pt idx="66">
                  <c:v>-4.2070279121398926</c:v>
                </c:pt>
                <c:pt idx="67">
                  <c:v>-4.2019758224487305</c:v>
                </c:pt>
                <c:pt idx="68">
                  <c:v>-4.1969170570373535</c:v>
                </c:pt>
                <c:pt idx="69">
                  <c:v>-4.1918411254882813</c:v>
                </c:pt>
                <c:pt idx="70">
                  <c:v>-4.1867575645446777</c:v>
                </c:pt>
                <c:pt idx="71">
                  <c:v>-4.1816596984863281</c:v>
                </c:pt>
                <c:pt idx="72">
                  <c:v>-4.1765561103820801</c:v>
                </c:pt>
                <c:pt idx="73">
                  <c:v>-4.1714363098144531</c:v>
                </c:pt>
                <c:pt idx="74">
                  <c:v>-4.1663098335266113</c:v>
                </c:pt>
                <c:pt idx="75">
                  <c:v>-4.1611671447753906</c:v>
                </c:pt>
                <c:pt idx="76">
                  <c:v>-4.1560163497924805</c:v>
                </c:pt>
                <c:pt idx="77">
                  <c:v>-4.1508517265319824</c:v>
                </c:pt>
                <c:pt idx="78">
                  <c:v>-4.1456780433654785</c:v>
                </c:pt>
                <c:pt idx="79">
                  <c:v>-4.1404910087585449</c:v>
                </c:pt>
                <c:pt idx="80">
                  <c:v>-4.1352939605712891</c:v>
                </c:pt>
                <c:pt idx="81">
                  <c:v>-4.1300845146179199</c:v>
                </c:pt>
                <c:pt idx="82">
                  <c:v>-4.1248669624328613</c:v>
                </c:pt>
                <c:pt idx="83">
                  <c:v>-4.1196351051330566</c:v>
                </c:pt>
                <c:pt idx="84">
                  <c:v>-4.1143951416015625</c:v>
                </c:pt>
                <c:pt idx="85">
                  <c:v>-4.1091403961181641</c:v>
                </c:pt>
                <c:pt idx="86">
                  <c:v>-4.1038804054260254</c:v>
                </c:pt>
                <c:pt idx="87">
                  <c:v>-4.0986027717590332</c:v>
                </c:pt>
                <c:pt idx="88">
                  <c:v>-4.09332275390625</c:v>
                </c:pt>
                <c:pt idx="89">
                  <c:v>-4.0880341529846191</c:v>
                </c:pt>
                <c:pt idx="90">
                  <c:v>-4.0827317237854004</c:v>
                </c:pt>
                <c:pt idx="91">
                  <c:v>-4.0774235725402832</c:v>
                </c:pt>
                <c:pt idx="92">
                  <c:v>-4.0720996856689453</c:v>
                </c:pt>
                <c:pt idx="93">
                  <c:v>-4.0667710304260254</c:v>
                </c:pt>
                <c:pt idx="94">
                  <c:v>-4.0614337921142578</c:v>
                </c:pt>
                <c:pt idx="95">
                  <c:v>-4.0560827255249023</c:v>
                </c:pt>
                <c:pt idx="96">
                  <c:v>-4.0507259368896484</c:v>
                </c:pt>
                <c:pt idx="97">
                  <c:v>-4.045353889465332</c:v>
                </c:pt>
                <c:pt idx="98">
                  <c:v>-4.0399770736694336</c:v>
                </c:pt>
                <c:pt idx="99">
                  <c:v>-4.0345902442932129</c:v>
                </c:pt>
                <c:pt idx="100">
                  <c:v>-4.0291905403137207</c:v>
                </c:pt>
                <c:pt idx="101">
                  <c:v>-4.0237860679626465</c:v>
                </c:pt>
                <c:pt idx="102">
                  <c:v>-4.0183682441711426</c:v>
                </c:pt>
                <c:pt idx="103">
                  <c:v>-4.0129423141479492</c:v>
                </c:pt>
                <c:pt idx="104">
                  <c:v>-4.0075116157531738</c:v>
                </c:pt>
                <c:pt idx="105">
                  <c:v>-4.0020675659179688</c:v>
                </c:pt>
                <c:pt idx="106">
                  <c:v>-3.9966161251068115</c:v>
                </c:pt>
                <c:pt idx="107">
                  <c:v>-3.9911582469940186</c:v>
                </c:pt>
                <c:pt idx="108">
                  <c:v>-3.985684871673584</c:v>
                </c:pt>
                <c:pt idx="109">
                  <c:v>-3.9802072048187256</c:v>
                </c:pt>
                <c:pt idx="110">
                  <c:v>-3.974724292755127</c:v>
                </c:pt>
                <c:pt idx="111">
                  <c:v>-3.9692273139953613</c:v>
                </c:pt>
                <c:pt idx="112">
                  <c:v>-3.9637236595153809</c:v>
                </c:pt>
                <c:pt idx="113">
                  <c:v>-3.9582147598266602</c:v>
                </c:pt>
                <c:pt idx="114">
                  <c:v>-3.9526939392089844</c:v>
                </c:pt>
                <c:pt idx="115">
                  <c:v>-3.9471638202667236</c:v>
                </c:pt>
                <c:pt idx="116">
                  <c:v>-3.9416296482086182</c:v>
                </c:pt>
                <c:pt idx="117">
                  <c:v>-3.9360854625701904</c:v>
                </c:pt>
                <c:pt idx="118">
                  <c:v>-3.9305291175842285</c:v>
                </c:pt>
                <c:pt idx="119">
                  <c:v>-3.9249696731567383</c:v>
                </c:pt>
                <c:pt idx="120">
                  <c:v>-3.9194035530090332</c:v>
                </c:pt>
                <c:pt idx="121">
                  <c:v>-3.9138224124908447</c:v>
                </c:pt>
                <c:pt idx="122">
                  <c:v>-3.9082367420196533</c:v>
                </c:pt>
                <c:pt idx="123">
                  <c:v>-3.9026467800140381</c:v>
                </c:pt>
                <c:pt idx="124">
                  <c:v>-3.8970460891723633</c:v>
                </c:pt>
                <c:pt idx="125">
                  <c:v>-3.8914339542388916</c:v>
                </c:pt>
                <c:pt idx="126">
                  <c:v>-3.8858182430267334</c:v>
                </c:pt>
                <c:pt idx="127">
                  <c:v>-3.8801958560943604</c:v>
                </c:pt>
                <c:pt idx="128">
                  <c:v>-3.8745608329772949</c:v>
                </c:pt>
                <c:pt idx="129">
                  <c:v>-3.8689188957214355</c:v>
                </c:pt>
                <c:pt idx="130">
                  <c:v>-3.8632733821868896</c:v>
                </c:pt>
                <c:pt idx="131">
                  <c:v>-3.8576192855834961</c:v>
                </c:pt>
                <c:pt idx="132">
                  <c:v>-3.8519530296325684</c:v>
                </c:pt>
                <c:pt idx="133">
                  <c:v>-3.8462812900543213</c:v>
                </c:pt>
                <c:pt idx="134">
                  <c:v>-3.8406047821044922</c:v>
                </c:pt>
                <c:pt idx="135">
                  <c:v>-3.8349192142486572</c:v>
                </c:pt>
                <c:pt idx="136">
                  <c:v>-3.8292222023010254</c:v>
                </c:pt>
                <c:pt idx="137">
                  <c:v>-3.8235206604003906</c:v>
                </c:pt>
                <c:pt idx="138">
                  <c:v>-3.8178160190582275</c:v>
                </c:pt>
                <c:pt idx="139">
                  <c:v>-3.8121066093444824</c:v>
                </c:pt>
                <c:pt idx="140">
                  <c:v>-3.8063910007476807</c:v>
                </c:pt>
                <c:pt idx="141">
                  <c:v>-3.8006610870361328</c:v>
                </c:pt>
                <c:pt idx="142">
                  <c:v>-3.7949264049530029</c:v>
                </c:pt>
                <c:pt idx="143">
                  <c:v>-3.7891876697540283</c:v>
                </c:pt>
                <c:pt idx="144">
                  <c:v>-3.7834429740905762</c:v>
                </c:pt>
                <c:pt idx="145">
                  <c:v>-3.7776873111724854</c:v>
                </c:pt>
                <c:pt idx="146">
                  <c:v>-3.7719225883483887</c:v>
                </c:pt>
                <c:pt idx="147">
                  <c:v>-3.7661542892456055</c:v>
                </c:pt>
                <c:pt idx="148">
                  <c:v>-3.7603809833526611</c:v>
                </c:pt>
                <c:pt idx="149">
                  <c:v>-3.7545990943908691</c:v>
                </c:pt>
                <c:pt idx="150">
                  <c:v>-3.7488057613372803</c:v>
                </c:pt>
                <c:pt idx="151">
                  <c:v>-3.7430076599121094</c:v>
                </c:pt>
                <c:pt idx="152">
                  <c:v>-3.7372055053710938</c:v>
                </c:pt>
                <c:pt idx="153">
                  <c:v>-3.7313964366912842</c:v>
                </c:pt>
                <c:pt idx="154">
                  <c:v>-3.7255790233612061</c:v>
                </c:pt>
                <c:pt idx="155">
                  <c:v>-3.7197506427764893</c:v>
                </c:pt>
                <c:pt idx="156">
                  <c:v>-3.713918924331665</c:v>
                </c:pt>
                <c:pt idx="157">
                  <c:v>-3.7080836296081543</c:v>
                </c:pt>
                <c:pt idx="158">
                  <c:v>-3.702242374420166</c:v>
                </c:pt>
                <c:pt idx="159">
                  <c:v>-3.6963891983032227</c:v>
                </c:pt>
                <c:pt idx="160">
                  <c:v>-3.6905276775360107</c:v>
                </c:pt>
                <c:pt idx="161">
                  <c:v>-3.6846621036529541</c:v>
                </c:pt>
                <c:pt idx="162">
                  <c:v>-3.67879319190979</c:v>
                </c:pt>
                <c:pt idx="163">
                  <c:v>-3.6729195117950439</c:v>
                </c:pt>
                <c:pt idx="164">
                  <c:v>-3.6670382022857666</c:v>
                </c:pt>
                <c:pt idx="165">
                  <c:v>-3.6611456871032715</c:v>
                </c:pt>
                <c:pt idx="166">
                  <c:v>-3.6552462577819824</c:v>
                </c:pt>
                <c:pt idx="167">
                  <c:v>-3.6493439674377441</c:v>
                </c:pt>
                <c:pt idx="168">
                  <c:v>-3.643437385559082</c:v>
                </c:pt>
                <c:pt idx="169">
                  <c:v>-3.6375248432159424</c:v>
                </c:pt>
                <c:pt idx="170">
                  <c:v>-3.6316056251525879</c:v>
                </c:pt>
                <c:pt idx="171">
                  <c:v>-3.6256766319274902</c:v>
                </c:pt>
                <c:pt idx="172">
                  <c:v>-3.6197400093078613</c:v>
                </c:pt>
                <c:pt idx="173">
                  <c:v>-3.6138002872467041</c:v>
                </c:pt>
                <c:pt idx="174">
                  <c:v>-3.6078565120697021</c:v>
                </c:pt>
                <c:pt idx="175">
                  <c:v>-3.60190749168396</c:v>
                </c:pt>
                <c:pt idx="176">
                  <c:v>-3.595952033996582</c:v>
                </c:pt>
                <c:pt idx="177">
                  <c:v>-3.5899863243103027</c:v>
                </c:pt>
                <c:pt idx="178">
                  <c:v>-3.584012508392334</c:v>
                </c:pt>
                <c:pt idx="179">
                  <c:v>-3.5780353546142578</c:v>
                </c:pt>
                <c:pt idx="180">
                  <c:v>-3.5720548629760742</c:v>
                </c:pt>
                <c:pt idx="181">
                  <c:v>-3.5660712718963623</c:v>
                </c:pt>
                <c:pt idx="182">
                  <c:v>-3.5600831508636475</c:v>
                </c:pt>
                <c:pt idx="183">
                  <c:v>-3.5540902614593506</c:v>
                </c:pt>
                <c:pt idx="184">
                  <c:v>-3.5480904579162598</c:v>
                </c:pt>
                <c:pt idx="185">
                  <c:v>-3.5420808792114258</c:v>
                </c:pt>
                <c:pt idx="186">
                  <c:v>-3.5360639095306396</c:v>
                </c:pt>
                <c:pt idx="187">
                  <c:v>-3.5300424098968506</c:v>
                </c:pt>
                <c:pt idx="188">
                  <c:v>-3.5240175724029541</c:v>
                </c:pt>
                <c:pt idx="189">
                  <c:v>-3.5179886817932129</c:v>
                </c:pt>
                <c:pt idx="190">
                  <c:v>-3.5119543075561523</c:v>
                </c:pt>
                <c:pt idx="191">
                  <c:v>-3.5059123039245605</c:v>
                </c:pt>
                <c:pt idx="192">
                  <c:v>-3.4998607635498047</c:v>
                </c:pt>
                <c:pt idx="193">
                  <c:v>-3.4938020706176758</c:v>
                </c:pt>
                <c:pt idx="194">
                  <c:v>-3.4877395629882813</c:v>
                </c:pt>
                <c:pt idx="195">
                  <c:v>-3.4816739559173584</c:v>
                </c:pt>
                <c:pt idx="196">
                  <c:v>-3.4756031036376953</c:v>
                </c:pt>
                <c:pt idx="197">
                  <c:v>-3.4695272445678711</c:v>
                </c:pt>
                <c:pt idx="198">
                  <c:v>-3.4634461402893066</c:v>
                </c:pt>
                <c:pt idx="199">
                  <c:v>-3.4573550224304199</c:v>
                </c:pt>
                <c:pt idx="200">
                  <c:v>-3.4512553215026855</c:v>
                </c:pt>
                <c:pt idx="201">
                  <c:v>-3.4451515674591064</c:v>
                </c:pt>
                <c:pt idx="202">
                  <c:v>-3.439044713973999</c:v>
                </c:pt>
                <c:pt idx="203">
                  <c:v>-3.4329342842102051</c:v>
                </c:pt>
                <c:pt idx="204">
                  <c:v>-3.4268193244934082</c:v>
                </c:pt>
                <c:pt idx="205">
                  <c:v>-3.4206976890563965</c:v>
                </c:pt>
                <c:pt idx="206">
                  <c:v>-3.4145703315734863</c:v>
                </c:pt>
                <c:pt idx="207">
                  <c:v>-3.4084348678588867</c:v>
                </c:pt>
                <c:pt idx="208">
                  <c:v>-3.4022910594940186</c:v>
                </c:pt>
                <c:pt idx="209">
                  <c:v>-3.3961427211761475</c:v>
                </c:pt>
                <c:pt idx="210">
                  <c:v>-3.3899908065795898</c:v>
                </c:pt>
                <c:pt idx="211">
                  <c:v>-3.3838355541229248</c:v>
                </c:pt>
                <c:pt idx="212">
                  <c:v>-3.3776764869689941</c:v>
                </c:pt>
                <c:pt idx="213">
                  <c:v>-3.3715133666992188</c:v>
                </c:pt>
                <c:pt idx="214">
                  <c:v>-3.3653430938720703</c:v>
                </c:pt>
                <c:pt idx="215">
                  <c:v>-3.3591666221618652</c:v>
                </c:pt>
                <c:pt idx="216">
                  <c:v>-3.3529810905456543</c:v>
                </c:pt>
                <c:pt idx="217">
                  <c:v>-3.3467888832092285</c:v>
                </c:pt>
                <c:pt idx="218">
                  <c:v>-3.3405921459197998</c:v>
                </c:pt>
                <c:pt idx="219">
                  <c:v>-3.3343918323516846</c:v>
                </c:pt>
                <c:pt idx="220">
                  <c:v>-3.3281881809234619</c:v>
                </c:pt>
                <c:pt idx="221">
                  <c:v>-3.3219809532165527</c:v>
                </c:pt>
                <c:pt idx="222">
                  <c:v>-3.3157694339752197</c:v>
                </c:pt>
                <c:pt idx="223">
                  <c:v>-3.3095521926879883</c:v>
                </c:pt>
                <c:pt idx="224">
                  <c:v>-3.303330659866333</c:v>
                </c:pt>
                <c:pt idx="225">
                  <c:v>-3.2971017360687256</c:v>
                </c:pt>
                <c:pt idx="226">
                  <c:v>-3.290863037109375</c:v>
                </c:pt>
                <c:pt idx="227">
                  <c:v>-3.2846183776855469</c:v>
                </c:pt>
                <c:pt idx="228">
                  <c:v>-3.278369665145874</c:v>
                </c:pt>
                <c:pt idx="229">
                  <c:v>-3.2721173763275146</c:v>
                </c:pt>
                <c:pt idx="230">
                  <c:v>-3.2658617496490479</c:v>
                </c:pt>
                <c:pt idx="231">
                  <c:v>-3.2596020698547363</c:v>
                </c:pt>
                <c:pt idx="232">
                  <c:v>-3.2533383369445801</c:v>
                </c:pt>
                <c:pt idx="233">
                  <c:v>-3.2470700740814209</c:v>
                </c:pt>
                <c:pt idx="234">
                  <c:v>-3.2407963275909424</c:v>
                </c:pt>
                <c:pt idx="235">
                  <c:v>-3.234515905380249</c:v>
                </c:pt>
                <c:pt idx="236">
                  <c:v>-3.2282278537750244</c:v>
                </c:pt>
                <c:pt idx="237">
                  <c:v>-3.221933126449585</c:v>
                </c:pt>
                <c:pt idx="238">
                  <c:v>-3.215632438659668</c:v>
                </c:pt>
                <c:pt idx="239">
                  <c:v>-3.2093276977539063</c:v>
                </c:pt>
                <c:pt idx="240">
                  <c:v>-3.2030196189880371</c:v>
                </c:pt>
                <c:pt idx="241">
                  <c:v>-3.1967082023620605</c:v>
                </c:pt>
                <c:pt idx="242">
                  <c:v>-3.1903927326202393</c:v>
                </c:pt>
                <c:pt idx="243">
                  <c:v>-3.184072732925415</c:v>
                </c:pt>
                <c:pt idx="244">
                  <c:v>-3.1777477264404297</c:v>
                </c:pt>
                <c:pt idx="245">
                  <c:v>-3.1714162826538086</c:v>
                </c:pt>
                <c:pt idx="246">
                  <c:v>-3.1650791168212891</c:v>
                </c:pt>
                <c:pt idx="247">
                  <c:v>-3.158733606338501</c:v>
                </c:pt>
                <c:pt idx="248">
                  <c:v>-3.1523807048797607</c:v>
                </c:pt>
                <c:pt idx="249">
                  <c:v>-3.1460237503051758</c:v>
                </c:pt>
                <c:pt idx="250">
                  <c:v>-3.1396629810333252</c:v>
                </c:pt>
                <c:pt idx="251">
                  <c:v>-3.1332988739013672</c:v>
                </c:pt>
                <c:pt idx="252">
                  <c:v>-3.1269311904907227</c:v>
                </c:pt>
                <c:pt idx="253">
                  <c:v>-3.1205601692199707</c:v>
                </c:pt>
                <c:pt idx="254">
                  <c:v>-3.1141858100891113</c:v>
                </c:pt>
                <c:pt idx="255">
                  <c:v>-3.1078078746795654</c:v>
                </c:pt>
                <c:pt idx="256">
                  <c:v>-3.101426362991333</c:v>
                </c:pt>
                <c:pt idx="257">
                  <c:v>-3.0950400829315186</c:v>
                </c:pt>
                <c:pt idx="258">
                  <c:v>-3.0886490345001221</c:v>
                </c:pt>
                <c:pt idx="259">
                  <c:v>-3.0822534561157227</c:v>
                </c:pt>
                <c:pt idx="260">
                  <c:v>-3.0758514404296875</c:v>
                </c:pt>
                <c:pt idx="261">
                  <c:v>-3.0694413185119629</c:v>
                </c:pt>
                <c:pt idx="262">
                  <c:v>-3.0630261898040771</c:v>
                </c:pt>
                <c:pt idx="263">
                  <c:v>-3.0566039085388184</c:v>
                </c:pt>
                <c:pt idx="264">
                  <c:v>-3.0501768589019775</c:v>
                </c:pt>
                <c:pt idx="265">
                  <c:v>-3.0437462329864502</c:v>
                </c:pt>
                <c:pt idx="266">
                  <c:v>-3.0373117923736572</c:v>
                </c:pt>
                <c:pt idx="267">
                  <c:v>-3.0308742523193359</c:v>
                </c:pt>
                <c:pt idx="268">
                  <c:v>-3.0244326591491699</c:v>
                </c:pt>
                <c:pt idx="269">
                  <c:v>-3.0179867744445801</c:v>
                </c:pt>
                <c:pt idx="270">
                  <c:v>-3.0115375518798828</c:v>
                </c:pt>
                <c:pt idx="271">
                  <c:v>-3.0050826072692871</c:v>
                </c:pt>
                <c:pt idx="272">
                  <c:v>-2.9986245632171631</c:v>
                </c:pt>
                <c:pt idx="273">
                  <c:v>-2.9921591281890869</c:v>
                </c:pt>
                <c:pt idx="274">
                  <c:v>-2.9856882095336914</c:v>
                </c:pt>
                <c:pt idx="275">
                  <c:v>-2.979210376739502</c:v>
                </c:pt>
                <c:pt idx="276">
                  <c:v>-2.9727251529693604</c:v>
                </c:pt>
                <c:pt idx="277">
                  <c:v>-2.9662342071533203</c:v>
                </c:pt>
                <c:pt idx="278">
                  <c:v>-2.959740161895752</c:v>
                </c:pt>
                <c:pt idx="279">
                  <c:v>-2.9532420635223389</c:v>
                </c:pt>
                <c:pt idx="280">
                  <c:v>-2.9467406272888184</c:v>
                </c:pt>
                <c:pt idx="281">
                  <c:v>-2.9402358531951904</c:v>
                </c:pt>
                <c:pt idx="282">
                  <c:v>-2.9337265491485596</c:v>
                </c:pt>
                <c:pt idx="283">
                  <c:v>-2.9272141456604004</c:v>
                </c:pt>
                <c:pt idx="284">
                  <c:v>-2.9206960201263428</c:v>
                </c:pt>
                <c:pt idx="285">
                  <c:v>-2.9141733646392822</c:v>
                </c:pt>
                <c:pt idx="286">
                  <c:v>-2.9076459407806396</c:v>
                </c:pt>
                <c:pt idx="287">
                  <c:v>-2.9011120796203613</c:v>
                </c:pt>
                <c:pt idx="288">
                  <c:v>-2.8945739269256592</c:v>
                </c:pt>
                <c:pt idx="289">
                  <c:v>-2.8880288600921631</c:v>
                </c:pt>
                <c:pt idx="290">
                  <c:v>-2.881476879119873</c:v>
                </c:pt>
                <c:pt idx="291">
                  <c:v>-2.8749196529388428</c:v>
                </c:pt>
                <c:pt idx="292">
                  <c:v>-2.8683576583862305</c:v>
                </c:pt>
                <c:pt idx="293">
                  <c:v>-2.8617925643920898</c:v>
                </c:pt>
                <c:pt idx="294">
                  <c:v>-2.8552234172821045</c:v>
                </c:pt>
                <c:pt idx="295">
                  <c:v>-2.8486511707305908</c:v>
                </c:pt>
                <c:pt idx="296">
                  <c:v>-2.8420751094818115</c:v>
                </c:pt>
                <c:pt idx="297">
                  <c:v>-2.8354957103729248</c:v>
                </c:pt>
                <c:pt idx="298">
                  <c:v>-2.8289120197296143</c:v>
                </c:pt>
                <c:pt idx="299">
                  <c:v>-2.822324275970459</c:v>
                </c:pt>
                <c:pt idx="300">
                  <c:v>-2.8157320022583008</c:v>
                </c:pt>
                <c:pt idx="301">
                  <c:v>-2.8091330528259277</c:v>
                </c:pt>
                <c:pt idx="302">
                  <c:v>-2.8025310039520264</c:v>
                </c:pt>
                <c:pt idx="303">
                  <c:v>-2.7959229946136475</c:v>
                </c:pt>
                <c:pt idx="304">
                  <c:v>-2.7893083095550537</c:v>
                </c:pt>
                <c:pt idx="305">
                  <c:v>-2.782686710357666</c:v>
                </c:pt>
                <c:pt idx="306">
                  <c:v>-2.7760593891143799</c:v>
                </c:pt>
                <c:pt idx="307">
                  <c:v>-2.7694261074066162</c:v>
                </c:pt>
                <c:pt idx="308">
                  <c:v>-2.762789249420166</c:v>
                </c:pt>
                <c:pt idx="309">
                  <c:v>-2.7561488151550293</c:v>
                </c:pt>
                <c:pt idx="310">
                  <c:v>-2.7495050430297852</c:v>
                </c:pt>
                <c:pt idx="311">
                  <c:v>-2.7428576946258545</c:v>
                </c:pt>
                <c:pt idx="312">
                  <c:v>-2.7362065315246582</c:v>
                </c:pt>
                <c:pt idx="313">
                  <c:v>-2.7295520305633545</c:v>
                </c:pt>
                <c:pt idx="314">
                  <c:v>-2.722893238067627</c:v>
                </c:pt>
                <c:pt idx="315">
                  <c:v>-2.7162303924560547</c:v>
                </c:pt>
                <c:pt idx="316">
                  <c:v>-2.7095625400543213</c:v>
                </c:pt>
                <c:pt idx="317">
                  <c:v>-2.7028903961181641</c:v>
                </c:pt>
                <c:pt idx="318">
                  <c:v>-2.6962132453918457</c:v>
                </c:pt>
                <c:pt idx="319">
                  <c:v>-2.6895279884338379</c:v>
                </c:pt>
                <c:pt idx="320">
                  <c:v>-2.6828393936157227</c:v>
                </c:pt>
                <c:pt idx="321">
                  <c:v>-2.6761434078216553</c:v>
                </c:pt>
                <c:pt idx="322">
                  <c:v>-2.669440746307373</c:v>
                </c:pt>
                <c:pt idx="323">
                  <c:v>-2.6627340316772461</c:v>
                </c:pt>
                <c:pt idx="324">
                  <c:v>-2.6560220718383789</c:v>
                </c:pt>
                <c:pt idx="325">
                  <c:v>-2.6493062973022461</c:v>
                </c:pt>
                <c:pt idx="326">
                  <c:v>-2.6425871849060059</c:v>
                </c:pt>
                <c:pt idx="327">
                  <c:v>-2.6358644962310791</c:v>
                </c:pt>
                <c:pt idx="328">
                  <c:v>-2.6291382312774658</c:v>
                </c:pt>
                <c:pt idx="329">
                  <c:v>-2.6224086284637451</c:v>
                </c:pt>
                <c:pt idx="330">
                  <c:v>-2.6156747341156006</c:v>
                </c:pt>
                <c:pt idx="331">
                  <c:v>-2.6089379787445068</c:v>
                </c:pt>
                <c:pt idx="332">
                  <c:v>-2.602196216583252</c:v>
                </c:pt>
                <c:pt idx="333">
                  <c:v>-2.5954487323760986</c:v>
                </c:pt>
                <c:pt idx="334">
                  <c:v>-2.5886974334716797</c:v>
                </c:pt>
                <c:pt idx="335">
                  <c:v>-2.5819411277770996</c:v>
                </c:pt>
                <c:pt idx="336">
                  <c:v>-2.5751798152923584</c:v>
                </c:pt>
                <c:pt idx="337">
                  <c:v>-2.5684127807617188</c:v>
                </c:pt>
                <c:pt idx="338">
                  <c:v>-2.5616393089294434</c:v>
                </c:pt>
                <c:pt idx="339">
                  <c:v>-2.5548603534698486</c:v>
                </c:pt>
                <c:pt idx="340">
                  <c:v>-2.5480751991271973</c:v>
                </c:pt>
                <c:pt idx="341">
                  <c:v>-2.5412852764129639</c:v>
                </c:pt>
                <c:pt idx="342">
                  <c:v>-2.5344908237457275</c:v>
                </c:pt>
                <c:pt idx="343">
                  <c:v>-2.5276923179626465</c:v>
                </c:pt>
                <c:pt idx="344">
                  <c:v>-2.5208902359008789</c:v>
                </c:pt>
                <c:pt idx="345">
                  <c:v>-2.5140848159790039</c:v>
                </c:pt>
                <c:pt idx="346">
                  <c:v>-2.5072755813598633</c:v>
                </c:pt>
                <c:pt idx="347">
                  <c:v>-2.5004630088806152</c:v>
                </c:pt>
                <c:pt idx="348">
                  <c:v>-2.4936463832855225</c:v>
                </c:pt>
                <c:pt idx="349">
                  <c:v>-2.4868264198303223</c:v>
                </c:pt>
                <c:pt idx="350">
                  <c:v>-2.4800019264221191</c:v>
                </c:pt>
                <c:pt idx="351">
                  <c:v>-2.4731738567352295</c:v>
                </c:pt>
                <c:pt idx="352">
                  <c:v>-2.466341495513916</c:v>
                </c:pt>
                <c:pt idx="353">
                  <c:v>-2.4595046043395996</c:v>
                </c:pt>
                <c:pt idx="354">
                  <c:v>-2.4526641368865967</c:v>
                </c:pt>
                <c:pt idx="355">
                  <c:v>-2.4458181858062744</c:v>
                </c:pt>
                <c:pt idx="356">
                  <c:v>-2.4389698505401611</c:v>
                </c:pt>
                <c:pt idx="357">
                  <c:v>-2.4321153163909912</c:v>
                </c:pt>
                <c:pt idx="358">
                  <c:v>-2.4252579212188721</c:v>
                </c:pt>
                <c:pt idx="359">
                  <c:v>-2.4183957576751709</c:v>
                </c:pt>
                <c:pt idx="360">
                  <c:v>-2.411529541015625</c:v>
                </c:pt>
                <c:pt idx="361">
                  <c:v>-2.4046580791473389</c:v>
                </c:pt>
                <c:pt idx="362">
                  <c:v>-2.3977813720703125</c:v>
                </c:pt>
                <c:pt idx="363">
                  <c:v>-2.3908998966217041</c:v>
                </c:pt>
                <c:pt idx="364">
                  <c:v>-2.3840141296386719</c:v>
                </c:pt>
                <c:pt idx="365">
                  <c:v>-2.3771231174468994</c:v>
                </c:pt>
                <c:pt idx="366">
                  <c:v>-2.3702270984649658</c:v>
                </c:pt>
                <c:pt idx="367">
                  <c:v>-2.3633263111114502</c:v>
                </c:pt>
                <c:pt idx="368">
                  <c:v>-2.3564200401306152</c:v>
                </c:pt>
                <c:pt idx="369">
                  <c:v>-2.3495101928710938</c:v>
                </c:pt>
                <c:pt idx="370">
                  <c:v>-2.3425967693328857</c:v>
                </c:pt>
                <c:pt idx="371">
                  <c:v>-2.3356795310974121</c:v>
                </c:pt>
                <c:pt idx="372">
                  <c:v>-2.3287584781646729</c:v>
                </c:pt>
                <c:pt idx="373">
                  <c:v>-2.3218340873718262</c:v>
                </c:pt>
                <c:pt idx="374">
                  <c:v>-2.314906120300293</c:v>
                </c:pt>
                <c:pt idx="375">
                  <c:v>-2.3079745769500732</c:v>
                </c:pt>
                <c:pt idx="376">
                  <c:v>-2.301039457321167</c:v>
                </c:pt>
                <c:pt idx="377">
                  <c:v>-2.2941005229949951</c:v>
                </c:pt>
                <c:pt idx="378">
                  <c:v>-2.2871580123901367</c:v>
                </c:pt>
                <c:pt idx="379">
                  <c:v>-2.2802112102508545</c:v>
                </c:pt>
                <c:pt idx="380">
                  <c:v>-2.2732613086700439</c:v>
                </c:pt>
                <c:pt idx="381">
                  <c:v>-2.2663071155548096</c:v>
                </c:pt>
                <c:pt idx="382">
                  <c:v>-2.2593486309051514</c:v>
                </c:pt>
                <c:pt idx="383">
                  <c:v>-2.2523858547210693</c:v>
                </c:pt>
                <c:pt idx="384">
                  <c:v>-2.2454190254211426</c:v>
                </c:pt>
                <c:pt idx="385">
                  <c:v>-2.2384481430053711</c:v>
                </c:pt>
                <c:pt idx="386">
                  <c:v>-2.2314739227294922</c:v>
                </c:pt>
                <c:pt idx="387">
                  <c:v>-2.2244932651519775</c:v>
                </c:pt>
                <c:pt idx="388">
                  <c:v>-2.2175092697143555</c:v>
                </c:pt>
                <c:pt idx="389">
                  <c:v>-2.210519552230835</c:v>
                </c:pt>
                <c:pt idx="390">
                  <c:v>-2.2035253047943115</c:v>
                </c:pt>
                <c:pt idx="391">
                  <c:v>-2.1965262889862061</c:v>
                </c:pt>
                <c:pt idx="392">
                  <c:v>-2.1895210742950439</c:v>
                </c:pt>
                <c:pt idx="393">
                  <c:v>-2.1825113296508789</c:v>
                </c:pt>
                <c:pt idx="394">
                  <c:v>-2.175494909286499</c:v>
                </c:pt>
                <c:pt idx="395">
                  <c:v>-2.1684746742248535</c:v>
                </c:pt>
                <c:pt idx="396">
                  <c:v>-2.1614503860473633</c:v>
                </c:pt>
                <c:pt idx="397">
                  <c:v>-2.154421329498291</c:v>
                </c:pt>
                <c:pt idx="398">
                  <c:v>-2.1473889350891113</c:v>
                </c:pt>
                <c:pt idx="399">
                  <c:v>-2.1403520107269287</c:v>
                </c:pt>
                <c:pt idx="400">
                  <c:v>-2.1333115100860596</c:v>
                </c:pt>
                <c:pt idx="401">
                  <c:v>-2.1262674331665039</c:v>
                </c:pt>
                <c:pt idx="402">
                  <c:v>-2.1192197799682617</c:v>
                </c:pt>
                <c:pt idx="403">
                  <c:v>-2.1121687889099121</c:v>
                </c:pt>
                <c:pt idx="404">
                  <c:v>-2.1051139831542969</c:v>
                </c:pt>
                <c:pt idx="405">
                  <c:v>-2.0980556011199951</c:v>
                </c:pt>
                <c:pt idx="406">
                  <c:v>-2.0909936428070068</c:v>
                </c:pt>
                <c:pt idx="407">
                  <c:v>-2.0839283466339111</c:v>
                </c:pt>
                <c:pt idx="408">
                  <c:v>-2.0768592357635498</c:v>
                </c:pt>
                <c:pt idx="409">
                  <c:v>-2.0697867870330811</c:v>
                </c:pt>
                <c:pt idx="410">
                  <c:v>-2.0627105236053467</c:v>
                </c:pt>
                <c:pt idx="411">
                  <c:v>-2.0556309223175049</c:v>
                </c:pt>
                <c:pt idx="412">
                  <c:v>-2.0485475063323975</c:v>
                </c:pt>
                <c:pt idx="413">
                  <c:v>-2.0414602756500244</c:v>
                </c:pt>
                <c:pt idx="414">
                  <c:v>-2.0343692302703857</c:v>
                </c:pt>
                <c:pt idx="415">
                  <c:v>-2.0272743701934814</c:v>
                </c:pt>
                <c:pt idx="416">
                  <c:v>-2.0201752185821533</c:v>
                </c:pt>
                <c:pt idx="417">
                  <c:v>-2.0130715370178223</c:v>
                </c:pt>
                <c:pt idx="418">
                  <c:v>-2.0059645175933838</c:v>
                </c:pt>
                <c:pt idx="419">
                  <c:v>-1.9988528490066528</c:v>
                </c:pt>
                <c:pt idx="420">
                  <c:v>-1.9917365312576294</c:v>
                </c:pt>
                <c:pt idx="421">
                  <c:v>-1.9846161603927612</c:v>
                </c:pt>
                <c:pt idx="422">
                  <c:v>-1.9774911403656006</c:v>
                </c:pt>
                <c:pt idx="423">
                  <c:v>-1.9703612327575684</c:v>
                </c:pt>
                <c:pt idx="424">
                  <c:v>-1.9632256031036377</c:v>
                </c:pt>
                <c:pt idx="425">
                  <c:v>-1.9560854434967041</c:v>
                </c:pt>
                <c:pt idx="426">
                  <c:v>-1.9489401578903198</c:v>
                </c:pt>
                <c:pt idx="427">
                  <c:v>-1.9417884349822998</c:v>
                </c:pt>
                <c:pt idx="428">
                  <c:v>-1.9346327781677246</c:v>
                </c:pt>
                <c:pt idx="429">
                  <c:v>-1.9274709224700928</c:v>
                </c:pt>
                <c:pt idx="430">
                  <c:v>-1.920305609703064</c:v>
                </c:pt>
                <c:pt idx="431">
                  <c:v>-1.913135290145874</c:v>
                </c:pt>
                <c:pt idx="432">
                  <c:v>-1.9059618711471558</c:v>
                </c:pt>
                <c:pt idx="433">
                  <c:v>-1.898783802986145</c:v>
                </c:pt>
                <c:pt idx="434">
                  <c:v>-1.8916015625</c:v>
                </c:pt>
                <c:pt idx="435">
                  <c:v>-1.8844159841537476</c:v>
                </c:pt>
                <c:pt idx="436">
                  <c:v>-1.8772265911102295</c:v>
                </c:pt>
                <c:pt idx="437">
                  <c:v>-1.8700336217880249</c:v>
                </c:pt>
                <c:pt idx="438">
                  <c:v>-1.8628369569778442</c:v>
                </c:pt>
                <c:pt idx="439">
                  <c:v>-1.8556368350982666</c:v>
                </c:pt>
                <c:pt idx="440">
                  <c:v>-1.8484330177307129</c:v>
                </c:pt>
                <c:pt idx="441">
                  <c:v>-1.8412256240844727</c:v>
                </c:pt>
                <c:pt idx="442">
                  <c:v>-1.8340147733688354</c:v>
                </c:pt>
                <c:pt idx="443">
                  <c:v>-1.8267998695373535</c:v>
                </c:pt>
                <c:pt idx="444">
                  <c:v>-1.8195815086364746</c:v>
                </c:pt>
                <c:pt idx="445">
                  <c:v>-1.8123594522476196</c:v>
                </c:pt>
                <c:pt idx="446">
                  <c:v>-1.8051332235336304</c:v>
                </c:pt>
                <c:pt idx="447">
                  <c:v>-1.7979040145874023</c:v>
                </c:pt>
                <c:pt idx="448">
                  <c:v>-1.79067063331604</c:v>
                </c:pt>
                <c:pt idx="449">
                  <c:v>-1.7834327220916748</c:v>
                </c:pt>
                <c:pt idx="450">
                  <c:v>-1.7761907577514648</c:v>
                </c:pt>
                <c:pt idx="451">
                  <c:v>-1.7689449787139893</c:v>
                </c:pt>
                <c:pt idx="452">
                  <c:v>-1.7616959810256958</c:v>
                </c:pt>
                <c:pt idx="453">
                  <c:v>-1.7544430494308472</c:v>
                </c:pt>
                <c:pt idx="454">
                  <c:v>-1.7471855878829956</c:v>
                </c:pt>
                <c:pt idx="455">
                  <c:v>-1.7399234771728516</c:v>
                </c:pt>
                <c:pt idx="456">
                  <c:v>-1.7326571941375732</c:v>
                </c:pt>
                <c:pt idx="457">
                  <c:v>-1.725386381149292</c:v>
                </c:pt>
                <c:pt idx="458">
                  <c:v>-1.7181123495101929</c:v>
                </c:pt>
                <c:pt idx="459">
                  <c:v>-1.7108330726623535</c:v>
                </c:pt>
                <c:pt idx="460">
                  <c:v>-1.7035495042800903</c:v>
                </c:pt>
                <c:pt idx="461">
                  <c:v>-1.6962617635726929</c:v>
                </c:pt>
                <c:pt idx="462">
                  <c:v>-1.6889678239822388</c:v>
                </c:pt>
                <c:pt idx="463">
                  <c:v>-1.681667685508728</c:v>
                </c:pt>
                <c:pt idx="464">
                  <c:v>-1.6743628978729248</c:v>
                </c:pt>
                <c:pt idx="465">
                  <c:v>-1.667055606842041</c:v>
                </c:pt>
                <c:pt idx="466">
                  <c:v>-1.6597398519515991</c:v>
                </c:pt>
                <c:pt idx="467">
                  <c:v>-1.6524207592010498</c:v>
                </c:pt>
                <c:pt idx="468">
                  <c:v>-1.645098090171814</c:v>
                </c:pt>
                <c:pt idx="469">
                  <c:v>-1.6377699375152588</c:v>
                </c:pt>
                <c:pt idx="470">
                  <c:v>-1.6304380893707275</c:v>
                </c:pt>
                <c:pt idx="471">
                  <c:v>-1.6231024265289307</c:v>
                </c:pt>
                <c:pt idx="472">
                  <c:v>-1.6157630681991577</c:v>
                </c:pt>
                <c:pt idx="473">
                  <c:v>-1.6084201335906982</c:v>
                </c:pt>
                <c:pt idx="474">
                  <c:v>-1.6010736227035522</c:v>
                </c:pt>
                <c:pt idx="475">
                  <c:v>-1.5937235355377197</c:v>
                </c:pt>
                <c:pt idx="476">
                  <c:v>-1.5863697528839111</c:v>
                </c:pt>
                <c:pt idx="477">
                  <c:v>-1.5790125131607056</c:v>
                </c:pt>
                <c:pt idx="478">
                  <c:v>-1.5716515779495239</c:v>
                </c:pt>
                <c:pt idx="479">
                  <c:v>-1.5642869472503662</c:v>
                </c:pt>
                <c:pt idx="480">
                  <c:v>-1.5569185018539429</c:v>
                </c:pt>
                <c:pt idx="481">
                  <c:v>-1.5495468378067017</c:v>
                </c:pt>
                <c:pt idx="482">
                  <c:v>-1.5421701669692993</c:v>
                </c:pt>
                <c:pt idx="483">
                  <c:v>-1.5347906351089478</c:v>
                </c:pt>
                <c:pt idx="484">
                  <c:v>-1.5274064540863037</c:v>
                </c:pt>
                <c:pt idx="485">
                  <c:v>-1.5200190544128418</c:v>
                </c:pt>
                <c:pt idx="486">
                  <c:v>-1.5126276016235352</c:v>
                </c:pt>
                <c:pt idx="487">
                  <c:v>-1.5052326917648315</c:v>
                </c:pt>
                <c:pt idx="488">
                  <c:v>-1.4978331327438354</c:v>
                </c:pt>
                <c:pt idx="489">
                  <c:v>-1.4904290437698364</c:v>
                </c:pt>
                <c:pt idx="490">
                  <c:v>-1.48302161693573</c:v>
                </c:pt>
                <c:pt idx="491">
                  <c:v>-1.475608229637146</c:v>
                </c:pt>
                <c:pt idx="492">
                  <c:v>-1.4681919813156128</c:v>
                </c:pt>
                <c:pt idx="493">
                  <c:v>-1.4607712030410767</c:v>
                </c:pt>
                <c:pt idx="494">
                  <c:v>-1.4533467292785645</c:v>
                </c:pt>
                <c:pt idx="495">
                  <c:v>-1.4459167718887329</c:v>
                </c:pt>
                <c:pt idx="496">
                  <c:v>-1.438482403755188</c:v>
                </c:pt>
                <c:pt idx="497">
                  <c:v>-1.4310415983200073</c:v>
                </c:pt>
                <c:pt idx="498">
                  <c:v>-1.4235978126525879</c:v>
                </c:pt>
                <c:pt idx="499">
                  <c:v>-1.4161487817764282</c:v>
                </c:pt>
                <c:pt idx="500">
                  <c:v>-1.4086917638778687</c:v>
                </c:pt>
                <c:pt idx="501">
                  <c:v>-1.4012296199798584</c:v>
                </c:pt>
                <c:pt idx="502">
                  <c:v>-1.3937641382217407</c:v>
                </c:pt>
                <c:pt idx="503">
                  <c:v>-1.3862943649291992</c:v>
                </c:pt>
                <c:pt idx="504">
                  <c:v>-1.3788195848464966</c:v>
                </c:pt>
                <c:pt idx="505">
                  <c:v>-1.371341347694397</c:v>
                </c:pt>
                <c:pt idx="506">
                  <c:v>-1.363858699798584</c:v>
                </c:pt>
                <c:pt idx="507">
                  <c:v>-1.3563721179962158</c:v>
                </c:pt>
                <c:pt idx="508">
                  <c:v>-1.3488819599151611</c:v>
                </c:pt>
                <c:pt idx="509">
                  <c:v>-1.3413882255554199</c:v>
                </c:pt>
                <c:pt idx="510">
                  <c:v>-1.3338907957077026</c:v>
                </c:pt>
                <c:pt idx="511">
                  <c:v>-1.3263897895812988</c:v>
                </c:pt>
                <c:pt idx="512">
                  <c:v>-1.3188852071762085</c:v>
                </c:pt>
                <c:pt idx="513">
                  <c:v>-1.3113769292831421</c:v>
                </c:pt>
                <c:pt idx="514">
                  <c:v>-1.3038650751113892</c:v>
                </c:pt>
                <c:pt idx="515">
                  <c:v>-1.2963492870330811</c:v>
                </c:pt>
                <c:pt idx="516">
                  <c:v>-1.2888295650482178</c:v>
                </c:pt>
                <c:pt idx="517">
                  <c:v>-1.2813065052032471</c:v>
                </c:pt>
                <c:pt idx="518">
                  <c:v>-1.2737787961959839</c:v>
                </c:pt>
                <c:pt idx="519">
                  <c:v>-1.2662472724914551</c:v>
                </c:pt>
                <c:pt idx="520">
                  <c:v>-1.2587109804153442</c:v>
                </c:pt>
                <c:pt idx="521">
                  <c:v>-1.2511712312698364</c:v>
                </c:pt>
                <c:pt idx="522">
                  <c:v>-1.2436263561248779</c:v>
                </c:pt>
                <c:pt idx="523">
                  <c:v>-1.2360769510269165</c:v>
                </c:pt>
                <c:pt idx="524">
                  <c:v>-1.2285246849060059</c:v>
                </c:pt>
                <c:pt idx="525">
                  <c:v>-1.2209672927856445</c:v>
                </c:pt>
                <c:pt idx="526">
                  <c:v>-1.2134068012237549</c:v>
                </c:pt>
                <c:pt idx="527">
                  <c:v>-1.2058402299880981</c:v>
                </c:pt>
                <c:pt idx="528">
                  <c:v>-1.1982700824737549</c:v>
                </c:pt>
                <c:pt idx="529">
                  <c:v>-1.1906929016113281</c:v>
                </c:pt>
                <c:pt idx="530">
                  <c:v>-1.1831091642379761</c:v>
                </c:pt>
                <c:pt idx="531">
                  <c:v>-1.1755211353302002</c:v>
                </c:pt>
                <c:pt idx="532">
                  <c:v>-1.1679266691207886</c:v>
                </c:pt>
                <c:pt idx="533">
                  <c:v>-1.1603274345397949</c:v>
                </c:pt>
                <c:pt idx="534">
                  <c:v>-1.1527230739593506</c:v>
                </c:pt>
                <c:pt idx="535">
                  <c:v>-1.1451144218444824</c:v>
                </c:pt>
                <c:pt idx="536">
                  <c:v>-1.1375019550323486</c:v>
                </c:pt>
                <c:pt idx="537">
                  <c:v>-1.1298853158950806</c:v>
                </c:pt>
                <c:pt idx="538">
                  <c:v>-1.1222652196884155</c:v>
                </c:pt>
                <c:pt idx="539">
                  <c:v>-1.1146413087844849</c:v>
                </c:pt>
                <c:pt idx="540">
                  <c:v>-1.1070142984390259</c:v>
                </c:pt>
                <c:pt idx="541">
                  <c:v>-1.0993832349777222</c:v>
                </c:pt>
                <c:pt idx="542">
                  <c:v>-1.0917484760284424</c:v>
                </c:pt>
                <c:pt idx="543">
                  <c:v>-1.0841101408004761</c:v>
                </c:pt>
                <c:pt idx="544">
                  <c:v>-1.0764681100845337</c:v>
                </c:pt>
                <c:pt idx="545">
                  <c:v>-1.0688225030899048</c:v>
                </c:pt>
                <c:pt idx="546">
                  <c:v>-1.0611733198165894</c:v>
                </c:pt>
                <c:pt idx="547">
                  <c:v>-1.0535204410552979</c:v>
                </c:pt>
                <c:pt idx="548">
                  <c:v>-1.0458639860153198</c:v>
                </c:pt>
                <c:pt idx="549">
                  <c:v>-1.0382034778594971</c:v>
                </c:pt>
                <c:pt idx="550">
                  <c:v>-1.0305393934249878</c:v>
                </c:pt>
                <c:pt idx="551">
                  <c:v>-1.0228712558746338</c:v>
                </c:pt>
                <c:pt idx="552">
                  <c:v>-1.0151991844177246</c:v>
                </c:pt>
                <c:pt idx="553">
                  <c:v>-1.0075238943099976</c:v>
                </c:pt>
                <c:pt idx="554">
                  <c:v>-0.99984455108642578</c:v>
                </c:pt>
                <c:pt idx="555">
                  <c:v>-0.99216026067733765</c:v>
                </c:pt>
                <c:pt idx="556">
                  <c:v>-0.98447203636169434</c:v>
                </c:pt>
                <c:pt idx="557">
                  <c:v>-0.9767804741859436</c:v>
                </c:pt>
                <c:pt idx="558">
                  <c:v>-0.96908456087112427</c:v>
                </c:pt>
                <c:pt idx="559">
                  <c:v>-0.96138471364974976</c:v>
                </c:pt>
                <c:pt idx="560">
                  <c:v>-0.9536815881729126</c:v>
                </c:pt>
                <c:pt idx="561">
                  <c:v>-0.94597345590591431</c:v>
                </c:pt>
                <c:pt idx="562">
                  <c:v>-0.93826240301132202</c:v>
                </c:pt>
                <c:pt idx="563">
                  <c:v>-0.93054598569869995</c:v>
                </c:pt>
                <c:pt idx="564">
                  <c:v>-0.92282724380493164</c:v>
                </c:pt>
                <c:pt idx="565">
                  <c:v>-0.91510355472564697</c:v>
                </c:pt>
                <c:pt idx="566">
                  <c:v>-0.90737658739089966</c:v>
                </c:pt>
                <c:pt idx="567">
                  <c:v>-0.89964598417282104</c:v>
                </c:pt>
                <c:pt idx="568">
                  <c:v>-0.89191240072250366</c:v>
                </c:pt>
                <c:pt idx="569">
                  <c:v>-0.88417387008666992</c:v>
                </c:pt>
                <c:pt idx="570">
                  <c:v>-0.87643164396286011</c:v>
                </c:pt>
                <c:pt idx="571">
                  <c:v>-0.86868447065353394</c:v>
                </c:pt>
                <c:pt idx="572">
                  <c:v>-0.86093497276306152</c:v>
                </c:pt>
                <c:pt idx="573">
                  <c:v>-0.85318118333816528</c:v>
                </c:pt>
                <c:pt idx="574">
                  <c:v>-0.84542447328567505</c:v>
                </c:pt>
                <c:pt idx="575">
                  <c:v>-0.83766239881515503</c:v>
                </c:pt>
                <c:pt idx="576">
                  <c:v>-0.82989734411239624</c:v>
                </c:pt>
                <c:pt idx="577">
                  <c:v>-0.82212728261947632</c:v>
                </c:pt>
                <c:pt idx="578">
                  <c:v>-0.81435602903366089</c:v>
                </c:pt>
                <c:pt idx="579">
                  <c:v>-0.80657976865768433</c:v>
                </c:pt>
                <c:pt idx="580">
                  <c:v>-0.79880052804946899</c:v>
                </c:pt>
                <c:pt idx="581">
                  <c:v>-0.79101765155792236</c:v>
                </c:pt>
                <c:pt idx="582">
                  <c:v>-0.78323149681091309</c:v>
                </c:pt>
                <c:pt idx="583">
                  <c:v>-0.77544069290161133</c:v>
                </c:pt>
                <c:pt idx="584">
                  <c:v>-0.76764762401580811</c:v>
                </c:pt>
                <c:pt idx="585">
                  <c:v>-0.75984984636306763</c:v>
                </c:pt>
                <c:pt idx="586">
                  <c:v>-0.75204914808273315</c:v>
                </c:pt>
                <c:pt idx="587">
                  <c:v>-0.74424415826797485</c:v>
                </c:pt>
                <c:pt idx="588">
                  <c:v>-0.73643726110458374</c:v>
                </c:pt>
                <c:pt idx="589">
                  <c:v>-0.72862666845321655</c:v>
                </c:pt>
                <c:pt idx="590">
                  <c:v>-0.72081387042999268</c:v>
                </c:pt>
                <c:pt idx="591">
                  <c:v>-0.71299707889556885</c:v>
                </c:pt>
                <c:pt idx="592">
                  <c:v>-0.70517635345458984</c:v>
                </c:pt>
                <c:pt idx="593">
                  <c:v>-0.69735294580459595</c:v>
                </c:pt>
                <c:pt idx="594">
                  <c:v>-0.68952596187591553</c:v>
                </c:pt>
                <c:pt idx="595">
                  <c:v>-0.68169605731964111</c:v>
                </c:pt>
                <c:pt idx="596">
                  <c:v>-0.6738625168800354</c:v>
                </c:pt>
                <c:pt idx="597">
                  <c:v>-0.66602462530136108</c:v>
                </c:pt>
                <c:pt idx="598">
                  <c:v>-0.65818345546722412</c:v>
                </c:pt>
                <c:pt idx="599">
                  <c:v>-0.65033972263336182</c:v>
                </c:pt>
                <c:pt idx="600">
                  <c:v>-0.64249300956726074</c:v>
                </c:pt>
                <c:pt idx="601">
                  <c:v>-0.63464236259460449</c:v>
                </c:pt>
                <c:pt idx="602">
                  <c:v>-0.62678980827331543</c:v>
                </c:pt>
                <c:pt idx="603">
                  <c:v>-0.61893290281295776</c:v>
                </c:pt>
                <c:pt idx="604">
                  <c:v>-0.61107277870178223</c:v>
                </c:pt>
                <c:pt idx="605">
                  <c:v>-0.60320931673049927</c:v>
                </c:pt>
                <c:pt idx="606">
                  <c:v>-0.59534227848052979</c:v>
                </c:pt>
                <c:pt idx="607">
                  <c:v>-0.587471604347229</c:v>
                </c:pt>
                <c:pt idx="608">
                  <c:v>-0.57959729433059692</c:v>
                </c:pt>
                <c:pt idx="609">
                  <c:v>-0.57171934843063354</c:v>
                </c:pt>
                <c:pt idx="610">
                  <c:v>-0.56383776664733887</c:v>
                </c:pt>
                <c:pt idx="611">
                  <c:v>-0.55595260858535767</c:v>
                </c:pt>
                <c:pt idx="612">
                  <c:v>-0.54806381464004517</c:v>
                </c:pt>
                <c:pt idx="613">
                  <c:v>-0.54017138481140137</c:v>
                </c:pt>
                <c:pt idx="614">
                  <c:v>-0.53227531909942627</c:v>
                </c:pt>
                <c:pt idx="615">
                  <c:v>-0.52437567710876465</c:v>
                </c:pt>
                <c:pt idx="616">
                  <c:v>-0.51647233963012695</c:v>
                </c:pt>
                <c:pt idx="617">
                  <c:v>-0.50856542587280273</c:v>
                </c:pt>
                <c:pt idx="618">
                  <c:v>-0.50065487623214722</c:v>
                </c:pt>
                <c:pt idx="619">
                  <c:v>-0.49274072051048279</c:v>
                </c:pt>
                <c:pt idx="620">
                  <c:v>-0.48482292890548706</c:v>
                </c:pt>
                <c:pt idx="621">
                  <c:v>-0.47690150141716003</c:v>
                </c:pt>
                <c:pt idx="622">
                  <c:v>-0.4689764678478241</c:v>
                </c:pt>
                <c:pt idx="623">
                  <c:v>-0.46104782819747925</c:v>
                </c:pt>
                <c:pt idx="624">
                  <c:v>-0.45311552286148071</c:v>
                </c:pt>
                <c:pt idx="625">
                  <c:v>-0.44517964124679565</c:v>
                </c:pt>
                <c:pt idx="626">
                  <c:v>-0.43724009394645691</c:v>
                </c:pt>
                <c:pt idx="627">
                  <c:v>-0.42929697036743164</c:v>
                </c:pt>
                <c:pt idx="628">
                  <c:v>-0.42135018110275269</c:v>
                </c:pt>
                <c:pt idx="629">
                  <c:v>-0.41339978575706482</c:v>
                </c:pt>
                <c:pt idx="630">
                  <c:v>-0.40544578433036804</c:v>
                </c:pt>
                <c:pt idx="631">
                  <c:v>-0.39748814702033997</c:v>
                </c:pt>
                <c:pt idx="632">
                  <c:v>-0.38952690362930298</c:v>
                </c:pt>
                <c:pt idx="633">
                  <c:v>-0.38156202435493469</c:v>
                </c:pt>
                <c:pt idx="634">
                  <c:v>-0.37359350919723511</c:v>
                </c:pt>
                <c:pt idx="635">
                  <c:v>-0.36562106013298035</c:v>
                </c:pt>
                <c:pt idx="636">
                  <c:v>-0.35764458775520325</c:v>
                </c:pt>
                <c:pt idx="637">
                  <c:v>-0.34966489672660828</c:v>
                </c:pt>
                <c:pt idx="638">
                  <c:v>-0.3416808545589447</c:v>
                </c:pt>
                <c:pt idx="639">
                  <c:v>-0.33369320631027222</c:v>
                </c:pt>
                <c:pt idx="640">
                  <c:v>-0.32570260763168335</c:v>
                </c:pt>
                <c:pt idx="641">
                  <c:v>-0.31770700216293335</c:v>
                </c:pt>
                <c:pt idx="642">
                  <c:v>-0.30970743298530579</c:v>
                </c:pt>
                <c:pt idx="643">
                  <c:v>-0.30170422792434692</c:v>
                </c:pt>
                <c:pt idx="644">
                  <c:v>-0.2936970591545105</c:v>
                </c:pt>
                <c:pt idx="645">
                  <c:v>-0.28568592667579651</c:v>
                </c:pt>
                <c:pt idx="646">
                  <c:v>-0.27767112851142883</c:v>
                </c:pt>
                <c:pt idx="647">
                  <c:v>-0.26965346932411194</c:v>
                </c:pt>
                <c:pt idx="648">
                  <c:v>-0.26163110136985779</c:v>
                </c:pt>
                <c:pt idx="649">
                  <c:v>-0.25360545516014099</c:v>
                </c:pt>
                <c:pt idx="650">
                  <c:v>-0.24557407200336456</c:v>
                </c:pt>
                <c:pt idx="651">
                  <c:v>-0.23754048347473145</c:v>
                </c:pt>
                <c:pt idx="652">
                  <c:v>-0.22950257360935211</c:v>
                </c:pt>
                <c:pt idx="653">
                  <c:v>-0.22145961225032806</c:v>
                </c:pt>
                <c:pt idx="654">
                  <c:v>-0.21341374516487122</c:v>
                </c:pt>
                <c:pt idx="655">
                  <c:v>-0.20536389946937561</c:v>
                </c:pt>
                <c:pt idx="656">
                  <c:v>-0.1973097175359726</c:v>
                </c:pt>
                <c:pt idx="657">
                  <c:v>-0.18925157189369202</c:v>
                </c:pt>
                <c:pt idx="658">
                  <c:v>-0.18119049072265625</c:v>
                </c:pt>
                <c:pt idx="659">
                  <c:v>-0.17312508821487427</c:v>
                </c:pt>
                <c:pt idx="660">
                  <c:v>-0.16505677998065948</c:v>
                </c:pt>
                <c:pt idx="661">
                  <c:v>-0.1569841206073761</c:v>
                </c:pt>
                <c:pt idx="662">
                  <c:v>-0.14890819787979126</c:v>
                </c:pt>
                <c:pt idx="663">
                  <c:v>-0.14082759618759155</c:v>
                </c:pt>
                <c:pt idx="664">
                  <c:v>-0.13274514675140381</c:v>
                </c:pt>
                <c:pt idx="665">
                  <c:v>-0.12465978413820267</c:v>
                </c:pt>
                <c:pt idx="666">
                  <c:v>-0.11657008528709412</c:v>
                </c:pt>
                <c:pt idx="667">
                  <c:v>-0.10847712308168411</c:v>
                </c:pt>
                <c:pt idx="668">
                  <c:v>-0.100380539894104</c:v>
                </c:pt>
                <c:pt idx="669">
                  <c:v>-9.228033572435379E-2</c:v>
                </c:pt>
                <c:pt idx="670">
                  <c:v>-8.4177583456039429E-2</c:v>
                </c:pt>
                <c:pt idx="671">
                  <c:v>-7.6070494949817657E-2</c:v>
                </c:pt>
                <c:pt idx="672">
                  <c:v>-6.7959785461425781E-2</c:v>
                </c:pt>
                <c:pt idx="673">
                  <c:v>-5.9844739735126495E-2</c:v>
                </c:pt>
                <c:pt idx="674">
                  <c:v>-5.1726788282394409E-2</c:v>
                </c:pt>
                <c:pt idx="675">
                  <c:v>-4.3604146689176559E-2</c:v>
                </c:pt>
                <c:pt idx="676">
                  <c:v>-3.5478241741657257E-2</c:v>
                </c:pt>
                <c:pt idx="677">
                  <c:v>-2.7348002418875694E-2</c:v>
                </c:pt>
                <c:pt idx="678">
                  <c:v>-1.9216287881135941E-2</c:v>
                </c:pt>
                <c:pt idx="679">
                  <c:v>-1.1079522781074047E-2</c:v>
                </c:pt>
                <c:pt idx="680">
                  <c:v>-2.93877930380404E-3</c:v>
                </c:pt>
                <c:pt idx="681">
                  <c:v>5.208092276006937E-3</c:v>
                </c:pt>
                <c:pt idx="682">
                  <c:v>1.3358945026993752E-2</c:v>
                </c:pt>
                <c:pt idx="683">
                  <c:v>2.1515930071473122E-2</c:v>
                </c:pt>
                <c:pt idx="684">
                  <c:v>2.9676180332899094E-2</c:v>
                </c:pt>
                <c:pt idx="685">
                  <c:v>3.7842925637960434E-2</c:v>
                </c:pt>
                <c:pt idx="686">
                  <c:v>4.6017248183488846E-2</c:v>
                </c:pt>
                <c:pt idx="687">
                  <c:v>5.4195921868085861E-2</c:v>
                </c:pt>
                <c:pt idx="688">
                  <c:v>6.2378942966461182E-2</c:v>
                </c:pt>
                <c:pt idx="689">
                  <c:v>7.0565596222877502E-2</c:v>
                </c:pt>
                <c:pt idx="690">
                  <c:v>7.875659316778183E-2</c:v>
                </c:pt>
                <c:pt idx="691">
                  <c:v>8.6953029036521912E-2</c:v>
                </c:pt>
                <c:pt idx="692">
                  <c:v>9.515380859375E-2</c:v>
                </c:pt>
                <c:pt idx="693">
                  <c:v>0.10335750877857208</c:v>
                </c:pt>
                <c:pt idx="694">
                  <c:v>0.11156447976827621</c:v>
                </c:pt>
                <c:pt idx="695">
                  <c:v>0.11977652460336685</c:v>
                </c:pt>
                <c:pt idx="696">
                  <c:v>0.12799184024333954</c:v>
                </c:pt>
                <c:pt idx="697">
                  <c:v>0.13621115684509277</c:v>
                </c:pt>
                <c:pt idx="698">
                  <c:v>0.14443409442901611</c:v>
                </c:pt>
                <c:pt idx="699">
                  <c:v>0.15266066789627075</c:v>
                </c:pt>
                <c:pt idx="700">
                  <c:v>0.16089123487472534</c:v>
                </c:pt>
                <c:pt idx="701">
                  <c:v>0.16912543773651123</c:v>
                </c:pt>
                <c:pt idx="702">
                  <c:v>0.17736327648162842</c:v>
                </c:pt>
                <c:pt idx="703">
                  <c:v>0.1856047511100769</c:v>
                </c:pt>
                <c:pt idx="704">
                  <c:v>0.1938498467206955</c:v>
                </c:pt>
                <c:pt idx="705">
                  <c:v>0.20209857821464539</c:v>
                </c:pt>
                <c:pt idx="706">
                  <c:v>0.21035094559192657</c:v>
                </c:pt>
                <c:pt idx="707">
                  <c:v>0.21860694885253906</c:v>
                </c:pt>
                <c:pt idx="708">
                  <c:v>0.22686657309532166</c:v>
                </c:pt>
                <c:pt idx="709">
                  <c:v>0.23512983322143555</c:v>
                </c:pt>
                <c:pt idx="710">
                  <c:v>0.24339672923088074</c:v>
                </c:pt>
                <c:pt idx="711">
                  <c:v>0.25166726112365723</c:v>
                </c:pt>
                <c:pt idx="712">
                  <c:v>0.25994139909744263</c:v>
                </c:pt>
                <c:pt idx="713">
                  <c:v>0.26821920275688171</c:v>
                </c:pt>
                <c:pt idx="714">
                  <c:v>0.27650061249732971</c:v>
                </c:pt>
                <c:pt idx="715">
                  <c:v>0.28478565812110901</c:v>
                </c:pt>
                <c:pt idx="716">
                  <c:v>0.2930743396282196</c:v>
                </c:pt>
                <c:pt idx="717">
                  <c:v>0.3013666570186615</c:v>
                </c:pt>
                <c:pt idx="718">
                  <c:v>0.3096625804901123</c:v>
                </c:pt>
                <c:pt idx="719">
                  <c:v>0.3179621696472168</c:v>
                </c:pt>
                <c:pt idx="720">
                  <c:v>0.3262653648853302</c:v>
                </c:pt>
                <c:pt idx="721">
                  <c:v>0.3345721960067749</c:v>
                </c:pt>
                <c:pt idx="722">
                  <c:v>0.3428826630115509</c:v>
                </c:pt>
                <c:pt idx="723">
                  <c:v>0.3511967658996582</c:v>
                </c:pt>
                <c:pt idx="724">
                  <c:v>0.35951447486877441</c:v>
                </c:pt>
                <c:pt idx="725">
                  <c:v>0.36783581972122192</c:v>
                </c:pt>
                <c:pt idx="726">
                  <c:v>0.37616044282913208</c:v>
                </c:pt>
                <c:pt idx="727">
                  <c:v>0.38448905944824219</c:v>
                </c:pt>
                <c:pt idx="728">
                  <c:v>0.39282092452049255</c:v>
                </c:pt>
                <c:pt idx="729">
                  <c:v>0.40115642547607422</c:v>
                </c:pt>
                <c:pt idx="730">
                  <c:v>0.40949591994285583</c:v>
                </c:pt>
                <c:pt idx="731">
                  <c:v>0.4178386926651001</c:v>
                </c:pt>
                <c:pt idx="732">
                  <c:v>0.42618471384048462</c:v>
                </c:pt>
                <c:pt idx="733">
                  <c:v>0.43453511595726013</c:v>
                </c:pt>
                <c:pt idx="734">
                  <c:v>0.44288912415504456</c:v>
                </c:pt>
                <c:pt idx="735">
                  <c:v>0.45124676823616028</c:v>
                </c:pt>
                <c:pt idx="736">
                  <c:v>0.45960801839828491</c:v>
                </c:pt>
                <c:pt idx="737">
                  <c:v>0.46797293424606323</c:v>
                </c:pt>
                <c:pt idx="738">
                  <c:v>0.47634145617485046</c:v>
                </c:pt>
                <c:pt idx="739">
                  <c:v>0.48471361398696899</c:v>
                </c:pt>
                <c:pt idx="740">
                  <c:v>0.49308937788009644</c:v>
                </c:pt>
                <c:pt idx="741">
                  <c:v>0.50146877765655518</c:v>
                </c:pt>
                <c:pt idx="742">
                  <c:v>0.50985181331634521</c:v>
                </c:pt>
                <c:pt idx="743">
                  <c:v>0.51823848485946655</c:v>
                </c:pt>
                <c:pt idx="744">
                  <c:v>0.52662879228591919</c:v>
                </c:pt>
                <c:pt idx="745">
                  <c:v>0.53502273559570313</c:v>
                </c:pt>
                <c:pt idx="746">
                  <c:v>0.54342025518417358</c:v>
                </c:pt>
                <c:pt idx="747">
                  <c:v>0.55182141065597534</c:v>
                </c:pt>
                <c:pt idx="748">
                  <c:v>0.56022626161575317</c:v>
                </c:pt>
                <c:pt idx="749">
                  <c:v>0.56863504648208618</c:v>
                </c:pt>
                <c:pt idx="750">
                  <c:v>0.57704746723175049</c:v>
                </c:pt>
                <c:pt idx="751">
                  <c:v>0.58546352386474609</c:v>
                </c:pt>
                <c:pt idx="752">
                  <c:v>0.59388315677642822</c:v>
                </c:pt>
                <c:pt idx="753">
                  <c:v>0.60230648517608643</c:v>
                </c:pt>
                <c:pt idx="754">
                  <c:v>0.61073452234268188</c:v>
                </c:pt>
                <c:pt idx="755">
                  <c:v>0.61916619539260864</c:v>
                </c:pt>
                <c:pt idx="756">
                  <c:v>0.6276015043258667</c:v>
                </c:pt>
                <c:pt idx="757">
                  <c:v>0.63604259490966797</c:v>
                </c:pt>
                <c:pt idx="758">
                  <c:v>0.64448589086532593</c:v>
                </c:pt>
                <c:pt idx="759">
                  <c:v>0.65293318033218384</c:v>
                </c:pt>
                <c:pt idx="760">
                  <c:v>0.66138410568237305</c:v>
                </c:pt>
                <c:pt idx="761">
                  <c:v>0.66984015703201294</c:v>
                </c:pt>
                <c:pt idx="762">
                  <c:v>0.67829865217208862</c:v>
                </c:pt>
                <c:pt idx="763">
                  <c:v>0.68676269054412842</c:v>
                </c:pt>
                <c:pt idx="764">
                  <c:v>0.69522851705551147</c:v>
                </c:pt>
                <c:pt idx="765">
                  <c:v>0.70370125770568848</c:v>
                </c:pt>
                <c:pt idx="766">
                  <c:v>0.71217727661132813</c:v>
                </c:pt>
                <c:pt idx="767">
                  <c:v>0.72065877914428711</c:v>
                </c:pt>
                <c:pt idx="768">
                  <c:v>0.72914284467697144</c:v>
                </c:pt>
                <c:pt idx="769">
                  <c:v>0.7376331090927124</c:v>
                </c:pt>
                <c:pt idx="770">
                  <c:v>0.74612623453140259</c:v>
                </c:pt>
                <c:pt idx="771">
                  <c:v>0.7546241283416748</c:v>
                </c:pt>
                <c:pt idx="772">
                  <c:v>0.76312679052352905</c:v>
                </c:pt>
                <c:pt idx="773">
                  <c:v>0.77163273096084595</c:v>
                </c:pt>
                <c:pt idx="774">
                  <c:v>0.7801474928855896</c:v>
                </c:pt>
                <c:pt idx="775">
                  <c:v>0.78866589069366455</c:v>
                </c:pt>
                <c:pt idx="776">
                  <c:v>0.79718905687332153</c:v>
                </c:pt>
                <c:pt idx="777">
                  <c:v>0.8057173490524292</c:v>
                </c:pt>
                <c:pt idx="778">
                  <c:v>0.8142504096031189</c:v>
                </c:pt>
                <c:pt idx="779">
                  <c:v>0.82278817892074585</c:v>
                </c:pt>
                <c:pt idx="780">
                  <c:v>0.83133113384246826</c:v>
                </c:pt>
                <c:pt idx="781">
                  <c:v>0.83987885713577271</c:v>
                </c:pt>
                <c:pt idx="782">
                  <c:v>0.8484305739402771</c:v>
                </c:pt>
                <c:pt idx="783">
                  <c:v>0.85698634386062622</c:v>
                </c:pt>
                <c:pt idx="784">
                  <c:v>0.86554574966430664</c:v>
                </c:pt>
                <c:pt idx="785">
                  <c:v>0.87410873174667358</c:v>
                </c:pt>
                <c:pt idx="786">
                  <c:v>0.8826754093170166</c:v>
                </c:pt>
                <c:pt idx="787">
                  <c:v>0.89124572277069092</c:v>
                </c:pt>
                <c:pt idx="788">
                  <c:v>0.89981967210769653</c:v>
                </c:pt>
                <c:pt idx="789">
                  <c:v>0.90839731693267822</c:v>
                </c:pt>
                <c:pt idx="790">
                  <c:v>0.91697853803634644</c:v>
                </c:pt>
                <c:pt idx="791">
                  <c:v>0.92556339502334595</c:v>
                </c:pt>
                <c:pt idx="792">
                  <c:v>0.93415194749832153</c:v>
                </c:pt>
                <c:pt idx="793">
                  <c:v>0.94274413585662842</c:v>
                </c:pt>
                <c:pt idx="794">
                  <c:v>0.95133990049362183</c:v>
                </c:pt>
                <c:pt idx="795">
                  <c:v>0.95994013547897339</c:v>
                </c:pt>
                <c:pt idx="796">
                  <c:v>0.96854323148727417</c:v>
                </c:pt>
                <c:pt idx="797">
                  <c:v>0.9771503210067749</c:v>
                </c:pt>
                <c:pt idx="798">
                  <c:v>0.98576146364212036</c:v>
                </c:pt>
                <c:pt idx="799">
                  <c:v>0.99437695741653442</c:v>
                </c:pt>
                <c:pt idx="800">
                  <c:v>1.0029969215393066</c:v>
                </c:pt>
                <c:pt idx="801">
                  <c:v>1.0116215944290161</c:v>
                </c:pt>
                <c:pt idx="802">
                  <c:v>1.0201983451843262</c:v>
                </c:pt>
                <c:pt idx="803">
                  <c:v>1.0287790298461914</c:v>
                </c:pt>
                <c:pt idx="804">
                  <c:v>1.0373635292053223</c:v>
                </c:pt>
                <c:pt idx="805">
                  <c:v>1.0459525585174561</c:v>
                </c:pt>
                <c:pt idx="806">
                  <c:v>1.0545444488525391</c:v>
                </c:pt>
                <c:pt idx="807">
                  <c:v>1.0631399154663086</c:v>
                </c:pt>
                <c:pt idx="808">
                  <c:v>1.0717384815216064</c:v>
                </c:pt>
                <c:pt idx="809">
                  <c:v>1.0803405046463013</c:v>
                </c:pt>
                <c:pt idx="810">
                  <c:v>1.088945746421814</c:v>
                </c:pt>
                <c:pt idx="811">
                  <c:v>1.0975555181503296</c:v>
                </c:pt>
                <c:pt idx="812">
                  <c:v>1.1061669588088989</c:v>
                </c:pt>
                <c:pt idx="813">
                  <c:v>1.1147825717926025</c:v>
                </c:pt>
                <c:pt idx="814">
                  <c:v>1.123399019241333</c:v>
                </c:pt>
                <c:pt idx="815">
                  <c:v>1.1320198774337769</c:v>
                </c:pt>
                <c:pt idx="816">
                  <c:v>1.140642523765564</c:v>
                </c:pt>
                <c:pt idx="817">
                  <c:v>1.1492691040039063</c:v>
                </c:pt>
                <c:pt idx="818">
                  <c:v>1.1578965187072754</c:v>
                </c:pt>
                <c:pt idx="819">
                  <c:v>1.1665298938751221</c:v>
                </c:pt>
                <c:pt idx="820">
                  <c:v>1.1751632690429688</c:v>
                </c:pt>
                <c:pt idx="821">
                  <c:v>1.1838014125823975</c:v>
                </c:pt>
                <c:pt idx="822">
                  <c:v>1.1924384832382202</c:v>
                </c:pt>
                <c:pt idx="823">
                  <c:v>1.2010797262191772</c:v>
                </c:pt>
                <c:pt idx="824">
                  <c:v>1.2097233533859253</c:v>
                </c:pt>
                <c:pt idx="825">
                  <c:v>1.2183686494827271</c:v>
                </c:pt>
                <c:pt idx="826">
                  <c:v>1.2270150184631348</c:v>
                </c:pt>
                <c:pt idx="827">
                  <c:v>1.2356641292572021</c:v>
                </c:pt>
                <c:pt idx="828">
                  <c:v>1.244315505027771</c:v>
                </c:pt>
                <c:pt idx="829">
                  <c:v>1.2529680728912354</c:v>
                </c:pt>
                <c:pt idx="830">
                  <c:v>1.2616215944290161</c:v>
                </c:pt>
                <c:pt idx="831">
                  <c:v>1.2702786922454834</c:v>
                </c:pt>
                <c:pt idx="832">
                  <c:v>1.2789359092712402</c:v>
                </c:pt>
                <c:pt idx="833">
                  <c:v>1.287596583366394</c:v>
                </c:pt>
                <c:pt idx="834">
                  <c:v>1.2962579727172852</c:v>
                </c:pt>
                <c:pt idx="835">
                  <c:v>1.3049211502075195</c:v>
                </c:pt>
                <c:pt idx="836">
                  <c:v>1.3135844469070435</c:v>
                </c:pt>
                <c:pt idx="837">
                  <c:v>1.3222504854202271</c:v>
                </c:pt>
                <c:pt idx="838">
                  <c:v>1.3309166431427002</c:v>
                </c:pt>
                <c:pt idx="839">
                  <c:v>1.3395833969116211</c:v>
                </c:pt>
                <c:pt idx="840">
                  <c:v>1.3482481241226196</c:v>
                </c:pt>
                <c:pt idx="841">
                  <c:v>1.3569149971008301</c:v>
                </c:pt>
                <c:pt idx="842">
                  <c:v>1.3655822277069092</c:v>
                </c:pt>
                <c:pt idx="843">
                  <c:v>1.3742491006851196</c:v>
                </c:pt>
                <c:pt idx="844">
                  <c:v>1.3829140663146973</c:v>
                </c:pt>
                <c:pt idx="845">
                  <c:v>1.3915799856185913</c:v>
                </c:pt>
                <c:pt idx="846">
                  <c:v>1.4002460241317749</c:v>
                </c:pt>
                <c:pt idx="847">
                  <c:v>1.4089118242263794</c:v>
                </c:pt>
                <c:pt idx="848">
                  <c:v>1.4175752401351929</c:v>
                </c:pt>
                <c:pt idx="849">
                  <c:v>1.4262402057647705</c:v>
                </c:pt>
                <c:pt idx="850">
                  <c:v>1.4349023103713989</c:v>
                </c:pt>
                <c:pt idx="851">
                  <c:v>1.4435648918151855</c:v>
                </c:pt>
                <c:pt idx="852">
                  <c:v>1.4522260427474976</c:v>
                </c:pt>
                <c:pt idx="853">
                  <c:v>1.4608871936798096</c:v>
                </c:pt>
                <c:pt idx="854">
                  <c:v>1.4695463180541992</c:v>
                </c:pt>
                <c:pt idx="855">
                  <c:v>1.4782063961029053</c:v>
                </c:pt>
                <c:pt idx="856">
                  <c:v>1.4868639707565308</c:v>
                </c:pt>
                <c:pt idx="857">
                  <c:v>1.495519757270813</c:v>
                </c:pt>
                <c:pt idx="858">
                  <c:v>1.5041754245758057</c:v>
                </c:pt>
                <c:pt idx="859">
                  <c:v>1.5128287076950073</c:v>
                </c:pt>
                <c:pt idx="860">
                  <c:v>1.5214803218841553</c:v>
                </c:pt>
                <c:pt idx="861">
                  <c:v>1.5301320552825928</c:v>
                </c:pt>
                <c:pt idx="862">
                  <c:v>1.5387803316116333</c:v>
                </c:pt>
                <c:pt idx="863">
                  <c:v>1.5474275350570679</c:v>
                </c:pt>
                <c:pt idx="864">
                  <c:v>1.5560734272003174</c:v>
                </c:pt>
                <c:pt idx="865">
                  <c:v>1.5647176504135132</c:v>
                </c:pt>
                <c:pt idx="866">
                  <c:v>1.5733600854873657</c:v>
                </c:pt>
                <c:pt idx="867">
                  <c:v>1.5820002555847168</c:v>
                </c:pt>
                <c:pt idx="868">
                  <c:v>1.5906388759613037</c:v>
                </c:pt>
                <c:pt idx="869">
                  <c:v>1.5992758274078369</c:v>
                </c:pt>
                <c:pt idx="870">
                  <c:v>1.6079111099243164</c:v>
                </c:pt>
                <c:pt idx="871">
                  <c:v>1.6165444850921631</c:v>
                </c:pt>
                <c:pt idx="872">
                  <c:v>1.6251760721206665</c:v>
                </c:pt>
                <c:pt idx="873">
                  <c:v>1.6338056325912476</c:v>
                </c:pt>
                <c:pt idx="874">
                  <c:v>1.6424331665039063</c:v>
                </c:pt>
                <c:pt idx="875">
                  <c:v>1.6510586738586426</c:v>
                </c:pt>
                <c:pt idx="876">
                  <c:v>1.6596819162368774</c:v>
                </c:pt>
                <c:pt idx="877">
                  <c:v>1.6683028936386108</c:v>
                </c:pt>
                <c:pt idx="878">
                  <c:v>1.6769211292266846</c:v>
                </c:pt>
                <c:pt idx="879">
                  <c:v>1.6855374574661255</c:v>
                </c:pt>
                <c:pt idx="880">
                  <c:v>1.6941508054733276</c:v>
                </c:pt>
                <c:pt idx="881">
                  <c:v>1.7027608156204224</c:v>
                </c:pt>
                <c:pt idx="882">
                  <c:v>1.7113680839538574</c:v>
                </c:pt>
                <c:pt idx="883">
                  <c:v>1.719973087310791</c:v>
                </c:pt>
                <c:pt idx="884">
                  <c:v>1.7285727262496948</c:v>
                </c:pt>
                <c:pt idx="885">
                  <c:v>1.7371693849563599</c:v>
                </c:pt>
                <c:pt idx="886">
                  <c:v>1.7457634210586548</c:v>
                </c:pt>
                <c:pt idx="887">
                  <c:v>1.7543506622314453</c:v>
                </c:pt>
                <c:pt idx="888">
                  <c:v>1.7629340887069702</c:v>
                </c:pt>
                <c:pt idx="889">
                  <c:v>1.7715128660202026</c:v>
                </c:pt>
                <c:pt idx="890">
                  <c:v>1.7800852060317993</c:v>
                </c:pt>
                <c:pt idx="891">
                  <c:v>1.7886531352996826</c:v>
                </c:pt>
                <c:pt idx="892">
                  <c:v>1.7972158193588257</c:v>
                </c:pt>
                <c:pt idx="893">
                  <c:v>1.8057746887207031</c:v>
                </c:pt>
                <c:pt idx="894">
                  <c:v>1.8143272399902344</c:v>
                </c:pt>
                <c:pt idx="895">
                  <c:v>1.8228772878646851</c:v>
                </c:pt>
                <c:pt idx="896">
                  <c:v>1.8314213752746582</c:v>
                </c:pt>
                <c:pt idx="897">
                  <c:v>1.839963436126709</c:v>
                </c:pt>
                <c:pt idx="898">
                  <c:v>1.8484987020492554</c:v>
                </c:pt>
                <c:pt idx="899">
                  <c:v>1.8570307493209839</c:v>
                </c:pt>
                <c:pt idx="900">
                  <c:v>1.8655569553375244</c:v>
                </c:pt>
                <c:pt idx="901">
                  <c:v>1.8740805387496948</c:v>
                </c:pt>
                <c:pt idx="902">
                  <c:v>1.8825987577438354</c:v>
                </c:pt>
                <c:pt idx="903">
                  <c:v>1.8911114931106567</c:v>
                </c:pt>
                <c:pt idx="904">
                  <c:v>1.8996204137802124</c:v>
                </c:pt>
                <c:pt idx="905">
                  <c:v>1.9081226587295532</c:v>
                </c:pt>
                <c:pt idx="906">
                  <c:v>1.9166210889816284</c:v>
                </c:pt>
                <c:pt idx="907">
                  <c:v>1.925114631652832</c:v>
                </c:pt>
                <c:pt idx="908">
                  <c:v>1.9336035251617432</c:v>
                </c:pt>
                <c:pt idx="909">
                  <c:v>1.9420872926712036</c:v>
                </c:pt>
                <c:pt idx="910">
                  <c:v>1.9505666494369507</c:v>
                </c:pt>
                <c:pt idx="911">
                  <c:v>1.9590411186218262</c:v>
                </c:pt>
                <c:pt idx="912">
                  <c:v>1.9675105810165405</c:v>
                </c:pt>
                <c:pt idx="913">
                  <c:v>1.9759746789932251</c:v>
                </c:pt>
                <c:pt idx="914">
                  <c:v>1.9844340085983276</c:v>
                </c:pt>
                <c:pt idx="915">
                  <c:v>1.9928878545761108</c:v>
                </c:pt>
                <c:pt idx="916">
                  <c:v>2.0013363361358643</c:v>
                </c:pt>
                <c:pt idx="917">
                  <c:v>2.009779691696167</c:v>
                </c:pt>
                <c:pt idx="918">
                  <c:v>2.0182175636291504</c:v>
                </c:pt>
                <c:pt idx="919">
                  <c:v>2.0266504287719727</c:v>
                </c:pt>
                <c:pt idx="920">
                  <c:v>2.0350782871246338</c:v>
                </c:pt>
                <c:pt idx="921">
                  <c:v>2.0435011386871338</c:v>
                </c:pt>
                <c:pt idx="922">
                  <c:v>2.0519192218780518</c:v>
                </c:pt>
                <c:pt idx="923">
                  <c:v>2.0603325366973877</c:v>
                </c:pt>
                <c:pt idx="924">
                  <c:v>2.0687415599822998</c:v>
                </c:pt>
                <c:pt idx="925">
                  <c:v>2.0771458148956299</c:v>
                </c:pt>
                <c:pt idx="926">
                  <c:v>2.0855460166931152</c:v>
                </c:pt>
                <c:pt idx="927">
                  <c:v>2.0939416885375977</c:v>
                </c:pt>
                <c:pt idx="928">
                  <c:v>2.1023335456848145</c:v>
                </c:pt>
                <c:pt idx="929">
                  <c:v>2.1107213497161865</c:v>
                </c:pt>
                <c:pt idx="930">
                  <c:v>2.1191051006317139</c:v>
                </c:pt>
                <c:pt idx="931">
                  <c:v>2.1274852752685547</c:v>
                </c:pt>
                <c:pt idx="932">
                  <c:v>2.1358616352081299</c:v>
                </c:pt>
                <c:pt idx="933">
                  <c:v>2.1442346572875977</c:v>
                </c:pt>
                <c:pt idx="934">
                  <c:v>2.152604341506958</c:v>
                </c:pt>
                <c:pt idx="935">
                  <c:v>2.1609704494476318</c:v>
                </c:pt>
                <c:pt idx="936">
                  <c:v>2.1693334579467773</c:v>
                </c:pt>
                <c:pt idx="937">
                  <c:v>2.1776936054229736</c:v>
                </c:pt>
                <c:pt idx="938">
                  <c:v>2.1860508918762207</c:v>
                </c:pt>
                <c:pt idx="939">
                  <c:v>2.1944050788879395</c:v>
                </c:pt>
                <c:pt idx="940">
                  <c:v>2.2027573585510254</c:v>
                </c:pt>
                <c:pt idx="941">
                  <c:v>2.2111063003540039</c:v>
                </c:pt>
                <c:pt idx="942">
                  <c:v>2.2194526195526123</c:v>
                </c:pt>
                <c:pt idx="943">
                  <c:v>2.2277970314025879</c:v>
                </c:pt>
                <c:pt idx="944">
                  <c:v>2.2361385822296143</c:v>
                </c:pt>
                <c:pt idx="945">
                  <c:v>2.244478702545166</c:v>
                </c:pt>
                <c:pt idx="946">
                  <c:v>2.2528166770935059</c:v>
                </c:pt>
                <c:pt idx="947">
                  <c:v>2.2611525058746338</c:v>
                </c:pt>
                <c:pt idx="948">
                  <c:v>2.2694871425628662</c:v>
                </c:pt>
                <c:pt idx="949">
                  <c:v>2.2778196334838867</c:v>
                </c:pt>
                <c:pt idx="950">
                  <c:v>2.2861502170562744</c:v>
                </c:pt>
                <c:pt idx="951">
                  <c:v>2.2944793701171875</c:v>
                </c:pt>
                <c:pt idx="952">
                  <c:v>2.3028080463409424</c:v>
                </c:pt>
                <c:pt idx="953">
                  <c:v>2.3111352920532227</c:v>
                </c:pt>
                <c:pt idx="954">
                  <c:v>2.3194613456726074</c:v>
                </c:pt>
                <c:pt idx="955">
                  <c:v>2.3277866840362549</c:v>
                </c:pt>
                <c:pt idx="956">
                  <c:v>2.3361108303070068</c:v>
                </c:pt>
                <c:pt idx="957">
                  <c:v>2.3444337844848633</c:v>
                </c:pt>
                <c:pt idx="958">
                  <c:v>2.3527562618255615</c:v>
                </c:pt>
                <c:pt idx="959">
                  <c:v>2.3610780239105225</c:v>
                </c:pt>
                <c:pt idx="960">
                  <c:v>2.3693990707397461</c:v>
                </c:pt>
                <c:pt idx="961">
                  <c:v>2.3777201175689697</c:v>
                </c:pt>
                <c:pt idx="962">
                  <c:v>2.3860414028167725</c:v>
                </c:pt>
                <c:pt idx="963">
                  <c:v>2.3943619728088379</c:v>
                </c:pt>
                <c:pt idx="964">
                  <c:v>2.4026834964752197</c:v>
                </c:pt>
                <c:pt idx="965">
                  <c:v>2.4110043048858643</c:v>
                </c:pt>
                <c:pt idx="966">
                  <c:v>2.4193260669708252</c:v>
                </c:pt>
                <c:pt idx="967">
                  <c:v>2.427647590637207</c:v>
                </c:pt>
                <c:pt idx="968">
                  <c:v>2.4359703063964844</c:v>
                </c:pt>
                <c:pt idx="969">
                  <c:v>2.4442932605743408</c:v>
                </c:pt>
                <c:pt idx="970">
                  <c:v>2.4526169300079346</c:v>
                </c:pt>
                <c:pt idx="971">
                  <c:v>2.4609415531158447</c:v>
                </c:pt>
                <c:pt idx="972">
                  <c:v>2.4692666530609131</c:v>
                </c:pt>
                <c:pt idx="973">
                  <c:v>2.4775931835174561</c:v>
                </c:pt>
                <c:pt idx="974">
                  <c:v>2.4859211444854736</c:v>
                </c:pt>
                <c:pt idx="975">
                  <c:v>2.4942498207092285</c:v>
                </c:pt>
                <c:pt idx="976">
                  <c:v>2.502579927444458</c:v>
                </c:pt>
                <c:pt idx="977">
                  <c:v>2.5109117031097412</c:v>
                </c:pt>
                <c:pt idx="978">
                  <c:v>2.519244909286499</c:v>
                </c:pt>
                <c:pt idx="979">
                  <c:v>2.5275800228118896</c:v>
                </c:pt>
                <c:pt idx="980">
                  <c:v>2.5359179973602295</c:v>
                </c:pt>
                <c:pt idx="981">
                  <c:v>2.5442571640014648</c:v>
                </c:pt>
                <c:pt idx="982">
                  <c:v>2.5525987148284912</c:v>
                </c:pt>
                <c:pt idx="983">
                  <c:v>2.5609428882598877</c:v>
                </c:pt>
                <c:pt idx="984">
                  <c:v>2.5692896842956543</c:v>
                </c:pt>
                <c:pt idx="985">
                  <c:v>2.5776386260986328</c:v>
                </c:pt>
                <c:pt idx="986">
                  <c:v>2.5859899520874023</c:v>
                </c:pt>
                <c:pt idx="987">
                  <c:v>2.5943448543548584</c:v>
                </c:pt>
                <c:pt idx="988">
                  <c:v>2.6027019023895264</c:v>
                </c:pt>
                <c:pt idx="989">
                  <c:v>2.6110620498657227</c:v>
                </c:pt>
                <c:pt idx="990">
                  <c:v>2.6194250583648682</c:v>
                </c:pt>
                <c:pt idx="991">
                  <c:v>2.6277916431427002</c:v>
                </c:pt>
                <c:pt idx="992">
                  <c:v>2.6361615657806396</c:v>
                </c:pt>
                <c:pt idx="993">
                  <c:v>2.6445348262786865</c:v>
                </c:pt>
                <c:pt idx="994">
                  <c:v>2.652911901473999</c:v>
                </c:pt>
                <c:pt idx="995">
                  <c:v>2.661292552947998</c:v>
                </c:pt>
                <c:pt idx="996">
                  <c:v>2.6696765422821045</c:v>
                </c:pt>
                <c:pt idx="997">
                  <c:v>2.6780660152435303</c:v>
                </c:pt>
                <c:pt idx="998">
                  <c:v>2.6864583492279053</c:v>
                </c:pt>
                <c:pt idx="999">
                  <c:v>2.6948554515838623</c:v>
                </c:pt>
                <c:pt idx="1000">
                  <c:v>2.7032558917999268</c:v>
                </c:pt>
                <c:pt idx="1001">
                  <c:v>2.7116608619689941</c:v>
                </c:pt>
                <c:pt idx="1002">
                  <c:v>2.7200710773468018</c:v>
                </c:pt>
                <c:pt idx="1003">
                  <c:v>2.7284865379333496</c:v>
                </c:pt>
                <c:pt idx="1004">
                  <c:v>2.7369050979614258</c:v>
                </c:pt>
                <c:pt idx="1005">
                  <c:v>2.7453296184539795</c:v>
                </c:pt>
                <c:pt idx="1006">
                  <c:v>2.7537593841552734</c:v>
                </c:pt>
                <c:pt idx="1007">
                  <c:v>2.7621936798095703</c:v>
                </c:pt>
                <c:pt idx="1008">
                  <c:v>2.770632266998291</c:v>
                </c:pt>
                <c:pt idx="1009">
                  <c:v>2.7790765762329102</c:v>
                </c:pt>
                <c:pt idx="1010">
                  <c:v>2.7875256538391113</c:v>
                </c:pt>
                <c:pt idx="1011">
                  <c:v>2.7959821224212646</c:v>
                </c:pt>
                <c:pt idx="1012">
                  <c:v>2.8044431209564209</c:v>
                </c:pt>
                <c:pt idx="1013">
                  <c:v>2.8129103183746338</c:v>
                </c:pt>
                <c:pt idx="1014">
                  <c:v>2.8213834762573242</c:v>
                </c:pt>
                <c:pt idx="1015">
                  <c:v>2.8298625946044922</c:v>
                </c:pt>
                <c:pt idx="1016">
                  <c:v>2.8383467197418213</c:v>
                </c:pt>
                <c:pt idx="1017">
                  <c:v>2.8468375205993652</c:v>
                </c:pt>
                <c:pt idx="1018">
                  <c:v>2.855334997177124</c:v>
                </c:pt>
                <c:pt idx="1019">
                  <c:v>2.8638396263122559</c:v>
                </c:pt>
                <c:pt idx="1020">
                  <c:v>2.8723499774932861</c:v>
                </c:pt>
                <c:pt idx="1021">
                  <c:v>2.8808679580688477</c:v>
                </c:pt>
                <c:pt idx="1022">
                  <c:v>2.8893914222717285</c:v>
                </c:pt>
                <c:pt idx="1023">
                  <c:v>2.8979227542877197</c:v>
                </c:pt>
                <c:pt idx="1024">
                  <c:v>2.906458854675293</c:v>
                </c:pt>
                <c:pt idx="1025">
                  <c:v>2.9150042533874512</c:v>
                </c:pt>
                <c:pt idx="1026">
                  <c:v>2.9235553741455078</c:v>
                </c:pt>
                <c:pt idx="1027">
                  <c:v>2.932114839553833</c:v>
                </c:pt>
                <c:pt idx="1028">
                  <c:v>2.9406816959381104</c:v>
                </c:pt>
                <c:pt idx="1029">
                  <c:v>2.9492566585540771</c:v>
                </c:pt>
                <c:pt idx="1030">
                  <c:v>2.9578371047973633</c:v>
                </c:pt>
                <c:pt idx="1031">
                  <c:v>2.9664287567138672</c:v>
                </c:pt>
                <c:pt idx="1032">
                  <c:v>2.9750261306762695</c:v>
                </c:pt>
                <c:pt idx="1033">
                  <c:v>2.9836328029632568</c:v>
                </c:pt>
                <c:pt idx="1034">
                  <c:v>2.9922463893890381</c:v>
                </c:pt>
                <c:pt idx="1035">
                  <c:v>3.0008697509765625</c:v>
                </c:pt>
                <c:pt idx="1036">
                  <c:v>3.0095005035400391</c:v>
                </c:pt>
                <c:pt idx="1037">
                  <c:v>3.0181403160095215</c:v>
                </c:pt>
                <c:pt idx="1038">
                  <c:v>3.0267877578735352</c:v>
                </c:pt>
                <c:pt idx="1039">
                  <c:v>3.0354452133178711</c:v>
                </c:pt>
                <c:pt idx="1040">
                  <c:v>3.0441100597381592</c:v>
                </c:pt>
                <c:pt idx="1041">
                  <c:v>3.052783727645874</c:v>
                </c:pt>
                <c:pt idx="1042">
                  <c:v>3.0614640712738037</c:v>
                </c:pt>
                <c:pt idx="1043">
                  <c:v>3.0701549053192139</c:v>
                </c:pt>
                <c:pt idx="1044">
                  <c:v>3.0788536071777344</c:v>
                </c:pt>
                <c:pt idx="1045">
                  <c:v>3.0875616073608398</c:v>
                </c:pt>
                <c:pt idx="1046">
                  <c:v>3.0962769985198975</c:v>
                </c:pt>
                <c:pt idx="1047">
                  <c:v>3.1050009727478027</c:v>
                </c:pt>
                <c:pt idx="1048">
                  <c:v>3.1137332916259766</c:v>
                </c:pt>
                <c:pt idx="1049">
                  <c:v>3.1224758625030518</c:v>
                </c:pt>
                <c:pt idx="1050">
                  <c:v>3.1312253475189209</c:v>
                </c:pt>
                <c:pt idx="1051">
                  <c:v>3.1399834156036377</c:v>
                </c:pt>
                <c:pt idx="1052">
                  <c:v>3.1487479209899902</c:v>
                </c:pt>
                <c:pt idx="1053">
                  <c:v>3.157522439956665</c:v>
                </c:pt>
                <c:pt idx="1054">
                  <c:v>3.1663048267364502</c:v>
                </c:pt>
                <c:pt idx="1055">
                  <c:v>3.1750965118408203</c:v>
                </c:pt>
                <c:pt idx="1056">
                  <c:v>3.1838958263397217</c:v>
                </c:pt>
                <c:pt idx="1057">
                  <c:v>3.192704439163208</c:v>
                </c:pt>
                <c:pt idx="1058">
                  <c:v>3.2015223503112793</c:v>
                </c:pt>
                <c:pt idx="1059">
                  <c:v>3.2103469371795654</c:v>
                </c:pt>
                <c:pt idx="1060">
                  <c:v>3.219179630279541</c:v>
                </c:pt>
                <c:pt idx="1061">
                  <c:v>3.2280206680297852</c:v>
                </c:pt>
                <c:pt idx="1062">
                  <c:v>3.236870288848877</c:v>
                </c:pt>
                <c:pt idx="1063">
                  <c:v>3.2457282543182373</c:v>
                </c:pt>
                <c:pt idx="1064">
                  <c:v>3.2545926570892334</c:v>
                </c:pt>
                <c:pt idx="1065">
                  <c:v>3.2634658813476563</c:v>
                </c:pt>
                <c:pt idx="1066">
                  <c:v>3.2723474502563477</c:v>
                </c:pt>
                <c:pt idx="1067">
                  <c:v>3.2812385559082031</c:v>
                </c:pt>
                <c:pt idx="1068">
                  <c:v>3.2901351451873779</c:v>
                </c:pt>
                <c:pt idx="1069">
                  <c:v>3.2990422248840332</c:v>
                </c:pt>
                <c:pt idx="1070">
                  <c:v>3.3079569339752197</c:v>
                </c:pt>
                <c:pt idx="1071">
                  <c:v>3.3168802261352539</c:v>
                </c:pt>
                <c:pt idx="1072">
                  <c:v>3.3258118629455566</c:v>
                </c:pt>
                <c:pt idx="1073">
                  <c:v>3.3347513675689697</c:v>
                </c:pt>
                <c:pt idx="1074">
                  <c:v>3.3436999320983887</c:v>
                </c:pt>
                <c:pt idx="1075">
                  <c:v>3.3526558876037598</c:v>
                </c:pt>
                <c:pt idx="1076">
                  <c:v>3.3616218566894531</c:v>
                </c:pt>
                <c:pt idx="1077">
                  <c:v>3.3705947399139404</c:v>
                </c:pt>
                <c:pt idx="1078">
                  <c:v>3.3795750141143799</c:v>
                </c:pt>
                <c:pt idx="1079">
                  <c:v>3.3885636329650879</c:v>
                </c:pt>
                <c:pt idx="1080">
                  <c:v>3.3975603580474854</c:v>
                </c:pt>
                <c:pt idx="1081">
                  <c:v>3.4065678119659424</c:v>
                </c:pt>
                <c:pt idx="1082">
                  <c:v>3.4155819416046143</c:v>
                </c:pt>
                <c:pt idx="1083">
                  <c:v>3.4246048927307129</c:v>
                </c:pt>
                <c:pt idx="1084">
                  <c:v>3.4336376190185547</c:v>
                </c:pt>
                <c:pt idx="1085">
                  <c:v>3.4426777362823486</c:v>
                </c:pt>
                <c:pt idx="1086">
                  <c:v>3.4517245292663574</c:v>
                </c:pt>
                <c:pt idx="1087">
                  <c:v>3.460780143737793</c:v>
                </c:pt>
                <c:pt idx="1088">
                  <c:v>3.469843864440918</c:v>
                </c:pt>
                <c:pt idx="1089">
                  <c:v>3.4789149761199951</c:v>
                </c:pt>
                <c:pt idx="1090">
                  <c:v>3.4879946708679199</c:v>
                </c:pt>
                <c:pt idx="1091">
                  <c:v>3.4970812797546387</c:v>
                </c:pt>
                <c:pt idx="1092">
                  <c:v>3.5061767101287842</c:v>
                </c:pt>
                <c:pt idx="1093">
                  <c:v>3.5152795314788818</c:v>
                </c:pt>
                <c:pt idx="1094">
                  <c:v>3.5243914127349854</c:v>
                </c:pt>
                <c:pt idx="1095">
                  <c:v>3.5335111618041992</c:v>
                </c:pt>
                <c:pt idx="1096">
                  <c:v>3.5426390171051025</c:v>
                </c:pt>
                <c:pt idx="1097">
                  <c:v>3.5517735481262207</c:v>
                </c:pt>
                <c:pt idx="1098">
                  <c:v>3.5609166622161865</c:v>
                </c:pt>
                <c:pt idx="1099">
                  <c:v>3.5700681209564209</c:v>
                </c:pt>
                <c:pt idx="1100">
                  <c:v>3.5792279243469238</c:v>
                </c:pt>
                <c:pt idx="1101">
                  <c:v>3.5883963108062744</c:v>
                </c:pt>
                <c:pt idx="1102">
                  <c:v>3.5975720882415771</c:v>
                </c:pt>
                <c:pt idx="1103">
                  <c:v>3.606755256652832</c:v>
                </c:pt>
                <c:pt idx="1104">
                  <c:v>3.615947961807251</c:v>
                </c:pt>
                <c:pt idx="1105">
                  <c:v>3.6251471042633057</c:v>
                </c:pt>
                <c:pt idx="1106">
                  <c:v>3.6343545913696289</c:v>
                </c:pt>
                <c:pt idx="1107">
                  <c:v>3.6435699462890625</c:v>
                </c:pt>
                <c:pt idx="1108">
                  <c:v>3.6527924537658691</c:v>
                </c:pt>
                <c:pt idx="1109">
                  <c:v>3.6620218753814697</c:v>
                </c:pt>
                <c:pt idx="1110">
                  <c:v>3.6712625026702881</c:v>
                </c:pt>
                <c:pt idx="1111">
                  <c:v>3.6805081367492676</c:v>
                </c:pt>
                <c:pt idx="1112">
                  <c:v>3.6897644996643066</c:v>
                </c:pt>
                <c:pt idx="1113">
                  <c:v>3.6990272998809814</c:v>
                </c:pt>
                <c:pt idx="1114">
                  <c:v>3.7082993984222412</c:v>
                </c:pt>
                <c:pt idx="1115">
                  <c:v>3.7175772190093994</c:v>
                </c:pt>
                <c:pt idx="1116">
                  <c:v>3.7268626689910889</c:v>
                </c:pt>
                <c:pt idx="1117">
                  <c:v>3.7361571788787842</c:v>
                </c:pt>
                <c:pt idx="1118">
                  <c:v>3.7454595565795898</c:v>
                </c:pt>
                <c:pt idx="1119">
                  <c:v>3.7547690868377686</c:v>
                </c:pt>
                <c:pt idx="1120">
                  <c:v>3.7640872001647949</c:v>
                </c:pt>
                <c:pt idx="1121">
                  <c:v>3.7734124660491943</c:v>
                </c:pt>
                <c:pt idx="1122">
                  <c:v>3.7827451229095459</c:v>
                </c:pt>
                <c:pt idx="1123">
                  <c:v>3.7920866012573242</c:v>
                </c:pt>
                <c:pt idx="1124">
                  <c:v>3.801436185836792</c:v>
                </c:pt>
                <c:pt idx="1125">
                  <c:v>3.8107926845550537</c:v>
                </c:pt>
                <c:pt idx="1126">
                  <c:v>3.8201596736907959</c:v>
                </c:pt>
                <c:pt idx="1127">
                  <c:v>3.8295350074768066</c:v>
                </c:pt>
                <c:pt idx="1128">
                  <c:v>3.8389167785644531</c:v>
                </c:pt>
                <c:pt idx="1129">
                  <c:v>3.8483045101165771</c:v>
                </c:pt>
                <c:pt idx="1130">
                  <c:v>3.8577044010162354</c:v>
                </c:pt>
                <c:pt idx="1131">
                  <c:v>3.8671102523803711</c:v>
                </c:pt>
                <c:pt idx="1132">
                  <c:v>3.8765244483947754</c:v>
                </c:pt>
                <c:pt idx="1133">
                  <c:v>3.8859477043151855</c:v>
                </c:pt>
                <c:pt idx="1134">
                  <c:v>3.8953802585601807</c:v>
                </c:pt>
                <c:pt idx="1135">
                  <c:v>3.904820442199707</c:v>
                </c:pt>
                <c:pt idx="1136">
                  <c:v>3.9142684936523438</c:v>
                </c:pt>
                <c:pt idx="1137">
                  <c:v>3.9237222671508789</c:v>
                </c:pt>
                <c:pt idx="1138">
                  <c:v>3.9331865310668945</c:v>
                </c:pt>
                <c:pt idx="1139">
                  <c:v>3.9426581859588623</c:v>
                </c:pt>
                <c:pt idx="1140">
                  <c:v>3.9521400928497314</c:v>
                </c:pt>
                <c:pt idx="1141">
                  <c:v>3.9616262912750244</c:v>
                </c:pt>
                <c:pt idx="1142">
                  <c:v>3.9711217880249023</c:v>
                </c:pt>
                <c:pt idx="1143">
                  <c:v>3.9806251525878906</c:v>
                </c:pt>
                <c:pt idx="1144">
                  <c:v>3.9901375770568848</c:v>
                </c:pt>
                <c:pt idx="1145">
                  <c:v>3.9996576309204102</c:v>
                </c:pt>
                <c:pt idx="1146">
                  <c:v>4.0091862678527832</c:v>
                </c:pt>
                <c:pt idx="1147">
                  <c:v>4.0187225341796875</c:v>
                </c:pt>
                <c:pt idx="1148">
                  <c:v>4.0282659530639648</c:v>
                </c:pt>
                <c:pt idx="1149">
                  <c:v>4.0378174781799316</c:v>
                </c:pt>
                <c:pt idx="1150">
                  <c:v>4.0473780632019043</c:v>
                </c:pt>
                <c:pt idx="1151">
                  <c:v>4.0569419860839844</c:v>
                </c:pt>
                <c:pt idx="1152">
                  <c:v>4.0665183067321777</c:v>
                </c:pt>
                <c:pt idx="1153">
                  <c:v>4.0761013031005859</c:v>
                </c:pt>
                <c:pt idx="1154">
                  <c:v>4.0856924057006836</c:v>
                </c:pt>
                <c:pt idx="1155">
                  <c:v>4.0952916145324707</c:v>
                </c:pt>
                <c:pt idx="1156">
                  <c:v>4.1049008369445801</c:v>
                </c:pt>
                <c:pt idx="1157">
                  <c:v>4.1145162582397461</c:v>
                </c:pt>
                <c:pt idx="1158">
                  <c:v>4.1241412162780762</c:v>
                </c:pt>
                <c:pt idx="1159">
                  <c:v>4.1337733268737793</c:v>
                </c:pt>
                <c:pt idx="1160">
                  <c:v>4.1434130668640137</c:v>
                </c:pt>
                <c:pt idx="1161">
                  <c:v>4.1530623435974121</c:v>
                </c:pt>
                <c:pt idx="1162">
                  <c:v>4.1627197265625</c:v>
                </c:pt>
                <c:pt idx="1163">
                  <c:v>4.1723847389221191</c:v>
                </c:pt>
                <c:pt idx="1164">
                  <c:v>4.1820564270019531</c:v>
                </c:pt>
                <c:pt idx="1165">
                  <c:v>4.191734790802002</c:v>
                </c:pt>
                <c:pt idx="1166">
                  <c:v>4.2014212608337402</c:v>
                </c:pt>
                <c:pt idx="1167">
                  <c:v>4.2111163139343262</c:v>
                </c:pt>
                <c:pt idx="1168">
                  <c:v>4.2208223342895508</c:v>
                </c:pt>
                <c:pt idx="1169">
                  <c:v>4.2305355072021484</c:v>
                </c:pt>
                <c:pt idx="1170">
                  <c:v>4.240257740020752</c:v>
                </c:pt>
                <c:pt idx="1171">
                  <c:v>4.2499880790710449</c:v>
                </c:pt>
                <c:pt idx="1172">
                  <c:v>4.2597274780273438</c:v>
                </c:pt>
                <c:pt idx="1173">
                  <c:v>4.2694730758666992</c:v>
                </c:pt>
                <c:pt idx="1174">
                  <c:v>4.2792282104492188</c:v>
                </c:pt>
                <c:pt idx="1175">
                  <c:v>4.2889909744262695</c:v>
                </c:pt>
                <c:pt idx="1176">
                  <c:v>4.2987632751464844</c:v>
                </c:pt>
                <c:pt idx="1177">
                  <c:v>4.3085422515869141</c:v>
                </c:pt>
                <c:pt idx="1178">
                  <c:v>4.3183307647705078</c:v>
                </c:pt>
                <c:pt idx="1179">
                  <c:v>4.328127384185791</c:v>
                </c:pt>
                <c:pt idx="1180">
                  <c:v>4.3379321098327637</c:v>
                </c:pt>
                <c:pt idx="1181">
                  <c:v>4.347745418548584</c:v>
                </c:pt>
                <c:pt idx="1182">
                  <c:v>4.357567310333252</c:v>
                </c:pt>
                <c:pt idx="1183">
                  <c:v>4.3673968315124512</c:v>
                </c:pt>
                <c:pt idx="1184">
                  <c:v>4.377234935760498</c:v>
                </c:pt>
                <c:pt idx="1185">
                  <c:v>4.3870820999145508</c:v>
                </c:pt>
                <c:pt idx="1186">
                  <c:v>4.3969364166259766</c:v>
                </c:pt>
                <c:pt idx="1187">
                  <c:v>4.40679931640625</c:v>
                </c:pt>
                <c:pt idx="1188">
                  <c:v>4.4166722297668457</c:v>
                </c:pt>
                <c:pt idx="1189">
                  <c:v>4.4265532493591309</c:v>
                </c:pt>
                <c:pt idx="1190">
                  <c:v>4.4364423751831055</c:v>
                </c:pt>
                <c:pt idx="1191">
                  <c:v>4.4463400840759277</c:v>
                </c:pt>
                <c:pt idx="1192">
                  <c:v>4.4562463760375977</c:v>
                </c:pt>
                <c:pt idx="1193">
                  <c:v>4.4661602973937988</c:v>
                </c:pt>
                <c:pt idx="1194">
                  <c:v>4.4760828018188477</c:v>
                </c:pt>
                <c:pt idx="1195">
                  <c:v>4.4860143661499023</c:v>
                </c:pt>
                <c:pt idx="1196">
                  <c:v>4.4959535598754883</c:v>
                </c:pt>
                <c:pt idx="1197">
                  <c:v>4.5059018135070801</c:v>
                </c:pt>
                <c:pt idx="1198">
                  <c:v>4.5158572196960449</c:v>
                </c:pt>
                <c:pt idx="1199">
                  <c:v>4.5258221626281738</c:v>
                </c:pt>
                <c:pt idx="1200">
                  <c:v>4.535794734954834</c:v>
                </c:pt>
                <c:pt idx="1201">
                  <c:v>4.5457763671875</c:v>
                </c:pt>
                <c:pt idx="1202">
                  <c:v>4.5557665824890137</c:v>
                </c:pt>
                <c:pt idx="1203">
                  <c:v>4.565765380859375</c:v>
                </c:pt>
                <c:pt idx="1204">
                  <c:v>4.5757718086242676</c:v>
                </c:pt>
                <c:pt idx="1205">
                  <c:v>4.585787296295166</c:v>
                </c:pt>
                <c:pt idx="1206">
                  <c:v>4.5958113670349121</c:v>
                </c:pt>
                <c:pt idx="1207">
                  <c:v>4.6058440208435059</c:v>
                </c:pt>
                <c:pt idx="1208">
                  <c:v>4.6158843040466309</c:v>
                </c:pt>
                <c:pt idx="1209">
                  <c:v>4.6259341239929199</c:v>
                </c:pt>
                <c:pt idx="1210">
                  <c:v>4.6359920501708984</c:v>
                </c:pt>
                <c:pt idx="1211">
                  <c:v>4.6460585594177246</c:v>
                </c:pt>
                <c:pt idx="1212">
                  <c:v>4.6561331748962402</c:v>
                </c:pt>
                <c:pt idx="1213">
                  <c:v>4.6662168502807617</c:v>
                </c:pt>
                <c:pt idx="1214">
                  <c:v>4.6763091087341309</c:v>
                </c:pt>
                <c:pt idx="1215">
                  <c:v>4.6864094734191895</c:v>
                </c:pt>
                <c:pt idx="1216">
                  <c:v>4.6965188980102539</c:v>
                </c:pt>
                <c:pt idx="1217">
                  <c:v>4.7066359519958496</c:v>
                </c:pt>
                <c:pt idx="1218">
                  <c:v>4.7167625427246094</c:v>
                </c:pt>
                <c:pt idx="1219">
                  <c:v>4.7268967628479004</c:v>
                </c:pt>
                <c:pt idx="1220">
                  <c:v>4.7370405197143555</c:v>
                </c:pt>
                <c:pt idx="1221">
                  <c:v>4.7471928596496582</c:v>
                </c:pt>
                <c:pt idx="1222">
                  <c:v>4.7573528289794922</c:v>
                </c:pt>
                <c:pt idx="1223">
                  <c:v>4.7675223350524902</c:v>
                </c:pt>
                <c:pt idx="1224">
                  <c:v>4.7777004241943359</c:v>
                </c:pt>
                <c:pt idx="1225">
                  <c:v>4.7878870964050293</c:v>
                </c:pt>
                <c:pt idx="1226">
                  <c:v>4.7980823516845703</c:v>
                </c:pt>
                <c:pt idx="1227">
                  <c:v>4.8082866668701172</c:v>
                </c:pt>
                <c:pt idx="1228">
                  <c:v>4.8184990882873535</c:v>
                </c:pt>
                <c:pt idx="1229">
                  <c:v>4.8287205696105957</c:v>
                </c:pt>
                <c:pt idx="1230">
                  <c:v>4.8389506340026855</c:v>
                </c:pt>
                <c:pt idx="1231">
                  <c:v>4.849189281463623</c:v>
                </c:pt>
                <c:pt idx="1232">
                  <c:v>4.8594369888305664</c:v>
                </c:pt>
                <c:pt idx="1233">
                  <c:v>4.8696932792663574</c:v>
                </c:pt>
                <c:pt idx="1234">
                  <c:v>4.8799581527709961</c:v>
                </c:pt>
                <c:pt idx="1235">
                  <c:v>4.8902316093444824</c:v>
                </c:pt>
                <c:pt idx="1236">
                  <c:v>4.9005141258239746</c:v>
                </c:pt>
                <c:pt idx="1237">
                  <c:v>4.9108057022094727</c:v>
                </c:pt>
                <c:pt idx="1238">
                  <c:v>4.9211053848266602</c:v>
                </c:pt>
                <c:pt idx="1239">
                  <c:v>4.9314146041870117</c:v>
                </c:pt>
                <c:pt idx="1240">
                  <c:v>4.9417319297790527</c:v>
                </c:pt>
                <c:pt idx="1241">
                  <c:v>4.9520583152770996</c:v>
                </c:pt>
                <c:pt idx="1242">
                  <c:v>4.9623937606811523</c:v>
                </c:pt>
                <c:pt idx="1243">
                  <c:v>4.9727377891540527</c:v>
                </c:pt>
                <c:pt idx="1244">
                  <c:v>4.983090877532959</c:v>
                </c:pt>
                <c:pt idx="1245">
                  <c:v>4.9934525489807129</c:v>
                </c:pt>
                <c:pt idx="1246">
                  <c:v>5.0038232803344727</c:v>
                </c:pt>
                <c:pt idx="1247">
                  <c:v>5.0142025947570801</c:v>
                </c:pt>
                <c:pt idx="1248">
                  <c:v>5.0245909690856934</c:v>
                </c:pt>
                <c:pt idx="1249">
                  <c:v>5.0349879264831543</c:v>
                </c:pt>
                <c:pt idx="1250">
                  <c:v>5.0453934669494629</c:v>
                </c:pt>
                <c:pt idx="1251">
                  <c:v>5.0558080673217773</c:v>
                </c:pt>
                <c:pt idx="1252">
                  <c:v>5.0662312507629395</c:v>
                </c:pt>
                <c:pt idx="1253">
                  <c:v>5.076662540435791</c:v>
                </c:pt>
                <c:pt idx="1254">
                  <c:v>5.0871028900146484</c:v>
                </c:pt>
                <c:pt idx="1255">
                  <c:v>5.0975513458251953</c:v>
                </c:pt>
                <c:pt idx="1256">
                  <c:v>5.108008861541748</c:v>
                </c:pt>
                <c:pt idx="1257">
                  <c:v>5.118474006652832</c:v>
                </c:pt>
                <c:pt idx="1258">
                  <c:v>5.1289482116699219</c:v>
                </c:pt>
                <c:pt idx="1259">
                  <c:v>5.1394305229187012</c:v>
                </c:pt>
                <c:pt idx="1260">
                  <c:v>5.1499209403991699</c:v>
                </c:pt>
                <c:pt idx="1261">
                  <c:v>5.1604199409484863</c:v>
                </c:pt>
                <c:pt idx="1262">
                  <c:v>5.1709270477294922</c:v>
                </c:pt>
                <c:pt idx="1263">
                  <c:v>5.1814422607421875</c:v>
                </c:pt>
                <c:pt idx="1264">
                  <c:v>5.1919655799865723</c:v>
                </c:pt>
                <c:pt idx="1265">
                  <c:v>5.2024970054626465</c:v>
                </c:pt>
                <c:pt idx="1266">
                  <c:v>5.2130365371704102</c:v>
                </c:pt>
                <c:pt idx="1267">
                  <c:v>5.2235836982727051</c:v>
                </c:pt>
                <c:pt idx="1268">
                  <c:v>5.2341394424438477</c:v>
                </c:pt>
                <c:pt idx="1269">
                  <c:v>5.2447028160095215</c:v>
                </c:pt>
                <c:pt idx="1270">
                  <c:v>5.2552742958068848</c:v>
                </c:pt>
                <c:pt idx="1271">
                  <c:v>5.2658534049987793</c:v>
                </c:pt>
                <c:pt idx="1272">
                  <c:v>5.2764401435852051</c:v>
                </c:pt>
                <c:pt idx="1273">
                  <c:v>5.2870345115661621</c:v>
                </c:pt>
                <c:pt idx="1274">
                  <c:v>5.2976365089416504</c:v>
                </c:pt>
                <c:pt idx="1275">
                  <c:v>5.3082466125488281</c:v>
                </c:pt>
                <c:pt idx="1276">
                  <c:v>5.3188643455505371</c:v>
                </c:pt>
                <c:pt idx="1277">
                  <c:v>5.3294892311096191</c:v>
                </c:pt>
                <c:pt idx="1278">
                  <c:v>5.3401222229003906</c:v>
                </c:pt>
                <c:pt idx="1279">
                  <c:v>5.3507623672485352</c:v>
                </c:pt>
                <c:pt idx="1280">
                  <c:v>5.3614101409912109</c:v>
                </c:pt>
                <c:pt idx="1281">
                  <c:v>5.3720650672912598</c:v>
                </c:pt>
                <c:pt idx="1282">
                  <c:v>5.382728099822998</c:v>
                </c:pt>
                <c:pt idx="1283">
                  <c:v>5.393397331237793</c:v>
                </c:pt>
                <c:pt idx="1284">
                  <c:v>5.4040746688842773</c:v>
                </c:pt>
                <c:pt idx="1285">
                  <c:v>5.4147586822509766</c:v>
                </c:pt>
                <c:pt idx="1286">
                  <c:v>5.4254512786865234</c:v>
                </c:pt>
                <c:pt idx="1287">
                  <c:v>5.436150074005127</c:v>
                </c:pt>
                <c:pt idx="1288">
                  <c:v>5.4468560218811035</c:v>
                </c:pt>
                <c:pt idx="1289">
                  <c:v>5.4575691223144531</c:v>
                </c:pt>
                <c:pt idx="1290">
                  <c:v>5.468289852142334</c:v>
                </c:pt>
                <c:pt idx="1291">
                  <c:v>5.4790177345275879</c:v>
                </c:pt>
                <c:pt idx="1292">
                  <c:v>5.4897527694702148</c:v>
                </c:pt>
                <c:pt idx="1293">
                  <c:v>5.5004940032958984</c:v>
                </c:pt>
                <c:pt idx="1294">
                  <c:v>5.5112423896789551</c:v>
                </c:pt>
                <c:pt idx="1295">
                  <c:v>5.5219974517822266</c:v>
                </c:pt>
                <c:pt idx="1296">
                  <c:v>5.5327596664428711</c:v>
                </c:pt>
                <c:pt idx="1297">
                  <c:v>5.5435280799865723</c:v>
                </c:pt>
                <c:pt idx="1298">
                  <c:v>5.5543045997619629</c:v>
                </c:pt>
                <c:pt idx="1299">
                  <c:v>5.5650863647460938</c:v>
                </c:pt>
                <c:pt idx="1300">
                  <c:v>5.5758757591247559</c:v>
                </c:pt>
                <c:pt idx="1301">
                  <c:v>5.5866718292236328</c:v>
                </c:pt>
                <c:pt idx="1302">
                  <c:v>5.5974750518798828</c:v>
                </c:pt>
                <c:pt idx="1303">
                  <c:v>5.6082839965820313</c:v>
                </c:pt>
                <c:pt idx="1304">
                  <c:v>5.6191000938415527</c:v>
                </c:pt>
                <c:pt idx="1305">
                  <c:v>5.6299214363098145</c:v>
                </c:pt>
                <c:pt idx="1306">
                  <c:v>5.6407508850097656</c:v>
                </c:pt>
                <c:pt idx="1307">
                  <c:v>5.6515851020812988</c:v>
                </c:pt>
                <c:pt idx="1308">
                  <c:v>5.6624259948730469</c:v>
                </c:pt>
                <c:pt idx="1309">
                  <c:v>5.6732730865478516</c:v>
                </c:pt>
                <c:pt idx="1310">
                  <c:v>5.6841268539428711</c:v>
                </c:pt>
                <c:pt idx="1311">
                  <c:v>5.6949863433837891</c:v>
                </c:pt>
                <c:pt idx="1312">
                  <c:v>5.7058529853820801</c:v>
                </c:pt>
                <c:pt idx="1313">
                  <c:v>5.7167258262634277</c:v>
                </c:pt>
                <c:pt idx="1314">
                  <c:v>5.7276043891906738</c:v>
                </c:pt>
                <c:pt idx="1315">
                  <c:v>5.7384891510009766</c:v>
                </c:pt>
                <c:pt idx="1316">
                  <c:v>5.7493777275085449</c:v>
                </c:pt>
                <c:pt idx="1317">
                  <c:v>5.7602739334106445</c:v>
                </c:pt>
                <c:pt idx="1318">
                  <c:v>5.7711753845214844</c:v>
                </c:pt>
                <c:pt idx="1319">
                  <c:v>5.7820835113525391</c:v>
                </c:pt>
                <c:pt idx="1320">
                  <c:v>5.7929964065551758</c:v>
                </c:pt>
                <c:pt idx="1321">
                  <c:v>5.8039164543151855</c:v>
                </c:pt>
                <c:pt idx="1322">
                  <c:v>5.8148422241210938</c:v>
                </c:pt>
                <c:pt idx="1323">
                  <c:v>5.8257737159729004</c:v>
                </c:pt>
                <c:pt idx="1324">
                  <c:v>5.8367109298706055</c:v>
                </c:pt>
                <c:pt idx="1325">
                  <c:v>5.8476543426513672</c:v>
                </c:pt>
                <c:pt idx="1326">
                  <c:v>5.8586030006408691</c:v>
                </c:pt>
                <c:pt idx="1327">
                  <c:v>5.8695564270019531</c:v>
                </c:pt>
                <c:pt idx="1328">
                  <c:v>5.8805155754089355</c:v>
                </c:pt>
                <c:pt idx="1329">
                  <c:v>5.8914799690246582</c:v>
                </c:pt>
                <c:pt idx="1330">
                  <c:v>5.9024510383605957</c:v>
                </c:pt>
                <c:pt idx="1331">
                  <c:v>5.9134268760681152</c:v>
                </c:pt>
                <c:pt idx="1332">
                  <c:v>5.9244093894958496</c:v>
                </c:pt>
                <c:pt idx="1333">
                  <c:v>5.9353971481323242</c:v>
                </c:pt>
                <c:pt idx="1334">
                  <c:v>5.9463891983032227</c:v>
                </c:pt>
                <c:pt idx="1335">
                  <c:v>5.9573864936828613</c:v>
                </c:pt>
                <c:pt idx="1336">
                  <c:v>5.9683890342712402</c:v>
                </c:pt>
                <c:pt idx="1337">
                  <c:v>5.9793968200683594</c:v>
                </c:pt>
                <c:pt idx="1338">
                  <c:v>5.990410327911377</c:v>
                </c:pt>
                <c:pt idx="1339">
                  <c:v>6.0014290809631348</c:v>
                </c:pt>
                <c:pt idx="1340">
                  <c:v>6.0124526023864746</c:v>
                </c:pt>
                <c:pt idx="1341">
                  <c:v>6.0234832763671875</c:v>
                </c:pt>
                <c:pt idx="1342">
                  <c:v>6.0345158576965332</c:v>
                </c:pt>
                <c:pt idx="1343">
                  <c:v>6.0455551147460938</c:v>
                </c:pt>
                <c:pt idx="1344">
                  <c:v>6.0565981864929199</c:v>
                </c:pt>
                <c:pt idx="1345">
                  <c:v>6.0676479339599609</c:v>
                </c:pt>
                <c:pt idx="1346">
                  <c:v>6.078700065612793</c:v>
                </c:pt>
                <c:pt idx="1347">
                  <c:v>6.0897574424743652</c:v>
                </c:pt>
                <c:pt idx="1348">
                  <c:v>6.1008205413818359</c:v>
                </c:pt>
                <c:pt idx="1349">
                  <c:v>6.1118903160095215</c:v>
                </c:pt>
                <c:pt idx="1350">
                  <c:v>6.122962474822998</c:v>
                </c:pt>
                <c:pt idx="1351">
                  <c:v>6.1340413093566895</c:v>
                </c:pt>
                <c:pt idx="1352">
                  <c:v>6.1451225280761719</c:v>
                </c:pt>
                <c:pt idx="1353">
                  <c:v>6.1562104225158691</c:v>
                </c:pt>
                <c:pt idx="1354">
                  <c:v>6.167302131652832</c:v>
                </c:pt>
                <c:pt idx="1355">
                  <c:v>6.1783995628356934</c:v>
                </c:pt>
                <c:pt idx="1356">
                  <c:v>6.1894993782043457</c:v>
                </c:pt>
                <c:pt idx="1357">
                  <c:v>6.2006053924560547</c:v>
                </c:pt>
                <c:pt idx="1358">
                  <c:v>6.2117137908935547</c:v>
                </c:pt>
                <c:pt idx="1359">
                  <c:v>6.2228279113769531</c:v>
                </c:pt>
                <c:pt idx="1360">
                  <c:v>6.2339463233947754</c:v>
                </c:pt>
                <c:pt idx="1361">
                  <c:v>6.2450675964355469</c:v>
                </c:pt>
                <c:pt idx="1362">
                  <c:v>6.2561917304992676</c:v>
                </c:pt>
                <c:pt idx="1363">
                  <c:v>6.2673230171203613</c:v>
                </c:pt>
                <c:pt idx="1364">
                  <c:v>6.2784571647644043</c:v>
                </c:pt>
                <c:pt idx="1365">
                  <c:v>6.2895965576171875</c:v>
                </c:pt>
                <c:pt idx="1366">
                  <c:v>6.3007392883300781</c:v>
                </c:pt>
                <c:pt idx="1367">
                  <c:v>6.3118863105773926</c:v>
                </c:pt>
                <c:pt idx="1368">
                  <c:v>6.3230361938476563</c:v>
                </c:pt>
                <c:pt idx="1369">
                  <c:v>6.334193229675293</c:v>
                </c:pt>
                <c:pt idx="1370">
                  <c:v>6.3453502655029297</c:v>
                </c:pt>
                <c:pt idx="1371">
                  <c:v>6.3565139770507813</c:v>
                </c:pt>
                <c:pt idx="1372">
                  <c:v>6.3676810264587402</c:v>
                </c:pt>
                <c:pt idx="1373">
                  <c:v>6.3788537979125977</c:v>
                </c:pt>
                <c:pt idx="1374">
                  <c:v>6.3900279998779297</c:v>
                </c:pt>
                <c:pt idx="1375">
                  <c:v>6.4012079238891602</c:v>
                </c:pt>
                <c:pt idx="1376">
                  <c:v>6.4123897552490234</c:v>
                </c:pt>
                <c:pt idx="1377">
                  <c:v>6.4235754013061523</c:v>
                </c:pt>
                <c:pt idx="1378">
                  <c:v>6.4347648620605469</c:v>
                </c:pt>
                <c:pt idx="1379">
                  <c:v>6.4459586143493652</c:v>
                </c:pt>
                <c:pt idx="1380">
                  <c:v>6.4571542739868164</c:v>
                </c:pt>
                <c:pt idx="1381">
                  <c:v>6.4683561325073242</c:v>
                </c:pt>
                <c:pt idx="1382">
                  <c:v>6.4795575141906738</c:v>
                </c:pt>
                <c:pt idx="1383">
                  <c:v>6.4907674789428711</c:v>
                </c:pt>
                <c:pt idx="1384">
                  <c:v>6.501978874206543</c:v>
                </c:pt>
                <c:pt idx="1385">
                  <c:v>6.5131936073303223</c:v>
                </c:pt>
                <c:pt idx="1386">
                  <c:v>6.5244126319885254</c:v>
                </c:pt>
                <c:pt idx="1387">
                  <c:v>6.5356364250183105</c:v>
                </c:pt>
                <c:pt idx="1388">
                  <c:v>6.5468611717224121</c:v>
                </c:pt>
                <c:pt idx="1389">
                  <c:v>6.5580906867980957</c:v>
                </c:pt>
                <c:pt idx="1390">
                  <c:v>6.5693240165710449</c:v>
                </c:pt>
                <c:pt idx="1391">
                  <c:v>6.5805602073669434</c:v>
                </c:pt>
                <c:pt idx="1392">
                  <c:v>6.5918006896972656</c:v>
                </c:pt>
                <c:pt idx="1393">
                  <c:v>6.6030445098876953</c:v>
                </c:pt>
                <c:pt idx="1394">
                  <c:v>6.6142902374267578</c:v>
                </c:pt>
                <c:pt idx="1395">
                  <c:v>6.6255388259887695</c:v>
                </c:pt>
                <c:pt idx="1396">
                  <c:v>6.6367912292480469</c:v>
                </c:pt>
                <c:pt idx="1397">
                  <c:v>6.6480469703674316</c:v>
                </c:pt>
                <c:pt idx="1398">
                  <c:v>6.6593055725097656</c:v>
                </c:pt>
                <c:pt idx="1399">
                  <c:v>6.6705679893493652</c:v>
                </c:pt>
                <c:pt idx="1400">
                  <c:v>6.6818323135375977</c:v>
                </c:pt>
                <c:pt idx="1401">
                  <c:v>6.6931009292602539</c:v>
                </c:pt>
                <c:pt idx="1402">
                  <c:v>6.704371452331543</c:v>
                </c:pt>
                <c:pt idx="1403">
                  <c:v>6.7156481742858887</c:v>
                </c:pt>
                <c:pt idx="1404">
                  <c:v>6.7269268035888672</c:v>
                </c:pt>
                <c:pt idx="1405">
                  <c:v>6.7382102012634277</c:v>
                </c:pt>
                <c:pt idx="1406">
                  <c:v>6.7494921684265137</c:v>
                </c:pt>
                <c:pt idx="1407">
                  <c:v>6.7607793807983398</c:v>
                </c:pt>
                <c:pt idx="1408">
                  <c:v>6.7720680236816406</c:v>
                </c:pt>
                <c:pt idx="1409">
                  <c:v>6.7833633422851563</c:v>
                </c:pt>
                <c:pt idx="1410">
                  <c:v>6.7946600914001465</c:v>
                </c:pt>
                <c:pt idx="1411">
                  <c:v>6.8059573173522949</c:v>
                </c:pt>
                <c:pt idx="1412">
                  <c:v>6.8172588348388672</c:v>
                </c:pt>
                <c:pt idx="1413">
                  <c:v>6.8285608291625977</c:v>
                </c:pt>
                <c:pt idx="1414">
                  <c:v>6.8398680686950684</c:v>
                </c:pt>
                <c:pt idx="1415">
                  <c:v>6.8511757850646973</c:v>
                </c:pt>
                <c:pt idx="1416">
                  <c:v>6.862485408782959</c:v>
                </c:pt>
                <c:pt idx="1417">
                  <c:v>6.8737983703613281</c:v>
                </c:pt>
                <c:pt idx="1418">
                  <c:v>6.8851132392883301</c:v>
                </c:pt>
                <c:pt idx="1419">
                  <c:v>6.8964323997497559</c:v>
                </c:pt>
                <c:pt idx="1420">
                  <c:v>6.9077534675598145</c:v>
                </c:pt>
                <c:pt idx="1421">
                  <c:v>6.9190726280212402</c:v>
                </c:pt>
                <c:pt idx="1422">
                  <c:v>6.9303979873657227</c:v>
                </c:pt>
                <c:pt idx="1423">
                  <c:v>6.9417238235473633</c:v>
                </c:pt>
                <c:pt idx="1424">
                  <c:v>6.9530515670776367</c:v>
                </c:pt>
                <c:pt idx="1425">
                  <c:v>6.9643816947937012</c:v>
                </c:pt>
                <c:pt idx="1426">
                  <c:v>6.9757156372070313</c:v>
                </c:pt>
                <c:pt idx="1427">
                  <c:v>6.9870510101318359</c:v>
                </c:pt>
                <c:pt idx="1428">
                  <c:v>6.9983892440795898</c:v>
                </c:pt>
                <c:pt idx="1429">
                  <c:v>7.0097274780273438</c:v>
                </c:pt>
                <c:pt idx="1430">
                  <c:v>7.0210676193237305</c:v>
                </c:pt>
                <c:pt idx="1431">
                  <c:v>7.0324101448059082</c:v>
                </c:pt>
                <c:pt idx="1432">
                  <c:v>7.043755054473877</c:v>
                </c:pt>
                <c:pt idx="1433">
                  <c:v>7.0551037788391113</c:v>
                </c:pt>
                <c:pt idx="1434">
                  <c:v>7.0664539337158203</c:v>
                </c:pt>
                <c:pt idx="1435">
                  <c:v>7.0778059959411621</c:v>
                </c:pt>
                <c:pt idx="1436">
                  <c:v>7.0891590118408203</c:v>
                </c:pt>
                <c:pt idx="1437">
                  <c:v>7.1005134582519531</c:v>
                </c:pt>
                <c:pt idx="1438">
                  <c:v>7.1118721961975098</c:v>
                </c:pt>
                <c:pt idx="1439">
                  <c:v>7.1232309341430664</c:v>
                </c:pt>
                <c:pt idx="1440">
                  <c:v>7.1345920562744141</c:v>
                </c:pt>
                <c:pt idx="1441">
                  <c:v>7.1459546089172363</c:v>
                </c:pt>
                <c:pt idx="1442">
                  <c:v>7.1573185920715332</c:v>
                </c:pt>
                <c:pt idx="1443">
                  <c:v>7.1686849594116211</c:v>
                </c:pt>
                <c:pt idx="1444">
                  <c:v>7.1800537109375</c:v>
                </c:pt>
                <c:pt idx="1445">
                  <c:v>7.1914238929748535</c:v>
                </c:pt>
                <c:pt idx="1446">
                  <c:v>7.2027974128723145</c:v>
                </c:pt>
                <c:pt idx="1447">
                  <c:v>7.2141728401184082</c:v>
                </c:pt>
                <c:pt idx="1448">
                  <c:v>7.2255496978759766</c:v>
                </c:pt>
                <c:pt idx="1449">
                  <c:v>7.2369284629821777</c:v>
                </c:pt>
                <c:pt idx="1450">
                  <c:v>7.2483086585998535</c:v>
                </c:pt>
                <c:pt idx="1451">
                  <c:v>7.2596907615661621</c:v>
                </c:pt>
                <c:pt idx="1452">
                  <c:v>7.2710752487182617</c:v>
                </c:pt>
                <c:pt idx="1453">
                  <c:v>7.2824611663818359</c:v>
                </c:pt>
                <c:pt idx="1454">
                  <c:v>7.293848991394043</c:v>
                </c:pt>
                <c:pt idx="1455">
                  <c:v>7.3052377700805664</c:v>
                </c:pt>
                <c:pt idx="1456">
                  <c:v>7.3166294097900391</c:v>
                </c:pt>
                <c:pt idx="1457">
                  <c:v>7.3280229568481445</c:v>
                </c:pt>
                <c:pt idx="1458">
                  <c:v>7.3394169807434082</c:v>
                </c:pt>
                <c:pt idx="1459">
                  <c:v>7.3508143424987793</c:v>
                </c:pt>
                <c:pt idx="1460">
                  <c:v>7.3622126579284668</c:v>
                </c:pt>
                <c:pt idx="1461">
                  <c:v>7.3736128807067871</c:v>
                </c:pt>
                <c:pt idx="1462">
                  <c:v>7.385014533996582</c:v>
                </c:pt>
                <c:pt idx="1463">
                  <c:v>7.396418571472168</c:v>
                </c:pt>
                <c:pt idx="1464">
                  <c:v>7.4078254699707031</c:v>
                </c:pt>
                <c:pt idx="1465">
                  <c:v>7.4192337989807129</c:v>
                </c:pt>
                <c:pt idx="1466">
                  <c:v>7.4306440353393555</c:v>
                </c:pt>
                <c:pt idx="1467">
                  <c:v>7.4420557022094727</c:v>
                </c:pt>
                <c:pt idx="1468">
                  <c:v>7.4534702301025391</c:v>
                </c:pt>
                <c:pt idx="1469">
                  <c:v>7.4648857116699219</c:v>
                </c:pt>
                <c:pt idx="1470">
                  <c:v>7.4763016700744629</c:v>
                </c:pt>
                <c:pt idx="1471">
                  <c:v>7.4877214431762695</c:v>
                </c:pt>
                <c:pt idx="1472">
                  <c:v>7.499143123626709</c:v>
                </c:pt>
                <c:pt idx="1473">
                  <c:v>7.5105667114257813</c:v>
                </c:pt>
                <c:pt idx="1474">
                  <c:v>7.5219922065734863</c:v>
                </c:pt>
                <c:pt idx="1475">
                  <c:v>7.533419132232666</c:v>
                </c:pt>
                <c:pt idx="1476">
                  <c:v>7.5448474884033203</c:v>
                </c:pt>
                <c:pt idx="1477">
                  <c:v>7.5562782287597656</c:v>
                </c:pt>
                <c:pt idx="1478">
                  <c:v>7.567711353302002</c:v>
                </c:pt>
                <c:pt idx="1479">
                  <c:v>7.5791459083557129</c:v>
                </c:pt>
                <c:pt idx="1480">
                  <c:v>7.590583324432373</c:v>
                </c:pt>
                <c:pt idx="1481">
                  <c:v>7.6020221710205078</c:v>
                </c:pt>
                <c:pt idx="1482">
                  <c:v>7.6134634017944336</c:v>
                </c:pt>
                <c:pt idx="1483">
                  <c:v>7.624906063079834</c:v>
                </c:pt>
                <c:pt idx="1484">
                  <c:v>7.6363506317138672</c:v>
                </c:pt>
                <c:pt idx="1485">
                  <c:v>7.6477975845336914</c:v>
                </c:pt>
                <c:pt idx="1486">
                  <c:v>7.6592459678649902</c:v>
                </c:pt>
                <c:pt idx="1487">
                  <c:v>7.6706962585449219</c:v>
                </c:pt>
                <c:pt idx="1488">
                  <c:v>7.6821489334106445</c:v>
                </c:pt>
                <c:pt idx="1489">
                  <c:v>7.6936030387878418</c:v>
                </c:pt>
                <c:pt idx="1490">
                  <c:v>7.7050595283508301</c:v>
                </c:pt>
                <c:pt idx="1491">
                  <c:v>7.716517448425293</c:v>
                </c:pt>
                <c:pt idx="1492">
                  <c:v>7.7279777526855469</c:v>
                </c:pt>
                <c:pt idx="1493">
                  <c:v>7.7394399642944336</c:v>
                </c:pt>
                <c:pt idx="1494">
                  <c:v>7.7509031295776367</c:v>
                </c:pt>
                <c:pt idx="1495">
                  <c:v>7.7623691558837891</c:v>
                </c:pt>
                <c:pt idx="1496">
                  <c:v>7.7738370895385742</c:v>
                </c:pt>
                <c:pt idx="1497">
                  <c:v>7.7853069305419922</c:v>
                </c:pt>
                <c:pt idx="1498">
                  <c:v>7.796778678894043</c:v>
                </c:pt>
                <c:pt idx="1499">
                  <c:v>7.8082523345947266</c:v>
                </c:pt>
                <c:pt idx="1500">
                  <c:v>7.8197283744812012</c:v>
                </c:pt>
                <c:pt idx="1501">
                  <c:v>7.8312058448791504</c:v>
                </c:pt>
                <c:pt idx="1502">
                  <c:v>7.8426856994628906</c:v>
                </c:pt>
                <c:pt idx="1503">
                  <c:v>7.8541669845581055</c:v>
                </c:pt>
                <c:pt idx="1504">
                  <c:v>7.8656506538391113</c:v>
                </c:pt>
                <c:pt idx="1505">
                  <c:v>7.87713623046875</c:v>
                </c:pt>
                <c:pt idx="1506">
                  <c:v>7.8886237144470215</c:v>
                </c:pt>
                <c:pt idx="1507">
                  <c:v>7.900113582611084</c:v>
                </c:pt>
                <c:pt idx="1508">
                  <c:v>7.9116048812866211</c:v>
                </c:pt>
                <c:pt idx="1509">
                  <c:v>7.9230985641479492</c:v>
                </c:pt>
                <c:pt idx="1510">
                  <c:v>7.934593677520752</c:v>
                </c:pt>
                <c:pt idx="1511">
                  <c:v>7.9460911750793457</c:v>
                </c:pt>
                <c:pt idx="1512">
                  <c:v>7.9575910568237305</c:v>
                </c:pt>
                <c:pt idx="1513">
                  <c:v>7.9690923690795898</c:v>
                </c:pt>
                <c:pt idx="1514">
                  <c:v>7.9805960655212402</c:v>
                </c:pt>
                <c:pt idx="1515">
                  <c:v>7.9921011924743652</c:v>
                </c:pt>
                <c:pt idx="1516">
                  <c:v>8.0036087036132813</c:v>
                </c:pt>
                <c:pt idx="1517">
                  <c:v>8.0151185989379883</c:v>
                </c:pt>
                <c:pt idx="1518">
                  <c:v>8.0266304016113281</c:v>
                </c:pt>
                <c:pt idx="1519">
                  <c:v>8.0381441116333008</c:v>
                </c:pt>
                <c:pt idx="1520">
                  <c:v>8.0496597290039063</c:v>
                </c:pt>
                <c:pt idx="1521">
                  <c:v>8.0611772537231445</c:v>
                </c:pt>
                <c:pt idx="1522">
                  <c:v>8.0726966857910156</c:v>
                </c:pt>
                <c:pt idx="1523">
                  <c:v>8.0842189788818359</c:v>
                </c:pt>
                <c:pt idx="1524">
                  <c:v>8.0957422256469727</c:v>
                </c:pt>
                <c:pt idx="1525">
                  <c:v>8.1072683334350586</c:v>
                </c:pt>
                <c:pt idx="1526">
                  <c:v>8.1187963485717773</c:v>
                </c:pt>
                <c:pt idx="1527">
                  <c:v>8.1303262710571289</c:v>
                </c:pt>
                <c:pt idx="1528">
                  <c:v>8.1418581008911133</c:v>
                </c:pt>
                <c:pt idx="1529">
                  <c:v>8.1533918380737305</c:v>
                </c:pt>
                <c:pt idx="1530">
                  <c:v>8.1649284362792969</c:v>
                </c:pt>
                <c:pt idx="1531">
                  <c:v>8.1764659881591797</c:v>
                </c:pt>
                <c:pt idx="1532">
                  <c:v>8.1880064010620117</c:v>
                </c:pt>
                <c:pt idx="1533">
                  <c:v>8.1995487213134766</c:v>
                </c:pt>
                <c:pt idx="1534">
                  <c:v>8.2110929489135742</c:v>
                </c:pt>
                <c:pt idx="1535">
                  <c:v>8.2226400375366211</c:v>
                </c:pt>
                <c:pt idx="1536">
                  <c:v>8.2341880798339844</c:v>
                </c:pt>
                <c:pt idx="1537">
                  <c:v>8.2457389831542969</c:v>
                </c:pt>
                <c:pt idx="1538">
                  <c:v>8.2572917938232422</c:v>
                </c:pt>
                <c:pt idx="1539">
                  <c:v>8.2688465118408203</c:v>
                </c:pt>
                <c:pt idx="1540">
                  <c:v>8.2804031372070313</c:v>
                </c:pt>
                <c:pt idx="1541">
                  <c:v>8.2919626235961914</c:v>
                </c:pt>
                <c:pt idx="1542">
                  <c:v>8.3035240173339844</c:v>
                </c:pt>
                <c:pt idx="1543">
                  <c:v>8.3150873184204102</c:v>
                </c:pt>
                <c:pt idx="1544">
                  <c:v>8.3266525268554688</c:v>
                </c:pt>
                <c:pt idx="1545">
                  <c:v>8.3382205963134766</c:v>
                </c:pt>
                <c:pt idx="1546">
                  <c:v>8.3497905731201172</c:v>
                </c:pt>
                <c:pt idx="1547">
                  <c:v>8.3613624572753906</c:v>
                </c:pt>
                <c:pt idx="1548">
                  <c:v>8.3729362487792969</c:v>
                </c:pt>
                <c:pt idx="1549">
                  <c:v>8.3845119476318359</c:v>
                </c:pt>
                <c:pt idx="1550">
                  <c:v>8.3960914611816406</c:v>
                </c:pt>
                <c:pt idx="1551">
                  <c:v>8.4076719284057617</c:v>
                </c:pt>
                <c:pt idx="1552">
                  <c:v>8.419255256652832</c:v>
                </c:pt>
                <c:pt idx="1553">
                  <c:v>8.4308395385742188</c:v>
                </c:pt>
                <c:pt idx="1554">
                  <c:v>8.4424276351928711</c:v>
                </c:pt>
                <c:pt idx="1555">
                  <c:v>8.4540166854858398</c:v>
                </c:pt>
                <c:pt idx="1556">
                  <c:v>8.4656085968017578</c:v>
                </c:pt>
                <c:pt idx="1557">
                  <c:v>8.4772024154663086</c:v>
                </c:pt>
                <c:pt idx="1558">
                  <c:v>8.4887981414794922</c:v>
                </c:pt>
                <c:pt idx="1559">
                  <c:v>8.5003957748413086</c:v>
                </c:pt>
                <c:pt idx="1560">
                  <c:v>8.5119962692260742</c:v>
                </c:pt>
                <c:pt idx="1561">
                  <c:v>8.5235986709594727</c:v>
                </c:pt>
                <c:pt idx="1562">
                  <c:v>8.5352039337158203</c:v>
                </c:pt>
                <c:pt idx="1563">
                  <c:v>8.5468111038208008</c:v>
                </c:pt>
                <c:pt idx="1564">
                  <c:v>8.5584211349487305</c:v>
                </c:pt>
                <c:pt idx="1565">
                  <c:v>8.5700321197509766</c:v>
                </c:pt>
                <c:pt idx="1566">
                  <c:v>8.5816459655761719</c:v>
                </c:pt>
                <c:pt idx="1567">
                  <c:v>8.59326171875</c:v>
                </c:pt>
                <c:pt idx="1568">
                  <c:v>8.6048803329467773</c:v>
                </c:pt>
                <c:pt idx="1569">
                  <c:v>8.6165018081665039</c:v>
                </c:pt>
                <c:pt idx="1570">
                  <c:v>8.6281242370605469</c:v>
                </c:pt>
                <c:pt idx="1571">
                  <c:v>8.6397495269775391</c:v>
                </c:pt>
                <c:pt idx="1572">
                  <c:v>8.6513767242431641</c:v>
                </c:pt>
                <c:pt idx="1573">
                  <c:v>8.6630048751831055</c:v>
                </c:pt>
                <c:pt idx="1574">
                  <c:v>8.6746368408203125</c:v>
                </c:pt>
                <c:pt idx="1575">
                  <c:v>8.6862697601318359</c:v>
                </c:pt>
                <c:pt idx="1576">
                  <c:v>8.6979074478149414</c:v>
                </c:pt>
                <c:pt idx="1577">
                  <c:v>8.7095451354980469</c:v>
                </c:pt>
                <c:pt idx="1578">
                  <c:v>8.7211875915527344</c:v>
                </c:pt>
                <c:pt idx="1579">
                  <c:v>8.7328300476074219</c:v>
                </c:pt>
                <c:pt idx="1580">
                  <c:v>8.7444753646850586</c:v>
                </c:pt>
                <c:pt idx="1581">
                  <c:v>8.7561235427856445</c:v>
                </c:pt>
                <c:pt idx="1582">
                  <c:v>8.7677736282348633</c:v>
                </c:pt>
                <c:pt idx="1583">
                  <c:v>8.7794256210327148</c:v>
                </c:pt>
                <c:pt idx="1584">
                  <c:v>8.791081428527832</c:v>
                </c:pt>
                <c:pt idx="1585">
                  <c:v>8.802739143371582</c:v>
                </c:pt>
                <c:pt idx="1586">
                  <c:v>8.8143997192382813</c:v>
                </c:pt>
                <c:pt idx="1587">
                  <c:v>8.8260612487792969</c:v>
                </c:pt>
                <c:pt idx="1588">
                  <c:v>8.8377265930175781</c:v>
                </c:pt>
                <c:pt idx="1589">
                  <c:v>8.8493928909301758</c:v>
                </c:pt>
                <c:pt idx="1590">
                  <c:v>8.8610620498657227</c:v>
                </c:pt>
                <c:pt idx="1591">
                  <c:v>8.8727340698242188</c:v>
                </c:pt>
                <c:pt idx="1592">
                  <c:v>8.8844089508056641</c:v>
                </c:pt>
                <c:pt idx="1593">
                  <c:v>8.8960857391357422</c:v>
                </c:pt>
                <c:pt idx="1594">
                  <c:v>8.9077634811401367</c:v>
                </c:pt>
                <c:pt idx="1595">
                  <c:v>8.9194450378417969</c:v>
                </c:pt>
                <c:pt idx="1596">
                  <c:v>8.9311294555664063</c:v>
                </c:pt>
                <c:pt idx="1597">
                  <c:v>8.9428157806396484</c:v>
                </c:pt>
                <c:pt idx="1598">
                  <c:v>8.9545040130615234</c:v>
                </c:pt>
                <c:pt idx="1599">
                  <c:v>8.9661960601806641</c:v>
                </c:pt>
                <c:pt idx="1600">
                  <c:v>8.9778890609741211</c:v>
                </c:pt>
                <c:pt idx="1601">
                  <c:v>8.9895858764648438</c:v>
                </c:pt>
                <c:pt idx="1602">
                  <c:v>9.0012836456298828</c:v>
                </c:pt>
                <c:pt idx="1603">
                  <c:v>9.0129861831665039</c:v>
                </c:pt>
                <c:pt idx="1604">
                  <c:v>9.0246896743774414</c:v>
                </c:pt>
                <c:pt idx="1605">
                  <c:v>9.0363950729370117</c:v>
                </c:pt>
                <c:pt idx="1606">
                  <c:v>9.0481033325195313</c:v>
                </c:pt>
                <c:pt idx="1607">
                  <c:v>9.0598154067993164</c:v>
                </c:pt>
                <c:pt idx="1608">
                  <c:v>9.0715293884277344</c:v>
                </c:pt>
                <c:pt idx="1609">
                  <c:v>9.0832452774047852</c:v>
                </c:pt>
                <c:pt idx="1610">
                  <c:v>9.0949630737304688</c:v>
                </c:pt>
                <c:pt idx="1611">
                  <c:v>9.1066856384277344</c:v>
                </c:pt>
                <c:pt idx="1612">
                  <c:v>9.1184091567993164</c:v>
                </c:pt>
                <c:pt idx="1613">
                  <c:v>9.1301336288452148</c:v>
                </c:pt>
                <c:pt idx="1614">
                  <c:v>9.1418619155883789</c:v>
                </c:pt>
                <c:pt idx="1615">
                  <c:v>9.1535930633544922</c:v>
                </c:pt>
                <c:pt idx="1616">
                  <c:v>9.1653261184692383</c:v>
                </c:pt>
                <c:pt idx="1617">
                  <c:v>9.1770639419555664</c:v>
                </c:pt>
                <c:pt idx="1618">
                  <c:v>9.1887998580932617</c:v>
                </c:pt>
                <c:pt idx="1619">
                  <c:v>9.2005424499511719</c:v>
                </c:pt>
                <c:pt idx="1620">
                  <c:v>9.2122840881347656</c:v>
                </c:pt>
                <c:pt idx="1621">
                  <c:v>9.2240304946899414</c:v>
                </c:pt>
                <c:pt idx="1622">
                  <c:v>9.2357778549194336</c:v>
                </c:pt>
                <c:pt idx="1623">
                  <c:v>9.2475309371948242</c:v>
                </c:pt>
                <c:pt idx="1624">
                  <c:v>9.2592840194702148</c:v>
                </c:pt>
                <c:pt idx="1625">
                  <c:v>9.2710409164428711</c:v>
                </c:pt>
                <c:pt idx="1626">
                  <c:v>9.2827978134155273</c:v>
                </c:pt>
                <c:pt idx="1627">
                  <c:v>9.2945594787597656</c:v>
                </c:pt>
                <c:pt idx="1628">
                  <c:v>9.3063240051269531</c:v>
                </c:pt>
                <c:pt idx="1629">
                  <c:v>9.3180942535400391</c:v>
                </c:pt>
                <c:pt idx="1630">
                  <c:v>9.3298625946044922</c:v>
                </c:pt>
                <c:pt idx="1631">
                  <c:v>9.3416347503662109</c:v>
                </c:pt>
                <c:pt idx="1632">
                  <c:v>9.3534088134765625</c:v>
                </c:pt>
                <c:pt idx="1633">
                  <c:v>9.3651866912841797</c:v>
                </c:pt>
                <c:pt idx="1634">
                  <c:v>9.3769674301147461</c:v>
                </c:pt>
                <c:pt idx="1635">
                  <c:v>9.3887510299682617</c:v>
                </c:pt>
                <c:pt idx="1636">
                  <c:v>9.4005365371704102</c:v>
                </c:pt>
                <c:pt idx="1637">
                  <c:v>9.4123268127441406</c:v>
                </c:pt>
                <c:pt idx="1638">
                  <c:v>9.4241161346435547</c:v>
                </c:pt>
                <c:pt idx="1639">
                  <c:v>9.4359111785888672</c:v>
                </c:pt>
                <c:pt idx="1640">
                  <c:v>9.4477062225341797</c:v>
                </c:pt>
                <c:pt idx="1641">
                  <c:v>9.4595060348510742</c:v>
                </c:pt>
                <c:pt idx="1642">
                  <c:v>9.4713068008422852</c:v>
                </c:pt>
                <c:pt idx="1643">
                  <c:v>9.4831123352050781</c:v>
                </c:pt>
                <c:pt idx="1644">
                  <c:v>9.4949178695678711</c:v>
                </c:pt>
                <c:pt idx="1645">
                  <c:v>9.5067300796508789</c:v>
                </c:pt>
                <c:pt idx="1646">
                  <c:v>9.5185422897338867</c:v>
                </c:pt>
                <c:pt idx="1647">
                  <c:v>9.530360221862793</c:v>
                </c:pt>
                <c:pt idx="1648">
                  <c:v>9.5421762466430664</c:v>
                </c:pt>
                <c:pt idx="1649">
                  <c:v>9.5539989471435547</c:v>
                </c:pt>
                <c:pt idx="1650">
                  <c:v>9.5658226013183594</c:v>
                </c:pt>
                <c:pt idx="1651">
                  <c:v>9.5776510238647461</c:v>
                </c:pt>
                <c:pt idx="1652">
                  <c:v>9.5894813537597656</c:v>
                </c:pt>
                <c:pt idx="1653">
                  <c:v>9.6013174057006836</c:v>
                </c:pt>
                <c:pt idx="1654">
                  <c:v>9.6131525039672852</c:v>
                </c:pt>
                <c:pt idx="1655">
                  <c:v>9.6249933242797852</c:v>
                </c:pt>
                <c:pt idx="1656">
                  <c:v>9.6368331909179688</c:v>
                </c:pt>
                <c:pt idx="1657">
                  <c:v>9.6486787796020508</c:v>
                </c:pt>
                <c:pt idx="1658">
                  <c:v>9.6605253219604492</c:v>
                </c:pt>
                <c:pt idx="1659">
                  <c:v>9.6723756790161133</c:v>
                </c:pt>
                <c:pt idx="1660">
                  <c:v>9.6842260360717773</c:v>
                </c:pt>
                <c:pt idx="1661">
                  <c:v>9.6960821151733398</c:v>
                </c:pt>
                <c:pt idx="1662">
                  <c:v>9.7079391479492188</c:v>
                </c:pt>
                <c:pt idx="1663">
                  <c:v>9.7197990417480469</c:v>
                </c:pt>
                <c:pt idx="1664">
                  <c:v>9.7316617965698242</c:v>
                </c:pt>
                <c:pt idx="1665">
                  <c:v>9.7435293197631836</c:v>
                </c:pt>
                <c:pt idx="1666">
                  <c:v>9.755396842956543</c:v>
                </c:pt>
                <c:pt idx="1667">
                  <c:v>9.7672691345214844</c:v>
                </c:pt>
                <c:pt idx="1668">
                  <c:v>9.7791433334350586</c:v>
                </c:pt>
                <c:pt idx="1669">
                  <c:v>9.7910213470458984</c:v>
                </c:pt>
                <c:pt idx="1670">
                  <c:v>9.8029012680053711</c:v>
                </c:pt>
                <c:pt idx="1671">
                  <c:v>9.8147850036621094</c:v>
                </c:pt>
                <c:pt idx="1672">
                  <c:v>9.8266716003417969</c:v>
                </c:pt>
                <c:pt idx="1673">
                  <c:v>9.8385610580444336</c:v>
                </c:pt>
                <c:pt idx="1674">
                  <c:v>9.8504543304443359</c:v>
                </c:pt>
                <c:pt idx="1675">
                  <c:v>9.8623504638671875</c:v>
                </c:pt>
                <c:pt idx="1676">
                  <c:v>9.8742494583129883</c:v>
                </c:pt>
                <c:pt idx="1677">
                  <c:v>9.8861503601074219</c:v>
                </c:pt>
                <c:pt idx="1678">
                  <c:v>9.8980560302734375</c:v>
                </c:pt>
                <c:pt idx="1679">
                  <c:v>9.9099626541137695</c:v>
                </c:pt>
                <c:pt idx="1680">
                  <c:v>9.9218721389770508</c:v>
                </c:pt>
                <c:pt idx="1681">
                  <c:v>9.9337873458862305</c:v>
                </c:pt>
                <c:pt idx="1682">
                  <c:v>9.9457025527954102</c:v>
                </c:pt>
                <c:pt idx="1683">
                  <c:v>9.9576244354248047</c:v>
                </c:pt>
                <c:pt idx="1684">
                  <c:v>9.9695472717285156</c:v>
                </c:pt>
                <c:pt idx="1685">
                  <c:v>9.9814739227294922</c:v>
                </c:pt>
                <c:pt idx="1686">
                  <c:v>9.9934053421020508</c:v>
                </c:pt>
                <c:pt idx="1687">
                  <c:v>10.005336761474609</c:v>
                </c:pt>
                <c:pt idx="1688">
                  <c:v>10.01727294921875</c:v>
                </c:pt>
                <c:pt idx="1689">
                  <c:v>10.029213905334473</c:v>
                </c:pt>
                <c:pt idx="1690">
                  <c:v>10.041156768798828</c:v>
                </c:pt>
                <c:pt idx="1691">
                  <c:v>10.053104400634766</c:v>
                </c:pt>
                <c:pt idx="1692">
                  <c:v>10.065055847167969</c:v>
                </c:pt>
                <c:pt idx="1693">
                  <c:v>10.077009201049805</c:v>
                </c:pt>
                <c:pt idx="1694">
                  <c:v>10.088964462280273</c:v>
                </c:pt>
                <c:pt idx="1695">
                  <c:v>10.100923538208008</c:v>
                </c:pt>
                <c:pt idx="1696">
                  <c:v>10.112885475158691</c:v>
                </c:pt>
                <c:pt idx="1697">
                  <c:v>10.124851226806641</c:v>
                </c:pt>
                <c:pt idx="1698">
                  <c:v>10.136822700500488</c:v>
                </c:pt>
                <c:pt idx="1699">
                  <c:v>10.14879322052002</c:v>
                </c:pt>
                <c:pt idx="1700">
                  <c:v>10.160767555236816</c:v>
                </c:pt>
                <c:pt idx="1701">
                  <c:v>10.172746658325195</c:v>
                </c:pt>
                <c:pt idx="1702">
                  <c:v>10.184727668762207</c:v>
                </c:pt>
                <c:pt idx="1703">
                  <c:v>10.196713447570801</c:v>
                </c:pt>
                <c:pt idx="1704">
                  <c:v>10.208702087402344</c:v>
                </c:pt>
                <c:pt idx="1705">
                  <c:v>10.220694541931152</c:v>
                </c:pt>
                <c:pt idx="1706">
                  <c:v>10.232688903808594</c:v>
                </c:pt>
                <c:pt idx="1707">
                  <c:v>10.244685173034668</c:v>
                </c:pt>
                <c:pt idx="1708">
                  <c:v>10.256683349609375</c:v>
                </c:pt>
                <c:pt idx="1709">
                  <c:v>10.268683433532715</c:v>
                </c:pt>
                <c:pt idx="1710">
                  <c:v>10.280688285827637</c:v>
                </c:pt>
                <c:pt idx="1711">
                  <c:v>10.292695045471191</c:v>
                </c:pt>
                <c:pt idx="1712">
                  <c:v>10.304704666137695</c:v>
                </c:pt>
                <c:pt idx="1713">
                  <c:v>10.316716194152832</c:v>
                </c:pt>
                <c:pt idx="1714">
                  <c:v>10.328733444213867</c:v>
                </c:pt>
                <c:pt idx="1715">
                  <c:v>10.340750694274902</c:v>
                </c:pt>
                <c:pt idx="1716">
                  <c:v>10.352773666381836</c:v>
                </c:pt>
                <c:pt idx="1717">
                  <c:v>10.364795684814453</c:v>
                </c:pt>
                <c:pt idx="1718">
                  <c:v>10.376822471618652</c:v>
                </c:pt>
                <c:pt idx="1719">
                  <c:v>10.388852119445801</c:v>
                </c:pt>
                <c:pt idx="1720">
                  <c:v>10.400885581970215</c:v>
                </c:pt>
                <c:pt idx="1721">
                  <c:v>10.412917137145996</c:v>
                </c:pt>
                <c:pt idx="1722">
                  <c:v>10.424956321716309</c:v>
                </c:pt>
                <c:pt idx="1723">
                  <c:v>10.436997413635254</c:v>
                </c:pt>
                <c:pt idx="1724">
                  <c:v>10.449042320251465</c:v>
                </c:pt>
                <c:pt idx="1725">
                  <c:v>10.461087226867676</c:v>
                </c:pt>
                <c:pt idx="1726">
                  <c:v>10.473137855529785</c:v>
                </c:pt>
                <c:pt idx="1727">
                  <c:v>10.485189437866211</c:v>
                </c:pt>
                <c:pt idx="1728">
                  <c:v>10.49724292755127</c:v>
                </c:pt>
                <c:pt idx="1729">
                  <c:v>10.509299278259277</c:v>
                </c:pt>
                <c:pt idx="1730">
                  <c:v>10.521357536315918</c:v>
                </c:pt>
                <c:pt idx="1731">
                  <c:v>10.533417701721191</c:v>
                </c:pt>
                <c:pt idx="1732">
                  <c:v>10.545483589172363</c:v>
                </c:pt>
                <c:pt idx="1733">
                  <c:v>10.557552337646484</c:v>
                </c:pt>
                <c:pt idx="1734">
                  <c:v>10.569622993469238</c:v>
                </c:pt>
                <c:pt idx="1735">
                  <c:v>10.581694602966309</c:v>
                </c:pt>
                <c:pt idx="1736">
                  <c:v>10.593772888183594</c:v>
                </c:pt>
                <c:pt idx="1737">
                  <c:v>10.605852127075195</c:v>
                </c:pt>
                <c:pt idx="1738">
                  <c:v>10.617934226989746</c:v>
                </c:pt>
                <c:pt idx="1739">
                  <c:v>10.630019187927246</c:v>
                </c:pt>
                <c:pt idx="1740">
                  <c:v>10.642107009887695</c:v>
                </c:pt>
                <c:pt idx="1741">
                  <c:v>10.654195785522461</c:v>
                </c:pt>
                <c:pt idx="1742">
                  <c:v>10.666288375854492</c:v>
                </c:pt>
                <c:pt idx="1743">
                  <c:v>10.678382873535156</c:v>
                </c:pt>
                <c:pt idx="1744">
                  <c:v>10.690479278564453</c:v>
                </c:pt>
                <c:pt idx="1745">
                  <c:v>10.702579498291016</c:v>
                </c:pt>
                <c:pt idx="1746">
                  <c:v>10.714679718017578</c:v>
                </c:pt>
                <c:pt idx="1747">
                  <c:v>10.726784706115723</c:v>
                </c:pt>
                <c:pt idx="1748">
                  <c:v>10.738889694213867</c:v>
                </c:pt>
                <c:pt idx="1749">
                  <c:v>10.750999450683594</c:v>
                </c:pt>
                <c:pt idx="1750">
                  <c:v>10.763111114501953</c:v>
                </c:pt>
                <c:pt idx="1751">
                  <c:v>10.775225639343262</c:v>
                </c:pt>
                <c:pt idx="1752">
                  <c:v>10.787342071533203</c:v>
                </c:pt>
                <c:pt idx="1753">
                  <c:v>10.79946231842041</c:v>
                </c:pt>
                <c:pt idx="1754">
                  <c:v>10.811583518981934</c:v>
                </c:pt>
                <c:pt idx="1755">
                  <c:v>10.823707580566406</c:v>
                </c:pt>
                <c:pt idx="1756">
                  <c:v>10.835832595825195</c:v>
                </c:pt>
                <c:pt idx="1757">
                  <c:v>10.84796142578125</c:v>
                </c:pt>
                <c:pt idx="1758">
                  <c:v>10.860091209411621</c:v>
                </c:pt>
                <c:pt idx="1759">
                  <c:v>10.872223854064941</c:v>
                </c:pt>
                <c:pt idx="1760">
                  <c:v>10.884359359741211</c:v>
                </c:pt>
                <c:pt idx="1761">
                  <c:v>10.89649486541748</c:v>
                </c:pt>
                <c:pt idx="1762">
                  <c:v>10.908633232116699</c:v>
                </c:pt>
                <c:pt idx="1763">
                  <c:v>10.920774459838867</c:v>
                </c:pt>
                <c:pt idx="1764">
                  <c:v>10.932918548583984</c:v>
                </c:pt>
                <c:pt idx="1765">
                  <c:v>10.945064544677734</c:v>
                </c:pt>
                <c:pt idx="1766">
                  <c:v>10.957211494445801</c:v>
                </c:pt>
                <c:pt idx="1767">
                  <c:v>10.969362258911133</c:v>
                </c:pt>
                <c:pt idx="1768">
                  <c:v>10.981514930725098</c:v>
                </c:pt>
                <c:pt idx="1769">
                  <c:v>10.993670463562012</c:v>
                </c:pt>
                <c:pt idx="1770">
                  <c:v>11.005825996398926</c:v>
                </c:pt>
                <c:pt idx="1771">
                  <c:v>11.017984390258789</c:v>
                </c:pt>
                <c:pt idx="1772">
                  <c:v>11.030145645141602</c:v>
                </c:pt>
                <c:pt idx="1773">
                  <c:v>11.042309761047363</c:v>
                </c:pt>
                <c:pt idx="1774">
                  <c:v>11.054475784301758</c:v>
                </c:pt>
                <c:pt idx="1775">
                  <c:v>11.066642761230469</c:v>
                </c:pt>
                <c:pt idx="1776">
                  <c:v>11.078812599182129</c:v>
                </c:pt>
                <c:pt idx="1777">
                  <c:v>11.090984344482422</c:v>
                </c:pt>
                <c:pt idx="1778">
                  <c:v>11.103158950805664</c:v>
                </c:pt>
                <c:pt idx="1779">
                  <c:v>11.115335464477539</c:v>
                </c:pt>
                <c:pt idx="1780">
                  <c:v>11.12751293182373</c:v>
                </c:pt>
                <c:pt idx="1781">
                  <c:v>11.139693260192871</c:v>
                </c:pt>
                <c:pt idx="1782">
                  <c:v>11.151876449584961</c:v>
                </c:pt>
                <c:pt idx="1783">
                  <c:v>11.164061546325684</c:v>
                </c:pt>
                <c:pt idx="1784">
                  <c:v>11.176248550415039</c:v>
                </c:pt>
                <c:pt idx="1785">
                  <c:v>11.188438415527344</c:v>
                </c:pt>
                <c:pt idx="1786">
                  <c:v>11.200630187988281</c:v>
                </c:pt>
                <c:pt idx="1787">
                  <c:v>11.212823867797852</c:v>
                </c:pt>
                <c:pt idx="1788">
                  <c:v>11.225020408630371</c:v>
                </c:pt>
                <c:pt idx="1789">
                  <c:v>11.237218856811523</c:v>
                </c:pt>
                <c:pt idx="1790">
                  <c:v>11.249418258666992</c:v>
                </c:pt>
                <c:pt idx="1791">
                  <c:v>11.261621475219727</c:v>
                </c:pt>
                <c:pt idx="1792">
                  <c:v>11.273826599121094</c:v>
                </c:pt>
                <c:pt idx="1793">
                  <c:v>11.286033630371094</c:v>
                </c:pt>
                <c:pt idx="1794">
                  <c:v>11.298242568969727</c:v>
                </c:pt>
                <c:pt idx="1795">
                  <c:v>11.310454368591309</c:v>
                </c:pt>
                <c:pt idx="1796">
                  <c:v>11.322668075561523</c:v>
                </c:pt>
                <c:pt idx="1797">
                  <c:v>11.334884643554688</c:v>
                </c:pt>
                <c:pt idx="1798">
                  <c:v>11.347103118896484</c:v>
                </c:pt>
                <c:pt idx="1799">
                  <c:v>11.359323501586914</c:v>
                </c:pt>
                <c:pt idx="1800">
                  <c:v>11.371546745300293</c:v>
                </c:pt>
                <c:pt idx="1801">
                  <c:v>11.383771896362305</c:v>
                </c:pt>
                <c:pt idx="1802">
                  <c:v>11.395998954772949</c:v>
                </c:pt>
                <c:pt idx="1803">
                  <c:v>11.408228874206543</c:v>
                </c:pt>
                <c:pt idx="1804">
                  <c:v>11.42046070098877</c:v>
                </c:pt>
                <c:pt idx="1805">
                  <c:v>11.432695388793945</c:v>
                </c:pt>
                <c:pt idx="1806">
                  <c:v>11.444931983947754</c:v>
                </c:pt>
                <c:pt idx="1807">
                  <c:v>11.457170486450195</c:v>
                </c:pt>
                <c:pt idx="1808">
                  <c:v>11.469411849975586</c:v>
                </c:pt>
                <c:pt idx="1809">
                  <c:v>11.481655120849609</c:v>
                </c:pt>
                <c:pt idx="1810">
                  <c:v>11.493900299072266</c:v>
                </c:pt>
                <c:pt idx="1811">
                  <c:v>11.506148338317871</c:v>
                </c:pt>
                <c:pt idx="1812">
                  <c:v>11.518399238586426</c:v>
                </c:pt>
                <c:pt idx="1813">
                  <c:v>11.530651092529297</c:v>
                </c:pt>
                <c:pt idx="1814">
                  <c:v>11.542906761169434</c:v>
                </c:pt>
                <c:pt idx="1815">
                  <c:v>11.555163383483887</c:v>
                </c:pt>
                <c:pt idx="1816">
                  <c:v>11.567422866821289</c:v>
                </c:pt>
                <c:pt idx="1817">
                  <c:v>11.579685211181641</c:v>
                </c:pt>
                <c:pt idx="1818">
                  <c:v>11.591949462890625</c:v>
                </c:pt>
                <c:pt idx="1819">
                  <c:v>11.604215621948242</c:v>
                </c:pt>
                <c:pt idx="1820">
                  <c:v>11.616484642028809</c:v>
                </c:pt>
                <c:pt idx="1821">
                  <c:v>11.628755569458008</c:v>
                </c:pt>
                <c:pt idx="1822">
                  <c:v>11.641029357910156</c:v>
                </c:pt>
                <c:pt idx="1823">
                  <c:v>11.653306007385254</c:v>
                </c:pt>
                <c:pt idx="1824">
                  <c:v>11.665583610534668</c:v>
                </c:pt>
                <c:pt idx="1825">
                  <c:v>11.677865028381348</c:v>
                </c:pt>
                <c:pt idx="1826">
                  <c:v>11.690147399902344</c:v>
                </c:pt>
                <c:pt idx="1827">
                  <c:v>11.702433586120605</c:v>
                </c:pt>
                <c:pt idx="1828">
                  <c:v>11.714720726013184</c:v>
                </c:pt>
                <c:pt idx="1829">
                  <c:v>11.727010726928711</c:v>
                </c:pt>
                <c:pt idx="1830">
                  <c:v>11.739303588867188</c:v>
                </c:pt>
                <c:pt idx="1831">
                  <c:v>11.751598358154297</c:v>
                </c:pt>
                <c:pt idx="1832">
                  <c:v>11.763895988464355</c:v>
                </c:pt>
                <c:pt idx="1833">
                  <c:v>11.776195526123047</c:v>
                </c:pt>
                <c:pt idx="1834">
                  <c:v>11.788497924804688</c:v>
                </c:pt>
                <c:pt idx="1835">
                  <c:v>11.800803184509277</c:v>
                </c:pt>
                <c:pt idx="1836">
                  <c:v>11.813109397888184</c:v>
                </c:pt>
                <c:pt idx="1837">
                  <c:v>11.825419425964355</c:v>
                </c:pt>
                <c:pt idx="1838">
                  <c:v>11.83773136138916</c:v>
                </c:pt>
                <c:pt idx="1839">
                  <c:v>11.850045204162598</c:v>
                </c:pt>
                <c:pt idx="1840">
                  <c:v>11.862361907958984</c:v>
                </c:pt>
                <c:pt idx="1841">
                  <c:v>11.87468147277832</c:v>
                </c:pt>
                <c:pt idx="1842">
                  <c:v>11.887002944946289</c:v>
                </c:pt>
                <c:pt idx="1843">
                  <c:v>11.899327278137207</c:v>
                </c:pt>
                <c:pt idx="1844">
                  <c:v>11.911653518676758</c:v>
                </c:pt>
                <c:pt idx="1845">
                  <c:v>11.923982620239258</c:v>
                </c:pt>
                <c:pt idx="1846">
                  <c:v>11.936313629150391</c:v>
                </c:pt>
                <c:pt idx="1847">
                  <c:v>11.948647499084473</c:v>
                </c:pt>
                <c:pt idx="1848">
                  <c:v>11.960984230041504</c:v>
                </c:pt>
                <c:pt idx="1849">
                  <c:v>11.973322868347168</c:v>
                </c:pt>
                <c:pt idx="1850">
                  <c:v>11.985664367675781</c:v>
                </c:pt>
                <c:pt idx="1851">
                  <c:v>11.998008728027344</c:v>
                </c:pt>
                <c:pt idx="1852">
                  <c:v>12.010354995727539</c:v>
                </c:pt>
                <c:pt idx="1853">
                  <c:v>12.022703170776367</c:v>
                </c:pt>
                <c:pt idx="1854">
                  <c:v>12.035055160522461</c:v>
                </c:pt>
                <c:pt idx="1855">
                  <c:v>12.047409057617188</c:v>
                </c:pt>
                <c:pt idx="1856">
                  <c:v>12.059764862060547</c:v>
                </c:pt>
                <c:pt idx="1857">
                  <c:v>12.072123527526855</c:v>
                </c:pt>
                <c:pt idx="1858">
                  <c:v>12.084484100341797</c:v>
                </c:pt>
                <c:pt idx="1859">
                  <c:v>12.096847534179688</c:v>
                </c:pt>
                <c:pt idx="1860">
                  <c:v>12.109213829040527</c:v>
                </c:pt>
                <c:pt idx="1861">
                  <c:v>12.12158203125</c:v>
                </c:pt>
                <c:pt idx="1862">
                  <c:v>12.133952140808105</c:v>
                </c:pt>
                <c:pt idx="1863">
                  <c:v>12.14632511138916</c:v>
                </c:pt>
                <c:pt idx="1864">
                  <c:v>12.158700942993164</c:v>
                </c:pt>
                <c:pt idx="1865">
                  <c:v>12.171078681945801</c:v>
                </c:pt>
                <c:pt idx="1866">
                  <c:v>12.18345832824707</c:v>
                </c:pt>
                <c:pt idx="1867">
                  <c:v>12.195840835571289</c:v>
                </c:pt>
                <c:pt idx="1868">
                  <c:v>12.208225250244141</c:v>
                </c:pt>
                <c:pt idx="1869">
                  <c:v>12.220611572265625</c:v>
                </c:pt>
                <c:pt idx="1870">
                  <c:v>12.233000755310059</c:v>
                </c:pt>
                <c:pt idx="1871">
                  <c:v>12.245392799377441</c:v>
                </c:pt>
                <c:pt idx="1872">
                  <c:v>12.257785797119141</c:v>
                </c:pt>
                <c:pt idx="1873">
                  <c:v>12.270181655883789</c:v>
                </c:pt>
                <c:pt idx="1874">
                  <c:v>12.282580375671387</c:v>
                </c:pt>
                <c:pt idx="1875">
                  <c:v>12.294980049133301</c:v>
                </c:pt>
                <c:pt idx="1876">
                  <c:v>12.307382583618164</c:v>
                </c:pt>
                <c:pt idx="1877">
                  <c:v>12.319787979125977</c:v>
                </c:pt>
                <c:pt idx="1878">
                  <c:v>12.332194328308105</c:v>
                </c:pt>
                <c:pt idx="1879">
                  <c:v>12.344603538513184</c:v>
                </c:pt>
                <c:pt idx="1880">
                  <c:v>12.357014656066895</c:v>
                </c:pt>
                <c:pt idx="1881">
                  <c:v>12.369428634643555</c:v>
                </c:pt>
                <c:pt idx="1882">
                  <c:v>12.381843566894531</c:v>
                </c:pt>
                <c:pt idx="1883">
                  <c:v>12.394261360168457</c:v>
                </c:pt>
                <c:pt idx="1884">
                  <c:v>12.406681060791016</c:v>
                </c:pt>
                <c:pt idx="1885">
                  <c:v>12.419102668762207</c:v>
                </c:pt>
                <c:pt idx="1886">
                  <c:v>12.431527137756348</c:v>
                </c:pt>
                <c:pt idx="1887">
                  <c:v>12.443953514099121</c:v>
                </c:pt>
                <c:pt idx="1888">
                  <c:v>12.456380844116211</c:v>
                </c:pt>
                <c:pt idx="1889">
                  <c:v>12.46881103515625</c:v>
                </c:pt>
                <c:pt idx="1890">
                  <c:v>12.481243133544922</c:v>
                </c:pt>
                <c:pt idx="1891">
                  <c:v>12.493678092956543</c:v>
                </c:pt>
                <c:pt idx="1892">
                  <c:v>12.50611400604248</c:v>
                </c:pt>
                <c:pt idx="1893">
                  <c:v>12.518551826477051</c:v>
                </c:pt>
                <c:pt idx="1894">
                  <c:v>12.53099250793457</c:v>
                </c:pt>
                <c:pt idx="1895">
                  <c:v>12.543434143066406</c:v>
                </c:pt>
                <c:pt idx="1896">
                  <c:v>12.555878639221191</c:v>
                </c:pt>
                <c:pt idx="1897">
                  <c:v>12.568325042724609</c:v>
                </c:pt>
                <c:pt idx="1898">
                  <c:v>12.58077335357666</c:v>
                </c:pt>
                <c:pt idx="1899">
                  <c:v>12.593222618103027</c:v>
                </c:pt>
                <c:pt idx="1900">
                  <c:v>12.605674743652344</c:v>
                </c:pt>
                <c:pt idx="1901">
                  <c:v>12.618128776550293</c:v>
                </c:pt>
                <c:pt idx="1902">
                  <c:v>12.630584716796875</c:v>
                </c:pt>
                <c:pt idx="1903">
                  <c:v>12.643041610717773</c:v>
                </c:pt>
                <c:pt idx="1904">
                  <c:v>12.655501365661621</c:v>
                </c:pt>
                <c:pt idx="1905">
                  <c:v>12.667963027954102</c:v>
                </c:pt>
                <c:pt idx="1906">
                  <c:v>12.680425643920898</c:v>
                </c:pt>
                <c:pt idx="1907">
                  <c:v>12.692891120910645</c:v>
                </c:pt>
                <c:pt idx="1908">
                  <c:v>12.705358505249023</c:v>
                </c:pt>
                <c:pt idx="1909">
                  <c:v>12.717826843261719</c:v>
                </c:pt>
                <c:pt idx="1910">
                  <c:v>12.730297088623047</c:v>
                </c:pt>
                <c:pt idx="1911">
                  <c:v>12.742769241333008</c:v>
                </c:pt>
                <c:pt idx="1912">
                  <c:v>12.755243301391602</c:v>
                </c:pt>
                <c:pt idx="1913">
                  <c:v>12.767719268798828</c:v>
                </c:pt>
                <c:pt idx="1914">
                  <c:v>12.780197143554688</c:v>
                </c:pt>
                <c:pt idx="1915">
                  <c:v>12.792675971984863</c:v>
                </c:pt>
                <c:pt idx="1916">
                  <c:v>12.805157661437988</c:v>
                </c:pt>
                <c:pt idx="1917">
                  <c:v>12.81764030456543</c:v>
                </c:pt>
                <c:pt idx="1918">
                  <c:v>12.830124855041504</c:v>
                </c:pt>
                <c:pt idx="1919">
                  <c:v>12.842611312866211</c:v>
                </c:pt>
                <c:pt idx="1920">
                  <c:v>12.855098724365234</c:v>
                </c:pt>
                <c:pt idx="1921">
                  <c:v>12.867588996887207</c:v>
                </c:pt>
                <c:pt idx="1922">
                  <c:v>12.880080223083496</c:v>
                </c:pt>
                <c:pt idx="1923">
                  <c:v>12.892572402954102</c:v>
                </c:pt>
                <c:pt idx="1924">
                  <c:v>12.905067443847656</c:v>
                </c:pt>
                <c:pt idx="1925">
                  <c:v>12.917563438415527</c:v>
                </c:pt>
                <c:pt idx="1926">
                  <c:v>12.930061340332031</c:v>
                </c:pt>
                <c:pt idx="1927">
                  <c:v>12.942560195922852</c:v>
                </c:pt>
                <c:pt idx="1928">
                  <c:v>12.955061912536621</c:v>
                </c:pt>
                <c:pt idx="1929">
                  <c:v>12.967563629150391</c:v>
                </c:pt>
                <c:pt idx="1930">
                  <c:v>12.980068206787109</c:v>
                </c:pt>
                <c:pt idx="1931">
                  <c:v>12.992573738098145</c:v>
                </c:pt>
                <c:pt idx="1932">
                  <c:v>13.005081176757813</c:v>
                </c:pt>
                <c:pt idx="1933">
                  <c:v>13.017589569091797</c:v>
                </c:pt>
                <c:pt idx="1934">
                  <c:v>13.030099868774414</c:v>
                </c:pt>
                <c:pt idx="1935">
                  <c:v>13.042612075805664</c:v>
                </c:pt>
                <c:pt idx="1936">
                  <c:v>13.05512523651123</c:v>
                </c:pt>
                <c:pt idx="1937">
                  <c:v>13.067641258239746</c:v>
                </c:pt>
                <c:pt idx="1938">
                  <c:v>13.080158233642578</c:v>
                </c:pt>
                <c:pt idx="1939">
                  <c:v>13.092676162719727</c:v>
                </c:pt>
                <c:pt idx="1940">
                  <c:v>13.105196952819824</c:v>
                </c:pt>
                <c:pt idx="1941">
                  <c:v>13.117718696594238</c:v>
                </c:pt>
                <c:pt idx="1942">
                  <c:v>13.130242347717285</c:v>
                </c:pt>
                <c:pt idx="1943">
                  <c:v>13.142767906188965</c:v>
                </c:pt>
                <c:pt idx="1944">
                  <c:v>13.155295372009277</c:v>
                </c:pt>
                <c:pt idx="1945">
                  <c:v>13.167824745178223</c:v>
                </c:pt>
                <c:pt idx="1946">
                  <c:v>13.180355072021484</c:v>
                </c:pt>
                <c:pt idx="1947">
                  <c:v>13.192888259887695</c:v>
                </c:pt>
                <c:pt idx="1948">
                  <c:v>13.205423355102539</c:v>
                </c:pt>
                <c:pt idx="1949">
                  <c:v>13.217960357666016</c:v>
                </c:pt>
                <c:pt idx="1950">
                  <c:v>13.230498313903809</c:v>
                </c:pt>
                <c:pt idx="1951">
                  <c:v>13.243039131164551</c:v>
                </c:pt>
                <c:pt idx="1952">
                  <c:v>13.255581855773926</c:v>
                </c:pt>
                <c:pt idx="1953">
                  <c:v>13.268126487731934</c:v>
                </c:pt>
                <c:pt idx="1954">
                  <c:v>13.280673027038574</c:v>
                </c:pt>
                <c:pt idx="1955">
                  <c:v>13.293221473693848</c:v>
                </c:pt>
                <c:pt idx="1956">
                  <c:v>13.305771827697754</c:v>
                </c:pt>
                <c:pt idx="1957">
                  <c:v>13.318324089050293</c:v>
                </c:pt>
                <c:pt idx="1958">
                  <c:v>13.330879211425781</c:v>
                </c:pt>
                <c:pt idx="1959">
                  <c:v>13.343436241149902</c:v>
                </c:pt>
                <c:pt idx="1960">
                  <c:v>13.355996131896973</c:v>
                </c:pt>
                <c:pt idx="1961">
                  <c:v>13.368556976318359</c:v>
                </c:pt>
                <c:pt idx="1962">
                  <c:v>13.381120681762695</c:v>
                </c:pt>
                <c:pt idx="1963">
                  <c:v>13.393686294555664</c:v>
                </c:pt>
                <c:pt idx="1964">
                  <c:v>13.406254768371582</c:v>
                </c:pt>
                <c:pt idx="1965">
                  <c:v>13.418824195861816</c:v>
                </c:pt>
                <c:pt idx="1966">
                  <c:v>13.431396484375</c:v>
                </c:pt>
                <c:pt idx="1967">
                  <c:v>13.443971633911133</c:v>
                </c:pt>
                <c:pt idx="1968">
                  <c:v>13.456548690795898</c:v>
                </c:pt>
                <c:pt idx="1969">
                  <c:v>13.469128608703613</c:v>
                </c:pt>
                <c:pt idx="1970">
                  <c:v>13.481710433959961</c:v>
                </c:pt>
                <c:pt idx="1971">
                  <c:v>13.494295120239258</c:v>
                </c:pt>
                <c:pt idx="1972">
                  <c:v>13.506880760192871</c:v>
                </c:pt>
                <c:pt idx="1973">
                  <c:v>13.51947021484375</c:v>
                </c:pt>
                <c:pt idx="1974">
                  <c:v>13.532061576843262</c:v>
                </c:pt>
                <c:pt idx="1975">
                  <c:v>13.544655799865723</c:v>
                </c:pt>
                <c:pt idx="1976">
                  <c:v>13.557251930236816</c:v>
                </c:pt>
                <c:pt idx="1977">
                  <c:v>13.569850921630859</c:v>
                </c:pt>
                <c:pt idx="1978">
                  <c:v>13.582452774047852</c:v>
                </c:pt>
                <c:pt idx="1979">
                  <c:v>13.595057487487793</c:v>
                </c:pt>
                <c:pt idx="1980">
                  <c:v>13.607664108276367</c:v>
                </c:pt>
                <c:pt idx="1981">
                  <c:v>13.620273590087891</c:v>
                </c:pt>
                <c:pt idx="1982">
                  <c:v>13.632884979248047</c:v>
                </c:pt>
                <c:pt idx="1983">
                  <c:v>13.645501136779785</c:v>
                </c:pt>
                <c:pt idx="1984">
                  <c:v>13.65811824798584</c:v>
                </c:pt>
                <c:pt idx="1985">
                  <c:v>13.670737266540527</c:v>
                </c:pt>
                <c:pt idx="1986">
                  <c:v>13.683361053466797</c:v>
                </c:pt>
                <c:pt idx="1987">
                  <c:v>13.695988655090332</c:v>
                </c:pt>
                <c:pt idx="1988">
                  <c:v>13.708617210388184</c:v>
                </c:pt>
                <c:pt idx="1989">
                  <c:v>13.721249580383301</c:v>
                </c:pt>
                <c:pt idx="1990">
                  <c:v>13.733884811401367</c:v>
                </c:pt>
                <c:pt idx="1991">
                  <c:v>13.746522903442383</c:v>
                </c:pt>
                <c:pt idx="1992">
                  <c:v>13.759161949157715</c:v>
                </c:pt>
                <c:pt idx="1993">
                  <c:v>13.771804809570313</c:v>
                </c:pt>
                <c:pt idx="1994">
                  <c:v>13.784451484680176</c:v>
                </c:pt>
                <c:pt idx="1995">
                  <c:v>13.797100067138672</c:v>
                </c:pt>
                <c:pt idx="1996">
                  <c:v>13.809752464294434</c:v>
                </c:pt>
                <c:pt idx="1997">
                  <c:v>13.822408676147461</c:v>
                </c:pt>
                <c:pt idx="1998">
                  <c:v>13.835065841674805</c:v>
                </c:pt>
                <c:pt idx="1999">
                  <c:v>13.847726821899414</c:v>
                </c:pt>
                <c:pt idx="2000">
                  <c:v>13.860390663146973</c:v>
                </c:pt>
                <c:pt idx="2001">
                  <c:v>13.87305736541748</c:v>
                </c:pt>
                <c:pt idx="2002">
                  <c:v>13.88572883605957</c:v>
                </c:pt>
                <c:pt idx="2003">
                  <c:v>13.898402214050293</c:v>
                </c:pt>
                <c:pt idx="2004">
                  <c:v>13.911078453063965</c:v>
                </c:pt>
                <c:pt idx="2005">
                  <c:v>13.923757553100586</c:v>
                </c:pt>
                <c:pt idx="2006">
                  <c:v>13.936440467834473</c:v>
                </c:pt>
                <c:pt idx="2007">
                  <c:v>13.949128150939941</c:v>
                </c:pt>
                <c:pt idx="2008">
                  <c:v>13.961816787719727</c:v>
                </c:pt>
                <c:pt idx="2009">
                  <c:v>13.974510192871094</c:v>
                </c:pt>
                <c:pt idx="2010">
                  <c:v>13.987205505371094</c:v>
                </c:pt>
                <c:pt idx="2011">
                  <c:v>13.999903678894043</c:v>
                </c:pt>
                <c:pt idx="2012">
                  <c:v>14.012605667114258</c:v>
                </c:pt>
                <c:pt idx="2013">
                  <c:v>14.025311470031738</c:v>
                </c:pt>
                <c:pt idx="2014">
                  <c:v>14.038020133972168</c:v>
                </c:pt>
                <c:pt idx="2015">
                  <c:v>14.050732612609863</c:v>
                </c:pt>
                <c:pt idx="2016">
                  <c:v>14.063448905944824</c:v>
                </c:pt>
                <c:pt idx="2017">
                  <c:v>14.076167106628418</c:v>
                </c:pt>
                <c:pt idx="2018">
                  <c:v>14.088890075683594</c:v>
                </c:pt>
                <c:pt idx="2019">
                  <c:v>14.101615905761719</c:v>
                </c:pt>
                <c:pt idx="2020">
                  <c:v>14.114344596862793</c:v>
                </c:pt>
                <c:pt idx="2021">
                  <c:v>14.127076148986816</c:v>
                </c:pt>
                <c:pt idx="2022">
                  <c:v>14.139810562133789</c:v>
                </c:pt>
                <c:pt idx="2023">
                  <c:v>14.152548789978027</c:v>
                </c:pt>
                <c:pt idx="2024">
                  <c:v>14.165292739868164</c:v>
                </c:pt>
                <c:pt idx="2025">
                  <c:v>14.178038597106934</c:v>
                </c:pt>
                <c:pt idx="2026">
                  <c:v>14.190787315368652</c:v>
                </c:pt>
                <c:pt idx="2027">
                  <c:v>14.203540802001953</c:v>
                </c:pt>
                <c:pt idx="2028">
                  <c:v>14.216296195983887</c:v>
                </c:pt>
                <c:pt idx="2029">
                  <c:v>14.229055404663086</c:v>
                </c:pt>
                <c:pt idx="2030">
                  <c:v>14.241819381713867</c:v>
                </c:pt>
                <c:pt idx="2031">
                  <c:v>14.254586219787598</c:v>
                </c:pt>
                <c:pt idx="2032">
                  <c:v>14.267355918884277</c:v>
                </c:pt>
                <c:pt idx="2033">
                  <c:v>14.280131340026855</c:v>
                </c:pt>
                <c:pt idx="2034">
                  <c:v>14.292910575866699</c:v>
                </c:pt>
                <c:pt idx="2035">
                  <c:v>14.305692672729492</c:v>
                </c:pt>
                <c:pt idx="2036">
                  <c:v>14.318476676940918</c:v>
                </c:pt>
                <c:pt idx="2037">
                  <c:v>14.331265449523926</c:v>
                </c:pt>
                <c:pt idx="2038">
                  <c:v>14.344058036804199</c:v>
                </c:pt>
                <c:pt idx="2039">
                  <c:v>14.356853485107422</c:v>
                </c:pt>
                <c:pt idx="2040">
                  <c:v>14.36965274810791</c:v>
                </c:pt>
                <c:pt idx="2041">
                  <c:v>14.382453918457031</c:v>
                </c:pt>
                <c:pt idx="2042">
                  <c:v>14.395259857177734</c:v>
                </c:pt>
                <c:pt idx="2043">
                  <c:v>14.408068656921387</c:v>
                </c:pt>
                <c:pt idx="2044">
                  <c:v>14.420882225036621</c:v>
                </c:pt>
                <c:pt idx="2045">
                  <c:v>14.433699607849121</c:v>
                </c:pt>
                <c:pt idx="2046">
                  <c:v>14.44651985168457</c:v>
                </c:pt>
                <c:pt idx="2047">
                  <c:v>14.459342956542969</c:v>
                </c:pt>
                <c:pt idx="2048">
                  <c:v>14.472170829772949</c:v>
                </c:pt>
                <c:pt idx="2049">
                  <c:v>14.485000610351563</c:v>
                </c:pt>
                <c:pt idx="2050">
                  <c:v>14.497835159301758</c:v>
                </c:pt>
                <c:pt idx="2051">
                  <c:v>14.510671615600586</c:v>
                </c:pt>
                <c:pt idx="2052">
                  <c:v>14.523512840270996</c:v>
                </c:pt>
                <c:pt idx="2053">
                  <c:v>14.536357879638672</c:v>
                </c:pt>
                <c:pt idx="2054">
                  <c:v>14.549208641052246</c:v>
                </c:pt>
                <c:pt idx="2055">
                  <c:v>14.562060356140137</c:v>
                </c:pt>
                <c:pt idx="2056">
                  <c:v>14.574916839599609</c:v>
                </c:pt>
                <c:pt idx="2057">
                  <c:v>14.587776184082031</c:v>
                </c:pt>
                <c:pt idx="2058">
                  <c:v>14.600640296936035</c:v>
                </c:pt>
                <c:pt idx="2059">
                  <c:v>14.613507270812988</c:v>
                </c:pt>
                <c:pt idx="2060">
                  <c:v>14.626377105712891</c:v>
                </c:pt>
                <c:pt idx="2061">
                  <c:v>14.639247894287109</c:v>
                </c:pt>
                <c:pt idx="2062">
                  <c:v>14.652125358581543</c:v>
                </c:pt>
                <c:pt idx="2063">
                  <c:v>14.665005683898926</c:v>
                </c:pt>
                <c:pt idx="2064">
                  <c:v>14.677888870239258</c:v>
                </c:pt>
                <c:pt idx="2065">
                  <c:v>14.690775871276855</c:v>
                </c:pt>
                <c:pt idx="2066">
                  <c:v>14.703666687011719</c:v>
                </c:pt>
                <c:pt idx="2067">
                  <c:v>14.716562271118164</c:v>
                </c:pt>
                <c:pt idx="2068">
                  <c:v>14.729459762573242</c:v>
                </c:pt>
                <c:pt idx="2069">
                  <c:v>14.742362976074219</c:v>
                </c:pt>
                <c:pt idx="2070">
                  <c:v>14.755269050598145</c:v>
                </c:pt>
                <c:pt idx="2071">
                  <c:v>14.768178939819336</c:v>
                </c:pt>
                <c:pt idx="2072">
                  <c:v>14.78109073638916</c:v>
                </c:pt>
                <c:pt idx="2073">
                  <c:v>14.794008255004883</c:v>
                </c:pt>
                <c:pt idx="2074">
                  <c:v>14.806927680969238</c:v>
                </c:pt>
                <c:pt idx="2075">
                  <c:v>14.819852828979492</c:v>
                </c:pt>
                <c:pt idx="2076">
                  <c:v>14.832782745361328</c:v>
                </c:pt>
                <c:pt idx="2077">
                  <c:v>14.84571361541748</c:v>
                </c:pt>
                <c:pt idx="2078">
                  <c:v>14.858651161193848</c:v>
                </c:pt>
                <c:pt idx="2079">
                  <c:v>14.871590614318848</c:v>
                </c:pt>
                <c:pt idx="2080">
                  <c:v>14.884533882141113</c:v>
                </c:pt>
                <c:pt idx="2081">
                  <c:v>14.897480010986328</c:v>
                </c:pt>
                <c:pt idx="2082">
                  <c:v>14.910430908203125</c:v>
                </c:pt>
                <c:pt idx="2083">
                  <c:v>14.923384666442871</c:v>
                </c:pt>
                <c:pt idx="2084">
                  <c:v>14.936342239379883</c:v>
                </c:pt>
                <c:pt idx="2085">
                  <c:v>14.949305534362793</c:v>
                </c:pt>
                <c:pt idx="2086">
                  <c:v>14.962270736694336</c:v>
                </c:pt>
                <c:pt idx="2087">
                  <c:v>14.975239753723145</c:v>
                </c:pt>
                <c:pt idx="2088">
                  <c:v>14.988214492797852</c:v>
                </c:pt>
                <c:pt idx="2089">
                  <c:v>15.001189231872559</c:v>
                </c:pt>
                <c:pt idx="2090">
                  <c:v>15.014171600341797</c:v>
                </c:pt>
                <c:pt idx="2091">
                  <c:v>15.027156829833984</c:v>
                </c:pt>
                <c:pt idx="2092">
                  <c:v>15.04014778137207</c:v>
                </c:pt>
                <c:pt idx="2093">
                  <c:v>15.053142547607422</c:v>
                </c:pt>
                <c:pt idx="2094">
                  <c:v>15.066139221191406</c:v>
                </c:pt>
                <c:pt idx="2095">
                  <c:v>15.079140663146973</c:v>
                </c:pt>
                <c:pt idx="2096">
                  <c:v>15.092144966125488</c:v>
                </c:pt>
                <c:pt idx="2097">
                  <c:v>15.105152130126953</c:v>
                </c:pt>
                <c:pt idx="2098">
                  <c:v>15.1181640625</c:v>
                </c:pt>
                <c:pt idx="2099">
                  <c:v>15.131181716918945</c:v>
                </c:pt>
                <c:pt idx="2100">
                  <c:v>15.14420223236084</c:v>
                </c:pt>
                <c:pt idx="2101">
                  <c:v>15.157225608825684</c:v>
                </c:pt>
                <c:pt idx="2102">
                  <c:v>15.170254707336426</c:v>
                </c:pt>
                <c:pt idx="2103">
                  <c:v>15.183285713195801</c:v>
                </c:pt>
                <c:pt idx="2104">
                  <c:v>15.196320533752441</c:v>
                </c:pt>
                <c:pt idx="2105">
                  <c:v>15.209359169006348</c:v>
                </c:pt>
                <c:pt idx="2106">
                  <c:v>15.22240161895752</c:v>
                </c:pt>
                <c:pt idx="2107">
                  <c:v>15.235447883605957</c:v>
                </c:pt>
                <c:pt idx="2108">
                  <c:v>15.248497009277344</c:v>
                </c:pt>
                <c:pt idx="2109">
                  <c:v>15.261549949645996</c:v>
                </c:pt>
                <c:pt idx="2110">
                  <c:v>15.27460765838623</c:v>
                </c:pt>
                <c:pt idx="2111">
                  <c:v>15.287670135498047</c:v>
                </c:pt>
                <c:pt idx="2112">
                  <c:v>15.300735473632813</c:v>
                </c:pt>
                <c:pt idx="2113">
                  <c:v>15.31380558013916</c:v>
                </c:pt>
                <c:pt idx="2114">
                  <c:v>15.326876640319824</c:v>
                </c:pt>
                <c:pt idx="2115">
                  <c:v>15.33995246887207</c:v>
                </c:pt>
                <c:pt idx="2116">
                  <c:v>15.353031158447266</c:v>
                </c:pt>
                <c:pt idx="2117">
                  <c:v>15.366114616394043</c:v>
                </c:pt>
                <c:pt idx="2118">
                  <c:v>15.37920093536377</c:v>
                </c:pt>
                <c:pt idx="2119">
                  <c:v>15.392292976379395</c:v>
                </c:pt>
                <c:pt idx="2120">
                  <c:v>15.405385971069336</c:v>
                </c:pt>
                <c:pt idx="2121">
                  <c:v>15.418482780456543</c:v>
                </c:pt>
                <c:pt idx="2122">
                  <c:v>15.431584358215332</c:v>
                </c:pt>
                <c:pt idx="2123">
                  <c:v>15.44468879699707</c:v>
                </c:pt>
                <c:pt idx="2124">
                  <c:v>15.457797050476074</c:v>
                </c:pt>
                <c:pt idx="2125">
                  <c:v>15.470911979675293</c:v>
                </c:pt>
                <c:pt idx="2126">
                  <c:v>15.484025955200195</c:v>
                </c:pt>
                <c:pt idx="2127">
                  <c:v>15.49714469909668</c:v>
                </c:pt>
                <c:pt idx="2128">
                  <c:v>15.510268211364746</c:v>
                </c:pt>
                <c:pt idx="2129">
                  <c:v>15.523396492004395</c:v>
                </c:pt>
                <c:pt idx="2130">
                  <c:v>15.536525726318359</c:v>
                </c:pt>
                <c:pt idx="2131">
                  <c:v>15.549659729003906</c:v>
                </c:pt>
                <c:pt idx="2132">
                  <c:v>15.562797546386719</c:v>
                </c:pt>
                <c:pt idx="2133">
                  <c:v>15.575940132141113</c:v>
                </c:pt>
                <c:pt idx="2134">
                  <c:v>15.589086532592773</c:v>
                </c:pt>
                <c:pt idx="2135">
                  <c:v>15.602236747741699</c:v>
                </c:pt>
                <c:pt idx="2136">
                  <c:v>15.615388870239258</c:v>
                </c:pt>
                <c:pt idx="2137">
                  <c:v>15.628548622131348</c:v>
                </c:pt>
                <c:pt idx="2138">
                  <c:v>15.641707420349121</c:v>
                </c:pt>
                <c:pt idx="2139">
                  <c:v>15.654873847961426</c:v>
                </c:pt>
                <c:pt idx="2140">
                  <c:v>15.668042182922363</c:v>
                </c:pt>
                <c:pt idx="2141">
                  <c:v>15.681215286254883</c:v>
                </c:pt>
                <c:pt idx="2142">
                  <c:v>15.694390296936035</c:v>
                </c:pt>
                <c:pt idx="2143">
                  <c:v>15.707572937011719</c:v>
                </c:pt>
                <c:pt idx="2144">
                  <c:v>15.720755577087402</c:v>
                </c:pt>
                <c:pt idx="2145">
                  <c:v>15.733944892883301</c:v>
                </c:pt>
                <c:pt idx="2146">
                  <c:v>15.747136116027832</c:v>
                </c:pt>
                <c:pt idx="2147">
                  <c:v>15.760332107543945</c:v>
                </c:pt>
                <c:pt idx="2148">
                  <c:v>15.773531913757324</c:v>
                </c:pt>
                <c:pt idx="2149">
                  <c:v>15.786736488342285</c:v>
                </c:pt>
                <c:pt idx="2150">
                  <c:v>15.799942970275879</c:v>
                </c:pt>
                <c:pt idx="2151">
                  <c:v>15.813156127929688</c:v>
                </c:pt>
                <c:pt idx="2152">
                  <c:v>15.826373100280762</c:v>
                </c:pt>
                <c:pt idx="2153">
                  <c:v>15.839592933654785</c:v>
                </c:pt>
                <c:pt idx="2154">
                  <c:v>15.852813720703125</c:v>
                </c:pt>
                <c:pt idx="2155">
                  <c:v>15.866043090820313</c:v>
                </c:pt>
                <c:pt idx="2156">
                  <c:v>15.8792724609375</c:v>
                </c:pt>
                <c:pt idx="2157">
                  <c:v>15.892507553100586</c:v>
                </c:pt>
                <c:pt idx="2158">
                  <c:v>15.905741691589355</c:v>
                </c:pt>
                <c:pt idx="2159">
                  <c:v>15.918983459472656</c:v>
                </c:pt>
                <c:pt idx="2160">
                  <c:v>15.932226181030273</c:v>
                </c:pt>
                <c:pt idx="2161">
                  <c:v>15.945475578308105</c:v>
                </c:pt>
                <c:pt idx="2162">
                  <c:v>15.958724975585938</c:v>
                </c:pt>
                <c:pt idx="2163">
                  <c:v>15.971982002258301</c:v>
                </c:pt>
                <c:pt idx="2164">
                  <c:v>15.985238075256348</c:v>
                </c:pt>
                <c:pt idx="2165">
                  <c:v>15.998498916625977</c:v>
                </c:pt>
                <c:pt idx="2166">
                  <c:v>16.01207160949707</c:v>
                </c:pt>
                <c:pt idx="2167">
                  <c:v>16.025651931762695</c:v>
                </c:pt>
                <c:pt idx="2168">
                  <c:v>16.039230346679688</c:v>
                </c:pt>
                <c:pt idx="2169">
                  <c:v>16.052816390991211</c:v>
                </c:pt>
                <c:pt idx="2170">
                  <c:v>16.066402435302734</c:v>
                </c:pt>
                <c:pt idx="2171">
                  <c:v>16.079996109008789</c:v>
                </c:pt>
                <c:pt idx="2172">
                  <c:v>16.093587875366211</c:v>
                </c:pt>
                <c:pt idx="2173">
                  <c:v>16.107187271118164</c:v>
                </c:pt>
                <c:pt idx="2174">
                  <c:v>16.120786666870117</c:v>
                </c:pt>
                <c:pt idx="2175">
                  <c:v>16.134391784667969</c:v>
                </c:pt>
                <c:pt idx="2176">
                  <c:v>16.148000717163086</c:v>
                </c:pt>
                <c:pt idx="2177">
                  <c:v>16.161613464355469</c:v>
                </c:pt>
                <c:pt idx="2178">
                  <c:v>16.175228118896484</c:v>
                </c:pt>
                <c:pt idx="2179">
                  <c:v>16.188850402832031</c:v>
                </c:pt>
                <c:pt idx="2180">
                  <c:v>16.202472686767578</c:v>
                </c:pt>
                <c:pt idx="2181">
                  <c:v>16.216100692749023</c:v>
                </c:pt>
                <c:pt idx="2182">
                  <c:v>16.229732513427734</c:v>
                </c:pt>
                <c:pt idx="2183">
                  <c:v>16.243371963500977</c:v>
                </c:pt>
                <c:pt idx="2184">
                  <c:v>16.257009506225586</c:v>
                </c:pt>
                <c:pt idx="2185">
                  <c:v>16.270654678344727</c:v>
                </c:pt>
                <c:pt idx="2186">
                  <c:v>16.284299850463867</c:v>
                </c:pt>
                <c:pt idx="2187">
                  <c:v>16.297954559326172</c:v>
                </c:pt>
                <c:pt idx="2188">
                  <c:v>16.311607360839844</c:v>
                </c:pt>
                <c:pt idx="2189">
                  <c:v>16.325265884399414</c:v>
                </c:pt>
                <c:pt idx="2190">
                  <c:v>16.33892822265625</c:v>
                </c:pt>
                <c:pt idx="2191">
                  <c:v>16.352594375610352</c:v>
                </c:pt>
                <c:pt idx="2192">
                  <c:v>16.366262435913086</c:v>
                </c:pt>
                <c:pt idx="2193">
                  <c:v>16.379936218261719</c:v>
                </c:pt>
                <c:pt idx="2194">
                  <c:v>16.393613815307617</c:v>
                </c:pt>
                <c:pt idx="2195">
                  <c:v>16.407295227050781</c:v>
                </c:pt>
                <c:pt idx="2196">
                  <c:v>16.420980453491211</c:v>
                </c:pt>
                <c:pt idx="2197">
                  <c:v>16.434671401977539</c:v>
                </c:pt>
                <c:pt idx="2198">
                  <c:v>16.448362350463867</c:v>
                </c:pt>
                <c:pt idx="2199">
                  <c:v>16.462060928344727</c:v>
                </c:pt>
                <c:pt idx="2200">
                  <c:v>16.475761413574219</c:v>
                </c:pt>
                <c:pt idx="2201">
                  <c:v>16.489465713500977</c:v>
                </c:pt>
                <c:pt idx="2202">
                  <c:v>16.503173828125</c:v>
                </c:pt>
                <c:pt idx="2203">
                  <c:v>16.516887664794922</c:v>
                </c:pt>
                <c:pt idx="2204">
                  <c:v>16.530599594116211</c:v>
                </c:pt>
                <c:pt idx="2205">
                  <c:v>16.544321060180664</c:v>
                </c:pt>
                <c:pt idx="2206">
                  <c:v>16.558042526245117</c:v>
                </c:pt>
                <c:pt idx="2207">
                  <c:v>16.571769714355469</c:v>
                </c:pt>
                <c:pt idx="2208">
                  <c:v>16.585498809814453</c:v>
                </c:pt>
                <c:pt idx="2209">
                  <c:v>16.599231719970703</c:v>
                </c:pt>
                <c:pt idx="2210">
                  <c:v>16.612966537475586</c:v>
                </c:pt>
                <c:pt idx="2211">
                  <c:v>16.626710891723633</c:v>
                </c:pt>
                <c:pt idx="2212">
                  <c:v>16.640453338623047</c:v>
                </c:pt>
                <c:pt idx="2213">
                  <c:v>16.654201507568359</c:v>
                </c:pt>
                <c:pt idx="2214">
                  <c:v>16.667951583862305</c:v>
                </c:pt>
                <c:pt idx="2215">
                  <c:v>16.681707382202148</c:v>
                </c:pt>
                <c:pt idx="2216">
                  <c:v>16.695465087890625</c:v>
                </c:pt>
                <c:pt idx="2217">
                  <c:v>16.709226608276367</c:v>
                </c:pt>
                <c:pt idx="2218">
                  <c:v>16.722991943359375</c:v>
                </c:pt>
                <c:pt idx="2219">
                  <c:v>16.736761093139648</c:v>
                </c:pt>
                <c:pt idx="2220">
                  <c:v>16.750532150268555</c:v>
                </c:pt>
                <c:pt idx="2221">
                  <c:v>16.764308929443359</c:v>
                </c:pt>
                <c:pt idx="2222">
                  <c:v>16.778087615966797</c:v>
                </c:pt>
                <c:pt idx="2223">
                  <c:v>16.7918701171875</c:v>
                </c:pt>
                <c:pt idx="2224">
                  <c:v>16.805658340454102</c:v>
                </c:pt>
                <c:pt idx="2225">
                  <c:v>16.819450378417969</c:v>
                </c:pt>
                <c:pt idx="2226">
                  <c:v>16.833244323730469</c:v>
                </c:pt>
                <c:pt idx="2227">
                  <c:v>16.847043991088867</c:v>
                </c:pt>
                <c:pt idx="2228">
                  <c:v>16.860845565795898</c:v>
                </c:pt>
                <c:pt idx="2229">
                  <c:v>16.874652862548828</c:v>
                </c:pt>
                <c:pt idx="2230">
                  <c:v>16.888463973999023</c:v>
                </c:pt>
                <c:pt idx="2231">
                  <c:v>16.902278900146484</c:v>
                </c:pt>
                <c:pt idx="2232">
                  <c:v>16.916095733642578</c:v>
                </c:pt>
                <c:pt idx="2233">
                  <c:v>16.92991828918457</c:v>
                </c:pt>
                <c:pt idx="2234">
                  <c:v>16.943744659423828</c:v>
                </c:pt>
                <c:pt idx="2235">
                  <c:v>16.957574844360352</c:v>
                </c:pt>
                <c:pt idx="2236">
                  <c:v>16.971408843994141</c:v>
                </c:pt>
                <c:pt idx="2237">
                  <c:v>16.985246658325195</c:v>
                </c:pt>
                <c:pt idx="2238">
                  <c:v>16.999088287353516</c:v>
                </c:pt>
                <c:pt idx="2239">
                  <c:v>17.012933731079102</c:v>
                </c:pt>
                <c:pt idx="2240">
                  <c:v>17.02678108215332</c:v>
                </c:pt>
                <c:pt idx="2241">
                  <c:v>17.040634155273438</c:v>
                </c:pt>
                <c:pt idx="2242">
                  <c:v>17.054489135742188</c:v>
                </c:pt>
                <c:pt idx="2243">
                  <c:v>17.06834602355957</c:v>
                </c:pt>
                <c:pt idx="2244">
                  <c:v>17.082206726074219</c:v>
                </c:pt>
                <c:pt idx="2245">
                  <c:v>17.096073150634766</c:v>
                </c:pt>
                <c:pt idx="2246">
                  <c:v>17.109943389892578</c:v>
                </c:pt>
                <c:pt idx="2247">
                  <c:v>17.123817443847656</c:v>
                </c:pt>
                <c:pt idx="2248">
                  <c:v>17.1376953125</c:v>
                </c:pt>
                <c:pt idx="2249">
                  <c:v>17.151576995849609</c:v>
                </c:pt>
                <c:pt idx="2250">
                  <c:v>17.165460586547852</c:v>
                </c:pt>
                <c:pt idx="2251">
                  <c:v>17.179347991943359</c:v>
                </c:pt>
                <c:pt idx="2252">
                  <c:v>17.193241119384766</c:v>
                </c:pt>
                <c:pt idx="2253">
                  <c:v>17.207136154174805</c:v>
                </c:pt>
                <c:pt idx="2254">
                  <c:v>17.221036911010742</c:v>
                </c:pt>
                <c:pt idx="2255">
                  <c:v>17.23493766784668</c:v>
                </c:pt>
                <c:pt idx="2256">
                  <c:v>17.248844146728516</c:v>
                </c:pt>
                <c:pt idx="2257">
                  <c:v>17.262754440307617</c:v>
                </c:pt>
                <c:pt idx="2258">
                  <c:v>17.276666641235352</c:v>
                </c:pt>
                <c:pt idx="2259">
                  <c:v>17.290584564208984</c:v>
                </c:pt>
                <c:pt idx="2260">
                  <c:v>17.304506301879883</c:v>
                </c:pt>
                <c:pt idx="2261">
                  <c:v>17.318429946899414</c:v>
                </c:pt>
                <c:pt idx="2262">
                  <c:v>17.332355499267578</c:v>
                </c:pt>
                <c:pt idx="2263">
                  <c:v>17.346286773681641</c:v>
                </c:pt>
                <c:pt idx="2264">
                  <c:v>17.360219955444336</c:v>
                </c:pt>
                <c:pt idx="2265">
                  <c:v>17.374156951904297</c:v>
                </c:pt>
                <c:pt idx="2266">
                  <c:v>17.388097763061523</c:v>
                </c:pt>
                <c:pt idx="2267">
                  <c:v>17.402042388916016</c:v>
                </c:pt>
                <c:pt idx="2268">
                  <c:v>17.415992736816406</c:v>
                </c:pt>
                <c:pt idx="2269">
                  <c:v>17.42994499206543</c:v>
                </c:pt>
                <c:pt idx="2270">
                  <c:v>17.443901062011719</c:v>
                </c:pt>
                <c:pt idx="2271">
                  <c:v>17.457860946655273</c:v>
                </c:pt>
                <c:pt idx="2272">
                  <c:v>17.471824645996094</c:v>
                </c:pt>
                <c:pt idx="2273">
                  <c:v>17.485790252685547</c:v>
                </c:pt>
                <c:pt idx="2274">
                  <c:v>17.499759674072266</c:v>
                </c:pt>
                <c:pt idx="2275">
                  <c:v>17.51373291015625</c:v>
                </c:pt>
                <c:pt idx="2276">
                  <c:v>17.527711868286133</c:v>
                </c:pt>
                <c:pt idx="2277">
                  <c:v>17.541690826416016</c:v>
                </c:pt>
                <c:pt idx="2278">
                  <c:v>17.555673599243164</c:v>
                </c:pt>
                <c:pt idx="2279">
                  <c:v>17.569660186767578</c:v>
                </c:pt>
                <c:pt idx="2280">
                  <c:v>17.583652496337891</c:v>
                </c:pt>
                <c:pt idx="2281">
                  <c:v>17.597646713256836</c:v>
                </c:pt>
                <c:pt idx="2282">
                  <c:v>17.61164665222168</c:v>
                </c:pt>
                <c:pt idx="2283">
                  <c:v>17.625644683837891</c:v>
                </c:pt>
                <c:pt idx="2284">
                  <c:v>17.639650344848633</c:v>
                </c:pt>
                <c:pt idx="2285">
                  <c:v>17.653661727905273</c:v>
                </c:pt>
                <c:pt idx="2286">
                  <c:v>17.667675018310547</c:v>
                </c:pt>
                <c:pt idx="2287">
                  <c:v>17.681692123413086</c:v>
                </c:pt>
                <c:pt idx="2288">
                  <c:v>17.695711135864258</c:v>
                </c:pt>
                <c:pt idx="2289">
                  <c:v>17.709735870361328</c:v>
                </c:pt>
                <c:pt idx="2290">
                  <c:v>17.723764419555664</c:v>
                </c:pt>
                <c:pt idx="2291">
                  <c:v>17.737794876098633</c:v>
                </c:pt>
                <c:pt idx="2292">
                  <c:v>17.7518310546875</c:v>
                </c:pt>
                <c:pt idx="2293">
                  <c:v>17.765869140625</c:v>
                </c:pt>
                <c:pt idx="2294">
                  <c:v>17.779912948608398</c:v>
                </c:pt>
                <c:pt idx="2295">
                  <c:v>17.793956756591797</c:v>
                </c:pt>
                <c:pt idx="2296">
                  <c:v>17.808006286621094</c:v>
                </c:pt>
                <c:pt idx="2297">
                  <c:v>17.822059631347656</c:v>
                </c:pt>
                <c:pt idx="2298">
                  <c:v>17.836114883422852</c:v>
                </c:pt>
                <c:pt idx="2299">
                  <c:v>17.850175857543945</c:v>
                </c:pt>
                <c:pt idx="2300">
                  <c:v>17.864238739013672</c:v>
                </c:pt>
                <c:pt idx="2301">
                  <c:v>17.878303527832031</c:v>
                </c:pt>
                <c:pt idx="2302">
                  <c:v>17.892374038696289</c:v>
                </c:pt>
                <c:pt idx="2303">
                  <c:v>17.906448364257813</c:v>
                </c:pt>
                <c:pt idx="2304">
                  <c:v>17.920526504516602</c:v>
                </c:pt>
                <c:pt idx="2305">
                  <c:v>17.934606552124023</c:v>
                </c:pt>
                <c:pt idx="2306">
                  <c:v>17.948690414428711</c:v>
                </c:pt>
                <c:pt idx="2307">
                  <c:v>17.962779998779297</c:v>
                </c:pt>
                <c:pt idx="2308">
                  <c:v>17.976871490478516</c:v>
                </c:pt>
                <c:pt idx="2309">
                  <c:v>17.990964889526367</c:v>
                </c:pt>
                <c:pt idx="2310">
                  <c:v>18.005064010620117</c:v>
                </c:pt>
                <c:pt idx="2311">
                  <c:v>18.0191650390625</c:v>
                </c:pt>
                <c:pt idx="2312">
                  <c:v>18.033269882202148</c:v>
                </c:pt>
                <c:pt idx="2313">
                  <c:v>18.047378540039063</c:v>
                </c:pt>
                <c:pt idx="2314">
                  <c:v>18.061491012573242</c:v>
                </c:pt>
                <c:pt idx="2315">
                  <c:v>18.075605392456055</c:v>
                </c:pt>
                <c:pt idx="2316">
                  <c:v>18.089725494384766</c:v>
                </c:pt>
                <c:pt idx="2317">
                  <c:v>18.103847503662109</c:v>
                </c:pt>
                <c:pt idx="2318">
                  <c:v>18.117975234985352</c:v>
                </c:pt>
                <c:pt idx="2319">
                  <c:v>18.132104873657227</c:v>
                </c:pt>
                <c:pt idx="2320">
                  <c:v>18.146238327026367</c:v>
                </c:pt>
                <c:pt idx="2321">
                  <c:v>18.160375595092773</c:v>
                </c:pt>
                <c:pt idx="2322">
                  <c:v>18.174514770507813</c:v>
                </c:pt>
                <c:pt idx="2323">
                  <c:v>18.18865966796875</c:v>
                </c:pt>
                <c:pt idx="2324">
                  <c:v>18.20280647277832</c:v>
                </c:pt>
                <c:pt idx="2325">
                  <c:v>18.216958999633789</c:v>
                </c:pt>
                <c:pt idx="2326">
                  <c:v>18.231113433837891</c:v>
                </c:pt>
                <c:pt idx="2327">
                  <c:v>18.245271682739258</c:v>
                </c:pt>
                <c:pt idx="2328">
                  <c:v>18.259431838989258</c:v>
                </c:pt>
                <c:pt idx="2329">
                  <c:v>18.273597717285156</c:v>
                </c:pt>
                <c:pt idx="2330">
                  <c:v>18.28776741027832</c:v>
                </c:pt>
                <c:pt idx="2331">
                  <c:v>18.301939010620117</c:v>
                </c:pt>
                <c:pt idx="2332">
                  <c:v>18.31611442565918</c:v>
                </c:pt>
                <c:pt idx="2333">
                  <c:v>18.330291748046875</c:v>
                </c:pt>
                <c:pt idx="2334">
                  <c:v>18.344474792480469</c:v>
                </c:pt>
                <c:pt idx="2335">
                  <c:v>18.358659744262695</c:v>
                </c:pt>
                <c:pt idx="2336">
                  <c:v>18.37285041809082</c:v>
                </c:pt>
                <c:pt idx="2337">
                  <c:v>18.387042999267578</c:v>
                </c:pt>
                <c:pt idx="2338">
                  <c:v>18.401239395141602</c:v>
                </c:pt>
                <c:pt idx="2339">
                  <c:v>18.415439605712891</c:v>
                </c:pt>
                <c:pt idx="2340">
                  <c:v>18.429641723632813</c:v>
                </c:pt>
                <c:pt idx="2341">
                  <c:v>18.443849563598633</c:v>
                </c:pt>
                <c:pt idx="2342">
                  <c:v>18.458059310913086</c:v>
                </c:pt>
                <c:pt idx="2343">
                  <c:v>18.472274780273438</c:v>
                </c:pt>
                <c:pt idx="2344">
                  <c:v>18.486492156982422</c:v>
                </c:pt>
                <c:pt idx="2345">
                  <c:v>18.500713348388672</c:v>
                </c:pt>
                <c:pt idx="2346">
                  <c:v>18.514938354492188</c:v>
                </c:pt>
                <c:pt idx="2347">
                  <c:v>18.529165267944336</c:v>
                </c:pt>
                <c:pt idx="2348">
                  <c:v>18.543397903442383</c:v>
                </c:pt>
                <c:pt idx="2349">
                  <c:v>18.557632446289063</c:v>
                </c:pt>
                <c:pt idx="2350">
                  <c:v>18.571870803833008</c:v>
                </c:pt>
                <c:pt idx="2351">
                  <c:v>18.586112976074219</c:v>
                </c:pt>
                <c:pt idx="2352">
                  <c:v>18.600358963012695</c:v>
                </c:pt>
                <c:pt idx="2353">
                  <c:v>18.614606857299805</c:v>
                </c:pt>
                <c:pt idx="2354">
                  <c:v>18.628860473632813</c:v>
                </c:pt>
                <c:pt idx="2355">
                  <c:v>18.643115997314453</c:v>
                </c:pt>
                <c:pt idx="2356">
                  <c:v>18.657375335693359</c:v>
                </c:pt>
                <c:pt idx="2357">
                  <c:v>18.671638488769531</c:v>
                </c:pt>
                <c:pt idx="2358">
                  <c:v>18.685905456542969</c:v>
                </c:pt>
                <c:pt idx="2359">
                  <c:v>18.700176239013672</c:v>
                </c:pt>
                <c:pt idx="2360">
                  <c:v>18.714448928833008</c:v>
                </c:pt>
                <c:pt idx="2361">
                  <c:v>18.728725433349609</c:v>
                </c:pt>
                <c:pt idx="2362">
                  <c:v>18.743005752563477</c:v>
                </c:pt>
                <c:pt idx="2363">
                  <c:v>18.757289886474609</c:v>
                </c:pt>
                <c:pt idx="2364">
                  <c:v>18.771577835083008</c:v>
                </c:pt>
                <c:pt idx="2365">
                  <c:v>18.785869598388672</c:v>
                </c:pt>
                <c:pt idx="2366">
                  <c:v>18.800163269042969</c:v>
                </c:pt>
                <c:pt idx="2367">
                  <c:v>18.814460754394531</c:v>
                </c:pt>
                <c:pt idx="2368">
                  <c:v>18.828762054443359</c:v>
                </c:pt>
                <c:pt idx="2369">
                  <c:v>18.843067169189453</c:v>
                </c:pt>
                <c:pt idx="2370">
                  <c:v>18.857376098632813</c:v>
                </c:pt>
                <c:pt idx="2371">
                  <c:v>18.871688842773438</c:v>
                </c:pt>
                <c:pt idx="2372">
                  <c:v>18.886003494262695</c:v>
                </c:pt>
                <c:pt idx="2373">
                  <c:v>18.900321960449219</c:v>
                </c:pt>
                <c:pt idx="2374">
                  <c:v>18.914646148681641</c:v>
                </c:pt>
                <c:pt idx="2375">
                  <c:v>18.928970336914063</c:v>
                </c:pt>
                <c:pt idx="2376">
                  <c:v>18.943300247192383</c:v>
                </c:pt>
                <c:pt idx="2377">
                  <c:v>18.957633972167969</c:v>
                </c:pt>
                <c:pt idx="2378">
                  <c:v>18.971969604492188</c:v>
                </c:pt>
                <c:pt idx="2379">
                  <c:v>18.986309051513672</c:v>
                </c:pt>
                <c:pt idx="2380">
                  <c:v>19.000652313232422</c:v>
                </c:pt>
                <c:pt idx="2381">
                  <c:v>19.014999389648438</c:v>
                </c:pt>
                <c:pt idx="2382">
                  <c:v>19.029350280761719</c:v>
                </c:pt>
                <c:pt idx="2383">
                  <c:v>19.043704986572266</c:v>
                </c:pt>
                <c:pt idx="2384">
                  <c:v>19.058061599731445</c:v>
                </c:pt>
                <c:pt idx="2385">
                  <c:v>19.072422027587891</c:v>
                </c:pt>
                <c:pt idx="2386">
                  <c:v>19.086786270141602</c:v>
                </c:pt>
                <c:pt idx="2387">
                  <c:v>19.101154327392578</c:v>
                </c:pt>
                <c:pt idx="2388">
                  <c:v>19.11552619934082</c:v>
                </c:pt>
                <c:pt idx="2389">
                  <c:v>19.129899978637695</c:v>
                </c:pt>
                <c:pt idx="2390">
                  <c:v>19.144279479980469</c:v>
                </c:pt>
                <c:pt idx="2391">
                  <c:v>19.158660888671875</c:v>
                </c:pt>
                <c:pt idx="2392">
                  <c:v>19.173046112060547</c:v>
                </c:pt>
                <c:pt idx="2393">
                  <c:v>19.187435150146484</c:v>
                </c:pt>
                <c:pt idx="2394">
                  <c:v>19.201828002929688</c:v>
                </c:pt>
                <c:pt idx="2395">
                  <c:v>19.216224670410156</c:v>
                </c:pt>
                <c:pt idx="2396">
                  <c:v>19.230623245239258</c:v>
                </c:pt>
                <c:pt idx="2397">
                  <c:v>19.245025634765625</c:v>
                </c:pt>
                <c:pt idx="2398">
                  <c:v>19.259431838989258</c:v>
                </c:pt>
                <c:pt idx="2399">
                  <c:v>19.273841857910156</c:v>
                </c:pt>
                <c:pt idx="2400">
                  <c:v>19.28825569152832</c:v>
                </c:pt>
                <c:pt idx="2401">
                  <c:v>19.302671432495117</c:v>
                </c:pt>
                <c:pt idx="2402">
                  <c:v>19.317092895507813</c:v>
                </c:pt>
                <c:pt idx="2403">
                  <c:v>19.331516265869141</c:v>
                </c:pt>
                <c:pt idx="2404">
                  <c:v>19.345943450927734</c:v>
                </c:pt>
                <c:pt idx="2405">
                  <c:v>19.360374450683594</c:v>
                </c:pt>
                <c:pt idx="2406">
                  <c:v>19.374807357788086</c:v>
                </c:pt>
                <c:pt idx="2407">
                  <c:v>19.389245986938477</c:v>
                </c:pt>
                <c:pt idx="2408">
                  <c:v>19.4036865234375</c:v>
                </c:pt>
                <c:pt idx="2409">
                  <c:v>19.418130874633789</c:v>
                </c:pt>
                <c:pt idx="2410">
                  <c:v>19.432579040527344</c:v>
                </c:pt>
                <c:pt idx="2411">
                  <c:v>19.447031021118164</c:v>
                </c:pt>
                <c:pt idx="2412">
                  <c:v>19.46148681640625</c:v>
                </c:pt>
                <c:pt idx="2413">
                  <c:v>19.475944519042969</c:v>
                </c:pt>
                <c:pt idx="2414">
                  <c:v>19.490407943725586</c:v>
                </c:pt>
                <c:pt idx="2415">
                  <c:v>19.504873275756836</c:v>
                </c:pt>
                <c:pt idx="2416">
                  <c:v>19.519342422485352</c:v>
                </c:pt>
                <c:pt idx="2417">
                  <c:v>19.533815383911133</c:v>
                </c:pt>
                <c:pt idx="2418">
                  <c:v>19.548290252685547</c:v>
                </c:pt>
                <c:pt idx="2419">
                  <c:v>19.562770843505859</c:v>
                </c:pt>
                <c:pt idx="2420">
                  <c:v>19.577253341674805</c:v>
                </c:pt>
                <c:pt idx="2421">
                  <c:v>19.591739654541016</c:v>
                </c:pt>
                <c:pt idx="2422">
                  <c:v>19.606229782104492</c:v>
                </c:pt>
                <c:pt idx="2423">
                  <c:v>19.620723724365234</c:v>
                </c:pt>
                <c:pt idx="2424">
                  <c:v>19.635221481323242</c:v>
                </c:pt>
                <c:pt idx="2425">
                  <c:v>19.649721145629883</c:v>
                </c:pt>
                <c:pt idx="2426">
                  <c:v>19.664224624633789</c:v>
                </c:pt>
                <c:pt idx="2427">
                  <c:v>19.678731918334961</c:v>
                </c:pt>
                <c:pt idx="2428">
                  <c:v>19.693243026733398</c:v>
                </c:pt>
                <c:pt idx="2429">
                  <c:v>19.707757949829102</c:v>
                </c:pt>
                <c:pt idx="2430">
                  <c:v>19.72227668762207</c:v>
                </c:pt>
                <c:pt idx="2431">
                  <c:v>19.736797332763672</c:v>
                </c:pt>
                <c:pt idx="2432">
                  <c:v>19.751321792602539</c:v>
                </c:pt>
                <c:pt idx="2433">
                  <c:v>19.765850067138672</c:v>
                </c:pt>
                <c:pt idx="2434">
                  <c:v>19.78038215637207</c:v>
                </c:pt>
                <c:pt idx="2435">
                  <c:v>19.794918060302734</c:v>
                </c:pt>
                <c:pt idx="2436">
                  <c:v>19.809455871582031</c:v>
                </c:pt>
                <c:pt idx="2437">
                  <c:v>19.823999404907227</c:v>
                </c:pt>
                <c:pt idx="2438">
                  <c:v>19.838544845581055</c:v>
                </c:pt>
                <c:pt idx="2439">
                  <c:v>19.853094100952148</c:v>
                </c:pt>
                <c:pt idx="2440">
                  <c:v>19.867647171020508</c:v>
                </c:pt>
                <c:pt idx="2441">
                  <c:v>19.882204055786133</c:v>
                </c:pt>
                <c:pt idx="2442">
                  <c:v>19.896764755249023</c:v>
                </c:pt>
                <c:pt idx="2443">
                  <c:v>19.911327362060547</c:v>
                </c:pt>
                <c:pt idx="2444">
                  <c:v>19.925893783569336</c:v>
                </c:pt>
                <c:pt idx="2445">
                  <c:v>19.940464019775391</c:v>
                </c:pt>
                <c:pt idx="2446">
                  <c:v>19.955038070678711</c:v>
                </c:pt>
                <c:pt idx="2447">
                  <c:v>19.969615936279297</c:v>
                </c:pt>
                <c:pt idx="2448">
                  <c:v>19.984197616577148</c:v>
                </c:pt>
                <c:pt idx="2449">
                  <c:v>19.998781204223633</c:v>
                </c:pt>
                <c:pt idx="2450">
                  <c:v>20.013370513916016</c:v>
                </c:pt>
                <c:pt idx="2451">
                  <c:v>20.027961730957031</c:v>
                </c:pt>
                <c:pt idx="2452">
                  <c:v>20.042556762695313</c:v>
                </c:pt>
                <c:pt idx="2453">
                  <c:v>20.057155609130859</c:v>
                </c:pt>
                <c:pt idx="2454">
                  <c:v>20.071758270263672</c:v>
                </c:pt>
                <c:pt idx="2455">
                  <c:v>20.086362838745117</c:v>
                </c:pt>
                <c:pt idx="2456">
                  <c:v>20.100971221923828</c:v>
                </c:pt>
                <c:pt idx="2457">
                  <c:v>20.115583419799805</c:v>
                </c:pt>
                <c:pt idx="2458">
                  <c:v>20.130199432373047</c:v>
                </c:pt>
                <c:pt idx="2459">
                  <c:v>20.144819259643555</c:v>
                </c:pt>
                <c:pt idx="2460">
                  <c:v>20.159442901611328</c:v>
                </c:pt>
                <c:pt idx="2461">
                  <c:v>20.174068450927734</c:v>
                </c:pt>
                <c:pt idx="2462">
                  <c:v>20.188699722290039</c:v>
                </c:pt>
                <c:pt idx="2463">
                  <c:v>20.203330993652344</c:v>
                </c:pt>
                <c:pt idx="2464">
                  <c:v>20.217967987060547</c:v>
                </c:pt>
                <c:pt idx="2465">
                  <c:v>20.232608795166016</c:v>
                </c:pt>
                <c:pt idx="2466">
                  <c:v>20.24725341796875</c:v>
                </c:pt>
                <c:pt idx="2467">
                  <c:v>20.261899948120117</c:v>
                </c:pt>
                <c:pt idx="2468">
                  <c:v>20.27655029296875</c:v>
                </c:pt>
                <c:pt idx="2469">
                  <c:v>20.291204452514648</c:v>
                </c:pt>
                <c:pt idx="2470">
                  <c:v>20.305862426757813</c:v>
                </c:pt>
                <c:pt idx="2471">
                  <c:v>20.320524215698242</c:v>
                </c:pt>
                <c:pt idx="2472">
                  <c:v>20.335189819335938</c:v>
                </c:pt>
                <c:pt idx="2473">
                  <c:v>20.349857330322266</c:v>
                </c:pt>
                <c:pt idx="2474">
                  <c:v>20.364528656005859</c:v>
                </c:pt>
                <c:pt idx="2475">
                  <c:v>20.379203796386719</c:v>
                </c:pt>
                <c:pt idx="2476">
                  <c:v>20.393882751464844</c:v>
                </c:pt>
                <c:pt idx="2477">
                  <c:v>20.408565521240234</c:v>
                </c:pt>
                <c:pt idx="2478">
                  <c:v>20.423250198364258</c:v>
                </c:pt>
                <c:pt idx="2479">
                  <c:v>20.437938690185547</c:v>
                </c:pt>
                <c:pt idx="2480">
                  <c:v>20.452630996704102</c:v>
                </c:pt>
                <c:pt idx="2481">
                  <c:v>20.467327117919922</c:v>
                </c:pt>
                <c:pt idx="2482">
                  <c:v>20.482027053833008</c:v>
                </c:pt>
                <c:pt idx="2483">
                  <c:v>20.496730804443359</c:v>
                </c:pt>
                <c:pt idx="2484">
                  <c:v>20.511436462402344</c:v>
                </c:pt>
                <c:pt idx="2485">
                  <c:v>20.526145935058594</c:v>
                </c:pt>
                <c:pt idx="2486">
                  <c:v>20.540859222412109</c:v>
                </c:pt>
                <c:pt idx="2487">
                  <c:v>20.555576324462891</c:v>
                </c:pt>
                <c:pt idx="2488">
                  <c:v>20.570297241210938</c:v>
                </c:pt>
                <c:pt idx="2489">
                  <c:v>20.585020065307617</c:v>
                </c:pt>
                <c:pt idx="2490">
                  <c:v>20.599748611450195</c:v>
                </c:pt>
                <c:pt idx="2491">
                  <c:v>20.614480972290039</c:v>
                </c:pt>
                <c:pt idx="2492">
                  <c:v>20.629217147827148</c:v>
                </c:pt>
                <c:pt idx="2493">
                  <c:v>20.643955230712891</c:v>
                </c:pt>
                <c:pt idx="2494">
                  <c:v>20.658697128295898</c:v>
                </c:pt>
                <c:pt idx="2495">
                  <c:v>20.673442840576172</c:v>
                </c:pt>
                <c:pt idx="2496">
                  <c:v>20.688194274902344</c:v>
                </c:pt>
                <c:pt idx="2497">
                  <c:v>20.702945709228516</c:v>
                </c:pt>
                <c:pt idx="2498">
                  <c:v>20.717702865600586</c:v>
                </c:pt>
                <c:pt idx="2499">
                  <c:v>20.732461929321289</c:v>
                </c:pt>
                <c:pt idx="2500">
                  <c:v>20.747226715087891</c:v>
                </c:pt>
                <c:pt idx="2501">
                  <c:v>20.761991500854492</c:v>
                </c:pt>
                <c:pt idx="2502">
                  <c:v>20.776762008666992</c:v>
                </c:pt>
                <c:pt idx="2503">
                  <c:v>20.791536331176758</c:v>
                </c:pt>
                <c:pt idx="2504">
                  <c:v>20.806314468383789</c:v>
                </c:pt>
                <c:pt idx="2505">
                  <c:v>20.821094512939453</c:v>
                </c:pt>
                <c:pt idx="2506">
                  <c:v>20.835878372192383</c:v>
                </c:pt>
                <c:pt idx="2507">
                  <c:v>20.850666046142578</c:v>
                </c:pt>
                <c:pt idx="2508">
                  <c:v>20.865457534790039</c:v>
                </c:pt>
                <c:pt idx="2509">
                  <c:v>20.880252838134766</c:v>
                </c:pt>
                <c:pt idx="2510">
                  <c:v>20.895051956176758</c:v>
                </c:pt>
                <c:pt idx="2511">
                  <c:v>20.909852981567383</c:v>
                </c:pt>
                <c:pt idx="2512">
                  <c:v>20.924659729003906</c:v>
                </c:pt>
                <c:pt idx="2513">
                  <c:v>20.93946647644043</c:v>
                </c:pt>
                <c:pt idx="2514">
                  <c:v>20.954280853271484</c:v>
                </c:pt>
                <c:pt idx="2515">
                  <c:v>20.969095230102539</c:v>
                </c:pt>
                <c:pt idx="2516">
                  <c:v>20.983913421630859</c:v>
                </c:pt>
                <c:pt idx="2517">
                  <c:v>20.998735427856445</c:v>
                </c:pt>
                <c:pt idx="2518">
                  <c:v>21.013561248779297</c:v>
                </c:pt>
                <c:pt idx="2519">
                  <c:v>21.028390884399414</c:v>
                </c:pt>
                <c:pt idx="2520">
                  <c:v>21.043224334716797</c:v>
                </c:pt>
                <c:pt idx="2521">
                  <c:v>21.058061599731445</c:v>
                </c:pt>
                <c:pt idx="2522">
                  <c:v>21.072902679443359</c:v>
                </c:pt>
                <c:pt idx="2523">
                  <c:v>21.087745666503906</c:v>
                </c:pt>
                <c:pt idx="2524">
                  <c:v>21.102592468261719</c:v>
                </c:pt>
                <c:pt idx="2525">
                  <c:v>21.117443084716797</c:v>
                </c:pt>
                <c:pt idx="2526">
                  <c:v>21.132297515869141</c:v>
                </c:pt>
                <c:pt idx="2527">
                  <c:v>21.14715576171875</c:v>
                </c:pt>
                <c:pt idx="2528">
                  <c:v>21.162017822265625</c:v>
                </c:pt>
                <c:pt idx="2529">
                  <c:v>21.176883697509766</c:v>
                </c:pt>
                <c:pt idx="2530">
                  <c:v>21.191753387451172</c:v>
                </c:pt>
                <c:pt idx="2531">
                  <c:v>21.206624984741211</c:v>
                </c:pt>
                <c:pt idx="2532">
                  <c:v>21.221498489379883</c:v>
                </c:pt>
                <c:pt idx="2533">
                  <c:v>21.236379623413086</c:v>
                </c:pt>
                <c:pt idx="2534">
                  <c:v>21.251262664794922</c:v>
                </c:pt>
                <c:pt idx="2535">
                  <c:v>21.266149520874023</c:v>
                </c:pt>
                <c:pt idx="2536">
                  <c:v>21.281038284301758</c:v>
                </c:pt>
                <c:pt idx="2537">
                  <c:v>21.295930862426758</c:v>
                </c:pt>
                <c:pt idx="2538">
                  <c:v>21.310827255249023</c:v>
                </c:pt>
                <c:pt idx="2539">
                  <c:v>21.325729370117188</c:v>
                </c:pt>
                <c:pt idx="2540">
                  <c:v>21.340633392333984</c:v>
                </c:pt>
                <c:pt idx="2541">
                  <c:v>21.355541229248047</c:v>
                </c:pt>
                <c:pt idx="2542">
                  <c:v>21.370452880859375</c:v>
                </c:pt>
                <c:pt idx="2543">
                  <c:v>21.385368347167969</c:v>
                </c:pt>
                <c:pt idx="2544">
                  <c:v>21.400287628173828</c:v>
                </c:pt>
                <c:pt idx="2545">
                  <c:v>21.41520881652832</c:v>
                </c:pt>
                <c:pt idx="2546">
                  <c:v>21.430135726928711</c:v>
                </c:pt>
                <c:pt idx="2547">
                  <c:v>21.445064544677734</c:v>
                </c:pt>
                <c:pt idx="2548">
                  <c:v>21.459995269775391</c:v>
                </c:pt>
                <c:pt idx="2549">
                  <c:v>21.474931716918945</c:v>
                </c:pt>
                <c:pt idx="2550">
                  <c:v>21.489870071411133</c:v>
                </c:pt>
                <c:pt idx="2551">
                  <c:v>21.504814147949219</c:v>
                </c:pt>
                <c:pt idx="2552">
                  <c:v>21.519760131835938</c:v>
                </c:pt>
                <c:pt idx="2553">
                  <c:v>21.534711837768555</c:v>
                </c:pt>
                <c:pt idx="2554">
                  <c:v>21.549663543701172</c:v>
                </c:pt>
                <c:pt idx="2555">
                  <c:v>21.564620971679688</c:v>
                </c:pt>
                <c:pt idx="2556">
                  <c:v>21.579580307006836</c:v>
                </c:pt>
                <c:pt idx="2557">
                  <c:v>21.594545364379883</c:v>
                </c:pt>
                <c:pt idx="2558">
                  <c:v>21.609512329101563</c:v>
                </c:pt>
                <c:pt idx="2559">
                  <c:v>21.624485015869141</c:v>
                </c:pt>
                <c:pt idx="2560">
                  <c:v>21.639457702636719</c:v>
                </c:pt>
                <c:pt idx="2561">
                  <c:v>21.65443229675293</c:v>
                </c:pt>
                <c:pt idx="2562">
                  <c:v>21.669410705566406</c:v>
                </c:pt>
                <c:pt idx="2563">
                  <c:v>21.684394836425781</c:v>
                </c:pt>
                <c:pt idx="2564">
                  <c:v>21.699382781982422</c:v>
                </c:pt>
                <c:pt idx="2565">
                  <c:v>21.714376449584961</c:v>
                </c:pt>
                <c:pt idx="2566">
                  <c:v>21.7293701171875</c:v>
                </c:pt>
                <c:pt idx="2567">
                  <c:v>21.744369506835938</c:v>
                </c:pt>
                <c:pt idx="2568">
                  <c:v>21.759370803833008</c:v>
                </c:pt>
                <c:pt idx="2569">
                  <c:v>21.774375915527344</c:v>
                </c:pt>
                <c:pt idx="2570">
                  <c:v>21.789384841918945</c:v>
                </c:pt>
                <c:pt idx="2571">
                  <c:v>21.804397583007813</c:v>
                </c:pt>
                <c:pt idx="2572">
                  <c:v>21.819414138793945</c:v>
                </c:pt>
                <c:pt idx="2573">
                  <c:v>21.834434509277344</c:v>
                </c:pt>
                <c:pt idx="2574">
                  <c:v>21.849456787109375</c:v>
                </c:pt>
                <c:pt idx="2575">
                  <c:v>21.864484786987305</c:v>
                </c:pt>
                <c:pt idx="2576">
                  <c:v>21.879514694213867</c:v>
                </c:pt>
                <c:pt idx="2577">
                  <c:v>21.894548416137695</c:v>
                </c:pt>
                <c:pt idx="2578">
                  <c:v>21.909585952758789</c:v>
                </c:pt>
                <c:pt idx="2579">
                  <c:v>21.924625396728516</c:v>
                </c:pt>
                <c:pt idx="2580">
                  <c:v>21.939670562744141</c:v>
                </c:pt>
                <c:pt idx="2581">
                  <c:v>21.954719543457031</c:v>
                </c:pt>
                <c:pt idx="2582">
                  <c:v>21.969768524169922</c:v>
                </c:pt>
                <c:pt idx="2583">
                  <c:v>21.984823226928711</c:v>
                </c:pt>
                <c:pt idx="2584">
                  <c:v>21.999881744384766</c:v>
                </c:pt>
                <c:pt idx="2585">
                  <c:v>22.014944076538086</c:v>
                </c:pt>
                <c:pt idx="2586">
                  <c:v>22.030008316040039</c:v>
                </c:pt>
                <c:pt idx="2587">
                  <c:v>22.045080184936523</c:v>
                </c:pt>
                <c:pt idx="2588">
                  <c:v>22.060152053833008</c:v>
                </c:pt>
                <c:pt idx="2589">
                  <c:v>22.075227737426758</c:v>
                </c:pt>
                <c:pt idx="2590">
                  <c:v>22.090309143066406</c:v>
                </c:pt>
                <c:pt idx="2591">
                  <c:v>22.105392456054688</c:v>
                </c:pt>
                <c:pt idx="2592">
                  <c:v>22.120479583740234</c:v>
                </c:pt>
                <c:pt idx="2593">
                  <c:v>22.13557243347168</c:v>
                </c:pt>
                <c:pt idx="2594">
                  <c:v>22.150667190551758</c:v>
                </c:pt>
                <c:pt idx="2595">
                  <c:v>22.165765762329102</c:v>
                </c:pt>
                <c:pt idx="2596">
                  <c:v>22.180866241455078</c:v>
                </c:pt>
                <c:pt idx="2597">
                  <c:v>22.195974349975586</c:v>
                </c:pt>
                <c:pt idx="2598">
                  <c:v>22.211082458496094</c:v>
                </c:pt>
                <c:pt idx="2599">
                  <c:v>22.2261962890625</c:v>
                </c:pt>
                <c:pt idx="2600">
                  <c:v>22.241310119628906</c:v>
                </c:pt>
                <c:pt idx="2601">
                  <c:v>22.256431579589844</c:v>
                </c:pt>
                <c:pt idx="2602">
                  <c:v>22.271553039550781</c:v>
                </c:pt>
                <c:pt idx="2603">
                  <c:v>22.28668212890625</c:v>
                </c:pt>
                <c:pt idx="2604">
                  <c:v>22.301809310913086</c:v>
                </c:pt>
                <c:pt idx="2605">
                  <c:v>22.316944122314453</c:v>
                </c:pt>
                <c:pt idx="2606">
                  <c:v>22.33207893371582</c:v>
                </c:pt>
                <c:pt idx="2607">
                  <c:v>22.347221374511719</c:v>
                </c:pt>
                <c:pt idx="2608">
                  <c:v>22.362363815307617</c:v>
                </c:pt>
                <c:pt idx="2609">
                  <c:v>22.377511978149414</c:v>
                </c:pt>
                <c:pt idx="2610">
                  <c:v>22.392662048339844</c:v>
                </c:pt>
                <c:pt idx="2611">
                  <c:v>22.407817840576172</c:v>
                </c:pt>
                <c:pt idx="2612">
                  <c:v>22.4229736328125</c:v>
                </c:pt>
                <c:pt idx="2613">
                  <c:v>22.438135147094727</c:v>
                </c:pt>
                <c:pt idx="2614">
                  <c:v>22.453300476074219</c:v>
                </c:pt>
                <c:pt idx="2615">
                  <c:v>22.468471527099609</c:v>
                </c:pt>
                <c:pt idx="2616">
                  <c:v>22.483640670776367</c:v>
                </c:pt>
                <c:pt idx="2617">
                  <c:v>22.498815536499023</c:v>
                </c:pt>
                <c:pt idx="2618">
                  <c:v>22.513994216918945</c:v>
                </c:pt>
                <c:pt idx="2619">
                  <c:v>22.5291748046875</c:v>
                </c:pt>
                <c:pt idx="2620">
                  <c:v>22.54435920715332</c:v>
                </c:pt>
                <c:pt idx="2621">
                  <c:v>22.559549331665039</c:v>
                </c:pt>
                <c:pt idx="2622">
                  <c:v>22.574741363525391</c:v>
                </c:pt>
                <c:pt idx="2623">
                  <c:v>22.589937210083008</c:v>
                </c:pt>
                <c:pt idx="2624">
                  <c:v>22.605134963989258</c:v>
                </c:pt>
                <c:pt idx="2625">
                  <c:v>22.620340347290039</c:v>
                </c:pt>
                <c:pt idx="2626">
                  <c:v>22.63554573059082</c:v>
                </c:pt>
                <c:pt idx="2627">
                  <c:v>22.650754928588867</c:v>
                </c:pt>
                <c:pt idx="2628">
                  <c:v>22.66596794128418</c:v>
                </c:pt>
                <c:pt idx="2629">
                  <c:v>22.681184768676758</c:v>
                </c:pt>
                <c:pt idx="2630">
                  <c:v>22.696405410766602</c:v>
                </c:pt>
                <c:pt idx="2631">
                  <c:v>22.711629867553711</c:v>
                </c:pt>
                <c:pt idx="2632">
                  <c:v>22.726856231689453</c:v>
                </c:pt>
                <c:pt idx="2633">
                  <c:v>22.742090225219727</c:v>
                </c:pt>
                <c:pt idx="2634">
                  <c:v>22.75732421875</c:v>
                </c:pt>
                <c:pt idx="2635">
                  <c:v>22.772563934326172</c:v>
                </c:pt>
                <c:pt idx="2636">
                  <c:v>22.787805557250977</c:v>
                </c:pt>
                <c:pt idx="2637">
                  <c:v>22.80305290222168</c:v>
                </c:pt>
                <c:pt idx="2638">
                  <c:v>22.818300247192383</c:v>
                </c:pt>
                <c:pt idx="2639">
                  <c:v>22.833555221557617</c:v>
                </c:pt>
                <c:pt idx="2640">
                  <c:v>22.848810195922852</c:v>
                </c:pt>
                <c:pt idx="2641">
                  <c:v>22.864072799682617</c:v>
                </c:pt>
                <c:pt idx="2642">
                  <c:v>22.879337310791016</c:v>
                </c:pt>
                <c:pt idx="2643">
                  <c:v>22.89460563659668</c:v>
                </c:pt>
                <c:pt idx="2644">
                  <c:v>22.909873962402344</c:v>
                </c:pt>
                <c:pt idx="2645">
                  <c:v>22.925149917602539</c:v>
                </c:pt>
                <c:pt idx="2646">
                  <c:v>22.940425872802734</c:v>
                </c:pt>
                <c:pt idx="2647">
                  <c:v>22.955707550048828</c:v>
                </c:pt>
                <c:pt idx="2648">
                  <c:v>22.970991134643555</c:v>
                </c:pt>
                <c:pt idx="2649">
                  <c:v>22.986282348632813</c:v>
                </c:pt>
                <c:pt idx="2650">
                  <c:v>23.00157356262207</c:v>
                </c:pt>
                <c:pt idx="2651">
                  <c:v>23.016870498657227</c:v>
                </c:pt>
                <c:pt idx="2652">
                  <c:v>23.032169342041016</c:v>
                </c:pt>
                <c:pt idx="2653">
                  <c:v>23.04747200012207</c:v>
                </c:pt>
                <c:pt idx="2654">
                  <c:v>23.062776565551758</c:v>
                </c:pt>
                <c:pt idx="2655">
                  <c:v>23.078086853027344</c:v>
                </c:pt>
                <c:pt idx="2656">
                  <c:v>23.093399047851563</c:v>
                </c:pt>
                <c:pt idx="2657">
                  <c:v>23.10871696472168</c:v>
                </c:pt>
                <c:pt idx="2658">
                  <c:v>23.124032974243164</c:v>
                </c:pt>
                <c:pt idx="2659">
                  <c:v>23.139358520507813</c:v>
                </c:pt>
                <c:pt idx="2660">
                  <c:v>23.154682159423828</c:v>
                </c:pt>
                <c:pt idx="2661">
                  <c:v>23.170013427734375</c:v>
                </c:pt>
                <c:pt idx="2662">
                  <c:v>23.185346603393555</c:v>
                </c:pt>
                <c:pt idx="2663">
                  <c:v>23.200685501098633</c:v>
                </c:pt>
                <c:pt idx="2664">
                  <c:v>23.216026306152344</c:v>
                </c:pt>
                <c:pt idx="2665">
                  <c:v>23.23137092590332</c:v>
                </c:pt>
                <c:pt idx="2666">
                  <c:v>23.24671745300293</c:v>
                </c:pt>
                <c:pt idx="2667">
                  <c:v>23.262069702148438</c:v>
                </c:pt>
                <c:pt idx="2668">
                  <c:v>23.277421951293945</c:v>
                </c:pt>
                <c:pt idx="2669">
                  <c:v>23.292781829833984</c:v>
                </c:pt>
                <c:pt idx="2670">
                  <c:v>23.308139801025391</c:v>
                </c:pt>
                <c:pt idx="2671">
                  <c:v>23.323509216308594</c:v>
                </c:pt>
                <c:pt idx="2672">
                  <c:v>23.338876724243164</c:v>
                </c:pt>
                <c:pt idx="2673">
                  <c:v>23.354249954223633</c:v>
                </c:pt>
                <c:pt idx="2674">
                  <c:v>23.369623184204102</c:v>
                </c:pt>
                <c:pt idx="2675">
                  <c:v>23.385004043579102</c:v>
                </c:pt>
                <c:pt idx="2676">
                  <c:v>23.400388717651367</c:v>
                </c:pt>
                <c:pt idx="2677">
                  <c:v>23.415775299072266</c:v>
                </c:pt>
                <c:pt idx="2678">
                  <c:v>23.431163787841797</c:v>
                </c:pt>
                <c:pt idx="2679">
                  <c:v>23.446559906005859</c:v>
                </c:pt>
                <c:pt idx="2680">
                  <c:v>23.461954116821289</c:v>
                </c:pt>
                <c:pt idx="2681">
                  <c:v>23.477354049682617</c:v>
                </c:pt>
                <c:pt idx="2682">
                  <c:v>23.492757797241211</c:v>
                </c:pt>
                <c:pt idx="2683">
                  <c:v>23.50816535949707</c:v>
                </c:pt>
                <c:pt idx="2684">
                  <c:v>23.523574829101563</c:v>
                </c:pt>
                <c:pt idx="2685">
                  <c:v>23.538993835449219</c:v>
                </c:pt>
                <c:pt idx="2686">
                  <c:v>23.554412841796875</c:v>
                </c:pt>
                <c:pt idx="2687">
                  <c:v>23.56983757019043</c:v>
                </c:pt>
                <c:pt idx="2688">
                  <c:v>23.585264205932617</c:v>
                </c:pt>
                <c:pt idx="2689">
                  <c:v>23.600692749023438</c:v>
                </c:pt>
                <c:pt idx="2690">
                  <c:v>23.616125106811523</c:v>
                </c:pt>
                <c:pt idx="2691">
                  <c:v>23.631565093994141</c:v>
                </c:pt>
                <c:pt idx="2692">
                  <c:v>23.647003173828125</c:v>
                </c:pt>
                <c:pt idx="2693">
                  <c:v>23.662450790405273</c:v>
                </c:pt>
                <c:pt idx="2694">
                  <c:v>23.677896499633789</c:v>
                </c:pt>
                <c:pt idx="2695">
                  <c:v>23.693349838256836</c:v>
                </c:pt>
                <c:pt idx="2696">
                  <c:v>23.708806991577148</c:v>
                </c:pt>
                <c:pt idx="2697">
                  <c:v>23.724266052246094</c:v>
                </c:pt>
                <c:pt idx="2698">
                  <c:v>23.739728927612305</c:v>
                </c:pt>
                <c:pt idx="2699">
                  <c:v>23.755195617675781</c:v>
                </c:pt>
                <c:pt idx="2700">
                  <c:v>23.770662307739258</c:v>
                </c:pt>
                <c:pt idx="2701">
                  <c:v>23.786142349243164</c:v>
                </c:pt>
                <c:pt idx="2702">
                  <c:v>23.801620483398438</c:v>
                </c:pt>
                <c:pt idx="2703">
                  <c:v>23.817102432250977</c:v>
                </c:pt>
                <c:pt idx="2704">
                  <c:v>23.832586288452148</c:v>
                </c:pt>
                <c:pt idx="2705">
                  <c:v>23.848077774047852</c:v>
                </c:pt>
                <c:pt idx="2706">
                  <c:v>23.863565444946289</c:v>
                </c:pt>
                <c:pt idx="2707">
                  <c:v>23.879060745239258</c:v>
                </c:pt>
                <c:pt idx="2708">
                  <c:v>23.894554138183594</c:v>
                </c:pt>
                <c:pt idx="2709">
                  <c:v>23.910058975219727</c:v>
                </c:pt>
                <c:pt idx="2710">
                  <c:v>23.925561904907227</c:v>
                </c:pt>
                <c:pt idx="2711">
                  <c:v>23.941072463989258</c:v>
                </c:pt>
                <c:pt idx="2712">
                  <c:v>23.956581115722656</c:v>
                </c:pt>
                <c:pt idx="2713">
                  <c:v>23.972099304199219</c:v>
                </c:pt>
                <c:pt idx="2714">
                  <c:v>23.987617492675781</c:v>
                </c:pt>
                <c:pt idx="2715">
                  <c:v>24.003141403198242</c:v>
                </c:pt>
                <c:pt idx="2716">
                  <c:v>24.018667221069336</c:v>
                </c:pt>
                <c:pt idx="2717">
                  <c:v>24.034196853637695</c:v>
                </c:pt>
                <c:pt idx="2718">
                  <c:v>24.049726486206055</c:v>
                </c:pt>
                <c:pt idx="2719">
                  <c:v>24.065263748168945</c:v>
                </c:pt>
                <c:pt idx="2720">
                  <c:v>24.080802917480469</c:v>
                </c:pt>
                <c:pt idx="2721">
                  <c:v>24.096347808837891</c:v>
                </c:pt>
                <c:pt idx="2722">
                  <c:v>24.111896514892578</c:v>
                </c:pt>
                <c:pt idx="2723">
                  <c:v>24.127449035644531</c:v>
                </c:pt>
                <c:pt idx="2724">
                  <c:v>24.143003463745117</c:v>
                </c:pt>
                <c:pt idx="2725">
                  <c:v>24.158563613891602</c:v>
                </c:pt>
                <c:pt idx="2726">
                  <c:v>24.174123764038086</c:v>
                </c:pt>
                <c:pt idx="2727">
                  <c:v>24.189689636230469</c:v>
                </c:pt>
                <c:pt idx="2728">
                  <c:v>24.205257415771484</c:v>
                </c:pt>
                <c:pt idx="2729">
                  <c:v>24.220829010009766</c:v>
                </c:pt>
                <c:pt idx="2730">
                  <c:v>24.23640251159668</c:v>
                </c:pt>
                <c:pt idx="2731">
                  <c:v>24.251983642578125</c:v>
                </c:pt>
                <c:pt idx="2732">
                  <c:v>24.26756477355957</c:v>
                </c:pt>
                <c:pt idx="2733">
                  <c:v>24.283149719238281</c:v>
                </c:pt>
                <c:pt idx="2734">
                  <c:v>24.298742294311523</c:v>
                </c:pt>
                <c:pt idx="2735">
                  <c:v>24.314336776733398</c:v>
                </c:pt>
                <c:pt idx="2736">
                  <c:v>24.329933166503906</c:v>
                </c:pt>
                <c:pt idx="2737">
                  <c:v>24.345535278320313</c:v>
                </c:pt>
                <c:pt idx="2738">
                  <c:v>24.361141204833984</c:v>
                </c:pt>
                <c:pt idx="2739">
                  <c:v>24.376752853393555</c:v>
                </c:pt>
                <c:pt idx="2740">
                  <c:v>24.392362594604492</c:v>
                </c:pt>
                <c:pt idx="2741">
                  <c:v>24.407978057861328</c:v>
                </c:pt>
                <c:pt idx="2742">
                  <c:v>24.42359733581543</c:v>
                </c:pt>
                <c:pt idx="2743">
                  <c:v>24.439224243164063</c:v>
                </c:pt>
                <c:pt idx="2744">
                  <c:v>24.454853057861328</c:v>
                </c:pt>
                <c:pt idx="2745">
                  <c:v>24.470481872558594</c:v>
                </c:pt>
                <c:pt idx="2746">
                  <c:v>24.486118316650391</c:v>
                </c:pt>
                <c:pt idx="2747">
                  <c:v>24.501758575439453</c:v>
                </c:pt>
                <c:pt idx="2748">
                  <c:v>24.517402648925781</c:v>
                </c:pt>
                <c:pt idx="2749">
                  <c:v>24.533052444458008</c:v>
                </c:pt>
                <c:pt idx="2750">
                  <c:v>24.548704147338867</c:v>
                </c:pt>
                <c:pt idx="2751">
                  <c:v>24.564359664916992</c:v>
                </c:pt>
                <c:pt idx="2752">
                  <c:v>24.58001708984375</c:v>
                </c:pt>
                <c:pt idx="2753">
                  <c:v>24.595680236816406</c:v>
                </c:pt>
                <c:pt idx="2754">
                  <c:v>24.611349105834961</c:v>
                </c:pt>
                <c:pt idx="2755">
                  <c:v>24.627017974853516</c:v>
                </c:pt>
                <c:pt idx="2756">
                  <c:v>24.642690658569336</c:v>
                </c:pt>
                <c:pt idx="2757">
                  <c:v>24.658367156982422</c:v>
                </c:pt>
                <c:pt idx="2758">
                  <c:v>24.674045562744141</c:v>
                </c:pt>
                <c:pt idx="2759">
                  <c:v>24.689725875854492</c:v>
                </c:pt>
                <c:pt idx="2760">
                  <c:v>24.705413818359375</c:v>
                </c:pt>
                <c:pt idx="2761">
                  <c:v>24.721099853515625</c:v>
                </c:pt>
                <c:pt idx="2762">
                  <c:v>24.736795425415039</c:v>
                </c:pt>
                <c:pt idx="2763">
                  <c:v>24.752492904663086</c:v>
                </c:pt>
                <c:pt idx="2764">
                  <c:v>24.768194198608398</c:v>
                </c:pt>
                <c:pt idx="2765">
                  <c:v>24.783899307250977</c:v>
                </c:pt>
                <c:pt idx="2766">
                  <c:v>24.799606323242188</c:v>
                </c:pt>
                <c:pt idx="2767">
                  <c:v>24.815315246582031</c:v>
                </c:pt>
                <c:pt idx="2768">
                  <c:v>24.831029891967773</c:v>
                </c:pt>
                <c:pt idx="2769">
                  <c:v>24.846750259399414</c:v>
                </c:pt>
                <c:pt idx="2770">
                  <c:v>24.86247444152832</c:v>
                </c:pt>
                <c:pt idx="2771">
                  <c:v>24.878198623657227</c:v>
                </c:pt>
                <c:pt idx="2772">
                  <c:v>24.893930435180664</c:v>
                </c:pt>
                <c:pt idx="2773">
                  <c:v>24.909660339355469</c:v>
                </c:pt>
                <c:pt idx="2774">
                  <c:v>24.925397872924805</c:v>
                </c:pt>
                <c:pt idx="2775">
                  <c:v>24.941139221191406</c:v>
                </c:pt>
                <c:pt idx="2776">
                  <c:v>24.956884384155273</c:v>
                </c:pt>
                <c:pt idx="2777">
                  <c:v>24.972631454467773</c:v>
                </c:pt>
                <c:pt idx="2778">
                  <c:v>24.988384246826172</c:v>
                </c:pt>
                <c:pt idx="2779">
                  <c:v>25.00413703918457</c:v>
                </c:pt>
                <c:pt idx="2780">
                  <c:v>25.0198974609375</c:v>
                </c:pt>
                <c:pt idx="2781">
                  <c:v>25.035659790039063</c:v>
                </c:pt>
                <c:pt idx="2782">
                  <c:v>25.051424026489258</c:v>
                </c:pt>
                <c:pt idx="2783">
                  <c:v>25.067190170288086</c:v>
                </c:pt>
                <c:pt idx="2784">
                  <c:v>25.082962036132813</c:v>
                </c:pt>
                <c:pt idx="2785">
                  <c:v>25.09874153137207</c:v>
                </c:pt>
                <c:pt idx="2786">
                  <c:v>25.114524841308594</c:v>
                </c:pt>
                <c:pt idx="2787">
                  <c:v>25.13031005859375</c:v>
                </c:pt>
                <c:pt idx="2788">
                  <c:v>25.146099090576172</c:v>
                </c:pt>
                <c:pt idx="2789">
                  <c:v>25.161890029907227</c:v>
                </c:pt>
                <c:pt idx="2790">
                  <c:v>25.177688598632813</c:v>
                </c:pt>
                <c:pt idx="2791">
                  <c:v>25.193489074707031</c:v>
                </c:pt>
                <c:pt idx="2792">
                  <c:v>25.209293365478516</c:v>
                </c:pt>
                <c:pt idx="2793">
                  <c:v>25.225099563598633</c:v>
                </c:pt>
                <c:pt idx="2794">
                  <c:v>25.240913391113281</c:v>
                </c:pt>
                <c:pt idx="2795">
                  <c:v>25.256723403930664</c:v>
                </c:pt>
                <c:pt idx="2796">
                  <c:v>25.272544860839844</c:v>
                </c:pt>
                <c:pt idx="2797">
                  <c:v>25.288366317749023</c:v>
                </c:pt>
                <c:pt idx="2798">
                  <c:v>25.304189682006836</c:v>
                </c:pt>
                <c:pt idx="2799">
                  <c:v>25.320016860961914</c:v>
                </c:pt>
                <c:pt idx="2800">
                  <c:v>25.335851669311523</c:v>
                </c:pt>
                <c:pt idx="2801">
                  <c:v>25.351688385009766</c:v>
                </c:pt>
                <c:pt idx="2802">
                  <c:v>25.367528915405273</c:v>
                </c:pt>
                <c:pt idx="2803">
                  <c:v>25.383371353149414</c:v>
                </c:pt>
                <c:pt idx="2804">
                  <c:v>25.39921760559082</c:v>
                </c:pt>
                <c:pt idx="2805">
                  <c:v>25.415063858032227</c:v>
                </c:pt>
                <c:pt idx="2806">
                  <c:v>25.430919647216797</c:v>
                </c:pt>
                <c:pt idx="2807">
                  <c:v>25.44677734375</c:v>
                </c:pt>
                <c:pt idx="2808">
                  <c:v>25.462640762329102</c:v>
                </c:pt>
                <c:pt idx="2809">
                  <c:v>25.47850227355957</c:v>
                </c:pt>
                <c:pt idx="2810">
                  <c:v>25.494369506835938</c:v>
                </c:pt>
                <c:pt idx="2811">
                  <c:v>25.510236740112305</c:v>
                </c:pt>
                <c:pt idx="2812">
                  <c:v>25.52610969543457</c:v>
                </c:pt>
                <c:pt idx="2813">
                  <c:v>25.541982650756836</c:v>
                </c:pt>
                <c:pt idx="2814">
                  <c:v>25.557863235473633</c:v>
                </c:pt>
                <c:pt idx="2815">
                  <c:v>25.573745727539063</c:v>
                </c:pt>
                <c:pt idx="2816">
                  <c:v>25.589632034301758</c:v>
                </c:pt>
                <c:pt idx="2817">
                  <c:v>25.605520248413086</c:v>
                </c:pt>
                <c:pt idx="2818">
                  <c:v>25.621416091918945</c:v>
                </c:pt>
                <c:pt idx="2819">
                  <c:v>25.637311935424805</c:v>
                </c:pt>
                <c:pt idx="2820">
                  <c:v>25.653213500976563</c:v>
                </c:pt>
                <c:pt idx="2821">
                  <c:v>25.669113159179688</c:v>
                </c:pt>
                <c:pt idx="2822">
                  <c:v>25.685022354125977</c:v>
                </c:pt>
                <c:pt idx="2823">
                  <c:v>25.700935363769531</c:v>
                </c:pt>
                <c:pt idx="2824">
                  <c:v>25.716850280761719</c:v>
                </c:pt>
                <c:pt idx="2825">
                  <c:v>25.732769012451172</c:v>
                </c:pt>
                <c:pt idx="2826">
                  <c:v>25.748691558837891</c:v>
                </c:pt>
                <c:pt idx="2827">
                  <c:v>25.764616012573242</c:v>
                </c:pt>
                <c:pt idx="2828">
                  <c:v>25.780546188354492</c:v>
                </c:pt>
                <c:pt idx="2829">
                  <c:v>25.796478271484375</c:v>
                </c:pt>
                <c:pt idx="2830">
                  <c:v>25.812416076660156</c:v>
                </c:pt>
                <c:pt idx="2831">
                  <c:v>25.828353881835938</c:v>
                </c:pt>
                <c:pt idx="2832">
                  <c:v>25.84429931640625</c:v>
                </c:pt>
                <c:pt idx="2833">
                  <c:v>25.860244750976563</c:v>
                </c:pt>
                <c:pt idx="2834">
                  <c:v>25.876199722290039</c:v>
                </c:pt>
                <c:pt idx="2835">
                  <c:v>25.892152786254883</c:v>
                </c:pt>
                <c:pt idx="2836">
                  <c:v>25.908109664916992</c:v>
                </c:pt>
                <c:pt idx="2837">
                  <c:v>25.924072265625</c:v>
                </c:pt>
                <c:pt idx="2838">
                  <c:v>25.940038681030273</c:v>
                </c:pt>
                <c:pt idx="2839">
                  <c:v>25.956008911132813</c:v>
                </c:pt>
                <c:pt idx="2840">
                  <c:v>25.971982955932617</c:v>
                </c:pt>
                <c:pt idx="2841">
                  <c:v>25.987960815429688</c:v>
                </c:pt>
                <c:pt idx="2842">
                  <c:v>26.003944396972656</c:v>
                </c:pt>
                <c:pt idx="2843">
                  <c:v>26.019927978515625</c:v>
                </c:pt>
                <c:pt idx="2844">
                  <c:v>26.035915374755859</c:v>
                </c:pt>
                <c:pt idx="2845">
                  <c:v>26.051904678344727</c:v>
                </c:pt>
                <c:pt idx="2846">
                  <c:v>26.067903518676758</c:v>
                </c:pt>
                <c:pt idx="2847">
                  <c:v>26.083904266357422</c:v>
                </c:pt>
                <c:pt idx="2848">
                  <c:v>26.099908828735352</c:v>
                </c:pt>
                <c:pt idx="2849">
                  <c:v>26.115913391113281</c:v>
                </c:pt>
                <c:pt idx="2850">
                  <c:v>26.131921768188477</c:v>
                </c:pt>
                <c:pt idx="2851">
                  <c:v>26.147939682006836</c:v>
                </c:pt>
                <c:pt idx="2852">
                  <c:v>26.163957595825195</c:v>
                </c:pt>
                <c:pt idx="2853">
                  <c:v>26.179977416992188</c:v>
                </c:pt>
                <c:pt idx="2854">
                  <c:v>26.196001052856445</c:v>
                </c:pt>
                <c:pt idx="2855">
                  <c:v>26.212030410766602</c:v>
                </c:pt>
                <c:pt idx="2856">
                  <c:v>26.228063583374023</c:v>
                </c:pt>
                <c:pt idx="2857">
                  <c:v>26.244098663330078</c:v>
                </c:pt>
                <c:pt idx="2858">
                  <c:v>26.260137557983398</c:v>
                </c:pt>
                <c:pt idx="2859">
                  <c:v>26.276180267333984</c:v>
                </c:pt>
                <c:pt idx="2860">
                  <c:v>26.292228698730469</c:v>
                </c:pt>
                <c:pt idx="2861">
                  <c:v>26.308277130126953</c:v>
                </c:pt>
                <c:pt idx="2862">
                  <c:v>26.324329376220703</c:v>
                </c:pt>
                <c:pt idx="2863">
                  <c:v>26.340385437011719</c:v>
                </c:pt>
                <c:pt idx="2864">
                  <c:v>26.356443405151367</c:v>
                </c:pt>
                <c:pt idx="2865">
                  <c:v>26.372507095336914</c:v>
                </c:pt>
                <c:pt idx="2866">
                  <c:v>26.388572692871094</c:v>
                </c:pt>
                <c:pt idx="2867">
                  <c:v>26.404642105102539</c:v>
                </c:pt>
                <c:pt idx="2868">
                  <c:v>26.42071533203125</c:v>
                </c:pt>
                <c:pt idx="2869">
                  <c:v>26.436792373657227</c:v>
                </c:pt>
                <c:pt idx="2870">
                  <c:v>26.452873229980469</c:v>
                </c:pt>
                <c:pt idx="2871">
                  <c:v>26.468954086303711</c:v>
                </c:pt>
                <c:pt idx="2872">
                  <c:v>26.485044479370117</c:v>
                </c:pt>
                <c:pt idx="2873">
                  <c:v>26.501134872436523</c:v>
                </c:pt>
                <c:pt idx="2874">
                  <c:v>26.517230987548828</c:v>
                </c:pt>
                <c:pt idx="2875">
                  <c:v>26.533329010009766</c:v>
                </c:pt>
                <c:pt idx="2876">
                  <c:v>26.549428939819336</c:v>
                </c:pt>
                <c:pt idx="2877">
                  <c:v>26.565532684326172</c:v>
                </c:pt>
                <c:pt idx="2878">
                  <c:v>26.581640243530273</c:v>
                </c:pt>
                <c:pt idx="2879">
                  <c:v>26.597751617431641</c:v>
                </c:pt>
                <c:pt idx="2880">
                  <c:v>26.613862991333008</c:v>
                </c:pt>
                <c:pt idx="2881">
                  <c:v>26.629978179931641</c:v>
                </c:pt>
                <c:pt idx="2882">
                  <c:v>26.646100997924805</c:v>
                </c:pt>
                <c:pt idx="2883">
                  <c:v>26.662225723266602</c:v>
                </c:pt>
                <c:pt idx="2884">
                  <c:v>26.678354263305664</c:v>
                </c:pt>
                <c:pt idx="2885">
                  <c:v>26.694486618041992</c:v>
                </c:pt>
                <c:pt idx="2886">
                  <c:v>26.710624694824219</c:v>
                </c:pt>
                <c:pt idx="2887">
                  <c:v>26.726766586303711</c:v>
                </c:pt>
                <c:pt idx="2888">
                  <c:v>26.742910385131836</c:v>
                </c:pt>
                <c:pt idx="2889">
                  <c:v>26.759056091308594</c:v>
                </c:pt>
                <c:pt idx="2890">
                  <c:v>26.77520751953125</c:v>
                </c:pt>
                <c:pt idx="2891">
                  <c:v>26.791360855102539</c:v>
                </c:pt>
                <c:pt idx="2892">
                  <c:v>26.807521820068359</c:v>
                </c:pt>
                <c:pt idx="2893">
                  <c:v>26.82368278503418</c:v>
                </c:pt>
                <c:pt idx="2894">
                  <c:v>26.839847564697266</c:v>
                </c:pt>
                <c:pt idx="2895">
                  <c:v>26.856016159057617</c:v>
                </c:pt>
                <c:pt idx="2896">
                  <c:v>26.872184753417969</c:v>
                </c:pt>
                <c:pt idx="2897">
                  <c:v>26.888362884521484</c:v>
                </c:pt>
                <c:pt idx="2898">
                  <c:v>26.904539108276367</c:v>
                </c:pt>
                <c:pt idx="2899">
                  <c:v>26.920721054077148</c:v>
                </c:pt>
                <c:pt idx="2900">
                  <c:v>26.936904907226563</c:v>
                </c:pt>
                <c:pt idx="2901">
                  <c:v>26.953094482421875</c:v>
                </c:pt>
                <c:pt idx="2902">
                  <c:v>26.969287872314453</c:v>
                </c:pt>
                <c:pt idx="2903">
                  <c:v>26.985485076904297</c:v>
                </c:pt>
                <c:pt idx="2904">
                  <c:v>27.001686096191406</c:v>
                </c:pt>
                <c:pt idx="2905">
                  <c:v>27.017889022827148</c:v>
                </c:pt>
                <c:pt idx="2906">
                  <c:v>27.034095764160156</c:v>
                </c:pt>
                <c:pt idx="2907">
                  <c:v>27.050304412841797</c:v>
                </c:pt>
                <c:pt idx="2908">
                  <c:v>27.066518783569336</c:v>
                </c:pt>
                <c:pt idx="2909">
                  <c:v>27.082736968994141</c:v>
                </c:pt>
                <c:pt idx="2910">
                  <c:v>27.098957061767578</c:v>
                </c:pt>
                <c:pt idx="2911">
                  <c:v>27.115180969238281</c:v>
                </c:pt>
                <c:pt idx="2912">
                  <c:v>27.131406784057617</c:v>
                </c:pt>
                <c:pt idx="2913">
                  <c:v>27.147638320922852</c:v>
                </c:pt>
                <c:pt idx="2914">
                  <c:v>27.163869857788086</c:v>
                </c:pt>
                <c:pt idx="2915">
                  <c:v>27.180107116699219</c:v>
                </c:pt>
                <c:pt idx="2916">
                  <c:v>27.19635009765625</c:v>
                </c:pt>
                <c:pt idx="2917">
                  <c:v>27.212593078613281</c:v>
                </c:pt>
                <c:pt idx="2918">
                  <c:v>27.228839874267578</c:v>
                </c:pt>
                <c:pt idx="2919">
                  <c:v>27.245092391967773</c:v>
                </c:pt>
                <c:pt idx="2920">
                  <c:v>27.261348724365234</c:v>
                </c:pt>
                <c:pt idx="2921">
                  <c:v>27.277606964111328</c:v>
                </c:pt>
                <c:pt idx="2922">
                  <c:v>27.29387092590332</c:v>
                </c:pt>
                <c:pt idx="2923">
                  <c:v>27.310136795043945</c:v>
                </c:pt>
                <c:pt idx="2924">
                  <c:v>27.326404571533203</c:v>
                </c:pt>
                <c:pt idx="2925">
                  <c:v>27.342676162719727</c:v>
                </c:pt>
                <c:pt idx="2926">
                  <c:v>27.358951568603516</c:v>
                </c:pt>
                <c:pt idx="2927">
                  <c:v>27.375232696533203</c:v>
                </c:pt>
                <c:pt idx="2928">
                  <c:v>27.391517639160156</c:v>
                </c:pt>
                <c:pt idx="2929">
                  <c:v>27.407802581787109</c:v>
                </c:pt>
                <c:pt idx="2930">
                  <c:v>27.424093246459961</c:v>
                </c:pt>
                <c:pt idx="2931">
                  <c:v>27.440387725830078</c:v>
                </c:pt>
                <c:pt idx="2932">
                  <c:v>27.456684112548828</c:v>
                </c:pt>
                <c:pt idx="2933">
                  <c:v>27.472986221313477</c:v>
                </c:pt>
                <c:pt idx="2934">
                  <c:v>27.489292144775391</c:v>
                </c:pt>
                <c:pt idx="2935">
                  <c:v>27.505599975585938</c:v>
                </c:pt>
                <c:pt idx="2936">
                  <c:v>27.52191162109375</c:v>
                </c:pt>
                <c:pt idx="2937">
                  <c:v>27.538227081298828</c:v>
                </c:pt>
                <c:pt idx="2938">
                  <c:v>27.554546356201172</c:v>
                </c:pt>
                <c:pt idx="2939">
                  <c:v>27.570869445800781</c:v>
                </c:pt>
                <c:pt idx="2940">
                  <c:v>27.587192535400391</c:v>
                </c:pt>
                <c:pt idx="2941">
                  <c:v>27.603523254394531</c:v>
                </c:pt>
                <c:pt idx="2942">
                  <c:v>27.619853973388672</c:v>
                </c:pt>
                <c:pt idx="2943">
                  <c:v>27.636190414428711</c:v>
                </c:pt>
                <c:pt idx="2944">
                  <c:v>27.652530670166016</c:v>
                </c:pt>
                <c:pt idx="2945">
                  <c:v>27.668874740600586</c:v>
                </c:pt>
                <c:pt idx="2946">
                  <c:v>27.685220718383789</c:v>
                </c:pt>
                <c:pt idx="2947">
                  <c:v>27.701570510864258</c:v>
                </c:pt>
                <c:pt idx="2948">
                  <c:v>27.717924118041992</c:v>
                </c:pt>
                <c:pt idx="2949">
                  <c:v>27.734279632568359</c:v>
                </c:pt>
                <c:pt idx="2950">
                  <c:v>27.750638961791992</c:v>
                </c:pt>
                <c:pt idx="2951">
                  <c:v>27.767004013061523</c:v>
                </c:pt>
                <c:pt idx="2952">
                  <c:v>27.783369064331055</c:v>
                </c:pt>
                <c:pt idx="2953">
                  <c:v>27.799739837646484</c:v>
                </c:pt>
                <c:pt idx="2954">
                  <c:v>27.816112518310547</c:v>
                </c:pt>
                <c:pt idx="2955">
                  <c:v>27.832489013671875</c:v>
                </c:pt>
                <c:pt idx="2956">
                  <c:v>27.848869323730469</c:v>
                </c:pt>
                <c:pt idx="2957">
                  <c:v>27.865253448486328</c:v>
                </c:pt>
                <c:pt idx="2958">
                  <c:v>27.881641387939453</c:v>
                </c:pt>
                <c:pt idx="2959">
                  <c:v>27.898033142089844</c:v>
                </c:pt>
                <c:pt idx="2960">
                  <c:v>27.9144287109375</c:v>
                </c:pt>
                <c:pt idx="2961">
                  <c:v>27.930826187133789</c:v>
                </c:pt>
                <c:pt idx="2962">
                  <c:v>27.947227478027344</c:v>
                </c:pt>
                <c:pt idx="2963">
                  <c:v>27.963630676269531</c:v>
                </c:pt>
                <c:pt idx="2964">
                  <c:v>27.980039596557617</c:v>
                </c:pt>
                <c:pt idx="2965">
                  <c:v>27.996450424194336</c:v>
                </c:pt>
                <c:pt idx="2966">
                  <c:v>28.01286506652832</c:v>
                </c:pt>
                <c:pt idx="2967">
                  <c:v>28.02928352355957</c:v>
                </c:pt>
                <c:pt idx="2968">
                  <c:v>28.045705795288086</c:v>
                </c:pt>
                <c:pt idx="2969">
                  <c:v>28.062131881713867</c:v>
                </c:pt>
                <c:pt idx="2970">
                  <c:v>28.078557968139648</c:v>
                </c:pt>
                <c:pt idx="2971">
                  <c:v>28.094991683959961</c:v>
                </c:pt>
                <c:pt idx="2972">
                  <c:v>28.111427307128906</c:v>
                </c:pt>
                <c:pt idx="2973">
                  <c:v>28.127866744995117</c:v>
                </c:pt>
                <c:pt idx="2974">
                  <c:v>28.144308090209961</c:v>
                </c:pt>
                <c:pt idx="2975">
                  <c:v>28.160755157470703</c:v>
                </c:pt>
                <c:pt idx="2976">
                  <c:v>28.177204132080078</c:v>
                </c:pt>
                <c:pt idx="2977">
                  <c:v>28.193656921386719</c:v>
                </c:pt>
                <c:pt idx="2978">
                  <c:v>28.210113525390625</c:v>
                </c:pt>
                <c:pt idx="2979">
                  <c:v>28.226573944091797</c:v>
                </c:pt>
                <c:pt idx="2980">
                  <c:v>28.243038177490234</c:v>
                </c:pt>
                <c:pt idx="2981">
                  <c:v>28.259504318237305</c:v>
                </c:pt>
                <c:pt idx="2982">
                  <c:v>28.275974273681641</c:v>
                </c:pt>
                <c:pt idx="2983">
                  <c:v>28.292448043823242</c:v>
                </c:pt>
                <c:pt idx="2984">
                  <c:v>28.308925628662109</c:v>
                </c:pt>
                <c:pt idx="2985">
                  <c:v>28.325405120849609</c:v>
                </c:pt>
                <c:pt idx="2986">
                  <c:v>28.341890335083008</c:v>
                </c:pt>
                <c:pt idx="2987">
                  <c:v>28.358377456665039</c:v>
                </c:pt>
                <c:pt idx="2988">
                  <c:v>28.374868392944336</c:v>
                </c:pt>
                <c:pt idx="2989">
                  <c:v>28.391363143920898</c:v>
                </c:pt>
                <c:pt idx="2990">
                  <c:v>28.407861709594727</c:v>
                </c:pt>
                <c:pt idx="2991">
                  <c:v>28.424362182617188</c:v>
                </c:pt>
                <c:pt idx="2992">
                  <c:v>28.440866470336914</c:v>
                </c:pt>
                <c:pt idx="2993">
                  <c:v>28.457374572753906</c:v>
                </c:pt>
                <c:pt idx="2994">
                  <c:v>28.473886489868164</c:v>
                </c:pt>
                <c:pt idx="2995">
                  <c:v>28.490402221679688</c:v>
                </c:pt>
                <c:pt idx="2996">
                  <c:v>28.506919860839844</c:v>
                </c:pt>
                <c:pt idx="2997">
                  <c:v>28.523443222045898</c:v>
                </c:pt>
                <c:pt idx="2998">
                  <c:v>28.539968490600586</c:v>
                </c:pt>
                <c:pt idx="2999">
                  <c:v>28.556495666503906</c:v>
                </c:pt>
              </c:numCache>
            </c:numRef>
          </c:xVal>
          <c:yVal>
            <c:numRef>
              <c:f>'[RB revised.xlsx]Graph Calculations'!$I$21:$DKR$21</c:f>
              <c:numCache>
                <c:formatCode>General</c:formatCode>
                <c:ptCount val="3000"/>
                <c:pt idx="0">
                  <c:v>70992.60791015625</c:v>
                </c:pt>
                <c:pt idx="1">
                  <c:v>70992.6845703125</c:v>
                </c:pt>
                <c:pt idx="2">
                  <c:v>70992.76123046875</c:v>
                </c:pt>
                <c:pt idx="3">
                  <c:v>70908.923828125</c:v>
                </c:pt>
                <c:pt idx="4">
                  <c:v>70810.85791015625</c:v>
                </c:pt>
                <c:pt idx="5">
                  <c:v>70684.7060546875</c:v>
                </c:pt>
                <c:pt idx="6">
                  <c:v>70533.58251953125</c:v>
                </c:pt>
                <c:pt idx="7">
                  <c:v>70376.8310546875</c:v>
                </c:pt>
                <c:pt idx="8">
                  <c:v>70222.5361328125</c:v>
                </c:pt>
                <c:pt idx="9">
                  <c:v>70067.4130859375</c:v>
                </c:pt>
                <c:pt idx="10">
                  <c:v>69905.14697265625</c:v>
                </c:pt>
                <c:pt idx="11">
                  <c:v>69731.50927734375</c:v>
                </c:pt>
                <c:pt idx="12">
                  <c:v>69558.18603515625</c:v>
                </c:pt>
                <c:pt idx="13">
                  <c:v>69389.234375</c:v>
                </c:pt>
                <c:pt idx="14">
                  <c:v>69230.25390625</c:v>
                </c:pt>
                <c:pt idx="15">
                  <c:v>69075.64501953125</c:v>
                </c:pt>
                <c:pt idx="16">
                  <c:v>68921.75048828125</c:v>
                </c:pt>
                <c:pt idx="17">
                  <c:v>68765.19873046875</c:v>
                </c:pt>
                <c:pt idx="18">
                  <c:v>68607.87548828125</c:v>
                </c:pt>
                <c:pt idx="19">
                  <c:v>68453.26611328125</c:v>
                </c:pt>
                <c:pt idx="20">
                  <c:v>68307.71435546875</c:v>
                </c:pt>
                <c:pt idx="21">
                  <c:v>68166.6201171875</c:v>
                </c:pt>
                <c:pt idx="22">
                  <c:v>68024.75390625</c:v>
                </c:pt>
                <c:pt idx="23">
                  <c:v>67888.7734375</c:v>
                </c:pt>
                <c:pt idx="24">
                  <c:v>67768.878662109375</c:v>
                </c:pt>
                <c:pt idx="25">
                  <c:v>67652.041259765625</c:v>
                </c:pt>
                <c:pt idx="26">
                  <c:v>67529.546630859375</c:v>
                </c:pt>
                <c:pt idx="27">
                  <c:v>67409.994873046875</c:v>
                </c:pt>
                <c:pt idx="28">
                  <c:v>67301.414306640625</c:v>
                </c:pt>
                <c:pt idx="29">
                  <c:v>67196.376953125</c:v>
                </c:pt>
                <c:pt idx="30">
                  <c:v>67093.139404296875</c:v>
                </c:pt>
                <c:pt idx="31">
                  <c:v>66996.644775390625</c:v>
                </c:pt>
                <c:pt idx="32">
                  <c:v>66912.378662109375</c:v>
                </c:pt>
                <c:pt idx="33">
                  <c:v>66829.91259765625</c:v>
                </c:pt>
                <c:pt idx="34">
                  <c:v>66742.38916015625</c:v>
                </c:pt>
                <c:pt idx="35">
                  <c:v>66649.89453125</c:v>
                </c:pt>
                <c:pt idx="36">
                  <c:v>66565.05712890625</c:v>
                </c:pt>
                <c:pt idx="37">
                  <c:v>66497.07666015625</c:v>
                </c:pt>
                <c:pt idx="38">
                  <c:v>66448.324951171875</c:v>
                </c:pt>
                <c:pt idx="39">
                  <c:v>66404.373046875</c:v>
                </c:pt>
                <c:pt idx="40">
                  <c:v>66346.64990234375</c:v>
                </c:pt>
                <c:pt idx="41">
                  <c:v>66272.012451171875</c:v>
                </c:pt>
                <c:pt idx="42">
                  <c:v>66199.4033203125</c:v>
                </c:pt>
                <c:pt idx="43">
                  <c:v>66143.537353515625</c:v>
                </c:pt>
                <c:pt idx="44">
                  <c:v>66098.5283203125</c:v>
                </c:pt>
                <c:pt idx="45">
                  <c:v>66049.14794921875</c:v>
                </c:pt>
                <c:pt idx="46">
                  <c:v>65987.796142578125</c:v>
                </c:pt>
                <c:pt idx="47">
                  <c:v>65919.987182617188</c:v>
                </c:pt>
                <c:pt idx="48">
                  <c:v>65852.292602539063</c:v>
                </c:pt>
                <c:pt idx="49">
                  <c:v>65793.826538085938</c:v>
                </c:pt>
                <c:pt idx="50">
                  <c:v>65750.760375976563</c:v>
                </c:pt>
                <c:pt idx="51">
                  <c:v>65713.437133789063</c:v>
                </c:pt>
                <c:pt idx="52">
                  <c:v>65669.42822265625</c:v>
                </c:pt>
                <c:pt idx="53">
                  <c:v>65622.476440429688</c:v>
                </c:pt>
                <c:pt idx="54">
                  <c:v>65592.096069335938</c:v>
                </c:pt>
                <c:pt idx="55">
                  <c:v>65572.829956054688</c:v>
                </c:pt>
                <c:pt idx="56">
                  <c:v>65548.649536132813</c:v>
                </c:pt>
                <c:pt idx="57">
                  <c:v>65515.954956054688</c:v>
                </c:pt>
                <c:pt idx="58">
                  <c:v>65483.288818359375</c:v>
                </c:pt>
                <c:pt idx="59">
                  <c:v>65453.394165039063</c:v>
                </c:pt>
                <c:pt idx="60">
                  <c:v>65431.642333984375</c:v>
                </c:pt>
                <c:pt idx="61">
                  <c:v>65415.747680664063</c:v>
                </c:pt>
                <c:pt idx="62">
                  <c:v>65389.281616210938</c:v>
                </c:pt>
                <c:pt idx="63">
                  <c:v>65351.129760742188</c:v>
                </c:pt>
                <c:pt idx="64">
                  <c:v>65317.549438476563</c:v>
                </c:pt>
                <c:pt idx="65">
                  <c:v>65292.540405273438</c:v>
                </c:pt>
                <c:pt idx="66">
                  <c:v>65269.702880859375</c:v>
                </c:pt>
                <c:pt idx="67">
                  <c:v>65257.608276367188</c:v>
                </c:pt>
                <c:pt idx="68">
                  <c:v>65254.342163085938</c:v>
                </c:pt>
                <c:pt idx="69">
                  <c:v>65242.961791992188</c:v>
                </c:pt>
                <c:pt idx="70">
                  <c:v>65213.467163085938</c:v>
                </c:pt>
                <c:pt idx="71">
                  <c:v>65185.943969726563</c:v>
                </c:pt>
                <c:pt idx="72">
                  <c:v>65166.477783203125</c:v>
                </c:pt>
                <c:pt idx="73">
                  <c:v>65150.240356445313</c:v>
                </c:pt>
                <c:pt idx="74">
                  <c:v>65126.345581054688</c:v>
                </c:pt>
                <c:pt idx="75">
                  <c:v>65102.651000976563</c:v>
                </c:pt>
                <c:pt idx="76">
                  <c:v>65086.670654296875</c:v>
                </c:pt>
                <c:pt idx="77">
                  <c:v>65075.861694335938</c:v>
                </c:pt>
                <c:pt idx="78">
                  <c:v>65066.424072265625</c:v>
                </c:pt>
                <c:pt idx="79">
                  <c:v>65053.643798828125</c:v>
                </c:pt>
                <c:pt idx="80">
                  <c:v>65036.891967773438</c:v>
                </c:pt>
                <c:pt idx="81">
                  <c:v>65017.397277832031</c:v>
                </c:pt>
                <c:pt idx="82">
                  <c:v>65001.6455078125</c:v>
                </c:pt>
                <c:pt idx="83">
                  <c:v>64988.37939453125</c:v>
                </c:pt>
                <c:pt idx="84">
                  <c:v>64974.084716796875</c:v>
                </c:pt>
                <c:pt idx="85">
                  <c:v>64963.247192382813</c:v>
                </c:pt>
                <c:pt idx="86">
                  <c:v>64955.181091308594</c:v>
                </c:pt>
                <c:pt idx="87">
                  <c:v>64947.743591308594</c:v>
                </c:pt>
                <c:pt idx="88">
                  <c:v>64939.7060546875</c:v>
                </c:pt>
                <c:pt idx="89">
                  <c:v>64929.354248046875</c:v>
                </c:pt>
                <c:pt idx="90">
                  <c:v>64909.402465820313</c:v>
                </c:pt>
                <c:pt idx="91">
                  <c:v>64882.45068359375</c:v>
                </c:pt>
                <c:pt idx="92">
                  <c:v>64860.813171386719</c:v>
                </c:pt>
                <c:pt idx="93">
                  <c:v>64850.889892578125</c:v>
                </c:pt>
                <c:pt idx="94">
                  <c:v>64850.852416992188</c:v>
                </c:pt>
                <c:pt idx="95">
                  <c:v>64857.957702636719</c:v>
                </c:pt>
                <c:pt idx="96">
                  <c:v>64861.377380371094</c:v>
                </c:pt>
                <c:pt idx="97">
                  <c:v>64854.625549316406</c:v>
                </c:pt>
                <c:pt idx="98">
                  <c:v>64836.930908203125</c:v>
                </c:pt>
                <c:pt idx="99">
                  <c:v>64818.207641601563</c:v>
                </c:pt>
                <c:pt idx="100">
                  <c:v>64809.827270507813</c:v>
                </c:pt>
                <c:pt idx="101">
                  <c:v>64815.589782714844</c:v>
                </c:pt>
                <c:pt idx="102">
                  <c:v>64816.609375</c:v>
                </c:pt>
                <c:pt idx="103">
                  <c:v>64794.571838378906</c:v>
                </c:pt>
                <c:pt idx="104">
                  <c:v>64766.277221679688</c:v>
                </c:pt>
                <c:pt idx="105">
                  <c:v>64754.268249511719</c:v>
                </c:pt>
                <c:pt idx="106">
                  <c:v>64763.773559570313</c:v>
                </c:pt>
                <c:pt idx="107">
                  <c:v>64780.82177734375</c:v>
                </c:pt>
                <c:pt idx="108">
                  <c:v>64788.584289550781</c:v>
                </c:pt>
                <c:pt idx="109">
                  <c:v>64781.00390625</c:v>
                </c:pt>
                <c:pt idx="110">
                  <c:v>64769.394958496094</c:v>
                </c:pt>
                <c:pt idx="111">
                  <c:v>64756.643127441406</c:v>
                </c:pt>
                <c:pt idx="112">
                  <c:v>64731.805603027344</c:v>
                </c:pt>
                <c:pt idx="113">
                  <c:v>64704.082397460938</c:v>
                </c:pt>
                <c:pt idx="114">
                  <c:v>64695.21630859375</c:v>
                </c:pt>
                <c:pt idx="115">
                  <c:v>64707.178771972656</c:v>
                </c:pt>
                <c:pt idx="116">
                  <c:v>64720.598388671875</c:v>
                </c:pt>
                <c:pt idx="117">
                  <c:v>64720.275146484375</c:v>
                </c:pt>
                <c:pt idx="118">
                  <c:v>64707.466186523438</c:v>
                </c:pt>
                <c:pt idx="119">
                  <c:v>64694.885803222656</c:v>
                </c:pt>
                <c:pt idx="120">
                  <c:v>64688.191162109375</c:v>
                </c:pt>
                <c:pt idx="121">
                  <c:v>64682.496520996094</c:v>
                </c:pt>
                <c:pt idx="122">
                  <c:v>64678.773254394531</c:v>
                </c:pt>
                <c:pt idx="123">
                  <c:v>64679.535766601563</c:v>
                </c:pt>
                <c:pt idx="124">
                  <c:v>64679.383972167969</c:v>
                </c:pt>
                <c:pt idx="125">
                  <c:v>64672.289306640625</c:v>
                </c:pt>
                <c:pt idx="126">
                  <c:v>64658.794616699219</c:v>
                </c:pt>
                <c:pt idx="127">
                  <c:v>64638.328552246094</c:v>
                </c:pt>
                <c:pt idx="128">
                  <c:v>64616.976745605469</c:v>
                </c:pt>
                <c:pt idx="129">
                  <c:v>64604.482055664063</c:v>
                </c:pt>
                <c:pt idx="130">
                  <c:v>64601.558837890625</c:v>
                </c:pt>
                <c:pt idx="131">
                  <c:v>64597.635620117188</c:v>
                </c:pt>
                <c:pt idx="132">
                  <c:v>64591.540954589844</c:v>
                </c:pt>
                <c:pt idx="133">
                  <c:v>64592.274841308594</c:v>
                </c:pt>
                <c:pt idx="134">
                  <c:v>64598.008728027344</c:v>
                </c:pt>
                <c:pt idx="135">
                  <c:v>64604.885498046875</c:v>
                </c:pt>
                <c:pt idx="136">
                  <c:v>64607.019409179688</c:v>
                </c:pt>
                <c:pt idx="137">
                  <c:v>64595.696166992188</c:v>
                </c:pt>
                <c:pt idx="138">
                  <c:v>64575.887268066406</c:v>
                </c:pt>
                <c:pt idx="139">
                  <c:v>64571.792602539063</c:v>
                </c:pt>
                <c:pt idx="140">
                  <c:v>64587.212219238281</c:v>
                </c:pt>
                <c:pt idx="141">
                  <c:v>64599.74609375</c:v>
                </c:pt>
                <c:pt idx="142">
                  <c:v>64595.165710449219</c:v>
                </c:pt>
                <c:pt idx="143">
                  <c:v>64581.528198242188</c:v>
                </c:pt>
                <c:pt idx="144">
                  <c:v>64571.719299316406</c:v>
                </c:pt>
                <c:pt idx="145">
                  <c:v>64569.053161621094</c:v>
                </c:pt>
                <c:pt idx="146">
                  <c:v>64567.815673828125</c:v>
                </c:pt>
                <c:pt idx="147">
                  <c:v>64563.578125</c:v>
                </c:pt>
                <c:pt idx="148">
                  <c:v>64558.312072753906</c:v>
                </c:pt>
                <c:pt idx="149">
                  <c:v>64552.474548339844</c:v>
                </c:pt>
                <c:pt idx="150">
                  <c:v>64544.036987304688</c:v>
                </c:pt>
                <c:pt idx="151">
                  <c:v>64530.056640625</c:v>
                </c:pt>
                <c:pt idx="152">
                  <c:v>64525.79052734375</c:v>
                </c:pt>
                <c:pt idx="153">
                  <c:v>64535.981567382813</c:v>
                </c:pt>
                <c:pt idx="154">
                  <c:v>64542.401245117188</c:v>
                </c:pt>
                <c:pt idx="155">
                  <c:v>64528.220825195313</c:v>
                </c:pt>
                <c:pt idx="156">
                  <c:v>64510.469024658203</c:v>
                </c:pt>
                <c:pt idx="157">
                  <c:v>64509.545806884766</c:v>
                </c:pt>
                <c:pt idx="158">
                  <c:v>64519.193969726563</c:v>
                </c:pt>
                <c:pt idx="159">
                  <c:v>64527.327880859375</c:v>
                </c:pt>
                <c:pt idx="160">
                  <c:v>64526.97607421875</c:v>
                </c:pt>
                <c:pt idx="161">
                  <c:v>64519.53857421875</c:v>
                </c:pt>
                <c:pt idx="162">
                  <c:v>64508.815338134766</c:v>
                </c:pt>
                <c:pt idx="163">
                  <c:v>64503.749267578125</c:v>
                </c:pt>
                <c:pt idx="164">
                  <c:v>64509.568878173828</c:v>
                </c:pt>
                <c:pt idx="165">
                  <c:v>64513.674194335938</c:v>
                </c:pt>
                <c:pt idx="166">
                  <c:v>64510.836700439453</c:v>
                </c:pt>
                <c:pt idx="167">
                  <c:v>64508.227752685547</c:v>
                </c:pt>
                <c:pt idx="168">
                  <c:v>64508.847381591797</c:v>
                </c:pt>
                <c:pt idx="169">
                  <c:v>64509.409851074219</c:v>
                </c:pt>
                <c:pt idx="170">
                  <c:v>64508.972351074219</c:v>
                </c:pt>
                <c:pt idx="171">
                  <c:v>64511.106231689453</c:v>
                </c:pt>
                <c:pt idx="172">
                  <c:v>64506.268737792969</c:v>
                </c:pt>
                <c:pt idx="173">
                  <c:v>64492.802642822266</c:v>
                </c:pt>
                <c:pt idx="174">
                  <c:v>64478.87939453125</c:v>
                </c:pt>
                <c:pt idx="175">
                  <c:v>64472.784729003906</c:v>
                </c:pt>
                <c:pt idx="176">
                  <c:v>64467.890075683594</c:v>
                </c:pt>
                <c:pt idx="177">
                  <c:v>64463.452545166016</c:v>
                </c:pt>
                <c:pt idx="178">
                  <c:v>64467.47216796875</c:v>
                </c:pt>
                <c:pt idx="179">
                  <c:v>64475.977508544922</c:v>
                </c:pt>
                <c:pt idx="180">
                  <c:v>64469.682861328125</c:v>
                </c:pt>
                <c:pt idx="181">
                  <c:v>64453.502471923828</c:v>
                </c:pt>
                <c:pt idx="182">
                  <c:v>64449.322113037109</c:v>
                </c:pt>
                <c:pt idx="183">
                  <c:v>64463.884582519531</c:v>
                </c:pt>
                <c:pt idx="184">
                  <c:v>64479.704193115234</c:v>
                </c:pt>
                <c:pt idx="185">
                  <c:v>64484.838104248047</c:v>
                </c:pt>
                <c:pt idx="186">
                  <c:v>64477.6005859375</c:v>
                </c:pt>
                <c:pt idx="187">
                  <c:v>64464.077362060547</c:v>
                </c:pt>
                <c:pt idx="188">
                  <c:v>64453.754119873047</c:v>
                </c:pt>
                <c:pt idx="189">
                  <c:v>64452.859466552734</c:v>
                </c:pt>
                <c:pt idx="190">
                  <c:v>64458.479095458984</c:v>
                </c:pt>
                <c:pt idx="191">
                  <c:v>64460.298706054688</c:v>
                </c:pt>
                <c:pt idx="192">
                  <c:v>64456.718322753906</c:v>
                </c:pt>
                <c:pt idx="193">
                  <c:v>64451.795104980469</c:v>
                </c:pt>
                <c:pt idx="194">
                  <c:v>64448.128997802734</c:v>
                </c:pt>
                <c:pt idx="195">
                  <c:v>64443.605773925781</c:v>
                </c:pt>
                <c:pt idx="196">
                  <c:v>64439.911102294922</c:v>
                </c:pt>
                <c:pt idx="197">
                  <c:v>64444.530731201172</c:v>
                </c:pt>
                <c:pt idx="198">
                  <c:v>64454.721801757813</c:v>
                </c:pt>
                <c:pt idx="199">
                  <c:v>64461.284271240234</c:v>
                </c:pt>
                <c:pt idx="200">
                  <c:v>64453.675323486328</c:v>
                </c:pt>
                <c:pt idx="201">
                  <c:v>64438.094940185547</c:v>
                </c:pt>
                <c:pt idx="202">
                  <c:v>64428.000274658203</c:v>
                </c:pt>
                <c:pt idx="203">
                  <c:v>64424.219909667969</c:v>
                </c:pt>
                <c:pt idx="204">
                  <c:v>64420.039520263672</c:v>
                </c:pt>
                <c:pt idx="205">
                  <c:v>64415.602020263672</c:v>
                </c:pt>
                <c:pt idx="206">
                  <c:v>64423.021636962891</c:v>
                </c:pt>
                <c:pt idx="207">
                  <c:v>64434.412689208984</c:v>
                </c:pt>
                <c:pt idx="208">
                  <c:v>64437.575164794922</c:v>
                </c:pt>
                <c:pt idx="209">
                  <c:v>64429.623352050781</c:v>
                </c:pt>
                <c:pt idx="210">
                  <c:v>64418.528686523438</c:v>
                </c:pt>
                <c:pt idx="211">
                  <c:v>64406.891174316406</c:v>
                </c:pt>
                <c:pt idx="212">
                  <c:v>64404.510803222656</c:v>
                </c:pt>
                <c:pt idx="213">
                  <c:v>64409.787567138672</c:v>
                </c:pt>
                <c:pt idx="214">
                  <c:v>64409.007202148438</c:v>
                </c:pt>
                <c:pt idx="215">
                  <c:v>64398.683959960938</c:v>
                </c:pt>
                <c:pt idx="216">
                  <c:v>64392.189300537109</c:v>
                </c:pt>
                <c:pt idx="217">
                  <c:v>64393.4375</c:v>
                </c:pt>
                <c:pt idx="218">
                  <c:v>64400.742828369141</c:v>
                </c:pt>
                <c:pt idx="219">
                  <c:v>64405.162445068359</c:v>
                </c:pt>
                <c:pt idx="220">
                  <c:v>64400.924926757813</c:v>
                </c:pt>
                <c:pt idx="221">
                  <c:v>64397.773132324219</c:v>
                </c:pt>
                <c:pt idx="222">
                  <c:v>64403.849884033203</c:v>
                </c:pt>
                <c:pt idx="223">
                  <c:v>64409.298095703125</c:v>
                </c:pt>
                <c:pt idx="224">
                  <c:v>64404.489135742188</c:v>
                </c:pt>
                <c:pt idx="225">
                  <c:v>64394.708770751953</c:v>
                </c:pt>
                <c:pt idx="226">
                  <c:v>64387.328399658203</c:v>
                </c:pt>
                <c:pt idx="227">
                  <c:v>64386.976593017578</c:v>
                </c:pt>
                <c:pt idx="228">
                  <c:v>64391.767639160156</c:v>
                </c:pt>
                <c:pt idx="229">
                  <c:v>64393.930114746094</c:v>
                </c:pt>
                <c:pt idx="230">
                  <c:v>64391.292602539063</c:v>
                </c:pt>
                <c:pt idx="231">
                  <c:v>64383.712219238281</c:v>
                </c:pt>
                <c:pt idx="232">
                  <c:v>64380.531829833984</c:v>
                </c:pt>
                <c:pt idx="233">
                  <c:v>64381.351470947266</c:v>
                </c:pt>
                <c:pt idx="234">
                  <c:v>64382.742523193359</c:v>
                </c:pt>
                <c:pt idx="235">
                  <c:v>64379.933563232422</c:v>
                </c:pt>
                <c:pt idx="236">
                  <c:v>64378.296051025391</c:v>
                </c:pt>
                <c:pt idx="237">
                  <c:v>64380.944244384766</c:v>
                </c:pt>
                <c:pt idx="238">
                  <c:v>64381.563873291016</c:v>
                </c:pt>
                <c:pt idx="239">
                  <c:v>64380.183502197266</c:v>
                </c:pt>
                <c:pt idx="240">
                  <c:v>64375.517395019531</c:v>
                </c:pt>
                <c:pt idx="241">
                  <c:v>64371.965606689453</c:v>
                </c:pt>
                <c:pt idx="242">
                  <c:v>64365.585235595703</c:v>
                </c:pt>
                <c:pt idx="243">
                  <c:v>64359.204833984375</c:v>
                </c:pt>
                <c:pt idx="244">
                  <c:v>64355.595886230469</c:v>
                </c:pt>
                <c:pt idx="245">
                  <c:v>64358.929809570313</c:v>
                </c:pt>
                <c:pt idx="246">
                  <c:v>64372.492279052734</c:v>
                </c:pt>
                <c:pt idx="247">
                  <c:v>64385.483337402344</c:v>
                </c:pt>
                <c:pt idx="248">
                  <c:v>64384.045806884766</c:v>
                </c:pt>
                <c:pt idx="249">
                  <c:v>64368.179718017578</c:v>
                </c:pt>
                <c:pt idx="250">
                  <c:v>64357.285064697266</c:v>
                </c:pt>
                <c:pt idx="251">
                  <c:v>64353.733245849609</c:v>
                </c:pt>
                <c:pt idx="252">
                  <c:v>64353.495727539063</c:v>
                </c:pt>
                <c:pt idx="253">
                  <c:v>64355.143920898438</c:v>
                </c:pt>
                <c:pt idx="254">
                  <c:v>64358.506408691406</c:v>
                </c:pt>
                <c:pt idx="255">
                  <c:v>64353.211761474609</c:v>
                </c:pt>
                <c:pt idx="256">
                  <c:v>64345.117095947266</c:v>
                </c:pt>
                <c:pt idx="257">
                  <c:v>64342.222442626953</c:v>
                </c:pt>
                <c:pt idx="258">
                  <c:v>64347.699188232422</c:v>
                </c:pt>
                <c:pt idx="259">
                  <c:v>64352.404541015625</c:v>
                </c:pt>
                <c:pt idx="260">
                  <c:v>64350.938446044922</c:v>
                </c:pt>
                <c:pt idx="261">
                  <c:v>64345.215209960938</c:v>
                </c:pt>
                <c:pt idx="262">
                  <c:v>64342.491973876953</c:v>
                </c:pt>
                <c:pt idx="263">
                  <c:v>64340.825897216797</c:v>
                </c:pt>
                <c:pt idx="264">
                  <c:v>64335.074066162109</c:v>
                </c:pt>
                <c:pt idx="265">
                  <c:v>64332.179412841797</c:v>
                </c:pt>
                <c:pt idx="266">
                  <c:v>64333.370452880859</c:v>
                </c:pt>
                <c:pt idx="267">
                  <c:v>64338.190093994141</c:v>
                </c:pt>
                <c:pt idx="268">
                  <c:v>64344.23828125</c:v>
                </c:pt>
                <c:pt idx="269">
                  <c:v>64353.029327392578</c:v>
                </c:pt>
                <c:pt idx="270">
                  <c:v>64358.791809082031</c:v>
                </c:pt>
                <c:pt idx="271">
                  <c:v>64352.468597412109</c:v>
                </c:pt>
                <c:pt idx="272">
                  <c:v>64335.659637451172</c:v>
                </c:pt>
                <c:pt idx="273">
                  <c:v>64319.336395263672</c:v>
                </c:pt>
                <c:pt idx="274">
                  <c:v>64314.298889160156</c:v>
                </c:pt>
                <c:pt idx="275">
                  <c:v>64317.861358642578</c:v>
                </c:pt>
                <c:pt idx="276">
                  <c:v>64322.223846435547</c:v>
                </c:pt>
                <c:pt idx="277">
                  <c:v>64326.700622558594</c:v>
                </c:pt>
                <c:pt idx="278">
                  <c:v>64327.577362060547</c:v>
                </c:pt>
                <c:pt idx="279">
                  <c:v>64327.711273193359</c:v>
                </c:pt>
                <c:pt idx="280">
                  <c:v>64326.559478759766</c:v>
                </c:pt>
                <c:pt idx="281">
                  <c:v>64324.121948242188</c:v>
                </c:pt>
                <c:pt idx="282">
                  <c:v>64323.341583251953</c:v>
                </c:pt>
                <c:pt idx="283">
                  <c:v>64324.989776611328</c:v>
                </c:pt>
                <c:pt idx="284">
                  <c:v>64326.209411621094</c:v>
                </c:pt>
                <c:pt idx="285">
                  <c:v>64321.943298339844</c:v>
                </c:pt>
                <c:pt idx="286">
                  <c:v>64316.477233886719</c:v>
                </c:pt>
                <c:pt idx="287">
                  <c:v>64315.239715576172</c:v>
                </c:pt>
                <c:pt idx="288">
                  <c:v>64319.916473388672</c:v>
                </c:pt>
                <c:pt idx="289">
                  <c:v>64330.050384521484</c:v>
                </c:pt>
                <c:pt idx="290">
                  <c:v>64337.412872314453</c:v>
                </c:pt>
                <c:pt idx="291">
                  <c:v>64341.203918457031</c:v>
                </c:pt>
                <c:pt idx="292">
                  <c:v>64339.337829589844</c:v>
                </c:pt>
                <c:pt idx="293">
                  <c:v>64321.614593505859</c:v>
                </c:pt>
                <c:pt idx="294">
                  <c:v>64281.177062988281</c:v>
                </c:pt>
                <c:pt idx="295">
                  <c:v>64238.253829956055</c:v>
                </c:pt>
                <c:pt idx="296">
                  <c:v>64215.787734985352</c:v>
                </c:pt>
                <c:pt idx="297">
                  <c:v>64216.950225830078</c:v>
                </c:pt>
                <c:pt idx="298">
                  <c:v>64218.541275024414</c:v>
                </c:pt>
                <c:pt idx="299">
                  <c:v>64205.989471435547</c:v>
                </c:pt>
                <c:pt idx="300">
                  <c:v>64186.009094238281</c:v>
                </c:pt>
                <c:pt idx="301">
                  <c:v>64181.371566772461</c:v>
                </c:pt>
                <c:pt idx="302">
                  <c:v>64195.562622070313</c:v>
                </c:pt>
                <c:pt idx="303">
                  <c:v>64209.439392089844</c:v>
                </c:pt>
                <c:pt idx="304">
                  <c:v>64208.973297119141</c:v>
                </c:pt>
                <c:pt idx="305">
                  <c:v>64199.535781860352</c:v>
                </c:pt>
                <c:pt idx="306">
                  <c:v>64199.755401611328</c:v>
                </c:pt>
                <c:pt idx="307">
                  <c:v>64211.2607421875</c:v>
                </c:pt>
                <c:pt idx="308">
                  <c:v>64220.508941650391</c:v>
                </c:pt>
                <c:pt idx="309">
                  <c:v>64220.299987792969</c:v>
                </c:pt>
                <c:pt idx="310">
                  <c:v>64219.719604492188</c:v>
                </c:pt>
                <c:pt idx="311">
                  <c:v>64218.967803955078</c:v>
                </c:pt>
                <c:pt idx="312">
                  <c:v>64215.558853149414</c:v>
                </c:pt>
                <c:pt idx="313">
                  <c:v>64213.349914550781</c:v>
                </c:pt>
                <c:pt idx="314">
                  <c:v>64209.283813476563</c:v>
                </c:pt>
                <c:pt idx="315">
                  <c:v>64193.646301269531</c:v>
                </c:pt>
                <c:pt idx="316">
                  <c:v>64174.323059082031</c:v>
                </c:pt>
                <c:pt idx="317">
                  <c:v>64169.399826049805</c:v>
                </c:pt>
                <c:pt idx="318">
                  <c:v>64180.019454956055</c:v>
                </c:pt>
                <c:pt idx="319">
                  <c:v>64199.124786376953</c:v>
                </c:pt>
                <c:pt idx="320">
                  <c:v>64214.401565551758</c:v>
                </c:pt>
                <c:pt idx="321">
                  <c:v>64214.2783203125</c:v>
                </c:pt>
                <c:pt idx="322">
                  <c:v>64200.955093383789</c:v>
                </c:pt>
                <c:pt idx="323">
                  <c:v>64192.488998413086</c:v>
                </c:pt>
                <c:pt idx="324">
                  <c:v>64194.165771484375</c:v>
                </c:pt>
                <c:pt idx="325">
                  <c:v>64201.556823730469</c:v>
                </c:pt>
                <c:pt idx="326">
                  <c:v>64201.462158203125</c:v>
                </c:pt>
                <c:pt idx="327">
                  <c:v>64191.853210449219</c:v>
                </c:pt>
                <c:pt idx="328">
                  <c:v>64189.244262695313</c:v>
                </c:pt>
                <c:pt idx="329">
                  <c:v>64201.09245300293</c:v>
                </c:pt>
                <c:pt idx="330">
                  <c:v>64210.312072753906</c:v>
                </c:pt>
                <c:pt idx="331">
                  <c:v>64203.845993041992</c:v>
                </c:pt>
                <c:pt idx="332">
                  <c:v>64191.551330566406</c:v>
                </c:pt>
                <c:pt idx="333">
                  <c:v>64181.542373657227</c:v>
                </c:pt>
                <c:pt idx="334">
                  <c:v>64178.561996459961</c:v>
                </c:pt>
                <c:pt idx="335">
                  <c:v>64180.495910644531</c:v>
                </c:pt>
                <c:pt idx="336">
                  <c:v>64182.372680664063</c:v>
                </c:pt>
                <c:pt idx="337">
                  <c:v>64184.420867919922</c:v>
                </c:pt>
                <c:pt idx="338">
                  <c:v>64188.611923217773</c:v>
                </c:pt>
                <c:pt idx="339">
                  <c:v>64188.888687133789</c:v>
                </c:pt>
                <c:pt idx="340">
                  <c:v>64186.394027709961</c:v>
                </c:pt>
                <c:pt idx="341">
                  <c:v>64187.642227172852</c:v>
                </c:pt>
                <c:pt idx="342">
                  <c:v>64195.06184387207</c:v>
                </c:pt>
                <c:pt idx="343">
                  <c:v>64201.910034179688</c:v>
                </c:pt>
                <c:pt idx="344">
                  <c:v>64199.072525024414</c:v>
                </c:pt>
                <c:pt idx="345">
                  <c:v>64189.149291992188</c:v>
                </c:pt>
                <c:pt idx="346">
                  <c:v>64182.368911743164</c:v>
                </c:pt>
                <c:pt idx="347">
                  <c:v>64177.27424621582</c:v>
                </c:pt>
                <c:pt idx="348">
                  <c:v>64169.351013183594</c:v>
                </c:pt>
                <c:pt idx="349">
                  <c:v>64163.770629882813</c:v>
                </c:pt>
                <c:pt idx="350">
                  <c:v>64168.418838500977</c:v>
                </c:pt>
                <c:pt idx="351">
                  <c:v>64175.924163818359</c:v>
                </c:pt>
                <c:pt idx="352">
                  <c:v>64181.429504394531</c:v>
                </c:pt>
                <c:pt idx="353">
                  <c:v>64183.10627746582</c:v>
                </c:pt>
                <c:pt idx="354">
                  <c:v>64183.040176391602</c:v>
                </c:pt>
                <c:pt idx="355">
                  <c:v>64182.488372802734</c:v>
                </c:pt>
                <c:pt idx="356">
                  <c:v>64181.307998657227</c:v>
                </c:pt>
                <c:pt idx="357">
                  <c:v>64182.099044799805</c:v>
                </c:pt>
                <c:pt idx="358">
                  <c:v>64179.432968139648</c:v>
                </c:pt>
                <c:pt idx="359">
                  <c:v>64175.138305664063</c:v>
                </c:pt>
                <c:pt idx="360">
                  <c:v>64168.843643188477</c:v>
                </c:pt>
                <c:pt idx="361">
                  <c:v>64162.863265991211</c:v>
                </c:pt>
                <c:pt idx="362">
                  <c:v>64158.225738525391</c:v>
                </c:pt>
                <c:pt idx="363">
                  <c:v>64155.445358276367</c:v>
                </c:pt>
                <c:pt idx="364">
                  <c:v>64153.379272460938</c:v>
                </c:pt>
                <c:pt idx="365">
                  <c:v>64149.913177490234</c:v>
                </c:pt>
                <c:pt idx="366">
                  <c:v>64151.161376953125</c:v>
                </c:pt>
                <c:pt idx="367">
                  <c:v>64151.895278930664</c:v>
                </c:pt>
                <c:pt idx="368">
                  <c:v>64145.200622558594</c:v>
                </c:pt>
                <c:pt idx="369">
                  <c:v>64133.877395629883</c:v>
                </c:pt>
                <c:pt idx="370">
                  <c:v>64128.782730102539</c:v>
                </c:pt>
                <c:pt idx="371">
                  <c:v>64133.602355957031</c:v>
                </c:pt>
                <c:pt idx="372">
                  <c:v>64147.793395996094</c:v>
                </c:pt>
                <c:pt idx="373">
                  <c:v>64161.698745727539</c:v>
                </c:pt>
                <c:pt idx="374">
                  <c:v>64164.546936035156</c:v>
                </c:pt>
                <c:pt idx="375">
                  <c:v>64158.309417724609</c:v>
                </c:pt>
                <c:pt idx="376">
                  <c:v>64147.843322753906</c:v>
                </c:pt>
                <c:pt idx="377">
                  <c:v>64132.520095825195</c:v>
                </c:pt>
                <c:pt idx="378">
                  <c:v>64120.911140441895</c:v>
                </c:pt>
                <c:pt idx="379">
                  <c:v>64122.759338378906</c:v>
                </c:pt>
                <c:pt idx="380">
                  <c:v>64132.750396728516</c:v>
                </c:pt>
                <c:pt idx="381">
                  <c:v>64143.255722045898</c:v>
                </c:pt>
                <c:pt idx="382">
                  <c:v>64154.589630126953</c:v>
                </c:pt>
                <c:pt idx="383">
                  <c:v>64161.237838745117</c:v>
                </c:pt>
                <c:pt idx="384">
                  <c:v>64155.7431640625</c:v>
                </c:pt>
                <c:pt idx="385">
                  <c:v>64145.877075195313</c:v>
                </c:pt>
                <c:pt idx="386">
                  <c:v>64142.525268554688</c:v>
                </c:pt>
                <c:pt idx="387">
                  <c:v>64145.030609130859</c:v>
                </c:pt>
                <c:pt idx="388">
                  <c:v>64148.421661376953</c:v>
                </c:pt>
                <c:pt idx="389">
                  <c:v>64152.584136962891</c:v>
                </c:pt>
                <c:pt idx="390">
                  <c:v>64157.546630859375</c:v>
                </c:pt>
                <c:pt idx="391">
                  <c:v>64153.737670898438</c:v>
                </c:pt>
                <c:pt idx="392">
                  <c:v>64141.071578979492</c:v>
                </c:pt>
                <c:pt idx="393">
                  <c:v>64132.519775390625</c:v>
                </c:pt>
                <c:pt idx="394">
                  <c:v>64131.453689575195</c:v>
                </c:pt>
                <c:pt idx="395">
                  <c:v>64133.730453491211</c:v>
                </c:pt>
                <c:pt idx="396">
                  <c:v>64136.778656005859</c:v>
                </c:pt>
                <c:pt idx="397">
                  <c:v>64139.969696044922</c:v>
                </c:pt>
                <c:pt idx="398">
                  <c:v>64137.075042724609</c:v>
                </c:pt>
                <c:pt idx="399">
                  <c:v>64133.551803588867</c:v>
                </c:pt>
                <c:pt idx="400">
                  <c:v>64135.571426391602</c:v>
                </c:pt>
                <c:pt idx="401">
                  <c:v>64137.019622802734</c:v>
                </c:pt>
                <c:pt idx="402">
                  <c:v>64130.29638671875</c:v>
                </c:pt>
                <c:pt idx="403">
                  <c:v>64124.373153686523</c:v>
                </c:pt>
                <c:pt idx="404">
                  <c:v>64127.535636901855</c:v>
                </c:pt>
                <c:pt idx="405">
                  <c:v>64134.669540405273</c:v>
                </c:pt>
                <c:pt idx="406">
                  <c:v>64139.232025146484</c:v>
                </c:pt>
                <c:pt idx="407">
                  <c:v>64142.19450378418</c:v>
                </c:pt>
                <c:pt idx="408">
                  <c:v>64142.414123535156</c:v>
                </c:pt>
                <c:pt idx="409">
                  <c:v>64136.176605224609</c:v>
                </c:pt>
                <c:pt idx="410">
                  <c:v>64125.73908996582</c:v>
                </c:pt>
                <c:pt idx="411">
                  <c:v>64123.587287902832</c:v>
                </c:pt>
                <c:pt idx="412">
                  <c:v>64132.978332519531</c:v>
                </c:pt>
                <c:pt idx="413">
                  <c:v>64143.626525878906</c:v>
                </c:pt>
                <c:pt idx="414">
                  <c:v>64137.074722290039</c:v>
                </c:pt>
                <c:pt idx="415">
                  <c:v>64119.29434967041</c:v>
                </c:pt>
                <c:pt idx="416">
                  <c:v>64104.713973999023</c:v>
                </c:pt>
                <c:pt idx="417">
                  <c:v>64105.419311523438</c:v>
                </c:pt>
                <c:pt idx="418">
                  <c:v>64114.924652099609</c:v>
                </c:pt>
                <c:pt idx="419">
                  <c:v>64125.687126159668</c:v>
                </c:pt>
                <c:pt idx="420">
                  <c:v>64132.878189086914</c:v>
                </c:pt>
                <c:pt idx="421">
                  <c:v>64135.897811889648</c:v>
                </c:pt>
                <c:pt idx="422">
                  <c:v>64137.803146362305</c:v>
                </c:pt>
                <c:pt idx="423">
                  <c:v>64139.994201660156</c:v>
                </c:pt>
                <c:pt idx="424">
                  <c:v>64143.75666809082</c:v>
                </c:pt>
                <c:pt idx="425">
                  <c:v>64144.233444213867</c:v>
                </c:pt>
                <c:pt idx="426">
                  <c:v>64137.938781738281</c:v>
                </c:pt>
                <c:pt idx="427">
                  <c:v>64132.329833984375</c:v>
                </c:pt>
                <c:pt idx="428">
                  <c:v>64129.749450683594</c:v>
                </c:pt>
                <c:pt idx="429">
                  <c:v>64124.911933898926</c:v>
                </c:pt>
                <c:pt idx="430">
                  <c:v>64119.560127258301</c:v>
                </c:pt>
                <c:pt idx="431">
                  <c:v>64124.036895751953</c:v>
                </c:pt>
                <c:pt idx="432">
                  <c:v>64131.456512451172</c:v>
                </c:pt>
                <c:pt idx="433">
                  <c:v>64129.1904296875</c:v>
                </c:pt>
                <c:pt idx="434">
                  <c:v>64126.352912902832</c:v>
                </c:pt>
                <c:pt idx="435">
                  <c:v>64127.17253112793</c:v>
                </c:pt>
                <c:pt idx="436">
                  <c:v>64129.706436157227</c:v>
                </c:pt>
                <c:pt idx="437">
                  <c:v>64133.354629516602</c:v>
                </c:pt>
                <c:pt idx="438">
                  <c:v>64141.802825927734</c:v>
                </c:pt>
                <c:pt idx="439">
                  <c:v>64148.736740112305</c:v>
                </c:pt>
                <c:pt idx="440">
                  <c:v>64148.527786254883</c:v>
                </c:pt>
                <c:pt idx="441">
                  <c:v>64145.861694335938</c:v>
                </c:pt>
                <c:pt idx="442">
                  <c:v>64140.567031860352</c:v>
                </c:pt>
                <c:pt idx="443">
                  <c:v>64137.443801879883</c:v>
                </c:pt>
                <c:pt idx="444">
                  <c:v>64132.377716064453</c:v>
                </c:pt>
                <c:pt idx="445">
                  <c:v>64130.22590637207</c:v>
                </c:pt>
                <c:pt idx="446">
                  <c:v>64137.274108886719</c:v>
                </c:pt>
                <c:pt idx="447">
                  <c:v>64151.093734741211</c:v>
                </c:pt>
                <c:pt idx="448">
                  <c:v>64156.14192199707</c:v>
                </c:pt>
                <c:pt idx="449">
                  <c:v>64150.304397583008</c:v>
                </c:pt>
                <c:pt idx="450">
                  <c:v>64147.266876220703</c:v>
                </c:pt>
                <c:pt idx="451">
                  <c:v>64145.915084838867</c:v>
                </c:pt>
                <c:pt idx="452">
                  <c:v>64144.877563476563</c:v>
                </c:pt>
                <c:pt idx="453">
                  <c:v>64148.154327392578</c:v>
                </c:pt>
                <c:pt idx="454">
                  <c:v>64155.859664916992</c:v>
                </c:pt>
                <c:pt idx="455">
                  <c:v>64156.936431884766</c:v>
                </c:pt>
                <c:pt idx="456">
                  <c:v>64150.556045532227</c:v>
                </c:pt>
                <c:pt idx="457">
                  <c:v>64143.289962768555</c:v>
                </c:pt>
                <c:pt idx="458">
                  <c:v>64139.93815612793</c:v>
                </c:pt>
                <c:pt idx="459">
                  <c:v>64141.957778930664</c:v>
                </c:pt>
                <c:pt idx="460">
                  <c:v>64147.748825073242</c:v>
                </c:pt>
                <c:pt idx="461">
                  <c:v>64154.082733154297</c:v>
                </c:pt>
                <c:pt idx="462">
                  <c:v>64159.188079833984</c:v>
                </c:pt>
                <c:pt idx="463">
                  <c:v>64162.579132080078</c:v>
                </c:pt>
                <c:pt idx="464">
                  <c:v>64157.427322387695</c:v>
                </c:pt>
                <c:pt idx="465">
                  <c:v>64141.646942138672</c:v>
                </c:pt>
                <c:pt idx="466">
                  <c:v>64128.895141601563</c:v>
                </c:pt>
                <c:pt idx="467">
                  <c:v>64127.257621765137</c:v>
                </c:pt>
                <c:pt idx="468">
                  <c:v>64131.477249145508</c:v>
                </c:pt>
                <c:pt idx="469">
                  <c:v>64127.382583618164</c:v>
                </c:pt>
                <c:pt idx="470">
                  <c:v>64118.402206420898</c:v>
                </c:pt>
                <c:pt idx="471">
                  <c:v>64116.021827697754</c:v>
                </c:pt>
                <c:pt idx="472">
                  <c:v>64120.184310913086</c:v>
                </c:pt>
                <c:pt idx="473">
                  <c:v>64116.375366210938</c:v>
                </c:pt>
                <c:pt idx="474">
                  <c:v>64108.194984436035</c:v>
                </c:pt>
                <c:pt idx="475">
                  <c:v>64108.21460723877</c:v>
                </c:pt>
                <c:pt idx="476">
                  <c:v>64115.719947814941</c:v>
                </c:pt>
                <c:pt idx="477">
                  <c:v>64124.625282287598</c:v>
                </c:pt>
                <c:pt idx="478">
                  <c:v>64130.987762451172</c:v>
                </c:pt>
                <c:pt idx="479">
                  <c:v>64132.664535522461</c:v>
                </c:pt>
                <c:pt idx="480">
                  <c:v>64130.569869995117</c:v>
                </c:pt>
                <c:pt idx="481">
                  <c:v>64129.960922241211</c:v>
                </c:pt>
                <c:pt idx="482">
                  <c:v>64122.466262817383</c:v>
                </c:pt>
                <c:pt idx="483">
                  <c:v>64108.571594238281</c:v>
                </c:pt>
                <c:pt idx="484">
                  <c:v>64097.276931762695</c:v>
                </c:pt>
                <c:pt idx="485">
                  <c:v>64099.982269287109</c:v>
                </c:pt>
                <c:pt idx="486">
                  <c:v>64109.716178894043</c:v>
                </c:pt>
                <c:pt idx="487">
                  <c:v>64115.735801696777</c:v>
                </c:pt>
                <c:pt idx="488">
                  <c:v>64111.49828338623</c:v>
                </c:pt>
                <c:pt idx="489">
                  <c:v>64100.975051879883</c:v>
                </c:pt>
                <c:pt idx="490">
                  <c:v>64092.280387878418</c:v>
                </c:pt>
                <c:pt idx="491">
                  <c:v>64086.328582763672</c:v>
                </c:pt>
                <c:pt idx="492">
                  <c:v>64088.033920288086</c:v>
                </c:pt>
                <c:pt idx="493">
                  <c:v>64099.224975585938</c:v>
                </c:pt>
                <c:pt idx="494">
                  <c:v>64116.758880615234</c:v>
                </c:pt>
                <c:pt idx="495">
                  <c:v>64127.178504943848</c:v>
                </c:pt>
                <c:pt idx="496">
                  <c:v>64126.426704406738</c:v>
                </c:pt>
                <c:pt idx="497">
                  <c:v>64125.360610961914</c:v>
                </c:pt>
                <c:pt idx="498">
                  <c:v>64125.29451751709</c:v>
                </c:pt>
                <c:pt idx="499">
                  <c:v>64115.514144897461</c:v>
                </c:pt>
                <c:pt idx="500">
                  <c:v>64096.676620483398</c:v>
                </c:pt>
                <c:pt idx="501">
                  <c:v>64082.667678833008</c:v>
                </c:pt>
                <c:pt idx="502">
                  <c:v>64074.087295532227</c:v>
                </c:pt>
                <c:pt idx="503">
                  <c:v>64064.678352355957</c:v>
                </c:pt>
                <c:pt idx="504">
                  <c:v>64061.097972869873</c:v>
                </c:pt>
                <c:pt idx="505">
                  <c:v>64066.346168518066</c:v>
                </c:pt>
                <c:pt idx="506">
                  <c:v>64075.165794372559</c:v>
                </c:pt>
                <c:pt idx="507">
                  <c:v>64077.128273010254</c:v>
                </c:pt>
                <c:pt idx="508">
                  <c:v>64073.40503692627</c:v>
                </c:pt>
                <c:pt idx="509">
                  <c:v>64067.853233337402</c:v>
                </c:pt>
                <c:pt idx="510">
                  <c:v>64070.644287109375</c:v>
                </c:pt>
                <c:pt idx="511">
                  <c:v>64076.892478942871</c:v>
                </c:pt>
                <c:pt idx="512">
                  <c:v>64080.169250488281</c:v>
                </c:pt>
                <c:pt idx="513">
                  <c:v>64073.960296630859</c:v>
                </c:pt>
                <c:pt idx="514">
                  <c:v>64066.979919433594</c:v>
                </c:pt>
                <c:pt idx="515">
                  <c:v>64064.485260009766</c:v>
                </c:pt>
                <c:pt idx="516">
                  <c:v>64059.47631072998</c:v>
                </c:pt>
                <c:pt idx="517">
                  <c:v>64046.153076171875</c:v>
                </c:pt>
                <c:pt idx="518">
                  <c:v>64040.229843139648</c:v>
                </c:pt>
                <c:pt idx="519">
                  <c:v>64052.363754272461</c:v>
                </c:pt>
                <c:pt idx="520">
                  <c:v>64066.869087219238</c:v>
                </c:pt>
                <c:pt idx="521">
                  <c:v>64070.574432373047</c:v>
                </c:pt>
                <c:pt idx="522">
                  <c:v>64064.394050598145</c:v>
                </c:pt>
                <c:pt idx="523">
                  <c:v>64060.927959442139</c:v>
                </c:pt>
                <c:pt idx="524">
                  <c:v>64059.376155853271</c:v>
                </c:pt>
                <c:pt idx="525">
                  <c:v>64057.824352264404</c:v>
                </c:pt>
                <c:pt idx="526">
                  <c:v>64055.129688262939</c:v>
                </c:pt>
                <c:pt idx="527">
                  <c:v>64054.035026550293</c:v>
                </c:pt>
                <c:pt idx="528">
                  <c:v>64051.540363311768</c:v>
                </c:pt>
                <c:pt idx="529">
                  <c:v>64051.645702362061</c:v>
                </c:pt>
                <c:pt idx="530">
                  <c:v>64057.008182525635</c:v>
                </c:pt>
                <c:pt idx="531">
                  <c:v>64060.856376647949</c:v>
                </c:pt>
                <c:pt idx="532">
                  <c:v>64056.818855285645</c:v>
                </c:pt>
                <c:pt idx="533">
                  <c:v>64047.238479614258</c:v>
                </c:pt>
                <c:pt idx="534">
                  <c:v>64038.915245056152</c:v>
                </c:pt>
                <c:pt idx="535">
                  <c:v>64034.506298065186</c:v>
                </c:pt>
                <c:pt idx="536">
                  <c:v>64034.154495239258</c:v>
                </c:pt>
                <c:pt idx="537">
                  <c:v>64036.031261444092</c:v>
                </c:pt>
                <c:pt idx="538">
                  <c:v>64046.393741607666</c:v>
                </c:pt>
                <c:pt idx="539">
                  <c:v>64058.670505523682</c:v>
                </c:pt>
                <c:pt idx="540">
                  <c:v>64058.604415893555</c:v>
                </c:pt>
                <c:pt idx="541">
                  <c:v>64049.995468139648</c:v>
                </c:pt>
                <c:pt idx="542">
                  <c:v>64044.443660736084</c:v>
                </c:pt>
                <c:pt idx="543">
                  <c:v>64043.063285827637</c:v>
                </c:pt>
                <c:pt idx="544">
                  <c:v>64032.45433807373</c:v>
                </c:pt>
                <c:pt idx="545">
                  <c:v>64022.331104278564</c:v>
                </c:pt>
                <c:pt idx="546">
                  <c:v>64018.236440658569</c:v>
                </c:pt>
                <c:pt idx="547">
                  <c:v>64018.656064987183</c:v>
                </c:pt>
                <c:pt idx="548">
                  <c:v>64017.332830429077</c:v>
                </c:pt>
                <c:pt idx="549">
                  <c:v>64014.609597206116</c:v>
                </c:pt>
                <c:pt idx="550">
                  <c:v>64011.514935493469</c:v>
                </c:pt>
                <c:pt idx="551">
                  <c:v>64012.448843955994</c:v>
                </c:pt>
                <c:pt idx="552">
                  <c:v>64027.239896774292</c:v>
                </c:pt>
                <c:pt idx="553">
                  <c:v>64058.830947875977</c:v>
                </c:pt>
                <c:pt idx="554">
                  <c:v>64087.507713317871</c:v>
                </c:pt>
                <c:pt idx="555">
                  <c:v>64094.870193481445</c:v>
                </c:pt>
                <c:pt idx="556">
                  <c:v>64081.51838684082</c:v>
                </c:pt>
                <c:pt idx="557">
                  <c:v>64067.195152282715</c:v>
                </c:pt>
                <c:pt idx="558">
                  <c:v>64062.671920776367</c:v>
                </c:pt>
                <c:pt idx="559">
                  <c:v>64064.405830383301</c:v>
                </c:pt>
                <c:pt idx="560">
                  <c:v>64067.254028320313</c:v>
                </c:pt>
                <c:pt idx="561">
                  <c:v>64070.38793182373</c:v>
                </c:pt>
                <c:pt idx="562">
                  <c:v>64079.778984069824</c:v>
                </c:pt>
                <c:pt idx="563">
                  <c:v>64090.198608398438</c:v>
                </c:pt>
                <c:pt idx="564">
                  <c:v>64094.418235778809</c:v>
                </c:pt>
                <c:pt idx="565">
                  <c:v>64096.123573303223</c:v>
                </c:pt>
                <c:pt idx="566">
                  <c:v>64097.428909301758</c:v>
                </c:pt>
                <c:pt idx="567">
                  <c:v>64096.419960021973</c:v>
                </c:pt>
                <c:pt idx="568">
                  <c:v>64090.782440185547</c:v>
                </c:pt>
                <c:pt idx="569">
                  <c:v>64087.430633544922</c:v>
                </c:pt>
                <c:pt idx="570">
                  <c:v>64082.307403564453</c:v>
                </c:pt>
                <c:pt idx="571">
                  <c:v>64075.81273651123</c:v>
                </c:pt>
                <c:pt idx="572">
                  <c:v>64070.375221252441</c:v>
                </c:pt>
                <c:pt idx="573">
                  <c:v>64071.251983642578</c:v>
                </c:pt>
                <c:pt idx="574">
                  <c:v>64078.985893249512</c:v>
                </c:pt>
                <c:pt idx="575">
                  <c:v>64086.862663269043</c:v>
                </c:pt>
                <c:pt idx="576">
                  <c:v>64089.167999267578</c:v>
                </c:pt>
                <c:pt idx="577">
                  <c:v>64084.844764709473</c:v>
                </c:pt>
                <c:pt idx="578">
                  <c:v>64080.378677368164</c:v>
                </c:pt>
                <c:pt idx="579">
                  <c:v>64082.9697265625</c:v>
                </c:pt>
                <c:pt idx="580">
                  <c:v>64090.675064086914</c:v>
                </c:pt>
                <c:pt idx="581">
                  <c:v>64097.694686889648</c:v>
                </c:pt>
                <c:pt idx="582">
                  <c:v>64102.171455383301</c:v>
                </c:pt>
                <c:pt idx="583">
                  <c:v>64110.962509155273</c:v>
                </c:pt>
                <c:pt idx="584">
                  <c:v>64121.582130432129</c:v>
                </c:pt>
                <c:pt idx="585">
                  <c:v>64129.401748657227</c:v>
                </c:pt>
                <c:pt idx="586">
                  <c:v>64127.678520202637</c:v>
                </c:pt>
                <c:pt idx="587">
                  <c:v>64119.869567871094</c:v>
                </c:pt>
                <c:pt idx="588">
                  <c:v>64115.974906921387</c:v>
                </c:pt>
                <c:pt idx="589">
                  <c:v>64123.880249023438</c:v>
                </c:pt>
                <c:pt idx="590">
                  <c:v>64131.128448486328</c:v>
                </c:pt>
                <c:pt idx="591">
                  <c:v>64386.233764648438</c:v>
                </c:pt>
                <c:pt idx="592">
                  <c:v>66362.6533203125</c:v>
                </c:pt>
                <c:pt idx="593">
                  <c:v>73134.0732421875</c:v>
                </c:pt>
                <c:pt idx="594">
                  <c:v>88128.20703125</c:v>
                </c:pt>
                <c:pt idx="595">
                  <c:v>113230.8828125</c:v>
                </c:pt>
                <c:pt idx="596">
                  <c:v>148303.9609375</c:v>
                </c:pt>
                <c:pt idx="597">
                  <c:v>192504.609375</c:v>
                </c:pt>
                <c:pt idx="598">
                  <c:v>246242.25</c:v>
                </c:pt>
                <c:pt idx="599">
                  <c:v>291753.359375</c:v>
                </c:pt>
                <c:pt idx="600">
                  <c:v>313643.015625</c:v>
                </c:pt>
                <c:pt idx="601">
                  <c:v>313643.09375</c:v>
                </c:pt>
                <c:pt idx="602">
                  <c:v>313643.15625</c:v>
                </c:pt>
                <c:pt idx="603">
                  <c:v>313643.234375</c:v>
                </c:pt>
                <c:pt idx="604">
                  <c:v>313643.3125</c:v>
                </c:pt>
                <c:pt idx="605">
                  <c:v>313643.390625</c:v>
                </c:pt>
                <c:pt idx="606">
                  <c:v>313643.46875</c:v>
                </c:pt>
                <c:pt idx="607">
                  <c:v>313643.546875</c:v>
                </c:pt>
                <c:pt idx="608">
                  <c:v>313643.625</c:v>
                </c:pt>
                <c:pt idx="609">
                  <c:v>313643.703125</c:v>
                </c:pt>
                <c:pt idx="610">
                  <c:v>313643.78125</c:v>
                </c:pt>
                <c:pt idx="611">
                  <c:v>313643.859375</c:v>
                </c:pt>
                <c:pt idx="612">
                  <c:v>313643.9375</c:v>
                </c:pt>
                <c:pt idx="613">
                  <c:v>313644.015625</c:v>
                </c:pt>
                <c:pt idx="614">
                  <c:v>313644.078125</c:v>
                </c:pt>
                <c:pt idx="615">
                  <c:v>313644.15625</c:v>
                </c:pt>
                <c:pt idx="616">
                  <c:v>313644.234375</c:v>
                </c:pt>
                <c:pt idx="617">
                  <c:v>313644.3125</c:v>
                </c:pt>
                <c:pt idx="618">
                  <c:v>313644.390625</c:v>
                </c:pt>
                <c:pt idx="619">
                  <c:v>313644.46875</c:v>
                </c:pt>
                <c:pt idx="620">
                  <c:v>313644.546875</c:v>
                </c:pt>
                <c:pt idx="621">
                  <c:v>313644.625</c:v>
                </c:pt>
                <c:pt idx="622">
                  <c:v>313644.703125</c:v>
                </c:pt>
                <c:pt idx="623">
                  <c:v>313644.78125</c:v>
                </c:pt>
                <c:pt idx="624">
                  <c:v>313644.859375</c:v>
                </c:pt>
                <c:pt idx="625">
                  <c:v>313644.921875</c:v>
                </c:pt>
                <c:pt idx="626">
                  <c:v>313645</c:v>
                </c:pt>
                <c:pt idx="627">
                  <c:v>313645.078125</c:v>
                </c:pt>
                <c:pt idx="628">
                  <c:v>313645.15625</c:v>
                </c:pt>
                <c:pt idx="629">
                  <c:v>313645.234375</c:v>
                </c:pt>
                <c:pt idx="630">
                  <c:v>313645.3125</c:v>
                </c:pt>
                <c:pt idx="631">
                  <c:v>313645.390625</c:v>
                </c:pt>
                <c:pt idx="632">
                  <c:v>313645.46875</c:v>
                </c:pt>
                <c:pt idx="633">
                  <c:v>313645.546875</c:v>
                </c:pt>
                <c:pt idx="634">
                  <c:v>313645.625</c:v>
                </c:pt>
                <c:pt idx="635">
                  <c:v>313645.703125</c:v>
                </c:pt>
                <c:pt idx="636">
                  <c:v>313645.78125</c:v>
                </c:pt>
                <c:pt idx="637">
                  <c:v>313645.84375</c:v>
                </c:pt>
                <c:pt idx="638">
                  <c:v>313645.921875</c:v>
                </c:pt>
                <c:pt idx="639">
                  <c:v>313646</c:v>
                </c:pt>
                <c:pt idx="640">
                  <c:v>313646.078125</c:v>
                </c:pt>
                <c:pt idx="641">
                  <c:v>313646.15625</c:v>
                </c:pt>
                <c:pt idx="642">
                  <c:v>313646.234375</c:v>
                </c:pt>
                <c:pt idx="643">
                  <c:v>313646.3125</c:v>
                </c:pt>
                <c:pt idx="644">
                  <c:v>313646.390625</c:v>
                </c:pt>
                <c:pt idx="645">
                  <c:v>313646.46875</c:v>
                </c:pt>
                <c:pt idx="646">
                  <c:v>313646.546875</c:v>
                </c:pt>
                <c:pt idx="647">
                  <c:v>313646.625</c:v>
                </c:pt>
                <c:pt idx="648">
                  <c:v>313646.6875</c:v>
                </c:pt>
                <c:pt idx="649">
                  <c:v>313646.765625</c:v>
                </c:pt>
                <c:pt idx="650">
                  <c:v>313646.84375</c:v>
                </c:pt>
                <c:pt idx="651">
                  <c:v>313646.921875</c:v>
                </c:pt>
                <c:pt idx="652">
                  <c:v>313647</c:v>
                </c:pt>
                <c:pt idx="653">
                  <c:v>313647.078125</c:v>
                </c:pt>
                <c:pt idx="654">
                  <c:v>313647.15625</c:v>
                </c:pt>
                <c:pt idx="655">
                  <c:v>313647.234375</c:v>
                </c:pt>
                <c:pt idx="656">
                  <c:v>313647.3125</c:v>
                </c:pt>
                <c:pt idx="657">
                  <c:v>313647.390625</c:v>
                </c:pt>
                <c:pt idx="658">
                  <c:v>313647.46875</c:v>
                </c:pt>
                <c:pt idx="659">
                  <c:v>313647.546875</c:v>
                </c:pt>
                <c:pt idx="660">
                  <c:v>313647.609375</c:v>
                </c:pt>
                <c:pt idx="661">
                  <c:v>313647.6875</c:v>
                </c:pt>
                <c:pt idx="662">
                  <c:v>313647.765625</c:v>
                </c:pt>
                <c:pt idx="663">
                  <c:v>313647.84375</c:v>
                </c:pt>
                <c:pt idx="664">
                  <c:v>313647.921875</c:v>
                </c:pt>
                <c:pt idx="665">
                  <c:v>313648</c:v>
                </c:pt>
                <c:pt idx="666">
                  <c:v>313648.078125</c:v>
                </c:pt>
                <c:pt idx="667">
                  <c:v>313648.15625</c:v>
                </c:pt>
                <c:pt idx="668">
                  <c:v>313648.234375</c:v>
                </c:pt>
                <c:pt idx="669">
                  <c:v>313648.3125</c:v>
                </c:pt>
                <c:pt idx="670">
                  <c:v>313648.390625</c:v>
                </c:pt>
                <c:pt idx="671">
                  <c:v>313648.453125</c:v>
                </c:pt>
                <c:pt idx="672">
                  <c:v>313648.53125</c:v>
                </c:pt>
                <c:pt idx="673">
                  <c:v>313648.609375</c:v>
                </c:pt>
                <c:pt idx="674">
                  <c:v>313648.6875</c:v>
                </c:pt>
                <c:pt idx="675">
                  <c:v>313648.765625</c:v>
                </c:pt>
                <c:pt idx="676">
                  <c:v>313648.84375</c:v>
                </c:pt>
                <c:pt idx="677">
                  <c:v>313648.921875</c:v>
                </c:pt>
                <c:pt idx="678">
                  <c:v>313649</c:v>
                </c:pt>
                <c:pt idx="679">
                  <c:v>313649.078125</c:v>
                </c:pt>
                <c:pt idx="680">
                  <c:v>313649.15625</c:v>
                </c:pt>
                <c:pt idx="681">
                  <c:v>313649.234375</c:v>
                </c:pt>
                <c:pt idx="682">
                  <c:v>313649.3125</c:v>
                </c:pt>
                <c:pt idx="683">
                  <c:v>313649.375</c:v>
                </c:pt>
                <c:pt idx="684">
                  <c:v>313649.453125</c:v>
                </c:pt>
                <c:pt idx="685">
                  <c:v>313649.53125</c:v>
                </c:pt>
                <c:pt idx="686">
                  <c:v>313649.609375</c:v>
                </c:pt>
                <c:pt idx="687">
                  <c:v>313649.6875</c:v>
                </c:pt>
                <c:pt idx="688">
                  <c:v>313649.765625</c:v>
                </c:pt>
                <c:pt idx="689">
                  <c:v>313649.84375</c:v>
                </c:pt>
                <c:pt idx="690">
                  <c:v>313649.921875</c:v>
                </c:pt>
                <c:pt idx="691">
                  <c:v>313650</c:v>
                </c:pt>
                <c:pt idx="692">
                  <c:v>313650.078125</c:v>
                </c:pt>
                <c:pt idx="693">
                  <c:v>307371.15625</c:v>
                </c:pt>
                <c:pt idx="694">
                  <c:v>304238.546875</c:v>
                </c:pt>
                <c:pt idx="695">
                  <c:v>296381.78125</c:v>
                </c:pt>
                <c:pt idx="696">
                  <c:v>262577.4375</c:v>
                </c:pt>
                <c:pt idx="697">
                  <c:v>193393.1171875</c:v>
                </c:pt>
                <c:pt idx="698">
                  <c:v>129958.5078125</c:v>
                </c:pt>
                <c:pt idx="699">
                  <c:v>94391.439453125</c:v>
                </c:pt>
                <c:pt idx="700">
                  <c:v>79309.115234375</c:v>
                </c:pt>
                <c:pt idx="701">
                  <c:v>75196.9638671875</c:v>
                </c:pt>
                <c:pt idx="702">
                  <c:v>75540.92578125</c:v>
                </c:pt>
                <c:pt idx="703">
                  <c:v>77071.1455078125</c:v>
                </c:pt>
                <c:pt idx="704">
                  <c:v>78899.1943359375</c:v>
                </c:pt>
                <c:pt idx="705">
                  <c:v>81648.099609375</c:v>
                </c:pt>
                <c:pt idx="706">
                  <c:v>86164.71875</c:v>
                </c:pt>
                <c:pt idx="707">
                  <c:v>92223.109375</c:v>
                </c:pt>
                <c:pt idx="708">
                  <c:v>98714.04296875</c:v>
                </c:pt>
                <c:pt idx="709">
                  <c:v>104886.03515625</c:v>
                </c:pt>
                <c:pt idx="710">
                  <c:v>110953.59765625</c:v>
                </c:pt>
                <c:pt idx="711">
                  <c:v>117752.24609375</c:v>
                </c:pt>
                <c:pt idx="712">
                  <c:v>126277.12109375</c:v>
                </c:pt>
                <c:pt idx="713">
                  <c:v>137421.0546875</c:v>
                </c:pt>
                <c:pt idx="714">
                  <c:v>151677.7890625</c:v>
                </c:pt>
                <c:pt idx="715">
                  <c:v>168358.578125</c:v>
                </c:pt>
                <c:pt idx="716">
                  <c:v>184266.9453125</c:v>
                </c:pt>
                <c:pt idx="717">
                  <c:v>193165.390625</c:v>
                </c:pt>
                <c:pt idx="718">
                  <c:v>189747.609375</c:v>
                </c:pt>
                <c:pt idx="719">
                  <c:v>174331.40625</c:v>
                </c:pt>
                <c:pt idx="720">
                  <c:v>152237.59375</c:v>
                </c:pt>
                <c:pt idx="721">
                  <c:v>130307.640625</c:v>
                </c:pt>
                <c:pt idx="722">
                  <c:v>113957.86328125</c:v>
                </c:pt>
                <c:pt idx="723">
                  <c:v>105040.08203125</c:v>
                </c:pt>
                <c:pt idx="724">
                  <c:v>101248.87109375</c:v>
                </c:pt>
                <c:pt idx="725">
                  <c:v>99842.46484375</c:v>
                </c:pt>
                <c:pt idx="726">
                  <c:v>100216.96875</c:v>
                </c:pt>
                <c:pt idx="727">
                  <c:v>102786.9609375</c:v>
                </c:pt>
                <c:pt idx="728">
                  <c:v>107298.12109375</c:v>
                </c:pt>
                <c:pt idx="729">
                  <c:v>112886.484375</c:v>
                </c:pt>
                <c:pt idx="730">
                  <c:v>118800.8203125</c:v>
                </c:pt>
                <c:pt idx="731">
                  <c:v>124674.49609375</c:v>
                </c:pt>
                <c:pt idx="732">
                  <c:v>130315.0546875</c:v>
                </c:pt>
                <c:pt idx="733">
                  <c:v>135517.875</c:v>
                </c:pt>
                <c:pt idx="734">
                  <c:v>140052.84375</c:v>
                </c:pt>
                <c:pt idx="735">
                  <c:v>143763.890625</c:v>
                </c:pt>
                <c:pt idx="736">
                  <c:v>146612.9921875</c:v>
                </c:pt>
                <c:pt idx="737">
                  <c:v>146783.296875</c:v>
                </c:pt>
                <c:pt idx="738">
                  <c:v>139884.234375</c:v>
                </c:pt>
                <c:pt idx="739">
                  <c:v>125055.96484375</c:v>
                </c:pt>
                <c:pt idx="740">
                  <c:v>109094.78515625</c:v>
                </c:pt>
                <c:pt idx="741">
                  <c:v>99212.9765625</c:v>
                </c:pt>
                <c:pt idx="742">
                  <c:v>95011.826171875</c:v>
                </c:pt>
                <c:pt idx="743">
                  <c:v>93122.587890625</c:v>
                </c:pt>
                <c:pt idx="744">
                  <c:v>92968.607421875</c:v>
                </c:pt>
                <c:pt idx="745">
                  <c:v>94121.369140625</c:v>
                </c:pt>
                <c:pt idx="746">
                  <c:v>94174.390625</c:v>
                </c:pt>
                <c:pt idx="747">
                  <c:v>92260.6953125</c:v>
                </c:pt>
                <c:pt idx="748">
                  <c:v>90335.62890625</c:v>
                </c:pt>
                <c:pt idx="749">
                  <c:v>91374.962890625</c:v>
                </c:pt>
                <c:pt idx="750">
                  <c:v>100985.75390625</c:v>
                </c:pt>
                <c:pt idx="751">
                  <c:v>129766.515625</c:v>
                </c:pt>
                <c:pt idx="752">
                  <c:v>186363.4765625</c:v>
                </c:pt>
                <c:pt idx="753">
                  <c:v>258353.390625</c:v>
                </c:pt>
                <c:pt idx="754">
                  <c:v>311100.546875</c:v>
                </c:pt>
                <c:pt idx="755">
                  <c:v>309584.25</c:v>
                </c:pt>
                <c:pt idx="756">
                  <c:v>254338.90625</c:v>
                </c:pt>
                <c:pt idx="757">
                  <c:v>181616.609375</c:v>
                </c:pt>
                <c:pt idx="758">
                  <c:v>128020.625</c:v>
                </c:pt>
                <c:pt idx="759">
                  <c:v>103040.24609375</c:v>
                </c:pt>
                <c:pt idx="760">
                  <c:v>97402.1796875</c:v>
                </c:pt>
                <c:pt idx="761">
                  <c:v>102504.51171875</c:v>
                </c:pt>
                <c:pt idx="762">
                  <c:v>112845.4453125</c:v>
                </c:pt>
                <c:pt idx="763">
                  <c:v>125401.46484375</c:v>
                </c:pt>
                <c:pt idx="764">
                  <c:v>137905.171875</c:v>
                </c:pt>
                <c:pt idx="765">
                  <c:v>148461.25</c:v>
                </c:pt>
                <c:pt idx="766">
                  <c:v>154098.5546875</c:v>
                </c:pt>
                <c:pt idx="767">
                  <c:v>150596.8046875</c:v>
                </c:pt>
                <c:pt idx="768">
                  <c:v>136593.109375</c:v>
                </c:pt>
                <c:pt idx="769">
                  <c:v>117139.5546875</c:v>
                </c:pt>
                <c:pt idx="770">
                  <c:v>100595.6015625</c:v>
                </c:pt>
                <c:pt idx="771">
                  <c:v>91151.765625</c:v>
                </c:pt>
                <c:pt idx="772">
                  <c:v>87171.5859375</c:v>
                </c:pt>
                <c:pt idx="773">
                  <c:v>85368.26171875</c:v>
                </c:pt>
                <c:pt idx="774">
                  <c:v>86066.99609375</c:v>
                </c:pt>
                <c:pt idx="775">
                  <c:v>92751.216796875</c:v>
                </c:pt>
                <c:pt idx="776">
                  <c:v>108511.72265625</c:v>
                </c:pt>
                <c:pt idx="777">
                  <c:v>133947.625</c:v>
                </c:pt>
                <c:pt idx="778">
                  <c:v>167622.25</c:v>
                </c:pt>
                <c:pt idx="779">
                  <c:v>207016.296875</c:v>
                </c:pt>
                <c:pt idx="780">
                  <c:v>249594.828125</c:v>
                </c:pt>
                <c:pt idx="781">
                  <c:v>288538.8125</c:v>
                </c:pt>
                <c:pt idx="782">
                  <c:v>310743.375</c:v>
                </c:pt>
                <c:pt idx="783">
                  <c:v>313657.0625</c:v>
                </c:pt>
                <c:pt idx="784">
                  <c:v>313657.140625</c:v>
                </c:pt>
                <c:pt idx="785">
                  <c:v>308460.1875</c:v>
                </c:pt>
                <c:pt idx="786">
                  <c:v>263664.453125</c:v>
                </c:pt>
                <c:pt idx="787">
                  <c:v>192739.6796875</c:v>
                </c:pt>
                <c:pt idx="788">
                  <c:v>133692.640625</c:v>
                </c:pt>
                <c:pt idx="789">
                  <c:v>104561.34765625</c:v>
                </c:pt>
                <c:pt idx="790">
                  <c:v>95007.767578125</c:v>
                </c:pt>
                <c:pt idx="791">
                  <c:v>93710.986328125</c:v>
                </c:pt>
                <c:pt idx="792">
                  <c:v>92787.978515625</c:v>
                </c:pt>
                <c:pt idx="793">
                  <c:v>89850.8828125</c:v>
                </c:pt>
                <c:pt idx="794">
                  <c:v>86241.90234375</c:v>
                </c:pt>
                <c:pt idx="795">
                  <c:v>83537.951171875</c:v>
                </c:pt>
                <c:pt idx="796">
                  <c:v>82179.19921875</c:v>
                </c:pt>
                <c:pt idx="797">
                  <c:v>82339.046875</c:v>
                </c:pt>
                <c:pt idx="798">
                  <c:v>84556.638671875</c:v>
                </c:pt>
                <c:pt idx="799">
                  <c:v>89125.23046875</c:v>
                </c:pt>
                <c:pt idx="800">
                  <c:v>94742.021484375</c:v>
                </c:pt>
                <c:pt idx="801">
                  <c:v>97543.640625</c:v>
                </c:pt>
                <c:pt idx="802">
                  <c:v>95007.57421875</c:v>
                </c:pt>
                <c:pt idx="803">
                  <c:v>90431.080078125</c:v>
                </c:pt>
                <c:pt idx="804">
                  <c:v>91142.15625</c:v>
                </c:pt>
                <c:pt idx="805">
                  <c:v>101369.890625</c:v>
                </c:pt>
                <c:pt idx="806">
                  <c:v>120580.8828125</c:v>
                </c:pt>
                <c:pt idx="807">
                  <c:v>146454.703125</c:v>
                </c:pt>
                <c:pt idx="808">
                  <c:v>177393.234375</c:v>
                </c:pt>
                <c:pt idx="809">
                  <c:v>213425.828125</c:v>
                </c:pt>
                <c:pt idx="810">
                  <c:v>257835.046875</c:v>
                </c:pt>
                <c:pt idx="811">
                  <c:v>295792.71875</c:v>
                </c:pt>
                <c:pt idx="812">
                  <c:v>313659.28125</c:v>
                </c:pt>
                <c:pt idx="813">
                  <c:v>313659.359375</c:v>
                </c:pt>
                <c:pt idx="814">
                  <c:v>313659.4375</c:v>
                </c:pt>
                <c:pt idx="815">
                  <c:v>313659.515625</c:v>
                </c:pt>
                <c:pt idx="816">
                  <c:v>313659.59375</c:v>
                </c:pt>
                <c:pt idx="817">
                  <c:v>313659.671875</c:v>
                </c:pt>
                <c:pt idx="818">
                  <c:v>313659.75</c:v>
                </c:pt>
                <c:pt idx="819">
                  <c:v>313659.828125</c:v>
                </c:pt>
                <c:pt idx="820">
                  <c:v>313659.90625</c:v>
                </c:pt>
                <c:pt idx="821">
                  <c:v>313659.96875</c:v>
                </c:pt>
                <c:pt idx="822">
                  <c:v>313660.046875</c:v>
                </c:pt>
                <c:pt idx="823">
                  <c:v>313660.125</c:v>
                </c:pt>
                <c:pt idx="824">
                  <c:v>313660.203125</c:v>
                </c:pt>
                <c:pt idx="825">
                  <c:v>313660.28125</c:v>
                </c:pt>
                <c:pt idx="826">
                  <c:v>313660.359375</c:v>
                </c:pt>
                <c:pt idx="827">
                  <c:v>313660.4375</c:v>
                </c:pt>
                <c:pt idx="828">
                  <c:v>313660.515625</c:v>
                </c:pt>
                <c:pt idx="829">
                  <c:v>312321.8125</c:v>
                </c:pt>
                <c:pt idx="830">
                  <c:v>271885.5</c:v>
                </c:pt>
                <c:pt idx="831">
                  <c:v>199059.421875</c:v>
                </c:pt>
                <c:pt idx="832">
                  <c:v>129619.6171875</c:v>
                </c:pt>
                <c:pt idx="833">
                  <c:v>92363.869140625</c:v>
                </c:pt>
                <c:pt idx="834">
                  <c:v>76847.6591796875</c:v>
                </c:pt>
                <c:pt idx="835">
                  <c:v>72058.45068359375</c:v>
                </c:pt>
                <c:pt idx="836">
                  <c:v>70722.8984375</c:v>
                </c:pt>
                <c:pt idx="837">
                  <c:v>69892.08984375</c:v>
                </c:pt>
                <c:pt idx="838">
                  <c:v>69148.96630859375</c:v>
                </c:pt>
                <c:pt idx="839">
                  <c:v>68635.72900390625</c:v>
                </c:pt>
                <c:pt idx="840">
                  <c:v>68415.5771484375</c:v>
                </c:pt>
                <c:pt idx="841">
                  <c:v>68616.08251953125</c:v>
                </c:pt>
                <c:pt idx="842">
                  <c:v>69750.90234375</c:v>
                </c:pt>
                <c:pt idx="843">
                  <c:v>72809.0078125</c:v>
                </c:pt>
                <c:pt idx="844">
                  <c:v>78855.76953125</c:v>
                </c:pt>
                <c:pt idx="845">
                  <c:v>88454.103515625</c:v>
                </c:pt>
                <c:pt idx="846">
                  <c:v>101412.3515625</c:v>
                </c:pt>
                <c:pt idx="847">
                  <c:v>117047.80078125</c:v>
                </c:pt>
                <c:pt idx="848">
                  <c:v>134646.046875</c:v>
                </c:pt>
                <c:pt idx="849">
                  <c:v>152633.8671875</c:v>
                </c:pt>
                <c:pt idx="850">
                  <c:v>163158.171875</c:v>
                </c:pt>
                <c:pt idx="851">
                  <c:v>155219.25</c:v>
                </c:pt>
                <c:pt idx="852">
                  <c:v>129225.5546875</c:v>
                </c:pt>
                <c:pt idx="853">
                  <c:v>99551.40234375</c:v>
                </c:pt>
                <c:pt idx="854">
                  <c:v>79406.537109375</c:v>
                </c:pt>
                <c:pt idx="855">
                  <c:v>70013.185546875</c:v>
                </c:pt>
                <c:pt idx="856">
                  <c:v>66872.7197265625</c:v>
                </c:pt>
                <c:pt idx="857">
                  <c:v>65984.910766601563</c:v>
                </c:pt>
                <c:pt idx="858">
                  <c:v>65574.416137695313</c:v>
                </c:pt>
                <c:pt idx="859">
                  <c:v>65282.03564453125</c:v>
                </c:pt>
                <c:pt idx="860">
                  <c:v>65108.3125</c:v>
                </c:pt>
                <c:pt idx="861">
                  <c:v>65023.132080078125</c:v>
                </c:pt>
                <c:pt idx="862">
                  <c:v>64971.123168945313</c:v>
                </c:pt>
                <c:pt idx="863">
                  <c:v>64925.3427734375</c:v>
                </c:pt>
                <c:pt idx="864">
                  <c:v>64892.990966796875</c:v>
                </c:pt>
                <c:pt idx="865">
                  <c:v>64887.324890136719</c:v>
                </c:pt>
                <c:pt idx="866">
                  <c:v>64911.544494628906</c:v>
                </c:pt>
                <c:pt idx="867">
                  <c:v>64990.87841796875</c:v>
                </c:pt>
                <c:pt idx="868">
                  <c:v>65178.840942382813</c:v>
                </c:pt>
                <c:pt idx="869">
                  <c:v>65479.746215820313</c:v>
                </c:pt>
                <c:pt idx="870">
                  <c:v>65772.994384765625</c:v>
                </c:pt>
                <c:pt idx="871">
                  <c:v>65874.871215820313</c:v>
                </c:pt>
                <c:pt idx="872">
                  <c:v>65707.776489257813</c:v>
                </c:pt>
                <c:pt idx="873">
                  <c:v>65381.853271484375</c:v>
                </c:pt>
                <c:pt idx="874">
                  <c:v>65080.2158203125</c:v>
                </c:pt>
                <c:pt idx="875">
                  <c:v>64900.035400390625</c:v>
                </c:pt>
                <c:pt idx="876">
                  <c:v>64821.283569335938</c:v>
                </c:pt>
                <c:pt idx="877">
                  <c:v>64791.30322265625</c:v>
                </c:pt>
                <c:pt idx="878">
                  <c:v>64778.837097167969</c:v>
                </c:pt>
                <c:pt idx="879">
                  <c:v>64781.799621582031</c:v>
                </c:pt>
                <c:pt idx="880">
                  <c:v>64799.904907226563</c:v>
                </c:pt>
                <c:pt idx="881">
                  <c:v>64827.324584960938</c:v>
                </c:pt>
                <c:pt idx="882">
                  <c:v>64857.515625</c:v>
                </c:pt>
                <c:pt idx="883">
                  <c:v>64883.420959472656</c:v>
                </c:pt>
                <c:pt idx="884">
                  <c:v>64903.7548828125</c:v>
                </c:pt>
                <c:pt idx="885">
                  <c:v>64927.345886230469</c:v>
                </c:pt>
                <c:pt idx="886">
                  <c:v>64948.594116210938</c:v>
                </c:pt>
                <c:pt idx="887">
                  <c:v>64929.356567382813</c:v>
                </c:pt>
                <c:pt idx="888">
                  <c:v>64848.776184082031</c:v>
                </c:pt>
                <c:pt idx="889">
                  <c:v>64738.710144042969</c:v>
                </c:pt>
                <c:pt idx="890">
                  <c:v>64645.8154296875</c:v>
                </c:pt>
                <c:pt idx="891">
                  <c:v>64584.492248535156</c:v>
                </c:pt>
                <c:pt idx="892">
                  <c:v>64550.283264160156</c:v>
                </c:pt>
                <c:pt idx="893">
                  <c:v>64539.7314453125</c:v>
                </c:pt>
                <c:pt idx="894">
                  <c:v>64535.265380859375</c:v>
                </c:pt>
                <c:pt idx="895">
                  <c:v>64525.113586425781</c:v>
                </c:pt>
                <c:pt idx="896">
                  <c:v>64517.076049804688</c:v>
                </c:pt>
                <c:pt idx="897">
                  <c:v>64517.124267578125</c:v>
                </c:pt>
                <c:pt idx="898">
                  <c:v>64516.315307617188</c:v>
                </c:pt>
                <c:pt idx="899">
                  <c:v>64515.192077636719</c:v>
                </c:pt>
                <c:pt idx="900">
                  <c:v>64520.097412109375</c:v>
                </c:pt>
                <c:pt idx="901">
                  <c:v>64522.345581054688</c:v>
                </c:pt>
                <c:pt idx="902">
                  <c:v>64513.622375488281</c:v>
                </c:pt>
                <c:pt idx="903">
                  <c:v>64490.670562744141</c:v>
                </c:pt>
                <c:pt idx="904">
                  <c:v>64469.575897216797</c:v>
                </c:pt>
                <c:pt idx="905">
                  <c:v>64462.138366699219</c:v>
                </c:pt>
                <c:pt idx="906">
                  <c:v>64469.043701171875</c:v>
                </c:pt>
                <c:pt idx="907">
                  <c:v>64482.57763671875</c:v>
                </c:pt>
                <c:pt idx="908">
                  <c:v>64498.482971191406</c:v>
                </c:pt>
                <c:pt idx="909">
                  <c:v>64514.359741210938</c:v>
                </c:pt>
                <c:pt idx="910">
                  <c:v>64525.722229003906</c:v>
                </c:pt>
                <c:pt idx="911">
                  <c:v>64532.998962402344</c:v>
                </c:pt>
                <c:pt idx="912">
                  <c:v>64533.932861328125</c:v>
                </c:pt>
                <c:pt idx="913">
                  <c:v>64545.52392578125</c:v>
                </c:pt>
                <c:pt idx="914">
                  <c:v>64585.286437988281</c:v>
                </c:pt>
                <c:pt idx="915">
                  <c:v>64666.848876953125</c:v>
                </c:pt>
                <c:pt idx="916">
                  <c:v>64805.297119140625</c:v>
                </c:pt>
                <c:pt idx="917">
                  <c:v>65096.802368164063</c:v>
                </c:pt>
                <c:pt idx="918">
                  <c:v>65823.79345703125</c:v>
                </c:pt>
                <c:pt idx="919">
                  <c:v>67461.984619140625</c:v>
                </c:pt>
                <c:pt idx="920">
                  <c:v>70484.80419921875</c:v>
                </c:pt>
                <c:pt idx="921">
                  <c:v>75112.1669921875</c:v>
                </c:pt>
                <c:pt idx="922">
                  <c:v>81133.7578125</c:v>
                </c:pt>
                <c:pt idx="923">
                  <c:v>87542.43359375</c:v>
                </c:pt>
                <c:pt idx="924">
                  <c:v>91949.853515625</c:v>
                </c:pt>
                <c:pt idx="925">
                  <c:v>91414.90234375</c:v>
                </c:pt>
                <c:pt idx="926">
                  <c:v>85424.779296875</c:v>
                </c:pt>
                <c:pt idx="927">
                  <c:v>77045.626953125</c:v>
                </c:pt>
                <c:pt idx="928">
                  <c:v>70210.9326171875</c:v>
                </c:pt>
                <c:pt idx="929">
                  <c:v>66486.923583984375</c:v>
                </c:pt>
                <c:pt idx="930">
                  <c:v>65182.028930664063</c:v>
                </c:pt>
                <c:pt idx="931">
                  <c:v>65056.705688476563</c:v>
                </c:pt>
                <c:pt idx="932">
                  <c:v>65350.382446289063</c:v>
                </c:pt>
                <c:pt idx="933">
                  <c:v>65796.4306640625</c:v>
                </c:pt>
                <c:pt idx="934">
                  <c:v>66295.078857421875</c:v>
                </c:pt>
                <c:pt idx="935">
                  <c:v>66753.098388671875</c:v>
                </c:pt>
                <c:pt idx="936">
                  <c:v>67068.00390625</c:v>
                </c:pt>
                <c:pt idx="937">
                  <c:v>67156.4521484375</c:v>
                </c:pt>
                <c:pt idx="938">
                  <c:v>66956.98583984375</c:v>
                </c:pt>
                <c:pt idx="939">
                  <c:v>66485.69140625</c:v>
                </c:pt>
                <c:pt idx="940">
                  <c:v>65861.110961914063</c:v>
                </c:pt>
                <c:pt idx="941">
                  <c:v>65263.959106445313</c:v>
                </c:pt>
                <c:pt idx="942">
                  <c:v>64820.293029785156</c:v>
                </c:pt>
                <c:pt idx="943">
                  <c:v>64557.85546875</c:v>
                </c:pt>
                <c:pt idx="944">
                  <c:v>64431.075103759766</c:v>
                </c:pt>
                <c:pt idx="945">
                  <c:v>64379.351898193359</c:v>
                </c:pt>
                <c:pt idx="946">
                  <c:v>64357.857208251953</c:v>
                </c:pt>
                <c:pt idx="947">
                  <c:v>64360.219696044922</c:v>
                </c:pt>
                <c:pt idx="948">
                  <c:v>64382.667907714844</c:v>
                </c:pt>
                <c:pt idx="949">
                  <c:v>64420.144653320313</c:v>
                </c:pt>
                <c:pt idx="950">
                  <c:v>64467.421417236328</c:v>
                </c:pt>
                <c:pt idx="951">
                  <c:v>64519.726745605469</c:v>
                </c:pt>
                <c:pt idx="952">
                  <c:v>64570.232116699219</c:v>
                </c:pt>
                <c:pt idx="953">
                  <c:v>64614.966003417969</c:v>
                </c:pt>
                <c:pt idx="954">
                  <c:v>64649.8427734375</c:v>
                </c:pt>
                <c:pt idx="955">
                  <c:v>64659.748107910156</c:v>
                </c:pt>
                <c:pt idx="956">
                  <c:v>64628.08203125</c:v>
                </c:pt>
                <c:pt idx="957">
                  <c:v>64556.7587890625</c:v>
                </c:pt>
                <c:pt idx="958">
                  <c:v>64467.949829101563</c:v>
                </c:pt>
                <c:pt idx="959">
                  <c:v>64388.740905761719</c:v>
                </c:pt>
                <c:pt idx="960">
                  <c:v>64334.017669677734</c:v>
                </c:pt>
                <c:pt idx="961">
                  <c:v>64306.637298583984</c:v>
                </c:pt>
                <c:pt idx="962">
                  <c:v>64303.828338623047</c:v>
                </c:pt>
                <c:pt idx="963">
                  <c:v>64311.990814208984</c:v>
                </c:pt>
                <c:pt idx="964">
                  <c:v>64320.524719238281</c:v>
                </c:pt>
                <c:pt idx="965">
                  <c:v>64329.687194824219</c:v>
                </c:pt>
                <c:pt idx="966">
                  <c:v>64337.449676513672</c:v>
                </c:pt>
                <c:pt idx="967">
                  <c:v>64338.555023193359</c:v>
                </c:pt>
                <c:pt idx="968">
                  <c:v>64323.517517089844</c:v>
                </c:pt>
                <c:pt idx="969">
                  <c:v>64301.308563232422</c:v>
                </c:pt>
                <c:pt idx="970">
                  <c:v>64280.928192138672</c:v>
                </c:pt>
                <c:pt idx="971">
                  <c:v>64269.976379394531</c:v>
                </c:pt>
                <c:pt idx="972">
                  <c:v>64266.024566650391</c:v>
                </c:pt>
                <c:pt idx="973">
                  <c:v>64260.729919433594</c:v>
                </c:pt>
                <c:pt idx="974">
                  <c:v>64252.063812255859</c:v>
                </c:pt>
                <c:pt idx="975">
                  <c:v>64249.454864501953</c:v>
                </c:pt>
                <c:pt idx="976">
                  <c:v>64259.103057861328</c:v>
                </c:pt>
                <c:pt idx="977">
                  <c:v>64282.179840087891</c:v>
                </c:pt>
                <c:pt idx="978">
                  <c:v>64336.170867919922</c:v>
                </c:pt>
                <c:pt idx="979">
                  <c:v>64452.961944580078</c:v>
                </c:pt>
                <c:pt idx="980">
                  <c:v>64652.724426269531</c:v>
                </c:pt>
                <c:pt idx="981">
                  <c:v>64927.715454101563</c:v>
                </c:pt>
                <c:pt idx="982">
                  <c:v>65224.906494140625</c:v>
                </c:pt>
                <c:pt idx="983">
                  <c:v>65444.154663085938</c:v>
                </c:pt>
                <c:pt idx="984">
                  <c:v>65489.631469726563</c:v>
                </c:pt>
                <c:pt idx="985">
                  <c:v>65344.85107421875</c:v>
                </c:pt>
                <c:pt idx="986">
                  <c:v>65084.5849609375</c:v>
                </c:pt>
                <c:pt idx="987">
                  <c:v>64813.97607421875</c:v>
                </c:pt>
                <c:pt idx="988">
                  <c:v>64603.481384277344</c:v>
                </c:pt>
                <c:pt idx="989">
                  <c:v>64472.701019287109</c:v>
                </c:pt>
                <c:pt idx="990">
                  <c:v>64412.720642089844</c:v>
                </c:pt>
                <c:pt idx="991">
                  <c:v>64400.340270996094</c:v>
                </c:pt>
                <c:pt idx="992">
                  <c:v>64413.645599365234</c:v>
                </c:pt>
                <c:pt idx="993">
                  <c:v>64435.379516601563</c:v>
                </c:pt>
                <c:pt idx="994">
                  <c:v>64465.199157714844</c:v>
                </c:pt>
                <c:pt idx="995">
                  <c:v>64523.590209960938</c:v>
                </c:pt>
                <c:pt idx="996">
                  <c:v>64664.124084472656</c:v>
                </c:pt>
                <c:pt idx="997">
                  <c:v>64952.829467773438</c:v>
                </c:pt>
                <c:pt idx="998">
                  <c:v>65405.106201171875</c:v>
                </c:pt>
                <c:pt idx="999">
                  <c:v>65948.011596679688</c:v>
                </c:pt>
                <c:pt idx="1000">
                  <c:v>66425.516845703125</c:v>
                </c:pt>
                <c:pt idx="1001">
                  <c:v>66662.907958984375</c:v>
                </c:pt>
                <c:pt idx="1002">
                  <c:v>66560.641845703125</c:v>
                </c:pt>
                <c:pt idx="1003">
                  <c:v>66162.57568359375</c:v>
                </c:pt>
                <c:pt idx="1004">
                  <c:v>65616.366821289063</c:v>
                </c:pt>
                <c:pt idx="1005">
                  <c:v>65090.729248046875</c:v>
                </c:pt>
                <c:pt idx="1006">
                  <c:v>64708.606079101563</c:v>
                </c:pt>
                <c:pt idx="1007">
                  <c:v>64512.511413574219</c:v>
                </c:pt>
                <c:pt idx="1008">
                  <c:v>64467.216735839844</c:v>
                </c:pt>
                <c:pt idx="1009">
                  <c:v>64503.950622558594</c:v>
                </c:pt>
                <c:pt idx="1010">
                  <c:v>64559.313110351563</c:v>
                </c:pt>
                <c:pt idx="1011">
                  <c:v>64580.561340332031</c:v>
                </c:pt>
                <c:pt idx="1012">
                  <c:v>64543.523803710938</c:v>
                </c:pt>
                <c:pt idx="1013">
                  <c:v>64462.057708740234</c:v>
                </c:pt>
                <c:pt idx="1014">
                  <c:v>64381.620178222656</c:v>
                </c:pt>
                <c:pt idx="1015">
                  <c:v>64333.982666015625</c:v>
                </c:pt>
                <c:pt idx="1016">
                  <c:v>64329.830871582031</c:v>
                </c:pt>
                <c:pt idx="1017">
                  <c:v>64352.450469970703</c:v>
                </c:pt>
                <c:pt idx="1018">
                  <c:v>64384.812957763672</c:v>
                </c:pt>
                <c:pt idx="1019">
                  <c:v>64409.889739990234</c:v>
                </c:pt>
                <c:pt idx="1020">
                  <c:v>64417.052215576172</c:v>
                </c:pt>
                <c:pt idx="1021">
                  <c:v>64397.471832275391</c:v>
                </c:pt>
                <c:pt idx="1022">
                  <c:v>64359.234313964844</c:v>
                </c:pt>
                <c:pt idx="1023">
                  <c:v>64320.682495117188</c:v>
                </c:pt>
                <c:pt idx="1024">
                  <c:v>64299.159271240234</c:v>
                </c:pt>
                <c:pt idx="1025">
                  <c:v>64299.036041259766</c:v>
                </c:pt>
                <c:pt idx="1026">
                  <c:v>64316.827087402344</c:v>
                </c:pt>
                <c:pt idx="1027">
                  <c:v>64393.103851318359</c:v>
                </c:pt>
                <c:pt idx="1028">
                  <c:v>64734.037780761719</c:v>
                </c:pt>
                <c:pt idx="1029">
                  <c:v>65951.885986328125</c:v>
                </c:pt>
                <c:pt idx="1030">
                  <c:v>69212.04833984375</c:v>
                </c:pt>
                <c:pt idx="1031">
                  <c:v>75908.125</c:v>
                </c:pt>
                <c:pt idx="1032">
                  <c:v>86636.744140625</c:v>
                </c:pt>
                <c:pt idx="1033">
                  <c:v>99807.62109375</c:v>
                </c:pt>
                <c:pt idx="1034">
                  <c:v>111075.75390625</c:v>
                </c:pt>
                <c:pt idx="1035">
                  <c:v>115040.83203125</c:v>
                </c:pt>
                <c:pt idx="1036">
                  <c:v>109429.22265625</c:v>
                </c:pt>
                <c:pt idx="1037">
                  <c:v>97215.15625</c:v>
                </c:pt>
                <c:pt idx="1038">
                  <c:v>84104.60546875</c:v>
                </c:pt>
                <c:pt idx="1039">
                  <c:v>74170.7392578125</c:v>
                </c:pt>
                <c:pt idx="1040">
                  <c:v>68395.21630859375</c:v>
                </c:pt>
                <c:pt idx="1041">
                  <c:v>65782.607177734375</c:v>
                </c:pt>
                <c:pt idx="1042">
                  <c:v>64882.598205566406</c:v>
                </c:pt>
                <c:pt idx="1043">
                  <c:v>64685.93212890625</c:v>
                </c:pt>
                <c:pt idx="1044">
                  <c:v>64735.951721191406</c:v>
                </c:pt>
                <c:pt idx="1045">
                  <c:v>64880.885620117188</c:v>
                </c:pt>
                <c:pt idx="1046">
                  <c:v>65040.219604492188</c:v>
                </c:pt>
                <c:pt idx="1047">
                  <c:v>65146.867797851563</c:v>
                </c:pt>
                <c:pt idx="1048">
                  <c:v>65157.858764648438</c:v>
                </c:pt>
                <c:pt idx="1049">
                  <c:v>65077.76416015625</c:v>
                </c:pt>
                <c:pt idx="1050">
                  <c:v>64938.240905761719</c:v>
                </c:pt>
                <c:pt idx="1051">
                  <c:v>64796.689086914063</c:v>
                </c:pt>
                <c:pt idx="1052">
                  <c:v>64714.108703613281</c:v>
                </c:pt>
                <c:pt idx="1053">
                  <c:v>64708.699768066406</c:v>
                </c:pt>
                <c:pt idx="1054">
                  <c:v>64745.433715820313</c:v>
                </c:pt>
                <c:pt idx="1055">
                  <c:v>64769.367614746094</c:v>
                </c:pt>
                <c:pt idx="1056">
                  <c:v>64754.730102539063</c:v>
                </c:pt>
                <c:pt idx="1057">
                  <c:v>64715.121154785156</c:v>
                </c:pt>
                <c:pt idx="1058">
                  <c:v>64693.712158203125</c:v>
                </c:pt>
                <c:pt idx="1059">
                  <c:v>64710.446105957031</c:v>
                </c:pt>
                <c:pt idx="1060">
                  <c:v>64749.065734863281</c:v>
                </c:pt>
                <c:pt idx="1061">
                  <c:v>64767.313903808594</c:v>
                </c:pt>
                <c:pt idx="1062">
                  <c:v>64735.533508300781</c:v>
                </c:pt>
                <c:pt idx="1063">
                  <c:v>64644.296020507813</c:v>
                </c:pt>
                <c:pt idx="1064">
                  <c:v>64515.829895019531</c:v>
                </c:pt>
                <c:pt idx="1065">
                  <c:v>64388.935272216797</c:v>
                </c:pt>
                <c:pt idx="1066">
                  <c:v>64301.269165039063</c:v>
                </c:pt>
                <c:pt idx="1067">
                  <c:v>64260.37451171875</c:v>
                </c:pt>
                <c:pt idx="1068">
                  <c:v>64248.05126953125</c:v>
                </c:pt>
                <c:pt idx="1069">
                  <c:v>64241.899475097656</c:v>
                </c:pt>
                <c:pt idx="1070">
                  <c:v>64238.34765625</c:v>
                </c:pt>
                <c:pt idx="1071">
                  <c:v>64230.538711547852</c:v>
                </c:pt>
                <c:pt idx="1072">
                  <c:v>64216.129760742188</c:v>
                </c:pt>
                <c:pt idx="1073">
                  <c:v>64199.206527709961</c:v>
                </c:pt>
                <c:pt idx="1074">
                  <c:v>64185.426162719727</c:v>
                </c:pt>
                <c:pt idx="1075">
                  <c:v>64164.102920532227</c:v>
                </c:pt>
                <c:pt idx="1076">
                  <c:v>64137.265396118164</c:v>
                </c:pt>
                <c:pt idx="1077">
                  <c:v>64118.142166137695</c:v>
                </c:pt>
                <c:pt idx="1078">
                  <c:v>64112.390365600586</c:v>
                </c:pt>
                <c:pt idx="1079">
                  <c:v>64108.78141784668</c:v>
                </c:pt>
                <c:pt idx="1080">
                  <c:v>64107.286750793457</c:v>
                </c:pt>
                <c:pt idx="1081">
                  <c:v>64106.36351776123</c:v>
                </c:pt>
                <c:pt idx="1082">
                  <c:v>64109.383140563965</c:v>
                </c:pt>
                <c:pt idx="1083">
                  <c:v>64110.888481140137</c:v>
                </c:pt>
                <c:pt idx="1084">
                  <c:v>64118.65096282959</c:v>
                </c:pt>
                <c:pt idx="1085">
                  <c:v>64126.756301879883</c:v>
                </c:pt>
                <c:pt idx="1086">
                  <c:v>64132.175918579102</c:v>
                </c:pt>
                <c:pt idx="1087">
                  <c:v>64130.452682495117</c:v>
                </c:pt>
                <c:pt idx="1088">
                  <c:v>64129.929458618164</c:v>
                </c:pt>
                <c:pt idx="1089">
                  <c:v>64132.291931152344</c:v>
                </c:pt>
                <c:pt idx="1090">
                  <c:v>64136.282989501953</c:v>
                </c:pt>
                <c:pt idx="1091">
                  <c:v>64134.81689453125</c:v>
                </c:pt>
                <c:pt idx="1092">
                  <c:v>64136.636520385742</c:v>
                </c:pt>
                <c:pt idx="1093">
                  <c:v>64145.741851806641</c:v>
                </c:pt>
                <c:pt idx="1094">
                  <c:v>64153.704330444336</c:v>
                </c:pt>
                <c:pt idx="1095">
                  <c:v>64151.981109619141</c:v>
                </c:pt>
                <c:pt idx="1096">
                  <c:v>64144.486434936523</c:v>
                </c:pt>
                <c:pt idx="1097">
                  <c:v>64131.934631347656</c:v>
                </c:pt>
                <c:pt idx="1098">
                  <c:v>64119.982833862305</c:v>
                </c:pt>
                <c:pt idx="1099">
                  <c:v>64120.573883056641</c:v>
                </c:pt>
                <c:pt idx="1100">
                  <c:v>64137.30778503418</c:v>
                </c:pt>
                <c:pt idx="1101">
                  <c:v>64159.641708374023</c:v>
                </c:pt>
                <c:pt idx="1102">
                  <c:v>64177.604187011719</c:v>
                </c:pt>
                <c:pt idx="1103">
                  <c:v>64184.709518432617</c:v>
                </c:pt>
                <c:pt idx="1104">
                  <c:v>64177.671997070313</c:v>
                </c:pt>
                <c:pt idx="1105">
                  <c:v>64160.434478759766</c:v>
                </c:pt>
                <c:pt idx="1106">
                  <c:v>64146.111251831055</c:v>
                </c:pt>
                <c:pt idx="1107">
                  <c:v>64139.816589355469</c:v>
                </c:pt>
                <c:pt idx="1108">
                  <c:v>64129.579071044922</c:v>
                </c:pt>
                <c:pt idx="1109">
                  <c:v>64112.741546630859</c:v>
                </c:pt>
                <c:pt idx="1110">
                  <c:v>64105.732597351074</c:v>
                </c:pt>
                <c:pt idx="1111">
                  <c:v>64108.895080566406</c:v>
                </c:pt>
                <c:pt idx="1112">
                  <c:v>64106.371841430664</c:v>
                </c:pt>
                <c:pt idx="1113">
                  <c:v>64100.048606872559</c:v>
                </c:pt>
                <c:pt idx="1114">
                  <c:v>64101.953948974609</c:v>
                </c:pt>
                <c:pt idx="1115">
                  <c:v>64109.144996643066</c:v>
                </c:pt>
                <c:pt idx="1116">
                  <c:v>64122.707481384277</c:v>
                </c:pt>
                <c:pt idx="1117">
                  <c:v>64151.755676269531</c:v>
                </c:pt>
                <c:pt idx="1118">
                  <c:v>64184.318161010742</c:v>
                </c:pt>
                <c:pt idx="1119">
                  <c:v>64201.137771606445</c:v>
                </c:pt>
                <c:pt idx="1120">
                  <c:v>64198.014541625977</c:v>
                </c:pt>
                <c:pt idx="1121">
                  <c:v>64181.205596923828</c:v>
                </c:pt>
                <c:pt idx="1122">
                  <c:v>64155.453796386719</c:v>
                </c:pt>
                <c:pt idx="1123">
                  <c:v>64131.501983642578</c:v>
                </c:pt>
                <c:pt idx="1124">
                  <c:v>64119.00732421875</c:v>
                </c:pt>
                <c:pt idx="1125">
                  <c:v>64114.455520629883</c:v>
                </c:pt>
                <c:pt idx="1126">
                  <c:v>64114.246574401855</c:v>
                </c:pt>
                <c:pt idx="1127">
                  <c:v>64112.094764709473</c:v>
                </c:pt>
                <c:pt idx="1128">
                  <c:v>64106.542961120605</c:v>
                </c:pt>
                <c:pt idx="1129">
                  <c:v>64099.448295593262</c:v>
                </c:pt>
                <c:pt idx="1130">
                  <c:v>64102.610778808594</c:v>
                </c:pt>
                <c:pt idx="1131">
                  <c:v>64112.773262023926</c:v>
                </c:pt>
                <c:pt idx="1132">
                  <c:v>64121.992881774902</c:v>
                </c:pt>
                <c:pt idx="1133">
                  <c:v>64132.383941650391</c:v>
                </c:pt>
                <c:pt idx="1134">
                  <c:v>64161.974990844727</c:v>
                </c:pt>
                <c:pt idx="1135">
                  <c:v>64212.137466430664</c:v>
                </c:pt>
                <c:pt idx="1136">
                  <c:v>64270.071380615234</c:v>
                </c:pt>
                <c:pt idx="1137">
                  <c:v>64321.119567871094</c:v>
                </c:pt>
                <c:pt idx="1138">
                  <c:v>64361.482055664063</c:v>
                </c:pt>
                <c:pt idx="1139">
                  <c:v>64392.215972900391</c:v>
                </c:pt>
                <c:pt idx="1140">
                  <c:v>64418.721313476563</c:v>
                </c:pt>
                <c:pt idx="1141">
                  <c:v>64448.140930175781</c:v>
                </c:pt>
                <c:pt idx="1142">
                  <c:v>64469.274841308594</c:v>
                </c:pt>
                <c:pt idx="1143">
                  <c:v>64460.723022460938</c:v>
                </c:pt>
                <c:pt idx="1144">
                  <c:v>64414.7998046875</c:v>
                </c:pt>
                <c:pt idx="1145">
                  <c:v>64346.819427490234</c:v>
                </c:pt>
                <c:pt idx="1146">
                  <c:v>64275.353332519531</c:v>
                </c:pt>
                <c:pt idx="1147">
                  <c:v>64219.401519775391</c:v>
                </c:pt>
                <c:pt idx="1148">
                  <c:v>64190.992568969727</c:v>
                </c:pt>
                <c:pt idx="1149">
                  <c:v>64187.355056762695</c:v>
                </c:pt>
                <c:pt idx="1150">
                  <c:v>64189.917526245117</c:v>
                </c:pt>
                <c:pt idx="1151">
                  <c:v>64184.194305419922</c:v>
                </c:pt>
                <c:pt idx="1152">
                  <c:v>64171.128204345703</c:v>
                </c:pt>
                <c:pt idx="1153">
                  <c:v>64155.147827148438</c:v>
                </c:pt>
                <c:pt idx="1154">
                  <c:v>64136.28173828125</c:v>
                </c:pt>
                <c:pt idx="1155">
                  <c:v>64118.158508300781</c:v>
                </c:pt>
                <c:pt idx="1156">
                  <c:v>64112.378128051758</c:v>
                </c:pt>
                <c:pt idx="1157">
                  <c:v>64116.140609741211</c:v>
                </c:pt>
                <c:pt idx="1158">
                  <c:v>64122.503089904785</c:v>
                </c:pt>
                <c:pt idx="1159">
                  <c:v>64134.351287841797</c:v>
                </c:pt>
                <c:pt idx="1160">
                  <c:v>64164.056625366211</c:v>
                </c:pt>
                <c:pt idx="1161">
                  <c:v>64210.333389282227</c:v>
                </c:pt>
                <c:pt idx="1162">
                  <c:v>64270.438720703125</c:v>
                </c:pt>
                <c:pt idx="1163">
                  <c:v>64345.344055175781</c:v>
                </c:pt>
                <c:pt idx="1164">
                  <c:v>64437.906555175781</c:v>
                </c:pt>
                <c:pt idx="1165">
                  <c:v>64535.240478515625</c:v>
                </c:pt>
                <c:pt idx="1166">
                  <c:v>64614.117248535156</c:v>
                </c:pt>
                <c:pt idx="1167">
                  <c:v>64642.50830078125</c:v>
                </c:pt>
                <c:pt idx="1168">
                  <c:v>64601.556457519531</c:v>
                </c:pt>
                <c:pt idx="1169">
                  <c:v>64507.233245849609</c:v>
                </c:pt>
                <c:pt idx="1170">
                  <c:v>64397.881439208984</c:v>
                </c:pt>
                <c:pt idx="1171">
                  <c:v>64303.186767578125</c:v>
                </c:pt>
                <c:pt idx="1172">
                  <c:v>64239.663528442383</c:v>
                </c:pt>
                <c:pt idx="1173">
                  <c:v>64206.797439575195</c:v>
                </c:pt>
                <c:pt idx="1174">
                  <c:v>64192.474212646484</c:v>
                </c:pt>
                <c:pt idx="1175">
                  <c:v>64184.008117675781</c:v>
                </c:pt>
                <c:pt idx="1176">
                  <c:v>64173.74201965332</c:v>
                </c:pt>
                <c:pt idx="1177">
                  <c:v>64161.418792724609</c:v>
                </c:pt>
                <c:pt idx="1178">
                  <c:v>64153.152694702148</c:v>
                </c:pt>
                <c:pt idx="1179">
                  <c:v>64156.286605834961</c:v>
                </c:pt>
                <c:pt idx="1180">
                  <c:v>64168.134811401367</c:v>
                </c:pt>
                <c:pt idx="1181">
                  <c:v>64183.211578369141</c:v>
                </c:pt>
                <c:pt idx="1182">
                  <c:v>64189.631195068359</c:v>
                </c:pt>
                <c:pt idx="1183">
                  <c:v>64175.19367980957</c:v>
                </c:pt>
                <c:pt idx="1184">
                  <c:v>64152.041870117188</c:v>
                </c:pt>
                <c:pt idx="1185">
                  <c:v>64138.147201538086</c:v>
                </c:pt>
                <c:pt idx="1186">
                  <c:v>64138.395401000977</c:v>
                </c:pt>
                <c:pt idx="1187">
                  <c:v>64146.615020751953</c:v>
                </c:pt>
                <c:pt idx="1188">
                  <c:v>64161.148941040039</c:v>
                </c:pt>
                <c:pt idx="1189">
                  <c:v>64171.425704956055</c:v>
                </c:pt>
                <c:pt idx="1190">
                  <c:v>64167.902465820313</c:v>
                </c:pt>
                <c:pt idx="1191">
                  <c:v>64148.75065612793</c:v>
                </c:pt>
                <c:pt idx="1192">
                  <c:v>64123.827430725098</c:v>
                </c:pt>
                <c:pt idx="1193">
                  <c:v>64104.504196166992</c:v>
                </c:pt>
                <c:pt idx="1194">
                  <c:v>64091.466674804688</c:v>
                </c:pt>
                <c:pt idx="1195">
                  <c:v>64073.714866638184</c:v>
                </c:pt>
                <c:pt idx="1196">
                  <c:v>64057.448780059814</c:v>
                </c:pt>
                <c:pt idx="1197">
                  <c:v>64056.182689666748</c:v>
                </c:pt>
                <c:pt idx="1198">
                  <c:v>64064.516593933105</c:v>
                </c:pt>
                <c:pt idx="1199">
                  <c:v>64068.336219787598</c:v>
                </c:pt>
                <c:pt idx="1200">
                  <c:v>64068.755844116211</c:v>
                </c:pt>
                <c:pt idx="1201">
                  <c:v>64072.061180114746</c:v>
                </c:pt>
                <c:pt idx="1202">
                  <c:v>64076.966522216797</c:v>
                </c:pt>
                <c:pt idx="1203">
                  <c:v>64081.471855163574</c:v>
                </c:pt>
                <c:pt idx="1204">
                  <c:v>64084.605766296387</c:v>
                </c:pt>
                <c:pt idx="1205">
                  <c:v>64089.99681854248</c:v>
                </c:pt>
                <c:pt idx="1206">
                  <c:v>64098.530723571777</c:v>
                </c:pt>
                <c:pt idx="1207">
                  <c:v>64103.378921508789</c:v>
                </c:pt>
                <c:pt idx="1208">
                  <c:v>64100.712829589844</c:v>
                </c:pt>
                <c:pt idx="1209">
                  <c:v>64096.932456970215</c:v>
                </c:pt>
                <c:pt idx="1210">
                  <c:v>64102.723503112793</c:v>
                </c:pt>
                <c:pt idx="1211">
                  <c:v>64113.057418823242</c:v>
                </c:pt>
                <c:pt idx="1212">
                  <c:v>64113.334182739258</c:v>
                </c:pt>
                <c:pt idx="1213">
                  <c:v>64097.49666595459</c:v>
                </c:pt>
                <c:pt idx="1214">
                  <c:v>64080.802001953125</c:v>
                </c:pt>
                <c:pt idx="1215">
                  <c:v>64074.621620178223</c:v>
                </c:pt>
                <c:pt idx="1216">
                  <c:v>64072.612678527832</c:v>
                </c:pt>
                <c:pt idx="1217">
                  <c:v>64063.089443206787</c:v>
                </c:pt>
                <c:pt idx="1218">
                  <c:v>64050.251922607422</c:v>
                </c:pt>
                <c:pt idx="1219">
                  <c:v>64039.671546936035</c:v>
                </c:pt>
                <c:pt idx="1220">
                  <c:v>64034.862598419189</c:v>
                </c:pt>
                <c:pt idx="1221">
                  <c:v>64035.625076293945</c:v>
                </c:pt>
                <c:pt idx="1222">
                  <c:v>64041.244701385498</c:v>
                </c:pt>
                <c:pt idx="1223">
                  <c:v>64044.550037384033</c:v>
                </c:pt>
                <c:pt idx="1224">
                  <c:v>64044.369663238525</c:v>
                </c:pt>
                <c:pt idx="1225">
                  <c:v>64043.04642868042</c:v>
                </c:pt>
                <c:pt idx="1226">
                  <c:v>64043.751766204834</c:v>
                </c:pt>
                <c:pt idx="1227">
                  <c:v>64044.714248657227</c:v>
                </c:pt>
                <c:pt idx="1228">
                  <c:v>64046.619583129883</c:v>
                </c:pt>
                <c:pt idx="1229">
                  <c:v>64052.839206695557</c:v>
                </c:pt>
                <c:pt idx="1230">
                  <c:v>64066.373115539551</c:v>
                </c:pt>
                <c:pt idx="1231">
                  <c:v>64082.164169311523</c:v>
                </c:pt>
                <c:pt idx="1232">
                  <c:v>64094.298080444336</c:v>
                </c:pt>
                <c:pt idx="1233">
                  <c:v>64102.431983947754</c:v>
                </c:pt>
                <c:pt idx="1234">
                  <c:v>64107.165893554688</c:v>
                </c:pt>
                <c:pt idx="1235">
                  <c:v>64108.27123260498</c:v>
                </c:pt>
                <c:pt idx="1236">
                  <c:v>64106.890853881836</c:v>
                </c:pt>
                <c:pt idx="1237">
                  <c:v>64107.93904876709</c:v>
                </c:pt>
                <c:pt idx="1238">
                  <c:v>64116.18724822998</c:v>
                </c:pt>
                <c:pt idx="1239">
                  <c:v>64127.921157836914</c:v>
                </c:pt>
                <c:pt idx="1240">
                  <c:v>64136.740783691406</c:v>
                </c:pt>
                <c:pt idx="1241">
                  <c:v>64143.931823730469</c:v>
                </c:pt>
                <c:pt idx="1242">
                  <c:v>64147.465744018555</c:v>
                </c:pt>
                <c:pt idx="1243">
                  <c:v>64144.342514038086</c:v>
                </c:pt>
                <c:pt idx="1244">
                  <c:v>64131.647842407227</c:v>
                </c:pt>
                <c:pt idx="1245">
                  <c:v>64116.296035766602</c:v>
                </c:pt>
                <c:pt idx="1246">
                  <c:v>64102.544235229492</c:v>
                </c:pt>
                <c:pt idx="1247">
                  <c:v>64095.078140258789</c:v>
                </c:pt>
                <c:pt idx="1248">
                  <c:v>64090.497764587402</c:v>
                </c:pt>
                <c:pt idx="1249">
                  <c:v>64086.145957946777</c:v>
                </c:pt>
                <c:pt idx="1250">
                  <c:v>64089.90843963623</c:v>
                </c:pt>
                <c:pt idx="1251">
                  <c:v>64099.670921325684</c:v>
                </c:pt>
                <c:pt idx="1252">
                  <c:v>64107.376258850098</c:v>
                </c:pt>
                <c:pt idx="1253">
                  <c:v>64109.681594848633</c:v>
                </c:pt>
                <c:pt idx="1254">
                  <c:v>64112.872650146484</c:v>
                </c:pt>
                <c:pt idx="1255">
                  <c:v>64115.263702392578</c:v>
                </c:pt>
                <c:pt idx="1256">
                  <c:v>64116.940467834473</c:v>
                </c:pt>
                <c:pt idx="1257">
                  <c:v>64112.331520080566</c:v>
                </c:pt>
                <c:pt idx="1258">
                  <c:v>64104.265426635742</c:v>
                </c:pt>
                <c:pt idx="1259">
                  <c:v>64096.513626098633</c:v>
                </c:pt>
                <c:pt idx="1260">
                  <c:v>64096.247535705566</c:v>
                </c:pt>
                <c:pt idx="1261">
                  <c:v>64097.667152404785</c:v>
                </c:pt>
                <c:pt idx="1262">
                  <c:v>64102.372489929199</c:v>
                </c:pt>
                <c:pt idx="1263">
                  <c:v>64104.392120361328</c:v>
                </c:pt>
                <c:pt idx="1264">
                  <c:v>64105.554595947266</c:v>
                </c:pt>
                <c:pt idx="1265">
                  <c:v>64112.088508605957</c:v>
                </c:pt>
                <c:pt idx="1266">
                  <c:v>64125.593841552734</c:v>
                </c:pt>
                <c:pt idx="1267">
                  <c:v>64133.270614624023</c:v>
                </c:pt>
                <c:pt idx="1268">
                  <c:v>64135.090240478516</c:v>
                </c:pt>
                <c:pt idx="1269">
                  <c:v>64136.624145507813</c:v>
                </c:pt>
                <c:pt idx="1270">
                  <c:v>64131.872344970703</c:v>
                </c:pt>
                <c:pt idx="1271">
                  <c:v>64116.034820556641</c:v>
                </c:pt>
                <c:pt idx="1272">
                  <c:v>64099.140159606934</c:v>
                </c:pt>
                <c:pt idx="1273">
                  <c:v>64093.188346862793</c:v>
                </c:pt>
                <c:pt idx="1274">
                  <c:v>64093.722259521484</c:v>
                </c:pt>
                <c:pt idx="1275">
                  <c:v>64091.399024963379</c:v>
                </c:pt>
                <c:pt idx="1276">
                  <c:v>64083.30436706543</c:v>
                </c:pt>
                <c:pt idx="1277">
                  <c:v>64076.923988342285</c:v>
                </c:pt>
                <c:pt idx="1278">
                  <c:v>64080.400756835938</c:v>
                </c:pt>
                <c:pt idx="1279">
                  <c:v>64097.906089782715</c:v>
                </c:pt>
                <c:pt idx="1280">
                  <c:v>64124.55428314209</c:v>
                </c:pt>
                <c:pt idx="1281">
                  <c:v>64148.088195800781</c:v>
                </c:pt>
                <c:pt idx="1282">
                  <c:v>64154.650680541992</c:v>
                </c:pt>
                <c:pt idx="1283">
                  <c:v>64143.356018066406</c:v>
                </c:pt>
                <c:pt idx="1284">
                  <c:v>64131.689926147461</c:v>
                </c:pt>
                <c:pt idx="1285">
                  <c:v>64129.395263671875</c:v>
                </c:pt>
                <c:pt idx="1286">
                  <c:v>64131.243453979492</c:v>
                </c:pt>
                <c:pt idx="1287">
                  <c:v>64127.234504699707</c:v>
                </c:pt>
                <c:pt idx="1288">
                  <c:v>64119.911270141602</c:v>
                </c:pt>
                <c:pt idx="1289">
                  <c:v>64116.016609191895</c:v>
                </c:pt>
                <c:pt idx="1290">
                  <c:v>64117.779090881348</c:v>
                </c:pt>
                <c:pt idx="1291">
                  <c:v>64127.455856323242</c:v>
                </c:pt>
                <c:pt idx="1292">
                  <c:v>64137.732620239258</c:v>
                </c:pt>
                <c:pt idx="1293">
                  <c:v>64142.609390258789</c:v>
                </c:pt>
                <c:pt idx="1294">
                  <c:v>64142.314727783203</c:v>
                </c:pt>
                <c:pt idx="1295">
                  <c:v>64148.020065307617</c:v>
                </c:pt>
                <c:pt idx="1296">
                  <c:v>64169.011123657227</c:v>
                </c:pt>
                <c:pt idx="1297">
                  <c:v>64199.973602294922</c:v>
                </c:pt>
                <c:pt idx="1298">
                  <c:v>64229.250366210938</c:v>
                </c:pt>
                <c:pt idx="1299">
                  <c:v>64244.584274291992</c:v>
                </c:pt>
                <c:pt idx="1300">
                  <c:v>64243.289611816406</c:v>
                </c:pt>
                <c:pt idx="1301">
                  <c:v>64230.880661010742</c:v>
                </c:pt>
                <c:pt idx="1302">
                  <c:v>64210.500289916992</c:v>
                </c:pt>
                <c:pt idx="1303">
                  <c:v>64189.234191894531</c:v>
                </c:pt>
                <c:pt idx="1304">
                  <c:v>64180.653823852539</c:v>
                </c:pt>
                <c:pt idx="1305">
                  <c:v>64193.187728881836</c:v>
                </c:pt>
                <c:pt idx="1306">
                  <c:v>64213.921630859375</c:v>
                </c:pt>
                <c:pt idx="1307">
                  <c:v>64225.084121704102</c:v>
                </c:pt>
                <c:pt idx="1308">
                  <c:v>64230.418029785156</c:v>
                </c:pt>
                <c:pt idx="1309">
                  <c:v>64236.009078979492</c:v>
                </c:pt>
                <c:pt idx="1310">
                  <c:v>64241.17155456543</c:v>
                </c:pt>
                <c:pt idx="1311">
                  <c:v>64239.762603759766</c:v>
                </c:pt>
                <c:pt idx="1312">
                  <c:v>64229.46794128418</c:v>
                </c:pt>
                <c:pt idx="1313">
                  <c:v>64211.201858520508</c:v>
                </c:pt>
                <c:pt idx="1314">
                  <c:v>64200.050048828125</c:v>
                </c:pt>
                <c:pt idx="1315">
                  <c:v>64219.841110229492</c:v>
                </c:pt>
                <c:pt idx="1316">
                  <c:v>64267.460723876953</c:v>
                </c:pt>
                <c:pt idx="1317">
                  <c:v>64321.394622802734</c:v>
                </c:pt>
                <c:pt idx="1318">
                  <c:v>64365.128540039063</c:v>
                </c:pt>
                <c:pt idx="1319">
                  <c:v>64397.691040039063</c:v>
                </c:pt>
                <c:pt idx="1320">
                  <c:v>64415.710662841797</c:v>
                </c:pt>
                <c:pt idx="1321">
                  <c:v>64415.301696777344</c:v>
                </c:pt>
                <c:pt idx="1322">
                  <c:v>64400.864196777344</c:v>
                </c:pt>
                <c:pt idx="1323">
                  <c:v>64386.312377929688</c:v>
                </c:pt>
                <c:pt idx="1324">
                  <c:v>64383.303436279297</c:v>
                </c:pt>
                <c:pt idx="1325">
                  <c:v>64396.551635742188</c:v>
                </c:pt>
                <c:pt idx="1326">
                  <c:v>64423.999816894531</c:v>
                </c:pt>
                <c:pt idx="1327">
                  <c:v>64459.162292480469</c:v>
                </c:pt>
                <c:pt idx="1328">
                  <c:v>64481.410491943359</c:v>
                </c:pt>
                <c:pt idx="1329">
                  <c:v>64478.972961425781</c:v>
                </c:pt>
                <c:pt idx="1330">
                  <c:v>64452.878326416016</c:v>
                </c:pt>
                <c:pt idx="1331">
                  <c:v>64414.783660888672</c:v>
                </c:pt>
                <c:pt idx="1332">
                  <c:v>64377.660400390625</c:v>
                </c:pt>
                <c:pt idx="1333">
                  <c:v>64351.708618164063</c:v>
                </c:pt>
                <c:pt idx="1334">
                  <c:v>64337.071105957031</c:v>
                </c:pt>
                <c:pt idx="1335">
                  <c:v>64330.690704345703</c:v>
                </c:pt>
                <c:pt idx="1336">
                  <c:v>64337.910339355469</c:v>
                </c:pt>
                <c:pt idx="1337">
                  <c:v>64357.129974365234</c:v>
                </c:pt>
                <c:pt idx="1338">
                  <c:v>64376.235290527344</c:v>
                </c:pt>
                <c:pt idx="1339">
                  <c:v>64382.883483886719</c:v>
                </c:pt>
                <c:pt idx="1340">
                  <c:v>64378.560272216797</c:v>
                </c:pt>
                <c:pt idx="1341">
                  <c:v>64373.465606689453</c:v>
                </c:pt>
                <c:pt idx="1342">
                  <c:v>64369.228088378906</c:v>
                </c:pt>
                <c:pt idx="1343">
                  <c:v>64364.304840087891</c:v>
                </c:pt>
                <c:pt idx="1344">
                  <c:v>64365.238739013672</c:v>
                </c:pt>
                <c:pt idx="1345">
                  <c:v>64370.001220703125</c:v>
                </c:pt>
                <c:pt idx="1346">
                  <c:v>64365.420867919922</c:v>
                </c:pt>
                <c:pt idx="1347">
                  <c:v>64350.383331298828</c:v>
                </c:pt>
                <c:pt idx="1348">
                  <c:v>64348.860107421875</c:v>
                </c:pt>
                <c:pt idx="1349">
                  <c:v>64362.194000244141</c:v>
                </c:pt>
                <c:pt idx="1350">
                  <c:v>64374.18505859375</c:v>
                </c:pt>
                <c:pt idx="1351">
                  <c:v>64381.147552490234</c:v>
                </c:pt>
                <c:pt idx="1352">
                  <c:v>64396.42431640625</c:v>
                </c:pt>
                <c:pt idx="1353">
                  <c:v>64422.015350341797</c:v>
                </c:pt>
                <c:pt idx="1354">
                  <c:v>64452.863555908203</c:v>
                </c:pt>
                <c:pt idx="1355">
                  <c:v>64484.34033203125</c:v>
                </c:pt>
                <c:pt idx="1356">
                  <c:v>64515.731384277344</c:v>
                </c:pt>
                <c:pt idx="1357">
                  <c:v>64543.63671875</c:v>
                </c:pt>
                <c:pt idx="1358">
                  <c:v>64567.627746582031</c:v>
                </c:pt>
                <c:pt idx="1359">
                  <c:v>64575.447387695313</c:v>
                </c:pt>
                <c:pt idx="1360">
                  <c:v>64561.409851074219</c:v>
                </c:pt>
                <c:pt idx="1361">
                  <c:v>64543.572326660156</c:v>
                </c:pt>
                <c:pt idx="1362">
                  <c:v>64532.820556640625</c:v>
                </c:pt>
                <c:pt idx="1363">
                  <c:v>64528.382995605469</c:v>
                </c:pt>
                <c:pt idx="1364">
                  <c:v>64522.431213378906</c:v>
                </c:pt>
                <c:pt idx="1365">
                  <c:v>64509.193695068359</c:v>
                </c:pt>
                <c:pt idx="1366">
                  <c:v>64487.270477294922</c:v>
                </c:pt>
                <c:pt idx="1367">
                  <c:v>64479.718658447266</c:v>
                </c:pt>
                <c:pt idx="1368">
                  <c:v>64494.481140136719</c:v>
                </c:pt>
                <c:pt idx="1369">
                  <c:v>64499.786468505859</c:v>
                </c:pt>
                <c:pt idx="1370">
                  <c:v>64485.491821289063</c:v>
                </c:pt>
                <c:pt idx="1371">
                  <c:v>64477.082855224609</c:v>
                </c:pt>
                <c:pt idx="1372">
                  <c:v>64487.016784667969</c:v>
                </c:pt>
                <c:pt idx="1373">
                  <c:v>64507.550689697266</c:v>
                </c:pt>
                <c:pt idx="1374">
                  <c:v>64545.027465820313</c:v>
                </c:pt>
                <c:pt idx="1375">
                  <c:v>64597.18994140625</c:v>
                </c:pt>
                <c:pt idx="1376">
                  <c:v>64641.8095703125</c:v>
                </c:pt>
                <c:pt idx="1377">
                  <c:v>64658.800598144531</c:v>
                </c:pt>
                <c:pt idx="1378">
                  <c:v>64649.1630859375</c:v>
                </c:pt>
                <c:pt idx="1379">
                  <c:v>64616.78271484375</c:v>
                </c:pt>
                <c:pt idx="1380">
                  <c:v>64570.488037109375</c:v>
                </c:pt>
                <c:pt idx="1381">
                  <c:v>64520.13623046875</c:v>
                </c:pt>
                <c:pt idx="1382">
                  <c:v>64477.241577148438</c:v>
                </c:pt>
                <c:pt idx="1383">
                  <c:v>64443.346923828125</c:v>
                </c:pt>
                <c:pt idx="1384">
                  <c:v>64414.9951171875</c:v>
                </c:pt>
                <c:pt idx="1385">
                  <c:v>64395.586181640625</c:v>
                </c:pt>
                <c:pt idx="1386">
                  <c:v>64389.405792236328</c:v>
                </c:pt>
                <c:pt idx="1387">
                  <c:v>64397.396850585938</c:v>
                </c:pt>
                <c:pt idx="1388">
                  <c:v>64404.416473388672</c:v>
                </c:pt>
                <c:pt idx="1389">
                  <c:v>64403.521820068359</c:v>
                </c:pt>
                <c:pt idx="1390">
                  <c:v>64392.055725097656</c:v>
                </c:pt>
                <c:pt idx="1391">
                  <c:v>64379.418182373047</c:v>
                </c:pt>
                <c:pt idx="1392">
                  <c:v>64368.637817382813</c:v>
                </c:pt>
                <c:pt idx="1393">
                  <c:v>64363.571716308594</c:v>
                </c:pt>
                <c:pt idx="1394">
                  <c:v>64361.162780761719</c:v>
                </c:pt>
                <c:pt idx="1395">
                  <c:v>64366.382415771484</c:v>
                </c:pt>
                <c:pt idx="1396">
                  <c:v>64376.916320800781</c:v>
                </c:pt>
                <c:pt idx="1397">
                  <c:v>64380.764495849609</c:v>
                </c:pt>
                <c:pt idx="1398">
                  <c:v>64374.441284179688</c:v>
                </c:pt>
                <c:pt idx="1399">
                  <c:v>64368.746612548828</c:v>
                </c:pt>
                <c:pt idx="1400">
                  <c:v>64371.337677001953</c:v>
                </c:pt>
                <c:pt idx="1401">
                  <c:v>64378.014434814453</c:v>
                </c:pt>
                <c:pt idx="1402">
                  <c:v>64387.976898193359</c:v>
                </c:pt>
                <c:pt idx="1403">
                  <c:v>64399.567962646484</c:v>
                </c:pt>
                <c:pt idx="1404">
                  <c:v>64413.930450439453</c:v>
                </c:pt>
                <c:pt idx="1405">
                  <c:v>64430.635772705078</c:v>
                </c:pt>
                <c:pt idx="1406">
                  <c:v>64441.169677734375</c:v>
                </c:pt>
                <c:pt idx="1407">
                  <c:v>64440.989318847656</c:v>
                </c:pt>
                <c:pt idx="1408">
                  <c:v>64432.866088867188</c:v>
                </c:pt>
                <c:pt idx="1409">
                  <c:v>64421.199981689453</c:v>
                </c:pt>
                <c:pt idx="1410">
                  <c:v>64404.505310058594</c:v>
                </c:pt>
                <c:pt idx="1411">
                  <c:v>64385.610656738281</c:v>
                </c:pt>
                <c:pt idx="1412">
                  <c:v>64368.658843994141</c:v>
                </c:pt>
                <c:pt idx="1413">
                  <c:v>64362.021331787109</c:v>
                </c:pt>
                <c:pt idx="1414">
                  <c:v>64373.155242919922</c:v>
                </c:pt>
                <c:pt idx="1415">
                  <c:v>64409.88916015625</c:v>
                </c:pt>
                <c:pt idx="1416">
                  <c:v>64480.451629638672</c:v>
                </c:pt>
                <c:pt idx="1417">
                  <c:v>64605.014099121094</c:v>
                </c:pt>
                <c:pt idx="1418">
                  <c:v>64803.348022460938</c:v>
                </c:pt>
                <c:pt idx="1419">
                  <c:v>65101.053344726563</c:v>
                </c:pt>
                <c:pt idx="1420">
                  <c:v>65580.1015625</c:v>
                </c:pt>
                <c:pt idx="1421">
                  <c:v>66391.349853515625</c:v>
                </c:pt>
                <c:pt idx="1422">
                  <c:v>67685.51220703125</c:v>
                </c:pt>
                <c:pt idx="1423">
                  <c:v>69510.64599609375</c:v>
                </c:pt>
                <c:pt idx="1424">
                  <c:v>71742.0087890625</c:v>
                </c:pt>
                <c:pt idx="1425">
                  <c:v>74025.1142578125</c:v>
                </c:pt>
                <c:pt idx="1426">
                  <c:v>75814.84765625</c:v>
                </c:pt>
                <c:pt idx="1427">
                  <c:v>76568.2392578125</c:v>
                </c:pt>
                <c:pt idx="1428">
                  <c:v>75999.916015625</c:v>
                </c:pt>
                <c:pt idx="1429">
                  <c:v>74261.220703125</c:v>
                </c:pt>
                <c:pt idx="1430">
                  <c:v>71867.2978515625</c:v>
                </c:pt>
                <c:pt idx="1431">
                  <c:v>69442.06005859375</c:v>
                </c:pt>
                <c:pt idx="1432">
                  <c:v>67439.508544921875</c:v>
                </c:pt>
                <c:pt idx="1433">
                  <c:v>66042.38525390625</c:v>
                </c:pt>
                <c:pt idx="1434">
                  <c:v>65202.204833984375</c:v>
                </c:pt>
                <c:pt idx="1435">
                  <c:v>64755.767333984375</c:v>
                </c:pt>
                <c:pt idx="1436">
                  <c:v>64544.386962890625</c:v>
                </c:pt>
                <c:pt idx="1437">
                  <c:v>64459.97802734375</c:v>
                </c:pt>
                <c:pt idx="1438">
                  <c:v>64430.197631835938</c:v>
                </c:pt>
                <c:pt idx="1439">
                  <c:v>64410.560119628906</c:v>
                </c:pt>
                <c:pt idx="1440">
                  <c:v>64394.122589111328</c:v>
                </c:pt>
                <c:pt idx="1441">
                  <c:v>64392.427947998047</c:v>
                </c:pt>
                <c:pt idx="1442">
                  <c:v>64400.333282470703</c:v>
                </c:pt>
                <c:pt idx="1443">
                  <c:v>64410.152893066406</c:v>
                </c:pt>
                <c:pt idx="1444">
                  <c:v>64425.772521972656</c:v>
                </c:pt>
                <c:pt idx="1445">
                  <c:v>64450.877868652344</c:v>
                </c:pt>
                <c:pt idx="1446">
                  <c:v>64469.411773681641</c:v>
                </c:pt>
                <c:pt idx="1447">
                  <c:v>64479.888519287109</c:v>
                </c:pt>
                <c:pt idx="1448">
                  <c:v>64492.422454833984</c:v>
                </c:pt>
                <c:pt idx="1449">
                  <c:v>64516.527770996094</c:v>
                </c:pt>
                <c:pt idx="1450">
                  <c:v>64544.604553222656</c:v>
                </c:pt>
                <c:pt idx="1451">
                  <c:v>64572.167053222656</c:v>
                </c:pt>
                <c:pt idx="1452">
                  <c:v>64590.043762207031</c:v>
                </c:pt>
                <c:pt idx="1453">
                  <c:v>64595.606262207031</c:v>
                </c:pt>
                <c:pt idx="1454">
                  <c:v>64589.368774414063</c:v>
                </c:pt>
                <c:pt idx="1455">
                  <c:v>64575.988403320313</c:v>
                </c:pt>
                <c:pt idx="1456">
                  <c:v>64560.408020019531</c:v>
                </c:pt>
                <c:pt idx="1457">
                  <c:v>64551.370483398438</c:v>
                </c:pt>
                <c:pt idx="1458">
                  <c:v>64534.790100097656</c:v>
                </c:pt>
                <c:pt idx="1459">
                  <c:v>64506.524017333984</c:v>
                </c:pt>
                <c:pt idx="1460">
                  <c:v>64477.715057373047</c:v>
                </c:pt>
                <c:pt idx="1461">
                  <c:v>64470.306121826172</c:v>
                </c:pt>
                <c:pt idx="1462">
                  <c:v>64481.440032958984</c:v>
                </c:pt>
                <c:pt idx="1463">
                  <c:v>64498.031066894531</c:v>
                </c:pt>
                <c:pt idx="1464">
                  <c:v>64511.450714111328</c:v>
                </c:pt>
                <c:pt idx="1465">
                  <c:v>64522.184631347656</c:v>
                </c:pt>
                <c:pt idx="1466">
                  <c:v>64528.861389160156</c:v>
                </c:pt>
                <c:pt idx="1467">
                  <c:v>64525.481018066406</c:v>
                </c:pt>
                <c:pt idx="1468">
                  <c:v>64514.157775878906</c:v>
                </c:pt>
                <c:pt idx="1469">
                  <c:v>64503.491668701172</c:v>
                </c:pt>
                <c:pt idx="1470">
                  <c:v>64493.082733154297</c:v>
                </c:pt>
                <c:pt idx="1471">
                  <c:v>64483.045196533203</c:v>
                </c:pt>
                <c:pt idx="1472">
                  <c:v>64482.350555419922</c:v>
                </c:pt>
                <c:pt idx="1473">
                  <c:v>64494.884460449219</c:v>
                </c:pt>
                <c:pt idx="1474">
                  <c:v>64517.532653808594</c:v>
                </c:pt>
                <c:pt idx="1475">
                  <c:v>64551.095153808594</c:v>
                </c:pt>
                <c:pt idx="1476">
                  <c:v>64589.743347167969</c:v>
                </c:pt>
                <c:pt idx="1477">
                  <c:v>64618.762939453125</c:v>
                </c:pt>
                <c:pt idx="1478">
                  <c:v>64648.239685058594</c:v>
                </c:pt>
                <c:pt idx="1479">
                  <c:v>64696.145080566406</c:v>
                </c:pt>
                <c:pt idx="1480">
                  <c:v>64754.364685058594</c:v>
                </c:pt>
                <c:pt idx="1481">
                  <c:v>64793.669982910156</c:v>
                </c:pt>
                <c:pt idx="1482">
                  <c:v>64807.746765136719</c:v>
                </c:pt>
                <c:pt idx="1483">
                  <c:v>64800.50927734375</c:v>
                </c:pt>
                <c:pt idx="1484">
                  <c:v>64782.728881835938</c:v>
                </c:pt>
                <c:pt idx="1485">
                  <c:v>64766.119934082031</c:v>
                </c:pt>
                <c:pt idx="1486">
                  <c:v>64746.139587402344</c:v>
                </c:pt>
                <c:pt idx="1487">
                  <c:v>64714.844909667969</c:v>
                </c:pt>
                <c:pt idx="1488">
                  <c:v>64685.464538574219</c:v>
                </c:pt>
                <c:pt idx="1489">
                  <c:v>64677.741271972656</c:v>
                </c:pt>
                <c:pt idx="1490">
                  <c:v>64683.189453125</c:v>
                </c:pt>
                <c:pt idx="1491">
                  <c:v>64689.123413085938</c:v>
                </c:pt>
                <c:pt idx="1492">
                  <c:v>64693.971557617188</c:v>
                </c:pt>
                <c:pt idx="1493">
                  <c:v>64693.734069824219</c:v>
                </c:pt>
                <c:pt idx="1494">
                  <c:v>64693.582275390625</c:v>
                </c:pt>
                <c:pt idx="1495">
                  <c:v>64702.459045410156</c:v>
                </c:pt>
                <c:pt idx="1496">
                  <c:v>64716.992919921875</c:v>
                </c:pt>
                <c:pt idx="1497">
                  <c:v>64723.783996582031</c:v>
                </c:pt>
                <c:pt idx="1498">
                  <c:v>64726.575012207031</c:v>
                </c:pt>
                <c:pt idx="1499">
                  <c:v>64728.137512207031</c:v>
                </c:pt>
                <c:pt idx="1500">
                  <c:v>64728.700012207031</c:v>
                </c:pt>
                <c:pt idx="1501">
                  <c:v>64731.11962890625</c:v>
                </c:pt>
                <c:pt idx="1502">
                  <c:v>64739.910705566406</c:v>
                </c:pt>
                <c:pt idx="1503">
                  <c:v>64752.701721191406</c:v>
                </c:pt>
                <c:pt idx="1504">
                  <c:v>64756.721374511719</c:v>
                </c:pt>
                <c:pt idx="1505">
                  <c:v>64749.083801269531</c:v>
                </c:pt>
                <c:pt idx="1506">
                  <c:v>64742.646301269531</c:v>
                </c:pt>
                <c:pt idx="1507">
                  <c:v>64749.95166015625</c:v>
                </c:pt>
                <c:pt idx="1508">
                  <c:v>64760.914123535156</c:v>
                </c:pt>
                <c:pt idx="1509">
                  <c:v>64765.219482421875</c:v>
                </c:pt>
                <c:pt idx="1510">
                  <c:v>64765.410522460938</c:v>
                </c:pt>
                <c:pt idx="1511">
                  <c:v>64777.287292480469</c:v>
                </c:pt>
                <c:pt idx="1512">
                  <c:v>64806.821166992188</c:v>
                </c:pt>
                <c:pt idx="1513">
                  <c:v>64850.297973632813</c:v>
                </c:pt>
                <c:pt idx="1514">
                  <c:v>64906.174743652344</c:v>
                </c:pt>
                <c:pt idx="1515">
                  <c:v>64976.937194824219</c:v>
                </c:pt>
                <c:pt idx="1516">
                  <c:v>65064.5283203125</c:v>
                </c:pt>
                <c:pt idx="1517">
                  <c:v>65168.147827148438</c:v>
                </c:pt>
                <c:pt idx="1518">
                  <c:v>65280.024658203125</c:v>
                </c:pt>
                <c:pt idx="1519">
                  <c:v>65375.387084960938</c:v>
                </c:pt>
                <c:pt idx="1520">
                  <c:v>65427.778198242188</c:v>
                </c:pt>
                <c:pt idx="1521">
                  <c:v>65419.769287109375</c:v>
                </c:pt>
                <c:pt idx="1522">
                  <c:v>65355.674560546875</c:v>
                </c:pt>
                <c:pt idx="1523">
                  <c:v>65258.20849609375</c:v>
                </c:pt>
                <c:pt idx="1524">
                  <c:v>65153.7138671875</c:v>
                </c:pt>
                <c:pt idx="1525">
                  <c:v>65050.56201171875</c:v>
                </c:pt>
                <c:pt idx="1526">
                  <c:v>64960.2958984375</c:v>
                </c:pt>
                <c:pt idx="1527">
                  <c:v>64898.001281738281</c:v>
                </c:pt>
                <c:pt idx="1528">
                  <c:v>64864.935180664063</c:v>
                </c:pt>
                <c:pt idx="1529">
                  <c:v>64850.783386230469</c:v>
                </c:pt>
                <c:pt idx="1530">
                  <c:v>64840.945861816406</c:v>
                </c:pt>
                <c:pt idx="1531">
                  <c:v>64828.765441894531</c:v>
                </c:pt>
                <c:pt idx="1532">
                  <c:v>64816.870788574219</c:v>
                </c:pt>
                <c:pt idx="1533">
                  <c:v>64815.547546386719</c:v>
                </c:pt>
                <c:pt idx="1534">
                  <c:v>64829.338623046875</c:v>
                </c:pt>
                <c:pt idx="1535">
                  <c:v>64843.301086425781</c:v>
                </c:pt>
                <c:pt idx="1536">
                  <c:v>64843.892150878906</c:v>
                </c:pt>
                <c:pt idx="1537">
                  <c:v>64835.854614257813</c:v>
                </c:pt>
                <c:pt idx="1538">
                  <c:v>64834.759948730469</c:v>
                </c:pt>
                <c:pt idx="1539">
                  <c:v>64846.951049804688</c:v>
                </c:pt>
                <c:pt idx="1540">
                  <c:v>64862.14208984375</c:v>
                </c:pt>
                <c:pt idx="1541">
                  <c:v>64871.190246582031</c:v>
                </c:pt>
                <c:pt idx="1542">
                  <c:v>64878.238464355469</c:v>
                </c:pt>
                <c:pt idx="1543">
                  <c:v>64893.258117675781</c:v>
                </c:pt>
                <c:pt idx="1544">
                  <c:v>64910.563415527344</c:v>
                </c:pt>
                <c:pt idx="1545">
                  <c:v>64918.240173339844</c:v>
                </c:pt>
                <c:pt idx="1546">
                  <c:v>64918.059814453125</c:v>
                </c:pt>
                <c:pt idx="1547">
                  <c:v>64918.879455566406</c:v>
                </c:pt>
                <c:pt idx="1548">
                  <c:v>64920.099060058594</c:v>
                </c:pt>
                <c:pt idx="1549">
                  <c:v>64922.375854492188</c:v>
                </c:pt>
                <c:pt idx="1550">
                  <c:v>64927.68115234375</c:v>
                </c:pt>
                <c:pt idx="1551">
                  <c:v>64940.557922363281</c:v>
                </c:pt>
                <c:pt idx="1552">
                  <c:v>64957.406127929688</c:v>
                </c:pt>
                <c:pt idx="1553">
                  <c:v>64968.368591308594</c:v>
                </c:pt>
                <c:pt idx="1554">
                  <c:v>64969.1025390625</c:v>
                </c:pt>
                <c:pt idx="1555">
                  <c:v>64966.922119140625</c:v>
                </c:pt>
                <c:pt idx="1556">
                  <c:v>64966.684631347656</c:v>
                </c:pt>
                <c:pt idx="1557">
                  <c:v>64974.218505859375</c:v>
                </c:pt>
                <c:pt idx="1558">
                  <c:v>64991.781005859375</c:v>
                </c:pt>
                <c:pt idx="1559">
                  <c:v>65015.772094726563</c:v>
                </c:pt>
                <c:pt idx="1560">
                  <c:v>65038.134521484375</c:v>
                </c:pt>
                <c:pt idx="1561">
                  <c:v>65061.66845703125</c:v>
                </c:pt>
                <c:pt idx="1562">
                  <c:v>65079.030883789063</c:v>
                </c:pt>
                <c:pt idx="1563">
                  <c:v>65080.936279296875</c:v>
                </c:pt>
                <c:pt idx="1564">
                  <c:v>65067.098754882813</c:v>
                </c:pt>
                <c:pt idx="1565">
                  <c:v>65050.604125976563</c:v>
                </c:pt>
                <c:pt idx="1566">
                  <c:v>65040.537963867188</c:v>
                </c:pt>
                <c:pt idx="1567">
                  <c:v>65035.957641601563</c:v>
                </c:pt>
                <c:pt idx="1568">
                  <c:v>65031.834350585938</c:v>
                </c:pt>
                <c:pt idx="1569">
                  <c:v>65022.025451660156</c:v>
                </c:pt>
                <c:pt idx="1570">
                  <c:v>65009.559326171875</c:v>
                </c:pt>
                <c:pt idx="1571">
                  <c:v>65004.893249511719</c:v>
                </c:pt>
                <c:pt idx="1572">
                  <c:v>65007.541442871094</c:v>
                </c:pt>
                <c:pt idx="1573">
                  <c:v>65008.189636230469</c:v>
                </c:pt>
                <c:pt idx="1574">
                  <c:v>65006.00927734375</c:v>
                </c:pt>
                <c:pt idx="1575">
                  <c:v>65008.828918457031</c:v>
                </c:pt>
                <c:pt idx="1576">
                  <c:v>65014.077087402344</c:v>
                </c:pt>
                <c:pt idx="1577">
                  <c:v>65020.982421875</c:v>
                </c:pt>
                <c:pt idx="1578">
                  <c:v>65029.344848632813</c:v>
                </c:pt>
                <c:pt idx="1579">
                  <c:v>65043.135986328125</c:v>
                </c:pt>
                <c:pt idx="1580">
                  <c:v>65064.641357421875</c:v>
                </c:pt>
                <c:pt idx="1581">
                  <c:v>65102.546630859375</c:v>
                </c:pt>
                <c:pt idx="1582">
                  <c:v>65148.0234375</c:v>
                </c:pt>
                <c:pt idx="1583">
                  <c:v>65187.9287109375</c:v>
                </c:pt>
                <c:pt idx="1584">
                  <c:v>65216.719848632813</c:v>
                </c:pt>
                <c:pt idx="1585">
                  <c:v>65229.2822265625</c:v>
                </c:pt>
                <c:pt idx="1586">
                  <c:v>65220.273315429688</c:v>
                </c:pt>
                <c:pt idx="1587">
                  <c:v>65192.921508789063</c:v>
                </c:pt>
                <c:pt idx="1588">
                  <c:v>65158.541137695313</c:v>
                </c:pt>
                <c:pt idx="1589">
                  <c:v>65122.81787109375</c:v>
                </c:pt>
                <c:pt idx="1590">
                  <c:v>65101.808959960938</c:v>
                </c:pt>
                <c:pt idx="1591">
                  <c:v>65120.285766601563</c:v>
                </c:pt>
                <c:pt idx="1592">
                  <c:v>65200.705322265625</c:v>
                </c:pt>
                <c:pt idx="1593">
                  <c:v>65375.210693359375</c:v>
                </c:pt>
                <c:pt idx="1594">
                  <c:v>65682.487426757813</c:v>
                </c:pt>
                <c:pt idx="1595">
                  <c:v>66168.64990234375</c:v>
                </c:pt>
                <c:pt idx="1596">
                  <c:v>66878.86962890625</c:v>
                </c:pt>
                <c:pt idx="1597">
                  <c:v>67838.23193359375</c:v>
                </c:pt>
                <c:pt idx="1598">
                  <c:v>69004.45166015625</c:v>
                </c:pt>
                <c:pt idx="1599">
                  <c:v>70258.95703125</c:v>
                </c:pt>
                <c:pt idx="1600">
                  <c:v>71413.291015625</c:v>
                </c:pt>
                <c:pt idx="1601">
                  <c:v>72245.5390625</c:v>
                </c:pt>
                <c:pt idx="1602">
                  <c:v>72560.47265625</c:v>
                </c:pt>
                <c:pt idx="1603">
                  <c:v>72264.3212890625</c:v>
                </c:pt>
                <c:pt idx="1604">
                  <c:v>71418.59814453125</c:v>
                </c:pt>
                <c:pt idx="1605">
                  <c:v>70216.27490234375</c:v>
                </c:pt>
                <c:pt idx="1606">
                  <c:v>68888.06591796875</c:v>
                </c:pt>
                <c:pt idx="1607">
                  <c:v>67635.628173828125</c:v>
                </c:pt>
                <c:pt idx="1608">
                  <c:v>66599.41943359375</c:v>
                </c:pt>
                <c:pt idx="1609">
                  <c:v>65839.867553710938</c:v>
                </c:pt>
                <c:pt idx="1610">
                  <c:v>65339.858520507813</c:v>
                </c:pt>
                <c:pt idx="1611">
                  <c:v>65036.9638671875</c:v>
                </c:pt>
                <c:pt idx="1612">
                  <c:v>64862.069274902344</c:v>
                </c:pt>
                <c:pt idx="1613">
                  <c:v>64759.917419433594</c:v>
                </c:pt>
                <c:pt idx="1614">
                  <c:v>64698.622802734375</c:v>
                </c:pt>
                <c:pt idx="1615">
                  <c:v>64664.785278320313</c:v>
                </c:pt>
                <c:pt idx="1616">
                  <c:v>64658.147766113281</c:v>
                </c:pt>
                <c:pt idx="1617">
                  <c:v>64671.881652832031</c:v>
                </c:pt>
                <c:pt idx="1618">
                  <c:v>64684.701293945313</c:v>
                </c:pt>
                <c:pt idx="1619">
                  <c:v>64678.86376953125</c:v>
                </c:pt>
                <c:pt idx="1620">
                  <c:v>64657.911926269531</c:v>
                </c:pt>
                <c:pt idx="1621">
                  <c:v>64637.10302734375</c:v>
                </c:pt>
                <c:pt idx="1622">
                  <c:v>64625.551208496094</c:v>
                </c:pt>
                <c:pt idx="1623">
                  <c:v>64616.999389648438</c:v>
                </c:pt>
                <c:pt idx="1624">
                  <c:v>64604.876159667969</c:v>
                </c:pt>
                <c:pt idx="1625">
                  <c:v>64593.067199707031</c:v>
                </c:pt>
                <c:pt idx="1626">
                  <c:v>64582.286804199219</c:v>
                </c:pt>
                <c:pt idx="1627">
                  <c:v>64574.735046386719</c:v>
                </c:pt>
                <c:pt idx="1628">
                  <c:v>64574.954650878906</c:v>
                </c:pt>
                <c:pt idx="1629">
                  <c:v>64582.631408691406</c:v>
                </c:pt>
                <c:pt idx="1630">
                  <c:v>64586.393920898438</c:v>
                </c:pt>
                <c:pt idx="1631">
                  <c:v>64583.499206542969</c:v>
                </c:pt>
                <c:pt idx="1632">
                  <c:v>64580.233154296875</c:v>
                </c:pt>
                <c:pt idx="1633">
                  <c:v>64583.081359863281</c:v>
                </c:pt>
                <c:pt idx="1634">
                  <c:v>64594.5009765625</c:v>
                </c:pt>
                <c:pt idx="1635">
                  <c:v>64606.749145507813</c:v>
                </c:pt>
                <c:pt idx="1636">
                  <c:v>64607.397338867188</c:v>
                </c:pt>
                <c:pt idx="1637">
                  <c:v>64600.674133300781</c:v>
                </c:pt>
                <c:pt idx="1638">
                  <c:v>64606.893737792969</c:v>
                </c:pt>
                <c:pt idx="1639">
                  <c:v>64620.141906738281</c:v>
                </c:pt>
                <c:pt idx="1640">
                  <c:v>64616.275817871094</c:v>
                </c:pt>
                <c:pt idx="1641">
                  <c:v>64596.266906738281</c:v>
                </c:pt>
                <c:pt idx="1642">
                  <c:v>64585.429382324219</c:v>
                </c:pt>
                <c:pt idx="1643">
                  <c:v>64595.448974609375</c:v>
                </c:pt>
                <c:pt idx="1644">
                  <c:v>64612.440063476563</c:v>
                </c:pt>
                <c:pt idx="1645">
                  <c:v>64621.516845703125</c:v>
                </c:pt>
                <c:pt idx="1646">
                  <c:v>64621.107849121094</c:v>
                </c:pt>
                <c:pt idx="1647">
                  <c:v>64620.727478027344</c:v>
                </c:pt>
                <c:pt idx="1648">
                  <c:v>64621.832824707031</c:v>
                </c:pt>
                <c:pt idx="1649">
                  <c:v>64622.909606933594</c:v>
                </c:pt>
                <c:pt idx="1650">
                  <c:v>64625.500671386719</c:v>
                </c:pt>
                <c:pt idx="1651">
                  <c:v>64634.948852539063</c:v>
                </c:pt>
                <c:pt idx="1652">
                  <c:v>64655.025634765625</c:v>
                </c:pt>
                <c:pt idx="1653">
                  <c:v>64693.959533691406</c:v>
                </c:pt>
                <c:pt idx="1654">
                  <c:v>64749.779113769531</c:v>
                </c:pt>
                <c:pt idx="1655">
                  <c:v>64824.998779296875</c:v>
                </c:pt>
                <c:pt idx="1656">
                  <c:v>64916.789794921875</c:v>
                </c:pt>
                <c:pt idx="1657">
                  <c:v>65020.666564941406</c:v>
                </c:pt>
                <c:pt idx="1658">
                  <c:v>65125.714721679688</c:v>
                </c:pt>
                <c:pt idx="1659">
                  <c:v>65213.820068359375</c:v>
                </c:pt>
                <c:pt idx="1660">
                  <c:v>65256.811157226563</c:v>
                </c:pt>
                <c:pt idx="1661">
                  <c:v>65240.259399414063</c:v>
                </c:pt>
                <c:pt idx="1662">
                  <c:v>65185.564697265625</c:v>
                </c:pt>
                <c:pt idx="1663">
                  <c:v>65109.612915039063</c:v>
                </c:pt>
                <c:pt idx="1664">
                  <c:v>65020.689636230469</c:v>
                </c:pt>
                <c:pt idx="1665">
                  <c:v>64929.252136230469</c:v>
                </c:pt>
                <c:pt idx="1666">
                  <c:v>64850.814636230469</c:v>
                </c:pt>
                <c:pt idx="1667">
                  <c:v>64787.148559570313</c:v>
                </c:pt>
                <c:pt idx="1668">
                  <c:v>64741.053894042969</c:v>
                </c:pt>
                <c:pt idx="1669">
                  <c:v>64718.073486328125</c:v>
                </c:pt>
                <c:pt idx="1670">
                  <c:v>64712.093139648438</c:v>
                </c:pt>
                <c:pt idx="1671">
                  <c:v>64717.084167480469</c:v>
                </c:pt>
                <c:pt idx="1672">
                  <c:v>64736.618103027344</c:v>
                </c:pt>
                <c:pt idx="1673">
                  <c:v>64779.780578613281</c:v>
                </c:pt>
                <c:pt idx="1674">
                  <c:v>64858.514465332031</c:v>
                </c:pt>
                <c:pt idx="1675">
                  <c:v>64986.191223144531</c:v>
                </c:pt>
                <c:pt idx="1676">
                  <c:v>65152.7822265625</c:v>
                </c:pt>
                <c:pt idx="1677">
                  <c:v>65336.887573242188</c:v>
                </c:pt>
                <c:pt idx="1678">
                  <c:v>65521.564331054688</c:v>
                </c:pt>
                <c:pt idx="1679">
                  <c:v>65688.212524414063</c:v>
                </c:pt>
                <c:pt idx="1680">
                  <c:v>65805.375122070313</c:v>
                </c:pt>
                <c:pt idx="1681">
                  <c:v>65851.251831054688</c:v>
                </c:pt>
                <c:pt idx="1682">
                  <c:v>65816.814331054688</c:v>
                </c:pt>
                <c:pt idx="1683">
                  <c:v>65710.1767578125</c:v>
                </c:pt>
                <c:pt idx="1684">
                  <c:v>65552.253540039063</c:v>
                </c:pt>
                <c:pt idx="1685">
                  <c:v>65365.330322265625</c:v>
                </c:pt>
                <c:pt idx="1686">
                  <c:v>65167.407104492188</c:v>
                </c:pt>
                <c:pt idx="1687">
                  <c:v>64981.998168945313</c:v>
                </c:pt>
                <c:pt idx="1688">
                  <c:v>64829.189208984375</c:v>
                </c:pt>
                <c:pt idx="1689">
                  <c:v>64715.351684570313</c:v>
                </c:pt>
                <c:pt idx="1690">
                  <c:v>64648.971313476563</c:v>
                </c:pt>
                <c:pt idx="1691">
                  <c:v>64624.733764648438</c:v>
                </c:pt>
                <c:pt idx="1692">
                  <c:v>64612.267700195313</c:v>
                </c:pt>
                <c:pt idx="1693">
                  <c:v>64596.030151367188</c:v>
                </c:pt>
                <c:pt idx="1694">
                  <c:v>64582.706909179688</c:v>
                </c:pt>
                <c:pt idx="1695">
                  <c:v>64584.126586914063</c:v>
                </c:pt>
                <c:pt idx="1696">
                  <c:v>64587.174743652344</c:v>
                </c:pt>
                <c:pt idx="1697">
                  <c:v>64582.765808105469</c:v>
                </c:pt>
                <c:pt idx="1698">
                  <c:v>64570.499694824219</c:v>
                </c:pt>
                <c:pt idx="1699">
                  <c:v>64565.005065917969</c:v>
                </c:pt>
                <c:pt idx="1700">
                  <c:v>64571.281799316406</c:v>
                </c:pt>
                <c:pt idx="1701">
                  <c:v>64577.301452636719</c:v>
                </c:pt>
                <c:pt idx="1702">
                  <c:v>64576.378234863281</c:v>
                </c:pt>
                <c:pt idx="1703">
                  <c:v>64575.483520507813</c:v>
                </c:pt>
                <c:pt idx="1704">
                  <c:v>64577.046020507813</c:v>
                </c:pt>
                <c:pt idx="1705">
                  <c:v>64573.379943847656</c:v>
                </c:pt>
                <c:pt idx="1706">
                  <c:v>64568.313842773438</c:v>
                </c:pt>
                <c:pt idx="1707">
                  <c:v>64573.5048828125</c:v>
                </c:pt>
                <c:pt idx="1708">
                  <c:v>64587.695922851563</c:v>
                </c:pt>
                <c:pt idx="1709">
                  <c:v>64602.601257324219</c:v>
                </c:pt>
                <c:pt idx="1710">
                  <c:v>64609.47802734375</c:v>
                </c:pt>
                <c:pt idx="1711">
                  <c:v>64609.497680664063</c:v>
                </c:pt>
                <c:pt idx="1712">
                  <c:v>64608.66015625</c:v>
                </c:pt>
                <c:pt idx="1713">
                  <c:v>64614.308349609375</c:v>
                </c:pt>
                <c:pt idx="1714">
                  <c:v>64610.299377441406</c:v>
                </c:pt>
                <c:pt idx="1715">
                  <c:v>64595.261901855469</c:v>
                </c:pt>
                <c:pt idx="1716">
                  <c:v>64588.538635253906</c:v>
                </c:pt>
                <c:pt idx="1717">
                  <c:v>64596.8154296875</c:v>
                </c:pt>
                <c:pt idx="1718">
                  <c:v>64605.43505859375</c:v>
                </c:pt>
                <c:pt idx="1719">
                  <c:v>64605.968933105469</c:v>
                </c:pt>
                <c:pt idx="1720">
                  <c:v>64612.90283203125</c:v>
                </c:pt>
                <c:pt idx="1721">
                  <c:v>64626.35107421875</c:v>
                </c:pt>
                <c:pt idx="1722">
                  <c:v>64640.799255371094</c:v>
                </c:pt>
                <c:pt idx="1723">
                  <c:v>64649.561706542969</c:v>
                </c:pt>
                <c:pt idx="1724">
                  <c:v>64656.724182128906</c:v>
                </c:pt>
                <c:pt idx="1725">
                  <c:v>64661.258117675781</c:v>
                </c:pt>
                <c:pt idx="1726">
                  <c:v>64662.106323242188</c:v>
                </c:pt>
                <c:pt idx="1727">
                  <c:v>64666.668762207031</c:v>
                </c:pt>
                <c:pt idx="1728">
                  <c:v>64679.231262207031</c:v>
                </c:pt>
                <c:pt idx="1729">
                  <c:v>64698.622314453125</c:v>
                </c:pt>
                <c:pt idx="1730">
                  <c:v>64718.413391113281</c:v>
                </c:pt>
                <c:pt idx="1731">
                  <c:v>64734.204406738281</c:v>
                </c:pt>
                <c:pt idx="1732">
                  <c:v>64748.424072265625</c:v>
                </c:pt>
                <c:pt idx="1733">
                  <c:v>64758.672241210938</c:v>
                </c:pt>
                <c:pt idx="1734">
                  <c:v>64755.7490234375</c:v>
                </c:pt>
                <c:pt idx="1735">
                  <c:v>64741.597229003906</c:v>
                </c:pt>
                <c:pt idx="1736">
                  <c:v>64723.216857910156</c:v>
                </c:pt>
                <c:pt idx="1737">
                  <c:v>64701.893615722656</c:v>
                </c:pt>
                <c:pt idx="1738">
                  <c:v>64674.656066894531</c:v>
                </c:pt>
                <c:pt idx="1739">
                  <c:v>64643.704284667969</c:v>
                </c:pt>
                <c:pt idx="1740">
                  <c:v>64611.323913574219</c:v>
                </c:pt>
                <c:pt idx="1741">
                  <c:v>64583.2578125</c:v>
                </c:pt>
                <c:pt idx="1742">
                  <c:v>64570.563171386719</c:v>
                </c:pt>
                <c:pt idx="1743">
                  <c:v>64566.182739257813</c:v>
                </c:pt>
                <c:pt idx="1744">
                  <c:v>64565.23095703125</c:v>
                </c:pt>
                <c:pt idx="1745">
                  <c:v>64573.107727050781</c:v>
                </c:pt>
                <c:pt idx="1746">
                  <c:v>64607.784484863281</c:v>
                </c:pt>
                <c:pt idx="1747">
                  <c:v>64670.061279296875</c:v>
                </c:pt>
                <c:pt idx="1748">
                  <c:v>64757.138000488281</c:v>
                </c:pt>
                <c:pt idx="1749">
                  <c:v>64878.757629394531</c:v>
                </c:pt>
                <c:pt idx="1750">
                  <c:v>65053.920166015625</c:v>
                </c:pt>
                <c:pt idx="1751">
                  <c:v>65283.539794921875</c:v>
                </c:pt>
                <c:pt idx="1752">
                  <c:v>65554.759399414063</c:v>
                </c:pt>
                <c:pt idx="1753">
                  <c:v>65838.836181640625</c:v>
                </c:pt>
                <c:pt idx="1754">
                  <c:v>66097.42724609375</c:v>
                </c:pt>
                <c:pt idx="1755">
                  <c:v>66285.361083984375</c:v>
                </c:pt>
                <c:pt idx="1756">
                  <c:v>66372.4091796875</c:v>
                </c:pt>
                <c:pt idx="1757">
                  <c:v>66338.02880859375</c:v>
                </c:pt>
                <c:pt idx="1758">
                  <c:v>66192.59130859375</c:v>
                </c:pt>
                <c:pt idx="1759">
                  <c:v>65973.325317382813</c:v>
                </c:pt>
                <c:pt idx="1760">
                  <c:v>65715.71630859375</c:v>
                </c:pt>
                <c:pt idx="1761">
                  <c:v>65442.393188476563</c:v>
                </c:pt>
                <c:pt idx="1762">
                  <c:v>65185.669921875</c:v>
                </c:pt>
                <c:pt idx="1763">
                  <c:v>64974.51806640625</c:v>
                </c:pt>
                <c:pt idx="1764">
                  <c:v>64810.766296386719</c:v>
                </c:pt>
                <c:pt idx="1765">
                  <c:v>64685.614501953125</c:v>
                </c:pt>
                <c:pt idx="1766">
                  <c:v>64602.31982421875</c:v>
                </c:pt>
                <c:pt idx="1767">
                  <c:v>64558.710876464844</c:v>
                </c:pt>
                <c:pt idx="1768">
                  <c:v>64531.787658691406</c:v>
                </c:pt>
                <c:pt idx="1769">
                  <c:v>64505.007263183594</c:v>
                </c:pt>
                <c:pt idx="1770">
                  <c:v>64490.798309326172</c:v>
                </c:pt>
                <c:pt idx="1771">
                  <c:v>64499.275085449219</c:v>
                </c:pt>
                <c:pt idx="1772">
                  <c:v>64510.408996582031</c:v>
                </c:pt>
                <c:pt idx="1773">
                  <c:v>64504.400024414063</c:v>
                </c:pt>
                <c:pt idx="1774">
                  <c:v>64485.4482421875</c:v>
                </c:pt>
                <c:pt idx="1775">
                  <c:v>64468.667846679688</c:v>
                </c:pt>
                <c:pt idx="1776">
                  <c:v>64463.973205566406</c:v>
                </c:pt>
                <c:pt idx="1777">
                  <c:v>64473.878540039063</c:v>
                </c:pt>
                <c:pt idx="1778">
                  <c:v>64487.069580078125</c:v>
                </c:pt>
                <c:pt idx="1779">
                  <c:v>64493.260650634766</c:v>
                </c:pt>
                <c:pt idx="1780">
                  <c:v>64488.39453125</c:v>
                </c:pt>
                <c:pt idx="1781">
                  <c:v>64481.871307373047</c:v>
                </c:pt>
                <c:pt idx="1782">
                  <c:v>64488.519500732422</c:v>
                </c:pt>
                <c:pt idx="1783">
                  <c:v>64501.453430175781</c:v>
                </c:pt>
                <c:pt idx="1784">
                  <c:v>64503.215881347656</c:v>
                </c:pt>
                <c:pt idx="1785">
                  <c:v>64491.692657470703</c:v>
                </c:pt>
                <c:pt idx="1786">
                  <c:v>64482.798004150391</c:v>
                </c:pt>
                <c:pt idx="1787">
                  <c:v>64483.246185302734</c:v>
                </c:pt>
                <c:pt idx="1788">
                  <c:v>64487.837249755859</c:v>
                </c:pt>
                <c:pt idx="1789">
                  <c:v>64492.942596435547</c:v>
                </c:pt>
                <c:pt idx="1790">
                  <c:v>64501.847930908203</c:v>
                </c:pt>
                <c:pt idx="1791">
                  <c:v>64515.153259277344</c:v>
                </c:pt>
                <c:pt idx="1792">
                  <c:v>64523.144287109375</c:v>
                </c:pt>
                <c:pt idx="1793">
                  <c:v>64518.078247070313</c:v>
                </c:pt>
                <c:pt idx="1794">
                  <c:v>64511.212127685547</c:v>
                </c:pt>
                <c:pt idx="1795">
                  <c:v>64514.746032714844</c:v>
                </c:pt>
                <c:pt idx="1796">
                  <c:v>64532.137084960938</c:v>
                </c:pt>
                <c:pt idx="1797">
                  <c:v>64563.585266113281</c:v>
                </c:pt>
                <c:pt idx="1798">
                  <c:v>64613.262023925781</c:v>
                </c:pt>
                <c:pt idx="1799">
                  <c:v>64677.595947265625</c:v>
                </c:pt>
                <c:pt idx="1800">
                  <c:v>64746.929870605469</c:v>
                </c:pt>
                <c:pt idx="1801">
                  <c:v>64822.520935058594</c:v>
                </c:pt>
                <c:pt idx="1802">
                  <c:v>64912.169128417969</c:v>
                </c:pt>
                <c:pt idx="1803">
                  <c:v>65004.645874023438</c:v>
                </c:pt>
                <c:pt idx="1804">
                  <c:v>65073.579833984375</c:v>
                </c:pt>
                <c:pt idx="1805">
                  <c:v>65098.6279296875</c:v>
                </c:pt>
                <c:pt idx="1806">
                  <c:v>65081.9619140625</c:v>
                </c:pt>
                <c:pt idx="1807">
                  <c:v>65033.010131835938</c:v>
                </c:pt>
                <c:pt idx="1808">
                  <c:v>64956.4296875</c:v>
                </c:pt>
                <c:pt idx="1809">
                  <c:v>64856.306457519531</c:v>
                </c:pt>
                <c:pt idx="1810">
                  <c:v>64754.811828613281</c:v>
                </c:pt>
                <c:pt idx="1811">
                  <c:v>64676.345703125</c:v>
                </c:pt>
                <c:pt idx="1812">
                  <c:v>64620.565368652344</c:v>
                </c:pt>
                <c:pt idx="1813">
                  <c:v>64578.756408691406</c:v>
                </c:pt>
                <c:pt idx="1814">
                  <c:v>64546.176025390625</c:v>
                </c:pt>
                <c:pt idx="1815">
                  <c:v>64524.7099609375</c:v>
                </c:pt>
                <c:pt idx="1816">
                  <c:v>64512.986694335938</c:v>
                </c:pt>
                <c:pt idx="1817">
                  <c:v>64502.149169921875</c:v>
                </c:pt>
                <c:pt idx="1818">
                  <c:v>64491.854522705078</c:v>
                </c:pt>
                <c:pt idx="1819">
                  <c:v>64486.159851074219</c:v>
                </c:pt>
                <c:pt idx="1820">
                  <c:v>64489.550903320313</c:v>
                </c:pt>
                <c:pt idx="1821">
                  <c:v>64498.056243896484</c:v>
                </c:pt>
                <c:pt idx="1822">
                  <c:v>64507.590148925781</c:v>
                </c:pt>
                <c:pt idx="1823">
                  <c:v>64513.638366699219</c:v>
                </c:pt>
                <c:pt idx="1824">
                  <c:v>64517.543701171875</c:v>
                </c:pt>
                <c:pt idx="1825">
                  <c:v>64520.049011230469</c:v>
                </c:pt>
                <c:pt idx="1826">
                  <c:v>64519.668640136719</c:v>
                </c:pt>
                <c:pt idx="1827">
                  <c:v>64515.54541015625</c:v>
                </c:pt>
                <c:pt idx="1828">
                  <c:v>64509.479339599609</c:v>
                </c:pt>
                <c:pt idx="1829">
                  <c:v>64499.956085205078</c:v>
                </c:pt>
                <c:pt idx="1830">
                  <c:v>64495.661437988281</c:v>
                </c:pt>
                <c:pt idx="1831">
                  <c:v>64498.452484130859</c:v>
                </c:pt>
                <c:pt idx="1832">
                  <c:v>64502.443542480469</c:v>
                </c:pt>
                <c:pt idx="1833">
                  <c:v>64500.805999755859</c:v>
                </c:pt>
                <c:pt idx="1834">
                  <c:v>64495.739929199219</c:v>
                </c:pt>
                <c:pt idx="1835">
                  <c:v>64489.159545898438</c:v>
                </c:pt>
                <c:pt idx="1836">
                  <c:v>64485.636322021484</c:v>
                </c:pt>
                <c:pt idx="1837">
                  <c:v>64488.741638183594</c:v>
                </c:pt>
                <c:pt idx="1838">
                  <c:v>64500.246978759766</c:v>
                </c:pt>
                <c:pt idx="1839">
                  <c:v>64511.038024902344</c:v>
                </c:pt>
                <c:pt idx="1840">
                  <c:v>64515.914794921875</c:v>
                </c:pt>
                <c:pt idx="1841">
                  <c:v>64516.191589355469</c:v>
                </c:pt>
                <c:pt idx="1842">
                  <c:v>64516.582641601563</c:v>
                </c:pt>
                <c:pt idx="1843">
                  <c:v>64516.630798339844</c:v>
                </c:pt>
                <c:pt idx="1844">
                  <c:v>64517.421875</c:v>
                </c:pt>
                <c:pt idx="1845">
                  <c:v>64515.127197265625</c:v>
                </c:pt>
                <c:pt idx="1846">
                  <c:v>64506.832550048828</c:v>
                </c:pt>
                <c:pt idx="1847">
                  <c:v>64499.937896728516</c:v>
                </c:pt>
                <c:pt idx="1848">
                  <c:v>64503.871795654297</c:v>
                </c:pt>
                <c:pt idx="1849">
                  <c:v>64506.005706787109</c:v>
                </c:pt>
                <c:pt idx="1850">
                  <c:v>64498.596740722656</c:v>
                </c:pt>
                <c:pt idx="1851">
                  <c:v>64490.016387939453</c:v>
                </c:pt>
                <c:pt idx="1852">
                  <c:v>64492.864562988281</c:v>
                </c:pt>
                <c:pt idx="1853">
                  <c:v>64496.827056884766</c:v>
                </c:pt>
                <c:pt idx="1854">
                  <c:v>64492.703826904297</c:v>
                </c:pt>
                <c:pt idx="1855">
                  <c:v>64479.923431396484</c:v>
                </c:pt>
                <c:pt idx="1856">
                  <c:v>64460.800201416016</c:v>
                </c:pt>
                <c:pt idx="1857">
                  <c:v>64447.791259765625</c:v>
                </c:pt>
                <c:pt idx="1858">
                  <c:v>64445.953735351563</c:v>
                </c:pt>
                <c:pt idx="1859">
                  <c:v>64446.601928710938</c:v>
                </c:pt>
                <c:pt idx="1860">
                  <c:v>64441.535858154297</c:v>
                </c:pt>
                <c:pt idx="1861">
                  <c:v>64439.012603759766</c:v>
                </c:pt>
                <c:pt idx="1862">
                  <c:v>64435.889373779297</c:v>
                </c:pt>
                <c:pt idx="1863">
                  <c:v>64426.423278808594</c:v>
                </c:pt>
                <c:pt idx="1864">
                  <c:v>64411.671478271484</c:v>
                </c:pt>
                <c:pt idx="1865">
                  <c:v>64404.662536621094</c:v>
                </c:pt>
                <c:pt idx="1866">
                  <c:v>64414.025024414063</c:v>
                </c:pt>
                <c:pt idx="1867">
                  <c:v>64432.616058349609</c:v>
                </c:pt>
                <c:pt idx="1868">
                  <c:v>64437.521392822266</c:v>
                </c:pt>
                <c:pt idx="1869">
                  <c:v>64425.598175048828</c:v>
                </c:pt>
                <c:pt idx="1870">
                  <c:v>64409.132080078125</c:v>
                </c:pt>
                <c:pt idx="1871">
                  <c:v>64398.037414550781</c:v>
                </c:pt>
                <c:pt idx="1872">
                  <c:v>64386.514190673828</c:v>
                </c:pt>
                <c:pt idx="1873">
                  <c:v>64379.01953125</c:v>
                </c:pt>
                <c:pt idx="1874">
                  <c:v>64381.867706298828</c:v>
                </c:pt>
                <c:pt idx="1875">
                  <c:v>64394.173065185547</c:v>
                </c:pt>
                <c:pt idx="1876">
                  <c:v>64401.506958007813</c:v>
                </c:pt>
                <c:pt idx="1877">
                  <c:v>64397.6123046875</c:v>
                </c:pt>
                <c:pt idx="1878">
                  <c:v>64399.489074707031</c:v>
                </c:pt>
                <c:pt idx="1879">
                  <c:v>64410.280120849609</c:v>
                </c:pt>
                <c:pt idx="1880">
                  <c:v>64419.242584228516</c:v>
                </c:pt>
                <c:pt idx="1881">
                  <c:v>64420.833648681641</c:v>
                </c:pt>
                <c:pt idx="1882">
                  <c:v>64419.796142578125</c:v>
                </c:pt>
                <c:pt idx="1883">
                  <c:v>64413.387176513672</c:v>
                </c:pt>
                <c:pt idx="1884">
                  <c:v>64402.606811523438</c:v>
                </c:pt>
                <c:pt idx="1885">
                  <c:v>64401.454986572266</c:v>
                </c:pt>
                <c:pt idx="1886">
                  <c:v>64414.503204345703</c:v>
                </c:pt>
                <c:pt idx="1887">
                  <c:v>64424.208526611328</c:v>
                </c:pt>
                <c:pt idx="1888">
                  <c:v>64417.65673828125</c:v>
                </c:pt>
                <c:pt idx="1889">
                  <c:v>64396.847778320313</c:v>
                </c:pt>
                <c:pt idx="1890">
                  <c:v>64381.181701660156</c:v>
                </c:pt>
                <c:pt idx="1891">
                  <c:v>64382.744171142578</c:v>
                </c:pt>
                <c:pt idx="1892">
                  <c:v>64399.335235595703</c:v>
                </c:pt>
                <c:pt idx="1893">
                  <c:v>64410.526275634766</c:v>
                </c:pt>
                <c:pt idx="1894">
                  <c:v>64408.5458984375</c:v>
                </c:pt>
                <c:pt idx="1895">
                  <c:v>64402.108367919922</c:v>
                </c:pt>
                <c:pt idx="1896">
                  <c:v>64400.413726806641</c:v>
                </c:pt>
                <c:pt idx="1897">
                  <c:v>64401.061920166016</c:v>
                </c:pt>
                <c:pt idx="1898">
                  <c:v>64404.367248535156</c:v>
                </c:pt>
                <c:pt idx="1899">
                  <c:v>64405.329742431641</c:v>
                </c:pt>
                <c:pt idx="1900">
                  <c:v>64399.777923583984</c:v>
                </c:pt>
                <c:pt idx="1901">
                  <c:v>64397.483245849609</c:v>
                </c:pt>
                <c:pt idx="1902">
                  <c:v>64412.074310302734</c:v>
                </c:pt>
                <c:pt idx="1903">
                  <c:v>64430.265350341797</c:v>
                </c:pt>
                <c:pt idx="1904">
                  <c:v>64431.770690917969</c:v>
                </c:pt>
                <c:pt idx="1905">
                  <c:v>64418.533172607422</c:v>
                </c:pt>
                <c:pt idx="1906">
                  <c:v>64411.924224853516</c:v>
                </c:pt>
                <c:pt idx="1907">
                  <c:v>64417.229583740234</c:v>
                </c:pt>
                <c:pt idx="1908">
                  <c:v>64425.792053222656</c:v>
                </c:pt>
                <c:pt idx="1909">
                  <c:v>64435.097381591797</c:v>
                </c:pt>
                <c:pt idx="1910">
                  <c:v>64441.745574951172</c:v>
                </c:pt>
                <c:pt idx="1911">
                  <c:v>64436.679504394531</c:v>
                </c:pt>
                <c:pt idx="1912">
                  <c:v>64421.213409423828</c:v>
                </c:pt>
                <c:pt idx="1913">
                  <c:v>64413.747314453125</c:v>
                </c:pt>
                <c:pt idx="1914">
                  <c:v>64419.366943359375</c:v>
                </c:pt>
                <c:pt idx="1915">
                  <c:v>64427.100830078125</c:v>
                </c:pt>
                <c:pt idx="1916">
                  <c:v>64431.377624511719</c:v>
                </c:pt>
                <c:pt idx="1917">
                  <c:v>64433.111511230469</c:v>
                </c:pt>
                <c:pt idx="1918">
                  <c:v>64433.588287353516</c:v>
                </c:pt>
                <c:pt idx="1919">
                  <c:v>64434.522186279297</c:v>
                </c:pt>
                <c:pt idx="1920">
                  <c:v>64442.827545166016</c:v>
                </c:pt>
                <c:pt idx="1921">
                  <c:v>64453.161437988281</c:v>
                </c:pt>
                <c:pt idx="1922">
                  <c:v>64458.095336914063</c:v>
                </c:pt>
                <c:pt idx="1923">
                  <c:v>64457.943542480469</c:v>
                </c:pt>
                <c:pt idx="1924">
                  <c:v>64458.277465820313</c:v>
                </c:pt>
                <c:pt idx="1925">
                  <c:v>64455.868499755859</c:v>
                </c:pt>
                <c:pt idx="1926">
                  <c:v>64455.859558105469</c:v>
                </c:pt>
                <c:pt idx="1927">
                  <c:v>64467.393463134766</c:v>
                </c:pt>
                <c:pt idx="1928">
                  <c:v>64488.041656494141</c:v>
                </c:pt>
                <c:pt idx="1929">
                  <c:v>64500.632720947266</c:v>
                </c:pt>
                <c:pt idx="1930">
                  <c:v>64496.252349853516</c:v>
                </c:pt>
                <c:pt idx="1931">
                  <c:v>64485.843383789063</c:v>
                </c:pt>
                <c:pt idx="1932">
                  <c:v>64485.463012695313</c:v>
                </c:pt>
                <c:pt idx="1933">
                  <c:v>64488.911193847656</c:v>
                </c:pt>
                <c:pt idx="1934">
                  <c:v>64485.416534423828</c:v>
                </c:pt>
                <c:pt idx="1935">
                  <c:v>64484.664733886719</c:v>
                </c:pt>
                <c:pt idx="1936">
                  <c:v>64498.227233886719</c:v>
                </c:pt>
                <c:pt idx="1937">
                  <c:v>64515.246826171875</c:v>
                </c:pt>
                <c:pt idx="1938">
                  <c:v>64524.837890625</c:v>
                </c:pt>
                <c:pt idx="1939">
                  <c:v>64530.143249511719</c:v>
                </c:pt>
                <c:pt idx="1940">
                  <c:v>64534.677124023438</c:v>
                </c:pt>
                <c:pt idx="1941">
                  <c:v>64539.75390625</c:v>
                </c:pt>
                <c:pt idx="1942">
                  <c:v>64545.087829589844</c:v>
                </c:pt>
                <c:pt idx="1943">
                  <c:v>64547.650268554688</c:v>
                </c:pt>
                <c:pt idx="1944">
                  <c:v>64549.927062988281</c:v>
                </c:pt>
                <c:pt idx="1945">
                  <c:v>64555.460998535156</c:v>
                </c:pt>
                <c:pt idx="1946">
                  <c:v>64565.366333007813</c:v>
                </c:pt>
                <c:pt idx="1947">
                  <c:v>64573.900207519531</c:v>
                </c:pt>
                <c:pt idx="1948">
                  <c:v>64580.976989746094</c:v>
                </c:pt>
                <c:pt idx="1949">
                  <c:v>64586.339477539063</c:v>
                </c:pt>
                <c:pt idx="1950">
                  <c:v>64592.044799804688</c:v>
                </c:pt>
                <c:pt idx="1951">
                  <c:v>64601.350158691406</c:v>
                </c:pt>
                <c:pt idx="1952">
                  <c:v>64607.969787597656</c:v>
                </c:pt>
                <c:pt idx="1953">
                  <c:v>64613.275085449219</c:v>
                </c:pt>
                <c:pt idx="1954">
                  <c:v>64618.380432128906</c:v>
                </c:pt>
                <c:pt idx="1955">
                  <c:v>64618.942932128906</c:v>
                </c:pt>
                <c:pt idx="1956">
                  <c:v>64609.048278808594</c:v>
                </c:pt>
                <c:pt idx="1957">
                  <c:v>64597.867858886719</c:v>
                </c:pt>
                <c:pt idx="1958">
                  <c:v>64601.401794433594</c:v>
                </c:pt>
                <c:pt idx="1959">
                  <c:v>64614.878540039063</c:v>
                </c:pt>
                <c:pt idx="1960">
                  <c:v>64624.812438964844</c:v>
                </c:pt>
                <c:pt idx="1961">
                  <c:v>64618.689208984375</c:v>
                </c:pt>
                <c:pt idx="1962">
                  <c:v>64604.537414550781</c:v>
                </c:pt>
                <c:pt idx="1963">
                  <c:v>64594.157043457031</c:v>
                </c:pt>
                <c:pt idx="1964">
                  <c:v>64592.119506835938</c:v>
                </c:pt>
                <c:pt idx="1965">
                  <c:v>64592.539184570313</c:v>
                </c:pt>
                <c:pt idx="1966">
                  <c:v>64594.387329101563</c:v>
                </c:pt>
                <c:pt idx="1967">
                  <c:v>64598.349853515625</c:v>
                </c:pt>
                <c:pt idx="1968">
                  <c:v>64606.912292480469</c:v>
                </c:pt>
                <c:pt idx="1969">
                  <c:v>64614.474792480469</c:v>
                </c:pt>
                <c:pt idx="1970">
                  <c:v>64612.208679199219</c:v>
                </c:pt>
                <c:pt idx="1971">
                  <c:v>64602.314025878906</c:v>
                </c:pt>
                <c:pt idx="1972">
                  <c:v>64599.276489257813</c:v>
                </c:pt>
                <c:pt idx="1973">
                  <c:v>64608.239013671875</c:v>
                </c:pt>
                <c:pt idx="1974">
                  <c:v>64617.601501464844</c:v>
                </c:pt>
                <c:pt idx="1975">
                  <c:v>64623.849670410156</c:v>
                </c:pt>
                <c:pt idx="1976">
                  <c:v>64631.755004882813</c:v>
                </c:pt>
                <c:pt idx="1977">
                  <c:v>64640.003234863281</c:v>
                </c:pt>
                <c:pt idx="1978">
                  <c:v>64640.708557128906</c:v>
                </c:pt>
                <c:pt idx="1979">
                  <c:v>64633.299621582031</c:v>
                </c:pt>
                <c:pt idx="1980">
                  <c:v>64623.862060546875</c:v>
                </c:pt>
                <c:pt idx="1981">
                  <c:v>64615.281677246094</c:v>
                </c:pt>
                <c:pt idx="1982">
                  <c:v>64606.387023925781</c:v>
                </c:pt>
                <c:pt idx="1983">
                  <c:v>64606.292358398438</c:v>
                </c:pt>
                <c:pt idx="1984">
                  <c:v>64614.026306152344</c:v>
                </c:pt>
                <c:pt idx="1985">
                  <c:v>64618.674499511719</c:v>
                </c:pt>
                <c:pt idx="1986">
                  <c:v>64618.694091796875</c:v>
                </c:pt>
                <c:pt idx="1987">
                  <c:v>64623.485168457031</c:v>
                </c:pt>
                <c:pt idx="1988">
                  <c:v>64621.84765625</c:v>
                </c:pt>
                <c:pt idx="1989">
                  <c:v>64603.095825195313</c:v>
                </c:pt>
                <c:pt idx="1990">
                  <c:v>64584.372619628906</c:v>
                </c:pt>
                <c:pt idx="1991">
                  <c:v>64582.620788574219</c:v>
                </c:pt>
                <c:pt idx="1992">
                  <c:v>64587.726135253906</c:v>
                </c:pt>
                <c:pt idx="1993">
                  <c:v>64590.631469726563</c:v>
                </c:pt>
                <c:pt idx="1994">
                  <c:v>64597.422546386719</c:v>
                </c:pt>
                <c:pt idx="1995">
                  <c:v>64606.870727539063</c:v>
                </c:pt>
                <c:pt idx="1996">
                  <c:v>64606.118896484375</c:v>
                </c:pt>
                <c:pt idx="1997">
                  <c:v>64596.738525390625</c:v>
                </c:pt>
                <c:pt idx="1998">
                  <c:v>64594.2724609375</c:v>
                </c:pt>
                <c:pt idx="1999">
                  <c:v>64601.120666503906</c:v>
                </c:pt>
                <c:pt idx="2000">
                  <c:v>64608.597412109375</c:v>
                </c:pt>
                <c:pt idx="2001">
                  <c:v>64606.817016601563</c:v>
                </c:pt>
                <c:pt idx="2002">
                  <c:v>64597.236633300781</c:v>
                </c:pt>
                <c:pt idx="2003">
                  <c:v>64591.970581054688</c:v>
                </c:pt>
                <c:pt idx="2004">
                  <c:v>64596.047302246094</c:v>
                </c:pt>
                <c:pt idx="2005">
                  <c:v>64603.409790039063</c:v>
                </c:pt>
                <c:pt idx="2006">
                  <c:v>64603.057983398438</c:v>
                </c:pt>
                <c:pt idx="2007">
                  <c:v>64598.049072265625</c:v>
                </c:pt>
                <c:pt idx="2008">
                  <c:v>64589.354370117188</c:v>
                </c:pt>
                <c:pt idx="2009">
                  <c:v>64578.716857910156</c:v>
                </c:pt>
                <c:pt idx="2010">
                  <c:v>64566.850769042969</c:v>
                </c:pt>
                <c:pt idx="2011">
                  <c:v>64562.470397949219</c:v>
                </c:pt>
                <c:pt idx="2012">
                  <c:v>64567.975769042969</c:v>
                </c:pt>
                <c:pt idx="2013">
                  <c:v>64567.281066894531</c:v>
                </c:pt>
                <c:pt idx="2014">
                  <c:v>64558.043579101563</c:v>
                </c:pt>
                <c:pt idx="2015">
                  <c:v>64558.034606933594</c:v>
                </c:pt>
                <c:pt idx="2016">
                  <c:v>64576.339965820313</c:v>
                </c:pt>
                <c:pt idx="2017">
                  <c:v>64599.531005859375</c:v>
                </c:pt>
                <c:pt idx="2018">
                  <c:v>64616.036315917969</c:v>
                </c:pt>
                <c:pt idx="2019">
                  <c:v>64621.74169921875</c:v>
                </c:pt>
                <c:pt idx="2020">
                  <c:v>64615.41845703125</c:v>
                </c:pt>
                <c:pt idx="2021">
                  <c:v>64606.409484863281</c:v>
                </c:pt>
                <c:pt idx="2022">
                  <c:v>64602.400573730469</c:v>
                </c:pt>
                <c:pt idx="2023">
                  <c:v>64601.220153808594</c:v>
                </c:pt>
                <c:pt idx="2024">
                  <c:v>64601.725524902344</c:v>
                </c:pt>
                <c:pt idx="2025">
                  <c:v>64601.230834960938</c:v>
                </c:pt>
                <c:pt idx="2026">
                  <c:v>64600.593322753906</c:v>
                </c:pt>
                <c:pt idx="2027">
                  <c:v>64606.127258300781</c:v>
                </c:pt>
                <c:pt idx="2028">
                  <c:v>64620.061157226563</c:v>
                </c:pt>
                <c:pt idx="2029">
                  <c:v>64632.966491699219</c:v>
                </c:pt>
                <c:pt idx="2030">
                  <c:v>64640.814697265625</c:v>
                </c:pt>
                <c:pt idx="2031">
                  <c:v>64645.148559570313</c:v>
                </c:pt>
                <c:pt idx="2032">
                  <c:v>64646.053894042969</c:v>
                </c:pt>
                <c:pt idx="2033">
                  <c:v>64644.502136230469</c:v>
                </c:pt>
                <c:pt idx="2034">
                  <c:v>64646.807434082031</c:v>
                </c:pt>
                <c:pt idx="2035">
                  <c:v>64648.912780761719</c:v>
                </c:pt>
                <c:pt idx="2036">
                  <c:v>64637.475280761719</c:v>
                </c:pt>
                <c:pt idx="2037">
                  <c:v>64609.180603027344</c:v>
                </c:pt>
                <c:pt idx="2038">
                  <c:v>64585.000244140625</c:v>
                </c:pt>
                <c:pt idx="2039">
                  <c:v>64580.619873046875</c:v>
                </c:pt>
                <c:pt idx="2040">
                  <c:v>64588.068054199219</c:v>
                </c:pt>
                <c:pt idx="2041">
                  <c:v>64584.773376464844</c:v>
                </c:pt>
                <c:pt idx="2042">
                  <c:v>64569.6787109375</c:v>
                </c:pt>
                <c:pt idx="2043">
                  <c:v>64553.812622070313</c:v>
                </c:pt>
                <c:pt idx="2044">
                  <c:v>64547.232238769531</c:v>
                </c:pt>
                <c:pt idx="2045">
                  <c:v>64549.623291015625</c:v>
                </c:pt>
                <c:pt idx="2046">
                  <c:v>64566.471496582031</c:v>
                </c:pt>
                <c:pt idx="2047">
                  <c:v>64601.691101074219</c:v>
                </c:pt>
                <c:pt idx="2048">
                  <c:v>64643.225036621094</c:v>
                </c:pt>
                <c:pt idx="2049">
                  <c:v>64671.844665527344</c:v>
                </c:pt>
                <c:pt idx="2050">
                  <c:v>64684.292846679688</c:v>
                </c:pt>
                <c:pt idx="2051">
                  <c:v>64686.969604492188</c:v>
                </c:pt>
                <c:pt idx="2052">
                  <c:v>64685.474975585938</c:v>
                </c:pt>
                <c:pt idx="2053">
                  <c:v>64677.894592285156</c:v>
                </c:pt>
                <c:pt idx="2054">
                  <c:v>64663.857055664063</c:v>
                </c:pt>
                <c:pt idx="2055">
                  <c:v>64643.533813476563</c:v>
                </c:pt>
                <c:pt idx="2056">
                  <c:v>64623.182006835938</c:v>
                </c:pt>
                <c:pt idx="2057">
                  <c:v>64600.515930175781</c:v>
                </c:pt>
                <c:pt idx="2058">
                  <c:v>64574.392700195313</c:v>
                </c:pt>
                <c:pt idx="2059">
                  <c:v>64546.240905761719</c:v>
                </c:pt>
                <c:pt idx="2060">
                  <c:v>64530.060546875</c:v>
                </c:pt>
                <c:pt idx="2061">
                  <c:v>64527.594421386719</c:v>
                </c:pt>
                <c:pt idx="2062">
                  <c:v>64529.928344726563</c:v>
                </c:pt>
                <c:pt idx="2063">
                  <c:v>64525.890808105469</c:v>
                </c:pt>
                <c:pt idx="2064">
                  <c:v>64522.481872558594</c:v>
                </c:pt>
                <c:pt idx="2065">
                  <c:v>64525.187194824219</c:v>
                </c:pt>
                <c:pt idx="2066">
                  <c:v>64524.06396484375</c:v>
                </c:pt>
                <c:pt idx="2067">
                  <c:v>64517.140747070313</c:v>
                </c:pt>
                <c:pt idx="2068">
                  <c:v>64508.731781005859</c:v>
                </c:pt>
                <c:pt idx="2069">
                  <c:v>64497.808563232422</c:v>
                </c:pt>
                <c:pt idx="2070">
                  <c:v>64489.113891601563</c:v>
                </c:pt>
                <c:pt idx="2071">
                  <c:v>64495.562103271484</c:v>
                </c:pt>
                <c:pt idx="2072">
                  <c:v>64523.610290527344</c:v>
                </c:pt>
                <c:pt idx="2073">
                  <c:v>64566.915649414063</c:v>
                </c:pt>
                <c:pt idx="2074">
                  <c:v>64637.24951171875</c:v>
                </c:pt>
                <c:pt idx="2075">
                  <c:v>64761.611999511719</c:v>
                </c:pt>
                <c:pt idx="2076">
                  <c:v>64971.231628417969</c:v>
                </c:pt>
                <c:pt idx="2077">
                  <c:v>65298.651245117188</c:v>
                </c:pt>
                <c:pt idx="2078">
                  <c:v>65787.299438476563</c:v>
                </c:pt>
                <c:pt idx="2079">
                  <c:v>66497.147705078125</c:v>
                </c:pt>
                <c:pt idx="2080">
                  <c:v>67474.4814453125</c:v>
                </c:pt>
                <c:pt idx="2081">
                  <c:v>68732.32958984375</c:v>
                </c:pt>
                <c:pt idx="2082">
                  <c:v>70243.6064453125</c:v>
                </c:pt>
                <c:pt idx="2083">
                  <c:v>71951.51171875</c:v>
                </c:pt>
                <c:pt idx="2084">
                  <c:v>73775.07421875</c:v>
                </c:pt>
                <c:pt idx="2085">
                  <c:v>75585.4365234375</c:v>
                </c:pt>
                <c:pt idx="2086">
                  <c:v>77226.4853515625</c:v>
                </c:pt>
                <c:pt idx="2087">
                  <c:v>78540.8193359375</c:v>
                </c:pt>
                <c:pt idx="2088">
                  <c:v>79381.0380859375</c:v>
                </c:pt>
                <c:pt idx="2089">
                  <c:v>79637.8583984375</c:v>
                </c:pt>
                <c:pt idx="2090">
                  <c:v>79270.849609375</c:v>
                </c:pt>
                <c:pt idx="2091">
                  <c:v>78334.4404296875</c:v>
                </c:pt>
                <c:pt idx="2092">
                  <c:v>76933.7744140625</c:v>
                </c:pt>
                <c:pt idx="2093">
                  <c:v>75221.822265625</c:v>
                </c:pt>
                <c:pt idx="2094">
                  <c:v>73369.5849609375</c:v>
                </c:pt>
                <c:pt idx="2095">
                  <c:v>71536.6328125</c:v>
                </c:pt>
                <c:pt idx="2096">
                  <c:v>69846.79541015625</c:v>
                </c:pt>
                <c:pt idx="2097">
                  <c:v>68391.44384765625</c:v>
                </c:pt>
                <c:pt idx="2098">
                  <c:v>67214.491943359375</c:v>
                </c:pt>
                <c:pt idx="2099">
                  <c:v>66312.48291015625</c:v>
                </c:pt>
                <c:pt idx="2100">
                  <c:v>65653.416870117188</c:v>
                </c:pt>
                <c:pt idx="2101">
                  <c:v>65198.293701171875</c:v>
                </c:pt>
                <c:pt idx="2102">
                  <c:v>64900.570434570313</c:v>
                </c:pt>
                <c:pt idx="2103">
                  <c:v>64719.904296875</c:v>
                </c:pt>
                <c:pt idx="2104">
                  <c:v>64613.723937988281</c:v>
                </c:pt>
                <c:pt idx="2105">
                  <c:v>64543.229309082031</c:v>
                </c:pt>
                <c:pt idx="2106">
                  <c:v>64495.363189697266</c:v>
                </c:pt>
                <c:pt idx="2107">
                  <c:v>64469.497100830078</c:v>
                </c:pt>
                <c:pt idx="2108">
                  <c:v>64462.316741943359</c:v>
                </c:pt>
                <c:pt idx="2109">
                  <c:v>64453.907775878906</c:v>
                </c:pt>
                <c:pt idx="2110">
                  <c:v>64441.670257568359</c:v>
                </c:pt>
                <c:pt idx="2111">
                  <c:v>64425.375610351563</c:v>
                </c:pt>
                <c:pt idx="2112">
                  <c:v>64414.795227050781</c:v>
                </c:pt>
                <c:pt idx="2113">
                  <c:v>64407.500549316406</c:v>
                </c:pt>
                <c:pt idx="2114">
                  <c:v>64394.605895996094</c:v>
                </c:pt>
                <c:pt idx="2115">
                  <c:v>64380.282653808594</c:v>
                </c:pt>
                <c:pt idx="2116">
                  <c:v>64375.473724365234</c:v>
                </c:pt>
                <c:pt idx="2117">
                  <c:v>64379.921905517578</c:v>
                </c:pt>
                <c:pt idx="2118">
                  <c:v>64372.570098876953</c:v>
                </c:pt>
                <c:pt idx="2119">
                  <c:v>64354.989715576172</c:v>
                </c:pt>
                <c:pt idx="2120">
                  <c:v>64342.580780029297</c:v>
                </c:pt>
                <c:pt idx="2121">
                  <c:v>64341.000396728516</c:v>
                </c:pt>
                <c:pt idx="2122">
                  <c:v>64339.048583984375</c:v>
                </c:pt>
                <c:pt idx="2123">
                  <c:v>64332.553924560547</c:v>
                </c:pt>
                <c:pt idx="2124">
                  <c:v>64323.944976806641</c:v>
                </c:pt>
                <c:pt idx="2125">
                  <c:v>64324.421752929688</c:v>
                </c:pt>
                <c:pt idx="2126">
                  <c:v>64334.641387939453</c:v>
                </c:pt>
                <c:pt idx="2127">
                  <c:v>64346.089569091797</c:v>
                </c:pt>
                <c:pt idx="2128">
                  <c:v>64346.566345214844</c:v>
                </c:pt>
                <c:pt idx="2129">
                  <c:v>64340.900238037109</c:v>
                </c:pt>
                <c:pt idx="2130">
                  <c:v>64340.09130859375</c:v>
                </c:pt>
                <c:pt idx="2131">
                  <c:v>64340.739501953125</c:v>
                </c:pt>
                <c:pt idx="2132">
                  <c:v>64335.101959228516</c:v>
                </c:pt>
                <c:pt idx="2133">
                  <c:v>64321.178741455078</c:v>
                </c:pt>
                <c:pt idx="2134">
                  <c:v>64313.255493164063</c:v>
                </c:pt>
                <c:pt idx="2135">
                  <c:v>64318.846557617188</c:v>
                </c:pt>
                <c:pt idx="2136">
                  <c:v>64331.637603759766</c:v>
                </c:pt>
                <c:pt idx="2137">
                  <c:v>64340.857238769531</c:v>
                </c:pt>
                <c:pt idx="2138">
                  <c:v>64340.876861572266</c:v>
                </c:pt>
                <c:pt idx="2139">
                  <c:v>64329.525054931641</c:v>
                </c:pt>
                <c:pt idx="2140">
                  <c:v>64316.401824951172</c:v>
                </c:pt>
                <c:pt idx="2141">
                  <c:v>64313.478576660156</c:v>
                </c:pt>
                <c:pt idx="2142">
                  <c:v>64317.841064453125</c:v>
                </c:pt>
                <c:pt idx="2143">
                  <c:v>64316.774963378906</c:v>
                </c:pt>
                <c:pt idx="2144">
                  <c:v>64313.851745605469</c:v>
                </c:pt>
                <c:pt idx="2145">
                  <c:v>64312.328521728516</c:v>
                </c:pt>
                <c:pt idx="2146">
                  <c:v>64306.290985107422</c:v>
                </c:pt>
                <c:pt idx="2147">
                  <c:v>64300.710601806641</c:v>
                </c:pt>
                <c:pt idx="2148">
                  <c:v>64305.673095703125</c:v>
                </c:pt>
                <c:pt idx="2149">
                  <c:v>64316.464141845703</c:v>
                </c:pt>
                <c:pt idx="2150">
                  <c:v>64315.455200195313</c:v>
                </c:pt>
                <c:pt idx="2151">
                  <c:v>64306.474822998047</c:v>
                </c:pt>
                <c:pt idx="2152">
                  <c:v>64297.29443359375</c:v>
                </c:pt>
                <c:pt idx="2153">
                  <c:v>64288.942626953125</c:v>
                </c:pt>
                <c:pt idx="2154">
                  <c:v>64282.5908203125</c:v>
                </c:pt>
                <c:pt idx="2155">
                  <c:v>64290.21044921875</c:v>
                </c:pt>
                <c:pt idx="2156">
                  <c:v>64307.487213134766</c:v>
                </c:pt>
                <c:pt idx="2157">
                  <c:v>64312.706848144531</c:v>
                </c:pt>
                <c:pt idx="2158">
                  <c:v>64297.040740966797</c:v>
                </c:pt>
                <c:pt idx="2159">
                  <c:v>64279.517517089844</c:v>
                </c:pt>
                <c:pt idx="2160">
                  <c:v>64273.908569335938</c:v>
                </c:pt>
                <c:pt idx="2161">
                  <c:v>64276.328186035156</c:v>
                </c:pt>
                <c:pt idx="2162">
                  <c:v>64280.71923828125</c:v>
                </c:pt>
                <c:pt idx="2163">
                  <c:v>64279.053161621094</c:v>
                </c:pt>
                <c:pt idx="2164">
                  <c:v>64272.558502197266</c:v>
                </c:pt>
                <c:pt idx="2165">
                  <c:v>64269.035247802734</c:v>
                </c:pt>
                <c:pt idx="2166">
                  <c:v>64268.797729492188</c:v>
                </c:pt>
                <c:pt idx="2167">
                  <c:v>64261.645935058594</c:v>
                </c:pt>
                <c:pt idx="2168">
                  <c:v>64251.408416748047</c:v>
                </c:pt>
                <c:pt idx="2169">
                  <c:v>64254.113754272461</c:v>
                </c:pt>
                <c:pt idx="2170">
                  <c:v>64260.504791259766</c:v>
                </c:pt>
                <c:pt idx="2171">
                  <c:v>64258.438720703125</c:v>
                </c:pt>
                <c:pt idx="2172">
                  <c:v>64252.515487670898</c:v>
                </c:pt>
                <c:pt idx="2173">
                  <c:v>64254.477966308594</c:v>
                </c:pt>
                <c:pt idx="2174">
                  <c:v>64263.040435791016</c:v>
                </c:pt>
                <c:pt idx="2175">
                  <c:v>64265.345764160156</c:v>
                </c:pt>
                <c:pt idx="2176">
                  <c:v>64261.279693603516</c:v>
                </c:pt>
                <c:pt idx="2177">
                  <c:v>64253.813598632813</c:v>
                </c:pt>
                <c:pt idx="2178">
                  <c:v>64252.433227539063</c:v>
                </c:pt>
                <c:pt idx="2179">
                  <c:v>64254.452850341797</c:v>
                </c:pt>
                <c:pt idx="2180">
                  <c:v>64255.472473144531</c:v>
                </c:pt>
                <c:pt idx="2181">
                  <c:v>64247.492095947266</c:v>
                </c:pt>
                <c:pt idx="2182">
                  <c:v>64234.054565429688</c:v>
                </c:pt>
                <c:pt idx="2183">
                  <c:v>64229.388473510742</c:v>
                </c:pt>
                <c:pt idx="2184">
                  <c:v>64232.665252685547</c:v>
                </c:pt>
                <c:pt idx="2185">
                  <c:v>64232.599151611328</c:v>
                </c:pt>
                <c:pt idx="2186">
                  <c:v>64227.733062744141</c:v>
                </c:pt>
                <c:pt idx="2187">
                  <c:v>64228.495544433594</c:v>
                </c:pt>
                <c:pt idx="2188">
                  <c:v>64232.000885009766</c:v>
                </c:pt>
                <c:pt idx="2189">
                  <c:v>64226.934799194336</c:v>
                </c:pt>
                <c:pt idx="2190">
                  <c:v>64214.097274780273</c:v>
                </c:pt>
                <c:pt idx="2191">
                  <c:v>64202.088317871094</c:v>
                </c:pt>
                <c:pt idx="2192">
                  <c:v>64197.707946777344</c:v>
                </c:pt>
                <c:pt idx="2193">
                  <c:v>64199.241851806641</c:v>
                </c:pt>
                <c:pt idx="2194">
                  <c:v>64200.261474609375</c:v>
                </c:pt>
                <c:pt idx="2195">
                  <c:v>64194.652526855469</c:v>
                </c:pt>
                <c:pt idx="2196">
                  <c:v>64189.129302978516</c:v>
                </c:pt>
                <c:pt idx="2197">
                  <c:v>64190.063201904297</c:v>
                </c:pt>
                <c:pt idx="2198">
                  <c:v>64194.225692749023</c:v>
                </c:pt>
                <c:pt idx="2199">
                  <c:v>64200.188171386719</c:v>
                </c:pt>
                <c:pt idx="2200">
                  <c:v>64209.293502807617</c:v>
                </c:pt>
                <c:pt idx="2201">
                  <c:v>64211.341705322266</c:v>
                </c:pt>
                <c:pt idx="2202">
                  <c:v>64201.961318969727</c:v>
                </c:pt>
                <c:pt idx="2203">
                  <c:v>64193.580947875977</c:v>
                </c:pt>
                <c:pt idx="2204">
                  <c:v>64195.429138183594</c:v>
                </c:pt>
                <c:pt idx="2205">
                  <c:v>64195.648773193359</c:v>
                </c:pt>
                <c:pt idx="2206">
                  <c:v>64184.011245727539</c:v>
                </c:pt>
                <c:pt idx="2207">
                  <c:v>64168.288009643555</c:v>
                </c:pt>
                <c:pt idx="2208">
                  <c:v>64162.25048828125</c:v>
                </c:pt>
                <c:pt idx="2209">
                  <c:v>64172.327255249023</c:v>
                </c:pt>
                <c:pt idx="2210">
                  <c:v>64190.832595825195</c:v>
                </c:pt>
                <c:pt idx="2211">
                  <c:v>64209.566513061523</c:v>
                </c:pt>
                <c:pt idx="2212">
                  <c:v>64222.557556152344</c:v>
                </c:pt>
                <c:pt idx="2213">
                  <c:v>64225.520034790039</c:v>
                </c:pt>
                <c:pt idx="2214">
                  <c:v>64216.911087036133</c:v>
                </c:pt>
                <c:pt idx="2215">
                  <c:v>64200.673568725586</c:v>
                </c:pt>
                <c:pt idx="2216">
                  <c:v>64190.350341796875</c:v>
                </c:pt>
                <c:pt idx="2217">
                  <c:v>64187.455673217773</c:v>
                </c:pt>
                <c:pt idx="2218">
                  <c:v>64185.189590454102</c:v>
                </c:pt>
                <c:pt idx="2219">
                  <c:v>64181.837783813477</c:v>
                </c:pt>
                <c:pt idx="2220">
                  <c:v>64178.000259399414</c:v>
                </c:pt>
                <c:pt idx="2221">
                  <c:v>64173.762741088867</c:v>
                </c:pt>
                <c:pt idx="2222">
                  <c:v>64177.153793334961</c:v>
                </c:pt>
                <c:pt idx="2223">
                  <c:v>64184.059127807617</c:v>
                </c:pt>
                <c:pt idx="2224">
                  <c:v>64182.907318115234</c:v>
                </c:pt>
                <c:pt idx="2225">
                  <c:v>64175.44123840332</c:v>
                </c:pt>
                <c:pt idx="2226">
                  <c:v>64173.775146484375</c:v>
                </c:pt>
                <c:pt idx="2227">
                  <c:v>64176.680480957031</c:v>
                </c:pt>
                <c:pt idx="2228">
                  <c:v>64174.614395141602</c:v>
                </c:pt>
                <c:pt idx="2229">
                  <c:v>64172.948303222656</c:v>
                </c:pt>
                <c:pt idx="2230">
                  <c:v>64171.882202148438</c:v>
                </c:pt>
                <c:pt idx="2231">
                  <c:v>64165.730407714844</c:v>
                </c:pt>
                <c:pt idx="2232">
                  <c:v>64152.578598022461</c:v>
                </c:pt>
                <c:pt idx="2233">
                  <c:v>64143.912506103516</c:v>
                </c:pt>
                <c:pt idx="2234">
                  <c:v>64147.446411132813</c:v>
                </c:pt>
                <c:pt idx="2235">
                  <c:v>64154.094604492188</c:v>
                </c:pt>
                <c:pt idx="2236">
                  <c:v>64148.514236450195</c:v>
                </c:pt>
                <c:pt idx="2237">
                  <c:v>64134.16242980957</c:v>
                </c:pt>
                <c:pt idx="2238">
                  <c:v>64125.039192199707</c:v>
                </c:pt>
                <c:pt idx="2239">
                  <c:v>64125.687393188477</c:v>
                </c:pt>
                <c:pt idx="2240">
                  <c:v>64131.307006835938</c:v>
                </c:pt>
                <c:pt idx="2241">
                  <c:v>64133.726638793945</c:v>
                </c:pt>
                <c:pt idx="2242">
                  <c:v>64134.917694091797</c:v>
                </c:pt>
                <c:pt idx="2243">
                  <c:v>64143.394454956055</c:v>
                </c:pt>
                <c:pt idx="2244">
                  <c:v>64164.185501098633</c:v>
                </c:pt>
                <c:pt idx="2245">
                  <c:v>64178.205123901367</c:v>
                </c:pt>
                <c:pt idx="2246">
                  <c:v>64173.224746704102</c:v>
                </c:pt>
                <c:pt idx="2247">
                  <c:v>64158.701522827148</c:v>
                </c:pt>
                <c:pt idx="2248">
                  <c:v>64150.978286743164</c:v>
                </c:pt>
                <c:pt idx="2249">
                  <c:v>64153.197906494141</c:v>
                </c:pt>
                <c:pt idx="2250">
                  <c:v>64154.931823730469</c:v>
                </c:pt>
                <c:pt idx="2251">
                  <c:v>64147.751434326172</c:v>
                </c:pt>
                <c:pt idx="2252">
                  <c:v>64140.999633789063</c:v>
                </c:pt>
                <c:pt idx="2253">
                  <c:v>64140.762115478516</c:v>
                </c:pt>
                <c:pt idx="2254">
                  <c:v>64139.09602355957</c:v>
                </c:pt>
                <c:pt idx="2255">
                  <c:v>64139.258499145508</c:v>
                </c:pt>
                <c:pt idx="2256">
                  <c:v>64148.592422485352</c:v>
                </c:pt>
                <c:pt idx="2257">
                  <c:v>64161.440612792969</c:v>
                </c:pt>
                <c:pt idx="2258">
                  <c:v>64165.031661987305</c:v>
                </c:pt>
                <c:pt idx="2259">
                  <c:v>64163.479858398438</c:v>
                </c:pt>
                <c:pt idx="2260">
                  <c:v>64158.328048706055</c:v>
                </c:pt>
                <c:pt idx="2261">
                  <c:v>64149.261962890625</c:v>
                </c:pt>
                <c:pt idx="2262">
                  <c:v>64140.567291259766</c:v>
                </c:pt>
                <c:pt idx="2263">
                  <c:v>64134.558349609375</c:v>
                </c:pt>
                <c:pt idx="2264">
                  <c:v>64124.349403381348</c:v>
                </c:pt>
                <c:pt idx="2265">
                  <c:v>64114.597595214844</c:v>
                </c:pt>
                <c:pt idx="2266">
                  <c:v>64114.217224121094</c:v>
                </c:pt>
                <c:pt idx="2267">
                  <c:v>64120.951126098633</c:v>
                </c:pt>
                <c:pt idx="2268">
                  <c:v>64123.227897644043</c:v>
                </c:pt>
                <c:pt idx="2269">
                  <c:v>64120.190376281738</c:v>
                </c:pt>
                <c:pt idx="2270">
                  <c:v>64118.838569641113</c:v>
                </c:pt>
                <c:pt idx="2271">
                  <c:v>64124.572479248047</c:v>
                </c:pt>
                <c:pt idx="2272">
                  <c:v>64129.277816772461</c:v>
                </c:pt>
                <c:pt idx="2273">
                  <c:v>64120.554580688477</c:v>
                </c:pt>
                <c:pt idx="2274">
                  <c:v>64112.917068481445</c:v>
                </c:pt>
                <c:pt idx="2275">
                  <c:v>64122.993827819824</c:v>
                </c:pt>
                <c:pt idx="2276">
                  <c:v>64140.756317138672</c:v>
                </c:pt>
                <c:pt idx="2277">
                  <c:v>64149.204513549805</c:v>
                </c:pt>
                <c:pt idx="2278">
                  <c:v>64150.1669921875</c:v>
                </c:pt>
                <c:pt idx="2279">
                  <c:v>64145.52946472168</c:v>
                </c:pt>
                <c:pt idx="2280">
                  <c:v>64131.120513916016</c:v>
                </c:pt>
                <c:pt idx="2281">
                  <c:v>64117.140144348145</c:v>
                </c:pt>
                <c:pt idx="2282">
                  <c:v>64110.674049377441</c:v>
                </c:pt>
                <c:pt idx="2283">
                  <c:v>64107.665100097656</c:v>
                </c:pt>
                <c:pt idx="2284">
                  <c:v>64108.370445251465</c:v>
                </c:pt>
                <c:pt idx="2285">
                  <c:v>64117.847206115723</c:v>
                </c:pt>
                <c:pt idx="2286">
                  <c:v>64128.29541015625</c:v>
                </c:pt>
                <c:pt idx="2287">
                  <c:v>64130.029312133789</c:v>
                </c:pt>
                <c:pt idx="2288">
                  <c:v>64130.477508544922</c:v>
                </c:pt>
                <c:pt idx="2289">
                  <c:v>64133.211410522461</c:v>
                </c:pt>
                <c:pt idx="2290">
                  <c:v>64131.20246887207</c:v>
                </c:pt>
                <c:pt idx="2291">
                  <c:v>64126.793518066406</c:v>
                </c:pt>
                <c:pt idx="2292">
                  <c:v>64132.527435302734</c:v>
                </c:pt>
                <c:pt idx="2293">
                  <c:v>64146.947052001953</c:v>
                </c:pt>
                <c:pt idx="2294">
                  <c:v>64151.223815917969</c:v>
                </c:pt>
                <c:pt idx="2295">
                  <c:v>64140.500579833984</c:v>
                </c:pt>
                <c:pt idx="2296">
                  <c:v>64127.320205688477</c:v>
                </c:pt>
                <c:pt idx="2297">
                  <c:v>64121.596977233887</c:v>
                </c:pt>
                <c:pt idx="2298">
                  <c:v>64121.273742675781</c:v>
                </c:pt>
                <c:pt idx="2299">
                  <c:v>64127.664794921875</c:v>
                </c:pt>
                <c:pt idx="2300">
                  <c:v>64134.170135498047</c:v>
                </c:pt>
                <c:pt idx="2301">
                  <c:v>64134.9326171875</c:v>
                </c:pt>
                <c:pt idx="2302">
                  <c:v>64135.666519165039</c:v>
                </c:pt>
                <c:pt idx="2303">
                  <c:v>64142.200424194336</c:v>
                </c:pt>
                <c:pt idx="2304">
                  <c:v>64143.277191162109</c:v>
                </c:pt>
                <c:pt idx="2305">
                  <c:v>64130.896820068359</c:v>
                </c:pt>
                <c:pt idx="2306">
                  <c:v>64115.745010375977</c:v>
                </c:pt>
                <c:pt idx="2307">
                  <c:v>64111.421775817871</c:v>
                </c:pt>
                <c:pt idx="2308">
                  <c:v>64119.184257507324</c:v>
                </c:pt>
                <c:pt idx="2309">
                  <c:v>64133.889602661133</c:v>
                </c:pt>
                <c:pt idx="2310">
                  <c:v>64148.452072143555</c:v>
                </c:pt>
                <c:pt idx="2311">
                  <c:v>64154.728851318359</c:v>
                </c:pt>
                <c:pt idx="2312">
                  <c:v>64145.919891357422</c:v>
                </c:pt>
                <c:pt idx="2313">
                  <c:v>64126.939521789551</c:v>
                </c:pt>
                <c:pt idx="2314">
                  <c:v>64112.387710571289</c:v>
                </c:pt>
                <c:pt idx="2315">
                  <c:v>64106.550193786621</c:v>
                </c:pt>
                <c:pt idx="2316">
                  <c:v>64104.884101867676</c:v>
                </c:pt>
                <c:pt idx="2317">
                  <c:v>64107.018013000488</c:v>
                </c:pt>
                <c:pt idx="2318">
                  <c:v>64120.609062194824</c:v>
                </c:pt>
                <c:pt idx="2319">
                  <c:v>64140.600112915039</c:v>
                </c:pt>
                <c:pt idx="2320">
                  <c:v>64150.16259765625</c:v>
                </c:pt>
                <c:pt idx="2321">
                  <c:v>64142.725082397461</c:v>
                </c:pt>
                <c:pt idx="2322">
                  <c:v>64127.80184173584</c:v>
                </c:pt>
                <c:pt idx="2323">
                  <c:v>64115.192893981934</c:v>
                </c:pt>
                <c:pt idx="2324">
                  <c:v>64107.526802062988</c:v>
                </c:pt>
                <c:pt idx="2325">
                  <c:v>64105.517860412598</c:v>
                </c:pt>
                <c:pt idx="2326">
                  <c:v>64109.937477111816</c:v>
                </c:pt>
                <c:pt idx="2327">
                  <c:v>64118.67138671875</c:v>
                </c:pt>
                <c:pt idx="2328">
                  <c:v>64125.805297851563</c:v>
                </c:pt>
                <c:pt idx="2329">
                  <c:v>64126.996353149414</c:v>
                </c:pt>
                <c:pt idx="2330">
                  <c:v>64120.958831787109</c:v>
                </c:pt>
                <c:pt idx="2331">
                  <c:v>64112.664169311523</c:v>
                </c:pt>
                <c:pt idx="2332">
                  <c:v>64107.998077392578</c:v>
                </c:pt>
                <c:pt idx="2333">
                  <c:v>64107.017700195313</c:v>
                </c:pt>
                <c:pt idx="2334">
                  <c:v>64102.665893554688</c:v>
                </c:pt>
                <c:pt idx="2335">
                  <c:v>64099.371231079102</c:v>
                </c:pt>
                <c:pt idx="2336">
                  <c:v>64100.905143737793</c:v>
                </c:pt>
                <c:pt idx="2337">
                  <c:v>64102.067626953125</c:v>
                </c:pt>
                <c:pt idx="2338">
                  <c:v>64096.772964477539</c:v>
                </c:pt>
                <c:pt idx="2339">
                  <c:v>64094.964012145996</c:v>
                </c:pt>
                <c:pt idx="2340">
                  <c:v>64103.612205505371</c:v>
                </c:pt>
                <c:pt idx="2341">
                  <c:v>64112.774688720703</c:v>
                </c:pt>
                <c:pt idx="2342">
                  <c:v>64105.480026245117</c:v>
                </c:pt>
                <c:pt idx="2343">
                  <c:v>64089.756790161133</c:v>
                </c:pt>
                <c:pt idx="2344">
                  <c:v>64086.090698242188</c:v>
                </c:pt>
                <c:pt idx="2345">
                  <c:v>64097.081756591797</c:v>
                </c:pt>
                <c:pt idx="2346">
                  <c:v>64107.387092590332</c:v>
                </c:pt>
                <c:pt idx="2347">
                  <c:v>64109.521003723145</c:v>
                </c:pt>
                <c:pt idx="2348">
                  <c:v>64104.854911804199</c:v>
                </c:pt>
                <c:pt idx="2349">
                  <c:v>64097.045959472656</c:v>
                </c:pt>
                <c:pt idx="2350">
                  <c:v>64092.637016296387</c:v>
                </c:pt>
                <c:pt idx="2351">
                  <c:v>64086.856636047363</c:v>
                </c:pt>
                <c:pt idx="2352">
                  <c:v>64074.247688293457</c:v>
                </c:pt>
                <c:pt idx="2353">
                  <c:v>64062.467311859131</c:v>
                </c:pt>
                <c:pt idx="2354">
                  <c:v>64065.344078063965</c:v>
                </c:pt>
                <c:pt idx="2355">
                  <c:v>64081.563697814941</c:v>
                </c:pt>
                <c:pt idx="2356">
                  <c:v>64098.383323669434</c:v>
                </c:pt>
                <c:pt idx="2357">
                  <c:v>64102.231521606445</c:v>
                </c:pt>
                <c:pt idx="2358">
                  <c:v>64096.022567749023</c:v>
                </c:pt>
                <c:pt idx="2359">
                  <c:v>64093.013626098633</c:v>
                </c:pt>
                <c:pt idx="2360">
                  <c:v>64094.718963623047</c:v>
                </c:pt>
                <c:pt idx="2361">
                  <c:v>64089.767158508301</c:v>
                </c:pt>
                <c:pt idx="2362">
                  <c:v>64075.672492980957</c:v>
                </c:pt>
                <c:pt idx="2363">
                  <c:v>64068.74925994873</c:v>
                </c:pt>
                <c:pt idx="2364">
                  <c:v>64080.397453308105</c:v>
                </c:pt>
                <c:pt idx="2365">
                  <c:v>64099.674217224121</c:v>
                </c:pt>
                <c:pt idx="2366">
                  <c:v>64103.093841552734</c:v>
                </c:pt>
                <c:pt idx="2367">
                  <c:v>64090.142036437988</c:v>
                </c:pt>
                <c:pt idx="2368">
                  <c:v>64078.161659240723</c:v>
                </c:pt>
                <c:pt idx="2369">
                  <c:v>64075.038429260254</c:v>
                </c:pt>
                <c:pt idx="2370">
                  <c:v>64078.086624145508</c:v>
                </c:pt>
                <c:pt idx="2371">
                  <c:v>64085.90625</c:v>
                </c:pt>
                <c:pt idx="2372">
                  <c:v>64085.325866699219</c:v>
                </c:pt>
                <c:pt idx="2373">
                  <c:v>64072.488349914551</c:v>
                </c:pt>
                <c:pt idx="2374">
                  <c:v>64066.050834655762</c:v>
                </c:pt>
                <c:pt idx="2375">
                  <c:v>64080.756172180176</c:v>
                </c:pt>
                <c:pt idx="2376">
                  <c:v>64098.518646240234</c:v>
                </c:pt>
                <c:pt idx="2377">
                  <c:v>64102.023986816406</c:v>
                </c:pt>
                <c:pt idx="2378">
                  <c:v>64093.157897949219</c:v>
                </c:pt>
                <c:pt idx="2379">
                  <c:v>64082.834663391113</c:v>
                </c:pt>
                <c:pt idx="2380">
                  <c:v>64079.454284667969</c:v>
                </c:pt>
                <c:pt idx="2381">
                  <c:v>64083.702484130859</c:v>
                </c:pt>
                <c:pt idx="2382">
                  <c:v>64088.722106933594</c:v>
                </c:pt>
                <c:pt idx="2383">
                  <c:v>64085.770301818848</c:v>
                </c:pt>
                <c:pt idx="2384">
                  <c:v>64077.818496704102</c:v>
                </c:pt>
                <c:pt idx="2385">
                  <c:v>64069.95240020752</c:v>
                </c:pt>
                <c:pt idx="2386">
                  <c:v>64067.972023010254</c:v>
                </c:pt>
                <c:pt idx="2387">
                  <c:v>64069.848793029785</c:v>
                </c:pt>
                <c:pt idx="2388">
                  <c:v>64069.468414306641</c:v>
                </c:pt>
                <c:pt idx="2389">
                  <c:v>64067.888038635254</c:v>
                </c:pt>
                <c:pt idx="2390">
                  <c:v>64073.964805603027</c:v>
                </c:pt>
                <c:pt idx="2391">
                  <c:v>64087.212997436523</c:v>
                </c:pt>
                <c:pt idx="2392">
                  <c:v>64094.032623291016</c:v>
                </c:pt>
                <c:pt idx="2393">
                  <c:v>64089.909393310547</c:v>
                </c:pt>
                <c:pt idx="2394">
                  <c:v>64087.214729309082</c:v>
                </c:pt>
                <c:pt idx="2395">
                  <c:v>64090.520065307617</c:v>
                </c:pt>
                <c:pt idx="2396">
                  <c:v>64092.453971862793</c:v>
                </c:pt>
                <c:pt idx="2397">
                  <c:v>64083.587882995605</c:v>
                </c:pt>
                <c:pt idx="2398">
                  <c:v>64071.321792602539</c:v>
                </c:pt>
                <c:pt idx="2399">
                  <c:v>64067.398559570313</c:v>
                </c:pt>
                <c:pt idx="2400">
                  <c:v>64076.361038208008</c:v>
                </c:pt>
                <c:pt idx="2401">
                  <c:v>64086.894950866699</c:v>
                </c:pt>
                <c:pt idx="2402">
                  <c:v>64087.314575195313</c:v>
                </c:pt>
                <c:pt idx="2403">
                  <c:v>64080.305625915527</c:v>
                </c:pt>
                <c:pt idx="2404">
                  <c:v>64070.953819274902</c:v>
                </c:pt>
                <c:pt idx="2405">
                  <c:v>64062.830585479736</c:v>
                </c:pt>
                <c:pt idx="2406">
                  <c:v>64061.05020904541</c:v>
                </c:pt>
                <c:pt idx="2407">
                  <c:v>64064.812690734863</c:v>
                </c:pt>
                <c:pt idx="2408">
                  <c:v>64070.432312011719</c:v>
                </c:pt>
                <c:pt idx="2409">
                  <c:v>64074.62336730957</c:v>
                </c:pt>
                <c:pt idx="2410">
                  <c:v>64079.785842895508</c:v>
                </c:pt>
                <c:pt idx="2411">
                  <c:v>64081.891181945801</c:v>
                </c:pt>
                <c:pt idx="2412">
                  <c:v>64073.425094604492</c:v>
                </c:pt>
                <c:pt idx="2413">
                  <c:v>64060.530429840088</c:v>
                </c:pt>
                <c:pt idx="2414">
                  <c:v>64053.178623199463</c:v>
                </c:pt>
                <c:pt idx="2415">
                  <c:v>64058.341102600098</c:v>
                </c:pt>
                <c:pt idx="2416">
                  <c:v>64066.84644317627</c:v>
                </c:pt>
                <c:pt idx="2417">
                  <c:v>64069.266067504883</c:v>
                </c:pt>
                <c:pt idx="2418">
                  <c:v>64063.171401977539</c:v>
                </c:pt>
                <c:pt idx="2419">
                  <c:v>64056.448169708252</c:v>
                </c:pt>
                <c:pt idx="2420">
                  <c:v>64053.239219665527</c:v>
                </c:pt>
                <c:pt idx="2421">
                  <c:v>64054.1731300354</c:v>
                </c:pt>
                <c:pt idx="2422">
                  <c:v>64064.792755126953</c:v>
                </c:pt>
                <c:pt idx="2423">
                  <c:v>64079.440948486328</c:v>
                </c:pt>
                <c:pt idx="2424">
                  <c:v>64080.232002258301</c:v>
                </c:pt>
                <c:pt idx="2425">
                  <c:v>64068.851623535156</c:v>
                </c:pt>
                <c:pt idx="2426">
                  <c:v>64063.699817657471</c:v>
                </c:pt>
                <c:pt idx="2427">
                  <c:v>64068.405158996582</c:v>
                </c:pt>
                <c:pt idx="2428">
                  <c:v>64075.024780273438</c:v>
                </c:pt>
                <c:pt idx="2429">
                  <c:v>64077.47297668457</c:v>
                </c:pt>
                <c:pt idx="2430">
                  <c:v>64072.206886291504</c:v>
                </c:pt>
                <c:pt idx="2431">
                  <c:v>64064.626502990723</c:v>
                </c:pt>
                <c:pt idx="2432">
                  <c:v>64064.417556762695</c:v>
                </c:pt>
                <c:pt idx="2433">
                  <c:v>64069.265754699707</c:v>
                </c:pt>
                <c:pt idx="2434">
                  <c:v>64068.113945007324</c:v>
                </c:pt>
                <c:pt idx="2435">
                  <c:v>64060.390712738037</c:v>
                </c:pt>
                <c:pt idx="2436">
                  <c:v>64054.553195953369</c:v>
                </c:pt>
                <c:pt idx="2437">
                  <c:v>64054.258533477783</c:v>
                </c:pt>
                <c:pt idx="2438">
                  <c:v>64063.021011352539</c:v>
                </c:pt>
                <c:pt idx="2439">
                  <c:v>64071.92635345459</c:v>
                </c:pt>
                <c:pt idx="2440">
                  <c:v>64072.345977783203</c:v>
                </c:pt>
                <c:pt idx="2441">
                  <c:v>64062.0227394104</c:v>
                </c:pt>
                <c:pt idx="2442">
                  <c:v>64051.242362976074</c:v>
                </c:pt>
                <c:pt idx="2443">
                  <c:v>64044.261985778809</c:v>
                </c:pt>
                <c:pt idx="2444">
                  <c:v>64039.538753509521</c:v>
                </c:pt>
                <c:pt idx="2445">
                  <c:v>64037.158374786377</c:v>
                </c:pt>
                <c:pt idx="2446">
                  <c:v>64037.892284393311</c:v>
                </c:pt>
                <c:pt idx="2447">
                  <c:v>64043.626194000244</c:v>
                </c:pt>
                <c:pt idx="2448">
                  <c:v>64053.560104370117</c:v>
                </c:pt>
                <c:pt idx="2449">
                  <c:v>64064.779724121094</c:v>
                </c:pt>
                <c:pt idx="2450">
                  <c:v>64071.513633728027</c:v>
                </c:pt>
                <c:pt idx="2451">
                  <c:v>64066.218971252441</c:v>
                </c:pt>
                <c:pt idx="2452">
                  <c:v>64054.981452941895</c:v>
                </c:pt>
                <c:pt idx="2453">
                  <c:v>64051.143936157227</c:v>
                </c:pt>
                <c:pt idx="2454">
                  <c:v>64055.792129516602</c:v>
                </c:pt>
                <c:pt idx="2455">
                  <c:v>64053.583183288574</c:v>
                </c:pt>
                <c:pt idx="2456">
                  <c:v>64047.945663452148</c:v>
                </c:pt>
                <c:pt idx="2457">
                  <c:v>64047.536712646484</c:v>
                </c:pt>
                <c:pt idx="2458">
                  <c:v>64046.384910583496</c:v>
                </c:pt>
                <c:pt idx="2459">
                  <c:v>64040.40453338623</c:v>
                </c:pt>
                <c:pt idx="2460">
                  <c:v>64036.081298828125</c:v>
                </c:pt>
                <c:pt idx="2461">
                  <c:v>64038.90092086792</c:v>
                </c:pt>
                <c:pt idx="2462">
                  <c:v>64041.349117279053</c:v>
                </c:pt>
                <c:pt idx="2463">
                  <c:v>64041.225883483887</c:v>
                </c:pt>
                <c:pt idx="2464">
                  <c:v>64044.874076843262</c:v>
                </c:pt>
                <c:pt idx="2465">
                  <c:v>64055.893699645996</c:v>
                </c:pt>
                <c:pt idx="2466">
                  <c:v>64066.370468139648</c:v>
                </c:pt>
                <c:pt idx="2467">
                  <c:v>64067.53295135498</c:v>
                </c:pt>
                <c:pt idx="2468">
                  <c:v>64066.181144714355</c:v>
                </c:pt>
                <c:pt idx="2469">
                  <c:v>64064.372192382813</c:v>
                </c:pt>
                <c:pt idx="2470">
                  <c:v>64057.820388793945</c:v>
                </c:pt>
                <c:pt idx="2471">
                  <c:v>64043.411441802979</c:v>
                </c:pt>
                <c:pt idx="2472">
                  <c:v>64034.059635162354</c:v>
                </c:pt>
                <c:pt idx="2473">
                  <c:v>64040.822116851807</c:v>
                </c:pt>
                <c:pt idx="2474">
                  <c:v>64059.498882293701</c:v>
                </c:pt>
                <c:pt idx="2475">
                  <c:v>64067.289932250977</c:v>
                </c:pt>
                <c:pt idx="2476">
                  <c:v>64060.566699981689</c:v>
                </c:pt>
                <c:pt idx="2477">
                  <c:v>64052.300609588623</c:v>
                </c:pt>
                <c:pt idx="2478">
                  <c:v>64050.663089752197</c:v>
                </c:pt>
                <c:pt idx="2479">
                  <c:v>64048.96842956543</c:v>
                </c:pt>
                <c:pt idx="2480">
                  <c:v>64046.702339172363</c:v>
                </c:pt>
                <c:pt idx="2481">
                  <c:v>64048.750534057617</c:v>
                </c:pt>
                <c:pt idx="2482">
                  <c:v>64054.713012695313</c:v>
                </c:pt>
                <c:pt idx="2483">
                  <c:v>64058.904064178467</c:v>
                </c:pt>
                <c:pt idx="2484">
                  <c:v>64057.952259063721</c:v>
                </c:pt>
                <c:pt idx="2485">
                  <c:v>64051.857597351074</c:v>
                </c:pt>
                <c:pt idx="2486">
                  <c:v>64048.191505432129</c:v>
                </c:pt>
                <c:pt idx="2487">
                  <c:v>64052.953987121582</c:v>
                </c:pt>
                <c:pt idx="2488">
                  <c:v>64058.545040130615</c:v>
                </c:pt>
                <c:pt idx="2489">
                  <c:v>64057.56466293335</c:v>
                </c:pt>
                <c:pt idx="2490">
                  <c:v>64051.669998168945</c:v>
                </c:pt>
                <c:pt idx="2491">
                  <c:v>64043.289623260498</c:v>
                </c:pt>
                <c:pt idx="2492">
                  <c:v>64039.337818145752</c:v>
                </c:pt>
                <c:pt idx="2493">
                  <c:v>64050.557441711426</c:v>
                </c:pt>
                <c:pt idx="2494">
                  <c:v>64062.919921875</c:v>
                </c:pt>
                <c:pt idx="2495">
                  <c:v>64057.396686553955</c:v>
                </c:pt>
                <c:pt idx="2496">
                  <c:v>64044.073455810547</c:v>
                </c:pt>
                <c:pt idx="2497">
                  <c:v>64043.464508056641</c:v>
                </c:pt>
                <c:pt idx="2498">
                  <c:v>64050.512702941895</c:v>
                </c:pt>
                <c:pt idx="2499">
                  <c:v>64051.10375213623</c:v>
                </c:pt>
                <c:pt idx="2500">
                  <c:v>64044.609092712402</c:v>
                </c:pt>
                <c:pt idx="2501">
                  <c:v>64043.028713226318</c:v>
                </c:pt>
                <c:pt idx="2502">
                  <c:v>64045.419765472412</c:v>
                </c:pt>
                <c:pt idx="2503">
                  <c:v>64049.382247924805</c:v>
                </c:pt>
                <c:pt idx="2504">
                  <c:v>64058.17329788208</c:v>
                </c:pt>
                <c:pt idx="2505">
                  <c:v>64069.821495056152</c:v>
                </c:pt>
                <c:pt idx="2506">
                  <c:v>64069.726829528809</c:v>
                </c:pt>
                <c:pt idx="2507">
                  <c:v>64054.489311218262</c:v>
                </c:pt>
                <c:pt idx="2508">
                  <c:v>64042.537506103516</c:v>
                </c:pt>
                <c:pt idx="2509">
                  <c:v>64042.642845153809</c:v>
                </c:pt>
                <c:pt idx="2510">
                  <c:v>64048.919609069824</c:v>
                </c:pt>
                <c:pt idx="2511">
                  <c:v>64056.024948120117</c:v>
                </c:pt>
                <c:pt idx="2512">
                  <c:v>64057.61600112915</c:v>
                </c:pt>
                <c:pt idx="2513">
                  <c:v>64055.321338653564</c:v>
                </c:pt>
                <c:pt idx="2514">
                  <c:v>64054.25524520874</c:v>
                </c:pt>
                <c:pt idx="2515">
                  <c:v>64054.017726898193</c:v>
                </c:pt>
                <c:pt idx="2516">
                  <c:v>64043.237350463867</c:v>
                </c:pt>
                <c:pt idx="2517">
                  <c:v>64022.571260452271</c:v>
                </c:pt>
                <c:pt idx="2518">
                  <c:v>64020.590883255005</c:v>
                </c:pt>
                <c:pt idx="2519">
                  <c:v>64041.753364562988</c:v>
                </c:pt>
                <c:pt idx="2520">
                  <c:v>64064.001556396484</c:v>
                </c:pt>
                <c:pt idx="2521">
                  <c:v>64063.564037322998</c:v>
                </c:pt>
                <c:pt idx="2522">
                  <c:v>64046.126518249512</c:v>
                </c:pt>
                <c:pt idx="2523">
                  <c:v>64026.231857299805</c:v>
                </c:pt>
                <c:pt idx="2524">
                  <c:v>64017.765766143799</c:v>
                </c:pt>
                <c:pt idx="2525">
                  <c:v>64024.356817245483</c:v>
                </c:pt>
                <c:pt idx="2526">
                  <c:v>64036.347869873047</c:v>
                </c:pt>
                <c:pt idx="2527">
                  <c:v>64038.45320892334</c:v>
                </c:pt>
                <c:pt idx="2528">
                  <c:v>64034.844261169434</c:v>
                </c:pt>
                <c:pt idx="2529">
                  <c:v>64034.09245300293</c:v>
                </c:pt>
                <c:pt idx="2530">
                  <c:v>64036.540649414063</c:v>
                </c:pt>
                <c:pt idx="2531">
                  <c:v>64035.845985412598</c:v>
                </c:pt>
                <c:pt idx="2532">
                  <c:v>64035.751323699951</c:v>
                </c:pt>
                <c:pt idx="2533">
                  <c:v>64041.828090667725</c:v>
                </c:pt>
                <c:pt idx="2534">
                  <c:v>64051.219142913818</c:v>
                </c:pt>
                <c:pt idx="2535">
                  <c:v>64057.438766479492</c:v>
                </c:pt>
                <c:pt idx="2536">
                  <c:v>64059.744102478027</c:v>
                </c:pt>
                <c:pt idx="2537">
                  <c:v>64060.620868682861</c:v>
                </c:pt>
                <c:pt idx="2538">
                  <c:v>64060.269065856934</c:v>
                </c:pt>
                <c:pt idx="2539">
                  <c:v>64055.517261505127</c:v>
                </c:pt>
                <c:pt idx="2540">
                  <c:v>64049.794025421143</c:v>
                </c:pt>
                <c:pt idx="2541">
                  <c:v>64047.185077667236</c:v>
                </c:pt>
                <c:pt idx="2542">
                  <c:v>64047.176128387451</c:v>
                </c:pt>
                <c:pt idx="2543">
                  <c:v>64042.110038757324</c:v>
                </c:pt>
                <c:pt idx="2544">
                  <c:v>64033.701091766357</c:v>
                </c:pt>
                <c:pt idx="2545">
                  <c:v>64030.263570785522</c:v>
                </c:pt>
                <c:pt idx="2546">
                  <c:v>64035.968910217285</c:v>
                </c:pt>
                <c:pt idx="2547">
                  <c:v>64043.045677185059</c:v>
                </c:pt>
                <c:pt idx="2548">
                  <c:v>64045.465297698975</c:v>
                </c:pt>
                <c:pt idx="2549">
                  <c:v>64040.656349182129</c:v>
                </c:pt>
                <c:pt idx="2550">
                  <c:v>64039.990261077881</c:v>
                </c:pt>
                <c:pt idx="2551">
                  <c:v>64047.581310272217</c:v>
                </c:pt>
                <c:pt idx="2552">
                  <c:v>64053.458076477051</c:v>
                </c:pt>
                <c:pt idx="2553">
                  <c:v>64044.763416290283</c:v>
                </c:pt>
                <c:pt idx="2554">
                  <c:v>64035.011611938477</c:v>
                </c:pt>
                <c:pt idx="2555">
                  <c:v>64033.031234741211</c:v>
                </c:pt>
                <c:pt idx="2556">
                  <c:v>64038.879428863525</c:v>
                </c:pt>
                <c:pt idx="2557">
                  <c:v>64043.184764862061</c:v>
                </c:pt>
                <c:pt idx="2558">
                  <c:v>64048.547245025635</c:v>
                </c:pt>
                <c:pt idx="2559">
                  <c:v>64048.395442962646</c:v>
                </c:pt>
                <c:pt idx="2560">
                  <c:v>64047.872207641602</c:v>
                </c:pt>
                <c:pt idx="2561">
                  <c:v>64049.148975372314</c:v>
                </c:pt>
                <c:pt idx="2562">
                  <c:v>64048.511455535889</c:v>
                </c:pt>
                <c:pt idx="2563">
                  <c:v>64046.045364379883</c:v>
                </c:pt>
                <c:pt idx="2564">
                  <c:v>64053.836414337158</c:v>
                </c:pt>
                <c:pt idx="2565">
                  <c:v>64071.370323181152</c:v>
                </c:pt>
                <c:pt idx="2566">
                  <c:v>64077.647087097168</c:v>
                </c:pt>
                <c:pt idx="2567">
                  <c:v>64066.866714477539</c:v>
                </c:pt>
                <c:pt idx="2568">
                  <c:v>64048.057765960693</c:v>
                </c:pt>
                <c:pt idx="2569">
                  <c:v>64034.391674041748</c:v>
                </c:pt>
                <c:pt idx="2570">
                  <c:v>64031.068441390991</c:v>
                </c:pt>
                <c:pt idx="2571">
                  <c:v>64034.773780822754</c:v>
                </c:pt>
                <c:pt idx="2572">
                  <c:v>64041.19340133667</c:v>
                </c:pt>
                <c:pt idx="2573">
                  <c:v>64050.384452819824</c:v>
                </c:pt>
                <c:pt idx="2574">
                  <c:v>64057.175506591797</c:v>
                </c:pt>
                <c:pt idx="2575">
                  <c:v>64053.023700714111</c:v>
                </c:pt>
                <c:pt idx="2576">
                  <c:v>64043.500469207764</c:v>
                </c:pt>
                <c:pt idx="2577">
                  <c:v>64034.234375</c:v>
                </c:pt>
                <c:pt idx="2578">
                  <c:v>64028.111143112183</c:v>
                </c:pt>
                <c:pt idx="2579">
                  <c:v>64030.416481018066</c:v>
                </c:pt>
                <c:pt idx="2580">
                  <c:v>64042.236103057861</c:v>
                </c:pt>
                <c:pt idx="2581">
                  <c:v>64048.598583221436</c:v>
                </c:pt>
                <c:pt idx="2582">
                  <c:v>64038.903923034668</c:v>
                </c:pt>
                <c:pt idx="2583">
                  <c:v>64025.637830734253</c:v>
                </c:pt>
                <c:pt idx="2584">
                  <c:v>64021.543169021606</c:v>
                </c:pt>
                <c:pt idx="2585">
                  <c:v>64028.33422088623</c:v>
                </c:pt>
                <c:pt idx="2586">
                  <c:v>64038.125270843506</c:v>
                </c:pt>
                <c:pt idx="2587">
                  <c:v>64042.487754821777</c:v>
                </c:pt>
                <c:pt idx="2588">
                  <c:v>64039.821662902832</c:v>
                </c:pt>
                <c:pt idx="2589">
                  <c:v>64038.898429870605</c:v>
                </c:pt>
                <c:pt idx="2590">
                  <c:v>64044.860908508301</c:v>
                </c:pt>
                <c:pt idx="2591">
                  <c:v>64046.451961517334</c:v>
                </c:pt>
                <c:pt idx="2592">
                  <c:v>64037.928726196289</c:v>
                </c:pt>
                <c:pt idx="2593">
                  <c:v>64031.091207504272</c:v>
                </c:pt>
                <c:pt idx="2594">
                  <c:v>64033.539402008057</c:v>
                </c:pt>
                <c:pt idx="2595">
                  <c:v>64038.730453491211</c:v>
                </c:pt>
                <c:pt idx="2596">
                  <c:v>64038.321506500244</c:v>
                </c:pt>
                <c:pt idx="2597">
                  <c:v>64035.055416107178</c:v>
                </c:pt>
                <c:pt idx="2598">
                  <c:v>64033.075038909912</c:v>
                </c:pt>
                <c:pt idx="2599">
                  <c:v>64035.151805877686</c:v>
                </c:pt>
                <c:pt idx="2600">
                  <c:v>64036.65714263916</c:v>
                </c:pt>
                <c:pt idx="2601">
                  <c:v>64034.133907318115</c:v>
                </c:pt>
                <c:pt idx="2602">
                  <c:v>64030.782104492188</c:v>
                </c:pt>
                <c:pt idx="2603">
                  <c:v>64035.716014862061</c:v>
                </c:pt>
                <c:pt idx="2604">
                  <c:v>64050.449920654297</c:v>
                </c:pt>
                <c:pt idx="2605">
                  <c:v>64068.840972900391</c:v>
                </c:pt>
                <c:pt idx="2606">
                  <c:v>64075.003456115723</c:v>
                </c:pt>
                <c:pt idx="2607">
                  <c:v>64064.85164642334</c:v>
                </c:pt>
                <c:pt idx="2608">
                  <c:v>64050.785556793213</c:v>
                </c:pt>
                <c:pt idx="2609">
                  <c:v>64046.233753204346</c:v>
                </c:pt>
                <c:pt idx="2610">
                  <c:v>64049.39623260498</c:v>
                </c:pt>
                <c:pt idx="2611">
                  <c:v>64050.844429016113</c:v>
                </c:pt>
                <c:pt idx="2612">
                  <c:v>64049.835479736328</c:v>
                </c:pt>
                <c:pt idx="2613">
                  <c:v>64048.026531219482</c:v>
                </c:pt>
                <c:pt idx="2614">
                  <c:v>64048.131870269775</c:v>
                </c:pt>
                <c:pt idx="2615">
                  <c:v>64045.32292175293</c:v>
                </c:pt>
                <c:pt idx="2616">
                  <c:v>64041.542545318604</c:v>
                </c:pt>
                <c:pt idx="2617">
                  <c:v>64042.305027008057</c:v>
                </c:pt>
                <c:pt idx="2618">
                  <c:v>64048.496078491211</c:v>
                </c:pt>
                <c:pt idx="2619">
                  <c:v>64047.172843933105</c:v>
                </c:pt>
                <c:pt idx="2620">
                  <c:v>64034.849609375</c:v>
                </c:pt>
                <c:pt idx="2621">
                  <c:v>64028.012090682983</c:v>
                </c:pt>
                <c:pt idx="2622">
                  <c:v>64031.831714630127</c:v>
                </c:pt>
                <c:pt idx="2623">
                  <c:v>64031.422765731812</c:v>
                </c:pt>
                <c:pt idx="2624">
                  <c:v>64018.899532318115</c:v>
                </c:pt>
                <c:pt idx="2625">
                  <c:v>64010.262013435364</c:v>
                </c:pt>
                <c:pt idx="2626">
                  <c:v>64016.967350006104</c:v>
                </c:pt>
                <c:pt idx="2627">
                  <c:v>64035.129829406738</c:v>
                </c:pt>
                <c:pt idx="2628">
                  <c:v>64047.035167694092</c:v>
                </c:pt>
                <c:pt idx="2629">
                  <c:v>64041.911933898926</c:v>
                </c:pt>
                <c:pt idx="2630">
                  <c:v>64028.160129547119</c:v>
                </c:pt>
                <c:pt idx="2631">
                  <c:v>64021.265466690063</c:v>
                </c:pt>
                <c:pt idx="2632">
                  <c:v>64021.113662719727</c:v>
                </c:pt>
                <c:pt idx="2633">
                  <c:v>64024.618999481201</c:v>
                </c:pt>
                <c:pt idx="2634">
                  <c:v>64035.438621520996</c:v>
                </c:pt>
                <c:pt idx="2635">
                  <c:v>64049.00110244751</c:v>
                </c:pt>
                <c:pt idx="2636">
                  <c:v>64054.306442260742</c:v>
                </c:pt>
                <c:pt idx="2637">
                  <c:v>64049.640350341797</c:v>
                </c:pt>
                <c:pt idx="2638">
                  <c:v>64041.688545227051</c:v>
                </c:pt>
                <c:pt idx="2639">
                  <c:v>64038.079597473145</c:v>
                </c:pt>
                <c:pt idx="2640">
                  <c:v>64045.156364440918</c:v>
                </c:pt>
                <c:pt idx="2641">
                  <c:v>64054.004558563232</c:v>
                </c:pt>
                <c:pt idx="2642">
                  <c:v>64057.424182891846</c:v>
                </c:pt>
                <c:pt idx="2643">
                  <c:v>64051.700946807861</c:v>
                </c:pt>
                <c:pt idx="2644">
                  <c:v>64042.749141693115</c:v>
                </c:pt>
                <c:pt idx="2645">
                  <c:v>64035.683052062988</c:v>
                </c:pt>
                <c:pt idx="2646">
                  <c:v>64049.874103546143</c:v>
                </c:pt>
                <c:pt idx="2647">
                  <c:v>64075.179443359375</c:v>
                </c:pt>
                <c:pt idx="2648">
                  <c:v>64091.741920471191</c:v>
                </c:pt>
                <c:pt idx="2649">
                  <c:v>64086.532974243164</c:v>
                </c:pt>
                <c:pt idx="2650">
                  <c:v>64071.724029541016</c:v>
                </c:pt>
                <c:pt idx="2651">
                  <c:v>64056.400791168213</c:v>
                </c:pt>
                <c:pt idx="2652">
                  <c:v>64048.048988342285</c:v>
                </c:pt>
                <c:pt idx="2653">
                  <c:v>64043.411468505859</c:v>
                </c:pt>
                <c:pt idx="2654">
                  <c:v>64037.516803741455</c:v>
                </c:pt>
                <c:pt idx="2655">
                  <c:v>64033.136428833008</c:v>
                </c:pt>
                <c:pt idx="2656">
                  <c:v>64033.241767883301</c:v>
                </c:pt>
                <c:pt idx="2657">
                  <c:v>64033.889961242676</c:v>
                </c:pt>
                <c:pt idx="2658">
                  <c:v>64034.623870849609</c:v>
                </c:pt>
                <c:pt idx="2659">
                  <c:v>64036.957778930664</c:v>
                </c:pt>
                <c:pt idx="2660">
                  <c:v>64041.663116455078</c:v>
                </c:pt>
                <c:pt idx="2661">
                  <c:v>64047.082740783691</c:v>
                </c:pt>
                <c:pt idx="2662">
                  <c:v>64048.988079071045</c:v>
                </c:pt>
                <c:pt idx="2663">
                  <c:v>64046.179130554199</c:v>
                </c:pt>
                <c:pt idx="2664">
                  <c:v>64039.770183563232</c:v>
                </c:pt>
                <c:pt idx="2665">
                  <c:v>64032.761234283447</c:v>
                </c:pt>
                <c:pt idx="2666">
                  <c:v>64026.466571807861</c:v>
                </c:pt>
                <c:pt idx="2667">
                  <c:v>64028.800479888916</c:v>
                </c:pt>
                <c:pt idx="2668">
                  <c:v>64041.620105743408</c:v>
                </c:pt>
                <c:pt idx="2669">
                  <c:v>64050.525440216064</c:v>
                </c:pt>
                <c:pt idx="2670">
                  <c:v>64039.087921142578</c:v>
                </c:pt>
                <c:pt idx="2671">
                  <c:v>64016.336116790771</c:v>
                </c:pt>
                <c:pt idx="2672">
                  <c:v>64005.527168750763</c:v>
                </c:pt>
                <c:pt idx="2673">
                  <c:v>64013.803935050964</c:v>
                </c:pt>
                <c:pt idx="2674">
                  <c:v>64023.509273529053</c:v>
                </c:pt>
                <c:pt idx="2675">
                  <c:v>64022.100324630737</c:v>
                </c:pt>
                <c:pt idx="2676">
                  <c:v>64017.462804794312</c:v>
                </c:pt>
                <c:pt idx="2677">
                  <c:v>64016.739570617676</c:v>
                </c:pt>
                <c:pt idx="2678">
                  <c:v>64019.016338348389</c:v>
                </c:pt>
                <c:pt idx="2679">
                  <c:v>64022.550247192383</c:v>
                </c:pt>
                <c:pt idx="2680">
                  <c:v>64037.598442077637</c:v>
                </c:pt>
                <c:pt idx="2681">
                  <c:v>64053.818065643311</c:v>
                </c:pt>
                <c:pt idx="2682">
                  <c:v>64053.951972961426</c:v>
                </c:pt>
                <c:pt idx="2683">
                  <c:v>64043.943027496338</c:v>
                </c:pt>
                <c:pt idx="2684">
                  <c:v>64043.076934814453</c:v>
                </c:pt>
                <c:pt idx="2685">
                  <c:v>64047.982273101807</c:v>
                </c:pt>
                <c:pt idx="2686">
                  <c:v>64052.23046875</c:v>
                </c:pt>
                <c:pt idx="2687">
                  <c:v>64057.364376068115</c:v>
                </c:pt>
                <c:pt idx="2688">
                  <c:v>64061.841144561768</c:v>
                </c:pt>
                <c:pt idx="2689">
                  <c:v>64060.917907714844</c:v>
                </c:pt>
                <c:pt idx="2690">
                  <c:v>64058.280387878418</c:v>
                </c:pt>
                <c:pt idx="2691">
                  <c:v>64052.557155609131</c:v>
                </c:pt>
                <c:pt idx="2692">
                  <c:v>64045.148208618164</c:v>
                </c:pt>
                <c:pt idx="2693">
                  <c:v>64047.42497253418</c:v>
                </c:pt>
                <c:pt idx="2694">
                  <c:v>64054.387454986572</c:v>
                </c:pt>
                <c:pt idx="2695">
                  <c:v>64055.864219665527</c:v>
                </c:pt>
                <c:pt idx="2696">
                  <c:v>64054.96955871582</c:v>
                </c:pt>
                <c:pt idx="2697">
                  <c:v>64059.189182281494</c:v>
                </c:pt>
                <c:pt idx="2698">
                  <c:v>64064.180236816406</c:v>
                </c:pt>
                <c:pt idx="2699">
                  <c:v>64061.571285247803</c:v>
                </c:pt>
                <c:pt idx="2700">
                  <c:v>64059.733764648438</c:v>
                </c:pt>
                <c:pt idx="2701">
                  <c:v>64060.52481842041</c:v>
                </c:pt>
                <c:pt idx="2702">
                  <c:v>64057.030155181885</c:v>
                </c:pt>
                <c:pt idx="2703">
                  <c:v>64046.792636871338</c:v>
                </c:pt>
                <c:pt idx="2704">
                  <c:v>64040.040832519531</c:v>
                </c:pt>
                <c:pt idx="2705">
                  <c:v>64035.603313446045</c:v>
                </c:pt>
                <c:pt idx="2706">
                  <c:v>64026.05150604248</c:v>
                </c:pt>
                <c:pt idx="2707">
                  <c:v>64017.356843948364</c:v>
                </c:pt>
                <c:pt idx="2708">
                  <c:v>64017.919324874878</c:v>
                </c:pt>
                <c:pt idx="2709">
                  <c:v>64023.310377120972</c:v>
                </c:pt>
                <c:pt idx="2710">
                  <c:v>64030.072856903076</c:v>
                </c:pt>
                <c:pt idx="2711">
                  <c:v>64039.77819442749</c:v>
                </c:pt>
                <c:pt idx="2712">
                  <c:v>64046.054962158203</c:v>
                </c:pt>
                <c:pt idx="2713">
                  <c:v>64045.074584960938</c:v>
                </c:pt>
                <c:pt idx="2714">
                  <c:v>64041.408493041992</c:v>
                </c:pt>
                <c:pt idx="2715">
                  <c:v>64044.370975494385</c:v>
                </c:pt>
                <c:pt idx="2716">
                  <c:v>64050.01916885376</c:v>
                </c:pt>
                <c:pt idx="2717">
                  <c:v>64052.438793182373</c:v>
                </c:pt>
                <c:pt idx="2718">
                  <c:v>64049.172702789307</c:v>
                </c:pt>
                <c:pt idx="2719">
                  <c:v>64041.763751983643</c:v>
                </c:pt>
                <c:pt idx="2720">
                  <c:v>64033.154804229736</c:v>
                </c:pt>
                <c:pt idx="2721">
                  <c:v>64031.46014213562</c:v>
                </c:pt>
                <c:pt idx="2722">
                  <c:v>64041.336910247803</c:v>
                </c:pt>
                <c:pt idx="2723">
                  <c:v>64060.013675689697</c:v>
                </c:pt>
                <c:pt idx="2724">
                  <c:v>64066.60472869873</c:v>
                </c:pt>
                <c:pt idx="2725">
                  <c:v>64053.767208099365</c:v>
                </c:pt>
                <c:pt idx="2726">
                  <c:v>64028.35825920105</c:v>
                </c:pt>
                <c:pt idx="2727">
                  <c:v>64012.092168807983</c:v>
                </c:pt>
                <c:pt idx="2728">
                  <c:v>64016.283220291138</c:v>
                </c:pt>
                <c:pt idx="2729">
                  <c:v>64031.331415176392</c:v>
                </c:pt>
                <c:pt idx="2730">
                  <c:v>64039.608180999756</c:v>
                </c:pt>
                <c:pt idx="2731">
                  <c:v>64038.227806091309</c:v>
                </c:pt>
                <c:pt idx="2732">
                  <c:v>64033.933143615723</c:v>
                </c:pt>
                <c:pt idx="2733">
                  <c:v>64034.181339263916</c:v>
                </c:pt>
                <c:pt idx="2734">
                  <c:v>64041.57239151001</c:v>
                </c:pt>
                <c:pt idx="2735">
                  <c:v>64050.592014312744</c:v>
                </c:pt>
                <c:pt idx="2736">
                  <c:v>64050.325923919678</c:v>
                </c:pt>
                <c:pt idx="2737">
                  <c:v>64048.288402557373</c:v>
                </c:pt>
                <c:pt idx="2738">
                  <c:v>64048.936595916748</c:v>
                </c:pt>
                <c:pt idx="2739">
                  <c:v>64043.24193572998</c:v>
                </c:pt>
                <c:pt idx="2740">
                  <c:v>64028.632986068726</c:v>
                </c:pt>
                <c:pt idx="2741">
                  <c:v>64021.938323974609</c:v>
                </c:pt>
                <c:pt idx="2742">
                  <c:v>64035.729377746582</c:v>
                </c:pt>
                <c:pt idx="2743">
                  <c:v>64056.777572631836</c:v>
                </c:pt>
                <c:pt idx="2744">
                  <c:v>64063.79719543457</c:v>
                </c:pt>
                <c:pt idx="2745">
                  <c:v>64058.245388031006</c:v>
                </c:pt>
                <c:pt idx="2746">
                  <c:v>64054.95072555542</c:v>
                </c:pt>
                <c:pt idx="2747">
                  <c:v>64049.970352172852</c:v>
                </c:pt>
                <c:pt idx="2748">
                  <c:v>64037.361404418945</c:v>
                </c:pt>
                <c:pt idx="2749">
                  <c:v>64026.952453613281</c:v>
                </c:pt>
                <c:pt idx="2750">
                  <c:v>64027.943506240845</c:v>
                </c:pt>
                <c:pt idx="2751">
                  <c:v>64032.534557342529</c:v>
                </c:pt>
                <c:pt idx="2752">
                  <c:v>64035.811325073242</c:v>
                </c:pt>
                <c:pt idx="2753">
                  <c:v>64040.459518432617</c:v>
                </c:pt>
                <c:pt idx="2754">
                  <c:v>64047.22200012207</c:v>
                </c:pt>
                <c:pt idx="2755">
                  <c:v>64046.184478759766</c:v>
                </c:pt>
                <c:pt idx="2756">
                  <c:v>64036.289817810059</c:v>
                </c:pt>
                <c:pt idx="2757">
                  <c:v>64032.709442138672</c:v>
                </c:pt>
                <c:pt idx="2758">
                  <c:v>64041.357635498047</c:v>
                </c:pt>
                <c:pt idx="2759">
                  <c:v>64045.177261352539</c:v>
                </c:pt>
                <c:pt idx="2760">
                  <c:v>64036.711170196533</c:v>
                </c:pt>
                <c:pt idx="2761">
                  <c:v>64030.273649215698</c:v>
                </c:pt>
                <c:pt idx="2762">
                  <c:v>64030.607559204102</c:v>
                </c:pt>
                <c:pt idx="2763">
                  <c:v>64029.112895965576</c:v>
                </c:pt>
                <c:pt idx="2764">
                  <c:v>64026.50394821167</c:v>
                </c:pt>
                <c:pt idx="2765">
                  <c:v>64030.295000076294</c:v>
                </c:pt>
                <c:pt idx="2766">
                  <c:v>64043.314624786377</c:v>
                </c:pt>
                <c:pt idx="2767">
                  <c:v>64055.477104187012</c:v>
                </c:pt>
                <c:pt idx="2768">
                  <c:v>64059.868156433105</c:v>
                </c:pt>
                <c:pt idx="2769">
                  <c:v>64053.744922637939</c:v>
                </c:pt>
                <c:pt idx="2770">
                  <c:v>64043.421688079834</c:v>
                </c:pt>
                <c:pt idx="2771">
                  <c:v>64038.727024078369</c:v>
                </c:pt>
                <c:pt idx="2772">
                  <c:v>64045.575222015381</c:v>
                </c:pt>
                <c:pt idx="2773">
                  <c:v>64058.480560302734</c:v>
                </c:pt>
                <c:pt idx="2774">
                  <c:v>64064.871612548828</c:v>
                </c:pt>
                <c:pt idx="2775">
                  <c:v>64060.205520629883</c:v>
                </c:pt>
                <c:pt idx="2776">
                  <c:v>64051.853713989258</c:v>
                </c:pt>
                <c:pt idx="2777">
                  <c:v>64047.787624359131</c:v>
                </c:pt>
                <c:pt idx="2778">
                  <c:v>64049.807247161865</c:v>
                </c:pt>
                <c:pt idx="2779">
                  <c:v>64050.512584686279</c:v>
                </c:pt>
                <c:pt idx="2780">
                  <c:v>64042.789352416992</c:v>
                </c:pt>
                <c:pt idx="2781">
                  <c:v>64036.323261260986</c:v>
                </c:pt>
                <c:pt idx="2782">
                  <c:v>64037.54288482666</c:v>
                </c:pt>
                <c:pt idx="2783">
                  <c:v>64041.219650268555</c:v>
                </c:pt>
                <c:pt idx="2784">
                  <c:v>64037.439273834229</c:v>
                </c:pt>
                <c:pt idx="2785">
                  <c:v>64034.773181915283</c:v>
                </c:pt>
                <c:pt idx="2786">
                  <c:v>64035.021377563477</c:v>
                </c:pt>
                <c:pt idx="2787">
                  <c:v>64038.183856964111</c:v>
                </c:pt>
                <c:pt idx="2788">
                  <c:v>64048.374908447266</c:v>
                </c:pt>
                <c:pt idx="2789">
                  <c:v>64056.680248260498</c:v>
                </c:pt>
                <c:pt idx="2790">
                  <c:v>64049.842727661133</c:v>
                </c:pt>
                <c:pt idx="2791">
                  <c:v>64042.805206298828</c:v>
                </c:pt>
                <c:pt idx="2792">
                  <c:v>64048.110546112061</c:v>
                </c:pt>
                <c:pt idx="2793">
                  <c:v>64052.558738708496</c:v>
                </c:pt>
                <c:pt idx="2794">
                  <c:v>64040.26407623291</c:v>
                </c:pt>
                <c:pt idx="2795">
                  <c:v>64027.483701705933</c:v>
                </c:pt>
                <c:pt idx="2796">
                  <c:v>64027.417610168457</c:v>
                </c:pt>
                <c:pt idx="2797">
                  <c:v>64043.637233734131</c:v>
                </c:pt>
                <c:pt idx="2798">
                  <c:v>64062.599716186523</c:v>
                </c:pt>
                <c:pt idx="2799">
                  <c:v>64069.962196350098</c:v>
                </c:pt>
                <c:pt idx="2800">
                  <c:v>64057.353248596191</c:v>
                </c:pt>
                <c:pt idx="2801">
                  <c:v>64041.058586120605</c:v>
                </c:pt>
                <c:pt idx="2802">
                  <c:v>64035.306777954102</c:v>
                </c:pt>
                <c:pt idx="2803">
                  <c:v>64041.040687561035</c:v>
                </c:pt>
                <c:pt idx="2804">
                  <c:v>64041.71745300293</c:v>
                </c:pt>
                <c:pt idx="2805">
                  <c:v>64034.565650939941</c:v>
                </c:pt>
                <c:pt idx="2806">
                  <c:v>64026.699558258057</c:v>
                </c:pt>
                <c:pt idx="2807">
                  <c:v>64026.86203956604</c:v>
                </c:pt>
                <c:pt idx="2808">
                  <c:v>64032.338806152344</c:v>
                </c:pt>
                <c:pt idx="2809">
                  <c:v>64038.072715759277</c:v>
                </c:pt>
                <c:pt idx="2810">
                  <c:v>64040.063766479492</c:v>
                </c:pt>
                <c:pt idx="2811">
                  <c:v>64042.969104766846</c:v>
                </c:pt>
                <c:pt idx="2812">
                  <c:v>64044.98872756958</c:v>
                </c:pt>
                <c:pt idx="2813">
                  <c:v>64046.608348846436</c:v>
                </c:pt>
                <c:pt idx="2814">
                  <c:v>64047.285118103027</c:v>
                </c:pt>
                <c:pt idx="2815">
                  <c:v>64054.590454101563</c:v>
                </c:pt>
                <c:pt idx="2816">
                  <c:v>64062.752933502197</c:v>
                </c:pt>
                <c:pt idx="2817">
                  <c:v>64066.515419006348</c:v>
                </c:pt>
                <c:pt idx="2818">
                  <c:v>64064.792182922363</c:v>
                </c:pt>
                <c:pt idx="2819">
                  <c:v>64066.64037322998</c:v>
                </c:pt>
                <c:pt idx="2820">
                  <c:v>64075.202857971191</c:v>
                </c:pt>
                <c:pt idx="2821">
                  <c:v>64076.222480773926</c:v>
                </c:pt>
                <c:pt idx="2822">
                  <c:v>64065.042106628418</c:v>
                </c:pt>
                <c:pt idx="2823">
                  <c:v>64056.061725616455</c:v>
                </c:pt>
                <c:pt idx="2824">
                  <c:v>64063.224208831787</c:v>
                </c:pt>
                <c:pt idx="2825">
                  <c:v>64080.100975036621</c:v>
                </c:pt>
                <c:pt idx="2826">
                  <c:v>64086.292022705078</c:v>
                </c:pt>
                <c:pt idx="2827">
                  <c:v>64071.425933837891</c:v>
                </c:pt>
                <c:pt idx="2828">
                  <c:v>64050.502700805664</c:v>
                </c:pt>
                <c:pt idx="2829">
                  <c:v>64044.950897216797</c:v>
                </c:pt>
                <c:pt idx="2830">
                  <c:v>64052.570518493652</c:v>
                </c:pt>
                <c:pt idx="2831">
                  <c:v>64060.047286987305</c:v>
                </c:pt>
                <c:pt idx="2832">
                  <c:v>64065.866912841797</c:v>
                </c:pt>
                <c:pt idx="2833">
                  <c:v>64066.029388427734</c:v>
                </c:pt>
                <c:pt idx="2834">
                  <c:v>64058.849014282227</c:v>
                </c:pt>
                <c:pt idx="2835">
                  <c:v>64057.868637084961</c:v>
                </c:pt>
                <c:pt idx="2836">
                  <c:v>64064.745399475098</c:v>
                </c:pt>
                <c:pt idx="2837">
                  <c:v>64060.965026855469</c:v>
                </c:pt>
                <c:pt idx="2838">
                  <c:v>64046.670364379883</c:v>
                </c:pt>
                <c:pt idx="2839">
                  <c:v>64047.575702667236</c:v>
                </c:pt>
                <c:pt idx="2840">
                  <c:v>64058.10961151123</c:v>
                </c:pt>
                <c:pt idx="2841">
                  <c:v>64063.557804107666</c:v>
                </c:pt>
                <c:pt idx="2842">
                  <c:v>64063.720287322998</c:v>
                </c:pt>
                <c:pt idx="2843">
                  <c:v>64064.539909362793</c:v>
                </c:pt>
                <c:pt idx="2844">
                  <c:v>64060.073818206787</c:v>
                </c:pt>
                <c:pt idx="2845">
                  <c:v>64052.32201385498</c:v>
                </c:pt>
                <c:pt idx="2846">
                  <c:v>64050.055923461914</c:v>
                </c:pt>
                <c:pt idx="2847">
                  <c:v>64050.81840133667</c:v>
                </c:pt>
                <c:pt idx="2848">
                  <c:v>64050.466598510742</c:v>
                </c:pt>
                <c:pt idx="2849">
                  <c:v>64046.343364715576</c:v>
                </c:pt>
                <c:pt idx="2850">
                  <c:v>64044.762985229492</c:v>
                </c:pt>
                <c:pt idx="2851">
                  <c:v>64046.268325805664</c:v>
                </c:pt>
                <c:pt idx="2852">
                  <c:v>64049.173664093018</c:v>
                </c:pt>
                <c:pt idx="2853">
                  <c:v>64051.793285369873</c:v>
                </c:pt>
                <c:pt idx="2854">
                  <c:v>64051.670051574707</c:v>
                </c:pt>
                <c:pt idx="2855">
                  <c:v>64046.28967666626</c:v>
                </c:pt>
                <c:pt idx="2856">
                  <c:v>64044.423583984375</c:v>
                </c:pt>
                <c:pt idx="2857">
                  <c:v>64048.728923797607</c:v>
                </c:pt>
                <c:pt idx="2858">
                  <c:v>64053.434261322021</c:v>
                </c:pt>
                <c:pt idx="2859">
                  <c:v>64051.653884887695</c:v>
                </c:pt>
                <c:pt idx="2860">
                  <c:v>64048.444934844971</c:v>
                </c:pt>
                <c:pt idx="2861">
                  <c:v>64047.835987091064</c:v>
                </c:pt>
                <c:pt idx="2862">
                  <c:v>64049.884181976318</c:v>
                </c:pt>
                <c:pt idx="2863">
                  <c:v>64053.018089294434</c:v>
                </c:pt>
                <c:pt idx="2864">
                  <c:v>64053.352001190186</c:v>
                </c:pt>
                <c:pt idx="2865">
                  <c:v>64048.628765106201</c:v>
                </c:pt>
                <c:pt idx="2866">
                  <c:v>64040.734104156494</c:v>
                </c:pt>
                <c:pt idx="2867">
                  <c:v>64036.782299041748</c:v>
                </c:pt>
                <c:pt idx="2868">
                  <c:v>64041.316207885742</c:v>
                </c:pt>
                <c:pt idx="2869">
                  <c:v>64052.107257843018</c:v>
                </c:pt>
                <c:pt idx="2870">
                  <c:v>64061.06974029541</c:v>
                </c:pt>
                <c:pt idx="2871">
                  <c:v>64058.460792541504</c:v>
                </c:pt>
                <c:pt idx="2872">
                  <c:v>64054.451843261719</c:v>
                </c:pt>
                <c:pt idx="2873">
                  <c:v>64056.528610229492</c:v>
                </c:pt>
                <c:pt idx="2874">
                  <c:v>64065.205375671387</c:v>
                </c:pt>
                <c:pt idx="2875">
                  <c:v>64064.139282226563</c:v>
                </c:pt>
                <c:pt idx="2876">
                  <c:v>64054.244625091553</c:v>
                </c:pt>
                <c:pt idx="2877">
                  <c:v>64049.664245605469</c:v>
                </c:pt>
                <c:pt idx="2878">
                  <c:v>64060.426727294922</c:v>
                </c:pt>
                <c:pt idx="2879">
                  <c:v>64074.446350097656</c:v>
                </c:pt>
                <c:pt idx="2880">
                  <c:v>64072.465972900391</c:v>
                </c:pt>
                <c:pt idx="2881">
                  <c:v>64059.999881744385</c:v>
                </c:pt>
                <c:pt idx="2882">
                  <c:v>64050.962364196777</c:v>
                </c:pt>
                <c:pt idx="2883">
                  <c:v>64055.439128875732</c:v>
                </c:pt>
                <c:pt idx="2884">
                  <c:v>64068.773040771484</c:v>
                </c:pt>
                <c:pt idx="2885">
                  <c:v>64080.878379821777</c:v>
                </c:pt>
                <c:pt idx="2886">
                  <c:v>64085.583717346191</c:v>
                </c:pt>
                <c:pt idx="2887">
                  <c:v>64085.203338623047</c:v>
                </c:pt>
                <c:pt idx="2888">
                  <c:v>64079.251533508301</c:v>
                </c:pt>
                <c:pt idx="2889">
                  <c:v>64065.728302001953</c:v>
                </c:pt>
                <c:pt idx="2890">
                  <c:v>64050.91934967041</c:v>
                </c:pt>
                <c:pt idx="2891">
                  <c:v>64050.538974761963</c:v>
                </c:pt>
                <c:pt idx="2892">
                  <c:v>64058.815738677979</c:v>
                </c:pt>
                <c:pt idx="2893">
                  <c:v>64055.692504882813</c:v>
                </c:pt>
                <c:pt idx="2894">
                  <c:v>64040.797843933105</c:v>
                </c:pt>
                <c:pt idx="2895">
                  <c:v>64028.07460975647</c:v>
                </c:pt>
                <c:pt idx="2896">
                  <c:v>64027.122804641724</c:v>
                </c:pt>
                <c:pt idx="2897">
                  <c:v>64032.770999908447</c:v>
                </c:pt>
                <c:pt idx="2898">
                  <c:v>64039.70491027832</c:v>
                </c:pt>
                <c:pt idx="2899">
                  <c:v>64043.267391204834</c:v>
                </c:pt>
                <c:pt idx="2900">
                  <c:v>64045.429870605469</c:v>
                </c:pt>
                <c:pt idx="2901">
                  <c:v>64046.449493408203</c:v>
                </c:pt>
                <c:pt idx="2902">
                  <c:v>64040.697689056396</c:v>
                </c:pt>
                <c:pt idx="2903">
                  <c:v>64032.003025054932</c:v>
                </c:pt>
                <c:pt idx="2904">
                  <c:v>64031.394077301025</c:v>
                </c:pt>
                <c:pt idx="2905">
                  <c:v>64046.527988433838</c:v>
                </c:pt>
                <c:pt idx="2906">
                  <c:v>64061.833324432373</c:v>
                </c:pt>
                <c:pt idx="2907">
                  <c:v>64063.024375915527</c:v>
                </c:pt>
                <c:pt idx="2908">
                  <c:v>64051.64400100708</c:v>
                </c:pt>
                <c:pt idx="2909">
                  <c:v>64043.520767211914</c:v>
                </c:pt>
                <c:pt idx="2910">
                  <c:v>64042.026103973389</c:v>
                </c:pt>
                <c:pt idx="2911">
                  <c:v>64037.074298858643</c:v>
                </c:pt>
                <c:pt idx="2912">
                  <c:v>64032.265350341797</c:v>
                </c:pt>
                <c:pt idx="2913">
                  <c:v>64030.94211769104</c:v>
                </c:pt>
                <c:pt idx="2914">
                  <c:v>64035.561740875244</c:v>
                </c:pt>
                <c:pt idx="2915">
                  <c:v>64040.581363677979</c:v>
                </c:pt>
                <c:pt idx="2916">
                  <c:v>64048.058128356934</c:v>
                </c:pt>
                <c:pt idx="2917">
                  <c:v>64050.734897613525</c:v>
                </c:pt>
                <c:pt idx="2918">
                  <c:v>64045.983089447021</c:v>
                </c:pt>
                <c:pt idx="2919">
                  <c:v>64039.374141693115</c:v>
                </c:pt>
                <c:pt idx="2920">
                  <c:v>64037.936622619629</c:v>
                </c:pt>
                <c:pt idx="2921">
                  <c:v>64042.213390350342</c:v>
                </c:pt>
                <c:pt idx="2922">
                  <c:v>64048.147296905518</c:v>
                </c:pt>
                <c:pt idx="2923">
                  <c:v>64051.338352203369</c:v>
                </c:pt>
                <c:pt idx="2924">
                  <c:v>64050.272258758545</c:v>
                </c:pt>
                <c:pt idx="2925">
                  <c:v>64042.920455932617</c:v>
                </c:pt>
                <c:pt idx="2926">
                  <c:v>64034.225791931152</c:v>
                </c:pt>
                <c:pt idx="2927">
                  <c:v>64028.959701538086</c:v>
                </c:pt>
                <c:pt idx="2928">
                  <c:v>64029.950754165649</c:v>
                </c:pt>
                <c:pt idx="2929">
                  <c:v>64036.456089019775</c:v>
                </c:pt>
                <c:pt idx="2930">
                  <c:v>64044.904285430908</c:v>
                </c:pt>
                <c:pt idx="2931">
                  <c:v>64045.581050872803</c:v>
                </c:pt>
                <c:pt idx="2932">
                  <c:v>64034.286388397217</c:v>
                </c:pt>
                <c:pt idx="2933">
                  <c:v>64025.991727828979</c:v>
                </c:pt>
                <c:pt idx="2934">
                  <c:v>64030.697065353394</c:v>
                </c:pt>
                <c:pt idx="2935">
                  <c:v>64041.802402496338</c:v>
                </c:pt>
                <c:pt idx="2936">
                  <c:v>64048.593456268311</c:v>
                </c:pt>
                <c:pt idx="2937">
                  <c:v>64045.870220184326</c:v>
                </c:pt>
                <c:pt idx="2938">
                  <c:v>64041.289844512939</c:v>
                </c:pt>
                <c:pt idx="2939">
                  <c:v>64042.252323150635</c:v>
                </c:pt>
                <c:pt idx="2940">
                  <c:v>64048.357662200928</c:v>
                </c:pt>
                <c:pt idx="2941">
                  <c:v>64051.891571044922</c:v>
                </c:pt>
                <c:pt idx="2942">
                  <c:v>64050.196910858154</c:v>
                </c:pt>
                <c:pt idx="2943">
                  <c:v>64048.902248382568</c:v>
                </c:pt>
                <c:pt idx="2944">
                  <c:v>64051.379013061523</c:v>
                </c:pt>
                <c:pt idx="2945">
                  <c:v>64054.827209472656</c:v>
                </c:pt>
                <c:pt idx="2946">
                  <c:v>64054.70397567749</c:v>
                </c:pt>
                <c:pt idx="2947">
                  <c:v>64049.495025634766</c:v>
                </c:pt>
                <c:pt idx="2948">
                  <c:v>64042.5146484375</c:v>
                </c:pt>
                <c:pt idx="2949">
                  <c:v>64037.019985198975</c:v>
                </c:pt>
                <c:pt idx="2950">
                  <c:v>64035.153896331787</c:v>
                </c:pt>
                <c:pt idx="2951">
                  <c:v>64033.630661010742</c:v>
                </c:pt>
                <c:pt idx="2952">
                  <c:v>64033.364570617676</c:v>
                </c:pt>
                <c:pt idx="2953">
                  <c:v>64033.184196472168</c:v>
                </c:pt>
                <c:pt idx="2954">
                  <c:v>64030.032388687134</c:v>
                </c:pt>
                <c:pt idx="2955">
                  <c:v>64024.394870758057</c:v>
                </c:pt>
                <c:pt idx="2956">
                  <c:v>64027.671636581421</c:v>
                </c:pt>
                <c:pt idx="2957">
                  <c:v>64042.376972198486</c:v>
                </c:pt>
                <c:pt idx="2958">
                  <c:v>64052.25373840332</c:v>
                </c:pt>
                <c:pt idx="2959">
                  <c:v>64048.901935577393</c:v>
                </c:pt>
                <c:pt idx="2960">
                  <c:v>64037.578701019287</c:v>
                </c:pt>
                <c:pt idx="2961">
                  <c:v>64033.741180419922</c:v>
                </c:pt>
                <c:pt idx="2962">
                  <c:v>64032.332233428955</c:v>
                </c:pt>
                <c:pt idx="2963">
                  <c:v>64031.694713592529</c:v>
                </c:pt>
                <c:pt idx="2964">
                  <c:v>64032.171482086182</c:v>
                </c:pt>
                <c:pt idx="2965">
                  <c:v>64038.476818084717</c:v>
                </c:pt>
                <c:pt idx="2966">
                  <c:v>64041.58215713501</c:v>
                </c:pt>
                <c:pt idx="2967">
                  <c:v>64042.544635772705</c:v>
                </c:pt>
                <c:pt idx="2968">
                  <c:v>64041.649974822998</c:v>
                </c:pt>
                <c:pt idx="2969">
                  <c:v>64040.383884429932</c:v>
                </c:pt>
                <c:pt idx="2970">
                  <c:v>64038.317790985107</c:v>
                </c:pt>
                <c:pt idx="2971">
                  <c:v>64036.651702880859</c:v>
                </c:pt>
                <c:pt idx="2972">
                  <c:v>64029.157039642334</c:v>
                </c:pt>
                <c:pt idx="2973">
                  <c:v>64017.462377548218</c:v>
                </c:pt>
                <c:pt idx="2974">
                  <c:v>64010.081999778748</c:v>
                </c:pt>
                <c:pt idx="2975">
                  <c:v>64011.330194473267</c:v>
                </c:pt>
                <c:pt idx="2976">
                  <c:v>64022.89267539978</c:v>
                </c:pt>
                <c:pt idx="2977">
                  <c:v>64035.226585388184</c:v>
                </c:pt>
                <c:pt idx="2978">
                  <c:v>64037.303352355957</c:v>
                </c:pt>
                <c:pt idx="2979">
                  <c:v>64028.665830612183</c:v>
                </c:pt>
                <c:pt idx="2980">
                  <c:v>64021.971168518066</c:v>
                </c:pt>
                <c:pt idx="2981">
                  <c:v>64019.419363021851</c:v>
                </c:pt>
                <c:pt idx="2982">
                  <c:v>64026.038986206055</c:v>
                </c:pt>
                <c:pt idx="2983">
                  <c:v>64041.087181091309</c:v>
                </c:pt>
                <c:pt idx="2984">
                  <c:v>64053.135375976563</c:v>
                </c:pt>
                <c:pt idx="2985">
                  <c:v>64048.669284820557</c:v>
                </c:pt>
                <c:pt idx="2986">
                  <c:v>64032.660339355469</c:v>
                </c:pt>
                <c:pt idx="2987">
                  <c:v>64024.937103271484</c:v>
                </c:pt>
                <c:pt idx="2988">
                  <c:v>64031.956727981567</c:v>
                </c:pt>
                <c:pt idx="2989">
                  <c:v>64045.804920196533</c:v>
                </c:pt>
                <c:pt idx="2990">
                  <c:v>64054.081687927246</c:v>
                </c:pt>
                <c:pt idx="2991">
                  <c:v>64052.844169616699</c:v>
                </c:pt>
                <c:pt idx="2992">
                  <c:v>64042.720935821533</c:v>
                </c:pt>
                <c:pt idx="2993">
                  <c:v>64033.111988067627</c:v>
                </c:pt>
                <c:pt idx="2994">
                  <c:v>64029.760181427002</c:v>
                </c:pt>
                <c:pt idx="2995">
                  <c:v>64024.208375930786</c:v>
                </c:pt>
                <c:pt idx="2996">
                  <c:v>64018.799428939819</c:v>
                </c:pt>
                <c:pt idx="2997">
                  <c:v>64019.876194000244</c:v>
                </c:pt>
                <c:pt idx="2998">
                  <c:v>64019.952960968018</c:v>
                </c:pt>
                <c:pt idx="2999">
                  <c:v>64020.029727935791</c:v>
                </c:pt>
              </c:numCache>
            </c:numRef>
          </c:yVal>
          <c:smooth val="0"/>
          <c:extLst>
            <c:ext xmlns:c16="http://schemas.microsoft.com/office/drawing/2014/chart" uri="{C3380CC4-5D6E-409C-BE32-E72D297353CC}">
              <c16:uniqueId val="{00000003-951A-40BF-BA6C-3B319E7ECED3}"/>
            </c:ext>
          </c:extLst>
        </c:ser>
        <c:ser>
          <c:idx val="4"/>
          <c:order val="4"/>
          <c:tx>
            <c:v>LW RB + GlcNAc + Fut8</c:v>
          </c:tx>
          <c:spPr>
            <a:ln w="19050">
              <a:solidFill>
                <a:srgbClr val="6719B3"/>
              </a:solidFill>
              <a:prstDash val="solid"/>
              <a:round/>
            </a:ln>
            <a:effectLst/>
          </c:spPr>
          <c:marker>
            <c:symbol val="none"/>
          </c:marker>
          <c:xVal>
            <c:numRef>
              <c:f>'[RB revised.xlsx]Graph Calculations'!$I$25:$DKR$25</c:f>
              <c:numCache>
                <c:formatCode>General</c:formatCode>
                <c:ptCount val="3000"/>
                <c:pt idx="0">
                  <c:v>-4.4836134910583496</c:v>
                </c:pt>
                <c:pt idx="1">
                  <c:v>-4.4820003509521484</c:v>
                </c:pt>
                <c:pt idx="2">
                  <c:v>-4.4800639152526855</c:v>
                </c:pt>
                <c:pt idx="3">
                  <c:v>-4.4778599739074707</c:v>
                </c:pt>
                <c:pt idx="4">
                  <c:v>-4.4754323959350586</c:v>
                </c:pt>
                <c:pt idx="5">
                  <c:v>-4.472806453704834</c:v>
                </c:pt>
                <c:pt idx="6">
                  <c:v>-4.4700088500976563</c:v>
                </c:pt>
                <c:pt idx="7">
                  <c:v>-4.4670534133911133</c:v>
                </c:pt>
                <c:pt idx="8">
                  <c:v>-4.4639625549316406</c:v>
                </c:pt>
                <c:pt idx="9">
                  <c:v>-4.4607415199279785</c:v>
                </c:pt>
                <c:pt idx="10">
                  <c:v>-4.457404613494873</c:v>
                </c:pt>
                <c:pt idx="11">
                  <c:v>-4.4539666175842285</c:v>
                </c:pt>
                <c:pt idx="12">
                  <c:v>-4.4504289627075195</c:v>
                </c:pt>
                <c:pt idx="13">
                  <c:v>-4.446807861328125</c:v>
                </c:pt>
                <c:pt idx="14">
                  <c:v>-4.4431028366088867</c:v>
                </c:pt>
                <c:pt idx="15">
                  <c:v>-4.4393267631530762</c:v>
                </c:pt>
                <c:pt idx="16">
                  <c:v>-4.4354844093322754</c:v>
                </c:pt>
                <c:pt idx="17">
                  <c:v>-4.431577205657959</c:v>
                </c:pt>
                <c:pt idx="18">
                  <c:v>-4.4276151657104492</c:v>
                </c:pt>
                <c:pt idx="19">
                  <c:v>-4.4235944747924805</c:v>
                </c:pt>
                <c:pt idx="20">
                  <c:v>-4.4195222854614258</c:v>
                </c:pt>
                <c:pt idx="21">
                  <c:v>-4.4154090881347656</c:v>
                </c:pt>
                <c:pt idx="22">
                  <c:v>-4.4112458229064941</c:v>
                </c:pt>
                <c:pt idx="23">
                  <c:v>-4.4070463180541992</c:v>
                </c:pt>
                <c:pt idx="24">
                  <c:v>-4.402808666229248</c:v>
                </c:pt>
                <c:pt idx="25">
                  <c:v>-4.398531436920166</c:v>
                </c:pt>
                <c:pt idx="26">
                  <c:v>-4.3942184448242188</c:v>
                </c:pt>
                <c:pt idx="27">
                  <c:v>-4.3898754119873047</c:v>
                </c:pt>
                <c:pt idx="28">
                  <c:v>-4.3855018615722656</c:v>
                </c:pt>
                <c:pt idx="29">
                  <c:v>-4.3810944557189941</c:v>
                </c:pt>
                <c:pt idx="30">
                  <c:v>-4.3766651153564453</c:v>
                </c:pt>
                <c:pt idx="31">
                  <c:v>-4.3722019195556641</c:v>
                </c:pt>
                <c:pt idx="32">
                  <c:v>-4.3677191734313965</c:v>
                </c:pt>
                <c:pt idx="33">
                  <c:v>-4.3632144927978516</c:v>
                </c:pt>
                <c:pt idx="34">
                  <c:v>-4.3586788177490234</c:v>
                </c:pt>
                <c:pt idx="35">
                  <c:v>-4.3541245460510254</c:v>
                </c:pt>
                <c:pt idx="36">
                  <c:v>-4.3495497703552246</c:v>
                </c:pt>
                <c:pt idx="37">
                  <c:v>-4.3449516296386719</c:v>
                </c:pt>
                <c:pt idx="38">
                  <c:v>-4.340329647064209</c:v>
                </c:pt>
                <c:pt idx="39">
                  <c:v>-4.3356847763061523</c:v>
                </c:pt>
                <c:pt idx="40">
                  <c:v>-4.3310275077819824</c:v>
                </c:pt>
                <c:pt idx="41">
                  <c:v>-4.3263511657714844</c:v>
                </c:pt>
                <c:pt idx="42">
                  <c:v>-4.321652889251709</c:v>
                </c:pt>
                <c:pt idx="43">
                  <c:v>-4.3169398307800293</c:v>
                </c:pt>
                <c:pt idx="44">
                  <c:v>-4.3122086524963379</c:v>
                </c:pt>
                <c:pt idx="45">
                  <c:v>-4.3074617385864258</c:v>
                </c:pt>
                <c:pt idx="46">
                  <c:v>-4.302696704864502</c:v>
                </c:pt>
                <c:pt idx="47">
                  <c:v>-4.2979135513305664</c:v>
                </c:pt>
                <c:pt idx="48">
                  <c:v>-4.2931122779846191</c:v>
                </c:pt>
                <c:pt idx="49">
                  <c:v>-4.288292407989502</c:v>
                </c:pt>
                <c:pt idx="50">
                  <c:v>-4.2834572792053223</c:v>
                </c:pt>
                <c:pt idx="51">
                  <c:v>-4.2786116600036621</c:v>
                </c:pt>
                <c:pt idx="52">
                  <c:v>-4.2737503051757813</c:v>
                </c:pt>
                <c:pt idx="53">
                  <c:v>-4.2688698768615723</c:v>
                </c:pt>
                <c:pt idx="54">
                  <c:v>-4.263972282409668</c:v>
                </c:pt>
                <c:pt idx="55">
                  <c:v>-4.2590651512145996</c:v>
                </c:pt>
                <c:pt idx="56">
                  <c:v>-4.254143238067627</c:v>
                </c:pt>
                <c:pt idx="57">
                  <c:v>-4.2492027282714844</c:v>
                </c:pt>
                <c:pt idx="58">
                  <c:v>-4.2442502975463867</c:v>
                </c:pt>
                <c:pt idx="59">
                  <c:v>-4.2392878532409668</c:v>
                </c:pt>
                <c:pt idx="60">
                  <c:v>-4.234309196472168</c:v>
                </c:pt>
                <c:pt idx="61">
                  <c:v>-4.2293224334716797</c:v>
                </c:pt>
                <c:pt idx="62">
                  <c:v>-4.2243185043334961</c:v>
                </c:pt>
                <c:pt idx="63">
                  <c:v>-4.2192997932434082</c:v>
                </c:pt>
                <c:pt idx="64">
                  <c:v>-4.2142724990844727</c:v>
                </c:pt>
                <c:pt idx="65">
                  <c:v>-4.2092270851135254</c:v>
                </c:pt>
                <c:pt idx="66">
                  <c:v>-4.2041735649108887</c:v>
                </c:pt>
                <c:pt idx="67">
                  <c:v>-4.1991057395935059</c:v>
                </c:pt>
                <c:pt idx="68">
                  <c:v>-4.1940221786499023</c:v>
                </c:pt>
                <c:pt idx="69">
                  <c:v>-4.1889305114746094</c:v>
                </c:pt>
                <c:pt idx="70">
                  <c:v>-4.1838216781616211</c:v>
                </c:pt>
                <c:pt idx="71">
                  <c:v>-4.1787071228027344</c:v>
                </c:pt>
                <c:pt idx="72">
                  <c:v>-4.1735754013061523</c:v>
                </c:pt>
                <c:pt idx="73">
                  <c:v>-4.1684408187866211</c:v>
                </c:pt>
                <c:pt idx="74">
                  <c:v>-4.1632885932922363</c:v>
                </c:pt>
                <c:pt idx="75">
                  <c:v>-4.1581301689147949</c:v>
                </c:pt>
                <c:pt idx="76">
                  <c:v>-4.1529550552368164</c:v>
                </c:pt>
                <c:pt idx="77">
                  <c:v>-4.1477737426757813</c:v>
                </c:pt>
                <c:pt idx="78">
                  <c:v>-4.142575740814209</c:v>
                </c:pt>
                <c:pt idx="79">
                  <c:v>-4.1373724937438965</c:v>
                </c:pt>
                <c:pt idx="80">
                  <c:v>-4.1321525573730469</c:v>
                </c:pt>
                <c:pt idx="81">
                  <c:v>-4.126927375793457</c:v>
                </c:pt>
                <c:pt idx="82">
                  <c:v>-4.1216850280761719</c:v>
                </c:pt>
                <c:pt idx="83">
                  <c:v>-4.1164374351501465</c:v>
                </c:pt>
                <c:pt idx="84">
                  <c:v>-4.111175537109375</c:v>
                </c:pt>
                <c:pt idx="85">
                  <c:v>-4.1059060096740723</c:v>
                </c:pt>
                <c:pt idx="86">
                  <c:v>-4.1006269454956055</c:v>
                </c:pt>
                <c:pt idx="87">
                  <c:v>-4.0953354835510254</c:v>
                </c:pt>
                <c:pt idx="88">
                  <c:v>-4.0900378227233887</c:v>
                </c:pt>
                <c:pt idx="89">
                  <c:v>-4.0847234725952148</c:v>
                </c:pt>
                <c:pt idx="90">
                  <c:v>-4.07940673828125</c:v>
                </c:pt>
                <c:pt idx="91">
                  <c:v>-4.0740828514099121</c:v>
                </c:pt>
                <c:pt idx="92">
                  <c:v>-4.0687432289123535</c:v>
                </c:pt>
                <c:pt idx="93">
                  <c:v>-4.0633988380432129</c:v>
                </c:pt>
                <c:pt idx="94">
                  <c:v>-4.0580415725708008</c:v>
                </c:pt>
                <c:pt idx="95">
                  <c:v>-4.0526762008666992</c:v>
                </c:pt>
                <c:pt idx="96">
                  <c:v>-4.0473031997680664</c:v>
                </c:pt>
                <c:pt idx="97">
                  <c:v>-4.0419154167175293</c:v>
                </c:pt>
                <c:pt idx="98">
                  <c:v>-4.0365238189697266</c:v>
                </c:pt>
                <c:pt idx="99">
                  <c:v>-4.0311203002929688</c:v>
                </c:pt>
                <c:pt idx="100">
                  <c:v>-4.0257062911987305</c:v>
                </c:pt>
                <c:pt idx="101">
                  <c:v>-4.0202875137329102</c:v>
                </c:pt>
                <c:pt idx="102">
                  <c:v>-4.014854907989502</c:v>
                </c:pt>
                <c:pt idx="103">
                  <c:v>-4.0094146728515625</c:v>
                </c:pt>
                <c:pt idx="104">
                  <c:v>-4.0039701461791992</c:v>
                </c:pt>
                <c:pt idx="105">
                  <c:v>-3.9985091686248779</c:v>
                </c:pt>
                <c:pt idx="106">
                  <c:v>-3.9930434226989746</c:v>
                </c:pt>
                <c:pt idx="107">
                  <c:v>-3.9875712394714355</c:v>
                </c:pt>
                <c:pt idx="108">
                  <c:v>-3.9820852279663086</c:v>
                </c:pt>
                <c:pt idx="109">
                  <c:v>-3.9765932559967041</c:v>
                </c:pt>
                <c:pt idx="110">
                  <c:v>-3.971095085144043</c:v>
                </c:pt>
                <c:pt idx="111">
                  <c:v>-3.9655840396881104</c:v>
                </c:pt>
                <c:pt idx="112">
                  <c:v>-3.9600660800933838</c:v>
                </c:pt>
                <c:pt idx="113">
                  <c:v>-3.9545438289642334</c:v>
                </c:pt>
                <c:pt idx="114">
                  <c:v>-3.9490110874176025</c:v>
                </c:pt>
                <c:pt idx="115">
                  <c:v>-3.9434671401977539</c:v>
                </c:pt>
                <c:pt idx="116">
                  <c:v>-3.9379198551177979</c:v>
                </c:pt>
                <c:pt idx="117">
                  <c:v>-3.9323649406433105</c:v>
                </c:pt>
                <c:pt idx="118">
                  <c:v>-3.9267959594726563</c:v>
                </c:pt>
                <c:pt idx="119">
                  <c:v>-3.921222448348999</c:v>
                </c:pt>
                <c:pt idx="120">
                  <c:v>-3.9156427383422852</c:v>
                </c:pt>
                <c:pt idx="121">
                  <c:v>-3.9100537300109863</c:v>
                </c:pt>
                <c:pt idx="122">
                  <c:v>-3.9044539928436279</c:v>
                </c:pt>
                <c:pt idx="123">
                  <c:v>-3.8988509178161621</c:v>
                </c:pt>
                <c:pt idx="124">
                  <c:v>-3.8932406902313232</c:v>
                </c:pt>
                <c:pt idx="125">
                  <c:v>-3.8876168727874756</c:v>
                </c:pt>
                <c:pt idx="126">
                  <c:v>-3.8819873332977295</c:v>
                </c:pt>
                <c:pt idx="127">
                  <c:v>-3.8763537406921387</c:v>
                </c:pt>
                <c:pt idx="128">
                  <c:v>-3.8707127571105957</c:v>
                </c:pt>
                <c:pt idx="129">
                  <c:v>-3.8650581836700439</c:v>
                </c:pt>
                <c:pt idx="130">
                  <c:v>-3.8593990802764893</c:v>
                </c:pt>
                <c:pt idx="131">
                  <c:v>-3.8537359237670898</c:v>
                </c:pt>
                <c:pt idx="132">
                  <c:v>-3.8480641841888428</c:v>
                </c:pt>
                <c:pt idx="133">
                  <c:v>-3.8423793315887451</c:v>
                </c:pt>
                <c:pt idx="134">
                  <c:v>-3.8366904258728027</c:v>
                </c:pt>
                <c:pt idx="135">
                  <c:v>-3.8309972286224365</c:v>
                </c:pt>
                <c:pt idx="136">
                  <c:v>-3.8252959251403809</c:v>
                </c:pt>
                <c:pt idx="137">
                  <c:v>-3.8195829391479492</c:v>
                </c:pt>
                <c:pt idx="138">
                  <c:v>-3.8138644695281982</c:v>
                </c:pt>
                <c:pt idx="139">
                  <c:v>-3.8081414699554443</c:v>
                </c:pt>
                <c:pt idx="140">
                  <c:v>-3.802412748336792</c:v>
                </c:pt>
                <c:pt idx="141">
                  <c:v>-3.7966721057891846</c:v>
                </c:pt>
                <c:pt idx="142">
                  <c:v>-3.7909235954284668</c:v>
                </c:pt>
                <c:pt idx="143">
                  <c:v>-3.7851717472076416</c:v>
                </c:pt>
                <c:pt idx="144">
                  <c:v>-3.7794167995452881</c:v>
                </c:pt>
                <c:pt idx="145">
                  <c:v>-3.7736566066741943</c:v>
                </c:pt>
                <c:pt idx="146">
                  <c:v>-3.7678894996643066</c:v>
                </c:pt>
                <c:pt idx="147">
                  <c:v>-3.7621099948883057</c:v>
                </c:pt>
                <c:pt idx="148">
                  <c:v>-3.7563250064849854</c:v>
                </c:pt>
                <c:pt idx="149">
                  <c:v>-3.7505359649658203</c:v>
                </c:pt>
                <c:pt idx="150">
                  <c:v>-3.7447419166564941</c:v>
                </c:pt>
                <c:pt idx="151">
                  <c:v>-3.7389383316040039</c:v>
                </c:pt>
                <c:pt idx="152">
                  <c:v>-3.7331249713897705</c:v>
                </c:pt>
                <c:pt idx="153">
                  <c:v>-3.727306604385376</c:v>
                </c:pt>
                <c:pt idx="154">
                  <c:v>-3.7214846611022949</c:v>
                </c:pt>
                <c:pt idx="155">
                  <c:v>-3.7156572341918945</c:v>
                </c:pt>
                <c:pt idx="156">
                  <c:v>-3.709820032119751</c:v>
                </c:pt>
                <c:pt idx="157">
                  <c:v>-3.703972339630127</c:v>
                </c:pt>
                <c:pt idx="158">
                  <c:v>-3.6981205940246582</c:v>
                </c:pt>
                <c:pt idx="159">
                  <c:v>-3.6922652721405029</c:v>
                </c:pt>
                <c:pt idx="160">
                  <c:v>-3.6864044666290283</c:v>
                </c:pt>
                <c:pt idx="161">
                  <c:v>-3.6805367469787598</c:v>
                </c:pt>
                <c:pt idx="162">
                  <c:v>-3.6746571063995361</c:v>
                </c:pt>
                <c:pt idx="163">
                  <c:v>-3.6687717437744141</c:v>
                </c:pt>
                <c:pt idx="164">
                  <c:v>-3.6628832817077637</c:v>
                </c:pt>
                <c:pt idx="165">
                  <c:v>-3.6569905281066895</c:v>
                </c:pt>
                <c:pt idx="166">
                  <c:v>-3.6510920524597168</c:v>
                </c:pt>
                <c:pt idx="167">
                  <c:v>-3.6451854705810547</c:v>
                </c:pt>
                <c:pt idx="168">
                  <c:v>-3.6392683982849121</c:v>
                </c:pt>
                <c:pt idx="169">
                  <c:v>-3.6333460807800293</c:v>
                </c:pt>
                <c:pt idx="170">
                  <c:v>-3.6274204254150391</c:v>
                </c:pt>
                <c:pt idx="171">
                  <c:v>-3.621490478515625</c:v>
                </c:pt>
                <c:pt idx="172">
                  <c:v>-3.6155555248260498</c:v>
                </c:pt>
                <c:pt idx="173">
                  <c:v>-3.6096138954162598</c:v>
                </c:pt>
                <c:pt idx="174">
                  <c:v>-3.6036624908447266</c:v>
                </c:pt>
                <c:pt idx="175">
                  <c:v>-3.597703218460083</c:v>
                </c:pt>
                <c:pt idx="176">
                  <c:v>-3.5917403697967529</c:v>
                </c:pt>
                <c:pt idx="177">
                  <c:v>-3.5857739448547363</c:v>
                </c:pt>
                <c:pt idx="178">
                  <c:v>-3.5798025131225586</c:v>
                </c:pt>
                <c:pt idx="179">
                  <c:v>-3.5738255977630615</c:v>
                </c:pt>
                <c:pt idx="180">
                  <c:v>-3.5678408145904541</c:v>
                </c:pt>
                <c:pt idx="181">
                  <c:v>-3.5618462562561035</c:v>
                </c:pt>
                <c:pt idx="182">
                  <c:v>-3.5558462142944336</c:v>
                </c:pt>
                <c:pt idx="183">
                  <c:v>-3.5498430728912354</c:v>
                </c:pt>
                <c:pt idx="184">
                  <c:v>-3.5438363552093506</c:v>
                </c:pt>
                <c:pt idx="185">
                  <c:v>-3.5378243923187256</c:v>
                </c:pt>
                <c:pt idx="186">
                  <c:v>-3.5318062305450439</c:v>
                </c:pt>
                <c:pt idx="187">
                  <c:v>-3.525780200958252</c:v>
                </c:pt>
                <c:pt idx="188">
                  <c:v>-3.5197451114654541</c:v>
                </c:pt>
                <c:pt idx="189">
                  <c:v>-3.5137042999267578</c:v>
                </c:pt>
                <c:pt idx="190">
                  <c:v>-3.5076603889465332</c:v>
                </c:pt>
                <c:pt idx="191">
                  <c:v>-3.5016131401062012</c:v>
                </c:pt>
                <c:pt idx="192">
                  <c:v>-3.4955627918243408</c:v>
                </c:pt>
                <c:pt idx="193">
                  <c:v>-3.4895086288452148</c:v>
                </c:pt>
                <c:pt idx="194">
                  <c:v>-3.4834494590759277</c:v>
                </c:pt>
                <c:pt idx="195">
                  <c:v>-3.4773848056793213</c:v>
                </c:pt>
                <c:pt idx="196">
                  <c:v>-3.4713125228881836</c:v>
                </c:pt>
                <c:pt idx="197">
                  <c:v>-3.4652318954467773</c:v>
                </c:pt>
                <c:pt idx="198">
                  <c:v>-3.4591438770294189</c:v>
                </c:pt>
                <c:pt idx="199">
                  <c:v>-3.4530525207519531</c:v>
                </c:pt>
                <c:pt idx="200">
                  <c:v>-3.4469578266143799</c:v>
                </c:pt>
                <c:pt idx="201">
                  <c:v>-3.4408588409423828</c:v>
                </c:pt>
                <c:pt idx="202">
                  <c:v>-3.4347548484802246</c:v>
                </c:pt>
                <c:pt idx="203">
                  <c:v>-3.4286448955535889</c:v>
                </c:pt>
                <c:pt idx="204">
                  <c:v>-3.4225265979766846</c:v>
                </c:pt>
                <c:pt idx="205">
                  <c:v>-3.4163997173309326</c:v>
                </c:pt>
                <c:pt idx="206">
                  <c:v>-3.4102671146392822</c:v>
                </c:pt>
                <c:pt idx="207">
                  <c:v>-3.4041311740875244</c:v>
                </c:pt>
                <c:pt idx="208">
                  <c:v>-3.3979918956756592</c:v>
                </c:pt>
                <c:pt idx="209">
                  <c:v>-3.391848087310791</c:v>
                </c:pt>
                <c:pt idx="210">
                  <c:v>-3.385699987411499</c:v>
                </c:pt>
                <c:pt idx="211">
                  <c:v>-3.3795464038848877</c:v>
                </c:pt>
                <c:pt idx="212">
                  <c:v>-3.3733859062194824</c:v>
                </c:pt>
                <c:pt idx="213">
                  <c:v>-3.3672184944152832</c:v>
                </c:pt>
                <c:pt idx="214">
                  <c:v>-3.3610434532165527</c:v>
                </c:pt>
                <c:pt idx="215">
                  <c:v>-3.3548634052276611</c:v>
                </c:pt>
                <c:pt idx="216">
                  <c:v>-3.3486795425415039</c:v>
                </c:pt>
                <c:pt idx="217">
                  <c:v>-3.3424923419952393</c:v>
                </c:pt>
                <c:pt idx="218">
                  <c:v>-3.336301326751709</c:v>
                </c:pt>
                <c:pt idx="219">
                  <c:v>-3.3301055431365967</c:v>
                </c:pt>
                <c:pt idx="220">
                  <c:v>-3.3239052295684814</c:v>
                </c:pt>
                <c:pt idx="221">
                  <c:v>-3.3177008628845215</c:v>
                </c:pt>
                <c:pt idx="222">
                  <c:v>-3.3114891052246094</c:v>
                </c:pt>
                <c:pt idx="223">
                  <c:v>-3.3052678108215332</c:v>
                </c:pt>
                <c:pt idx="224">
                  <c:v>-3.2990410327911377</c:v>
                </c:pt>
                <c:pt idx="225">
                  <c:v>-3.292809009552002</c:v>
                </c:pt>
                <c:pt idx="226">
                  <c:v>-3.2865736484527588</c:v>
                </c:pt>
                <c:pt idx="227">
                  <c:v>-3.2803349494934082</c:v>
                </c:pt>
                <c:pt idx="228">
                  <c:v>-3.2740926742553711</c:v>
                </c:pt>
                <c:pt idx="229">
                  <c:v>-3.2678465843200684</c:v>
                </c:pt>
                <c:pt idx="230">
                  <c:v>-3.2615954875946045</c:v>
                </c:pt>
                <c:pt idx="231">
                  <c:v>-3.2553398609161377</c:v>
                </c:pt>
                <c:pt idx="232">
                  <c:v>-3.2490768432617188</c:v>
                </c:pt>
                <c:pt idx="233">
                  <c:v>-3.2428069114685059</c:v>
                </c:pt>
                <c:pt idx="234">
                  <c:v>-3.2365291118621826</c:v>
                </c:pt>
                <c:pt idx="235">
                  <c:v>-3.2302463054656982</c:v>
                </c:pt>
                <c:pt idx="236">
                  <c:v>-3.22395920753479</c:v>
                </c:pt>
                <c:pt idx="237">
                  <c:v>-3.2176685333251953</c:v>
                </c:pt>
                <c:pt idx="238">
                  <c:v>-3.2113747596740723</c:v>
                </c:pt>
                <c:pt idx="239">
                  <c:v>-3.2050764560699463</c:v>
                </c:pt>
                <c:pt idx="240">
                  <c:v>-3.1987740993499756</c:v>
                </c:pt>
                <c:pt idx="241">
                  <c:v>-3.1924669742584229</c:v>
                </c:pt>
                <c:pt idx="242">
                  <c:v>-3.1861546039581299</c:v>
                </c:pt>
                <c:pt idx="243">
                  <c:v>-3.179835319519043</c:v>
                </c:pt>
                <c:pt idx="244">
                  <c:v>-3.1735079288482666</c:v>
                </c:pt>
                <c:pt idx="245">
                  <c:v>-3.1671731472015381</c:v>
                </c:pt>
                <c:pt idx="246">
                  <c:v>-3.1608340740203857</c:v>
                </c:pt>
                <c:pt idx="247">
                  <c:v>-3.1544911861419678</c:v>
                </c:pt>
                <c:pt idx="248">
                  <c:v>-3.1481451988220215</c:v>
                </c:pt>
                <c:pt idx="249">
                  <c:v>-3.1417946815490723</c:v>
                </c:pt>
                <c:pt idx="250">
                  <c:v>-3.1354408264160156</c:v>
                </c:pt>
                <c:pt idx="251">
                  <c:v>-3.1290817260742188</c:v>
                </c:pt>
                <c:pt idx="252">
                  <c:v>-3.1227190494537354</c:v>
                </c:pt>
                <c:pt idx="253">
                  <c:v>-3.1163504123687744</c:v>
                </c:pt>
                <c:pt idx="254">
                  <c:v>-3.1099753379821777</c:v>
                </c:pt>
                <c:pt idx="255">
                  <c:v>-3.1035912036895752</c:v>
                </c:pt>
                <c:pt idx="256">
                  <c:v>-3.0972015857696533</c:v>
                </c:pt>
                <c:pt idx="257">
                  <c:v>-3.0908069610595703</c:v>
                </c:pt>
                <c:pt idx="258">
                  <c:v>-3.0844082832336426</c:v>
                </c:pt>
                <c:pt idx="259">
                  <c:v>-3.0780065059661865</c:v>
                </c:pt>
                <c:pt idx="260">
                  <c:v>-3.0716009140014648</c:v>
                </c:pt>
                <c:pt idx="261">
                  <c:v>-3.0651919841766357</c:v>
                </c:pt>
                <c:pt idx="262">
                  <c:v>-3.0587780475616455</c:v>
                </c:pt>
                <c:pt idx="263">
                  <c:v>-3.0523602962493896</c:v>
                </c:pt>
                <c:pt idx="264">
                  <c:v>-3.0459372997283936</c:v>
                </c:pt>
                <c:pt idx="265">
                  <c:v>-3.0395100116729736</c:v>
                </c:pt>
                <c:pt idx="266">
                  <c:v>-3.033076286315918</c:v>
                </c:pt>
                <c:pt idx="267">
                  <c:v>-3.0266335010528564</c:v>
                </c:pt>
                <c:pt idx="268">
                  <c:v>-3.0201852321624756</c:v>
                </c:pt>
                <c:pt idx="269">
                  <c:v>-3.0137317180633545</c:v>
                </c:pt>
                <c:pt idx="270">
                  <c:v>-3.0072739124298096</c:v>
                </c:pt>
                <c:pt idx="271">
                  <c:v>-3.0008125305175781</c:v>
                </c:pt>
                <c:pt idx="272">
                  <c:v>-2.9943478107452393</c:v>
                </c:pt>
                <c:pt idx="273">
                  <c:v>-2.9878795146942139</c:v>
                </c:pt>
                <c:pt idx="274">
                  <c:v>-2.9814078807830811</c:v>
                </c:pt>
                <c:pt idx="275">
                  <c:v>-2.9749326705932617</c:v>
                </c:pt>
                <c:pt idx="276">
                  <c:v>-2.9684543609619141</c:v>
                </c:pt>
                <c:pt idx="277">
                  <c:v>-2.9619724750518799</c:v>
                </c:pt>
                <c:pt idx="278">
                  <c:v>-2.9554860591888428</c:v>
                </c:pt>
                <c:pt idx="279">
                  <c:v>-2.94899582862854</c:v>
                </c:pt>
                <c:pt idx="280">
                  <c:v>-2.9425013065338135</c:v>
                </c:pt>
                <c:pt idx="281">
                  <c:v>-2.9360024929046631</c:v>
                </c:pt>
                <c:pt idx="282">
                  <c:v>-2.9294981956481934</c:v>
                </c:pt>
                <c:pt idx="283">
                  <c:v>-2.9229891300201416</c:v>
                </c:pt>
                <c:pt idx="284">
                  <c:v>-2.9164736270904541</c:v>
                </c:pt>
                <c:pt idx="285">
                  <c:v>-2.9099504947662354</c:v>
                </c:pt>
                <c:pt idx="286">
                  <c:v>-2.9034206867218018</c:v>
                </c:pt>
                <c:pt idx="287">
                  <c:v>-2.8968868255615234</c:v>
                </c:pt>
                <c:pt idx="288">
                  <c:v>-2.8903484344482422</c:v>
                </c:pt>
                <c:pt idx="289">
                  <c:v>-2.8838067054748535</c:v>
                </c:pt>
                <c:pt idx="290">
                  <c:v>-2.8772614002227783</c:v>
                </c:pt>
                <c:pt idx="291">
                  <c:v>-2.8707125186920166</c:v>
                </c:pt>
                <c:pt idx="292">
                  <c:v>-2.8641600608825684</c:v>
                </c:pt>
                <c:pt idx="293">
                  <c:v>-2.8576037883758545</c:v>
                </c:pt>
                <c:pt idx="294">
                  <c:v>-2.851043701171875</c:v>
                </c:pt>
                <c:pt idx="295">
                  <c:v>-2.8444786071777344</c:v>
                </c:pt>
                <c:pt idx="296">
                  <c:v>-2.8379096984863281</c:v>
                </c:pt>
                <c:pt idx="297">
                  <c:v>-2.8313362598419189</c:v>
                </c:pt>
                <c:pt idx="298">
                  <c:v>-2.824756383895874</c:v>
                </c:pt>
                <c:pt idx="299">
                  <c:v>-2.818171501159668</c:v>
                </c:pt>
                <c:pt idx="300">
                  <c:v>-2.8115799427032471</c:v>
                </c:pt>
                <c:pt idx="301">
                  <c:v>-2.8049814701080322</c:v>
                </c:pt>
                <c:pt idx="302">
                  <c:v>-2.798377513885498</c:v>
                </c:pt>
                <c:pt idx="303">
                  <c:v>-2.7917685508728027</c:v>
                </c:pt>
                <c:pt idx="304">
                  <c:v>-2.78515625</c:v>
                </c:pt>
                <c:pt idx="305">
                  <c:v>-2.7785406112670898</c:v>
                </c:pt>
                <c:pt idx="306">
                  <c:v>-2.7719213962554932</c:v>
                </c:pt>
                <c:pt idx="307">
                  <c:v>-2.76529860496521</c:v>
                </c:pt>
                <c:pt idx="308">
                  <c:v>-2.758671760559082</c:v>
                </c:pt>
                <c:pt idx="309">
                  <c:v>-2.7520408630371094</c:v>
                </c:pt>
                <c:pt idx="310">
                  <c:v>-2.745405912399292</c:v>
                </c:pt>
                <c:pt idx="311">
                  <c:v>-2.7387669086456299</c:v>
                </c:pt>
                <c:pt idx="312">
                  <c:v>-2.7321228981018066</c:v>
                </c:pt>
                <c:pt idx="313">
                  <c:v>-2.7254748344421387</c:v>
                </c:pt>
                <c:pt idx="314">
                  <c:v>-2.7188196182250977</c:v>
                </c:pt>
                <c:pt idx="315">
                  <c:v>-2.7121593952178955</c:v>
                </c:pt>
                <c:pt idx="316">
                  <c:v>-2.7054939270019531</c:v>
                </c:pt>
                <c:pt idx="317">
                  <c:v>-2.6988222599029541</c:v>
                </c:pt>
                <c:pt idx="318">
                  <c:v>-2.6921448707580566</c:v>
                </c:pt>
                <c:pt idx="319">
                  <c:v>-2.6854622364044189</c:v>
                </c:pt>
                <c:pt idx="320">
                  <c:v>-2.6787760257720947</c:v>
                </c:pt>
                <c:pt idx="321">
                  <c:v>-2.6720857620239258</c:v>
                </c:pt>
                <c:pt idx="322">
                  <c:v>-2.6653921604156494</c:v>
                </c:pt>
                <c:pt idx="323">
                  <c:v>-2.6586949825286865</c:v>
                </c:pt>
                <c:pt idx="324">
                  <c:v>-2.6519944667816162</c:v>
                </c:pt>
                <c:pt idx="325">
                  <c:v>-2.6452903747558594</c:v>
                </c:pt>
                <c:pt idx="326">
                  <c:v>-2.6385824680328369</c:v>
                </c:pt>
                <c:pt idx="327">
                  <c:v>-2.6318702697753906</c:v>
                </c:pt>
                <c:pt idx="328">
                  <c:v>-2.6251547336578369</c:v>
                </c:pt>
                <c:pt idx="329">
                  <c:v>-2.618433952331543</c:v>
                </c:pt>
                <c:pt idx="330">
                  <c:v>-2.6117091178894043</c:v>
                </c:pt>
                <c:pt idx="331">
                  <c:v>-2.6049797534942627</c:v>
                </c:pt>
                <c:pt idx="332">
                  <c:v>-2.5982451438903809</c:v>
                </c:pt>
                <c:pt idx="333">
                  <c:v>-2.5915050506591797</c:v>
                </c:pt>
                <c:pt idx="334">
                  <c:v>-2.584758996963501</c:v>
                </c:pt>
                <c:pt idx="335">
                  <c:v>-2.578005313873291</c:v>
                </c:pt>
                <c:pt idx="336">
                  <c:v>-2.5712471008300781</c:v>
                </c:pt>
                <c:pt idx="337">
                  <c:v>-2.5644834041595459</c:v>
                </c:pt>
                <c:pt idx="338">
                  <c:v>-2.5577154159545898</c:v>
                </c:pt>
                <c:pt idx="339">
                  <c:v>-2.5509433746337891</c:v>
                </c:pt>
                <c:pt idx="340">
                  <c:v>-2.5441677570343018</c:v>
                </c:pt>
                <c:pt idx="341">
                  <c:v>-2.537388801574707</c:v>
                </c:pt>
                <c:pt idx="342">
                  <c:v>-2.5306062698364258</c:v>
                </c:pt>
                <c:pt idx="343">
                  <c:v>-2.5238204002380371</c:v>
                </c:pt>
                <c:pt idx="344">
                  <c:v>-2.5170309543609619</c:v>
                </c:pt>
                <c:pt idx="345">
                  <c:v>-2.5102376937866211</c:v>
                </c:pt>
                <c:pt idx="346">
                  <c:v>-2.5034403800964355</c:v>
                </c:pt>
                <c:pt idx="347">
                  <c:v>-2.4966394901275635</c:v>
                </c:pt>
                <c:pt idx="348">
                  <c:v>-2.4898343086242676</c:v>
                </c:pt>
                <c:pt idx="349">
                  <c:v>-2.4830243587493896</c:v>
                </c:pt>
                <c:pt idx="350">
                  <c:v>-2.476210355758667</c:v>
                </c:pt>
                <c:pt idx="351">
                  <c:v>-2.4693922996520996</c:v>
                </c:pt>
                <c:pt idx="352">
                  <c:v>-2.4625699520111084</c:v>
                </c:pt>
                <c:pt idx="353">
                  <c:v>-2.4557421207427979</c:v>
                </c:pt>
                <c:pt idx="354">
                  <c:v>-2.4489090442657471</c:v>
                </c:pt>
                <c:pt idx="355">
                  <c:v>-2.4420709609985352</c:v>
                </c:pt>
                <c:pt idx="356">
                  <c:v>-2.4352271556854248</c:v>
                </c:pt>
                <c:pt idx="357">
                  <c:v>-2.4283781051635742</c:v>
                </c:pt>
                <c:pt idx="358">
                  <c:v>-2.4215233325958252</c:v>
                </c:pt>
                <c:pt idx="359">
                  <c:v>-2.4146645069122314</c:v>
                </c:pt>
                <c:pt idx="360">
                  <c:v>-2.4078013896942139</c:v>
                </c:pt>
                <c:pt idx="361">
                  <c:v>-2.4009337425231934</c:v>
                </c:pt>
                <c:pt idx="362">
                  <c:v>-2.3940620422363281</c:v>
                </c:pt>
                <c:pt idx="363">
                  <c:v>-2.3871872425079346</c:v>
                </c:pt>
                <c:pt idx="364">
                  <c:v>-2.3803083896636963</c:v>
                </c:pt>
                <c:pt idx="365">
                  <c:v>-2.3734261989593506</c:v>
                </c:pt>
                <c:pt idx="366">
                  <c:v>-2.3665404319763184</c:v>
                </c:pt>
                <c:pt idx="367">
                  <c:v>-2.3596510887145996</c:v>
                </c:pt>
                <c:pt idx="368">
                  <c:v>-2.3527584075927734</c:v>
                </c:pt>
                <c:pt idx="369">
                  <c:v>-2.3458621501922607</c:v>
                </c:pt>
                <c:pt idx="370">
                  <c:v>-2.3389623165130615</c:v>
                </c:pt>
                <c:pt idx="371">
                  <c:v>-2.3320589065551758</c:v>
                </c:pt>
                <c:pt idx="372">
                  <c:v>-2.3251521587371826</c:v>
                </c:pt>
                <c:pt idx="373">
                  <c:v>-2.3182415962219238</c:v>
                </c:pt>
                <c:pt idx="374">
                  <c:v>-2.3113272190093994</c:v>
                </c:pt>
                <c:pt idx="375">
                  <c:v>-2.3044090270996094</c:v>
                </c:pt>
                <c:pt idx="376">
                  <c:v>-2.2974870204925537</c:v>
                </c:pt>
                <c:pt idx="377">
                  <c:v>-2.2905607223510742</c:v>
                </c:pt>
                <c:pt idx="378">
                  <c:v>-2.2836306095123291</c:v>
                </c:pt>
                <c:pt idx="379">
                  <c:v>-2.2766971588134766</c:v>
                </c:pt>
                <c:pt idx="380">
                  <c:v>-2.2697594165802002</c:v>
                </c:pt>
                <c:pt idx="381">
                  <c:v>-2.2628178596496582</c:v>
                </c:pt>
                <c:pt idx="382">
                  <c:v>-2.2558715343475342</c:v>
                </c:pt>
                <c:pt idx="383">
                  <c:v>-2.2489209175109863</c:v>
                </c:pt>
                <c:pt idx="384">
                  <c:v>-2.2419650554656982</c:v>
                </c:pt>
                <c:pt idx="385">
                  <c:v>-2.235004186630249</c:v>
                </c:pt>
                <c:pt idx="386">
                  <c:v>-2.2280378341674805</c:v>
                </c:pt>
                <c:pt idx="387">
                  <c:v>-2.2210662364959717</c:v>
                </c:pt>
                <c:pt idx="388">
                  <c:v>-2.2140896320343018</c:v>
                </c:pt>
                <c:pt idx="389">
                  <c:v>-2.2071070671081543</c:v>
                </c:pt>
                <c:pt idx="390">
                  <c:v>-2.2001206874847412</c:v>
                </c:pt>
                <c:pt idx="391">
                  <c:v>-2.1931285858154297</c:v>
                </c:pt>
                <c:pt idx="392">
                  <c:v>-2.1861326694488525</c:v>
                </c:pt>
                <c:pt idx="393">
                  <c:v>-2.179133415222168</c:v>
                </c:pt>
                <c:pt idx="394">
                  <c:v>-2.1721296310424805</c:v>
                </c:pt>
                <c:pt idx="395">
                  <c:v>-2.1651225090026855</c:v>
                </c:pt>
                <c:pt idx="396">
                  <c:v>-2.158111572265625</c:v>
                </c:pt>
                <c:pt idx="397">
                  <c:v>-2.1510975360870361</c:v>
                </c:pt>
                <c:pt idx="398">
                  <c:v>-2.1440796852111816</c:v>
                </c:pt>
                <c:pt idx="399">
                  <c:v>-2.1370584964752197</c:v>
                </c:pt>
                <c:pt idx="400">
                  <c:v>-2.1300337314605713</c:v>
                </c:pt>
                <c:pt idx="401">
                  <c:v>-2.1230051517486572</c:v>
                </c:pt>
                <c:pt idx="402">
                  <c:v>-2.1159729957580566</c:v>
                </c:pt>
                <c:pt idx="403">
                  <c:v>-2.1089370250701904</c:v>
                </c:pt>
                <c:pt idx="404">
                  <c:v>-2.1018979549407959</c:v>
                </c:pt>
                <c:pt idx="405">
                  <c:v>-2.0948538780212402</c:v>
                </c:pt>
                <c:pt idx="406">
                  <c:v>-2.0878071784973145</c:v>
                </c:pt>
                <c:pt idx="407">
                  <c:v>-2.0807557106018066</c:v>
                </c:pt>
                <c:pt idx="408">
                  <c:v>-2.0737011432647705</c:v>
                </c:pt>
                <c:pt idx="409">
                  <c:v>-2.0666422843933105</c:v>
                </c:pt>
                <c:pt idx="410">
                  <c:v>-2.059579610824585</c:v>
                </c:pt>
                <c:pt idx="411">
                  <c:v>-2.0525131225585938</c:v>
                </c:pt>
                <c:pt idx="412">
                  <c:v>-2.0454416275024414</c:v>
                </c:pt>
                <c:pt idx="413">
                  <c:v>-2.0383667945861816</c:v>
                </c:pt>
                <c:pt idx="414">
                  <c:v>-2.0312869548797607</c:v>
                </c:pt>
                <c:pt idx="415">
                  <c:v>-2.0242033004760742</c:v>
                </c:pt>
                <c:pt idx="416">
                  <c:v>-2.0171144008636475</c:v>
                </c:pt>
                <c:pt idx="417">
                  <c:v>-2.0100212097167969</c:v>
                </c:pt>
                <c:pt idx="418">
                  <c:v>-2.002922534942627</c:v>
                </c:pt>
                <c:pt idx="419">
                  <c:v>-1.9958193302154541</c:v>
                </c:pt>
                <c:pt idx="420">
                  <c:v>-1.9887107610702515</c:v>
                </c:pt>
                <c:pt idx="421">
                  <c:v>-1.9815975427627563</c:v>
                </c:pt>
                <c:pt idx="422">
                  <c:v>-1.9744802713394165</c:v>
                </c:pt>
                <c:pt idx="423">
                  <c:v>-1.9673582315444946</c:v>
                </c:pt>
                <c:pt idx="424">
                  <c:v>-1.9602310657501221</c:v>
                </c:pt>
                <c:pt idx="425">
                  <c:v>-1.9530997276306152</c:v>
                </c:pt>
                <c:pt idx="426">
                  <c:v>-1.9459642171859741</c:v>
                </c:pt>
                <c:pt idx="427">
                  <c:v>-1.9388241767883301</c:v>
                </c:pt>
                <c:pt idx="428">
                  <c:v>-1.9316810369491577</c:v>
                </c:pt>
                <c:pt idx="429">
                  <c:v>-1.9245339632034302</c:v>
                </c:pt>
                <c:pt idx="430">
                  <c:v>-1.9173833131790161</c:v>
                </c:pt>
                <c:pt idx="431">
                  <c:v>-1.9102292060852051</c:v>
                </c:pt>
                <c:pt idx="432">
                  <c:v>-1.9030716419219971</c:v>
                </c:pt>
                <c:pt idx="433">
                  <c:v>-1.8959105014801025</c:v>
                </c:pt>
                <c:pt idx="434">
                  <c:v>-1.8887457847595215</c:v>
                </c:pt>
                <c:pt idx="435">
                  <c:v>-1.8815770149230957</c:v>
                </c:pt>
                <c:pt idx="436">
                  <c:v>-1.8744052648544312</c:v>
                </c:pt>
                <c:pt idx="437">
                  <c:v>-1.867229700088501</c:v>
                </c:pt>
                <c:pt idx="438">
                  <c:v>-1.8600509166717529</c:v>
                </c:pt>
                <c:pt idx="439">
                  <c:v>-1.8528672456741333</c:v>
                </c:pt>
                <c:pt idx="440">
                  <c:v>-1.8456804752349854</c:v>
                </c:pt>
                <c:pt idx="441">
                  <c:v>-1.8384891748428345</c:v>
                </c:pt>
                <c:pt idx="442">
                  <c:v>-1.8312944173812866</c:v>
                </c:pt>
                <c:pt idx="443">
                  <c:v>-1.8240957260131836</c:v>
                </c:pt>
                <c:pt idx="444">
                  <c:v>-1.8168926239013672</c:v>
                </c:pt>
                <c:pt idx="445">
                  <c:v>-1.8096859455108643</c:v>
                </c:pt>
                <c:pt idx="446">
                  <c:v>-1.8024750947952271</c:v>
                </c:pt>
                <c:pt idx="447">
                  <c:v>-1.7952606678009033</c:v>
                </c:pt>
                <c:pt idx="448">
                  <c:v>-1.7880405187606812</c:v>
                </c:pt>
                <c:pt idx="449">
                  <c:v>-1.7808171510696411</c:v>
                </c:pt>
                <c:pt idx="450">
                  <c:v>-1.7735886573791504</c:v>
                </c:pt>
                <c:pt idx="451">
                  <c:v>-1.7663573026657104</c:v>
                </c:pt>
                <c:pt idx="452">
                  <c:v>-1.7591203451156616</c:v>
                </c:pt>
                <c:pt idx="453">
                  <c:v>-1.7518802881240845</c:v>
                </c:pt>
                <c:pt idx="454">
                  <c:v>-1.7446351051330566</c:v>
                </c:pt>
                <c:pt idx="455">
                  <c:v>-1.7373872995376587</c:v>
                </c:pt>
                <c:pt idx="456">
                  <c:v>-1.730134129524231</c:v>
                </c:pt>
                <c:pt idx="457">
                  <c:v>-1.7228753566741943</c:v>
                </c:pt>
                <c:pt idx="458">
                  <c:v>-1.7156111001968384</c:v>
                </c:pt>
                <c:pt idx="459">
                  <c:v>-1.7083398103713989</c:v>
                </c:pt>
                <c:pt idx="460">
                  <c:v>-1.7010647058486938</c:v>
                </c:pt>
                <c:pt idx="461">
                  <c:v>-1.6937853097915649</c:v>
                </c:pt>
                <c:pt idx="462">
                  <c:v>-1.6865015029907227</c:v>
                </c:pt>
                <c:pt idx="463">
                  <c:v>-1.6792143583297729</c:v>
                </c:pt>
                <c:pt idx="464">
                  <c:v>-1.671923041343689</c:v>
                </c:pt>
                <c:pt idx="465">
                  <c:v>-1.664628267288208</c:v>
                </c:pt>
                <c:pt idx="466">
                  <c:v>-1.6573299169540405</c:v>
                </c:pt>
                <c:pt idx="467">
                  <c:v>-1.6500279903411865</c:v>
                </c:pt>
                <c:pt idx="468">
                  <c:v>-1.642722487449646</c:v>
                </c:pt>
                <c:pt idx="469">
                  <c:v>-1.6354135274887085</c:v>
                </c:pt>
                <c:pt idx="470">
                  <c:v>-1.6281009912490845</c:v>
                </c:pt>
                <c:pt idx="471">
                  <c:v>-1.6207848787307739</c:v>
                </c:pt>
                <c:pt idx="472">
                  <c:v>-1.6134653091430664</c:v>
                </c:pt>
                <c:pt idx="473">
                  <c:v>-1.6061421632766724</c:v>
                </c:pt>
                <c:pt idx="474">
                  <c:v>-1.5988154411315918</c:v>
                </c:pt>
                <c:pt idx="475">
                  <c:v>-1.5914852619171143</c:v>
                </c:pt>
                <c:pt idx="476">
                  <c:v>-1.5841515064239502</c:v>
                </c:pt>
                <c:pt idx="477">
                  <c:v>-1.576813817024231</c:v>
                </c:pt>
                <c:pt idx="478">
                  <c:v>-1.5694729089736938</c:v>
                </c:pt>
                <c:pt idx="479">
                  <c:v>-1.5621281862258911</c:v>
                </c:pt>
                <c:pt idx="480">
                  <c:v>-1.5547792911529541</c:v>
                </c:pt>
                <c:pt idx="481">
                  <c:v>-1.547427773475647</c:v>
                </c:pt>
                <c:pt idx="482">
                  <c:v>-1.5400718450546265</c:v>
                </c:pt>
                <c:pt idx="483">
                  <c:v>-1.5327116250991821</c:v>
                </c:pt>
                <c:pt idx="484">
                  <c:v>-1.5253475904464722</c:v>
                </c:pt>
                <c:pt idx="485">
                  <c:v>-1.5179802179336548</c:v>
                </c:pt>
                <c:pt idx="486">
                  <c:v>-1.5106087923049927</c:v>
                </c:pt>
                <c:pt idx="487">
                  <c:v>-1.5032334327697754</c:v>
                </c:pt>
                <c:pt idx="488">
                  <c:v>-1.4958535432815552</c:v>
                </c:pt>
                <c:pt idx="489">
                  <c:v>-1.4884698390960693</c:v>
                </c:pt>
                <c:pt idx="490">
                  <c:v>-1.481082558631897</c:v>
                </c:pt>
                <c:pt idx="491">
                  <c:v>-1.4736907482147217</c:v>
                </c:pt>
                <c:pt idx="492">
                  <c:v>-1.4662944078445435</c:v>
                </c:pt>
                <c:pt idx="493">
                  <c:v>-1.4588918685913086</c:v>
                </c:pt>
                <c:pt idx="494">
                  <c:v>-1.4514877796173096</c:v>
                </c:pt>
                <c:pt idx="495">
                  <c:v>-1.4440771341323853</c:v>
                </c:pt>
                <c:pt idx="496">
                  <c:v>-1.4366613626480103</c:v>
                </c:pt>
                <c:pt idx="497">
                  <c:v>-1.4292383193969727</c:v>
                </c:pt>
                <c:pt idx="498">
                  <c:v>-1.4218111038208008</c:v>
                </c:pt>
                <c:pt idx="499">
                  <c:v>-1.4143790006637573</c:v>
                </c:pt>
                <c:pt idx="500">
                  <c:v>-1.4069417715072632</c:v>
                </c:pt>
                <c:pt idx="501">
                  <c:v>-1.3995002508163452</c:v>
                </c:pt>
                <c:pt idx="502">
                  <c:v>-1.392054557800293</c:v>
                </c:pt>
                <c:pt idx="503">
                  <c:v>-1.3846046924591064</c:v>
                </c:pt>
                <c:pt idx="504">
                  <c:v>-1.3771505355834961</c:v>
                </c:pt>
                <c:pt idx="505">
                  <c:v>-1.3696928024291992</c:v>
                </c:pt>
                <c:pt idx="506">
                  <c:v>-1.3622314929962158</c:v>
                </c:pt>
                <c:pt idx="507">
                  <c:v>-1.3547667264938354</c:v>
                </c:pt>
                <c:pt idx="508">
                  <c:v>-1.3472983837127686</c:v>
                </c:pt>
                <c:pt idx="509">
                  <c:v>-1.3398264646530151</c:v>
                </c:pt>
                <c:pt idx="510">
                  <c:v>-1.3323509693145752</c:v>
                </c:pt>
                <c:pt idx="511">
                  <c:v>-1.3248718976974487</c:v>
                </c:pt>
                <c:pt idx="512">
                  <c:v>-1.3173890113830566</c:v>
                </c:pt>
                <c:pt idx="513">
                  <c:v>-1.3099014759063721</c:v>
                </c:pt>
                <c:pt idx="514">
                  <c:v>-1.3024104833602905</c:v>
                </c:pt>
                <c:pt idx="515">
                  <c:v>-1.2949148416519165</c:v>
                </c:pt>
                <c:pt idx="516">
                  <c:v>-1.2874153852462769</c:v>
                </c:pt>
                <c:pt idx="517">
                  <c:v>-1.2799116373062134</c:v>
                </c:pt>
                <c:pt idx="518">
                  <c:v>-1.272403359413147</c:v>
                </c:pt>
                <c:pt idx="519">
                  <c:v>-1.2648918628692627</c:v>
                </c:pt>
                <c:pt idx="520">
                  <c:v>-1.2573761940002441</c:v>
                </c:pt>
                <c:pt idx="521">
                  <c:v>-1.2498571872711182</c:v>
                </c:pt>
                <c:pt idx="522">
                  <c:v>-1.2423326969146729</c:v>
                </c:pt>
                <c:pt idx="523">
                  <c:v>-1.2348052263259888</c:v>
                </c:pt>
                <c:pt idx="524">
                  <c:v>-1.2272719144821167</c:v>
                </c:pt>
                <c:pt idx="525">
                  <c:v>-1.2197331190109253</c:v>
                </c:pt>
                <c:pt idx="526">
                  <c:v>-1.2121893167495728</c:v>
                </c:pt>
                <c:pt idx="527">
                  <c:v>-1.2046422958374023</c:v>
                </c:pt>
                <c:pt idx="528">
                  <c:v>-1.1970887184143066</c:v>
                </c:pt>
                <c:pt idx="529">
                  <c:v>-1.1895295381546021</c:v>
                </c:pt>
                <c:pt idx="530">
                  <c:v>-1.1819654703140259</c:v>
                </c:pt>
                <c:pt idx="531">
                  <c:v>-1.1743954420089722</c:v>
                </c:pt>
                <c:pt idx="532">
                  <c:v>-1.1668215990066528</c:v>
                </c:pt>
                <c:pt idx="533">
                  <c:v>-1.1592434644699097</c:v>
                </c:pt>
                <c:pt idx="534">
                  <c:v>-1.1516610383987427</c:v>
                </c:pt>
                <c:pt idx="535">
                  <c:v>-1.1440753936767578</c:v>
                </c:pt>
                <c:pt idx="536">
                  <c:v>-1.1364859342575073</c:v>
                </c:pt>
                <c:pt idx="537">
                  <c:v>-1.1288927793502808</c:v>
                </c:pt>
                <c:pt idx="538">
                  <c:v>-1.1212961673736572</c:v>
                </c:pt>
                <c:pt idx="539">
                  <c:v>-1.1136958599090576</c:v>
                </c:pt>
                <c:pt idx="540">
                  <c:v>-1.106092095375061</c:v>
                </c:pt>
                <c:pt idx="541">
                  <c:v>-1.0984846353530884</c:v>
                </c:pt>
                <c:pt idx="542">
                  <c:v>-1.0908733606338501</c:v>
                </c:pt>
                <c:pt idx="543">
                  <c:v>-1.0832585096359253</c:v>
                </c:pt>
                <c:pt idx="544">
                  <c:v>-1.0756403207778931</c:v>
                </c:pt>
                <c:pt idx="545">
                  <c:v>-1.0680176019668579</c:v>
                </c:pt>
                <c:pt idx="546">
                  <c:v>-1.0603913068771362</c:v>
                </c:pt>
                <c:pt idx="547">
                  <c:v>-1.0527608394622803</c:v>
                </c:pt>
                <c:pt idx="548">
                  <c:v>-1.0451253652572632</c:v>
                </c:pt>
                <c:pt idx="549">
                  <c:v>-1.0374860763549805</c:v>
                </c:pt>
                <c:pt idx="550">
                  <c:v>-1.0298434495925903</c:v>
                </c:pt>
                <c:pt idx="551">
                  <c:v>-1.0221959352493286</c:v>
                </c:pt>
                <c:pt idx="552">
                  <c:v>-1.0145448446273804</c:v>
                </c:pt>
                <c:pt idx="553">
                  <c:v>-1.0068904161453247</c:v>
                </c:pt>
                <c:pt idx="554">
                  <c:v>-0.99923050403594971</c:v>
                </c:pt>
                <c:pt idx="555">
                  <c:v>-0.99156832695007324</c:v>
                </c:pt>
                <c:pt idx="556">
                  <c:v>-0.98390120267868042</c:v>
                </c:pt>
                <c:pt idx="557">
                  <c:v>-0.97623056173324585</c:v>
                </c:pt>
                <c:pt idx="558">
                  <c:v>-0.96855664253234863</c:v>
                </c:pt>
                <c:pt idx="559">
                  <c:v>-0.96087843179702759</c:v>
                </c:pt>
                <c:pt idx="560">
                  <c:v>-0.95319604873657227</c:v>
                </c:pt>
                <c:pt idx="561">
                  <c:v>-0.94551068544387817</c:v>
                </c:pt>
                <c:pt idx="562">
                  <c:v>-0.93782079219818115</c:v>
                </c:pt>
                <c:pt idx="563">
                  <c:v>-0.93012559413909912</c:v>
                </c:pt>
                <c:pt idx="564">
                  <c:v>-0.92242711782455444</c:v>
                </c:pt>
                <c:pt idx="565">
                  <c:v>-0.91472512483596802</c:v>
                </c:pt>
                <c:pt idx="566">
                  <c:v>-0.90701818466186523</c:v>
                </c:pt>
                <c:pt idx="567">
                  <c:v>-0.89930862188339233</c:v>
                </c:pt>
                <c:pt idx="568">
                  <c:v>-0.89159590005874634</c:v>
                </c:pt>
                <c:pt idx="569">
                  <c:v>-0.88388091325759888</c:v>
                </c:pt>
                <c:pt idx="570">
                  <c:v>-0.87616205215454102</c:v>
                </c:pt>
                <c:pt idx="571">
                  <c:v>-0.86843925714492798</c:v>
                </c:pt>
                <c:pt idx="572">
                  <c:v>-0.8607138991355896</c:v>
                </c:pt>
                <c:pt idx="573">
                  <c:v>-0.8529849648475647</c:v>
                </c:pt>
                <c:pt idx="574">
                  <c:v>-0.84525072574615479</c:v>
                </c:pt>
                <c:pt idx="575">
                  <c:v>-0.83751434087753296</c:v>
                </c:pt>
                <c:pt idx="576">
                  <c:v>-0.82977259159088135</c:v>
                </c:pt>
                <c:pt idx="577">
                  <c:v>-0.82202833890914917</c:v>
                </c:pt>
                <c:pt idx="578">
                  <c:v>-0.81428021192550659</c:v>
                </c:pt>
                <c:pt idx="579">
                  <c:v>-0.80652874708175659</c:v>
                </c:pt>
                <c:pt idx="580">
                  <c:v>-0.79877275228500366</c:v>
                </c:pt>
                <c:pt idx="581">
                  <c:v>-0.79101520776748657</c:v>
                </c:pt>
                <c:pt idx="582">
                  <c:v>-0.78325307369232178</c:v>
                </c:pt>
                <c:pt idx="583">
                  <c:v>-0.77548700571060181</c:v>
                </c:pt>
                <c:pt idx="584">
                  <c:v>-0.76771670579910278</c:v>
                </c:pt>
                <c:pt idx="585">
                  <c:v>-0.75994384288787842</c:v>
                </c:pt>
                <c:pt idx="586">
                  <c:v>-0.75216740369796753</c:v>
                </c:pt>
                <c:pt idx="587">
                  <c:v>-0.74438875913619995</c:v>
                </c:pt>
                <c:pt idx="588">
                  <c:v>-0.73660624027252197</c:v>
                </c:pt>
                <c:pt idx="589">
                  <c:v>-0.72881972789764404</c:v>
                </c:pt>
                <c:pt idx="590">
                  <c:v>-0.72103071212768555</c:v>
                </c:pt>
                <c:pt idx="591">
                  <c:v>-0.71323919296264648</c:v>
                </c:pt>
                <c:pt idx="592">
                  <c:v>-0.70544302463531494</c:v>
                </c:pt>
                <c:pt idx="593">
                  <c:v>-0.69764292240142822</c:v>
                </c:pt>
                <c:pt idx="594">
                  <c:v>-0.68984103202819824</c:v>
                </c:pt>
                <c:pt idx="595">
                  <c:v>-0.68203657865524292</c:v>
                </c:pt>
                <c:pt idx="596">
                  <c:v>-0.67422854900360107</c:v>
                </c:pt>
                <c:pt idx="597">
                  <c:v>-0.66641759872436523</c:v>
                </c:pt>
                <c:pt idx="598">
                  <c:v>-0.65860313177108765</c:v>
                </c:pt>
                <c:pt idx="599">
                  <c:v>-0.65078473091125488</c:v>
                </c:pt>
                <c:pt idx="600">
                  <c:v>-0.64296382665634155</c:v>
                </c:pt>
                <c:pt idx="601">
                  <c:v>-0.635140061378479</c:v>
                </c:pt>
                <c:pt idx="602">
                  <c:v>-0.62731266021728516</c:v>
                </c:pt>
                <c:pt idx="603">
                  <c:v>-0.61948210000991821</c:v>
                </c:pt>
                <c:pt idx="604">
                  <c:v>-0.61164897680282593</c:v>
                </c:pt>
                <c:pt idx="605">
                  <c:v>-0.60381233692169189</c:v>
                </c:pt>
                <c:pt idx="606">
                  <c:v>-0.59597277641296387</c:v>
                </c:pt>
                <c:pt idx="607">
                  <c:v>-0.58812892436981201</c:v>
                </c:pt>
                <c:pt idx="608">
                  <c:v>-0.58028227090835571</c:v>
                </c:pt>
                <c:pt idx="609">
                  <c:v>-0.57243204116821289</c:v>
                </c:pt>
                <c:pt idx="610">
                  <c:v>-0.56457823514938354</c:v>
                </c:pt>
                <c:pt idx="611">
                  <c:v>-0.55672085285186768</c:v>
                </c:pt>
                <c:pt idx="612">
                  <c:v>-0.54885995388031006</c:v>
                </c:pt>
                <c:pt idx="613">
                  <c:v>-0.54099541902542114</c:v>
                </c:pt>
                <c:pt idx="614">
                  <c:v>-0.53312736749649048</c:v>
                </c:pt>
                <c:pt idx="615">
                  <c:v>-0.52525573968887329</c:v>
                </c:pt>
                <c:pt idx="616">
                  <c:v>-0.51738053560256958</c:v>
                </c:pt>
                <c:pt idx="617">
                  <c:v>-0.50950181484222412</c:v>
                </c:pt>
                <c:pt idx="618">
                  <c:v>-0.50161945819854736</c:v>
                </c:pt>
                <c:pt idx="619">
                  <c:v>-0.49373358488082886</c:v>
                </c:pt>
                <c:pt idx="620">
                  <c:v>-0.48584416508674622</c:v>
                </c:pt>
                <c:pt idx="621">
                  <c:v>-0.47795113921165466</c:v>
                </c:pt>
                <c:pt idx="622">
                  <c:v>-0.47005459666252136</c:v>
                </c:pt>
                <c:pt idx="623">
                  <c:v>-0.4621540904045105</c:v>
                </c:pt>
                <c:pt idx="624">
                  <c:v>-0.45425039529800415</c:v>
                </c:pt>
                <c:pt idx="625">
                  <c:v>-0.44634315371513367</c:v>
                </c:pt>
                <c:pt idx="626">
                  <c:v>-0.43843233585357666</c:v>
                </c:pt>
                <c:pt idx="627">
                  <c:v>-0.43051794171333313</c:v>
                </c:pt>
                <c:pt idx="628">
                  <c:v>-0.42260000109672546</c:v>
                </c:pt>
                <c:pt idx="629">
                  <c:v>-0.41467779874801636</c:v>
                </c:pt>
                <c:pt idx="630">
                  <c:v>-0.40675273537635803</c:v>
                </c:pt>
                <c:pt idx="631">
                  <c:v>-0.39882376790046692</c:v>
                </c:pt>
                <c:pt idx="632">
                  <c:v>-0.39089122414588928</c:v>
                </c:pt>
                <c:pt idx="633">
                  <c:v>-0.38295510411262512</c:v>
                </c:pt>
                <c:pt idx="634">
                  <c:v>-0.37501475214958191</c:v>
                </c:pt>
                <c:pt idx="635">
                  <c:v>-0.36707115173339844</c:v>
                </c:pt>
                <c:pt idx="636">
                  <c:v>-0.35912436246871948</c:v>
                </c:pt>
                <c:pt idx="637">
                  <c:v>-0.35117226839065552</c:v>
                </c:pt>
                <c:pt idx="638">
                  <c:v>-0.3432176411151886</c:v>
                </c:pt>
                <c:pt idx="639">
                  <c:v>-0.33525910973548889</c:v>
                </c:pt>
                <c:pt idx="640">
                  <c:v>-0.3272966742515564</c:v>
                </c:pt>
                <c:pt idx="641">
                  <c:v>-0.31932926177978516</c:v>
                </c:pt>
                <c:pt idx="642">
                  <c:v>-0.31135934591293335</c:v>
                </c:pt>
                <c:pt idx="643">
                  <c:v>-0.30338478088378906</c:v>
                </c:pt>
                <c:pt idx="644">
                  <c:v>-0.2954084575176239</c:v>
                </c:pt>
                <c:pt idx="645">
                  <c:v>-0.28742644190788269</c:v>
                </c:pt>
                <c:pt idx="646">
                  <c:v>-0.27944013476371765</c:v>
                </c:pt>
                <c:pt idx="647">
                  <c:v>-0.27145063877105713</c:v>
                </c:pt>
                <c:pt idx="648">
                  <c:v>-0.26345720887184143</c:v>
                </c:pt>
                <c:pt idx="649">
                  <c:v>-0.25545954704284668</c:v>
                </c:pt>
                <c:pt idx="650">
                  <c:v>-0.24745757877826691</c:v>
                </c:pt>
                <c:pt idx="651">
                  <c:v>-0.2394520491361618</c:v>
                </c:pt>
                <c:pt idx="652">
                  <c:v>-0.23144154250621796</c:v>
                </c:pt>
                <c:pt idx="653">
                  <c:v>-0.22342924773693085</c:v>
                </c:pt>
                <c:pt idx="654">
                  <c:v>-0.2154126763343811</c:v>
                </c:pt>
                <c:pt idx="655">
                  <c:v>-0.20739112794399261</c:v>
                </c:pt>
                <c:pt idx="656">
                  <c:v>-0.1993660032749176</c:v>
                </c:pt>
                <c:pt idx="657">
                  <c:v>-0.19133695960044861</c:v>
                </c:pt>
                <c:pt idx="658">
                  <c:v>-0.18330363929271698</c:v>
                </c:pt>
                <c:pt idx="659">
                  <c:v>-0.17526747286319733</c:v>
                </c:pt>
                <c:pt idx="660">
                  <c:v>-0.16722595691680908</c:v>
                </c:pt>
                <c:pt idx="661">
                  <c:v>-0.15918336808681488</c:v>
                </c:pt>
                <c:pt idx="662">
                  <c:v>-0.15113614499568939</c:v>
                </c:pt>
                <c:pt idx="663">
                  <c:v>-0.14308500289916992</c:v>
                </c:pt>
                <c:pt idx="664">
                  <c:v>-0.13502958416938782</c:v>
                </c:pt>
                <c:pt idx="665">
                  <c:v>-0.12697024643421173</c:v>
                </c:pt>
                <c:pt idx="666">
                  <c:v>-0.11890804767608643</c:v>
                </c:pt>
                <c:pt idx="667">
                  <c:v>-0.11084336042404175</c:v>
                </c:pt>
                <c:pt idx="668">
                  <c:v>-0.10277332365512848</c:v>
                </c:pt>
                <c:pt idx="669">
                  <c:v>-9.470079094171524E-2</c:v>
                </c:pt>
                <c:pt idx="670">
                  <c:v>-8.6625047028064728E-2</c:v>
                </c:pt>
                <c:pt idx="671">
                  <c:v>-7.8547179698944092E-2</c:v>
                </c:pt>
                <c:pt idx="672">
                  <c:v>-7.0465020835399628E-2</c:v>
                </c:pt>
                <c:pt idx="673">
                  <c:v>-6.2379308044910431E-2</c:v>
                </c:pt>
                <c:pt idx="674">
                  <c:v>-5.4288242012262344E-2</c:v>
                </c:pt>
                <c:pt idx="675">
                  <c:v>-4.619540274143219E-2</c:v>
                </c:pt>
                <c:pt idx="676">
                  <c:v>-3.8099713623523712E-2</c:v>
                </c:pt>
                <c:pt idx="677">
                  <c:v>-3.0000463128089905E-2</c:v>
                </c:pt>
                <c:pt idx="678">
                  <c:v>-2.1896576508879662E-2</c:v>
                </c:pt>
                <c:pt idx="679">
                  <c:v>-1.3789844699203968E-2</c:v>
                </c:pt>
                <c:pt idx="680">
                  <c:v>-5.6791920214891434E-3</c:v>
                </c:pt>
                <c:pt idx="681">
                  <c:v>2.4346637073904276E-3</c:v>
                </c:pt>
                <c:pt idx="682">
                  <c:v>1.0555312968790531E-2</c:v>
                </c:pt>
                <c:pt idx="683">
                  <c:v>1.8679885193705559E-2</c:v>
                </c:pt>
                <c:pt idx="684">
                  <c:v>2.6809819042682648E-2</c:v>
                </c:pt>
                <c:pt idx="685">
                  <c:v>3.494475781917572E-2</c:v>
                </c:pt>
                <c:pt idx="686">
                  <c:v>4.3085061013698578E-2</c:v>
                </c:pt>
                <c:pt idx="687">
                  <c:v>5.1229652017354965E-2</c:v>
                </c:pt>
                <c:pt idx="688">
                  <c:v>5.937817320227623E-2</c:v>
                </c:pt>
                <c:pt idx="689">
                  <c:v>6.7530982196331024E-2</c:v>
                </c:pt>
                <c:pt idx="690">
                  <c:v>7.568880170583725E-2</c:v>
                </c:pt>
                <c:pt idx="691">
                  <c:v>8.3851635456085205E-2</c:v>
                </c:pt>
                <c:pt idx="692">
                  <c:v>9.2017322778701782E-2</c:v>
                </c:pt>
                <c:pt idx="693">
                  <c:v>0.10018910467624664</c:v>
                </c:pt>
                <c:pt idx="694">
                  <c:v>0.10836374014616013</c:v>
                </c:pt>
                <c:pt idx="695">
                  <c:v>0.11654230207204819</c:v>
                </c:pt>
                <c:pt idx="696">
                  <c:v>0.12472444772720337</c:v>
                </c:pt>
                <c:pt idx="697">
                  <c:v>0.13291087746620178</c:v>
                </c:pt>
                <c:pt idx="698">
                  <c:v>0.14110088348388672</c:v>
                </c:pt>
                <c:pt idx="699">
                  <c:v>0.14929483830928802</c:v>
                </c:pt>
                <c:pt idx="700">
                  <c:v>0.15749235451221466</c:v>
                </c:pt>
                <c:pt idx="701">
                  <c:v>0.16569343209266663</c:v>
                </c:pt>
                <c:pt idx="702">
                  <c:v>0.17389810085296631</c:v>
                </c:pt>
                <c:pt idx="703">
                  <c:v>0.18210633099079132</c:v>
                </c:pt>
                <c:pt idx="704">
                  <c:v>0.19031813740730286</c:v>
                </c:pt>
                <c:pt idx="705">
                  <c:v>0.19853352010250092</c:v>
                </c:pt>
                <c:pt idx="706">
                  <c:v>0.2067524790763855</c:v>
                </c:pt>
                <c:pt idx="707">
                  <c:v>0.21497499942779541</c:v>
                </c:pt>
                <c:pt idx="708">
                  <c:v>0.22320109605789185</c:v>
                </c:pt>
                <c:pt idx="709">
                  <c:v>0.2314307689666748</c:v>
                </c:pt>
                <c:pt idx="710">
                  <c:v>0.23966400325298309</c:v>
                </c:pt>
                <c:pt idx="711">
                  <c:v>0.24790081381797791</c:v>
                </c:pt>
                <c:pt idx="712">
                  <c:v>0.25614121556282043</c:v>
                </c:pt>
                <c:pt idx="713">
                  <c:v>0.2643851637840271</c:v>
                </c:pt>
                <c:pt idx="714">
                  <c:v>0.27263268828392029</c:v>
                </c:pt>
                <c:pt idx="715">
                  <c:v>0.2808837890625</c:v>
                </c:pt>
                <c:pt idx="716">
                  <c:v>0.28913846611976624</c:v>
                </c:pt>
                <c:pt idx="717">
                  <c:v>0.29739668965339661</c:v>
                </c:pt>
                <c:pt idx="718">
                  <c:v>0.30565851926803589</c:v>
                </c:pt>
                <c:pt idx="719">
                  <c:v>0.31392389535903931</c:v>
                </c:pt>
                <c:pt idx="720">
                  <c:v>0.32219284772872925</c:v>
                </c:pt>
                <c:pt idx="721">
                  <c:v>0.33046537637710571</c:v>
                </c:pt>
                <c:pt idx="722">
                  <c:v>0.33874145150184631</c:v>
                </c:pt>
                <c:pt idx="723">
                  <c:v>0.34702113270759583</c:v>
                </c:pt>
                <c:pt idx="724">
                  <c:v>0.35530436038970947</c:v>
                </c:pt>
                <c:pt idx="725">
                  <c:v>0.36359116435050964</c:v>
                </c:pt>
                <c:pt idx="726">
                  <c:v>0.37188154458999634</c:v>
                </c:pt>
                <c:pt idx="727">
                  <c:v>0.38017550110816956</c:v>
                </c:pt>
                <c:pt idx="728">
                  <c:v>0.38847300410270691</c:v>
                </c:pt>
                <c:pt idx="729">
                  <c:v>0.39677408337593079</c:v>
                </c:pt>
                <c:pt idx="730">
                  <c:v>0.40507873892784119</c:v>
                </c:pt>
                <c:pt idx="731">
                  <c:v>0.41338697075843811</c:v>
                </c:pt>
                <c:pt idx="732">
                  <c:v>0.42169839143753052</c:v>
                </c:pt>
                <c:pt idx="733">
                  <c:v>0.4300137460231781</c:v>
                </c:pt>
                <c:pt idx="734">
                  <c:v>0.43833267688751221</c:v>
                </c:pt>
                <c:pt idx="735">
                  <c:v>0.44665515422821045</c:v>
                </c:pt>
                <c:pt idx="736">
                  <c:v>0.4549812376499176</c:v>
                </c:pt>
                <c:pt idx="737">
                  <c:v>0.46331086754798889</c:v>
                </c:pt>
                <c:pt idx="738">
                  <c:v>0.4716440737247467</c:v>
                </c:pt>
                <c:pt idx="739">
                  <c:v>0.47998085618019104</c:v>
                </c:pt>
                <c:pt idx="740">
                  <c:v>0.48832118511199951</c:v>
                </c:pt>
                <c:pt idx="741">
                  <c:v>0.49666509032249451</c:v>
                </c:pt>
                <c:pt idx="742">
                  <c:v>0.50501257181167603</c:v>
                </c:pt>
                <c:pt idx="743">
                  <c:v>0.51336359977722168</c:v>
                </c:pt>
                <c:pt idx="744">
                  <c:v>0.52171820402145386</c:v>
                </c:pt>
                <c:pt idx="745">
                  <c:v>0.53007638454437256</c:v>
                </c:pt>
                <c:pt idx="746">
                  <c:v>0.53843814134597778</c:v>
                </c:pt>
                <c:pt idx="747">
                  <c:v>0.54680347442626953</c:v>
                </c:pt>
                <c:pt idx="748">
                  <c:v>0.55517232418060303</c:v>
                </c:pt>
                <c:pt idx="749">
                  <c:v>0.56354516744613647</c:v>
                </c:pt>
                <c:pt idx="750">
                  <c:v>0.57192188501358032</c:v>
                </c:pt>
                <c:pt idx="751">
                  <c:v>0.58030223846435547</c:v>
                </c:pt>
                <c:pt idx="752">
                  <c:v>0.58868575096130371</c:v>
                </c:pt>
                <c:pt idx="753">
                  <c:v>0.59707468748092651</c:v>
                </c:pt>
                <c:pt idx="754">
                  <c:v>0.60546571016311646</c:v>
                </c:pt>
                <c:pt idx="755">
                  <c:v>0.61386102437973022</c:v>
                </c:pt>
                <c:pt idx="756">
                  <c:v>0.62226104736328125</c:v>
                </c:pt>
                <c:pt idx="757">
                  <c:v>0.63066422939300537</c:v>
                </c:pt>
                <c:pt idx="758">
                  <c:v>0.63907140493392944</c:v>
                </c:pt>
                <c:pt idx="759">
                  <c:v>0.64748245477676392</c:v>
                </c:pt>
                <c:pt idx="760">
                  <c:v>0.65589898824691772</c:v>
                </c:pt>
                <c:pt idx="761">
                  <c:v>0.66431832313537598</c:v>
                </c:pt>
                <c:pt idx="762">
                  <c:v>0.6727415919303894</c:v>
                </c:pt>
                <c:pt idx="763">
                  <c:v>0.68116879463195801</c:v>
                </c:pt>
                <c:pt idx="764">
                  <c:v>0.6896018385887146</c:v>
                </c:pt>
                <c:pt idx="765">
                  <c:v>0.69803619384765625</c:v>
                </c:pt>
                <c:pt idx="766">
                  <c:v>0.70647597312927246</c:v>
                </c:pt>
                <c:pt idx="767">
                  <c:v>0.71491968631744385</c:v>
                </c:pt>
                <c:pt idx="768">
                  <c:v>0.72336775064468384</c:v>
                </c:pt>
                <c:pt idx="769">
                  <c:v>0.73182123899459839</c:v>
                </c:pt>
                <c:pt idx="770">
                  <c:v>0.74027830362319946</c:v>
                </c:pt>
                <c:pt idx="771">
                  <c:v>0.74873965978622437</c:v>
                </c:pt>
                <c:pt idx="772">
                  <c:v>0.75720572471618652</c:v>
                </c:pt>
                <c:pt idx="773">
                  <c:v>0.76567721366882324</c:v>
                </c:pt>
                <c:pt idx="774">
                  <c:v>0.7741541862487793</c:v>
                </c:pt>
                <c:pt idx="775">
                  <c:v>0.78263545036315918</c:v>
                </c:pt>
                <c:pt idx="776">
                  <c:v>0.79112255573272705</c:v>
                </c:pt>
                <c:pt idx="777">
                  <c:v>0.79961395263671875</c:v>
                </c:pt>
                <c:pt idx="778">
                  <c:v>0.80810970067977905</c:v>
                </c:pt>
                <c:pt idx="779">
                  <c:v>0.81661015748977661</c:v>
                </c:pt>
                <c:pt idx="780">
                  <c:v>0.82511454820632935</c:v>
                </c:pt>
                <c:pt idx="781">
                  <c:v>0.83362400531768799</c:v>
                </c:pt>
                <c:pt idx="782">
                  <c:v>0.8421359658241272</c:v>
                </c:pt>
                <c:pt idx="783">
                  <c:v>0.85065299272537231</c:v>
                </c:pt>
                <c:pt idx="784">
                  <c:v>0.85917395353317261</c:v>
                </c:pt>
                <c:pt idx="785">
                  <c:v>0.86769890785217285</c:v>
                </c:pt>
                <c:pt idx="786">
                  <c:v>0.87622743844985962</c:v>
                </c:pt>
                <c:pt idx="787">
                  <c:v>0.88475954532623291</c:v>
                </c:pt>
                <c:pt idx="788">
                  <c:v>0.89329522848129272</c:v>
                </c:pt>
                <c:pt idx="789">
                  <c:v>0.90183448791503906</c:v>
                </c:pt>
                <c:pt idx="790">
                  <c:v>0.91037732362747192</c:v>
                </c:pt>
                <c:pt idx="791">
                  <c:v>0.91892373561859131</c:v>
                </c:pt>
                <c:pt idx="792">
                  <c:v>0.92747378349304199</c:v>
                </c:pt>
                <c:pt idx="793">
                  <c:v>0.93602734804153442</c:v>
                </c:pt>
                <c:pt idx="794">
                  <c:v>0.94458454847335815</c:v>
                </c:pt>
                <c:pt idx="795">
                  <c:v>0.95314532518386841</c:v>
                </c:pt>
                <c:pt idx="796">
                  <c:v>0.96170961856842041</c:v>
                </c:pt>
                <c:pt idx="797">
                  <c:v>0.9702790379524231</c:v>
                </c:pt>
                <c:pt idx="798">
                  <c:v>0.97885280847549438</c:v>
                </c:pt>
                <c:pt idx="799">
                  <c:v>0.98743057250976563</c:v>
                </c:pt>
                <c:pt idx="800">
                  <c:v>0.99601149559020996</c:v>
                </c:pt>
                <c:pt idx="801">
                  <c:v>1.0045967102050781</c:v>
                </c:pt>
                <c:pt idx="802">
                  <c:v>1.0131351947784424</c:v>
                </c:pt>
                <c:pt idx="803">
                  <c:v>1.0216777324676514</c:v>
                </c:pt>
                <c:pt idx="804">
                  <c:v>1.0302234888076782</c:v>
                </c:pt>
                <c:pt idx="805">
                  <c:v>1.0387740135192871</c:v>
                </c:pt>
                <c:pt idx="806">
                  <c:v>1.0473285913467407</c:v>
                </c:pt>
                <c:pt idx="807">
                  <c:v>1.0558862686157227</c:v>
                </c:pt>
                <c:pt idx="808">
                  <c:v>1.0644505023956299</c:v>
                </c:pt>
                <c:pt idx="809">
                  <c:v>1.0730159282684326</c:v>
                </c:pt>
                <c:pt idx="810">
                  <c:v>1.0815869569778442</c:v>
                </c:pt>
                <c:pt idx="811">
                  <c:v>1.0901603698730469</c:v>
                </c:pt>
                <c:pt idx="812">
                  <c:v>1.0987367630004883</c:v>
                </c:pt>
                <c:pt idx="813">
                  <c:v>1.107317328453064</c:v>
                </c:pt>
                <c:pt idx="814">
                  <c:v>1.1159031391143799</c:v>
                </c:pt>
                <c:pt idx="815">
                  <c:v>1.1244900226593018</c:v>
                </c:pt>
                <c:pt idx="816">
                  <c:v>1.1330806016921997</c:v>
                </c:pt>
                <c:pt idx="817">
                  <c:v>1.1416753530502319</c:v>
                </c:pt>
                <c:pt idx="818">
                  <c:v>1.1502722501754761</c:v>
                </c:pt>
                <c:pt idx="819">
                  <c:v>1.1588705778121948</c:v>
                </c:pt>
                <c:pt idx="820">
                  <c:v>1.1674717664718628</c:v>
                </c:pt>
                <c:pt idx="821">
                  <c:v>1.1760748624801636</c:v>
                </c:pt>
                <c:pt idx="822">
                  <c:v>1.1846814155578613</c:v>
                </c:pt>
                <c:pt idx="823">
                  <c:v>1.1932921409606934</c:v>
                </c:pt>
                <c:pt idx="824">
                  <c:v>1.2019064426422119</c:v>
                </c:pt>
                <c:pt idx="825">
                  <c:v>1.21052086353302</c:v>
                </c:pt>
                <c:pt idx="826">
                  <c:v>1.2191401720046997</c:v>
                </c:pt>
                <c:pt idx="827">
                  <c:v>1.2277603149414063</c:v>
                </c:pt>
                <c:pt idx="828">
                  <c:v>1.2363823652267456</c:v>
                </c:pt>
                <c:pt idx="829">
                  <c:v>1.2450063228607178</c:v>
                </c:pt>
                <c:pt idx="830">
                  <c:v>1.2536302804946899</c:v>
                </c:pt>
                <c:pt idx="831">
                  <c:v>1.2622562646865845</c:v>
                </c:pt>
                <c:pt idx="832">
                  <c:v>1.2708830833435059</c:v>
                </c:pt>
                <c:pt idx="833">
                  <c:v>1.2795122861862183</c:v>
                </c:pt>
                <c:pt idx="834">
                  <c:v>1.2881426811218262</c:v>
                </c:pt>
                <c:pt idx="835">
                  <c:v>1.2967743873596191</c:v>
                </c:pt>
                <c:pt idx="836">
                  <c:v>1.3054070472717285</c:v>
                </c:pt>
                <c:pt idx="837">
                  <c:v>1.3140398263931274</c:v>
                </c:pt>
                <c:pt idx="838">
                  <c:v>1.3226734399795532</c:v>
                </c:pt>
                <c:pt idx="839">
                  <c:v>1.3313093185424805</c:v>
                </c:pt>
                <c:pt idx="840">
                  <c:v>1.339945912361145</c:v>
                </c:pt>
                <c:pt idx="841">
                  <c:v>1.3485833406448364</c:v>
                </c:pt>
                <c:pt idx="842">
                  <c:v>1.3572189807891846</c:v>
                </c:pt>
                <c:pt idx="843">
                  <c:v>1.3658559322357178</c:v>
                </c:pt>
                <c:pt idx="844">
                  <c:v>1.3744931221008301</c:v>
                </c:pt>
                <c:pt idx="845">
                  <c:v>1.3831298351287842</c:v>
                </c:pt>
                <c:pt idx="846">
                  <c:v>1.3917666673660278</c:v>
                </c:pt>
                <c:pt idx="847">
                  <c:v>1.4004040956497192</c:v>
                </c:pt>
                <c:pt idx="848">
                  <c:v>1.4090415239334106</c:v>
                </c:pt>
                <c:pt idx="849">
                  <c:v>1.4176789522171021</c:v>
                </c:pt>
                <c:pt idx="850">
                  <c:v>1.4263154268264771</c:v>
                </c:pt>
                <c:pt idx="851">
                  <c:v>1.434950590133667</c:v>
                </c:pt>
                <c:pt idx="852">
                  <c:v>1.4435850381851196</c:v>
                </c:pt>
                <c:pt idx="853">
                  <c:v>1.4522188901901245</c:v>
                </c:pt>
                <c:pt idx="854">
                  <c:v>1.4608503580093384</c:v>
                </c:pt>
                <c:pt idx="855">
                  <c:v>1.4694808721542358</c:v>
                </c:pt>
                <c:pt idx="856">
                  <c:v>1.4781116247177124</c:v>
                </c:pt>
                <c:pt idx="857">
                  <c:v>1.4867390394210815</c:v>
                </c:pt>
                <c:pt idx="858">
                  <c:v>1.4953641891479492</c:v>
                </c:pt>
                <c:pt idx="859">
                  <c:v>1.5039877891540527</c:v>
                </c:pt>
                <c:pt idx="860">
                  <c:v>1.5126093626022339</c:v>
                </c:pt>
                <c:pt idx="861">
                  <c:v>1.5212277173995972</c:v>
                </c:pt>
                <c:pt idx="862">
                  <c:v>1.5298449993133545</c:v>
                </c:pt>
                <c:pt idx="863">
                  <c:v>1.5384588241577148</c:v>
                </c:pt>
                <c:pt idx="864">
                  <c:v>1.5470719337463379</c:v>
                </c:pt>
                <c:pt idx="865">
                  <c:v>1.5556830167770386</c:v>
                </c:pt>
                <c:pt idx="866">
                  <c:v>1.564292311668396</c:v>
                </c:pt>
                <c:pt idx="867">
                  <c:v>1.5728998184204102</c:v>
                </c:pt>
                <c:pt idx="868">
                  <c:v>1.5815043449401855</c:v>
                </c:pt>
                <c:pt idx="869">
                  <c:v>1.5901075601577759</c:v>
                </c:pt>
                <c:pt idx="870">
                  <c:v>1.5987081527709961</c:v>
                </c:pt>
                <c:pt idx="871">
                  <c:v>1.6073068380355835</c:v>
                </c:pt>
                <c:pt idx="872">
                  <c:v>1.6159026622772217</c:v>
                </c:pt>
                <c:pt idx="873">
                  <c:v>1.6244962215423584</c:v>
                </c:pt>
                <c:pt idx="874">
                  <c:v>1.6330885887145996</c:v>
                </c:pt>
                <c:pt idx="875">
                  <c:v>1.6416782140731812</c:v>
                </c:pt>
                <c:pt idx="876">
                  <c:v>1.6502652168273926</c:v>
                </c:pt>
                <c:pt idx="877">
                  <c:v>1.6588501930236816</c:v>
                </c:pt>
                <c:pt idx="878">
                  <c:v>1.667432427406311</c:v>
                </c:pt>
                <c:pt idx="879">
                  <c:v>1.6760126352310181</c:v>
                </c:pt>
                <c:pt idx="880">
                  <c:v>1.6845901012420654</c:v>
                </c:pt>
                <c:pt idx="881">
                  <c:v>1.6931651830673218</c:v>
                </c:pt>
                <c:pt idx="882">
                  <c:v>1.7017375230789185</c:v>
                </c:pt>
                <c:pt idx="883">
                  <c:v>1.7103073596954346</c:v>
                </c:pt>
                <c:pt idx="884">
                  <c:v>1.7188743352890015</c:v>
                </c:pt>
                <c:pt idx="885">
                  <c:v>1.7274385690689087</c:v>
                </c:pt>
                <c:pt idx="886">
                  <c:v>1.7359999418258667</c:v>
                </c:pt>
                <c:pt idx="887">
                  <c:v>1.7445583343505859</c:v>
                </c:pt>
                <c:pt idx="888">
                  <c:v>1.7531133890151978</c:v>
                </c:pt>
                <c:pt idx="889">
                  <c:v>1.7616652250289917</c:v>
                </c:pt>
                <c:pt idx="890">
                  <c:v>1.7702136039733887</c:v>
                </c:pt>
                <c:pt idx="891">
                  <c:v>1.7787586450576782</c:v>
                </c:pt>
                <c:pt idx="892">
                  <c:v>1.7872992753982544</c:v>
                </c:pt>
                <c:pt idx="893">
                  <c:v>1.7958353757858276</c:v>
                </c:pt>
                <c:pt idx="894">
                  <c:v>1.8043675422668457</c:v>
                </c:pt>
                <c:pt idx="895">
                  <c:v>1.8128947019577026</c:v>
                </c:pt>
                <c:pt idx="896">
                  <c:v>1.8214156627655029</c:v>
                </c:pt>
                <c:pt idx="897">
                  <c:v>1.8299324512481689</c:v>
                </c:pt>
                <c:pt idx="898">
                  <c:v>1.8384412527084351</c:v>
                </c:pt>
                <c:pt idx="899">
                  <c:v>1.8469463586807251</c:v>
                </c:pt>
                <c:pt idx="900">
                  <c:v>1.8554470539093018</c:v>
                </c:pt>
                <c:pt idx="901">
                  <c:v>1.8639407157897949</c:v>
                </c:pt>
                <c:pt idx="902">
                  <c:v>1.8724299669265747</c:v>
                </c:pt>
                <c:pt idx="903">
                  <c:v>1.8809117078781128</c:v>
                </c:pt>
                <c:pt idx="904">
                  <c:v>1.8893907070159912</c:v>
                </c:pt>
                <c:pt idx="905">
                  <c:v>1.8978627920150757</c:v>
                </c:pt>
                <c:pt idx="906">
                  <c:v>1.9063323736190796</c:v>
                </c:pt>
                <c:pt idx="907">
                  <c:v>1.9147963523864746</c:v>
                </c:pt>
                <c:pt idx="908">
                  <c:v>1.9232546091079712</c:v>
                </c:pt>
                <c:pt idx="909">
                  <c:v>1.9317076206207275</c:v>
                </c:pt>
                <c:pt idx="910">
                  <c:v>1.9401551485061646</c:v>
                </c:pt>
                <c:pt idx="911">
                  <c:v>1.9485982656478882</c:v>
                </c:pt>
                <c:pt idx="912">
                  <c:v>1.9570357799530029</c:v>
                </c:pt>
                <c:pt idx="913">
                  <c:v>1.9654688835144043</c:v>
                </c:pt>
                <c:pt idx="914">
                  <c:v>1.9738961458206177</c:v>
                </c:pt>
                <c:pt idx="915">
                  <c:v>1.9823184013366699</c:v>
                </c:pt>
                <c:pt idx="916">
                  <c:v>1.9907358884811401</c:v>
                </c:pt>
                <c:pt idx="917">
                  <c:v>1.9991474151611328</c:v>
                </c:pt>
                <c:pt idx="918">
                  <c:v>2.007554292678833</c:v>
                </c:pt>
                <c:pt idx="919">
                  <c:v>2.0159561634063721</c:v>
                </c:pt>
                <c:pt idx="920">
                  <c:v>2.0243513584136963</c:v>
                </c:pt>
                <c:pt idx="921">
                  <c:v>2.0327425003051758</c:v>
                </c:pt>
                <c:pt idx="922">
                  <c:v>2.0411281585693359</c:v>
                </c:pt>
                <c:pt idx="923">
                  <c:v>2.0495092868804932</c:v>
                </c:pt>
                <c:pt idx="924">
                  <c:v>2.0578858852386475</c:v>
                </c:pt>
                <c:pt idx="925">
                  <c:v>2.0662577152252197</c:v>
                </c:pt>
                <c:pt idx="926">
                  <c:v>2.07462477684021</c:v>
                </c:pt>
                <c:pt idx="927">
                  <c:v>2.0829877853393555</c:v>
                </c:pt>
                <c:pt idx="928">
                  <c:v>2.0913460254669189</c:v>
                </c:pt>
                <c:pt idx="929">
                  <c:v>2.0997014045715332</c:v>
                </c:pt>
                <c:pt idx="930">
                  <c:v>2.1080520153045654</c:v>
                </c:pt>
                <c:pt idx="931">
                  <c:v>2.116398811340332</c:v>
                </c:pt>
                <c:pt idx="932">
                  <c:v>2.1247415542602539</c:v>
                </c:pt>
                <c:pt idx="933">
                  <c:v>2.1330811977386475</c:v>
                </c:pt>
                <c:pt idx="934">
                  <c:v>2.1414170265197754</c:v>
                </c:pt>
                <c:pt idx="935">
                  <c:v>2.1497504711151123</c:v>
                </c:pt>
                <c:pt idx="936">
                  <c:v>2.1580793857574463</c:v>
                </c:pt>
                <c:pt idx="937">
                  <c:v>2.1664059162139893</c:v>
                </c:pt>
                <c:pt idx="938">
                  <c:v>2.1747283935546875</c:v>
                </c:pt>
                <c:pt idx="939">
                  <c:v>2.1830487251281738</c:v>
                </c:pt>
                <c:pt idx="940">
                  <c:v>2.1913661956787109</c:v>
                </c:pt>
                <c:pt idx="941">
                  <c:v>2.1996810436248779</c:v>
                </c:pt>
                <c:pt idx="942">
                  <c:v>2.2079927921295166</c:v>
                </c:pt>
                <c:pt idx="943">
                  <c:v>2.2163023948669434</c:v>
                </c:pt>
                <c:pt idx="944">
                  <c:v>2.2246091365814209</c:v>
                </c:pt>
                <c:pt idx="945">
                  <c:v>2.2329144477844238</c:v>
                </c:pt>
                <c:pt idx="946">
                  <c:v>2.2412161827087402</c:v>
                </c:pt>
                <c:pt idx="947">
                  <c:v>2.2495172023773193</c:v>
                </c:pt>
                <c:pt idx="948">
                  <c:v>2.2578160762786865</c:v>
                </c:pt>
                <c:pt idx="949">
                  <c:v>2.2661125659942627</c:v>
                </c:pt>
                <c:pt idx="950">
                  <c:v>2.2744078636169434</c:v>
                </c:pt>
                <c:pt idx="951">
                  <c:v>2.2827014923095703</c:v>
                </c:pt>
                <c:pt idx="952">
                  <c:v>2.2909927368164063</c:v>
                </c:pt>
                <c:pt idx="953">
                  <c:v>2.299283504486084</c:v>
                </c:pt>
                <c:pt idx="954">
                  <c:v>2.3075728416442871</c:v>
                </c:pt>
                <c:pt idx="955">
                  <c:v>2.3158614635467529</c:v>
                </c:pt>
                <c:pt idx="956">
                  <c:v>2.3241481781005859</c:v>
                </c:pt>
                <c:pt idx="957">
                  <c:v>2.3324346542358398</c:v>
                </c:pt>
                <c:pt idx="958">
                  <c:v>2.3407196998596191</c:v>
                </c:pt>
                <c:pt idx="959">
                  <c:v>2.3490045070648193</c:v>
                </c:pt>
                <c:pt idx="960">
                  <c:v>2.357288122177124</c:v>
                </c:pt>
                <c:pt idx="961">
                  <c:v>2.3655726909637451</c:v>
                </c:pt>
                <c:pt idx="962">
                  <c:v>2.3738560676574707</c:v>
                </c:pt>
                <c:pt idx="963">
                  <c:v>2.3821401596069336</c:v>
                </c:pt>
                <c:pt idx="964">
                  <c:v>2.3904237747192383</c:v>
                </c:pt>
                <c:pt idx="965">
                  <c:v>2.398707389831543</c:v>
                </c:pt>
                <c:pt idx="966">
                  <c:v>2.4069900512695313</c:v>
                </c:pt>
                <c:pt idx="967">
                  <c:v>2.4152743816375732</c:v>
                </c:pt>
                <c:pt idx="968">
                  <c:v>2.423558235168457</c:v>
                </c:pt>
                <c:pt idx="969">
                  <c:v>2.431842565536499</c:v>
                </c:pt>
                <c:pt idx="970">
                  <c:v>2.4401271343231201</c:v>
                </c:pt>
                <c:pt idx="971">
                  <c:v>2.4484124183654785</c:v>
                </c:pt>
                <c:pt idx="972">
                  <c:v>2.4566981792449951</c:v>
                </c:pt>
                <c:pt idx="973">
                  <c:v>2.4649853706359863</c:v>
                </c:pt>
                <c:pt idx="974">
                  <c:v>2.4732739925384521</c:v>
                </c:pt>
                <c:pt idx="975">
                  <c:v>2.4815647602081299</c:v>
                </c:pt>
                <c:pt idx="976">
                  <c:v>2.4898548126220703</c:v>
                </c:pt>
                <c:pt idx="977">
                  <c:v>2.4981472492218018</c:v>
                </c:pt>
                <c:pt idx="978">
                  <c:v>2.5064394474029541</c:v>
                </c:pt>
                <c:pt idx="979">
                  <c:v>2.5147354602813721</c:v>
                </c:pt>
                <c:pt idx="980">
                  <c:v>2.52303147315979</c:v>
                </c:pt>
                <c:pt idx="981">
                  <c:v>2.531329870223999</c:v>
                </c:pt>
                <c:pt idx="982">
                  <c:v>2.5396296977996826</c:v>
                </c:pt>
                <c:pt idx="983">
                  <c:v>2.5479326248168945</c:v>
                </c:pt>
                <c:pt idx="984">
                  <c:v>2.556236743927002</c:v>
                </c:pt>
                <c:pt idx="985">
                  <c:v>2.5645444393157959</c:v>
                </c:pt>
                <c:pt idx="986">
                  <c:v>2.5728540420532227</c:v>
                </c:pt>
                <c:pt idx="987">
                  <c:v>2.5811657905578613</c:v>
                </c:pt>
                <c:pt idx="988">
                  <c:v>2.5894796848297119</c:v>
                </c:pt>
                <c:pt idx="989">
                  <c:v>2.597797155380249</c:v>
                </c:pt>
                <c:pt idx="990">
                  <c:v>2.6061174869537354</c:v>
                </c:pt>
                <c:pt idx="991">
                  <c:v>2.6144413948059082</c:v>
                </c:pt>
                <c:pt idx="992">
                  <c:v>2.6227681636810303</c:v>
                </c:pt>
                <c:pt idx="993">
                  <c:v>2.6310985088348389</c:v>
                </c:pt>
                <c:pt idx="994">
                  <c:v>2.6394312381744385</c:v>
                </c:pt>
                <c:pt idx="995">
                  <c:v>2.6477675437927246</c:v>
                </c:pt>
                <c:pt idx="996">
                  <c:v>2.6561076641082764</c:v>
                </c:pt>
                <c:pt idx="997">
                  <c:v>2.6644518375396729</c:v>
                </c:pt>
                <c:pt idx="998">
                  <c:v>2.6728003025054932</c:v>
                </c:pt>
                <c:pt idx="999">
                  <c:v>2.68115234375</c:v>
                </c:pt>
                <c:pt idx="1000">
                  <c:v>2.6895089149475098</c:v>
                </c:pt>
                <c:pt idx="1001">
                  <c:v>2.6978690624237061</c:v>
                </c:pt>
                <c:pt idx="1002">
                  <c:v>2.7062342166900635</c:v>
                </c:pt>
                <c:pt idx="1003">
                  <c:v>2.7146024703979492</c:v>
                </c:pt>
                <c:pt idx="1004">
                  <c:v>2.7229769229888916</c:v>
                </c:pt>
                <c:pt idx="1005">
                  <c:v>2.7313556671142578</c:v>
                </c:pt>
                <c:pt idx="1006">
                  <c:v>2.7397391796112061</c:v>
                </c:pt>
                <c:pt idx="1007">
                  <c:v>2.7481274604797363</c:v>
                </c:pt>
                <c:pt idx="1008">
                  <c:v>2.7565217018127441</c:v>
                </c:pt>
                <c:pt idx="1009">
                  <c:v>2.7649190425872803</c:v>
                </c:pt>
                <c:pt idx="1010">
                  <c:v>2.7733237743377686</c:v>
                </c:pt>
                <c:pt idx="1011">
                  <c:v>2.7817313671112061</c:v>
                </c:pt>
                <c:pt idx="1012">
                  <c:v>2.7901453971862793</c:v>
                </c:pt>
                <c:pt idx="1013">
                  <c:v>2.7985646724700928</c:v>
                </c:pt>
                <c:pt idx="1014">
                  <c:v>2.8069906234741211</c:v>
                </c:pt>
                <c:pt idx="1015">
                  <c:v>2.8154215812683105</c:v>
                </c:pt>
                <c:pt idx="1016">
                  <c:v>2.8238601684570313</c:v>
                </c:pt>
                <c:pt idx="1017">
                  <c:v>2.8323044776916504</c:v>
                </c:pt>
                <c:pt idx="1018">
                  <c:v>2.8407549858093262</c:v>
                </c:pt>
                <c:pt idx="1019">
                  <c:v>2.8492109775543213</c:v>
                </c:pt>
                <c:pt idx="1020">
                  <c:v>2.8576738834381104</c:v>
                </c:pt>
                <c:pt idx="1021">
                  <c:v>2.8661432266235352</c:v>
                </c:pt>
                <c:pt idx="1022">
                  <c:v>2.8746190071105957</c:v>
                </c:pt>
                <c:pt idx="1023">
                  <c:v>2.8831014633178711</c:v>
                </c:pt>
                <c:pt idx="1024">
                  <c:v>2.8915905952453613</c:v>
                </c:pt>
                <c:pt idx="1025">
                  <c:v>2.9000866413116455</c:v>
                </c:pt>
                <c:pt idx="1026">
                  <c:v>2.908592700958252</c:v>
                </c:pt>
                <c:pt idx="1027">
                  <c:v>2.9171032905578613</c:v>
                </c:pt>
                <c:pt idx="1028">
                  <c:v>2.9256210327148438</c:v>
                </c:pt>
                <c:pt idx="1029">
                  <c:v>2.9341452121734619</c:v>
                </c:pt>
                <c:pt idx="1030">
                  <c:v>2.9426767826080322</c:v>
                </c:pt>
                <c:pt idx="1031">
                  <c:v>2.9512152671813965</c:v>
                </c:pt>
                <c:pt idx="1032">
                  <c:v>2.9597620964050293</c:v>
                </c:pt>
                <c:pt idx="1033">
                  <c:v>2.9683163166046143</c:v>
                </c:pt>
                <c:pt idx="1034">
                  <c:v>2.9768798351287842</c:v>
                </c:pt>
                <c:pt idx="1035">
                  <c:v>2.9854500293731689</c:v>
                </c:pt>
                <c:pt idx="1036">
                  <c:v>2.9940285682678223</c:v>
                </c:pt>
                <c:pt idx="1037">
                  <c:v>3.0026142597198486</c:v>
                </c:pt>
                <c:pt idx="1038">
                  <c:v>3.0112097263336182</c:v>
                </c:pt>
                <c:pt idx="1039">
                  <c:v>3.0198135375976563</c:v>
                </c:pt>
                <c:pt idx="1040">
                  <c:v>3.0284268856048584</c:v>
                </c:pt>
                <c:pt idx="1041">
                  <c:v>3.0370454788208008</c:v>
                </c:pt>
                <c:pt idx="1042">
                  <c:v>3.0456738471984863</c:v>
                </c:pt>
                <c:pt idx="1043">
                  <c:v>3.054309606552124</c:v>
                </c:pt>
                <c:pt idx="1044">
                  <c:v>3.0629556179046631</c:v>
                </c:pt>
                <c:pt idx="1045">
                  <c:v>3.0716090202331543</c:v>
                </c:pt>
                <c:pt idx="1046">
                  <c:v>3.0802700519561768</c:v>
                </c:pt>
                <c:pt idx="1047">
                  <c:v>3.0889396667480469</c:v>
                </c:pt>
                <c:pt idx="1048">
                  <c:v>3.0976183414459229</c:v>
                </c:pt>
                <c:pt idx="1049">
                  <c:v>3.1063051223754883</c:v>
                </c:pt>
                <c:pt idx="1050">
                  <c:v>3.1150016784667969</c:v>
                </c:pt>
                <c:pt idx="1051">
                  <c:v>3.1237063407897949</c:v>
                </c:pt>
                <c:pt idx="1052">
                  <c:v>3.1324186325073242</c:v>
                </c:pt>
                <c:pt idx="1053">
                  <c:v>3.1411383152008057</c:v>
                </c:pt>
                <c:pt idx="1054">
                  <c:v>3.1498661041259766</c:v>
                </c:pt>
                <c:pt idx="1055">
                  <c:v>3.1586024761199951</c:v>
                </c:pt>
                <c:pt idx="1056">
                  <c:v>3.1673476696014404</c:v>
                </c:pt>
                <c:pt idx="1057">
                  <c:v>3.1761009693145752</c:v>
                </c:pt>
                <c:pt idx="1058">
                  <c:v>3.1848640441894531</c:v>
                </c:pt>
                <c:pt idx="1059">
                  <c:v>3.1936368942260742</c:v>
                </c:pt>
                <c:pt idx="1060">
                  <c:v>3.202418327331543</c:v>
                </c:pt>
                <c:pt idx="1061">
                  <c:v>3.2112059593200684</c:v>
                </c:pt>
                <c:pt idx="1062">
                  <c:v>3.2200033664703369</c:v>
                </c:pt>
                <c:pt idx="1063">
                  <c:v>3.2288086414337158</c:v>
                </c:pt>
                <c:pt idx="1064">
                  <c:v>3.2376210689544678</c:v>
                </c:pt>
                <c:pt idx="1065">
                  <c:v>3.2464420795440674</c:v>
                </c:pt>
                <c:pt idx="1066">
                  <c:v>3.2552709579467773</c:v>
                </c:pt>
                <c:pt idx="1067">
                  <c:v>3.2641093730926514</c:v>
                </c:pt>
                <c:pt idx="1068">
                  <c:v>3.2729551792144775</c:v>
                </c:pt>
                <c:pt idx="1069">
                  <c:v>3.2818076610565186</c:v>
                </c:pt>
                <c:pt idx="1070">
                  <c:v>3.2906680107116699</c:v>
                </c:pt>
                <c:pt idx="1071">
                  <c:v>3.2995381355285645</c:v>
                </c:pt>
                <c:pt idx="1072">
                  <c:v>3.3084149360656738</c:v>
                </c:pt>
                <c:pt idx="1073">
                  <c:v>3.3173017501831055</c:v>
                </c:pt>
                <c:pt idx="1074">
                  <c:v>3.3261945247650146</c:v>
                </c:pt>
                <c:pt idx="1075">
                  <c:v>3.3350982666015625</c:v>
                </c:pt>
                <c:pt idx="1076">
                  <c:v>3.3440086841583252</c:v>
                </c:pt>
                <c:pt idx="1077">
                  <c:v>3.3529262542724609</c:v>
                </c:pt>
                <c:pt idx="1078">
                  <c:v>3.3618512153625488</c:v>
                </c:pt>
                <c:pt idx="1079">
                  <c:v>3.3707857131958008</c:v>
                </c:pt>
                <c:pt idx="1080">
                  <c:v>3.3797273635864258</c:v>
                </c:pt>
                <c:pt idx="1081">
                  <c:v>3.3886792659759521</c:v>
                </c:pt>
                <c:pt idx="1082">
                  <c:v>3.397636890411377</c:v>
                </c:pt>
                <c:pt idx="1083">
                  <c:v>3.4066038131713867</c:v>
                </c:pt>
                <c:pt idx="1084">
                  <c:v>3.4155786037445068</c:v>
                </c:pt>
                <c:pt idx="1085">
                  <c:v>3.4245619773864746</c:v>
                </c:pt>
                <c:pt idx="1086">
                  <c:v>3.4335513114929199</c:v>
                </c:pt>
                <c:pt idx="1087">
                  <c:v>3.4425513744354248</c:v>
                </c:pt>
                <c:pt idx="1088">
                  <c:v>3.4515552520751953</c:v>
                </c:pt>
                <c:pt idx="1089">
                  <c:v>3.4605710506439209</c:v>
                </c:pt>
                <c:pt idx="1090">
                  <c:v>3.4695925712585449</c:v>
                </c:pt>
                <c:pt idx="1091">
                  <c:v>3.4786229133605957</c:v>
                </c:pt>
                <c:pt idx="1092">
                  <c:v>3.4876611232757568</c:v>
                </c:pt>
                <c:pt idx="1093">
                  <c:v>3.4967076778411865</c:v>
                </c:pt>
                <c:pt idx="1094">
                  <c:v>3.5057601928710938</c:v>
                </c:pt>
                <c:pt idx="1095">
                  <c:v>3.5148220062255859</c:v>
                </c:pt>
                <c:pt idx="1096">
                  <c:v>3.5238907337188721</c:v>
                </c:pt>
                <c:pt idx="1097">
                  <c:v>3.5329699516296387</c:v>
                </c:pt>
                <c:pt idx="1098">
                  <c:v>3.5420541763305664</c:v>
                </c:pt>
                <c:pt idx="1099">
                  <c:v>3.5511484146118164</c:v>
                </c:pt>
                <c:pt idx="1100">
                  <c:v>3.5602502822875977</c:v>
                </c:pt>
                <c:pt idx="1101">
                  <c:v>3.5693612098693848</c:v>
                </c:pt>
                <c:pt idx="1102">
                  <c:v>3.5784778594970703</c:v>
                </c:pt>
                <c:pt idx="1103">
                  <c:v>3.5876026153564453</c:v>
                </c:pt>
                <c:pt idx="1104">
                  <c:v>3.5967347621917725</c:v>
                </c:pt>
                <c:pt idx="1105">
                  <c:v>3.6058759689331055</c:v>
                </c:pt>
                <c:pt idx="1106">
                  <c:v>3.6150250434875488</c:v>
                </c:pt>
                <c:pt idx="1107">
                  <c:v>3.6241824626922607</c:v>
                </c:pt>
                <c:pt idx="1108">
                  <c:v>3.6333475112915039</c:v>
                </c:pt>
                <c:pt idx="1109">
                  <c:v>3.6425189971923828</c:v>
                </c:pt>
                <c:pt idx="1110">
                  <c:v>3.6516971588134766</c:v>
                </c:pt>
                <c:pt idx="1111">
                  <c:v>3.6608850955963135</c:v>
                </c:pt>
                <c:pt idx="1112">
                  <c:v>3.6700809001922607</c:v>
                </c:pt>
                <c:pt idx="1113">
                  <c:v>3.6792848110198975</c:v>
                </c:pt>
                <c:pt idx="1114">
                  <c:v>3.6884965896606445</c:v>
                </c:pt>
                <c:pt idx="1115">
                  <c:v>3.6977164745330811</c:v>
                </c:pt>
                <c:pt idx="1116">
                  <c:v>3.7069451808929443</c:v>
                </c:pt>
                <c:pt idx="1117">
                  <c:v>3.7161819934844971</c:v>
                </c:pt>
                <c:pt idx="1118">
                  <c:v>3.7254242897033691</c:v>
                </c:pt>
                <c:pt idx="1119">
                  <c:v>3.7346756458282471</c:v>
                </c:pt>
                <c:pt idx="1120">
                  <c:v>3.743931770324707</c:v>
                </c:pt>
                <c:pt idx="1121">
                  <c:v>3.7531983852386475</c:v>
                </c:pt>
                <c:pt idx="1122">
                  <c:v>3.762470006942749</c:v>
                </c:pt>
                <c:pt idx="1123">
                  <c:v>3.7717516422271729</c:v>
                </c:pt>
                <c:pt idx="1124">
                  <c:v>3.7810409069061279</c:v>
                </c:pt>
                <c:pt idx="1125">
                  <c:v>3.790337085723877</c:v>
                </c:pt>
                <c:pt idx="1126">
                  <c:v>3.7996430397033691</c:v>
                </c:pt>
                <c:pt idx="1127">
                  <c:v>3.8089568614959717</c:v>
                </c:pt>
                <c:pt idx="1128">
                  <c:v>3.8182780742645264</c:v>
                </c:pt>
                <c:pt idx="1129">
                  <c:v>3.8276093006134033</c:v>
                </c:pt>
                <c:pt idx="1130">
                  <c:v>3.8369448184967041</c:v>
                </c:pt>
                <c:pt idx="1131">
                  <c:v>3.8462905883789063</c:v>
                </c:pt>
                <c:pt idx="1132">
                  <c:v>3.8556454181671143</c:v>
                </c:pt>
                <c:pt idx="1133">
                  <c:v>3.8650059700012207</c:v>
                </c:pt>
                <c:pt idx="1134">
                  <c:v>3.8743762969970703</c:v>
                </c:pt>
                <c:pt idx="1135">
                  <c:v>3.8837542533874512</c:v>
                </c:pt>
                <c:pt idx="1136">
                  <c:v>3.8931393623352051</c:v>
                </c:pt>
                <c:pt idx="1137">
                  <c:v>3.9025328159332275</c:v>
                </c:pt>
                <c:pt idx="1138">
                  <c:v>3.9119312763214111</c:v>
                </c:pt>
                <c:pt idx="1139">
                  <c:v>3.9213404655456543</c:v>
                </c:pt>
                <c:pt idx="1140">
                  <c:v>3.9307558536529541</c:v>
                </c:pt>
                <c:pt idx="1141">
                  <c:v>3.9401791095733643</c:v>
                </c:pt>
                <c:pt idx="1142">
                  <c:v>3.9496111869812012</c:v>
                </c:pt>
                <c:pt idx="1143">
                  <c:v>3.9590518474578857</c:v>
                </c:pt>
                <c:pt idx="1144">
                  <c:v>3.9684984683990479</c:v>
                </c:pt>
                <c:pt idx="1145">
                  <c:v>3.9779551029205322</c:v>
                </c:pt>
                <c:pt idx="1146">
                  <c:v>3.9874186515808105</c:v>
                </c:pt>
                <c:pt idx="1147">
                  <c:v>3.9968914985656738</c:v>
                </c:pt>
                <c:pt idx="1148">
                  <c:v>4.0063719749450684</c:v>
                </c:pt>
                <c:pt idx="1149">
                  <c:v>4.0158596038818359</c:v>
                </c:pt>
                <c:pt idx="1150">
                  <c:v>4.0253543853759766</c:v>
                </c:pt>
                <c:pt idx="1151">
                  <c:v>4.0348577499389648</c:v>
                </c:pt>
                <c:pt idx="1152">
                  <c:v>4.0443687438964844</c:v>
                </c:pt>
                <c:pt idx="1153">
                  <c:v>4.0538878440856934</c:v>
                </c:pt>
                <c:pt idx="1154">
                  <c:v>4.0634140968322754</c:v>
                </c:pt>
                <c:pt idx="1155">
                  <c:v>4.0729508399963379</c:v>
                </c:pt>
                <c:pt idx="1156">
                  <c:v>4.0824933052062988</c:v>
                </c:pt>
                <c:pt idx="1157">
                  <c:v>4.0920448303222656</c:v>
                </c:pt>
                <c:pt idx="1158">
                  <c:v>4.1016035079956055</c:v>
                </c:pt>
                <c:pt idx="1159">
                  <c:v>4.111170768737793</c:v>
                </c:pt>
                <c:pt idx="1160">
                  <c:v>4.1207447052001953</c:v>
                </c:pt>
                <c:pt idx="1161">
                  <c:v>4.1303277015686035</c:v>
                </c:pt>
                <c:pt idx="1162">
                  <c:v>4.1399188041687012</c:v>
                </c:pt>
                <c:pt idx="1163">
                  <c:v>4.1495170593261719</c:v>
                </c:pt>
                <c:pt idx="1164">
                  <c:v>4.1591224670410156</c:v>
                </c:pt>
                <c:pt idx="1165">
                  <c:v>4.1687378883361816</c:v>
                </c:pt>
                <c:pt idx="1166">
                  <c:v>4.1783604621887207</c:v>
                </c:pt>
                <c:pt idx="1167">
                  <c:v>4.1879911422729492</c:v>
                </c:pt>
                <c:pt idx="1168">
                  <c:v>4.1976308822631836</c:v>
                </c:pt>
                <c:pt idx="1169">
                  <c:v>4.2072772979736328</c:v>
                </c:pt>
                <c:pt idx="1170">
                  <c:v>4.2169313430786133</c:v>
                </c:pt>
                <c:pt idx="1171">
                  <c:v>4.2265934944152832</c:v>
                </c:pt>
                <c:pt idx="1172">
                  <c:v>4.236264705657959</c:v>
                </c:pt>
                <c:pt idx="1173">
                  <c:v>4.2459430694580078</c:v>
                </c:pt>
                <c:pt idx="1174">
                  <c:v>4.2556295394897461</c:v>
                </c:pt>
                <c:pt idx="1175">
                  <c:v>4.2653241157531738</c:v>
                </c:pt>
                <c:pt idx="1176">
                  <c:v>4.2750263214111328</c:v>
                </c:pt>
                <c:pt idx="1177">
                  <c:v>4.2847356796264648</c:v>
                </c:pt>
                <c:pt idx="1178">
                  <c:v>4.2944536209106445</c:v>
                </c:pt>
                <c:pt idx="1179">
                  <c:v>4.3041801452636719</c:v>
                </c:pt>
                <c:pt idx="1180">
                  <c:v>4.3139147758483887</c:v>
                </c:pt>
                <c:pt idx="1181">
                  <c:v>4.3236565589904785</c:v>
                </c:pt>
                <c:pt idx="1182">
                  <c:v>4.3334083557128906</c:v>
                </c:pt>
                <c:pt idx="1183">
                  <c:v>4.3431673049926758</c:v>
                </c:pt>
                <c:pt idx="1184">
                  <c:v>4.3529329299926758</c:v>
                </c:pt>
                <c:pt idx="1185">
                  <c:v>4.3627076148986816</c:v>
                </c:pt>
                <c:pt idx="1186">
                  <c:v>4.3724913597106934</c:v>
                </c:pt>
                <c:pt idx="1187">
                  <c:v>4.3822832107543945</c:v>
                </c:pt>
                <c:pt idx="1188">
                  <c:v>4.392082691192627</c:v>
                </c:pt>
                <c:pt idx="1189">
                  <c:v>4.4018902778625488</c:v>
                </c:pt>
                <c:pt idx="1190">
                  <c:v>4.4117064476013184</c:v>
                </c:pt>
                <c:pt idx="1191">
                  <c:v>4.4215316772460938</c:v>
                </c:pt>
                <c:pt idx="1192">
                  <c:v>4.4313640594482422</c:v>
                </c:pt>
                <c:pt idx="1193">
                  <c:v>4.4412055015563965</c:v>
                </c:pt>
                <c:pt idx="1194">
                  <c:v>4.4510550498962402</c:v>
                </c:pt>
                <c:pt idx="1195">
                  <c:v>4.4609136581420898</c:v>
                </c:pt>
                <c:pt idx="1196">
                  <c:v>4.4707798957824707</c:v>
                </c:pt>
                <c:pt idx="1197">
                  <c:v>4.480654239654541</c:v>
                </c:pt>
                <c:pt idx="1198">
                  <c:v>4.4905366897583008</c:v>
                </c:pt>
                <c:pt idx="1199">
                  <c:v>4.5004277229309082</c:v>
                </c:pt>
                <c:pt idx="1200">
                  <c:v>4.5103263854980469</c:v>
                </c:pt>
                <c:pt idx="1201">
                  <c:v>4.5202341079711914</c:v>
                </c:pt>
                <c:pt idx="1202">
                  <c:v>4.5301499366760254</c:v>
                </c:pt>
                <c:pt idx="1203">
                  <c:v>4.5400738716125488</c:v>
                </c:pt>
                <c:pt idx="1204">
                  <c:v>4.5500063896179199</c:v>
                </c:pt>
                <c:pt idx="1205">
                  <c:v>4.5599470138549805</c:v>
                </c:pt>
                <c:pt idx="1206">
                  <c:v>4.5698962211608887</c:v>
                </c:pt>
                <c:pt idx="1207">
                  <c:v>4.5798535346984863</c:v>
                </c:pt>
                <c:pt idx="1208">
                  <c:v>4.5898194313049316</c:v>
                </c:pt>
                <c:pt idx="1209">
                  <c:v>4.5997934341430664</c:v>
                </c:pt>
                <c:pt idx="1210">
                  <c:v>4.6097755432128906</c:v>
                </c:pt>
                <c:pt idx="1211">
                  <c:v>4.6197662353515625</c:v>
                </c:pt>
                <c:pt idx="1212">
                  <c:v>4.629765510559082</c:v>
                </c:pt>
                <c:pt idx="1213">
                  <c:v>4.639772891998291</c:v>
                </c:pt>
                <c:pt idx="1214">
                  <c:v>4.6497888565063477</c:v>
                </c:pt>
                <c:pt idx="1215">
                  <c:v>4.6598129272460938</c:v>
                </c:pt>
                <c:pt idx="1216">
                  <c:v>4.6698455810546875</c:v>
                </c:pt>
                <c:pt idx="1217">
                  <c:v>4.6798868179321289</c:v>
                </c:pt>
                <c:pt idx="1218">
                  <c:v>4.6899361610412598</c:v>
                </c:pt>
                <c:pt idx="1219">
                  <c:v>4.6999940872192383</c:v>
                </c:pt>
                <c:pt idx="1220">
                  <c:v>4.7100605964660645</c:v>
                </c:pt>
                <c:pt idx="1221">
                  <c:v>4.7201356887817383</c:v>
                </c:pt>
                <c:pt idx="1222">
                  <c:v>4.7302188873291016</c:v>
                </c:pt>
                <c:pt idx="1223">
                  <c:v>4.7403106689453125</c:v>
                </c:pt>
                <c:pt idx="1224">
                  <c:v>4.7504110336303711</c:v>
                </c:pt>
                <c:pt idx="1225">
                  <c:v>4.7605195045471191</c:v>
                </c:pt>
                <c:pt idx="1226">
                  <c:v>4.7706365585327148</c:v>
                </c:pt>
                <c:pt idx="1227">
                  <c:v>4.7807621955871582</c:v>
                </c:pt>
                <c:pt idx="1228">
                  <c:v>4.7908964157104492</c:v>
                </c:pt>
                <c:pt idx="1229">
                  <c:v>4.8010396957397461</c:v>
                </c:pt>
                <c:pt idx="1230">
                  <c:v>4.8111910820007324</c:v>
                </c:pt>
                <c:pt idx="1231">
                  <c:v>4.8213510513305664</c:v>
                </c:pt>
                <c:pt idx="1232">
                  <c:v>4.831519603729248</c:v>
                </c:pt>
                <c:pt idx="1233">
                  <c:v>4.8416967391967773</c:v>
                </c:pt>
                <c:pt idx="1234">
                  <c:v>4.8518824577331543</c:v>
                </c:pt>
                <c:pt idx="1235">
                  <c:v>4.8620767593383789</c:v>
                </c:pt>
                <c:pt idx="1236">
                  <c:v>4.8722796440124512</c:v>
                </c:pt>
                <c:pt idx="1237">
                  <c:v>4.8824911117553711</c:v>
                </c:pt>
                <c:pt idx="1238">
                  <c:v>4.8927111625671387</c:v>
                </c:pt>
                <c:pt idx="1239">
                  <c:v>4.9029402732849121</c:v>
                </c:pt>
                <c:pt idx="1240">
                  <c:v>4.913177490234375</c:v>
                </c:pt>
                <c:pt idx="1241">
                  <c:v>4.9234237670898438</c:v>
                </c:pt>
                <c:pt idx="1242">
                  <c:v>4.9336786270141602</c:v>
                </c:pt>
                <c:pt idx="1243">
                  <c:v>4.9439420700073242</c:v>
                </c:pt>
                <c:pt idx="1244">
                  <c:v>4.9542145729064941</c:v>
                </c:pt>
                <c:pt idx="1245">
                  <c:v>4.9644951820373535</c:v>
                </c:pt>
                <c:pt idx="1246">
                  <c:v>4.9747848510742188</c:v>
                </c:pt>
                <c:pt idx="1247">
                  <c:v>4.9850831031799316</c:v>
                </c:pt>
                <c:pt idx="1248">
                  <c:v>4.9953904151916504</c:v>
                </c:pt>
                <c:pt idx="1249">
                  <c:v>5.0057063102722168</c:v>
                </c:pt>
                <c:pt idx="1250">
                  <c:v>5.0160307884216309</c:v>
                </c:pt>
                <c:pt idx="1251">
                  <c:v>5.0263638496398926</c:v>
                </c:pt>
                <c:pt idx="1252">
                  <c:v>5.036705493927002</c:v>
                </c:pt>
                <c:pt idx="1253">
                  <c:v>5.0470561981201172</c:v>
                </c:pt>
                <c:pt idx="1254">
                  <c:v>5.0574150085449219</c:v>
                </c:pt>
                <c:pt idx="1255">
                  <c:v>5.0677824020385742</c:v>
                </c:pt>
                <c:pt idx="1256">
                  <c:v>5.0781583786010742</c:v>
                </c:pt>
                <c:pt idx="1257">
                  <c:v>5.0885429382324219</c:v>
                </c:pt>
                <c:pt idx="1258">
                  <c:v>5.098935604095459</c:v>
                </c:pt>
                <c:pt idx="1259">
                  <c:v>5.1093368530273438</c:v>
                </c:pt>
                <c:pt idx="1260">
                  <c:v>5.119746208190918</c:v>
                </c:pt>
                <c:pt idx="1261">
                  <c:v>5.1301641464233398</c:v>
                </c:pt>
                <c:pt idx="1262">
                  <c:v>5.1405901908874512</c:v>
                </c:pt>
                <c:pt idx="1263">
                  <c:v>5.151024341583252</c:v>
                </c:pt>
                <c:pt idx="1264">
                  <c:v>5.1614665985107422</c:v>
                </c:pt>
                <c:pt idx="1265">
                  <c:v>5.1719174385070801</c:v>
                </c:pt>
                <c:pt idx="1266">
                  <c:v>5.1823763847351074</c:v>
                </c:pt>
                <c:pt idx="1267">
                  <c:v>5.1928424835205078</c:v>
                </c:pt>
                <c:pt idx="1268">
                  <c:v>5.2033171653747559</c:v>
                </c:pt>
                <c:pt idx="1269">
                  <c:v>5.2137994766235352</c:v>
                </c:pt>
                <c:pt idx="1270">
                  <c:v>5.2242894172668457</c:v>
                </c:pt>
                <c:pt idx="1271">
                  <c:v>5.2347874641418457</c:v>
                </c:pt>
                <c:pt idx="1272">
                  <c:v>5.2452940940856934</c:v>
                </c:pt>
                <c:pt idx="1273">
                  <c:v>5.2558078765869141</c:v>
                </c:pt>
                <c:pt idx="1274">
                  <c:v>5.266329288482666</c:v>
                </c:pt>
                <c:pt idx="1275">
                  <c:v>5.2768588066101074</c:v>
                </c:pt>
                <c:pt idx="1276">
                  <c:v>5.2873954772949219</c:v>
                </c:pt>
                <c:pt idx="1277">
                  <c:v>5.2979397773742676</c:v>
                </c:pt>
                <c:pt idx="1278">
                  <c:v>5.3084917068481445</c:v>
                </c:pt>
                <c:pt idx="1279">
                  <c:v>5.3190512657165527</c:v>
                </c:pt>
                <c:pt idx="1280">
                  <c:v>5.3296184539794922</c:v>
                </c:pt>
                <c:pt idx="1281">
                  <c:v>5.3401927947998047</c:v>
                </c:pt>
                <c:pt idx="1282">
                  <c:v>5.3507747650146484</c:v>
                </c:pt>
                <c:pt idx="1283">
                  <c:v>5.3613638877868652</c:v>
                </c:pt>
                <c:pt idx="1284">
                  <c:v>5.3719606399536133</c:v>
                </c:pt>
                <c:pt idx="1285">
                  <c:v>5.3825645446777344</c:v>
                </c:pt>
                <c:pt idx="1286">
                  <c:v>5.3931756019592285</c:v>
                </c:pt>
                <c:pt idx="1287">
                  <c:v>5.4037933349609375</c:v>
                </c:pt>
                <c:pt idx="1288">
                  <c:v>5.4144191741943359</c:v>
                </c:pt>
                <c:pt idx="1289">
                  <c:v>5.425051212310791</c:v>
                </c:pt>
                <c:pt idx="1290">
                  <c:v>5.4356908798217773</c:v>
                </c:pt>
                <c:pt idx="1291">
                  <c:v>5.4463381767272949</c:v>
                </c:pt>
                <c:pt idx="1292">
                  <c:v>5.4569931030273438</c:v>
                </c:pt>
                <c:pt idx="1293">
                  <c:v>5.467653751373291</c:v>
                </c:pt>
                <c:pt idx="1294">
                  <c:v>5.4783215522766113</c:v>
                </c:pt>
                <c:pt idx="1295">
                  <c:v>5.4889960289001465</c:v>
                </c:pt>
                <c:pt idx="1296">
                  <c:v>5.4996776580810547</c:v>
                </c:pt>
                <c:pt idx="1297">
                  <c:v>5.5103659629821777</c:v>
                </c:pt>
                <c:pt idx="1298">
                  <c:v>5.5210614204406738</c:v>
                </c:pt>
                <c:pt idx="1299">
                  <c:v>5.5317630767822266</c:v>
                </c:pt>
                <c:pt idx="1300">
                  <c:v>5.5424714088439941</c:v>
                </c:pt>
                <c:pt idx="1301">
                  <c:v>5.553187370300293</c:v>
                </c:pt>
                <c:pt idx="1302">
                  <c:v>5.5639100074768066</c:v>
                </c:pt>
                <c:pt idx="1303">
                  <c:v>5.574638843536377</c:v>
                </c:pt>
                <c:pt idx="1304">
                  <c:v>5.5853748321533203</c:v>
                </c:pt>
                <c:pt idx="1305">
                  <c:v>5.5961165428161621</c:v>
                </c:pt>
                <c:pt idx="1306">
                  <c:v>5.6068649291992188</c:v>
                </c:pt>
                <c:pt idx="1307">
                  <c:v>5.617619514465332</c:v>
                </c:pt>
                <c:pt idx="1308">
                  <c:v>5.6283812522888184</c:v>
                </c:pt>
                <c:pt idx="1309">
                  <c:v>5.6391496658325195</c:v>
                </c:pt>
                <c:pt idx="1310">
                  <c:v>5.6499233245849609</c:v>
                </c:pt>
                <c:pt idx="1311">
                  <c:v>5.6607041358947754</c:v>
                </c:pt>
                <c:pt idx="1312">
                  <c:v>5.6714897155761719</c:v>
                </c:pt>
                <c:pt idx="1313">
                  <c:v>5.6822829246520996</c:v>
                </c:pt>
                <c:pt idx="1314">
                  <c:v>5.6930818557739258</c:v>
                </c:pt>
                <c:pt idx="1315">
                  <c:v>5.7038865089416504</c:v>
                </c:pt>
                <c:pt idx="1316">
                  <c:v>5.7146973609924316</c:v>
                </c:pt>
                <c:pt idx="1317">
                  <c:v>5.7255148887634277</c:v>
                </c:pt>
                <c:pt idx="1318">
                  <c:v>5.7363371849060059</c:v>
                </c:pt>
                <c:pt idx="1319">
                  <c:v>5.7471671104431152</c:v>
                </c:pt>
                <c:pt idx="1320">
                  <c:v>5.7580018043518066</c:v>
                </c:pt>
                <c:pt idx="1321">
                  <c:v>5.7688422203063965</c:v>
                </c:pt>
                <c:pt idx="1322">
                  <c:v>5.779688835144043</c:v>
                </c:pt>
                <c:pt idx="1323">
                  <c:v>5.7905421257019043</c:v>
                </c:pt>
                <c:pt idx="1324">
                  <c:v>5.8014011383056641</c:v>
                </c:pt>
                <c:pt idx="1325">
                  <c:v>5.8122663497924805</c:v>
                </c:pt>
                <c:pt idx="1326">
                  <c:v>5.8231363296508789</c:v>
                </c:pt>
                <c:pt idx="1327">
                  <c:v>5.8340115547180176</c:v>
                </c:pt>
                <c:pt idx="1328">
                  <c:v>5.8448925018310547</c:v>
                </c:pt>
                <c:pt idx="1329">
                  <c:v>5.855781078338623</c:v>
                </c:pt>
                <c:pt idx="1330">
                  <c:v>5.8666729927062988</c:v>
                </c:pt>
                <c:pt idx="1331">
                  <c:v>5.8775715827941895</c:v>
                </c:pt>
                <c:pt idx="1332">
                  <c:v>5.8884754180908203</c:v>
                </c:pt>
                <c:pt idx="1333">
                  <c:v>5.8993849754333496</c:v>
                </c:pt>
                <c:pt idx="1334">
                  <c:v>5.9102997779846191</c:v>
                </c:pt>
                <c:pt idx="1335">
                  <c:v>5.9212203025817871</c:v>
                </c:pt>
                <c:pt idx="1336">
                  <c:v>5.9321470260620117</c:v>
                </c:pt>
                <c:pt idx="1337">
                  <c:v>5.9430770874023438</c:v>
                </c:pt>
                <c:pt idx="1338">
                  <c:v>5.954012393951416</c:v>
                </c:pt>
                <c:pt idx="1339">
                  <c:v>5.9649543762207031</c:v>
                </c:pt>
                <c:pt idx="1340">
                  <c:v>5.9759011268615723</c:v>
                </c:pt>
                <c:pt idx="1341">
                  <c:v>5.9868531227111816</c:v>
                </c:pt>
                <c:pt idx="1342">
                  <c:v>5.9978103637695313</c:v>
                </c:pt>
                <c:pt idx="1343">
                  <c:v>6.0087704658508301</c:v>
                </c:pt>
                <c:pt idx="1344">
                  <c:v>6.0197362899780273</c:v>
                </c:pt>
                <c:pt idx="1345">
                  <c:v>6.030707836151123</c:v>
                </c:pt>
                <c:pt idx="1346">
                  <c:v>6.0416836738586426</c:v>
                </c:pt>
                <c:pt idx="1347">
                  <c:v>6.0526657104492188</c:v>
                </c:pt>
                <c:pt idx="1348">
                  <c:v>6.0636544227600098</c:v>
                </c:pt>
                <c:pt idx="1349">
                  <c:v>6.0746474266052246</c:v>
                </c:pt>
                <c:pt idx="1350">
                  <c:v>6.0856432914733887</c:v>
                </c:pt>
                <c:pt idx="1351">
                  <c:v>6.0966472625732422</c:v>
                </c:pt>
                <c:pt idx="1352">
                  <c:v>6.1076545715332031</c:v>
                </c:pt>
                <c:pt idx="1353">
                  <c:v>6.1186647415161133</c:v>
                </c:pt>
                <c:pt idx="1354">
                  <c:v>6.1296830177307129</c:v>
                </c:pt>
                <c:pt idx="1355">
                  <c:v>6.1407041549682617</c:v>
                </c:pt>
                <c:pt idx="1356">
                  <c:v>6.1517305374145508</c:v>
                </c:pt>
                <c:pt idx="1357">
                  <c:v>6.1627602577209473</c:v>
                </c:pt>
                <c:pt idx="1358">
                  <c:v>6.1737995147705078</c:v>
                </c:pt>
                <c:pt idx="1359">
                  <c:v>6.184840202331543</c:v>
                </c:pt>
                <c:pt idx="1360">
                  <c:v>6.1958861351013184</c:v>
                </c:pt>
                <c:pt idx="1361">
                  <c:v>6.2069344520568848</c:v>
                </c:pt>
                <c:pt idx="1362">
                  <c:v>6.2179899215698242</c:v>
                </c:pt>
                <c:pt idx="1363">
                  <c:v>6.2290482521057129</c:v>
                </c:pt>
                <c:pt idx="1364">
                  <c:v>6.2401151657104492</c:v>
                </c:pt>
                <c:pt idx="1365">
                  <c:v>6.2511820793151855</c:v>
                </c:pt>
                <c:pt idx="1366">
                  <c:v>6.2622551918029785</c:v>
                </c:pt>
                <c:pt idx="1367">
                  <c:v>6.2733316421508789</c:v>
                </c:pt>
                <c:pt idx="1368">
                  <c:v>6.2844109535217285</c:v>
                </c:pt>
                <c:pt idx="1369">
                  <c:v>6.2954955101013184</c:v>
                </c:pt>
                <c:pt idx="1370">
                  <c:v>6.3065834045410156</c:v>
                </c:pt>
                <c:pt idx="1371">
                  <c:v>6.3176722526550293</c:v>
                </c:pt>
                <c:pt idx="1372">
                  <c:v>6.3287668228149414</c:v>
                </c:pt>
                <c:pt idx="1373">
                  <c:v>6.3398637771606445</c:v>
                </c:pt>
                <c:pt idx="1374">
                  <c:v>6.3509659767150879</c:v>
                </c:pt>
                <c:pt idx="1375">
                  <c:v>6.3620729446411133</c:v>
                </c:pt>
                <c:pt idx="1376">
                  <c:v>6.3731851577758789</c:v>
                </c:pt>
                <c:pt idx="1377">
                  <c:v>6.3843002319335938</c:v>
                </c:pt>
                <c:pt idx="1378">
                  <c:v>6.3954200744628906</c:v>
                </c:pt>
                <c:pt idx="1379">
                  <c:v>6.4065403938293457</c:v>
                </c:pt>
                <c:pt idx="1380">
                  <c:v>6.4176673889160156</c:v>
                </c:pt>
                <c:pt idx="1381">
                  <c:v>6.4287986755371094</c:v>
                </c:pt>
                <c:pt idx="1382">
                  <c:v>6.4399333000183105</c:v>
                </c:pt>
                <c:pt idx="1383">
                  <c:v>6.4510717391967773</c:v>
                </c:pt>
                <c:pt idx="1384">
                  <c:v>6.4622159004211426</c:v>
                </c:pt>
                <c:pt idx="1385">
                  <c:v>6.473362922668457</c:v>
                </c:pt>
                <c:pt idx="1386">
                  <c:v>6.4845128059387207</c:v>
                </c:pt>
                <c:pt idx="1387">
                  <c:v>6.495668888092041</c:v>
                </c:pt>
                <c:pt idx="1388">
                  <c:v>6.5068302154541016</c:v>
                </c:pt>
                <c:pt idx="1389">
                  <c:v>6.5179920196533203</c:v>
                </c:pt>
                <c:pt idx="1390">
                  <c:v>6.5291595458984375</c:v>
                </c:pt>
                <c:pt idx="1391">
                  <c:v>6.5403299331665039</c:v>
                </c:pt>
                <c:pt idx="1392">
                  <c:v>6.5515041351318359</c:v>
                </c:pt>
                <c:pt idx="1393">
                  <c:v>6.5626821517944336</c:v>
                </c:pt>
                <c:pt idx="1394">
                  <c:v>6.5738649368286133</c:v>
                </c:pt>
                <c:pt idx="1395">
                  <c:v>6.5850491523742676</c:v>
                </c:pt>
                <c:pt idx="1396">
                  <c:v>6.5962357521057129</c:v>
                </c:pt>
                <c:pt idx="1397">
                  <c:v>6.6074280738830566</c:v>
                </c:pt>
                <c:pt idx="1398">
                  <c:v>6.6186232566833496</c:v>
                </c:pt>
                <c:pt idx="1399">
                  <c:v>6.6298184394836426</c:v>
                </c:pt>
                <c:pt idx="1400">
                  <c:v>6.6410183906555176</c:v>
                </c:pt>
                <c:pt idx="1401">
                  <c:v>6.6522212028503418</c:v>
                </c:pt>
                <c:pt idx="1402">
                  <c:v>6.6634268760681152</c:v>
                </c:pt>
                <c:pt idx="1403">
                  <c:v>6.6746349334716797</c:v>
                </c:pt>
                <c:pt idx="1404">
                  <c:v>6.6858453750610352</c:v>
                </c:pt>
                <c:pt idx="1405">
                  <c:v>6.6970601081848145</c:v>
                </c:pt>
                <c:pt idx="1406">
                  <c:v>6.7082767486572266</c:v>
                </c:pt>
                <c:pt idx="1407">
                  <c:v>6.7194943428039551</c:v>
                </c:pt>
                <c:pt idx="1408">
                  <c:v>6.7307147979736328</c:v>
                </c:pt>
                <c:pt idx="1409">
                  <c:v>6.7419395446777344</c:v>
                </c:pt>
                <c:pt idx="1410">
                  <c:v>6.7531652450561523</c:v>
                </c:pt>
                <c:pt idx="1411">
                  <c:v>6.7643952369689941</c:v>
                </c:pt>
                <c:pt idx="1412">
                  <c:v>6.7756285667419434</c:v>
                </c:pt>
                <c:pt idx="1413">
                  <c:v>6.786865234375</c:v>
                </c:pt>
                <c:pt idx="1414">
                  <c:v>6.7981038093566895</c:v>
                </c:pt>
                <c:pt idx="1415">
                  <c:v>6.8093461990356445</c:v>
                </c:pt>
                <c:pt idx="1416">
                  <c:v>6.820589542388916</c:v>
                </c:pt>
                <c:pt idx="1417">
                  <c:v>6.8318362236022949</c:v>
                </c:pt>
                <c:pt idx="1418">
                  <c:v>6.8430871963500977</c:v>
                </c:pt>
                <c:pt idx="1419">
                  <c:v>6.8543415069580078</c:v>
                </c:pt>
                <c:pt idx="1420">
                  <c:v>6.8655953407287598</c:v>
                </c:pt>
                <c:pt idx="1421">
                  <c:v>6.8768515586853027</c:v>
                </c:pt>
                <c:pt idx="1422">
                  <c:v>6.8881106376647949</c:v>
                </c:pt>
                <c:pt idx="1423">
                  <c:v>6.8993706703186035</c:v>
                </c:pt>
                <c:pt idx="1424">
                  <c:v>6.9106345176696777</c:v>
                </c:pt>
                <c:pt idx="1425">
                  <c:v>6.9218993186950684</c:v>
                </c:pt>
                <c:pt idx="1426">
                  <c:v>6.9331660270690918</c:v>
                </c:pt>
                <c:pt idx="1427">
                  <c:v>6.9444355964660645</c:v>
                </c:pt>
                <c:pt idx="1428">
                  <c:v>6.9557061195373535</c:v>
                </c:pt>
                <c:pt idx="1429">
                  <c:v>6.9669790267944336</c:v>
                </c:pt>
                <c:pt idx="1430">
                  <c:v>6.9782528877258301</c:v>
                </c:pt>
                <c:pt idx="1431">
                  <c:v>6.9895296096801758</c:v>
                </c:pt>
                <c:pt idx="1432">
                  <c:v>7.0008072853088379</c:v>
                </c:pt>
                <c:pt idx="1433">
                  <c:v>7.012087345123291</c:v>
                </c:pt>
                <c:pt idx="1434">
                  <c:v>7.0233674049377441</c:v>
                </c:pt>
                <c:pt idx="1435">
                  <c:v>7.0346498489379883</c:v>
                </c:pt>
                <c:pt idx="1436">
                  <c:v>7.0459332466125488</c:v>
                </c:pt>
                <c:pt idx="1437">
                  <c:v>7.0572199821472168</c:v>
                </c:pt>
                <c:pt idx="1438">
                  <c:v>7.0685081481933594</c:v>
                </c:pt>
                <c:pt idx="1439">
                  <c:v>7.079798698425293</c:v>
                </c:pt>
                <c:pt idx="1440">
                  <c:v>7.091090202331543</c:v>
                </c:pt>
                <c:pt idx="1441">
                  <c:v>7.1023836135864258</c:v>
                </c:pt>
                <c:pt idx="1442">
                  <c:v>7.1136784553527832</c:v>
                </c:pt>
                <c:pt idx="1443">
                  <c:v>7.1249756813049316</c:v>
                </c:pt>
                <c:pt idx="1444">
                  <c:v>7.1362743377685547</c:v>
                </c:pt>
                <c:pt idx="1445">
                  <c:v>7.1475749015808105</c:v>
                </c:pt>
                <c:pt idx="1446">
                  <c:v>7.1588778495788574</c:v>
                </c:pt>
                <c:pt idx="1447">
                  <c:v>7.1701822280883789</c:v>
                </c:pt>
                <c:pt idx="1448">
                  <c:v>7.181488037109375</c:v>
                </c:pt>
                <c:pt idx="1449">
                  <c:v>7.1927952766418457</c:v>
                </c:pt>
                <c:pt idx="1450">
                  <c:v>7.2041044235229492</c:v>
                </c:pt>
                <c:pt idx="1451">
                  <c:v>7.215416431427002</c:v>
                </c:pt>
                <c:pt idx="1452">
                  <c:v>7.2267289161682129</c:v>
                </c:pt>
                <c:pt idx="1453">
                  <c:v>7.2380433082580566</c:v>
                </c:pt>
                <c:pt idx="1454">
                  <c:v>7.249359130859375</c:v>
                </c:pt>
                <c:pt idx="1455">
                  <c:v>7.2606773376464844</c:v>
                </c:pt>
                <c:pt idx="1456">
                  <c:v>7.2719969749450684</c:v>
                </c:pt>
                <c:pt idx="1457">
                  <c:v>7.2833194732666016</c:v>
                </c:pt>
                <c:pt idx="1458">
                  <c:v>7.294642448425293</c:v>
                </c:pt>
                <c:pt idx="1459">
                  <c:v>7.3059682846069336</c:v>
                </c:pt>
                <c:pt idx="1460">
                  <c:v>7.317296028137207</c:v>
                </c:pt>
                <c:pt idx="1461">
                  <c:v>7.3286256790161133</c:v>
                </c:pt>
                <c:pt idx="1462">
                  <c:v>7.3399562835693359</c:v>
                </c:pt>
                <c:pt idx="1463">
                  <c:v>7.3512892723083496</c:v>
                </c:pt>
                <c:pt idx="1464">
                  <c:v>7.3626241683959961</c:v>
                </c:pt>
                <c:pt idx="1465">
                  <c:v>7.3739609718322754</c:v>
                </c:pt>
                <c:pt idx="1466">
                  <c:v>7.3852996826171875</c:v>
                </c:pt>
                <c:pt idx="1467">
                  <c:v>7.3966398239135742</c:v>
                </c:pt>
                <c:pt idx="1468">
                  <c:v>7.4079809188842773</c:v>
                </c:pt>
                <c:pt idx="1469">
                  <c:v>7.4193248748779297</c:v>
                </c:pt>
                <c:pt idx="1470">
                  <c:v>7.4306697845458984</c:v>
                </c:pt>
                <c:pt idx="1471">
                  <c:v>7.4420175552368164</c:v>
                </c:pt>
                <c:pt idx="1472">
                  <c:v>7.4533662796020508</c:v>
                </c:pt>
                <c:pt idx="1473">
                  <c:v>7.464716911315918</c:v>
                </c:pt>
                <c:pt idx="1474">
                  <c:v>7.4760689735412598</c:v>
                </c:pt>
                <c:pt idx="1475">
                  <c:v>7.4874238967895508</c:v>
                </c:pt>
                <c:pt idx="1476">
                  <c:v>7.4987797737121582</c:v>
                </c:pt>
                <c:pt idx="1477">
                  <c:v>7.5101385116577148</c:v>
                </c:pt>
                <c:pt idx="1478">
                  <c:v>7.5214982032775879</c:v>
                </c:pt>
                <c:pt idx="1479">
                  <c:v>7.532860279083252</c:v>
                </c:pt>
                <c:pt idx="1480">
                  <c:v>7.5442237854003906</c:v>
                </c:pt>
                <c:pt idx="1481">
                  <c:v>7.5555896759033203</c:v>
                </c:pt>
                <c:pt idx="1482">
                  <c:v>7.5669569969177246</c:v>
                </c:pt>
                <c:pt idx="1483">
                  <c:v>7.5783257484436035</c:v>
                </c:pt>
                <c:pt idx="1484">
                  <c:v>7.5896964073181152</c:v>
                </c:pt>
                <c:pt idx="1485">
                  <c:v>7.601069450378418</c:v>
                </c:pt>
                <c:pt idx="1486">
                  <c:v>7.6124444007873535</c:v>
                </c:pt>
                <c:pt idx="1487">
                  <c:v>7.6238217353820801</c:v>
                </c:pt>
                <c:pt idx="1488">
                  <c:v>7.6352005004882813</c:v>
                </c:pt>
                <c:pt idx="1489">
                  <c:v>7.6465811729431152</c:v>
                </c:pt>
                <c:pt idx="1490">
                  <c:v>7.657963752746582</c:v>
                </c:pt>
                <c:pt idx="1491">
                  <c:v>7.6693482398986816</c:v>
                </c:pt>
                <c:pt idx="1492">
                  <c:v>7.6807346343994141</c:v>
                </c:pt>
                <c:pt idx="1493">
                  <c:v>7.6921224594116211</c:v>
                </c:pt>
                <c:pt idx="1494">
                  <c:v>7.7035126686096191</c:v>
                </c:pt>
                <c:pt idx="1495">
                  <c:v>7.71490478515625</c:v>
                </c:pt>
                <c:pt idx="1496">
                  <c:v>7.7262988090515137</c:v>
                </c:pt>
                <c:pt idx="1497">
                  <c:v>7.737694263458252</c:v>
                </c:pt>
                <c:pt idx="1498">
                  <c:v>7.7490921020507813</c:v>
                </c:pt>
                <c:pt idx="1499">
                  <c:v>7.7604918479919434</c:v>
                </c:pt>
                <c:pt idx="1500">
                  <c:v>7.7718930244445801</c:v>
                </c:pt>
                <c:pt idx="1501">
                  <c:v>7.7832965850830078</c:v>
                </c:pt>
                <c:pt idx="1502">
                  <c:v>7.7947020530700684</c:v>
                </c:pt>
                <c:pt idx="1503">
                  <c:v>7.8061094284057617</c:v>
                </c:pt>
                <c:pt idx="1504">
                  <c:v>7.8175182342529297</c:v>
                </c:pt>
                <c:pt idx="1505">
                  <c:v>7.8289294242858887</c:v>
                </c:pt>
                <c:pt idx="1506">
                  <c:v>7.8403425216674805</c:v>
                </c:pt>
                <c:pt idx="1507">
                  <c:v>7.8517575263977051</c:v>
                </c:pt>
                <c:pt idx="1508">
                  <c:v>7.8631744384765625</c:v>
                </c:pt>
                <c:pt idx="1509">
                  <c:v>7.8745932579040527</c:v>
                </c:pt>
                <c:pt idx="1510">
                  <c:v>7.8860139846801758</c:v>
                </c:pt>
                <c:pt idx="1511">
                  <c:v>7.8974366188049316</c:v>
                </c:pt>
                <c:pt idx="1512">
                  <c:v>7.9088611602783203</c:v>
                </c:pt>
                <c:pt idx="1513">
                  <c:v>7.9202876091003418</c:v>
                </c:pt>
                <c:pt idx="1514">
                  <c:v>7.9317159652709961</c:v>
                </c:pt>
                <c:pt idx="1515">
                  <c:v>7.9431467056274414</c:v>
                </c:pt>
                <c:pt idx="1516">
                  <c:v>7.9545788764953613</c:v>
                </c:pt>
                <c:pt idx="1517">
                  <c:v>7.9660134315490723</c:v>
                </c:pt>
                <c:pt idx="1518">
                  <c:v>7.977449893951416</c:v>
                </c:pt>
                <c:pt idx="1519">
                  <c:v>7.9888882637023926</c:v>
                </c:pt>
                <c:pt idx="1520">
                  <c:v>8.0003280639648438</c:v>
                </c:pt>
                <c:pt idx="1521">
                  <c:v>8.0117712020874023</c:v>
                </c:pt>
                <c:pt idx="1522">
                  <c:v>8.0232152938842773</c:v>
                </c:pt>
                <c:pt idx="1523">
                  <c:v>8.0346612930297852</c:v>
                </c:pt>
                <c:pt idx="1524">
                  <c:v>8.0461091995239258</c:v>
                </c:pt>
                <c:pt idx="1525">
                  <c:v>8.0575599670410156</c:v>
                </c:pt>
                <c:pt idx="1526">
                  <c:v>8.0690116882324219</c:v>
                </c:pt>
                <c:pt idx="1527">
                  <c:v>8.0804662704467773</c:v>
                </c:pt>
                <c:pt idx="1528">
                  <c:v>8.0919218063354492</c:v>
                </c:pt>
                <c:pt idx="1529">
                  <c:v>8.1033802032470703</c:v>
                </c:pt>
                <c:pt idx="1530">
                  <c:v>8.1148405075073242</c:v>
                </c:pt>
                <c:pt idx="1531">
                  <c:v>8.1263027191162109</c:v>
                </c:pt>
                <c:pt idx="1532">
                  <c:v>8.1377668380737305</c:v>
                </c:pt>
                <c:pt idx="1533">
                  <c:v>8.1492338180541992</c:v>
                </c:pt>
                <c:pt idx="1534">
                  <c:v>8.1607017517089844</c:v>
                </c:pt>
                <c:pt idx="1535">
                  <c:v>8.1721715927124023</c:v>
                </c:pt>
                <c:pt idx="1536">
                  <c:v>8.1836442947387695</c:v>
                </c:pt>
                <c:pt idx="1537">
                  <c:v>8.1951189041137695</c:v>
                </c:pt>
                <c:pt idx="1538">
                  <c:v>8.2065954208374023</c:v>
                </c:pt>
                <c:pt idx="1539">
                  <c:v>8.218073844909668</c:v>
                </c:pt>
                <c:pt idx="1540">
                  <c:v>8.2295541763305664</c:v>
                </c:pt>
                <c:pt idx="1541">
                  <c:v>8.2410364151000977</c:v>
                </c:pt>
                <c:pt idx="1542">
                  <c:v>8.2525215148925781</c:v>
                </c:pt>
                <c:pt idx="1543">
                  <c:v>8.264007568359375</c:v>
                </c:pt>
                <c:pt idx="1544">
                  <c:v>8.2754964828491211</c:v>
                </c:pt>
                <c:pt idx="1545">
                  <c:v>8.2869873046875</c:v>
                </c:pt>
                <c:pt idx="1546">
                  <c:v>8.2984800338745117</c:v>
                </c:pt>
                <c:pt idx="1547">
                  <c:v>8.3099746704101563</c:v>
                </c:pt>
                <c:pt idx="1548">
                  <c:v>8.32147216796875</c:v>
                </c:pt>
                <c:pt idx="1549">
                  <c:v>8.3329706192016602</c:v>
                </c:pt>
                <c:pt idx="1550">
                  <c:v>8.3444719314575195</c:v>
                </c:pt>
                <c:pt idx="1551">
                  <c:v>8.3559751510620117</c:v>
                </c:pt>
                <c:pt idx="1552">
                  <c:v>8.3674812316894531</c:v>
                </c:pt>
                <c:pt idx="1553">
                  <c:v>8.3789882659912109</c:v>
                </c:pt>
                <c:pt idx="1554">
                  <c:v>8.390498161315918</c:v>
                </c:pt>
                <c:pt idx="1555">
                  <c:v>8.4020099639892578</c:v>
                </c:pt>
                <c:pt idx="1556">
                  <c:v>8.4135236740112305</c:v>
                </c:pt>
                <c:pt idx="1557">
                  <c:v>8.4250402450561523</c:v>
                </c:pt>
                <c:pt idx="1558">
                  <c:v>8.4365577697753906</c:v>
                </c:pt>
                <c:pt idx="1559">
                  <c:v>8.4480791091918945</c:v>
                </c:pt>
                <c:pt idx="1560">
                  <c:v>8.4596014022827148</c:v>
                </c:pt>
                <c:pt idx="1561">
                  <c:v>8.4711265563964844</c:v>
                </c:pt>
                <c:pt idx="1562">
                  <c:v>8.4826526641845703</c:v>
                </c:pt>
                <c:pt idx="1563">
                  <c:v>8.4941825866699219</c:v>
                </c:pt>
                <c:pt idx="1564">
                  <c:v>8.5057134628295898</c:v>
                </c:pt>
                <c:pt idx="1565">
                  <c:v>8.517247200012207</c:v>
                </c:pt>
                <c:pt idx="1566">
                  <c:v>8.528782844543457</c:v>
                </c:pt>
                <c:pt idx="1567">
                  <c:v>8.5403203964233398</c:v>
                </c:pt>
                <c:pt idx="1568">
                  <c:v>8.5518598556518555</c:v>
                </c:pt>
                <c:pt idx="1569">
                  <c:v>8.5634021759033203</c:v>
                </c:pt>
                <c:pt idx="1570">
                  <c:v>8.5749454498291016</c:v>
                </c:pt>
                <c:pt idx="1571">
                  <c:v>8.586491584777832</c:v>
                </c:pt>
                <c:pt idx="1572">
                  <c:v>8.5980396270751953</c:v>
                </c:pt>
                <c:pt idx="1573">
                  <c:v>8.6095905303955078</c:v>
                </c:pt>
                <c:pt idx="1574">
                  <c:v>8.6211433410644531</c:v>
                </c:pt>
                <c:pt idx="1575">
                  <c:v>8.6326980590820313</c:v>
                </c:pt>
                <c:pt idx="1576">
                  <c:v>8.6442546844482422</c:v>
                </c:pt>
                <c:pt idx="1577">
                  <c:v>8.6558141708374023</c:v>
                </c:pt>
                <c:pt idx="1578">
                  <c:v>8.6673765182495117</c:v>
                </c:pt>
                <c:pt idx="1579">
                  <c:v>8.6789398193359375</c:v>
                </c:pt>
                <c:pt idx="1580">
                  <c:v>8.6905050277709961</c:v>
                </c:pt>
                <c:pt idx="1581">
                  <c:v>8.7020730972290039</c:v>
                </c:pt>
                <c:pt idx="1582">
                  <c:v>8.7136440277099609</c:v>
                </c:pt>
                <c:pt idx="1583">
                  <c:v>8.7252178192138672</c:v>
                </c:pt>
                <c:pt idx="1584">
                  <c:v>8.7367916107177734</c:v>
                </c:pt>
                <c:pt idx="1585">
                  <c:v>8.7483692169189453</c:v>
                </c:pt>
                <c:pt idx="1586">
                  <c:v>8.7599477767944336</c:v>
                </c:pt>
                <c:pt idx="1587">
                  <c:v>8.7715301513671875</c:v>
                </c:pt>
                <c:pt idx="1588">
                  <c:v>8.7831144332885742</c:v>
                </c:pt>
                <c:pt idx="1589">
                  <c:v>8.7947006225585938</c:v>
                </c:pt>
                <c:pt idx="1590">
                  <c:v>8.8062887191772461</c:v>
                </c:pt>
                <c:pt idx="1591">
                  <c:v>8.8178787231445313</c:v>
                </c:pt>
                <c:pt idx="1592">
                  <c:v>8.8294715881347656</c:v>
                </c:pt>
                <c:pt idx="1593">
                  <c:v>8.8410663604736328</c:v>
                </c:pt>
                <c:pt idx="1594">
                  <c:v>8.8526639938354492</c:v>
                </c:pt>
                <c:pt idx="1595">
                  <c:v>8.8642635345458984</c:v>
                </c:pt>
                <c:pt idx="1596">
                  <c:v>8.8758668899536133</c:v>
                </c:pt>
                <c:pt idx="1597">
                  <c:v>8.8874711990356445</c:v>
                </c:pt>
                <c:pt idx="1598">
                  <c:v>8.899078369140625</c:v>
                </c:pt>
                <c:pt idx="1599">
                  <c:v>8.9106864929199219</c:v>
                </c:pt>
                <c:pt idx="1600">
                  <c:v>8.9222984313964844</c:v>
                </c:pt>
                <c:pt idx="1601">
                  <c:v>8.9339122772216797</c:v>
                </c:pt>
                <c:pt idx="1602">
                  <c:v>8.9455270767211914</c:v>
                </c:pt>
                <c:pt idx="1603">
                  <c:v>8.9571466445922852</c:v>
                </c:pt>
                <c:pt idx="1604">
                  <c:v>8.9687671661376953</c:v>
                </c:pt>
                <c:pt idx="1605">
                  <c:v>8.9803915023803711</c:v>
                </c:pt>
                <c:pt idx="1606">
                  <c:v>8.9920177459716797</c:v>
                </c:pt>
                <c:pt idx="1607">
                  <c:v>9.0036478042602539</c:v>
                </c:pt>
                <c:pt idx="1608">
                  <c:v>9.0152769088745117</c:v>
                </c:pt>
                <c:pt idx="1609">
                  <c:v>9.0269107818603516</c:v>
                </c:pt>
                <c:pt idx="1610">
                  <c:v>9.0385465621948242</c:v>
                </c:pt>
                <c:pt idx="1611">
                  <c:v>9.0501852035522461</c:v>
                </c:pt>
                <c:pt idx="1612">
                  <c:v>9.0618247985839844</c:v>
                </c:pt>
                <c:pt idx="1613">
                  <c:v>9.0734691619873047</c:v>
                </c:pt>
                <c:pt idx="1614">
                  <c:v>9.085113525390625</c:v>
                </c:pt>
                <c:pt idx="1615">
                  <c:v>9.0967617034912109</c:v>
                </c:pt>
                <c:pt idx="1616">
                  <c:v>9.1084108352661133</c:v>
                </c:pt>
                <c:pt idx="1617">
                  <c:v>9.1200637817382813</c:v>
                </c:pt>
                <c:pt idx="1618">
                  <c:v>9.1317195892333984</c:v>
                </c:pt>
                <c:pt idx="1619">
                  <c:v>9.143376350402832</c:v>
                </c:pt>
                <c:pt idx="1620">
                  <c:v>9.1550359725952148</c:v>
                </c:pt>
                <c:pt idx="1621">
                  <c:v>9.1666975021362305</c:v>
                </c:pt>
                <c:pt idx="1622">
                  <c:v>9.1783628463745117</c:v>
                </c:pt>
                <c:pt idx="1623">
                  <c:v>9.1900300979614258</c:v>
                </c:pt>
                <c:pt idx="1624">
                  <c:v>9.2017002105712891</c:v>
                </c:pt>
                <c:pt idx="1625">
                  <c:v>9.2133722305297852</c:v>
                </c:pt>
                <c:pt idx="1626">
                  <c:v>9.2250461578369141</c:v>
                </c:pt>
                <c:pt idx="1627">
                  <c:v>9.2367229461669922</c:v>
                </c:pt>
                <c:pt idx="1628">
                  <c:v>9.2484016418457031</c:v>
                </c:pt>
                <c:pt idx="1629">
                  <c:v>9.2600851058959961</c:v>
                </c:pt>
                <c:pt idx="1630">
                  <c:v>9.2717695236206055</c:v>
                </c:pt>
                <c:pt idx="1631">
                  <c:v>9.2834568023681641</c:v>
                </c:pt>
                <c:pt idx="1632">
                  <c:v>9.2951469421386719</c:v>
                </c:pt>
                <c:pt idx="1633">
                  <c:v>9.3068389892578125</c:v>
                </c:pt>
                <c:pt idx="1634">
                  <c:v>9.3185348510742188</c:v>
                </c:pt>
                <c:pt idx="1635">
                  <c:v>9.3302316665649414</c:v>
                </c:pt>
                <c:pt idx="1636">
                  <c:v>9.3419313430786133</c:v>
                </c:pt>
                <c:pt idx="1637">
                  <c:v>9.3536338806152344</c:v>
                </c:pt>
                <c:pt idx="1638">
                  <c:v>9.3653402328491211</c:v>
                </c:pt>
                <c:pt idx="1639">
                  <c:v>9.3770465850830078</c:v>
                </c:pt>
                <c:pt idx="1640">
                  <c:v>9.3887567520141602</c:v>
                </c:pt>
                <c:pt idx="1641">
                  <c:v>9.4004688262939453</c:v>
                </c:pt>
                <c:pt idx="1642">
                  <c:v>9.4121847152709961</c:v>
                </c:pt>
                <c:pt idx="1643">
                  <c:v>9.4239015579223633</c:v>
                </c:pt>
                <c:pt idx="1644">
                  <c:v>9.4356231689453125</c:v>
                </c:pt>
                <c:pt idx="1645">
                  <c:v>9.4473457336425781</c:v>
                </c:pt>
                <c:pt idx="1646">
                  <c:v>9.459071159362793</c:v>
                </c:pt>
                <c:pt idx="1647">
                  <c:v>9.4708003997802734</c:v>
                </c:pt>
                <c:pt idx="1648">
                  <c:v>9.4825315475463867</c:v>
                </c:pt>
                <c:pt idx="1649">
                  <c:v>9.4942665100097656</c:v>
                </c:pt>
                <c:pt idx="1650">
                  <c:v>9.5060043334960938</c:v>
                </c:pt>
                <c:pt idx="1651">
                  <c:v>9.5177431106567383</c:v>
                </c:pt>
                <c:pt idx="1652">
                  <c:v>9.5294876098632813</c:v>
                </c:pt>
                <c:pt idx="1653">
                  <c:v>9.5412330627441406</c:v>
                </c:pt>
                <c:pt idx="1654">
                  <c:v>9.5529813766479492</c:v>
                </c:pt>
                <c:pt idx="1655">
                  <c:v>9.5647315979003906</c:v>
                </c:pt>
                <c:pt idx="1656">
                  <c:v>9.5764846801757813</c:v>
                </c:pt>
                <c:pt idx="1657">
                  <c:v>9.5882396697998047</c:v>
                </c:pt>
                <c:pt idx="1658">
                  <c:v>9.5999984741210938</c:v>
                </c:pt>
                <c:pt idx="1659">
                  <c:v>9.611760139465332</c:v>
                </c:pt>
                <c:pt idx="1660">
                  <c:v>9.6235256195068359</c:v>
                </c:pt>
                <c:pt idx="1661">
                  <c:v>9.6352920532226563</c:v>
                </c:pt>
                <c:pt idx="1662">
                  <c:v>9.6470632553100586</c:v>
                </c:pt>
                <c:pt idx="1663">
                  <c:v>9.6588354110717773</c:v>
                </c:pt>
                <c:pt idx="1664">
                  <c:v>9.6706094741821289</c:v>
                </c:pt>
                <c:pt idx="1665">
                  <c:v>9.6823863983154297</c:v>
                </c:pt>
                <c:pt idx="1666">
                  <c:v>9.6941661834716797</c:v>
                </c:pt>
                <c:pt idx="1667">
                  <c:v>9.7059497833251953</c:v>
                </c:pt>
                <c:pt idx="1668">
                  <c:v>9.7177371978759766</c:v>
                </c:pt>
                <c:pt idx="1669">
                  <c:v>9.7295255661010742</c:v>
                </c:pt>
                <c:pt idx="1670">
                  <c:v>9.7413167953491211</c:v>
                </c:pt>
                <c:pt idx="1671">
                  <c:v>9.7531089782714844</c:v>
                </c:pt>
                <c:pt idx="1672">
                  <c:v>9.7649059295654297</c:v>
                </c:pt>
                <c:pt idx="1673">
                  <c:v>9.7767047882080078</c:v>
                </c:pt>
                <c:pt idx="1674">
                  <c:v>9.788508415222168</c:v>
                </c:pt>
                <c:pt idx="1675">
                  <c:v>9.8003129959106445</c:v>
                </c:pt>
                <c:pt idx="1676">
                  <c:v>9.8121223449707031</c:v>
                </c:pt>
                <c:pt idx="1677">
                  <c:v>9.8239326477050781</c:v>
                </c:pt>
                <c:pt idx="1678">
                  <c:v>9.8357458114624023</c:v>
                </c:pt>
                <c:pt idx="1679">
                  <c:v>9.847559928894043</c:v>
                </c:pt>
                <c:pt idx="1680">
                  <c:v>9.8593788146972656</c:v>
                </c:pt>
                <c:pt idx="1681">
                  <c:v>9.8711986541748047</c:v>
                </c:pt>
                <c:pt idx="1682">
                  <c:v>9.8830232620239258</c:v>
                </c:pt>
                <c:pt idx="1683">
                  <c:v>9.8948497772216797</c:v>
                </c:pt>
                <c:pt idx="1684">
                  <c:v>9.9066810607910156</c:v>
                </c:pt>
                <c:pt idx="1685">
                  <c:v>9.9185152053833008</c:v>
                </c:pt>
                <c:pt idx="1686">
                  <c:v>9.9303512573242188</c:v>
                </c:pt>
                <c:pt idx="1687">
                  <c:v>9.9421901702880859</c:v>
                </c:pt>
                <c:pt idx="1688">
                  <c:v>9.9540338516235352</c:v>
                </c:pt>
                <c:pt idx="1689">
                  <c:v>9.9658784866333008</c:v>
                </c:pt>
                <c:pt idx="1690">
                  <c:v>9.9777259826660156</c:v>
                </c:pt>
                <c:pt idx="1691">
                  <c:v>9.9895753860473633</c:v>
                </c:pt>
                <c:pt idx="1692">
                  <c:v>10.001428604125977</c:v>
                </c:pt>
                <c:pt idx="1693">
                  <c:v>10.013285636901855</c:v>
                </c:pt>
                <c:pt idx="1694">
                  <c:v>10.025146484375</c:v>
                </c:pt>
                <c:pt idx="1695">
                  <c:v>10.037008285522461</c:v>
                </c:pt>
                <c:pt idx="1696">
                  <c:v>10.048874855041504</c:v>
                </c:pt>
                <c:pt idx="1697">
                  <c:v>10.06074333190918</c:v>
                </c:pt>
                <c:pt idx="1698">
                  <c:v>10.072616577148438</c:v>
                </c:pt>
                <c:pt idx="1699">
                  <c:v>10.084490776062012</c:v>
                </c:pt>
                <c:pt idx="1700">
                  <c:v>10.096367835998535</c:v>
                </c:pt>
                <c:pt idx="1701">
                  <c:v>10.108250617980957</c:v>
                </c:pt>
                <c:pt idx="1702">
                  <c:v>10.120135307312012</c:v>
                </c:pt>
                <c:pt idx="1703">
                  <c:v>10.132020950317383</c:v>
                </c:pt>
                <c:pt idx="1704">
                  <c:v>10.143912315368652</c:v>
                </c:pt>
                <c:pt idx="1705">
                  <c:v>10.155804634094238</c:v>
                </c:pt>
                <c:pt idx="1706">
                  <c:v>10.167702674865723</c:v>
                </c:pt>
                <c:pt idx="1707">
                  <c:v>10.179601669311523</c:v>
                </c:pt>
                <c:pt idx="1708">
                  <c:v>10.19150447845459</c:v>
                </c:pt>
                <c:pt idx="1709">
                  <c:v>10.203408241271973</c:v>
                </c:pt>
                <c:pt idx="1710">
                  <c:v>10.21531867980957</c:v>
                </c:pt>
                <c:pt idx="1711">
                  <c:v>10.227231979370117</c:v>
                </c:pt>
                <c:pt idx="1712">
                  <c:v>10.23914623260498</c:v>
                </c:pt>
                <c:pt idx="1713">
                  <c:v>10.251063346862793</c:v>
                </c:pt>
                <c:pt idx="1714">
                  <c:v>10.262981414794922</c:v>
                </c:pt>
                <c:pt idx="1715">
                  <c:v>10.274904251098633</c:v>
                </c:pt>
                <c:pt idx="1716">
                  <c:v>10.286829948425293</c:v>
                </c:pt>
                <c:pt idx="1717">
                  <c:v>10.298757553100586</c:v>
                </c:pt>
                <c:pt idx="1718">
                  <c:v>10.310688972473145</c:v>
                </c:pt>
                <c:pt idx="1719">
                  <c:v>10.322620391845703</c:v>
                </c:pt>
                <c:pt idx="1720">
                  <c:v>10.33455753326416</c:v>
                </c:pt>
                <c:pt idx="1721">
                  <c:v>10.346494674682617</c:v>
                </c:pt>
                <c:pt idx="1722">
                  <c:v>10.358438491821289</c:v>
                </c:pt>
                <c:pt idx="1723">
                  <c:v>10.370382308959961</c:v>
                </c:pt>
                <c:pt idx="1724">
                  <c:v>10.382327079772949</c:v>
                </c:pt>
                <c:pt idx="1725">
                  <c:v>10.39427661895752</c:v>
                </c:pt>
                <c:pt idx="1726">
                  <c:v>10.40622615814209</c:v>
                </c:pt>
                <c:pt idx="1727">
                  <c:v>10.418179512023926</c:v>
                </c:pt>
                <c:pt idx="1728">
                  <c:v>10.430136680603027</c:v>
                </c:pt>
                <c:pt idx="1729">
                  <c:v>10.442094802856445</c:v>
                </c:pt>
                <c:pt idx="1730">
                  <c:v>10.454058647155762</c:v>
                </c:pt>
                <c:pt idx="1731">
                  <c:v>10.466023445129395</c:v>
                </c:pt>
                <c:pt idx="1732">
                  <c:v>10.477989196777344</c:v>
                </c:pt>
                <c:pt idx="1733">
                  <c:v>10.489956855773926</c:v>
                </c:pt>
                <c:pt idx="1734">
                  <c:v>10.501931190490723</c:v>
                </c:pt>
                <c:pt idx="1735">
                  <c:v>10.513907432556152</c:v>
                </c:pt>
                <c:pt idx="1736">
                  <c:v>10.525885581970215</c:v>
                </c:pt>
                <c:pt idx="1737">
                  <c:v>10.53786563873291</c:v>
                </c:pt>
                <c:pt idx="1738">
                  <c:v>10.549848556518555</c:v>
                </c:pt>
                <c:pt idx="1739">
                  <c:v>10.561835289001465</c:v>
                </c:pt>
                <c:pt idx="1740">
                  <c:v>10.573822975158691</c:v>
                </c:pt>
                <c:pt idx="1741">
                  <c:v>10.585812568664551</c:v>
                </c:pt>
                <c:pt idx="1742">
                  <c:v>10.597804069519043</c:v>
                </c:pt>
                <c:pt idx="1743">
                  <c:v>10.609800338745117</c:v>
                </c:pt>
                <c:pt idx="1744">
                  <c:v>10.621799468994141</c:v>
                </c:pt>
                <c:pt idx="1745">
                  <c:v>10.633801460266113</c:v>
                </c:pt>
                <c:pt idx="1746">
                  <c:v>10.645808219909668</c:v>
                </c:pt>
                <c:pt idx="1747">
                  <c:v>10.657814025878906</c:v>
                </c:pt>
                <c:pt idx="1748">
                  <c:v>10.66982364654541</c:v>
                </c:pt>
                <c:pt idx="1749">
                  <c:v>10.681836128234863</c:v>
                </c:pt>
                <c:pt idx="1750">
                  <c:v>10.693854331970215</c:v>
                </c:pt>
                <c:pt idx="1751">
                  <c:v>10.70587158203125</c:v>
                </c:pt>
                <c:pt idx="1752">
                  <c:v>10.717891693115234</c:v>
                </c:pt>
                <c:pt idx="1753">
                  <c:v>10.729917526245117</c:v>
                </c:pt>
                <c:pt idx="1754">
                  <c:v>10.741944313049316</c:v>
                </c:pt>
                <c:pt idx="1755">
                  <c:v>10.753972053527832</c:v>
                </c:pt>
                <c:pt idx="1756">
                  <c:v>10.766002655029297</c:v>
                </c:pt>
                <c:pt idx="1757">
                  <c:v>10.778036117553711</c:v>
                </c:pt>
                <c:pt idx="1758">
                  <c:v>10.790075302124023</c:v>
                </c:pt>
                <c:pt idx="1759">
                  <c:v>10.802115440368652</c:v>
                </c:pt>
                <c:pt idx="1760">
                  <c:v>10.814154624938965</c:v>
                </c:pt>
                <c:pt idx="1761">
                  <c:v>10.82619571685791</c:v>
                </c:pt>
                <c:pt idx="1762">
                  <c:v>10.838240623474121</c:v>
                </c:pt>
                <c:pt idx="1763">
                  <c:v>10.850290298461914</c:v>
                </c:pt>
                <c:pt idx="1764">
                  <c:v>10.862339973449707</c:v>
                </c:pt>
                <c:pt idx="1765">
                  <c:v>10.874396324157715</c:v>
                </c:pt>
                <c:pt idx="1766">
                  <c:v>10.886451721191406</c:v>
                </c:pt>
                <c:pt idx="1767">
                  <c:v>10.898509979248047</c:v>
                </c:pt>
                <c:pt idx="1768">
                  <c:v>10.91057014465332</c:v>
                </c:pt>
                <c:pt idx="1769">
                  <c:v>10.922632217407227</c:v>
                </c:pt>
                <c:pt idx="1770">
                  <c:v>10.934699058532715</c:v>
                </c:pt>
                <c:pt idx="1771">
                  <c:v>10.946764945983887</c:v>
                </c:pt>
                <c:pt idx="1772">
                  <c:v>10.958834648132324</c:v>
                </c:pt>
                <c:pt idx="1773">
                  <c:v>10.970905303955078</c:v>
                </c:pt>
                <c:pt idx="1774">
                  <c:v>10.982980728149414</c:v>
                </c:pt>
                <c:pt idx="1775">
                  <c:v>10.995054244995117</c:v>
                </c:pt>
                <c:pt idx="1776">
                  <c:v>11.007133483886719</c:v>
                </c:pt>
                <c:pt idx="1777">
                  <c:v>11.019213676452637</c:v>
                </c:pt>
                <c:pt idx="1778">
                  <c:v>11.031296730041504</c:v>
                </c:pt>
                <c:pt idx="1779">
                  <c:v>11.043380737304688</c:v>
                </c:pt>
                <c:pt idx="1780">
                  <c:v>11.05546760559082</c:v>
                </c:pt>
                <c:pt idx="1781">
                  <c:v>11.06755542755127</c:v>
                </c:pt>
                <c:pt idx="1782">
                  <c:v>11.079646110534668</c:v>
                </c:pt>
                <c:pt idx="1783">
                  <c:v>11.091739654541016</c:v>
                </c:pt>
                <c:pt idx="1784">
                  <c:v>11.103836059570313</c:v>
                </c:pt>
                <c:pt idx="1785">
                  <c:v>11.115933418273926</c:v>
                </c:pt>
                <c:pt idx="1786">
                  <c:v>11.128031730651855</c:v>
                </c:pt>
                <c:pt idx="1787">
                  <c:v>11.140132904052734</c:v>
                </c:pt>
                <c:pt idx="1788">
                  <c:v>11.152235984802246</c:v>
                </c:pt>
                <c:pt idx="1789">
                  <c:v>11.16434383392334</c:v>
                </c:pt>
                <c:pt idx="1790">
                  <c:v>11.176453590393066</c:v>
                </c:pt>
                <c:pt idx="1791">
                  <c:v>11.188565254211426</c:v>
                </c:pt>
                <c:pt idx="1792">
                  <c:v>11.200678825378418</c:v>
                </c:pt>
                <c:pt idx="1793">
                  <c:v>11.212793350219727</c:v>
                </c:pt>
                <c:pt idx="1794">
                  <c:v>11.224913597106934</c:v>
                </c:pt>
                <c:pt idx="1795">
                  <c:v>11.237033843994141</c:v>
                </c:pt>
                <c:pt idx="1796">
                  <c:v>11.249157905578613</c:v>
                </c:pt>
                <c:pt idx="1797">
                  <c:v>11.261282920837402</c:v>
                </c:pt>
                <c:pt idx="1798">
                  <c:v>11.273408889770508</c:v>
                </c:pt>
                <c:pt idx="1799">
                  <c:v>11.285538673400879</c:v>
                </c:pt>
                <c:pt idx="1800">
                  <c:v>11.297672271728516</c:v>
                </c:pt>
                <c:pt idx="1801">
                  <c:v>11.309807777404785</c:v>
                </c:pt>
                <c:pt idx="1802">
                  <c:v>11.321944236755371</c:v>
                </c:pt>
                <c:pt idx="1803">
                  <c:v>11.334083557128906</c:v>
                </c:pt>
                <c:pt idx="1804">
                  <c:v>11.346224784851074</c:v>
                </c:pt>
                <c:pt idx="1805">
                  <c:v>11.358367919921875</c:v>
                </c:pt>
                <c:pt idx="1806">
                  <c:v>11.370512008666992</c:v>
                </c:pt>
                <c:pt idx="1807">
                  <c:v>11.382659912109375</c:v>
                </c:pt>
                <c:pt idx="1808">
                  <c:v>11.394811630249023</c:v>
                </c:pt>
                <c:pt idx="1809">
                  <c:v>11.406962394714355</c:v>
                </c:pt>
                <c:pt idx="1810">
                  <c:v>11.41911792755127</c:v>
                </c:pt>
                <c:pt idx="1811">
                  <c:v>11.431275367736816</c:v>
                </c:pt>
                <c:pt idx="1812">
                  <c:v>11.443435668945313</c:v>
                </c:pt>
                <c:pt idx="1813">
                  <c:v>11.455596923828125</c:v>
                </c:pt>
                <c:pt idx="1814">
                  <c:v>11.467761039733887</c:v>
                </c:pt>
                <c:pt idx="1815">
                  <c:v>11.479926109313965</c:v>
                </c:pt>
                <c:pt idx="1816">
                  <c:v>11.492095947265625</c:v>
                </c:pt>
                <c:pt idx="1817">
                  <c:v>11.504266738891602</c:v>
                </c:pt>
                <c:pt idx="1818">
                  <c:v>11.516440391540527</c:v>
                </c:pt>
                <c:pt idx="1819">
                  <c:v>11.528614044189453</c:v>
                </c:pt>
                <c:pt idx="1820">
                  <c:v>11.540792465209961</c:v>
                </c:pt>
                <c:pt idx="1821">
                  <c:v>11.552972793579102</c:v>
                </c:pt>
                <c:pt idx="1822">
                  <c:v>11.565155982971191</c:v>
                </c:pt>
                <c:pt idx="1823">
                  <c:v>11.577340126037598</c:v>
                </c:pt>
                <c:pt idx="1824">
                  <c:v>11.58952808380127</c:v>
                </c:pt>
                <c:pt idx="1825">
                  <c:v>11.601715087890625</c:v>
                </c:pt>
                <c:pt idx="1826">
                  <c:v>11.613907814025879</c:v>
                </c:pt>
                <c:pt idx="1827">
                  <c:v>11.626101493835449</c:v>
                </c:pt>
                <c:pt idx="1828">
                  <c:v>11.638298034667969</c:v>
                </c:pt>
                <c:pt idx="1829">
                  <c:v>11.650496482849121</c:v>
                </c:pt>
                <c:pt idx="1830">
                  <c:v>11.662697792053223</c:v>
                </c:pt>
                <c:pt idx="1831">
                  <c:v>11.674901008605957</c:v>
                </c:pt>
                <c:pt idx="1832">
                  <c:v>11.687107086181641</c:v>
                </c:pt>
                <c:pt idx="1833">
                  <c:v>11.699315071105957</c:v>
                </c:pt>
                <c:pt idx="1834">
                  <c:v>11.711525917053223</c:v>
                </c:pt>
                <c:pt idx="1835">
                  <c:v>11.723737716674805</c:v>
                </c:pt>
                <c:pt idx="1836">
                  <c:v>11.735953330993652</c:v>
                </c:pt>
                <c:pt idx="1837">
                  <c:v>11.748171806335449</c:v>
                </c:pt>
                <c:pt idx="1838">
                  <c:v>11.760392189025879</c:v>
                </c:pt>
                <c:pt idx="1839">
                  <c:v>11.772613525390625</c:v>
                </c:pt>
                <c:pt idx="1840">
                  <c:v>11.784838676452637</c:v>
                </c:pt>
                <c:pt idx="1841">
                  <c:v>11.797066688537598</c:v>
                </c:pt>
                <c:pt idx="1842">
                  <c:v>11.809295654296875</c:v>
                </c:pt>
                <c:pt idx="1843">
                  <c:v>11.821528434753418</c:v>
                </c:pt>
                <c:pt idx="1844">
                  <c:v>11.833763122558594</c:v>
                </c:pt>
                <c:pt idx="1845">
                  <c:v>11.845998764038086</c:v>
                </c:pt>
                <c:pt idx="1846">
                  <c:v>11.858238220214844</c:v>
                </c:pt>
                <c:pt idx="1847">
                  <c:v>11.870479583740234</c:v>
                </c:pt>
                <c:pt idx="1848">
                  <c:v>11.882723808288574</c:v>
                </c:pt>
                <c:pt idx="1849">
                  <c:v>11.894970893859863</c:v>
                </c:pt>
                <c:pt idx="1850">
                  <c:v>11.907219886779785</c:v>
                </c:pt>
                <c:pt idx="1851">
                  <c:v>11.91947078704834</c:v>
                </c:pt>
                <c:pt idx="1852">
                  <c:v>11.931724548339844</c:v>
                </c:pt>
                <c:pt idx="1853">
                  <c:v>11.94398021697998</c:v>
                </c:pt>
                <c:pt idx="1854">
                  <c:v>11.956238746643066</c:v>
                </c:pt>
                <c:pt idx="1855">
                  <c:v>11.968500137329102</c:v>
                </c:pt>
                <c:pt idx="1856">
                  <c:v>11.98076343536377</c:v>
                </c:pt>
                <c:pt idx="1857">
                  <c:v>11.993029594421387</c:v>
                </c:pt>
                <c:pt idx="1858">
                  <c:v>12.005297660827637</c:v>
                </c:pt>
                <c:pt idx="1859">
                  <c:v>12.017568588256836</c:v>
                </c:pt>
                <c:pt idx="1860">
                  <c:v>12.029841423034668</c:v>
                </c:pt>
                <c:pt idx="1861">
                  <c:v>12.042117118835449</c:v>
                </c:pt>
                <c:pt idx="1862">
                  <c:v>12.054394721984863</c:v>
                </c:pt>
                <c:pt idx="1863">
                  <c:v>12.066675186157227</c:v>
                </c:pt>
                <c:pt idx="1864">
                  <c:v>12.078958511352539</c:v>
                </c:pt>
                <c:pt idx="1865">
                  <c:v>12.091243743896484</c:v>
                </c:pt>
                <c:pt idx="1866">
                  <c:v>12.103530883789063</c:v>
                </c:pt>
                <c:pt idx="1867">
                  <c:v>12.11582088470459</c:v>
                </c:pt>
                <c:pt idx="1868">
                  <c:v>12.12811279296875</c:v>
                </c:pt>
                <c:pt idx="1869">
                  <c:v>12.140407562255859</c:v>
                </c:pt>
                <c:pt idx="1870">
                  <c:v>12.152704238891602</c:v>
                </c:pt>
                <c:pt idx="1871">
                  <c:v>12.165002822875977</c:v>
                </c:pt>
                <c:pt idx="1872">
                  <c:v>12.177304267883301</c:v>
                </c:pt>
                <c:pt idx="1873">
                  <c:v>12.189608573913574</c:v>
                </c:pt>
                <c:pt idx="1874">
                  <c:v>12.201913833618164</c:v>
                </c:pt>
                <c:pt idx="1875">
                  <c:v>12.214221954345703</c:v>
                </c:pt>
                <c:pt idx="1876">
                  <c:v>12.226532936096191</c:v>
                </c:pt>
                <c:pt idx="1877">
                  <c:v>12.238844871520996</c:v>
                </c:pt>
                <c:pt idx="1878">
                  <c:v>12.25115966796875</c:v>
                </c:pt>
                <c:pt idx="1879">
                  <c:v>12.263477325439453</c:v>
                </c:pt>
                <c:pt idx="1880">
                  <c:v>12.275796890258789</c:v>
                </c:pt>
                <c:pt idx="1881">
                  <c:v>12.288117408752441</c:v>
                </c:pt>
                <c:pt idx="1882">
                  <c:v>12.300441741943359</c:v>
                </c:pt>
                <c:pt idx="1883">
                  <c:v>12.312767028808594</c:v>
                </c:pt>
                <c:pt idx="1884">
                  <c:v>12.325095176696777</c:v>
                </c:pt>
                <c:pt idx="1885">
                  <c:v>12.337425231933594</c:v>
                </c:pt>
                <c:pt idx="1886">
                  <c:v>12.349757194519043</c:v>
                </c:pt>
                <c:pt idx="1887">
                  <c:v>12.362092018127441</c:v>
                </c:pt>
                <c:pt idx="1888">
                  <c:v>12.374427795410156</c:v>
                </c:pt>
                <c:pt idx="1889">
                  <c:v>12.38676643371582</c:v>
                </c:pt>
                <c:pt idx="1890">
                  <c:v>12.399106979370117</c:v>
                </c:pt>
                <c:pt idx="1891">
                  <c:v>12.411449432373047</c:v>
                </c:pt>
                <c:pt idx="1892">
                  <c:v>12.423794746398926</c:v>
                </c:pt>
                <c:pt idx="1893">
                  <c:v>12.436141967773438</c:v>
                </c:pt>
                <c:pt idx="1894">
                  <c:v>12.448490142822266</c:v>
                </c:pt>
                <c:pt idx="1895">
                  <c:v>12.460841178894043</c:v>
                </c:pt>
                <c:pt idx="1896">
                  <c:v>12.473194122314453</c:v>
                </c:pt>
                <c:pt idx="1897">
                  <c:v>12.485548973083496</c:v>
                </c:pt>
                <c:pt idx="1898">
                  <c:v>12.497905731201172</c:v>
                </c:pt>
                <c:pt idx="1899">
                  <c:v>12.51026439666748</c:v>
                </c:pt>
                <c:pt idx="1900">
                  <c:v>12.522624969482422</c:v>
                </c:pt>
                <c:pt idx="1901">
                  <c:v>12.534988403320313</c:v>
                </c:pt>
                <c:pt idx="1902">
                  <c:v>12.54735279083252</c:v>
                </c:pt>
                <c:pt idx="1903">
                  <c:v>12.559719085693359</c:v>
                </c:pt>
                <c:pt idx="1904">
                  <c:v>12.572087287902832</c:v>
                </c:pt>
                <c:pt idx="1905">
                  <c:v>12.584458351135254</c:v>
                </c:pt>
                <c:pt idx="1906">
                  <c:v>12.596830368041992</c:v>
                </c:pt>
                <c:pt idx="1907">
                  <c:v>12.609204292297363</c:v>
                </c:pt>
                <c:pt idx="1908">
                  <c:v>12.621580123901367</c:v>
                </c:pt>
                <c:pt idx="1909">
                  <c:v>12.63395881652832</c:v>
                </c:pt>
                <c:pt idx="1910">
                  <c:v>12.646339416503906</c:v>
                </c:pt>
                <c:pt idx="1911">
                  <c:v>12.658720970153809</c:v>
                </c:pt>
                <c:pt idx="1912">
                  <c:v>12.671104431152344</c:v>
                </c:pt>
                <c:pt idx="1913">
                  <c:v>12.683489799499512</c:v>
                </c:pt>
                <c:pt idx="1914">
                  <c:v>12.695877075195313</c:v>
                </c:pt>
                <c:pt idx="1915">
                  <c:v>12.70826530456543</c:v>
                </c:pt>
                <c:pt idx="1916">
                  <c:v>12.720656394958496</c:v>
                </c:pt>
                <c:pt idx="1917">
                  <c:v>12.733048439025879</c:v>
                </c:pt>
                <c:pt idx="1918">
                  <c:v>12.745442390441895</c:v>
                </c:pt>
                <c:pt idx="1919">
                  <c:v>12.757838249206543</c:v>
                </c:pt>
                <c:pt idx="1920">
                  <c:v>12.770236015319824</c:v>
                </c:pt>
                <c:pt idx="1921">
                  <c:v>12.782635688781738</c:v>
                </c:pt>
                <c:pt idx="1922">
                  <c:v>12.795036315917969</c:v>
                </c:pt>
                <c:pt idx="1923">
                  <c:v>12.807438850402832</c:v>
                </c:pt>
                <c:pt idx="1924">
                  <c:v>12.819843292236328</c:v>
                </c:pt>
                <c:pt idx="1925">
                  <c:v>12.832249641418457</c:v>
                </c:pt>
                <c:pt idx="1926">
                  <c:v>12.844657897949219</c:v>
                </c:pt>
                <c:pt idx="1927">
                  <c:v>12.857067108154297</c:v>
                </c:pt>
                <c:pt idx="1928">
                  <c:v>12.869478225708008</c:v>
                </c:pt>
                <c:pt idx="1929">
                  <c:v>12.881891250610352</c:v>
                </c:pt>
                <c:pt idx="1930">
                  <c:v>12.894306182861328</c:v>
                </c:pt>
                <c:pt idx="1931">
                  <c:v>12.906722068786621</c:v>
                </c:pt>
                <c:pt idx="1932">
                  <c:v>12.919139862060547</c:v>
                </c:pt>
                <c:pt idx="1933">
                  <c:v>12.931560516357422</c:v>
                </c:pt>
                <c:pt idx="1934">
                  <c:v>12.94398021697998</c:v>
                </c:pt>
                <c:pt idx="1935">
                  <c:v>12.956402778625488</c:v>
                </c:pt>
                <c:pt idx="1936">
                  <c:v>12.968826293945313</c:v>
                </c:pt>
                <c:pt idx="1937">
                  <c:v>12.98125171661377</c:v>
                </c:pt>
                <c:pt idx="1938">
                  <c:v>12.993679046630859</c:v>
                </c:pt>
                <c:pt idx="1939">
                  <c:v>13.006108283996582</c:v>
                </c:pt>
                <c:pt idx="1940">
                  <c:v>13.018538475036621</c:v>
                </c:pt>
                <c:pt idx="1941">
                  <c:v>13.030969619750977</c:v>
                </c:pt>
                <c:pt idx="1942">
                  <c:v>13.043402671813965</c:v>
                </c:pt>
                <c:pt idx="1943">
                  <c:v>13.055838584899902</c:v>
                </c:pt>
                <c:pt idx="1944">
                  <c:v>13.06827449798584</c:v>
                </c:pt>
                <c:pt idx="1945">
                  <c:v>13.080713272094727</c:v>
                </c:pt>
                <c:pt idx="1946">
                  <c:v>13.09315299987793</c:v>
                </c:pt>
                <c:pt idx="1947">
                  <c:v>13.105595588684082</c:v>
                </c:pt>
                <c:pt idx="1948">
                  <c:v>13.118039131164551</c:v>
                </c:pt>
                <c:pt idx="1949">
                  <c:v>13.130484580993652</c:v>
                </c:pt>
                <c:pt idx="1950">
                  <c:v>13.14293098449707</c:v>
                </c:pt>
                <c:pt idx="1951">
                  <c:v>13.155380249023438</c:v>
                </c:pt>
                <c:pt idx="1952">
                  <c:v>13.167831420898438</c:v>
                </c:pt>
                <c:pt idx="1953">
                  <c:v>13.18028450012207</c:v>
                </c:pt>
                <c:pt idx="1954">
                  <c:v>13.192737579345703</c:v>
                </c:pt>
                <c:pt idx="1955">
                  <c:v>13.205194473266602</c:v>
                </c:pt>
                <c:pt idx="1956">
                  <c:v>13.217652320861816</c:v>
                </c:pt>
                <c:pt idx="1957">
                  <c:v>13.23011302947998</c:v>
                </c:pt>
                <c:pt idx="1958">
                  <c:v>13.242574691772461</c:v>
                </c:pt>
                <c:pt idx="1959">
                  <c:v>13.255039215087891</c:v>
                </c:pt>
                <c:pt idx="1960">
                  <c:v>13.267504692077637</c:v>
                </c:pt>
                <c:pt idx="1961">
                  <c:v>13.279973030090332</c:v>
                </c:pt>
                <c:pt idx="1962">
                  <c:v>13.29244327545166</c:v>
                </c:pt>
                <c:pt idx="1963">
                  <c:v>13.304916381835938</c:v>
                </c:pt>
                <c:pt idx="1964">
                  <c:v>13.317389488220215</c:v>
                </c:pt>
                <c:pt idx="1965">
                  <c:v>13.329866409301758</c:v>
                </c:pt>
                <c:pt idx="1966">
                  <c:v>13.342345237731934</c:v>
                </c:pt>
                <c:pt idx="1967">
                  <c:v>13.354827880859375</c:v>
                </c:pt>
                <c:pt idx="1968">
                  <c:v>13.367310523986816</c:v>
                </c:pt>
                <c:pt idx="1969">
                  <c:v>13.379795074462891</c:v>
                </c:pt>
                <c:pt idx="1970">
                  <c:v>13.39228343963623</c:v>
                </c:pt>
                <c:pt idx="1971">
                  <c:v>13.404772758483887</c:v>
                </c:pt>
                <c:pt idx="1972">
                  <c:v>13.417264938354492</c:v>
                </c:pt>
                <c:pt idx="1973">
                  <c:v>13.429759979248047</c:v>
                </c:pt>
                <c:pt idx="1974">
                  <c:v>13.442257881164551</c:v>
                </c:pt>
                <c:pt idx="1975">
                  <c:v>13.454757690429688</c:v>
                </c:pt>
                <c:pt idx="1976">
                  <c:v>13.467257499694824</c:v>
                </c:pt>
                <c:pt idx="1977">
                  <c:v>13.479762077331543</c:v>
                </c:pt>
                <c:pt idx="1978">
                  <c:v>13.492266654968262</c:v>
                </c:pt>
                <c:pt idx="1979">
                  <c:v>13.504775047302246</c:v>
                </c:pt>
                <c:pt idx="1980">
                  <c:v>13.51728630065918</c:v>
                </c:pt>
                <c:pt idx="1981">
                  <c:v>13.529799461364746</c:v>
                </c:pt>
                <c:pt idx="1982">
                  <c:v>13.542315483093262</c:v>
                </c:pt>
                <c:pt idx="1983">
                  <c:v>13.554834365844727</c:v>
                </c:pt>
                <c:pt idx="1984">
                  <c:v>13.567354202270508</c:v>
                </c:pt>
                <c:pt idx="1985">
                  <c:v>13.579877853393555</c:v>
                </c:pt>
                <c:pt idx="1986">
                  <c:v>13.592404365539551</c:v>
                </c:pt>
                <c:pt idx="1987">
                  <c:v>13.604931831359863</c:v>
                </c:pt>
                <c:pt idx="1988">
                  <c:v>13.617463111877441</c:v>
                </c:pt>
                <c:pt idx="1989">
                  <c:v>13.629996299743652</c:v>
                </c:pt>
                <c:pt idx="1990">
                  <c:v>13.64253044128418</c:v>
                </c:pt>
                <c:pt idx="1991">
                  <c:v>13.655070304870605</c:v>
                </c:pt>
                <c:pt idx="1992">
                  <c:v>13.667611122131348</c:v>
                </c:pt>
                <c:pt idx="1993">
                  <c:v>13.680154800415039</c:v>
                </c:pt>
                <c:pt idx="1994">
                  <c:v>13.69270133972168</c:v>
                </c:pt>
                <c:pt idx="1995">
                  <c:v>13.70525074005127</c:v>
                </c:pt>
                <c:pt idx="1996">
                  <c:v>13.717803001403809</c:v>
                </c:pt>
                <c:pt idx="1997">
                  <c:v>13.730358123779297</c:v>
                </c:pt>
                <c:pt idx="1998">
                  <c:v>13.742916107177734</c:v>
                </c:pt>
                <c:pt idx="1999">
                  <c:v>13.755476951599121</c:v>
                </c:pt>
                <c:pt idx="2000">
                  <c:v>13.768040657043457</c:v>
                </c:pt>
                <c:pt idx="2001">
                  <c:v>13.780607223510742</c:v>
                </c:pt>
                <c:pt idx="2002">
                  <c:v>13.793176651000977</c:v>
                </c:pt>
                <c:pt idx="2003">
                  <c:v>13.805749893188477</c:v>
                </c:pt>
                <c:pt idx="2004">
                  <c:v>13.818325996398926</c:v>
                </c:pt>
                <c:pt idx="2005">
                  <c:v>13.830904006958008</c:v>
                </c:pt>
                <c:pt idx="2006">
                  <c:v>13.843485832214355</c:v>
                </c:pt>
                <c:pt idx="2007">
                  <c:v>13.856069564819336</c:v>
                </c:pt>
                <c:pt idx="2008">
                  <c:v>13.868658065795898</c:v>
                </c:pt>
                <c:pt idx="2009">
                  <c:v>13.881248474121094</c:v>
                </c:pt>
                <c:pt idx="2010">
                  <c:v>13.893841743469238</c:v>
                </c:pt>
                <c:pt idx="2011">
                  <c:v>13.906439781188965</c:v>
                </c:pt>
                <c:pt idx="2012">
                  <c:v>13.919040679931641</c:v>
                </c:pt>
                <c:pt idx="2013">
                  <c:v>13.931644439697266</c:v>
                </c:pt>
                <c:pt idx="2014">
                  <c:v>13.944250106811523</c:v>
                </c:pt>
                <c:pt idx="2015">
                  <c:v>13.956860542297363</c:v>
                </c:pt>
                <c:pt idx="2016">
                  <c:v>13.969472885131836</c:v>
                </c:pt>
                <c:pt idx="2017">
                  <c:v>13.982089042663574</c:v>
                </c:pt>
                <c:pt idx="2018">
                  <c:v>13.994709014892578</c:v>
                </c:pt>
                <c:pt idx="2019">
                  <c:v>14.007331848144531</c:v>
                </c:pt>
                <c:pt idx="2020">
                  <c:v>14.019956588745117</c:v>
                </c:pt>
                <c:pt idx="2021">
                  <c:v>14.032585144042969</c:v>
                </c:pt>
                <c:pt idx="2022">
                  <c:v>14.04521656036377</c:v>
                </c:pt>
                <c:pt idx="2023">
                  <c:v>14.057851791381836</c:v>
                </c:pt>
                <c:pt idx="2024">
                  <c:v>14.070489883422852</c:v>
                </c:pt>
                <c:pt idx="2025">
                  <c:v>14.083132743835449</c:v>
                </c:pt>
                <c:pt idx="2026">
                  <c:v>14.095778465270996</c:v>
                </c:pt>
                <c:pt idx="2027">
                  <c:v>14.108427047729492</c:v>
                </c:pt>
                <c:pt idx="2028">
                  <c:v>14.121078491210938</c:v>
                </c:pt>
                <c:pt idx="2029">
                  <c:v>14.133733749389648</c:v>
                </c:pt>
                <c:pt idx="2030">
                  <c:v>14.146390914916992</c:v>
                </c:pt>
                <c:pt idx="2031">
                  <c:v>14.159052848815918</c:v>
                </c:pt>
                <c:pt idx="2032">
                  <c:v>14.171717643737793</c:v>
                </c:pt>
                <c:pt idx="2033">
                  <c:v>14.184385299682617</c:v>
                </c:pt>
                <c:pt idx="2034">
                  <c:v>14.197056770324707</c:v>
                </c:pt>
                <c:pt idx="2035">
                  <c:v>14.209731101989746</c:v>
                </c:pt>
                <c:pt idx="2036">
                  <c:v>14.222409248352051</c:v>
                </c:pt>
                <c:pt idx="2037">
                  <c:v>14.235091209411621</c:v>
                </c:pt>
                <c:pt idx="2038">
                  <c:v>14.247776031494141</c:v>
                </c:pt>
                <c:pt idx="2039">
                  <c:v>14.260464668273926</c:v>
                </c:pt>
                <c:pt idx="2040">
                  <c:v>14.273157119750977</c:v>
                </c:pt>
                <c:pt idx="2041">
                  <c:v>14.28585147857666</c:v>
                </c:pt>
                <c:pt idx="2042">
                  <c:v>14.298551559448242</c:v>
                </c:pt>
                <c:pt idx="2043">
                  <c:v>14.311254501342773</c:v>
                </c:pt>
                <c:pt idx="2044">
                  <c:v>14.32396125793457</c:v>
                </c:pt>
                <c:pt idx="2045">
                  <c:v>14.336669921875</c:v>
                </c:pt>
                <c:pt idx="2046">
                  <c:v>14.349383354187012</c:v>
                </c:pt>
                <c:pt idx="2047">
                  <c:v>14.362098693847656</c:v>
                </c:pt>
                <c:pt idx="2048">
                  <c:v>14.374818801879883</c:v>
                </c:pt>
                <c:pt idx="2049">
                  <c:v>14.387541770935059</c:v>
                </c:pt>
                <c:pt idx="2050">
                  <c:v>14.400269508361816</c:v>
                </c:pt>
                <c:pt idx="2051">
                  <c:v>14.412998199462891</c:v>
                </c:pt>
                <c:pt idx="2052">
                  <c:v>14.42573356628418</c:v>
                </c:pt>
                <c:pt idx="2053">
                  <c:v>14.438470840454102</c:v>
                </c:pt>
                <c:pt idx="2054">
                  <c:v>14.451211929321289</c:v>
                </c:pt>
                <c:pt idx="2055">
                  <c:v>14.463955879211426</c:v>
                </c:pt>
                <c:pt idx="2056">
                  <c:v>14.476705551147461</c:v>
                </c:pt>
                <c:pt idx="2057">
                  <c:v>14.489457130432129</c:v>
                </c:pt>
                <c:pt idx="2058">
                  <c:v>14.502215385437012</c:v>
                </c:pt>
                <c:pt idx="2059">
                  <c:v>14.514974594116211</c:v>
                </c:pt>
                <c:pt idx="2060">
                  <c:v>14.527737617492676</c:v>
                </c:pt>
                <c:pt idx="2061">
                  <c:v>14.540504455566406</c:v>
                </c:pt>
                <c:pt idx="2062">
                  <c:v>14.553274154663086</c:v>
                </c:pt>
                <c:pt idx="2063">
                  <c:v>14.566045761108398</c:v>
                </c:pt>
                <c:pt idx="2064">
                  <c:v>14.578823089599609</c:v>
                </c:pt>
                <c:pt idx="2065">
                  <c:v>14.591602325439453</c:v>
                </c:pt>
                <c:pt idx="2066">
                  <c:v>14.604387283325195</c:v>
                </c:pt>
                <c:pt idx="2067">
                  <c:v>14.617175102233887</c:v>
                </c:pt>
                <c:pt idx="2068">
                  <c:v>14.62996768951416</c:v>
                </c:pt>
                <c:pt idx="2069">
                  <c:v>14.642762184143066</c:v>
                </c:pt>
                <c:pt idx="2070">
                  <c:v>14.655562400817871</c:v>
                </c:pt>
                <c:pt idx="2071">
                  <c:v>14.668363571166992</c:v>
                </c:pt>
                <c:pt idx="2072">
                  <c:v>14.681168556213379</c:v>
                </c:pt>
                <c:pt idx="2073">
                  <c:v>14.693976402282715</c:v>
                </c:pt>
                <c:pt idx="2074">
                  <c:v>14.706788063049316</c:v>
                </c:pt>
                <c:pt idx="2075">
                  <c:v>14.719602584838867</c:v>
                </c:pt>
                <c:pt idx="2076">
                  <c:v>14.732421875</c:v>
                </c:pt>
                <c:pt idx="2077">
                  <c:v>14.745244026184082</c:v>
                </c:pt>
                <c:pt idx="2078">
                  <c:v>14.758071899414063</c:v>
                </c:pt>
                <c:pt idx="2079">
                  <c:v>14.770901679992676</c:v>
                </c:pt>
                <c:pt idx="2080">
                  <c:v>14.783735275268555</c:v>
                </c:pt>
                <c:pt idx="2081">
                  <c:v>14.79656982421875</c:v>
                </c:pt>
                <c:pt idx="2082">
                  <c:v>14.809412956237793</c:v>
                </c:pt>
                <c:pt idx="2083">
                  <c:v>14.822257041931152</c:v>
                </c:pt>
                <c:pt idx="2084">
                  <c:v>14.835105895996094</c:v>
                </c:pt>
                <c:pt idx="2085">
                  <c:v>14.847956657409668</c:v>
                </c:pt>
                <c:pt idx="2086">
                  <c:v>14.860813140869141</c:v>
                </c:pt>
                <c:pt idx="2087">
                  <c:v>14.873671531677246</c:v>
                </c:pt>
                <c:pt idx="2088">
                  <c:v>14.886534690856934</c:v>
                </c:pt>
                <c:pt idx="2089">
                  <c:v>14.89940071105957</c:v>
                </c:pt>
                <c:pt idx="2090">
                  <c:v>14.912270545959473</c:v>
                </c:pt>
                <c:pt idx="2091">
                  <c:v>14.925144195556641</c:v>
                </c:pt>
                <c:pt idx="2092">
                  <c:v>14.938022613525391</c:v>
                </c:pt>
                <c:pt idx="2093">
                  <c:v>14.950902938842773</c:v>
                </c:pt>
                <c:pt idx="2094">
                  <c:v>14.963790893554688</c:v>
                </c:pt>
                <c:pt idx="2095">
                  <c:v>14.976679801940918</c:v>
                </c:pt>
                <c:pt idx="2096">
                  <c:v>14.989574432373047</c:v>
                </c:pt>
                <c:pt idx="2097">
                  <c:v>15.002470970153809</c:v>
                </c:pt>
                <c:pt idx="2098">
                  <c:v>15.015373229980469</c:v>
                </c:pt>
                <c:pt idx="2099">
                  <c:v>15.028275489807129</c:v>
                </c:pt>
                <c:pt idx="2100">
                  <c:v>15.041183471679688</c:v>
                </c:pt>
                <c:pt idx="2101">
                  <c:v>15.054093360900879</c:v>
                </c:pt>
                <c:pt idx="2102">
                  <c:v>15.067009925842285</c:v>
                </c:pt>
                <c:pt idx="2103">
                  <c:v>15.079928398132324</c:v>
                </c:pt>
                <c:pt idx="2104">
                  <c:v>15.092852592468262</c:v>
                </c:pt>
                <c:pt idx="2105">
                  <c:v>15.105776786804199</c:v>
                </c:pt>
                <c:pt idx="2106">
                  <c:v>15.118710517883301</c:v>
                </c:pt>
                <c:pt idx="2107">
                  <c:v>15.131643295288086</c:v>
                </c:pt>
                <c:pt idx="2108">
                  <c:v>15.14458179473877</c:v>
                </c:pt>
                <c:pt idx="2109">
                  <c:v>15.157524108886719</c:v>
                </c:pt>
                <c:pt idx="2110">
                  <c:v>15.170473098754883</c:v>
                </c:pt>
                <c:pt idx="2111">
                  <c:v>15.183422088623047</c:v>
                </c:pt>
                <c:pt idx="2112">
                  <c:v>15.196376800537109</c:v>
                </c:pt>
                <c:pt idx="2113">
                  <c:v>15.209333419799805</c:v>
                </c:pt>
                <c:pt idx="2114">
                  <c:v>15.222292900085449</c:v>
                </c:pt>
                <c:pt idx="2115">
                  <c:v>15.235257148742676</c:v>
                </c:pt>
                <c:pt idx="2116">
                  <c:v>15.248226165771484</c:v>
                </c:pt>
                <c:pt idx="2117">
                  <c:v>15.261198997497559</c:v>
                </c:pt>
                <c:pt idx="2118">
                  <c:v>15.274177551269531</c:v>
                </c:pt>
                <c:pt idx="2119">
                  <c:v>15.287155151367188</c:v>
                </c:pt>
                <c:pt idx="2120">
                  <c:v>15.300140380859375</c:v>
                </c:pt>
                <c:pt idx="2121">
                  <c:v>15.313124656677246</c:v>
                </c:pt>
                <c:pt idx="2122">
                  <c:v>15.326115608215332</c:v>
                </c:pt>
                <c:pt idx="2123">
                  <c:v>15.339108467102051</c:v>
                </c:pt>
                <c:pt idx="2124">
                  <c:v>15.352107048034668</c:v>
                </c:pt>
                <c:pt idx="2125">
                  <c:v>15.365104675292969</c:v>
                </c:pt>
                <c:pt idx="2126">
                  <c:v>15.378111839294434</c:v>
                </c:pt>
                <c:pt idx="2127">
                  <c:v>15.391119003295898</c:v>
                </c:pt>
                <c:pt idx="2128">
                  <c:v>15.404130935668945</c:v>
                </c:pt>
                <c:pt idx="2129">
                  <c:v>15.417145729064941</c:v>
                </c:pt>
                <c:pt idx="2130">
                  <c:v>15.430166244506836</c:v>
                </c:pt>
                <c:pt idx="2131">
                  <c:v>15.44318962097168</c:v>
                </c:pt>
                <c:pt idx="2132">
                  <c:v>15.456215858459473</c:v>
                </c:pt>
                <c:pt idx="2133">
                  <c:v>15.469245910644531</c:v>
                </c:pt>
                <c:pt idx="2134">
                  <c:v>15.482278823852539</c:v>
                </c:pt>
                <c:pt idx="2135">
                  <c:v>15.495316505432129</c:v>
                </c:pt>
                <c:pt idx="2136">
                  <c:v>15.508359909057617</c:v>
                </c:pt>
                <c:pt idx="2137">
                  <c:v>15.521405220031738</c:v>
                </c:pt>
                <c:pt idx="2138">
                  <c:v>15.534454345703125</c:v>
                </c:pt>
                <c:pt idx="2139">
                  <c:v>15.547507286071777</c:v>
                </c:pt>
                <c:pt idx="2140">
                  <c:v>15.560563087463379</c:v>
                </c:pt>
                <c:pt idx="2141">
                  <c:v>15.57362174987793</c:v>
                </c:pt>
                <c:pt idx="2142">
                  <c:v>15.586684226989746</c:v>
                </c:pt>
                <c:pt idx="2143">
                  <c:v>15.599750518798828</c:v>
                </c:pt>
                <c:pt idx="2144">
                  <c:v>15.612821578979492</c:v>
                </c:pt>
                <c:pt idx="2145">
                  <c:v>15.625894546508789</c:v>
                </c:pt>
                <c:pt idx="2146">
                  <c:v>15.638972282409668</c:v>
                </c:pt>
                <c:pt idx="2147">
                  <c:v>15.652053833007813</c:v>
                </c:pt>
                <c:pt idx="2148">
                  <c:v>15.665141105651855</c:v>
                </c:pt>
                <c:pt idx="2149">
                  <c:v>15.678232192993164</c:v>
                </c:pt>
                <c:pt idx="2150">
                  <c:v>15.691330909729004</c:v>
                </c:pt>
                <c:pt idx="2151">
                  <c:v>15.704427719116211</c:v>
                </c:pt>
                <c:pt idx="2152">
                  <c:v>15.717529296875</c:v>
                </c:pt>
                <c:pt idx="2153">
                  <c:v>15.730636596679688</c:v>
                </c:pt>
                <c:pt idx="2154">
                  <c:v>15.743747711181641</c:v>
                </c:pt>
                <c:pt idx="2155">
                  <c:v>15.756862640380859</c:v>
                </c:pt>
                <c:pt idx="2156">
                  <c:v>15.769980430603027</c:v>
                </c:pt>
                <c:pt idx="2157">
                  <c:v>15.783100128173828</c:v>
                </c:pt>
                <c:pt idx="2158">
                  <c:v>15.796224594116211</c:v>
                </c:pt>
                <c:pt idx="2159">
                  <c:v>15.809353828430176</c:v>
                </c:pt>
                <c:pt idx="2160">
                  <c:v>15.82248592376709</c:v>
                </c:pt>
                <c:pt idx="2161">
                  <c:v>15.83562183380127</c:v>
                </c:pt>
                <c:pt idx="2162">
                  <c:v>15.848761558532715</c:v>
                </c:pt>
                <c:pt idx="2163">
                  <c:v>15.861903190612793</c:v>
                </c:pt>
                <c:pt idx="2164">
                  <c:v>15.875049591064453</c:v>
                </c:pt>
                <c:pt idx="2165">
                  <c:v>15.888198852539063</c:v>
                </c:pt>
                <c:pt idx="2166">
                  <c:v>15.90135383605957</c:v>
                </c:pt>
                <c:pt idx="2167">
                  <c:v>15.914512634277344</c:v>
                </c:pt>
                <c:pt idx="2168">
                  <c:v>15.92767333984375</c:v>
                </c:pt>
                <c:pt idx="2169">
                  <c:v>15.940836906433105</c:v>
                </c:pt>
                <c:pt idx="2170">
                  <c:v>15.95400333404541</c:v>
                </c:pt>
                <c:pt idx="2171">
                  <c:v>15.967174530029297</c:v>
                </c:pt>
                <c:pt idx="2172">
                  <c:v>15.980348587036133</c:v>
                </c:pt>
                <c:pt idx="2173">
                  <c:v>15.993526458740234</c:v>
                </c:pt>
                <c:pt idx="2174">
                  <c:v>16.007013320922852</c:v>
                </c:pt>
                <c:pt idx="2175">
                  <c:v>16.020502090454102</c:v>
                </c:pt>
                <c:pt idx="2176">
                  <c:v>16.033994674682617</c:v>
                </c:pt>
                <c:pt idx="2177">
                  <c:v>16.047492980957031</c:v>
                </c:pt>
                <c:pt idx="2178">
                  <c:v>16.060993194580078</c:v>
                </c:pt>
                <c:pt idx="2179">
                  <c:v>16.074499130249023</c:v>
                </c:pt>
                <c:pt idx="2180">
                  <c:v>16.088006973266602</c:v>
                </c:pt>
                <c:pt idx="2181">
                  <c:v>16.101518630981445</c:v>
                </c:pt>
                <c:pt idx="2182">
                  <c:v>16.115034103393555</c:v>
                </c:pt>
                <c:pt idx="2183">
                  <c:v>16.12855339050293</c:v>
                </c:pt>
                <c:pt idx="2184">
                  <c:v>16.142078399658203</c:v>
                </c:pt>
                <c:pt idx="2185">
                  <c:v>16.155605316162109</c:v>
                </c:pt>
                <c:pt idx="2186">
                  <c:v>16.169136047363281</c:v>
                </c:pt>
                <c:pt idx="2187">
                  <c:v>16.182670593261719</c:v>
                </c:pt>
                <c:pt idx="2188">
                  <c:v>16.196210861206055</c:v>
                </c:pt>
                <c:pt idx="2189">
                  <c:v>16.209749221801758</c:v>
                </c:pt>
                <c:pt idx="2190">
                  <c:v>16.223295211791992</c:v>
                </c:pt>
                <c:pt idx="2191">
                  <c:v>16.236843109130859</c:v>
                </c:pt>
                <c:pt idx="2192">
                  <c:v>16.250394821166992</c:v>
                </c:pt>
                <c:pt idx="2193">
                  <c:v>16.263948440551758</c:v>
                </c:pt>
                <c:pt idx="2194">
                  <c:v>16.277507781982422</c:v>
                </c:pt>
                <c:pt idx="2195">
                  <c:v>16.291070938110352</c:v>
                </c:pt>
                <c:pt idx="2196">
                  <c:v>16.30463981628418</c:v>
                </c:pt>
                <c:pt idx="2197">
                  <c:v>16.318212509155273</c:v>
                </c:pt>
                <c:pt idx="2198">
                  <c:v>16.331789016723633</c:v>
                </c:pt>
                <c:pt idx="2199">
                  <c:v>16.345367431640625</c:v>
                </c:pt>
                <c:pt idx="2200">
                  <c:v>16.358949661254883</c:v>
                </c:pt>
                <c:pt idx="2201">
                  <c:v>16.372535705566406</c:v>
                </c:pt>
                <c:pt idx="2202">
                  <c:v>16.386125564575195</c:v>
                </c:pt>
                <c:pt idx="2203">
                  <c:v>16.39971923828125</c:v>
                </c:pt>
                <c:pt idx="2204">
                  <c:v>16.413314819335938</c:v>
                </c:pt>
                <c:pt idx="2205">
                  <c:v>16.426916122436523</c:v>
                </c:pt>
                <c:pt idx="2206">
                  <c:v>16.440521240234375</c:v>
                </c:pt>
                <c:pt idx="2207">
                  <c:v>16.454128265380859</c:v>
                </c:pt>
                <c:pt idx="2208">
                  <c:v>16.467741012573242</c:v>
                </c:pt>
                <c:pt idx="2209">
                  <c:v>16.481359481811523</c:v>
                </c:pt>
                <c:pt idx="2210">
                  <c:v>16.494977951049805</c:v>
                </c:pt>
                <c:pt idx="2211">
                  <c:v>16.508600234985352</c:v>
                </c:pt>
                <c:pt idx="2212">
                  <c:v>16.522224426269531</c:v>
                </c:pt>
                <c:pt idx="2213">
                  <c:v>16.535856246948242</c:v>
                </c:pt>
                <c:pt idx="2214">
                  <c:v>16.549488067626953</c:v>
                </c:pt>
                <c:pt idx="2215">
                  <c:v>16.563127517700195</c:v>
                </c:pt>
                <c:pt idx="2216">
                  <c:v>16.576765060424805</c:v>
                </c:pt>
                <c:pt idx="2217">
                  <c:v>16.590410232543945</c:v>
                </c:pt>
                <c:pt idx="2218">
                  <c:v>16.604059219360352</c:v>
                </c:pt>
                <c:pt idx="2219">
                  <c:v>16.617712020874023</c:v>
                </c:pt>
                <c:pt idx="2220">
                  <c:v>16.631366729736328</c:v>
                </c:pt>
                <c:pt idx="2221">
                  <c:v>16.645023345947266</c:v>
                </c:pt>
                <c:pt idx="2222">
                  <c:v>16.658683776855469</c:v>
                </c:pt>
                <c:pt idx="2223">
                  <c:v>16.672348022460938</c:v>
                </c:pt>
                <c:pt idx="2224">
                  <c:v>16.686016082763672</c:v>
                </c:pt>
                <c:pt idx="2225">
                  <c:v>16.699689865112305</c:v>
                </c:pt>
                <c:pt idx="2226">
                  <c:v>16.713363647460938</c:v>
                </c:pt>
                <c:pt idx="2227">
                  <c:v>16.727041244506836</c:v>
                </c:pt>
                <c:pt idx="2228">
                  <c:v>16.74072265625</c:v>
                </c:pt>
                <c:pt idx="2229">
                  <c:v>16.75440788269043</c:v>
                </c:pt>
                <c:pt idx="2230">
                  <c:v>16.768095016479492</c:v>
                </c:pt>
                <c:pt idx="2231">
                  <c:v>16.78178596496582</c:v>
                </c:pt>
                <c:pt idx="2232">
                  <c:v>16.795482635498047</c:v>
                </c:pt>
                <c:pt idx="2233">
                  <c:v>16.809181213378906</c:v>
                </c:pt>
                <c:pt idx="2234">
                  <c:v>16.822883605957031</c:v>
                </c:pt>
                <c:pt idx="2235">
                  <c:v>16.836591720581055</c:v>
                </c:pt>
                <c:pt idx="2236">
                  <c:v>16.850301742553711</c:v>
                </c:pt>
                <c:pt idx="2237">
                  <c:v>16.864017486572266</c:v>
                </c:pt>
                <c:pt idx="2238">
                  <c:v>16.877737045288086</c:v>
                </c:pt>
                <c:pt idx="2239">
                  <c:v>16.891460418701172</c:v>
                </c:pt>
                <c:pt idx="2240">
                  <c:v>16.905185699462891</c:v>
                </c:pt>
                <c:pt idx="2241">
                  <c:v>16.918916702270508</c:v>
                </c:pt>
                <c:pt idx="2242">
                  <c:v>16.932647705078125</c:v>
                </c:pt>
                <c:pt idx="2243">
                  <c:v>16.946382522583008</c:v>
                </c:pt>
                <c:pt idx="2244">
                  <c:v>16.960123062133789</c:v>
                </c:pt>
                <c:pt idx="2245">
                  <c:v>16.973867416381836</c:v>
                </c:pt>
                <c:pt idx="2246">
                  <c:v>16.987615585327148</c:v>
                </c:pt>
                <c:pt idx="2247">
                  <c:v>17.001365661621094</c:v>
                </c:pt>
                <c:pt idx="2248">
                  <c:v>17.015119552612305</c:v>
                </c:pt>
                <c:pt idx="2249">
                  <c:v>17.028877258300781</c:v>
                </c:pt>
                <c:pt idx="2250">
                  <c:v>17.042640686035156</c:v>
                </c:pt>
                <c:pt idx="2251">
                  <c:v>17.056406021118164</c:v>
                </c:pt>
                <c:pt idx="2252">
                  <c:v>17.070175170898438</c:v>
                </c:pt>
                <c:pt idx="2253">
                  <c:v>17.083946228027344</c:v>
                </c:pt>
                <c:pt idx="2254">
                  <c:v>17.097724914550781</c:v>
                </c:pt>
                <c:pt idx="2255">
                  <c:v>17.111505508422852</c:v>
                </c:pt>
                <c:pt idx="2256">
                  <c:v>17.125288009643555</c:v>
                </c:pt>
                <c:pt idx="2257">
                  <c:v>17.139076232910156</c:v>
                </c:pt>
                <c:pt idx="2258">
                  <c:v>17.152864456176758</c:v>
                </c:pt>
                <c:pt idx="2259">
                  <c:v>17.166658401489258</c:v>
                </c:pt>
                <c:pt idx="2260">
                  <c:v>17.180458068847656</c:v>
                </c:pt>
                <c:pt idx="2261">
                  <c:v>17.194257736206055</c:v>
                </c:pt>
                <c:pt idx="2262">
                  <c:v>17.208063125610352</c:v>
                </c:pt>
                <c:pt idx="2263">
                  <c:v>17.221874237060547</c:v>
                </c:pt>
                <c:pt idx="2264">
                  <c:v>17.235685348510742</c:v>
                </c:pt>
                <c:pt idx="2265">
                  <c:v>17.249500274658203</c:v>
                </c:pt>
                <c:pt idx="2266">
                  <c:v>17.263320922851563</c:v>
                </c:pt>
                <c:pt idx="2267">
                  <c:v>17.277141571044922</c:v>
                </c:pt>
                <c:pt idx="2268">
                  <c:v>17.29096794128418</c:v>
                </c:pt>
                <c:pt idx="2269">
                  <c:v>17.30479621887207</c:v>
                </c:pt>
                <c:pt idx="2270">
                  <c:v>17.318628311157227</c:v>
                </c:pt>
                <c:pt idx="2271">
                  <c:v>17.332464218139648</c:v>
                </c:pt>
                <c:pt idx="2272">
                  <c:v>17.346303939819336</c:v>
                </c:pt>
                <c:pt idx="2273">
                  <c:v>17.360147476196289</c:v>
                </c:pt>
                <c:pt idx="2274">
                  <c:v>17.373994827270508</c:v>
                </c:pt>
                <c:pt idx="2275">
                  <c:v>17.387845993041992</c:v>
                </c:pt>
                <c:pt idx="2276">
                  <c:v>17.401697158813477</c:v>
                </c:pt>
                <c:pt idx="2277">
                  <c:v>17.415555953979492</c:v>
                </c:pt>
                <c:pt idx="2278">
                  <c:v>17.429414749145508</c:v>
                </c:pt>
                <c:pt idx="2279">
                  <c:v>17.443279266357422</c:v>
                </c:pt>
                <c:pt idx="2280">
                  <c:v>17.457147598266602</c:v>
                </c:pt>
                <c:pt idx="2281">
                  <c:v>17.471019744873047</c:v>
                </c:pt>
                <c:pt idx="2282">
                  <c:v>17.484893798828125</c:v>
                </c:pt>
                <c:pt idx="2283">
                  <c:v>17.498769760131836</c:v>
                </c:pt>
                <c:pt idx="2284">
                  <c:v>17.512651443481445</c:v>
                </c:pt>
                <c:pt idx="2285">
                  <c:v>17.526535034179688</c:v>
                </c:pt>
                <c:pt idx="2286">
                  <c:v>17.540422439575195</c:v>
                </c:pt>
                <c:pt idx="2287">
                  <c:v>17.554315567016602</c:v>
                </c:pt>
                <c:pt idx="2288">
                  <c:v>17.568210601806641</c:v>
                </c:pt>
                <c:pt idx="2289">
                  <c:v>17.582109451293945</c:v>
                </c:pt>
                <c:pt idx="2290">
                  <c:v>17.596012115478516</c:v>
                </c:pt>
                <c:pt idx="2291">
                  <c:v>17.609918594360352</c:v>
                </c:pt>
                <c:pt idx="2292">
                  <c:v>17.62382698059082</c:v>
                </c:pt>
                <c:pt idx="2293">
                  <c:v>17.637741088867188</c:v>
                </c:pt>
                <c:pt idx="2294">
                  <c:v>17.651657104492188</c:v>
                </c:pt>
                <c:pt idx="2295">
                  <c:v>17.665576934814453</c:v>
                </c:pt>
                <c:pt idx="2296">
                  <c:v>17.679500579833984</c:v>
                </c:pt>
                <c:pt idx="2297">
                  <c:v>17.693429946899414</c:v>
                </c:pt>
                <c:pt idx="2298">
                  <c:v>17.707359313964844</c:v>
                </c:pt>
                <c:pt idx="2299">
                  <c:v>17.721294403076172</c:v>
                </c:pt>
                <c:pt idx="2300">
                  <c:v>17.735233306884766</c:v>
                </c:pt>
                <c:pt idx="2301">
                  <c:v>17.749174118041992</c:v>
                </c:pt>
                <c:pt idx="2302">
                  <c:v>17.763118743896484</c:v>
                </c:pt>
                <c:pt idx="2303">
                  <c:v>17.777065277099609</c:v>
                </c:pt>
                <c:pt idx="2304">
                  <c:v>17.791017532348633</c:v>
                </c:pt>
                <c:pt idx="2305">
                  <c:v>17.804971694946289</c:v>
                </c:pt>
                <c:pt idx="2306">
                  <c:v>17.818929672241211</c:v>
                </c:pt>
                <c:pt idx="2307">
                  <c:v>17.832891464233398</c:v>
                </c:pt>
                <c:pt idx="2308">
                  <c:v>17.846857070922852</c:v>
                </c:pt>
                <c:pt idx="2309">
                  <c:v>17.86082649230957</c:v>
                </c:pt>
                <c:pt idx="2310">
                  <c:v>17.874799728393555</c:v>
                </c:pt>
                <c:pt idx="2311">
                  <c:v>17.888774871826172</c:v>
                </c:pt>
                <c:pt idx="2312">
                  <c:v>17.902755737304688</c:v>
                </c:pt>
                <c:pt idx="2313">
                  <c:v>17.916738510131836</c:v>
                </c:pt>
                <c:pt idx="2314">
                  <c:v>17.930723190307617</c:v>
                </c:pt>
                <c:pt idx="2315">
                  <c:v>17.944713592529297</c:v>
                </c:pt>
                <c:pt idx="2316">
                  <c:v>17.958705902099609</c:v>
                </c:pt>
                <c:pt idx="2317">
                  <c:v>17.972702026367188</c:v>
                </c:pt>
                <c:pt idx="2318">
                  <c:v>17.986701965332031</c:v>
                </c:pt>
                <c:pt idx="2319">
                  <c:v>18.000705718994141</c:v>
                </c:pt>
                <c:pt idx="2320">
                  <c:v>18.014713287353516</c:v>
                </c:pt>
                <c:pt idx="2321">
                  <c:v>18.028724670410156</c:v>
                </c:pt>
                <c:pt idx="2322">
                  <c:v>18.04273796081543</c:v>
                </c:pt>
                <c:pt idx="2323">
                  <c:v>18.056755065917969</c:v>
                </c:pt>
                <c:pt idx="2324">
                  <c:v>18.070775985717773</c:v>
                </c:pt>
                <c:pt idx="2325">
                  <c:v>18.084800720214844</c:v>
                </c:pt>
                <c:pt idx="2326">
                  <c:v>18.098827362060547</c:v>
                </c:pt>
                <c:pt idx="2327">
                  <c:v>18.112857818603516</c:v>
                </c:pt>
                <c:pt idx="2328">
                  <c:v>18.126893997192383</c:v>
                </c:pt>
                <c:pt idx="2329">
                  <c:v>18.140932083129883</c:v>
                </c:pt>
                <c:pt idx="2330">
                  <c:v>18.154972076416016</c:v>
                </c:pt>
                <c:pt idx="2331">
                  <c:v>18.169017791748047</c:v>
                </c:pt>
                <c:pt idx="2332">
                  <c:v>18.183065414428711</c:v>
                </c:pt>
                <c:pt idx="2333">
                  <c:v>18.197118759155273</c:v>
                </c:pt>
                <c:pt idx="2334">
                  <c:v>18.211174011230469</c:v>
                </c:pt>
                <c:pt idx="2335">
                  <c:v>18.225231170654297</c:v>
                </c:pt>
                <c:pt idx="2336">
                  <c:v>18.239294052124023</c:v>
                </c:pt>
                <c:pt idx="2337">
                  <c:v>18.253360748291016</c:v>
                </c:pt>
                <c:pt idx="2338">
                  <c:v>18.267429351806641</c:v>
                </c:pt>
                <c:pt idx="2339">
                  <c:v>18.281501770019531</c:v>
                </c:pt>
                <c:pt idx="2340">
                  <c:v>18.295578002929688</c:v>
                </c:pt>
                <c:pt idx="2341">
                  <c:v>18.309656143188477</c:v>
                </c:pt>
                <c:pt idx="2342">
                  <c:v>18.323740005493164</c:v>
                </c:pt>
                <c:pt idx="2343">
                  <c:v>18.337825775146484</c:v>
                </c:pt>
                <c:pt idx="2344">
                  <c:v>18.35191535949707</c:v>
                </c:pt>
                <c:pt idx="2345">
                  <c:v>18.366008758544922</c:v>
                </c:pt>
                <c:pt idx="2346">
                  <c:v>18.380105972290039</c:v>
                </c:pt>
                <c:pt idx="2347">
                  <c:v>18.394205093383789</c:v>
                </c:pt>
                <c:pt idx="2348">
                  <c:v>18.408308029174805</c:v>
                </c:pt>
                <c:pt idx="2349">
                  <c:v>18.422414779663086</c:v>
                </c:pt>
                <c:pt idx="2350">
                  <c:v>18.436525344848633</c:v>
                </c:pt>
                <c:pt idx="2351">
                  <c:v>18.450639724731445</c:v>
                </c:pt>
                <c:pt idx="2352">
                  <c:v>18.464756011962891</c:v>
                </c:pt>
                <c:pt idx="2353">
                  <c:v>18.478878021240234</c:v>
                </c:pt>
                <c:pt idx="2354">
                  <c:v>18.493001937866211</c:v>
                </c:pt>
                <c:pt idx="2355">
                  <c:v>18.507129669189453</c:v>
                </c:pt>
                <c:pt idx="2356">
                  <c:v>18.521259307861328</c:v>
                </c:pt>
                <c:pt idx="2357">
                  <c:v>18.535394668579102</c:v>
                </c:pt>
                <c:pt idx="2358">
                  <c:v>18.549531936645508</c:v>
                </c:pt>
                <c:pt idx="2359">
                  <c:v>18.56367301940918</c:v>
                </c:pt>
                <c:pt idx="2360">
                  <c:v>18.577817916870117</c:v>
                </c:pt>
                <c:pt idx="2361">
                  <c:v>18.59196662902832</c:v>
                </c:pt>
                <c:pt idx="2362">
                  <c:v>18.606119155883789</c:v>
                </c:pt>
                <c:pt idx="2363">
                  <c:v>18.620273590087891</c:v>
                </c:pt>
                <c:pt idx="2364">
                  <c:v>18.634431838989258</c:v>
                </c:pt>
                <c:pt idx="2365">
                  <c:v>18.648593902587891</c:v>
                </c:pt>
                <c:pt idx="2366">
                  <c:v>18.662759780883789</c:v>
                </c:pt>
                <c:pt idx="2367">
                  <c:v>18.67692756652832</c:v>
                </c:pt>
                <c:pt idx="2368">
                  <c:v>18.69110107421875</c:v>
                </c:pt>
                <c:pt idx="2369">
                  <c:v>18.705276489257813</c:v>
                </c:pt>
                <c:pt idx="2370">
                  <c:v>18.719455718994141</c:v>
                </c:pt>
                <c:pt idx="2371">
                  <c:v>18.733638763427734</c:v>
                </c:pt>
                <c:pt idx="2372">
                  <c:v>18.747823715209961</c:v>
                </c:pt>
                <c:pt idx="2373">
                  <c:v>18.762012481689453</c:v>
                </c:pt>
                <c:pt idx="2374">
                  <c:v>18.776206970214844</c:v>
                </c:pt>
                <c:pt idx="2375">
                  <c:v>18.790403366088867</c:v>
                </c:pt>
                <c:pt idx="2376">
                  <c:v>18.804601669311523</c:v>
                </c:pt>
                <c:pt idx="2377">
                  <c:v>18.818805694580078</c:v>
                </c:pt>
                <c:pt idx="2378">
                  <c:v>18.833011627197266</c:v>
                </c:pt>
                <c:pt idx="2379">
                  <c:v>18.847221374511719</c:v>
                </c:pt>
                <c:pt idx="2380">
                  <c:v>18.861434936523438</c:v>
                </c:pt>
                <c:pt idx="2381">
                  <c:v>18.875652313232422</c:v>
                </c:pt>
                <c:pt idx="2382">
                  <c:v>18.889873504638672</c:v>
                </c:pt>
                <c:pt idx="2383">
                  <c:v>18.904096603393555</c:v>
                </c:pt>
                <c:pt idx="2384">
                  <c:v>18.918323516845703</c:v>
                </c:pt>
                <c:pt idx="2385">
                  <c:v>18.932554244995117</c:v>
                </c:pt>
                <c:pt idx="2386">
                  <c:v>18.946788787841797</c:v>
                </c:pt>
                <c:pt idx="2387">
                  <c:v>18.961027145385742</c:v>
                </c:pt>
                <c:pt idx="2388">
                  <c:v>18.97526741027832</c:v>
                </c:pt>
                <c:pt idx="2389">
                  <c:v>18.989513397216797</c:v>
                </c:pt>
                <c:pt idx="2390">
                  <c:v>19.003761291503906</c:v>
                </c:pt>
                <c:pt idx="2391">
                  <c:v>19.018013000488281</c:v>
                </c:pt>
                <c:pt idx="2392">
                  <c:v>19.032266616821289</c:v>
                </c:pt>
                <c:pt idx="2393">
                  <c:v>19.046525955200195</c:v>
                </c:pt>
                <c:pt idx="2394">
                  <c:v>19.060787200927734</c:v>
                </c:pt>
                <c:pt idx="2395">
                  <c:v>19.075052261352539</c:v>
                </c:pt>
                <c:pt idx="2396">
                  <c:v>19.089321136474609</c:v>
                </c:pt>
                <c:pt idx="2397">
                  <c:v>19.103591918945313</c:v>
                </c:pt>
                <c:pt idx="2398">
                  <c:v>19.117868423461914</c:v>
                </c:pt>
                <c:pt idx="2399">
                  <c:v>19.132146835327148</c:v>
                </c:pt>
                <c:pt idx="2400">
                  <c:v>19.146429061889648</c:v>
                </c:pt>
                <c:pt idx="2401">
                  <c:v>19.160715103149414</c:v>
                </c:pt>
                <c:pt idx="2402">
                  <c:v>19.175004959106445</c:v>
                </c:pt>
                <c:pt idx="2403">
                  <c:v>19.189296722412109</c:v>
                </c:pt>
                <c:pt idx="2404">
                  <c:v>19.203592300415039</c:v>
                </c:pt>
                <c:pt idx="2405">
                  <c:v>19.217891693115234</c:v>
                </c:pt>
                <c:pt idx="2406">
                  <c:v>19.232194900512695</c:v>
                </c:pt>
                <c:pt idx="2407">
                  <c:v>19.246501922607422</c:v>
                </c:pt>
                <c:pt idx="2408">
                  <c:v>19.260810852050781</c:v>
                </c:pt>
                <c:pt idx="2409">
                  <c:v>19.275123596191406</c:v>
                </c:pt>
                <c:pt idx="2410">
                  <c:v>19.289440155029297</c:v>
                </c:pt>
                <c:pt idx="2411">
                  <c:v>19.303760528564453</c:v>
                </c:pt>
                <c:pt idx="2412">
                  <c:v>19.318084716796875</c:v>
                </c:pt>
                <c:pt idx="2413">
                  <c:v>19.332412719726563</c:v>
                </c:pt>
                <c:pt idx="2414">
                  <c:v>19.346742630004883</c:v>
                </c:pt>
                <c:pt idx="2415">
                  <c:v>19.361076354980469</c:v>
                </c:pt>
                <c:pt idx="2416">
                  <c:v>19.37541389465332</c:v>
                </c:pt>
                <c:pt idx="2417">
                  <c:v>19.389755249023438</c:v>
                </c:pt>
                <c:pt idx="2418">
                  <c:v>19.404098510742188</c:v>
                </c:pt>
                <c:pt idx="2419">
                  <c:v>19.418447494506836</c:v>
                </c:pt>
                <c:pt idx="2420">
                  <c:v>19.432798385620117</c:v>
                </c:pt>
                <c:pt idx="2421">
                  <c:v>19.447153091430664</c:v>
                </c:pt>
                <c:pt idx="2422">
                  <c:v>19.461511611938477</c:v>
                </c:pt>
                <c:pt idx="2423">
                  <c:v>19.475873947143555</c:v>
                </c:pt>
                <c:pt idx="2424">
                  <c:v>19.490238189697266</c:v>
                </c:pt>
                <c:pt idx="2425">
                  <c:v>19.504606246948242</c:v>
                </c:pt>
                <c:pt idx="2426">
                  <c:v>19.518978118896484</c:v>
                </c:pt>
                <c:pt idx="2427">
                  <c:v>19.533353805541992</c:v>
                </c:pt>
                <c:pt idx="2428">
                  <c:v>19.547733306884766</c:v>
                </c:pt>
                <c:pt idx="2429">
                  <c:v>19.562114715576172</c:v>
                </c:pt>
                <c:pt idx="2430">
                  <c:v>19.576499938964844</c:v>
                </c:pt>
                <c:pt idx="2431">
                  <c:v>19.590890884399414</c:v>
                </c:pt>
                <c:pt idx="2432">
                  <c:v>19.605283737182617</c:v>
                </c:pt>
                <c:pt idx="2433">
                  <c:v>19.619678497314453</c:v>
                </c:pt>
                <c:pt idx="2434">
                  <c:v>19.634077072143555</c:v>
                </c:pt>
                <c:pt idx="2435">
                  <c:v>19.648481369018555</c:v>
                </c:pt>
                <c:pt idx="2436">
                  <c:v>19.662887573242188</c:v>
                </c:pt>
                <c:pt idx="2437">
                  <c:v>19.677297592163086</c:v>
                </c:pt>
                <c:pt idx="2438">
                  <c:v>19.69171142578125</c:v>
                </c:pt>
                <c:pt idx="2439">
                  <c:v>19.706127166748047</c:v>
                </c:pt>
                <c:pt idx="2440">
                  <c:v>19.720546722412109</c:v>
                </c:pt>
                <c:pt idx="2441">
                  <c:v>19.73497200012207</c:v>
                </c:pt>
                <c:pt idx="2442">
                  <c:v>19.749399185180664</c:v>
                </c:pt>
                <c:pt idx="2443">
                  <c:v>19.763830184936523</c:v>
                </c:pt>
                <c:pt idx="2444">
                  <c:v>19.778263092041016</c:v>
                </c:pt>
                <c:pt idx="2445">
                  <c:v>19.792701721191406</c:v>
                </c:pt>
                <c:pt idx="2446">
                  <c:v>19.807140350341797</c:v>
                </c:pt>
                <c:pt idx="2447">
                  <c:v>19.821586608886719</c:v>
                </c:pt>
                <c:pt idx="2448">
                  <c:v>19.836032867431641</c:v>
                </c:pt>
                <c:pt idx="2449">
                  <c:v>19.850484848022461</c:v>
                </c:pt>
                <c:pt idx="2450">
                  <c:v>19.864938735961914</c:v>
                </c:pt>
                <c:pt idx="2451">
                  <c:v>19.879396438598633</c:v>
                </c:pt>
                <c:pt idx="2452">
                  <c:v>19.893857955932617</c:v>
                </c:pt>
                <c:pt idx="2453">
                  <c:v>19.908323287963867</c:v>
                </c:pt>
                <c:pt idx="2454">
                  <c:v>19.922792434692383</c:v>
                </c:pt>
                <c:pt idx="2455">
                  <c:v>19.937265396118164</c:v>
                </c:pt>
                <c:pt idx="2456">
                  <c:v>19.951740264892578</c:v>
                </c:pt>
                <c:pt idx="2457">
                  <c:v>19.966218948364258</c:v>
                </c:pt>
                <c:pt idx="2458">
                  <c:v>19.980701446533203</c:v>
                </c:pt>
                <c:pt idx="2459">
                  <c:v>19.995187759399414</c:v>
                </c:pt>
                <c:pt idx="2460">
                  <c:v>20.009675979614258</c:v>
                </c:pt>
                <c:pt idx="2461">
                  <c:v>20.024169921875</c:v>
                </c:pt>
                <c:pt idx="2462">
                  <c:v>20.038665771484375</c:v>
                </c:pt>
                <c:pt idx="2463">
                  <c:v>20.053163528442383</c:v>
                </c:pt>
                <c:pt idx="2464">
                  <c:v>20.067667007446289</c:v>
                </c:pt>
                <c:pt idx="2465">
                  <c:v>20.082172393798828</c:v>
                </c:pt>
                <c:pt idx="2466">
                  <c:v>20.096681594848633</c:v>
                </c:pt>
                <c:pt idx="2467">
                  <c:v>20.111196517944336</c:v>
                </c:pt>
                <c:pt idx="2468">
                  <c:v>20.125713348388672</c:v>
                </c:pt>
                <c:pt idx="2469">
                  <c:v>20.140233993530273</c:v>
                </c:pt>
                <c:pt idx="2470">
                  <c:v>20.154756546020508</c:v>
                </c:pt>
                <c:pt idx="2471">
                  <c:v>20.169282913208008</c:v>
                </c:pt>
                <c:pt idx="2472">
                  <c:v>20.183813095092773</c:v>
                </c:pt>
                <c:pt idx="2473">
                  <c:v>20.198348999023438</c:v>
                </c:pt>
                <c:pt idx="2474">
                  <c:v>20.212884902954102</c:v>
                </c:pt>
                <c:pt idx="2475">
                  <c:v>20.227426528930664</c:v>
                </c:pt>
                <c:pt idx="2476">
                  <c:v>20.241971969604492</c:v>
                </c:pt>
                <c:pt idx="2477">
                  <c:v>20.256519317626953</c:v>
                </c:pt>
                <c:pt idx="2478">
                  <c:v>20.271068572998047</c:v>
                </c:pt>
                <c:pt idx="2479">
                  <c:v>20.285623550415039</c:v>
                </c:pt>
                <c:pt idx="2480">
                  <c:v>20.300180435180664</c:v>
                </c:pt>
                <c:pt idx="2481">
                  <c:v>20.314743041992188</c:v>
                </c:pt>
                <c:pt idx="2482">
                  <c:v>20.329307556152344</c:v>
                </c:pt>
                <c:pt idx="2483">
                  <c:v>20.343875885009766</c:v>
                </c:pt>
                <c:pt idx="2484">
                  <c:v>20.35844612121582</c:v>
                </c:pt>
                <c:pt idx="2485">
                  <c:v>20.373022079467773</c:v>
                </c:pt>
                <c:pt idx="2486">
                  <c:v>20.387599945068359</c:v>
                </c:pt>
                <c:pt idx="2487">
                  <c:v>20.402181625366211</c:v>
                </c:pt>
                <c:pt idx="2488">
                  <c:v>20.416765213012695</c:v>
                </c:pt>
                <c:pt idx="2489">
                  <c:v>20.431354522705078</c:v>
                </c:pt>
                <c:pt idx="2490">
                  <c:v>20.445947647094727</c:v>
                </c:pt>
                <c:pt idx="2491">
                  <c:v>20.460544586181641</c:v>
                </c:pt>
                <c:pt idx="2492">
                  <c:v>20.475143432617188</c:v>
                </c:pt>
                <c:pt idx="2493">
                  <c:v>20.48974609375</c:v>
                </c:pt>
                <c:pt idx="2494">
                  <c:v>20.504352569580078</c:v>
                </c:pt>
                <c:pt idx="2495">
                  <c:v>20.518964767456055</c:v>
                </c:pt>
                <c:pt idx="2496">
                  <c:v>20.533576965332031</c:v>
                </c:pt>
                <c:pt idx="2497">
                  <c:v>20.548194885253906</c:v>
                </c:pt>
                <c:pt idx="2498">
                  <c:v>20.562814712524414</c:v>
                </c:pt>
                <c:pt idx="2499">
                  <c:v>20.577438354492188</c:v>
                </c:pt>
                <c:pt idx="2500">
                  <c:v>20.592065811157227</c:v>
                </c:pt>
                <c:pt idx="2501">
                  <c:v>20.606697082519531</c:v>
                </c:pt>
                <c:pt idx="2502">
                  <c:v>20.621332168579102</c:v>
                </c:pt>
                <c:pt idx="2503">
                  <c:v>20.635969161987305</c:v>
                </c:pt>
                <c:pt idx="2504">
                  <c:v>20.650609970092773</c:v>
                </c:pt>
                <c:pt idx="2505">
                  <c:v>20.665254592895508</c:v>
                </c:pt>
                <c:pt idx="2506">
                  <c:v>20.679901123046875</c:v>
                </c:pt>
                <c:pt idx="2507">
                  <c:v>20.694553375244141</c:v>
                </c:pt>
                <c:pt idx="2508">
                  <c:v>20.709207534790039</c:v>
                </c:pt>
                <c:pt idx="2509">
                  <c:v>20.723867416381836</c:v>
                </c:pt>
                <c:pt idx="2510">
                  <c:v>20.738529205322266</c:v>
                </c:pt>
                <c:pt idx="2511">
                  <c:v>20.753192901611328</c:v>
                </c:pt>
                <c:pt idx="2512">
                  <c:v>20.767860412597656</c:v>
                </c:pt>
                <c:pt idx="2513">
                  <c:v>20.782533645629883</c:v>
                </c:pt>
                <c:pt idx="2514">
                  <c:v>20.797210693359375</c:v>
                </c:pt>
                <c:pt idx="2515">
                  <c:v>20.8118896484375</c:v>
                </c:pt>
                <c:pt idx="2516">
                  <c:v>20.826572418212891</c:v>
                </c:pt>
                <c:pt idx="2517">
                  <c:v>20.841259002685547</c:v>
                </c:pt>
                <c:pt idx="2518">
                  <c:v>20.855947494506836</c:v>
                </c:pt>
                <c:pt idx="2519">
                  <c:v>20.870641708374023</c:v>
                </c:pt>
                <c:pt idx="2520">
                  <c:v>20.885337829589844</c:v>
                </c:pt>
                <c:pt idx="2521">
                  <c:v>20.90003776550293</c:v>
                </c:pt>
                <c:pt idx="2522">
                  <c:v>20.914741516113281</c:v>
                </c:pt>
                <c:pt idx="2523">
                  <c:v>20.929449081420898</c:v>
                </c:pt>
                <c:pt idx="2524">
                  <c:v>20.944158554077148</c:v>
                </c:pt>
                <c:pt idx="2525">
                  <c:v>20.958873748779297</c:v>
                </c:pt>
                <c:pt idx="2526">
                  <c:v>20.973590850830078</c:v>
                </c:pt>
                <c:pt idx="2527">
                  <c:v>20.988311767578125</c:v>
                </c:pt>
                <c:pt idx="2528">
                  <c:v>21.003034591674805</c:v>
                </c:pt>
                <c:pt idx="2529">
                  <c:v>21.017763137817383</c:v>
                </c:pt>
                <c:pt idx="2530">
                  <c:v>21.032491683959961</c:v>
                </c:pt>
                <c:pt idx="2531">
                  <c:v>21.04722785949707</c:v>
                </c:pt>
                <c:pt idx="2532">
                  <c:v>21.06196403503418</c:v>
                </c:pt>
                <c:pt idx="2533">
                  <c:v>21.076705932617188</c:v>
                </c:pt>
                <c:pt idx="2534">
                  <c:v>21.091449737548828</c:v>
                </c:pt>
                <c:pt idx="2535">
                  <c:v>21.106199264526367</c:v>
                </c:pt>
                <c:pt idx="2536">
                  <c:v>21.120950698852539</c:v>
                </c:pt>
                <c:pt idx="2537">
                  <c:v>21.135705947875977</c:v>
                </c:pt>
                <c:pt idx="2538">
                  <c:v>21.150466918945313</c:v>
                </c:pt>
                <c:pt idx="2539">
                  <c:v>21.165229797363281</c:v>
                </c:pt>
                <c:pt idx="2540">
                  <c:v>21.179996490478516</c:v>
                </c:pt>
                <c:pt idx="2541">
                  <c:v>21.194765090942383</c:v>
                </c:pt>
                <c:pt idx="2542">
                  <c:v>21.209539413452148</c:v>
                </c:pt>
                <c:pt idx="2543">
                  <c:v>21.224313735961914</c:v>
                </c:pt>
                <c:pt idx="2544">
                  <c:v>21.239093780517578</c:v>
                </c:pt>
                <c:pt idx="2545">
                  <c:v>21.253877639770508</c:v>
                </c:pt>
                <c:pt idx="2546">
                  <c:v>21.26866340637207</c:v>
                </c:pt>
                <c:pt idx="2547">
                  <c:v>21.283452987670898</c:v>
                </c:pt>
                <c:pt idx="2548">
                  <c:v>21.298244476318359</c:v>
                </c:pt>
                <c:pt idx="2549">
                  <c:v>21.313043594360352</c:v>
                </c:pt>
                <c:pt idx="2550">
                  <c:v>21.327842712402344</c:v>
                </c:pt>
                <c:pt idx="2551">
                  <c:v>21.342647552490234</c:v>
                </c:pt>
                <c:pt idx="2552">
                  <c:v>21.357454299926758</c:v>
                </c:pt>
                <c:pt idx="2553">
                  <c:v>21.372264862060547</c:v>
                </c:pt>
                <c:pt idx="2554">
                  <c:v>21.387079238891602</c:v>
                </c:pt>
                <c:pt idx="2555">
                  <c:v>21.401897430419922</c:v>
                </c:pt>
                <c:pt idx="2556">
                  <c:v>21.416721343994141</c:v>
                </c:pt>
                <c:pt idx="2557">
                  <c:v>21.431547164916992</c:v>
                </c:pt>
                <c:pt idx="2558">
                  <c:v>21.446376800537109</c:v>
                </c:pt>
                <c:pt idx="2559">
                  <c:v>21.461208343505859</c:v>
                </c:pt>
                <c:pt idx="2560">
                  <c:v>21.476043701171875</c:v>
                </c:pt>
                <c:pt idx="2561">
                  <c:v>21.490880966186523</c:v>
                </c:pt>
                <c:pt idx="2562">
                  <c:v>21.505725860595703</c:v>
                </c:pt>
                <c:pt idx="2563">
                  <c:v>21.520572662353516</c:v>
                </c:pt>
                <c:pt idx="2564">
                  <c:v>21.535421371459961</c:v>
                </c:pt>
                <c:pt idx="2565">
                  <c:v>21.550273895263672</c:v>
                </c:pt>
                <c:pt idx="2566">
                  <c:v>21.565132141113281</c:v>
                </c:pt>
                <c:pt idx="2567">
                  <c:v>21.579992294311523</c:v>
                </c:pt>
                <c:pt idx="2568">
                  <c:v>21.594856262207031</c:v>
                </c:pt>
                <c:pt idx="2569">
                  <c:v>21.609722137451172</c:v>
                </c:pt>
                <c:pt idx="2570">
                  <c:v>21.624593734741211</c:v>
                </c:pt>
                <c:pt idx="2571">
                  <c:v>21.639467239379883</c:v>
                </c:pt>
                <c:pt idx="2572">
                  <c:v>21.654342651367188</c:v>
                </c:pt>
                <c:pt idx="2573">
                  <c:v>21.669223785400391</c:v>
                </c:pt>
                <c:pt idx="2574">
                  <c:v>21.684106826782227</c:v>
                </c:pt>
                <c:pt idx="2575">
                  <c:v>21.698993682861328</c:v>
                </c:pt>
                <c:pt idx="2576">
                  <c:v>21.713882446289063</c:v>
                </c:pt>
                <c:pt idx="2577">
                  <c:v>21.728775024414063</c:v>
                </c:pt>
                <c:pt idx="2578">
                  <c:v>21.743673324584961</c:v>
                </c:pt>
                <c:pt idx="2579">
                  <c:v>21.758573532104492</c:v>
                </c:pt>
                <c:pt idx="2580">
                  <c:v>21.773479461669922</c:v>
                </c:pt>
                <c:pt idx="2581">
                  <c:v>21.788387298583984</c:v>
                </c:pt>
                <c:pt idx="2582">
                  <c:v>21.803298950195313</c:v>
                </c:pt>
                <c:pt idx="2583">
                  <c:v>21.818214416503906</c:v>
                </c:pt>
                <c:pt idx="2584">
                  <c:v>21.833131790161133</c:v>
                </c:pt>
                <c:pt idx="2585">
                  <c:v>21.848054885864258</c:v>
                </c:pt>
                <c:pt idx="2586">
                  <c:v>21.862979888916016</c:v>
                </c:pt>
                <c:pt idx="2587">
                  <c:v>21.877908706665039</c:v>
                </c:pt>
                <c:pt idx="2588">
                  <c:v>21.892839431762695</c:v>
                </c:pt>
                <c:pt idx="2589">
                  <c:v>21.90777587890625</c:v>
                </c:pt>
                <c:pt idx="2590">
                  <c:v>21.922714233398438</c:v>
                </c:pt>
                <c:pt idx="2591">
                  <c:v>21.937656402587891</c:v>
                </c:pt>
                <c:pt idx="2592">
                  <c:v>21.952602386474609</c:v>
                </c:pt>
                <c:pt idx="2593">
                  <c:v>21.967550277709961</c:v>
                </c:pt>
                <c:pt idx="2594">
                  <c:v>21.982503890991211</c:v>
                </c:pt>
                <c:pt idx="2595">
                  <c:v>21.997459411621094</c:v>
                </c:pt>
                <c:pt idx="2596">
                  <c:v>22.012418746948242</c:v>
                </c:pt>
                <c:pt idx="2597">
                  <c:v>22.027381896972656</c:v>
                </c:pt>
                <c:pt idx="2598">
                  <c:v>22.042348861694336</c:v>
                </c:pt>
                <c:pt idx="2599">
                  <c:v>22.057319641113281</c:v>
                </c:pt>
                <c:pt idx="2600">
                  <c:v>22.072294235229492</c:v>
                </c:pt>
                <c:pt idx="2601">
                  <c:v>22.087272644042969</c:v>
                </c:pt>
                <c:pt idx="2602">
                  <c:v>22.102254867553711</c:v>
                </c:pt>
                <c:pt idx="2603">
                  <c:v>22.117238998413086</c:v>
                </c:pt>
                <c:pt idx="2604">
                  <c:v>22.132226943969727</c:v>
                </c:pt>
                <c:pt idx="2605">
                  <c:v>22.147218704223633</c:v>
                </c:pt>
                <c:pt idx="2606">
                  <c:v>22.16221809387207</c:v>
                </c:pt>
                <c:pt idx="2607">
                  <c:v>22.177215576171875</c:v>
                </c:pt>
                <c:pt idx="2608">
                  <c:v>22.192218780517578</c:v>
                </c:pt>
                <c:pt idx="2609">
                  <c:v>22.207221984863281</c:v>
                </c:pt>
                <c:pt idx="2610">
                  <c:v>22.222230911254883</c:v>
                </c:pt>
                <c:pt idx="2611">
                  <c:v>22.237241744995117</c:v>
                </c:pt>
                <c:pt idx="2612">
                  <c:v>22.252256393432617</c:v>
                </c:pt>
                <c:pt idx="2613">
                  <c:v>22.267274856567383</c:v>
                </c:pt>
                <c:pt idx="2614">
                  <c:v>22.28230094909668</c:v>
                </c:pt>
                <c:pt idx="2615">
                  <c:v>22.297327041625977</c:v>
                </c:pt>
                <c:pt idx="2616">
                  <c:v>22.312356948852539</c:v>
                </c:pt>
                <c:pt idx="2617">
                  <c:v>22.327388763427734</c:v>
                </c:pt>
                <c:pt idx="2618">
                  <c:v>22.342428207397461</c:v>
                </c:pt>
                <c:pt idx="2619">
                  <c:v>22.357467651367188</c:v>
                </c:pt>
                <c:pt idx="2620">
                  <c:v>22.372512817382813</c:v>
                </c:pt>
                <c:pt idx="2621">
                  <c:v>22.387557983398438</c:v>
                </c:pt>
                <c:pt idx="2622">
                  <c:v>22.402610778808594</c:v>
                </c:pt>
                <c:pt idx="2623">
                  <c:v>22.41766357421875</c:v>
                </c:pt>
                <c:pt idx="2624">
                  <c:v>22.432720184326172</c:v>
                </c:pt>
                <c:pt idx="2625">
                  <c:v>22.447780609130859</c:v>
                </c:pt>
                <c:pt idx="2626">
                  <c:v>22.462844848632813</c:v>
                </c:pt>
                <c:pt idx="2627">
                  <c:v>22.477910995483398</c:v>
                </c:pt>
                <c:pt idx="2628">
                  <c:v>22.492982864379883</c:v>
                </c:pt>
                <c:pt idx="2629">
                  <c:v>22.508056640625</c:v>
                </c:pt>
                <c:pt idx="2630">
                  <c:v>22.523136138916016</c:v>
                </c:pt>
                <c:pt idx="2631">
                  <c:v>22.538215637207031</c:v>
                </c:pt>
                <c:pt idx="2632">
                  <c:v>22.553302764892578</c:v>
                </c:pt>
                <c:pt idx="2633">
                  <c:v>22.568391799926758</c:v>
                </c:pt>
                <c:pt idx="2634">
                  <c:v>22.583484649658203</c:v>
                </c:pt>
                <c:pt idx="2635">
                  <c:v>22.598579406738281</c:v>
                </c:pt>
                <c:pt idx="2636">
                  <c:v>22.613677978515625</c:v>
                </c:pt>
                <c:pt idx="2637">
                  <c:v>22.628780364990234</c:v>
                </c:pt>
                <c:pt idx="2638">
                  <c:v>22.643886566162109</c:v>
                </c:pt>
                <c:pt idx="2639">
                  <c:v>22.658994674682617</c:v>
                </c:pt>
                <c:pt idx="2640">
                  <c:v>22.674108505249023</c:v>
                </c:pt>
                <c:pt idx="2641">
                  <c:v>22.68922233581543</c:v>
                </c:pt>
                <c:pt idx="2642">
                  <c:v>22.704341888427734</c:v>
                </c:pt>
                <c:pt idx="2643">
                  <c:v>22.719465255737305</c:v>
                </c:pt>
                <c:pt idx="2644">
                  <c:v>22.734590530395508</c:v>
                </c:pt>
                <c:pt idx="2645">
                  <c:v>22.749721527099609</c:v>
                </c:pt>
                <c:pt idx="2646">
                  <c:v>22.764858245849609</c:v>
                </c:pt>
                <c:pt idx="2647">
                  <c:v>22.779994964599609</c:v>
                </c:pt>
                <c:pt idx="2648">
                  <c:v>22.795139312744141</c:v>
                </c:pt>
                <c:pt idx="2649">
                  <c:v>22.810281753540039</c:v>
                </c:pt>
                <c:pt idx="2650">
                  <c:v>22.825433731079102</c:v>
                </c:pt>
                <c:pt idx="2651">
                  <c:v>22.840583801269531</c:v>
                </c:pt>
                <c:pt idx="2652">
                  <c:v>22.855741500854492</c:v>
                </c:pt>
                <c:pt idx="2653">
                  <c:v>22.870901107788086</c:v>
                </c:pt>
                <c:pt idx="2654">
                  <c:v>22.886064529418945</c:v>
                </c:pt>
                <c:pt idx="2655">
                  <c:v>22.901229858398438</c:v>
                </c:pt>
                <c:pt idx="2656">
                  <c:v>22.916402816772461</c:v>
                </c:pt>
                <c:pt idx="2657">
                  <c:v>22.931575775146484</c:v>
                </c:pt>
                <c:pt idx="2658">
                  <c:v>22.946754455566406</c:v>
                </c:pt>
                <c:pt idx="2659">
                  <c:v>22.961935043334961</c:v>
                </c:pt>
                <c:pt idx="2660">
                  <c:v>22.977123260498047</c:v>
                </c:pt>
                <c:pt idx="2661">
                  <c:v>22.992313385009766</c:v>
                </c:pt>
                <c:pt idx="2662">
                  <c:v>23.00750732421875</c:v>
                </c:pt>
                <c:pt idx="2663">
                  <c:v>23.022701263427734</c:v>
                </c:pt>
                <c:pt idx="2664">
                  <c:v>23.037900924682617</c:v>
                </c:pt>
                <c:pt idx="2665">
                  <c:v>23.053104400634766</c:v>
                </c:pt>
                <c:pt idx="2666">
                  <c:v>23.068309783935547</c:v>
                </c:pt>
                <c:pt idx="2667">
                  <c:v>23.083518981933594</c:v>
                </c:pt>
                <c:pt idx="2668">
                  <c:v>23.098730087280273</c:v>
                </c:pt>
                <c:pt idx="2669">
                  <c:v>23.113946914672852</c:v>
                </c:pt>
                <c:pt idx="2670">
                  <c:v>23.129165649414063</c:v>
                </c:pt>
                <c:pt idx="2671">
                  <c:v>23.144386291503906</c:v>
                </c:pt>
                <c:pt idx="2672">
                  <c:v>23.159612655639648</c:v>
                </c:pt>
                <c:pt idx="2673">
                  <c:v>23.174837112426758</c:v>
                </c:pt>
                <c:pt idx="2674">
                  <c:v>23.190071105957031</c:v>
                </c:pt>
                <c:pt idx="2675">
                  <c:v>23.205307006835938</c:v>
                </c:pt>
                <c:pt idx="2676">
                  <c:v>23.220546722412109</c:v>
                </c:pt>
                <c:pt idx="2677">
                  <c:v>23.235788345336914</c:v>
                </c:pt>
                <c:pt idx="2678">
                  <c:v>23.251033782958984</c:v>
                </c:pt>
                <c:pt idx="2679">
                  <c:v>23.26628303527832</c:v>
                </c:pt>
                <c:pt idx="2680">
                  <c:v>23.281536102294922</c:v>
                </c:pt>
                <c:pt idx="2681">
                  <c:v>23.296791076660156</c:v>
                </c:pt>
                <c:pt idx="2682">
                  <c:v>23.312047958374023</c:v>
                </c:pt>
                <c:pt idx="2683">
                  <c:v>23.327308654785156</c:v>
                </c:pt>
                <c:pt idx="2684">
                  <c:v>23.342575073242188</c:v>
                </c:pt>
                <c:pt idx="2685">
                  <c:v>23.357845306396484</c:v>
                </c:pt>
                <c:pt idx="2686">
                  <c:v>23.373117446899414</c:v>
                </c:pt>
                <c:pt idx="2687">
                  <c:v>23.388393402099609</c:v>
                </c:pt>
                <c:pt idx="2688">
                  <c:v>23.403675079345703</c:v>
                </c:pt>
                <c:pt idx="2689">
                  <c:v>23.418956756591797</c:v>
                </c:pt>
                <c:pt idx="2690">
                  <c:v>23.434244155883789</c:v>
                </c:pt>
                <c:pt idx="2691">
                  <c:v>23.449531555175781</c:v>
                </c:pt>
                <c:pt idx="2692">
                  <c:v>23.464828491210938</c:v>
                </c:pt>
                <c:pt idx="2693">
                  <c:v>23.480125427246094</c:v>
                </c:pt>
                <c:pt idx="2694">
                  <c:v>23.495428085327148</c:v>
                </c:pt>
                <c:pt idx="2695">
                  <c:v>23.510734558105469</c:v>
                </c:pt>
                <c:pt idx="2696">
                  <c:v>23.526044845581055</c:v>
                </c:pt>
                <c:pt idx="2697">
                  <c:v>23.541358947753906</c:v>
                </c:pt>
                <c:pt idx="2698">
                  <c:v>23.556676864624023</c:v>
                </c:pt>
                <c:pt idx="2699">
                  <c:v>23.571994781494141</c:v>
                </c:pt>
                <c:pt idx="2700">
                  <c:v>23.587316513061523</c:v>
                </c:pt>
                <c:pt idx="2701">
                  <c:v>23.602643966674805</c:v>
                </c:pt>
                <c:pt idx="2702">
                  <c:v>23.617977142333984</c:v>
                </c:pt>
                <c:pt idx="2703">
                  <c:v>23.633310317993164</c:v>
                </c:pt>
                <c:pt idx="2704">
                  <c:v>23.648651123046875</c:v>
                </c:pt>
                <c:pt idx="2705">
                  <c:v>23.663993835449219</c:v>
                </c:pt>
                <c:pt idx="2706">
                  <c:v>23.679338455200195</c:v>
                </c:pt>
                <c:pt idx="2707">
                  <c:v>23.694684982299805</c:v>
                </c:pt>
                <c:pt idx="2708">
                  <c:v>23.710039138793945</c:v>
                </c:pt>
                <c:pt idx="2709">
                  <c:v>23.725393295288086</c:v>
                </c:pt>
                <c:pt idx="2710">
                  <c:v>23.740753173828125</c:v>
                </c:pt>
                <c:pt idx="2711">
                  <c:v>23.75611686706543</c:v>
                </c:pt>
                <c:pt idx="2712">
                  <c:v>23.771482467651367</c:v>
                </c:pt>
                <c:pt idx="2713">
                  <c:v>23.78685188293457</c:v>
                </c:pt>
                <c:pt idx="2714">
                  <c:v>23.802227020263672</c:v>
                </c:pt>
                <c:pt idx="2715">
                  <c:v>23.817605972290039</c:v>
                </c:pt>
                <c:pt idx="2716">
                  <c:v>23.832986831665039</c:v>
                </c:pt>
                <c:pt idx="2717">
                  <c:v>23.848371505737305</c:v>
                </c:pt>
                <c:pt idx="2718">
                  <c:v>23.863758087158203</c:v>
                </c:pt>
                <c:pt idx="2719">
                  <c:v>23.879148483276367</c:v>
                </c:pt>
                <c:pt idx="2720">
                  <c:v>23.89454460144043</c:v>
                </c:pt>
                <c:pt idx="2721">
                  <c:v>23.909940719604492</c:v>
                </c:pt>
                <c:pt idx="2722">
                  <c:v>23.925338745117188</c:v>
                </c:pt>
                <c:pt idx="2723">
                  <c:v>23.940742492675781</c:v>
                </c:pt>
                <c:pt idx="2724">
                  <c:v>23.956151962280273</c:v>
                </c:pt>
                <c:pt idx="2725">
                  <c:v>23.971565246582031</c:v>
                </c:pt>
                <c:pt idx="2726">
                  <c:v>23.986980438232422</c:v>
                </c:pt>
                <c:pt idx="2727">
                  <c:v>24.002397537231445</c:v>
                </c:pt>
                <c:pt idx="2728">
                  <c:v>24.017820358276367</c:v>
                </c:pt>
                <c:pt idx="2729">
                  <c:v>24.033245086669922</c:v>
                </c:pt>
                <c:pt idx="2730">
                  <c:v>24.048675537109375</c:v>
                </c:pt>
                <c:pt idx="2731">
                  <c:v>24.064109802246094</c:v>
                </c:pt>
                <c:pt idx="2732">
                  <c:v>24.079545974731445</c:v>
                </c:pt>
                <c:pt idx="2733">
                  <c:v>24.09498405456543</c:v>
                </c:pt>
                <c:pt idx="2734">
                  <c:v>24.110427856445313</c:v>
                </c:pt>
                <c:pt idx="2735">
                  <c:v>24.125873565673828</c:v>
                </c:pt>
                <c:pt idx="2736">
                  <c:v>24.141323089599609</c:v>
                </c:pt>
                <c:pt idx="2737">
                  <c:v>24.156778335571289</c:v>
                </c:pt>
                <c:pt idx="2738">
                  <c:v>24.172233581542969</c:v>
                </c:pt>
                <c:pt idx="2739">
                  <c:v>24.187694549560547</c:v>
                </c:pt>
                <c:pt idx="2740">
                  <c:v>24.203159332275391</c:v>
                </c:pt>
                <c:pt idx="2741">
                  <c:v>24.218626022338867</c:v>
                </c:pt>
                <c:pt idx="2742">
                  <c:v>24.234098434448242</c:v>
                </c:pt>
                <c:pt idx="2743">
                  <c:v>24.249570846557617</c:v>
                </c:pt>
                <c:pt idx="2744">
                  <c:v>24.265048980712891</c:v>
                </c:pt>
                <c:pt idx="2745">
                  <c:v>24.28053092956543</c:v>
                </c:pt>
                <c:pt idx="2746">
                  <c:v>24.296014785766602</c:v>
                </c:pt>
                <c:pt idx="2747">
                  <c:v>24.311508178710938</c:v>
                </c:pt>
                <c:pt idx="2748">
                  <c:v>24.327003479003906</c:v>
                </c:pt>
                <c:pt idx="2749">
                  <c:v>24.342500686645508</c:v>
                </c:pt>
                <c:pt idx="2750">
                  <c:v>24.358001708984375</c:v>
                </c:pt>
                <c:pt idx="2751">
                  <c:v>24.373508453369141</c:v>
                </c:pt>
                <c:pt idx="2752">
                  <c:v>24.389015197753906</c:v>
                </c:pt>
                <c:pt idx="2753">
                  <c:v>24.404525756835938</c:v>
                </c:pt>
                <c:pt idx="2754">
                  <c:v>24.420042037963867</c:v>
                </c:pt>
                <c:pt idx="2755">
                  <c:v>24.43556022644043</c:v>
                </c:pt>
                <c:pt idx="2756">
                  <c:v>24.451084136962891</c:v>
                </c:pt>
                <c:pt idx="2757">
                  <c:v>24.466609954833984</c:v>
                </c:pt>
                <c:pt idx="2758">
                  <c:v>24.482141494750977</c:v>
                </c:pt>
                <c:pt idx="2759">
                  <c:v>24.497676849365234</c:v>
                </c:pt>
                <c:pt idx="2760">
                  <c:v>24.513214111328125</c:v>
                </c:pt>
                <c:pt idx="2761">
                  <c:v>24.528755187988281</c:v>
                </c:pt>
                <c:pt idx="2762">
                  <c:v>24.544300079345703</c:v>
                </c:pt>
                <c:pt idx="2763">
                  <c:v>24.559848785400391</c:v>
                </c:pt>
                <c:pt idx="2764">
                  <c:v>24.575399398803711</c:v>
                </c:pt>
                <c:pt idx="2765">
                  <c:v>24.590957641601563</c:v>
                </c:pt>
                <c:pt idx="2766">
                  <c:v>24.606515884399414</c:v>
                </c:pt>
                <c:pt idx="2767">
                  <c:v>24.622081756591797</c:v>
                </c:pt>
                <c:pt idx="2768">
                  <c:v>24.63764762878418</c:v>
                </c:pt>
                <c:pt idx="2769">
                  <c:v>24.653217315673828</c:v>
                </c:pt>
                <c:pt idx="2770">
                  <c:v>24.668788909912109</c:v>
                </c:pt>
                <c:pt idx="2771">
                  <c:v>24.684366226196289</c:v>
                </c:pt>
                <c:pt idx="2772">
                  <c:v>24.699945449829102</c:v>
                </c:pt>
                <c:pt idx="2773">
                  <c:v>24.71552848815918</c:v>
                </c:pt>
                <c:pt idx="2774">
                  <c:v>24.731113433837891</c:v>
                </c:pt>
                <c:pt idx="2775">
                  <c:v>24.746706008911133</c:v>
                </c:pt>
                <c:pt idx="2776">
                  <c:v>24.762298583984375</c:v>
                </c:pt>
                <c:pt idx="2777">
                  <c:v>24.777896881103516</c:v>
                </c:pt>
                <c:pt idx="2778">
                  <c:v>24.793498992919922</c:v>
                </c:pt>
                <c:pt idx="2779">
                  <c:v>24.809104919433594</c:v>
                </c:pt>
                <c:pt idx="2780">
                  <c:v>24.824712753295898</c:v>
                </c:pt>
                <c:pt idx="2781">
                  <c:v>24.840322494506836</c:v>
                </c:pt>
                <c:pt idx="2782">
                  <c:v>24.855937957763672</c:v>
                </c:pt>
                <c:pt idx="2783">
                  <c:v>24.871557235717773</c:v>
                </c:pt>
                <c:pt idx="2784">
                  <c:v>24.887178421020508</c:v>
                </c:pt>
                <c:pt idx="2785">
                  <c:v>24.902803421020508</c:v>
                </c:pt>
                <c:pt idx="2786">
                  <c:v>24.918432235717773</c:v>
                </c:pt>
                <c:pt idx="2787">
                  <c:v>24.934062957763672</c:v>
                </c:pt>
                <c:pt idx="2788">
                  <c:v>24.949697494506836</c:v>
                </c:pt>
                <c:pt idx="2789">
                  <c:v>24.965339660644531</c:v>
                </c:pt>
                <c:pt idx="2790">
                  <c:v>24.980981826782227</c:v>
                </c:pt>
                <c:pt idx="2791">
                  <c:v>24.99662971496582</c:v>
                </c:pt>
                <c:pt idx="2792">
                  <c:v>25.012273788452148</c:v>
                </c:pt>
                <c:pt idx="2793">
                  <c:v>25.027927398681641</c:v>
                </c:pt>
                <c:pt idx="2794">
                  <c:v>25.043582916259766</c:v>
                </c:pt>
                <c:pt idx="2795">
                  <c:v>25.059244155883789</c:v>
                </c:pt>
                <c:pt idx="2796">
                  <c:v>25.074907302856445</c:v>
                </c:pt>
                <c:pt idx="2797">
                  <c:v>25.090574264526367</c:v>
                </c:pt>
                <c:pt idx="2798">
                  <c:v>25.106245040893555</c:v>
                </c:pt>
                <c:pt idx="2799">
                  <c:v>25.121923446655273</c:v>
                </c:pt>
                <c:pt idx="2800">
                  <c:v>25.137599945068359</c:v>
                </c:pt>
                <c:pt idx="2801">
                  <c:v>25.153284072875977</c:v>
                </c:pt>
                <c:pt idx="2802">
                  <c:v>25.168972015380859</c:v>
                </c:pt>
                <c:pt idx="2803">
                  <c:v>25.184661865234375</c:v>
                </c:pt>
                <c:pt idx="2804">
                  <c:v>25.200359344482422</c:v>
                </c:pt>
                <c:pt idx="2805">
                  <c:v>25.216054916381836</c:v>
                </c:pt>
                <c:pt idx="2806">
                  <c:v>25.231756210327148</c:v>
                </c:pt>
                <c:pt idx="2807">
                  <c:v>25.247463226318359</c:v>
                </c:pt>
                <c:pt idx="2808">
                  <c:v>25.26317024230957</c:v>
                </c:pt>
                <c:pt idx="2809">
                  <c:v>25.27888298034668</c:v>
                </c:pt>
                <c:pt idx="2810">
                  <c:v>25.294597625732422</c:v>
                </c:pt>
                <c:pt idx="2811">
                  <c:v>25.310314178466797</c:v>
                </c:pt>
                <c:pt idx="2812">
                  <c:v>25.32603645324707</c:v>
                </c:pt>
                <c:pt idx="2813">
                  <c:v>25.341760635375977</c:v>
                </c:pt>
                <c:pt idx="2814">
                  <c:v>25.357490539550781</c:v>
                </c:pt>
                <c:pt idx="2815">
                  <c:v>25.373222351074219</c:v>
                </c:pt>
                <c:pt idx="2816">
                  <c:v>25.388959884643555</c:v>
                </c:pt>
                <c:pt idx="2817">
                  <c:v>25.404697418212891</c:v>
                </c:pt>
                <c:pt idx="2818">
                  <c:v>25.420442581176758</c:v>
                </c:pt>
                <c:pt idx="2819">
                  <c:v>25.436189651489258</c:v>
                </c:pt>
                <c:pt idx="2820">
                  <c:v>25.451940536499023</c:v>
                </c:pt>
                <c:pt idx="2821">
                  <c:v>25.467693328857422</c:v>
                </c:pt>
                <c:pt idx="2822">
                  <c:v>25.483449935913086</c:v>
                </c:pt>
                <c:pt idx="2823">
                  <c:v>25.49920654296875</c:v>
                </c:pt>
                <c:pt idx="2824">
                  <c:v>25.514972686767578</c:v>
                </c:pt>
                <c:pt idx="2825">
                  <c:v>25.530740737915039</c:v>
                </c:pt>
                <c:pt idx="2826">
                  <c:v>25.546506881713867</c:v>
                </c:pt>
                <c:pt idx="2827">
                  <c:v>25.562282562255859</c:v>
                </c:pt>
                <c:pt idx="2828">
                  <c:v>25.578056335449219</c:v>
                </c:pt>
                <c:pt idx="2829">
                  <c:v>25.593839645385742</c:v>
                </c:pt>
                <c:pt idx="2830">
                  <c:v>25.609622955322266</c:v>
                </c:pt>
                <c:pt idx="2831">
                  <c:v>25.625410079956055</c:v>
                </c:pt>
                <c:pt idx="2832">
                  <c:v>25.641199111938477</c:v>
                </c:pt>
                <c:pt idx="2833">
                  <c:v>25.65699577331543</c:v>
                </c:pt>
                <c:pt idx="2834">
                  <c:v>25.672794342041016</c:v>
                </c:pt>
                <c:pt idx="2835">
                  <c:v>25.688596725463867</c:v>
                </c:pt>
                <c:pt idx="2836">
                  <c:v>25.704401016235352</c:v>
                </c:pt>
                <c:pt idx="2837">
                  <c:v>25.720211029052734</c:v>
                </c:pt>
                <c:pt idx="2838">
                  <c:v>25.73602294921875</c:v>
                </c:pt>
                <c:pt idx="2839">
                  <c:v>25.751838684082031</c:v>
                </c:pt>
                <c:pt idx="2840">
                  <c:v>25.767656326293945</c:v>
                </c:pt>
                <c:pt idx="2841">
                  <c:v>25.783481597900391</c:v>
                </c:pt>
                <c:pt idx="2842">
                  <c:v>25.799306869506836</c:v>
                </c:pt>
                <c:pt idx="2843">
                  <c:v>25.815135955810547</c:v>
                </c:pt>
                <c:pt idx="2844">
                  <c:v>25.830968856811523</c:v>
                </c:pt>
                <c:pt idx="2845">
                  <c:v>25.846807479858398</c:v>
                </c:pt>
                <c:pt idx="2846">
                  <c:v>25.862648010253906</c:v>
                </c:pt>
                <c:pt idx="2847">
                  <c:v>25.87849235534668</c:v>
                </c:pt>
                <c:pt idx="2848">
                  <c:v>25.894340515136719</c:v>
                </c:pt>
                <c:pt idx="2849">
                  <c:v>25.910192489624023</c:v>
                </c:pt>
                <c:pt idx="2850">
                  <c:v>25.926048278808594</c:v>
                </c:pt>
                <c:pt idx="2851">
                  <c:v>25.94190788269043</c:v>
                </c:pt>
                <c:pt idx="2852">
                  <c:v>25.957771301269531</c:v>
                </c:pt>
                <c:pt idx="2853">
                  <c:v>25.973638534545898</c:v>
                </c:pt>
                <c:pt idx="2854">
                  <c:v>25.989507675170898</c:v>
                </c:pt>
                <c:pt idx="2855">
                  <c:v>26.005380630493164</c:v>
                </c:pt>
                <c:pt idx="2856">
                  <c:v>26.021255493164063</c:v>
                </c:pt>
                <c:pt idx="2857">
                  <c:v>26.037137985229492</c:v>
                </c:pt>
                <c:pt idx="2858">
                  <c:v>26.053020477294922</c:v>
                </c:pt>
                <c:pt idx="2859">
                  <c:v>26.06890869140625</c:v>
                </c:pt>
                <c:pt idx="2860">
                  <c:v>26.084798812866211</c:v>
                </c:pt>
                <c:pt idx="2861">
                  <c:v>26.10069465637207</c:v>
                </c:pt>
                <c:pt idx="2862">
                  <c:v>26.116592407226563</c:v>
                </c:pt>
                <c:pt idx="2863">
                  <c:v>26.132492065429688</c:v>
                </c:pt>
                <c:pt idx="2864">
                  <c:v>26.148399353027344</c:v>
                </c:pt>
                <c:pt idx="2865">
                  <c:v>26.164306640625</c:v>
                </c:pt>
                <c:pt idx="2866">
                  <c:v>26.180217742919922</c:v>
                </c:pt>
                <c:pt idx="2867">
                  <c:v>26.196134567260742</c:v>
                </c:pt>
                <c:pt idx="2868">
                  <c:v>26.212055206298828</c:v>
                </c:pt>
                <c:pt idx="2869">
                  <c:v>26.227977752685547</c:v>
                </c:pt>
                <c:pt idx="2870">
                  <c:v>26.243902206420898</c:v>
                </c:pt>
                <c:pt idx="2871">
                  <c:v>26.259832382202148</c:v>
                </c:pt>
                <c:pt idx="2872">
                  <c:v>26.275764465332031</c:v>
                </c:pt>
                <c:pt idx="2873">
                  <c:v>26.291698455810547</c:v>
                </c:pt>
                <c:pt idx="2874">
                  <c:v>26.307638168334961</c:v>
                </c:pt>
                <c:pt idx="2875">
                  <c:v>26.323581695556641</c:v>
                </c:pt>
                <c:pt idx="2876">
                  <c:v>26.339527130126953</c:v>
                </c:pt>
                <c:pt idx="2877">
                  <c:v>26.355476379394531</c:v>
                </c:pt>
                <c:pt idx="2878">
                  <c:v>26.371429443359375</c:v>
                </c:pt>
                <c:pt idx="2879">
                  <c:v>26.387384414672852</c:v>
                </c:pt>
                <c:pt idx="2880">
                  <c:v>26.403343200683594</c:v>
                </c:pt>
                <c:pt idx="2881">
                  <c:v>26.419305801391602</c:v>
                </c:pt>
                <c:pt idx="2882">
                  <c:v>26.435270309448242</c:v>
                </c:pt>
                <c:pt idx="2883">
                  <c:v>26.451240539550781</c:v>
                </c:pt>
                <c:pt idx="2884">
                  <c:v>26.467212677001953</c:v>
                </c:pt>
                <c:pt idx="2885">
                  <c:v>26.483190536499023</c:v>
                </c:pt>
                <c:pt idx="2886">
                  <c:v>26.499170303344727</c:v>
                </c:pt>
                <c:pt idx="2887">
                  <c:v>26.515153884887695</c:v>
                </c:pt>
                <c:pt idx="2888">
                  <c:v>26.53114128112793</c:v>
                </c:pt>
                <c:pt idx="2889">
                  <c:v>26.54713249206543</c:v>
                </c:pt>
                <c:pt idx="2890">
                  <c:v>26.563127517700195</c:v>
                </c:pt>
                <c:pt idx="2891">
                  <c:v>26.579124450683594</c:v>
                </c:pt>
                <c:pt idx="2892">
                  <c:v>26.595125198364258</c:v>
                </c:pt>
                <c:pt idx="2893">
                  <c:v>26.611127853393555</c:v>
                </c:pt>
                <c:pt idx="2894">
                  <c:v>26.62713623046875</c:v>
                </c:pt>
                <c:pt idx="2895">
                  <c:v>26.643148422241211</c:v>
                </c:pt>
                <c:pt idx="2896">
                  <c:v>26.659162521362305</c:v>
                </c:pt>
                <c:pt idx="2897">
                  <c:v>26.675182342529297</c:v>
                </c:pt>
                <c:pt idx="2898">
                  <c:v>26.691204071044922</c:v>
                </c:pt>
                <c:pt idx="2899">
                  <c:v>26.707229614257813</c:v>
                </c:pt>
                <c:pt idx="2900">
                  <c:v>26.723258972167969</c:v>
                </c:pt>
                <c:pt idx="2901">
                  <c:v>26.739292144775391</c:v>
                </c:pt>
                <c:pt idx="2902">
                  <c:v>26.755327224731445</c:v>
                </c:pt>
                <c:pt idx="2903">
                  <c:v>26.771366119384766</c:v>
                </c:pt>
                <c:pt idx="2904">
                  <c:v>26.787408828735352</c:v>
                </c:pt>
                <c:pt idx="2905">
                  <c:v>26.80345344543457</c:v>
                </c:pt>
                <c:pt idx="2906">
                  <c:v>26.819503784179688</c:v>
                </c:pt>
                <c:pt idx="2907">
                  <c:v>26.835556030273438</c:v>
                </c:pt>
                <c:pt idx="2908">
                  <c:v>26.851612091064453</c:v>
                </c:pt>
                <c:pt idx="2909">
                  <c:v>26.867673873901367</c:v>
                </c:pt>
                <c:pt idx="2910">
                  <c:v>26.883737564086914</c:v>
                </c:pt>
                <c:pt idx="2911">
                  <c:v>26.899803161621094</c:v>
                </c:pt>
                <c:pt idx="2912">
                  <c:v>26.915874481201172</c:v>
                </c:pt>
                <c:pt idx="2913">
                  <c:v>26.931947708129883</c:v>
                </c:pt>
                <c:pt idx="2914">
                  <c:v>26.948024749755859</c:v>
                </c:pt>
                <c:pt idx="2915">
                  <c:v>26.964103698730469</c:v>
                </c:pt>
                <c:pt idx="2916">
                  <c:v>26.980188369750977</c:v>
                </c:pt>
                <c:pt idx="2917">
                  <c:v>26.996274948120117</c:v>
                </c:pt>
                <c:pt idx="2918">
                  <c:v>27.012365341186523</c:v>
                </c:pt>
                <c:pt idx="2919">
                  <c:v>27.028459548950195</c:v>
                </c:pt>
                <c:pt idx="2920">
                  <c:v>27.044557571411133</c:v>
                </c:pt>
                <c:pt idx="2921">
                  <c:v>27.060657501220703</c:v>
                </c:pt>
                <c:pt idx="2922">
                  <c:v>27.076763153076172</c:v>
                </c:pt>
                <c:pt idx="2923">
                  <c:v>27.092868804931641</c:v>
                </c:pt>
                <c:pt idx="2924">
                  <c:v>27.108980178833008</c:v>
                </c:pt>
                <c:pt idx="2925">
                  <c:v>27.125093460083008</c:v>
                </c:pt>
                <c:pt idx="2926">
                  <c:v>27.141210556030273</c:v>
                </c:pt>
                <c:pt idx="2927">
                  <c:v>27.157331466674805</c:v>
                </c:pt>
                <c:pt idx="2928">
                  <c:v>27.173454284667969</c:v>
                </c:pt>
                <c:pt idx="2929">
                  <c:v>27.189582824707031</c:v>
                </c:pt>
                <c:pt idx="2930">
                  <c:v>27.205713272094727</c:v>
                </c:pt>
                <c:pt idx="2931">
                  <c:v>27.221847534179688</c:v>
                </c:pt>
                <c:pt idx="2932">
                  <c:v>27.237985610961914</c:v>
                </c:pt>
                <c:pt idx="2933">
                  <c:v>27.254127502441406</c:v>
                </c:pt>
                <c:pt idx="2934">
                  <c:v>27.270271301269531</c:v>
                </c:pt>
                <c:pt idx="2935">
                  <c:v>27.286420822143555</c:v>
                </c:pt>
                <c:pt idx="2936">
                  <c:v>27.302572250366211</c:v>
                </c:pt>
                <c:pt idx="2937">
                  <c:v>27.318727493286133</c:v>
                </c:pt>
                <c:pt idx="2938">
                  <c:v>27.334884643554688</c:v>
                </c:pt>
                <c:pt idx="2939">
                  <c:v>27.351045608520508</c:v>
                </c:pt>
                <c:pt idx="2940">
                  <c:v>27.367210388183594</c:v>
                </c:pt>
                <c:pt idx="2941">
                  <c:v>27.383377075195313</c:v>
                </c:pt>
                <c:pt idx="2942">
                  <c:v>27.39954948425293</c:v>
                </c:pt>
                <c:pt idx="2943">
                  <c:v>27.415725708007813</c:v>
                </c:pt>
                <c:pt idx="2944">
                  <c:v>27.431903839111328</c:v>
                </c:pt>
                <c:pt idx="2945">
                  <c:v>27.448085784912109</c:v>
                </c:pt>
                <c:pt idx="2946">
                  <c:v>27.464271545410156</c:v>
                </c:pt>
                <c:pt idx="2947">
                  <c:v>27.480459213256836</c:v>
                </c:pt>
                <c:pt idx="2948">
                  <c:v>27.496650695800781</c:v>
                </c:pt>
                <c:pt idx="2949">
                  <c:v>27.512845993041992</c:v>
                </c:pt>
                <c:pt idx="2950">
                  <c:v>27.529045104980469</c:v>
                </c:pt>
                <c:pt idx="2951">
                  <c:v>27.545248031616211</c:v>
                </c:pt>
                <c:pt idx="2952">
                  <c:v>27.561454772949219</c:v>
                </c:pt>
                <c:pt idx="2953">
                  <c:v>27.577663421630859</c:v>
                </c:pt>
                <c:pt idx="2954">
                  <c:v>27.593875885009766</c:v>
                </c:pt>
                <c:pt idx="2955">
                  <c:v>27.610092163085938</c:v>
                </c:pt>
                <c:pt idx="2956">
                  <c:v>27.626312255859375</c:v>
                </c:pt>
                <c:pt idx="2957">
                  <c:v>27.642534255981445</c:v>
                </c:pt>
                <c:pt idx="2958">
                  <c:v>27.658760070800781</c:v>
                </c:pt>
                <c:pt idx="2959">
                  <c:v>27.674989700317383</c:v>
                </c:pt>
                <c:pt idx="2960">
                  <c:v>27.69122314453125</c:v>
                </c:pt>
                <c:pt idx="2961">
                  <c:v>27.707460403442383</c:v>
                </c:pt>
                <c:pt idx="2962">
                  <c:v>27.723699569702148</c:v>
                </c:pt>
                <c:pt idx="2963">
                  <c:v>27.73994255065918</c:v>
                </c:pt>
                <c:pt idx="2964">
                  <c:v>27.756189346313477</c:v>
                </c:pt>
                <c:pt idx="2965">
                  <c:v>27.772438049316406</c:v>
                </c:pt>
                <c:pt idx="2966">
                  <c:v>27.788692474365234</c:v>
                </c:pt>
                <c:pt idx="2967">
                  <c:v>27.804948806762695</c:v>
                </c:pt>
                <c:pt idx="2968">
                  <c:v>27.821208953857422</c:v>
                </c:pt>
                <c:pt idx="2969">
                  <c:v>27.837472915649414</c:v>
                </c:pt>
                <c:pt idx="2970">
                  <c:v>27.853738784790039</c:v>
                </c:pt>
                <c:pt idx="2971">
                  <c:v>27.87000846862793</c:v>
                </c:pt>
                <c:pt idx="2972">
                  <c:v>27.886281967163086</c:v>
                </c:pt>
                <c:pt idx="2973">
                  <c:v>27.902559280395508</c:v>
                </c:pt>
                <c:pt idx="2974">
                  <c:v>27.918840408325195</c:v>
                </c:pt>
                <c:pt idx="2975">
                  <c:v>27.935123443603516</c:v>
                </c:pt>
                <c:pt idx="2976">
                  <c:v>27.951410293579102</c:v>
                </c:pt>
                <c:pt idx="2977">
                  <c:v>27.967700958251953</c:v>
                </c:pt>
                <c:pt idx="2978">
                  <c:v>27.98399543762207</c:v>
                </c:pt>
                <c:pt idx="2979">
                  <c:v>28.00029182434082</c:v>
                </c:pt>
                <c:pt idx="2980">
                  <c:v>28.016592025756836</c:v>
                </c:pt>
                <c:pt idx="2981">
                  <c:v>28.032896041870117</c:v>
                </c:pt>
                <c:pt idx="2982">
                  <c:v>28.049203872680664</c:v>
                </c:pt>
                <c:pt idx="2983">
                  <c:v>28.065515518188477</c:v>
                </c:pt>
                <c:pt idx="2984">
                  <c:v>28.081829071044922</c:v>
                </c:pt>
                <c:pt idx="2985">
                  <c:v>28.098146438598633</c:v>
                </c:pt>
                <c:pt idx="2986">
                  <c:v>28.114467620849609</c:v>
                </c:pt>
                <c:pt idx="2987">
                  <c:v>28.130790710449219</c:v>
                </c:pt>
                <c:pt idx="2988">
                  <c:v>28.147119522094727</c:v>
                </c:pt>
                <c:pt idx="2989">
                  <c:v>28.163450241088867</c:v>
                </c:pt>
                <c:pt idx="2990">
                  <c:v>28.179784774780273</c:v>
                </c:pt>
                <c:pt idx="2991">
                  <c:v>28.196121215820313</c:v>
                </c:pt>
                <c:pt idx="2992">
                  <c:v>28.21246337890625</c:v>
                </c:pt>
                <c:pt idx="2993">
                  <c:v>28.22880744934082</c:v>
                </c:pt>
                <c:pt idx="2994">
                  <c:v>28.245155334472656</c:v>
                </c:pt>
                <c:pt idx="2995">
                  <c:v>28.261507034301758</c:v>
                </c:pt>
                <c:pt idx="2996">
                  <c:v>28.277860641479492</c:v>
                </c:pt>
                <c:pt idx="2997">
                  <c:v>28.294219970703125</c:v>
                </c:pt>
                <c:pt idx="2998">
                  <c:v>28.310581207275391</c:v>
                </c:pt>
                <c:pt idx="2999">
                  <c:v>28.326946258544922</c:v>
                </c:pt>
              </c:numCache>
            </c:numRef>
          </c:xVal>
          <c:yVal>
            <c:numRef>
              <c:f>'[RB revised.xlsx]Graph Calculations'!$I$26:$DKR$26</c:f>
              <c:numCache>
                <c:formatCode>General</c:formatCode>
                <c:ptCount val="3000"/>
                <c:pt idx="0">
                  <c:v>84976.9765625</c:v>
                </c:pt>
                <c:pt idx="1">
                  <c:v>84977.095703125</c:v>
                </c:pt>
                <c:pt idx="2">
                  <c:v>84977.21484375</c:v>
                </c:pt>
                <c:pt idx="3">
                  <c:v>84914.39111328125</c:v>
                </c:pt>
                <c:pt idx="4">
                  <c:v>84835.51025390625</c:v>
                </c:pt>
                <c:pt idx="5">
                  <c:v>84755.05810546875</c:v>
                </c:pt>
                <c:pt idx="6">
                  <c:v>84681.8916015625</c:v>
                </c:pt>
                <c:pt idx="7">
                  <c:v>84607.3818359375</c:v>
                </c:pt>
                <c:pt idx="8">
                  <c:v>84521.18701171875</c:v>
                </c:pt>
                <c:pt idx="9">
                  <c:v>84426.90576171875</c:v>
                </c:pt>
                <c:pt idx="10">
                  <c:v>84323.7109375</c:v>
                </c:pt>
                <c:pt idx="11">
                  <c:v>84203.6015625</c:v>
                </c:pt>
                <c:pt idx="12">
                  <c:v>84067.80615234375</c:v>
                </c:pt>
                <c:pt idx="13">
                  <c:v>83933.896728515625</c:v>
                </c:pt>
                <c:pt idx="14">
                  <c:v>83813.844482421875</c:v>
                </c:pt>
                <c:pt idx="15">
                  <c:v>83709.649169921875</c:v>
                </c:pt>
                <c:pt idx="16">
                  <c:v>83617.9970703125</c:v>
                </c:pt>
                <c:pt idx="17">
                  <c:v>83526.28759765625</c:v>
                </c:pt>
                <c:pt idx="18">
                  <c:v>83427.03515625</c:v>
                </c:pt>
                <c:pt idx="19">
                  <c:v>83338.782958984375</c:v>
                </c:pt>
                <c:pt idx="20">
                  <c:v>83266.787841796875</c:v>
                </c:pt>
                <c:pt idx="21">
                  <c:v>83191.33544921875</c:v>
                </c:pt>
                <c:pt idx="22">
                  <c:v>83099.68310546875</c:v>
                </c:pt>
                <c:pt idx="23">
                  <c:v>83010.45947265625</c:v>
                </c:pt>
                <c:pt idx="24">
                  <c:v>82929.892822265625</c:v>
                </c:pt>
                <c:pt idx="25">
                  <c:v>82849.04052734375</c:v>
                </c:pt>
                <c:pt idx="26">
                  <c:v>82769.6455078125</c:v>
                </c:pt>
                <c:pt idx="27">
                  <c:v>82701.564453125</c:v>
                </c:pt>
                <c:pt idx="28">
                  <c:v>82646.8837890625</c:v>
                </c:pt>
                <c:pt idx="29">
                  <c:v>82586.9169921875</c:v>
                </c:pt>
                <c:pt idx="30">
                  <c:v>82511.40771484375</c:v>
                </c:pt>
                <c:pt idx="31">
                  <c:v>82432.441162109375</c:v>
                </c:pt>
                <c:pt idx="32">
                  <c:v>82371.931640625</c:v>
                </c:pt>
                <c:pt idx="33">
                  <c:v>82324.793701171875</c:v>
                </c:pt>
                <c:pt idx="34">
                  <c:v>82275.2841796875</c:v>
                </c:pt>
                <c:pt idx="35">
                  <c:v>82220.68896484375</c:v>
                </c:pt>
                <c:pt idx="36">
                  <c:v>82170.065185546875</c:v>
                </c:pt>
                <c:pt idx="37">
                  <c:v>82126.15576171875</c:v>
                </c:pt>
                <c:pt idx="38">
                  <c:v>82082.9892578125</c:v>
                </c:pt>
                <c:pt idx="39">
                  <c:v>82040.194091796875</c:v>
                </c:pt>
                <c:pt idx="40">
                  <c:v>82001.713256835938</c:v>
                </c:pt>
                <c:pt idx="41">
                  <c:v>81960.546630859375</c:v>
                </c:pt>
                <c:pt idx="42">
                  <c:v>81908.494384765625</c:v>
                </c:pt>
                <c:pt idx="43">
                  <c:v>81859.156372070313</c:v>
                </c:pt>
                <c:pt idx="44">
                  <c:v>81824.961181640625</c:v>
                </c:pt>
                <c:pt idx="45">
                  <c:v>81795.966064453125</c:v>
                </c:pt>
                <c:pt idx="46">
                  <c:v>81763.11376953125</c:v>
                </c:pt>
                <c:pt idx="47">
                  <c:v>81733.375732421875</c:v>
                </c:pt>
                <c:pt idx="48">
                  <c:v>81707.437744140625</c:v>
                </c:pt>
                <c:pt idx="49">
                  <c:v>81675.471069335938</c:v>
                </c:pt>
                <c:pt idx="50">
                  <c:v>81639.590209960938</c:v>
                </c:pt>
                <c:pt idx="51">
                  <c:v>81606.452270507813</c:v>
                </c:pt>
                <c:pt idx="52">
                  <c:v>81586.799926757813</c:v>
                </c:pt>
                <c:pt idx="53">
                  <c:v>81575.261962890625</c:v>
                </c:pt>
                <c:pt idx="54">
                  <c:v>81560.323974609375</c:v>
                </c:pt>
                <c:pt idx="55">
                  <c:v>81528.100219726563</c:v>
                </c:pt>
                <c:pt idx="56">
                  <c:v>81489.390747070313</c:v>
                </c:pt>
                <c:pt idx="57">
                  <c:v>81460.795654296875</c:v>
                </c:pt>
                <c:pt idx="58">
                  <c:v>81436.200439453125</c:v>
                </c:pt>
                <c:pt idx="59">
                  <c:v>81400.57666015625</c:v>
                </c:pt>
                <c:pt idx="60">
                  <c:v>81365.038696289063</c:v>
                </c:pt>
                <c:pt idx="61">
                  <c:v>81350.8720703125</c:v>
                </c:pt>
                <c:pt idx="62">
                  <c:v>81344.677001953125</c:v>
                </c:pt>
                <c:pt idx="63">
                  <c:v>81327.453247070313</c:v>
                </c:pt>
                <c:pt idx="64">
                  <c:v>81307.115234375</c:v>
                </c:pt>
                <c:pt idx="65">
                  <c:v>81292.862915039063</c:v>
                </c:pt>
                <c:pt idx="66">
                  <c:v>81277.096313476563</c:v>
                </c:pt>
                <c:pt idx="67">
                  <c:v>81256.843994140625</c:v>
                </c:pt>
                <c:pt idx="68">
                  <c:v>81240.220336914063</c:v>
                </c:pt>
                <c:pt idx="69">
                  <c:v>81223.99658203125</c:v>
                </c:pt>
                <c:pt idx="70">
                  <c:v>81201.658569335938</c:v>
                </c:pt>
                <c:pt idx="71">
                  <c:v>81180.549072265625</c:v>
                </c:pt>
                <c:pt idx="72">
                  <c:v>81166.782592773438</c:v>
                </c:pt>
                <c:pt idx="73">
                  <c:v>81154.673095703125</c:v>
                </c:pt>
                <c:pt idx="74">
                  <c:v>81140.792236328125</c:v>
                </c:pt>
                <c:pt idx="75">
                  <c:v>81127.225708007813</c:v>
                </c:pt>
                <c:pt idx="76">
                  <c:v>81112.716186523438</c:v>
                </c:pt>
                <c:pt idx="77">
                  <c:v>81098.892456054688</c:v>
                </c:pt>
                <c:pt idx="78">
                  <c:v>81090.897338867188</c:v>
                </c:pt>
                <c:pt idx="79">
                  <c:v>81076.559326171875</c:v>
                </c:pt>
                <c:pt idx="80">
                  <c:v>81047.70703125</c:v>
                </c:pt>
                <c:pt idx="81">
                  <c:v>81018.0546875</c:v>
                </c:pt>
                <c:pt idx="82">
                  <c:v>81006.973815917969</c:v>
                </c:pt>
                <c:pt idx="83">
                  <c:v>81006.892944335938</c:v>
                </c:pt>
                <c:pt idx="84">
                  <c:v>81006.983520507813</c:v>
                </c:pt>
                <c:pt idx="85">
                  <c:v>81001.016967773438</c:v>
                </c:pt>
                <c:pt idx="86">
                  <c:v>80986.107482910156</c:v>
                </c:pt>
                <c:pt idx="87">
                  <c:v>80963.569519042969</c:v>
                </c:pt>
                <c:pt idx="88">
                  <c:v>80949.888610839844</c:v>
                </c:pt>
                <c:pt idx="89">
                  <c:v>80950.579162597656</c:v>
                </c:pt>
                <c:pt idx="90">
                  <c:v>80954.155456542969</c:v>
                </c:pt>
                <c:pt idx="91">
                  <c:v>80938.017456054688</c:v>
                </c:pt>
                <c:pt idx="92">
                  <c:v>80909.65087890625</c:v>
                </c:pt>
                <c:pt idx="93">
                  <c:v>80895.369995117188</c:v>
                </c:pt>
                <c:pt idx="94">
                  <c:v>80902.603393554688</c:v>
                </c:pt>
                <c:pt idx="95">
                  <c:v>80904.751098632813</c:v>
                </c:pt>
                <c:pt idx="96">
                  <c:v>80894.184509277344</c:v>
                </c:pt>
                <c:pt idx="97">
                  <c:v>80883.5322265625</c:v>
                </c:pt>
                <c:pt idx="98">
                  <c:v>80881.394226074219</c:v>
                </c:pt>
                <c:pt idx="99">
                  <c:v>80878.913330078125</c:v>
                </c:pt>
                <c:pt idx="100">
                  <c:v>80870.746765136719</c:v>
                </c:pt>
                <c:pt idx="101">
                  <c:v>80853.865905761719</c:v>
                </c:pt>
                <c:pt idx="102">
                  <c:v>80834.29931640625</c:v>
                </c:pt>
                <c:pt idx="103">
                  <c:v>80824.046997070313</c:v>
                </c:pt>
                <c:pt idx="104">
                  <c:v>80822.423278808594</c:v>
                </c:pt>
                <c:pt idx="105">
                  <c:v>80814.170959472656</c:v>
                </c:pt>
                <c:pt idx="106">
                  <c:v>80794.547241210938</c:v>
                </c:pt>
                <c:pt idx="107">
                  <c:v>80776.666381835938</c:v>
                </c:pt>
                <c:pt idx="108">
                  <c:v>80767.099792480469</c:v>
                </c:pt>
                <c:pt idx="109">
                  <c:v>80760.247497558594</c:v>
                </c:pt>
                <c:pt idx="110">
                  <c:v>80756.623779296875</c:v>
                </c:pt>
                <c:pt idx="111">
                  <c:v>80754.628601074219</c:v>
                </c:pt>
                <c:pt idx="112">
                  <c:v>80747.976318359375</c:v>
                </c:pt>
                <c:pt idx="113">
                  <c:v>80736.723999023438</c:v>
                </c:pt>
                <c:pt idx="114">
                  <c:v>80731.557434082031</c:v>
                </c:pt>
                <c:pt idx="115">
                  <c:v>80737.962280273438</c:v>
                </c:pt>
                <c:pt idx="116">
                  <c:v>80743.081420898438</c:v>
                </c:pt>
                <c:pt idx="117">
                  <c:v>80734.000549316406</c:v>
                </c:pt>
                <c:pt idx="118">
                  <c:v>80720.662536621094</c:v>
                </c:pt>
                <c:pt idx="119">
                  <c:v>80711.181640625</c:v>
                </c:pt>
                <c:pt idx="120">
                  <c:v>80704.872192382813</c:v>
                </c:pt>
                <c:pt idx="121">
                  <c:v>80708.47705078125</c:v>
                </c:pt>
                <c:pt idx="122">
                  <c:v>80721.939025878906</c:v>
                </c:pt>
                <c:pt idx="123">
                  <c:v>80726.086730957031</c:v>
                </c:pt>
                <c:pt idx="124">
                  <c:v>80712.577270507813</c:v>
                </c:pt>
                <c:pt idx="125">
                  <c:v>80700.439270019531</c:v>
                </c:pt>
                <c:pt idx="126">
                  <c:v>80696.901245117188</c:v>
                </c:pt>
                <c:pt idx="127">
                  <c:v>80693.448974609375</c:v>
                </c:pt>
                <c:pt idx="128">
                  <c:v>80685.082397460938</c:v>
                </c:pt>
                <c:pt idx="129">
                  <c:v>80677.058654785156</c:v>
                </c:pt>
                <c:pt idx="130">
                  <c:v>80674.00634765625</c:v>
                </c:pt>
                <c:pt idx="131">
                  <c:v>80672.239807128906</c:v>
                </c:pt>
                <c:pt idx="132">
                  <c:v>80667.330322265625</c:v>
                </c:pt>
                <c:pt idx="133">
                  <c:v>80656.392333984375</c:v>
                </c:pt>
                <c:pt idx="134">
                  <c:v>80646.025756835938</c:v>
                </c:pt>
                <c:pt idx="135">
                  <c:v>80636.887756347656</c:v>
                </c:pt>
                <c:pt idx="136">
                  <c:v>80627.178283691406</c:v>
                </c:pt>
                <c:pt idx="137">
                  <c:v>80616.697387695313</c:v>
                </c:pt>
                <c:pt idx="138">
                  <c:v>80610.330810546875</c:v>
                </c:pt>
                <c:pt idx="139">
                  <c:v>80612.42138671875</c:v>
                </c:pt>
                <c:pt idx="140">
                  <c:v>80623.626220703125</c:v>
                </c:pt>
                <c:pt idx="141">
                  <c:v>80640.888244628906</c:v>
                </c:pt>
                <c:pt idx="142">
                  <c:v>80646.235900878906</c:v>
                </c:pt>
                <c:pt idx="143">
                  <c:v>80632.383605957031</c:v>
                </c:pt>
                <c:pt idx="144">
                  <c:v>80614.931335449219</c:v>
                </c:pt>
                <c:pt idx="145">
                  <c:v>80603.279052734375</c:v>
                </c:pt>
                <c:pt idx="146">
                  <c:v>80589.855285644531</c:v>
                </c:pt>
                <c:pt idx="147">
                  <c:v>80577.7744140625</c:v>
                </c:pt>
                <c:pt idx="148">
                  <c:v>80579.95068359375</c:v>
                </c:pt>
                <c:pt idx="149">
                  <c:v>80596.869812011719</c:v>
                </c:pt>
                <c:pt idx="150">
                  <c:v>80611.674682617188</c:v>
                </c:pt>
                <c:pt idx="151">
                  <c:v>80608.42236328125</c:v>
                </c:pt>
                <c:pt idx="152">
                  <c:v>80582.884338378906</c:v>
                </c:pt>
                <c:pt idx="153">
                  <c:v>80546.803466796875</c:v>
                </c:pt>
                <c:pt idx="154">
                  <c:v>80519.579772949219</c:v>
                </c:pt>
                <c:pt idx="155">
                  <c:v>80508.413177490234</c:v>
                </c:pt>
                <c:pt idx="156">
                  <c:v>80502.246612548828</c:v>
                </c:pt>
                <c:pt idx="157">
                  <c:v>80487.36572265625</c:v>
                </c:pt>
                <c:pt idx="158">
                  <c:v>80471.084869384766</c:v>
                </c:pt>
                <c:pt idx="159">
                  <c:v>80459.775421142578</c:v>
                </c:pt>
                <c:pt idx="160">
                  <c:v>80451.323120117188</c:v>
                </c:pt>
                <c:pt idx="161">
                  <c:v>80447.727966308594</c:v>
                </c:pt>
                <c:pt idx="162">
                  <c:v>80459.847076416016</c:v>
                </c:pt>
                <c:pt idx="163">
                  <c:v>80474.737640380859</c:v>
                </c:pt>
                <c:pt idx="164">
                  <c:v>80477.771057128906</c:v>
                </c:pt>
                <c:pt idx="165">
                  <c:v>80476.175903320313</c:v>
                </c:pt>
                <c:pt idx="166">
                  <c:v>80481.237884521484</c:v>
                </c:pt>
                <c:pt idx="167">
                  <c:v>80489.242736816406</c:v>
                </c:pt>
                <c:pt idx="168">
                  <c:v>80486.733306884766</c:v>
                </c:pt>
                <c:pt idx="169">
                  <c:v>80470.938140869141</c:v>
                </c:pt>
                <c:pt idx="170">
                  <c:v>80449.228698730469</c:v>
                </c:pt>
                <c:pt idx="171">
                  <c:v>80432.976409912109</c:v>
                </c:pt>
                <c:pt idx="172">
                  <c:v>80420.009826660156</c:v>
                </c:pt>
                <c:pt idx="173">
                  <c:v>80404.614654541016</c:v>
                </c:pt>
                <c:pt idx="174">
                  <c:v>80396.733795166016</c:v>
                </c:pt>
                <c:pt idx="175">
                  <c:v>80401.795776367188</c:v>
                </c:pt>
                <c:pt idx="176">
                  <c:v>80413.143493652344</c:v>
                </c:pt>
                <c:pt idx="177">
                  <c:v>80422.691192626953</c:v>
                </c:pt>
                <c:pt idx="178">
                  <c:v>80427.324584960938</c:v>
                </c:pt>
                <c:pt idx="179">
                  <c:v>80425.100860595703</c:v>
                </c:pt>
                <c:pt idx="180">
                  <c:v>80418.105712890625</c:v>
                </c:pt>
                <c:pt idx="181">
                  <c:v>80411.453430175781</c:v>
                </c:pt>
                <c:pt idx="182">
                  <c:v>80413.943969726563</c:v>
                </c:pt>
                <c:pt idx="183">
                  <c:v>80428.805969238281</c:v>
                </c:pt>
                <c:pt idx="184">
                  <c:v>80440.582244873047</c:v>
                </c:pt>
                <c:pt idx="185">
                  <c:v>80430.672790527344</c:v>
                </c:pt>
                <c:pt idx="186">
                  <c:v>80408.963348388672</c:v>
                </c:pt>
                <c:pt idx="187">
                  <c:v>80400.25390625</c:v>
                </c:pt>
                <c:pt idx="188">
                  <c:v>80412.658752441406</c:v>
                </c:pt>
                <c:pt idx="189">
                  <c:v>80429.520751953125</c:v>
                </c:pt>
                <c:pt idx="190">
                  <c:v>80440.554168701172</c:v>
                </c:pt>
                <c:pt idx="191">
                  <c:v>80437.501861572266</c:v>
                </c:pt>
                <c:pt idx="192">
                  <c:v>80418.506713867188</c:v>
                </c:pt>
                <c:pt idx="193">
                  <c:v>80393.425842285156</c:v>
                </c:pt>
                <c:pt idx="194">
                  <c:v>80381.030670166016</c:v>
                </c:pt>
                <c:pt idx="195">
                  <c:v>80380.60693359375</c:v>
                </c:pt>
                <c:pt idx="196">
                  <c:v>80384.583221435547</c:v>
                </c:pt>
                <c:pt idx="197">
                  <c:v>80385.473785400391</c:v>
                </c:pt>
                <c:pt idx="198">
                  <c:v>80380.07861328125</c:v>
                </c:pt>
                <c:pt idx="199">
                  <c:v>80376.226318359375</c:v>
                </c:pt>
                <c:pt idx="200">
                  <c:v>80382.3740234375</c:v>
                </c:pt>
                <c:pt idx="201">
                  <c:v>80389.321716308594</c:v>
                </c:pt>
                <c:pt idx="202">
                  <c:v>80389.212280273438</c:v>
                </c:pt>
                <c:pt idx="203">
                  <c:v>80379.588562011719</c:v>
                </c:pt>
                <c:pt idx="204">
                  <c:v>80366.193389892578</c:v>
                </c:pt>
                <c:pt idx="205">
                  <c:v>80357.712524414063</c:v>
                </c:pt>
                <c:pt idx="206">
                  <c:v>80362.545959472656</c:v>
                </c:pt>
                <c:pt idx="207">
                  <c:v>80366.750793457031</c:v>
                </c:pt>
                <c:pt idx="208">
                  <c:v>80365.327056884766</c:v>
                </c:pt>
                <c:pt idx="209">
                  <c:v>80365.446197509766</c:v>
                </c:pt>
                <c:pt idx="210">
                  <c:v>80368.051025390625</c:v>
                </c:pt>
                <c:pt idx="211">
                  <c:v>80362.19873046875</c:v>
                </c:pt>
                <c:pt idx="212">
                  <c:v>80346.689300537109</c:v>
                </c:pt>
                <c:pt idx="213">
                  <c:v>80333.494140625</c:v>
                </c:pt>
                <c:pt idx="214">
                  <c:v>80328.156127929688</c:v>
                </c:pt>
                <c:pt idx="215">
                  <c:v>80326.503845214844</c:v>
                </c:pt>
                <c:pt idx="216">
                  <c:v>80326.937255859375</c:v>
                </c:pt>
                <c:pt idx="217">
                  <c:v>80329.913513183594</c:v>
                </c:pt>
                <c:pt idx="218">
                  <c:v>80336.404083251953</c:v>
                </c:pt>
                <c:pt idx="219">
                  <c:v>80345.037506103516</c:v>
                </c:pt>
                <c:pt idx="220">
                  <c:v>80350.585205078125</c:v>
                </c:pt>
                <c:pt idx="221">
                  <c:v>80342.590026855469</c:v>
                </c:pt>
                <c:pt idx="222">
                  <c:v>80330.052032470703</c:v>
                </c:pt>
                <c:pt idx="223">
                  <c:v>80330.771148681641</c:v>
                </c:pt>
                <c:pt idx="224">
                  <c:v>80343.461700439453</c:v>
                </c:pt>
                <c:pt idx="225">
                  <c:v>80350.809417724609</c:v>
                </c:pt>
                <c:pt idx="226">
                  <c:v>80344.042816162109</c:v>
                </c:pt>
                <c:pt idx="227">
                  <c:v>80332.590545654297</c:v>
                </c:pt>
                <c:pt idx="228">
                  <c:v>80328.623962402344</c:v>
                </c:pt>
                <c:pt idx="229">
                  <c:v>80336.543090820313</c:v>
                </c:pt>
                <c:pt idx="230">
                  <c:v>80336.576507568359</c:v>
                </c:pt>
                <c:pt idx="231">
                  <c:v>80331.352752685547</c:v>
                </c:pt>
                <c:pt idx="232">
                  <c:v>80332.986175537109</c:v>
                </c:pt>
                <c:pt idx="233">
                  <c:v>80337.048156738281</c:v>
                </c:pt>
                <c:pt idx="234">
                  <c:v>80326.91015625</c:v>
                </c:pt>
                <c:pt idx="235">
                  <c:v>80314.915008544922</c:v>
                </c:pt>
                <c:pt idx="236">
                  <c:v>80311.376983642578</c:v>
                </c:pt>
                <c:pt idx="237">
                  <c:v>80312.181823730469</c:v>
                </c:pt>
                <c:pt idx="238">
                  <c:v>80312.843811035156</c:v>
                </c:pt>
                <c:pt idx="239">
                  <c:v>80320.705810546875</c:v>
                </c:pt>
                <c:pt idx="240">
                  <c:v>80326.167785644531</c:v>
                </c:pt>
                <c:pt idx="241">
                  <c:v>80322.715484619141</c:v>
                </c:pt>
                <c:pt idx="242">
                  <c:v>80315.577484130859</c:v>
                </c:pt>
                <c:pt idx="243">
                  <c:v>80312.068054199219</c:v>
                </c:pt>
                <c:pt idx="244">
                  <c:v>80306.987182617188</c:v>
                </c:pt>
                <c:pt idx="245">
                  <c:v>80292.306304931641</c:v>
                </c:pt>
                <c:pt idx="246">
                  <c:v>80280.311157226563</c:v>
                </c:pt>
                <c:pt idx="247">
                  <c:v>80279.858856201172</c:v>
                </c:pt>
                <c:pt idx="248">
                  <c:v>80284.806549072266</c:v>
                </c:pt>
                <c:pt idx="249">
                  <c:v>80283.011383056641</c:v>
                </c:pt>
                <c:pt idx="250">
                  <c:v>80278.244812011719</c:v>
                </c:pt>
                <c:pt idx="251">
                  <c:v>80276.049652099609</c:v>
                </c:pt>
                <c:pt idx="252">
                  <c:v>80269.883056640625</c:v>
                </c:pt>
                <c:pt idx="253">
                  <c:v>80262.630767822266</c:v>
                </c:pt>
                <c:pt idx="254">
                  <c:v>80264.378479003906</c:v>
                </c:pt>
                <c:pt idx="255">
                  <c:v>80270.297607421875</c:v>
                </c:pt>
                <c:pt idx="256">
                  <c:v>80269.102447509766</c:v>
                </c:pt>
                <c:pt idx="257">
                  <c:v>80261.535858154297</c:v>
                </c:pt>
                <c:pt idx="258">
                  <c:v>80258.083557128906</c:v>
                </c:pt>
                <c:pt idx="259">
                  <c:v>80262.716979980469</c:v>
                </c:pt>
                <c:pt idx="260">
                  <c:v>80273.036102294922</c:v>
                </c:pt>
                <c:pt idx="261">
                  <c:v>80283.098083496094</c:v>
                </c:pt>
                <c:pt idx="262">
                  <c:v>80288.045806884766</c:v>
                </c:pt>
                <c:pt idx="263">
                  <c:v>80286.136352539063</c:v>
                </c:pt>
                <c:pt idx="264">
                  <c:v>80280.741180419922</c:v>
                </c:pt>
                <c:pt idx="265">
                  <c:v>80276.060333251953</c:v>
                </c:pt>
                <c:pt idx="266">
                  <c:v>80275.722320556641</c:v>
                </c:pt>
                <c:pt idx="267">
                  <c:v>80273.098571777344</c:v>
                </c:pt>
                <c:pt idx="268">
                  <c:v>80263.817718505859</c:v>
                </c:pt>
                <c:pt idx="269">
                  <c:v>80254.879699707031</c:v>
                </c:pt>
                <c:pt idx="270">
                  <c:v>80254.741683959961</c:v>
                </c:pt>
                <c:pt idx="271">
                  <c:v>80257.317962646484</c:v>
                </c:pt>
                <c:pt idx="272">
                  <c:v>80254.265655517578</c:v>
                </c:pt>
                <c:pt idx="273">
                  <c:v>80249.213363647461</c:v>
                </c:pt>
                <c:pt idx="274">
                  <c:v>80241.646774291992</c:v>
                </c:pt>
                <c:pt idx="275">
                  <c:v>80236.280197143555</c:v>
                </c:pt>
                <c:pt idx="276">
                  <c:v>80236.085037231445</c:v>
                </c:pt>
                <c:pt idx="277">
                  <c:v>80245.061309814453</c:v>
                </c:pt>
                <c:pt idx="278">
                  <c:v>80247.609008789063</c:v>
                </c:pt>
                <c:pt idx="279">
                  <c:v>80240.842422485352</c:v>
                </c:pt>
                <c:pt idx="280">
                  <c:v>80229.647277832031</c:v>
                </c:pt>
                <c:pt idx="281">
                  <c:v>80225.052124023438</c:v>
                </c:pt>
                <c:pt idx="282">
                  <c:v>80226.199813842773</c:v>
                </c:pt>
                <c:pt idx="283">
                  <c:v>80223.804656982422</c:v>
                </c:pt>
                <c:pt idx="284">
                  <c:v>80221.40950012207</c:v>
                </c:pt>
                <c:pt idx="285">
                  <c:v>80224.785781860352</c:v>
                </c:pt>
                <c:pt idx="286">
                  <c:v>80237.419189453125</c:v>
                </c:pt>
                <c:pt idx="287">
                  <c:v>80247.25260925293</c:v>
                </c:pt>
                <c:pt idx="288">
                  <c:v>80244.343170166016</c:v>
                </c:pt>
                <c:pt idx="289">
                  <c:v>80230.54801940918</c:v>
                </c:pt>
                <c:pt idx="290">
                  <c:v>80217.552856445313</c:v>
                </c:pt>
                <c:pt idx="291">
                  <c:v>80219.157699584961</c:v>
                </c:pt>
                <c:pt idx="292">
                  <c:v>80230.07682800293</c:v>
                </c:pt>
                <c:pt idx="293">
                  <c:v>80236.110244750977</c:v>
                </c:pt>
                <c:pt idx="294">
                  <c:v>80229.286514282227</c:v>
                </c:pt>
                <c:pt idx="295">
                  <c:v>80220.005645751953</c:v>
                </c:pt>
                <c:pt idx="296">
                  <c:v>80218.867630004883</c:v>
                </c:pt>
                <c:pt idx="297">
                  <c:v>80224.701049804688</c:v>
                </c:pt>
                <c:pt idx="298">
                  <c:v>80231.677322387695</c:v>
                </c:pt>
                <c:pt idx="299">
                  <c:v>80232.910736083984</c:v>
                </c:pt>
                <c:pt idx="300">
                  <c:v>80231.544158935547</c:v>
                </c:pt>
                <c:pt idx="301">
                  <c:v>80230.348999023438</c:v>
                </c:pt>
                <c:pt idx="302">
                  <c:v>80227.66813659668</c:v>
                </c:pt>
                <c:pt idx="303">
                  <c:v>80227.701538085938</c:v>
                </c:pt>
                <c:pt idx="304">
                  <c:v>80236.64924621582</c:v>
                </c:pt>
                <c:pt idx="305">
                  <c:v>80241.454086303711</c:v>
                </c:pt>
                <c:pt idx="306">
                  <c:v>80228.801788330078</c:v>
                </c:pt>
                <c:pt idx="307">
                  <c:v>80216.435211181641</c:v>
                </c:pt>
                <c:pt idx="308">
                  <c:v>80223.868621826172</c:v>
                </c:pt>
                <c:pt idx="309">
                  <c:v>80237.816329956055</c:v>
                </c:pt>
                <c:pt idx="310">
                  <c:v>80240.106887817383</c:v>
                </c:pt>
                <c:pt idx="311">
                  <c:v>80231.397445678711</c:v>
                </c:pt>
                <c:pt idx="312">
                  <c:v>80220.145141601563</c:v>
                </c:pt>
                <c:pt idx="313">
                  <c:v>80214.092849731445</c:v>
                </c:pt>
                <c:pt idx="314">
                  <c:v>80219.126266479492</c:v>
                </c:pt>
                <c:pt idx="315">
                  <c:v>80222.131103515625</c:v>
                </c:pt>
                <c:pt idx="316">
                  <c:v>80214.96452331543</c:v>
                </c:pt>
                <c:pt idx="317">
                  <c:v>80205.455078125</c:v>
                </c:pt>
                <c:pt idx="318">
                  <c:v>80209.174209594727</c:v>
                </c:pt>
                <c:pt idx="319">
                  <c:v>80214.007629394531</c:v>
                </c:pt>
                <c:pt idx="320">
                  <c:v>80211.641036987305</c:v>
                </c:pt>
                <c:pt idx="321">
                  <c:v>80204.531600952148</c:v>
                </c:pt>
                <c:pt idx="322">
                  <c:v>80197.736434936523</c:v>
                </c:pt>
                <c:pt idx="323">
                  <c:v>80189.912719726563</c:v>
                </c:pt>
                <c:pt idx="324">
                  <c:v>80182.117553710938</c:v>
                </c:pt>
                <c:pt idx="325">
                  <c:v>80176.179550170898</c:v>
                </c:pt>
                <c:pt idx="326">
                  <c:v>80175.070098876953</c:v>
                </c:pt>
                <c:pt idx="327">
                  <c:v>80176.817810058594</c:v>
                </c:pt>
                <c:pt idx="328">
                  <c:v>80182.365509033203</c:v>
                </c:pt>
                <c:pt idx="329">
                  <c:v>80187.941772460938</c:v>
                </c:pt>
                <c:pt idx="330">
                  <c:v>80193.146621704102</c:v>
                </c:pt>
                <c:pt idx="331">
                  <c:v>80188.951461791992</c:v>
                </c:pt>
                <c:pt idx="332">
                  <c:v>80181.727737426758</c:v>
                </c:pt>
                <c:pt idx="333">
                  <c:v>80177.73258972168</c:v>
                </c:pt>
                <c:pt idx="334">
                  <c:v>80176.166000366211</c:v>
                </c:pt>
                <c:pt idx="335">
                  <c:v>80173.285125732422</c:v>
                </c:pt>
                <c:pt idx="336">
                  <c:v>80175.632827758789</c:v>
                </c:pt>
                <c:pt idx="337">
                  <c:v>80183.809097290039</c:v>
                </c:pt>
                <c:pt idx="338">
                  <c:v>80185.699661254883</c:v>
                </c:pt>
                <c:pt idx="339">
                  <c:v>80181.790222167969</c:v>
                </c:pt>
                <c:pt idx="340">
                  <c:v>80177.652206420898</c:v>
                </c:pt>
                <c:pt idx="341">
                  <c:v>80177.114196777344</c:v>
                </c:pt>
                <c:pt idx="342">
                  <c:v>80178.861892700195</c:v>
                </c:pt>
                <c:pt idx="343">
                  <c:v>80184.438171386719</c:v>
                </c:pt>
                <c:pt idx="344">
                  <c:v>80189.528732299805</c:v>
                </c:pt>
                <c:pt idx="345">
                  <c:v>80194.676422119141</c:v>
                </c:pt>
                <c:pt idx="346">
                  <c:v>80197.909851074219</c:v>
                </c:pt>
                <c:pt idx="347">
                  <c:v>80196.257537841797</c:v>
                </c:pt>
                <c:pt idx="348">
                  <c:v>80188.148101806641</c:v>
                </c:pt>
                <c:pt idx="349">
                  <c:v>80180.324371337891</c:v>
                </c:pt>
                <c:pt idx="350">
                  <c:v>80172.843505859375</c:v>
                </c:pt>
                <c:pt idx="351">
                  <c:v>80168.619781494141</c:v>
                </c:pt>
                <c:pt idx="352">
                  <c:v>80167.310333251953</c:v>
                </c:pt>
                <c:pt idx="353">
                  <c:v>80167.058044433594</c:v>
                </c:pt>
                <c:pt idx="354">
                  <c:v>80167.977172851563</c:v>
                </c:pt>
                <c:pt idx="355">
                  <c:v>80167.210586547852</c:v>
                </c:pt>
                <c:pt idx="356">
                  <c:v>80162.272567749023</c:v>
                </c:pt>
                <c:pt idx="357">
                  <c:v>80157.30598449707</c:v>
                </c:pt>
                <c:pt idx="358">
                  <c:v>80162.253692626953</c:v>
                </c:pt>
                <c:pt idx="359">
                  <c:v>80172.172821044922</c:v>
                </c:pt>
                <c:pt idx="360">
                  <c:v>80176.091949462891</c:v>
                </c:pt>
                <c:pt idx="361">
                  <c:v>80171.268218994141</c:v>
                </c:pt>
                <c:pt idx="362">
                  <c:v>80168.530212402344</c:v>
                </c:pt>
                <c:pt idx="363">
                  <c:v>80172.135055541992</c:v>
                </c:pt>
                <c:pt idx="364">
                  <c:v>80171.654174804688</c:v>
                </c:pt>
                <c:pt idx="365">
                  <c:v>80159.401885986328</c:v>
                </c:pt>
                <c:pt idx="366">
                  <c:v>80144.035293579102</c:v>
                </c:pt>
                <c:pt idx="367">
                  <c:v>80139.783004760742</c:v>
                </c:pt>
                <c:pt idx="368">
                  <c:v>80146.730697631836</c:v>
                </c:pt>
                <c:pt idx="369">
                  <c:v>80151.535552978516</c:v>
                </c:pt>
                <c:pt idx="370">
                  <c:v>80157.054672241211</c:v>
                </c:pt>
                <c:pt idx="371">
                  <c:v>80170.345230102539</c:v>
                </c:pt>
                <c:pt idx="372">
                  <c:v>80180.864364624023</c:v>
                </c:pt>
                <c:pt idx="373">
                  <c:v>80180.983489990234</c:v>
                </c:pt>
                <c:pt idx="374">
                  <c:v>80175.845474243164</c:v>
                </c:pt>
                <c:pt idx="375">
                  <c:v>80163.993179321289</c:v>
                </c:pt>
                <c:pt idx="376">
                  <c:v>80149.683746337891</c:v>
                </c:pt>
                <c:pt idx="377">
                  <c:v>80149.431442260742</c:v>
                </c:pt>
                <c:pt idx="378">
                  <c:v>80158.09342956543</c:v>
                </c:pt>
                <c:pt idx="379">
                  <c:v>80161.555419921875</c:v>
                </c:pt>
                <c:pt idx="380">
                  <c:v>80159.417404174805</c:v>
                </c:pt>
                <c:pt idx="381">
                  <c:v>80155.707962036133</c:v>
                </c:pt>
                <c:pt idx="382">
                  <c:v>80147.769943237305</c:v>
                </c:pt>
                <c:pt idx="383">
                  <c:v>80141.403366088867</c:v>
                </c:pt>
                <c:pt idx="384">
                  <c:v>80137.379638671875</c:v>
                </c:pt>
                <c:pt idx="385">
                  <c:v>80136.413055419922</c:v>
                </c:pt>
                <c:pt idx="386">
                  <c:v>80135.617889404297</c:v>
                </c:pt>
                <c:pt idx="387">
                  <c:v>80134.022735595703</c:v>
                </c:pt>
                <c:pt idx="388">
                  <c:v>80130.999008178711</c:v>
                </c:pt>
                <c:pt idx="389">
                  <c:v>80127.203857421875</c:v>
                </c:pt>
                <c:pt idx="390">
                  <c:v>80127.780128479004</c:v>
                </c:pt>
                <c:pt idx="391">
                  <c:v>80137.699264526367</c:v>
                </c:pt>
                <c:pt idx="392">
                  <c:v>80149.01838684082</c:v>
                </c:pt>
                <c:pt idx="393">
                  <c:v>80150.080383300781</c:v>
                </c:pt>
                <c:pt idx="394">
                  <c:v>80148.599502563477</c:v>
                </c:pt>
                <c:pt idx="395">
                  <c:v>80154.375778198242</c:v>
                </c:pt>
                <c:pt idx="396">
                  <c:v>80156.35205078125</c:v>
                </c:pt>
                <c:pt idx="397">
                  <c:v>80149.356903076172</c:v>
                </c:pt>
                <c:pt idx="398">
                  <c:v>80139.218887329102</c:v>
                </c:pt>
                <c:pt idx="399">
                  <c:v>80136.595153808594</c:v>
                </c:pt>
                <c:pt idx="400">
                  <c:v>80136.771423339844</c:v>
                </c:pt>
                <c:pt idx="401">
                  <c:v>80137.290557861328</c:v>
                </c:pt>
                <c:pt idx="402">
                  <c:v>80133.209686279297</c:v>
                </c:pt>
                <c:pt idx="403">
                  <c:v>80127.843101501465</c:v>
                </c:pt>
                <c:pt idx="404">
                  <c:v>80125.762237548828</c:v>
                </c:pt>
                <c:pt idx="405">
                  <c:v>80126.881362915039</c:v>
                </c:pt>
                <c:pt idx="406">
                  <c:v>80126.286209106445</c:v>
                </c:pt>
                <c:pt idx="407">
                  <c:v>80118.033912658691</c:v>
                </c:pt>
                <c:pt idx="408">
                  <c:v>80110.581611633301</c:v>
                </c:pt>
                <c:pt idx="409">
                  <c:v>80110.81502532959</c:v>
                </c:pt>
                <c:pt idx="410">
                  <c:v>80117.391296386719</c:v>
                </c:pt>
                <c:pt idx="411">
                  <c:v>80126.110427856445</c:v>
                </c:pt>
                <c:pt idx="412">
                  <c:v>80130.172409057617</c:v>
                </c:pt>
                <c:pt idx="413">
                  <c:v>80127.291542053223</c:v>
                </c:pt>
                <c:pt idx="414">
                  <c:v>80122.724960327148</c:v>
                </c:pt>
                <c:pt idx="415">
                  <c:v>80122.386947631836</c:v>
                </c:pt>
                <c:pt idx="416">
                  <c:v>80123.077507019043</c:v>
                </c:pt>
                <c:pt idx="417">
                  <c:v>80120.510925292969</c:v>
                </c:pt>
                <c:pt idx="418">
                  <c:v>80116.687194824219</c:v>
                </c:pt>
                <c:pt idx="419">
                  <c:v>80114.949180603027</c:v>
                </c:pt>
                <c:pt idx="420">
                  <c:v>80122.668312072754</c:v>
                </c:pt>
                <c:pt idx="421">
                  <c:v>80136.616012573242</c:v>
                </c:pt>
                <c:pt idx="422">
                  <c:v>80142.649429321289</c:v>
                </c:pt>
                <c:pt idx="423">
                  <c:v>80136.854278564453</c:v>
                </c:pt>
                <c:pt idx="424">
                  <c:v>80124.059120178223</c:v>
                </c:pt>
                <c:pt idx="425">
                  <c:v>80111.492530822754</c:v>
                </c:pt>
                <c:pt idx="426">
                  <c:v>80102.668807983398</c:v>
                </c:pt>
                <c:pt idx="427">
                  <c:v>80103.816505432129</c:v>
                </c:pt>
                <c:pt idx="428">
                  <c:v>80112.249923706055</c:v>
                </c:pt>
                <c:pt idx="429">
                  <c:v>80115.254768371582</c:v>
                </c:pt>
                <c:pt idx="430">
                  <c:v>80111.88818359375</c:v>
                </c:pt>
                <c:pt idx="431">
                  <c:v>80112.03588104248</c:v>
                </c:pt>
                <c:pt idx="432">
                  <c:v>80122.555015563965</c:v>
                </c:pt>
                <c:pt idx="433">
                  <c:v>80127.502716064453</c:v>
                </c:pt>
                <c:pt idx="434">
                  <c:v>80122.307556152344</c:v>
                </c:pt>
                <c:pt idx="435">
                  <c:v>80119.998115539551</c:v>
                </c:pt>
                <c:pt idx="436">
                  <c:v>80127.060104370117</c:v>
                </c:pt>
                <c:pt idx="437">
                  <c:v>80131.693511962891</c:v>
                </c:pt>
                <c:pt idx="438">
                  <c:v>80125.355506896973</c:v>
                </c:pt>
                <c:pt idx="439">
                  <c:v>80117.160346984863</c:v>
                </c:pt>
                <c:pt idx="440">
                  <c:v>80114.85090637207</c:v>
                </c:pt>
                <c:pt idx="441">
                  <c:v>80115.255752563477</c:v>
                </c:pt>
                <c:pt idx="442">
                  <c:v>80112.546310424805</c:v>
                </c:pt>
                <c:pt idx="443">
                  <c:v>80113.265441894531</c:v>
                </c:pt>
                <c:pt idx="444">
                  <c:v>80124.898857116699</c:v>
                </c:pt>
                <c:pt idx="445">
                  <c:v>80141.817993164063</c:v>
                </c:pt>
                <c:pt idx="446">
                  <c:v>80150.022827148438</c:v>
                </c:pt>
                <c:pt idx="447">
                  <c:v>80150.313385009766</c:v>
                </c:pt>
                <c:pt idx="448">
                  <c:v>80143.061096191406</c:v>
                </c:pt>
                <c:pt idx="449">
                  <c:v>80127.723075866699</c:v>
                </c:pt>
                <c:pt idx="450">
                  <c:v>80111.242210388184</c:v>
                </c:pt>
                <c:pt idx="451">
                  <c:v>80110.447052001953</c:v>
                </c:pt>
                <c:pt idx="452">
                  <c:v>80124.48046875</c:v>
                </c:pt>
                <c:pt idx="453">
                  <c:v>80139.799591064453</c:v>
                </c:pt>
                <c:pt idx="454">
                  <c:v>80143.118728637695</c:v>
                </c:pt>
                <c:pt idx="455">
                  <c:v>80136.63786315918</c:v>
                </c:pt>
                <c:pt idx="456">
                  <c:v>80131.614135742188</c:v>
                </c:pt>
                <c:pt idx="457">
                  <c:v>80139.561828613281</c:v>
                </c:pt>
                <c:pt idx="458">
                  <c:v>80154.195251464844</c:v>
                </c:pt>
                <c:pt idx="459">
                  <c:v>80161.571517944336</c:v>
                </c:pt>
                <c:pt idx="460">
                  <c:v>80154.862075805664</c:v>
                </c:pt>
                <c:pt idx="461">
                  <c:v>80144.63835144043</c:v>
                </c:pt>
                <c:pt idx="462">
                  <c:v>80143.500335693359</c:v>
                </c:pt>
                <c:pt idx="463">
                  <c:v>80147.590896606445</c:v>
                </c:pt>
                <c:pt idx="464">
                  <c:v>80145.852890014648</c:v>
                </c:pt>
                <c:pt idx="465">
                  <c:v>80139.6005859375</c:v>
                </c:pt>
                <c:pt idx="466">
                  <c:v>80139.205429077148</c:v>
                </c:pt>
                <c:pt idx="467">
                  <c:v>80140.63883972168</c:v>
                </c:pt>
                <c:pt idx="468">
                  <c:v>80146.215118408203</c:v>
                </c:pt>
                <c:pt idx="469">
                  <c:v>80151.105682373047</c:v>
                </c:pt>
                <c:pt idx="470">
                  <c:v>80152.081954956055</c:v>
                </c:pt>
                <c:pt idx="471">
                  <c:v>80146.315368652344</c:v>
                </c:pt>
                <c:pt idx="472">
                  <c:v>80144.40592956543</c:v>
                </c:pt>
                <c:pt idx="473">
                  <c:v>80142.639343261719</c:v>
                </c:pt>
                <c:pt idx="474">
                  <c:v>80138.672760009766</c:v>
                </c:pt>
                <c:pt idx="475">
                  <c:v>80134.163314819336</c:v>
                </c:pt>
                <c:pt idx="476">
                  <c:v>80131.968154907227</c:v>
                </c:pt>
                <c:pt idx="477">
                  <c:v>80128.915863037109</c:v>
                </c:pt>
                <c:pt idx="478">
                  <c:v>80117.74927520752</c:v>
                </c:pt>
                <c:pt idx="479">
                  <c:v>80111.839828491211</c:v>
                </c:pt>
                <c:pt idx="480">
                  <c:v>80118.044677734375</c:v>
                </c:pt>
                <c:pt idx="481">
                  <c:v>80126.735237121582</c:v>
                </c:pt>
                <c:pt idx="482">
                  <c:v>80118.168647766113</c:v>
                </c:pt>
                <c:pt idx="483">
                  <c:v>80104.773490905762</c:v>
                </c:pt>
                <c:pt idx="484">
                  <c:v>80097.892623901367</c:v>
                </c:pt>
                <c:pt idx="485">
                  <c:v>80096.440322875977</c:v>
                </c:pt>
                <c:pt idx="486">
                  <c:v>80095.33088684082</c:v>
                </c:pt>
                <c:pt idx="487">
                  <c:v>80092.650016784668</c:v>
                </c:pt>
                <c:pt idx="488">
                  <c:v>80090.597717285156</c:v>
                </c:pt>
                <c:pt idx="489">
                  <c:v>80089.402557373047</c:v>
                </c:pt>
                <c:pt idx="490">
                  <c:v>80088.693115234375</c:v>
                </c:pt>
                <c:pt idx="491">
                  <c:v>80089.469390869141</c:v>
                </c:pt>
                <c:pt idx="492">
                  <c:v>80090.731376647949</c:v>
                </c:pt>
                <c:pt idx="493">
                  <c:v>80088.393363952637</c:v>
                </c:pt>
                <c:pt idx="494">
                  <c:v>80081.455352783203</c:v>
                </c:pt>
                <c:pt idx="495">
                  <c:v>80076.888763427734</c:v>
                </c:pt>
                <c:pt idx="496">
                  <c:v>80077.265037536621</c:v>
                </c:pt>
                <c:pt idx="497">
                  <c:v>80081.641311645508</c:v>
                </c:pt>
                <c:pt idx="498">
                  <c:v>80083.674728393555</c:v>
                </c:pt>
                <c:pt idx="499">
                  <c:v>80086.622428894043</c:v>
                </c:pt>
                <c:pt idx="500">
                  <c:v>80091.684417724609</c:v>
                </c:pt>
                <c:pt idx="501">
                  <c:v>80100.974975585938</c:v>
                </c:pt>
                <c:pt idx="502">
                  <c:v>80104.351249694824</c:v>
                </c:pt>
                <c:pt idx="503">
                  <c:v>80099.070373535156</c:v>
                </c:pt>
                <c:pt idx="504">
                  <c:v>80086.903793334961</c:v>
                </c:pt>
                <c:pt idx="505">
                  <c:v>80077.594352722168</c:v>
                </c:pt>
                <c:pt idx="506">
                  <c:v>80075.284912109375</c:v>
                </c:pt>
                <c:pt idx="507">
                  <c:v>80075.546897888184</c:v>
                </c:pt>
                <c:pt idx="508">
                  <c:v>80076.808883666992</c:v>
                </c:pt>
                <c:pt idx="509">
                  <c:v>80072.699440002441</c:v>
                </c:pt>
                <c:pt idx="510">
                  <c:v>80071.190002441406</c:v>
                </c:pt>
                <c:pt idx="511">
                  <c:v>80085.137702941895</c:v>
                </c:pt>
                <c:pt idx="512">
                  <c:v>80106.113975524902</c:v>
                </c:pt>
                <c:pt idx="513">
                  <c:v>80105.890243530273</c:v>
                </c:pt>
                <c:pt idx="514">
                  <c:v>80085.323661804199</c:v>
                </c:pt>
                <c:pt idx="515">
                  <c:v>80066.842788696289</c:v>
                </c:pt>
                <c:pt idx="516">
                  <c:v>80061.161922454834</c:v>
                </c:pt>
                <c:pt idx="517">
                  <c:v>80064.452484130859</c:v>
                </c:pt>
                <c:pt idx="518">
                  <c:v>80066.714469909668</c:v>
                </c:pt>
                <c:pt idx="519">
                  <c:v>80061.433597564697</c:v>
                </c:pt>
                <c:pt idx="520">
                  <c:v>80053.981300354004</c:v>
                </c:pt>
                <c:pt idx="521">
                  <c:v>80054.843284606934</c:v>
                </c:pt>
                <c:pt idx="522">
                  <c:v>80056.276702880859</c:v>
                </c:pt>
                <c:pt idx="523">
                  <c:v>80054.338687896729</c:v>
                </c:pt>
                <c:pt idx="524">
                  <c:v>80056.657817840576</c:v>
                </c:pt>
                <c:pt idx="525">
                  <c:v>80065.748374938965</c:v>
                </c:pt>
                <c:pt idx="526">
                  <c:v>80070.667503356934</c:v>
                </c:pt>
                <c:pt idx="527">
                  <c:v>80059.7294921875</c:v>
                </c:pt>
                <c:pt idx="528">
                  <c:v>80037.562908172607</c:v>
                </c:pt>
                <c:pt idx="529">
                  <c:v>80023.653467178345</c:v>
                </c:pt>
                <c:pt idx="530">
                  <c:v>80025.829740524292</c:v>
                </c:pt>
                <c:pt idx="531">
                  <c:v>80031.46315574646</c:v>
                </c:pt>
                <c:pt idx="532">
                  <c:v>80029.496570587158</c:v>
                </c:pt>
                <c:pt idx="533">
                  <c:v>80028.101415634155</c:v>
                </c:pt>
                <c:pt idx="534">
                  <c:v>80029.163402557373</c:v>
                </c:pt>
                <c:pt idx="535">
                  <c:v>80030.1682472229</c:v>
                </c:pt>
                <c:pt idx="536">
                  <c:v>80034.144519805908</c:v>
                </c:pt>
                <c:pt idx="537">
                  <c:v>80041.463649749756</c:v>
                </c:pt>
                <c:pt idx="538">
                  <c:v>80039.325637817383</c:v>
                </c:pt>
                <c:pt idx="539">
                  <c:v>80030.730480194092</c:v>
                </c:pt>
                <c:pt idx="540">
                  <c:v>80028.335325241089</c:v>
                </c:pt>
                <c:pt idx="541">
                  <c:v>80038.625885009766</c:v>
                </c:pt>
                <c:pt idx="542">
                  <c:v>80047.802154541016</c:v>
                </c:pt>
                <c:pt idx="543">
                  <c:v>80044.207000732422</c:v>
                </c:pt>
                <c:pt idx="544">
                  <c:v>80030.783271789551</c:v>
                </c:pt>
                <c:pt idx="545">
                  <c:v>80018.845260620117</c:v>
                </c:pt>
                <c:pt idx="546">
                  <c:v>80017.392961502075</c:v>
                </c:pt>
                <c:pt idx="547">
                  <c:v>80024.026376724243</c:v>
                </c:pt>
                <c:pt idx="548">
                  <c:v>80029.2883644104</c:v>
                </c:pt>
                <c:pt idx="549">
                  <c:v>80028.664636611938</c:v>
                </c:pt>
                <c:pt idx="550">
                  <c:v>80032.012336730957</c:v>
                </c:pt>
                <c:pt idx="551">
                  <c:v>80049.302894592285</c:v>
                </c:pt>
                <c:pt idx="552">
                  <c:v>80072.164886474609</c:v>
                </c:pt>
                <c:pt idx="553">
                  <c:v>80084.426872253418</c:v>
                </c:pt>
                <c:pt idx="554">
                  <c:v>80081.48885345459</c:v>
                </c:pt>
                <c:pt idx="555">
                  <c:v>80071.150840759277</c:v>
                </c:pt>
                <c:pt idx="556">
                  <c:v>80065.09854888916</c:v>
                </c:pt>
                <c:pt idx="557">
                  <c:v>80064.760536193848</c:v>
                </c:pt>
                <c:pt idx="558">
                  <c:v>80061.851089477539</c:v>
                </c:pt>
                <c:pt idx="559">
                  <c:v>80054.770221710205</c:v>
                </c:pt>
                <c:pt idx="560">
                  <c:v>80054.260780334473</c:v>
                </c:pt>
                <c:pt idx="561">
                  <c:v>80071.065620422363</c:v>
                </c:pt>
                <c:pt idx="562">
                  <c:v>80091.184753417969</c:v>
                </c:pt>
                <c:pt idx="563">
                  <c:v>80094.361022949219</c:v>
                </c:pt>
                <c:pt idx="564">
                  <c:v>80081.737297058105</c:v>
                </c:pt>
                <c:pt idx="565">
                  <c:v>80076.285003662109</c:v>
                </c:pt>
                <c:pt idx="566">
                  <c:v>80086.004127502441</c:v>
                </c:pt>
                <c:pt idx="567">
                  <c:v>80100.123260498047</c:v>
                </c:pt>
                <c:pt idx="568">
                  <c:v>80102.270957946777</c:v>
                </c:pt>
                <c:pt idx="569">
                  <c:v>80092.675804138184</c:v>
                </c:pt>
                <c:pt idx="570">
                  <c:v>80077.309219360352</c:v>
                </c:pt>
                <c:pt idx="571">
                  <c:v>80060.914066314697</c:v>
                </c:pt>
                <c:pt idx="572">
                  <c:v>80045.576053619385</c:v>
                </c:pt>
                <c:pt idx="573">
                  <c:v>80044.438037872314</c:v>
                </c:pt>
                <c:pt idx="574">
                  <c:v>80055.300025939941</c:v>
                </c:pt>
                <c:pt idx="575">
                  <c:v>80064.962013244629</c:v>
                </c:pt>
                <c:pt idx="576">
                  <c:v>80074.738288879395</c:v>
                </c:pt>
                <c:pt idx="577">
                  <c:v>80090.685989379883</c:v>
                </c:pt>
                <c:pt idx="578">
                  <c:v>80105.176544189453</c:v>
                </c:pt>
                <c:pt idx="579">
                  <c:v>80105.381385803223</c:v>
                </c:pt>
                <c:pt idx="580">
                  <c:v>80095.41480255127</c:v>
                </c:pt>
                <c:pt idx="581">
                  <c:v>80087.448219299316</c:v>
                </c:pt>
                <c:pt idx="582">
                  <c:v>80087.795921325684</c:v>
                </c:pt>
                <c:pt idx="583">
                  <c:v>80098.82933807373</c:v>
                </c:pt>
                <c:pt idx="584">
                  <c:v>80115.577041625977</c:v>
                </c:pt>
                <c:pt idx="585">
                  <c:v>80130.724746704102</c:v>
                </c:pt>
                <c:pt idx="586">
                  <c:v>80137.32958984375</c:v>
                </c:pt>
                <c:pt idx="587">
                  <c:v>80137.248718261719</c:v>
                </c:pt>
                <c:pt idx="588">
                  <c:v>80141.282135009766</c:v>
                </c:pt>
                <c:pt idx="589">
                  <c:v>80147.17268371582</c:v>
                </c:pt>
                <c:pt idx="590">
                  <c:v>80146.66325378418</c:v>
                </c:pt>
                <c:pt idx="591">
                  <c:v>80150.068084716797</c:v>
                </c:pt>
                <c:pt idx="592">
                  <c:v>80209.501510620117</c:v>
                </c:pt>
                <c:pt idx="593">
                  <c:v>80700.306335449219</c:v>
                </c:pt>
                <c:pt idx="594">
                  <c:v>83184.197021484375</c:v>
                </c:pt>
                <c:pt idx="595">
                  <c:v>90664.14453125</c:v>
                </c:pt>
                <c:pt idx="596">
                  <c:v>106361.8359375</c:v>
                </c:pt>
                <c:pt idx="597">
                  <c:v>131937.32421875</c:v>
                </c:pt>
                <c:pt idx="598">
                  <c:v>167110.6171875</c:v>
                </c:pt>
                <c:pt idx="599">
                  <c:v>210908.1953125</c:v>
                </c:pt>
                <c:pt idx="600">
                  <c:v>263767.59375</c:v>
                </c:pt>
                <c:pt idx="601">
                  <c:v>308386.140625</c:v>
                </c:pt>
                <c:pt idx="602">
                  <c:v>329815.640625</c:v>
                </c:pt>
                <c:pt idx="603">
                  <c:v>329815.75</c:v>
                </c:pt>
                <c:pt idx="604">
                  <c:v>329815.875</c:v>
                </c:pt>
                <c:pt idx="605">
                  <c:v>329816</c:v>
                </c:pt>
                <c:pt idx="606">
                  <c:v>329816.109375</c:v>
                </c:pt>
                <c:pt idx="607">
                  <c:v>329816.234375</c:v>
                </c:pt>
                <c:pt idx="608">
                  <c:v>329816.34375</c:v>
                </c:pt>
                <c:pt idx="609">
                  <c:v>329816.46875</c:v>
                </c:pt>
                <c:pt idx="610">
                  <c:v>329816.59375</c:v>
                </c:pt>
                <c:pt idx="611">
                  <c:v>329816.703125</c:v>
                </c:pt>
                <c:pt idx="612">
                  <c:v>329816.828125</c:v>
                </c:pt>
                <c:pt idx="613">
                  <c:v>329816.953125</c:v>
                </c:pt>
                <c:pt idx="614">
                  <c:v>329817.0625</c:v>
                </c:pt>
                <c:pt idx="615">
                  <c:v>329817.1875</c:v>
                </c:pt>
                <c:pt idx="616">
                  <c:v>329817.296875</c:v>
                </c:pt>
                <c:pt idx="617">
                  <c:v>329817.421875</c:v>
                </c:pt>
                <c:pt idx="618">
                  <c:v>329817.546875</c:v>
                </c:pt>
                <c:pt idx="619">
                  <c:v>329817.65625</c:v>
                </c:pt>
                <c:pt idx="620">
                  <c:v>329817.78125</c:v>
                </c:pt>
                <c:pt idx="621">
                  <c:v>329817.90625</c:v>
                </c:pt>
                <c:pt idx="622">
                  <c:v>329818.015625</c:v>
                </c:pt>
                <c:pt idx="623">
                  <c:v>329818.140625</c:v>
                </c:pt>
                <c:pt idx="624">
                  <c:v>329818.25</c:v>
                </c:pt>
                <c:pt idx="625">
                  <c:v>329818.375</c:v>
                </c:pt>
                <c:pt idx="626">
                  <c:v>329818.5</c:v>
                </c:pt>
                <c:pt idx="627">
                  <c:v>329818.609375</c:v>
                </c:pt>
                <c:pt idx="628">
                  <c:v>329818.734375</c:v>
                </c:pt>
                <c:pt idx="629">
                  <c:v>329818.859375</c:v>
                </c:pt>
                <c:pt idx="630">
                  <c:v>329818.96875</c:v>
                </c:pt>
                <c:pt idx="631">
                  <c:v>329819.09375</c:v>
                </c:pt>
                <c:pt idx="632">
                  <c:v>329819.203125</c:v>
                </c:pt>
                <c:pt idx="633">
                  <c:v>329819.328125</c:v>
                </c:pt>
                <c:pt idx="634">
                  <c:v>329819.453125</c:v>
                </c:pt>
                <c:pt idx="635">
                  <c:v>329819.5625</c:v>
                </c:pt>
                <c:pt idx="636">
                  <c:v>329819.6875</c:v>
                </c:pt>
                <c:pt idx="637">
                  <c:v>329819.8125</c:v>
                </c:pt>
                <c:pt idx="638">
                  <c:v>329819.921875</c:v>
                </c:pt>
                <c:pt idx="639">
                  <c:v>329820.046875</c:v>
                </c:pt>
                <c:pt idx="640">
                  <c:v>329820.15625</c:v>
                </c:pt>
                <c:pt idx="641">
                  <c:v>329820.28125</c:v>
                </c:pt>
                <c:pt idx="642">
                  <c:v>329820.40625</c:v>
                </c:pt>
                <c:pt idx="643">
                  <c:v>329820.515625</c:v>
                </c:pt>
                <c:pt idx="644">
                  <c:v>329820.640625</c:v>
                </c:pt>
                <c:pt idx="645">
                  <c:v>329820.765625</c:v>
                </c:pt>
                <c:pt idx="646">
                  <c:v>329820.875</c:v>
                </c:pt>
                <c:pt idx="647">
                  <c:v>329821</c:v>
                </c:pt>
                <c:pt idx="648">
                  <c:v>329821.109375</c:v>
                </c:pt>
                <c:pt idx="649">
                  <c:v>329821.234375</c:v>
                </c:pt>
                <c:pt idx="650">
                  <c:v>329821.359375</c:v>
                </c:pt>
                <c:pt idx="651">
                  <c:v>329821.46875</c:v>
                </c:pt>
                <c:pt idx="652">
                  <c:v>329821.59375</c:v>
                </c:pt>
                <c:pt idx="653">
                  <c:v>329821.71875</c:v>
                </c:pt>
                <c:pt idx="654">
                  <c:v>329821.828125</c:v>
                </c:pt>
                <c:pt idx="655">
                  <c:v>329821.953125</c:v>
                </c:pt>
                <c:pt idx="656">
                  <c:v>329822.0625</c:v>
                </c:pt>
                <c:pt idx="657">
                  <c:v>329822.1875</c:v>
                </c:pt>
                <c:pt idx="658">
                  <c:v>329822.3125</c:v>
                </c:pt>
                <c:pt idx="659">
                  <c:v>329822.421875</c:v>
                </c:pt>
                <c:pt idx="660">
                  <c:v>329822.546875</c:v>
                </c:pt>
                <c:pt idx="661">
                  <c:v>329822.671875</c:v>
                </c:pt>
                <c:pt idx="662">
                  <c:v>329822.78125</c:v>
                </c:pt>
                <c:pt idx="663">
                  <c:v>329822.90625</c:v>
                </c:pt>
                <c:pt idx="664">
                  <c:v>329823.015625</c:v>
                </c:pt>
                <c:pt idx="665">
                  <c:v>329823.140625</c:v>
                </c:pt>
                <c:pt idx="666">
                  <c:v>329823.265625</c:v>
                </c:pt>
                <c:pt idx="667">
                  <c:v>329823.375</c:v>
                </c:pt>
                <c:pt idx="668">
                  <c:v>329823.5</c:v>
                </c:pt>
                <c:pt idx="669">
                  <c:v>329823.625</c:v>
                </c:pt>
                <c:pt idx="670">
                  <c:v>329823.734375</c:v>
                </c:pt>
                <c:pt idx="671">
                  <c:v>329823.859375</c:v>
                </c:pt>
                <c:pt idx="672">
                  <c:v>329823.96875</c:v>
                </c:pt>
                <c:pt idx="673">
                  <c:v>329824.09375</c:v>
                </c:pt>
                <c:pt idx="674">
                  <c:v>329824.21875</c:v>
                </c:pt>
                <c:pt idx="675">
                  <c:v>329824.328125</c:v>
                </c:pt>
                <c:pt idx="676">
                  <c:v>329824.453125</c:v>
                </c:pt>
                <c:pt idx="677">
                  <c:v>329824.578125</c:v>
                </c:pt>
                <c:pt idx="678">
                  <c:v>329824.6875</c:v>
                </c:pt>
                <c:pt idx="679">
                  <c:v>329824.8125</c:v>
                </c:pt>
                <c:pt idx="680">
                  <c:v>329824.921875</c:v>
                </c:pt>
                <c:pt idx="681">
                  <c:v>329825.046875</c:v>
                </c:pt>
                <c:pt idx="682">
                  <c:v>329825.171875</c:v>
                </c:pt>
                <c:pt idx="683">
                  <c:v>329825.28125</c:v>
                </c:pt>
                <c:pt idx="684">
                  <c:v>329825.40625</c:v>
                </c:pt>
                <c:pt idx="685">
                  <c:v>329825.53125</c:v>
                </c:pt>
                <c:pt idx="686">
                  <c:v>329825.640625</c:v>
                </c:pt>
                <c:pt idx="687">
                  <c:v>329825.765625</c:v>
                </c:pt>
                <c:pt idx="688">
                  <c:v>329825.875</c:v>
                </c:pt>
                <c:pt idx="689">
                  <c:v>329826</c:v>
                </c:pt>
                <c:pt idx="690">
                  <c:v>329826.125</c:v>
                </c:pt>
                <c:pt idx="691">
                  <c:v>329826.234375</c:v>
                </c:pt>
                <c:pt idx="692">
                  <c:v>329826.359375</c:v>
                </c:pt>
                <c:pt idx="693">
                  <c:v>329826.46875</c:v>
                </c:pt>
                <c:pt idx="694">
                  <c:v>329826.59375</c:v>
                </c:pt>
                <c:pt idx="695">
                  <c:v>329826.71875</c:v>
                </c:pt>
                <c:pt idx="696">
                  <c:v>329826.828125</c:v>
                </c:pt>
                <c:pt idx="697">
                  <c:v>324220.8125</c:v>
                </c:pt>
                <c:pt idx="698">
                  <c:v>320979.078125</c:v>
                </c:pt>
                <c:pt idx="699">
                  <c:v>315356.796875</c:v>
                </c:pt>
                <c:pt idx="700">
                  <c:v>284436.9375</c:v>
                </c:pt>
                <c:pt idx="701">
                  <c:v>217124.109375</c:v>
                </c:pt>
                <c:pt idx="702">
                  <c:v>151193.203125</c:v>
                </c:pt>
                <c:pt idx="703">
                  <c:v>113026.41015625</c:v>
                </c:pt>
                <c:pt idx="704">
                  <c:v>96409.47265625</c:v>
                </c:pt>
                <c:pt idx="705">
                  <c:v>91703.048828125</c:v>
                </c:pt>
                <c:pt idx="706">
                  <c:v>92013.25390625</c:v>
                </c:pt>
                <c:pt idx="707">
                  <c:v>93678.3154296875</c:v>
                </c:pt>
                <c:pt idx="708">
                  <c:v>95619.6064453125</c:v>
                </c:pt>
                <c:pt idx="709">
                  <c:v>98488.783203125</c:v>
                </c:pt>
                <c:pt idx="710">
                  <c:v>103280.2734375</c:v>
                </c:pt>
                <c:pt idx="711">
                  <c:v>109845.1640625</c:v>
                </c:pt>
                <c:pt idx="712">
                  <c:v>117028.94140625</c:v>
                </c:pt>
                <c:pt idx="713">
                  <c:v>123987.57421875</c:v>
                </c:pt>
                <c:pt idx="714">
                  <c:v>130910.77734375</c:v>
                </c:pt>
                <c:pt idx="715">
                  <c:v>138690.52734375</c:v>
                </c:pt>
                <c:pt idx="716">
                  <c:v>148395.21875</c:v>
                </c:pt>
                <c:pt idx="717">
                  <c:v>160892.1640625</c:v>
                </c:pt>
                <c:pt idx="718">
                  <c:v>176434.1953125</c:v>
                </c:pt>
                <c:pt idx="719">
                  <c:v>193749.484375</c:v>
                </c:pt>
                <c:pt idx="720">
                  <c:v>208710.6640625</c:v>
                </c:pt>
                <c:pt idx="721">
                  <c:v>214477.5625</c:v>
                </c:pt>
                <c:pt idx="722">
                  <c:v>206830.875</c:v>
                </c:pt>
                <c:pt idx="723">
                  <c:v>187638.8515625</c:v>
                </c:pt>
                <c:pt idx="724">
                  <c:v>163478.0546875</c:v>
                </c:pt>
                <c:pt idx="725">
                  <c:v>141456.71875</c:v>
                </c:pt>
                <c:pt idx="726">
                  <c:v>126539.46484375</c:v>
                </c:pt>
                <c:pt idx="727">
                  <c:v>119116.09765625</c:v>
                </c:pt>
                <c:pt idx="728">
                  <c:v>116037.55859375</c:v>
                </c:pt>
                <c:pt idx="729">
                  <c:v>114841.79296875</c:v>
                </c:pt>
                <c:pt idx="730">
                  <c:v>115429.33984375</c:v>
                </c:pt>
                <c:pt idx="731">
                  <c:v>118284.9453125</c:v>
                </c:pt>
                <c:pt idx="732">
                  <c:v>122979.609375</c:v>
                </c:pt>
                <c:pt idx="733">
                  <c:v>128502.15625</c:v>
                </c:pt>
                <c:pt idx="734">
                  <c:v>134075.2734375</c:v>
                </c:pt>
                <c:pt idx="735">
                  <c:v>139329.79296875</c:v>
                </c:pt>
                <c:pt idx="736">
                  <c:v>144109.96875</c:v>
                </c:pt>
                <c:pt idx="737">
                  <c:v>148359.515625</c:v>
                </c:pt>
                <c:pt idx="738">
                  <c:v>152106.953125</c:v>
                </c:pt>
                <c:pt idx="739">
                  <c:v>155372.296875</c:v>
                </c:pt>
                <c:pt idx="740">
                  <c:v>158044.703125</c:v>
                </c:pt>
                <c:pt idx="741">
                  <c:v>158232.90625</c:v>
                </c:pt>
                <c:pt idx="742">
                  <c:v>151904.65625</c:v>
                </c:pt>
                <c:pt idx="743">
                  <c:v>138282.17578125</c:v>
                </c:pt>
                <c:pt idx="744">
                  <c:v>123561.58203125</c:v>
                </c:pt>
                <c:pt idx="745">
                  <c:v>114409.328125</c:v>
                </c:pt>
                <c:pt idx="746">
                  <c:v>110567.5625</c:v>
                </c:pt>
                <c:pt idx="747">
                  <c:v>108814.224609375</c:v>
                </c:pt>
                <c:pt idx="748">
                  <c:v>108555.65625</c:v>
                </c:pt>
                <c:pt idx="749">
                  <c:v>109643.51953125</c:v>
                </c:pt>
                <c:pt idx="750">
                  <c:v>109925.58203125</c:v>
                </c:pt>
                <c:pt idx="751">
                  <c:v>108376.04296875</c:v>
                </c:pt>
                <c:pt idx="752">
                  <c:v>106642.4765625</c:v>
                </c:pt>
                <c:pt idx="753">
                  <c:v>107352.423828125</c:v>
                </c:pt>
                <c:pt idx="754">
                  <c:v>115565</c:v>
                </c:pt>
                <c:pt idx="755">
                  <c:v>141455.43359375</c:v>
                </c:pt>
                <c:pt idx="756">
                  <c:v>194588.4921875</c:v>
                </c:pt>
                <c:pt idx="757">
                  <c:v>267615.921875</c:v>
                </c:pt>
                <c:pt idx="758">
                  <c:v>323442.453125</c:v>
                </c:pt>
                <c:pt idx="759">
                  <c:v>328958.171875</c:v>
                </c:pt>
                <c:pt idx="760">
                  <c:v>278675.578125</c:v>
                </c:pt>
                <c:pt idx="761">
                  <c:v>207971.3203125</c:v>
                </c:pt>
                <c:pt idx="762">
                  <c:v>149910.953125</c:v>
                </c:pt>
                <c:pt idx="763">
                  <c:v>120254.1015625</c:v>
                </c:pt>
                <c:pt idx="764">
                  <c:v>109929.935546875</c:v>
                </c:pt>
                <c:pt idx="765">
                  <c:v>110391.826171875</c:v>
                </c:pt>
                <c:pt idx="766">
                  <c:v>116074.515625</c:v>
                </c:pt>
                <c:pt idx="767">
                  <c:v>123672.6640625</c:v>
                </c:pt>
                <c:pt idx="768">
                  <c:v>130031.3828125</c:v>
                </c:pt>
                <c:pt idx="769">
                  <c:v>133100.671875</c:v>
                </c:pt>
                <c:pt idx="770">
                  <c:v>132143.6796875</c:v>
                </c:pt>
                <c:pt idx="771">
                  <c:v>126752.796875</c:v>
                </c:pt>
                <c:pt idx="772">
                  <c:v>117841.171875</c:v>
                </c:pt>
                <c:pt idx="773">
                  <c:v>109292.03515625</c:v>
                </c:pt>
                <c:pt idx="774">
                  <c:v>104441.26953125</c:v>
                </c:pt>
                <c:pt idx="775">
                  <c:v>102572.98828125</c:v>
                </c:pt>
                <c:pt idx="776">
                  <c:v>101489.3359375</c:v>
                </c:pt>
                <c:pt idx="777">
                  <c:v>102147.369140625</c:v>
                </c:pt>
                <c:pt idx="778">
                  <c:v>108434.66015625</c:v>
                </c:pt>
                <c:pt idx="779">
                  <c:v>123767.80859375</c:v>
                </c:pt>
                <c:pt idx="780">
                  <c:v>148657.1875</c:v>
                </c:pt>
                <c:pt idx="781">
                  <c:v>181462.875</c:v>
                </c:pt>
                <c:pt idx="782">
                  <c:v>219685.65625</c:v>
                </c:pt>
                <c:pt idx="783">
                  <c:v>260456.375</c:v>
                </c:pt>
                <c:pt idx="784">
                  <c:v>300539.515625</c:v>
                </c:pt>
                <c:pt idx="785">
                  <c:v>325315.75</c:v>
                </c:pt>
                <c:pt idx="786">
                  <c:v>329837.5625</c:v>
                </c:pt>
                <c:pt idx="787">
                  <c:v>329837.671875</c:v>
                </c:pt>
                <c:pt idx="788">
                  <c:v>327629.796875</c:v>
                </c:pt>
                <c:pt idx="789">
                  <c:v>288691.59375</c:v>
                </c:pt>
                <c:pt idx="790">
                  <c:v>220503.546875</c:v>
                </c:pt>
                <c:pt idx="791">
                  <c:v>157255.890625</c:v>
                </c:pt>
                <c:pt idx="792">
                  <c:v>124132.35546875</c:v>
                </c:pt>
                <c:pt idx="793">
                  <c:v>112353.703125</c:v>
                </c:pt>
                <c:pt idx="794">
                  <c:v>110720.59375</c:v>
                </c:pt>
                <c:pt idx="795">
                  <c:v>110475.65625</c:v>
                </c:pt>
                <c:pt idx="796">
                  <c:v>108043.375</c:v>
                </c:pt>
                <c:pt idx="797">
                  <c:v>104280.5234375</c:v>
                </c:pt>
                <c:pt idx="798">
                  <c:v>101118.669921875</c:v>
                </c:pt>
                <c:pt idx="799">
                  <c:v>99338.189453125</c:v>
                </c:pt>
                <c:pt idx="800">
                  <c:v>99083.13671875</c:v>
                </c:pt>
                <c:pt idx="801">
                  <c:v>100744.54296875</c:v>
                </c:pt>
                <c:pt idx="802">
                  <c:v>104728.34765625</c:v>
                </c:pt>
                <c:pt idx="803">
                  <c:v>110390.72265625</c:v>
                </c:pt>
                <c:pt idx="804">
                  <c:v>114506.95703125</c:v>
                </c:pt>
                <c:pt idx="805">
                  <c:v>113499.7890625</c:v>
                </c:pt>
                <c:pt idx="806">
                  <c:v>108830.109375</c:v>
                </c:pt>
                <c:pt idx="807">
                  <c:v>107521.80078125</c:v>
                </c:pt>
                <c:pt idx="808">
                  <c:v>115341.77734375</c:v>
                </c:pt>
                <c:pt idx="809">
                  <c:v>132756.92578125</c:v>
                </c:pt>
                <c:pt idx="810">
                  <c:v>157527.671875</c:v>
                </c:pt>
                <c:pt idx="811">
                  <c:v>188044.6484375</c:v>
                </c:pt>
                <c:pt idx="812">
                  <c:v>224241.515625</c:v>
                </c:pt>
                <c:pt idx="813">
                  <c:v>269020.6875</c:v>
                </c:pt>
                <c:pt idx="814">
                  <c:v>308914.65625</c:v>
                </c:pt>
                <c:pt idx="815">
                  <c:v>329527.984375</c:v>
                </c:pt>
                <c:pt idx="816">
                  <c:v>329841.125</c:v>
                </c:pt>
                <c:pt idx="817">
                  <c:v>329841.25</c:v>
                </c:pt>
                <c:pt idx="818">
                  <c:v>329841.375</c:v>
                </c:pt>
                <c:pt idx="819">
                  <c:v>329841.484375</c:v>
                </c:pt>
                <c:pt idx="820">
                  <c:v>329841.609375</c:v>
                </c:pt>
                <c:pt idx="821">
                  <c:v>329841.71875</c:v>
                </c:pt>
                <c:pt idx="822">
                  <c:v>329841.84375</c:v>
                </c:pt>
                <c:pt idx="823">
                  <c:v>329841.96875</c:v>
                </c:pt>
                <c:pt idx="824">
                  <c:v>329842.078125</c:v>
                </c:pt>
                <c:pt idx="825">
                  <c:v>329842.203125</c:v>
                </c:pt>
                <c:pt idx="826">
                  <c:v>329842.328125</c:v>
                </c:pt>
                <c:pt idx="827">
                  <c:v>329842.4375</c:v>
                </c:pt>
                <c:pt idx="828">
                  <c:v>329842.5625</c:v>
                </c:pt>
                <c:pt idx="829">
                  <c:v>329842.671875</c:v>
                </c:pt>
                <c:pt idx="830">
                  <c:v>329842.796875</c:v>
                </c:pt>
                <c:pt idx="831">
                  <c:v>329842.921875</c:v>
                </c:pt>
                <c:pt idx="832">
                  <c:v>329843.03125</c:v>
                </c:pt>
                <c:pt idx="833">
                  <c:v>323086.8125</c:v>
                </c:pt>
                <c:pt idx="834">
                  <c:v>272592.953125</c:v>
                </c:pt>
                <c:pt idx="835">
                  <c:v>195492.5078125</c:v>
                </c:pt>
                <c:pt idx="836">
                  <c:v>133714.65625</c:v>
                </c:pt>
                <c:pt idx="837">
                  <c:v>102904.83203125</c:v>
                </c:pt>
                <c:pt idx="838">
                  <c:v>90976.1220703125</c:v>
                </c:pt>
                <c:pt idx="839">
                  <c:v>87556.041015625</c:v>
                </c:pt>
                <c:pt idx="840">
                  <c:v>86470.1884765625</c:v>
                </c:pt>
                <c:pt idx="841">
                  <c:v>85658.5361328125</c:v>
                </c:pt>
                <c:pt idx="842">
                  <c:v>84987.14111328125</c:v>
                </c:pt>
                <c:pt idx="843">
                  <c:v>84593.4033203125</c:v>
                </c:pt>
                <c:pt idx="844">
                  <c:v>84556.322265625</c:v>
                </c:pt>
                <c:pt idx="845">
                  <c:v>85148.92724609375</c:v>
                </c:pt>
                <c:pt idx="846">
                  <c:v>87122.1318359375</c:v>
                </c:pt>
                <c:pt idx="847">
                  <c:v>91588.537109375</c:v>
                </c:pt>
                <c:pt idx="848">
                  <c:v>99452.3125</c:v>
                </c:pt>
                <c:pt idx="849">
                  <c:v>110914.146484375</c:v>
                </c:pt>
                <c:pt idx="850">
                  <c:v>125456.6640625</c:v>
                </c:pt>
                <c:pt idx="851">
                  <c:v>142281.0703125</c:v>
                </c:pt>
                <c:pt idx="852">
                  <c:v>160681.4765625</c:v>
                </c:pt>
                <c:pt idx="853">
                  <c:v>178168.8515625</c:v>
                </c:pt>
                <c:pt idx="854">
                  <c:v>184564.8828125</c:v>
                </c:pt>
                <c:pt idx="855">
                  <c:v>170252.3203125</c:v>
                </c:pt>
                <c:pt idx="856">
                  <c:v>140016.41015625</c:v>
                </c:pt>
                <c:pt idx="857">
                  <c:v>110619.927734375</c:v>
                </c:pt>
                <c:pt idx="858">
                  <c:v>92643.8759765625</c:v>
                </c:pt>
                <c:pt idx="859">
                  <c:v>84909.28076171875</c:v>
                </c:pt>
                <c:pt idx="860">
                  <c:v>82469.228271484375</c:v>
                </c:pt>
                <c:pt idx="861">
                  <c:v>81749.490356445313</c:v>
                </c:pt>
                <c:pt idx="862">
                  <c:v>81380.43798828125</c:v>
                </c:pt>
                <c:pt idx="863">
                  <c:v>81127.757080078125</c:v>
                </c:pt>
                <c:pt idx="864">
                  <c:v>80982.533386230469</c:v>
                </c:pt>
                <c:pt idx="865">
                  <c:v>80906.823974609375</c:v>
                </c:pt>
                <c:pt idx="866">
                  <c:v>80860.0859375</c:v>
                </c:pt>
                <c:pt idx="867">
                  <c:v>80822.062194824219</c:v>
                </c:pt>
                <c:pt idx="868">
                  <c:v>80793.4384765625</c:v>
                </c:pt>
                <c:pt idx="869">
                  <c:v>80784.186218261719</c:v>
                </c:pt>
                <c:pt idx="870">
                  <c:v>80825.162475585938</c:v>
                </c:pt>
                <c:pt idx="871">
                  <c:v>80965.510192871094</c:v>
                </c:pt>
                <c:pt idx="872">
                  <c:v>81232.000732421875</c:v>
                </c:pt>
                <c:pt idx="873">
                  <c:v>81562.062744140625</c:v>
                </c:pt>
                <c:pt idx="874">
                  <c:v>81787.753295898438</c:v>
                </c:pt>
                <c:pt idx="875">
                  <c:v>81756.243774414063</c:v>
                </c:pt>
                <c:pt idx="876">
                  <c:v>81491.191528320313</c:v>
                </c:pt>
                <c:pt idx="877">
                  <c:v>81167.02490234375</c:v>
                </c:pt>
                <c:pt idx="878">
                  <c:v>80927.572631835938</c:v>
                </c:pt>
                <c:pt idx="879">
                  <c:v>80795.577514648438</c:v>
                </c:pt>
                <c:pt idx="880">
                  <c:v>80736.668029785156</c:v>
                </c:pt>
                <c:pt idx="881">
                  <c:v>80718.787170410156</c:v>
                </c:pt>
                <c:pt idx="882">
                  <c:v>80722.792053222656</c:v>
                </c:pt>
                <c:pt idx="883">
                  <c:v>80731.825439453125</c:v>
                </c:pt>
                <c:pt idx="884">
                  <c:v>80741.744567871094</c:v>
                </c:pt>
                <c:pt idx="885">
                  <c:v>80759.03515625</c:v>
                </c:pt>
                <c:pt idx="886">
                  <c:v>80789.668518066406</c:v>
                </c:pt>
                <c:pt idx="887">
                  <c:v>80826.644836425781</c:v>
                </c:pt>
                <c:pt idx="888">
                  <c:v>80857.106811523438</c:v>
                </c:pt>
                <c:pt idx="889">
                  <c:v>80873.79736328125</c:v>
                </c:pt>
                <c:pt idx="890">
                  <c:v>80868.573608398438</c:v>
                </c:pt>
                <c:pt idx="891">
                  <c:v>80825.892761230469</c:v>
                </c:pt>
                <c:pt idx="892">
                  <c:v>80742.011901855469</c:v>
                </c:pt>
                <c:pt idx="893">
                  <c:v>80640.245300292969</c:v>
                </c:pt>
                <c:pt idx="894">
                  <c:v>80553.878723144531</c:v>
                </c:pt>
                <c:pt idx="895">
                  <c:v>80505.454986572266</c:v>
                </c:pt>
                <c:pt idx="896">
                  <c:v>80492.802703857422</c:v>
                </c:pt>
                <c:pt idx="897">
                  <c:v>80493.121826171875</c:v>
                </c:pt>
                <c:pt idx="898">
                  <c:v>80489.583831787109</c:v>
                </c:pt>
                <c:pt idx="899">
                  <c:v>80484.44580078125</c:v>
                </c:pt>
                <c:pt idx="900">
                  <c:v>80485.079223632813</c:v>
                </c:pt>
                <c:pt idx="901">
                  <c:v>80485.541198730469</c:v>
                </c:pt>
                <c:pt idx="902">
                  <c:v>80480.717468261719</c:v>
                </c:pt>
                <c:pt idx="903">
                  <c:v>80470.065185546875</c:v>
                </c:pt>
                <c:pt idx="904">
                  <c:v>80462.070037841797</c:v>
                </c:pt>
                <c:pt idx="905">
                  <c:v>80458.303436279297</c:v>
                </c:pt>
                <c:pt idx="906">
                  <c:v>80455.165435791016</c:v>
                </c:pt>
                <c:pt idx="907">
                  <c:v>80446.941711425781</c:v>
                </c:pt>
                <c:pt idx="908">
                  <c:v>80442.003692626953</c:v>
                </c:pt>
                <c:pt idx="909">
                  <c:v>80443.408538818359</c:v>
                </c:pt>
                <c:pt idx="910">
                  <c:v>80447.384796142578</c:v>
                </c:pt>
                <c:pt idx="911">
                  <c:v>80453.246795654297</c:v>
                </c:pt>
                <c:pt idx="912">
                  <c:v>80469.937347412109</c:v>
                </c:pt>
                <c:pt idx="913">
                  <c:v>80490.542205810547</c:v>
                </c:pt>
                <c:pt idx="914">
                  <c:v>80499.518463134766</c:v>
                </c:pt>
                <c:pt idx="915">
                  <c:v>80494.151885986328</c:v>
                </c:pt>
                <c:pt idx="916">
                  <c:v>80493.071014404297</c:v>
                </c:pt>
                <c:pt idx="917">
                  <c:v>80518.847290039063</c:v>
                </c:pt>
                <c:pt idx="918">
                  <c:v>80585.909301757813</c:v>
                </c:pt>
                <c:pt idx="919">
                  <c:v>80696.5712890625</c:v>
                </c:pt>
                <c:pt idx="920">
                  <c:v>80874.033264160156</c:v>
                </c:pt>
                <c:pt idx="921">
                  <c:v>81263.352416992188</c:v>
                </c:pt>
                <c:pt idx="922">
                  <c:v>82236.1572265625</c:v>
                </c:pt>
                <c:pt idx="923">
                  <c:v>84314.390625</c:v>
                </c:pt>
                <c:pt idx="924">
                  <c:v>87921.53857421875</c:v>
                </c:pt>
                <c:pt idx="925">
                  <c:v>93144.54296875</c:v>
                </c:pt>
                <c:pt idx="926">
                  <c:v>99543.490234375</c:v>
                </c:pt>
                <c:pt idx="927">
                  <c:v>105675.32421875</c:v>
                </c:pt>
                <c:pt idx="928">
                  <c:v>108722.357421875</c:v>
                </c:pt>
                <c:pt idx="929">
                  <c:v>106224.962890625</c:v>
                </c:pt>
                <c:pt idx="930">
                  <c:v>98934.7109375</c:v>
                </c:pt>
                <c:pt idx="931">
                  <c:v>90641.486328125</c:v>
                </c:pt>
                <c:pt idx="932">
                  <c:v>84714.94873046875</c:v>
                </c:pt>
                <c:pt idx="933">
                  <c:v>81842.639038085938</c:v>
                </c:pt>
                <c:pt idx="934">
                  <c:v>81002.958190917969</c:v>
                </c:pt>
                <c:pt idx="935">
                  <c:v>81062.763061523438</c:v>
                </c:pt>
                <c:pt idx="936">
                  <c:v>81424.396484375</c:v>
                </c:pt>
                <c:pt idx="937">
                  <c:v>81883.144165039063</c:v>
                </c:pt>
                <c:pt idx="938">
                  <c:v>82350.063232421875</c:v>
                </c:pt>
                <c:pt idx="939">
                  <c:v>82726.81103515625</c:v>
                </c:pt>
                <c:pt idx="940">
                  <c:v>82928.472900390625</c:v>
                </c:pt>
                <c:pt idx="941">
                  <c:v>82898.220703125</c:v>
                </c:pt>
                <c:pt idx="942">
                  <c:v>82610.368408203125</c:v>
                </c:pt>
                <c:pt idx="943">
                  <c:v>82097.97314453125</c:v>
                </c:pt>
                <c:pt idx="944">
                  <c:v>81492.578125</c:v>
                </c:pt>
                <c:pt idx="945">
                  <c:v>80965.782897949219</c:v>
                </c:pt>
                <c:pt idx="946">
                  <c:v>80618.98779296875</c:v>
                </c:pt>
                <c:pt idx="947">
                  <c:v>80443.792602539063</c:v>
                </c:pt>
                <c:pt idx="948">
                  <c:v>80374.197448730469</c:v>
                </c:pt>
                <c:pt idx="949">
                  <c:v>80350.916595458984</c:v>
                </c:pt>
                <c:pt idx="950">
                  <c:v>80345.407135009766</c:v>
                </c:pt>
                <c:pt idx="951">
                  <c:v>80354.240570068359</c:v>
                </c:pt>
                <c:pt idx="952">
                  <c:v>80379.245391845703</c:v>
                </c:pt>
                <c:pt idx="953">
                  <c:v>80417.021667480469</c:v>
                </c:pt>
                <c:pt idx="954">
                  <c:v>80460.283660888672</c:v>
                </c:pt>
                <c:pt idx="955">
                  <c:v>80514.117065429688</c:v>
                </c:pt>
                <c:pt idx="956">
                  <c:v>80579.321899414063</c:v>
                </c:pt>
                <c:pt idx="957">
                  <c:v>80637.441040039063</c:v>
                </c:pt>
                <c:pt idx="958">
                  <c:v>80660.845886230469</c:v>
                </c:pt>
                <c:pt idx="959">
                  <c:v>80641.993591308594</c:v>
                </c:pt>
                <c:pt idx="960">
                  <c:v>80591.198425292969</c:v>
                </c:pt>
                <c:pt idx="961">
                  <c:v>80522.489013671875</c:v>
                </c:pt>
                <c:pt idx="962">
                  <c:v>80449.69384765625</c:v>
                </c:pt>
                <c:pt idx="963">
                  <c:v>80387.184417724609</c:v>
                </c:pt>
                <c:pt idx="964">
                  <c:v>80340.817810058594</c:v>
                </c:pt>
                <c:pt idx="965">
                  <c:v>80311.394104003906</c:v>
                </c:pt>
                <c:pt idx="966">
                  <c:v>80297.513214111328</c:v>
                </c:pt>
                <c:pt idx="967">
                  <c:v>80297.689483642578</c:v>
                </c:pt>
                <c:pt idx="968">
                  <c:v>80306.751495361328</c:v>
                </c:pt>
                <c:pt idx="969">
                  <c:v>80317.584899902344</c:v>
                </c:pt>
                <c:pt idx="970">
                  <c:v>80325.818298339844</c:v>
                </c:pt>
                <c:pt idx="971">
                  <c:v>80328.280303955078</c:v>
                </c:pt>
                <c:pt idx="972">
                  <c:v>80318.056579589844</c:v>
                </c:pt>
                <c:pt idx="973">
                  <c:v>80292.747131347656</c:v>
                </c:pt>
                <c:pt idx="974">
                  <c:v>80266.123413085938</c:v>
                </c:pt>
                <c:pt idx="975">
                  <c:v>80249.099670410156</c:v>
                </c:pt>
                <c:pt idx="976">
                  <c:v>80240.704513549805</c:v>
                </c:pt>
                <c:pt idx="977">
                  <c:v>80236.223648071289</c:v>
                </c:pt>
                <c:pt idx="978">
                  <c:v>80239.257064819336</c:v>
                </c:pt>
                <c:pt idx="979">
                  <c:v>80249.519058227539</c:v>
                </c:pt>
                <c:pt idx="980">
                  <c:v>80272.152465820313</c:v>
                </c:pt>
                <c:pt idx="981">
                  <c:v>80317.957305908203</c:v>
                </c:pt>
                <c:pt idx="982">
                  <c:v>80419.762145996094</c:v>
                </c:pt>
                <c:pt idx="983">
                  <c:v>80619.909851074219</c:v>
                </c:pt>
                <c:pt idx="984">
                  <c:v>80921.057556152344</c:v>
                </c:pt>
                <c:pt idx="985">
                  <c:v>81249.46240234375</c:v>
                </c:pt>
                <c:pt idx="986">
                  <c:v>81485.895874023438</c:v>
                </c:pt>
                <c:pt idx="987">
                  <c:v>81546.957763671875</c:v>
                </c:pt>
                <c:pt idx="988">
                  <c:v>81422.276977539063</c:v>
                </c:pt>
                <c:pt idx="989">
                  <c:v>81172.824584960938</c:v>
                </c:pt>
                <c:pt idx="990">
                  <c:v>80893.772338867188</c:v>
                </c:pt>
                <c:pt idx="991">
                  <c:v>80667.891479492188</c:v>
                </c:pt>
                <c:pt idx="992">
                  <c:v>80531.839172363281</c:v>
                </c:pt>
                <c:pt idx="993">
                  <c:v>80468.729736328125</c:v>
                </c:pt>
                <c:pt idx="994">
                  <c:v>80449.220275878906</c:v>
                </c:pt>
                <c:pt idx="995">
                  <c:v>80454.196563720703</c:v>
                </c:pt>
                <c:pt idx="996">
                  <c:v>80483.801391601563</c:v>
                </c:pt>
                <c:pt idx="997">
                  <c:v>80538.006225585938</c:v>
                </c:pt>
                <c:pt idx="998">
                  <c:v>80649.182495117188</c:v>
                </c:pt>
                <c:pt idx="999">
                  <c:v>80891.615905761719</c:v>
                </c:pt>
                <c:pt idx="1000">
                  <c:v>81343.735107421875</c:v>
                </c:pt>
                <c:pt idx="1001">
                  <c:v>81995.254150390625</c:v>
                </c:pt>
                <c:pt idx="1002">
                  <c:v>82685.744873046875</c:v>
                </c:pt>
                <c:pt idx="1003">
                  <c:v>83138.720947265625</c:v>
                </c:pt>
                <c:pt idx="1004">
                  <c:v>83136.3544921875</c:v>
                </c:pt>
                <c:pt idx="1005">
                  <c:v>82683.130615234375</c:v>
                </c:pt>
                <c:pt idx="1006">
                  <c:v>81990.735595703125</c:v>
                </c:pt>
                <c:pt idx="1007">
                  <c:v>81322.740356445313</c:v>
                </c:pt>
                <c:pt idx="1008">
                  <c:v>80848.516662597656</c:v>
                </c:pt>
                <c:pt idx="1009">
                  <c:v>80607.321533203125</c:v>
                </c:pt>
                <c:pt idx="1010">
                  <c:v>80536.5263671875</c:v>
                </c:pt>
                <c:pt idx="1011">
                  <c:v>80557.245483398438</c:v>
                </c:pt>
                <c:pt idx="1012">
                  <c:v>80595.193176269531</c:v>
                </c:pt>
                <c:pt idx="1013">
                  <c:v>80601.483764648438</c:v>
                </c:pt>
                <c:pt idx="1014">
                  <c:v>80555.031433105469</c:v>
                </c:pt>
                <c:pt idx="1015">
                  <c:v>80482.236297607422</c:v>
                </c:pt>
                <c:pt idx="1016">
                  <c:v>80415.612579345703</c:v>
                </c:pt>
                <c:pt idx="1017">
                  <c:v>80374.417419433594</c:v>
                </c:pt>
                <c:pt idx="1018">
                  <c:v>80373.165130615234</c:v>
                </c:pt>
                <c:pt idx="1019">
                  <c:v>80406.084259033203</c:v>
                </c:pt>
                <c:pt idx="1020">
                  <c:v>80444.460510253906</c:v>
                </c:pt>
                <c:pt idx="1021">
                  <c:v>80460.979644775391</c:v>
                </c:pt>
                <c:pt idx="1022">
                  <c:v>80449.784484863281</c:v>
                </c:pt>
                <c:pt idx="1023">
                  <c:v>80414.760772705078</c:v>
                </c:pt>
                <c:pt idx="1024">
                  <c:v>80373.651336669922</c:v>
                </c:pt>
                <c:pt idx="1025">
                  <c:v>80346.084747314453</c:v>
                </c:pt>
                <c:pt idx="1026">
                  <c:v>80343.775299072266</c:v>
                </c:pt>
                <c:pt idx="1027">
                  <c:v>80360.808715820313</c:v>
                </c:pt>
                <c:pt idx="1028">
                  <c:v>80382.384979248047</c:v>
                </c:pt>
                <c:pt idx="1029">
                  <c:v>80469.704132080078</c:v>
                </c:pt>
                <c:pt idx="1030">
                  <c:v>80949.480407714844</c:v>
                </c:pt>
                <c:pt idx="1031">
                  <c:v>82617.799560546875</c:v>
                </c:pt>
                <c:pt idx="1032">
                  <c:v>86724.5185546875</c:v>
                </c:pt>
                <c:pt idx="1033">
                  <c:v>94494.837890625</c:v>
                </c:pt>
                <c:pt idx="1034">
                  <c:v>106019.5</c:v>
                </c:pt>
                <c:pt idx="1035">
                  <c:v>119046.50390625</c:v>
                </c:pt>
                <c:pt idx="1036">
                  <c:v>128927.30859375</c:v>
                </c:pt>
                <c:pt idx="1037">
                  <c:v>130856.11328125</c:v>
                </c:pt>
                <c:pt idx="1038">
                  <c:v>123763.12109375</c:v>
                </c:pt>
                <c:pt idx="1039">
                  <c:v>111293.923828125</c:v>
                </c:pt>
                <c:pt idx="1040">
                  <c:v>98801.12890625</c:v>
                </c:pt>
                <c:pt idx="1041">
                  <c:v>89598.93359375</c:v>
                </c:pt>
                <c:pt idx="1042">
                  <c:v>84277.9384765625</c:v>
                </c:pt>
                <c:pt idx="1043">
                  <c:v>81823.8291015625</c:v>
                </c:pt>
                <c:pt idx="1044">
                  <c:v>80916.576782226563</c:v>
                </c:pt>
                <c:pt idx="1045">
                  <c:v>80653.324462890625</c:v>
                </c:pt>
                <c:pt idx="1046">
                  <c:v>80629.957885742188</c:v>
                </c:pt>
                <c:pt idx="1047">
                  <c:v>80728.162719726563</c:v>
                </c:pt>
                <c:pt idx="1048">
                  <c:v>80900.281860351563</c:v>
                </c:pt>
                <c:pt idx="1049">
                  <c:v>81086.458129882813</c:v>
                </c:pt>
                <c:pt idx="1050">
                  <c:v>81220.777221679688</c:v>
                </c:pt>
                <c:pt idx="1051">
                  <c:v>81255.267822265625</c:v>
                </c:pt>
                <c:pt idx="1052">
                  <c:v>81180.558349609375</c:v>
                </c:pt>
                <c:pt idx="1053">
                  <c:v>81037.963256835938</c:v>
                </c:pt>
                <c:pt idx="1054">
                  <c:v>80899.253784179688</c:v>
                </c:pt>
                <c:pt idx="1055">
                  <c:v>80816.858642578125</c:v>
                </c:pt>
                <c:pt idx="1056">
                  <c:v>80808.977783203125</c:v>
                </c:pt>
                <c:pt idx="1057">
                  <c:v>80845.011169433594</c:v>
                </c:pt>
                <c:pt idx="1058">
                  <c:v>80875.3017578125</c:v>
                </c:pt>
                <c:pt idx="1059">
                  <c:v>80862.020874023438</c:v>
                </c:pt>
                <c:pt idx="1060">
                  <c:v>80820.282836914063</c:v>
                </c:pt>
                <c:pt idx="1061">
                  <c:v>80793.94482421875</c:v>
                </c:pt>
                <c:pt idx="1062">
                  <c:v>80809.206848144531</c:v>
                </c:pt>
                <c:pt idx="1063">
                  <c:v>80845.811645507813</c:v>
                </c:pt>
                <c:pt idx="1064">
                  <c:v>80859.759399414063</c:v>
                </c:pt>
                <c:pt idx="1065">
                  <c:v>80815.021362304688</c:v>
                </c:pt>
                <c:pt idx="1066">
                  <c:v>80706.397644042969</c:v>
                </c:pt>
                <c:pt idx="1067">
                  <c:v>80564.973937988281</c:v>
                </c:pt>
                <c:pt idx="1068">
                  <c:v>80435.550170898438</c:v>
                </c:pt>
                <c:pt idx="1069">
                  <c:v>80348.412170410156</c:v>
                </c:pt>
                <c:pt idx="1070">
                  <c:v>80306.531311035156</c:v>
                </c:pt>
                <c:pt idx="1071">
                  <c:v>80295.936157226563</c:v>
                </c:pt>
                <c:pt idx="1072">
                  <c:v>80299.112426757813</c:v>
                </c:pt>
                <c:pt idx="1073">
                  <c:v>80302.888702392578</c:v>
                </c:pt>
                <c:pt idx="1074">
                  <c:v>80297.436401367188</c:v>
                </c:pt>
                <c:pt idx="1075">
                  <c:v>80281.984100341797</c:v>
                </c:pt>
                <c:pt idx="1076">
                  <c:v>80260.503234863281</c:v>
                </c:pt>
                <c:pt idx="1077">
                  <c:v>80242.193786621094</c:v>
                </c:pt>
                <c:pt idx="1078">
                  <c:v>80231.855758666992</c:v>
                </c:pt>
                <c:pt idx="1079">
                  <c:v>80220.374893188477</c:v>
                </c:pt>
                <c:pt idx="1080">
                  <c:v>80200.522598266602</c:v>
                </c:pt>
                <c:pt idx="1081">
                  <c:v>80179.12744140625</c:v>
                </c:pt>
                <c:pt idx="1082">
                  <c:v>80170.61799621582</c:v>
                </c:pt>
                <c:pt idx="1083">
                  <c:v>80172.594268798828</c:v>
                </c:pt>
                <c:pt idx="1084">
                  <c:v>80169.28483581543</c:v>
                </c:pt>
                <c:pt idx="1085">
                  <c:v>80156.975387573242</c:v>
                </c:pt>
                <c:pt idx="1086">
                  <c:v>80151.694519042969</c:v>
                </c:pt>
                <c:pt idx="1087">
                  <c:v>80163.042221069336</c:v>
                </c:pt>
                <c:pt idx="1088">
                  <c:v>80181.961349487305</c:v>
                </c:pt>
                <c:pt idx="1089">
                  <c:v>80197.566192626953</c:v>
                </c:pt>
                <c:pt idx="1090">
                  <c:v>80203.142471313477</c:v>
                </c:pt>
                <c:pt idx="1091">
                  <c:v>80196.061599731445</c:v>
                </c:pt>
                <c:pt idx="1092">
                  <c:v>80184.123580932617</c:v>
                </c:pt>
                <c:pt idx="1093">
                  <c:v>80176.299850463867</c:v>
                </c:pt>
                <c:pt idx="1094">
                  <c:v>80170.790420532227</c:v>
                </c:pt>
                <c:pt idx="1095">
                  <c:v>80168.338119506836</c:v>
                </c:pt>
                <c:pt idx="1096">
                  <c:v>80169.28581237793</c:v>
                </c:pt>
                <c:pt idx="1097">
                  <c:v>80174.119232177734</c:v>
                </c:pt>
                <c:pt idx="1098">
                  <c:v>80178.381225585938</c:v>
                </c:pt>
                <c:pt idx="1099">
                  <c:v>80183.186065673828</c:v>
                </c:pt>
                <c:pt idx="1100">
                  <c:v>80186.362335205078</c:v>
                </c:pt>
                <c:pt idx="1101">
                  <c:v>80188.595748901367</c:v>
                </c:pt>
                <c:pt idx="1102">
                  <c:v>80189.343460083008</c:v>
                </c:pt>
                <c:pt idx="1103">
                  <c:v>80192.262588500977</c:v>
                </c:pt>
                <c:pt idx="1104">
                  <c:v>80199.781707763672</c:v>
                </c:pt>
                <c:pt idx="1105">
                  <c:v>80211.643707275391</c:v>
                </c:pt>
                <c:pt idx="1106">
                  <c:v>80219.905685424805</c:v>
                </c:pt>
                <c:pt idx="1107">
                  <c:v>80218.281967163086</c:v>
                </c:pt>
                <c:pt idx="1108">
                  <c:v>80207.258239746094</c:v>
                </c:pt>
                <c:pt idx="1109">
                  <c:v>80193.063079833984</c:v>
                </c:pt>
                <c:pt idx="1110">
                  <c:v>80174.582214355469</c:v>
                </c:pt>
                <c:pt idx="1111">
                  <c:v>80155.587051391602</c:v>
                </c:pt>
                <c:pt idx="1112">
                  <c:v>80142.163330078125</c:v>
                </c:pt>
                <c:pt idx="1113">
                  <c:v>80133.453887939453</c:v>
                </c:pt>
                <c:pt idx="1114">
                  <c:v>80119.515869140625</c:v>
                </c:pt>
                <c:pt idx="1115">
                  <c:v>80107.463569641113</c:v>
                </c:pt>
                <c:pt idx="1116">
                  <c:v>80115.096984863281</c:v>
                </c:pt>
                <c:pt idx="1117">
                  <c:v>80143.216110229492</c:v>
                </c:pt>
                <c:pt idx="1118">
                  <c:v>80172.020965576172</c:v>
                </c:pt>
                <c:pt idx="1119">
                  <c:v>80193.111526489258</c:v>
                </c:pt>
                <c:pt idx="1120">
                  <c:v>80214.373504638672</c:v>
                </c:pt>
                <c:pt idx="1121">
                  <c:v>80240.206924438477</c:v>
                </c:pt>
                <c:pt idx="1122">
                  <c:v>80258.983184814453</c:v>
                </c:pt>
                <c:pt idx="1123">
                  <c:v>80259.416595458984</c:v>
                </c:pt>
                <c:pt idx="1124">
                  <c:v>80240.564315795898</c:v>
                </c:pt>
                <c:pt idx="1125">
                  <c:v>80213.31201171875</c:v>
                </c:pt>
                <c:pt idx="1126">
                  <c:v>80189.402572631836</c:v>
                </c:pt>
                <c:pt idx="1127">
                  <c:v>80169.893127441406</c:v>
                </c:pt>
                <c:pt idx="1128">
                  <c:v>80153.726547241211</c:v>
                </c:pt>
                <c:pt idx="1129">
                  <c:v>80146.102813720703</c:v>
                </c:pt>
                <c:pt idx="1130">
                  <c:v>80153.736236572266</c:v>
                </c:pt>
                <c:pt idx="1131">
                  <c:v>80171.398223876953</c:v>
                </c:pt>
                <c:pt idx="1132">
                  <c:v>80182.774490356445</c:v>
                </c:pt>
                <c:pt idx="1133">
                  <c:v>80182.436477661133</c:v>
                </c:pt>
                <c:pt idx="1134">
                  <c:v>80178.7841796875</c:v>
                </c:pt>
                <c:pt idx="1135">
                  <c:v>80178.846176147461</c:v>
                </c:pt>
                <c:pt idx="1136">
                  <c:v>80179.108154296875</c:v>
                </c:pt>
                <c:pt idx="1137">
                  <c:v>80195.170135498047</c:v>
                </c:pt>
                <c:pt idx="1138">
                  <c:v>80241.917846679688</c:v>
                </c:pt>
                <c:pt idx="1139">
                  <c:v>80311.322692871094</c:v>
                </c:pt>
                <c:pt idx="1140">
                  <c:v>80374.070404052734</c:v>
                </c:pt>
                <c:pt idx="1141">
                  <c:v>80424.160949707031</c:v>
                </c:pt>
                <c:pt idx="1142">
                  <c:v>80466.537231445313</c:v>
                </c:pt>
                <c:pt idx="1143">
                  <c:v>80503.227783203125</c:v>
                </c:pt>
                <c:pt idx="1144">
                  <c:v>80533.546936035156</c:v>
                </c:pt>
                <c:pt idx="1145">
                  <c:v>80550.437438964844</c:v>
                </c:pt>
                <c:pt idx="1146">
                  <c:v>80534.585144042969</c:v>
                </c:pt>
                <c:pt idx="1147">
                  <c:v>80480.447143554688</c:v>
                </c:pt>
                <c:pt idx="1148">
                  <c:v>80408.966278076172</c:v>
                </c:pt>
                <c:pt idx="1149">
                  <c:v>80335.113983154297</c:v>
                </c:pt>
                <c:pt idx="1150">
                  <c:v>80274.290252685547</c:v>
                </c:pt>
                <c:pt idx="1151">
                  <c:v>80244.266525268555</c:v>
                </c:pt>
                <c:pt idx="1152">
                  <c:v>80243.014236450195</c:v>
                </c:pt>
                <c:pt idx="1153">
                  <c:v>80241.390502929688</c:v>
                </c:pt>
                <c:pt idx="1154">
                  <c:v>80226.681060791016</c:v>
                </c:pt>
                <c:pt idx="1155">
                  <c:v>80199.000198364258</c:v>
                </c:pt>
                <c:pt idx="1156">
                  <c:v>80175.005035400391</c:v>
                </c:pt>
                <c:pt idx="1157">
                  <c:v>80167.952743530273</c:v>
                </c:pt>
                <c:pt idx="1158">
                  <c:v>80174.043304443359</c:v>
                </c:pt>
                <c:pt idx="1159">
                  <c:v>80170.419570922852</c:v>
                </c:pt>
                <c:pt idx="1160">
                  <c:v>80164.738708496094</c:v>
                </c:pt>
                <c:pt idx="1161">
                  <c:v>80173.229263305664</c:v>
                </c:pt>
                <c:pt idx="1162">
                  <c:v>80190.862670898438</c:v>
                </c:pt>
                <c:pt idx="1163">
                  <c:v>80201.381805419922</c:v>
                </c:pt>
                <c:pt idx="1164">
                  <c:v>80205.186645507813</c:v>
                </c:pt>
                <c:pt idx="1165">
                  <c:v>80228.620071411133</c:v>
                </c:pt>
                <c:pt idx="1166">
                  <c:v>80283.682037353516</c:v>
                </c:pt>
                <c:pt idx="1167">
                  <c:v>80366.686889648438</c:v>
                </c:pt>
                <c:pt idx="1168">
                  <c:v>80462.606018066406</c:v>
                </c:pt>
                <c:pt idx="1169">
                  <c:v>80569.182312011719</c:v>
                </c:pt>
                <c:pt idx="1170">
                  <c:v>80658.444274902344</c:v>
                </c:pt>
                <c:pt idx="1171">
                  <c:v>80690.820556640625</c:v>
                </c:pt>
                <c:pt idx="1172">
                  <c:v>80653.739685058594</c:v>
                </c:pt>
                <c:pt idx="1173">
                  <c:v>80567.544555664063</c:v>
                </c:pt>
                <c:pt idx="1174">
                  <c:v>80461.892242431641</c:v>
                </c:pt>
                <c:pt idx="1175">
                  <c:v>80361.697082519531</c:v>
                </c:pt>
                <c:pt idx="1176">
                  <c:v>80282.473358154297</c:v>
                </c:pt>
                <c:pt idx="1177">
                  <c:v>80232.535339355469</c:v>
                </c:pt>
                <c:pt idx="1178">
                  <c:v>80214.454467773438</c:v>
                </c:pt>
                <c:pt idx="1179">
                  <c:v>80219.087890625</c:v>
                </c:pt>
                <c:pt idx="1180">
                  <c:v>80222.178436279297</c:v>
                </c:pt>
                <c:pt idx="1181">
                  <c:v>80213.954711914063</c:v>
                </c:pt>
                <c:pt idx="1182">
                  <c:v>80204.016708374023</c:v>
                </c:pt>
                <c:pt idx="1183">
                  <c:v>80202.421539306641</c:v>
                </c:pt>
                <c:pt idx="1184">
                  <c:v>80211.254959106445</c:v>
                </c:pt>
                <c:pt idx="1185">
                  <c:v>80224.231231689453</c:v>
                </c:pt>
                <c:pt idx="1186">
                  <c:v>80233.607513427734</c:v>
                </c:pt>
                <c:pt idx="1187">
                  <c:v>80233.669494628906</c:v>
                </c:pt>
                <c:pt idx="1188">
                  <c:v>80224.760055541992</c:v>
                </c:pt>
                <c:pt idx="1189">
                  <c:v>80209.736328125</c:v>
                </c:pt>
                <c:pt idx="1190">
                  <c:v>80192.426879882813</c:v>
                </c:pt>
                <c:pt idx="1191">
                  <c:v>80181.260299682617</c:v>
                </c:pt>
                <c:pt idx="1192">
                  <c:v>80178.236572265625</c:v>
                </c:pt>
                <c:pt idx="1193">
                  <c:v>80182.327133178711</c:v>
                </c:pt>
                <c:pt idx="1194">
                  <c:v>80183.617691040039</c:v>
                </c:pt>
                <c:pt idx="1195">
                  <c:v>80174.079681396484</c:v>
                </c:pt>
                <c:pt idx="1196">
                  <c:v>80154.684524536133</c:v>
                </c:pt>
                <c:pt idx="1197">
                  <c:v>80135.775085449219</c:v>
                </c:pt>
                <c:pt idx="1198">
                  <c:v>80122.637062072754</c:v>
                </c:pt>
                <c:pt idx="1199">
                  <c:v>80111.556198120117</c:v>
                </c:pt>
                <c:pt idx="1200">
                  <c:v>80104.646751403809</c:v>
                </c:pt>
                <c:pt idx="1201">
                  <c:v>80109.365882873535</c:v>
                </c:pt>
                <c:pt idx="1202">
                  <c:v>80129.227874755859</c:v>
                </c:pt>
                <c:pt idx="1203">
                  <c:v>80147.71842956543</c:v>
                </c:pt>
                <c:pt idx="1204">
                  <c:v>80152.89469909668</c:v>
                </c:pt>
                <c:pt idx="1205">
                  <c:v>80141.413833618164</c:v>
                </c:pt>
                <c:pt idx="1206">
                  <c:v>80125.875816345215</c:v>
                </c:pt>
                <c:pt idx="1207">
                  <c:v>80116.65209197998</c:v>
                </c:pt>
                <c:pt idx="1208">
                  <c:v>80124.971221923828</c:v>
                </c:pt>
                <c:pt idx="1209">
                  <c:v>80139.661773681641</c:v>
                </c:pt>
                <c:pt idx="1210">
                  <c:v>80136.209487915039</c:v>
                </c:pt>
                <c:pt idx="1211">
                  <c:v>80105.185752868652</c:v>
                </c:pt>
                <c:pt idx="1212">
                  <c:v>80070.16202545166</c:v>
                </c:pt>
                <c:pt idx="1213">
                  <c:v>80052.995441436768</c:v>
                </c:pt>
                <c:pt idx="1214">
                  <c:v>80050.257427215576</c:v>
                </c:pt>
                <c:pt idx="1215">
                  <c:v>80051.262271881104</c:v>
                </c:pt>
                <c:pt idx="1216">
                  <c:v>80057.49568939209</c:v>
                </c:pt>
                <c:pt idx="1217">
                  <c:v>80062.329105377197</c:v>
                </c:pt>
                <c:pt idx="1218">
                  <c:v>80054.905376434326</c:v>
                </c:pt>
                <c:pt idx="1219">
                  <c:v>80040.053077697754</c:v>
                </c:pt>
                <c:pt idx="1220">
                  <c:v>80027.800779342651</c:v>
                </c:pt>
                <c:pt idx="1221">
                  <c:v>80019.291337966919</c:v>
                </c:pt>
                <c:pt idx="1222">
                  <c:v>80012.953324317932</c:v>
                </c:pt>
                <c:pt idx="1223">
                  <c:v>80009.072454452515</c:v>
                </c:pt>
                <c:pt idx="1224">
                  <c:v>80004.305870056152</c:v>
                </c:pt>
                <c:pt idx="1225">
                  <c:v>80002.596428632736</c:v>
                </c:pt>
                <c:pt idx="1226">
                  <c:v>80004.315558433533</c:v>
                </c:pt>
                <c:pt idx="1227">
                  <c:v>80006.120402812958</c:v>
                </c:pt>
                <c:pt idx="1228">
                  <c:v>80002.925246715546</c:v>
                </c:pt>
                <c:pt idx="1229">
                  <c:v>80004.472948074341</c:v>
                </c:pt>
                <c:pt idx="1230">
                  <c:v>80010.734934806824</c:v>
                </c:pt>
                <c:pt idx="1231">
                  <c:v>80024.539779663086</c:v>
                </c:pt>
                <c:pt idx="1232">
                  <c:v>80038.458908081055</c:v>
                </c:pt>
                <c:pt idx="1233">
                  <c:v>80054.120895385742</c:v>
                </c:pt>
                <c:pt idx="1234">
                  <c:v>80065.897171020508</c:v>
                </c:pt>
                <c:pt idx="1235">
                  <c:v>80068.159156799316</c:v>
                </c:pt>
                <c:pt idx="1236">
                  <c:v>80057.421142578125</c:v>
                </c:pt>
                <c:pt idx="1237">
                  <c:v>80049.454559326172</c:v>
                </c:pt>
                <c:pt idx="1238">
                  <c:v>80050.345115661621</c:v>
                </c:pt>
                <c:pt idx="1239">
                  <c:v>80052.578533172607</c:v>
                </c:pt>
                <c:pt idx="1240">
                  <c:v>80053.354804992676</c:v>
                </c:pt>
                <c:pt idx="1241">
                  <c:v>80059.845363616943</c:v>
                </c:pt>
                <c:pt idx="1242">
                  <c:v>80068.993064880371</c:v>
                </c:pt>
                <c:pt idx="1243">
                  <c:v>80079.312194824219</c:v>
                </c:pt>
                <c:pt idx="1244">
                  <c:v>80091.517036437988</c:v>
                </c:pt>
                <c:pt idx="1245">
                  <c:v>80102.636169433594</c:v>
                </c:pt>
                <c:pt idx="1246">
                  <c:v>80103.926727294922</c:v>
                </c:pt>
                <c:pt idx="1247">
                  <c:v>80095.788711547852</c:v>
                </c:pt>
                <c:pt idx="1248">
                  <c:v>80088.250701904297</c:v>
                </c:pt>
                <c:pt idx="1249">
                  <c:v>80084.598403930664</c:v>
                </c:pt>
                <c:pt idx="1250">
                  <c:v>80078.631820678711</c:v>
                </c:pt>
                <c:pt idx="1251">
                  <c:v>80063.608089447021</c:v>
                </c:pt>
                <c:pt idx="1252">
                  <c:v>80049.527221679688</c:v>
                </c:pt>
                <c:pt idx="1253">
                  <c:v>80046.446350097656</c:v>
                </c:pt>
                <c:pt idx="1254">
                  <c:v>80055.736907958984</c:v>
                </c:pt>
                <c:pt idx="1255">
                  <c:v>80067.970321655273</c:v>
                </c:pt>
                <c:pt idx="1256">
                  <c:v>80078.746597290039</c:v>
                </c:pt>
                <c:pt idx="1257">
                  <c:v>80084.037155151367</c:v>
                </c:pt>
                <c:pt idx="1258">
                  <c:v>80087.842002868652</c:v>
                </c:pt>
                <c:pt idx="1259">
                  <c:v>80087.018272399902</c:v>
                </c:pt>
                <c:pt idx="1260">
                  <c:v>80082.623115539551</c:v>
                </c:pt>
                <c:pt idx="1261">
                  <c:v>80074.742248535156</c:v>
                </c:pt>
                <c:pt idx="1262">
                  <c:v>80065.718521118164</c:v>
                </c:pt>
                <c:pt idx="1263">
                  <c:v>80057.237648010254</c:v>
                </c:pt>
                <c:pt idx="1264">
                  <c:v>80055.01392364502</c:v>
                </c:pt>
                <c:pt idx="1265">
                  <c:v>80066.761619567871</c:v>
                </c:pt>
                <c:pt idx="1266">
                  <c:v>80080.823608398438</c:v>
                </c:pt>
                <c:pt idx="1267">
                  <c:v>80082.828453063965</c:v>
                </c:pt>
                <c:pt idx="1268">
                  <c:v>80072.690444946289</c:v>
                </c:pt>
                <c:pt idx="1269">
                  <c:v>80062.581001281738</c:v>
                </c:pt>
                <c:pt idx="1270">
                  <c:v>80059.157272338867</c:v>
                </c:pt>
                <c:pt idx="1271">
                  <c:v>80059.819259643555</c:v>
                </c:pt>
                <c:pt idx="1272">
                  <c:v>80062.109817504883</c:v>
                </c:pt>
                <c:pt idx="1273">
                  <c:v>80063.571804046631</c:v>
                </c:pt>
                <c:pt idx="1274">
                  <c:v>80067.890937805176</c:v>
                </c:pt>
                <c:pt idx="1275">
                  <c:v>80074.552925109863</c:v>
                </c:pt>
                <c:pt idx="1276">
                  <c:v>80074.614906311035</c:v>
                </c:pt>
                <c:pt idx="1277">
                  <c:v>80066.41975402832</c:v>
                </c:pt>
                <c:pt idx="1278">
                  <c:v>80059.538883209229</c:v>
                </c:pt>
                <c:pt idx="1279">
                  <c:v>80056.972297668457</c:v>
                </c:pt>
                <c:pt idx="1280">
                  <c:v>80056.862857818604</c:v>
                </c:pt>
                <c:pt idx="1281">
                  <c:v>80061.210559844971</c:v>
                </c:pt>
                <c:pt idx="1282">
                  <c:v>80070.015403747559</c:v>
                </c:pt>
                <c:pt idx="1283">
                  <c:v>80078.963104248047</c:v>
                </c:pt>
                <c:pt idx="1284">
                  <c:v>80086.367950439453</c:v>
                </c:pt>
                <c:pt idx="1285">
                  <c:v>80092.74422454834</c:v>
                </c:pt>
                <c:pt idx="1286">
                  <c:v>80096.806205749512</c:v>
                </c:pt>
                <c:pt idx="1287">
                  <c:v>80099.668197631836</c:v>
                </c:pt>
                <c:pt idx="1288">
                  <c:v>80094.444465637207</c:v>
                </c:pt>
                <c:pt idx="1289">
                  <c:v>80083.735023498535</c:v>
                </c:pt>
                <c:pt idx="1290">
                  <c:v>80070.282730102539</c:v>
                </c:pt>
                <c:pt idx="1291">
                  <c:v>80059.801856994629</c:v>
                </c:pt>
                <c:pt idx="1292">
                  <c:v>80058.178131103516</c:v>
                </c:pt>
                <c:pt idx="1293">
                  <c:v>80067.811546325684</c:v>
                </c:pt>
                <c:pt idx="1294">
                  <c:v>80077.302101135254</c:v>
                </c:pt>
                <c:pt idx="1295">
                  <c:v>80078.564094543457</c:v>
                </c:pt>
                <c:pt idx="1296">
                  <c:v>80071.140365600586</c:v>
                </c:pt>
                <c:pt idx="1297">
                  <c:v>80062.916637420654</c:v>
                </c:pt>
                <c:pt idx="1298">
                  <c:v>80065.864334106445</c:v>
                </c:pt>
                <c:pt idx="1299">
                  <c:v>80079.754898071289</c:v>
                </c:pt>
                <c:pt idx="1300">
                  <c:v>80090.045455932617</c:v>
                </c:pt>
                <c:pt idx="1301">
                  <c:v>80090.993156433105</c:v>
                </c:pt>
                <c:pt idx="1302">
                  <c:v>80088.769432067871</c:v>
                </c:pt>
                <c:pt idx="1303">
                  <c:v>80087.00284576416</c:v>
                </c:pt>
                <c:pt idx="1304">
                  <c:v>80085.464828491211</c:v>
                </c:pt>
                <c:pt idx="1305">
                  <c:v>80089.955390930176</c:v>
                </c:pt>
                <c:pt idx="1306">
                  <c:v>80103.360237121582</c:v>
                </c:pt>
                <c:pt idx="1307">
                  <c:v>80113.479362487793</c:v>
                </c:pt>
                <c:pt idx="1308">
                  <c:v>80113.969924926758</c:v>
                </c:pt>
                <c:pt idx="1309">
                  <c:v>80121.03190612793</c:v>
                </c:pt>
                <c:pt idx="1310">
                  <c:v>80145.608184814453</c:v>
                </c:pt>
                <c:pt idx="1311">
                  <c:v>80169.613021850586</c:v>
                </c:pt>
                <c:pt idx="1312">
                  <c:v>80184.960723876953</c:v>
                </c:pt>
                <c:pt idx="1313">
                  <c:v>80194.479858398438</c:v>
                </c:pt>
                <c:pt idx="1314">
                  <c:v>80196.941848754883</c:v>
                </c:pt>
                <c:pt idx="1315">
                  <c:v>80182.175262451172</c:v>
                </c:pt>
                <c:pt idx="1316">
                  <c:v>80162.294387817383</c:v>
                </c:pt>
                <c:pt idx="1317">
                  <c:v>80149.470657348633</c:v>
                </c:pt>
                <c:pt idx="1318">
                  <c:v>80144.561218261719</c:v>
                </c:pt>
                <c:pt idx="1319">
                  <c:v>80140.337493896484</c:v>
                </c:pt>
                <c:pt idx="1320">
                  <c:v>80137.085189819336</c:v>
                </c:pt>
                <c:pt idx="1321">
                  <c:v>80130.547180175781</c:v>
                </c:pt>
                <c:pt idx="1322">
                  <c:v>80124.15202331543</c:v>
                </c:pt>
                <c:pt idx="1323">
                  <c:v>80128.728302001953</c:v>
                </c:pt>
                <c:pt idx="1324">
                  <c:v>80143.847427368164</c:v>
                </c:pt>
                <c:pt idx="1325">
                  <c:v>80154.566558837891</c:v>
                </c:pt>
                <c:pt idx="1326">
                  <c:v>80161.79997253418</c:v>
                </c:pt>
                <c:pt idx="1327">
                  <c:v>80167.347671508789</c:v>
                </c:pt>
                <c:pt idx="1328">
                  <c:v>80170.123947143555</c:v>
                </c:pt>
                <c:pt idx="1329">
                  <c:v>80172.528793334961</c:v>
                </c:pt>
                <c:pt idx="1330">
                  <c:v>80186.476486206055</c:v>
                </c:pt>
                <c:pt idx="1331">
                  <c:v>80207.25276184082</c:v>
                </c:pt>
                <c:pt idx="1332">
                  <c:v>80230.857604980469</c:v>
                </c:pt>
                <c:pt idx="1333">
                  <c:v>80245.948165893555</c:v>
                </c:pt>
                <c:pt idx="1334">
                  <c:v>80247.41015625</c:v>
                </c:pt>
                <c:pt idx="1335">
                  <c:v>80239.58642578125</c:v>
                </c:pt>
                <c:pt idx="1336">
                  <c:v>80242.44841003418</c:v>
                </c:pt>
                <c:pt idx="1337">
                  <c:v>80259.281829833984</c:v>
                </c:pt>
                <c:pt idx="1338">
                  <c:v>80276.600952148438</c:v>
                </c:pt>
                <c:pt idx="1339">
                  <c:v>80283.777221679688</c:v>
                </c:pt>
                <c:pt idx="1340">
                  <c:v>80278.953521728516</c:v>
                </c:pt>
                <c:pt idx="1341">
                  <c:v>80267.758361816406</c:v>
                </c:pt>
                <c:pt idx="1342">
                  <c:v>80255.363189697266</c:v>
                </c:pt>
                <c:pt idx="1343">
                  <c:v>80253.482330322266</c:v>
                </c:pt>
                <c:pt idx="1344">
                  <c:v>80265.887176513672</c:v>
                </c:pt>
                <c:pt idx="1345">
                  <c:v>80275.263427734375</c:v>
                </c:pt>
                <c:pt idx="1346">
                  <c:v>80270.925415039063</c:v>
                </c:pt>
                <c:pt idx="1347">
                  <c:v>80256.501708984375</c:v>
                </c:pt>
                <c:pt idx="1348">
                  <c:v>80251.420837402344</c:v>
                </c:pt>
                <c:pt idx="1349">
                  <c:v>80257.168518066406</c:v>
                </c:pt>
                <c:pt idx="1350">
                  <c:v>80277.316223144531</c:v>
                </c:pt>
                <c:pt idx="1351">
                  <c:v>80297.035369873047</c:v>
                </c:pt>
                <c:pt idx="1352">
                  <c:v>80305.011627197266</c:v>
                </c:pt>
                <c:pt idx="1353">
                  <c:v>80306.987915039063</c:v>
                </c:pt>
                <c:pt idx="1354">
                  <c:v>80310.364196777344</c:v>
                </c:pt>
                <c:pt idx="1355">
                  <c:v>80317.654754638672</c:v>
                </c:pt>
                <c:pt idx="1356">
                  <c:v>80321.773864746094</c:v>
                </c:pt>
                <c:pt idx="1357">
                  <c:v>80324.721557617188</c:v>
                </c:pt>
                <c:pt idx="1358">
                  <c:v>80322.869262695313</c:v>
                </c:pt>
                <c:pt idx="1359">
                  <c:v>80321.902679443359</c:v>
                </c:pt>
                <c:pt idx="1360">
                  <c:v>80330.393249511719</c:v>
                </c:pt>
                <c:pt idx="1361">
                  <c:v>80348.712371826172</c:v>
                </c:pt>
                <c:pt idx="1362">
                  <c:v>80369.317230224609</c:v>
                </c:pt>
                <c:pt idx="1363">
                  <c:v>80384.464935302734</c:v>
                </c:pt>
                <c:pt idx="1364">
                  <c:v>80393.498352050781</c:v>
                </c:pt>
                <c:pt idx="1365">
                  <c:v>80396.846038818359</c:v>
                </c:pt>
                <c:pt idx="1366">
                  <c:v>80395.565155029297</c:v>
                </c:pt>
                <c:pt idx="1367">
                  <c:v>80397.255737304688</c:v>
                </c:pt>
                <c:pt idx="1368">
                  <c:v>80401.9462890625</c:v>
                </c:pt>
                <c:pt idx="1369">
                  <c:v>80395.665405273438</c:v>
                </c:pt>
                <c:pt idx="1370">
                  <c:v>80375.013122558594</c:v>
                </c:pt>
                <c:pt idx="1371">
                  <c:v>80355.789398193359</c:v>
                </c:pt>
                <c:pt idx="1372">
                  <c:v>80348.251373291016</c:v>
                </c:pt>
                <c:pt idx="1373">
                  <c:v>80348.256225585938</c:v>
                </c:pt>
                <c:pt idx="1374">
                  <c:v>80350.261077880859</c:v>
                </c:pt>
                <c:pt idx="1375">
                  <c:v>80350.523040771484</c:v>
                </c:pt>
                <c:pt idx="1376">
                  <c:v>80348.870758056641</c:v>
                </c:pt>
                <c:pt idx="1377">
                  <c:v>80351.41845703125</c:v>
                </c:pt>
                <c:pt idx="1378">
                  <c:v>80354.937591552734</c:v>
                </c:pt>
                <c:pt idx="1379">
                  <c:v>80349.913848876953</c:v>
                </c:pt>
                <c:pt idx="1380">
                  <c:v>80341.290130615234</c:v>
                </c:pt>
                <c:pt idx="1381">
                  <c:v>80346.009246826172</c:v>
                </c:pt>
                <c:pt idx="1382">
                  <c:v>80359.556945800781</c:v>
                </c:pt>
                <c:pt idx="1383">
                  <c:v>80365.676086425781</c:v>
                </c:pt>
                <c:pt idx="1384">
                  <c:v>80355.59521484375</c:v>
                </c:pt>
                <c:pt idx="1385">
                  <c:v>80342.485778808594</c:v>
                </c:pt>
                <c:pt idx="1386">
                  <c:v>80332.347778320313</c:v>
                </c:pt>
                <c:pt idx="1387">
                  <c:v>80322.009765625</c:v>
                </c:pt>
                <c:pt idx="1388">
                  <c:v>80312.014587402344</c:v>
                </c:pt>
                <c:pt idx="1389">
                  <c:v>80310.248016357422</c:v>
                </c:pt>
                <c:pt idx="1390">
                  <c:v>80308.967132568359</c:v>
                </c:pt>
                <c:pt idx="1391">
                  <c:v>80304.571990966797</c:v>
                </c:pt>
                <c:pt idx="1392">
                  <c:v>80302.833984375</c:v>
                </c:pt>
                <c:pt idx="1393">
                  <c:v>80303.210235595703</c:v>
                </c:pt>
                <c:pt idx="1394">
                  <c:v>80295.586517333984</c:v>
                </c:pt>
                <c:pt idx="1395">
                  <c:v>80288.505645751953</c:v>
                </c:pt>
                <c:pt idx="1396">
                  <c:v>80285.739074707031</c:v>
                </c:pt>
                <c:pt idx="1397">
                  <c:v>80281.915344238281</c:v>
                </c:pt>
                <c:pt idx="1398">
                  <c:v>80281.205902099609</c:v>
                </c:pt>
                <c:pt idx="1399">
                  <c:v>80291.410736083984</c:v>
                </c:pt>
                <c:pt idx="1400">
                  <c:v>80303.415588378906</c:v>
                </c:pt>
                <c:pt idx="1401">
                  <c:v>80301.877563476563</c:v>
                </c:pt>
                <c:pt idx="1402">
                  <c:v>80284.910980224609</c:v>
                </c:pt>
                <c:pt idx="1403">
                  <c:v>80267.458679199219</c:v>
                </c:pt>
                <c:pt idx="1404">
                  <c:v>80264.120666503906</c:v>
                </c:pt>
                <c:pt idx="1405">
                  <c:v>80275.811248779297</c:v>
                </c:pt>
                <c:pt idx="1406">
                  <c:v>80281.644653320313</c:v>
                </c:pt>
                <c:pt idx="1407">
                  <c:v>80272.563781738281</c:v>
                </c:pt>
                <c:pt idx="1408">
                  <c:v>80255.740051269531</c:v>
                </c:pt>
                <c:pt idx="1409">
                  <c:v>80249.144897460938</c:v>
                </c:pt>
                <c:pt idx="1410">
                  <c:v>80257.149749755859</c:v>
                </c:pt>
                <c:pt idx="1411">
                  <c:v>80275.326019287109</c:v>
                </c:pt>
                <c:pt idx="1412">
                  <c:v>80296.330871582031</c:v>
                </c:pt>
                <c:pt idx="1413">
                  <c:v>80310.3642578125</c:v>
                </c:pt>
                <c:pt idx="1414">
                  <c:v>80309.654846191406</c:v>
                </c:pt>
                <c:pt idx="1415">
                  <c:v>80302.173950195313</c:v>
                </c:pt>
                <c:pt idx="1416">
                  <c:v>80298.493103027344</c:v>
                </c:pt>
                <c:pt idx="1417">
                  <c:v>80296.269378662109</c:v>
                </c:pt>
                <c:pt idx="1418">
                  <c:v>80289.788482666016</c:v>
                </c:pt>
                <c:pt idx="1419">
                  <c:v>80287.25048828125</c:v>
                </c:pt>
                <c:pt idx="1420">
                  <c:v>80290.912475585938</c:v>
                </c:pt>
                <c:pt idx="1421">
                  <c:v>80289.317321777344</c:v>
                </c:pt>
                <c:pt idx="1422">
                  <c:v>80274.636444091797</c:v>
                </c:pt>
                <c:pt idx="1423">
                  <c:v>80256.326995849609</c:v>
                </c:pt>
                <c:pt idx="1424">
                  <c:v>80246.617553710938</c:v>
                </c:pt>
                <c:pt idx="1425">
                  <c:v>80253.822402954102</c:v>
                </c:pt>
                <c:pt idx="1426">
                  <c:v>80274.198669433594</c:v>
                </c:pt>
                <c:pt idx="1427">
                  <c:v>80299.403533935547</c:v>
                </c:pt>
                <c:pt idx="1428">
                  <c:v>80315.836944580078</c:v>
                </c:pt>
                <c:pt idx="1429">
                  <c:v>80323.613220214844</c:v>
                </c:pt>
                <c:pt idx="1430">
                  <c:v>80324.932342529297</c:v>
                </c:pt>
                <c:pt idx="1431">
                  <c:v>80317.937194824219</c:v>
                </c:pt>
                <c:pt idx="1432">
                  <c:v>80302.799163818359</c:v>
                </c:pt>
                <c:pt idx="1433">
                  <c:v>80285.032592773438</c:v>
                </c:pt>
                <c:pt idx="1434">
                  <c:v>80270.494567871094</c:v>
                </c:pt>
                <c:pt idx="1435">
                  <c:v>80265.356567382813</c:v>
                </c:pt>
                <c:pt idx="1436">
                  <c:v>80269.275695800781</c:v>
                </c:pt>
                <c:pt idx="1437">
                  <c:v>80275.109100341797</c:v>
                </c:pt>
                <c:pt idx="1438">
                  <c:v>80273.942504882813</c:v>
                </c:pt>
                <c:pt idx="1439">
                  <c:v>80273.575927734375</c:v>
                </c:pt>
                <c:pt idx="1440">
                  <c:v>80278.037933349609</c:v>
                </c:pt>
                <c:pt idx="1441">
                  <c:v>80286.271331787109</c:v>
                </c:pt>
                <c:pt idx="1442">
                  <c:v>80283.961883544922</c:v>
                </c:pt>
                <c:pt idx="1443">
                  <c:v>80267.566741943359</c:v>
                </c:pt>
                <c:pt idx="1444">
                  <c:v>80249.857299804688</c:v>
                </c:pt>
                <c:pt idx="1445">
                  <c:v>80245.062149047852</c:v>
                </c:pt>
                <c:pt idx="1446">
                  <c:v>80246.438415527344</c:v>
                </c:pt>
                <c:pt idx="1447">
                  <c:v>80247.586120605469</c:v>
                </c:pt>
                <c:pt idx="1448">
                  <c:v>80257.390960693359</c:v>
                </c:pt>
                <c:pt idx="1449">
                  <c:v>80279.767242431641</c:v>
                </c:pt>
                <c:pt idx="1450">
                  <c:v>80299.743499755859</c:v>
                </c:pt>
                <c:pt idx="1451">
                  <c:v>80313.919769287109</c:v>
                </c:pt>
                <c:pt idx="1452">
                  <c:v>80333.267486572266</c:v>
                </c:pt>
                <c:pt idx="1453">
                  <c:v>80361.072326660156</c:v>
                </c:pt>
                <c:pt idx="1454">
                  <c:v>80383.934326171875</c:v>
                </c:pt>
                <c:pt idx="1455">
                  <c:v>80396.110595703125</c:v>
                </c:pt>
                <c:pt idx="1456">
                  <c:v>80400.715423583984</c:v>
                </c:pt>
                <c:pt idx="1457">
                  <c:v>80396.348846435547</c:v>
                </c:pt>
                <c:pt idx="1458">
                  <c:v>80385.753692626953</c:v>
                </c:pt>
                <c:pt idx="1459">
                  <c:v>80374.901397705078</c:v>
                </c:pt>
                <c:pt idx="1460">
                  <c:v>80364.563385009766</c:v>
                </c:pt>
                <c:pt idx="1461">
                  <c:v>80349.311065673828</c:v>
                </c:pt>
                <c:pt idx="1462">
                  <c:v>80330.830200195313</c:v>
                </c:pt>
                <c:pt idx="1463">
                  <c:v>80315.035064697266</c:v>
                </c:pt>
                <c:pt idx="1464">
                  <c:v>80308.868469238281</c:v>
                </c:pt>
                <c:pt idx="1465">
                  <c:v>80315.187591552734</c:v>
                </c:pt>
                <c:pt idx="1466">
                  <c:v>80329.478149414063</c:v>
                </c:pt>
                <c:pt idx="1467">
                  <c:v>80343.111572265625</c:v>
                </c:pt>
                <c:pt idx="1468">
                  <c:v>80345.630706787109</c:v>
                </c:pt>
                <c:pt idx="1469">
                  <c:v>80339.235534667969</c:v>
                </c:pt>
                <c:pt idx="1470">
                  <c:v>80332.440399169922</c:v>
                </c:pt>
                <c:pt idx="1471">
                  <c:v>80336.845245361328</c:v>
                </c:pt>
                <c:pt idx="1472">
                  <c:v>80353.478637695313</c:v>
                </c:pt>
                <c:pt idx="1473">
                  <c:v>80378.369201660156</c:v>
                </c:pt>
                <c:pt idx="1474">
                  <c:v>80402.374053955078</c:v>
                </c:pt>
                <c:pt idx="1475">
                  <c:v>80411.807464599609</c:v>
                </c:pt>
                <c:pt idx="1476">
                  <c:v>80404.069458007813</c:v>
                </c:pt>
                <c:pt idx="1477">
                  <c:v>80393.960021972656</c:v>
                </c:pt>
                <c:pt idx="1478">
                  <c:v>80401.279144287109</c:v>
                </c:pt>
                <c:pt idx="1479">
                  <c:v>80421.055419921875</c:v>
                </c:pt>
                <c:pt idx="1480">
                  <c:v>80436.231689453125</c:v>
                </c:pt>
                <c:pt idx="1481">
                  <c:v>80438.579376220703</c:v>
                </c:pt>
                <c:pt idx="1482">
                  <c:v>80431.355651855469</c:v>
                </c:pt>
                <c:pt idx="1483">
                  <c:v>80427.074798583984</c:v>
                </c:pt>
                <c:pt idx="1484">
                  <c:v>80439.422485351563</c:v>
                </c:pt>
                <c:pt idx="1485">
                  <c:v>80463.113037109375</c:v>
                </c:pt>
                <c:pt idx="1486">
                  <c:v>80475.175048828125</c:v>
                </c:pt>
                <c:pt idx="1487">
                  <c:v>80477.779876708984</c:v>
                </c:pt>
                <c:pt idx="1488">
                  <c:v>80482.984741210938</c:v>
                </c:pt>
                <c:pt idx="1489">
                  <c:v>80493.703857421875</c:v>
                </c:pt>
                <c:pt idx="1490">
                  <c:v>80498.565856933594</c:v>
                </c:pt>
                <c:pt idx="1491">
                  <c:v>80503.570678710938</c:v>
                </c:pt>
                <c:pt idx="1492">
                  <c:v>80518.375549316406</c:v>
                </c:pt>
                <c:pt idx="1493">
                  <c:v>80542.008972167969</c:v>
                </c:pt>
                <c:pt idx="1494">
                  <c:v>80560.099487304688</c:v>
                </c:pt>
                <c:pt idx="1495">
                  <c:v>80563.332946777344</c:v>
                </c:pt>
                <c:pt idx="1496">
                  <c:v>80562.709167480469</c:v>
                </c:pt>
                <c:pt idx="1497">
                  <c:v>80569.514038085938</c:v>
                </c:pt>
                <c:pt idx="1498">
                  <c:v>80578.233154296875</c:v>
                </c:pt>
                <c:pt idx="1499">
                  <c:v>80579.666564941406</c:v>
                </c:pt>
                <c:pt idx="1500">
                  <c:v>80577.871398925781</c:v>
                </c:pt>
                <c:pt idx="1501">
                  <c:v>80586.133422851563</c:v>
                </c:pt>
                <c:pt idx="1502">
                  <c:v>80600.681091308594</c:v>
                </c:pt>
                <c:pt idx="1503">
                  <c:v>80617.857360839844</c:v>
                </c:pt>
                <c:pt idx="1504">
                  <c:v>80635.519348144531</c:v>
                </c:pt>
                <c:pt idx="1505">
                  <c:v>80652.32421875</c:v>
                </c:pt>
                <c:pt idx="1506">
                  <c:v>80660.471923828125</c:v>
                </c:pt>
                <c:pt idx="1507">
                  <c:v>80670.819641113281</c:v>
                </c:pt>
                <c:pt idx="1508">
                  <c:v>80686.310180664063</c:v>
                </c:pt>
                <c:pt idx="1509">
                  <c:v>80698.743591308594</c:v>
                </c:pt>
                <c:pt idx="1510">
                  <c:v>80705.948425292969</c:v>
                </c:pt>
                <c:pt idx="1511">
                  <c:v>80720.353271484375</c:v>
                </c:pt>
                <c:pt idx="1512">
                  <c:v>80741.300964355469</c:v>
                </c:pt>
                <c:pt idx="1513">
                  <c:v>80751.991516113281</c:v>
                </c:pt>
                <c:pt idx="1514">
                  <c:v>80747.710693359375</c:v>
                </c:pt>
                <c:pt idx="1515">
                  <c:v>80741.115539550781</c:v>
                </c:pt>
                <c:pt idx="1516">
                  <c:v>80750.063232421875</c:v>
                </c:pt>
                <c:pt idx="1517">
                  <c:v>80768.553771972656</c:v>
                </c:pt>
                <c:pt idx="1518">
                  <c:v>80788.4443359375</c:v>
                </c:pt>
                <c:pt idx="1519">
                  <c:v>80813.677734375</c:v>
                </c:pt>
                <c:pt idx="1520">
                  <c:v>80847.911193847656</c:v>
                </c:pt>
                <c:pt idx="1521">
                  <c:v>80896.001708984375</c:v>
                </c:pt>
                <c:pt idx="1522">
                  <c:v>80952.177978515625</c:v>
                </c:pt>
                <c:pt idx="1523">
                  <c:v>81003.297119140625</c:v>
                </c:pt>
                <c:pt idx="1524">
                  <c:v>81035.787719726563</c:v>
                </c:pt>
                <c:pt idx="1525">
                  <c:v>81050.049682617188</c:v>
                </c:pt>
                <c:pt idx="1526">
                  <c:v>81044.940185546875</c:v>
                </c:pt>
                <c:pt idx="1527">
                  <c:v>81021.630798339844</c:v>
                </c:pt>
                <c:pt idx="1528">
                  <c:v>80983.692749023438</c:v>
                </c:pt>
                <c:pt idx="1529">
                  <c:v>80942.240478515625</c:v>
                </c:pt>
                <c:pt idx="1530">
                  <c:v>80908.159606933594</c:v>
                </c:pt>
                <c:pt idx="1531">
                  <c:v>80876.593017578125</c:v>
                </c:pt>
                <c:pt idx="1532">
                  <c:v>80834.855041503906</c:v>
                </c:pt>
                <c:pt idx="1533">
                  <c:v>80792.945556640625</c:v>
                </c:pt>
                <c:pt idx="1534">
                  <c:v>80768.464721679688</c:v>
                </c:pt>
                <c:pt idx="1535">
                  <c:v>80766.783813476563</c:v>
                </c:pt>
                <c:pt idx="1536">
                  <c:v>80776.588684082031</c:v>
                </c:pt>
                <c:pt idx="1537">
                  <c:v>80785.5078125</c:v>
                </c:pt>
                <c:pt idx="1538">
                  <c:v>80782.541198730469</c:v>
                </c:pt>
                <c:pt idx="1539">
                  <c:v>80774.8603515625</c:v>
                </c:pt>
                <c:pt idx="1540">
                  <c:v>80772.09375</c:v>
                </c:pt>
                <c:pt idx="1541">
                  <c:v>80773.698608398438</c:v>
                </c:pt>
                <c:pt idx="1542">
                  <c:v>80773.874877929688</c:v>
                </c:pt>
                <c:pt idx="1543">
                  <c:v>80769.479736328125</c:v>
                </c:pt>
                <c:pt idx="1544">
                  <c:v>80765.770263671875</c:v>
                </c:pt>
                <c:pt idx="1545">
                  <c:v>80769.289428710938</c:v>
                </c:pt>
                <c:pt idx="1546">
                  <c:v>80776.008544921875</c:v>
                </c:pt>
                <c:pt idx="1547">
                  <c:v>80782.841979980469</c:v>
                </c:pt>
                <c:pt idx="1548">
                  <c:v>80789.189636230469</c:v>
                </c:pt>
                <c:pt idx="1549">
                  <c:v>80794.137390136719</c:v>
                </c:pt>
                <c:pt idx="1550">
                  <c:v>80790.799377441406</c:v>
                </c:pt>
                <c:pt idx="1551">
                  <c:v>80791.232788085938</c:v>
                </c:pt>
                <c:pt idx="1552">
                  <c:v>80802.780456542969</c:v>
                </c:pt>
                <c:pt idx="1553">
                  <c:v>80806.956726074219</c:v>
                </c:pt>
                <c:pt idx="1554">
                  <c:v>80794.447326660156</c:v>
                </c:pt>
                <c:pt idx="1555">
                  <c:v>80785.652160644531</c:v>
                </c:pt>
                <c:pt idx="1556">
                  <c:v>80795.085571289063</c:v>
                </c:pt>
                <c:pt idx="1557">
                  <c:v>80812.890380859375</c:v>
                </c:pt>
                <c:pt idx="1558">
                  <c:v>80831.552368164063</c:v>
                </c:pt>
                <c:pt idx="1559">
                  <c:v>80850.1572265625</c:v>
                </c:pt>
                <c:pt idx="1560">
                  <c:v>80856.133483886719</c:v>
                </c:pt>
                <c:pt idx="1561">
                  <c:v>80852.252624511719</c:v>
                </c:pt>
                <c:pt idx="1562">
                  <c:v>80848.314636230469</c:v>
                </c:pt>
                <c:pt idx="1563">
                  <c:v>80850.262329101563</c:v>
                </c:pt>
                <c:pt idx="1564">
                  <c:v>80849.238586425781</c:v>
                </c:pt>
                <c:pt idx="1565">
                  <c:v>80850.243469238281</c:v>
                </c:pt>
                <c:pt idx="1566">
                  <c:v>80850.133972167969</c:v>
                </c:pt>
                <c:pt idx="1567">
                  <c:v>80850.3388671875</c:v>
                </c:pt>
                <c:pt idx="1568">
                  <c:v>80851.857971191406</c:v>
                </c:pt>
                <c:pt idx="1569">
                  <c:v>80859.69140625</c:v>
                </c:pt>
                <c:pt idx="1570">
                  <c:v>80865.096252441406</c:v>
                </c:pt>
                <c:pt idx="1571">
                  <c:v>80862.529663085938</c:v>
                </c:pt>
                <c:pt idx="1572">
                  <c:v>80854.734497070313</c:v>
                </c:pt>
                <c:pt idx="1573">
                  <c:v>80853.367919921875</c:v>
                </c:pt>
                <c:pt idx="1574">
                  <c:v>80854.487060546875</c:v>
                </c:pt>
                <c:pt idx="1575">
                  <c:v>80854.491882324219</c:v>
                </c:pt>
                <c:pt idx="1576">
                  <c:v>80845.468139648438</c:v>
                </c:pt>
                <c:pt idx="1577">
                  <c:v>80832.644409179688</c:v>
                </c:pt>
                <c:pt idx="1578">
                  <c:v>80826.1064453125</c:v>
                </c:pt>
                <c:pt idx="1579">
                  <c:v>80832.368408203125</c:v>
                </c:pt>
                <c:pt idx="1580">
                  <c:v>80834.658935546875</c:v>
                </c:pt>
                <c:pt idx="1581">
                  <c:v>80826.378112792969</c:v>
                </c:pt>
                <c:pt idx="1582">
                  <c:v>80829.411499023438</c:v>
                </c:pt>
                <c:pt idx="1583">
                  <c:v>80848.702087402344</c:v>
                </c:pt>
                <c:pt idx="1584">
                  <c:v>80864.22119140625</c:v>
                </c:pt>
                <c:pt idx="1585">
                  <c:v>80859.711730957031</c:v>
                </c:pt>
                <c:pt idx="1586">
                  <c:v>80848.716613769531</c:v>
                </c:pt>
                <c:pt idx="1587">
                  <c:v>80858.664306640625</c:v>
                </c:pt>
                <c:pt idx="1588">
                  <c:v>80899.097717285156</c:v>
                </c:pt>
                <c:pt idx="1589">
                  <c:v>80952.159729003906</c:v>
                </c:pt>
                <c:pt idx="1590">
                  <c:v>80993.993103027344</c:v>
                </c:pt>
                <c:pt idx="1591">
                  <c:v>81017.626525878906</c:v>
                </c:pt>
                <c:pt idx="1592">
                  <c:v>81026.345703125</c:v>
                </c:pt>
                <c:pt idx="1593">
                  <c:v>81016.550476074219</c:v>
                </c:pt>
                <c:pt idx="1594">
                  <c:v>80986.86962890625</c:v>
                </c:pt>
                <c:pt idx="1595">
                  <c:v>80950.731628417969</c:v>
                </c:pt>
                <c:pt idx="1596">
                  <c:v>80928.879333496094</c:v>
                </c:pt>
                <c:pt idx="1597">
                  <c:v>80932.112731933594</c:v>
                </c:pt>
                <c:pt idx="1598">
                  <c:v>80971.946166992188</c:v>
                </c:pt>
                <c:pt idx="1599">
                  <c:v>81074.122436523438</c:v>
                </c:pt>
                <c:pt idx="1600">
                  <c:v>81282.69873046875</c:v>
                </c:pt>
                <c:pt idx="1601">
                  <c:v>81636.246459960938</c:v>
                </c:pt>
                <c:pt idx="1602">
                  <c:v>82159.737060546875</c:v>
                </c:pt>
                <c:pt idx="1603">
                  <c:v>82858.541748046875</c:v>
                </c:pt>
                <c:pt idx="1604">
                  <c:v>83713.232421875</c:v>
                </c:pt>
                <c:pt idx="1605">
                  <c:v>84627.32275390625</c:v>
                </c:pt>
                <c:pt idx="1606">
                  <c:v>85458.29931640625</c:v>
                </c:pt>
                <c:pt idx="1607">
                  <c:v>86049.53271484375</c:v>
                </c:pt>
                <c:pt idx="1608">
                  <c:v>86273.19482421875</c:v>
                </c:pt>
                <c:pt idx="1609">
                  <c:v>86051.6279296875</c:v>
                </c:pt>
                <c:pt idx="1610">
                  <c:v>85436.861328125</c:v>
                </c:pt>
                <c:pt idx="1611">
                  <c:v>84570.78076171875</c:v>
                </c:pt>
                <c:pt idx="1612">
                  <c:v>83615.013916015625</c:v>
                </c:pt>
                <c:pt idx="1613">
                  <c:v>82703.39013671875</c:v>
                </c:pt>
                <c:pt idx="1614">
                  <c:v>81940.080810546875</c:v>
                </c:pt>
                <c:pt idx="1615">
                  <c:v>81375.657104492188</c:v>
                </c:pt>
                <c:pt idx="1616">
                  <c:v>81000.51904296875</c:v>
                </c:pt>
                <c:pt idx="1617">
                  <c:v>80771.381042480469</c:v>
                </c:pt>
                <c:pt idx="1618">
                  <c:v>80634.357299804688</c:v>
                </c:pt>
                <c:pt idx="1619">
                  <c:v>80546.476440429688</c:v>
                </c:pt>
                <c:pt idx="1620">
                  <c:v>80489.967010498047</c:v>
                </c:pt>
                <c:pt idx="1621">
                  <c:v>80461.714721679688</c:v>
                </c:pt>
                <c:pt idx="1622">
                  <c:v>80447.290985107422</c:v>
                </c:pt>
                <c:pt idx="1623">
                  <c:v>80434.638702392578</c:v>
                </c:pt>
                <c:pt idx="1624">
                  <c:v>80429.529235839844</c:v>
                </c:pt>
                <c:pt idx="1625">
                  <c:v>80436.905517578125</c:v>
                </c:pt>
                <c:pt idx="1626">
                  <c:v>80439.967498779297</c:v>
                </c:pt>
                <c:pt idx="1627">
                  <c:v>80428.400909423828</c:v>
                </c:pt>
                <c:pt idx="1628">
                  <c:v>80416.120056152344</c:v>
                </c:pt>
                <c:pt idx="1629">
                  <c:v>80415.467742919922</c:v>
                </c:pt>
                <c:pt idx="1630">
                  <c:v>80420.244018554688</c:v>
                </c:pt>
                <c:pt idx="1631">
                  <c:v>80415.591735839844</c:v>
                </c:pt>
                <c:pt idx="1632">
                  <c:v>80405.910858154297</c:v>
                </c:pt>
                <c:pt idx="1633">
                  <c:v>80395.658569335938</c:v>
                </c:pt>
                <c:pt idx="1634">
                  <c:v>80387.749114990234</c:v>
                </c:pt>
                <c:pt idx="1635">
                  <c:v>80383.811096191406</c:v>
                </c:pt>
                <c:pt idx="1636">
                  <c:v>80389.815948486328</c:v>
                </c:pt>
                <c:pt idx="1637">
                  <c:v>80403.192230224609</c:v>
                </c:pt>
                <c:pt idx="1638">
                  <c:v>80415.882781982422</c:v>
                </c:pt>
                <c:pt idx="1639">
                  <c:v>80418.459045410156</c:v>
                </c:pt>
                <c:pt idx="1640">
                  <c:v>80408.378173828125</c:v>
                </c:pt>
                <c:pt idx="1641">
                  <c:v>80394.783020019531</c:v>
                </c:pt>
                <c:pt idx="1642">
                  <c:v>80386.759307861328</c:v>
                </c:pt>
                <c:pt idx="1643">
                  <c:v>80388.192718505859</c:v>
                </c:pt>
                <c:pt idx="1644">
                  <c:v>80395.854705810547</c:v>
                </c:pt>
                <c:pt idx="1645">
                  <c:v>80399.059539794922</c:v>
                </c:pt>
                <c:pt idx="1646">
                  <c:v>80391.864379882813</c:v>
                </c:pt>
                <c:pt idx="1647">
                  <c:v>80383.326385498047</c:v>
                </c:pt>
                <c:pt idx="1648">
                  <c:v>80384.245513916016</c:v>
                </c:pt>
                <c:pt idx="1649">
                  <c:v>80392.193206787109</c:v>
                </c:pt>
                <c:pt idx="1650">
                  <c:v>80399.598052978516</c:v>
                </c:pt>
                <c:pt idx="1651">
                  <c:v>80411.345764160156</c:v>
                </c:pt>
                <c:pt idx="1652">
                  <c:v>80431.950592041016</c:v>
                </c:pt>
                <c:pt idx="1653">
                  <c:v>80457.241149902344</c:v>
                </c:pt>
                <c:pt idx="1654">
                  <c:v>80489.474578857422</c:v>
                </c:pt>
                <c:pt idx="1655">
                  <c:v>80554.822265625</c:v>
                </c:pt>
                <c:pt idx="1656">
                  <c:v>80688.798522949219</c:v>
                </c:pt>
                <c:pt idx="1657">
                  <c:v>80935.23193359375</c:v>
                </c:pt>
                <c:pt idx="1658">
                  <c:v>81343.493896484375</c:v>
                </c:pt>
                <c:pt idx="1659">
                  <c:v>81947.127319335938</c:v>
                </c:pt>
                <c:pt idx="1660">
                  <c:v>82762.36083984375</c:v>
                </c:pt>
                <c:pt idx="1661">
                  <c:v>83782.22265625</c:v>
                </c:pt>
                <c:pt idx="1662">
                  <c:v>84940.6845703125</c:v>
                </c:pt>
                <c:pt idx="1663">
                  <c:v>86106.14697265625</c:v>
                </c:pt>
                <c:pt idx="1664">
                  <c:v>87117.86572265625</c:v>
                </c:pt>
                <c:pt idx="1665">
                  <c:v>87809.64208984375</c:v>
                </c:pt>
                <c:pt idx="1666">
                  <c:v>88038.07568359375</c:v>
                </c:pt>
                <c:pt idx="1667">
                  <c:v>87747.9091796875</c:v>
                </c:pt>
                <c:pt idx="1668">
                  <c:v>87002.42822265625</c:v>
                </c:pt>
                <c:pt idx="1669">
                  <c:v>85943.46142578125</c:v>
                </c:pt>
                <c:pt idx="1670">
                  <c:v>84743.6376953125</c:v>
                </c:pt>
                <c:pt idx="1671">
                  <c:v>83571.042724609375</c:v>
                </c:pt>
                <c:pt idx="1672">
                  <c:v>82561.24755859375</c:v>
                </c:pt>
                <c:pt idx="1673">
                  <c:v>81791.166625976563</c:v>
                </c:pt>
                <c:pt idx="1674">
                  <c:v>81263.142822265625</c:v>
                </c:pt>
                <c:pt idx="1675">
                  <c:v>80925.690612792969</c:v>
                </c:pt>
                <c:pt idx="1676">
                  <c:v>80732.152587890625</c:v>
                </c:pt>
                <c:pt idx="1677">
                  <c:v>80642.243103027344</c:v>
                </c:pt>
                <c:pt idx="1678">
                  <c:v>80613.247985839844</c:v>
                </c:pt>
                <c:pt idx="1679">
                  <c:v>80613.309936523438</c:v>
                </c:pt>
                <c:pt idx="1680">
                  <c:v>80641.686218261719</c:v>
                </c:pt>
                <c:pt idx="1681">
                  <c:v>80703.833923339844</c:v>
                </c:pt>
                <c:pt idx="1682">
                  <c:v>80792.067321777344</c:v>
                </c:pt>
                <c:pt idx="1683">
                  <c:v>80899.329345703125</c:v>
                </c:pt>
                <c:pt idx="1684">
                  <c:v>81023.391296386719</c:v>
                </c:pt>
                <c:pt idx="1685">
                  <c:v>81156.253295898438</c:v>
                </c:pt>
                <c:pt idx="1686">
                  <c:v>81276.88671875</c:v>
                </c:pt>
                <c:pt idx="1687">
                  <c:v>81355.577270507813</c:v>
                </c:pt>
                <c:pt idx="1688">
                  <c:v>81378.753540039063</c:v>
                </c:pt>
                <c:pt idx="1689">
                  <c:v>81339.3583984375</c:v>
                </c:pt>
                <c:pt idx="1690">
                  <c:v>81244.820434570313</c:v>
                </c:pt>
                <c:pt idx="1691">
                  <c:v>81105.053833007813</c:v>
                </c:pt>
                <c:pt idx="1692">
                  <c:v>80948.001525878906</c:v>
                </c:pt>
                <c:pt idx="1693">
                  <c:v>80801.777770996094</c:v>
                </c:pt>
                <c:pt idx="1694">
                  <c:v>80682.211181640625</c:v>
                </c:pt>
                <c:pt idx="1695">
                  <c:v>80592.416015625</c:v>
                </c:pt>
                <c:pt idx="1696">
                  <c:v>80527.792297363281</c:v>
                </c:pt>
                <c:pt idx="1697">
                  <c:v>80483.825714111328</c:v>
                </c:pt>
                <c:pt idx="1698">
                  <c:v>80469.859130859375</c:v>
                </c:pt>
                <c:pt idx="1699">
                  <c:v>80487.0068359375</c:v>
                </c:pt>
                <c:pt idx="1700">
                  <c:v>80507.754547119141</c:v>
                </c:pt>
                <c:pt idx="1701">
                  <c:v>80510.930816650391</c:v>
                </c:pt>
                <c:pt idx="1702">
                  <c:v>80507.049957275391</c:v>
                </c:pt>
                <c:pt idx="1703">
                  <c:v>80503.826232910156</c:v>
                </c:pt>
                <c:pt idx="1704">
                  <c:v>80500.945343017578</c:v>
                </c:pt>
                <c:pt idx="1705">
                  <c:v>80503.093048095703</c:v>
                </c:pt>
                <c:pt idx="1706">
                  <c:v>80508.183624267578</c:v>
                </c:pt>
                <c:pt idx="1707">
                  <c:v>80502.217041015625</c:v>
                </c:pt>
                <c:pt idx="1708">
                  <c:v>80485.621856689453</c:v>
                </c:pt>
                <c:pt idx="1709">
                  <c:v>80471.683868408203</c:v>
                </c:pt>
                <c:pt idx="1710">
                  <c:v>80465.860137939453</c:v>
                </c:pt>
                <c:pt idx="1711">
                  <c:v>80465.522125244141</c:v>
                </c:pt>
                <c:pt idx="1712">
                  <c:v>80471.298400878906</c:v>
                </c:pt>
                <c:pt idx="1713">
                  <c:v>80479.274658203125</c:v>
                </c:pt>
                <c:pt idx="1714">
                  <c:v>80486.193786621094</c:v>
                </c:pt>
                <c:pt idx="1715">
                  <c:v>80501.684356689453</c:v>
                </c:pt>
                <c:pt idx="1716">
                  <c:v>80519.7177734375</c:v>
                </c:pt>
                <c:pt idx="1717">
                  <c:v>80524.094055175781</c:v>
                </c:pt>
                <c:pt idx="1718">
                  <c:v>80514.12744140625</c:v>
                </c:pt>
                <c:pt idx="1719">
                  <c:v>80516.618041992188</c:v>
                </c:pt>
                <c:pt idx="1720">
                  <c:v>80538.651428222656</c:v>
                </c:pt>
                <c:pt idx="1721">
                  <c:v>80559.827697753906</c:v>
                </c:pt>
                <c:pt idx="1722">
                  <c:v>80569.71826171875</c:v>
                </c:pt>
                <c:pt idx="1723">
                  <c:v>80573.665954589844</c:v>
                </c:pt>
                <c:pt idx="1724">
                  <c:v>80579.95654296875</c:v>
                </c:pt>
                <c:pt idx="1725">
                  <c:v>80587.18994140625</c:v>
                </c:pt>
                <c:pt idx="1726">
                  <c:v>80596.337646484375</c:v>
                </c:pt>
                <c:pt idx="1727">
                  <c:v>80609.999633789063</c:v>
                </c:pt>
                <c:pt idx="1728">
                  <c:v>80637.66162109375</c:v>
                </c:pt>
                <c:pt idx="1729">
                  <c:v>80668.095031738281</c:v>
                </c:pt>
                <c:pt idx="1730">
                  <c:v>80676.871276855469</c:v>
                </c:pt>
                <c:pt idx="1731">
                  <c:v>80657.847595214844</c:v>
                </c:pt>
                <c:pt idx="1732">
                  <c:v>80634.509582519531</c:v>
                </c:pt>
                <c:pt idx="1733">
                  <c:v>80624.828674316406</c:v>
                </c:pt>
                <c:pt idx="1734">
                  <c:v>80632.204956054688</c:v>
                </c:pt>
                <c:pt idx="1735">
                  <c:v>80640.638366699219</c:v>
                </c:pt>
                <c:pt idx="1736">
                  <c:v>80641.043212890625</c:v>
                </c:pt>
                <c:pt idx="1737">
                  <c:v>80638.533752441406</c:v>
                </c:pt>
                <c:pt idx="1738">
                  <c:v>80643.195739746094</c:v>
                </c:pt>
                <c:pt idx="1739">
                  <c:v>80650.000610351563</c:v>
                </c:pt>
                <c:pt idx="1740">
                  <c:v>80659.319763183594</c:v>
                </c:pt>
                <c:pt idx="1741">
                  <c:v>80672.524597167969</c:v>
                </c:pt>
                <c:pt idx="1742">
                  <c:v>80675.072265625</c:v>
                </c:pt>
                <c:pt idx="1743">
                  <c:v>80659.934265136719</c:v>
                </c:pt>
                <c:pt idx="1744">
                  <c:v>80637.653381347656</c:v>
                </c:pt>
                <c:pt idx="1745">
                  <c:v>80619.829650878906</c:v>
                </c:pt>
                <c:pt idx="1746">
                  <c:v>80605.777404785156</c:v>
                </c:pt>
                <c:pt idx="1747">
                  <c:v>80598.182250976563</c:v>
                </c:pt>
                <c:pt idx="1748">
                  <c:v>80591.95849609375</c:v>
                </c:pt>
                <c:pt idx="1749">
                  <c:v>80582.649047851563</c:v>
                </c:pt>
                <c:pt idx="1750">
                  <c:v>80577.768188476563</c:v>
                </c:pt>
                <c:pt idx="1751">
                  <c:v>80589.315856933594</c:v>
                </c:pt>
                <c:pt idx="1752">
                  <c:v>80616.720703125</c:v>
                </c:pt>
                <c:pt idx="1753">
                  <c:v>80662.78271484375</c:v>
                </c:pt>
                <c:pt idx="1754">
                  <c:v>80731.273254394531</c:v>
                </c:pt>
                <c:pt idx="1755">
                  <c:v>80819.106689453125</c:v>
                </c:pt>
                <c:pt idx="1756">
                  <c:v>80933.36865234375</c:v>
                </c:pt>
                <c:pt idx="1757">
                  <c:v>81081.973510742188</c:v>
                </c:pt>
                <c:pt idx="1758">
                  <c:v>81262.692626953125</c:v>
                </c:pt>
                <c:pt idx="1759">
                  <c:v>81458.040405273438</c:v>
                </c:pt>
                <c:pt idx="1760">
                  <c:v>81656.045166015625</c:v>
                </c:pt>
                <c:pt idx="1761">
                  <c:v>81840.478637695313</c:v>
                </c:pt>
                <c:pt idx="1762">
                  <c:v>81983.340576171875</c:v>
                </c:pt>
                <c:pt idx="1763">
                  <c:v>82054.9169921875</c:v>
                </c:pt>
                <c:pt idx="1764">
                  <c:v>82040.693115234375</c:v>
                </c:pt>
                <c:pt idx="1765">
                  <c:v>81949.640869140625</c:v>
                </c:pt>
                <c:pt idx="1766">
                  <c:v>81790.531372070313</c:v>
                </c:pt>
                <c:pt idx="1767">
                  <c:v>81583.936279296875</c:v>
                </c:pt>
                <c:pt idx="1768">
                  <c:v>81363.3125</c:v>
                </c:pt>
                <c:pt idx="1769">
                  <c:v>81178.231689453125</c:v>
                </c:pt>
                <c:pt idx="1770">
                  <c:v>81043.122192382813</c:v>
                </c:pt>
                <c:pt idx="1771">
                  <c:v>80950.955627441406</c:v>
                </c:pt>
                <c:pt idx="1772">
                  <c:v>80877.103332519531</c:v>
                </c:pt>
                <c:pt idx="1773">
                  <c:v>80812.279602050781</c:v>
                </c:pt>
                <c:pt idx="1774">
                  <c:v>80758.398742675781</c:v>
                </c:pt>
                <c:pt idx="1775">
                  <c:v>80730.117858886719</c:v>
                </c:pt>
                <c:pt idx="1776">
                  <c:v>80713.922729492188</c:v>
                </c:pt>
                <c:pt idx="1777">
                  <c:v>80694.556091308594</c:v>
                </c:pt>
                <c:pt idx="1778">
                  <c:v>80678.303833007813</c:v>
                </c:pt>
                <c:pt idx="1779">
                  <c:v>80681.880065917969</c:v>
                </c:pt>
                <c:pt idx="1780">
                  <c:v>80690.456359863281</c:v>
                </c:pt>
                <c:pt idx="1781">
                  <c:v>80688.689758300781</c:v>
                </c:pt>
                <c:pt idx="1782">
                  <c:v>80676.780334472656</c:v>
                </c:pt>
                <c:pt idx="1783">
                  <c:v>80668.6708984375</c:v>
                </c:pt>
                <c:pt idx="1784">
                  <c:v>80677.561462402344</c:v>
                </c:pt>
                <c:pt idx="1785">
                  <c:v>80696.794860839844</c:v>
                </c:pt>
                <c:pt idx="1786">
                  <c:v>80709.171142578125</c:v>
                </c:pt>
                <c:pt idx="1787">
                  <c:v>80705.918823242188</c:v>
                </c:pt>
                <c:pt idx="1788">
                  <c:v>80695.152282714844</c:v>
                </c:pt>
                <c:pt idx="1789">
                  <c:v>80679.528503417969</c:v>
                </c:pt>
                <c:pt idx="1790">
                  <c:v>80663.504821777344</c:v>
                </c:pt>
                <c:pt idx="1791">
                  <c:v>80659.852478027344</c:v>
                </c:pt>
                <c:pt idx="1792">
                  <c:v>80668.943054199219</c:v>
                </c:pt>
                <c:pt idx="1793">
                  <c:v>80678.805053710938</c:v>
                </c:pt>
                <c:pt idx="1794">
                  <c:v>80685.209899902344</c:v>
                </c:pt>
                <c:pt idx="1795">
                  <c:v>80689.786193847656</c:v>
                </c:pt>
                <c:pt idx="1796">
                  <c:v>80692.448181152344</c:v>
                </c:pt>
                <c:pt idx="1797">
                  <c:v>80696.567260742188</c:v>
                </c:pt>
                <c:pt idx="1798">
                  <c:v>80706.486389160156</c:v>
                </c:pt>
                <c:pt idx="1799">
                  <c:v>80717.462707519531</c:v>
                </c:pt>
                <c:pt idx="1800">
                  <c:v>80728.49609375</c:v>
                </c:pt>
                <c:pt idx="1801">
                  <c:v>80739.786682128906</c:v>
                </c:pt>
                <c:pt idx="1802">
                  <c:v>80758.505798339844</c:v>
                </c:pt>
                <c:pt idx="1803">
                  <c:v>80792.224914550781</c:v>
                </c:pt>
                <c:pt idx="1804">
                  <c:v>80846.829772949219</c:v>
                </c:pt>
                <c:pt idx="1805">
                  <c:v>80907.634582519531</c:v>
                </c:pt>
                <c:pt idx="1806">
                  <c:v>80972.725158691406</c:v>
                </c:pt>
                <c:pt idx="1807">
                  <c:v>81042.6728515625</c:v>
                </c:pt>
                <c:pt idx="1808">
                  <c:v>81114.306274414063</c:v>
                </c:pt>
                <c:pt idx="1809">
                  <c:v>81173.9111328125</c:v>
                </c:pt>
                <c:pt idx="1810">
                  <c:v>81215.658813476563</c:v>
                </c:pt>
                <c:pt idx="1811">
                  <c:v>81229.520874023438</c:v>
                </c:pt>
                <c:pt idx="1812">
                  <c:v>81208.239990234375</c:v>
                </c:pt>
                <c:pt idx="1813">
                  <c:v>81161.416259765625</c:v>
                </c:pt>
                <c:pt idx="1814">
                  <c:v>81101.7353515625</c:v>
                </c:pt>
                <c:pt idx="1815">
                  <c:v>81029.511596679688</c:v>
                </c:pt>
                <c:pt idx="1816">
                  <c:v>80944.716491699219</c:v>
                </c:pt>
                <c:pt idx="1817">
                  <c:v>80859.378479003906</c:v>
                </c:pt>
                <c:pt idx="1818">
                  <c:v>80780.783325195313</c:v>
                </c:pt>
                <c:pt idx="1819">
                  <c:v>80718.959594726563</c:v>
                </c:pt>
                <c:pt idx="1820">
                  <c:v>80682.250122070313</c:v>
                </c:pt>
                <c:pt idx="1821">
                  <c:v>80663.483520507813</c:v>
                </c:pt>
                <c:pt idx="1822">
                  <c:v>80639.116943359375</c:v>
                </c:pt>
                <c:pt idx="1823">
                  <c:v>80614.378967285156</c:v>
                </c:pt>
                <c:pt idx="1824">
                  <c:v>80606.412353515625</c:v>
                </c:pt>
                <c:pt idx="1825">
                  <c:v>80615.017211914063</c:v>
                </c:pt>
                <c:pt idx="1826">
                  <c:v>80621.6220703125</c:v>
                </c:pt>
                <c:pt idx="1827">
                  <c:v>80618.712585449219</c:v>
                </c:pt>
                <c:pt idx="1828">
                  <c:v>80613.14599609375</c:v>
                </c:pt>
                <c:pt idx="1829">
                  <c:v>80607.465148925781</c:v>
                </c:pt>
                <c:pt idx="1830">
                  <c:v>80600.241455078125</c:v>
                </c:pt>
                <c:pt idx="1831">
                  <c:v>80587.531982421875</c:v>
                </c:pt>
                <c:pt idx="1832">
                  <c:v>80576.308288574219</c:v>
                </c:pt>
                <c:pt idx="1833">
                  <c:v>80568.570251464844</c:v>
                </c:pt>
                <c:pt idx="1834">
                  <c:v>80562.91796875</c:v>
                </c:pt>
                <c:pt idx="1835">
                  <c:v>80557.122802734375</c:v>
                </c:pt>
                <c:pt idx="1836">
                  <c:v>80550.927612304688</c:v>
                </c:pt>
                <c:pt idx="1837">
                  <c:v>80544.789611816406</c:v>
                </c:pt>
                <c:pt idx="1838">
                  <c:v>80544.423034667969</c:v>
                </c:pt>
                <c:pt idx="1839">
                  <c:v>80549.370727539063</c:v>
                </c:pt>
                <c:pt idx="1840">
                  <c:v>80549.661315917969</c:v>
                </c:pt>
                <c:pt idx="1841">
                  <c:v>80548.837585449219</c:v>
                </c:pt>
                <c:pt idx="1842">
                  <c:v>80549.613830566406</c:v>
                </c:pt>
                <c:pt idx="1843">
                  <c:v>80550.332946777344</c:v>
                </c:pt>
                <c:pt idx="1844">
                  <c:v>80545.166381835938</c:v>
                </c:pt>
                <c:pt idx="1845">
                  <c:v>80540.571228027344</c:v>
                </c:pt>
                <c:pt idx="1846">
                  <c:v>80534.461791992188</c:v>
                </c:pt>
                <c:pt idx="1847">
                  <c:v>80528.295227050781</c:v>
                </c:pt>
                <c:pt idx="1848">
                  <c:v>80526.928649902344</c:v>
                </c:pt>
                <c:pt idx="1849">
                  <c:v>80537.476318359375</c:v>
                </c:pt>
                <c:pt idx="1850">
                  <c:v>80553.195434570313</c:v>
                </c:pt>
                <c:pt idx="1851">
                  <c:v>80559.371704101563</c:v>
                </c:pt>
                <c:pt idx="1852">
                  <c:v>80552.233703613281</c:v>
                </c:pt>
                <c:pt idx="1853">
                  <c:v>80544.9814453125</c:v>
                </c:pt>
                <c:pt idx="1854">
                  <c:v>80542.557678222656</c:v>
                </c:pt>
                <c:pt idx="1855">
                  <c:v>80540.476806640625</c:v>
                </c:pt>
                <c:pt idx="1856">
                  <c:v>80544.053100585938</c:v>
                </c:pt>
                <c:pt idx="1857">
                  <c:v>80554.172241210938</c:v>
                </c:pt>
                <c:pt idx="1858">
                  <c:v>80551.8056640625</c:v>
                </c:pt>
                <c:pt idx="1859">
                  <c:v>80533.896179199219</c:v>
                </c:pt>
                <c:pt idx="1860">
                  <c:v>80522.815307617188</c:v>
                </c:pt>
                <c:pt idx="1861">
                  <c:v>80524.877319335938</c:v>
                </c:pt>
                <c:pt idx="1862">
                  <c:v>80525.482177734375</c:v>
                </c:pt>
                <c:pt idx="1863">
                  <c:v>80522.315551757813</c:v>
                </c:pt>
                <c:pt idx="1864">
                  <c:v>80520.777587890625</c:v>
                </c:pt>
                <c:pt idx="1865">
                  <c:v>80523.496704101563</c:v>
                </c:pt>
                <c:pt idx="1866">
                  <c:v>80520.958679199219</c:v>
                </c:pt>
                <c:pt idx="1867">
                  <c:v>80510.020660400391</c:v>
                </c:pt>
                <c:pt idx="1868">
                  <c:v>80494.082641601563</c:v>
                </c:pt>
                <c:pt idx="1869">
                  <c:v>80480.544647216797</c:v>
                </c:pt>
                <c:pt idx="1870">
                  <c:v>80463.635192871094</c:v>
                </c:pt>
                <c:pt idx="1871">
                  <c:v>80449.925750732422</c:v>
                </c:pt>
                <c:pt idx="1872">
                  <c:v>80444.102020263672</c:v>
                </c:pt>
                <c:pt idx="1873">
                  <c:v>80448.106872558594</c:v>
                </c:pt>
                <c:pt idx="1874">
                  <c:v>80452.140289306641</c:v>
                </c:pt>
                <c:pt idx="1875">
                  <c:v>80453.859405517578</c:v>
                </c:pt>
                <c:pt idx="1876">
                  <c:v>80447.492828369141</c:v>
                </c:pt>
                <c:pt idx="1877">
                  <c:v>80434.154815673828</c:v>
                </c:pt>
                <c:pt idx="1878">
                  <c:v>80424.073944091797</c:v>
                </c:pt>
                <c:pt idx="1879">
                  <c:v>80419.050231933594</c:v>
                </c:pt>
                <c:pt idx="1880">
                  <c:v>80410.797912597656</c:v>
                </c:pt>
                <c:pt idx="1881">
                  <c:v>80403.745635986328</c:v>
                </c:pt>
                <c:pt idx="1882">
                  <c:v>80404.8076171875</c:v>
                </c:pt>
                <c:pt idx="1883">
                  <c:v>80407.041015625</c:v>
                </c:pt>
                <c:pt idx="1884">
                  <c:v>80393.903015136719</c:v>
                </c:pt>
                <c:pt idx="1885">
                  <c:v>80379.993560791016</c:v>
                </c:pt>
                <c:pt idx="1886">
                  <c:v>80375.055572509766</c:v>
                </c:pt>
                <c:pt idx="1887">
                  <c:v>80379.6318359375</c:v>
                </c:pt>
                <c:pt idx="1888">
                  <c:v>80390.065246582031</c:v>
                </c:pt>
                <c:pt idx="1889">
                  <c:v>80401.984375</c:v>
                </c:pt>
                <c:pt idx="1890">
                  <c:v>80403.274932861328</c:v>
                </c:pt>
                <c:pt idx="1891">
                  <c:v>80393.765502929688</c:v>
                </c:pt>
                <c:pt idx="1892">
                  <c:v>80382.541778564453</c:v>
                </c:pt>
                <c:pt idx="1893">
                  <c:v>80371.403747558594</c:v>
                </c:pt>
                <c:pt idx="1894">
                  <c:v>80359.580017089844</c:v>
                </c:pt>
                <c:pt idx="1895">
                  <c:v>80353.842010498047</c:v>
                </c:pt>
                <c:pt idx="1896">
                  <c:v>80358.475433349609</c:v>
                </c:pt>
                <c:pt idx="1897">
                  <c:v>80369.765991210938</c:v>
                </c:pt>
                <c:pt idx="1898">
                  <c:v>80372.999389648438</c:v>
                </c:pt>
                <c:pt idx="1899">
                  <c:v>80364.547119140625</c:v>
                </c:pt>
                <c:pt idx="1900">
                  <c:v>80351.266235351563</c:v>
                </c:pt>
                <c:pt idx="1901">
                  <c:v>80342.099639892578</c:v>
                </c:pt>
                <c:pt idx="1902">
                  <c:v>80341.704498291016</c:v>
                </c:pt>
                <c:pt idx="1903">
                  <c:v>80344.023620605469</c:v>
                </c:pt>
                <c:pt idx="1904">
                  <c:v>80336.599884033203</c:v>
                </c:pt>
                <c:pt idx="1905">
                  <c:v>80319.747589111328</c:v>
                </c:pt>
                <c:pt idx="1906">
                  <c:v>80320.495300292969</c:v>
                </c:pt>
                <c:pt idx="1907">
                  <c:v>80346.100128173828</c:v>
                </c:pt>
                <c:pt idx="1908">
                  <c:v>80369.762115478516</c:v>
                </c:pt>
                <c:pt idx="1909">
                  <c:v>80371.024108886719</c:v>
                </c:pt>
                <c:pt idx="1910">
                  <c:v>80356.486114501953</c:v>
                </c:pt>
                <c:pt idx="1911">
                  <c:v>80341.976654052734</c:v>
                </c:pt>
                <c:pt idx="1912">
                  <c:v>80333.981506347656</c:v>
                </c:pt>
                <c:pt idx="1913">
                  <c:v>80333.214935302734</c:v>
                </c:pt>
                <c:pt idx="1914">
                  <c:v>80339.534057617188</c:v>
                </c:pt>
                <c:pt idx="1915">
                  <c:v>80347.28173828125</c:v>
                </c:pt>
                <c:pt idx="1916">
                  <c:v>80355.115173339844</c:v>
                </c:pt>
                <c:pt idx="1917">
                  <c:v>80358.177154541016</c:v>
                </c:pt>
                <c:pt idx="1918">
                  <c:v>80354.067718505859</c:v>
                </c:pt>
                <c:pt idx="1919">
                  <c:v>80342.758270263672</c:v>
                </c:pt>
                <c:pt idx="1920">
                  <c:v>80337.305969238281</c:v>
                </c:pt>
                <c:pt idx="1921">
                  <c:v>80345.539398193359</c:v>
                </c:pt>
                <c:pt idx="1922">
                  <c:v>80356.629943847656</c:v>
                </c:pt>
                <c:pt idx="1923">
                  <c:v>80358.377655029297</c:v>
                </c:pt>
                <c:pt idx="1924">
                  <c:v>80350.268218994141</c:v>
                </c:pt>
                <c:pt idx="1925">
                  <c:v>80341.587341308594</c:v>
                </c:pt>
                <c:pt idx="1926">
                  <c:v>80337.735046386719</c:v>
                </c:pt>
                <c:pt idx="1927">
                  <c:v>80341.139892578125</c:v>
                </c:pt>
                <c:pt idx="1928">
                  <c:v>80344.40185546875</c:v>
                </c:pt>
                <c:pt idx="1929">
                  <c:v>80341.635284423828</c:v>
                </c:pt>
                <c:pt idx="1930">
                  <c:v>80336.754425048828</c:v>
                </c:pt>
                <c:pt idx="1931">
                  <c:v>80341.102111816406</c:v>
                </c:pt>
                <c:pt idx="1932">
                  <c:v>80356.821258544922</c:v>
                </c:pt>
                <c:pt idx="1933">
                  <c:v>80373.740386962891</c:v>
                </c:pt>
                <c:pt idx="1934">
                  <c:v>80379.459503173828</c:v>
                </c:pt>
                <c:pt idx="1935">
                  <c:v>80378.321502685547</c:v>
                </c:pt>
                <c:pt idx="1936">
                  <c:v>80377.554901123047</c:v>
                </c:pt>
                <c:pt idx="1937">
                  <c:v>80373.445465087891</c:v>
                </c:pt>
                <c:pt idx="1938">
                  <c:v>80364.678894042969</c:v>
                </c:pt>
                <c:pt idx="1939">
                  <c:v>80355.626586914063</c:v>
                </c:pt>
                <c:pt idx="1940">
                  <c:v>80356.260009765625</c:v>
                </c:pt>
                <c:pt idx="1941">
                  <c:v>80365.664855957031</c:v>
                </c:pt>
                <c:pt idx="1942">
                  <c:v>80371.241119384766</c:v>
                </c:pt>
                <c:pt idx="1943">
                  <c:v>80364.245971679688</c:v>
                </c:pt>
                <c:pt idx="1944">
                  <c:v>80358.250793457031</c:v>
                </c:pt>
                <c:pt idx="1945">
                  <c:v>80367.884216308594</c:v>
                </c:pt>
                <c:pt idx="1946">
                  <c:v>80380.831909179688</c:v>
                </c:pt>
                <c:pt idx="1947">
                  <c:v>80385.808197021484</c:v>
                </c:pt>
                <c:pt idx="1948">
                  <c:v>80385.898742675781</c:v>
                </c:pt>
                <c:pt idx="1949">
                  <c:v>80392.989318847656</c:v>
                </c:pt>
                <c:pt idx="1950">
                  <c:v>80402.994140625</c:v>
                </c:pt>
                <c:pt idx="1951">
                  <c:v>80412.456146240234</c:v>
                </c:pt>
                <c:pt idx="1952">
                  <c:v>80418.718139648438</c:v>
                </c:pt>
                <c:pt idx="1953">
                  <c:v>80421.208679199219</c:v>
                </c:pt>
                <c:pt idx="1954">
                  <c:v>80416.870666503906</c:v>
                </c:pt>
                <c:pt idx="1955">
                  <c:v>80409.989807128906</c:v>
                </c:pt>
                <c:pt idx="1956">
                  <c:v>80410.823211669922</c:v>
                </c:pt>
                <c:pt idx="1957">
                  <c:v>80417.942352294922</c:v>
                </c:pt>
                <c:pt idx="1958">
                  <c:v>80421.547180175781</c:v>
                </c:pt>
                <c:pt idx="1959">
                  <c:v>80418.837738037109</c:v>
                </c:pt>
                <c:pt idx="1960">
                  <c:v>80416.58544921875</c:v>
                </c:pt>
                <c:pt idx="1961">
                  <c:v>80416.161712646484</c:v>
                </c:pt>
                <c:pt idx="1962">
                  <c:v>80416.766571044922</c:v>
                </c:pt>
                <c:pt idx="1963">
                  <c:v>80422.971405029297</c:v>
                </c:pt>
                <c:pt idx="1964">
                  <c:v>80431.919128417969</c:v>
                </c:pt>
                <c:pt idx="1965">
                  <c:v>80435.666809082031</c:v>
                </c:pt>
                <c:pt idx="1966">
                  <c:v>80435.814514160156</c:v>
                </c:pt>
                <c:pt idx="1967">
                  <c:v>80445.676513671875</c:v>
                </c:pt>
                <c:pt idx="1968">
                  <c:v>80456.081359863281</c:v>
                </c:pt>
                <c:pt idx="1969">
                  <c:v>80451.543334960938</c:v>
                </c:pt>
                <c:pt idx="1970">
                  <c:v>80434.519622802734</c:v>
                </c:pt>
                <c:pt idx="1971">
                  <c:v>80419.838745117188</c:v>
                </c:pt>
                <c:pt idx="1972">
                  <c:v>80414.900726318359</c:v>
                </c:pt>
                <c:pt idx="1973">
                  <c:v>80415.762725830078</c:v>
                </c:pt>
                <c:pt idx="1974">
                  <c:v>80423.367553710938</c:v>
                </c:pt>
                <c:pt idx="1975">
                  <c:v>80428.829559326172</c:v>
                </c:pt>
                <c:pt idx="1976">
                  <c:v>80427.548675537109</c:v>
                </c:pt>
                <c:pt idx="1977">
                  <c:v>80420.810668945313</c:v>
                </c:pt>
                <c:pt idx="1978">
                  <c:v>80414.786926269531</c:v>
                </c:pt>
                <c:pt idx="1979">
                  <c:v>80413.277496337891</c:v>
                </c:pt>
                <c:pt idx="1980">
                  <c:v>80416.139465332031</c:v>
                </c:pt>
                <c:pt idx="1981">
                  <c:v>80422.658599853516</c:v>
                </c:pt>
                <c:pt idx="1982">
                  <c:v>80426.663452148438</c:v>
                </c:pt>
                <c:pt idx="1983">
                  <c:v>80430.725433349609</c:v>
                </c:pt>
                <c:pt idx="1984">
                  <c:v>80435.244567871094</c:v>
                </c:pt>
                <c:pt idx="1985">
                  <c:v>80433.077972412109</c:v>
                </c:pt>
                <c:pt idx="1986">
                  <c:v>80422.82568359375</c:v>
                </c:pt>
                <c:pt idx="1987">
                  <c:v>80413.544830322266</c:v>
                </c:pt>
                <c:pt idx="1988">
                  <c:v>80409.835388183594</c:v>
                </c:pt>
                <c:pt idx="1989">
                  <c:v>80401.783081054688</c:v>
                </c:pt>
                <c:pt idx="1990">
                  <c:v>80398.616485595703</c:v>
                </c:pt>
                <c:pt idx="1991">
                  <c:v>80406.64990234375</c:v>
                </c:pt>
                <c:pt idx="1992">
                  <c:v>80424.483337402344</c:v>
                </c:pt>
                <c:pt idx="1993">
                  <c:v>80434.802459716797</c:v>
                </c:pt>
                <c:pt idx="1994">
                  <c:v>80435.721588134766</c:v>
                </c:pt>
                <c:pt idx="1995">
                  <c:v>80431.869293212891</c:v>
                </c:pt>
                <c:pt idx="1996">
                  <c:v>80426.502716064453</c:v>
                </c:pt>
                <c:pt idx="1997">
                  <c:v>80416.107543945313</c:v>
                </c:pt>
                <c:pt idx="1998">
                  <c:v>80409.969543457031</c:v>
                </c:pt>
                <c:pt idx="1999">
                  <c:v>80415.94580078125</c:v>
                </c:pt>
                <c:pt idx="2000">
                  <c:v>80428.06494140625</c:v>
                </c:pt>
                <c:pt idx="2001">
                  <c:v>80433.726928710938</c:v>
                </c:pt>
                <c:pt idx="2002">
                  <c:v>80433.074615478516</c:v>
                </c:pt>
                <c:pt idx="2003">
                  <c:v>80428.279479980469</c:v>
                </c:pt>
                <c:pt idx="2004">
                  <c:v>80422.255737304688</c:v>
                </c:pt>
                <c:pt idx="2005">
                  <c:v>80418.517730712891</c:v>
                </c:pt>
                <c:pt idx="2006">
                  <c:v>80419.493988037109</c:v>
                </c:pt>
                <c:pt idx="2007">
                  <c:v>80423.755981445313</c:v>
                </c:pt>
                <c:pt idx="2008">
                  <c:v>80428.617980957031</c:v>
                </c:pt>
                <c:pt idx="2009">
                  <c:v>80432.851379394531</c:v>
                </c:pt>
                <c:pt idx="2010">
                  <c:v>80437.799102783203</c:v>
                </c:pt>
                <c:pt idx="2011">
                  <c:v>80439.261077880859</c:v>
                </c:pt>
                <c:pt idx="2012">
                  <c:v>80438.751647949219</c:v>
                </c:pt>
                <c:pt idx="2013">
                  <c:v>80441.842193603516</c:v>
                </c:pt>
                <c:pt idx="2014">
                  <c:v>80444.361328125</c:v>
                </c:pt>
                <c:pt idx="2015">
                  <c:v>80432.651885986328</c:v>
                </c:pt>
                <c:pt idx="2016">
                  <c:v>80418.285308837891</c:v>
                </c:pt>
                <c:pt idx="2017">
                  <c:v>80422.090148925781</c:v>
                </c:pt>
                <c:pt idx="2018">
                  <c:v>80435.352142333984</c:v>
                </c:pt>
                <c:pt idx="2019">
                  <c:v>80441.585540771484</c:v>
                </c:pt>
                <c:pt idx="2020">
                  <c:v>80440.647521972656</c:v>
                </c:pt>
                <c:pt idx="2021">
                  <c:v>80440.566650390625</c:v>
                </c:pt>
                <c:pt idx="2022">
                  <c:v>80441.342926025391</c:v>
                </c:pt>
                <c:pt idx="2023">
                  <c:v>80444.233489990234</c:v>
                </c:pt>
                <c:pt idx="2024">
                  <c:v>80448.181182861328</c:v>
                </c:pt>
                <c:pt idx="2025">
                  <c:v>80454.043182373047</c:v>
                </c:pt>
                <c:pt idx="2026">
                  <c:v>80463.419464111328</c:v>
                </c:pt>
                <c:pt idx="2027">
                  <c:v>80473.395721435547</c:v>
                </c:pt>
                <c:pt idx="2028">
                  <c:v>80477.257720947266</c:v>
                </c:pt>
                <c:pt idx="2029">
                  <c:v>80473.176849365234</c:v>
                </c:pt>
                <c:pt idx="2030">
                  <c:v>80466.867401123047</c:v>
                </c:pt>
                <c:pt idx="2031">
                  <c:v>80471.015106201172</c:v>
                </c:pt>
                <c:pt idx="2032">
                  <c:v>80487.534240722656</c:v>
                </c:pt>
                <c:pt idx="2033">
                  <c:v>80506.796234130859</c:v>
                </c:pt>
                <c:pt idx="2034">
                  <c:v>80514.572509765625</c:v>
                </c:pt>
                <c:pt idx="2035">
                  <c:v>80512.377319335938</c:v>
                </c:pt>
                <c:pt idx="2036">
                  <c:v>80510.353607177734</c:v>
                </c:pt>
                <c:pt idx="2037">
                  <c:v>80515.387023925781</c:v>
                </c:pt>
                <c:pt idx="2038">
                  <c:v>80521.706176757813</c:v>
                </c:pt>
                <c:pt idx="2039">
                  <c:v>80523.310974121094</c:v>
                </c:pt>
                <c:pt idx="2040">
                  <c:v>80522.944396972656</c:v>
                </c:pt>
                <c:pt idx="2041">
                  <c:v>80526.177856445313</c:v>
                </c:pt>
                <c:pt idx="2042">
                  <c:v>80536.696960449219</c:v>
                </c:pt>
                <c:pt idx="2043">
                  <c:v>80548.787536621094</c:v>
                </c:pt>
                <c:pt idx="2044">
                  <c:v>80550.649536132813</c:v>
                </c:pt>
                <c:pt idx="2045">
                  <c:v>80533.997192382813</c:v>
                </c:pt>
                <c:pt idx="2046">
                  <c:v>80504.944915771484</c:v>
                </c:pt>
                <c:pt idx="2047">
                  <c:v>80476.206909179688</c:v>
                </c:pt>
                <c:pt idx="2048">
                  <c:v>80455.95458984375</c:v>
                </c:pt>
                <c:pt idx="2049">
                  <c:v>80449.159454345703</c:v>
                </c:pt>
                <c:pt idx="2050">
                  <c:v>80457.221435546875</c:v>
                </c:pt>
                <c:pt idx="2051">
                  <c:v>80471.197692871094</c:v>
                </c:pt>
                <c:pt idx="2052">
                  <c:v>80479.688262939453</c:v>
                </c:pt>
                <c:pt idx="2053">
                  <c:v>80488.950256347656</c:v>
                </c:pt>
                <c:pt idx="2054">
                  <c:v>80513.412231445313</c:v>
                </c:pt>
                <c:pt idx="2055">
                  <c:v>80551.874206542969</c:v>
                </c:pt>
                <c:pt idx="2056">
                  <c:v>80588.736206054688</c:v>
                </c:pt>
                <c:pt idx="2057">
                  <c:v>80612.226745605469</c:v>
                </c:pt>
                <c:pt idx="2058">
                  <c:v>80619.974487304688</c:v>
                </c:pt>
                <c:pt idx="2059">
                  <c:v>80617.150756835938</c:v>
                </c:pt>
                <c:pt idx="2060">
                  <c:v>80609.84130859375</c:v>
                </c:pt>
                <c:pt idx="2061">
                  <c:v>80601.617553710938</c:v>
                </c:pt>
                <c:pt idx="2062">
                  <c:v>80586.965270996094</c:v>
                </c:pt>
                <c:pt idx="2063">
                  <c:v>80559.31298828125</c:v>
                </c:pt>
                <c:pt idx="2064">
                  <c:v>80520.632080078125</c:v>
                </c:pt>
                <c:pt idx="2065">
                  <c:v>80487.522674560547</c:v>
                </c:pt>
                <c:pt idx="2066">
                  <c:v>80466.498931884766</c:v>
                </c:pt>
                <c:pt idx="2067">
                  <c:v>80445.646636962891</c:v>
                </c:pt>
                <c:pt idx="2068">
                  <c:v>80424.880065917969</c:v>
                </c:pt>
                <c:pt idx="2069">
                  <c:v>80422.399169921875</c:v>
                </c:pt>
                <c:pt idx="2070">
                  <c:v>80431.718322753906</c:v>
                </c:pt>
                <c:pt idx="2071">
                  <c:v>80429.180297851563</c:v>
                </c:pt>
                <c:pt idx="2072">
                  <c:v>80419.956573486328</c:v>
                </c:pt>
                <c:pt idx="2073">
                  <c:v>80422.618560791016</c:v>
                </c:pt>
                <c:pt idx="2074">
                  <c:v>80433.223388671875</c:v>
                </c:pt>
                <c:pt idx="2075">
                  <c:v>80432.656829833984</c:v>
                </c:pt>
                <c:pt idx="2076">
                  <c:v>80416.975952148438</c:v>
                </c:pt>
                <c:pt idx="2077">
                  <c:v>80393.923645019531</c:v>
                </c:pt>
                <c:pt idx="2078">
                  <c:v>80383.071350097656</c:v>
                </c:pt>
                <c:pt idx="2079">
                  <c:v>80388.504760742188</c:v>
                </c:pt>
                <c:pt idx="2080">
                  <c:v>80405.652465820313</c:v>
                </c:pt>
                <c:pt idx="2081">
                  <c:v>80442.028747558594</c:v>
                </c:pt>
                <c:pt idx="2082">
                  <c:v>80528.37646484375</c:v>
                </c:pt>
                <c:pt idx="2083">
                  <c:v>80692.238403320313</c:v>
                </c:pt>
                <c:pt idx="2084">
                  <c:v>80946.643249511719</c:v>
                </c:pt>
                <c:pt idx="2085">
                  <c:v>81321.562377929688</c:v>
                </c:pt>
                <c:pt idx="2086">
                  <c:v>81873.652954101563</c:v>
                </c:pt>
                <c:pt idx="2087">
                  <c:v>82671.572021484375</c:v>
                </c:pt>
                <c:pt idx="2088">
                  <c:v>83749.4912109375</c:v>
                </c:pt>
                <c:pt idx="2089">
                  <c:v>85113.43896484375</c:v>
                </c:pt>
                <c:pt idx="2090">
                  <c:v>86752.32958984375</c:v>
                </c:pt>
                <c:pt idx="2091">
                  <c:v>88623.048828125</c:v>
                </c:pt>
                <c:pt idx="2092">
                  <c:v>90619.396484375</c:v>
                </c:pt>
                <c:pt idx="2093">
                  <c:v>92592.4580078125</c:v>
                </c:pt>
                <c:pt idx="2094">
                  <c:v>94360.6630859375</c:v>
                </c:pt>
                <c:pt idx="2095">
                  <c:v>95732.7822265625</c:v>
                </c:pt>
                <c:pt idx="2096">
                  <c:v>96553.90234375</c:v>
                </c:pt>
                <c:pt idx="2097">
                  <c:v>96751.5625</c:v>
                </c:pt>
                <c:pt idx="2098">
                  <c:v>96310.9677734375</c:v>
                </c:pt>
                <c:pt idx="2099">
                  <c:v>95273.1728515625</c:v>
                </c:pt>
                <c:pt idx="2100">
                  <c:v>93751.091796875</c:v>
                </c:pt>
                <c:pt idx="2101">
                  <c:v>91915.611328125</c:v>
                </c:pt>
                <c:pt idx="2102">
                  <c:v>89938.55859375</c:v>
                </c:pt>
                <c:pt idx="2103">
                  <c:v>87982.62109375</c:v>
                </c:pt>
                <c:pt idx="2104">
                  <c:v>86186.05419921875</c:v>
                </c:pt>
                <c:pt idx="2105">
                  <c:v>84635.859375</c:v>
                </c:pt>
                <c:pt idx="2106">
                  <c:v>83365.064208984375</c:v>
                </c:pt>
                <c:pt idx="2107">
                  <c:v>82379.49755859375</c:v>
                </c:pt>
                <c:pt idx="2108">
                  <c:v>81661.388061523438</c:v>
                </c:pt>
                <c:pt idx="2109">
                  <c:v>81162.707275390625</c:v>
                </c:pt>
                <c:pt idx="2110">
                  <c:v>80832.797790527344</c:v>
                </c:pt>
                <c:pt idx="2111">
                  <c:v>80628.31689453125</c:v>
                </c:pt>
                <c:pt idx="2112">
                  <c:v>80506.436065673828</c:v>
                </c:pt>
                <c:pt idx="2113">
                  <c:v>80435.355194091797</c:v>
                </c:pt>
                <c:pt idx="2114">
                  <c:v>80392.702880859375</c:v>
                </c:pt>
                <c:pt idx="2115">
                  <c:v>80367.993438720703</c:v>
                </c:pt>
                <c:pt idx="2116">
                  <c:v>80344.912567138672</c:v>
                </c:pt>
                <c:pt idx="2117">
                  <c:v>80325.431701660156</c:v>
                </c:pt>
                <c:pt idx="2118">
                  <c:v>80313.750823974609</c:v>
                </c:pt>
                <c:pt idx="2119">
                  <c:v>80310.384246826172</c:v>
                </c:pt>
                <c:pt idx="2120">
                  <c:v>80309.331939697266</c:v>
                </c:pt>
                <c:pt idx="2121">
                  <c:v>80314.993927001953</c:v>
                </c:pt>
                <c:pt idx="2122">
                  <c:v>80323.055908203125</c:v>
                </c:pt>
                <c:pt idx="2123">
                  <c:v>80319.803619384766</c:v>
                </c:pt>
                <c:pt idx="2124">
                  <c:v>80302.722747802734</c:v>
                </c:pt>
                <c:pt idx="2125">
                  <c:v>80284.556182861328</c:v>
                </c:pt>
                <c:pt idx="2126">
                  <c:v>80281.046722412109</c:v>
                </c:pt>
                <c:pt idx="2127">
                  <c:v>80288.651580810547</c:v>
                </c:pt>
                <c:pt idx="2128">
                  <c:v>80294.484985351563</c:v>
                </c:pt>
                <c:pt idx="2129">
                  <c:v>80289.489837646484</c:v>
                </c:pt>
                <c:pt idx="2130">
                  <c:v>80281.008972167969</c:v>
                </c:pt>
                <c:pt idx="2131">
                  <c:v>80269.670959472656</c:v>
                </c:pt>
                <c:pt idx="2132">
                  <c:v>80253.732940673828</c:v>
                </c:pt>
                <c:pt idx="2133">
                  <c:v>80237.680633544922</c:v>
                </c:pt>
                <c:pt idx="2134">
                  <c:v>80237.514053344727</c:v>
                </c:pt>
                <c:pt idx="2135">
                  <c:v>80250.690322875977</c:v>
                </c:pt>
                <c:pt idx="2136">
                  <c:v>80257.523742675781</c:v>
                </c:pt>
                <c:pt idx="2137">
                  <c:v>80256.585723876953</c:v>
                </c:pt>
                <c:pt idx="2138">
                  <c:v>80255.619140625</c:v>
                </c:pt>
                <c:pt idx="2139">
                  <c:v>80250.338272094727</c:v>
                </c:pt>
                <c:pt idx="2140">
                  <c:v>80239.400253295898</c:v>
                </c:pt>
                <c:pt idx="2141">
                  <c:v>80232.747955322266</c:v>
                </c:pt>
                <c:pt idx="2142">
                  <c:v>80230.009948730469</c:v>
                </c:pt>
                <c:pt idx="2143">
                  <c:v>80223.300506591797</c:v>
                </c:pt>
                <c:pt idx="2144">
                  <c:v>80218.333923339844</c:v>
                </c:pt>
                <c:pt idx="2145">
                  <c:v>80219.824478149414</c:v>
                </c:pt>
                <c:pt idx="2146">
                  <c:v>80225.886474609375</c:v>
                </c:pt>
                <c:pt idx="2147">
                  <c:v>80227.291305541992</c:v>
                </c:pt>
                <c:pt idx="2148">
                  <c:v>80225.981872558594</c:v>
                </c:pt>
                <c:pt idx="2149">
                  <c:v>80228.415283203125</c:v>
                </c:pt>
                <c:pt idx="2150">
                  <c:v>80233.362991333008</c:v>
                </c:pt>
                <c:pt idx="2151">
                  <c:v>80228.196395874023</c:v>
                </c:pt>
                <c:pt idx="2152">
                  <c:v>80219.858383178711</c:v>
                </c:pt>
                <c:pt idx="2153">
                  <c:v>80218.920379638672</c:v>
                </c:pt>
                <c:pt idx="2154">
                  <c:v>80226.782363891602</c:v>
                </c:pt>
                <c:pt idx="2155">
                  <c:v>80225.130065917969</c:v>
                </c:pt>
                <c:pt idx="2156">
                  <c:v>80208.677764892578</c:v>
                </c:pt>
                <c:pt idx="2157">
                  <c:v>80197.282608032227</c:v>
                </c:pt>
                <c:pt idx="2158">
                  <c:v>80200.830307006836</c:v>
                </c:pt>
                <c:pt idx="2159">
                  <c:v>80207.692291259766</c:v>
                </c:pt>
                <c:pt idx="2160">
                  <c:v>80204.068572998047</c:v>
                </c:pt>
                <c:pt idx="2161">
                  <c:v>80197.873413085938</c:v>
                </c:pt>
                <c:pt idx="2162">
                  <c:v>80194.735397338867</c:v>
                </c:pt>
                <c:pt idx="2163">
                  <c:v>80196.168823242188</c:v>
                </c:pt>
                <c:pt idx="2164">
                  <c:v>80203.17366027832</c:v>
                </c:pt>
                <c:pt idx="2165">
                  <c:v>80210.949935913086</c:v>
                </c:pt>
                <c:pt idx="2166">
                  <c:v>80216.383346557617</c:v>
                </c:pt>
                <c:pt idx="2167">
                  <c:v>80220.359619140625</c:v>
                </c:pt>
                <c:pt idx="2168">
                  <c:v>80223.478759765625</c:v>
                </c:pt>
                <c:pt idx="2169">
                  <c:v>80222.312164306641</c:v>
                </c:pt>
                <c:pt idx="2170">
                  <c:v>80219.54557800293</c:v>
                </c:pt>
                <c:pt idx="2171">
                  <c:v>80221.807571411133</c:v>
                </c:pt>
                <c:pt idx="2172">
                  <c:v>80225.126693725586</c:v>
                </c:pt>
                <c:pt idx="2173">
                  <c:v>80227.502975463867</c:v>
                </c:pt>
                <c:pt idx="2174">
                  <c:v>80228.050674438477</c:v>
                </c:pt>
                <c:pt idx="2175">
                  <c:v>80225.598373413086</c:v>
                </c:pt>
                <c:pt idx="2176">
                  <c:v>80216.80322265625</c:v>
                </c:pt>
                <c:pt idx="2177">
                  <c:v>80208.036636352539</c:v>
                </c:pt>
                <c:pt idx="2178">
                  <c:v>80205.041473388672</c:v>
                </c:pt>
                <c:pt idx="2179">
                  <c:v>80214.246322631836</c:v>
                </c:pt>
                <c:pt idx="2180">
                  <c:v>80226.365447998047</c:v>
                </c:pt>
                <c:pt idx="2181">
                  <c:v>80232.513153076172</c:v>
                </c:pt>
                <c:pt idx="2182">
                  <c:v>80227.946578979492</c:v>
                </c:pt>
                <c:pt idx="2183">
                  <c:v>80218.637130737305</c:v>
                </c:pt>
                <c:pt idx="2184">
                  <c:v>80204.41340637207</c:v>
                </c:pt>
                <c:pt idx="2185">
                  <c:v>80192.189682006836</c:v>
                </c:pt>
                <c:pt idx="2186">
                  <c:v>80185.308807373047</c:v>
                </c:pt>
                <c:pt idx="2187">
                  <c:v>80182.6279296875</c:v>
                </c:pt>
                <c:pt idx="2188">
                  <c:v>80178.804214477539</c:v>
                </c:pt>
                <c:pt idx="2189">
                  <c:v>80178.151916503906</c:v>
                </c:pt>
                <c:pt idx="2190">
                  <c:v>80180.956756591797</c:v>
                </c:pt>
                <c:pt idx="2191">
                  <c:v>80186.618743896484</c:v>
                </c:pt>
                <c:pt idx="2192">
                  <c:v>80188.937866210938</c:v>
                </c:pt>
                <c:pt idx="2193">
                  <c:v>80187.685577392578</c:v>
                </c:pt>
                <c:pt idx="2194">
                  <c:v>80183.290420532227</c:v>
                </c:pt>
                <c:pt idx="2195">
                  <c:v>80177.123825073242</c:v>
                </c:pt>
                <c:pt idx="2196">
                  <c:v>80174.671539306641</c:v>
                </c:pt>
                <c:pt idx="2197">
                  <c:v>80182.104949951172</c:v>
                </c:pt>
                <c:pt idx="2198">
                  <c:v>80187.966934204102</c:v>
                </c:pt>
                <c:pt idx="2199">
                  <c:v>80184.714630126953</c:v>
                </c:pt>
                <c:pt idx="2200">
                  <c:v>80175.805191040039</c:v>
                </c:pt>
                <c:pt idx="2201">
                  <c:v>80175.838607788086</c:v>
                </c:pt>
                <c:pt idx="2202">
                  <c:v>80183.157745361328</c:v>
                </c:pt>
                <c:pt idx="2203">
                  <c:v>80193.591156005859</c:v>
                </c:pt>
                <c:pt idx="2204">
                  <c:v>80198.738861083984</c:v>
                </c:pt>
                <c:pt idx="2205">
                  <c:v>80194.315124511719</c:v>
                </c:pt>
                <c:pt idx="2206">
                  <c:v>80183.491409301758</c:v>
                </c:pt>
                <c:pt idx="2207">
                  <c:v>80172.096252441406</c:v>
                </c:pt>
                <c:pt idx="2208">
                  <c:v>80165.101089477539</c:v>
                </c:pt>
                <c:pt idx="2209">
                  <c:v>80167.47737121582</c:v>
                </c:pt>
                <c:pt idx="2210">
                  <c:v>80178.596496582031</c:v>
                </c:pt>
                <c:pt idx="2211">
                  <c:v>80188.944198608398</c:v>
                </c:pt>
                <c:pt idx="2212">
                  <c:v>80186.320465087891</c:v>
                </c:pt>
                <c:pt idx="2213">
                  <c:v>80177.353881835938</c:v>
                </c:pt>
                <c:pt idx="2214">
                  <c:v>80172.930160522461</c:v>
                </c:pt>
                <c:pt idx="2215">
                  <c:v>80175.706436157227</c:v>
                </c:pt>
                <c:pt idx="2216">
                  <c:v>80177.625564575195</c:v>
                </c:pt>
                <c:pt idx="2217">
                  <c:v>80178.144683837891</c:v>
                </c:pt>
                <c:pt idx="2218">
                  <c:v>80180.406677246094</c:v>
                </c:pt>
                <c:pt idx="2219">
                  <c:v>80183.982940673828</c:v>
                </c:pt>
                <c:pt idx="2220">
                  <c:v>80188.873504638672</c:v>
                </c:pt>
                <c:pt idx="2221">
                  <c:v>80189.764068603516</c:v>
                </c:pt>
                <c:pt idx="2222">
                  <c:v>80183.711761474609</c:v>
                </c:pt>
                <c:pt idx="2223">
                  <c:v>80173.288040161133</c:v>
                </c:pt>
                <c:pt idx="2224">
                  <c:v>80166.750030517578</c:v>
                </c:pt>
                <c:pt idx="2225">
                  <c:v>80166.269149780273</c:v>
                </c:pt>
                <c:pt idx="2226">
                  <c:v>80168.159713745117</c:v>
                </c:pt>
                <c:pt idx="2227">
                  <c:v>80171.221694946289</c:v>
                </c:pt>
                <c:pt idx="2228">
                  <c:v>80173.683685302734</c:v>
                </c:pt>
                <c:pt idx="2229">
                  <c:v>80177.802810668945</c:v>
                </c:pt>
                <c:pt idx="2230">
                  <c:v>80180.721954345703</c:v>
                </c:pt>
                <c:pt idx="2231">
                  <c:v>80179.441070556641</c:v>
                </c:pt>
                <c:pt idx="2232">
                  <c:v>80177.274490356445</c:v>
                </c:pt>
                <c:pt idx="2233">
                  <c:v>80176.165054321289</c:v>
                </c:pt>
                <c:pt idx="2234">
                  <c:v>80172.027038574219</c:v>
                </c:pt>
                <c:pt idx="2235">
                  <c:v>80163.860458374023</c:v>
                </c:pt>
                <c:pt idx="2236">
                  <c:v>80159.751007080078</c:v>
                </c:pt>
                <c:pt idx="2237">
                  <c:v>80159.527282714844</c:v>
                </c:pt>
                <c:pt idx="2238">
                  <c:v>80158.874984741211</c:v>
                </c:pt>
                <c:pt idx="2239">
                  <c:v>80158.079833984375</c:v>
                </c:pt>
                <c:pt idx="2240">
                  <c:v>80163.884674072266</c:v>
                </c:pt>
                <c:pt idx="2241">
                  <c:v>80171.603805541992</c:v>
                </c:pt>
                <c:pt idx="2242">
                  <c:v>80172.89436340332</c:v>
                </c:pt>
                <c:pt idx="2243">
                  <c:v>80168.670639038086</c:v>
                </c:pt>
                <c:pt idx="2244">
                  <c:v>80164.875473022461</c:v>
                </c:pt>
                <c:pt idx="2245">
                  <c:v>80171.0517578125</c:v>
                </c:pt>
                <c:pt idx="2246">
                  <c:v>80179.656600952148</c:v>
                </c:pt>
                <c:pt idx="2247">
                  <c:v>80178.975723266602</c:v>
                </c:pt>
                <c:pt idx="2248">
                  <c:v>80164.837707519531</c:v>
                </c:pt>
                <c:pt idx="2249">
                  <c:v>80153.69970703125</c:v>
                </c:pt>
                <c:pt idx="2250">
                  <c:v>80157.161682128906</c:v>
                </c:pt>
                <c:pt idx="2251">
                  <c:v>80169.623672485352</c:v>
                </c:pt>
                <c:pt idx="2252">
                  <c:v>80183.485656738281</c:v>
                </c:pt>
                <c:pt idx="2253">
                  <c:v>80187.319076538086</c:v>
                </c:pt>
                <c:pt idx="2254">
                  <c:v>80183.495346069336</c:v>
                </c:pt>
                <c:pt idx="2255">
                  <c:v>80175.614486694336</c:v>
                </c:pt>
                <c:pt idx="2256">
                  <c:v>80173.87646484375</c:v>
                </c:pt>
                <c:pt idx="2257">
                  <c:v>80179.081314086914</c:v>
                </c:pt>
                <c:pt idx="2258">
                  <c:v>80183.171875</c:v>
                </c:pt>
                <c:pt idx="2259">
                  <c:v>80175.262435913086</c:v>
                </c:pt>
                <c:pt idx="2260">
                  <c:v>80160.781555175781</c:v>
                </c:pt>
                <c:pt idx="2261">
                  <c:v>80155.443542480469</c:v>
                </c:pt>
                <c:pt idx="2262">
                  <c:v>80167.019821166992</c:v>
                </c:pt>
                <c:pt idx="2263">
                  <c:v>80188.167526245117</c:v>
                </c:pt>
                <c:pt idx="2264">
                  <c:v>80202.143798828125</c:v>
                </c:pt>
                <c:pt idx="2265">
                  <c:v>80197.748641967773</c:v>
                </c:pt>
                <c:pt idx="2266">
                  <c:v>80180.867767333984</c:v>
                </c:pt>
                <c:pt idx="2267">
                  <c:v>80168.529754638672</c:v>
                </c:pt>
                <c:pt idx="2268">
                  <c:v>80170.648880004883</c:v>
                </c:pt>
                <c:pt idx="2269">
                  <c:v>80180.339447021484</c:v>
                </c:pt>
                <c:pt idx="2270">
                  <c:v>80181.887145996094</c:v>
                </c:pt>
                <c:pt idx="2271">
                  <c:v>80173.091979980469</c:v>
                </c:pt>
                <c:pt idx="2272">
                  <c:v>80162.325408935547</c:v>
                </c:pt>
                <c:pt idx="2273">
                  <c:v>80153.530242919922</c:v>
                </c:pt>
                <c:pt idx="2274">
                  <c:v>80144.477951049805</c:v>
                </c:pt>
                <c:pt idx="2275">
                  <c:v>80137.597076416016</c:v>
                </c:pt>
                <c:pt idx="2276">
                  <c:v>80141.201919555664</c:v>
                </c:pt>
                <c:pt idx="2277">
                  <c:v>80159.29248046875</c:v>
                </c:pt>
                <c:pt idx="2278">
                  <c:v>80176.354461669922</c:v>
                </c:pt>
                <c:pt idx="2279">
                  <c:v>80177.416458129883</c:v>
                </c:pt>
                <c:pt idx="2280">
                  <c:v>80169.421295166016</c:v>
                </c:pt>
                <c:pt idx="2281">
                  <c:v>80168.997573852539</c:v>
                </c:pt>
                <c:pt idx="2282">
                  <c:v>80176.002410888672</c:v>
                </c:pt>
                <c:pt idx="2283">
                  <c:v>80184.921539306641</c:v>
                </c:pt>
                <c:pt idx="2284">
                  <c:v>80189.469253540039</c:v>
                </c:pt>
                <c:pt idx="2285">
                  <c:v>80186.702667236328</c:v>
                </c:pt>
                <c:pt idx="2286">
                  <c:v>80180.793228149414</c:v>
                </c:pt>
                <c:pt idx="2287">
                  <c:v>80177.998062133789</c:v>
                </c:pt>
                <c:pt idx="2288">
                  <c:v>80183.80290222168</c:v>
                </c:pt>
                <c:pt idx="2289">
                  <c:v>80194.750610351563</c:v>
                </c:pt>
                <c:pt idx="2290">
                  <c:v>80203.355453491211</c:v>
                </c:pt>
                <c:pt idx="2291">
                  <c:v>80202.188873291016</c:v>
                </c:pt>
                <c:pt idx="2292">
                  <c:v>80195.108001708984</c:v>
                </c:pt>
                <c:pt idx="2293">
                  <c:v>80195.769989013672</c:v>
                </c:pt>
                <c:pt idx="2294">
                  <c:v>80203.574829101563</c:v>
                </c:pt>
                <c:pt idx="2295">
                  <c:v>80203.808242797852</c:v>
                </c:pt>
                <c:pt idx="2296">
                  <c:v>80192.09880065918</c:v>
                </c:pt>
                <c:pt idx="2297">
                  <c:v>80185.789367675781</c:v>
                </c:pt>
                <c:pt idx="2298">
                  <c:v>80187.851348876953</c:v>
                </c:pt>
                <c:pt idx="2299">
                  <c:v>80185.456192016602</c:v>
                </c:pt>
                <c:pt idx="2300">
                  <c:v>80178.203903198242</c:v>
                </c:pt>
                <c:pt idx="2301">
                  <c:v>80176.037307739258</c:v>
                </c:pt>
                <c:pt idx="2302">
                  <c:v>80179.642150878906</c:v>
                </c:pt>
                <c:pt idx="2303">
                  <c:v>80187.389862060547</c:v>
                </c:pt>
                <c:pt idx="2304">
                  <c:v>80196.794708251953</c:v>
                </c:pt>
                <c:pt idx="2305">
                  <c:v>80203.170974731445</c:v>
                </c:pt>
                <c:pt idx="2306">
                  <c:v>80200.69010925293</c:v>
                </c:pt>
                <c:pt idx="2307">
                  <c:v>80193.694946289063</c:v>
                </c:pt>
                <c:pt idx="2308">
                  <c:v>80189.642654418945</c:v>
                </c:pt>
                <c:pt idx="2309">
                  <c:v>80188.84748840332</c:v>
                </c:pt>
                <c:pt idx="2310">
                  <c:v>80194.452331542969</c:v>
                </c:pt>
                <c:pt idx="2311">
                  <c:v>80205.114318847656</c:v>
                </c:pt>
                <c:pt idx="2312">
                  <c:v>80211.947738647461</c:v>
                </c:pt>
                <c:pt idx="2313">
                  <c:v>80207.238296508789</c:v>
                </c:pt>
                <c:pt idx="2314">
                  <c:v>80203.728851318359</c:v>
                </c:pt>
                <c:pt idx="2315">
                  <c:v>80207.647979736328</c:v>
                </c:pt>
                <c:pt idx="2316">
                  <c:v>80217.624252319336</c:v>
                </c:pt>
                <c:pt idx="2317">
                  <c:v>80229.029098510742</c:v>
                </c:pt>
                <c:pt idx="2318">
                  <c:v>80234.405380249023</c:v>
                </c:pt>
                <c:pt idx="2319">
                  <c:v>80227.695938110352</c:v>
                </c:pt>
                <c:pt idx="2320">
                  <c:v>80220.215057373047</c:v>
                </c:pt>
                <c:pt idx="2321">
                  <c:v>80216.505630493164</c:v>
                </c:pt>
                <c:pt idx="2322">
                  <c:v>80211.624755859375</c:v>
                </c:pt>
                <c:pt idx="2323">
                  <c:v>80207.629592895508</c:v>
                </c:pt>
                <c:pt idx="2324">
                  <c:v>80211.834442138672</c:v>
                </c:pt>
                <c:pt idx="2325">
                  <c:v>80220.639282226563</c:v>
                </c:pt>
                <c:pt idx="2326">
                  <c:v>80230.215560913086</c:v>
                </c:pt>
                <c:pt idx="2327">
                  <c:v>80237.248977661133</c:v>
                </c:pt>
                <c:pt idx="2328">
                  <c:v>80239.5966796875</c:v>
                </c:pt>
                <c:pt idx="2329">
                  <c:v>80240.915802001953</c:v>
                </c:pt>
                <c:pt idx="2330">
                  <c:v>80245.492080688477</c:v>
                </c:pt>
                <c:pt idx="2331">
                  <c:v>80242.782638549805</c:v>
                </c:pt>
                <c:pt idx="2332">
                  <c:v>80227.987487792969</c:v>
                </c:pt>
                <c:pt idx="2333">
                  <c:v>80215.849472045898</c:v>
                </c:pt>
                <c:pt idx="2334">
                  <c:v>80217.854309082031</c:v>
                </c:pt>
                <c:pt idx="2335">
                  <c:v>80229.430587768555</c:v>
                </c:pt>
                <c:pt idx="2336">
                  <c:v>80238.94970703125</c:v>
                </c:pt>
                <c:pt idx="2337">
                  <c:v>80240.211700439453</c:v>
                </c:pt>
                <c:pt idx="2338">
                  <c:v>80229.673690795898</c:v>
                </c:pt>
                <c:pt idx="2339">
                  <c:v>80215.935668945313</c:v>
                </c:pt>
                <c:pt idx="2340">
                  <c:v>80212.140518188477</c:v>
                </c:pt>
                <c:pt idx="2341">
                  <c:v>80219.545364379883</c:v>
                </c:pt>
                <c:pt idx="2342">
                  <c:v>80223.093063354492</c:v>
                </c:pt>
                <c:pt idx="2343">
                  <c:v>80217.926483154297</c:v>
                </c:pt>
                <c:pt idx="2344">
                  <c:v>80210.074188232422</c:v>
                </c:pt>
                <c:pt idx="2345">
                  <c:v>80205.250457763672</c:v>
                </c:pt>
                <c:pt idx="2346">
                  <c:v>80205.283874511719</c:v>
                </c:pt>
                <c:pt idx="2347">
                  <c:v>80212.774429321289</c:v>
                </c:pt>
                <c:pt idx="2348">
                  <c:v>80220.407836914063</c:v>
                </c:pt>
                <c:pt idx="2349">
                  <c:v>80219.32698059082</c:v>
                </c:pt>
                <c:pt idx="2350">
                  <c:v>80218.531814575195</c:v>
                </c:pt>
                <c:pt idx="2351">
                  <c:v>80227.822372436523</c:v>
                </c:pt>
                <c:pt idx="2352">
                  <c:v>80241.770080566406</c:v>
                </c:pt>
                <c:pt idx="2353">
                  <c:v>80244.517776489258</c:v>
                </c:pt>
                <c:pt idx="2354">
                  <c:v>80230.808334350586</c:v>
                </c:pt>
                <c:pt idx="2355">
                  <c:v>80217.184616088867</c:v>
                </c:pt>
                <c:pt idx="2356">
                  <c:v>80215.218032836914</c:v>
                </c:pt>
                <c:pt idx="2357">
                  <c:v>80217.994293212891</c:v>
                </c:pt>
                <c:pt idx="2358">
                  <c:v>80212.913421630859</c:v>
                </c:pt>
                <c:pt idx="2359">
                  <c:v>80209.089706420898</c:v>
                </c:pt>
                <c:pt idx="2360">
                  <c:v>80210.780258178711</c:v>
                </c:pt>
                <c:pt idx="2361">
                  <c:v>80212.756530761719</c:v>
                </c:pt>
                <c:pt idx="2362">
                  <c:v>80210.047088623047</c:v>
                </c:pt>
                <c:pt idx="2363">
                  <c:v>80210.394790649414</c:v>
                </c:pt>
                <c:pt idx="2364">
                  <c:v>80212.713928222656</c:v>
                </c:pt>
                <c:pt idx="2365">
                  <c:v>80220.090194702148</c:v>
                </c:pt>
                <c:pt idx="2366">
                  <c:v>80228.323608398438</c:v>
                </c:pt>
                <c:pt idx="2367">
                  <c:v>80231.099884033203</c:v>
                </c:pt>
                <c:pt idx="2368">
                  <c:v>80222.219009399414</c:v>
                </c:pt>
                <c:pt idx="2369">
                  <c:v>80209.538146972656</c:v>
                </c:pt>
                <c:pt idx="2370">
                  <c:v>80203.628707885742</c:v>
                </c:pt>
                <c:pt idx="2371">
                  <c:v>80207.490692138672</c:v>
                </c:pt>
                <c:pt idx="2372">
                  <c:v>80213.524108886719</c:v>
                </c:pt>
                <c:pt idx="2373">
                  <c:v>80208.328948974609</c:v>
                </c:pt>
                <c:pt idx="2374">
                  <c:v>80191.390930175781</c:v>
                </c:pt>
                <c:pt idx="2375">
                  <c:v>80184.31005859375</c:v>
                </c:pt>
                <c:pt idx="2376">
                  <c:v>80194.42919921875</c:v>
                </c:pt>
                <c:pt idx="2377">
                  <c:v>80207.691177368164</c:v>
                </c:pt>
                <c:pt idx="2378">
                  <c:v>80210.724594116211</c:v>
                </c:pt>
                <c:pt idx="2379">
                  <c:v>80216.015151977539</c:v>
                </c:pt>
                <c:pt idx="2380">
                  <c:v>80222.677139282227</c:v>
                </c:pt>
                <c:pt idx="2381">
                  <c:v>80219.139129638672</c:v>
                </c:pt>
                <c:pt idx="2382">
                  <c:v>80203.629684448242</c:v>
                </c:pt>
                <c:pt idx="2383">
                  <c:v>80193.005966186523</c:v>
                </c:pt>
                <c:pt idx="2384">
                  <c:v>80191.582229614258</c:v>
                </c:pt>
                <c:pt idx="2385">
                  <c:v>80193.444213867188</c:v>
                </c:pt>
                <c:pt idx="2386">
                  <c:v>80193.420486450195</c:v>
                </c:pt>
                <c:pt idx="2387">
                  <c:v>80190.682479858398</c:v>
                </c:pt>
                <c:pt idx="2388">
                  <c:v>80188.944473266602</c:v>
                </c:pt>
                <c:pt idx="2389">
                  <c:v>80185.806457519531</c:v>
                </c:pt>
                <c:pt idx="2390">
                  <c:v>80179.811294555664</c:v>
                </c:pt>
                <c:pt idx="2391">
                  <c:v>80171.930435180664</c:v>
                </c:pt>
                <c:pt idx="2392">
                  <c:v>80170.478134155273</c:v>
                </c:pt>
                <c:pt idx="2393">
                  <c:v>80178.254409790039</c:v>
                </c:pt>
                <c:pt idx="2394">
                  <c:v>80194.744964599609</c:v>
                </c:pt>
                <c:pt idx="2395">
                  <c:v>80205.806945800781</c:v>
                </c:pt>
                <c:pt idx="2396">
                  <c:v>80200.754653930664</c:v>
                </c:pt>
                <c:pt idx="2397">
                  <c:v>80186.359497070313</c:v>
                </c:pt>
                <c:pt idx="2398">
                  <c:v>80181.535766601563</c:v>
                </c:pt>
                <c:pt idx="2399">
                  <c:v>80190.997756958008</c:v>
                </c:pt>
                <c:pt idx="2400">
                  <c:v>80197.05973815918</c:v>
                </c:pt>
                <c:pt idx="2401">
                  <c:v>80187.693161010742</c:v>
                </c:pt>
                <c:pt idx="2402">
                  <c:v>80171.298004150391</c:v>
                </c:pt>
                <c:pt idx="2403">
                  <c:v>80165.702850341797</c:v>
                </c:pt>
                <c:pt idx="2404">
                  <c:v>80170.193405151367</c:v>
                </c:pt>
                <c:pt idx="2405">
                  <c:v>80177.026824951172</c:v>
                </c:pt>
                <c:pt idx="2406">
                  <c:v>80182.545944213867</c:v>
                </c:pt>
                <c:pt idx="2407">
                  <c:v>80184.065078735352</c:v>
                </c:pt>
                <c:pt idx="2408">
                  <c:v>80175.898498535156</c:v>
                </c:pt>
                <c:pt idx="2409">
                  <c:v>80168.53190612793</c:v>
                </c:pt>
                <c:pt idx="2410">
                  <c:v>80163.251037597656</c:v>
                </c:pt>
                <c:pt idx="2411">
                  <c:v>80156.45588684082</c:v>
                </c:pt>
                <c:pt idx="2412">
                  <c:v>80152.717864990234</c:v>
                </c:pt>
                <c:pt idx="2413">
                  <c:v>80160.494140625</c:v>
                </c:pt>
                <c:pt idx="2414">
                  <c:v>80167.784698486328</c:v>
                </c:pt>
                <c:pt idx="2415">
                  <c:v>80161.275253295898</c:v>
                </c:pt>
                <c:pt idx="2416">
                  <c:v>80152.9658203125</c:v>
                </c:pt>
                <c:pt idx="2417">
                  <c:v>80152.770660400391</c:v>
                </c:pt>
                <c:pt idx="2418">
                  <c:v>80156.946929931641</c:v>
                </c:pt>
                <c:pt idx="2419">
                  <c:v>80157.094635009766</c:v>
                </c:pt>
                <c:pt idx="2420">
                  <c:v>80153.042343139648</c:v>
                </c:pt>
                <c:pt idx="2421">
                  <c:v>80149.932891845703</c:v>
                </c:pt>
                <c:pt idx="2422">
                  <c:v>80151.137741088867</c:v>
                </c:pt>
                <c:pt idx="2423">
                  <c:v>80153.371154785156</c:v>
                </c:pt>
                <c:pt idx="2424">
                  <c:v>80150.747421264648</c:v>
                </c:pt>
                <c:pt idx="2425">
                  <c:v>80148.809417724609</c:v>
                </c:pt>
                <c:pt idx="2426">
                  <c:v>80149.871398925781</c:v>
                </c:pt>
                <c:pt idx="2427">
                  <c:v>80149.79052734375</c:v>
                </c:pt>
                <c:pt idx="2428">
                  <c:v>80144.766799926758</c:v>
                </c:pt>
                <c:pt idx="2429">
                  <c:v>80141.800216674805</c:v>
                </c:pt>
                <c:pt idx="2430">
                  <c:v>80140.890777587891</c:v>
                </c:pt>
                <c:pt idx="2431">
                  <c:v>80138.609909057617</c:v>
                </c:pt>
                <c:pt idx="2432">
                  <c:v>80131.61474609375</c:v>
                </c:pt>
                <c:pt idx="2433">
                  <c:v>80123.619598388672</c:v>
                </c:pt>
                <c:pt idx="2434">
                  <c:v>80120.91015625</c:v>
                </c:pt>
                <c:pt idx="2435">
                  <c:v>80122.172142028809</c:v>
                </c:pt>
                <c:pt idx="2436">
                  <c:v>80131.919845581055</c:v>
                </c:pt>
                <c:pt idx="2437">
                  <c:v>80145.924682617188</c:v>
                </c:pt>
                <c:pt idx="2438">
                  <c:v>80150.843811035156</c:v>
                </c:pt>
                <c:pt idx="2439">
                  <c:v>80141.905807495117</c:v>
                </c:pt>
                <c:pt idx="2440">
                  <c:v>80135.282073974609</c:v>
                </c:pt>
                <c:pt idx="2441">
                  <c:v>80134.486923217773</c:v>
                </c:pt>
                <c:pt idx="2442">
                  <c:v>80132.291763305664</c:v>
                </c:pt>
                <c:pt idx="2443">
                  <c:v>80129.296615600586</c:v>
                </c:pt>
                <c:pt idx="2444">
                  <c:v>80122.90145111084</c:v>
                </c:pt>
                <c:pt idx="2445">
                  <c:v>80115.677726745605</c:v>
                </c:pt>
                <c:pt idx="2446">
                  <c:v>80120.882568359375</c:v>
                </c:pt>
                <c:pt idx="2447">
                  <c:v>80138.115982055664</c:v>
                </c:pt>
                <c:pt idx="2448">
                  <c:v>80146.663681030273</c:v>
                </c:pt>
                <c:pt idx="2449">
                  <c:v>80139.268539428711</c:v>
                </c:pt>
                <c:pt idx="2450">
                  <c:v>80130.330520629883</c:v>
                </c:pt>
                <c:pt idx="2451">
                  <c:v>80130.078216552734</c:v>
                </c:pt>
                <c:pt idx="2452">
                  <c:v>80134.511642456055</c:v>
                </c:pt>
                <c:pt idx="2453">
                  <c:v>80133.859344482422</c:v>
                </c:pt>
                <c:pt idx="2454">
                  <c:v>80128.035614013672</c:v>
                </c:pt>
                <c:pt idx="2455">
                  <c:v>80125.35474395752</c:v>
                </c:pt>
                <c:pt idx="2456">
                  <c:v>80123.15958404541</c:v>
                </c:pt>
                <c:pt idx="2457">
                  <c:v>80117.392997741699</c:v>
                </c:pt>
                <c:pt idx="2458">
                  <c:v>80114.883560180664</c:v>
                </c:pt>
                <c:pt idx="2459">
                  <c:v>80124.602691650391</c:v>
                </c:pt>
                <c:pt idx="2460">
                  <c:v>80137.293243408203</c:v>
                </c:pt>
                <c:pt idx="2461">
                  <c:v>80137.869522094727</c:v>
                </c:pt>
                <c:pt idx="2462">
                  <c:v>80129.445785522461</c:v>
                </c:pt>
                <c:pt idx="2463">
                  <c:v>80120.907775878906</c:v>
                </c:pt>
                <c:pt idx="2464">
                  <c:v>80118.45548248291</c:v>
                </c:pt>
                <c:pt idx="2465">
                  <c:v>80120.688896179199</c:v>
                </c:pt>
                <c:pt idx="2466">
                  <c:v>80124.322311401367</c:v>
                </c:pt>
                <c:pt idx="2467">
                  <c:v>80124.555725097656</c:v>
                </c:pt>
                <c:pt idx="2468">
                  <c:v>80121.874855041504</c:v>
                </c:pt>
                <c:pt idx="2469">
                  <c:v>80120.708274841309</c:v>
                </c:pt>
                <c:pt idx="2470">
                  <c:v>80120.913116455078</c:v>
                </c:pt>
                <c:pt idx="2471">
                  <c:v>80121.803672790527</c:v>
                </c:pt>
                <c:pt idx="2472">
                  <c:v>80124.065658569336</c:v>
                </c:pt>
                <c:pt idx="2473">
                  <c:v>80128.470504760742</c:v>
                </c:pt>
                <c:pt idx="2474">
                  <c:v>80129.503921508789</c:v>
                </c:pt>
                <c:pt idx="2475">
                  <c:v>80127.708763122559</c:v>
                </c:pt>
                <c:pt idx="2476">
                  <c:v>80129.170745849609</c:v>
                </c:pt>
                <c:pt idx="2477">
                  <c:v>80138.404174804688</c:v>
                </c:pt>
                <c:pt idx="2478">
                  <c:v>80149.123306274414</c:v>
                </c:pt>
                <c:pt idx="2479">
                  <c:v>80155.27099609375</c:v>
                </c:pt>
                <c:pt idx="2480">
                  <c:v>80146.418701171875</c:v>
                </c:pt>
                <c:pt idx="2481">
                  <c:v>80123.794975280762</c:v>
                </c:pt>
                <c:pt idx="2482">
                  <c:v>80096.828392028809</c:v>
                </c:pt>
                <c:pt idx="2483">
                  <c:v>80084.204666137695</c:v>
                </c:pt>
                <c:pt idx="2484">
                  <c:v>80084.638076782227</c:v>
                </c:pt>
                <c:pt idx="2485">
                  <c:v>80092.442924499512</c:v>
                </c:pt>
                <c:pt idx="2486">
                  <c:v>80100.676338195801</c:v>
                </c:pt>
                <c:pt idx="2487">
                  <c:v>80109.424041748047</c:v>
                </c:pt>
                <c:pt idx="2488">
                  <c:v>80120.857452392578</c:v>
                </c:pt>
                <c:pt idx="2489">
                  <c:v>80132.17658996582</c:v>
                </c:pt>
                <c:pt idx="2490">
                  <c:v>80132.952850341797</c:v>
                </c:pt>
                <c:pt idx="2491">
                  <c:v>80124.843414306641</c:v>
                </c:pt>
                <c:pt idx="2492">
                  <c:v>80120.819686889648</c:v>
                </c:pt>
                <c:pt idx="2493">
                  <c:v>80123.853103637695</c:v>
                </c:pt>
                <c:pt idx="2494">
                  <c:v>80123.972236633301</c:v>
                </c:pt>
                <c:pt idx="2495">
                  <c:v>80117.977081298828</c:v>
                </c:pt>
                <c:pt idx="2496">
                  <c:v>80104.781921386719</c:v>
                </c:pt>
                <c:pt idx="2497">
                  <c:v>80091.986763000488</c:v>
                </c:pt>
                <c:pt idx="2498">
                  <c:v>80086.791610717773</c:v>
                </c:pt>
                <c:pt idx="2499">
                  <c:v>80094.425025939941</c:v>
                </c:pt>
                <c:pt idx="2500">
                  <c:v>80104.71558380127</c:v>
                </c:pt>
                <c:pt idx="2501">
                  <c:v>80110.320426940918</c:v>
                </c:pt>
                <c:pt idx="2502">
                  <c:v>80108.610984802246</c:v>
                </c:pt>
                <c:pt idx="2503">
                  <c:v>80104.15869140625</c:v>
                </c:pt>
                <c:pt idx="2504">
                  <c:v>80102.3349609375</c:v>
                </c:pt>
                <c:pt idx="2505">
                  <c:v>80101.082664489746</c:v>
                </c:pt>
                <c:pt idx="2506">
                  <c:v>80096.573219299316</c:v>
                </c:pt>
                <c:pt idx="2507">
                  <c:v>80089.692352294922</c:v>
                </c:pt>
                <c:pt idx="2508">
                  <c:v>80091.154335021973</c:v>
                </c:pt>
                <c:pt idx="2509">
                  <c:v>80106.902038574219</c:v>
                </c:pt>
                <c:pt idx="2510">
                  <c:v>80128.02116394043</c:v>
                </c:pt>
                <c:pt idx="2511">
                  <c:v>80137.226013183594</c:v>
                </c:pt>
                <c:pt idx="2512">
                  <c:v>80129.602279663086</c:v>
                </c:pt>
                <c:pt idx="2513">
                  <c:v>80115.83570098877</c:v>
                </c:pt>
                <c:pt idx="2514">
                  <c:v>80109.154830932617</c:v>
                </c:pt>
                <c:pt idx="2515">
                  <c:v>80112.245391845703</c:v>
                </c:pt>
                <c:pt idx="2516">
                  <c:v>80113.564521789551</c:v>
                </c:pt>
                <c:pt idx="2517">
                  <c:v>80106.597938537598</c:v>
                </c:pt>
                <c:pt idx="2518">
                  <c:v>80099.488494873047</c:v>
                </c:pt>
                <c:pt idx="2519">
                  <c:v>80097.921905517578</c:v>
                </c:pt>
                <c:pt idx="2520">
                  <c:v>80097.212471008301</c:v>
                </c:pt>
                <c:pt idx="2521">
                  <c:v>80097.560165405273</c:v>
                </c:pt>
                <c:pt idx="2522">
                  <c:v>80104.165016174316</c:v>
                </c:pt>
                <c:pt idx="2523">
                  <c:v>80109.198425292969</c:v>
                </c:pt>
                <c:pt idx="2524">
                  <c:v>80108.203269958496</c:v>
                </c:pt>
                <c:pt idx="2525">
                  <c:v>80110.950973510742</c:v>
                </c:pt>
                <c:pt idx="2526">
                  <c:v>80116.527244567871</c:v>
                </c:pt>
                <c:pt idx="2527">
                  <c:v>80117.389236450195</c:v>
                </c:pt>
                <c:pt idx="2528">
                  <c:v>80108.222648620605</c:v>
                </c:pt>
                <c:pt idx="2529">
                  <c:v>80096.113204956055</c:v>
                </c:pt>
                <c:pt idx="2530">
                  <c:v>80092.23233795166</c:v>
                </c:pt>
                <c:pt idx="2531">
                  <c:v>80099.665756225586</c:v>
                </c:pt>
                <c:pt idx="2532">
                  <c:v>80105.070594787598</c:v>
                </c:pt>
                <c:pt idx="2533">
                  <c:v>80098.789726257324</c:v>
                </c:pt>
                <c:pt idx="2534">
                  <c:v>80086.451713562012</c:v>
                </c:pt>
                <c:pt idx="2535">
                  <c:v>80079.285133361816</c:v>
                </c:pt>
                <c:pt idx="2536">
                  <c:v>80076.832832336426</c:v>
                </c:pt>
                <c:pt idx="2537">
                  <c:v>80078.409103393555</c:v>
                </c:pt>
                <c:pt idx="2538">
                  <c:v>80084.471092224121</c:v>
                </c:pt>
                <c:pt idx="2539">
                  <c:v>80094.447364807129</c:v>
                </c:pt>
                <c:pt idx="2540">
                  <c:v>80103.023635864258</c:v>
                </c:pt>
                <c:pt idx="2541">
                  <c:v>80101.914192199707</c:v>
                </c:pt>
                <c:pt idx="2542">
                  <c:v>80090.890464782715</c:v>
                </c:pt>
                <c:pt idx="2543">
                  <c:v>80083.981025695801</c:v>
                </c:pt>
                <c:pt idx="2544">
                  <c:v>80089.957298278809</c:v>
                </c:pt>
                <c:pt idx="2545">
                  <c:v>80097.876426696777</c:v>
                </c:pt>
                <c:pt idx="2546">
                  <c:v>80094.138412475586</c:v>
                </c:pt>
                <c:pt idx="2547">
                  <c:v>80088.486114501953</c:v>
                </c:pt>
                <c:pt idx="2548">
                  <c:v>80090.633819580078</c:v>
                </c:pt>
                <c:pt idx="2549">
                  <c:v>80092.495803833008</c:v>
                </c:pt>
                <c:pt idx="2550">
                  <c:v>80090.500648498535</c:v>
                </c:pt>
                <c:pt idx="2551">
                  <c:v>80095.819778442383</c:v>
                </c:pt>
                <c:pt idx="2552">
                  <c:v>80106.767478942871</c:v>
                </c:pt>
                <c:pt idx="2553">
                  <c:v>80105.515182495117</c:v>
                </c:pt>
                <c:pt idx="2554">
                  <c:v>80088.948600769043</c:v>
                </c:pt>
                <c:pt idx="2555">
                  <c:v>80077.353439331055</c:v>
                </c:pt>
                <c:pt idx="2556">
                  <c:v>80081.329711914063</c:v>
                </c:pt>
                <c:pt idx="2557">
                  <c:v>80096.30598449707</c:v>
                </c:pt>
                <c:pt idx="2558">
                  <c:v>80104.910827636719</c:v>
                </c:pt>
                <c:pt idx="2559">
                  <c:v>80097.915672302246</c:v>
                </c:pt>
                <c:pt idx="2560">
                  <c:v>80084.377662658691</c:v>
                </c:pt>
                <c:pt idx="2561">
                  <c:v>80081.125366210938</c:v>
                </c:pt>
                <c:pt idx="2562">
                  <c:v>80085.158782958984</c:v>
                </c:pt>
                <c:pt idx="2563">
                  <c:v>80083.477912902832</c:v>
                </c:pt>
                <c:pt idx="2564">
                  <c:v>80075.797035217285</c:v>
                </c:pt>
                <c:pt idx="2565">
                  <c:v>80075.97331237793</c:v>
                </c:pt>
                <c:pt idx="2566">
                  <c:v>80085.321014404297</c:v>
                </c:pt>
                <c:pt idx="2567">
                  <c:v>80092.611572265625</c:v>
                </c:pt>
                <c:pt idx="2568">
                  <c:v>80089.016418457031</c:v>
                </c:pt>
                <c:pt idx="2569">
                  <c:v>80078.878402709961</c:v>
                </c:pt>
                <c:pt idx="2570">
                  <c:v>80069.683250427246</c:v>
                </c:pt>
                <c:pt idx="2571">
                  <c:v>80065.288093566895</c:v>
                </c:pt>
                <c:pt idx="2572">
                  <c:v>80066.835792541504</c:v>
                </c:pt>
                <c:pt idx="2573">
                  <c:v>80069.412063598633</c:v>
                </c:pt>
                <c:pt idx="2574">
                  <c:v>80069.131195068359</c:v>
                </c:pt>
                <c:pt idx="2575">
                  <c:v>80069.650321960449</c:v>
                </c:pt>
                <c:pt idx="2576">
                  <c:v>80072.426597595215</c:v>
                </c:pt>
                <c:pt idx="2577">
                  <c:v>80073.660011291504</c:v>
                </c:pt>
                <c:pt idx="2578">
                  <c:v>80070.979141235352</c:v>
                </c:pt>
                <c:pt idx="2579">
                  <c:v>80066.126846313477</c:v>
                </c:pt>
                <c:pt idx="2580">
                  <c:v>80058.674545288086</c:v>
                </c:pt>
                <c:pt idx="2581">
                  <c:v>80054.279388427734</c:v>
                </c:pt>
                <c:pt idx="2582">
                  <c:v>80060.627090454102</c:v>
                </c:pt>
                <c:pt idx="2583">
                  <c:v>80068.631935119629</c:v>
                </c:pt>
                <c:pt idx="2584">
                  <c:v>80065.893920898438</c:v>
                </c:pt>
                <c:pt idx="2585">
                  <c:v>80061.384479522705</c:v>
                </c:pt>
                <c:pt idx="2586">
                  <c:v>80067.475036621094</c:v>
                </c:pt>
                <c:pt idx="2587">
                  <c:v>80077.22274017334</c:v>
                </c:pt>
                <c:pt idx="2588">
                  <c:v>80080.170440673828</c:v>
                </c:pt>
                <c:pt idx="2589">
                  <c:v>80078.518142700195</c:v>
                </c:pt>
                <c:pt idx="2590">
                  <c:v>80075.037269592285</c:v>
                </c:pt>
                <c:pt idx="2591">
                  <c:v>80067.242118835449</c:v>
                </c:pt>
                <c:pt idx="2592">
                  <c:v>80057.046962738037</c:v>
                </c:pt>
                <c:pt idx="2593">
                  <c:v>80050.280376434326</c:v>
                </c:pt>
                <c:pt idx="2594">
                  <c:v>80042.170936584473</c:v>
                </c:pt>
                <c:pt idx="2595">
                  <c:v>80036.575778961182</c:v>
                </c:pt>
                <c:pt idx="2596">
                  <c:v>80039.18062210083</c:v>
                </c:pt>
                <c:pt idx="2597">
                  <c:v>80051.442611694336</c:v>
                </c:pt>
                <c:pt idx="2598">
                  <c:v>80061.104598999023</c:v>
                </c:pt>
                <c:pt idx="2599">
                  <c:v>80059.223728179932</c:v>
                </c:pt>
                <c:pt idx="2600">
                  <c:v>80045.057144165039</c:v>
                </c:pt>
                <c:pt idx="2601">
                  <c:v>80033.719131469727</c:v>
                </c:pt>
                <c:pt idx="2602">
                  <c:v>80035.838260650635</c:v>
                </c:pt>
                <c:pt idx="2603">
                  <c:v>80049.214530944824</c:v>
                </c:pt>
                <c:pt idx="2604">
                  <c:v>80061.61937713623</c:v>
                </c:pt>
                <c:pt idx="2605">
                  <c:v>80066.709938049316</c:v>
                </c:pt>
                <c:pt idx="2606">
                  <c:v>80061.143352508545</c:v>
                </c:pt>
                <c:pt idx="2607">
                  <c:v>80050.319622039795</c:v>
                </c:pt>
                <c:pt idx="2608">
                  <c:v>80042.981609344482</c:v>
                </c:pt>
                <c:pt idx="2609">
                  <c:v>80036.757884979248</c:v>
                </c:pt>
                <c:pt idx="2610">
                  <c:v>80031.877012252808</c:v>
                </c:pt>
                <c:pt idx="2611">
                  <c:v>80030.996143341064</c:v>
                </c:pt>
                <c:pt idx="2612">
                  <c:v>80034.800987243652</c:v>
                </c:pt>
                <c:pt idx="2613">
                  <c:v>80037.377258300781</c:v>
                </c:pt>
                <c:pt idx="2614">
                  <c:v>80035.467819213867</c:v>
                </c:pt>
                <c:pt idx="2615">
                  <c:v>80035.815521240234</c:v>
                </c:pt>
                <c:pt idx="2616">
                  <c:v>80042.820362091064</c:v>
                </c:pt>
                <c:pt idx="2617">
                  <c:v>80056.45378112793</c:v>
                </c:pt>
                <c:pt idx="2618">
                  <c:v>80062.8014793396</c:v>
                </c:pt>
                <c:pt idx="2619">
                  <c:v>80056.263465881348</c:v>
                </c:pt>
                <c:pt idx="2620">
                  <c:v>80045.154026031494</c:v>
                </c:pt>
                <c:pt idx="2621">
                  <c:v>80045.616012573242</c:v>
                </c:pt>
                <c:pt idx="2622">
                  <c:v>80058.135143280029</c:v>
                </c:pt>
                <c:pt idx="2623">
                  <c:v>80062.425701141357</c:v>
                </c:pt>
                <c:pt idx="2624">
                  <c:v>80048.859115600586</c:v>
                </c:pt>
                <c:pt idx="2625">
                  <c:v>80037.692531585693</c:v>
                </c:pt>
                <c:pt idx="2626">
                  <c:v>80046.468803405762</c:v>
                </c:pt>
                <c:pt idx="2627">
                  <c:v>80060.730792999268</c:v>
                </c:pt>
                <c:pt idx="2628">
                  <c:v>80061.992778778076</c:v>
                </c:pt>
                <c:pt idx="2629">
                  <c:v>80055.140480041504</c:v>
                </c:pt>
                <c:pt idx="2630">
                  <c:v>80047.88818359375</c:v>
                </c:pt>
                <c:pt idx="2631">
                  <c:v>80041.350170135498</c:v>
                </c:pt>
                <c:pt idx="2632">
                  <c:v>80033.783584594727</c:v>
                </c:pt>
                <c:pt idx="2633">
                  <c:v>80029.102714538574</c:v>
                </c:pt>
                <c:pt idx="2634">
                  <c:v>80035.107559204102</c:v>
                </c:pt>
                <c:pt idx="2635">
                  <c:v>80047.083831787109</c:v>
                </c:pt>
                <c:pt idx="2636">
                  <c:v>80054.945819854736</c:v>
                </c:pt>
                <c:pt idx="2637">
                  <c:v>80055.322090148926</c:v>
                </c:pt>
                <c:pt idx="2638">
                  <c:v>80058.384078979492</c:v>
                </c:pt>
                <c:pt idx="2639">
                  <c:v>80064.446067810059</c:v>
                </c:pt>
                <c:pt idx="2640">
                  <c:v>80069.593765258789</c:v>
                </c:pt>
                <c:pt idx="2641">
                  <c:v>80070.141464233398</c:v>
                </c:pt>
                <c:pt idx="2642">
                  <c:v>80062.203453063965</c:v>
                </c:pt>
                <c:pt idx="2643">
                  <c:v>80040.036869049072</c:v>
                </c:pt>
                <c:pt idx="2644">
                  <c:v>80019.69885635376</c:v>
                </c:pt>
                <c:pt idx="2645">
                  <c:v>80021.560844421387</c:v>
                </c:pt>
                <c:pt idx="2646">
                  <c:v>80037.165687561035</c:v>
                </c:pt>
                <c:pt idx="2647">
                  <c:v>80049.484817504883</c:v>
                </c:pt>
                <c:pt idx="2648">
                  <c:v>80061.34680557251</c:v>
                </c:pt>
                <c:pt idx="2649">
                  <c:v>80073.580223083496</c:v>
                </c:pt>
                <c:pt idx="2650">
                  <c:v>80073.270782470703</c:v>
                </c:pt>
                <c:pt idx="2651">
                  <c:v>80060.504196166992</c:v>
                </c:pt>
                <c:pt idx="2652">
                  <c:v>80047.50904083252</c:v>
                </c:pt>
                <c:pt idx="2653">
                  <c:v>80044.628170013428</c:v>
                </c:pt>
                <c:pt idx="2654">
                  <c:v>80048.290157318115</c:v>
                </c:pt>
                <c:pt idx="2655">
                  <c:v>80048.095001220703</c:v>
                </c:pt>
                <c:pt idx="2656">
                  <c:v>80036.728416442871</c:v>
                </c:pt>
                <c:pt idx="2657">
                  <c:v>80027.418973922729</c:v>
                </c:pt>
                <c:pt idx="2658">
                  <c:v>80032.595245361328</c:v>
                </c:pt>
                <c:pt idx="2659">
                  <c:v>80050.257232666016</c:v>
                </c:pt>
                <c:pt idx="2660">
                  <c:v>80064.004936218262</c:v>
                </c:pt>
                <c:pt idx="2661">
                  <c:v>80065.095497131348</c:v>
                </c:pt>
                <c:pt idx="2662">
                  <c:v>80057.386051177979</c:v>
                </c:pt>
                <c:pt idx="2663">
                  <c:v>80048.905181884766</c:v>
                </c:pt>
                <c:pt idx="2664">
                  <c:v>80045.395740509033</c:v>
                </c:pt>
                <c:pt idx="2665">
                  <c:v>80049.172012329102</c:v>
                </c:pt>
                <c:pt idx="2666">
                  <c:v>80051.862571716309</c:v>
                </c:pt>
                <c:pt idx="2667">
                  <c:v>80048.095985412598</c:v>
                </c:pt>
                <c:pt idx="2668">
                  <c:v>80039.672260284424</c:v>
                </c:pt>
                <c:pt idx="2669">
                  <c:v>80030.505676269531</c:v>
                </c:pt>
                <c:pt idx="2670">
                  <c:v>80023.2819480896</c:v>
                </c:pt>
                <c:pt idx="2671">
                  <c:v>80027.172506332397</c:v>
                </c:pt>
                <c:pt idx="2672">
                  <c:v>80039.091636657715</c:v>
                </c:pt>
                <c:pt idx="2673">
                  <c:v>80044.467910766602</c:v>
                </c:pt>
                <c:pt idx="2674">
                  <c:v>80044.90132522583</c:v>
                </c:pt>
                <c:pt idx="2675">
                  <c:v>80048.906169891357</c:v>
                </c:pt>
                <c:pt idx="2676">
                  <c:v>80051.225299835205</c:v>
                </c:pt>
                <c:pt idx="2677">
                  <c:v>80047.744426727295</c:v>
                </c:pt>
                <c:pt idx="2678">
                  <c:v>80040.634986877441</c:v>
                </c:pt>
                <c:pt idx="2679">
                  <c:v>80035.696975708008</c:v>
                </c:pt>
                <c:pt idx="2680">
                  <c:v>80031.358961105347</c:v>
                </c:pt>
                <c:pt idx="2681">
                  <c:v>80025.306661605835</c:v>
                </c:pt>
                <c:pt idx="2682">
                  <c:v>80020.082935333252</c:v>
                </c:pt>
                <c:pt idx="2683">
                  <c:v>80027.60206413269</c:v>
                </c:pt>
                <c:pt idx="2684">
                  <c:v>80046.178337097168</c:v>
                </c:pt>
                <c:pt idx="2685">
                  <c:v>80058.526039123535</c:v>
                </c:pt>
                <c:pt idx="2686">
                  <c:v>80056.988025665283</c:v>
                </c:pt>
                <c:pt idx="2687">
                  <c:v>80045.907154083252</c:v>
                </c:pt>
                <c:pt idx="2688">
                  <c:v>80034.026287078857</c:v>
                </c:pt>
                <c:pt idx="2689">
                  <c:v>80027.316844940186</c:v>
                </c:pt>
                <c:pt idx="2690">
                  <c:v>80030.578830718994</c:v>
                </c:pt>
                <c:pt idx="2691">
                  <c:v>80039.81224822998</c:v>
                </c:pt>
                <c:pt idx="2692">
                  <c:v>80054.50280380249</c:v>
                </c:pt>
                <c:pt idx="2693">
                  <c:v>80061.479076385498</c:v>
                </c:pt>
                <c:pt idx="2694">
                  <c:v>80054.112491607666</c:v>
                </c:pt>
                <c:pt idx="2695">
                  <c:v>80035.660194396973</c:v>
                </c:pt>
                <c:pt idx="2696">
                  <c:v>80018.97932434082</c:v>
                </c:pt>
                <c:pt idx="2697">
                  <c:v>80016.984169006348</c:v>
                </c:pt>
                <c:pt idx="2698">
                  <c:v>80030.560441970825</c:v>
                </c:pt>
                <c:pt idx="2699">
                  <c:v>80044.536712646484</c:v>
                </c:pt>
                <c:pt idx="2700">
                  <c:v>80044.427272796631</c:v>
                </c:pt>
                <c:pt idx="2701">
                  <c:v>80035.689258575439</c:v>
                </c:pt>
                <c:pt idx="2702">
                  <c:v>80030.922676086426</c:v>
                </c:pt>
                <c:pt idx="2703">
                  <c:v>80031.327520370483</c:v>
                </c:pt>
                <c:pt idx="2704">
                  <c:v>80034.618076324463</c:v>
                </c:pt>
                <c:pt idx="2705">
                  <c:v>80041.394351959229</c:v>
                </c:pt>
                <c:pt idx="2706">
                  <c:v>80045.599193572998</c:v>
                </c:pt>
                <c:pt idx="2707">
                  <c:v>80046.375469207764</c:v>
                </c:pt>
                <c:pt idx="2708">
                  <c:v>80047.637454986572</c:v>
                </c:pt>
                <c:pt idx="2709">
                  <c:v>80053.95658493042</c:v>
                </c:pt>
                <c:pt idx="2710">
                  <c:v>80053.647144317627</c:v>
                </c:pt>
                <c:pt idx="2711">
                  <c:v>80039.680557250977</c:v>
                </c:pt>
                <c:pt idx="2712">
                  <c:v>80021.799688339233</c:v>
                </c:pt>
                <c:pt idx="2713">
                  <c:v>80013.461675643921</c:v>
                </c:pt>
                <c:pt idx="2714">
                  <c:v>80020.666519165039</c:v>
                </c:pt>
                <c:pt idx="2715">
                  <c:v>80038.557079315186</c:v>
                </c:pt>
                <c:pt idx="2716">
                  <c:v>80052.047637939453</c:v>
                </c:pt>
                <c:pt idx="2717">
                  <c:v>80051.509624481201</c:v>
                </c:pt>
                <c:pt idx="2718">
                  <c:v>80045.543037414551</c:v>
                </c:pt>
                <c:pt idx="2719">
                  <c:v>80045.976455688477</c:v>
                </c:pt>
                <c:pt idx="2720">
                  <c:v>80048.181297302246</c:v>
                </c:pt>
                <c:pt idx="2721">
                  <c:v>80043.386142730713</c:v>
                </c:pt>
                <c:pt idx="2722">
                  <c:v>80036.87670135498</c:v>
                </c:pt>
                <c:pt idx="2723">
                  <c:v>80039.281543731689</c:v>
                </c:pt>
                <c:pt idx="2724">
                  <c:v>80050.743534088135</c:v>
                </c:pt>
                <c:pt idx="2725">
                  <c:v>80056.462661743164</c:v>
                </c:pt>
                <c:pt idx="2726">
                  <c:v>80052.38179397583</c:v>
                </c:pt>
                <c:pt idx="2727">
                  <c:v>80053.129493713379</c:v>
                </c:pt>
                <c:pt idx="2728">
                  <c:v>80057.191478729248</c:v>
                </c:pt>
                <c:pt idx="2729">
                  <c:v>80054.139183044434</c:v>
                </c:pt>
                <c:pt idx="2730">
                  <c:v>80044.915454864502</c:v>
                </c:pt>
                <c:pt idx="2731">
                  <c:v>80043.34886932373</c:v>
                </c:pt>
                <c:pt idx="2732">
                  <c:v>80049.810855865479</c:v>
                </c:pt>
                <c:pt idx="2733">
                  <c:v>80061.015701293945</c:v>
                </c:pt>
                <c:pt idx="2734">
                  <c:v>80068.249114990234</c:v>
                </c:pt>
                <c:pt idx="2735">
                  <c:v>80063.139675140381</c:v>
                </c:pt>
                <c:pt idx="2736">
                  <c:v>80044.658805847168</c:v>
                </c:pt>
                <c:pt idx="2737">
                  <c:v>80028.463649749756</c:v>
                </c:pt>
                <c:pt idx="2738">
                  <c:v>80029.811349868774</c:v>
                </c:pt>
                <c:pt idx="2739">
                  <c:v>80046.273338317871</c:v>
                </c:pt>
                <c:pt idx="2740">
                  <c:v>80055.078182220459</c:v>
                </c:pt>
                <c:pt idx="2741">
                  <c:v>80049.597312927246</c:v>
                </c:pt>
                <c:pt idx="2742">
                  <c:v>80037.716442108154</c:v>
                </c:pt>
                <c:pt idx="2743">
                  <c:v>80031.635570526123</c:v>
                </c:pt>
                <c:pt idx="2744">
                  <c:v>80034.268985748291</c:v>
                </c:pt>
                <c:pt idx="2745">
                  <c:v>80040.959545135498</c:v>
                </c:pt>
                <c:pt idx="2746">
                  <c:v>80040.164390563965</c:v>
                </c:pt>
                <c:pt idx="2747">
                  <c:v>80038.712089538574</c:v>
                </c:pt>
                <c:pt idx="2748">
                  <c:v>80042.888362884521</c:v>
                </c:pt>
                <c:pt idx="2749">
                  <c:v>80047.721778869629</c:v>
                </c:pt>
                <c:pt idx="2750">
                  <c:v>80044.612339019775</c:v>
                </c:pt>
                <c:pt idx="2751">
                  <c:v>80044.788608551025</c:v>
                </c:pt>
                <c:pt idx="2752">
                  <c:v>80048.707740783691</c:v>
                </c:pt>
                <c:pt idx="2753">
                  <c:v>80052.8268699646</c:v>
                </c:pt>
                <c:pt idx="2754">
                  <c:v>80052.060287475586</c:v>
                </c:pt>
                <c:pt idx="2755">
                  <c:v>80050.550842285156</c:v>
                </c:pt>
                <c:pt idx="2756">
                  <c:v>80051.612831115723</c:v>
                </c:pt>
                <c:pt idx="2757">
                  <c:v>80053.47481918335</c:v>
                </c:pt>
                <c:pt idx="2758">
                  <c:v>80051.479663848877</c:v>
                </c:pt>
                <c:pt idx="2759">
                  <c:v>80047.713077545166</c:v>
                </c:pt>
                <c:pt idx="2760">
                  <c:v>80048.117923736572</c:v>
                </c:pt>
                <c:pt idx="2761">
                  <c:v>80053.865623474121</c:v>
                </c:pt>
                <c:pt idx="2762">
                  <c:v>80061.12760925293</c:v>
                </c:pt>
                <c:pt idx="2763">
                  <c:v>80058.961025238037</c:v>
                </c:pt>
                <c:pt idx="2764">
                  <c:v>80050.880157470703</c:v>
                </c:pt>
                <c:pt idx="2765">
                  <c:v>80050.170715332031</c:v>
                </c:pt>
                <c:pt idx="2766">
                  <c:v>80061.06127166748</c:v>
                </c:pt>
                <c:pt idx="2767">
                  <c:v>80068.26611328125</c:v>
                </c:pt>
                <c:pt idx="2768">
                  <c:v>80072.156677246094</c:v>
                </c:pt>
                <c:pt idx="2769">
                  <c:v>80075.761520385742</c:v>
                </c:pt>
                <c:pt idx="2770">
                  <c:v>80074.537796020508</c:v>
                </c:pt>
                <c:pt idx="2771">
                  <c:v>80064.714065551758</c:v>
                </c:pt>
                <c:pt idx="2772">
                  <c:v>80055.347480773926</c:v>
                </c:pt>
                <c:pt idx="2773">
                  <c:v>80050.923751831055</c:v>
                </c:pt>
                <c:pt idx="2774">
                  <c:v>80044.757167816162</c:v>
                </c:pt>
                <c:pt idx="2775">
                  <c:v>80035.87629699707</c:v>
                </c:pt>
                <c:pt idx="2776">
                  <c:v>80029.538286209106</c:v>
                </c:pt>
                <c:pt idx="2777">
                  <c:v>80029.828844070435</c:v>
                </c:pt>
                <c:pt idx="2778">
                  <c:v>80034.205116271973</c:v>
                </c:pt>
                <c:pt idx="2779">
                  <c:v>80039.295677185059</c:v>
                </c:pt>
                <c:pt idx="2780">
                  <c:v>80042.614803314209</c:v>
                </c:pt>
                <c:pt idx="2781">
                  <c:v>80040.676792144775</c:v>
                </c:pt>
                <c:pt idx="2782">
                  <c:v>80036.681636810303</c:v>
                </c:pt>
                <c:pt idx="2783">
                  <c:v>80043.17219543457</c:v>
                </c:pt>
                <c:pt idx="2784">
                  <c:v>80052.577037811279</c:v>
                </c:pt>
                <c:pt idx="2785">
                  <c:v>80052.124740600586</c:v>
                </c:pt>
                <c:pt idx="2786">
                  <c:v>80045.815299987793</c:v>
                </c:pt>
                <c:pt idx="2787">
                  <c:v>80051.763000488281</c:v>
                </c:pt>
                <c:pt idx="2788">
                  <c:v>80062.939273834229</c:v>
                </c:pt>
                <c:pt idx="2789">
                  <c:v>80064.801261901855</c:v>
                </c:pt>
                <c:pt idx="2790">
                  <c:v>80059.748962402344</c:v>
                </c:pt>
                <c:pt idx="2791">
                  <c:v>80058.039520263672</c:v>
                </c:pt>
                <c:pt idx="2792">
                  <c:v>80055.758647918701</c:v>
                </c:pt>
                <c:pt idx="2793">
                  <c:v>80050.649208068848</c:v>
                </c:pt>
                <c:pt idx="2794">
                  <c:v>80043.996910095215</c:v>
                </c:pt>
                <c:pt idx="2795">
                  <c:v>80038.430324554443</c:v>
                </c:pt>
                <c:pt idx="2796">
                  <c:v>80032.206596374512</c:v>
                </c:pt>
                <c:pt idx="2797">
                  <c:v>80034.925727844238</c:v>
                </c:pt>
                <c:pt idx="2798">
                  <c:v>80045.444858551025</c:v>
                </c:pt>
                <c:pt idx="2799">
                  <c:v>80053.535415649414</c:v>
                </c:pt>
                <c:pt idx="2800">
                  <c:v>80051.197402954102</c:v>
                </c:pt>
                <c:pt idx="2801">
                  <c:v>80045.48796081543</c:v>
                </c:pt>
                <c:pt idx="2802">
                  <c:v>80040.292804718018</c:v>
                </c:pt>
                <c:pt idx="2803">
                  <c:v>80034.726219177246</c:v>
                </c:pt>
                <c:pt idx="2804">
                  <c:v>80026.473922729492</c:v>
                </c:pt>
                <c:pt idx="2805">
                  <c:v>80021.5930519104</c:v>
                </c:pt>
                <c:pt idx="2806">
                  <c:v>80025.197896957397</c:v>
                </c:pt>
                <c:pt idx="2807">
                  <c:v>80037.774169921875</c:v>
                </c:pt>
                <c:pt idx="2808">
                  <c:v>80049.093299865723</c:v>
                </c:pt>
                <c:pt idx="2809">
                  <c:v>80057.726715087891</c:v>
                </c:pt>
                <c:pt idx="2810">
                  <c:v>80060.96012878418</c:v>
                </c:pt>
                <c:pt idx="2811">
                  <c:v>80058.679260253906</c:v>
                </c:pt>
                <c:pt idx="2812">
                  <c:v>80050.798389434814</c:v>
                </c:pt>
                <c:pt idx="2813">
                  <c:v>80045.517520904541</c:v>
                </c:pt>
                <c:pt idx="2814">
                  <c:v>80043.865219116211</c:v>
                </c:pt>
                <c:pt idx="2815">
                  <c:v>80050.384349822998</c:v>
                </c:pt>
                <c:pt idx="2816">
                  <c:v>80063.017765045166</c:v>
                </c:pt>
                <c:pt idx="2817">
                  <c:v>80060.851181030273</c:v>
                </c:pt>
                <c:pt idx="2818">
                  <c:v>80039.22745513916</c:v>
                </c:pt>
                <c:pt idx="2819">
                  <c:v>80022.718013763428</c:v>
                </c:pt>
                <c:pt idx="2820">
                  <c:v>80029.551427841187</c:v>
                </c:pt>
                <c:pt idx="2821">
                  <c:v>80040.641986846924</c:v>
                </c:pt>
                <c:pt idx="2822">
                  <c:v>80042.103973388672</c:v>
                </c:pt>
                <c:pt idx="2823">
                  <c:v>80040.965961456299</c:v>
                </c:pt>
                <c:pt idx="2824">
                  <c:v>80047.256519317627</c:v>
                </c:pt>
                <c:pt idx="2825">
                  <c:v>80049.632793426514</c:v>
                </c:pt>
                <c:pt idx="2826">
                  <c:v>80037.494777679443</c:v>
                </c:pt>
                <c:pt idx="2827">
                  <c:v>80020.38533782959</c:v>
                </c:pt>
                <c:pt idx="2828">
                  <c:v>80020.675895690918</c:v>
                </c:pt>
                <c:pt idx="2829">
                  <c:v>80036.709312438965</c:v>
                </c:pt>
                <c:pt idx="2830">
                  <c:v>80048.142726898193</c:v>
                </c:pt>
                <c:pt idx="2831">
                  <c:v>80045.461856842041</c:v>
                </c:pt>
                <c:pt idx="2832">
                  <c:v>80046.638130187988</c:v>
                </c:pt>
                <c:pt idx="2833">
                  <c:v>80056.957260131836</c:v>
                </c:pt>
                <c:pt idx="2834">
                  <c:v>80057.104961395264</c:v>
                </c:pt>
                <c:pt idx="2835">
                  <c:v>80038.166946411133</c:v>
                </c:pt>
                <c:pt idx="2836">
                  <c:v>80020.60036277771</c:v>
                </c:pt>
                <c:pt idx="2837">
                  <c:v>80023.833778381348</c:v>
                </c:pt>
                <c:pt idx="2838">
                  <c:v>80040.638622283936</c:v>
                </c:pt>
                <c:pt idx="2839">
                  <c:v>80052.443466186523</c:v>
                </c:pt>
                <c:pt idx="2840">
                  <c:v>80049.391170501709</c:v>
                </c:pt>
                <c:pt idx="2841">
                  <c:v>80035.453155517578</c:v>
                </c:pt>
                <c:pt idx="2842">
                  <c:v>80021.000856399536</c:v>
                </c:pt>
                <c:pt idx="2843">
                  <c:v>80018.405700683594</c:v>
                </c:pt>
                <c:pt idx="2844">
                  <c:v>80028.210544586182</c:v>
                </c:pt>
                <c:pt idx="2845">
                  <c:v>80039.043960571289</c:v>
                </c:pt>
                <c:pt idx="2846">
                  <c:v>80043.991661071777</c:v>
                </c:pt>
                <c:pt idx="2847">
                  <c:v>80046.167934417725</c:v>
                </c:pt>
                <c:pt idx="2848">
                  <c:v>80048.601348876953</c:v>
                </c:pt>
                <c:pt idx="2849">
                  <c:v>80050.834766387939</c:v>
                </c:pt>
                <c:pt idx="2850">
                  <c:v>80054.353897094727</c:v>
                </c:pt>
                <c:pt idx="2851">
                  <c:v>80061.158740997314</c:v>
                </c:pt>
                <c:pt idx="2852">
                  <c:v>80068.506439208984</c:v>
                </c:pt>
                <c:pt idx="2853">
                  <c:v>80071.196998596191</c:v>
                </c:pt>
                <c:pt idx="2854">
                  <c:v>80063.973274230957</c:v>
                </c:pt>
                <c:pt idx="2855">
                  <c:v>80051.406688690186</c:v>
                </c:pt>
                <c:pt idx="2856">
                  <c:v>80039.125816345215</c:v>
                </c:pt>
                <c:pt idx="2857">
                  <c:v>80033.644947052002</c:v>
                </c:pt>
                <c:pt idx="2858">
                  <c:v>80035.564079284668</c:v>
                </c:pt>
                <c:pt idx="2859">
                  <c:v>80041.311779022217</c:v>
                </c:pt>
                <c:pt idx="2860">
                  <c:v>80045.316623687744</c:v>
                </c:pt>
                <c:pt idx="2861">
                  <c:v>80046.578609466553</c:v>
                </c:pt>
                <c:pt idx="2862">
                  <c:v>80045.012027740479</c:v>
                </c:pt>
                <c:pt idx="2863">
                  <c:v>80043.131156921387</c:v>
                </c:pt>
                <c:pt idx="2864">
                  <c:v>80038.621715545654</c:v>
                </c:pt>
                <c:pt idx="2865">
                  <c:v>80030.055130004883</c:v>
                </c:pt>
                <c:pt idx="2866">
                  <c:v>80023.659973144531</c:v>
                </c:pt>
                <c:pt idx="2867">
                  <c:v>80029.207675933838</c:v>
                </c:pt>
                <c:pt idx="2868">
                  <c:v>80043.183948516846</c:v>
                </c:pt>
                <c:pt idx="2869">
                  <c:v>80049.560222625732</c:v>
                </c:pt>
                <c:pt idx="2870">
                  <c:v>80039.450778961182</c:v>
                </c:pt>
                <c:pt idx="2871">
                  <c:v>80019.369909286499</c:v>
                </c:pt>
                <c:pt idx="2872">
                  <c:v>80015.346181869507</c:v>
                </c:pt>
                <c:pt idx="2873">
                  <c:v>80038.293884277344</c:v>
                </c:pt>
                <c:pt idx="2874">
                  <c:v>80062.155868530273</c:v>
                </c:pt>
                <c:pt idx="2875">
                  <c:v>80055.84642791748</c:v>
                </c:pt>
                <c:pt idx="2876">
                  <c:v>80032.679843902588</c:v>
                </c:pt>
                <c:pt idx="2877">
                  <c:v>80022.256116867065</c:v>
                </c:pt>
                <c:pt idx="2878">
                  <c:v>80024.260961532593</c:v>
                </c:pt>
                <c:pt idx="2879">
                  <c:v>80029.065805435181</c:v>
                </c:pt>
                <c:pt idx="2880">
                  <c:v>80036.156364440918</c:v>
                </c:pt>
                <c:pt idx="2881">
                  <c:v>80043.504066467285</c:v>
                </c:pt>
                <c:pt idx="2882">
                  <c:v>80045.366050720215</c:v>
                </c:pt>
                <c:pt idx="2883">
                  <c:v>80047.542324066162</c:v>
                </c:pt>
                <c:pt idx="2884">
                  <c:v>80055.34716796875</c:v>
                </c:pt>
                <c:pt idx="2885">
                  <c:v>80061.466297149658</c:v>
                </c:pt>
                <c:pt idx="2886">
                  <c:v>80064.356857299805</c:v>
                </c:pt>
                <c:pt idx="2887">
                  <c:v>80064.761703491211</c:v>
                </c:pt>
                <c:pt idx="2888">
                  <c:v>80061.9951171875</c:v>
                </c:pt>
                <c:pt idx="2889">
                  <c:v>80057.314247131348</c:v>
                </c:pt>
                <c:pt idx="2890">
                  <c:v>80056.290519714355</c:v>
                </c:pt>
                <c:pt idx="2891">
                  <c:v>80058.638221740723</c:v>
                </c:pt>
                <c:pt idx="2892">
                  <c:v>80053.81449508667</c:v>
                </c:pt>
                <c:pt idx="2893">
                  <c:v>80046.305053710938</c:v>
                </c:pt>
                <c:pt idx="2894">
                  <c:v>80040.052753448486</c:v>
                </c:pt>
                <c:pt idx="2895">
                  <c:v>80035.800453186035</c:v>
                </c:pt>
                <c:pt idx="2896">
                  <c:v>80031.176727294922</c:v>
                </c:pt>
                <c:pt idx="2897">
                  <c:v>80031.86728477478</c:v>
                </c:pt>
                <c:pt idx="2898">
                  <c:v>80043.814987182617</c:v>
                </c:pt>
                <c:pt idx="2899">
                  <c:v>80060.819831848145</c:v>
                </c:pt>
                <c:pt idx="2900">
                  <c:v>80064.881820678711</c:v>
                </c:pt>
                <c:pt idx="2901">
                  <c:v>80051.658092498779</c:v>
                </c:pt>
                <c:pt idx="2902">
                  <c:v>80037.491504669189</c:v>
                </c:pt>
                <c:pt idx="2903">
                  <c:v>80035.753494262695</c:v>
                </c:pt>
                <c:pt idx="2904">
                  <c:v>80042.444053649902</c:v>
                </c:pt>
                <c:pt idx="2905">
                  <c:v>80055.363182067871</c:v>
                </c:pt>
                <c:pt idx="2906">
                  <c:v>80069.510879516602</c:v>
                </c:pt>
                <c:pt idx="2907">
                  <c:v>80073.144302368164</c:v>
                </c:pt>
                <c:pt idx="2908">
                  <c:v>80068.206283569336</c:v>
                </c:pt>
                <c:pt idx="2909">
                  <c:v>80061.011131286621</c:v>
                </c:pt>
                <c:pt idx="2910">
                  <c:v>80051.787403106689</c:v>
                </c:pt>
                <c:pt idx="2911">
                  <c:v>80040.192245483398</c:v>
                </c:pt>
                <c:pt idx="2912">
                  <c:v>80035.568519592285</c:v>
                </c:pt>
                <c:pt idx="2913">
                  <c:v>80039.173362731934</c:v>
                </c:pt>
                <c:pt idx="2914">
                  <c:v>80046.349636077881</c:v>
                </c:pt>
                <c:pt idx="2915">
                  <c:v>80054.754482269287</c:v>
                </c:pt>
                <c:pt idx="2916">
                  <c:v>80057.330753326416</c:v>
                </c:pt>
                <c:pt idx="2917">
                  <c:v>80053.049884796143</c:v>
                </c:pt>
                <c:pt idx="2918">
                  <c:v>80049.140441894531</c:v>
                </c:pt>
                <c:pt idx="2919">
                  <c:v>80046.859569549561</c:v>
                </c:pt>
                <c:pt idx="2920">
                  <c:v>80043.892986297607</c:v>
                </c:pt>
                <c:pt idx="2921">
                  <c:v>80043.069259643555</c:v>
                </c:pt>
                <c:pt idx="2922">
                  <c:v>80047.931247711182</c:v>
                </c:pt>
                <c:pt idx="2923">
                  <c:v>80055.73609161377</c:v>
                </c:pt>
                <c:pt idx="2924">
                  <c:v>80060.455219268799</c:v>
                </c:pt>
                <c:pt idx="2925">
                  <c:v>80061.231494903564</c:v>
                </c:pt>
                <c:pt idx="2926">
                  <c:v>80062.779193878174</c:v>
                </c:pt>
                <c:pt idx="2927">
                  <c:v>80066.069755554199</c:v>
                </c:pt>
                <c:pt idx="2928">
                  <c:v>80067.103172302246</c:v>
                </c:pt>
                <c:pt idx="2929">
                  <c:v>80057.850868225098</c:v>
                </c:pt>
                <c:pt idx="2930">
                  <c:v>80044.284286499023</c:v>
                </c:pt>
                <c:pt idx="2931">
                  <c:v>80033.431987762451</c:v>
                </c:pt>
                <c:pt idx="2932">
                  <c:v>80030.00825881958</c:v>
                </c:pt>
                <c:pt idx="2933">
                  <c:v>80030.184532165527</c:v>
                </c:pt>
                <c:pt idx="2934">
                  <c:v>80035.475090026855</c:v>
                </c:pt>
                <c:pt idx="2935">
                  <c:v>80041.508506774902</c:v>
                </c:pt>
                <c:pt idx="2936">
                  <c:v>80041.941921234131</c:v>
                </c:pt>
                <c:pt idx="2937">
                  <c:v>80038.318195343018</c:v>
                </c:pt>
                <c:pt idx="2938">
                  <c:v>80038.694465637207</c:v>
                </c:pt>
                <c:pt idx="2939">
                  <c:v>80041.185024261475</c:v>
                </c:pt>
                <c:pt idx="2940">
                  <c:v>80040.904155731201</c:v>
                </c:pt>
                <c:pt idx="2941">
                  <c:v>80035.50899887085</c:v>
                </c:pt>
                <c:pt idx="2942">
                  <c:v>80033.370986938477</c:v>
                </c:pt>
                <c:pt idx="2943">
                  <c:v>80039.004402160645</c:v>
                </c:pt>
                <c:pt idx="2944">
                  <c:v>80051.066390991211</c:v>
                </c:pt>
                <c:pt idx="2945">
                  <c:v>80060.071235656738</c:v>
                </c:pt>
                <c:pt idx="2946">
                  <c:v>80059.933219909668</c:v>
                </c:pt>
                <c:pt idx="2947">
                  <c:v>80050.338066101074</c:v>
                </c:pt>
                <c:pt idx="2948">
                  <c:v>80037.942909240723</c:v>
                </c:pt>
                <c:pt idx="2949">
                  <c:v>80032.690608978271</c:v>
                </c:pt>
                <c:pt idx="2950">
                  <c:v>80037.609741210938</c:v>
                </c:pt>
                <c:pt idx="2951">
                  <c:v>80046.614585876465</c:v>
                </c:pt>
                <c:pt idx="2952">
                  <c:v>80047.876571655273</c:v>
                </c:pt>
                <c:pt idx="2953">
                  <c:v>80044.024272918701</c:v>
                </c:pt>
                <c:pt idx="2954">
                  <c:v>80040.886260986328</c:v>
                </c:pt>
                <c:pt idx="2955">
                  <c:v>80041.633960723877</c:v>
                </c:pt>
                <c:pt idx="2956">
                  <c:v>80040.038806915283</c:v>
                </c:pt>
                <c:pt idx="2957">
                  <c:v>80035.672222137451</c:v>
                </c:pt>
                <c:pt idx="2958">
                  <c:v>80034.019920349121</c:v>
                </c:pt>
                <c:pt idx="2959">
                  <c:v>80042.881908416748</c:v>
                </c:pt>
                <c:pt idx="2960">
                  <c:v>80051.429611206055</c:v>
                </c:pt>
                <c:pt idx="2961">
                  <c:v>80051.891597747803</c:v>
                </c:pt>
                <c:pt idx="2962">
                  <c:v>80046.267871856689</c:v>
                </c:pt>
                <c:pt idx="2963">
                  <c:v>80044.329856872559</c:v>
                </c:pt>
                <c:pt idx="2964">
                  <c:v>80044.620414733887</c:v>
                </c:pt>
                <c:pt idx="2965">
                  <c:v>80044.282402038574</c:v>
                </c:pt>
                <c:pt idx="2966">
                  <c:v>80036.115818023682</c:v>
                </c:pt>
                <c:pt idx="2967">
                  <c:v>80027.720663070679</c:v>
                </c:pt>
                <c:pt idx="2968">
                  <c:v>80029.496934890747</c:v>
                </c:pt>
                <c:pt idx="2969">
                  <c:v>80039.930351257324</c:v>
                </c:pt>
                <c:pt idx="2970">
                  <c:v>80041.906623840332</c:v>
                </c:pt>
                <c:pt idx="2971">
                  <c:v>80040.19718170166</c:v>
                </c:pt>
                <c:pt idx="2972">
                  <c:v>80045.230598449707</c:v>
                </c:pt>
                <c:pt idx="2973">
                  <c:v>80057.235443115234</c:v>
                </c:pt>
                <c:pt idx="2974">
                  <c:v>80060.154571533203</c:v>
                </c:pt>
                <c:pt idx="2975">
                  <c:v>80054.787986755371</c:v>
                </c:pt>
                <c:pt idx="2976">
                  <c:v>80051.621402740479</c:v>
                </c:pt>
                <c:pt idx="2977">
                  <c:v>80061.626247406006</c:v>
                </c:pt>
                <c:pt idx="2978">
                  <c:v>80078.088233947754</c:v>
                </c:pt>
                <c:pt idx="2979">
                  <c:v>80081.950218200684</c:v>
                </c:pt>
                <c:pt idx="2980">
                  <c:v>80065.69792175293</c:v>
                </c:pt>
                <c:pt idx="2981">
                  <c:v>80047.874195098877</c:v>
                </c:pt>
                <c:pt idx="2982">
                  <c:v>80046.593326568604</c:v>
                </c:pt>
                <c:pt idx="2983">
                  <c:v>80053.655311584473</c:v>
                </c:pt>
                <c:pt idx="2984">
                  <c:v>80053.031585693359</c:v>
                </c:pt>
                <c:pt idx="2985">
                  <c:v>80045.807857513428</c:v>
                </c:pt>
                <c:pt idx="2986">
                  <c:v>80043.841274261475</c:v>
                </c:pt>
                <c:pt idx="2987">
                  <c:v>80050.331832885742</c:v>
                </c:pt>
                <c:pt idx="2988">
                  <c:v>80054.47953414917</c:v>
                </c:pt>
                <c:pt idx="2989">
                  <c:v>80056.741519927979</c:v>
                </c:pt>
                <c:pt idx="2990">
                  <c:v>80062.774936676025</c:v>
                </c:pt>
                <c:pt idx="2991">
                  <c:v>80072.551208496094</c:v>
                </c:pt>
                <c:pt idx="2992">
                  <c:v>80077.61319732666</c:v>
                </c:pt>
                <c:pt idx="2993">
                  <c:v>80075.44660949707</c:v>
                </c:pt>
                <c:pt idx="2994">
                  <c:v>80068.937171936035</c:v>
                </c:pt>
                <c:pt idx="2995">
                  <c:v>80066.542015075684</c:v>
                </c:pt>
                <c:pt idx="2996">
                  <c:v>80063.203998565674</c:v>
                </c:pt>
                <c:pt idx="2997">
                  <c:v>80057.037414550781</c:v>
                </c:pt>
                <c:pt idx="2998">
                  <c:v>80057.156543731689</c:v>
                </c:pt>
                <c:pt idx="2999">
                  <c:v>80057.275676727295</c:v>
                </c:pt>
              </c:numCache>
            </c:numRef>
          </c:yVal>
          <c:smooth val="0"/>
          <c:extLst>
            <c:ext xmlns:c16="http://schemas.microsoft.com/office/drawing/2014/chart" uri="{C3380CC4-5D6E-409C-BE32-E72D297353CC}">
              <c16:uniqueId val="{00000004-951A-40BF-BA6C-3B319E7ECED3}"/>
            </c:ext>
          </c:extLst>
        </c:ser>
        <c:dLbls>
          <c:showLegendKey val="0"/>
          <c:showVal val="0"/>
          <c:showCatName val="0"/>
          <c:showSerName val="0"/>
          <c:showPercent val="0"/>
          <c:showBubbleSize val="0"/>
        </c:dLbls>
        <c:axId val="59983360"/>
        <c:axId val="57253888"/>
      </c:scatterChart>
      <c:valAx>
        <c:axId val="59983360"/>
        <c:scaling>
          <c:orientation val="minMax"/>
          <c:max val="12"/>
          <c:min val="6"/>
        </c:scaling>
        <c:delete val="0"/>
        <c:axPos val="b"/>
        <c:title>
          <c:tx>
            <c:rich>
              <a:bodyPr/>
              <a:lstStyle/>
              <a:p>
                <a:pPr>
                  <a:defRPr sz="1200"/>
                </a:pPr>
                <a:r>
                  <a:rPr lang="en-US" sz="1200"/>
                  <a:t>Glucose Units</a:t>
                </a:r>
              </a:p>
            </c:rich>
          </c:tx>
          <c:overlay val="0"/>
        </c:title>
        <c:numFmt formatCode="General" sourceLinked="0"/>
        <c:majorTickMark val="out"/>
        <c:minorTickMark val="none"/>
        <c:tickLblPos val="nextTo"/>
        <c:spPr>
          <a:ln w="19050">
            <a:solidFill>
              <a:schemeClr val="tx1"/>
            </a:solidFill>
          </a:ln>
        </c:spPr>
        <c:txPr>
          <a:bodyPr rot="-240000"/>
          <a:lstStyle/>
          <a:p>
            <a:pPr>
              <a:defRPr sz="1200" b="1" baseline="0"/>
            </a:pPr>
            <a:endParaRPr lang="en-US"/>
          </a:p>
        </c:txPr>
        <c:crossAx val="57253888"/>
        <c:crosses val="autoZero"/>
        <c:crossBetween val="between"/>
      </c:valAx>
      <c:valAx>
        <c:axId val="57253888"/>
        <c:scaling>
          <c:orientation val="minMax"/>
          <c:max val="90000"/>
          <c:min val="15000"/>
        </c:scaling>
        <c:delete val="1"/>
        <c:axPos val="l"/>
        <c:numFmt formatCode="General" sourceLinked="0"/>
        <c:majorTickMark val="out"/>
        <c:minorTickMark val="none"/>
        <c:tickLblPos val="nextTo"/>
        <c:crossAx val="59983360"/>
        <c:crosses val="autoZero"/>
        <c:crossBetween val="between"/>
        <c:majorUnit val="10000"/>
        <c:minorUnit val="10000"/>
      </c:valAx>
      <c:spPr>
        <a:solidFill>
          <a:srgbClr val="FFFFFF"/>
        </a:solidFill>
        <a:ln>
          <a:noFill/>
          <a:round/>
        </a:ln>
        <a:effectLst/>
      </c:spPr>
    </c:plotArea>
    <c:plotVisOnly val="1"/>
    <c:dispBlanksAs val="gap"/>
    <c:showDLblsOverMax val="0"/>
  </c:chart>
  <c:spPr>
    <a:solidFill>
      <a:srgbClr val="FFFFFF"/>
    </a:solidFill>
    <a:effectLst/>
  </c:spPr>
  <c:externalData r:id="rId1">
    <c:autoUpdate val="0"/>
  </c:externalData>
  <c:extLst/>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C5C5A3-DD06-4411-9A80-184327DB85EF}" type="datetimeFigureOut">
              <a:rPr lang="en-US" smtClean="0"/>
              <a:t>1/27/2020</a:t>
            </a:fld>
            <a:endParaRPr lang="en-US"/>
          </a:p>
        </p:txBody>
      </p:sp>
      <p:sp>
        <p:nvSpPr>
          <p:cNvPr id="4" name="Slide Image Placeholder 3"/>
          <p:cNvSpPr>
            <a:spLocks noGrp="1" noRot="1" noChangeAspect="1"/>
          </p:cNvSpPr>
          <p:nvPr>
            <p:ph type="sldImg" idx="2"/>
          </p:nvPr>
        </p:nvSpPr>
        <p:spPr>
          <a:xfrm>
            <a:off x="2143125" y="1143000"/>
            <a:ext cx="25717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037684-C14B-49CE-88D0-4591F36EC57D}" type="slidenum">
              <a:rPr lang="en-US" smtClean="0"/>
              <a:t>‹#›</a:t>
            </a:fld>
            <a:endParaRPr lang="en-US"/>
          </a:p>
        </p:txBody>
      </p:sp>
    </p:spTree>
    <p:extLst>
      <p:ext uri="{BB962C8B-B14F-4D97-AF65-F5344CB8AC3E}">
        <p14:creationId xmlns:p14="http://schemas.microsoft.com/office/powerpoint/2010/main" val="19713687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1143000"/>
            <a:ext cx="257175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5BBD581-107D-47C2-984E-FCB41BEF1201}" type="slidenum">
              <a:rPr lang="en-US" smtClean="0"/>
              <a:t>2</a:t>
            </a:fld>
            <a:endParaRPr lang="en-US"/>
          </a:p>
        </p:txBody>
      </p:sp>
    </p:spTree>
    <p:extLst>
      <p:ext uri="{BB962C8B-B14F-4D97-AF65-F5344CB8AC3E}">
        <p14:creationId xmlns:p14="http://schemas.microsoft.com/office/powerpoint/2010/main" val="33074245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795781"/>
            <a:ext cx="7772400" cy="382016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5763261"/>
            <a:ext cx="6858000" cy="2649219"/>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AB661FB-17CB-45FE-A855-2E031378116E}"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37429947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B661FB-17CB-45FE-A855-2E031378116E}"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40642971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584200"/>
            <a:ext cx="1971675" cy="929894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584200"/>
            <a:ext cx="5800725" cy="929894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B661FB-17CB-45FE-A855-2E031378116E}"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3568881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B661FB-17CB-45FE-A855-2E031378116E}"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11756933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2735583"/>
            <a:ext cx="7886700" cy="4564379"/>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7343143"/>
            <a:ext cx="7886700" cy="2400299"/>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AB661FB-17CB-45FE-A855-2E031378116E}"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15564587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2921000"/>
            <a:ext cx="3886200"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2921000"/>
            <a:ext cx="3886200"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AB661FB-17CB-45FE-A855-2E031378116E}" type="datetimeFigureOut">
              <a:rPr lang="en-US" smtClean="0"/>
              <a:t>1/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40306774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584202"/>
            <a:ext cx="7886700" cy="2120901"/>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2689861"/>
            <a:ext cx="3868340" cy="131825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4008120"/>
            <a:ext cx="3868340"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2689861"/>
            <a:ext cx="3887391" cy="131825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1" y="4008120"/>
            <a:ext cx="3887391"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AB661FB-17CB-45FE-A855-2E031378116E}" type="datetimeFigureOut">
              <a:rPr lang="en-US" smtClean="0"/>
              <a:t>1/2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7896104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AB661FB-17CB-45FE-A855-2E031378116E}" type="datetimeFigureOut">
              <a:rPr lang="en-US" smtClean="0"/>
              <a:t>1/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14907318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B661FB-17CB-45FE-A855-2E031378116E}" type="datetimeFigureOut">
              <a:rPr lang="en-US" smtClean="0"/>
              <a:t>1/2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8910245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731520"/>
            <a:ext cx="2949178" cy="256032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1579882"/>
            <a:ext cx="4629150" cy="779780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3291840"/>
            <a:ext cx="2949178" cy="609854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AB661FB-17CB-45FE-A855-2E031378116E}" type="datetimeFigureOut">
              <a:rPr lang="en-US" smtClean="0"/>
              <a:t>1/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19441365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731520"/>
            <a:ext cx="2949178" cy="256032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1579882"/>
            <a:ext cx="4629150" cy="7797800"/>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3291840"/>
            <a:ext cx="2949178" cy="609854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AB661FB-17CB-45FE-A855-2E031378116E}" type="datetimeFigureOut">
              <a:rPr lang="en-US" smtClean="0"/>
              <a:t>1/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74AB241-6EAE-4D35-A4E5-D1581E2676B5}" type="slidenum">
              <a:rPr lang="en-US" smtClean="0"/>
              <a:t>‹#›</a:t>
            </a:fld>
            <a:endParaRPr lang="en-US"/>
          </a:p>
        </p:txBody>
      </p:sp>
    </p:spTree>
    <p:extLst>
      <p:ext uri="{BB962C8B-B14F-4D97-AF65-F5344CB8AC3E}">
        <p14:creationId xmlns:p14="http://schemas.microsoft.com/office/powerpoint/2010/main" val="9436915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584202"/>
            <a:ext cx="7886700" cy="212090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2921000"/>
            <a:ext cx="7886700" cy="696214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10170162"/>
            <a:ext cx="2057400" cy="584200"/>
          </a:xfrm>
          <a:prstGeom prst="rect">
            <a:avLst/>
          </a:prstGeom>
        </p:spPr>
        <p:txBody>
          <a:bodyPr vert="horz" lIns="91440" tIns="45720" rIns="91440" bIns="45720" rtlCol="0" anchor="ctr"/>
          <a:lstStyle>
            <a:lvl1pPr algn="l">
              <a:defRPr sz="1200">
                <a:solidFill>
                  <a:schemeClr val="tx1">
                    <a:tint val="75000"/>
                  </a:schemeClr>
                </a:solidFill>
              </a:defRPr>
            </a:lvl1pPr>
          </a:lstStyle>
          <a:p>
            <a:fld id="{9AB661FB-17CB-45FE-A855-2E031378116E}" type="datetimeFigureOut">
              <a:rPr lang="en-US" smtClean="0"/>
              <a:t>1/27/2020</a:t>
            </a:fld>
            <a:endParaRPr lang="en-US"/>
          </a:p>
        </p:txBody>
      </p:sp>
      <p:sp>
        <p:nvSpPr>
          <p:cNvPr id="5" name="Footer Placeholder 4"/>
          <p:cNvSpPr>
            <a:spLocks noGrp="1"/>
          </p:cNvSpPr>
          <p:nvPr>
            <p:ph type="ftr" sz="quarter" idx="3"/>
          </p:nvPr>
        </p:nvSpPr>
        <p:spPr>
          <a:xfrm>
            <a:off x="3028950" y="10170162"/>
            <a:ext cx="3086100" cy="584200"/>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10170162"/>
            <a:ext cx="2057400" cy="584200"/>
          </a:xfrm>
          <a:prstGeom prst="rect">
            <a:avLst/>
          </a:prstGeom>
        </p:spPr>
        <p:txBody>
          <a:bodyPr vert="horz" lIns="91440" tIns="45720" rIns="91440" bIns="45720" rtlCol="0" anchor="ctr"/>
          <a:lstStyle>
            <a:lvl1pPr algn="r">
              <a:defRPr sz="1200">
                <a:solidFill>
                  <a:schemeClr val="tx1">
                    <a:tint val="75000"/>
                  </a:schemeClr>
                </a:solidFill>
              </a:defRPr>
            </a:lvl1pPr>
          </a:lstStyle>
          <a:p>
            <a:fld id="{E74AB241-6EAE-4D35-A4E5-D1581E2676B5}" type="slidenum">
              <a:rPr lang="en-US" smtClean="0"/>
              <a:t>‹#›</a:t>
            </a:fld>
            <a:endParaRPr lang="en-US"/>
          </a:p>
        </p:txBody>
      </p:sp>
    </p:spTree>
    <p:extLst>
      <p:ext uri="{BB962C8B-B14F-4D97-AF65-F5344CB8AC3E}">
        <p14:creationId xmlns:p14="http://schemas.microsoft.com/office/powerpoint/2010/main" val="950658814"/>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emf"/><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FAF845DB-5891-4418-8C14-0C60842FC5C1}"/>
              </a:ext>
            </a:extLst>
          </p:cNvPr>
          <p:cNvGrpSpPr/>
          <p:nvPr/>
        </p:nvGrpSpPr>
        <p:grpSpPr>
          <a:xfrm>
            <a:off x="1641721" y="1439788"/>
            <a:ext cx="5320183" cy="3631980"/>
            <a:chOff x="3484771" y="354393"/>
            <a:chExt cx="5320182" cy="3631980"/>
          </a:xfrm>
        </p:grpSpPr>
        <p:graphicFrame>
          <p:nvGraphicFramePr>
            <p:cNvPr id="30" name="Line Chart">
              <a:extLst>
                <a:ext uri="{FF2B5EF4-FFF2-40B4-BE49-F238E27FC236}">
                  <a16:creationId xmlns:a16="http://schemas.microsoft.com/office/drawing/2014/main" id="{00000000-0008-0000-0100-000001040000}"/>
                </a:ext>
              </a:extLst>
            </p:cNvPr>
            <p:cNvGraphicFramePr>
              <a:graphicFrameLocks/>
            </p:cNvGraphicFramePr>
            <p:nvPr>
              <p:extLst>
                <p:ext uri="{D42A27DB-BD31-4B8C-83A1-F6EECF244321}">
                  <p14:modId xmlns:p14="http://schemas.microsoft.com/office/powerpoint/2010/main" val="3349683723"/>
                </p:ext>
              </p:extLst>
            </p:nvPr>
          </p:nvGraphicFramePr>
          <p:xfrm>
            <a:off x="3918438" y="380159"/>
            <a:ext cx="4886515" cy="3606214"/>
          </p:xfrm>
          <a:graphic>
            <a:graphicData uri="http://schemas.openxmlformats.org/drawingml/2006/chart">
              <c:chart xmlns:c="http://schemas.openxmlformats.org/drawingml/2006/chart" xmlns:r="http://schemas.openxmlformats.org/officeDocument/2006/relationships" r:id="rId2"/>
            </a:graphicData>
          </a:graphic>
        </p:graphicFrame>
        <p:sp>
          <p:nvSpPr>
            <p:cNvPr id="42" name="TextBox 41">
              <a:extLst>
                <a:ext uri="{FF2B5EF4-FFF2-40B4-BE49-F238E27FC236}">
                  <a16:creationId xmlns:a16="http://schemas.microsoft.com/office/drawing/2014/main" id="{66A13064-9503-47BC-A385-5B1ABB2C0348}"/>
                </a:ext>
              </a:extLst>
            </p:cNvPr>
            <p:cNvSpPr txBox="1"/>
            <p:nvPr/>
          </p:nvSpPr>
          <p:spPr>
            <a:xfrm>
              <a:off x="6264328" y="2796420"/>
              <a:ext cx="359394" cy="246221"/>
            </a:xfrm>
            <a:prstGeom prst="rect">
              <a:avLst/>
            </a:prstGeom>
            <a:noFill/>
          </p:spPr>
          <p:txBody>
            <a:bodyPr wrap="none" rtlCol="0">
              <a:spAutoFit/>
            </a:bodyPr>
            <a:lstStyle/>
            <a:p>
              <a:r>
                <a:rPr lang="en-US" sz="1000" dirty="0"/>
                <a:t>M6</a:t>
              </a:r>
            </a:p>
          </p:txBody>
        </p:sp>
        <p:sp>
          <p:nvSpPr>
            <p:cNvPr id="43" name="TextBox 42">
              <a:extLst>
                <a:ext uri="{FF2B5EF4-FFF2-40B4-BE49-F238E27FC236}">
                  <a16:creationId xmlns:a16="http://schemas.microsoft.com/office/drawing/2014/main" id="{E77AEBDB-520A-42CF-A9E1-103EBF494DEA}"/>
                </a:ext>
              </a:extLst>
            </p:cNvPr>
            <p:cNvSpPr txBox="1"/>
            <p:nvPr/>
          </p:nvSpPr>
          <p:spPr>
            <a:xfrm>
              <a:off x="6834037" y="2925388"/>
              <a:ext cx="359394" cy="246221"/>
            </a:xfrm>
            <a:prstGeom prst="rect">
              <a:avLst/>
            </a:prstGeom>
            <a:noFill/>
          </p:spPr>
          <p:txBody>
            <a:bodyPr wrap="none" rtlCol="0">
              <a:spAutoFit/>
            </a:bodyPr>
            <a:lstStyle/>
            <a:p>
              <a:r>
                <a:rPr lang="en-US" sz="1000" dirty="0"/>
                <a:t>M7</a:t>
              </a:r>
            </a:p>
          </p:txBody>
        </p:sp>
        <p:sp>
          <p:nvSpPr>
            <p:cNvPr id="44" name="TextBox 43">
              <a:extLst>
                <a:ext uri="{FF2B5EF4-FFF2-40B4-BE49-F238E27FC236}">
                  <a16:creationId xmlns:a16="http://schemas.microsoft.com/office/drawing/2014/main" id="{DE93AB1E-E214-43FF-BB25-F4A1025CA530}"/>
                </a:ext>
              </a:extLst>
            </p:cNvPr>
            <p:cNvSpPr txBox="1"/>
            <p:nvPr/>
          </p:nvSpPr>
          <p:spPr>
            <a:xfrm>
              <a:off x="7442271" y="2918100"/>
              <a:ext cx="359394" cy="246221"/>
            </a:xfrm>
            <a:prstGeom prst="rect">
              <a:avLst/>
            </a:prstGeom>
            <a:noFill/>
          </p:spPr>
          <p:txBody>
            <a:bodyPr wrap="none" rtlCol="0">
              <a:spAutoFit/>
            </a:bodyPr>
            <a:lstStyle/>
            <a:p>
              <a:r>
                <a:rPr lang="en-US" sz="1000" dirty="0"/>
                <a:t>M8</a:t>
              </a:r>
            </a:p>
          </p:txBody>
        </p:sp>
        <p:sp>
          <p:nvSpPr>
            <p:cNvPr id="45" name="TextBox 44">
              <a:extLst>
                <a:ext uri="{FF2B5EF4-FFF2-40B4-BE49-F238E27FC236}">
                  <a16:creationId xmlns:a16="http://schemas.microsoft.com/office/drawing/2014/main" id="{38C0110F-553E-4B23-9F75-909EDE6E9041}"/>
                </a:ext>
              </a:extLst>
            </p:cNvPr>
            <p:cNvSpPr txBox="1"/>
            <p:nvPr/>
          </p:nvSpPr>
          <p:spPr>
            <a:xfrm>
              <a:off x="5574145" y="2593150"/>
              <a:ext cx="380232" cy="261610"/>
            </a:xfrm>
            <a:prstGeom prst="rect">
              <a:avLst/>
            </a:prstGeom>
            <a:noFill/>
          </p:spPr>
          <p:txBody>
            <a:bodyPr wrap="none" rtlCol="0">
              <a:spAutoFit/>
            </a:bodyPr>
            <a:lstStyle/>
            <a:p>
              <a:r>
                <a:rPr lang="en-US" sz="1100" b="1" dirty="0"/>
                <a:t>M5</a:t>
              </a:r>
            </a:p>
          </p:txBody>
        </p:sp>
        <p:sp>
          <p:nvSpPr>
            <p:cNvPr id="46" name="TextBox 45">
              <a:extLst>
                <a:ext uri="{FF2B5EF4-FFF2-40B4-BE49-F238E27FC236}">
                  <a16:creationId xmlns:a16="http://schemas.microsoft.com/office/drawing/2014/main" id="{A55806C6-CFB6-4F41-AF14-F785695A6BBA}"/>
                </a:ext>
              </a:extLst>
            </p:cNvPr>
            <p:cNvSpPr txBox="1"/>
            <p:nvPr/>
          </p:nvSpPr>
          <p:spPr>
            <a:xfrm>
              <a:off x="7878811" y="2956095"/>
              <a:ext cx="359394" cy="246221"/>
            </a:xfrm>
            <a:prstGeom prst="rect">
              <a:avLst/>
            </a:prstGeom>
            <a:noFill/>
          </p:spPr>
          <p:txBody>
            <a:bodyPr wrap="none" rtlCol="0">
              <a:spAutoFit/>
            </a:bodyPr>
            <a:lstStyle/>
            <a:p>
              <a:r>
                <a:rPr lang="en-US" sz="1000" dirty="0"/>
                <a:t>M9</a:t>
              </a:r>
            </a:p>
          </p:txBody>
        </p:sp>
        <p:sp>
          <p:nvSpPr>
            <p:cNvPr id="47" name="TextBox 46">
              <a:extLst>
                <a:ext uri="{FF2B5EF4-FFF2-40B4-BE49-F238E27FC236}">
                  <a16:creationId xmlns:a16="http://schemas.microsoft.com/office/drawing/2014/main" id="{38A060CD-DDBC-4555-9E01-ACE88AC47FFF}"/>
                </a:ext>
              </a:extLst>
            </p:cNvPr>
            <p:cNvSpPr txBox="1"/>
            <p:nvPr/>
          </p:nvSpPr>
          <p:spPr>
            <a:xfrm>
              <a:off x="6426407" y="2028133"/>
              <a:ext cx="473206" cy="261610"/>
            </a:xfrm>
            <a:prstGeom prst="rect">
              <a:avLst/>
            </a:prstGeom>
            <a:noFill/>
          </p:spPr>
          <p:txBody>
            <a:bodyPr wrap="none" rtlCol="0">
              <a:spAutoFit/>
            </a:bodyPr>
            <a:lstStyle/>
            <a:p>
              <a:r>
                <a:rPr lang="en-US" sz="1100" b="1" dirty="0">
                  <a:solidFill>
                    <a:srgbClr val="C00000"/>
                  </a:solidFill>
                </a:rPr>
                <a:t>M5N</a:t>
              </a:r>
            </a:p>
          </p:txBody>
        </p:sp>
        <p:sp>
          <p:nvSpPr>
            <p:cNvPr id="48" name="TextBox 47">
              <a:extLst>
                <a:ext uri="{FF2B5EF4-FFF2-40B4-BE49-F238E27FC236}">
                  <a16:creationId xmlns:a16="http://schemas.microsoft.com/office/drawing/2014/main" id="{4F58C81B-4231-4F3E-A917-8FCD99E3F788}"/>
                </a:ext>
              </a:extLst>
            </p:cNvPr>
            <p:cNvSpPr txBox="1"/>
            <p:nvPr/>
          </p:nvSpPr>
          <p:spPr>
            <a:xfrm>
              <a:off x="7286783" y="1462351"/>
              <a:ext cx="562975" cy="261610"/>
            </a:xfrm>
            <a:prstGeom prst="rect">
              <a:avLst/>
            </a:prstGeom>
            <a:noFill/>
          </p:spPr>
          <p:txBody>
            <a:bodyPr wrap="none" rtlCol="0">
              <a:spAutoFit/>
            </a:bodyPr>
            <a:lstStyle/>
            <a:p>
              <a:r>
                <a:rPr lang="en-US" sz="1100" b="1" dirty="0">
                  <a:solidFill>
                    <a:schemeClr val="accent6">
                      <a:lumMod val="50000"/>
                    </a:schemeClr>
                  </a:solidFill>
                </a:rPr>
                <a:t>M5NG</a:t>
              </a:r>
            </a:p>
          </p:txBody>
        </p:sp>
        <p:sp>
          <p:nvSpPr>
            <p:cNvPr id="49" name="TextBox 48">
              <a:extLst>
                <a:ext uri="{FF2B5EF4-FFF2-40B4-BE49-F238E27FC236}">
                  <a16:creationId xmlns:a16="http://schemas.microsoft.com/office/drawing/2014/main" id="{580D6249-73F9-4041-B853-D6ED6C8A8E4E}"/>
                </a:ext>
              </a:extLst>
            </p:cNvPr>
            <p:cNvSpPr txBox="1"/>
            <p:nvPr/>
          </p:nvSpPr>
          <p:spPr>
            <a:xfrm>
              <a:off x="4824950" y="935975"/>
              <a:ext cx="915363" cy="261610"/>
            </a:xfrm>
            <a:prstGeom prst="rect">
              <a:avLst/>
            </a:prstGeom>
            <a:noFill/>
          </p:spPr>
          <p:txBody>
            <a:bodyPr wrap="square" rtlCol="0">
              <a:spAutoFit/>
            </a:bodyPr>
            <a:lstStyle/>
            <a:p>
              <a:r>
                <a:rPr lang="en-US" sz="1100" b="1" dirty="0">
                  <a:solidFill>
                    <a:srgbClr val="00B0F0"/>
                  </a:solidFill>
                </a:rPr>
                <a:t>M5NGS</a:t>
              </a:r>
            </a:p>
          </p:txBody>
        </p:sp>
        <p:sp>
          <p:nvSpPr>
            <p:cNvPr id="50" name="TextBox 49">
              <a:extLst>
                <a:ext uri="{FF2B5EF4-FFF2-40B4-BE49-F238E27FC236}">
                  <a16:creationId xmlns:a16="http://schemas.microsoft.com/office/drawing/2014/main" id="{1A66446D-0CBC-4FCB-A59E-010E817ECC2D}"/>
                </a:ext>
              </a:extLst>
            </p:cNvPr>
            <p:cNvSpPr txBox="1"/>
            <p:nvPr/>
          </p:nvSpPr>
          <p:spPr>
            <a:xfrm>
              <a:off x="6593377" y="354393"/>
              <a:ext cx="577402" cy="261610"/>
            </a:xfrm>
            <a:prstGeom prst="rect">
              <a:avLst/>
            </a:prstGeom>
            <a:noFill/>
          </p:spPr>
          <p:txBody>
            <a:bodyPr wrap="none" rtlCol="0">
              <a:spAutoFit/>
            </a:bodyPr>
            <a:lstStyle/>
            <a:p>
              <a:r>
                <a:rPr lang="en-US" sz="1100" b="1" dirty="0">
                  <a:solidFill>
                    <a:srgbClr val="7030A0"/>
                  </a:solidFill>
                </a:rPr>
                <a:t>M5NF</a:t>
              </a:r>
              <a:r>
                <a:rPr lang="en-US" sz="1100" b="1" baseline="30000" dirty="0">
                  <a:solidFill>
                    <a:srgbClr val="7030A0"/>
                  </a:solidFill>
                </a:rPr>
                <a:t>c</a:t>
              </a:r>
            </a:p>
          </p:txBody>
        </p:sp>
        <p:sp>
          <p:nvSpPr>
            <p:cNvPr id="51" name="TextBox 50">
              <a:extLst>
                <a:ext uri="{FF2B5EF4-FFF2-40B4-BE49-F238E27FC236}">
                  <a16:creationId xmlns:a16="http://schemas.microsoft.com/office/drawing/2014/main" id="{01076499-C0CC-45DB-832F-AD7C77696A01}"/>
                </a:ext>
              </a:extLst>
            </p:cNvPr>
            <p:cNvSpPr txBox="1"/>
            <p:nvPr/>
          </p:nvSpPr>
          <p:spPr>
            <a:xfrm>
              <a:off x="3925840" y="2975353"/>
              <a:ext cx="343364" cy="261610"/>
            </a:xfrm>
            <a:prstGeom prst="rect">
              <a:avLst/>
            </a:prstGeom>
            <a:noFill/>
          </p:spPr>
          <p:txBody>
            <a:bodyPr wrap="none" rtlCol="0">
              <a:spAutoFit/>
            </a:bodyPr>
            <a:lstStyle/>
            <a:p>
              <a:r>
                <a:rPr lang="en-US" sz="1100" b="1" dirty="0"/>
                <a:t>RB</a:t>
              </a:r>
            </a:p>
          </p:txBody>
        </p:sp>
        <p:sp>
          <p:nvSpPr>
            <p:cNvPr id="52" name="TextBox 51">
              <a:extLst>
                <a:ext uri="{FF2B5EF4-FFF2-40B4-BE49-F238E27FC236}">
                  <a16:creationId xmlns:a16="http://schemas.microsoft.com/office/drawing/2014/main" id="{C41D5E8C-E6A9-497C-9999-2E5D24E54759}"/>
                </a:ext>
              </a:extLst>
            </p:cNvPr>
            <p:cNvSpPr txBox="1"/>
            <p:nvPr/>
          </p:nvSpPr>
          <p:spPr>
            <a:xfrm>
              <a:off x="3596694" y="2349251"/>
              <a:ext cx="845103" cy="261610"/>
            </a:xfrm>
            <a:prstGeom prst="rect">
              <a:avLst/>
            </a:prstGeom>
            <a:noFill/>
          </p:spPr>
          <p:txBody>
            <a:bodyPr wrap="none" rtlCol="0">
              <a:spAutoFit/>
            </a:bodyPr>
            <a:lstStyle/>
            <a:p>
              <a:r>
                <a:rPr lang="en-US" sz="1100" b="1" dirty="0">
                  <a:solidFill>
                    <a:srgbClr val="C00000"/>
                  </a:solidFill>
                </a:rPr>
                <a:t>RB/MGAT1</a:t>
              </a:r>
            </a:p>
          </p:txBody>
        </p:sp>
        <p:sp>
          <p:nvSpPr>
            <p:cNvPr id="53" name="TextBox 52">
              <a:extLst>
                <a:ext uri="{FF2B5EF4-FFF2-40B4-BE49-F238E27FC236}">
                  <a16:creationId xmlns:a16="http://schemas.microsoft.com/office/drawing/2014/main" id="{431A0A47-A64E-407A-80EF-8615EEE7CB56}"/>
                </a:ext>
              </a:extLst>
            </p:cNvPr>
            <p:cNvSpPr txBox="1"/>
            <p:nvPr/>
          </p:nvSpPr>
          <p:spPr>
            <a:xfrm>
              <a:off x="3484771" y="1634095"/>
              <a:ext cx="906017" cy="430887"/>
            </a:xfrm>
            <a:prstGeom prst="rect">
              <a:avLst/>
            </a:prstGeom>
            <a:noFill/>
          </p:spPr>
          <p:txBody>
            <a:bodyPr wrap="none" rtlCol="0">
              <a:spAutoFit/>
            </a:bodyPr>
            <a:lstStyle/>
            <a:p>
              <a:r>
                <a:rPr lang="en-US" sz="1100" b="1" dirty="0">
                  <a:solidFill>
                    <a:schemeClr val="accent6">
                      <a:lumMod val="50000"/>
                    </a:schemeClr>
                  </a:solidFill>
                </a:rPr>
                <a:t>RB/MGAT1/</a:t>
              </a:r>
            </a:p>
            <a:p>
              <a:r>
                <a:rPr lang="en-US" sz="1100" b="1" dirty="0">
                  <a:solidFill>
                    <a:schemeClr val="accent6">
                      <a:lumMod val="50000"/>
                    </a:schemeClr>
                  </a:solidFill>
                </a:rPr>
                <a:t>B4GalT1</a:t>
              </a:r>
            </a:p>
          </p:txBody>
        </p:sp>
        <p:sp>
          <p:nvSpPr>
            <p:cNvPr id="54" name="TextBox 53">
              <a:extLst>
                <a:ext uri="{FF2B5EF4-FFF2-40B4-BE49-F238E27FC236}">
                  <a16:creationId xmlns:a16="http://schemas.microsoft.com/office/drawing/2014/main" id="{38B7AF2E-B5E7-4CB3-835F-6368D2E4CF20}"/>
                </a:ext>
              </a:extLst>
            </p:cNvPr>
            <p:cNvSpPr txBox="1"/>
            <p:nvPr/>
          </p:nvSpPr>
          <p:spPr>
            <a:xfrm>
              <a:off x="3536734" y="1065042"/>
              <a:ext cx="1208985" cy="430887"/>
            </a:xfrm>
            <a:prstGeom prst="rect">
              <a:avLst/>
            </a:prstGeom>
            <a:noFill/>
          </p:spPr>
          <p:txBody>
            <a:bodyPr wrap="none" rtlCol="0">
              <a:spAutoFit/>
            </a:bodyPr>
            <a:lstStyle/>
            <a:p>
              <a:r>
                <a:rPr lang="en-US" sz="1100" b="1" dirty="0">
                  <a:solidFill>
                    <a:srgbClr val="00B0F0"/>
                  </a:solidFill>
                </a:rPr>
                <a:t>RB/MGAT1/</a:t>
              </a:r>
            </a:p>
            <a:p>
              <a:r>
                <a:rPr lang="en-US" sz="1100" b="1" dirty="0">
                  <a:solidFill>
                    <a:srgbClr val="00B0F0"/>
                  </a:solidFill>
                </a:rPr>
                <a:t>B4GalT1/ST6Gal1</a:t>
              </a:r>
            </a:p>
          </p:txBody>
        </p:sp>
        <p:sp>
          <p:nvSpPr>
            <p:cNvPr id="55" name="TextBox 54">
              <a:extLst>
                <a:ext uri="{FF2B5EF4-FFF2-40B4-BE49-F238E27FC236}">
                  <a16:creationId xmlns:a16="http://schemas.microsoft.com/office/drawing/2014/main" id="{5DAE9647-D6DC-483F-A494-5BE3D5196C68}"/>
                </a:ext>
              </a:extLst>
            </p:cNvPr>
            <p:cNvSpPr txBox="1"/>
            <p:nvPr/>
          </p:nvSpPr>
          <p:spPr>
            <a:xfrm>
              <a:off x="3536734" y="483688"/>
              <a:ext cx="906017" cy="430887"/>
            </a:xfrm>
            <a:prstGeom prst="rect">
              <a:avLst/>
            </a:prstGeom>
            <a:noFill/>
          </p:spPr>
          <p:txBody>
            <a:bodyPr wrap="none" rtlCol="0">
              <a:spAutoFit/>
            </a:bodyPr>
            <a:lstStyle/>
            <a:p>
              <a:r>
                <a:rPr lang="en-US" sz="1100" b="1" dirty="0">
                  <a:solidFill>
                    <a:srgbClr val="7030A0"/>
                  </a:solidFill>
                </a:rPr>
                <a:t>RB/MGAT1/</a:t>
              </a:r>
            </a:p>
            <a:p>
              <a:r>
                <a:rPr lang="en-US" sz="1100" b="1" dirty="0">
                  <a:solidFill>
                    <a:srgbClr val="7030A0"/>
                  </a:solidFill>
                </a:rPr>
                <a:t>FUT8</a:t>
              </a:r>
            </a:p>
          </p:txBody>
        </p:sp>
        <p:sp>
          <p:nvSpPr>
            <p:cNvPr id="67" name="TextBox 66">
              <a:extLst>
                <a:ext uri="{FF2B5EF4-FFF2-40B4-BE49-F238E27FC236}">
                  <a16:creationId xmlns:a16="http://schemas.microsoft.com/office/drawing/2014/main" id="{D89CD6F3-6357-4D38-8BD6-C109B724FE8D}"/>
                </a:ext>
              </a:extLst>
            </p:cNvPr>
            <p:cNvSpPr txBox="1"/>
            <p:nvPr/>
          </p:nvSpPr>
          <p:spPr>
            <a:xfrm>
              <a:off x="6813488" y="2370583"/>
              <a:ext cx="359394" cy="246221"/>
            </a:xfrm>
            <a:prstGeom prst="rect">
              <a:avLst/>
            </a:prstGeom>
            <a:noFill/>
          </p:spPr>
          <p:txBody>
            <a:bodyPr wrap="none" rtlCol="0">
              <a:spAutoFit/>
            </a:bodyPr>
            <a:lstStyle/>
            <a:p>
              <a:r>
                <a:rPr lang="en-US" sz="1000" dirty="0"/>
                <a:t>M7</a:t>
              </a:r>
            </a:p>
          </p:txBody>
        </p:sp>
        <p:sp>
          <p:nvSpPr>
            <p:cNvPr id="68" name="TextBox 67">
              <a:extLst>
                <a:ext uri="{FF2B5EF4-FFF2-40B4-BE49-F238E27FC236}">
                  <a16:creationId xmlns:a16="http://schemas.microsoft.com/office/drawing/2014/main" id="{551D9EFB-7D0D-411F-AE28-9DB590985652}"/>
                </a:ext>
              </a:extLst>
            </p:cNvPr>
            <p:cNvSpPr txBox="1"/>
            <p:nvPr/>
          </p:nvSpPr>
          <p:spPr>
            <a:xfrm>
              <a:off x="6792940" y="1784956"/>
              <a:ext cx="359394" cy="246221"/>
            </a:xfrm>
            <a:prstGeom prst="rect">
              <a:avLst/>
            </a:prstGeom>
            <a:noFill/>
          </p:spPr>
          <p:txBody>
            <a:bodyPr wrap="none" rtlCol="0">
              <a:spAutoFit/>
            </a:bodyPr>
            <a:lstStyle/>
            <a:p>
              <a:r>
                <a:rPr lang="en-US" sz="1000" dirty="0"/>
                <a:t>M7</a:t>
              </a:r>
            </a:p>
          </p:txBody>
        </p:sp>
        <p:sp>
          <p:nvSpPr>
            <p:cNvPr id="74" name="TextBox 73">
              <a:extLst>
                <a:ext uri="{FF2B5EF4-FFF2-40B4-BE49-F238E27FC236}">
                  <a16:creationId xmlns:a16="http://schemas.microsoft.com/office/drawing/2014/main" id="{C04CDA37-F417-4768-A4E4-5F28A354883C}"/>
                </a:ext>
              </a:extLst>
            </p:cNvPr>
            <p:cNvSpPr txBox="1"/>
            <p:nvPr/>
          </p:nvSpPr>
          <p:spPr>
            <a:xfrm>
              <a:off x="6844312" y="644525"/>
              <a:ext cx="359394" cy="246221"/>
            </a:xfrm>
            <a:prstGeom prst="rect">
              <a:avLst/>
            </a:prstGeom>
            <a:noFill/>
          </p:spPr>
          <p:txBody>
            <a:bodyPr wrap="none" rtlCol="0">
              <a:spAutoFit/>
            </a:bodyPr>
            <a:lstStyle/>
            <a:p>
              <a:r>
                <a:rPr lang="en-US" sz="1000" dirty="0"/>
                <a:t>M7</a:t>
              </a:r>
            </a:p>
          </p:txBody>
        </p:sp>
        <p:sp>
          <p:nvSpPr>
            <p:cNvPr id="75" name="TextBox 74">
              <a:extLst>
                <a:ext uri="{FF2B5EF4-FFF2-40B4-BE49-F238E27FC236}">
                  <a16:creationId xmlns:a16="http://schemas.microsoft.com/office/drawing/2014/main" id="{12DC2E68-13E1-4200-B35E-79C2F745585C}"/>
                </a:ext>
              </a:extLst>
            </p:cNvPr>
            <p:cNvSpPr txBox="1"/>
            <p:nvPr/>
          </p:nvSpPr>
          <p:spPr>
            <a:xfrm>
              <a:off x="6141038" y="2025858"/>
              <a:ext cx="359394" cy="246221"/>
            </a:xfrm>
            <a:prstGeom prst="rect">
              <a:avLst/>
            </a:prstGeom>
            <a:noFill/>
          </p:spPr>
          <p:txBody>
            <a:bodyPr wrap="none" rtlCol="0">
              <a:spAutoFit/>
            </a:bodyPr>
            <a:lstStyle/>
            <a:p>
              <a:r>
                <a:rPr lang="en-US" sz="1000" dirty="0"/>
                <a:t>M6</a:t>
              </a:r>
            </a:p>
          </p:txBody>
        </p:sp>
        <p:sp>
          <p:nvSpPr>
            <p:cNvPr id="76" name="TextBox 75">
              <a:extLst>
                <a:ext uri="{FF2B5EF4-FFF2-40B4-BE49-F238E27FC236}">
                  <a16:creationId xmlns:a16="http://schemas.microsoft.com/office/drawing/2014/main" id="{B2A10FB4-A85D-43B9-80E1-A0B48BCDDD6B}"/>
                </a:ext>
              </a:extLst>
            </p:cNvPr>
            <p:cNvSpPr txBox="1"/>
            <p:nvPr/>
          </p:nvSpPr>
          <p:spPr>
            <a:xfrm>
              <a:off x="6130763" y="1491601"/>
              <a:ext cx="359394" cy="246221"/>
            </a:xfrm>
            <a:prstGeom prst="rect">
              <a:avLst/>
            </a:prstGeom>
            <a:noFill/>
          </p:spPr>
          <p:txBody>
            <a:bodyPr wrap="none" rtlCol="0">
              <a:spAutoFit/>
            </a:bodyPr>
            <a:lstStyle/>
            <a:p>
              <a:r>
                <a:rPr lang="en-US" sz="1000" dirty="0"/>
                <a:t>M6</a:t>
              </a:r>
            </a:p>
          </p:txBody>
        </p:sp>
        <p:sp>
          <p:nvSpPr>
            <p:cNvPr id="77" name="TextBox 76">
              <a:extLst>
                <a:ext uri="{FF2B5EF4-FFF2-40B4-BE49-F238E27FC236}">
                  <a16:creationId xmlns:a16="http://schemas.microsoft.com/office/drawing/2014/main" id="{DBCFCD2D-26BF-461F-987E-C07B24598C35}"/>
                </a:ext>
              </a:extLst>
            </p:cNvPr>
            <p:cNvSpPr txBox="1"/>
            <p:nvPr/>
          </p:nvSpPr>
          <p:spPr>
            <a:xfrm>
              <a:off x="6151312" y="967620"/>
              <a:ext cx="359394" cy="246221"/>
            </a:xfrm>
            <a:prstGeom prst="rect">
              <a:avLst/>
            </a:prstGeom>
            <a:noFill/>
          </p:spPr>
          <p:txBody>
            <a:bodyPr wrap="none" rtlCol="0">
              <a:spAutoFit/>
            </a:bodyPr>
            <a:lstStyle/>
            <a:p>
              <a:r>
                <a:rPr lang="en-US" sz="1000" dirty="0"/>
                <a:t>M6</a:t>
              </a:r>
            </a:p>
          </p:txBody>
        </p:sp>
        <p:sp>
          <p:nvSpPr>
            <p:cNvPr id="78" name="TextBox 77">
              <a:extLst>
                <a:ext uri="{FF2B5EF4-FFF2-40B4-BE49-F238E27FC236}">
                  <a16:creationId xmlns:a16="http://schemas.microsoft.com/office/drawing/2014/main" id="{23402D5B-F1E6-4C6C-B510-D9E34B8E162F}"/>
                </a:ext>
              </a:extLst>
            </p:cNvPr>
            <p:cNvSpPr txBox="1"/>
            <p:nvPr/>
          </p:nvSpPr>
          <p:spPr>
            <a:xfrm>
              <a:off x="6141038" y="443638"/>
              <a:ext cx="359394" cy="246221"/>
            </a:xfrm>
            <a:prstGeom prst="rect">
              <a:avLst/>
            </a:prstGeom>
            <a:noFill/>
          </p:spPr>
          <p:txBody>
            <a:bodyPr wrap="none" rtlCol="0">
              <a:spAutoFit/>
            </a:bodyPr>
            <a:lstStyle/>
            <a:p>
              <a:r>
                <a:rPr lang="en-US" sz="1000" dirty="0"/>
                <a:t>M6</a:t>
              </a:r>
            </a:p>
          </p:txBody>
        </p:sp>
        <p:sp>
          <p:nvSpPr>
            <p:cNvPr id="79" name="TextBox 78">
              <a:extLst>
                <a:ext uri="{FF2B5EF4-FFF2-40B4-BE49-F238E27FC236}">
                  <a16:creationId xmlns:a16="http://schemas.microsoft.com/office/drawing/2014/main" id="{2C9317B2-4304-4A92-85CE-7D482AEEE083}"/>
                </a:ext>
              </a:extLst>
            </p:cNvPr>
            <p:cNvSpPr txBox="1"/>
            <p:nvPr/>
          </p:nvSpPr>
          <p:spPr>
            <a:xfrm>
              <a:off x="7483366" y="2363295"/>
              <a:ext cx="359394" cy="246221"/>
            </a:xfrm>
            <a:prstGeom prst="rect">
              <a:avLst/>
            </a:prstGeom>
            <a:noFill/>
          </p:spPr>
          <p:txBody>
            <a:bodyPr wrap="none" rtlCol="0">
              <a:spAutoFit/>
            </a:bodyPr>
            <a:lstStyle/>
            <a:p>
              <a:r>
                <a:rPr lang="en-US" sz="1000" dirty="0"/>
                <a:t>M8</a:t>
              </a:r>
            </a:p>
          </p:txBody>
        </p:sp>
        <p:sp>
          <p:nvSpPr>
            <p:cNvPr id="80" name="TextBox 79">
              <a:extLst>
                <a:ext uri="{FF2B5EF4-FFF2-40B4-BE49-F238E27FC236}">
                  <a16:creationId xmlns:a16="http://schemas.microsoft.com/office/drawing/2014/main" id="{AAB807A1-4BB7-40FF-A9F4-C1447372AA47}"/>
                </a:ext>
              </a:extLst>
            </p:cNvPr>
            <p:cNvSpPr txBox="1"/>
            <p:nvPr/>
          </p:nvSpPr>
          <p:spPr>
            <a:xfrm>
              <a:off x="7452545" y="1777668"/>
              <a:ext cx="359394" cy="246221"/>
            </a:xfrm>
            <a:prstGeom prst="rect">
              <a:avLst/>
            </a:prstGeom>
            <a:noFill/>
          </p:spPr>
          <p:txBody>
            <a:bodyPr wrap="none" rtlCol="0">
              <a:spAutoFit/>
            </a:bodyPr>
            <a:lstStyle/>
            <a:p>
              <a:r>
                <a:rPr lang="en-US" sz="1000" dirty="0"/>
                <a:t>M8</a:t>
              </a:r>
            </a:p>
          </p:txBody>
        </p:sp>
        <p:sp>
          <p:nvSpPr>
            <p:cNvPr id="81" name="TextBox 80">
              <a:extLst>
                <a:ext uri="{FF2B5EF4-FFF2-40B4-BE49-F238E27FC236}">
                  <a16:creationId xmlns:a16="http://schemas.microsoft.com/office/drawing/2014/main" id="{181F67CF-AF5C-4BF7-A448-186375776D7B}"/>
                </a:ext>
              </a:extLst>
            </p:cNvPr>
            <p:cNvSpPr txBox="1"/>
            <p:nvPr/>
          </p:nvSpPr>
          <p:spPr>
            <a:xfrm>
              <a:off x="7452545" y="626963"/>
              <a:ext cx="359394" cy="246221"/>
            </a:xfrm>
            <a:prstGeom prst="rect">
              <a:avLst/>
            </a:prstGeom>
            <a:noFill/>
          </p:spPr>
          <p:txBody>
            <a:bodyPr wrap="none" rtlCol="0">
              <a:spAutoFit/>
            </a:bodyPr>
            <a:lstStyle/>
            <a:p>
              <a:r>
                <a:rPr lang="en-US" sz="1000" dirty="0"/>
                <a:t>M8</a:t>
              </a:r>
            </a:p>
          </p:txBody>
        </p:sp>
        <p:sp>
          <p:nvSpPr>
            <p:cNvPr id="82" name="TextBox 81">
              <a:extLst>
                <a:ext uri="{FF2B5EF4-FFF2-40B4-BE49-F238E27FC236}">
                  <a16:creationId xmlns:a16="http://schemas.microsoft.com/office/drawing/2014/main" id="{671C689F-63FD-4FB1-A736-BD323606D262}"/>
                </a:ext>
              </a:extLst>
            </p:cNvPr>
            <p:cNvSpPr txBox="1"/>
            <p:nvPr/>
          </p:nvSpPr>
          <p:spPr>
            <a:xfrm>
              <a:off x="7452545" y="1202316"/>
              <a:ext cx="359394" cy="246221"/>
            </a:xfrm>
            <a:prstGeom prst="rect">
              <a:avLst/>
            </a:prstGeom>
            <a:noFill/>
          </p:spPr>
          <p:txBody>
            <a:bodyPr wrap="none" rtlCol="0">
              <a:spAutoFit/>
            </a:bodyPr>
            <a:lstStyle/>
            <a:p>
              <a:r>
                <a:rPr lang="en-US" sz="1000" dirty="0"/>
                <a:t>M8</a:t>
              </a:r>
            </a:p>
          </p:txBody>
        </p:sp>
        <p:sp>
          <p:nvSpPr>
            <p:cNvPr id="83" name="TextBox 82">
              <a:extLst>
                <a:ext uri="{FF2B5EF4-FFF2-40B4-BE49-F238E27FC236}">
                  <a16:creationId xmlns:a16="http://schemas.microsoft.com/office/drawing/2014/main" id="{18B9667A-8E7C-4436-B5C5-05792899053D}"/>
                </a:ext>
              </a:extLst>
            </p:cNvPr>
            <p:cNvSpPr txBox="1"/>
            <p:nvPr/>
          </p:nvSpPr>
          <p:spPr>
            <a:xfrm>
              <a:off x="7909635" y="2401291"/>
              <a:ext cx="359394" cy="246221"/>
            </a:xfrm>
            <a:prstGeom prst="rect">
              <a:avLst/>
            </a:prstGeom>
            <a:noFill/>
          </p:spPr>
          <p:txBody>
            <a:bodyPr wrap="none" rtlCol="0">
              <a:spAutoFit/>
            </a:bodyPr>
            <a:lstStyle/>
            <a:p>
              <a:r>
                <a:rPr lang="en-US" sz="1000" dirty="0"/>
                <a:t>M9</a:t>
              </a:r>
            </a:p>
          </p:txBody>
        </p:sp>
        <p:sp>
          <p:nvSpPr>
            <p:cNvPr id="84" name="TextBox 83">
              <a:extLst>
                <a:ext uri="{FF2B5EF4-FFF2-40B4-BE49-F238E27FC236}">
                  <a16:creationId xmlns:a16="http://schemas.microsoft.com/office/drawing/2014/main" id="{8B5C21EB-FADF-49FF-9E8B-D21057EE8B7D}"/>
                </a:ext>
              </a:extLst>
            </p:cNvPr>
            <p:cNvSpPr txBox="1"/>
            <p:nvPr/>
          </p:nvSpPr>
          <p:spPr>
            <a:xfrm>
              <a:off x="7899360" y="1815665"/>
              <a:ext cx="359394" cy="246221"/>
            </a:xfrm>
            <a:prstGeom prst="rect">
              <a:avLst/>
            </a:prstGeom>
            <a:noFill/>
          </p:spPr>
          <p:txBody>
            <a:bodyPr wrap="none" rtlCol="0">
              <a:spAutoFit/>
            </a:bodyPr>
            <a:lstStyle/>
            <a:p>
              <a:r>
                <a:rPr lang="en-US" sz="1000" dirty="0"/>
                <a:t>M9</a:t>
              </a:r>
            </a:p>
          </p:txBody>
        </p:sp>
        <p:sp>
          <p:nvSpPr>
            <p:cNvPr id="85" name="TextBox 84">
              <a:extLst>
                <a:ext uri="{FF2B5EF4-FFF2-40B4-BE49-F238E27FC236}">
                  <a16:creationId xmlns:a16="http://schemas.microsoft.com/office/drawing/2014/main" id="{361031AA-18A4-4751-B7BC-54FC15E338B9}"/>
                </a:ext>
              </a:extLst>
            </p:cNvPr>
            <p:cNvSpPr txBox="1"/>
            <p:nvPr/>
          </p:nvSpPr>
          <p:spPr>
            <a:xfrm>
              <a:off x="7909635" y="1240311"/>
              <a:ext cx="359394" cy="246221"/>
            </a:xfrm>
            <a:prstGeom prst="rect">
              <a:avLst/>
            </a:prstGeom>
            <a:noFill/>
          </p:spPr>
          <p:txBody>
            <a:bodyPr wrap="none" rtlCol="0">
              <a:spAutoFit/>
            </a:bodyPr>
            <a:lstStyle/>
            <a:p>
              <a:r>
                <a:rPr lang="en-US" sz="1000" dirty="0"/>
                <a:t>M9</a:t>
              </a:r>
            </a:p>
          </p:txBody>
        </p:sp>
        <p:sp>
          <p:nvSpPr>
            <p:cNvPr id="86" name="TextBox 85">
              <a:extLst>
                <a:ext uri="{FF2B5EF4-FFF2-40B4-BE49-F238E27FC236}">
                  <a16:creationId xmlns:a16="http://schemas.microsoft.com/office/drawing/2014/main" id="{2CABADB8-9F5E-49BF-B934-7AA0EC805AFD}"/>
                </a:ext>
              </a:extLst>
            </p:cNvPr>
            <p:cNvSpPr txBox="1"/>
            <p:nvPr/>
          </p:nvSpPr>
          <p:spPr>
            <a:xfrm>
              <a:off x="7919908" y="634135"/>
              <a:ext cx="359394" cy="246221"/>
            </a:xfrm>
            <a:prstGeom prst="rect">
              <a:avLst/>
            </a:prstGeom>
            <a:noFill/>
          </p:spPr>
          <p:txBody>
            <a:bodyPr wrap="none" rtlCol="0">
              <a:spAutoFit/>
            </a:bodyPr>
            <a:lstStyle/>
            <a:p>
              <a:r>
                <a:rPr lang="en-US" sz="1000" dirty="0"/>
                <a:t>M9</a:t>
              </a:r>
            </a:p>
          </p:txBody>
        </p:sp>
      </p:grpSp>
      <p:sp>
        <p:nvSpPr>
          <p:cNvPr id="268" name="TextBox 267">
            <a:extLst>
              <a:ext uri="{FF2B5EF4-FFF2-40B4-BE49-F238E27FC236}">
                <a16:creationId xmlns:a16="http://schemas.microsoft.com/office/drawing/2014/main" id="{4A3BDAF8-D78A-4F1B-B01C-9A358250B77C}"/>
              </a:ext>
            </a:extLst>
          </p:cNvPr>
          <p:cNvSpPr txBox="1"/>
          <p:nvPr/>
        </p:nvSpPr>
        <p:spPr>
          <a:xfrm>
            <a:off x="1716887" y="8359536"/>
            <a:ext cx="5756634" cy="1015663"/>
          </a:xfrm>
          <a:prstGeom prst="rect">
            <a:avLst/>
          </a:prstGeom>
          <a:noFill/>
        </p:spPr>
        <p:txBody>
          <a:bodyPr wrap="square" rtlCol="0">
            <a:spAutoFit/>
          </a:bodyPr>
          <a:lstStyle/>
          <a:p>
            <a:r>
              <a:rPr lang="en-US" sz="1000" b="1" dirty="0"/>
              <a:t>Supplemental Figure 1. Sequential conversion of  Man5 by MGAT1, B4GalT1, ST6Gal1, and FUT8.</a:t>
            </a:r>
            <a:r>
              <a:rPr lang="en-US" sz="1000" dirty="0"/>
              <a:t> </a:t>
            </a:r>
            <a:r>
              <a:rPr lang="en-US" sz="1000" b="1" dirty="0"/>
              <a:t>A</a:t>
            </a:r>
            <a:r>
              <a:rPr lang="en-US" sz="1000" dirty="0"/>
              <a:t>) Showing the </a:t>
            </a:r>
            <a:r>
              <a:rPr lang="en-US" sz="1000" dirty="0" err="1"/>
              <a:t>GlyQ</a:t>
            </a:r>
            <a:r>
              <a:rPr lang="en-US" sz="1000" dirty="0"/>
              <a:t> analysis of sequential samples in Fig. 4A. The Man5 glycan (M5) on RNase B (RB) was the only glycan that was converted by these enzymes. It was sequentially converted by MGAT1 and B4GalT1 to M5N and M5NG, respectively. FUT8 was able to convert M5N to M5NF</a:t>
            </a:r>
            <a:r>
              <a:rPr lang="en-US" sz="1000" baseline="30000" dirty="0"/>
              <a:t>c </a:t>
            </a:r>
            <a:r>
              <a:rPr lang="en-US" sz="1000" dirty="0"/>
              <a:t>. ST6Gal1 was able to convert M5NG to M5NGS. </a:t>
            </a:r>
            <a:r>
              <a:rPr lang="en-US" sz="1000" b="1" dirty="0"/>
              <a:t>B</a:t>
            </a:r>
            <a:r>
              <a:rPr lang="en-US" sz="1000" dirty="0"/>
              <a:t>)  The molecular structures of the glycans that were converted by the sequential enzymatic reactions in panel A.</a:t>
            </a:r>
            <a:endParaRPr lang="en-US" sz="1000" baseline="30000" dirty="0"/>
          </a:p>
        </p:txBody>
      </p:sp>
      <p:sp>
        <p:nvSpPr>
          <p:cNvPr id="28" name="TextBox 27">
            <a:extLst>
              <a:ext uri="{FF2B5EF4-FFF2-40B4-BE49-F238E27FC236}">
                <a16:creationId xmlns:a16="http://schemas.microsoft.com/office/drawing/2014/main" id="{25CFA2CE-FE34-4C22-BEDF-86F8498256AC}"/>
              </a:ext>
            </a:extLst>
          </p:cNvPr>
          <p:cNvSpPr txBox="1"/>
          <p:nvPr/>
        </p:nvSpPr>
        <p:spPr>
          <a:xfrm>
            <a:off x="1641719" y="1178620"/>
            <a:ext cx="317716" cy="369332"/>
          </a:xfrm>
          <a:prstGeom prst="rect">
            <a:avLst/>
          </a:prstGeom>
          <a:noFill/>
        </p:spPr>
        <p:txBody>
          <a:bodyPr wrap="none" rtlCol="0">
            <a:spAutoFit/>
          </a:bodyPr>
          <a:lstStyle/>
          <a:p>
            <a:r>
              <a:rPr lang="en-US" dirty="0"/>
              <a:t>A</a:t>
            </a:r>
          </a:p>
        </p:txBody>
      </p:sp>
      <p:grpSp>
        <p:nvGrpSpPr>
          <p:cNvPr id="3" name="Group 2">
            <a:extLst>
              <a:ext uri="{FF2B5EF4-FFF2-40B4-BE49-F238E27FC236}">
                <a16:creationId xmlns:a16="http://schemas.microsoft.com/office/drawing/2014/main" id="{A83476E0-A43C-4C28-BB2B-0AB272BBE89A}"/>
              </a:ext>
            </a:extLst>
          </p:cNvPr>
          <p:cNvGrpSpPr/>
          <p:nvPr/>
        </p:nvGrpSpPr>
        <p:grpSpPr>
          <a:xfrm>
            <a:off x="1693684" y="5345294"/>
            <a:ext cx="5433769" cy="2464485"/>
            <a:chOff x="2992055" y="6194781"/>
            <a:chExt cx="5433769" cy="2464485"/>
          </a:xfrm>
        </p:grpSpPr>
        <p:sp>
          <p:nvSpPr>
            <p:cNvPr id="269" name="Rectangle 268">
              <a:extLst>
                <a:ext uri="{FF2B5EF4-FFF2-40B4-BE49-F238E27FC236}">
                  <a16:creationId xmlns:a16="http://schemas.microsoft.com/office/drawing/2014/main" id="{6B360C7A-0C7C-4FDD-96C1-9BA6B17CE3A8}"/>
                </a:ext>
              </a:extLst>
            </p:cNvPr>
            <p:cNvSpPr/>
            <p:nvPr/>
          </p:nvSpPr>
          <p:spPr>
            <a:xfrm>
              <a:off x="3091159" y="6623228"/>
              <a:ext cx="1240277" cy="748857"/>
            </a:xfrm>
            <a:prstGeom prst="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1" name="Rectangle 270">
              <a:extLst>
                <a:ext uri="{FF2B5EF4-FFF2-40B4-BE49-F238E27FC236}">
                  <a16:creationId xmlns:a16="http://schemas.microsoft.com/office/drawing/2014/main" id="{193AF956-62EA-44E0-88E6-D3896F706E75}"/>
                </a:ext>
              </a:extLst>
            </p:cNvPr>
            <p:cNvSpPr/>
            <p:nvPr/>
          </p:nvSpPr>
          <p:spPr>
            <a:xfrm>
              <a:off x="6716077" y="6567334"/>
              <a:ext cx="1406888" cy="864703"/>
            </a:xfrm>
            <a:prstGeom prst="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2" name="Rectangle 271">
              <a:extLst>
                <a:ext uri="{FF2B5EF4-FFF2-40B4-BE49-F238E27FC236}">
                  <a16:creationId xmlns:a16="http://schemas.microsoft.com/office/drawing/2014/main" id="{71A0ECFB-B3FD-4BED-B89C-5A358526E8A4}"/>
                </a:ext>
              </a:extLst>
            </p:cNvPr>
            <p:cNvSpPr/>
            <p:nvPr/>
          </p:nvSpPr>
          <p:spPr>
            <a:xfrm>
              <a:off x="6666381" y="7799791"/>
              <a:ext cx="1655368" cy="859475"/>
            </a:xfrm>
            <a:prstGeom prst="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Rectangle 87">
              <a:extLst>
                <a:ext uri="{FF2B5EF4-FFF2-40B4-BE49-F238E27FC236}">
                  <a16:creationId xmlns:a16="http://schemas.microsoft.com/office/drawing/2014/main" id="{1974FAA2-FB8C-46FE-AE20-A652EA55E38A}"/>
                </a:ext>
              </a:extLst>
            </p:cNvPr>
            <p:cNvSpPr/>
            <p:nvPr/>
          </p:nvSpPr>
          <p:spPr>
            <a:xfrm>
              <a:off x="4887277" y="6593728"/>
              <a:ext cx="1240277" cy="813202"/>
            </a:xfrm>
            <a:prstGeom prst="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TextBox 88">
              <a:extLst>
                <a:ext uri="{FF2B5EF4-FFF2-40B4-BE49-F238E27FC236}">
                  <a16:creationId xmlns:a16="http://schemas.microsoft.com/office/drawing/2014/main" id="{375C4BC3-FC3A-4AA2-B555-C4B5FF8F62E0}"/>
                </a:ext>
              </a:extLst>
            </p:cNvPr>
            <p:cNvSpPr txBox="1"/>
            <p:nvPr/>
          </p:nvSpPr>
          <p:spPr>
            <a:xfrm>
              <a:off x="5482500" y="7478857"/>
              <a:ext cx="428322" cy="230832"/>
            </a:xfrm>
            <a:prstGeom prst="rect">
              <a:avLst/>
            </a:prstGeom>
            <a:noFill/>
          </p:spPr>
          <p:txBody>
            <a:bodyPr wrap="none" rtlCol="0">
              <a:spAutoFit/>
            </a:bodyPr>
            <a:lstStyle/>
            <a:p>
              <a:r>
                <a:rPr lang="en-US" sz="900" b="1" dirty="0"/>
                <a:t>FUT8</a:t>
              </a:r>
            </a:p>
          </p:txBody>
        </p:sp>
        <p:cxnSp>
          <p:nvCxnSpPr>
            <p:cNvPr id="93" name="Straight Arrow Connector 92">
              <a:extLst>
                <a:ext uri="{FF2B5EF4-FFF2-40B4-BE49-F238E27FC236}">
                  <a16:creationId xmlns:a16="http://schemas.microsoft.com/office/drawing/2014/main" id="{7B68BA0D-B70C-4800-AEE0-8097D1CDA8D4}"/>
                </a:ext>
              </a:extLst>
            </p:cNvPr>
            <p:cNvCxnSpPr>
              <a:cxnSpLocks/>
            </p:cNvCxnSpPr>
            <p:nvPr/>
          </p:nvCxnSpPr>
          <p:spPr>
            <a:xfrm>
              <a:off x="4376203" y="6969300"/>
              <a:ext cx="497660" cy="1017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7E67ECBA-BAB4-4C90-A1D2-DC23A69D0F0A}"/>
                </a:ext>
              </a:extLst>
            </p:cNvPr>
            <p:cNvCxnSpPr>
              <a:cxnSpLocks/>
              <a:stCxn id="88" idx="2"/>
              <a:endCxn id="270" idx="0"/>
            </p:cNvCxnSpPr>
            <p:nvPr/>
          </p:nvCxnSpPr>
          <p:spPr>
            <a:xfrm>
              <a:off x="5507413" y="7406934"/>
              <a:ext cx="8762" cy="36955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5" name="TextBox 94">
              <a:extLst>
                <a:ext uri="{FF2B5EF4-FFF2-40B4-BE49-F238E27FC236}">
                  <a16:creationId xmlns:a16="http://schemas.microsoft.com/office/drawing/2014/main" id="{57C4BA5A-BCCF-415C-83A9-62F7C9524EE9}"/>
                </a:ext>
              </a:extLst>
            </p:cNvPr>
            <p:cNvSpPr txBox="1"/>
            <p:nvPr/>
          </p:nvSpPr>
          <p:spPr>
            <a:xfrm>
              <a:off x="4347524" y="6732011"/>
              <a:ext cx="537327" cy="230832"/>
            </a:xfrm>
            <a:prstGeom prst="rect">
              <a:avLst/>
            </a:prstGeom>
            <a:noFill/>
          </p:spPr>
          <p:txBody>
            <a:bodyPr wrap="none" rtlCol="0">
              <a:spAutoFit/>
            </a:bodyPr>
            <a:lstStyle/>
            <a:p>
              <a:r>
                <a:rPr lang="en-US" sz="900" dirty="0"/>
                <a:t>MGAT1</a:t>
              </a:r>
            </a:p>
          </p:txBody>
        </p:sp>
        <p:grpSp>
          <p:nvGrpSpPr>
            <p:cNvPr id="118" name="Group 117">
              <a:extLst>
                <a:ext uri="{FF2B5EF4-FFF2-40B4-BE49-F238E27FC236}">
                  <a16:creationId xmlns:a16="http://schemas.microsoft.com/office/drawing/2014/main" id="{A5C01786-112E-4C53-9673-99C628691D08}"/>
                </a:ext>
              </a:extLst>
            </p:cNvPr>
            <p:cNvGrpSpPr/>
            <p:nvPr/>
          </p:nvGrpSpPr>
          <p:grpSpPr>
            <a:xfrm>
              <a:off x="4971156" y="6760058"/>
              <a:ext cx="1109122" cy="628450"/>
              <a:chOff x="1598497" y="1727627"/>
              <a:chExt cx="1109122" cy="628451"/>
            </a:xfrm>
          </p:grpSpPr>
          <p:cxnSp>
            <p:nvCxnSpPr>
              <p:cNvPr id="119" name="Straight Connector 118">
                <a:extLst>
                  <a:ext uri="{FF2B5EF4-FFF2-40B4-BE49-F238E27FC236}">
                    <a16:creationId xmlns:a16="http://schemas.microsoft.com/office/drawing/2014/main" id="{0144FBC4-7BC9-42B7-BD94-80850C3F8BC2}"/>
                  </a:ext>
                </a:extLst>
              </p:cNvPr>
              <p:cNvCxnSpPr>
                <a:cxnSpLocks/>
                <a:stCxn id="123" idx="3"/>
                <a:endCxn id="124" idx="3"/>
              </p:cNvCxnSpPr>
              <p:nvPr/>
            </p:nvCxnSpPr>
            <p:spPr>
              <a:xfrm flipH="1">
                <a:off x="1897838" y="2145083"/>
                <a:ext cx="208532" cy="17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0" name="Straight Connector 119">
                <a:extLst>
                  <a:ext uri="{FF2B5EF4-FFF2-40B4-BE49-F238E27FC236}">
                    <a16:creationId xmlns:a16="http://schemas.microsoft.com/office/drawing/2014/main" id="{E44459FD-EDA6-438A-8F54-391D0D883776}"/>
                  </a:ext>
                </a:extLst>
              </p:cNvPr>
              <p:cNvCxnSpPr>
                <a:cxnSpLocks/>
                <a:stCxn id="123" idx="1"/>
                <a:endCxn id="125" idx="1"/>
              </p:cNvCxnSpPr>
              <p:nvPr/>
            </p:nvCxnSpPr>
            <p:spPr>
              <a:xfrm flipH="1" flipV="1">
                <a:off x="1894409" y="1884919"/>
                <a:ext cx="211961" cy="152400"/>
              </a:xfrm>
              <a:prstGeom prst="line">
                <a:avLst/>
              </a:prstGeom>
            </p:spPr>
            <p:style>
              <a:lnRef idx="1">
                <a:schemeClr val="accent1"/>
              </a:lnRef>
              <a:fillRef idx="0">
                <a:schemeClr val="accent1"/>
              </a:fillRef>
              <a:effectRef idx="0">
                <a:schemeClr val="accent1"/>
              </a:effectRef>
              <a:fontRef idx="minor">
                <a:schemeClr val="tx1"/>
              </a:fontRef>
            </p:style>
          </p:cxnSp>
          <p:sp>
            <p:nvSpPr>
              <p:cNvPr id="121" name="Rectangle 120">
                <a:extLst>
                  <a:ext uri="{FF2B5EF4-FFF2-40B4-BE49-F238E27FC236}">
                    <a16:creationId xmlns:a16="http://schemas.microsoft.com/office/drawing/2014/main" id="{4D8128B1-EE1F-4D88-B271-312E79D8ACA1}"/>
                  </a:ext>
                </a:extLst>
              </p:cNvPr>
              <p:cNvSpPr/>
              <p:nvPr/>
            </p:nvSpPr>
            <p:spPr>
              <a:xfrm>
                <a:off x="2555219" y="2031875"/>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22" name="Rectangle 121">
                <a:extLst>
                  <a:ext uri="{FF2B5EF4-FFF2-40B4-BE49-F238E27FC236}">
                    <a16:creationId xmlns:a16="http://schemas.microsoft.com/office/drawing/2014/main" id="{1A7C6D5F-0639-491F-BD3E-76CCFF6A3A78}"/>
                  </a:ext>
                </a:extLst>
              </p:cNvPr>
              <p:cNvSpPr/>
              <p:nvPr/>
            </p:nvSpPr>
            <p:spPr>
              <a:xfrm>
                <a:off x="2333706" y="2031875"/>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23" name="Oval 122">
                <a:extLst>
                  <a:ext uri="{FF2B5EF4-FFF2-40B4-BE49-F238E27FC236}">
                    <a16:creationId xmlns:a16="http://schemas.microsoft.com/office/drawing/2014/main" id="{B8E4AF3F-5169-485C-A406-D7B83A0BEFF8}"/>
                  </a:ext>
                </a:extLst>
              </p:cNvPr>
              <p:cNvSpPr/>
              <p:nvPr/>
            </p:nvSpPr>
            <p:spPr>
              <a:xfrm>
                <a:off x="2084052" y="2015001"/>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itchFamily="34" charset="0"/>
                  <a:cs typeface="Arial" pitchFamily="34" charset="0"/>
                </a:endParaRPr>
              </a:p>
            </p:txBody>
          </p:sp>
          <p:sp>
            <p:nvSpPr>
              <p:cNvPr id="124" name="Oval 123">
                <a:extLst>
                  <a:ext uri="{FF2B5EF4-FFF2-40B4-BE49-F238E27FC236}">
                    <a16:creationId xmlns:a16="http://schemas.microsoft.com/office/drawing/2014/main" id="{2475A731-32FC-4089-897D-88DF5122F2D8}"/>
                  </a:ext>
                </a:extLst>
              </p:cNvPr>
              <p:cNvSpPr/>
              <p:nvPr/>
            </p:nvSpPr>
            <p:spPr>
              <a:xfrm>
                <a:off x="1875520" y="2187861"/>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25" name="Oval 124">
                <a:extLst>
                  <a:ext uri="{FF2B5EF4-FFF2-40B4-BE49-F238E27FC236}">
                    <a16:creationId xmlns:a16="http://schemas.microsoft.com/office/drawing/2014/main" id="{713BBD68-704B-4D2C-BC44-65BE97ECB67F}"/>
                  </a:ext>
                </a:extLst>
              </p:cNvPr>
              <p:cNvSpPr/>
              <p:nvPr/>
            </p:nvSpPr>
            <p:spPr>
              <a:xfrm>
                <a:off x="1872091" y="1862601"/>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26" name="Oval 125">
                <a:extLst>
                  <a:ext uri="{FF2B5EF4-FFF2-40B4-BE49-F238E27FC236}">
                    <a16:creationId xmlns:a16="http://schemas.microsoft.com/office/drawing/2014/main" id="{9E7BEE70-0B02-45D5-BBF3-BB065FF489A6}"/>
                  </a:ext>
                </a:extLst>
              </p:cNvPr>
              <p:cNvSpPr/>
              <p:nvPr/>
            </p:nvSpPr>
            <p:spPr>
              <a:xfrm>
                <a:off x="1605434" y="1727627"/>
                <a:ext cx="152400" cy="152400"/>
              </a:xfrm>
              <a:prstGeom prst="ellipse">
                <a:avLst/>
              </a:prstGeom>
              <a:solidFill>
                <a:srgbClr val="00B050"/>
              </a:solid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27" name="Oval 126">
                <a:extLst>
                  <a:ext uri="{FF2B5EF4-FFF2-40B4-BE49-F238E27FC236}">
                    <a16:creationId xmlns:a16="http://schemas.microsoft.com/office/drawing/2014/main" id="{B2A04F10-88F8-425A-A05F-53CD09C608F2}"/>
                  </a:ext>
                </a:extLst>
              </p:cNvPr>
              <p:cNvSpPr/>
              <p:nvPr/>
            </p:nvSpPr>
            <p:spPr>
              <a:xfrm>
                <a:off x="1598497" y="1959503"/>
                <a:ext cx="152400" cy="152400"/>
              </a:xfrm>
              <a:prstGeom prst="ellipse">
                <a:avLst/>
              </a:prstGeom>
              <a:solidFill>
                <a:srgbClr val="00B050"/>
              </a:solid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128" name="Straight Connector 127">
                <a:extLst>
                  <a:ext uri="{FF2B5EF4-FFF2-40B4-BE49-F238E27FC236}">
                    <a16:creationId xmlns:a16="http://schemas.microsoft.com/office/drawing/2014/main" id="{A6A1FA2E-C683-41F5-9652-5B1457E19C58}"/>
                  </a:ext>
                </a:extLst>
              </p:cNvPr>
              <p:cNvCxnSpPr>
                <a:cxnSpLocks/>
                <a:stCxn id="121" idx="3"/>
                <a:endCxn id="123" idx="6"/>
              </p:cNvCxnSpPr>
              <p:nvPr/>
            </p:nvCxnSpPr>
            <p:spPr>
              <a:xfrm flipH="1">
                <a:off x="2236452" y="2090723"/>
                <a:ext cx="471167" cy="478"/>
              </a:xfrm>
              <a:prstGeom prst="line">
                <a:avLst/>
              </a:prstGeom>
            </p:spPr>
            <p:style>
              <a:lnRef idx="1">
                <a:schemeClr val="accent1"/>
              </a:lnRef>
              <a:fillRef idx="0">
                <a:schemeClr val="accent1"/>
              </a:fillRef>
              <a:effectRef idx="0">
                <a:schemeClr val="accent1"/>
              </a:effectRef>
              <a:fontRef idx="minor">
                <a:schemeClr val="tx1"/>
              </a:fontRef>
            </p:style>
          </p:cxnSp>
          <p:cxnSp>
            <p:nvCxnSpPr>
              <p:cNvPr id="129" name="Straight Connector 128">
                <a:extLst>
                  <a:ext uri="{FF2B5EF4-FFF2-40B4-BE49-F238E27FC236}">
                    <a16:creationId xmlns:a16="http://schemas.microsoft.com/office/drawing/2014/main" id="{9DB6F729-F5C4-4397-842E-688E07A864E2}"/>
                  </a:ext>
                </a:extLst>
              </p:cNvPr>
              <p:cNvCxnSpPr>
                <a:stCxn id="125" idx="2"/>
                <a:endCxn id="126" idx="5"/>
              </p:cNvCxnSpPr>
              <p:nvPr/>
            </p:nvCxnSpPr>
            <p:spPr>
              <a:xfrm flipH="1" flipV="1">
                <a:off x="1735516" y="1857709"/>
                <a:ext cx="136575" cy="81092"/>
              </a:xfrm>
              <a:prstGeom prst="line">
                <a:avLst/>
              </a:prstGeom>
            </p:spPr>
            <p:style>
              <a:lnRef idx="1">
                <a:schemeClr val="accent1"/>
              </a:lnRef>
              <a:fillRef idx="0">
                <a:schemeClr val="accent1"/>
              </a:fillRef>
              <a:effectRef idx="0">
                <a:schemeClr val="accent1"/>
              </a:effectRef>
              <a:fontRef idx="minor">
                <a:schemeClr val="tx1"/>
              </a:fontRef>
            </p:style>
          </p:cxnSp>
          <p:cxnSp>
            <p:nvCxnSpPr>
              <p:cNvPr id="130" name="Straight Connector 129">
                <a:extLst>
                  <a:ext uri="{FF2B5EF4-FFF2-40B4-BE49-F238E27FC236}">
                    <a16:creationId xmlns:a16="http://schemas.microsoft.com/office/drawing/2014/main" id="{BD683A7F-E1C3-4896-9F01-C8189060A43B}"/>
                  </a:ext>
                </a:extLst>
              </p:cNvPr>
              <p:cNvCxnSpPr>
                <a:cxnSpLocks/>
                <a:stCxn id="127" idx="7"/>
                <a:endCxn id="125" idx="2"/>
              </p:cNvCxnSpPr>
              <p:nvPr/>
            </p:nvCxnSpPr>
            <p:spPr>
              <a:xfrm flipV="1">
                <a:off x="1728579" y="1938801"/>
                <a:ext cx="143512" cy="43020"/>
              </a:xfrm>
              <a:prstGeom prst="line">
                <a:avLst/>
              </a:prstGeom>
            </p:spPr>
            <p:style>
              <a:lnRef idx="1">
                <a:schemeClr val="accent1"/>
              </a:lnRef>
              <a:fillRef idx="0">
                <a:schemeClr val="accent1"/>
              </a:fillRef>
              <a:effectRef idx="0">
                <a:schemeClr val="accent1"/>
              </a:effectRef>
              <a:fontRef idx="minor">
                <a:schemeClr val="tx1"/>
              </a:fontRef>
            </p:style>
          </p:cxnSp>
          <p:sp>
            <p:nvSpPr>
              <p:cNvPr id="131" name="Rectangle 130">
                <a:extLst>
                  <a:ext uri="{FF2B5EF4-FFF2-40B4-BE49-F238E27FC236}">
                    <a16:creationId xmlns:a16="http://schemas.microsoft.com/office/drawing/2014/main" id="{C171F3B0-144C-4287-B0CD-078B16C81EE0}"/>
                  </a:ext>
                </a:extLst>
              </p:cNvPr>
              <p:cNvSpPr/>
              <p:nvPr/>
            </p:nvSpPr>
            <p:spPr>
              <a:xfrm>
                <a:off x="1602665" y="2209141"/>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cxnSp>
            <p:nvCxnSpPr>
              <p:cNvPr id="132" name="Straight Connector 131">
                <a:extLst>
                  <a:ext uri="{FF2B5EF4-FFF2-40B4-BE49-F238E27FC236}">
                    <a16:creationId xmlns:a16="http://schemas.microsoft.com/office/drawing/2014/main" id="{DFCC3215-7468-401E-8671-B3B30434DE00}"/>
                  </a:ext>
                </a:extLst>
              </p:cNvPr>
              <p:cNvCxnSpPr>
                <a:stCxn id="131" idx="3"/>
                <a:endCxn id="124" idx="2"/>
              </p:cNvCxnSpPr>
              <p:nvPr/>
            </p:nvCxnSpPr>
            <p:spPr>
              <a:xfrm flipV="1">
                <a:off x="1755065" y="2264061"/>
                <a:ext cx="120455" cy="3928"/>
              </a:xfrm>
              <a:prstGeom prst="line">
                <a:avLst/>
              </a:prstGeom>
            </p:spPr>
            <p:style>
              <a:lnRef idx="1">
                <a:schemeClr val="accent1"/>
              </a:lnRef>
              <a:fillRef idx="0">
                <a:schemeClr val="accent1"/>
              </a:fillRef>
              <a:effectRef idx="0">
                <a:schemeClr val="accent1"/>
              </a:effectRef>
              <a:fontRef idx="minor">
                <a:schemeClr val="tx1"/>
              </a:fontRef>
            </p:style>
          </p:cxnSp>
          <p:sp>
            <p:nvSpPr>
              <p:cNvPr id="133" name="TextBox 132">
                <a:extLst>
                  <a:ext uri="{FF2B5EF4-FFF2-40B4-BE49-F238E27FC236}">
                    <a16:creationId xmlns:a16="http://schemas.microsoft.com/office/drawing/2014/main" id="{60FA5BBA-33FF-4B31-9F77-2F1294B13825}"/>
                  </a:ext>
                </a:extLst>
              </p:cNvPr>
              <p:cNvSpPr txBox="1"/>
              <p:nvPr/>
            </p:nvSpPr>
            <p:spPr>
              <a:xfrm>
                <a:off x="1681890" y="2069959"/>
                <a:ext cx="290464" cy="215444"/>
              </a:xfrm>
              <a:prstGeom prst="rect">
                <a:avLst/>
              </a:prstGeom>
              <a:noFill/>
            </p:spPr>
            <p:txBody>
              <a:bodyPr wrap="none" rtlCol="0">
                <a:spAutoFit/>
              </a:bodyPr>
              <a:lstStyle/>
              <a:p>
                <a:r>
                  <a:rPr lang="el-GR" sz="800" dirty="0"/>
                  <a:t>β</a:t>
                </a:r>
                <a:r>
                  <a:rPr lang="en-US" sz="800" dirty="0"/>
                  <a:t>2</a:t>
                </a:r>
              </a:p>
            </p:txBody>
          </p:sp>
          <p:sp>
            <p:nvSpPr>
              <p:cNvPr id="134" name="TextBox 133">
                <a:extLst>
                  <a:ext uri="{FF2B5EF4-FFF2-40B4-BE49-F238E27FC236}">
                    <a16:creationId xmlns:a16="http://schemas.microsoft.com/office/drawing/2014/main" id="{4E4DC73A-9285-4F92-B2BC-BCEE9C6843B7}"/>
                  </a:ext>
                </a:extLst>
              </p:cNvPr>
              <p:cNvSpPr txBox="1"/>
              <p:nvPr/>
            </p:nvSpPr>
            <p:spPr>
              <a:xfrm>
                <a:off x="1966070" y="1813050"/>
                <a:ext cx="293670" cy="215444"/>
              </a:xfrm>
              <a:prstGeom prst="rect">
                <a:avLst/>
              </a:prstGeom>
              <a:noFill/>
            </p:spPr>
            <p:txBody>
              <a:bodyPr wrap="none" rtlCol="0">
                <a:spAutoFit/>
              </a:bodyPr>
              <a:lstStyle/>
              <a:p>
                <a:r>
                  <a:rPr lang="el-GR" sz="800" dirty="0"/>
                  <a:t>α</a:t>
                </a:r>
                <a:r>
                  <a:rPr lang="en-US" sz="800" dirty="0"/>
                  <a:t>6</a:t>
                </a:r>
              </a:p>
            </p:txBody>
          </p:sp>
          <p:sp>
            <p:nvSpPr>
              <p:cNvPr id="135" name="TextBox 134">
                <a:extLst>
                  <a:ext uri="{FF2B5EF4-FFF2-40B4-BE49-F238E27FC236}">
                    <a16:creationId xmlns:a16="http://schemas.microsoft.com/office/drawing/2014/main" id="{072C2969-13E9-4A8E-8952-29476C11D260}"/>
                  </a:ext>
                </a:extLst>
              </p:cNvPr>
              <p:cNvSpPr txBox="1"/>
              <p:nvPr/>
            </p:nvSpPr>
            <p:spPr>
              <a:xfrm>
                <a:off x="1966070" y="2140634"/>
                <a:ext cx="293670" cy="215444"/>
              </a:xfrm>
              <a:prstGeom prst="rect">
                <a:avLst/>
              </a:prstGeom>
              <a:noFill/>
            </p:spPr>
            <p:txBody>
              <a:bodyPr wrap="none" rtlCol="0">
                <a:spAutoFit/>
              </a:bodyPr>
              <a:lstStyle/>
              <a:p>
                <a:r>
                  <a:rPr lang="el-GR" sz="800" dirty="0"/>
                  <a:t>α</a:t>
                </a:r>
                <a:r>
                  <a:rPr lang="en-US" sz="800" dirty="0"/>
                  <a:t>3</a:t>
                </a:r>
              </a:p>
            </p:txBody>
          </p:sp>
        </p:grpSp>
        <p:sp>
          <p:nvSpPr>
            <p:cNvPr id="137" name="Oval 136">
              <a:extLst>
                <a:ext uri="{FF2B5EF4-FFF2-40B4-BE49-F238E27FC236}">
                  <a16:creationId xmlns:a16="http://schemas.microsoft.com/office/drawing/2014/main" id="{9E29050F-B87C-49DF-97E8-50532A979A1B}"/>
                </a:ext>
              </a:extLst>
            </p:cNvPr>
            <p:cNvSpPr/>
            <p:nvPr/>
          </p:nvSpPr>
          <p:spPr>
            <a:xfrm>
              <a:off x="3178610" y="6749371"/>
              <a:ext cx="152400" cy="152400"/>
            </a:xfrm>
            <a:prstGeom prst="ellipse">
              <a:avLst/>
            </a:prstGeom>
            <a:solidFill>
              <a:srgbClr val="00B050"/>
            </a:solidFill>
            <a:ln w="12700">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138" name="Straight Connector 137">
              <a:extLst>
                <a:ext uri="{FF2B5EF4-FFF2-40B4-BE49-F238E27FC236}">
                  <a16:creationId xmlns:a16="http://schemas.microsoft.com/office/drawing/2014/main" id="{438099C5-2A0E-4057-BC4D-300AB5F12FF6}"/>
                </a:ext>
              </a:extLst>
            </p:cNvPr>
            <p:cNvCxnSpPr>
              <a:cxnSpLocks/>
              <a:stCxn id="142" idx="3"/>
              <a:endCxn id="143" idx="3"/>
            </p:cNvCxnSpPr>
            <p:nvPr/>
          </p:nvCxnSpPr>
          <p:spPr>
            <a:xfrm flipH="1">
              <a:off x="3466956" y="7161940"/>
              <a:ext cx="212590" cy="160312"/>
            </a:xfrm>
            <a:prstGeom prst="line">
              <a:avLst/>
            </a:prstGeom>
          </p:spPr>
          <p:style>
            <a:lnRef idx="1">
              <a:schemeClr val="accent1"/>
            </a:lnRef>
            <a:fillRef idx="0">
              <a:schemeClr val="accent1"/>
            </a:fillRef>
            <a:effectRef idx="0">
              <a:schemeClr val="accent1"/>
            </a:effectRef>
            <a:fontRef idx="minor">
              <a:schemeClr val="tx1"/>
            </a:fontRef>
          </p:style>
        </p:cxnSp>
        <p:cxnSp>
          <p:nvCxnSpPr>
            <p:cNvPr id="139" name="Straight Connector 138">
              <a:extLst>
                <a:ext uri="{FF2B5EF4-FFF2-40B4-BE49-F238E27FC236}">
                  <a16:creationId xmlns:a16="http://schemas.microsoft.com/office/drawing/2014/main" id="{86983AA2-A980-4E56-AF24-EB502190B9D5}"/>
                </a:ext>
              </a:extLst>
            </p:cNvPr>
            <p:cNvCxnSpPr>
              <a:cxnSpLocks/>
              <a:stCxn id="142" idx="5"/>
              <a:endCxn id="144" idx="5"/>
            </p:cNvCxnSpPr>
            <p:nvPr/>
          </p:nvCxnSpPr>
          <p:spPr>
            <a:xfrm flipH="1" flipV="1">
              <a:off x="3575354" y="7009534"/>
              <a:ext cx="211962" cy="152400"/>
            </a:xfrm>
            <a:prstGeom prst="line">
              <a:avLst/>
            </a:prstGeom>
          </p:spPr>
          <p:style>
            <a:lnRef idx="1">
              <a:schemeClr val="accent1"/>
            </a:lnRef>
            <a:fillRef idx="0">
              <a:schemeClr val="accent1"/>
            </a:fillRef>
            <a:effectRef idx="0">
              <a:schemeClr val="accent1"/>
            </a:effectRef>
            <a:fontRef idx="minor">
              <a:schemeClr val="tx1"/>
            </a:fontRef>
          </p:style>
        </p:cxnSp>
        <p:sp>
          <p:nvSpPr>
            <p:cNvPr id="140" name="Rectangle 139">
              <a:extLst>
                <a:ext uri="{FF2B5EF4-FFF2-40B4-BE49-F238E27FC236}">
                  <a16:creationId xmlns:a16="http://schemas.microsoft.com/office/drawing/2014/main" id="{CBA23B03-3BF1-48E0-8E8E-F57F065C43F3}"/>
                </a:ext>
              </a:extLst>
            </p:cNvPr>
            <p:cNvSpPr/>
            <p:nvPr/>
          </p:nvSpPr>
          <p:spPr>
            <a:xfrm>
              <a:off x="4128396" y="7048733"/>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41" name="Rectangle 140">
              <a:extLst>
                <a:ext uri="{FF2B5EF4-FFF2-40B4-BE49-F238E27FC236}">
                  <a16:creationId xmlns:a16="http://schemas.microsoft.com/office/drawing/2014/main" id="{9ABFE541-C300-4CDC-90CC-8C75928734B4}"/>
                </a:ext>
              </a:extLst>
            </p:cNvPr>
            <p:cNvSpPr/>
            <p:nvPr/>
          </p:nvSpPr>
          <p:spPr>
            <a:xfrm>
              <a:off x="3906881" y="7048733"/>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42" name="Oval 141">
              <a:extLst>
                <a:ext uri="{FF2B5EF4-FFF2-40B4-BE49-F238E27FC236}">
                  <a16:creationId xmlns:a16="http://schemas.microsoft.com/office/drawing/2014/main" id="{9DD357E6-B155-43A8-ADBE-A0C1ED443A72}"/>
                </a:ext>
              </a:extLst>
            </p:cNvPr>
            <p:cNvSpPr/>
            <p:nvPr/>
          </p:nvSpPr>
          <p:spPr>
            <a:xfrm>
              <a:off x="3657228" y="7031854"/>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itchFamily="34" charset="0"/>
                <a:cs typeface="Arial" pitchFamily="34" charset="0"/>
              </a:endParaRPr>
            </a:p>
          </p:txBody>
        </p:sp>
        <p:sp>
          <p:nvSpPr>
            <p:cNvPr id="143" name="Oval 142">
              <a:extLst>
                <a:ext uri="{FF2B5EF4-FFF2-40B4-BE49-F238E27FC236}">
                  <a16:creationId xmlns:a16="http://schemas.microsoft.com/office/drawing/2014/main" id="{20015486-8F14-4433-942A-F9508D85A0E1}"/>
                </a:ext>
              </a:extLst>
            </p:cNvPr>
            <p:cNvSpPr/>
            <p:nvPr/>
          </p:nvSpPr>
          <p:spPr>
            <a:xfrm>
              <a:off x="3444640" y="7192164"/>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44" name="Oval 143">
              <a:extLst>
                <a:ext uri="{FF2B5EF4-FFF2-40B4-BE49-F238E27FC236}">
                  <a16:creationId xmlns:a16="http://schemas.microsoft.com/office/drawing/2014/main" id="{C02AAABF-B26F-4805-9802-67E8D82CECC2}"/>
                </a:ext>
              </a:extLst>
            </p:cNvPr>
            <p:cNvSpPr/>
            <p:nvPr/>
          </p:nvSpPr>
          <p:spPr>
            <a:xfrm>
              <a:off x="3445266" y="6879454"/>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45" name="Oval 144">
              <a:extLst>
                <a:ext uri="{FF2B5EF4-FFF2-40B4-BE49-F238E27FC236}">
                  <a16:creationId xmlns:a16="http://schemas.microsoft.com/office/drawing/2014/main" id="{FB4C0F9E-FCF0-436A-9CDE-42C7B07EC571}"/>
                </a:ext>
              </a:extLst>
            </p:cNvPr>
            <p:cNvSpPr/>
            <p:nvPr/>
          </p:nvSpPr>
          <p:spPr>
            <a:xfrm>
              <a:off x="3171675" y="6976356"/>
              <a:ext cx="152400" cy="152400"/>
            </a:xfrm>
            <a:prstGeom prst="ellipse">
              <a:avLst/>
            </a:prstGeom>
            <a:solidFill>
              <a:srgbClr val="00B050"/>
            </a:solidFill>
            <a:ln w="12700">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146" name="Straight Connector 145">
              <a:extLst>
                <a:ext uri="{FF2B5EF4-FFF2-40B4-BE49-F238E27FC236}">
                  <a16:creationId xmlns:a16="http://schemas.microsoft.com/office/drawing/2014/main" id="{6EFE64FE-B35E-4BFB-9BA3-8CA3DFDB6A6E}"/>
                </a:ext>
              </a:extLst>
            </p:cNvPr>
            <p:cNvCxnSpPr>
              <a:cxnSpLocks/>
              <a:stCxn id="140" idx="3"/>
              <a:endCxn id="142" idx="6"/>
            </p:cNvCxnSpPr>
            <p:nvPr/>
          </p:nvCxnSpPr>
          <p:spPr>
            <a:xfrm flipH="1">
              <a:off x="3809635" y="7107580"/>
              <a:ext cx="471167" cy="478"/>
            </a:xfrm>
            <a:prstGeom prst="line">
              <a:avLst/>
            </a:prstGeom>
          </p:spPr>
          <p:style>
            <a:lnRef idx="1">
              <a:schemeClr val="accent1"/>
            </a:lnRef>
            <a:fillRef idx="0">
              <a:schemeClr val="accent1"/>
            </a:fillRef>
            <a:effectRef idx="0">
              <a:schemeClr val="accent1"/>
            </a:effectRef>
            <a:fontRef idx="minor">
              <a:schemeClr val="tx1"/>
            </a:fontRef>
          </p:style>
        </p:cxnSp>
        <p:cxnSp>
          <p:nvCxnSpPr>
            <p:cNvPr id="147" name="Straight Connector 146">
              <a:extLst>
                <a:ext uri="{FF2B5EF4-FFF2-40B4-BE49-F238E27FC236}">
                  <a16:creationId xmlns:a16="http://schemas.microsoft.com/office/drawing/2014/main" id="{5BF552CE-565B-4134-8E34-8A8CF0A67558}"/>
                </a:ext>
              </a:extLst>
            </p:cNvPr>
            <p:cNvCxnSpPr>
              <a:cxnSpLocks/>
              <a:stCxn id="144" idx="2"/>
              <a:endCxn id="137" idx="5"/>
            </p:cNvCxnSpPr>
            <p:nvPr/>
          </p:nvCxnSpPr>
          <p:spPr>
            <a:xfrm flipH="1" flipV="1">
              <a:off x="3308698" y="6888333"/>
              <a:ext cx="136575" cy="67322"/>
            </a:xfrm>
            <a:prstGeom prst="line">
              <a:avLst/>
            </a:prstGeom>
          </p:spPr>
          <p:style>
            <a:lnRef idx="1">
              <a:schemeClr val="accent1"/>
            </a:lnRef>
            <a:fillRef idx="0">
              <a:schemeClr val="accent1"/>
            </a:fillRef>
            <a:effectRef idx="0">
              <a:schemeClr val="accent1"/>
            </a:effectRef>
            <a:fontRef idx="minor">
              <a:schemeClr val="tx1"/>
            </a:fontRef>
          </p:style>
        </p:cxnSp>
        <p:cxnSp>
          <p:nvCxnSpPr>
            <p:cNvPr id="148" name="Straight Connector 147">
              <a:extLst>
                <a:ext uri="{FF2B5EF4-FFF2-40B4-BE49-F238E27FC236}">
                  <a16:creationId xmlns:a16="http://schemas.microsoft.com/office/drawing/2014/main" id="{EE6E207E-F85D-45A0-A17F-0B6CAEBBAA59}"/>
                </a:ext>
              </a:extLst>
            </p:cNvPr>
            <p:cNvCxnSpPr>
              <a:cxnSpLocks/>
              <a:stCxn id="145" idx="7"/>
              <a:endCxn id="144" idx="2"/>
            </p:cNvCxnSpPr>
            <p:nvPr/>
          </p:nvCxnSpPr>
          <p:spPr>
            <a:xfrm flipV="1">
              <a:off x="3301755" y="6955653"/>
              <a:ext cx="143512" cy="43020"/>
            </a:xfrm>
            <a:prstGeom prst="line">
              <a:avLst/>
            </a:prstGeom>
          </p:spPr>
          <p:style>
            <a:lnRef idx="1">
              <a:schemeClr val="accent1"/>
            </a:lnRef>
            <a:fillRef idx="0">
              <a:schemeClr val="accent1"/>
            </a:fillRef>
            <a:effectRef idx="0">
              <a:schemeClr val="accent1"/>
            </a:effectRef>
            <a:fontRef idx="minor">
              <a:schemeClr val="tx1"/>
            </a:fontRef>
          </p:style>
        </p:cxnSp>
        <p:sp>
          <p:nvSpPr>
            <p:cNvPr id="149" name="TextBox 148">
              <a:extLst>
                <a:ext uri="{FF2B5EF4-FFF2-40B4-BE49-F238E27FC236}">
                  <a16:creationId xmlns:a16="http://schemas.microsoft.com/office/drawing/2014/main" id="{65D5EE51-332E-4531-B476-D85EA6CCB76E}"/>
                </a:ext>
              </a:extLst>
            </p:cNvPr>
            <p:cNvSpPr txBox="1"/>
            <p:nvPr/>
          </p:nvSpPr>
          <p:spPr>
            <a:xfrm>
              <a:off x="3522501" y="6879498"/>
              <a:ext cx="293670" cy="215444"/>
            </a:xfrm>
            <a:prstGeom prst="rect">
              <a:avLst/>
            </a:prstGeom>
            <a:noFill/>
          </p:spPr>
          <p:txBody>
            <a:bodyPr wrap="none" rtlCol="0">
              <a:spAutoFit/>
            </a:bodyPr>
            <a:lstStyle/>
            <a:p>
              <a:r>
                <a:rPr lang="el-GR" sz="800" dirty="0"/>
                <a:t>α</a:t>
              </a:r>
              <a:r>
                <a:rPr lang="en-US" sz="800" dirty="0"/>
                <a:t>6</a:t>
              </a:r>
            </a:p>
          </p:txBody>
        </p:sp>
        <p:sp>
          <p:nvSpPr>
            <p:cNvPr id="150" name="TextBox 149">
              <a:extLst>
                <a:ext uri="{FF2B5EF4-FFF2-40B4-BE49-F238E27FC236}">
                  <a16:creationId xmlns:a16="http://schemas.microsoft.com/office/drawing/2014/main" id="{B2AC32A0-BFCA-4086-B704-A24CD67578E5}"/>
                </a:ext>
              </a:extLst>
            </p:cNvPr>
            <p:cNvSpPr txBox="1"/>
            <p:nvPr/>
          </p:nvSpPr>
          <p:spPr>
            <a:xfrm>
              <a:off x="3531701" y="7150573"/>
              <a:ext cx="293670" cy="215444"/>
            </a:xfrm>
            <a:prstGeom prst="rect">
              <a:avLst/>
            </a:prstGeom>
            <a:noFill/>
          </p:spPr>
          <p:txBody>
            <a:bodyPr wrap="none" rtlCol="0">
              <a:spAutoFit/>
            </a:bodyPr>
            <a:lstStyle/>
            <a:p>
              <a:r>
                <a:rPr lang="el-GR" sz="800" dirty="0"/>
                <a:t>α</a:t>
              </a:r>
              <a:r>
                <a:rPr lang="en-US" sz="800" dirty="0"/>
                <a:t>3</a:t>
              </a:r>
            </a:p>
          </p:txBody>
        </p:sp>
        <p:sp>
          <p:nvSpPr>
            <p:cNvPr id="151" name="TextBox 150">
              <a:extLst>
                <a:ext uri="{FF2B5EF4-FFF2-40B4-BE49-F238E27FC236}">
                  <a16:creationId xmlns:a16="http://schemas.microsoft.com/office/drawing/2014/main" id="{44471AEF-EDAA-457B-AEEF-50E755BB984A}"/>
                </a:ext>
              </a:extLst>
            </p:cNvPr>
            <p:cNvSpPr txBox="1"/>
            <p:nvPr/>
          </p:nvSpPr>
          <p:spPr>
            <a:xfrm>
              <a:off x="3996353" y="6615527"/>
              <a:ext cx="460597" cy="246221"/>
            </a:xfrm>
            <a:prstGeom prst="rect">
              <a:avLst/>
            </a:prstGeom>
            <a:noFill/>
          </p:spPr>
          <p:txBody>
            <a:bodyPr wrap="square" rtlCol="0">
              <a:spAutoFit/>
            </a:bodyPr>
            <a:lstStyle/>
            <a:p>
              <a:r>
                <a:rPr lang="en-US" sz="1000" b="1" dirty="0"/>
                <a:t>M5</a:t>
              </a:r>
            </a:p>
          </p:txBody>
        </p:sp>
        <p:sp>
          <p:nvSpPr>
            <p:cNvPr id="152" name="TextBox 151">
              <a:extLst>
                <a:ext uri="{FF2B5EF4-FFF2-40B4-BE49-F238E27FC236}">
                  <a16:creationId xmlns:a16="http://schemas.microsoft.com/office/drawing/2014/main" id="{6841DE09-533E-4AC8-A178-D6DC7F094109}"/>
                </a:ext>
              </a:extLst>
            </p:cNvPr>
            <p:cNvSpPr txBox="1"/>
            <p:nvPr/>
          </p:nvSpPr>
          <p:spPr>
            <a:xfrm>
              <a:off x="5686981" y="6603069"/>
              <a:ext cx="607510" cy="246221"/>
            </a:xfrm>
            <a:prstGeom prst="rect">
              <a:avLst/>
            </a:prstGeom>
            <a:noFill/>
          </p:spPr>
          <p:txBody>
            <a:bodyPr wrap="square" rtlCol="0">
              <a:spAutoFit/>
            </a:bodyPr>
            <a:lstStyle/>
            <a:p>
              <a:r>
                <a:rPr lang="en-US" sz="1000" b="1" dirty="0">
                  <a:solidFill>
                    <a:srgbClr val="C00000"/>
                  </a:solidFill>
                </a:rPr>
                <a:t>M5N</a:t>
              </a:r>
            </a:p>
          </p:txBody>
        </p:sp>
        <p:grpSp>
          <p:nvGrpSpPr>
            <p:cNvPr id="153" name="Group 152">
              <a:extLst>
                <a:ext uri="{FF2B5EF4-FFF2-40B4-BE49-F238E27FC236}">
                  <a16:creationId xmlns:a16="http://schemas.microsoft.com/office/drawing/2014/main" id="{3CE71988-F833-4877-BA94-CBAC0F1BAD4F}"/>
                </a:ext>
              </a:extLst>
            </p:cNvPr>
            <p:cNvGrpSpPr/>
            <p:nvPr/>
          </p:nvGrpSpPr>
          <p:grpSpPr>
            <a:xfrm>
              <a:off x="6733420" y="6692918"/>
              <a:ext cx="1355150" cy="669554"/>
              <a:chOff x="2969557" y="2219469"/>
              <a:chExt cx="1355150" cy="618994"/>
            </a:xfrm>
          </p:grpSpPr>
          <p:cxnSp>
            <p:nvCxnSpPr>
              <p:cNvPr id="154" name="Straight Connector 153">
                <a:extLst>
                  <a:ext uri="{FF2B5EF4-FFF2-40B4-BE49-F238E27FC236}">
                    <a16:creationId xmlns:a16="http://schemas.microsoft.com/office/drawing/2014/main" id="{B64926F0-25CF-4AFF-B4F3-285FA868CD75}"/>
                  </a:ext>
                </a:extLst>
              </p:cNvPr>
              <p:cNvCxnSpPr>
                <a:cxnSpLocks/>
                <a:stCxn id="158" idx="3"/>
                <a:endCxn id="159" idx="3"/>
              </p:cNvCxnSpPr>
              <p:nvPr/>
            </p:nvCxnSpPr>
            <p:spPr>
              <a:xfrm flipH="1">
                <a:off x="3514926" y="2636925"/>
                <a:ext cx="208532" cy="17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5" name="Straight Connector 154">
                <a:extLst>
                  <a:ext uri="{FF2B5EF4-FFF2-40B4-BE49-F238E27FC236}">
                    <a16:creationId xmlns:a16="http://schemas.microsoft.com/office/drawing/2014/main" id="{E5BB4439-25D0-4AED-9494-555A5986DC16}"/>
                  </a:ext>
                </a:extLst>
              </p:cNvPr>
              <p:cNvCxnSpPr>
                <a:cxnSpLocks/>
                <a:stCxn id="158" idx="1"/>
                <a:endCxn id="160" idx="1"/>
              </p:cNvCxnSpPr>
              <p:nvPr/>
            </p:nvCxnSpPr>
            <p:spPr>
              <a:xfrm flipH="1" flipV="1">
                <a:off x="3511497" y="2376761"/>
                <a:ext cx="211961" cy="152400"/>
              </a:xfrm>
              <a:prstGeom prst="line">
                <a:avLst/>
              </a:prstGeom>
            </p:spPr>
            <p:style>
              <a:lnRef idx="1">
                <a:schemeClr val="accent1"/>
              </a:lnRef>
              <a:fillRef idx="0">
                <a:schemeClr val="accent1"/>
              </a:fillRef>
              <a:effectRef idx="0">
                <a:schemeClr val="accent1"/>
              </a:effectRef>
              <a:fontRef idx="minor">
                <a:schemeClr val="tx1"/>
              </a:fontRef>
            </p:style>
          </p:cxnSp>
          <p:sp>
            <p:nvSpPr>
              <p:cNvPr id="156" name="Rectangle 155">
                <a:extLst>
                  <a:ext uri="{FF2B5EF4-FFF2-40B4-BE49-F238E27FC236}">
                    <a16:creationId xmlns:a16="http://schemas.microsoft.com/office/drawing/2014/main" id="{A7C37705-4BE8-4567-B133-1155713C0BFE}"/>
                  </a:ext>
                </a:extLst>
              </p:cNvPr>
              <p:cNvSpPr/>
              <p:nvPr/>
            </p:nvSpPr>
            <p:spPr>
              <a:xfrm>
                <a:off x="4172307" y="2523717"/>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57" name="Rectangle 156">
                <a:extLst>
                  <a:ext uri="{FF2B5EF4-FFF2-40B4-BE49-F238E27FC236}">
                    <a16:creationId xmlns:a16="http://schemas.microsoft.com/office/drawing/2014/main" id="{85342FBD-D201-4FD5-9EE4-B59C50DA362C}"/>
                  </a:ext>
                </a:extLst>
              </p:cNvPr>
              <p:cNvSpPr/>
              <p:nvPr/>
            </p:nvSpPr>
            <p:spPr>
              <a:xfrm>
                <a:off x="3950794" y="2523717"/>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58" name="Oval 157">
                <a:extLst>
                  <a:ext uri="{FF2B5EF4-FFF2-40B4-BE49-F238E27FC236}">
                    <a16:creationId xmlns:a16="http://schemas.microsoft.com/office/drawing/2014/main" id="{5E4CD4D4-52E6-4D8E-A139-9B9677439B3A}"/>
                  </a:ext>
                </a:extLst>
              </p:cNvPr>
              <p:cNvSpPr/>
              <p:nvPr/>
            </p:nvSpPr>
            <p:spPr>
              <a:xfrm>
                <a:off x="3701140" y="2506843"/>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itchFamily="34" charset="0"/>
                  <a:cs typeface="Arial" pitchFamily="34" charset="0"/>
                </a:endParaRPr>
              </a:p>
            </p:txBody>
          </p:sp>
          <p:sp>
            <p:nvSpPr>
              <p:cNvPr id="159" name="Oval 158">
                <a:extLst>
                  <a:ext uri="{FF2B5EF4-FFF2-40B4-BE49-F238E27FC236}">
                    <a16:creationId xmlns:a16="http://schemas.microsoft.com/office/drawing/2014/main" id="{0B1D2D56-836A-4B01-A9F3-31E68B42CB54}"/>
                  </a:ext>
                </a:extLst>
              </p:cNvPr>
              <p:cNvSpPr/>
              <p:nvPr/>
            </p:nvSpPr>
            <p:spPr>
              <a:xfrm>
                <a:off x="3492608" y="2679703"/>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60" name="Oval 159">
                <a:extLst>
                  <a:ext uri="{FF2B5EF4-FFF2-40B4-BE49-F238E27FC236}">
                    <a16:creationId xmlns:a16="http://schemas.microsoft.com/office/drawing/2014/main" id="{52AE269E-B393-4BB9-A23B-2A17A52FEEF4}"/>
                  </a:ext>
                </a:extLst>
              </p:cNvPr>
              <p:cNvSpPr/>
              <p:nvPr/>
            </p:nvSpPr>
            <p:spPr>
              <a:xfrm>
                <a:off x="3489179" y="2354443"/>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61" name="Oval 160">
                <a:extLst>
                  <a:ext uri="{FF2B5EF4-FFF2-40B4-BE49-F238E27FC236}">
                    <a16:creationId xmlns:a16="http://schemas.microsoft.com/office/drawing/2014/main" id="{E545905D-0700-4060-832E-2AE33BC1AF5A}"/>
                  </a:ext>
                </a:extLst>
              </p:cNvPr>
              <p:cNvSpPr/>
              <p:nvPr/>
            </p:nvSpPr>
            <p:spPr>
              <a:xfrm>
                <a:off x="3222522" y="2219469"/>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62" name="Oval 161">
                <a:extLst>
                  <a:ext uri="{FF2B5EF4-FFF2-40B4-BE49-F238E27FC236}">
                    <a16:creationId xmlns:a16="http://schemas.microsoft.com/office/drawing/2014/main" id="{95048E56-9FA3-41F0-9D61-2CC98571A314}"/>
                  </a:ext>
                </a:extLst>
              </p:cNvPr>
              <p:cNvSpPr/>
              <p:nvPr/>
            </p:nvSpPr>
            <p:spPr>
              <a:xfrm>
                <a:off x="3215585" y="2451345"/>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163" name="Straight Connector 162">
                <a:extLst>
                  <a:ext uri="{FF2B5EF4-FFF2-40B4-BE49-F238E27FC236}">
                    <a16:creationId xmlns:a16="http://schemas.microsoft.com/office/drawing/2014/main" id="{45653AC7-99C9-4B18-BCA1-7676A75BD471}"/>
                  </a:ext>
                </a:extLst>
              </p:cNvPr>
              <p:cNvCxnSpPr>
                <a:cxnSpLocks/>
                <a:stCxn id="156" idx="3"/>
                <a:endCxn id="158" idx="6"/>
              </p:cNvCxnSpPr>
              <p:nvPr/>
            </p:nvCxnSpPr>
            <p:spPr>
              <a:xfrm flipH="1">
                <a:off x="3853540" y="2582565"/>
                <a:ext cx="471167" cy="478"/>
              </a:xfrm>
              <a:prstGeom prst="line">
                <a:avLst/>
              </a:prstGeom>
            </p:spPr>
            <p:style>
              <a:lnRef idx="1">
                <a:schemeClr val="accent1"/>
              </a:lnRef>
              <a:fillRef idx="0">
                <a:schemeClr val="accent1"/>
              </a:fillRef>
              <a:effectRef idx="0">
                <a:schemeClr val="accent1"/>
              </a:effectRef>
              <a:fontRef idx="minor">
                <a:schemeClr val="tx1"/>
              </a:fontRef>
            </p:style>
          </p:cxnSp>
          <p:cxnSp>
            <p:nvCxnSpPr>
              <p:cNvPr id="164" name="Straight Connector 163">
                <a:extLst>
                  <a:ext uri="{FF2B5EF4-FFF2-40B4-BE49-F238E27FC236}">
                    <a16:creationId xmlns:a16="http://schemas.microsoft.com/office/drawing/2014/main" id="{828F713B-4013-4CC7-A500-5FF9FCC64823}"/>
                  </a:ext>
                </a:extLst>
              </p:cNvPr>
              <p:cNvCxnSpPr>
                <a:stCxn id="160" idx="2"/>
                <a:endCxn id="161" idx="5"/>
              </p:cNvCxnSpPr>
              <p:nvPr/>
            </p:nvCxnSpPr>
            <p:spPr>
              <a:xfrm flipH="1" flipV="1">
                <a:off x="3352604" y="2349551"/>
                <a:ext cx="136575" cy="81092"/>
              </a:xfrm>
              <a:prstGeom prst="line">
                <a:avLst/>
              </a:prstGeom>
            </p:spPr>
            <p:style>
              <a:lnRef idx="1">
                <a:schemeClr val="accent1"/>
              </a:lnRef>
              <a:fillRef idx="0">
                <a:schemeClr val="accent1"/>
              </a:fillRef>
              <a:effectRef idx="0">
                <a:schemeClr val="accent1"/>
              </a:effectRef>
              <a:fontRef idx="minor">
                <a:schemeClr val="tx1"/>
              </a:fontRef>
            </p:style>
          </p:cxnSp>
          <p:cxnSp>
            <p:nvCxnSpPr>
              <p:cNvPr id="165" name="Straight Connector 164">
                <a:extLst>
                  <a:ext uri="{FF2B5EF4-FFF2-40B4-BE49-F238E27FC236}">
                    <a16:creationId xmlns:a16="http://schemas.microsoft.com/office/drawing/2014/main" id="{203B7C42-0315-41AD-B0AE-A179037AB697}"/>
                  </a:ext>
                </a:extLst>
              </p:cNvPr>
              <p:cNvCxnSpPr>
                <a:cxnSpLocks/>
                <a:stCxn id="162" idx="7"/>
                <a:endCxn id="160" idx="2"/>
              </p:cNvCxnSpPr>
              <p:nvPr/>
            </p:nvCxnSpPr>
            <p:spPr>
              <a:xfrm flipV="1">
                <a:off x="3345667" y="2430643"/>
                <a:ext cx="143512" cy="43020"/>
              </a:xfrm>
              <a:prstGeom prst="line">
                <a:avLst/>
              </a:prstGeom>
            </p:spPr>
            <p:style>
              <a:lnRef idx="1">
                <a:schemeClr val="accent1"/>
              </a:lnRef>
              <a:fillRef idx="0">
                <a:schemeClr val="accent1"/>
              </a:fillRef>
              <a:effectRef idx="0">
                <a:schemeClr val="accent1"/>
              </a:effectRef>
              <a:fontRef idx="minor">
                <a:schemeClr val="tx1"/>
              </a:fontRef>
            </p:style>
          </p:cxnSp>
          <p:sp>
            <p:nvSpPr>
              <p:cNvPr id="166" name="Rectangle 165">
                <a:extLst>
                  <a:ext uri="{FF2B5EF4-FFF2-40B4-BE49-F238E27FC236}">
                    <a16:creationId xmlns:a16="http://schemas.microsoft.com/office/drawing/2014/main" id="{ACCDA23B-B5A0-4735-B109-6A05C6E84375}"/>
                  </a:ext>
                </a:extLst>
              </p:cNvPr>
              <p:cNvSpPr/>
              <p:nvPr/>
            </p:nvSpPr>
            <p:spPr>
              <a:xfrm>
                <a:off x="3219753" y="2700983"/>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cxnSp>
            <p:nvCxnSpPr>
              <p:cNvPr id="167" name="Straight Connector 166">
                <a:extLst>
                  <a:ext uri="{FF2B5EF4-FFF2-40B4-BE49-F238E27FC236}">
                    <a16:creationId xmlns:a16="http://schemas.microsoft.com/office/drawing/2014/main" id="{C3129B6F-F2C5-4959-889F-99B912A907EE}"/>
                  </a:ext>
                </a:extLst>
              </p:cNvPr>
              <p:cNvCxnSpPr>
                <a:cxnSpLocks/>
                <a:stCxn id="170" idx="6"/>
                <a:endCxn id="159" idx="2"/>
              </p:cNvCxnSpPr>
              <p:nvPr/>
            </p:nvCxnSpPr>
            <p:spPr>
              <a:xfrm flipV="1">
                <a:off x="3121957" y="2755903"/>
                <a:ext cx="370651" cy="6360"/>
              </a:xfrm>
              <a:prstGeom prst="line">
                <a:avLst/>
              </a:prstGeom>
            </p:spPr>
            <p:style>
              <a:lnRef idx="1">
                <a:schemeClr val="accent1"/>
              </a:lnRef>
              <a:fillRef idx="0">
                <a:schemeClr val="accent1"/>
              </a:fillRef>
              <a:effectRef idx="0">
                <a:schemeClr val="accent1"/>
              </a:effectRef>
              <a:fontRef idx="minor">
                <a:schemeClr val="tx1"/>
              </a:fontRef>
            </p:style>
          </p:cxnSp>
          <p:sp>
            <p:nvSpPr>
              <p:cNvPr id="168" name="TextBox 167">
                <a:extLst>
                  <a:ext uri="{FF2B5EF4-FFF2-40B4-BE49-F238E27FC236}">
                    <a16:creationId xmlns:a16="http://schemas.microsoft.com/office/drawing/2014/main" id="{6062CEAE-8CAF-49B6-8D27-72EAEDEBDFDB}"/>
                  </a:ext>
                </a:extLst>
              </p:cNvPr>
              <p:cNvSpPr txBox="1"/>
              <p:nvPr/>
            </p:nvSpPr>
            <p:spPr>
              <a:xfrm>
                <a:off x="3583159" y="2304893"/>
                <a:ext cx="293670" cy="199175"/>
              </a:xfrm>
              <a:prstGeom prst="rect">
                <a:avLst/>
              </a:prstGeom>
              <a:noFill/>
            </p:spPr>
            <p:txBody>
              <a:bodyPr wrap="none" rtlCol="0">
                <a:spAutoFit/>
              </a:bodyPr>
              <a:lstStyle/>
              <a:p>
                <a:r>
                  <a:rPr lang="el-GR" sz="800" dirty="0"/>
                  <a:t>α</a:t>
                </a:r>
                <a:r>
                  <a:rPr lang="en-US" sz="800" dirty="0"/>
                  <a:t>6</a:t>
                </a:r>
              </a:p>
            </p:txBody>
          </p:sp>
          <p:sp>
            <p:nvSpPr>
              <p:cNvPr id="169" name="TextBox 168">
                <a:extLst>
                  <a:ext uri="{FF2B5EF4-FFF2-40B4-BE49-F238E27FC236}">
                    <a16:creationId xmlns:a16="http://schemas.microsoft.com/office/drawing/2014/main" id="{2D994EBE-B28D-4DA7-870A-368C2F8AA88D}"/>
                  </a:ext>
                </a:extLst>
              </p:cNvPr>
              <p:cNvSpPr txBox="1"/>
              <p:nvPr/>
            </p:nvSpPr>
            <p:spPr>
              <a:xfrm>
                <a:off x="3583159" y="2632476"/>
                <a:ext cx="293670" cy="199175"/>
              </a:xfrm>
              <a:prstGeom prst="rect">
                <a:avLst/>
              </a:prstGeom>
              <a:noFill/>
            </p:spPr>
            <p:txBody>
              <a:bodyPr wrap="none" rtlCol="0">
                <a:spAutoFit/>
              </a:bodyPr>
              <a:lstStyle/>
              <a:p>
                <a:r>
                  <a:rPr lang="el-GR" sz="800" dirty="0"/>
                  <a:t>α</a:t>
                </a:r>
                <a:r>
                  <a:rPr lang="en-US" sz="800" dirty="0"/>
                  <a:t>3</a:t>
                </a:r>
              </a:p>
            </p:txBody>
          </p:sp>
          <p:sp>
            <p:nvSpPr>
              <p:cNvPr id="170" name="Oval 169">
                <a:extLst>
                  <a:ext uri="{FF2B5EF4-FFF2-40B4-BE49-F238E27FC236}">
                    <a16:creationId xmlns:a16="http://schemas.microsoft.com/office/drawing/2014/main" id="{96F61908-DFC1-410F-AB61-5DBBD62F6768}"/>
                  </a:ext>
                </a:extLst>
              </p:cNvPr>
              <p:cNvSpPr/>
              <p:nvPr/>
            </p:nvSpPr>
            <p:spPr>
              <a:xfrm>
                <a:off x="2969557" y="2686063"/>
                <a:ext cx="152400" cy="1524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grpSp>
        <p:cxnSp>
          <p:nvCxnSpPr>
            <p:cNvPr id="191" name="Straight Arrow Connector 190">
              <a:extLst>
                <a:ext uri="{FF2B5EF4-FFF2-40B4-BE49-F238E27FC236}">
                  <a16:creationId xmlns:a16="http://schemas.microsoft.com/office/drawing/2014/main" id="{E21F0DE3-B8D1-4258-877D-D62C09F05F20}"/>
                </a:ext>
              </a:extLst>
            </p:cNvPr>
            <p:cNvCxnSpPr>
              <a:cxnSpLocks/>
              <a:stCxn id="88" idx="3"/>
              <a:endCxn id="271" idx="1"/>
            </p:cNvCxnSpPr>
            <p:nvPr/>
          </p:nvCxnSpPr>
          <p:spPr>
            <a:xfrm flipV="1">
              <a:off x="6127549" y="6999688"/>
              <a:ext cx="588522" cy="64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3" name="TextBox 192">
              <a:extLst>
                <a:ext uri="{FF2B5EF4-FFF2-40B4-BE49-F238E27FC236}">
                  <a16:creationId xmlns:a16="http://schemas.microsoft.com/office/drawing/2014/main" id="{3BECA12C-E2E8-4EBC-A2EA-166C50BC46CA}"/>
                </a:ext>
              </a:extLst>
            </p:cNvPr>
            <p:cNvSpPr txBox="1"/>
            <p:nvPr/>
          </p:nvSpPr>
          <p:spPr>
            <a:xfrm>
              <a:off x="6111089" y="6788828"/>
              <a:ext cx="572593" cy="230832"/>
            </a:xfrm>
            <a:prstGeom prst="rect">
              <a:avLst/>
            </a:prstGeom>
            <a:noFill/>
          </p:spPr>
          <p:txBody>
            <a:bodyPr wrap="none" rtlCol="0">
              <a:spAutoFit/>
            </a:bodyPr>
            <a:lstStyle/>
            <a:p>
              <a:r>
                <a:rPr lang="en-US" sz="900" dirty="0"/>
                <a:t>B4GalT1</a:t>
              </a:r>
            </a:p>
          </p:txBody>
        </p:sp>
        <p:sp>
          <p:nvSpPr>
            <p:cNvPr id="199" name="Oval 198">
              <a:extLst>
                <a:ext uri="{FF2B5EF4-FFF2-40B4-BE49-F238E27FC236}">
                  <a16:creationId xmlns:a16="http://schemas.microsoft.com/office/drawing/2014/main" id="{864290C6-F8CC-4404-B976-2DDEE9FDA9DB}"/>
                </a:ext>
              </a:extLst>
            </p:cNvPr>
            <p:cNvSpPr/>
            <p:nvPr/>
          </p:nvSpPr>
          <p:spPr>
            <a:xfrm>
              <a:off x="3168009" y="7636351"/>
              <a:ext cx="117520" cy="120857"/>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b="1">
                <a:latin typeface="Arial" pitchFamily="34" charset="0"/>
                <a:cs typeface="Arial" pitchFamily="34" charset="0"/>
              </a:endParaRPr>
            </a:p>
          </p:txBody>
        </p:sp>
        <p:sp>
          <p:nvSpPr>
            <p:cNvPr id="200" name="TextBox 199">
              <a:extLst>
                <a:ext uri="{FF2B5EF4-FFF2-40B4-BE49-F238E27FC236}">
                  <a16:creationId xmlns:a16="http://schemas.microsoft.com/office/drawing/2014/main" id="{5E11FC8A-08EB-494B-893D-7729F9EBBAE3}"/>
                </a:ext>
              </a:extLst>
            </p:cNvPr>
            <p:cNvSpPr txBox="1"/>
            <p:nvPr/>
          </p:nvSpPr>
          <p:spPr>
            <a:xfrm>
              <a:off x="3773432" y="7594088"/>
              <a:ext cx="556563" cy="215444"/>
            </a:xfrm>
            <a:prstGeom prst="rect">
              <a:avLst/>
            </a:prstGeom>
            <a:noFill/>
          </p:spPr>
          <p:txBody>
            <a:bodyPr wrap="none" rtlCol="0">
              <a:spAutoFit/>
            </a:bodyPr>
            <a:lstStyle/>
            <a:p>
              <a:r>
                <a:rPr lang="en-US" sz="800" b="1" dirty="0" err="1">
                  <a:latin typeface="Arial" pitchFamily="34" charset="0"/>
                  <a:cs typeface="Arial" pitchFamily="34" charset="0"/>
                </a:rPr>
                <a:t>GlcNAc</a:t>
              </a:r>
              <a:endParaRPr lang="en-US" sz="800" b="1" dirty="0">
                <a:latin typeface="Arial" pitchFamily="34" charset="0"/>
                <a:cs typeface="Arial" pitchFamily="34" charset="0"/>
              </a:endParaRPr>
            </a:p>
          </p:txBody>
        </p:sp>
        <p:sp>
          <p:nvSpPr>
            <p:cNvPr id="201" name="TextBox 200">
              <a:extLst>
                <a:ext uri="{FF2B5EF4-FFF2-40B4-BE49-F238E27FC236}">
                  <a16:creationId xmlns:a16="http://schemas.microsoft.com/office/drawing/2014/main" id="{D3D7D405-FA92-4E7E-8986-DF39DE51B683}"/>
                </a:ext>
              </a:extLst>
            </p:cNvPr>
            <p:cNvSpPr txBox="1"/>
            <p:nvPr/>
          </p:nvSpPr>
          <p:spPr>
            <a:xfrm>
              <a:off x="3267386" y="7594088"/>
              <a:ext cx="389850" cy="215444"/>
            </a:xfrm>
            <a:prstGeom prst="rect">
              <a:avLst/>
            </a:prstGeom>
            <a:noFill/>
          </p:spPr>
          <p:txBody>
            <a:bodyPr wrap="none" rtlCol="0">
              <a:spAutoFit/>
            </a:bodyPr>
            <a:lstStyle/>
            <a:p>
              <a:r>
                <a:rPr lang="en-US" sz="800" b="1" dirty="0">
                  <a:latin typeface="Arial" pitchFamily="34" charset="0"/>
                  <a:cs typeface="Arial" pitchFamily="34" charset="0"/>
                </a:rPr>
                <a:t>Man</a:t>
              </a:r>
            </a:p>
          </p:txBody>
        </p:sp>
        <p:sp>
          <p:nvSpPr>
            <p:cNvPr id="202" name="Rectangle 201">
              <a:extLst>
                <a:ext uri="{FF2B5EF4-FFF2-40B4-BE49-F238E27FC236}">
                  <a16:creationId xmlns:a16="http://schemas.microsoft.com/office/drawing/2014/main" id="{47FB2809-DE20-4AF5-B6F9-30C83F44BCD6}"/>
                </a:ext>
              </a:extLst>
            </p:cNvPr>
            <p:cNvSpPr/>
            <p:nvPr/>
          </p:nvSpPr>
          <p:spPr>
            <a:xfrm>
              <a:off x="3678137" y="7647199"/>
              <a:ext cx="117520" cy="9333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b="1">
                <a:latin typeface="Arial" pitchFamily="34" charset="0"/>
                <a:cs typeface="Arial" pitchFamily="34" charset="0"/>
              </a:endParaRPr>
            </a:p>
          </p:txBody>
        </p:sp>
        <p:sp>
          <p:nvSpPr>
            <p:cNvPr id="203" name="Isosceles Triangle 202">
              <a:extLst>
                <a:ext uri="{FF2B5EF4-FFF2-40B4-BE49-F238E27FC236}">
                  <a16:creationId xmlns:a16="http://schemas.microsoft.com/office/drawing/2014/main" id="{9F2FF698-B613-4EFB-B8A3-7952E7B8B690}"/>
                </a:ext>
              </a:extLst>
            </p:cNvPr>
            <p:cNvSpPr/>
            <p:nvPr/>
          </p:nvSpPr>
          <p:spPr>
            <a:xfrm>
              <a:off x="3154398" y="8064236"/>
              <a:ext cx="117520" cy="88423"/>
            </a:xfrm>
            <a:prstGeom prst="triangle">
              <a:avLst/>
            </a:prstGeom>
            <a:solidFill>
              <a:srgbClr val="00B05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04" name="TextBox 203">
              <a:extLst>
                <a:ext uri="{FF2B5EF4-FFF2-40B4-BE49-F238E27FC236}">
                  <a16:creationId xmlns:a16="http://schemas.microsoft.com/office/drawing/2014/main" id="{2A1ACDA6-FA95-4988-9BF6-FBEBA316874E}"/>
                </a:ext>
              </a:extLst>
            </p:cNvPr>
            <p:cNvSpPr txBox="1"/>
            <p:nvPr/>
          </p:nvSpPr>
          <p:spPr>
            <a:xfrm>
              <a:off x="3254000" y="8009736"/>
              <a:ext cx="367408" cy="215444"/>
            </a:xfrm>
            <a:prstGeom prst="rect">
              <a:avLst/>
            </a:prstGeom>
            <a:noFill/>
          </p:spPr>
          <p:txBody>
            <a:bodyPr wrap="none" rtlCol="0">
              <a:spAutoFit/>
            </a:bodyPr>
            <a:lstStyle/>
            <a:p>
              <a:r>
                <a:rPr lang="en-US" sz="800" b="1" dirty="0" err="1">
                  <a:latin typeface="Arial" pitchFamily="34" charset="0"/>
                  <a:cs typeface="Arial" pitchFamily="34" charset="0"/>
                </a:rPr>
                <a:t>Fuc</a:t>
              </a:r>
              <a:endParaRPr lang="en-US" sz="800" b="1" dirty="0">
                <a:latin typeface="Arial" pitchFamily="34" charset="0"/>
                <a:cs typeface="Arial" pitchFamily="34" charset="0"/>
              </a:endParaRPr>
            </a:p>
          </p:txBody>
        </p:sp>
        <p:sp>
          <p:nvSpPr>
            <p:cNvPr id="205" name="Oval 204">
              <a:extLst>
                <a:ext uri="{FF2B5EF4-FFF2-40B4-BE49-F238E27FC236}">
                  <a16:creationId xmlns:a16="http://schemas.microsoft.com/office/drawing/2014/main" id="{8322905A-4102-4403-B3AF-A6396FF6BC51}"/>
                </a:ext>
              </a:extLst>
            </p:cNvPr>
            <p:cNvSpPr/>
            <p:nvPr/>
          </p:nvSpPr>
          <p:spPr>
            <a:xfrm>
              <a:off x="3669566" y="8030788"/>
              <a:ext cx="152400" cy="1524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206" name="TextBox 205">
              <a:extLst>
                <a:ext uri="{FF2B5EF4-FFF2-40B4-BE49-F238E27FC236}">
                  <a16:creationId xmlns:a16="http://schemas.microsoft.com/office/drawing/2014/main" id="{AEC6CA2A-D85A-4E25-A5B7-A163680E8C7F}"/>
                </a:ext>
              </a:extLst>
            </p:cNvPr>
            <p:cNvSpPr txBox="1"/>
            <p:nvPr/>
          </p:nvSpPr>
          <p:spPr>
            <a:xfrm>
              <a:off x="3880121" y="8001351"/>
              <a:ext cx="351378" cy="215444"/>
            </a:xfrm>
            <a:prstGeom prst="rect">
              <a:avLst/>
            </a:prstGeom>
            <a:noFill/>
          </p:spPr>
          <p:txBody>
            <a:bodyPr wrap="none" rtlCol="0">
              <a:spAutoFit/>
            </a:bodyPr>
            <a:lstStyle/>
            <a:p>
              <a:r>
                <a:rPr lang="en-US" sz="800" b="1" dirty="0">
                  <a:latin typeface="Arial" pitchFamily="34" charset="0"/>
                  <a:cs typeface="Arial" pitchFamily="34" charset="0"/>
                </a:rPr>
                <a:t>Gal</a:t>
              </a:r>
            </a:p>
          </p:txBody>
        </p:sp>
        <p:grpSp>
          <p:nvGrpSpPr>
            <p:cNvPr id="207" name="Group 206">
              <a:extLst>
                <a:ext uri="{FF2B5EF4-FFF2-40B4-BE49-F238E27FC236}">
                  <a16:creationId xmlns:a16="http://schemas.microsoft.com/office/drawing/2014/main" id="{17B576ED-B94F-47C1-AB23-BC93929F7F1F}"/>
                </a:ext>
              </a:extLst>
            </p:cNvPr>
            <p:cNvGrpSpPr/>
            <p:nvPr/>
          </p:nvGrpSpPr>
          <p:grpSpPr>
            <a:xfrm>
              <a:off x="6688563" y="7892250"/>
              <a:ext cx="1567777" cy="669554"/>
              <a:chOff x="4560680" y="2175294"/>
              <a:chExt cx="1567777" cy="625497"/>
            </a:xfrm>
          </p:grpSpPr>
          <p:cxnSp>
            <p:nvCxnSpPr>
              <p:cNvPr id="208" name="Straight Connector 207">
                <a:extLst>
                  <a:ext uri="{FF2B5EF4-FFF2-40B4-BE49-F238E27FC236}">
                    <a16:creationId xmlns:a16="http://schemas.microsoft.com/office/drawing/2014/main" id="{B02900C1-1DBF-49C0-B3E9-5B4D786C6F36}"/>
                  </a:ext>
                </a:extLst>
              </p:cNvPr>
              <p:cNvCxnSpPr>
                <a:cxnSpLocks/>
                <a:stCxn id="212" idx="3"/>
                <a:endCxn id="213" idx="3"/>
              </p:cNvCxnSpPr>
              <p:nvPr/>
            </p:nvCxnSpPr>
            <p:spPr>
              <a:xfrm flipH="1">
                <a:off x="5318676" y="2592750"/>
                <a:ext cx="208532" cy="17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9" name="Straight Connector 208">
                <a:extLst>
                  <a:ext uri="{FF2B5EF4-FFF2-40B4-BE49-F238E27FC236}">
                    <a16:creationId xmlns:a16="http://schemas.microsoft.com/office/drawing/2014/main" id="{443A26D6-7260-44F6-BCEA-EE11622C6DEC}"/>
                  </a:ext>
                </a:extLst>
              </p:cNvPr>
              <p:cNvCxnSpPr>
                <a:cxnSpLocks/>
                <a:stCxn id="212" idx="1"/>
                <a:endCxn id="214" idx="1"/>
              </p:cNvCxnSpPr>
              <p:nvPr/>
            </p:nvCxnSpPr>
            <p:spPr>
              <a:xfrm flipH="1" flipV="1">
                <a:off x="5315247" y="2332586"/>
                <a:ext cx="211961" cy="152400"/>
              </a:xfrm>
              <a:prstGeom prst="line">
                <a:avLst/>
              </a:prstGeom>
            </p:spPr>
            <p:style>
              <a:lnRef idx="1">
                <a:schemeClr val="accent1"/>
              </a:lnRef>
              <a:fillRef idx="0">
                <a:schemeClr val="accent1"/>
              </a:fillRef>
              <a:effectRef idx="0">
                <a:schemeClr val="accent1"/>
              </a:effectRef>
              <a:fontRef idx="minor">
                <a:schemeClr val="tx1"/>
              </a:fontRef>
            </p:style>
          </p:cxnSp>
          <p:sp>
            <p:nvSpPr>
              <p:cNvPr id="210" name="Rectangle 209">
                <a:extLst>
                  <a:ext uri="{FF2B5EF4-FFF2-40B4-BE49-F238E27FC236}">
                    <a16:creationId xmlns:a16="http://schemas.microsoft.com/office/drawing/2014/main" id="{5E4DFB9B-F2E5-4B21-9A5B-D96BC267FBAD}"/>
                  </a:ext>
                </a:extLst>
              </p:cNvPr>
              <p:cNvSpPr/>
              <p:nvPr/>
            </p:nvSpPr>
            <p:spPr>
              <a:xfrm>
                <a:off x="5976057" y="2479542"/>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211" name="Rectangle 210">
                <a:extLst>
                  <a:ext uri="{FF2B5EF4-FFF2-40B4-BE49-F238E27FC236}">
                    <a16:creationId xmlns:a16="http://schemas.microsoft.com/office/drawing/2014/main" id="{B4D2E6F7-6D01-469D-A51F-D5D3CD49D997}"/>
                  </a:ext>
                </a:extLst>
              </p:cNvPr>
              <p:cNvSpPr/>
              <p:nvPr/>
            </p:nvSpPr>
            <p:spPr>
              <a:xfrm>
                <a:off x="5754544" y="2479542"/>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212" name="Oval 211">
                <a:extLst>
                  <a:ext uri="{FF2B5EF4-FFF2-40B4-BE49-F238E27FC236}">
                    <a16:creationId xmlns:a16="http://schemas.microsoft.com/office/drawing/2014/main" id="{2DF16F48-24DF-4A7B-BAC7-E298D0F85CED}"/>
                  </a:ext>
                </a:extLst>
              </p:cNvPr>
              <p:cNvSpPr/>
              <p:nvPr/>
            </p:nvSpPr>
            <p:spPr>
              <a:xfrm>
                <a:off x="5504890" y="2462668"/>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itchFamily="34" charset="0"/>
                  <a:cs typeface="Arial" pitchFamily="34" charset="0"/>
                </a:endParaRPr>
              </a:p>
            </p:txBody>
          </p:sp>
          <p:sp>
            <p:nvSpPr>
              <p:cNvPr id="213" name="Oval 212">
                <a:extLst>
                  <a:ext uri="{FF2B5EF4-FFF2-40B4-BE49-F238E27FC236}">
                    <a16:creationId xmlns:a16="http://schemas.microsoft.com/office/drawing/2014/main" id="{4BEC4D35-603B-4582-AF00-D276C4B38098}"/>
                  </a:ext>
                </a:extLst>
              </p:cNvPr>
              <p:cNvSpPr/>
              <p:nvPr/>
            </p:nvSpPr>
            <p:spPr>
              <a:xfrm>
                <a:off x="5296358" y="2635528"/>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214" name="Oval 213">
                <a:extLst>
                  <a:ext uri="{FF2B5EF4-FFF2-40B4-BE49-F238E27FC236}">
                    <a16:creationId xmlns:a16="http://schemas.microsoft.com/office/drawing/2014/main" id="{6C5647D1-BB0B-4AE2-BD5D-46006783B3A1}"/>
                  </a:ext>
                </a:extLst>
              </p:cNvPr>
              <p:cNvSpPr/>
              <p:nvPr/>
            </p:nvSpPr>
            <p:spPr>
              <a:xfrm>
                <a:off x="5292929" y="2310268"/>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215" name="Oval 214">
                <a:extLst>
                  <a:ext uri="{FF2B5EF4-FFF2-40B4-BE49-F238E27FC236}">
                    <a16:creationId xmlns:a16="http://schemas.microsoft.com/office/drawing/2014/main" id="{056ED369-7352-4E6F-AE56-965058C5CB66}"/>
                  </a:ext>
                </a:extLst>
              </p:cNvPr>
              <p:cNvSpPr/>
              <p:nvPr/>
            </p:nvSpPr>
            <p:spPr>
              <a:xfrm>
                <a:off x="5026272" y="2175294"/>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216" name="Oval 215">
                <a:extLst>
                  <a:ext uri="{FF2B5EF4-FFF2-40B4-BE49-F238E27FC236}">
                    <a16:creationId xmlns:a16="http://schemas.microsoft.com/office/drawing/2014/main" id="{ED1E70A3-DEC3-4A98-99C3-328C3A8786DB}"/>
                  </a:ext>
                </a:extLst>
              </p:cNvPr>
              <p:cNvSpPr/>
              <p:nvPr/>
            </p:nvSpPr>
            <p:spPr>
              <a:xfrm>
                <a:off x="5019335" y="2407170"/>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217" name="Straight Connector 216">
                <a:extLst>
                  <a:ext uri="{FF2B5EF4-FFF2-40B4-BE49-F238E27FC236}">
                    <a16:creationId xmlns:a16="http://schemas.microsoft.com/office/drawing/2014/main" id="{5FC1E3E4-55C4-4D14-AA36-AC2030EACD41}"/>
                  </a:ext>
                </a:extLst>
              </p:cNvPr>
              <p:cNvCxnSpPr>
                <a:cxnSpLocks/>
                <a:stCxn id="210" idx="3"/>
                <a:endCxn id="212" idx="6"/>
              </p:cNvCxnSpPr>
              <p:nvPr/>
            </p:nvCxnSpPr>
            <p:spPr>
              <a:xfrm flipH="1">
                <a:off x="5657290" y="2538390"/>
                <a:ext cx="471167" cy="478"/>
              </a:xfrm>
              <a:prstGeom prst="line">
                <a:avLst/>
              </a:prstGeom>
            </p:spPr>
            <p:style>
              <a:lnRef idx="1">
                <a:schemeClr val="accent1"/>
              </a:lnRef>
              <a:fillRef idx="0">
                <a:schemeClr val="accent1"/>
              </a:fillRef>
              <a:effectRef idx="0">
                <a:schemeClr val="accent1"/>
              </a:effectRef>
              <a:fontRef idx="minor">
                <a:schemeClr val="tx1"/>
              </a:fontRef>
            </p:style>
          </p:cxnSp>
          <p:cxnSp>
            <p:nvCxnSpPr>
              <p:cNvPr id="218" name="Straight Connector 217">
                <a:extLst>
                  <a:ext uri="{FF2B5EF4-FFF2-40B4-BE49-F238E27FC236}">
                    <a16:creationId xmlns:a16="http://schemas.microsoft.com/office/drawing/2014/main" id="{F88A4630-8E79-4700-A4E5-7F5727111B66}"/>
                  </a:ext>
                </a:extLst>
              </p:cNvPr>
              <p:cNvCxnSpPr>
                <a:stCxn id="214" idx="2"/>
                <a:endCxn id="215" idx="5"/>
              </p:cNvCxnSpPr>
              <p:nvPr/>
            </p:nvCxnSpPr>
            <p:spPr>
              <a:xfrm flipH="1" flipV="1">
                <a:off x="5156354" y="2305376"/>
                <a:ext cx="136575" cy="81092"/>
              </a:xfrm>
              <a:prstGeom prst="line">
                <a:avLst/>
              </a:prstGeom>
            </p:spPr>
            <p:style>
              <a:lnRef idx="1">
                <a:schemeClr val="accent1"/>
              </a:lnRef>
              <a:fillRef idx="0">
                <a:schemeClr val="accent1"/>
              </a:fillRef>
              <a:effectRef idx="0">
                <a:schemeClr val="accent1"/>
              </a:effectRef>
              <a:fontRef idx="minor">
                <a:schemeClr val="tx1"/>
              </a:fontRef>
            </p:style>
          </p:cxnSp>
          <p:cxnSp>
            <p:nvCxnSpPr>
              <p:cNvPr id="219" name="Straight Connector 218">
                <a:extLst>
                  <a:ext uri="{FF2B5EF4-FFF2-40B4-BE49-F238E27FC236}">
                    <a16:creationId xmlns:a16="http://schemas.microsoft.com/office/drawing/2014/main" id="{21F0B2A9-13FA-4932-A7BB-C9EDA5FA7119}"/>
                  </a:ext>
                </a:extLst>
              </p:cNvPr>
              <p:cNvCxnSpPr>
                <a:cxnSpLocks/>
                <a:stCxn id="216" idx="7"/>
                <a:endCxn id="214" idx="2"/>
              </p:cNvCxnSpPr>
              <p:nvPr/>
            </p:nvCxnSpPr>
            <p:spPr>
              <a:xfrm flipV="1">
                <a:off x="5149417" y="2386468"/>
                <a:ext cx="143512" cy="43020"/>
              </a:xfrm>
              <a:prstGeom prst="line">
                <a:avLst/>
              </a:prstGeom>
            </p:spPr>
            <p:style>
              <a:lnRef idx="1">
                <a:schemeClr val="accent1"/>
              </a:lnRef>
              <a:fillRef idx="0">
                <a:schemeClr val="accent1"/>
              </a:fillRef>
              <a:effectRef idx="0">
                <a:schemeClr val="accent1"/>
              </a:effectRef>
              <a:fontRef idx="minor">
                <a:schemeClr val="tx1"/>
              </a:fontRef>
            </p:style>
          </p:cxnSp>
          <p:sp>
            <p:nvSpPr>
              <p:cNvPr id="220" name="Rectangle 219">
                <a:extLst>
                  <a:ext uri="{FF2B5EF4-FFF2-40B4-BE49-F238E27FC236}">
                    <a16:creationId xmlns:a16="http://schemas.microsoft.com/office/drawing/2014/main" id="{7DEACE67-A7AF-496A-8EAC-5633E455ED33}"/>
                  </a:ext>
                </a:extLst>
              </p:cNvPr>
              <p:cNvSpPr/>
              <p:nvPr/>
            </p:nvSpPr>
            <p:spPr>
              <a:xfrm>
                <a:off x="5023503" y="2648016"/>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cxnSp>
            <p:nvCxnSpPr>
              <p:cNvPr id="221" name="Straight Connector 220">
                <a:extLst>
                  <a:ext uri="{FF2B5EF4-FFF2-40B4-BE49-F238E27FC236}">
                    <a16:creationId xmlns:a16="http://schemas.microsoft.com/office/drawing/2014/main" id="{AC483A14-0ED0-451F-9F40-3EBE4CFC176D}"/>
                  </a:ext>
                </a:extLst>
              </p:cNvPr>
              <p:cNvCxnSpPr>
                <a:cxnSpLocks/>
                <a:stCxn id="225" idx="3"/>
                <a:endCxn id="213" idx="2"/>
              </p:cNvCxnSpPr>
              <p:nvPr/>
            </p:nvCxnSpPr>
            <p:spPr>
              <a:xfrm flipV="1">
                <a:off x="4713080" y="2711728"/>
                <a:ext cx="583278" cy="12863"/>
              </a:xfrm>
              <a:prstGeom prst="line">
                <a:avLst/>
              </a:prstGeom>
            </p:spPr>
            <p:style>
              <a:lnRef idx="1">
                <a:schemeClr val="accent1"/>
              </a:lnRef>
              <a:fillRef idx="0">
                <a:schemeClr val="accent1"/>
              </a:fillRef>
              <a:effectRef idx="0">
                <a:schemeClr val="accent1"/>
              </a:effectRef>
              <a:fontRef idx="minor">
                <a:schemeClr val="tx1"/>
              </a:fontRef>
            </p:style>
          </p:cxnSp>
          <p:sp>
            <p:nvSpPr>
              <p:cNvPr id="222" name="TextBox 221">
                <a:extLst>
                  <a:ext uri="{FF2B5EF4-FFF2-40B4-BE49-F238E27FC236}">
                    <a16:creationId xmlns:a16="http://schemas.microsoft.com/office/drawing/2014/main" id="{7F9F8BB2-0D32-427A-80C1-BB85A93FC87B}"/>
                  </a:ext>
                </a:extLst>
              </p:cNvPr>
              <p:cNvSpPr txBox="1"/>
              <p:nvPr/>
            </p:nvSpPr>
            <p:spPr>
              <a:xfrm>
                <a:off x="5386909" y="2260717"/>
                <a:ext cx="293670" cy="201268"/>
              </a:xfrm>
              <a:prstGeom prst="rect">
                <a:avLst/>
              </a:prstGeom>
              <a:noFill/>
            </p:spPr>
            <p:txBody>
              <a:bodyPr wrap="none" rtlCol="0">
                <a:spAutoFit/>
              </a:bodyPr>
              <a:lstStyle/>
              <a:p>
                <a:r>
                  <a:rPr lang="el-GR" sz="800" dirty="0"/>
                  <a:t>α</a:t>
                </a:r>
                <a:r>
                  <a:rPr lang="en-US" sz="800" dirty="0"/>
                  <a:t>6</a:t>
                </a:r>
              </a:p>
            </p:txBody>
          </p:sp>
          <p:sp>
            <p:nvSpPr>
              <p:cNvPr id="223" name="TextBox 222">
                <a:extLst>
                  <a:ext uri="{FF2B5EF4-FFF2-40B4-BE49-F238E27FC236}">
                    <a16:creationId xmlns:a16="http://schemas.microsoft.com/office/drawing/2014/main" id="{8141F35C-5070-4016-8F9F-0D49D00B08D6}"/>
                  </a:ext>
                </a:extLst>
              </p:cNvPr>
              <p:cNvSpPr txBox="1"/>
              <p:nvPr/>
            </p:nvSpPr>
            <p:spPr>
              <a:xfrm>
                <a:off x="5386909" y="2588302"/>
                <a:ext cx="293670" cy="201268"/>
              </a:xfrm>
              <a:prstGeom prst="rect">
                <a:avLst/>
              </a:prstGeom>
              <a:noFill/>
            </p:spPr>
            <p:txBody>
              <a:bodyPr wrap="none" rtlCol="0">
                <a:spAutoFit/>
              </a:bodyPr>
              <a:lstStyle/>
              <a:p>
                <a:r>
                  <a:rPr lang="el-GR" sz="800" dirty="0"/>
                  <a:t>α</a:t>
                </a:r>
                <a:r>
                  <a:rPr lang="en-US" sz="800" dirty="0"/>
                  <a:t>3</a:t>
                </a:r>
              </a:p>
            </p:txBody>
          </p:sp>
          <p:sp>
            <p:nvSpPr>
              <p:cNvPr id="224" name="Oval 223">
                <a:extLst>
                  <a:ext uri="{FF2B5EF4-FFF2-40B4-BE49-F238E27FC236}">
                    <a16:creationId xmlns:a16="http://schemas.microsoft.com/office/drawing/2014/main" id="{1AB91828-DC0B-45AE-8659-BF0DD09E1400}"/>
                  </a:ext>
                </a:extLst>
              </p:cNvPr>
              <p:cNvSpPr/>
              <p:nvPr/>
            </p:nvSpPr>
            <p:spPr>
              <a:xfrm>
                <a:off x="4773307" y="2641888"/>
                <a:ext cx="152400" cy="1524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225" name="Diamond 224">
                <a:extLst>
                  <a:ext uri="{FF2B5EF4-FFF2-40B4-BE49-F238E27FC236}">
                    <a16:creationId xmlns:a16="http://schemas.microsoft.com/office/drawing/2014/main" id="{7A4555E7-FA66-4BBC-B883-52B5B6F63B3D}"/>
                  </a:ext>
                </a:extLst>
              </p:cNvPr>
              <p:cNvSpPr/>
              <p:nvPr/>
            </p:nvSpPr>
            <p:spPr>
              <a:xfrm>
                <a:off x="4560680" y="2648391"/>
                <a:ext cx="152400" cy="152400"/>
              </a:xfrm>
              <a:prstGeom prst="diamond">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226" name="Straight Arrow Connector 225">
              <a:extLst>
                <a:ext uri="{FF2B5EF4-FFF2-40B4-BE49-F238E27FC236}">
                  <a16:creationId xmlns:a16="http://schemas.microsoft.com/office/drawing/2014/main" id="{687ECD36-03B2-4D48-90FE-7727327C1E91}"/>
                </a:ext>
              </a:extLst>
            </p:cNvPr>
            <p:cNvCxnSpPr>
              <a:cxnSpLocks/>
            </p:cNvCxnSpPr>
            <p:nvPr/>
          </p:nvCxnSpPr>
          <p:spPr>
            <a:xfrm>
              <a:off x="7423630" y="7427665"/>
              <a:ext cx="0" cy="35224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27" name="TextBox 226">
              <a:extLst>
                <a:ext uri="{FF2B5EF4-FFF2-40B4-BE49-F238E27FC236}">
                  <a16:creationId xmlns:a16="http://schemas.microsoft.com/office/drawing/2014/main" id="{459D98A8-BD2C-41CF-A71A-AA17832E8C83}"/>
                </a:ext>
              </a:extLst>
            </p:cNvPr>
            <p:cNvSpPr txBox="1"/>
            <p:nvPr/>
          </p:nvSpPr>
          <p:spPr>
            <a:xfrm>
              <a:off x="7394896" y="7498629"/>
              <a:ext cx="562975" cy="230832"/>
            </a:xfrm>
            <a:prstGeom prst="rect">
              <a:avLst/>
            </a:prstGeom>
            <a:noFill/>
          </p:spPr>
          <p:txBody>
            <a:bodyPr wrap="none" rtlCol="0">
              <a:spAutoFit/>
            </a:bodyPr>
            <a:lstStyle/>
            <a:p>
              <a:r>
                <a:rPr lang="en-US" sz="900" dirty="0"/>
                <a:t>ST6Gal1</a:t>
              </a:r>
            </a:p>
          </p:txBody>
        </p:sp>
        <p:sp>
          <p:nvSpPr>
            <p:cNvPr id="233" name="TextBox 232">
              <a:extLst>
                <a:ext uri="{FF2B5EF4-FFF2-40B4-BE49-F238E27FC236}">
                  <a16:creationId xmlns:a16="http://schemas.microsoft.com/office/drawing/2014/main" id="{A42F3386-3888-48F1-B82C-A6B5348DFBF9}"/>
                </a:ext>
              </a:extLst>
            </p:cNvPr>
            <p:cNvSpPr txBox="1"/>
            <p:nvPr/>
          </p:nvSpPr>
          <p:spPr>
            <a:xfrm>
              <a:off x="7586962" y="6529250"/>
              <a:ext cx="535998" cy="246221"/>
            </a:xfrm>
            <a:prstGeom prst="rect">
              <a:avLst/>
            </a:prstGeom>
            <a:noFill/>
          </p:spPr>
          <p:txBody>
            <a:bodyPr wrap="square" rtlCol="0">
              <a:spAutoFit/>
            </a:bodyPr>
            <a:lstStyle/>
            <a:p>
              <a:r>
                <a:rPr lang="en-US" sz="1000" b="1" dirty="0">
                  <a:solidFill>
                    <a:srgbClr val="00B0F0"/>
                  </a:solidFill>
                </a:rPr>
                <a:t>M5NG</a:t>
              </a:r>
            </a:p>
          </p:txBody>
        </p:sp>
        <p:sp>
          <p:nvSpPr>
            <p:cNvPr id="234" name="TextBox 233">
              <a:extLst>
                <a:ext uri="{FF2B5EF4-FFF2-40B4-BE49-F238E27FC236}">
                  <a16:creationId xmlns:a16="http://schemas.microsoft.com/office/drawing/2014/main" id="{C056A49D-D6FF-4BF1-B2D7-5A0F2D6F3D23}"/>
                </a:ext>
              </a:extLst>
            </p:cNvPr>
            <p:cNvSpPr txBox="1"/>
            <p:nvPr/>
          </p:nvSpPr>
          <p:spPr>
            <a:xfrm>
              <a:off x="7814672" y="7787937"/>
              <a:ext cx="611152" cy="246221"/>
            </a:xfrm>
            <a:prstGeom prst="rect">
              <a:avLst/>
            </a:prstGeom>
            <a:noFill/>
          </p:spPr>
          <p:txBody>
            <a:bodyPr wrap="square" rtlCol="0">
              <a:spAutoFit/>
            </a:bodyPr>
            <a:lstStyle/>
            <a:p>
              <a:r>
                <a:rPr lang="en-US" sz="1000" b="1" dirty="0">
                  <a:solidFill>
                    <a:schemeClr val="accent6">
                      <a:lumMod val="50000"/>
                    </a:schemeClr>
                  </a:solidFill>
                </a:rPr>
                <a:t>M5NGS</a:t>
              </a:r>
            </a:p>
          </p:txBody>
        </p:sp>
        <p:grpSp>
          <p:nvGrpSpPr>
            <p:cNvPr id="22" name="Group 21">
              <a:extLst>
                <a:ext uri="{FF2B5EF4-FFF2-40B4-BE49-F238E27FC236}">
                  <a16:creationId xmlns:a16="http://schemas.microsoft.com/office/drawing/2014/main" id="{67A5CCBE-EA79-4F7E-9973-A4B1E160E786}"/>
                </a:ext>
              </a:extLst>
            </p:cNvPr>
            <p:cNvGrpSpPr/>
            <p:nvPr/>
          </p:nvGrpSpPr>
          <p:grpSpPr>
            <a:xfrm>
              <a:off x="4847520" y="7733227"/>
              <a:ext cx="1467523" cy="851751"/>
              <a:chOff x="7011556" y="2915177"/>
              <a:chExt cx="1467523" cy="851751"/>
            </a:xfrm>
          </p:grpSpPr>
          <p:sp>
            <p:nvSpPr>
              <p:cNvPr id="270" name="Rectangle 269">
                <a:extLst>
                  <a:ext uri="{FF2B5EF4-FFF2-40B4-BE49-F238E27FC236}">
                    <a16:creationId xmlns:a16="http://schemas.microsoft.com/office/drawing/2014/main" id="{2E06AD96-0ADE-45FF-AFF1-B60E7B122703}"/>
                  </a:ext>
                </a:extLst>
              </p:cNvPr>
              <p:cNvSpPr/>
              <p:nvPr/>
            </p:nvSpPr>
            <p:spPr>
              <a:xfrm>
                <a:off x="7011556" y="2958437"/>
                <a:ext cx="1337314" cy="808491"/>
              </a:xfrm>
              <a:prstGeom prst="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7" name="Straight Connector 96">
                <a:extLst>
                  <a:ext uri="{FF2B5EF4-FFF2-40B4-BE49-F238E27FC236}">
                    <a16:creationId xmlns:a16="http://schemas.microsoft.com/office/drawing/2014/main" id="{1876807A-43AB-4DFB-8DBB-387BB80C149C}"/>
                  </a:ext>
                </a:extLst>
              </p:cNvPr>
              <p:cNvCxnSpPr>
                <a:cxnSpLocks/>
                <a:stCxn id="113" idx="0"/>
                <a:endCxn id="101" idx="0"/>
              </p:cNvCxnSpPr>
              <p:nvPr/>
            </p:nvCxnSpPr>
            <p:spPr>
              <a:xfrm flipH="1">
                <a:off x="8139692" y="3168014"/>
                <a:ext cx="1375" cy="239409"/>
              </a:xfrm>
              <a:prstGeom prst="line">
                <a:avLst/>
              </a:prstGeom>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A9655B31-77CD-4191-B7CD-A2B504AF9694}"/>
                  </a:ext>
                </a:extLst>
              </p:cNvPr>
              <p:cNvCxnSpPr>
                <a:cxnSpLocks/>
                <a:stCxn id="103" idx="3"/>
                <a:endCxn id="104" idx="3"/>
              </p:cNvCxnSpPr>
              <p:nvPr/>
            </p:nvCxnSpPr>
            <p:spPr>
              <a:xfrm flipH="1">
                <a:off x="7406111" y="3520631"/>
                <a:ext cx="208532" cy="17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9B7A0D3F-7549-4657-8DE4-5979CC3411BD}"/>
                  </a:ext>
                </a:extLst>
              </p:cNvPr>
              <p:cNvCxnSpPr>
                <a:cxnSpLocks/>
                <a:stCxn id="111" idx="3"/>
                <a:endCxn id="104" idx="6"/>
              </p:cNvCxnSpPr>
              <p:nvPr/>
            </p:nvCxnSpPr>
            <p:spPr>
              <a:xfrm flipV="1">
                <a:off x="7265975" y="3639609"/>
                <a:ext cx="270218" cy="13974"/>
              </a:xfrm>
              <a:prstGeom prst="line">
                <a:avLst/>
              </a:prstGeom>
            </p:spPr>
            <p:style>
              <a:lnRef idx="1">
                <a:schemeClr val="accent1"/>
              </a:lnRef>
              <a:fillRef idx="0">
                <a:schemeClr val="accent1"/>
              </a:fillRef>
              <a:effectRef idx="0">
                <a:schemeClr val="accent1"/>
              </a:effectRef>
              <a:fontRef idx="minor">
                <a:schemeClr val="tx1"/>
              </a:fontRef>
            </p:style>
          </p:cxnSp>
          <p:cxnSp>
            <p:nvCxnSpPr>
              <p:cNvPr id="100" name="Straight Connector 99">
                <a:extLst>
                  <a:ext uri="{FF2B5EF4-FFF2-40B4-BE49-F238E27FC236}">
                    <a16:creationId xmlns:a16="http://schemas.microsoft.com/office/drawing/2014/main" id="{7481BC89-4E7B-4C11-A601-409C3502C3D8}"/>
                  </a:ext>
                </a:extLst>
              </p:cNvPr>
              <p:cNvCxnSpPr>
                <a:cxnSpLocks/>
                <a:stCxn id="103" idx="1"/>
                <a:endCxn id="105" idx="1"/>
              </p:cNvCxnSpPr>
              <p:nvPr/>
            </p:nvCxnSpPr>
            <p:spPr>
              <a:xfrm flipH="1" flipV="1">
                <a:off x="7402682" y="3260467"/>
                <a:ext cx="211961" cy="152400"/>
              </a:xfrm>
              <a:prstGeom prst="line">
                <a:avLst/>
              </a:prstGeom>
            </p:spPr>
            <p:style>
              <a:lnRef idx="1">
                <a:schemeClr val="accent1"/>
              </a:lnRef>
              <a:fillRef idx="0">
                <a:schemeClr val="accent1"/>
              </a:fillRef>
              <a:effectRef idx="0">
                <a:schemeClr val="accent1"/>
              </a:effectRef>
              <a:fontRef idx="minor">
                <a:schemeClr val="tx1"/>
              </a:fontRef>
            </p:style>
          </p:cxnSp>
          <p:sp>
            <p:nvSpPr>
              <p:cNvPr id="101" name="Rectangle 100">
                <a:extLst>
                  <a:ext uri="{FF2B5EF4-FFF2-40B4-BE49-F238E27FC236}">
                    <a16:creationId xmlns:a16="http://schemas.microsoft.com/office/drawing/2014/main" id="{4DB5264F-FD68-44A3-A65E-8C7C268745F7}"/>
                  </a:ext>
                </a:extLst>
              </p:cNvPr>
              <p:cNvSpPr/>
              <p:nvPr/>
            </p:nvSpPr>
            <p:spPr>
              <a:xfrm>
                <a:off x="8063492" y="3407423"/>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02" name="Rectangle 101">
                <a:extLst>
                  <a:ext uri="{FF2B5EF4-FFF2-40B4-BE49-F238E27FC236}">
                    <a16:creationId xmlns:a16="http://schemas.microsoft.com/office/drawing/2014/main" id="{3414E80C-E61B-4D0A-8D5D-7DC3A263EA9A}"/>
                  </a:ext>
                </a:extLst>
              </p:cNvPr>
              <p:cNvSpPr/>
              <p:nvPr/>
            </p:nvSpPr>
            <p:spPr>
              <a:xfrm>
                <a:off x="7841979" y="3407423"/>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03" name="Oval 102">
                <a:extLst>
                  <a:ext uri="{FF2B5EF4-FFF2-40B4-BE49-F238E27FC236}">
                    <a16:creationId xmlns:a16="http://schemas.microsoft.com/office/drawing/2014/main" id="{78BD539E-449F-4748-8F6E-2D451AACEEBD}"/>
                  </a:ext>
                </a:extLst>
              </p:cNvPr>
              <p:cNvSpPr/>
              <p:nvPr/>
            </p:nvSpPr>
            <p:spPr>
              <a:xfrm>
                <a:off x="7592325" y="3390549"/>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itchFamily="34" charset="0"/>
                  <a:cs typeface="Arial" pitchFamily="34" charset="0"/>
                </a:endParaRPr>
              </a:p>
            </p:txBody>
          </p:sp>
          <p:sp>
            <p:nvSpPr>
              <p:cNvPr id="104" name="Oval 103">
                <a:extLst>
                  <a:ext uri="{FF2B5EF4-FFF2-40B4-BE49-F238E27FC236}">
                    <a16:creationId xmlns:a16="http://schemas.microsoft.com/office/drawing/2014/main" id="{5D37079E-F0AD-4011-A279-C0504EBA3791}"/>
                  </a:ext>
                </a:extLst>
              </p:cNvPr>
              <p:cNvSpPr/>
              <p:nvPr/>
            </p:nvSpPr>
            <p:spPr>
              <a:xfrm>
                <a:off x="7383793" y="3563409"/>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05" name="Oval 104">
                <a:extLst>
                  <a:ext uri="{FF2B5EF4-FFF2-40B4-BE49-F238E27FC236}">
                    <a16:creationId xmlns:a16="http://schemas.microsoft.com/office/drawing/2014/main" id="{18AB0508-F4A1-4A9D-8C10-74E57A47CC82}"/>
                  </a:ext>
                </a:extLst>
              </p:cNvPr>
              <p:cNvSpPr/>
              <p:nvPr/>
            </p:nvSpPr>
            <p:spPr>
              <a:xfrm>
                <a:off x="7380364" y="3238149"/>
                <a:ext cx="152400" cy="15240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06" name="Oval 105">
                <a:extLst>
                  <a:ext uri="{FF2B5EF4-FFF2-40B4-BE49-F238E27FC236}">
                    <a16:creationId xmlns:a16="http://schemas.microsoft.com/office/drawing/2014/main" id="{9CB16B1A-9BA0-4AD2-8821-38C1CA88A133}"/>
                  </a:ext>
                </a:extLst>
              </p:cNvPr>
              <p:cNvSpPr/>
              <p:nvPr/>
            </p:nvSpPr>
            <p:spPr>
              <a:xfrm>
                <a:off x="7113707" y="3103175"/>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sp>
            <p:nvSpPr>
              <p:cNvPr id="107" name="Oval 106">
                <a:extLst>
                  <a:ext uri="{FF2B5EF4-FFF2-40B4-BE49-F238E27FC236}">
                    <a16:creationId xmlns:a16="http://schemas.microsoft.com/office/drawing/2014/main" id="{1483E7C2-4E54-46A2-ACC6-F5C511F99742}"/>
                  </a:ext>
                </a:extLst>
              </p:cNvPr>
              <p:cNvSpPr/>
              <p:nvPr/>
            </p:nvSpPr>
            <p:spPr>
              <a:xfrm>
                <a:off x="7106770" y="3335051"/>
                <a:ext cx="152400" cy="152400"/>
              </a:xfrm>
              <a:prstGeom prst="ellipse">
                <a:avLst/>
              </a:prstGeom>
              <a:solidFill>
                <a:srgbClr val="00B050"/>
              </a:solidFill>
              <a:ln>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itchFamily="34" charset="0"/>
                  <a:cs typeface="Arial" pitchFamily="34" charset="0"/>
                </a:endParaRPr>
              </a:p>
            </p:txBody>
          </p:sp>
          <p:cxnSp>
            <p:nvCxnSpPr>
              <p:cNvPr id="108" name="Straight Connector 107">
                <a:extLst>
                  <a:ext uri="{FF2B5EF4-FFF2-40B4-BE49-F238E27FC236}">
                    <a16:creationId xmlns:a16="http://schemas.microsoft.com/office/drawing/2014/main" id="{23687CA2-73D6-44F1-83B4-3975E4922724}"/>
                  </a:ext>
                </a:extLst>
              </p:cNvPr>
              <p:cNvCxnSpPr>
                <a:cxnSpLocks/>
                <a:stCxn id="101" idx="3"/>
                <a:endCxn id="103" idx="6"/>
              </p:cNvCxnSpPr>
              <p:nvPr/>
            </p:nvCxnSpPr>
            <p:spPr>
              <a:xfrm flipH="1">
                <a:off x="7744725" y="3466271"/>
                <a:ext cx="471167" cy="478"/>
              </a:xfrm>
              <a:prstGeom prst="line">
                <a:avLst/>
              </a:prstGeom>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ED7916B1-9EC4-462E-8E25-6D1740AF17B0}"/>
                  </a:ext>
                </a:extLst>
              </p:cNvPr>
              <p:cNvCxnSpPr>
                <a:stCxn id="105" idx="2"/>
                <a:endCxn id="106" idx="5"/>
              </p:cNvCxnSpPr>
              <p:nvPr/>
            </p:nvCxnSpPr>
            <p:spPr>
              <a:xfrm flipH="1" flipV="1">
                <a:off x="7243789" y="3233257"/>
                <a:ext cx="136575" cy="81092"/>
              </a:xfrm>
              <a:prstGeom prst="line">
                <a:avLst/>
              </a:prstGeom>
            </p:spPr>
            <p:style>
              <a:lnRef idx="1">
                <a:schemeClr val="accent1"/>
              </a:lnRef>
              <a:fillRef idx="0">
                <a:schemeClr val="accent1"/>
              </a:fillRef>
              <a:effectRef idx="0">
                <a:schemeClr val="accent1"/>
              </a:effectRef>
              <a:fontRef idx="minor">
                <a:schemeClr val="tx1"/>
              </a:fontRef>
            </p:style>
          </p:cxnSp>
          <p:cxnSp>
            <p:nvCxnSpPr>
              <p:cNvPr id="110" name="Straight Connector 109">
                <a:extLst>
                  <a:ext uri="{FF2B5EF4-FFF2-40B4-BE49-F238E27FC236}">
                    <a16:creationId xmlns:a16="http://schemas.microsoft.com/office/drawing/2014/main" id="{7D3420BB-78E1-4448-A1BF-493AB48117C3}"/>
                  </a:ext>
                </a:extLst>
              </p:cNvPr>
              <p:cNvCxnSpPr>
                <a:cxnSpLocks/>
                <a:stCxn id="107" idx="7"/>
                <a:endCxn id="105" idx="2"/>
              </p:cNvCxnSpPr>
              <p:nvPr/>
            </p:nvCxnSpPr>
            <p:spPr>
              <a:xfrm flipV="1">
                <a:off x="7236852" y="3314349"/>
                <a:ext cx="143512" cy="43020"/>
              </a:xfrm>
              <a:prstGeom prst="line">
                <a:avLst/>
              </a:prstGeom>
            </p:spPr>
            <p:style>
              <a:lnRef idx="1">
                <a:schemeClr val="accent1"/>
              </a:lnRef>
              <a:fillRef idx="0">
                <a:schemeClr val="accent1"/>
              </a:fillRef>
              <a:effectRef idx="0">
                <a:schemeClr val="accent1"/>
              </a:effectRef>
              <a:fontRef idx="minor">
                <a:schemeClr val="tx1"/>
              </a:fontRef>
            </p:style>
          </p:cxnSp>
          <p:sp>
            <p:nvSpPr>
              <p:cNvPr id="111" name="Rectangle 110">
                <a:extLst>
                  <a:ext uri="{FF2B5EF4-FFF2-40B4-BE49-F238E27FC236}">
                    <a16:creationId xmlns:a16="http://schemas.microsoft.com/office/drawing/2014/main" id="{5A4B44A8-6D75-400E-9358-9FF18F1C6848}"/>
                  </a:ext>
                </a:extLst>
              </p:cNvPr>
              <p:cNvSpPr/>
              <p:nvPr/>
            </p:nvSpPr>
            <p:spPr>
              <a:xfrm>
                <a:off x="7113575" y="3594735"/>
                <a:ext cx="152400" cy="117695"/>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latin typeface="Arial" pitchFamily="34" charset="0"/>
                  <a:cs typeface="Arial" pitchFamily="34" charset="0"/>
                </a:endParaRPr>
              </a:p>
            </p:txBody>
          </p:sp>
          <p:sp>
            <p:nvSpPr>
              <p:cNvPr id="112" name="TextBox 111">
                <a:extLst>
                  <a:ext uri="{FF2B5EF4-FFF2-40B4-BE49-F238E27FC236}">
                    <a16:creationId xmlns:a16="http://schemas.microsoft.com/office/drawing/2014/main" id="{0978B645-6F92-4624-9B99-9B4978FC03D3}"/>
                  </a:ext>
                </a:extLst>
              </p:cNvPr>
              <p:cNvSpPr txBox="1"/>
              <p:nvPr/>
            </p:nvSpPr>
            <p:spPr>
              <a:xfrm>
                <a:off x="8088586" y="3221130"/>
                <a:ext cx="293670" cy="215444"/>
              </a:xfrm>
              <a:prstGeom prst="rect">
                <a:avLst/>
              </a:prstGeom>
              <a:noFill/>
            </p:spPr>
            <p:txBody>
              <a:bodyPr wrap="none" rtlCol="0">
                <a:spAutoFit/>
              </a:bodyPr>
              <a:lstStyle/>
              <a:p>
                <a:r>
                  <a:rPr lang="el-GR" sz="800" dirty="0"/>
                  <a:t>α</a:t>
                </a:r>
                <a:r>
                  <a:rPr lang="en-US" sz="800" dirty="0"/>
                  <a:t>6</a:t>
                </a:r>
              </a:p>
            </p:txBody>
          </p:sp>
          <p:sp>
            <p:nvSpPr>
              <p:cNvPr id="113" name="Isosceles Triangle 112">
                <a:extLst>
                  <a:ext uri="{FF2B5EF4-FFF2-40B4-BE49-F238E27FC236}">
                    <a16:creationId xmlns:a16="http://schemas.microsoft.com/office/drawing/2014/main" id="{FD6ABDEC-22E0-49AF-B7B6-6AEC0277DCA3}"/>
                  </a:ext>
                </a:extLst>
              </p:cNvPr>
              <p:cNvSpPr/>
              <p:nvPr/>
            </p:nvSpPr>
            <p:spPr>
              <a:xfrm>
                <a:off x="8064867" y="3168014"/>
                <a:ext cx="152400" cy="111501"/>
              </a:xfrm>
              <a:prstGeom prst="triangle">
                <a:avLst/>
              </a:prstGeom>
              <a:solidFill>
                <a:srgbClr val="00B05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TextBox 113">
                <a:extLst>
                  <a:ext uri="{FF2B5EF4-FFF2-40B4-BE49-F238E27FC236}">
                    <a16:creationId xmlns:a16="http://schemas.microsoft.com/office/drawing/2014/main" id="{0B988C83-6E51-46FF-A5A6-DDA6A8832176}"/>
                  </a:ext>
                </a:extLst>
              </p:cNvPr>
              <p:cNvSpPr txBox="1"/>
              <p:nvPr/>
            </p:nvSpPr>
            <p:spPr>
              <a:xfrm>
                <a:off x="7493754" y="3212755"/>
                <a:ext cx="293670" cy="215444"/>
              </a:xfrm>
              <a:prstGeom prst="rect">
                <a:avLst/>
              </a:prstGeom>
              <a:noFill/>
            </p:spPr>
            <p:txBody>
              <a:bodyPr wrap="none" rtlCol="0">
                <a:spAutoFit/>
              </a:bodyPr>
              <a:lstStyle/>
              <a:p>
                <a:r>
                  <a:rPr lang="el-GR" sz="800" dirty="0"/>
                  <a:t>α</a:t>
                </a:r>
                <a:r>
                  <a:rPr lang="en-US" sz="800" dirty="0"/>
                  <a:t>6</a:t>
                </a:r>
              </a:p>
            </p:txBody>
          </p:sp>
          <p:sp>
            <p:nvSpPr>
              <p:cNvPr id="115" name="TextBox 114">
                <a:extLst>
                  <a:ext uri="{FF2B5EF4-FFF2-40B4-BE49-F238E27FC236}">
                    <a16:creationId xmlns:a16="http://schemas.microsoft.com/office/drawing/2014/main" id="{E2A33B5F-F87A-4DBE-A2EC-29CC5E2A872D}"/>
                  </a:ext>
                </a:extLst>
              </p:cNvPr>
              <p:cNvSpPr txBox="1"/>
              <p:nvPr/>
            </p:nvSpPr>
            <p:spPr>
              <a:xfrm>
                <a:off x="7484064" y="3522892"/>
                <a:ext cx="293670" cy="215444"/>
              </a:xfrm>
              <a:prstGeom prst="rect">
                <a:avLst/>
              </a:prstGeom>
              <a:noFill/>
            </p:spPr>
            <p:txBody>
              <a:bodyPr wrap="none" rtlCol="0">
                <a:spAutoFit/>
              </a:bodyPr>
              <a:lstStyle/>
              <a:p>
                <a:r>
                  <a:rPr lang="el-GR" sz="800" dirty="0"/>
                  <a:t>α</a:t>
                </a:r>
                <a:r>
                  <a:rPr lang="en-US" sz="800" dirty="0"/>
                  <a:t>3</a:t>
                </a:r>
              </a:p>
            </p:txBody>
          </p:sp>
          <p:sp>
            <p:nvSpPr>
              <p:cNvPr id="117" name="TextBox 116">
                <a:extLst>
                  <a:ext uri="{FF2B5EF4-FFF2-40B4-BE49-F238E27FC236}">
                    <a16:creationId xmlns:a16="http://schemas.microsoft.com/office/drawing/2014/main" id="{3314D802-6D5B-4864-97D3-87B8475472A9}"/>
                  </a:ext>
                </a:extLst>
              </p:cNvPr>
              <p:cNvSpPr txBox="1"/>
              <p:nvPr/>
            </p:nvSpPr>
            <p:spPr>
              <a:xfrm>
                <a:off x="7191254" y="3460458"/>
                <a:ext cx="290464" cy="215444"/>
              </a:xfrm>
              <a:prstGeom prst="rect">
                <a:avLst/>
              </a:prstGeom>
              <a:noFill/>
            </p:spPr>
            <p:txBody>
              <a:bodyPr wrap="none" rtlCol="0">
                <a:spAutoFit/>
              </a:bodyPr>
              <a:lstStyle/>
              <a:p>
                <a:r>
                  <a:rPr lang="el-GR" sz="800" dirty="0"/>
                  <a:t>β</a:t>
                </a:r>
                <a:r>
                  <a:rPr lang="en-US" sz="800" dirty="0"/>
                  <a:t>2</a:t>
                </a:r>
              </a:p>
            </p:txBody>
          </p:sp>
          <p:sp>
            <p:nvSpPr>
              <p:cNvPr id="267" name="TextBox 266">
                <a:extLst>
                  <a:ext uri="{FF2B5EF4-FFF2-40B4-BE49-F238E27FC236}">
                    <a16:creationId xmlns:a16="http://schemas.microsoft.com/office/drawing/2014/main" id="{3C1AE88D-11E3-469A-880B-CAA13882F443}"/>
                  </a:ext>
                </a:extLst>
              </p:cNvPr>
              <p:cNvSpPr txBox="1"/>
              <p:nvPr/>
            </p:nvSpPr>
            <p:spPr>
              <a:xfrm>
                <a:off x="7871569" y="2915177"/>
                <a:ext cx="607510" cy="246221"/>
              </a:xfrm>
              <a:prstGeom prst="rect">
                <a:avLst/>
              </a:prstGeom>
              <a:noFill/>
            </p:spPr>
            <p:txBody>
              <a:bodyPr wrap="square" rtlCol="0">
                <a:spAutoFit/>
              </a:bodyPr>
              <a:lstStyle/>
              <a:p>
                <a:r>
                  <a:rPr lang="en-US" sz="1000" b="1" dirty="0">
                    <a:solidFill>
                      <a:srgbClr val="7030A0"/>
                    </a:solidFill>
                  </a:rPr>
                  <a:t>M5NF</a:t>
                </a:r>
                <a:r>
                  <a:rPr lang="en-US" sz="1000" b="1" baseline="30000" dirty="0">
                    <a:solidFill>
                      <a:srgbClr val="7030A0"/>
                    </a:solidFill>
                  </a:rPr>
                  <a:t>c</a:t>
                </a:r>
              </a:p>
            </p:txBody>
          </p:sp>
        </p:grpSp>
        <p:sp>
          <p:nvSpPr>
            <p:cNvPr id="273" name="TextBox 272">
              <a:extLst>
                <a:ext uri="{FF2B5EF4-FFF2-40B4-BE49-F238E27FC236}">
                  <a16:creationId xmlns:a16="http://schemas.microsoft.com/office/drawing/2014/main" id="{FAB6BCF0-20D1-48E3-B277-B9C1EAA2D3BD}"/>
                </a:ext>
              </a:extLst>
            </p:cNvPr>
            <p:cNvSpPr txBox="1"/>
            <p:nvPr/>
          </p:nvSpPr>
          <p:spPr>
            <a:xfrm>
              <a:off x="2992055" y="6194781"/>
              <a:ext cx="309700" cy="369332"/>
            </a:xfrm>
            <a:prstGeom prst="rect">
              <a:avLst/>
            </a:prstGeom>
            <a:noFill/>
          </p:spPr>
          <p:txBody>
            <a:bodyPr wrap="none" rtlCol="0">
              <a:spAutoFit/>
            </a:bodyPr>
            <a:lstStyle/>
            <a:p>
              <a:r>
                <a:rPr lang="en-US" dirty="0"/>
                <a:t>B</a:t>
              </a:r>
            </a:p>
          </p:txBody>
        </p:sp>
        <p:sp>
          <p:nvSpPr>
            <p:cNvPr id="171" name="Diamond 170">
              <a:extLst>
                <a:ext uri="{FF2B5EF4-FFF2-40B4-BE49-F238E27FC236}">
                  <a16:creationId xmlns:a16="http://schemas.microsoft.com/office/drawing/2014/main" id="{56103DAF-9536-44CB-B3BE-8E0E74960481}"/>
                </a:ext>
              </a:extLst>
            </p:cNvPr>
            <p:cNvSpPr/>
            <p:nvPr/>
          </p:nvSpPr>
          <p:spPr>
            <a:xfrm>
              <a:off x="3150569" y="8391709"/>
              <a:ext cx="152400" cy="163134"/>
            </a:xfrm>
            <a:prstGeom prst="diamond">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2" name="TextBox 171">
              <a:extLst>
                <a:ext uri="{FF2B5EF4-FFF2-40B4-BE49-F238E27FC236}">
                  <a16:creationId xmlns:a16="http://schemas.microsoft.com/office/drawing/2014/main" id="{714FA87D-BA82-48E4-9490-3C65EF5BC4DE}"/>
                </a:ext>
              </a:extLst>
            </p:cNvPr>
            <p:cNvSpPr txBox="1"/>
            <p:nvPr/>
          </p:nvSpPr>
          <p:spPr>
            <a:xfrm>
              <a:off x="3281444" y="8371511"/>
              <a:ext cx="691215" cy="215444"/>
            </a:xfrm>
            <a:prstGeom prst="rect">
              <a:avLst/>
            </a:prstGeom>
            <a:noFill/>
          </p:spPr>
          <p:txBody>
            <a:bodyPr wrap="none" rtlCol="0">
              <a:spAutoFit/>
            </a:bodyPr>
            <a:lstStyle/>
            <a:p>
              <a:r>
                <a:rPr lang="en-US" sz="800" b="1" dirty="0">
                  <a:latin typeface="Arial" pitchFamily="34" charset="0"/>
                  <a:cs typeface="Arial" pitchFamily="34" charset="0"/>
                </a:rPr>
                <a:t>Sialic acid</a:t>
              </a:r>
            </a:p>
          </p:txBody>
        </p:sp>
      </p:grpSp>
    </p:spTree>
    <p:extLst>
      <p:ext uri="{BB962C8B-B14F-4D97-AF65-F5344CB8AC3E}">
        <p14:creationId xmlns:p14="http://schemas.microsoft.com/office/powerpoint/2010/main" val="1225171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TextBox 47">
            <a:extLst>
              <a:ext uri="{FF2B5EF4-FFF2-40B4-BE49-F238E27FC236}">
                <a16:creationId xmlns:a16="http://schemas.microsoft.com/office/drawing/2014/main" id="{9DDA394A-64E5-4C6D-AE36-EA3567992E48}"/>
              </a:ext>
            </a:extLst>
          </p:cNvPr>
          <p:cNvSpPr txBox="1"/>
          <p:nvPr/>
        </p:nvSpPr>
        <p:spPr>
          <a:xfrm>
            <a:off x="1691591" y="6354515"/>
            <a:ext cx="5234512" cy="3016210"/>
          </a:xfrm>
          <a:prstGeom prst="rect">
            <a:avLst/>
          </a:prstGeom>
          <a:noFill/>
        </p:spPr>
        <p:txBody>
          <a:bodyPr wrap="square" rtlCol="0">
            <a:spAutoFit/>
          </a:bodyPr>
          <a:lstStyle/>
          <a:p>
            <a:r>
              <a:rPr lang="en-US" sz="1000" b="1" dirty="0"/>
              <a:t>Supplemental Figure 2. The effect of sequential modification of  Man3 on recombinant H1N1 influenza viral neuraminidase by MGAT1, B4GalT1, ST6Gal1 on FUT8  labeling.</a:t>
            </a:r>
            <a:r>
              <a:rPr lang="en-US" sz="1000" dirty="0"/>
              <a:t> Recombinant 1918 H1N1 viral neuraminidase monomer (Mo) and dimer (Di) were used as substrates for the glycan modification. Pretreatment of the substrates for FUT8 labeling was performed by incubating the substrates with MGAT1, B4GalT1, and ST6Gal1 (in the presence of their donor substrates) for 30 minutes at 37</a:t>
            </a:r>
            <a:r>
              <a:rPr lang="en-US" sz="1000" baseline="30000" dirty="0"/>
              <a:t>o</a:t>
            </a:r>
            <a:r>
              <a:rPr lang="en-US" sz="1000" dirty="0"/>
              <a:t>C. Labeling was achieved by incubating the pretreated samples with the labeling enzymes FUT8 and the fluorescent donor substrate GDP-AF555-Fuc (555) or GDP-Cy5-Fuc (Cy5). For comparison, the dimeric neuraminidase was also pretreated with MGAT1 and FUT8 (in the presence of their donor substrates) at 37</a:t>
            </a:r>
            <a:r>
              <a:rPr lang="en-US" sz="1000" baseline="30000" dirty="0"/>
              <a:t>o</a:t>
            </a:r>
            <a:r>
              <a:rPr lang="en-US" sz="1000" dirty="0"/>
              <a:t>C for 30 minutes, and then labeled by incubating with B4GalT1 (B4) and ST6Gal1 (61) in the presence of the fluorescent donor substrates of CMP-AF555-SA or CMP-Cy5-SA. </a:t>
            </a:r>
          </a:p>
          <a:p>
            <a:endParaRPr lang="en-US" sz="1000" dirty="0"/>
          </a:p>
          <a:p>
            <a:r>
              <a:rPr lang="en-US" sz="1000" dirty="0"/>
              <a:t>This experiment demonstrate the following:</a:t>
            </a:r>
          </a:p>
          <a:p>
            <a:pPr marL="228598" indent="-228598">
              <a:buAutoNum type="arabicPeriod"/>
            </a:pPr>
            <a:r>
              <a:rPr lang="en-US" sz="1000" dirty="0"/>
              <a:t>The unmodified </a:t>
            </a:r>
            <a:r>
              <a:rPr lang="el-GR" sz="1000" dirty="0">
                <a:latin typeface="Calibri" panose="020F0502020204030204" pitchFamily="34" charset="0"/>
                <a:cs typeface="Calibri" panose="020F0502020204030204" pitchFamily="34" charset="0"/>
              </a:rPr>
              <a:t>α</a:t>
            </a:r>
            <a:r>
              <a:rPr lang="en-US" sz="1000" dirty="0"/>
              <a:t>1-3 arm </a:t>
            </a:r>
            <a:r>
              <a:rPr lang="en-US" sz="1000" dirty="0" err="1"/>
              <a:t>GlcNAc</a:t>
            </a:r>
            <a:r>
              <a:rPr lang="en-US" sz="1000" dirty="0"/>
              <a:t> residue introduced by MGAT1 is most critical for FUT8 recognition.  </a:t>
            </a:r>
          </a:p>
          <a:p>
            <a:pPr marL="228598" indent="-228598">
              <a:buAutoNum type="arabicPeriod"/>
            </a:pPr>
            <a:r>
              <a:rPr lang="en-US" sz="1000" dirty="0"/>
              <a:t>Extension of the 1-3 arm </a:t>
            </a:r>
            <a:r>
              <a:rPr lang="en-US" sz="1000" dirty="0" err="1"/>
              <a:t>GlcNAc</a:t>
            </a:r>
            <a:r>
              <a:rPr lang="en-US" sz="1000" dirty="0"/>
              <a:t> residue by B4Gal1 and ST6Ga1 significantly inhibit FUT8 recognition.</a:t>
            </a:r>
          </a:p>
          <a:p>
            <a:pPr marL="228598" indent="-228598">
              <a:buAutoNum type="arabicPeriod"/>
            </a:pPr>
            <a:r>
              <a:rPr lang="en-US" sz="1000" dirty="0"/>
              <a:t>While extension of the </a:t>
            </a:r>
            <a:r>
              <a:rPr lang="el-GR" sz="1000" dirty="0">
                <a:latin typeface="Calibri" panose="020F0502020204030204" pitchFamily="34" charset="0"/>
                <a:cs typeface="Calibri" panose="020F0502020204030204" pitchFamily="34" charset="0"/>
              </a:rPr>
              <a:t>α</a:t>
            </a:r>
            <a:r>
              <a:rPr lang="en-US" sz="1000" dirty="0"/>
              <a:t>1-3 arm </a:t>
            </a:r>
            <a:r>
              <a:rPr lang="en-US" sz="1000" dirty="0" err="1"/>
              <a:t>GlcNAc</a:t>
            </a:r>
            <a:r>
              <a:rPr lang="en-US" sz="1000" dirty="0"/>
              <a:t> residue by B4GalT1 and  ST6Gal1 inhibits core-6 </a:t>
            </a:r>
            <a:r>
              <a:rPr lang="en-US" sz="1000" dirty="0" err="1"/>
              <a:t>fucosylation</a:t>
            </a:r>
            <a:r>
              <a:rPr lang="en-US" sz="1000" dirty="0"/>
              <a:t>,  core-6 </a:t>
            </a:r>
            <a:r>
              <a:rPr lang="en-US" sz="1000" dirty="0" err="1"/>
              <a:t>fucosylation</a:t>
            </a:r>
            <a:r>
              <a:rPr lang="en-US" sz="1000" dirty="0"/>
              <a:t> has no obvious effect on ST6Gal1 substrate recognition.</a:t>
            </a:r>
          </a:p>
        </p:txBody>
      </p:sp>
      <p:grpSp>
        <p:nvGrpSpPr>
          <p:cNvPr id="8" name="Group 7">
            <a:extLst>
              <a:ext uri="{FF2B5EF4-FFF2-40B4-BE49-F238E27FC236}">
                <a16:creationId xmlns:a16="http://schemas.microsoft.com/office/drawing/2014/main" id="{9252A15F-E8EC-481E-86E9-5700FEECD697}"/>
              </a:ext>
            </a:extLst>
          </p:cNvPr>
          <p:cNvGrpSpPr/>
          <p:nvPr/>
        </p:nvGrpSpPr>
        <p:grpSpPr>
          <a:xfrm>
            <a:off x="1393823" y="1388636"/>
            <a:ext cx="5384942" cy="4842403"/>
            <a:chOff x="1747924" y="958323"/>
            <a:chExt cx="5376775" cy="4842403"/>
          </a:xfrm>
        </p:grpSpPr>
        <p:sp>
          <p:nvSpPr>
            <p:cNvPr id="131" name="TextBox 130">
              <a:extLst>
                <a:ext uri="{FF2B5EF4-FFF2-40B4-BE49-F238E27FC236}">
                  <a16:creationId xmlns:a16="http://schemas.microsoft.com/office/drawing/2014/main" id="{BC87B8B9-1D28-409A-81E9-80554CF41731}"/>
                </a:ext>
              </a:extLst>
            </p:cNvPr>
            <p:cNvSpPr txBox="1"/>
            <p:nvPr/>
          </p:nvSpPr>
          <p:spPr>
            <a:xfrm>
              <a:off x="1915557" y="2446865"/>
              <a:ext cx="453281" cy="246221"/>
            </a:xfrm>
            <a:prstGeom prst="rect">
              <a:avLst/>
            </a:prstGeom>
            <a:noFill/>
          </p:spPr>
          <p:txBody>
            <a:bodyPr wrap="none" rtlCol="0">
              <a:spAutoFit/>
            </a:bodyPr>
            <a:lstStyle/>
            <a:p>
              <a:r>
                <a:rPr lang="en-US" sz="1000" dirty="0"/>
                <a:t>FUT8</a:t>
              </a:r>
            </a:p>
          </p:txBody>
        </p:sp>
        <p:cxnSp>
          <p:nvCxnSpPr>
            <p:cNvPr id="132" name="Straight Arrow Connector 131">
              <a:extLst>
                <a:ext uri="{FF2B5EF4-FFF2-40B4-BE49-F238E27FC236}">
                  <a16:creationId xmlns:a16="http://schemas.microsoft.com/office/drawing/2014/main" id="{6261449D-56BF-4D7C-B2A4-DA9FCF6CD721}"/>
                </a:ext>
              </a:extLst>
            </p:cNvPr>
            <p:cNvCxnSpPr>
              <a:cxnSpLocks/>
            </p:cNvCxnSpPr>
            <p:nvPr/>
          </p:nvCxnSpPr>
          <p:spPr>
            <a:xfrm>
              <a:off x="2294792" y="2570444"/>
              <a:ext cx="1918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B6F0EDFE-4796-4842-8C4A-FFEF05B8EFDE}"/>
                </a:ext>
              </a:extLst>
            </p:cNvPr>
            <p:cNvSpPr txBox="1"/>
            <p:nvPr/>
          </p:nvSpPr>
          <p:spPr>
            <a:xfrm>
              <a:off x="6042502" y="958323"/>
              <a:ext cx="726980" cy="261610"/>
            </a:xfrm>
            <a:prstGeom prst="rect">
              <a:avLst/>
            </a:prstGeom>
            <a:noFill/>
          </p:spPr>
          <p:txBody>
            <a:bodyPr wrap="none" rtlCol="0">
              <a:spAutoFit/>
            </a:bodyPr>
            <a:lstStyle/>
            <a:p>
              <a:r>
                <a:rPr lang="en-US" sz="1100" dirty="0"/>
                <a:t>Mo/FUT8</a:t>
              </a:r>
            </a:p>
          </p:txBody>
        </p:sp>
        <p:cxnSp>
          <p:nvCxnSpPr>
            <p:cNvPr id="44" name="Straight Connector 43">
              <a:extLst>
                <a:ext uri="{FF2B5EF4-FFF2-40B4-BE49-F238E27FC236}">
                  <a16:creationId xmlns:a16="http://schemas.microsoft.com/office/drawing/2014/main" id="{5B859FC4-5B76-4969-A609-07BB66242B03}"/>
                </a:ext>
              </a:extLst>
            </p:cNvPr>
            <p:cNvCxnSpPr/>
            <p:nvPr/>
          </p:nvCxnSpPr>
          <p:spPr>
            <a:xfrm>
              <a:off x="5943956" y="13885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5E75BD64-513E-4098-9A96-15F4031A1C23}"/>
                </a:ext>
              </a:extLst>
            </p:cNvPr>
            <p:cNvSpPr txBox="1"/>
            <p:nvPr/>
          </p:nvSpPr>
          <p:spPr>
            <a:xfrm>
              <a:off x="2688712" y="958323"/>
              <a:ext cx="758991" cy="261610"/>
            </a:xfrm>
            <a:prstGeom prst="rect">
              <a:avLst/>
            </a:prstGeom>
            <a:noFill/>
          </p:spPr>
          <p:txBody>
            <a:bodyPr wrap="none" rtlCol="0">
              <a:spAutoFit/>
            </a:bodyPr>
            <a:lstStyle/>
            <a:p>
              <a:r>
                <a:rPr lang="en-US" sz="1100" dirty="0"/>
                <a:t> Mo/FUT8</a:t>
              </a:r>
            </a:p>
          </p:txBody>
        </p:sp>
        <p:cxnSp>
          <p:nvCxnSpPr>
            <p:cNvPr id="47" name="Straight Connector 46">
              <a:extLst>
                <a:ext uri="{FF2B5EF4-FFF2-40B4-BE49-F238E27FC236}">
                  <a16:creationId xmlns:a16="http://schemas.microsoft.com/office/drawing/2014/main" id="{BE315209-43D6-4401-AF06-093AC011C311}"/>
                </a:ext>
              </a:extLst>
            </p:cNvPr>
            <p:cNvCxnSpPr/>
            <p:nvPr/>
          </p:nvCxnSpPr>
          <p:spPr>
            <a:xfrm>
              <a:off x="2601400" y="13885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pic>
          <p:nvPicPr>
            <p:cNvPr id="4" name="Picture 3">
              <a:extLst>
                <a:ext uri="{FF2B5EF4-FFF2-40B4-BE49-F238E27FC236}">
                  <a16:creationId xmlns:a16="http://schemas.microsoft.com/office/drawing/2014/main" id="{10516DB3-E5BA-4D92-B718-8096E1AF790F}"/>
                </a:ext>
              </a:extLst>
            </p:cNvPr>
            <p:cNvPicPr>
              <a:picLocks noChangeAspect="1"/>
            </p:cNvPicPr>
            <p:nvPr/>
          </p:nvPicPr>
          <p:blipFill rotWithShape="1">
            <a:blip r:embed="rId3"/>
            <a:srcRect t="25870" b="38749"/>
            <a:stretch/>
          </p:blipFill>
          <p:spPr>
            <a:xfrm>
              <a:off x="2492429" y="2085975"/>
              <a:ext cx="4606138" cy="1190625"/>
            </a:xfrm>
            <a:prstGeom prst="rect">
              <a:avLst/>
            </a:prstGeom>
          </p:spPr>
        </p:pic>
        <p:sp>
          <p:nvSpPr>
            <p:cNvPr id="50" name="TextBox 49">
              <a:extLst>
                <a:ext uri="{FF2B5EF4-FFF2-40B4-BE49-F238E27FC236}">
                  <a16:creationId xmlns:a16="http://schemas.microsoft.com/office/drawing/2014/main" id="{92F6CAC5-F75C-4660-AE37-D54DD647BE3E}"/>
                </a:ext>
              </a:extLst>
            </p:cNvPr>
            <p:cNvSpPr txBox="1"/>
            <p:nvPr/>
          </p:nvSpPr>
          <p:spPr>
            <a:xfrm>
              <a:off x="3854765" y="958323"/>
              <a:ext cx="651753" cy="261610"/>
            </a:xfrm>
            <a:prstGeom prst="rect">
              <a:avLst/>
            </a:prstGeom>
            <a:noFill/>
          </p:spPr>
          <p:txBody>
            <a:bodyPr wrap="none" rtlCol="0">
              <a:spAutoFit/>
            </a:bodyPr>
            <a:lstStyle/>
            <a:p>
              <a:r>
                <a:rPr lang="en-US" sz="1100" dirty="0"/>
                <a:t>Di/FUT8</a:t>
              </a:r>
            </a:p>
          </p:txBody>
        </p:sp>
        <p:cxnSp>
          <p:nvCxnSpPr>
            <p:cNvPr id="52" name="Straight Connector 51">
              <a:extLst>
                <a:ext uri="{FF2B5EF4-FFF2-40B4-BE49-F238E27FC236}">
                  <a16:creationId xmlns:a16="http://schemas.microsoft.com/office/drawing/2014/main" id="{80742CC1-7DEF-4C84-8F54-2AABC420D7A2}"/>
                </a:ext>
              </a:extLst>
            </p:cNvPr>
            <p:cNvCxnSpPr/>
            <p:nvPr/>
          </p:nvCxnSpPr>
          <p:spPr>
            <a:xfrm>
              <a:off x="3690814" y="11980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259DEA8A-7FDD-4349-BD0F-EB9D27B61D47}"/>
                </a:ext>
              </a:extLst>
            </p:cNvPr>
            <p:cNvSpPr txBox="1"/>
            <p:nvPr/>
          </p:nvSpPr>
          <p:spPr>
            <a:xfrm>
              <a:off x="4915252" y="958323"/>
              <a:ext cx="784601" cy="261610"/>
            </a:xfrm>
            <a:prstGeom prst="rect">
              <a:avLst/>
            </a:prstGeom>
            <a:noFill/>
          </p:spPr>
          <p:txBody>
            <a:bodyPr wrap="none" rtlCol="0">
              <a:spAutoFit/>
            </a:bodyPr>
            <a:lstStyle/>
            <a:p>
              <a:r>
                <a:rPr lang="en-US" sz="1100" dirty="0"/>
                <a:t>Di/B4 + 61</a:t>
              </a:r>
            </a:p>
          </p:txBody>
        </p:sp>
        <p:cxnSp>
          <p:nvCxnSpPr>
            <p:cNvPr id="55" name="Straight Connector 54">
              <a:extLst>
                <a:ext uri="{FF2B5EF4-FFF2-40B4-BE49-F238E27FC236}">
                  <a16:creationId xmlns:a16="http://schemas.microsoft.com/office/drawing/2014/main" id="{023EB5DB-5F21-4010-8020-BF75FD00F4A4}"/>
                </a:ext>
              </a:extLst>
            </p:cNvPr>
            <p:cNvCxnSpPr/>
            <p:nvPr/>
          </p:nvCxnSpPr>
          <p:spPr>
            <a:xfrm>
              <a:off x="4841341" y="11980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508CC84A-05F2-44A5-86DE-783C56F66544}"/>
                </a:ext>
              </a:extLst>
            </p:cNvPr>
            <p:cNvCxnSpPr/>
            <p:nvPr/>
          </p:nvCxnSpPr>
          <p:spPr>
            <a:xfrm>
              <a:off x="3652714" y="1388578"/>
              <a:ext cx="443092"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5C1611C8-96E6-4519-8AE8-A54CF928BD10}"/>
                </a:ext>
              </a:extLst>
            </p:cNvPr>
            <p:cNvCxnSpPr/>
            <p:nvPr/>
          </p:nvCxnSpPr>
          <p:spPr>
            <a:xfrm>
              <a:off x="4215435" y="1388578"/>
              <a:ext cx="443092"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C9C5A84E-9345-4EC6-A27F-2C4E86DB4BA4}"/>
                </a:ext>
              </a:extLst>
            </p:cNvPr>
            <p:cNvCxnSpPr/>
            <p:nvPr/>
          </p:nvCxnSpPr>
          <p:spPr>
            <a:xfrm>
              <a:off x="4793640" y="1388578"/>
              <a:ext cx="443092"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9234EDB7-C6DE-4992-8EF9-47A4C1791B57}"/>
                </a:ext>
              </a:extLst>
            </p:cNvPr>
            <p:cNvCxnSpPr/>
            <p:nvPr/>
          </p:nvCxnSpPr>
          <p:spPr>
            <a:xfrm>
              <a:off x="5341584" y="1388578"/>
              <a:ext cx="443092" cy="0"/>
            </a:xfrm>
            <a:prstGeom prst="line">
              <a:avLst/>
            </a:prstGeom>
            <a:ln w="12700"/>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950E4673-D55F-4F65-8B91-DC1EAD4A9809}"/>
                </a:ext>
              </a:extLst>
            </p:cNvPr>
            <p:cNvSpPr txBox="1"/>
            <p:nvPr/>
          </p:nvSpPr>
          <p:spPr>
            <a:xfrm>
              <a:off x="3711330" y="1173736"/>
              <a:ext cx="381257" cy="246221"/>
            </a:xfrm>
            <a:prstGeom prst="rect">
              <a:avLst/>
            </a:prstGeom>
            <a:noFill/>
          </p:spPr>
          <p:txBody>
            <a:bodyPr wrap="none" rtlCol="0">
              <a:spAutoFit/>
            </a:bodyPr>
            <a:lstStyle/>
            <a:p>
              <a:r>
                <a:rPr lang="en-US" sz="1000" dirty="0"/>
                <a:t>555</a:t>
              </a:r>
            </a:p>
          </p:txBody>
        </p:sp>
        <p:sp>
          <p:nvSpPr>
            <p:cNvPr id="63" name="TextBox 62">
              <a:extLst>
                <a:ext uri="{FF2B5EF4-FFF2-40B4-BE49-F238E27FC236}">
                  <a16:creationId xmlns:a16="http://schemas.microsoft.com/office/drawing/2014/main" id="{28EA9B71-50ED-4224-9A98-2DE9DDB33684}"/>
                </a:ext>
              </a:extLst>
            </p:cNvPr>
            <p:cNvSpPr txBox="1"/>
            <p:nvPr/>
          </p:nvSpPr>
          <p:spPr>
            <a:xfrm>
              <a:off x="4848390" y="1173736"/>
              <a:ext cx="381257" cy="246221"/>
            </a:xfrm>
            <a:prstGeom prst="rect">
              <a:avLst/>
            </a:prstGeom>
            <a:noFill/>
          </p:spPr>
          <p:txBody>
            <a:bodyPr wrap="none" rtlCol="0">
              <a:spAutoFit/>
            </a:bodyPr>
            <a:lstStyle/>
            <a:p>
              <a:r>
                <a:rPr lang="en-US" sz="1000" dirty="0"/>
                <a:t>555</a:t>
              </a:r>
            </a:p>
          </p:txBody>
        </p:sp>
        <p:sp>
          <p:nvSpPr>
            <p:cNvPr id="64" name="TextBox 63">
              <a:extLst>
                <a:ext uri="{FF2B5EF4-FFF2-40B4-BE49-F238E27FC236}">
                  <a16:creationId xmlns:a16="http://schemas.microsoft.com/office/drawing/2014/main" id="{7301E03C-66C9-4FD9-BACF-26508BC75FEE}"/>
                </a:ext>
              </a:extLst>
            </p:cNvPr>
            <p:cNvSpPr txBox="1"/>
            <p:nvPr/>
          </p:nvSpPr>
          <p:spPr>
            <a:xfrm>
              <a:off x="4258490" y="1173736"/>
              <a:ext cx="376454" cy="246221"/>
            </a:xfrm>
            <a:prstGeom prst="rect">
              <a:avLst/>
            </a:prstGeom>
            <a:noFill/>
          </p:spPr>
          <p:txBody>
            <a:bodyPr wrap="none" rtlCol="0">
              <a:spAutoFit/>
            </a:bodyPr>
            <a:lstStyle/>
            <a:p>
              <a:r>
                <a:rPr lang="en-US" sz="1000" dirty="0"/>
                <a:t>Cy5</a:t>
              </a:r>
            </a:p>
          </p:txBody>
        </p:sp>
        <p:sp>
          <p:nvSpPr>
            <p:cNvPr id="65" name="TextBox 64">
              <a:extLst>
                <a:ext uri="{FF2B5EF4-FFF2-40B4-BE49-F238E27FC236}">
                  <a16:creationId xmlns:a16="http://schemas.microsoft.com/office/drawing/2014/main" id="{6914CF17-2369-4696-AA4B-12E6991CDB31}"/>
                </a:ext>
              </a:extLst>
            </p:cNvPr>
            <p:cNvSpPr txBox="1"/>
            <p:nvPr/>
          </p:nvSpPr>
          <p:spPr>
            <a:xfrm>
              <a:off x="5368527" y="1173736"/>
              <a:ext cx="376454" cy="246221"/>
            </a:xfrm>
            <a:prstGeom prst="rect">
              <a:avLst/>
            </a:prstGeom>
            <a:noFill/>
          </p:spPr>
          <p:txBody>
            <a:bodyPr wrap="none" rtlCol="0">
              <a:spAutoFit/>
            </a:bodyPr>
            <a:lstStyle/>
            <a:p>
              <a:r>
                <a:rPr lang="en-US" sz="1000" dirty="0"/>
                <a:t>Cy5</a:t>
              </a:r>
            </a:p>
          </p:txBody>
        </p:sp>
        <p:pic>
          <p:nvPicPr>
            <p:cNvPr id="12" name="Picture 11">
              <a:extLst>
                <a:ext uri="{FF2B5EF4-FFF2-40B4-BE49-F238E27FC236}">
                  <a16:creationId xmlns:a16="http://schemas.microsoft.com/office/drawing/2014/main" id="{EF7A7FEF-FEF1-4470-98A8-A0BC6A9F4806}"/>
                </a:ext>
              </a:extLst>
            </p:cNvPr>
            <p:cNvPicPr>
              <a:picLocks noChangeAspect="1"/>
            </p:cNvPicPr>
            <p:nvPr/>
          </p:nvPicPr>
          <p:blipFill rotWithShape="1">
            <a:blip r:embed="rId4"/>
            <a:srcRect l="1874" t="21206" b="20394"/>
            <a:stretch/>
          </p:blipFill>
          <p:spPr>
            <a:xfrm>
              <a:off x="2488223" y="3314699"/>
              <a:ext cx="4604042" cy="1200151"/>
            </a:xfrm>
            <a:prstGeom prst="rect">
              <a:avLst/>
            </a:prstGeom>
          </p:spPr>
        </p:pic>
        <p:pic>
          <p:nvPicPr>
            <p:cNvPr id="5" name="Picture 4">
              <a:extLst>
                <a:ext uri="{FF2B5EF4-FFF2-40B4-BE49-F238E27FC236}">
                  <a16:creationId xmlns:a16="http://schemas.microsoft.com/office/drawing/2014/main" id="{89DA921C-402D-4285-AF03-C653AC94A29B}"/>
                </a:ext>
              </a:extLst>
            </p:cNvPr>
            <p:cNvPicPr>
              <a:picLocks noChangeAspect="1"/>
            </p:cNvPicPr>
            <p:nvPr/>
          </p:nvPicPr>
          <p:blipFill rotWithShape="1">
            <a:blip r:embed="rId5"/>
            <a:srcRect l="20991" t="17502" b="37868"/>
            <a:stretch/>
          </p:blipFill>
          <p:spPr>
            <a:xfrm>
              <a:off x="2488223" y="4543426"/>
              <a:ext cx="4607902" cy="1257300"/>
            </a:xfrm>
            <a:prstGeom prst="rect">
              <a:avLst/>
            </a:prstGeom>
          </p:spPr>
        </p:pic>
        <p:sp>
          <p:nvSpPr>
            <p:cNvPr id="49" name="TextBox 48">
              <a:extLst>
                <a:ext uri="{FF2B5EF4-FFF2-40B4-BE49-F238E27FC236}">
                  <a16:creationId xmlns:a16="http://schemas.microsoft.com/office/drawing/2014/main" id="{13AA5128-0B9F-4AEF-B324-1A3852D63DC5}"/>
                </a:ext>
              </a:extLst>
            </p:cNvPr>
            <p:cNvSpPr txBox="1"/>
            <p:nvPr/>
          </p:nvSpPr>
          <p:spPr>
            <a:xfrm>
              <a:off x="2808492" y="1173736"/>
              <a:ext cx="376454" cy="246221"/>
            </a:xfrm>
            <a:prstGeom prst="rect">
              <a:avLst/>
            </a:prstGeom>
            <a:noFill/>
          </p:spPr>
          <p:txBody>
            <a:bodyPr wrap="none" rtlCol="0">
              <a:spAutoFit/>
            </a:bodyPr>
            <a:lstStyle/>
            <a:p>
              <a:r>
                <a:rPr lang="en-US" sz="1000" dirty="0"/>
                <a:t>Cy5</a:t>
              </a:r>
            </a:p>
          </p:txBody>
        </p:sp>
        <p:sp>
          <p:nvSpPr>
            <p:cNvPr id="54" name="TextBox 53">
              <a:extLst>
                <a:ext uri="{FF2B5EF4-FFF2-40B4-BE49-F238E27FC236}">
                  <a16:creationId xmlns:a16="http://schemas.microsoft.com/office/drawing/2014/main" id="{5BD6A5A5-4D30-4E7D-A004-437119662C89}"/>
                </a:ext>
              </a:extLst>
            </p:cNvPr>
            <p:cNvSpPr txBox="1"/>
            <p:nvPr/>
          </p:nvSpPr>
          <p:spPr>
            <a:xfrm>
              <a:off x="6169842" y="1173736"/>
              <a:ext cx="376454" cy="246221"/>
            </a:xfrm>
            <a:prstGeom prst="rect">
              <a:avLst/>
            </a:prstGeom>
            <a:noFill/>
          </p:spPr>
          <p:txBody>
            <a:bodyPr wrap="none" rtlCol="0">
              <a:spAutoFit/>
            </a:bodyPr>
            <a:lstStyle/>
            <a:p>
              <a:r>
                <a:rPr lang="en-US" sz="1000" dirty="0"/>
                <a:t>Cy5</a:t>
              </a:r>
            </a:p>
          </p:txBody>
        </p:sp>
        <p:cxnSp>
          <p:nvCxnSpPr>
            <p:cNvPr id="57" name="Straight Connector 56">
              <a:extLst>
                <a:ext uri="{FF2B5EF4-FFF2-40B4-BE49-F238E27FC236}">
                  <a16:creationId xmlns:a16="http://schemas.microsoft.com/office/drawing/2014/main" id="{F14D511B-E380-42B9-AA50-C3D0B1462958}"/>
                </a:ext>
              </a:extLst>
            </p:cNvPr>
            <p:cNvCxnSpPr/>
            <p:nvPr/>
          </p:nvCxnSpPr>
          <p:spPr>
            <a:xfrm>
              <a:off x="5943956" y="11980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EBCBF68F-5147-412C-9CA0-38B6AA81A224}"/>
                </a:ext>
              </a:extLst>
            </p:cNvPr>
            <p:cNvCxnSpPr/>
            <p:nvPr/>
          </p:nvCxnSpPr>
          <p:spPr>
            <a:xfrm>
              <a:off x="2601657" y="1198078"/>
              <a:ext cx="886185" cy="0"/>
            </a:xfrm>
            <a:prstGeom prst="line">
              <a:avLst/>
            </a:prstGeom>
            <a:ln w="12700"/>
          </p:spPr>
          <p:style>
            <a:lnRef idx="1">
              <a:schemeClr val="accent1"/>
            </a:lnRef>
            <a:fillRef idx="0">
              <a:schemeClr val="accent1"/>
            </a:fillRef>
            <a:effectRef idx="0">
              <a:schemeClr val="accent1"/>
            </a:effectRef>
            <a:fontRef idx="minor">
              <a:schemeClr val="tx1"/>
            </a:fontRef>
          </p:style>
        </p:cxnSp>
        <p:sp>
          <p:nvSpPr>
            <p:cNvPr id="66" name="TextBox 65">
              <a:extLst>
                <a:ext uri="{FF2B5EF4-FFF2-40B4-BE49-F238E27FC236}">
                  <a16:creationId xmlns:a16="http://schemas.microsoft.com/office/drawing/2014/main" id="{31ACA9AB-223E-4AA2-9136-343475B7D9B5}"/>
                </a:ext>
              </a:extLst>
            </p:cNvPr>
            <p:cNvSpPr txBox="1"/>
            <p:nvPr/>
          </p:nvSpPr>
          <p:spPr>
            <a:xfrm>
              <a:off x="1747924" y="1175933"/>
              <a:ext cx="904643" cy="261610"/>
            </a:xfrm>
            <a:prstGeom prst="rect">
              <a:avLst/>
            </a:prstGeom>
            <a:noFill/>
          </p:spPr>
          <p:txBody>
            <a:bodyPr wrap="none" rtlCol="0">
              <a:spAutoFit/>
            </a:bodyPr>
            <a:lstStyle/>
            <a:p>
              <a:r>
                <a:rPr lang="en-US" sz="1100" b="1" dirty="0"/>
                <a:t>Fluorophore</a:t>
              </a:r>
            </a:p>
          </p:txBody>
        </p:sp>
        <p:sp>
          <p:nvSpPr>
            <p:cNvPr id="69" name="TextBox 68">
              <a:extLst>
                <a:ext uri="{FF2B5EF4-FFF2-40B4-BE49-F238E27FC236}">
                  <a16:creationId xmlns:a16="http://schemas.microsoft.com/office/drawing/2014/main" id="{AE458BC7-F689-49F7-8140-3BFF0D8CA599}"/>
                </a:ext>
              </a:extLst>
            </p:cNvPr>
            <p:cNvSpPr txBox="1"/>
            <p:nvPr/>
          </p:nvSpPr>
          <p:spPr>
            <a:xfrm>
              <a:off x="1898126" y="958323"/>
              <a:ext cx="670960" cy="261610"/>
            </a:xfrm>
            <a:prstGeom prst="rect">
              <a:avLst/>
            </a:prstGeom>
            <a:noFill/>
          </p:spPr>
          <p:txBody>
            <a:bodyPr wrap="none" rtlCol="0">
              <a:spAutoFit/>
            </a:bodyPr>
            <a:lstStyle/>
            <a:p>
              <a:r>
                <a:rPr lang="en-US" sz="1100" b="1" dirty="0"/>
                <a:t>Labeling</a:t>
              </a:r>
            </a:p>
          </p:txBody>
        </p:sp>
        <p:sp>
          <p:nvSpPr>
            <p:cNvPr id="71" name="TextBox 70">
              <a:extLst>
                <a:ext uri="{FF2B5EF4-FFF2-40B4-BE49-F238E27FC236}">
                  <a16:creationId xmlns:a16="http://schemas.microsoft.com/office/drawing/2014/main" id="{691685C2-6F90-4C21-B71E-1348AA4D44E6}"/>
                </a:ext>
              </a:extLst>
            </p:cNvPr>
            <p:cNvSpPr txBox="1"/>
            <p:nvPr/>
          </p:nvSpPr>
          <p:spPr>
            <a:xfrm>
              <a:off x="1825351" y="1406856"/>
              <a:ext cx="2891621" cy="769441"/>
            </a:xfrm>
            <a:prstGeom prst="rect">
              <a:avLst/>
            </a:prstGeom>
            <a:noFill/>
          </p:spPr>
          <p:txBody>
            <a:bodyPr wrap="square" rtlCol="0">
              <a:spAutoFit/>
            </a:bodyPr>
            <a:lstStyle/>
            <a:p>
              <a:r>
                <a:rPr lang="en-US" sz="1100" b="1" dirty="0">
                  <a:latin typeface="Courier New" panose="02070309020205020404" pitchFamily="49" charset="0"/>
                  <a:cs typeface="Courier New" panose="02070309020205020404" pitchFamily="49" charset="0"/>
                </a:rPr>
                <a:t>MGAT1       +  +  +           </a:t>
              </a:r>
            </a:p>
            <a:p>
              <a:r>
                <a:rPr lang="en-US" sz="1100" b="1" dirty="0">
                  <a:latin typeface="Courier New" panose="02070309020205020404" pitchFamily="49" charset="0"/>
                  <a:cs typeface="Courier New" panose="02070309020205020404" pitchFamily="49" charset="0"/>
                </a:rPr>
                <a:t>B4GalT1        +  + </a:t>
              </a:r>
            </a:p>
            <a:p>
              <a:r>
                <a:rPr lang="en-US" sz="1100" b="1" dirty="0">
                  <a:latin typeface="Courier New" panose="02070309020205020404" pitchFamily="49" charset="0"/>
                  <a:cs typeface="Courier New" panose="02070309020205020404" pitchFamily="49" charset="0"/>
                </a:rPr>
                <a:t>ST6Gal1           + </a:t>
              </a:r>
            </a:p>
            <a:p>
              <a:r>
                <a:rPr lang="en-US" sz="1100" b="1" dirty="0">
                  <a:latin typeface="Courier New" panose="02070309020205020404" pitchFamily="49" charset="0"/>
                  <a:cs typeface="Courier New" panose="02070309020205020404" pitchFamily="49" charset="0"/>
                </a:rPr>
                <a:t>FUT8            </a:t>
              </a:r>
            </a:p>
          </p:txBody>
        </p:sp>
        <p:sp>
          <p:nvSpPr>
            <p:cNvPr id="72" name="TextBox 71">
              <a:extLst>
                <a:ext uri="{FF2B5EF4-FFF2-40B4-BE49-F238E27FC236}">
                  <a16:creationId xmlns:a16="http://schemas.microsoft.com/office/drawing/2014/main" id="{F0B98ADD-4B4B-4767-AE8D-3BAF7C5F6ED3}"/>
                </a:ext>
              </a:extLst>
            </p:cNvPr>
            <p:cNvSpPr txBox="1"/>
            <p:nvPr/>
          </p:nvSpPr>
          <p:spPr>
            <a:xfrm>
              <a:off x="3630775" y="1397130"/>
              <a:ext cx="1084100" cy="600164"/>
            </a:xfrm>
            <a:prstGeom prst="rect">
              <a:avLst/>
            </a:prstGeom>
            <a:noFill/>
          </p:spPr>
          <p:txBody>
            <a:bodyPr wrap="square" rtlCol="0">
              <a:spAutoFit/>
            </a:bodyPr>
            <a:lstStyle/>
            <a:p>
              <a:r>
                <a:rPr lang="en-US" sz="1100" b="1" dirty="0">
                  <a:latin typeface="Courier New" panose="02070309020205020404" pitchFamily="49" charset="0"/>
                  <a:cs typeface="Courier New" panose="02070309020205020404" pitchFamily="49" charset="0"/>
                </a:rPr>
                <a:t>+  +  +  +         </a:t>
              </a:r>
            </a:p>
            <a:p>
              <a:r>
                <a:rPr lang="en-US" sz="1100" b="1" dirty="0">
                  <a:latin typeface="Courier New" panose="02070309020205020404" pitchFamily="49" charset="0"/>
                  <a:cs typeface="Courier New" panose="02070309020205020404" pitchFamily="49" charset="0"/>
                </a:rPr>
                <a:t>   +     +</a:t>
              </a:r>
            </a:p>
            <a:p>
              <a:r>
                <a:rPr lang="en-US" sz="1100" b="1" dirty="0">
                  <a:latin typeface="Courier New" panose="02070309020205020404" pitchFamily="49" charset="0"/>
                  <a:cs typeface="Courier New" panose="02070309020205020404" pitchFamily="49" charset="0"/>
                </a:rPr>
                <a:t>   +     +            </a:t>
              </a:r>
            </a:p>
          </p:txBody>
        </p:sp>
        <p:sp>
          <p:nvSpPr>
            <p:cNvPr id="73" name="TextBox 72">
              <a:extLst>
                <a:ext uri="{FF2B5EF4-FFF2-40B4-BE49-F238E27FC236}">
                  <a16:creationId xmlns:a16="http://schemas.microsoft.com/office/drawing/2014/main" id="{7097560F-BB44-47FE-BAAF-ECF5BEEB41C7}"/>
                </a:ext>
              </a:extLst>
            </p:cNvPr>
            <p:cNvSpPr txBox="1"/>
            <p:nvPr/>
          </p:nvSpPr>
          <p:spPr>
            <a:xfrm>
              <a:off x="4745200" y="1397130"/>
              <a:ext cx="1084100" cy="769441"/>
            </a:xfrm>
            <a:prstGeom prst="rect">
              <a:avLst/>
            </a:prstGeom>
            <a:noFill/>
          </p:spPr>
          <p:txBody>
            <a:bodyPr wrap="square" rtlCol="0">
              <a:spAutoFit/>
            </a:bodyPr>
            <a:lstStyle/>
            <a:p>
              <a:r>
                <a:rPr lang="en-US" sz="1100" b="1" dirty="0">
                  <a:latin typeface="Courier New" panose="02070309020205020404" pitchFamily="49" charset="0"/>
                  <a:cs typeface="Courier New" panose="02070309020205020404" pitchFamily="49" charset="0"/>
                </a:rPr>
                <a:t>+  +  +  +         </a:t>
              </a:r>
            </a:p>
            <a:p>
              <a:r>
                <a:rPr lang="en-US" sz="1100" b="1" dirty="0">
                  <a:latin typeface="Courier New" panose="02070309020205020404" pitchFamily="49" charset="0"/>
                  <a:cs typeface="Courier New" panose="02070309020205020404" pitchFamily="49" charset="0"/>
                </a:rPr>
                <a:t>+     +   </a:t>
              </a:r>
            </a:p>
            <a:p>
              <a:endParaRPr lang="en-US" sz="1100" b="1" dirty="0">
                <a:latin typeface="Courier New" panose="02070309020205020404" pitchFamily="49" charset="0"/>
                <a:cs typeface="Courier New" panose="02070309020205020404" pitchFamily="49" charset="0"/>
              </a:endParaRPr>
            </a:p>
            <a:p>
              <a:r>
                <a:rPr lang="en-US" sz="1100" b="1" dirty="0">
                  <a:latin typeface="Courier New" panose="02070309020205020404" pitchFamily="49" charset="0"/>
                  <a:cs typeface="Courier New" panose="02070309020205020404" pitchFamily="49" charset="0"/>
                </a:rPr>
                <a:t>   +     +            </a:t>
              </a:r>
            </a:p>
          </p:txBody>
        </p:sp>
        <p:sp>
          <p:nvSpPr>
            <p:cNvPr id="74" name="TextBox 73">
              <a:extLst>
                <a:ext uri="{FF2B5EF4-FFF2-40B4-BE49-F238E27FC236}">
                  <a16:creationId xmlns:a16="http://schemas.microsoft.com/office/drawing/2014/main" id="{1B133966-50B7-4780-90E6-F79F33A9973D}"/>
                </a:ext>
              </a:extLst>
            </p:cNvPr>
            <p:cNvSpPr txBox="1"/>
            <p:nvPr/>
          </p:nvSpPr>
          <p:spPr>
            <a:xfrm>
              <a:off x="5859624" y="1406655"/>
              <a:ext cx="1265075" cy="600164"/>
            </a:xfrm>
            <a:prstGeom prst="rect">
              <a:avLst/>
            </a:prstGeom>
            <a:noFill/>
          </p:spPr>
          <p:txBody>
            <a:bodyPr wrap="square" rtlCol="0">
              <a:spAutoFit/>
            </a:bodyPr>
            <a:lstStyle/>
            <a:p>
              <a:r>
                <a:rPr lang="en-US" sz="1100" b="1" dirty="0">
                  <a:latin typeface="Courier New" panose="02070309020205020404" pitchFamily="49" charset="0"/>
                  <a:cs typeface="Courier New" panose="02070309020205020404" pitchFamily="49" charset="0"/>
                </a:rPr>
                <a:t>   +   +  +         </a:t>
              </a:r>
            </a:p>
            <a:p>
              <a:r>
                <a:rPr lang="en-US" sz="1100" b="1" dirty="0">
                  <a:latin typeface="Courier New" panose="02070309020205020404" pitchFamily="49" charset="0"/>
                  <a:cs typeface="Courier New" panose="02070309020205020404" pitchFamily="49" charset="0"/>
                </a:rPr>
                <a:t>       +  +</a:t>
              </a:r>
            </a:p>
            <a:p>
              <a:r>
                <a:rPr lang="en-US" sz="1100" b="1" dirty="0">
                  <a:latin typeface="Courier New" panose="02070309020205020404" pitchFamily="49" charset="0"/>
                  <a:cs typeface="Courier New" panose="02070309020205020404" pitchFamily="49" charset="0"/>
                </a:rPr>
                <a:t>          +            </a:t>
              </a:r>
            </a:p>
          </p:txBody>
        </p:sp>
      </p:grpSp>
    </p:spTree>
    <p:extLst>
      <p:ext uri="{BB962C8B-B14F-4D97-AF65-F5344CB8AC3E}">
        <p14:creationId xmlns:p14="http://schemas.microsoft.com/office/powerpoint/2010/main" val="4128913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631</TotalTime>
  <Words>496</Words>
  <Application>Microsoft Office PowerPoint</Application>
  <PresentationFormat>Custom</PresentationFormat>
  <Paragraphs>97</Paragraphs>
  <Slides>2</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Courier New</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on Wu</dc:creator>
  <cp:lastModifiedBy>zhengliang wu</cp:lastModifiedBy>
  <cp:revision>125</cp:revision>
  <dcterms:created xsi:type="dcterms:W3CDTF">2019-01-16T18:40:53Z</dcterms:created>
  <dcterms:modified xsi:type="dcterms:W3CDTF">2020-01-28T04:08:21Z</dcterms:modified>
</cp:coreProperties>
</file>